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 id="2147483733" r:id="rId2"/>
  </p:sldMasterIdLst>
  <p:notesMasterIdLst>
    <p:notesMasterId r:id="rId24"/>
  </p:notesMasterIdLst>
  <p:sldIdLst>
    <p:sldId id="574" r:id="rId3"/>
    <p:sldId id="276" r:id="rId4"/>
    <p:sldId id="573" r:id="rId5"/>
    <p:sldId id="576" r:id="rId6"/>
    <p:sldId id="4105" r:id="rId7"/>
    <p:sldId id="4119" r:id="rId8"/>
    <p:sldId id="4121" r:id="rId9"/>
    <p:sldId id="4127" r:id="rId10"/>
    <p:sldId id="4111" r:id="rId11"/>
    <p:sldId id="4112" r:id="rId12"/>
    <p:sldId id="4113" r:id="rId13"/>
    <p:sldId id="4133" r:id="rId14"/>
    <p:sldId id="4140" r:id="rId15"/>
    <p:sldId id="4142" r:id="rId16"/>
    <p:sldId id="3378" r:id="rId17"/>
    <p:sldId id="4131" r:id="rId18"/>
    <p:sldId id="4129" r:id="rId19"/>
    <p:sldId id="4130" r:id="rId20"/>
    <p:sldId id="4143" r:id="rId21"/>
    <p:sldId id="4132" r:id="rId22"/>
    <p:sldId id="4107" r:id="rId2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Grace Lee" initials="GL" lastIdx="13" clrIdx="0">
    <p:extLst>
      <p:ext uri="{19B8F6BF-5375-455C-9EA6-DF929625EA0E}">
        <p15:presenceInfo xmlns:p15="http://schemas.microsoft.com/office/powerpoint/2012/main" userId="S::grace.lee@sydney.edu.au::fd145552-a10d-4a31-a438-f8736fd84277"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EF8025"/>
    <a:srgbClr val="E6462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16AA00A-12D3-4356-855A-AAECC1B3E2E6}" v="5" dt="2023-04-14T03:41:44.84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021"/>
    <p:restoredTop sz="95313"/>
  </p:normalViewPr>
  <p:slideViewPr>
    <p:cSldViewPr snapToGrid="0">
      <p:cViewPr varScale="1">
        <p:scale>
          <a:sx n="106" d="100"/>
          <a:sy n="106" d="100"/>
        </p:scale>
        <p:origin x="1974" y="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presProps" Target="presProps.xml"/><Relationship Id="rId3" Type="http://schemas.openxmlformats.org/officeDocument/2006/relationships/slide" Target="slides/slide1.xml"/><Relationship Id="rId21" Type="http://schemas.openxmlformats.org/officeDocument/2006/relationships/slide" Target="slides/slide19.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commentAuthors" Target="commentAuthors.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notesMaster" Target="notesMasters/notesMaster1.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theme" Target="theme/theme1.xml"/><Relationship Id="rId10" Type="http://schemas.openxmlformats.org/officeDocument/2006/relationships/slide" Target="slides/slide8.xml"/><Relationship Id="rId19" Type="http://schemas.openxmlformats.org/officeDocument/2006/relationships/slide" Target="slides/slide17.xml"/><Relationship Id="rId31" Type="http://schemas.microsoft.com/office/2015/10/relationships/revisionInfo" Target="revisionInfo.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viewProps" Target="viewProps.xml"/><Relationship Id="rId30"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race Lee" userId="fd145552-a10d-4a31-a438-f8736fd84277" providerId="ADAL" clId="{EDCE6299-B909-6840-AE8F-8D55B29E9D82}"/>
    <pc:docChg chg="undo redo custSel addSld delSld modSld sldOrd delMainMaster">
      <pc:chgData name="Grace Lee" userId="fd145552-a10d-4a31-a438-f8736fd84277" providerId="ADAL" clId="{EDCE6299-B909-6840-AE8F-8D55B29E9D82}" dt="2021-09-15T09:10:26.545" v="5420" actId="20577"/>
      <pc:docMkLst>
        <pc:docMk/>
      </pc:docMkLst>
      <pc:sldChg chg="addSp delSp modSp mod">
        <pc:chgData name="Grace Lee" userId="fd145552-a10d-4a31-a438-f8736fd84277" providerId="ADAL" clId="{EDCE6299-B909-6840-AE8F-8D55B29E9D82}" dt="2021-09-15T01:38:15.312" v="3149" actId="14100"/>
        <pc:sldMkLst>
          <pc:docMk/>
          <pc:sldMk cId="187938002" sldId="3307"/>
        </pc:sldMkLst>
        <pc:spChg chg="mod">
          <ac:chgData name="Grace Lee" userId="fd145552-a10d-4a31-a438-f8736fd84277" providerId="ADAL" clId="{EDCE6299-B909-6840-AE8F-8D55B29E9D82}" dt="2021-09-13T22:44:45.801" v="1630" actId="1076"/>
          <ac:spMkLst>
            <pc:docMk/>
            <pc:sldMk cId="187938002" sldId="3307"/>
            <ac:spMk id="12" creationId="{9F619023-99B5-D048-963C-2919297AAD8E}"/>
          </ac:spMkLst>
        </pc:spChg>
        <pc:spChg chg="mod">
          <ac:chgData name="Grace Lee" userId="fd145552-a10d-4a31-a438-f8736fd84277" providerId="ADAL" clId="{EDCE6299-B909-6840-AE8F-8D55B29E9D82}" dt="2021-09-13T22:44:45.801" v="1630" actId="1076"/>
          <ac:spMkLst>
            <pc:docMk/>
            <pc:sldMk cId="187938002" sldId="3307"/>
            <ac:spMk id="14" creationId="{EE644C53-6D18-3B45-8ACC-5347164E1A9E}"/>
          </ac:spMkLst>
        </pc:spChg>
        <pc:spChg chg="mod">
          <ac:chgData name="Grace Lee" userId="fd145552-a10d-4a31-a438-f8736fd84277" providerId="ADAL" clId="{EDCE6299-B909-6840-AE8F-8D55B29E9D82}" dt="2021-09-13T22:44:45.801" v="1630" actId="1076"/>
          <ac:spMkLst>
            <pc:docMk/>
            <pc:sldMk cId="187938002" sldId="3307"/>
            <ac:spMk id="33" creationId="{13B1ABB1-D276-4877-8BAE-251F885C5B0D}"/>
          </ac:spMkLst>
        </pc:spChg>
        <pc:spChg chg="add del mod">
          <ac:chgData name="Grace Lee" userId="fd145552-a10d-4a31-a438-f8736fd84277" providerId="ADAL" clId="{EDCE6299-B909-6840-AE8F-8D55B29E9D82}" dt="2021-09-06T22:30:41.507" v="114" actId="478"/>
          <ac:spMkLst>
            <pc:docMk/>
            <pc:sldMk cId="187938002" sldId="3307"/>
            <ac:spMk id="33" creationId="{EA64DDCA-94DC-8B4A-8E7E-4BBEB1460194}"/>
          </ac:spMkLst>
        </pc:spChg>
        <pc:spChg chg="add del mod">
          <ac:chgData name="Grace Lee" userId="fd145552-a10d-4a31-a438-f8736fd84277" providerId="ADAL" clId="{EDCE6299-B909-6840-AE8F-8D55B29E9D82}" dt="2021-09-06T22:30:38.443" v="113" actId="478"/>
          <ac:spMkLst>
            <pc:docMk/>
            <pc:sldMk cId="187938002" sldId="3307"/>
            <ac:spMk id="34" creationId="{0920F7C8-B8C0-0E40-8B37-45048DAD7182}"/>
          </ac:spMkLst>
        </pc:spChg>
        <pc:spChg chg="mod">
          <ac:chgData name="Grace Lee" userId="fd145552-a10d-4a31-a438-f8736fd84277" providerId="ADAL" clId="{EDCE6299-B909-6840-AE8F-8D55B29E9D82}" dt="2021-09-13T22:44:45.801" v="1630" actId="1076"/>
          <ac:spMkLst>
            <pc:docMk/>
            <pc:sldMk cId="187938002" sldId="3307"/>
            <ac:spMk id="34" creationId="{E665CCA3-EA18-4949-9A2F-234BF75534EC}"/>
          </ac:spMkLst>
        </pc:spChg>
        <pc:spChg chg="mod">
          <ac:chgData name="Grace Lee" userId="fd145552-a10d-4a31-a438-f8736fd84277" providerId="ADAL" clId="{EDCE6299-B909-6840-AE8F-8D55B29E9D82}" dt="2021-09-13T22:44:45.801" v="1630" actId="1076"/>
          <ac:spMkLst>
            <pc:docMk/>
            <pc:sldMk cId="187938002" sldId="3307"/>
            <ac:spMk id="43" creationId="{7D43FE39-F0D3-4954-94D6-877CD290529C}"/>
          </ac:spMkLst>
        </pc:spChg>
        <pc:spChg chg="mod">
          <ac:chgData name="Grace Lee" userId="fd145552-a10d-4a31-a438-f8736fd84277" providerId="ADAL" clId="{EDCE6299-B909-6840-AE8F-8D55B29E9D82}" dt="2021-09-13T22:44:45.801" v="1630" actId="1076"/>
          <ac:spMkLst>
            <pc:docMk/>
            <pc:sldMk cId="187938002" sldId="3307"/>
            <ac:spMk id="44" creationId="{CA11516F-B663-47F7-9CB4-6E1B18A2CB7D}"/>
          </ac:spMkLst>
        </pc:spChg>
        <pc:spChg chg="mod">
          <ac:chgData name="Grace Lee" userId="fd145552-a10d-4a31-a438-f8736fd84277" providerId="ADAL" clId="{EDCE6299-B909-6840-AE8F-8D55B29E9D82}" dt="2021-09-13T22:44:45.801" v="1630" actId="1076"/>
          <ac:spMkLst>
            <pc:docMk/>
            <pc:sldMk cId="187938002" sldId="3307"/>
            <ac:spMk id="45" creationId="{D5C3ED16-AD74-42CC-ABF5-155637BC7D6C}"/>
          </ac:spMkLst>
        </pc:spChg>
        <pc:spChg chg="mod">
          <ac:chgData name="Grace Lee" userId="fd145552-a10d-4a31-a438-f8736fd84277" providerId="ADAL" clId="{EDCE6299-B909-6840-AE8F-8D55B29E9D82}" dt="2021-09-13T22:44:45.801" v="1630" actId="1076"/>
          <ac:spMkLst>
            <pc:docMk/>
            <pc:sldMk cId="187938002" sldId="3307"/>
            <ac:spMk id="46" creationId="{5958ABF2-247D-4ED1-82D8-E5A51F47A351}"/>
          </ac:spMkLst>
        </pc:spChg>
        <pc:spChg chg="mod">
          <ac:chgData name="Grace Lee" userId="fd145552-a10d-4a31-a438-f8736fd84277" providerId="ADAL" clId="{EDCE6299-B909-6840-AE8F-8D55B29E9D82}" dt="2021-09-13T22:44:45.801" v="1630" actId="1076"/>
          <ac:spMkLst>
            <pc:docMk/>
            <pc:sldMk cId="187938002" sldId="3307"/>
            <ac:spMk id="47" creationId="{0AF9B300-DEB3-4E6E-83FA-5563CD638822}"/>
          </ac:spMkLst>
        </pc:spChg>
        <pc:spChg chg="mod">
          <ac:chgData name="Grace Lee" userId="fd145552-a10d-4a31-a438-f8736fd84277" providerId="ADAL" clId="{EDCE6299-B909-6840-AE8F-8D55B29E9D82}" dt="2021-09-13T22:44:45.801" v="1630" actId="1076"/>
          <ac:spMkLst>
            <pc:docMk/>
            <pc:sldMk cId="187938002" sldId="3307"/>
            <ac:spMk id="48" creationId="{CE1789F8-D90A-417B-B724-1C8CC2CAB633}"/>
          </ac:spMkLst>
        </pc:spChg>
        <pc:spChg chg="mod">
          <ac:chgData name="Grace Lee" userId="fd145552-a10d-4a31-a438-f8736fd84277" providerId="ADAL" clId="{EDCE6299-B909-6840-AE8F-8D55B29E9D82}" dt="2021-09-13T22:44:45.801" v="1630" actId="1076"/>
          <ac:spMkLst>
            <pc:docMk/>
            <pc:sldMk cId="187938002" sldId="3307"/>
            <ac:spMk id="50" creationId="{A31F744C-0128-46AD-AC4B-4B41C48CEDF0}"/>
          </ac:spMkLst>
        </pc:spChg>
        <pc:spChg chg="mod">
          <ac:chgData name="Grace Lee" userId="fd145552-a10d-4a31-a438-f8736fd84277" providerId="ADAL" clId="{EDCE6299-B909-6840-AE8F-8D55B29E9D82}" dt="2021-09-13T22:44:45.801" v="1630" actId="1076"/>
          <ac:spMkLst>
            <pc:docMk/>
            <pc:sldMk cId="187938002" sldId="3307"/>
            <ac:spMk id="51" creationId="{5D5FCFB2-456C-406F-8954-FD516F8433CE}"/>
          </ac:spMkLst>
        </pc:spChg>
        <pc:spChg chg="mod">
          <ac:chgData name="Grace Lee" userId="fd145552-a10d-4a31-a438-f8736fd84277" providerId="ADAL" clId="{EDCE6299-B909-6840-AE8F-8D55B29E9D82}" dt="2021-09-13T22:44:45.801" v="1630" actId="1076"/>
          <ac:spMkLst>
            <pc:docMk/>
            <pc:sldMk cId="187938002" sldId="3307"/>
            <ac:spMk id="52" creationId="{D3911288-5557-40BC-9242-7FB0F239B2D3}"/>
          </ac:spMkLst>
        </pc:spChg>
        <pc:spChg chg="mod">
          <ac:chgData name="Grace Lee" userId="fd145552-a10d-4a31-a438-f8736fd84277" providerId="ADAL" clId="{EDCE6299-B909-6840-AE8F-8D55B29E9D82}" dt="2021-09-13T22:44:45.801" v="1630" actId="1076"/>
          <ac:spMkLst>
            <pc:docMk/>
            <pc:sldMk cId="187938002" sldId="3307"/>
            <ac:spMk id="53" creationId="{E2049701-CA4D-4E98-BAB8-A7EFF1DDA945}"/>
          </ac:spMkLst>
        </pc:spChg>
        <pc:spChg chg="mod">
          <ac:chgData name="Grace Lee" userId="fd145552-a10d-4a31-a438-f8736fd84277" providerId="ADAL" clId="{EDCE6299-B909-6840-AE8F-8D55B29E9D82}" dt="2021-09-13T22:44:45.801" v="1630" actId="1076"/>
          <ac:spMkLst>
            <pc:docMk/>
            <pc:sldMk cId="187938002" sldId="3307"/>
            <ac:spMk id="54" creationId="{B2962D8F-D897-4E77-BEF6-A9EB62576127}"/>
          </ac:spMkLst>
        </pc:spChg>
        <pc:spChg chg="mod">
          <ac:chgData name="Grace Lee" userId="fd145552-a10d-4a31-a438-f8736fd84277" providerId="ADAL" clId="{EDCE6299-B909-6840-AE8F-8D55B29E9D82}" dt="2021-09-13T22:44:45.801" v="1630" actId="1076"/>
          <ac:spMkLst>
            <pc:docMk/>
            <pc:sldMk cId="187938002" sldId="3307"/>
            <ac:spMk id="57" creationId="{FA2A4811-CACA-468B-8ADF-7842C0823E64}"/>
          </ac:spMkLst>
        </pc:spChg>
        <pc:spChg chg="mod">
          <ac:chgData name="Grace Lee" userId="fd145552-a10d-4a31-a438-f8736fd84277" providerId="ADAL" clId="{EDCE6299-B909-6840-AE8F-8D55B29E9D82}" dt="2021-09-13T22:44:45.801" v="1630" actId="1076"/>
          <ac:spMkLst>
            <pc:docMk/>
            <pc:sldMk cId="187938002" sldId="3307"/>
            <ac:spMk id="63" creationId="{A6CF363A-5E67-471D-96A1-BB99C4BF1B28}"/>
          </ac:spMkLst>
        </pc:spChg>
        <pc:spChg chg="mod">
          <ac:chgData name="Grace Lee" userId="fd145552-a10d-4a31-a438-f8736fd84277" providerId="ADAL" clId="{EDCE6299-B909-6840-AE8F-8D55B29E9D82}" dt="2021-09-13T22:44:45.801" v="1630" actId="1076"/>
          <ac:spMkLst>
            <pc:docMk/>
            <pc:sldMk cId="187938002" sldId="3307"/>
            <ac:spMk id="64" creationId="{BAC3AD93-4EBD-4BE0-8DE9-83249CB83F1C}"/>
          </ac:spMkLst>
        </pc:spChg>
        <pc:spChg chg="mod">
          <ac:chgData name="Grace Lee" userId="fd145552-a10d-4a31-a438-f8736fd84277" providerId="ADAL" clId="{EDCE6299-B909-6840-AE8F-8D55B29E9D82}" dt="2021-09-15T01:37:33.164" v="3144" actId="20577"/>
          <ac:spMkLst>
            <pc:docMk/>
            <pc:sldMk cId="187938002" sldId="3307"/>
            <ac:spMk id="68" creationId="{24FDD7D9-55CB-4156-8D71-084078C8F69F}"/>
          </ac:spMkLst>
        </pc:spChg>
        <pc:spChg chg="mod">
          <ac:chgData name="Grace Lee" userId="fd145552-a10d-4a31-a438-f8736fd84277" providerId="ADAL" clId="{EDCE6299-B909-6840-AE8F-8D55B29E9D82}" dt="2021-09-13T22:44:45.801" v="1630" actId="1076"/>
          <ac:spMkLst>
            <pc:docMk/>
            <pc:sldMk cId="187938002" sldId="3307"/>
            <ac:spMk id="69" creationId="{BFAA5FC3-2BF1-406E-B12D-BC8781E2E86A}"/>
          </ac:spMkLst>
        </pc:spChg>
        <pc:spChg chg="mod">
          <ac:chgData name="Grace Lee" userId="fd145552-a10d-4a31-a438-f8736fd84277" providerId="ADAL" clId="{EDCE6299-B909-6840-AE8F-8D55B29E9D82}" dt="2021-09-13T22:44:45.801" v="1630" actId="1076"/>
          <ac:spMkLst>
            <pc:docMk/>
            <pc:sldMk cId="187938002" sldId="3307"/>
            <ac:spMk id="73" creationId="{D121DF87-1DBC-43CB-806F-942268B34984}"/>
          </ac:spMkLst>
        </pc:spChg>
        <pc:spChg chg="del">
          <ac:chgData name="Grace Lee" userId="fd145552-a10d-4a31-a438-f8736fd84277" providerId="ADAL" clId="{EDCE6299-B909-6840-AE8F-8D55B29E9D82}" dt="2021-09-13T22:44:37.059" v="1628" actId="478"/>
          <ac:spMkLst>
            <pc:docMk/>
            <pc:sldMk cId="187938002" sldId="3307"/>
            <ac:spMk id="76" creationId="{506AA956-83B2-49A7-BBEF-2B6AC420A805}"/>
          </ac:spMkLst>
        </pc:spChg>
        <pc:spChg chg="del">
          <ac:chgData name="Grace Lee" userId="fd145552-a10d-4a31-a438-f8736fd84277" providerId="ADAL" clId="{EDCE6299-B909-6840-AE8F-8D55B29E9D82}" dt="2021-09-13T22:44:37.059" v="1628" actId="478"/>
          <ac:spMkLst>
            <pc:docMk/>
            <pc:sldMk cId="187938002" sldId="3307"/>
            <ac:spMk id="77" creationId="{C61E376B-77C1-409B-83EB-264467C1DB14}"/>
          </ac:spMkLst>
        </pc:spChg>
        <pc:spChg chg="del">
          <ac:chgData name="Grace Lee" userId="fd145552-a10d-4a31-a438-f8736fd84277" providerId="ADAL" clId="{EDCE6299-B909-6840-AE8F-8D55B29E9D82}" dt="2021-09-13T22:44:37.059" v="1628" actId="478"/>
          <ac:spMkLst>
            <pc:docMk/>
            <pc:sldMk cId="187938002" sldId="3307"/>
            <ac:spMk id="78" creationId="{C9330A01-3CCE-4132-8472-47F2722AF91D}"/>
          </ac:spMkLst>
        </pc:spChg>
        <pc:spChg chg="del">
          <ac:chgData name="Grace Lee" userId="fd145552-a10d-4a31-a438-f8736fd84277" providerId="ADAL" clId="{EDCE6299-B909-6840-AE8F-8D55B29E9D82}" dt="2021-09-13T22:44:37.059" v="1628" actId="478"/>
          <ac:spMkLst>
            <pc:docMk/>
            <pc:sldMk cId="187938002" sldId="3307"/>
            <ac:spMk id="79" creationId="{82502245-459B-47CB-B032-0F07547370D2}"/>
          </ac:spMkLst>
        </pc:spChg>
        <pc:spChg chg="mod">
          <ac:chgData name="Grace Lee" userId="fd145552-a10d-4a31-a438-f8736fd84277" providerId="ADAL" clId="{EDCE6299-B909-6840-AE8F-8D55B29E9D82}" dt="2021-09-13T22:44:45.801" v="1630" actId="1076"/>
          <ac:spMkLst>
            <pc:docMk/>
            <pc:sldMk cId="187938002" sldId="3307"/>
            <ac:spMk id="80" creationId="{85C8FBD3-427E-438E-8EEA-2643D9F29E92}"/>
          </ac:spMkLst>
        </pc:spChg>
        <pc:spChg chg="del">
          <ac:chgData name="Grace Lee" userId="fd145552-a10d-4a31-a438-f8736fd84277" providerId="ADAL" clId="{EDCE6299-B909-6840-AE8F-8D55B29E9D82}" dt="2021-09-13T22:44:38.067" v="1629" actId="478"/>
          <ac:spMkLst>
            <pc:docMk/>
            <pc:sldMk cId="187938002" sldId="3307"/>
            <ac:spMk id="81" creationId="{1970C673-2FFB-4BB5-B716-E360AD1E5706}"/>
          </ac:spMkLst>
        </pc:spChg>
        <pc:spChg chg="del">
          <ac:chgData name="Grace Lee" userId="fd145552-a10d-4a31-a438-f8736fd84277" providerId="ADAL" clId="{EDCE6299-B909-6840-AE8F-8D55B29E9D82}" dt="2021-09-13T22:44:37.059" v="1628" actId="478"/>
          <ac:spMkLst>
            <pc:docMk/>
            <pc:sldMk cId="187938002" sldId="3307"/>
            <ac:spMk id="83" creationId="{6CF9FFEC-7EC9-49CF-8EBB-91285658E3D3}"/>
          </ac:spMkLst>
        </pc:spChg>
        <pc:spChg chg="mod">
          <ac:chgData name="Grace Lee" userId="fd145552-a10d-4a31-a438-f8736fd84277" providerId="ADAL" clId="{EDCE6299-B909-6840-AE8F-8D55B29E9D82}" dt="2021-09-13T22:44:45.801" v="1630" actId="1076"/>
          <ac:spMkLst>
            <pc:docMk/>
            <pc:sldMk cId="187938002" sldId="3307"/>
            <ac:spMk id="93" creationId="{BF9A3230-00EC-4629-977A-A8CCE79ACC91}"/>
          </ac:spMkLst>
        </pc:spChg>
        <pc:spChg chg="mod">
          <ac:chgData name="Grace Lee" userId="fd145552-a10d-4a31-a438-f8736fd84277" providerId="ADAL" clId="{EDCE6299-B909-6840-AE8F-8D55B29E9D82}" dt="2021-09-13T22:44:45.801" v="1630" actId="1076"/>
          <ac:spMkLst>
            <pc:docMk/>
            <pc:sldMk cId="187938002" sldId="3307"/>
            <ac:spMk id="96" creationId="{A000FC63-CB2D-4BBE-8DE3-C3D6114AF543}"/>
          </ac:spMkLst>
        </pc:spChg>
        <pc:spChg chg="mod">
          <ac:chgData name="Grace Lee" userId="fd145552-a10d-4a31-a438-f8736fd84277" providerId="ADAL" clId="{EDCE6299-B909-6840-AE8F-8D55B29E9D82}" dt="2021-09-13T22:44:45.801" v="1630" actId="1076"/>
          <ac:spMkLst>
            <pc:docMk/>
            <pc:sldMk cId="187938002" sldId="3307"/>
            <ac:spMk id="104" creationId="{F81F728A-F6E0-4035-B83C-178C94467706}"/>
          </ac:spMkLst>
        </pc:spChg>
        <pc:spChg chg="mod">
          <ac:chgData name="Grace Lee" userId="fd145552-a10d-4a31-a438-f8736fd84277" providerId="ADAL" clId="{EDCE6299-B909-6840-AE8F-8D55B29E9D82}" dt="2021-09-13T22:44:45.801" v="1630" actId="1076"/>
          <ac:spMkLst>
            <pc:docMk/>
            <pc:sldMk cId="187938002" sldId="3307"/>
            <ac:spMk id="105" creationId="{46483DB8-79F9-4FBE-9B21-E97A274C2DEC}"/>
          </ac:spMkLst>
        </pc:spChg>
        <pc:spChg chg="mod">
          <ac:chgData name="Grace Lee" userId="fd145552-a10d-4a31-a438-f8736fd84277" providerId="ADAL" clId="{EDCE6299-B909-6840-AE8F-8D55B29E9D82}" dt="2021-09-13T22:44:45.801" v="1630" actId="1076"/>
          <ac:spMkLst>
            <pc:docMk/>
            <pc:sldMk cId="187938002" sldId="3307"/>
            <ac:spMk id="106" creationId="{DDA53C12-4572-4125-91CB-0096DC97ACEE}"/>
          </ac:spMkLst>
        </pc:spChg>
        <pc:spChg chg="mod">
          <ac:chgData name="Grace Lee" userId="fd145552-a10d-4a31-a438-f8736fd84277" providerId="ADAL" clId="{EDCE6299-B909-6840-AE8F-8D55B29E9D82}" dt="2021-09-13T22:44:45.801" v="1630" actId="1076"/>
          <ac:spMkLst>
            <pc:docMk/>
            <pc:sldMk cId="187938002" sldId="3307"/>
            <ac:spMk id="107" creationId="{548FE39C-1314-44EC-A0B3-37B35B05DB8B}"/>
          </ac:spMkLst>
        </pc:spChg>
        <pc:spChg chg="mod">
          <ac:chgData name="Grace Lee" userId="fd145552-a10d-4a31-a438-f8736fd84277" providerId="ADAL" clId="{EDCE6299-B909-6840-AE8F-8D55B29E9D82}" dt="2021-09-13T22:44:45.801" v="1630" actId="1076"/>
          <ac:spMkLst>
            <pc:docMk/>
            <pc:sldMk cId="187938002" sldId="3307"/>
            <ac:spMk id="110" creationId="{DA178DCD-074A-482D-856E-184518C9F5C8}"/>
          </ac:spMkLst>
        </pc:spChg>
        <pc:spChg chg="mod">
          <ac:chgData name="Grace Lee" userId="fd145552-a10d-4a31-a438-f8736fd84277" providerId="ADAL" clId="{EDCE6299-B909-6840-AE8F-8D55B29E9D82}" dt="2021-09-13T22:44:45.801" v="1630" actId="1076"/>
          <ac:spMkLst>
            <pc:docMk/>
            <pc:sldMk cId="187938002" sldId="3307"/>
            <ac:spMk id="111" creationId="{1793323B-16EA-4D26-913D-D89B75512963}"/>
          </ac:spMkLst>
        </pc:spChg>
        <pc:spChg chg="mod">
          <ac:chgData name="Grace Lee" userId="fd145552-a10d-4a31-a438-f8736fd84277" providerId="ADAL" clId="{EDCE6299-B909-6840-AE8F-8D55B29E9D82}" dt="2021-09-13T22:44:45.801" v="1630" actId="1076"/>
          <ac:spMkLst>
            <pc:docMk/>
            <pc:sldMk cId="187938002" sldId="3307"/>
            <ac:spMk id="112" creationId="{46F678A2-6687-4DBF-997D-4B943CDC732C}"/>
          </ac:spMkLst>
        </pc:spChg>
        <pc:spChg chg="mod">
          <ac:chgData name="Grace Lee" userId="fd145552-a10d-4a31-a438-f8736fd84277" providerId="ADAL" clId="{EDCE6299-B909-6840-AE8F-8D55B29E9D82}" dt="2021-09-13T22:44:45.801" v="1630" actId="1076"/>
          <ac:spMkLst>
            <pc:docMk/>
            <pc:sldMk cId="187938002" sldId="3307"/>
            <ac:spMk id="113" creationId="{423CAA18-74F3-473B-A719-8E275B53711E}"/>
          </ac:spMkLst>
        </pc:spChg>
        <pc:spChg chg="mod">
          <ac:chgData name="Grace Lee" userId="fd145552-a10d-4a31-a438-f8736fd84277" providerId="ADAL" clId="{EDCE6299-B909-6840-AE8F-8D55B29E9D82}" dt="2021-09-13T22:44:45.801" v="1630" actId="1076"/>
          <ac:spMkLst>
            <pc:docMk/>
            <pc:sldMk cId="187938002" sldId="3307"/>
            <ac:spMk id="122" creationId="{3C64D145-B45B-4A5C-B27C-BF927429E62D}"/>
          </ac:spMkLst>
        </pc:spChg>
        <pc:spChg chg="mod">
          <ac:chgData name="Grace Lee" userId="fd145552-a10d-4a31-a438-f8736fd84277" providerId="ADAL" clId="{EDCE6299-B909-6840-AE8F-8D55B29E9D82}" dt="2021-09-13T22:44:45.801" v="1630" actId="1076"/>
          <ac:spMkLst>
            <pc:docMk/>
            <pc:sldMk cId="187938002" sldId="3307"/>
            <ac:spMk id="123" creationId="{D97A2707-B6E7-4A7E-B13A-B40B0C744AD1}"/>
          </ac:spMkLst>
        </pc:spChg>
        <pc:spChg chg="mod">
          <ac:chgData name="Grace Lee" userId="fd145552-a10d-4a31-a438-f8736fd84277" providerId="ADAL" clId="{EDCE6299-B909-6840-AE8F-8D55B29E9D82}" dt="2021-09-13T22:44:45.801" v="1630" actId="1076"/>
          <ac:spMkLst>
            <pc:docMk/>
            <pc:sldMk cId="187938002" sldId="3307"/>
            <ac:spMk id="124" creationId="{6132A3D0-8A5A-47A5-B4DF-C2E42CA4C01F}"/>
          </ac:spMkLst>
        </pc:spChg>
        <pc:spChg chg="mod">
          <ac:chgData name="Grace Lee" userId="fd145552-a10d-4a31-a438-f8736fd84277" providerId="ADAL" clId="{EDCE6299-B909-6840-AE8F-8D55B29E9D82}" dt="2021-09-13T22:44:45.801" v="1630" actId="1076"/>
          <ac:spMkLst>
            <pc:docMk/>
            <pc:sldMk cId="187938002" sldId="3307"/>
            <ac:spMk id="125" creationId="{19466186-3ACE-48B2-84E6-321305D29EBF}"/>
          </ac:spMkLst>
        </pc:spChg>
        <pc:spChg chg="mod">
          <ac:chgData name="Grace Lee" userId="fd145552-a10d-4a31-a438-f8736fd84277" providerId="ADAL" clId="{EDCE6299-B909-6840-AE8F-8D55B29E9D82}" dt="2021-09-15T01:38:05.044" v="3147" actId="1036"/>
          <ac:spMkLst>
            <pc:docMk/>
            <pc:sldMk cId="187938002" sldId="3307"/>
            <ac:spMk id="126" creationId="{2947F216-E876-41EF-B668-B2DAEBAA2E8E}"/>
          </ac:spMkLst>
        </pc:spChg>
        <pc:spChg chg="mod">
          <ac:chgData name="Grace Lee" userId="fd145552-a10d-4a31-a438-f8736fd84277" providerId="ADAL" clId="{EDCE6299-B909-6840-AE8F-8D55B29E9D82}" dt="2021-09-13T22:44:45.801" v="1630" actId="1076"/>
          <ac:spMkLst>
            <pc:docMk/>
            <pc:sldMk cId="187938002" sldId="3307"/>
            <ac:spMk id="127" creationId="{936F3A3E-49E0-42A2-8748-2F7D774A345D}"/>
          </ac:spMkLst>
        </pc:spChg>
        <pc:spChg chg="mod">
          <ac:chgData name="Grace Lee" userId="fd145552-a10d-4a31-a438-f8736fd84277" providerId="ADAL" clId="{EDCE6299-B909-6840-AE8F-8D55B29E9D82}" dt="2021-09-15T01:38:15.312" v="3149" actId="14100"/>
          <ac:spMkLst>
            <pc:docMk/>
            <pc:sldMk cId="187938002" sldId="3307"/>
            <ac:spMk id="128" creationId="{413B379D-72C3-4BD0-94D4-6E70D5C21609}"/>
          </ac:spMkLst>
        </pc:spChg>
        <pc:spChg chg="mod">
          <ac:chgData name="Grace Lee" userId="fd145552-a10d-4a31-a438-f8736fd84277" providerId="ADAL" clId="{EDCE6299-B909-6840-AE8F-8D55B29E9D82}" dt="2021-09-13T22:44:45.801" v="1630" actId="1076"/>
          <ac:spMkLst>
            <pc:docMk/>
            <pc:sldMk cId="187938002" sldId="3307"/>
            <ac:spMk id="129" creationId="{FA223EBD-97A0-43D1-90D7-B90DDFFAC82A}"/>
          </ac:spMkLst>
        </pc:spChg>
        <pc:spChg chg="mod">
          <ac:chgData name="Grace Lee" userId="fd145552-a10d-4a31-a438-f8736fd84277" providerId="ADAL" clId="{EDCE6299-B909-6840-AE8F-8D55B29E9D82}" dt="2021-09-13T22:44:45.801" v="1630" actId="1076"/>
          <ac:spMkLst>
            <pc:docMk/>
            <pc:sldMk cId="187938002" sldId="3307"/>
            <ac:spMk id="130" creationId="{A1937A8D-739D-47D2-8F3B-5D3DEEC0CBFE}"/>
          </ac:spMkLst>
        </pc:spChg>
        <pc:spChg chg="mod">
          <ac:chgData name="Grace Lee" userId="fd145552-a10d-4a31-a438-f8736fd84277" providerId="ADAL" clId="{EDCE6299-B909-6840-AE8F-8D55B29E9D82}" dt="2021-09-13T22:44:45.801" v="1630" actId="1076"/>
          <ac:spMkLst>
            <pc:docMk/>
            <pc:sldMk cId="187938002" sldId="3307"/>
            <ac:spMk id="131" creationId="{50DF1E82-6ACA-4B66-B7D6-9690E79414D5}"/>
          </ac:spMkLst>
        </pc:spChg>
        <pc:spChg chg="mod">
          <ac:chgData name="Grace Lee" userId="fd145552-a10d-4a31-a438-f8736fd84277" providerId="ADAL" clId="{EDCE6299-B909-6840-AE8F-8D55B29E9D82}" dt="2021-09-13T22:44:45.801" v="1630" actId="1076"/>
          <ac:spMkLst>
            <pc:docMk/>
            <pc:sldMk cId="187938002" sldId="3307"/>
            <ac:spMk id="132" creationId="{7393E349-10BD-4486-B623-A0D748273765}"/>
          </ac:spMkLst>
        </pc:spChg>
        <pc:spChg chg="mod">
          <ac:chgData name="Grace Lee" userId="fd145552-a10d-4a31-a438-f8736fd84277" providerId="ADAL" clId="{EDCE6299-B909-6840-AE8F-8D55B29E9D82}" dt="2021-09-13T22:44:45.801" v="1630" actId="1076"/>
          <ac:spMkLst>
            <pc:docMk/>
            <pc:sldMk cId="187938002" sldId="3307"/>
            <ac:spMk id="133" creationId="{6D5F2BD9-90E5-4534-9DA8-7D6038BA4778}"/>
          </ac:spMkLst>
        </pc:spChg>
        <pc:spChg chg="mod">
          <ac:chgData name="Grace Lee" userId="fd145552-a10d-4a31-a438-f8736fd84277" providerId="ADAL" clId="{EDCE6299-B909-6840-AE8F-8D55B29E9D82}" dt="2021-09-13T22:44:45.801" v="1630" actId="1076"/>
          <ac:spMkLst>
            <pc:docMk/>
            <pc:sldMk cId="187938002" sldId="3307"/>
            <ac:spMk id="134" creationId="{66D1B34E-93CD-4AEE-A3EB-CFC645BAA956}"/>
          </ac:spMkLst>
        </pc:spChg>
        <pc:spChg chg="mod">
          <ac:chgData name="Grace Lee" userId="fd145552-a10d-4a31-a438-f8736fd84277" providerId="ADAL" clId="{EDCE6299-B909-6840-AE8F-8D55B29E9D82}" dt="2021-09-13T22:44:45.801" v="1630" actId="1076"/>
          <ac:spMkLst>
            <pc:docMk/>
            <pc:sldMk cId="187938002" sldId="3307"/>
            <ac:spMk id="136" creationId="{2F313FCC-1D52-4F98-88EE-F66379C630E8}"/>
          </ac:spMkLst>
        </pc:spChg>
        <pc:spChg chg="mod">
          <ac:chgData name="Grace Lee" userId="fd145552-a10d-4a31-a438-f8736fd84277" providerId="ADAL" clId="{EDCE6299-B909-6840-AE8F-8D55B29E9D82}" dt="2021-09-13T22:44:45.801" v="1630" actId="1076"/>
          <ac:spMkLst>
            <pc:docMk/>
            <pc:sldMk cId="187938002" sldId="3307"/>
            <ac:spMk id="137" creationId="{42A446C2-5ACE-4867-9439-7C3858B281F7}"/>
          </ac:spMkLst>
        </pc:spChg>
        <pc:spChg chg="mod">
          <ac:chgData name="Grace Lee" userId="fd145552-a10d-4a31-a438-f8736fd84277" providerId="ADAL" clId="{EDCE6299-B909-6840-AE8F-8D55B29E9D82}" dt="2021-09-13T22:44:45.801" v="1630" actId="1076"/>
          <ac:spMkLst>
            <pc:docMk/>
            <pc:sldMk cId="187938002" sldId="3307"/>
            <ac:spMk id="140" creationId="{2993D3FC-7E1C-4B15-8C2F-13E3FDEE4739}"/>
          </ac:spMkLst>
        </pc:spChg>
        <pc:spChg chg="del">
          <ac:chgData name="Grace Lee" userId="fd145552-a10d-4a31-a438-f8736fd84277" providerId="ADAL" clId="{EDCE6299-B909-6840-AE8F-8D55B29E9D82}" dt="2021-09-13T22:44:37.059" v="1628" actId="478"/>
          <ac:spMkLst>
            <pc:docMk/>
            <pc:sldMk cId="187938002" sldId="3307"/>
            <ac:spMk id="159" creationId="{768F0C11-6D59-4A7D-8A97-40F17D6A39E4}"/>
          </ac:spMkLst>
        </pc:spChg>
        <pc:spChg chg="del">
          <ac:chgData name="Grace Lee" userId="fd145552-a10d-4a31-a438-f8736fd84277" providerId="ADAL" clId="{EDCE6299-B909-6840-AE8F-8D55B29E9D82}" dt="2021-09-13T22:44:37.059" v="1628" actId="478"/>
          <ac:spMkLst>
            <pc:docMk/>
            <pc:sldMk cId="187938002" sldId="3307"/>
            <ac:spMk id="162" creationId="{290193BC-EAC3-4732-A4C6-E33D476B860B}"/>
          </ac:spMkLst>
        </pc:spChg>
        <pc:spChg chg="del">
          <ac:chgData name="Grace Lee" userId="fd145552-a10d-4a31-a438-f8736fd84277" providerId="ADAL" clId="{EDCE6299-B909-6840-AE8F-8D55B29E9D82}" dt="2021-09-13T22:44:37.059" v="1628" actId="478"/>
          <ac:spMkLst>
            <pc:docMk/>
            <pc:sldMk cId="187938002" sldId="3307"/>
            <ac:spMk id="171" creationId="{F3656F8A-FF42-4AC4-8FF8-DC399A5E5F15}"/>
          </ac:spMkLst>
        </pc:spChg>
        <pc:spChg chg="del">
          <ac:chgData name="Grace Lee" userId="fd145552-a10d-4a31-a438-f8736fd84277" providerId="ADAL" clId="{EDCE6299-B909-6840-AE8F-8D55B29E9D82}" dt="2021-09-13T22:44:37.059" v="1628" actId="478"/>
          <ac:spMkLst>
            <pc:docMk/>
            <pc:sldMk cId="187938002" sldId="3307"/>
            <ac:spMk id="173" creationId="{855A9869-5715-4B04-AB7F-C080D898EDDB}"/>
          </ac:spMkLst>
        </pc:spChg>
        <pc:spChg chg="mod">
          <ac:chgData name="Grace Lee" userId="fd145552-a10d-4a31-a438-f8736fd84277" providerId="ADAL" clId="{EDCE6299-B909-6840-AE8F-8D55B29E9D82}" dt="2021-09-13T22:44:45.801" v="1630" actId="1076"/>
          <ac:spMkLst>
            <pc:docMk/>
            <pc:sldMk cId="187938002" sldId="3307"/>
            <ac:spMk id="174" creationId="{712317E0-A6D2-404D-A1F4-2D883F388E56}"/>
          </ac:spMkLst>
        </pc:spChg>
        <pc:spChg chg="mod">
          <ac:chgData name="Grace Lee" userId="fd145552-a10d-4a31-a438-f8736fd84277" providerId="ADAL" clId="{EDCE6299-B909-6840-AE8F-8D55B29E9D82}" dt="2021-09-13T22:44:45.801" v="1630" actId="1076"/>
          <ac:spMkLst>
            <pc:docMk/>
            <pc:sldMk cId="187938002" sldId="3307"/>
            <ac:spMk id="175" creationId="{54CC318E-92C2-4F45-9CB0-4287FE94A1EC}"/>
          </ac:spMkLst>
        </pc:spChg>
        <pc:spChg chg="del">
          <ac:chgData name="Grace Lee" userId="fd145552-a10d-4a31-a438-f8736fd84277" providerId="ADAL" clId="{EDCE6299-B909-6840-AE8F-8D55B29E9D82}" dt="2021-09-13T22:44:37.059" v="1628" actId="478"/>
          <ac:spMkLst>
            <pc:docMk/>
            <pc:sldMk cId="187938002" sldId="3307"/>
            <ac:spMk id="176" creationId="{646101B8-2165-4DBC-90DB-9DDCC8A59445}"/>
          </ac:spMkLst>
        </pc:spChg>
        <pc:spChg chg="mod">
          <ac:chgData name="Grace Lee" userId="fd145552-a10d-4a31-a438-f8736fd84277" providerId="ADAL" clId="{EDCE6299-B909-6840-AE8F-8D55B29E9D82}" dt="2021-09-06T22:30:11.400" v="106" actId="14100"/>
          <ac:spMkLst>
            <pc:docMk/>
            <pc:sldMk cId="187938002" sldId="3307"/>
            <ac:spMk id="176" creationId="{946FEA16-97EE-492B-A8AE-F2AB6D8C96AA}"/>
          </ac:spMkLst>
        </pc:spChg>
        <pc:spChg chg="del">
          <ac:chgData name="Grace Lee" userId="fd145552-a10d-4a31-a438-f8736fd84277" providerId="ADAL" clId="{EDCE6299-B909-6840-AE8F-8D55B29E9D82}" dt="2021-09-13T22:44:37.059" v="1628" actId="478"/>
          <ac:spMkLst>
            <pc:docMk/>
            <pc:sldMk cId="187938002" sldId="3307"/>
            <ac:spMk id="177" creationId="{144B2700-38E9-4746-A6EE-A1E56E7D46D8}"/>
          </ac:spMkLst>
        </pc:spChg>
        <pc:spChg chg="mod">
          <ac:chgData name="Grace Lee" userId="fd145552-a10d-4a31-a438-f8736fd84277" providerId="ADAL" clId="{EDCE6299-B909-6840-AE8F-8D55B29E9D82}" dt="2021-09-13T22:44:45.801" v="1630" actId="1076"/>
          <ac:spMkLst>
            <pc:docMk/>
            <pc:sldMk cId="187938002" sldId="3307"/>
            <ac:spMk id="178" creationId="{581B84B5-D0C4-49FC-BA7E-AE210B5B26BA}"/>
          </ac:spMkLst>
        </pc:spChg>
        <pc:spChg chg="mod">
          <ac:chgData name="Grace Lee" userId="fd145552-a10d-4a31-a438-f8736fd84277" providerId="ADAL" clId="{EDCE6299-B909-6840-AE8F-8D55B29E9D82}" dt="2021-09-13T22:44:45.801" v="1630" actId="1076"/>
          <ac:spMkLst>
            <pc:docMk/>
            <pc:sldMk cId="187938002" sldId="3307"/>
            <ac:spMk id="179" creationId="{A30FC82F-D841-4BFF-982E-7659A7C67531}"/>
          </ac:spMkLst>
        </pc:spChg>
        <pc:spChg chg="del">
          <ac:chgData name="Grace Lee" userId="fd145552-a10d-4a31-a438-f8736fd84277" providerId="ADAL" clId="{EDCE6299-B909-6840-AE8F-8D55B29E9D82}" dt="2021-09-13T22:44:37.059" v="1628" actId="478"/>
          <ac:spMkLst>
            <pc:docMk/>
            <pc:sldMk cId="187938002" sldId="3307"/>
            <ac:spMk id="181" creationId="{0DB9AC23-C002-4B83-B229-1E7EF7D5F228}"/>
          </ac:spMkLst>
        </pc:spChg>
        <pc:spChg chg="del">
          <ac:chgData name="Grace Lee" userId="fd145552-a10d-4a31-a438-f8736fd84277" providerId="ADAL" clId="{EDCE6299-B909-6840-AE8F-8D55B29E9D82}" dt="2021-09-13T22:44:37.059" v="1628" actId="478"/>
          <ac:spMkLst>
            <pc:docMk/>
            <pc:sldMk cId="187938002" sldId="3307"/>
            <ac:spMk id="182" creationId="{520FA9EF-5467-4792-9198-7DD78B0A7E2F}"/>
          </ac:spMkLst>
        </pc:spChg>
        <pc:spChg chg="del mod">
          <ac:chgData name="Grace Lee" userId="fd145552-a10d-4a31-a438-f8736fd84277" providerId="ADAL" clId="{EDCE6299-B909-6840-AE8F-8D55B29E9D82}" dt="2021-09-13T22:44:37.059" v="1628" actId="478"/>
          <ac:spMkLst>
            <pc:docMk/>
            <pc:sldMk cId="187938002" sldId="3307"/>
            <ac:spMk id="183" creationId="{68FDE5F4-FA5B-491E-9DDB-6E4C466C4766}"/>
          </ac:spMkLst>
        </pc:spChg>
        <pc:spChg chg="del">
          <ac:chgData name="Grace Lee" userId="fd145552-a10d-4a31-a438-f8736fd84277" providerId="ADAL" clId="{EDCE6299-B909-6840-AE8F-8D55B29E9D82}" dt="2021-09-13T22:44:37.059" v="1628" actId="478"/>
          <ac:spMkLst>
            <pc:docMk/>
            <pc:sldMk cId="187938002" sldId="3307"/>
            <ac:spMk id="185" creationId="{EEEAB960-1996-45C4-9187-27BE2A9C4A2E}"/>
          </ac:spMkLst>
        </pc:spChg>
        <pc:spChg chg="del mod">
          <ac:chgData name="Grace Lee" userId="fd145552-a10d-4a31-a438-f8736fd84277" providerId="ADAL" clId="{EDCE6299-B909-6840-AE8F-8D55B29E9D82}" dt="2021-09-13T22:44:37.059" v="1628" actId="478"/>
          <ac:spMkLst>
            <pc:docMk/>
            <pc:sldMk cId="187938002" sldId="3307"/>
            <ac:spMk id="186" creationId="{B456F411-1A95-455A-BDB1-AE61C8D56E85}"/>
          </ac:spMkLst>
        </pc:spChg>
        <pc:spChg chg="del mod">
          <ac:chgData name="Grace Lee" userId="fd145552-a10d-4a31-a438-f8736fd84277" providerId="ADAL" clId="{EDCE6299-B909-6840-AE8F-8D55B29E9D82}" dt="2021-09-13T22:44:37.059" v="1628" actId="478"/>
          <ac:spMkLst>
            <pc:docMk/>
            <pc:sldMk cId="187938002" sldId="3307"/>
            <ac:spMk id="187" creationId="{C5547091-31B6-4C3C-B5FA-2DFA40E76745}"/>
          </ac:spMkLst>
        </pc:spChg>
        <pc:spChg chg="del">
          <ac:chgData name="Grace Lee" userId="fd145552-a10d-4a31-a438-f8736fd84277" providerId="ADAL" clId="{EDCE6299-B909-6840-AE8F-8D55B29E9D82}" dt="2021-09-13T22:44:37.059" v="1628" actId="478"/>
          <ac:spMkLst>
            <pc:docMk/>
            <pc:sldMk cId="187938002" sldId="3307"/>
            <ac:spMk id="189" creationId="{AEB2C093-0815-4D16-905B-69D2EDAF1FEE}"/>
          </ac:spMkLst>
        </pc:spChg>
        <pc:spChg chg="del">
          <ac:chgData name="Grace Lee" userId="fd145552-a10d-4a31-a438-f8736fd84277" providerId="ADAL" clId="{EDCE6299-B909-6840-AE8F-8D55B29E9D82}" dt="2021-09-13T22:44:37.059" v="1628" actId="478"/>
          <ac:spMkLst>
            <pc:docMk/>
            <pc:sldMk cId="187938002" sldId="3307"/>
            <ac:spMk id="190" creationId="{ADAD2512-4ACE-4FBE-B236-954614A28D12}"/>
          </ac:spMkLst>
        </pc:spChg>
        <pc:spChg chg="del">
          <ac:chgData name="Grace Lee" userId="fd145552-a10d-4a31-a438-f8736fd84277" providerId="ADAL" clId="{EDCE6299-B909-6840-AE8F-8D55B29E9D82}" dt="2021-09-13T22:44:37.059" v="1628" actId="478"/>
          <ac:spMkLst>
            <pc:docMk/>
            <pc:sldMk cId="187938002" sldId="3307"/>
            <ac:spMk id="191" creationId="{B7A99FBD-A908-4438-ADBE-8CD497A03857}"/>
          </ac:spMkLst>
        </pc:spChg>
        <pc:spChg chg="del">
          <ac:chgData name="Grace Lee" userId="fd145552-a10d-4a31-a438-f8736fd84277" providerId="ADAL" clId="{EDCE6299-B909-6840-AE8F-8D55B29E9D82}" dt="2021-09-13T22:44:37.059" v="1628" actId="478"/>
          <ac:spMkLst>
            <pc:docMk/>
            <pc:sldMk cId="187938002" sldId="3307"/>
            <ac:spMk id="193" creationId="{6AA4CE63-9ED3-4390-A642-471C24E9AA1C}"/>
          </ac:spMkLst>
        </pc:spChg>
        <pc:spChg chg="del">
          <ac:chgData name="Grace Lee" userId="fd145552-a10d-4a31-a438-f8736fd84277" providerId="ADAL" clId="{EDCE6299-B909-6840-AE8F-8D55B29E9D82}" dt="2021-09-13T22:44:37.059" v="1628" actId="478"/>
          <ac:spMkLst>
            <pc:docMk/>
            <pc:sldMk cId="187938002" sldId="3307"/>
            <ac:spMk id="194" creationId="{9C653993-4942-4716-B2C2-1E619AEC9A89}"/>
          </ac:spMkLst>
        </pc:spChg>
        <pc:spChg chg="del">
          <ac:chgData name="Grace Lee" userId="fd145552-a10d-4a31-a438-f8736fd84277" providerId="ADAL" clId="{EDCE6299-B909-6840-AE8F-8D55B29E9D82}" dt="2021-09-13T22:44:37.059" v="1628" actId="478"/>
          <ac:spMkLst>
            <pc:docMk/>
            <pc:sldMk cId="187938002" sldId="3307"/>
            <ac:spMk id="195" creationId="{21716DA0-562D-48A8-B021-85005F063029}"/>
          </ac:spMkLst>
        </pc:spChg>
        <pc:picChg chg="mod">
          <ac:chgData name="Grace Lee" userId="fd145552-a10d-4a31-a438-f8736fd84277" providerId="ADAL" clId="{EDCE6299-B909-6840-AE8F-8D55B29E9D82}" dt="2021-09-13T22:44:45.801" v="1630" actId="1076"/>
          <ac:picMkLst>
            <pc:docMk/>
            <pc:sldMk cId="187938002" sldId="3307"/>
            <ac:picMk id="6" creationId="{BC8612EB-7CA2-4DEE-BDEF-F8DDDF80D534}"/>
          </ac:picMkLst>
        </pc:picChg>
        <pc:picChg chg="mod">
          <ac:chgData name="Grace Lee" userId="fd145552-a10d-4a31-a438-f8736fd84277" providerId="ADAL" clId="{EDCE6299-B909-6840-AE8F-8D55B29E9D82}" dt="2021-09-13T22:44:45.801" v="1630" actId="1076"/>
          <ac:picMkLst>
            <pc:docMk/>
            <pc:sldMk cId="187938002" sldId="3307"/>
            <ac:picMk id="7" creationId="{7FB1E5D8-9C85-403E-885A-3F690338298A}"/>
          </ac:picMkLst>
        </pc:picChg>
        <pc:picChg chg="mod">
          <ac:chgData name="Grace Lee" userId="fd145552-a10d-4a31-a438-f8736fd84277" providerId="ADAL" clId="{EDCE6299-B909-6840-AE8F-8D55B29E9D82}" dt="2021-09-13T22:44:45.801" v="1630" actId="1076"/>
          <ac:picMkLst>
            <pc:docMk/>
            <pc:sldMk cId="187938002" sldId="3307"/>
            <ac:picMk id="8" creationId="{6595AECF-281B-402C-978D-232D26F9D20B}"/>
          </ac:picMkLst>
        </pc:picChg>
        <pc:picChg chg="mod">
          <ac:chgData name="Grace Lee" userId="fd145552-a10d-4a31-a438-f8736fd84277" providerId="ADAL" clId="{EDCE6299-B909-6840-AE8F-8D55B29E9D82}" dt="2021-09-13T22:44:45.801" v="1630" actId="1076"/>
          <ac:picMkLst>
            <pc:docMk/>
            <pc:sldMk cId="187938002" sldId="3307"/>
            <ac:picMk id="10" creationId="{B6A8F212-C495-45A6-BF2C-80AECC1DB4B5}"/>
          </ac:picMkLst>
        </pc:picChg>
      </pc:sldChg>
      <pc:sldChg chg="modSp mod modNotesTx">
        <pc:chgData name="Grace Lee" userId="fd145552-a10d-4a31-a438-f8736fd84277" providerId="ADAL" clId="{EDCE6299-B909-6840-AE8F-8D55B29E9D82}" dt="2021-09-15T01:45:30.328" v="3431" actId="313"/>
        <pc:sldMkLst>
          <pc:docMk/>
          <pc:sldMk cId="3729442319" sldId="3308"/>
        </pc:sldMkLst>
        <pc:graphicFrameChg chg="mod modGraphic">
          <ac:chgData name="Grace Lee" userId="fd145552-a10d-4a31-a438-f8736fd84277" providerId="ADAL" clId="{EDCE6299-B909-6840-AE8F-8D55B29E9D82}" dt="2021-09-15T01:45:30.328" v="3431" actId="313"/>
          <ac:graphicFrameMkLst>
            <pc:docMk/>
            <pc:sldMk cId="3729442319" sldId="3308"/>
            <ac:graphicFrameMk id="5" creationId="{1F6D69E8-098B-4675-AAE5-73A7D0391966}"/>
          </ac:graphicFrameMkLst>
        </pc:graphicFrameChg>
      </pc:sldChg>
      <pc:sldChg chg="addSp delSp modSp mod modNotesTx">
        <pc:chgData name="Grace Lee" userId="fd145552-a10d-4a31-a438-f8736fd84277" providerId="ADAL" clId="{EDCE6299-B909-6840-AE8F-8D55B29E9D82}" dt="2021-09-15T01:31:44.148" v="2914" actId="1036"/>
        <pc:sldMkLst>
          <pc:docMk/>
          <pc:sldMk cId="55687339" sldId="4099"/>
        </pc:sldMkLst>
        <pc:spChg chg="mod">
          <ac:chgData name="Grace Lee" userId="fd145552-a10d-4a31-a438-f8736fd84277" providerId="ADAL" clId="{EDCE6299-B909-6840-AE8F-8D55B29E9D82}" dt="2021-09-15T01:25:12.816" v="2612" actId="1035"/>
          <ac:spMkLst>
            <pc:docMk/>
            <pc:sldMk cId="55687339" sldId="4099"/>
            <ac:spMk id="4" creationId="{73BACEFA-6F9D-4B4F-ADFB-4CE9355D085F}"/>
          </ac:spMkLst>
        </pc:spChg>
        <pc:spChg chg="del mod">
          <ac:chgData name="Grace Lee" userId="fd145552-a10d-4a31-a438-f8736fd84277" providerId="ADAL" clId="{EDCE6299-B909-6840-AE8F-8D55B29E9D82}" dt="2021-09-15T01:01:40.328" v="2005"/>
          <ac:spMkLst>
            <pc:docMk/>
            <pc:sldMk cId="55687339" sldId="4099"/>
            <ac:spMk id="5" creationId="{0872CD3F-DC76-DA4C-A445-20BB3CC44BE5}"/>
          </ac:spMkLst>
        </pc:spChg>
        <pc:spChg chg="mod">
          <ac:chgData name="Grace Lee" userId="fd145552-a10d-4a31-a438-f8736fd84277" providerId="ADAL" clId="{EDCE6299-B909-6840-AE8F-8D55B29E9D82}" dt="2021-09-15T01:30:14.409" v="2862" actId="1035"/>
          <ac:spMkLst>
            <pc:docMk/>
            <pc:sldMk cId="55687339" sldId="4099"/>
            <ac:spMk id="7" creationId="{F489E4A2-8294-ED48-A0E3-25779C0A6D57}"/>
          </ac:spMkLst>
        </pc:spChg>
        <pc:spChg chg="mod">
          <ac:chgData name="Grace Lee" userId="fd145552-a10d-4a31-a438-f8736fd84277" providerId="ADAL" clId="{EDCE6299-B909-6840-AE8F-8D55B29E9D82}" dt="2021-09-15T01:30:23.124" v="2864" actId="20577"/>
          <ac:spMkLst>
            <pc:docMk/>
            <pc:sldMk cId="55687339" sldId="4099"/>
            <ac:spMk id="8" creationId="{3EA74568-F3FA-5242-B6D8-A9DFA74F07F4}"/>
          </ac:spMkLst>
        </pc:spChg>
        <pc:spChg chg="mod">
          <ac:chgData name="Grace Lee" userId="fd145552-a10d-4a31-a438-f8736fd84277" providerId="ADAL" clId="{EDCE6299-B909-6840-AE8F-8D55B29E9D82}" dt="2021-09-15T01:30:14.409" v="2862" actId="1035"/>
          <ac:spMkLst>
            <pc:docMk/>
            <pc:sldMk cId="55687339" sldId="4099"/>
            <ac:spMk id="12" creationId="{FE2C0543-0B10-6A4E-A802-9BB47BE17EC6}"/>
          </ac:spMkLst>
        </pc:spChg>
        <pc:spChg chg="mod">
          <ac:chgData name="Grace Lee" userId="fd145552-a10d-4a31-a438-f8736fd84277" providerId="ADAL" clId="{EDCE6299-B909-6840-AE8F-8D55B29E9D82}" dt="2021-09-15T01:30:13.975" v="2861" actId="14100"/>
          <ac:spMkLst>
            <pc:docMk/>
            <pc:sldMk cId="55687339" sldId="4099"/>
            <ac:spMk id="16" creationId="{87F0BD83-C1CE-E64D-8D99-249D9C49E7BB}"/>
          </ac:spMkLst>
        </pc:spChg>
        <pc:spChg chg="mod">
          <ac:chgData name="Grace Lee" userId="fd145552-a10d-4a31-a438-f8736fd84277" providerId="ADAL" clId="{EDCE6299-B909-6840-AE8F-8D55B29E9D82}" dt="2021-09-15T01:30:14.409" v="2862" actId="1035"/>
          <ac:spMkLst>
            <pc:docMk/>
            <pc:sldMk cId="55687339" sldId="4099"/>
            <ac:spMk id="18" creationId="{467894DC-5BD0-324D-9188-32E3ADED6CBA}"/>
          </ac:spMkLst>
        </pc:spChg>
        <pc:spChg chg="mod">
          <ac:chgData name="Grace Lee" userId="fd145552-a10d-4a31-a438-f8736fd84277" providerId="ADAL" clId="{EDCE6299-B909-6840-AE8F-8D55B29E9D82}" dt="2021-09-15T01:30:14.409" v="2862" actId="1035"/>
          <ac:spMkLst>
            <pc:docMk/>
            <pc:sldMk cId="55687339" sldId="4099"/>
            <ac:spMk id="19" creationId="{0AA73366-3A09-C04C-955C-E0EEFD6745A5}"/>
          </ac:spMkLst>
        </pc:spChg>
        <pc:spChg chg="mod">
          <ac:chgData name="Grace Lee" userId="fd145552-a10d-4a31-a438-f8736fd84277" providerId="ADAL" clId="{EDCE6299-B909-6840-AE8F-8D55B29E9D82}" dt="2021-09-15T01:30:14.409" v="2862" actId="1035"/>
          <ac:spMkLst>
            <pc:docMk/>
            <pc:sldMk cId="55687339" sldId="4099"/>
            <ac:spMk id="20" creationId="{1214E44B-7C5A-5E4D-9A78-2DA89479E32A}"/>
          </ac:spMkLst>
        </pc:spChg>
        <pc:spChg chg="mod">
          <ac:chgData name="Grace Lee" userId="fd145552-a10d-4a31-a438-f8736fd84277" providerId="ADAL" clId="{EDCE6299-B909-6840-AE8F-8D55B29E9D82}" dt="2021-09-15T01:30:14.409" v="2862" actId="1035"/>
          <ac:spMkLst>
            <pc:docMk/>
            <pc:sldMk cId="55687339" sldId="4099"/>
            <ac:spMk id="21" creationId="{FB4E85F6-620E-E742-B060-4AD19D91DC29}"/>
          </ac:spMkLst>
        </pc:spChg>
        <pc:spChg chg="mod">
          <ac:chgData name="Grace Lee" userId="fd145552-a10d-4a31-a438-f8736fd84277" providerId="ADAL" clId="{EDCE6299-B909-6840-AE8F-8D55B29E9D82}" dt="2021-09-15T01:30:14.409" v="2862" actId="1035"/>
          <ac:spMkLst>
            <pc:docMk/>
            <pc:sldMk cId="55687339" sldId="4099"/>
            <ac:spMk id="22" creationId="{AB19A81D-A07C-5F4A-86C9-3547A6AF0398}"/>
          </ac:spMkLst>
        </pc:spChg>
        <pc:spChg chg="mod">
          <ac:chgData name="Grace Lee" userId="fd145552-a10d-4a31-a438-f8736fd84277" providerId="ADAL" clId="{EDCE6299-B909-6840-AE8F-8D55B29E9D82}" dt="2021-09-15T01:30:14.409" v="2862" actId="1035"/>
          <ac:spMkLst>
            <pc:docMk/>
            <pc:sldMk cId="55687339" sldId="4099"/>
            <ac:spMk id="40" creationId="{06151578-3498-8C48-9859-ED9A7A9B7CB6}"/>
          </ac:spMkLst>
        </pc:spChg>
        <pc:spChg chg="mod">
          <ac:chgData name="Grace Lee" userId="fd145552-a10d-4a31-a438-f8736fd84277" providerId="ADAL" clId="{EDCE6299-B909-6840-AE8F-8D55B29E9D82}" dt="2021-09-15T01:31:39.784" v="2913" actId="14100"/>
          <ac:spMkLst>
            <pc:docMk/>
            <pc:sldMk cId="55687339" sldId="4099"/>
            <ac:spMk id="43" creationId="{58C17794-AA99-284A-8875-E1F2FC31E2E3}"/>
          </ac:spMkLst>
        </pc:spChg>
        <pc:spChg chg="mod">
          <ac:chgData name="Grace Lee" userId="fd145552-a10d-4a31-a438-f8736fd84277" providerId="ADAL" clId="{EDCE6299-B909-6840-AE8F-8D55B29E9D82}" dt="2021-09-15T01:30:14.409" v="2862" actId="1035"/>
          <ac:spMkLst>
            <pc:docMk/>
            <pc:sldMk cId="55687339" sldId="4099"/>
            <ac:spMk id="44" creationId="{28C4FE9E-CE15-734C-88B8-CF5787BB200C}"/>
          </ac:spMkLst>
        </pc:spChg>
        <pc:spChg chg="add mod">
          <ac:chgData name="Grace Lee" userId="fd145552-a10d-4a31-a438-f8736fd84277" providerId="ADAL" clId="{EDCE6299-B909-6840-AE8F-8D55B29E9D82}" dt="2021-09-15T01:30:14.409" v="2862" actId="1035"/>
          <ac:spMkLst>
            <pc:docMk/>
            <pc:sldMk cId="55687339" sldId="4099"/>
            <ac:spMk id="46" creationId="{E8898714-1D79-FA40-8F87-9FBF7E1BA1D8}"/>
          </ac:spMkLst>
        </pc:spChg>
        <pc:spChg chg="add mod">
          <ac:chgData name="Grace Lee" userId="fd145552-a10d-4a31-a438-f8736fd84277" providerId="ADAL" clId="{EDCE6299-B909-6840-AE8F-8D55B29E9D82}" dt="2021-09-15T01:30:14.409" v="2862" actId="1035"/>
          <ac:spMkLst>
            <pc:docMk/>
            <pc:sldMk cId="55687339" sldId="4099"/>
            <ac:spMk id="47" creationId="{DE2CBA83-78EB-9C47-8CD2-E3C79840D187}"/>
          </ac:spMkLst>
        </pc:spChg>
        <pc:spChg chg="mod">
          <ac:chgData name="Grace Lee" userId="fd145552-a10d-4a31-a438-f8736fd84277" providerId="ADAL" clId="{EDCE6299-B909-6840-AE8F-8D55B29E9D82}" dt="2021-09-15T01:30:14.409" v="2862" actId="1035"/>
          <ac:spMkLst>
            <pc:docMk/>
            <pc:sldMk cId="55687339" sldId="4099"/>
            <ac:spMk id="48" creationId="{9404629E-822B-244B-9CC3-56399CF077D2}"/>
          </ac:spMkLst>
        </pc:spChg>
        <pc:spChg chg="add del mod">
          <ac:chgData name="Grace Lee" userId="fd145552-a10d-4a31-a438-f8736fd84277" providerId="ADAL" clId="{EDCE6299-B909-6840-AE8F-8D55B29E9D82}" dt="2021-09-15T01:30:13.269" v="2859"/>
          <ac:spMkLst>
            <pc:docMk/>
            <pc:sldMk cId="55687339" sldId="4099"/>
            <ac:spMk id="49" creationId="{BC785D72-A7A9-7C42-B141-A5C175E7203A}"/>
          </ac:spMkLst>
        </pc:spChg>
        <pc:spChg chg="mod">
          <ac:chgData name="Grace Lee" userId="fd145552-a10d-4a31-a438-f8736fd84277" providerId="ADAL" clId="{EDCE6299-B909-6840-AE8F-8D55B29E9D82}" dt="2021-09-15T01:30:14.409" v="2862" actId="1035"/>
          <ac:spMkLst>
            <pc:docMk/>
            <pc:sldMk cId="55687339" sldId="4099"/>
            <ac:spMk id="50" creationId="{3DBDDE1E-FA4D-854C-8340-ACC7179EF695}"/>
          </ac:spMkLst>
        </pc:spChg>
        <pc:spChg chg="mod">
          <ac:chgData name="Grace Lee" userId="fd145552-a10d-4a31-a438-f8736fd84277" providerId="ADAL" clId="{EDCE6299-B909-6840-AE8F-8D55B29E9D82}" dt="2021-09-15T01:30:14.409" v="2862" actId="1035"/>
          <ac:spMkLst>
            <pc:docMk/>
            <pc:sldMk cId="55687339" sldId="4099"/>
            <ac:spMk id="51" creationId="{ABF8AF6A-CA06-A742-B17E-6D9DF22CC3E7}"/>
          </ac:spMkLst>
        </pc:spChg>
        <pc:spChg chg="add del mod">
          <ac:chgData name="Grace Lee" userId="fd145552-a10d-4a31-a438-f8736fd84277" providerId="ADAL" clId="{EDCE6299-B909-6840-AE8F-8D55B29E9D82}" dt="2021-09-15T01:30:12.219" v="2856"/>
          <ac:spMkLst>
            <pc:docMk/>
            <pc:sldMk cId="55687339" sldId="4099"/>
            <ac:spMk id="52" creationId="{7ABD722F-2B67-C445-834B-82B1D933A3AF}"/>
          </ac:spMkLst>
        </pc:spChg>
        <pc:spChg chg="mod">
          <ac:chgData name="Grace Lee" userId="fd145552-a10d-4a31-a438-f8736fd84277" providerId="ADAL" clId="{EDCE6299-B909-6840-AE8F-8D55B29E9D82}" dt="2021-09-15T01:30:14.409" v="2862" actId="1035"/>
          <ac:spMkLst>
            <pc:docMk/>
            <pc:sldMk cId="55687339" sldId="4099"/>
            <ac:spMk id="53" creationId="{6DC96E80-C7D4-4EBA-9932-BF14C22365D6}"/>
          </ac:spMkLst>
        </pc:spChg>
        <pc:spChg chg="mod">
          <ac:chgData name="Grace Lee" userId="fd145552-a10d-4a31-a438-f8736fd84277" providerId="ADAL" clId="{EDCE6299-B909-6840-AE8F-8D55B29E9D82}" dt="2021-09-15T01:30:14.409" v="2862" actId="1035"/>
          <ac:spMkLst>
            <pc:docMk/>
            <pc:sldMk cId="55687339" sldId="4099"/>
            <ac:spMk id="54" creationId="{20966284-2E31-45BD-A65C-E500A34DEA98}"/>
          </ac:spMkLst>
        </pc:spChg>
        <pc:spChg chg="mod">
          <ac:chgData name="Grace Lee" userId="fd145552-a10d-4a31-a438-f8736fd84277" providerId="ADAL" clId="{EDCE6299-B909-6840-AE8F-8D55B29E9D82}" dt="2021-09-15T01:30:14.409" v="2862" actId="1035"/>
          <ac:spMkLst>
            <pc:docMk/>
            <pc:sldMk cId="55687339" sldId="4099"/>
            <ac:spMk id="55" creationId="{C65B820F-C94C-47B9-A757-C873C4656D6D}"/>
          </ac:spMkLst>
        </pc:spChg>
        <pc:spChg chg="mod">
          <ac:chgData name="Grace Lee" userId="fd145552-a10d-4a31-a438-f8736fd84277" providerId="ADAL" clId="{EDCE6299-B909-6840-AE8F-8D55B29E9D82}" dt="2021-09-15T01:30:14.409" v="2862" actId="1035"/>
          <ac:spMkLst>
            <pc:docMk/>
            <pc:sldMk cId="55687339" sldId="4099"/>
            <ac:spMk id="56" creationId="{98D23327-E344-402E-AF2A-66EEAE768262}"/>
          </ac:spMkLst>
        </pc:spChg>
        <pc:spChg chg="mod">
          <ac:chgData name="Grace Lee" userId="fd145552-a10d-4a31-a438-f8736fd84277" providerId="ADAL" clId="{EDCE6299-B909-6840-AE8F-8D55B29E9D82}" dt="2021-09-15T01:30:14.409" v="2862" actId="1035"/>
          <ac:spMkLst>
            <pc:docMk/>
            <pc:sldMk cId="55687339" sldId="4099"/>
            <ac:spMk id="57" creationId="{028BCC21-0271-4D24-BE5D-39A2E06A1750}"/>
          </ac:spMkLst>
        </pc:spChg>
        <pc:spChg chg="mod">
          <ac:chgData name="Grace Lee" userId="fd145552-a10d-4a31-a438-f8736fd84277" providerId="ADAL" clId="{EDCE6299-B909-6840-AE8F-8D55B29E9D82}" dt="2021-09-15T01:30:14.409" v="2862" actId="1035"/>
          <ac:spMkLst>
            <pc:docMk/>
            <pc:sldMk cId="55687339" sldId="4099"/>
            <ac:spMk id="58" creationId="{EFF1E7A1-001E-454B-B506-0BAA36FC61D7}"/>
          </ac:spMkLst>
        </pc:spChg>
        <pc:spChg chg="mod">
          <ac:chgData name="Grace Lee" userId="fd145552-a10d-4a31-a438-f8736fd84277" providerId="ADAL" clId="{EDCE6299-B909-6840-AE8F-8D55B29E9D82}" dt="2021-09-15T01:30:14.409" v="2862" actId="1035"/>
          <ac:spMkLst>
            <pc:docMk/>
            <pc:sldMk cId="55687339" sldId="4099"/>
            <ac:spMk id="59" creationId="{D8A4664C-531E-466C-8B4F-087D118EF51C}"/>
          </ac:spMkLst>
        </pc:spChg>
        <pc:spChg chg="mod">
          <ac:chgData name="Grace Lee" userId="fd145552-a10d-4a31-a438-f8736fd84277" providerId="ADAL" clId="{EDCE6299-B909-6840-AE8F-8D55B29E9D82}" dt="2021-09-15T01:30:14.409" v="2862" actId="1035"/>
          <ac:spMkLst>
            <pc:docMk/>
            <pc:sldMk cId="55687339" sldId="4099"/>
            <ac:spMk id="60" creationId="{46110F5C-221D-4D8A-BB64-8D02A2C26E33}"/>
          </ac:spMkLst>
        </pc:spChg>
        <pc:spChg chg="mod">
          <ac:chgData name="Grace Lee" userId="fd145552-a10d-4a31-a438-f8736fd84277" providerId="ADAL" clId="{EDCE6299-B909-6840-AE8F-8D55B29E9D82}" dt="2021-09-15T01:30:14.409" v="2862" actId="1035"/>
          <ac:spMkLst>
            <pc:docMk/>
            <pc:sldMk cId="55687339" sldId="4099"/>
            <ac:spMk id="61" creationId="{6220F981-2F6B-4FD5-8194-92970A9D9210}"/>
          </ac:spMkLst>
        </pc:spChg>
        <pc:spChg chg="mod">
          <ac:chgData name="Grace Lee" userId="fd145552-a10d-4a31-a438-f8736fd84277" providerId="ADAL" clId="{EDCE6299-B909-6840-AE8F-8D55B29E9D82}" dt="2021-09-15T01:30:14.409" v="2862" actId="1035"/>
          <ac:spMkLst>
            <pc:docMk/>
            <pc:sldMk cId="55687339" sldId="4099"/>
            <ac:spMk id="62" creationId="{682238F5-2413-4964-968A-ACA45F28A1DA}"/>
          </ac:spMkLst>
        </pc:spChg>
        <pc:spChg chg="mod">
          <ac:chgData name="Grace Lee" userId="fd145552-a10d-4a31-a438-f8736fd84277" providerId="ADAL" clId="{EDCE6299-B909-6840-AE8F-8D55B29E9D82}" dt="2021-09-15T01:30:14.409" v="2862" actId="1035"/>
          <ac:spMkLst>
            <pc:docMk/>
            <pc:sldMk cId="55687339" sldId="4099"/>
            <ac:spMk id="63" creationId="{2FEA7768-459E-4788-A455-A895DB0AC749}"/>
          </ac:spMkLst>
        </pc:spChg>
        <pc:spChg chg="mod">
          <ac:chgData name="Grace Lee" userId="fd145552-a10d-4a31-a438-f8736fd84277" providerId="ADAL" clId="{EDCE6299-B909-6840-AE8F-8D55B29E9D82}" dt="2021-09-15T01:30:14.409" v="2862" actId="1035"/>
          <ac:spMkLst>
            <pc:docMk/>
            <pc:sldMk cId="55687339" sldId="4099"/>
            <ac:spMk id="64" creationId="{254AB6F3-89A1-4E1B-B11C-3C5F52E410A6}"/>
          </ac:spMkLst>
        </pc:spChg>
        <pc:spChg chg="mod">
          <ac:chgData name="Grace Lee" userId="fd145552-a10d-4a31-a438-f8736fd84277" providerId="ADAL" clId="{EDCE6299-B909-6840-AE8F-8D55B29E9D82}" dt="2021-09-15T01:30:14.409" v="2862" actId="1035"/>
          <ac:spMkLst>
            <pc:docMk/>
            <pc:sldMk cId="55687339" sldId="4099"/>
            <ac:spMk id="65" creationId="{CB1FBF99-35F4-44A9-9D72-5FEA0559D9BF}"/>
          </ac:spMkLst>
        </pc:spChg>
        <pc:spChg chg="mod">
          <ac:chgData name="Grace Lee" userId="fd145552-a10d-4a31-a438-f8736fd84277" providerId="ADAL" clId="{EDCE6299-B909-6840-AE8F-8D55B29E9D82}" dt="2021-09-15T01:30:14.409" v="2862" actId="1035"/>
          <ac:spMkLst>
            <pc:docMk/>
            <pc:sldMk cId="55687339" sldId="4099"/>
            <ac:spMk id="66" creationId="{897DE1CB-C62D-4B44-8A9C-13C59E127509}"/>
          </ac:spMkLst>
        </pc:spChg>
        <pc:spChg chg="mod">
          <ac:chgData name="Grace Lee" userId="fd145552-a10d-4a31-a438-f8736fd84277" providerId="ADAL" clId="{EDCE6299-B909-6840-AE8F-8D55B29E9D82}" dt="2021-09-15T01:30:14.409" v="2862" actId="1035"/>
          <ac:spMkLst>
            <pc:docMk/>
            <pc:sldMk cId="55687339" sldId="4099"/>
            <ac:spMk id="67" creationId="{535F0882-C5C7-4680-A719-0A07A80D882B}"/>
          </ac:spMkLst>
        </pc:spChg>
        <pc:spChg chg="mod">
          <ac:chgData name="Grace Lee" userId="fd145552-a10d-4a31-a438-f8736fd84277" providerId="ADAL" clId="{EDCE6299-B909-6840-AE8F-8D55B29E9D82}" dt="2021-09-15T01:30:14.409" v="2862" actId="1035"/>
          <ac:spMkLst>
            <pc:docMk/>
            <pc:sldMk cId="55687339" sldId="4099"/>
            <ac:spMk id="68" creationId="{9A49CD10-1D63-4FAC-9447-76A5C13EF15C}"/>
          </ac:spMkLst>
        </pc:spChg>
        <pc:spChg chg="add mod">
          <ac:chgData name="Grace Lee" userId="fd145552-a10d-4a31-a438-f8736fd84277" providerId="ADAL" clId="{EDCE6299-B909-6840-AE8F-8D55B29E9D82}" dt="2021-09-15T01:31:24.833" v="2909" actId="1036"/>
          <ac:spMkLst>
            <pc:docMk/>
            <pc:sldMk cId="55687339" sldId="4099"/>
            <ac:spMk id="69" creationId="{8BB5DE19-6B2C-4440-B58D-5FD25B416D39}"/>
          </ac:spMkLst>
        </pc:spChg>
        <pc:spChg chg="mod">
          <ac:chgData name="Grace Lee" userId="fd145552-a10d-4a31-a438-f8736fd84277" providerId="ADAL" clId="{EDCE6299-B909-6840-AE8F-8D55B29E9D82}" dt="2021-09-15T01:30:14.409" v="2862" actId="1035"/>
          <ac:spMkLst>
            <pc:docMk/>
            <pc:sldMk cId="55687339" sldId="4099"/>
            <ac:spMk id="70" creationId="{BF74347B-75F3-4553-9F06-BA17F0465A9B}"/>
          </ac:spMkLst>
        </pc:spChg>
        <pc:spChg chg="mod">
          <ac:chgData name="Grace Lee" userId="fd145552-a10d-4a31-a438-f8736fd84277" providerId="ADAL" clId="{EDCE6299-B909-6840-AE8F-8D55B29E9D82}" dt="2021-09-15T01:31:12.654" v="2901" actId="1076"/>
          <ac:spMkLst>
            <pc:docMk/>
            <pc:sldMk cId="55687339" sldId="4099"/>
            <ac:spMk id="71" creationId="{BE40ADCA-1D2B-4CEB-803D-937EB95FF248}"/>
          </ac:spMkLst>
        </pc:spChg>
        <pc:spChg chg="mod">
          <ac:chgData name="Grace Lee" userId="fd145552-a10d-4a31-a438-f8736fd84277" providerId="ADAL" clId="{EDCE6299-B909-6840-AE8F-8D55B29E9D82}" dt="2021-09-15T01:30:14.409" v="2862" actId="1035"/>
          <ac:spMkLst>
            <pc:docMk/>
            <pc:sldMk cId="55687339" sldId="4099"/>
            <ac:spMk id="72" creationId="{BE8C501C-64F1-4D88-98E2-3CF3C6C798B0}"/>
          </ac:spMkLst>
        </pc:spChg>
        <pc:spChg chg="mod">
          <ac:chgData name="Grace Lee" userId="fd145552-a10d-4a31-a438-f8736fd84277" providerId="ADAL" clId="{EDCE6299-B909-6840-AE8F-8D55B29E9D82}" dt="2021-09-15T01:30:14.409" v="2862" actId="1035"/>
          <ac:spMkLst>
            <pc:docMk/>
            <pc:sldMk cId="55687339" sldId="4099"/>
            <ac:spMk id="73" creationId="{E9A4F349-00C1-4F61-B241-F08552B13677}"/>
          </ac:spMkLst>
        </pc:spChg>
        <pc:spChg chg="mod">
          <ac:chgData name="Grace Lee" userId="fd145552-a10d-4a31-a438-f8736fd84277" providerId="ADAL" clId="{EDCE6299-B909-6840-AE8F-8D55B29E9D82}" dt="2021-09-15T01:30:14.409" v="2862" actId="1035"/>
          <ac:spMkLst>
            <pc:docMk/>
            <pc:sldMk cId="55687339" sldId="4099"/>
            <ac:spMk id="74" creationId="{692DD962-4E2E-42C7-8D0E-2C7403599DF8}"/>
          </ac:spMkLst>
        </pc:spChg>
        <pc:spChg chg="mod">
          <ac:chgData name="Grace Lee" userId="fd145552-a10d-4a31-a438-f8736fd84277" providerId="ADAL" clId="{EDCE6299-B909-6840-AE8F-8D55B29E9D82}" dt="2021-09-15T01:30:14.409" v="2862" actId="1035"/>
          <ac:spMkLst>
            <pc:docMk/>
            <pc:sldMk cId="55687339" sldId="4099"/>
            <ac:spMk id="75" creationId="{D3D76CA0-06C6-4EE2-AD66-B32AC4836672}"/>
          </ac:spMkLst>
        </pc:spChg>
        <pc:spChg chg="mod">
          <ac:chgData name="Grace Lee" userId="fd145552-a10d-4a31-a438-f8736fd84277" providerId="ADAL" clId="{EDCE6299-B909-6840-AE8F-8D55B29E9D82}" dt="2021-09-15T01:30:14.409" v="2862" actId="1035"/>
          <ac:spMkLst>
            <pc:docMk/>
            <pc:sldMk cId="55687339" sldId="4099"/>
            <ac:spMk id="76" creationId="{D86C25A9-3646-4C80-8719-49C32CE35419}"/>
          </ac:spMkLst>
        </pc:spChg>
        <pc:spChg chg="mod">
          <ac:chgData name="Grace Lee" userId="fd145552-a10d-4a31-a438-f8736fd84277" providerId="ADAL" clId="{EDCE6299-B909-6840-AE8F-8D55B29E9D82}" dt="2021-09-15T01:30:14.409" v="2862" actId="1035"/>
          <ac:spMkLst>
            <pc:docMk/>
            <pc:sldMk cId="55687339" sldId="4099"/>
            <ac:spMk id="77" creationId="{90988F15-36D9-448E-AC80-DCA6FE9B3FB4}"/>
          </ac:spMkLst>
        </pc:spChg>
        <pc:spChg chg="mod">
          <ac:chgData name="Grace Lee" userId="fd145552-a10d-4a31-a438-f8736fd84277" providerId="ADAL" clId="{EDCE6299-B909-6840-AE8F-8D55B29E9D82}" dt="2021-09-15T01:30:14.409" v="2862" actId="1035"/>
          <ac:spMkLst>
            <pc:docMk/>
            <pc:sldMk cId="55687339" sldId="4099"/>
            <ac:spMk id="78" creationId="{2BC42DF7-8C72-4FC7-9741-006F96ECED6C}"/>
          </ac:spMkLst>
        </pc:spChg>
        <pc:spChg chg="add mod">
          <ac:chgData name="Grace Lee" userId="fd145552-a10d-4a31-a438-f8736fd84277" providerId="ADAL" clId="{EDCE6299-B909-6840-AE8F-8D55B29E9D82}" dt="2021-09-15T01:31:44.148" v="2914" actId="1036"/>
          <ac:spMkLst>
            <pc:docMk/>
            <pc:sldMk cId="55687339" sldId="4099"/>
            <ac:spMk id="79" creationId="{E52AF8FF-F96C-D943-AEC3-EE149FE58666}"/>
          </ac:spMkLst>
        </pc:spChg>
        <pc:picChg chg="mod">
          <ac:chgData name="Grace Lee" userId="fd145552-a10d-4a31-a438-f8736fd84277" providerId="ADAL" clId="{EDCE6299-B909-6840-AE8F-8D55B29E9D82}" dt="2021-09-15T01:30:14.409" v="2862" actId="1035"/>
          <ac:picMkLst>
            <pc:docMk/>
            <pc:sldMk cId="55687339" sldId="4099"/>
            <ac:picMk id="3" creationId="{219E936F-4829-49A3-ADAF-593AAFFF9442}"/>
          </ac:picMkLst>
        </pc:picChg>
      </pc:sldChg>
      <pc:sldChg chg="modSp mod">
        <pc:chgData name="Grace Lee" userId="fd145552-a10d-4a31-a438-f8736fd84277" providerId="ADAL" clId="{EDCE6299-B909-6840-AE8F-8D55B29E9D82}" dt="2021-09-15T08:19:08.350" v="4144" actId="20577"/>
        <pc:sldMkLst>
          <pc:docMk/>
          <pc:sldMk cId="2280266633" sldId="4100"/>
        </pc:sldMkLst>
        <pc:spChg chg="mod">
          <ac:chgData name="Grace Lee" userId="fd145552-a10d-4a31-a438-f8736fd84277" providerId="ADAL" clId="{EDCE6299-B909-6840-AE8F-8D55B29E9D82}" dt="2021-09-15T08:14:40.646" v="3907" actId="1076"/>
          <ac:spMkLst>
            <pc:docMk/>
            <pc:sldMk cId="2280266633" sldId="4100"/>
            <ac:spMk id="3" creationId="{1C207EF0-D5F8-4C7D-9363-8246CDD5503A}"/>
          </ac:spMkLst>
        </pc:spChg>
        <pc:graphicFrameChg chg="mod modGraphic">
          <ac:chgData name="Grace Lee" userId="fd145552-a10d-4a31-a438-f8736fd84277" providerId="ADAL" clId="{EDCE6299-B909-6840-AE8F-8D55B29E9D82}" dt="2021-09-15T08:19:08.350" v="4144" actId="20577"/>
          <ac:graphicFrameMkLst>
            <pc:docMk/>
            <pc:sldMk cId="2280266633" sldId="4100"/>
            <ac:graphicFrameMk id="5" creationId="{1F6D69E8-098B-4675-AAE5-73A7D0391966}"/>
          </ac:graphicFrameMkLst>
        </pc:graphicFrameChg>
      </pc:sldChg>
      <pc:sldChg chg="addSp delSp modSp mod">
        <pc:chgData name="Grace Lee" userId="fd145552-a10d-4a31-a438-f8736fd84277" providerId="ADAL" clId="{EDCE6299-B909-6840-AE8F-8D55B29E9D82}" dt="2021-09-15T08:53:28.880" v="5188" actId="20577"/>
        <pc:sldMkLst>
          <pc:docMk/>
          <pc:sldMk cId="2675036270" sldId="4101"/>
        </pc:sldMkLst>
        <pc:spChg chg="add del mod">
          <ac:chgData name="Grace Lee" userId="fd145552-a10d-4a31-a438-f8736fd84277" providerId="ADAL" clId="{EDCE6299-B909-6840-AE8F-8D55B29E9D82}" dt="2021-09-15T08:40:05.313" v="4514" actId="478"/>
          <ac:spMkLst>
            <pc:docMk/>
            <pc:sldMk cId="2675036270" sldId="4101"/>
            <ac:spMk id="2" creationId="{AEC468F4-B124-E442-9085-390916656E45}"/>
          </ac:spMkLst>
        </pc:spChg>
        <pc:spChg chg="mod">
          <ac:chgData name="Grace Lee" userId="fd145552-a10d-4a31-a438-f8736fd84277" providerId="ADAL" clId="{EDCE6299-B909-6840-AE8F-8D55B29E9D82}" dt="2021-09-15T08:43:01.343" v="4777" actId="1035"/>
          <ac:spMkLst>
            <pc:docMk/>
            <pc:sldMk cId="2675036270" sldId="4101"/>
            <ac:spMk id="3" creationId="{1C207EF0-D5F8-4C7D-9363-8246CDD5503A}"/>
          </ac:spMkLst>
        </pc:spChg>
        <pc:graphicFrameChg chg="mod modGraphic">
          <ac:chgData name="Grace Lee" userId="fd145552-a10d-4a31-a438-f8736fd84277" providerId="ADAL" clId="{EDCE6299-B909-6840-AE8F-8D55B29E9D82}" dt="2021-09-15T08:53:28.880" v="5188" actId="20577"/>
          <ac:graphicFrameMkLst>
            <pc:docMk/>
            <pc:sldMk cId="2675036270" sldId="4101"/>
            <ac:graphicFrameMk id="5" creationId="{1F6D69E8-098B-4675-AAE5-73A7D0391966}"/>
          </ac:graphicFrameMkLst>
        </pc:graphicFrameChg>
      </pc:sldChg>
      <pc:sldChg chg="modSp mod">
        <pc:chgData name="Grace Lee" userId="fd145552-a10d-4a31-a438-f8736fd84277" providerId="ADAL" clId="{EDCE6299-B909-6840-AE8F-8D55B29E9D82}" dt="2021-09-15T01:33:09.583" v="3141" actId="20577"/>
        <pc:sldMkLst>
          <pc:docMk/>
          <pc:sldMk cId="2198890857" sldId="4102"/>
        </pc:sldMkLst>
        <pc:spChg chg="mod">
          <ac:chgData name="Grace Lee" userId="fd145552-a10d-4a31-a438-f8736fd84277" providerId="ADAL" clId="{EDCE6299-B909-6840-AE8F-8D55B29E9D82}" dt="2021-09-02T03:41:04.762" v="11" actId="20577"/>
          <ac:spMkLst>
            <pc:docMk/>
            <pc:sldMk cId="2198890857" sldId="4102"/>
            <ac:spMk id="3" creationId="{1C207EF0-D5F8-4C7D-9363-8246CDD5503A}"/>
          </ac:spMkLst>
        </pc:spChg>
        <pc:graphicFrameChg chg="modGraphic">
          <ac:chgData name="Grace Lee" userId="fd145552-a10d-4a31-a438-f8736fd84277" providerId="ADAL" clId="{EDCE6299-B909-6840-AE8F-8D55B29E9D82}" dt="2021-09-15T01:33:09.583" v="3141" actId="20577"/>
          <ac:graphicFrameMkLst>
            <pc:docMk/>
            <pc:sldMk cId="2198890857" sldId="4102"/>
            <ac:graphicFrameMk id="5" creationId="{1F6D69E8-098B-4675-AAE5-73A7D0391966}"/>
          </ac:graphicFrameMkLst>
        </pc:graphicFrameChg>
      </pc:sldChg>
      <pc:sldChg chg="modSp mod">
        <pc:chgData name="Grace Lee" userId="fd145552-a10d-4a31-a438-f8736fd84277" providerId="ADAL" clId="{EDCE6299-B909-6840-AE8F-8D55B29E9D82}" dt="2021-09-15T01:20:58.610" v="2588" actId="21"/>
        <pc:sldMkLst>
          <pc:docMk/>
          <pc:sldMk cId="660037898" sldId="4104"/>
        </pc:sldMkLst>
        <pc:graphicFrameChg chg="mod modGraphic">
          <ac:chgData name="Grace Lee" userId="fd145552-a10d-4a31-a438-f8736fd84277" providerId="ADAL" clId="{EDCE6299-B909-6840-AE8F-8D55B29E9D82}" dt="2021-09-15T01:20:58.610" v="2588" actId="21"/>
          <ac:graphicFrameMkLst>
            <pc:docMk/>
            <pc:sldMk cId="660037898" sldId="4104"/>
            <ac:graphicFrameMk id="4" creationId="{34A6E8FD-61D1-453E-B833-42E2C191607B}"/>
          </ac:graphicFrameMkLst>
        </pc:graphicFrameChg>
      </pc:sldChg>
      <pc:sldChg chg="addSp delSp modSp mod modNotesTx">
        <pc:chgData name="Grace Lee" userId="fd145552-a10d-4a31-a438-f8736fd84277" providerId="ADAL" clId="{EDCE6299-B909-6840-AE8F-8D55B29E9D82}" dt="2021-09-15T09:10:26.545" v="5420" actId="20577"/>
        <pc:sldMkLst>
          <pc:docMk/>
          <pc:sldMk cId="4043908164" sldId="4105"/>
        </pc:sldMkLst>
        <pc:spChg chg="del">
          <ac:chgData name="Grace Lee" userId="fd145552-a10d-4a31-a438-f8736fd84277" providerId="ADAL" clId="{EDCE6299-B909-6840-AE8F-8D55B29E9D82}" dt="2021-09-07T06:24:46.061" v="579" actId="478"/>
          <ac:spMkLst>
            <pc:docMk/>
            <pc:sldMk cId="4043908164" sldId="4105"/>
            <ac:spMk id="2" creationId="{594AAAD1-A302-415E-8929-53A6DDC5A801}"/>
          </ac:spMkLst>
        </pc:spChg>
        <pc:spChg chg="mod">
          <ac:chgData name="Grace Lee" userId="fd145552-a10d-4a31-a438-f8736fd84277" providerId="ADAL" clId="{EDCE6299-B909-6840-AE8F-8D55B29E9D82}" dt="2021-09-07T06:19:52.591" v="555" actId="20577"/>
          <ac:spMkLst>
            <pc:docMk/>
            <pc:sldMk cId="4043908164" sldId="4105"/>
            <ac:spMk id="3" creationId="{B354936E-C463-4D90-963C-698FEFB13AEA}"/>
          </ac:spMkLst>
        </pc:spChg>
        <pc:spChg chg="del mod">
          <ac:chgData name="Grace Lee" userId="fd145552-a10d-4a31-a438-f8736fd84277" providerId="ADAL" clId="{EDCE6299-B909-6840-AE8F-8D55B29E9D82}" dt="2021-09-07T06:30:31.052" v="1263" actId="478"/>
          <ac:spMkLst>
            <pc:docMk/>
            <pc:sldMk cId="4043908164" sldId="4105"/>
            <ac:spMk id="5" creationId="{C333899F-F847-4571-9683-DCBDF5945307}"/>
          </ac:spMkLst>
        </pc:spChg>
        <pc:spChg chg="mod">
          <ac:chgData name="Grace Lee" userId="fd145552-a10d-4a31-a438-f8736fd84277" providerId="ADAL" clId="{EDCE6299-B909-6840-AE8F-8D55B29E9D82}" dt="2021-09-07T06:23:31.686" v="561" actId="2711"/>
          <ac:spMkLst>
            <pc:docMk/>
            <pc:sldMk cId="4043908164" sldId="4105"/>
            <ac:spMk id="7" creationId="{1846FB9B-37BB-EC4D-9EBF-94E6FCC8BF5E}"/>
          </ac:spMkLst>
        </pc:spChg>
        <pc:spChg chg="mod">
          <ac:chgData name="Grace Lee" userId="fd145552-a10d-4a31-a438-f8736fd84277" providerId="ADAL" clId="{EDCE6299-B909-6840-AE8F-8D55B29E9D82}" dt="2021-09-07T06:23:31.686" v="561" actId="2711"/>
          <ac:spMkLst>
            <pc:docMk/>
            <pc:sldMk cId="4043908164" sldId="4105"/>
            <ac:spMk id="8" creationId="{2FE41BA6-ADD7-744F-A34B-67BFC335823A}"/>
          </ac:spMkLst>
        </pc:spChg>
        <pc:spChg chg="mod">
          <ac:chgData name="Grace Lee" userId="fd145552-a10d-4a31-a438-f8736fd84277" providerId="ADAL" clId="{EDCE6299-B909-6840-AE8F-8D55B29E9D82}" dt="2021-09-07T06:23:31.686" v="561" actId="2711"/>
          <ac:spMkLst>
            <pc:docMk/>
            <pc:sldMk cId="4043908164" sldId="4105"/>
            <ac:spMk id="9" creationId="{E800E75E-1D5F-F44C-8BCD-9031067F30AB}"/>
          </ac:spMkLst>
        </pc:spChg>
        <pc:spChg chg="mod">
          <ac:chgData name="Grace Lee" userId="fd145552-a10d-4a31-a438-f8736fd84277" providerId="ADAL" clId="{EDCE6299-B909-6840-AE8F-8D55B29E9D82}" dt="2021-09-07T06:23:31.686" v="561" actId="2711"/>
          <ac:spMkLst>
            <pc:docMk/>
            <pc:sldMk cId="4043908164" sldId="4105"/>
            <ac:spMk id="10" creationId="{E750656D-3C6E-2543-92DD-EC5B945453A8}"/>
          </ac:spMkLst>
        </pc:spChg>
        <pc:spChg chg="mod">
          <ac:chgData name="Grace Lee" userId="fd145552-a10d-4a31-a438-f8736fd84277" providerId="ADAL" clId="{EDCE6299-B909-6840-AE8F-8D55B29E9D82}" dt="2021-09-07T06:23:31.686" v="561" actId="2711"/>
          <ac:spMkLst>
            <pc:docMk/>
            <pc:sldMk cId="4043908164" sldId="4105"/>
            <ac:spMk id="11" creationId="{D8127E22-5080-9F44-A14E-9052B7592ED5}"/>
          </ac:spMkLst>
        </pc:spChg>
        <pc:spChg chg="mod">
          <ac:chgData name="Grace Lee" userId="fd145552-a10d-4a31-a438-f8736fd84277" providerId="ADAL" clId="{EDCE6299-B909-6840-AE8F-8D55B29E9D82}" dt="2021-09-07T06:23:31.686" v="561" actId="2711"/>
          <ac:spMkLst>
            <pc:docMk/>
            <pc:sldMk cId="4043908164" sldId="4105"/>
            <ac:spMk id="12" creationId="{A42D1546-D510-4A40-B4A0-43AA63127CF9}"/>
          </ac:spMkLst>
        </pc:spChg>
        <pc:spChg chg="mod">
          <ac:chgData name="Grace Lee" userId="fd145552-a10d-4a31-a438-f8736fd84277" providerId="ADAL" clId="{EDCE6299-B909-6840-AE8F-8D55B29E9D82}" dt="2021-09-07T06:23:31.686" v="561" actId="2711"/>
          <ac:spMkLst>
            <pc:docMk/>
            <pc:sldMk cId="4043908164" sldId="4105"/>
            <ac:spMk id="13" creationId="{46DE2508-383A-D744-A55B-B5143CA39403}"/>
          </ac:spMkLst>
        </pc:spChg>
        <pc:spChg chg="mod">
          <ac:chgData name="Grace Lee" userId="fd145552-a10d-4a31-a438-f8736fd84277" providerId="ADAL" clId="{EDCE6299-B909-6840-AE8F-8D55B29E9D82}" dt="2021-09-07T06:23:31.686" v="561" actId="2711"/>
          <ac:spMkLst>
            <pc:docMk/>
            <pc:sldMk cId="4043908164" sldId="4105"/>
            <ac:spMk id="14" creationId="{B32B9A6D-8D18-EF44-A1AC-125B25FD621C}"/>
          </ac:spMkLst>
        </pc:spChg>
        <pc:spChg chg="mod">
          <ac:chgData name="Grace Lee" userId="fd145552-a10d-4a31-a438-f8736fd84277" providerId="ADAL" clId="{EDCE6299-B909-6840-AE8F-8D55B29E9D82}" dt="2021-09-07T06:23:42.953" v="563" actId="207"/>
          <ac:spMkLst>
            <pc:docMk/>
            <pc:sldMk cId="4043908164" sldId="4105"/>
            <ac:spMk id="16" creationId="{5C4F5523-3810-8740-9FDB-2C7AD2162418}"/>
          </ac:spMkLst>
        </pc:spChg>
        <pc:spChg chg="mod">
          <ac:chgData name="Grace Lee" userId="fd145552-a10d-4a31-a438-f8736fd84277" providerId="ADAL" clId="{EDCE6299-B909-6840-AE8F-8D55B29E9D82}" dt="2021-09-07T06:23:42.953" v="563" actId="207"/>
          <ac:spMkLst>
            <pc:docMk/>
            <pc:sldMk cId="4043908164" sldId="4105"/>
            <ac:spMk id="17" creationId="{48497EAB-4356-3C45-A561-66F3E227526F}"/>
          </ac:spMkLst>
        </pc:spChg>
        <pc:spChg chg="mod">
          <ac:chgData name="Grace Lee" userId="fd145552-a10d-4a31-a438-f8736fd84277" providerId="ADAL" clId="{EDCE6299-B909-6840-AE8F-8D55B29E9D82}" dt="2021-09-07T06:23:42.953" v="563" actId="207"/>
          <ac:spMkLst>
            <pc:docMk/>
            <pc:sldMk cId="4043908164" sldId="4105"/>
            <ac:spMk id="18" creationId="{5BE47F52-F041-244B-9D34-FF46587BF74D}"/>
          </ac:spMkLst>
        </pc:spChg>
        <pc:spChg chg="mod">
          <ac:chgData name="Grace Lee" userId="fd145552-a10d-4a31-a438-f8736fd84277" providerId="ADAL" clId="{EDCE6299-B909-6840-AE8F-8D55B29E9D82}" dt="2021-09-07T06:23:42.953" v="563" actId="207"/>
          <ac:spMkLst>
            <pc:docMk/>
            <pc:sldMk cId="4043908164" sldId="4105"/>
            <ac:spMk id="19" creationId="{C627FBD0-7FAB-7A46-8F85-D7AE0B3410EB}"/>
          </ac:spMkLst>
        </pc:spChg>
        <pc:spChg chg="mod">
          <ac:chgData name="Grace Lee" userId="fd145552-a10d-4a31-a438-f8736fd84277" providerId="ADAL" clId="{EDCE6299-B909-6840-AE8F-8D55B29E9D82}" dt="2021-09-07T06:23:42.953" v="563" actId="207"/>
          <ac:spMkLst>
            <pc:docMk/>
            <pc:sldMk cId="4043908164" sldId="4105"/>
            <ac:spMk id="20" creationId="{CEFA674F-F94C-E947-8EF3-8476669A7521}"/>
          </ac:spMkLst>
        </pc:spChg>
        <pc:spChg chg="add del mod">
          <ac:chgData name="Grace Lee" userId="fd145552-a10d-4a31-a438-f8736fd84277" providerId="ADAL" clId="{EDCE6299-B909-6840-AE8F-8D55B29E9D82}" dt="2021-09-07T06:24:20.001" v="571" actId="478"/>
          <ac:spMkLst>
            <pc:docMk/>
            <pc:sldMk cId="4043908164" sldId="4105"/>
            <ac:spMk id="21" creationId="{C96F03D2-0B95-BC45-902D-44269C8DA366}"/>
          </ac:spMkLst>
        </pc:spChg>
        <pc:spChg chg="add del mod">
          <ac:chgData name="Grace Lee" userId="fd145552-a10d-4a31-a438-f8736fd84277" providerId="ADAL" clId="{EDCE6299-B909-6840-AE8F-8D55B29E9D82}" dt="2021-09-07T06:24:20.001" v="571" actId="478"/>
          <ac:spMkLst>
            <pc:docMk/>
            <pc:sldMk cId="4043908164" sldId="4105"/>
            <ac:spMk id="22" creationId="{FB1C5394-BBDD-5243-8BDB-DD97F6260EB0}"/>
          </ac:spMkLst>
        </pc:spChg>
        <pc:spChg chg="add del mod">
          <ac:chgData name="Grace Lee" userId="fd145552-a10d-4a31-a438-f8736fd84277" providerId="ADAL" clId="{EDCE6299-B909-6840-AE8F-8D55B29E9D82}" dt="2021-09-07T06:24:20.001" v="571" actId="478"/>
          <ac:spMkLst>
            <pc:docMk/>
            <pc:sldMk cId="4043908164" sldId="4105"/>
            <ac:spMk id="23" creationId="{77238871-CB8E-C949-A6D6-BA248857E2BC}"/>
          </ac:spMkLst>
        </pc:spChg>
        <pc:spChg chg="add del mod">
          <ac:chgData name="Grace Lee" userId="fd145552-a10d-4a31-a438-f8736fd84277" providerId="ADAL" clId="{EDCE6299-B909-6840-AE8F-8D55B29E9D82}" dt="2021-09-07T06:24:20.001" v="571" actId="478"/>
          <ac:spMkLst>
            <pc:docMk/>
            <pc:sldMk cId="4043908164" sldId="4105"/>
            <ac:spMk id="24" creationId="{20BA936E-AE60-D549-8300-8C39FB4DC23B}"/>
          </ac:spMkLst>
        </pc:spChg>
        <pc:spChg chg="add del mod">
          <ac:chgData name="Grace Lee" userId="fd145552-a10d-4a31-a438-f8736fd84277" providerId="ADAL" clId="{EDCE6299-B909-6840-AE8F-8D55B29E9D82}" dt="2021-09-07T06:24:20.001" v="571" actId="478"/>
          <ac:spMkLst>
            <pc:docMk/>
            <pc:sldMk cId="4043908164" sldId="4105"/>
            <ac:spMk id="25" creationId="{6ECBFEAE-A8AA-5D40-813A-48B428251472}"/>
          </ac:spMkLst>
        </pc:spChg>
        <pc:spChg chg="add del mod">
          <ac:chgData name="Grace Lee" userId="fd145552-a10d-4a31-a438-f8736fd84277" providerId="ADAL" clId="{EDCE6299-B909-6840-AE8F-8D55B29E9D82}" dt="2021-09-07T06:24:20.001" v="571" actId="478"/>
          <ac:spMkLst>
            <pc:docMk/>
            <pc:sldMk cId="4043908164" sldId="4105"/>
            <ac:spMk id="26" creationId="{7DED3BF5-96C0-154B-A7F8-D04558B3BAAD}"/>
          </ac:spMkLst>
        </pc:spChg>
        <pc:spChg chg="add del mod">
          <ac:chgData name="Grace Lee" userId="fd145552-a10d-4a31-a438-f8736fd84277" providerId="ADAL" clId="{EDCE6299-B909-6840-AE8F-8D55B29E9D82}" dt="2021-09-07T06:24:20.001" v="571" actId="478"/>
          <ac:spMkLst>
            <pc:docMk/>
            <pc:sldMk cId="4043908164" sldId="4105"/>
            <ac:spMk id="27" creationId="{4E2F3AB6-0E18-1C40-A011-2AA00BB21098}"/>
          </ac:spMkLst>
        </pc:spChg>
        <pc:spChg chg="add del mod">
          <ac:chgData name="Grace Lee" userId="fd145552-a10d-4a31-a438-f8736fd84277" providerId="ADAL" clId="{EDCE6299-B909-6840-AE8F-8D55B29E9D82}" dt="2021-09-07T06:24:20.001" v="571" actId="478"/>
          <ac:spMkLst>
            <pc:docMk/>
            <pc:sldMk cId="4043908164" sldId="4105"/>
            <ac:spMk id="28" creationId="{7542DBF0-5011-984E-8B30-E85BA8590774}"/>
          </ac:spMkLst>
        </pc:spChg>
        <pc:spChg chg="mod">
          <ac:chgData name="Grace Lee" userId="fd145552-a10d-4a31-a438-f8736fd84277" providerId="ADAL" clId="{EDCE6299-B909-6840-AE8F-8D55B29E9D82}" dt="2021-09-07T06:24:26.632" v="573"/>
          <ac:spMkLst>
            <pc:docMk/>
            <pc:sldMk cId="4043908164" sldId="4105"/>
            <ac:spMk id="30" creationId="{34EE5689-5A45-3843-BB6A-791F41F7CCA5}"/>
          </ac:spMkLst>
        </pc:spChg>
        <pc:spChg chg="mod">
          <ac:chgData name="Grace Lee" userId="fd145552-a10d-4a31-a438-f8736fd84277" providerId="ADAL" clId="{EDCE6299-B909-6840-AE8F-8D55B29E9D82}" dt="2021-09-07T06:24:26.632" v="573"/>
          <ac:spMkLst>
            <pc:docMk/>
            <pc:sldMk cId="4043908164" sldId="4105"/>
            <ac:spMk id="31" creationId="{885F8B59-2673-354A-AA75-F63381784F26}"/>
          </ac:spMkLst>
        </pc:spChg>
        <pc:spChg chg="mod">
          <ac:chgData name="Grace Lee" userId="fd145552-a10d-4a31-a438-f8736fd84277" providerId="ADAL" clId="{EDCE6299-B909-6840-AE8F-8D55B29E9D82}" dt="2021-09-07T06:24:26.632" v="573"/>
          <ac:spMkLst>
            <pc:docMk/>
            <pc:sldMk cId="4043908164" sldId="4105"/>
            <ac:spMk id="32" creationId="{EC4B94C4-CC85-9045-B7AF-6089ED4DA110}"/>
          </ac:spMkLst>
        </pc:spChg>
        <pc:spChg chg="mod">
          <ac:chgData name="Grace Lee" userId="fd145552-a10d-4a31-a438-f8736fd84277" providerId="ADAL" clId="{EDCE6299-B909-6840-AE8F-8D55B29E9D82}" dt="2021-09-07T06:24:26.632" v="573"/>
          <ac:spMkLst>
            <pc:docMk/>
            <pc:sldMk cId="4043908164" sldId="4105"/>
            <ac:spMk id="33" creationId="{04D896FC-4971-934B-BB22-9412CCEA84D0}"/>
          </ac:spMkLst>
        </pc:spChg>
        <pc:spChg chg="mod">
          <ac:chgData name="Grace Lee" userId="fd145552-a10d-4a31-a438-f8736fd84277" providerId="ADAL" clId="{EDCE6299-B909-6840-AE8F-8D55B29E9D82}" dt="2021-09-07T06:24:26.632" v="573"/>
          <ac:spMkLst>
            <pc:docMk/>
            <pc:sldMk cId="4043908164" sldId="4105"/>
            <ac:spMk id="34" creationId="{B049A919-F234-BD48-9796-A97E143B4FAC}"/>
          </ac:spMkLst>
        </pc:spChg>
        <pc:spChg chg="mod">
          <ac:chgData name="Grace Lee" userId="fd145552-a10d-4a31-a438-f8736fd84277" providerId="ADAL" clId="{EDCE6299-B909-6840-AE8F-8D55B29E9D82}" dt="2021-09-07T06:24:26.632" v="573"/>
          <ac:spMkLst>
            <pc:docMk/>
            <pc:sldMk cId="4043908164" sldId="4105"/>
            <ac:spMk id="35" creationId="{F8810737-F9E4-044F-A0D9-89CE98AE9A10}"/>
          </ac:spMkLst>
        </pc:spChg>
        <pc:spChg chg="mod">
          <ac:chgData name="Grace Lee" userId="fd145552-a10d-4a31-a438-f8736fd84277" providerId="ADAL" clId="{EDCE6299-B909-6840-AE8F-8D55B29E9D82}" dt="2021-09-07T06:24:26.632" v="573"/>
          <ac:spMkLst>
            <pc:docMk/>
            <pc:sldMk cId="4043908164" sldId="4105"/>
            <ac:spMk id="36" creationId="{0E8A3E5C-A3AD-AA4F-934F-F3D0767AEDAF}"/>
          </ac:spMkLst>
        </pc:spChg>
        <pc:spChg chg="mod">
          <ac:chgData name="Grace Lee" userId="fd145552-a10d-4a31-a438-f8736fd84277" providerId="ADAL" clId="{EDCE6299-B909-6840-AE8F-8D55B29E9D82}" dt="2021-09-07T06:24:26.632" v="573"/>
          <ac:spMkLst>
            <pc:docMk/>
            <pc:sldMk cId="4043908164" sldId="4105"/>
            <ac:spMk id="37" creationId="{E7A24C61-6D20-C947-BCF1-517C84059777}"/>
          </ac:spMkLst>
        </pc:spChg>
        <pc:spChg chg="mod">
          <ac:chgData name="Grace Lee" userId="fd145552-a10d-4a31-a438-f8736fd84277" providerId="ADAL" clId="{EDCE6299-B909-6840-AE8F-8D55B29E9D82}" dt="2021-09-07T06:24:26.632" v="573"/>
          <ac:spMkLst>
            <pc:docMk/>
            <pc:sldMk cId="4043908164" sldId="4105"/>
            <ac:spMk id="39" creationId="{C047FF3A-494D-2640-A105-65FE7010134B}"/>
          </ac:spMkLst>
        </pc:spChg>
        <pc:spChg chg="mod">
          <ac:chgData name="Grace Lee" userId="fd145552-a10d-4a31-a438-f8736fd84277" providerId="ADAL" clId="{EDCE6299-B909-6840-AE8F-8D55B29E9D82}" dt="2021-09-07T06:24:26.632" v="573"/>
          <ac:spMkLst>
            <pc:docMk/>
            <pc:sldMk cId="4043908164" sldId="4105"/>
            <ac:spMk id="40" creationId="{6C66D473-7179-9540-9CF8-B696455DCB40}"/>
          </ac:spMkLst>
        </pc:spChg>
        <pc:spChg chg="mod">
          <ac:chgData name="Grace Lee" userId="fd145552-a10d-4a31-a438-f8736fd84277" providerId="ADAL" clId="{EDCE6299-B909-6840-AE8F-8D55B29E9D82}" dt="2021-09-07T06:24:26.632" v="573"/>
          <ac:spMkLst>
            <pc:docMk/>
            <pc:sldMk cId="4043908164" sldId="4105"/>
            <ac:spMk id="41" creationId="{70E0177D-927D-7A41-859F-104289CA17D4}"/>
          </ac:spMkLst>
        </pc:spChg>
        <pc:spChg chg="mod">
          <ac:chgData name="Grace Lee" userId="fd145552-a10d-4a31-a438-f8736fd84277" providerId="ADAL" clId="{EDCE6299-B909-6840-AE8F-8D55B29E9D82}" dt="2021-09-07T06:24:26.632" v="573"/>
          <ac:spMkLst>
            <pc:docMk/>
            <pc:sldMk cId="4043908164" sldId="4105"/>
            <ac:spMk id="42" creationId="{16B93BE3-14EE-7A44-9CFE-19F82196D64F}"/>
          </ac:spMkLst>
        </pc:spChg>
        <pc:spChg chg="mod">
          <ac:chgData name="Grace Lee" userId="fd145552-a10d-4a31-a438-f8736fd84277" providerId="ADAL" clId="{EDCE6299-B909-6840-AE8F-8D55B29E9D82}" dt="2021-09-07T06:24:26.632" v="573"/>
          <ac:spMkLst>
            <pc:docMk/>
            <pc:sldMk cId="4043908164" sldId="4105"/>
            <ac:spMk id="43" creationId="{2792D7F3-C567-A443-B426-880E2A42F961}"/>
          </ac:spMkLst>
        </pc:spChg>
        <pc:spChg chg="add del mod">
          <ac:chgData name="Grace Lee" userId="fd145552-a10d-4a31-a438-f8736fd84277" providerId="ADAL" clId="{EDCE6299-B909-6840-AE8F-8D55B29E9D82}" dt="2021-09-07T06:24:29.618" v="574"/>
          <ac:spMkLst>
            <pc:docMk/>
            <pc:sldMk cId="4043908164" sldId="4105"/>
            <ac:spMk id="44" creationId="{689318D9-6877-8C42-98F5-B7B59A4EE82E}"/>
          </ac:spMkLst>
        </pc:spChg>
        <pc:spChg chg="add del mod">
          <ac:chgData name="Grace Lee" userId="fd145552-a10d-4a31-a438-f8736fd84277" providerId="ADAL" clId="{EDCE6299-B909-6840-AE8F-8D55B29E9D82}" dt="2021-09-07T06:24:29.618" v="574"/>
          <ac:spMkLst>
            <pc:docMk/>
            <pc:sldMk cId="4043908164" sldId="4105"/>
            <ac:spMk id="45" creationId="{FBC00C6E-5F03-C44E-A454-4BC4F9B76A5C}"/>
          </ac:spMkLst>
        </pc:spChg>
        <pc:spChg chg="add del mod">
          <ac:chgData name="Grace Lee" userId="fd145552-a10d-4a31-a438-f8736fd84277" providerId="ADAL" clId="{EDCE6299-B909-6840-AE8F-8D55B29E9D82}" dt="2021-09-07T06:24:29.618" v="574"/>
          <ac:spMkLst>
            <pc:docMk/>
            <pc:sldMk cId="4043908164" sldId="4105"/>
            <ac:spMk id="46" creationId="{8FFA1DAC-D3AC-0746-82B4-F06887C30247}"/>
          </ac:spMkLst>
        </pc:spChg>
        <pc:spChg chg="add del mod">
          <ac:chgData name="Grace Lee" userId="fd145552-a10d-4a31-a438-f8736fd84277" providerId="ADAL" clId="{EDCE6299-B909-6840-AE8F-8D55B29E9D82}" dt="2021-09-07T06:24:29.618" v="574"/>
          <ac:spMkLst>
            <pc:docMk/>
            <pc:sldMk cId="4043908164" sldId="4105"/>
            <ac:spMk id="47" creationId="{95D62C85-2A80-1845-9C53-FC391E98DB3A}"/>
          </ac:spMkLst>
        </pc:spChg>
        <pc:spChg chg="add del mod">
          <ac:chgData name="Grace Lee" userId="fd145552-a10d-4a31-a438-f8736fd84277" providerId="ADAL" clId="{EDCE6299-B909-6840-AE8F-8D55B29E9D82}" dt="2021-09-07T06:24:29.618" v="574"/>
          <ac:spMkLst>
            <pc:docMk/>
            <pc:sldMk cId="4043908164" sldId="4105"/>
            <ac:spMk id="48" creationId="{38731F5F-9557-0643-89BF-5628F2D743CC}"/>
          </ac:spMkLst>
        </pc:spChg>
        <pc:spChg chg="add del mod">
          <ac:chgData name="Grace Lee" userId="fd145552-a10d-4a31-a438-f8736fd84277" providerId="ADAL" clId="{EDCE6299-B909-6840-AE8F-8D55B29E9D82}" dt="2021-09-07T06:24:29.618" v="574"/>
          <ac:spMkLst>
            <pc:docMk/>
            <pc:sldMk cId="4043908164" sldId="4105"/>
            <ac:spMk id="49" creationId="{7AC482A4-D710-F541-9FBA-91369DE6E858}"/>
          </ac:spMkLst>
        </pc:spChg>
        <pc:spChg chg="add del mod">
          <ac:chgData name="Grace Lee" userId="fd145552-a10d-4a31-a438-f8736fd84277" providerId="ADAL" clId="{EDCE6299-B909-6840-AE8F-8D55B29E9D82}" dt="2021-09-07T06:24:29.618" v="574"/>
          <ac:spMkLst>
            <pc:docMk/>
            <pc:sldMk cId="4043908164" sldId="4105"/>
            <ac:spMk id="50" creationId="{C94FD4CA-3091-A24E-94EF-F2E528E4BFE4}"/>
          </ac:spMkLst>
        </pc:spChg>
        <pc:spChg chg="add del mod">
          <ac:chgData name="Grace Lee" userId="fd145552-a10d-4a31-a438-f8736fd84277" providerId="ADAL" clId="{EDCE6299-B909-6840-AE8F-8D55B29E9D82}" dt="2021-09-07T06:24:29.618" v="574"/>
          <ac:spMkLst>
            <pc:docMk/>
            <pc:sldMk cId="4043908164" sldId="4105"/>
            <ac:spMk id="51" creationId="{A9FE4CE2-8F69-F44E-8557-3945067A11F3}"/>
          </ac:spMkLst>
        </pc:spChg>
        <pc:spChg chg="mod">
          <ac:chgData name="Grace Lee" userId="fd145552-a10d-4a31-a438-f8736fd84277" providerId="ADAL" clId="{EDCE6299-B909-6840-AE8F-8D55B29E9D82}" dt="2021-09-07T06:31:41.871" v="1275" actId="1076"/>
          <ac:spMkLst>
            <pc:docMk/>
            <pc:sldMk cId="4043908164" sldId="4105"/>
            <ac:spMk id="53" creationId="{10F7C89A-6778-BD46-A6F1-89039C10E5FE}"/>
          </ac:spMkLst>
        </pc:spChg>
        <pc:spChg chg="mod">
          <ac:chgData name="Grace Lee" userId="fd145552-a10d-4a31-a438-f8736fd84277" providerId="ADAL" clId="{EDCE6299-B909-6840-AE8F-8D55B29E9D82}" dt="2021-09-07T06:31:55.405" v="1276" actId="1076"/>
          <ac:spMkLst>
            <pc:docMk/>
            <pc:sldMk cId="4043908164" sldId="4105"/>
            <ac:spMk id="54" creationId="{A03734DB-8179-A84C-8891-079083BEFFE9}"/>
          </ac:spMkLst>
        </pc:spChg>
        <pc:spChg chg="mod">
          <ac:chgData name="Grace Lee" userId="fd145552-a10d-4a31-a438-f8736fd84277" providerId="ADAL" clId="{EDCE6299-B909-6840-AE8F-8D55B29E9D82}" dt="2021-09-07T06:31:30.925" v="1274" actId="1076"/>
          <ac:spMkLst>
            <pc:docMk/>
            <pc:sldMk cId="4043908164" sldId="4105"/>
            <ac:spMk id="55" creationId="{792A54F5-D676-7B44-8129-7C3AFA8CFD55}"/>
          </ac:spMkLst>
        </pc:spChg>
        <pc:spChg chg="del mod">
          <ac:chgData name="Grace Lee" userId="fd145552-a10d-4a31-a438-f8736fd84277" providerId="ADAL" clId="{EDCE6299-B909-6840-AE8F-8D55B29E9D82}" dt="2021-09-07T06:31:20.156" v="1272" actId="478"/>
          <ac:spMkLst>
            <pc:docMk/>
            <pc:sldMk cId="4043908164" sldId="4105"/>
            <ac:spMk id="56" creationId="{5ADBC99C-DEB1-AD44-B9F4-6A040DF3D043}"/>
          </ac:spMkLst>
        </pc:spChg>
        <pc:spChg chg="mod">
          <ac:chgData name="Grace Lee" userId="fd145552-a10d-4a31-a438-f8736fd84277" providerId="ADAL" clId="{EDCE6299-B909-6840-AE8F-8D55B29E9D82}" dt="2021-09-07T06:31:41.871" v="1275" actId="1076"/>
          <ac:spMkLst>
            <pc:docMk/>
            <pc:sldMk cId="4043908164" sldId="4105"/>
            <ac:spMk id="57" creationId="{F03B7DCD-8868-9D4D-9ADE-E6796E91FD78}"/>
          </ac:spMkLst>
        </pc:spChg>
        <pc:spChg chg="mod">
          <ac:chgData name="Grace Lee" userId="fd145552-a10d-4a31-a438-f8736fd84277" providerId="ADAL" clId="{EDCE6299-B909-6840-AE8F-8D55B29E9D82}" dt="2021-09-07T06:31:55.405" v="1276" actId="1076"/>
          <ac:spMkLst>
            <pc:docMk/>
            <pc:sldMk cId="4043908164" sldId="4105"/>
            <ac:spMk id="58" creationId="{DB1AF0C3-4614-E743-970F-76904E67EA91}"/>
          </ac:spMkLst>
        </pc:spChg>
        <pc:spChg chg="del mod">
          <ac:chgData name="Grace Lee" userId="fd145552-a10d-4a31-a438-f8736fd84277" providerId="ADAL" clId="{EDCE6299-B909-6840-AE8F-8D55B29E9D82}" dt="2021-09-07T06:30:39.390" v="1264" actId="478"/>
          <ac:spMkLst>
            <pc:docMk/>
            <pc:sldMk cId="4043908164" sldId="4105"/>
            <ac:spMk id="59" creationId="{91F54F7C-97F0-814C-BEAE-65179AD93C7F}"/>
          </ac:spMkLst>
        </pc:spChg>
        <pc:spChg chg="del mod">
          <ac:chgData name="Grace Lee" userId="fd145552-a10d-4a31-a438-f8736fd84277" providerId="ADAL" clId="{EDCE6299-B909-6840-AE8F-8D55B29E9D82}" dt="2021-09-07T06:30:42.888" v="1265" actId="478"/>
          <ac:spMkLst>
            <pc:docMk/>
            <pc:sldMk cId="4043908164" sldId="4105"/>
            <ac:spMk id="60" creationId="{41363B3A-1C73-AD41-9FBC-84CAF6CE6B12}"/>
          </ac:spMkLst>
        </pc:spChg>
        <pc:spChg chg="mod">
          <ac:chgData name="Grace Lee" userId="fd145552-a10d-4a31-a438-f8736fd84277" providerId="ADAL" clId="{EDCE6299-B909-6840-AE8F-8D55B29E9D82}" dt="2021-09-07T06:24:49.893" v="581" actId="2711"/>
          <ac:spMkLst>
            <pc:docMk/>
            <pc:sldMk cId="4043908164" sldId="4105"/>
            <ac:spMk id="62" creationId="{C15FF70F-4B2F-8241-8116-539F914BA3F4}"/>
          </ac:spMkLst>
        </pc:spChg>
        <pc:spChg chg="mod">
          <ac:chgData name="Grace Lee" userId="fd145552-a10d-4a31-a438-f8736fd84277" providerId="ADAL" clId="{EDCE6299-B909-6840-AE8F-8D55B29E9D82}" dt="2021-09-07T06:24:49.893" v="581" actId="2711"/>
          <ac:spMkLst>
            <pc:docMk/>
            <pc:sldMk cId="4043908164" sldId="4105"/>
            <ac:spMk id="63" creationId="{2E33361A-7786-3C44-883F-D04A7A2752C4}"/>
          </ac:spMkLst>
        </pc:spChg>
        <pc:spChg chg="mod">
          <ac:chgData name="Grace Lee" userId="fd145552-a10d-4a31-a438-f8736fd84277" providerId="ADAL" clId="{EDCE6299-B909-6840-AE8F-8D55B29E9D82}" dt="2021-09-07T06:24:49.893" v="581" actId="2711"/>
          <ac:spMkLst>
            <pc:docMk/>
            <pc:sldMk cId="4043908164" sldId="4105"/>
            <ac:spMk id="64" creationId="{9FD8CD2F-B0A6-A946-B148-760694BD02F5}"/>
          </ac:spMkLst>
        </pc:spChg>
        <pc:spChg chg="mod">
          <ac:chgData name="Grace Lee" userId="fd145552-a10d-4a31-a438-f8736fd84277" providerId="ADAL" clId="{EDCE6299-B909-6840-AE8F-8D55B29E9D82}" dt="2021-09-07T06:24:49.893" v="581" actId="2711"/>
          <ac:spMkLst>
            <pc:docMk/>
            <pc:sldMk cId="4043908164" sldId="4105"/>
            <ac:spMk id="65" creationId="{2E894C03-254A-5840-BD79-E0CEB64AC326}"/>
          </ac:spMkLst>
        </pc:spChg>
        <pc:spChg chg="mod">
          <ac:chgData name="Grace Lee" userId="fd145552-a10d-4a31-a438-f8736fd84277" providerId="ADAL" clId="{EDCE6299-B909-6840-AE8F-8D55B29E9D82}" dt="2021-09-07T06:24:49.893" v="581" actId="2711"/>
          <ac:spMkLst>
            <pc:docMk/>
            <pc:sldMk cId="4043908164" sldId="4105"/>
            <ac:spMk id="66" creationId="{30DECAB5-61A7-F84D-8D07-90C13A0B47D7}"/>
          </ac:spMkLst>
        </pc:spChg>
        <pc:spChg chg="add mod">
          <ac:chgData name="Grace Lee" userId="fd145552-a10d-4a31-a438-f8736fd84277" providerId="ADAL" clId="{EDCE6299-B909-6840-AE8F-8D55B29E9D82}" dt="2021-09-15T09:06:07.416" v="5215" actId="1076"/>
          <ac:spMkLst>
            <pc:docMk/>
            <pc:sldMk cId="4043908164" sldId="4105"/>
            <ac:spMk id="67" creationId="{0F7CE110-6D83-8E47-A48C-994E1B2B49F2}"/>
          </ac:spMkLst>
        </pc:spChg>
        <pc:spChg chg="add del mod">
          <ac:chgData name="Grace Lee" userId="fd145552-a10d-4a31-a438-f8736fd84277" providerId="ADAL" clId="{EDCE6299-B909-6840-AE8F-8D55B29E9D82}" dt="2021-09-07T06:26:47.987" v="943" actId="478"/>
          <ac:spMkLst>
            <pc:docMk/>
            <pc:sldMk cId="4043908164" sldId="4105"/>
            <ac:spMk id="68" creationId="{040CBC93-3468-1E4F-BDD0-9C9484C3DF11}"/>
          </ac:spMkLst>
        </pc:spChg>
        <pc:spChg chg="add mod">
          <ac:chgData name="Grace Lee" userId="fd145552-a10d-4a31-a438-f8736fd84277" providerId="ADAL" clId="{EDCE6299-B909-6840-AE8F-8D55B29E9D82}" dt="2021-09-15T08:35:54.237" v="4425" actId="1076"/>
          <ac:spMkLst>
            <pc:docMk/>
            <pc:sldMk cId="4043908164" sldId="4105"/>
            <ac:spMk id="69" creationId="{22298092-8327-3444-886B-3937414AE4BE}"/>
          </ac:spMkLst>
        </pc:spChg>
        <pc:spChg chg="add del mod">
          <ac:chgData name="Grace Lee" userId="fd145552-a10d-4a31-a438-f8736fd84277" providerId="ADAL" clId="{EDCE6299-B909-6840-AE8F-8D55B29E9D82}" dt="2021-09-07T06:27:04.871" v="947" actId="478"/>
          <ac:spMkLst>
            <pc:docMk/>
            <pc:sldMk cId="4043908164" sldId="4105"/>
            <ac:spMk id="70" creationId="{17F83613-1CEF-AD41-B6E5-5D52E68686DD}"/>
          </ac:spMkLst>
        </pc:spChg>
        <pc:spChg chg="add del mod">
          <ac:chgData name="Grace Lee" userId="fd145552-a10d-4a31-a438-f8736fd84277" providerId="ADAL" clId="{EDCE6299-B909-6840-AE8F-8D55B29E9D82}" dt="2021-09-07T06:29:12.230" v="1205" actId="478"/>
          <ac:spMkLst>
            <pc:docMk/>
            <pc:sldMk cId="4043908164" sldId="4105"/>
            <ac:spMk id="71" creationId="{391A956B-42C3-AB47-B469-D21ACCAAEC7D}"/>
          </ac:spMkLst>
        </pc:spChg>
        <pc:spChg chg="add del mod">
          <ac:chgData name="Grace Lee" userId="fd145552-a10d-4a31-a438-f8736fd84277" providerId="ADAL" clId="{EDCE6299-B909-6840-AE8F-8D55B29E9D82}" dt="2021-09-07T06:28:45.550" v="1140" actId="478"/>
          <ac:spMkLst>
            <pc:docMk/>
            <pc:sldMk cId="4043908164" sldId="4105"/>
            <ac:spMk id="72" creationId="{7AF539C5-1591-B54F-9058-1F66B5ED1EC5}"/>
          </ac:spMkLst>
        </pc:spChg>
        <pc:spChg chg="add del mod">
          <ac:chgData name="Grace Lee" userId="fd145552-a10d-4a31-a438-f8736fd84277" providerId="ADAL" clId="{EDCE6299-B909-6840-AE8F-8D55B29E9D82}" dt="2021-09-07T06:29:43.401" v="1243" actId="478"/>
          <ac:spMkLst>
            <pc:docMk/>
            <pc:sldMk cId="4043908164" sldId="4105"/>
            <ac:spMk id="73" creationId="{86A239A7-EF68-854A-8CC0-82A859BFDC19}"/>
          </ac:spMkLst>
        </pc:spChg>
        <pc:spChg chg="add del mod">
          <ac:chgData name="Grace Lee" userId="fd145552-a10d-4a31-a438-f8736fd84277" providerId="ADAL" clId="{EDCE6299-B909-6840-AE8F-8D55B29E9D82}" dt="2021-09-07T06:28:47.117" v="1141" actId="478"/>
          <ac:spMkLst>
            <pc:docMk/>
            <pc:sldMk cId="4043908164" sldId="4105"/>
            <ac:spMk id="74" creationId="{5FD95404-B177-7E42-B886-C73BA6597C1B}"/>
          </ac:spMkLst>
        </pc:spChg>
        <pc:spChg chg="add del mod">
          <ac:chgData name="Grace Lee" userId="fd145552-a10d-4a31-a438-f8736fd84277" providerId="ADAL" clId="{EDCE6299-B909-6840-AE8F-8D55B29E9D82}" dt="2021-09-07T06:24:47.041" v="580" actId="478"/>
          <ac:spMkLst>
            <pc:docMk/>
            <pc:sldMk cId="4043908164" sldId="4105"/>
            <ac:spMk id="75" creationId="{99E33171-E2D5-9C40-8750-D9243E1259E1}"/>
          </ac:spMkLst>
        </pc:spChg>
        <pc:spChg chg="add mod">
          <ac:chgData name="Grace Lee" userId="fd145552-a10d-4a31-a438-f8736fd84277" providerId="ADAL" clId="{EDCE6299-B909-6840-AE8F-8D55B29E9D82}" dt="2021-09-15T09:10:26.545" v="5420" actId="20577"/>
          <ac:spMkLst>
            <pc:docMk/>
            <pc:sldMk cId="4043908164" sldId="4105"/>
            <ac:spMk id="76" creationId="{F9D7A803-10EA-064F-BF6C-06B6B89F9189}"/>
          </ac:spMkLst>
        </pc:spChg>
        <pc:spChg chg="add del mod">
          <ac:chgData name="Grace Lee" userId="fd145552-a10d-4a31-a438-f8736fd84277" providerId="ADAL" clId="{EDCE6299-B909-6840-AE8F-8D55B29E9D82}" dt="2021-09-07T06:30:26.234" v="1262" actId="478"/>
          <ac:spMkLst>
            <pc:docMk/>
            <pc:sldMk cId="4043908164" sldId="4105"/>
            <ac:spMk id="77" creationId="{BD9FBB71-0AE3-4245-8786-6A0E04A91D7E}"/>
          </ac:spMkLst>
        </pc:spChg>
        <pc:spChg chg="add del mod">
          <ac:chgData name="Grace Lee" userId="fd145552-a10d-4a31-a438-f8736fd84277" providerId="ADAL" clId="{EDCE6299-B909-6840-AE8F-8D55B29E9D82}" dt="2021-09-07T06:33:52.680" v="1280"/>
          <ac:spMkLst>
            <pc:docMk/>
            <pc:sldMk cId="4043908164" sldId="4105"/>
            <ac:spMk id="78" creationId="{0499DFBD-4C63-FB4E-B0FD-5DA4EA46E9CB}"/>
          </ac:spMkLst>
        </pc:spChg>
        <pc:spChg chg="add mod">
          <ac:chgData name="Grace Lee" userId="fd145552-a10d-4a31-a438-f8736fd84277" providerId="ADAL" clId="{EDCE6299-B909-6840-AE8F-8D55B29E9D82}" dt="2021-09-07T06:34:47.673" v="1293" actId="1076"/>
          <ac:spMkLst>
            <pc:docMk/>
            <pc:sldMk cId="4043908164" sldId="4105"/>
            <ac:spMk id="79" creationId="{A5C271A3-F497-5F49-AF11-C4AF673F45EA}"/>
          </ac:spMkLst>
        </pc:spChg>
        <pc:spChg chg="add del mod">
          <ac:chgData name="Grace Lee" userId="fd145552-a10d-4a31-a438-f8736fd84277" providerId="ADAL" clId="{EDCE6299-B909-6840-AE8F-8D55B29E9D82}" dt="2021-09-07T06:35:17.767" v="1297" actId="478"/>
          <ac:spMkLst>
            <pc:docMk/>
            <pc:sldMk cId="4043908164" sldId="4105"/>
            <ac:spMk id="80" creationId="{98BAAE2B-CC54-6748-BEC5-C6524DD2D914}"/>
          </ac:spMkLst>
        </pc:spChg>
        <pc:grpChg chg="add del mod">
          <ac:chgData name="Grace Lee" userId="fd145552-a10d-4a31-a438-f8736fd84277" providerId="ADAL" clId="{EDCE6299-B909-6840-AE8F-8D55B29E9D82}" dt="2021-09-07T06:24:20.001" v="571" actId="478"/>
          <ac:grpSpMkLst>
            <pc:docMk/>
            <pc:sldMk cId="4043908164" sldId="4105"/>
            <ac:grpSpMk id="6" creationId="{34FFD4FE-4A3D-8847-B27A-55395E1FAB95}"/>
          </ac:grpSpMkLst>
        </pc:grpChg>
        <pc:grpChg chg="add del mod">
          <ac:chgData name="Grace Lee" userId="fd145552-a10d-4a31-a438-f8736fd84277" providerId="ADAL" clId="{EDCE6299-B909-6840-AE8F-8D55B29E9D82}" dt="2021-09-07T06:24:20.001" v="571" actId="478"/>
          <ac:grpSpMkLst>
            <pc:docMk/>
            <pc:sldMk cId="4043908164" sldId="4105"/>
            <ac:grpSpMk id="15" creationId="{D4EA8344-8FDA-9444-9CD7-7E978BFCF270}"/>
          </ac:grpSpMkLst>
        </pc:grpChg>
        <pc:grpChg chg="add del mod">
          <ac:chgData name="Grace Lee" userId="fd145552-a10d-4a31-a438-f8736fd84277" providerId="ADAL" clId="{EDCE6299-B909-6840-AE8F-8D55B29E9D82}" dt="2021-09-07T06:24:29.618" v="574"/>
          <ac:grpSpMkLst>
            <pc:docMk/>
            <pc:sldMk cId="4043908164" sldId="4105"/>
            <ac:grpSpMk id="29" creationId="{03F37505-30D9-BC44-AED0-0AB01BD45ADF}"/>
          </ac:grpSpMkLst>
        </pc:grpChg>
        <pc:grpChg chg="add del mod">
          <ac:chgData name="Grace Lee" userId="fd145552-a10d-4a31-a438-f8736fd84277" providerId="ADAL" clId="{EDCE6299-B909-6840-AE8F-8D55B29E9D82}" dt="2021-09-07T06:24:29.618" v="574"/>
          <ac:grpSpMkLst>
            <pc:docMk/>
            <pc:sldMk cId="4043908164" sldId="4105"/>
            <ac:grpSpMk id="38" creationId="{03BDFB3C-DBA1-9448-8B1A-C36D77DDE140}"/>
          </ac:grpSpMkLst>
        </pc:grpChg>
        <pc:grpChg chg="add mod">
          <ac:chgData name="Grace Lee" userId="fd145552-a10d-4a31-a438-f8736fd84277" providerId="ADAL" clId="{EDCE6299-B909-6840-AE8F-8D55B29E9D82}" dt="2021-09-07T06:34:35.822" v="1290" actId="1076"/>
          <ac:grpSpMkLst>
            <pc:docMk/>
            <pc:sldMk cId="4043908164" sldId="4105"/>
            <ac:grpSpMk id="52" creationId="{AF4181E4-0FD4-684C-9095-D24E8ACF3CA9}"/>
          </ac:grpSpMkLst>
        </pc:grpChg>
        <pc:grpChg chg="add mod">
          <ac:chgData name="Grace Lee" userId="fd145552-a10d-4a31-a438-f8736fd84277" providerId="ADAL" clId="{EDCE6299-B909-6840-AE8F-8D55B29E9D82}" dt="2021-09-07T06:24:39.677" v="578"/>
          <ac:grpSpMkLst>
            <pc:docMk/>
            <pc:sldMk cId="4043908164" sldId="4105"/>
            <ac:grpSpMk id="61" creationId="{3F7A0C77-7479-0247-AE54-DF6E9F20CDCE}"/>
          </ac:grpSpMkLst>
        </pc:grpChg>
      </pc:sldChg>
      <pc:sldChg chg="modSp mod">
        <pc:chgData name="Grace Lee" userId="fd145552-a10d-4a31-a438-f8736fd84277" providerId="ADAL" clId="{EDCE6299-B909-6840-AE8F-8D55B29E9D82}" dt="2021-09-07T06:47:50.637" v="1568" actId="20577"/>
        <pc:sldMkLst>
          <pc:docMk/>
          <pc:sldMk cId="2210991997" sldId="4107"/>
        </pc:sldMkLst>
        <pc:spChg chg="mod">
          <ac:chgData name="Grace Lee" userId="fd145552-a10d-4a31-a438-f8736fd84277" providerId="ADAL" clId="{EDCE6299-B909-6840-AE8F-8D55B29E9D82}" dt="2021-09-07T06:47:50.637" v="1568" actId="20577"/>
          <ac:spMkLst>
            <pc:docMk/>
            <pc:sldMk cId="2210991997" sldId="4107"/>
            <ac:spMk id="3" creationId="{1C207EF0-D5F8-4C7D-9363-8246CDD5503A}"/>
          </ac:spMkLst>
        </pc:spChg>
      </pc:sldChg>
      <pc:sldChg chg="modSp add mod">
        <pc:chgData name="Grace Lee" userId="fd145552-a10d-4a31-a438-f8736fd84277" providerId="ADAL" clId="{EDCE6299-B909-6840-AE8F-8D55B29E9D82}" dt="2021-09-15T07:23:48.724" v="3441" actId="20577"/>
        <pc:sldMkLst>
          <pc:docMk/>
          <pc:sldMk cId="1691795552" sldId="4108"/>
        </pc:sldMkLst>
        <pc:spChg chg="mod">
          <ac:chgData name="Grace Lee" userId="fd145552-a10d-4a31-a438-f8736fd84277" providerId="ADAL" clId="{EDCE6299-B909-6840-AE8F-8D55B29E9D82}" dt="2021-09-07T06:19:23.829" v="485" actId="20577"/>
          <ac:spMkLst>
            <pc:docMk/>
            <pc:sldMk cId="1691795552" sldId="4108"/>
            <ac:spMk id="3" creationId="{B354936E-C463-4D90-963C-698FEFB13AEA}"/>
          </ac:spMkLst>
        </pc:spChg>
        <pc:graphicFrameChg chg="mod modGraphic">
          <ac:chgData name="Grace Lee" userId="fd145552-a10d-4a31-a438-f8736fd84277" providerId="ADAL" clId="{EDCE6299-B909-6840-AE8F-8D55B29E9D82}" dt="2021-09-15T07:23:48.724" v="3441" actId="20577"/>
          <ac:graphicFrameMkLst>
            <pc:docMk/>
            <pc:sldMk cId="1691795552" sldId="4108"/>
            <ac:graphicFrameMk id="4" creationId="{34A6E8FD-61D1-453E-B833-42E2C191607B}"/>
          </ac:graphicFrameMkLst>
        </pc:graphicFrameChg>
      </pc:sldChg>
      <pc:sldChg chg="modSp add mod">
        <pc:chgData name="Grace Lee" userId="fd145552-a10d-4a31-a438-f8736fd84277" providerId="ADAL" clId="{EDCE6299-B909-6840-AE8F-8D55B29E9D82}" dt="2021-09-07T06:48:01.720" v="1617" actId="20577"/>
        <pc:sldMkLst>
          <pc:docMk/>
          <pc:sldMk cId="1882970938" sldId="4109"/>
        </pc:sldMkLst>
        <pc:spChg chg="mod">
          <ac:chgData name="Grace Lee" userId="fd145552-a10d-4a31-a438-f8736fd84277" providerId="ADAL" clId="{EDCE6299-B909-6840-AE8F-8D55B29E9D82}" dt="2021-09-07T06:35:29.592" v="1328" actId="20577"/>
          <ac:spMkLst>
            <pc:docMk/>
            <pc:sldMk cId="1882970938" sldId="4109"/>
            <ac:spMk id="3" creationId="{B354936E-C463-4D90-963C-698FEFB13AEA}"/>
          </ac:spMkLst>
        </pc:spChg>
        <pc:spChg chg="mod">
          <ac:chgData name="Grace Lee" userId="fd145552-a10d-4a31-a438-f8736fd84277" providerId="ADAL" clId="{EDCE6299-B909-6840-AE8F-8D55B29E9D82}" dt="2021-09-07T06:48:01.720" v="1617" actId="20577"/>
          <ac:spMkLst>
            <pc:docMk/>
            <pc:sldMk cId="1882970938" sldId="4109"/>
            <ac:spMk id="5" creationId="{C333899F-F847-4571-9683-DCBDF5945307}"/>
          </ac:spMkLst>
        </pc:spChg>
      </pc:sldChg>
      <pc:sldChg chg="add del">
        <pc:chgData name="Grace Lee" userId="fd145552-a10d-4a31-a438-f8736fd84277" providerId="ADAL" clId="{EDCE6299-B909-6840-AE8F-8D55B29E9D82}" dt="2021-09-07T06:26:19.054" v="871" actId="2696"/>
        <pc:sldMkLst>
          <pc:docMk/>
          <pc:sldMk cId="106818707" sldId="4110"/>
        </pc:sldMkLst>
      </pc:sldChg>
      <pc:sldChg chg="modSp new del mod">
        <pc:chgData name="Grace Lee" userId="fd145552-a10d-4a31-a438-f8736fd84277" providerId="ADAL" clId="{EDCE6299-B909-6840-AE8F-8D55B29E9D82}" dt="2021-09-07T06:47:44.995" v="1558" actId="2696"/>
        <pc:sldMkLst>
          <pc:docMk/>
          <pc:sldMk cId="2344142150" sldId="4110"/>
        </pc:sldMkLst>
        <pc:spChg chg="mod">
          <ac:chgData name="Grace Lee" userId="fd145552-a10d-4a31-a438-f8736fd84277" providerId="ADAL" clId="{EDCE6299-B909-6840-AE8F-8D55B29E9D82}" dt="2021-09-07T06:47:43.743" v="1557" actId="20577"/>
          <ac:spMkLst>
            <pc:docMk/>
            <pc:sldMk cId="2344142150" sldId="4110"/>
            <ac:spMk id="2" creationId="{81076375-6C22-B44E-818A-8BCACCA6CD11}"/>
          </ac:spMkLst>
        </pc:spChg>
      </pc:sldChg>
      <pc:sldChg chg="del">
        <pc:chgData name="Grace Lee" userId="fd145552-a10d-4a31-a438-f8736fd84277" providerId="ADAL" clId="{EDCE6299-B909-6840-AE8F-8D55B29E9D82}" dt="2021-09-13T23:10:49.225" v="1632" actId="2696"/>
        <pc:sldMkLst>
          <pc:docMk/>
          <pc:sldMk cId="2346699544" sldId="4110"/>
        </pc:sldMkLst>
      </pc:sldChg>
      <pc:sldChg chg="add del">
        <pc:chgData name="Grace Lee" userId="fd145552-a10d-4a31-a438-f8736fd84277" providerId="ADAL" clId="{EDCE6299-B909-6840-AE8F-8D55B29E9D82}" dt="2021-09-07T06:23:56.363" v="565"/>
        <pc:sldMkLst>
          <pc:docMk/>
          <pc:sldMk cId="2458181508" sldId="4111"/>
        </pc:sldMkLst>
      </pc:sldChg>
      <pc:sldChg chg="add del">
        <pc:chgData name="Grace Lee" userId="fd145552-a10d-4a31-a438-f8736fd84277" providerId="ADAL" clId="{EDCE6299-B909-6840-AE8F-8D55B29E9D82}" dt="2021-09-07T06:24:06.769" v="567"/>
        <pc:sldMkLst>
          <pc:docMk/>
          <pc:sldMk cId="3247014438" sldId="4111"/>
        </pc:sldMkLst>
      </pc:sldChg>
      <pc:sldChg chg="add del">
        <pc:chgData name="Grace Lee" userId="fd145552-a10d-4a31-a438-f8736fd84277" providerId="ADAL" clId="{EDCE6299-B909-6840-AE8F-8D55B29E9D82}" dt="2021-09-07T06:24:14.029" v="570" actId="2696"/>
        <pc:sldMkLst>
          <pc:docMk/>
          <pc:sldMk cId="3619122964" sldId="4111"/>
        </pc:sldMkLst>
      </pc:sldChg>
      <pc:sldChg chg="modSp add del mod">
        <pc:chgData name="Grace Lee" userId="fd145552-a10d-4a31-a438-f8736fd84277" providerId="ADAL" clId="{EDCE6299-B909-6840-AE8F-8D55B29E9D82}" dt="2021-09-07T06:26:18.064" v="870" actId="2696"/>
        <pc:sldMkLst>
          <pc:docMk/>
          <pc:sldMk cId="2101655616" sldId="4112"/>
        </pc:sldMkLst>
        <pc:spChg chg="mod">
          <ac:chgData name="Grace Lee" userId="fd145552-a10d-4a31-a438-f8736fd84277" providerId="ADAL" clId="{EDCE6299-B909-6840-AE8F-8D55B29E9D82}" dt="2021-09-07T06:24:34.266" v="577" actId="1076"/>
          <ac:spMkLst>
            <pc:docMk/>
            <pc:sldMk cId="2101655616" sldId="4112"/>
            <ac:spMk id="10" creationId="{301784A5-898C-624D-B19C-57F02EA16B9C}"/>
          </ac:spMkLst>
        </pc:spChg>
        <pc:spChg chg="mod">
          <ac:chgData name="Grace Lee" userId="fd145552-a10d-4a31-a438-f8736fd84277" providerId="ADAL" clId="{EDCE6299-B909-6840-AE8F-8D55B29E9D82}" dt="2021-09-07T06:24:32.562" v="576" actId="1076"/>
          <ac:spMkLst>
            <pc:docMk/>
            <pc:sldMk cId="2101655616" sldId="4112"/>
            <ac:spMk id="11" creationId="{18AC6636-5D6E-0742-A107-80ADAD1BDDBA}"/>
          </ac:spMkLst>
        </pc:spChg>
      </pc:sldChg>
      <pc:sldChg chg="modSp del mod">
        <pc:chgData name="Grace Lee" userId="fd145552-a10d-4a31-a438-f8736fd84277" providerId="ADAL" clId="{EDCE6299-B909-6840-AE8F-8D55B29E9D82}" dt="2021-09-15T01:20:31.081" v="2561" actId="2696"/>
        <pc:sldMkLst>
          <pc:docMk/>
          <pc:sldMk cId="4012996916" sldId="4120"/>
        </pc:sldMkLst>
        <pc:graphicFrameChg chg="mod modGraphic">
          <ac:chgData name="Grace Lee" userId="fd145552-a10d-4a31-a438-f8736fd84277" providerId="ADAL" clId="{EDCE6299-B909-6840-AE8F-8D55B29E9D82}" dt="2021-09-15T01:19:53.118" v="2480" actId="21"/>
          <ac:graphicFrameMkLst>
            <pc:docMk/>
            <pc:sldMk cId="4012996916" sldId="4120"/>
            <ac:graphicFrameMk id="5" creationId="{1F6D69E8-098B-4675-AAE5-73A7D0391966}"/>
          </ac:graphicFrameMkLst>
        </pc:graphicFrameChg>
      </pc:sldChg>
      <pc:sldChg chg="modSp del mod">
        <pc:chgData name="Grace Lee" userId="fd145552-a10d-4a31-a438-f8736fd84277" providerId="ADAL" clId="{EDCE6299-B909-6840-AE8F-8D55B29E9D82}" dt="2021-09-14T05:34:25.271" v="1948" actId="2696"/>
        <pc:sldMkLst>
          <pc:docMk/>
          <pc:sldMk cId="928024666" sldId="4121"/>
        </pc:sldMkLst>
        <pc:graphicFrameChg chg="mod modGraphic">
          <ac:chgData name="Grace Lee" userId="fd145552-a10d-4a31-a438-f8736fd84277" providerId="ADAL" clId="{EDCE6299-B909-6840-AE8F-8D55B29E9D82}" dt="2021-09-14T05:34:12.407" v="1931" actId="6549"/>
          <ac:graphicFrameMkLst>
            <pc:docMk/>
            <pc:sldMk cId="928024666" sldId="4121"/>
            <ac:graphicFrameMk id="5" creationId="{1F6D69E8-098B-4675-AAE5-73A7D0391966}"/>
          </ac:graphicFrameMkLst>
        </pc:graphicFrameChg>
      </pc:sldChg>
      <pc:sldChg chg="add del">
        <pc:chgData name="Grace Lee" userId="fd145552-a10d-4a31-a438-f8736fd84277" providerId="ADAL" clId="{EDCE6299-B909-6840-AE8F-8D55B29E9D82}" dt="2021-09-15T07:23:21.122" v="3432" actId="2696"/>
        <pc:sldMkLst>
          <pc:docMk/>
          <pc:sldMk cId="2192673793" sldId="4122"/>
        </pc:sldMkLst>
      </pc:sldChg>
      <pc:sldChg chg="modSp new del mod ord">
        <pc:chgData name="Grace Lee" userId="fd145552-a10d-4a31-a438-f8736fd84277" providerId="ADAL" clId="{EDCE6299-B909-6840-AE8F-8D55B29E9D82}" dt="2021-09-13T23:23:26.966" v="1787" actId="2696"/>
        <pc:sldMkLst>
          <pc:docMk/>
          <pc:sldMk cId="2673259763" sldId="4123"/>
        </pc:sldMkLst>
        <pc:spChg chg="mod">
          <ac:chgData name="Grace Lee" userId="fd145552-a10d-4a31-a438-f8736fd84277" providerId="ADAL" clId="{EDCE6299-B909-6840-AE8F-8D55B29E9D82}" dt="2021-09-13T23:21:46.266" v="1786" actId="20577"/>
          <ac:spMkLst>
            <pc:docMk/>
            <pc:sldMk cId="2673259763" sldId="4123"/>
            <ac:spMk id="3" creationId="{97E89FC1-B438-5848-AAE2-5ABBB33F21FF}"/>
          </ac:spMkLst>
        </pc:spChg>
      </pc:sldChg>
      <pc:sldMasterChg chg="del delSldLayout">
        <pc:chgData name="Grace Lee" userId="fd145552-a10d-4a31-a438-f8736fd84277" providerId="ADAL" clId="{EDCE6299-B909-6840-AE8F-8D55B29E9D82}" dt="2021-09-07T06:26:18.064" v="870" actId="2696"/>
        <pc:sldMasterMkLst>
          <pc:docMk/>
          <pc:sldMasterMk cId="2935085865" sldId="2147483758"/>
        </pc:sldMasterMkLst>
        <pc:sldLayoutChg chg="del">
          <pc:chgData name="Grace Lee" userId="fd145552-a10d-4a31-a438-f8736fd84277" providerId="ADAL" clId="{EDCE6299-B909-6840-AE8F-8D55B29E9D82}" dt="2021-09-07T06:26:18.064" v="870" actId="2696"/>
          <pc:sldLayoutMkLst>
            <pc:docMk/>
            <pc:sldMasterMk cId="2935085865" sldId="2147483758"/>
            <pc:sldLayoutMk cId="31590622" sldId="2147483759"/>
          </pc:sldLayoutMkLst>
        </pc:sldLayoutChg>
      </pc:sldMasterChg>
    </pc:docChg>
  </pc:docChgLst>
  <pc:docChgLst>
    <pc:chgData name="Grace Lee" userId="S::grace.lee@sydney.edu.au::fd145552-a10d-4a31-a438-f8736fd84277" providerId="AD" clId="Web-{2CD01E67-36B8-5975-B773-85561CC6ACFC}"/>
    <pc:docChg chg="modSld">
      <pc:chgData name="Grace Lee" userId="S::grace.lee@sydney.edu.au::fd145552-a10d-4a31-a438-f8736fd84277" providerId="AD" clId="Web-{2CD01E67-36B8-5975-B773-85561CC6ACFC}" dt="2021-09-08T00:48:51.070" v="260" actId="1076"/>
      <pc:docMkLst>
        <pc:docMk/>
      </pc:docMkLst>
      <pc:sldChg chg="modSp">
        <pc:chgData name="Grace Lee" userId="S::grace.lee@sydney.edu.au::fd145552-a10d-4a31-a438-f8736fd84277" providerId="AD" clId="Web-{2CD01E67-36B8-5975-B773-85561CC6ACFC}" dt="2021-09-08T00:47:51.537" v="150" actId="1076"/>
        <pc:sldMkLst>
          <pc:docMk/>
          <pc:sldMk cId="660037898" sldId="4104"/>
        </pc:sldMkLst>
        <pc:spChg chg="mod">
          <ac:chgData name="Grace Lee" userId="S::grace.lee@sydney.edu.au::fd145552-a10d-4a31-a438-f8736fd84277" providerId="AD" clId="Web-{2CD01E67-36B8-5975-B773-85561CC6ACFC}" dt="2021-09-08T00:47:47.381" v="149" actId="20577"/>
          <ac:spMkLst>
            <pc:docMk/>
            <pc:sldMk cId="660037898" sldId="4104"/>
            <ac:spMk id="2" creationId="{594AAAD1-A302-415E-8929-53A6DDC5A801}"/>
          </ac:spMkLst>
        </pc:spChg>
        <pc:graphicFrameChg chg="mod">
          <ac:chgData name="Grace Lee" userId="S::grace.lee@sydney.edu.au::fd145552-a10d-4a31-a438-f8736fd84277" providerId="AD" clId="Web-{2CD01E67-36B8-5975-B773-85561CC6ACFC}" dt="2021-09-08T00:47:51.537" v="150" actId="1076"/>
          <ac:graphicFrameMkLst>
            <pc:docMk/>
            <pc:sldMk cId="660037898" sldId="4104"/>
            <ac:graphicFrameMk id="4" creationId="{34A6E8FD-61D1-453E-B833-42E2C191607B}"/>
          </ac:graphicFrameMkLst>
        </pc:graphicFrameChg>
      </pc:sldChg>
      <pc:sldChg chg="modSp">
        <pc:chgData name="Grace Lee" userId="S::grace.lee@sydney.edu.au::fd145552-a10d-4a31-a438-f8736fd84277" providerId="AD" clId="Web-{2CD01E67-36B8-5975-B773-85561CC6ACFC}" dt="2021-09-08T00:48:51.070" v="260" actId="1076"/>
        <pc:sldMkLst>
          <pc:docMk/>
          <pc:sldMk cId="4043908164" sldId="4105"/>
        </pc:sldMkLst>
        <pc:spChg chg="mod">
          <ac:chgData name="Grace Lee" userId="S::grace.lee@sydney.edu.au::fd145552-a10d-4a31-a438-f8736fd84277" providerId="AD" clId="Web-{2CD01E67-36B8-5975-B773-85561CC6ACFC}" dt="2021-09-08T00:48:51.070" v="260" actId="1076"/>
          <ac:spMkLst>
            <pc:docMk/>
            <pc:sldMk cId="4043908164" sldId="4105"/>
            <ac:spMk id="69" creationId="{22298092-8327-3444-886B-3937414AE4BE}"/>
          </ac:spMkLst>
        </pc:spChg>
      </pc:sldChg>
      <pc:sldChg chg="modSp">
        <pc:chgData name="Grace Lee" userId="S::grace.lee@sydney.edu.au::fd145552-a10d-4a31-a438-f8736fd84277" providerId="AD" clId="Web-{2CD01E67-36B8-5975-B773-85561CC6ACFC}" dt="2021-09-08T00:48:09.319" v="151" actId="20577"/>
        <pc:sldMkLst>
          <pc:docMk/>
          <pc:sldMk cId="1691795552" sldId="4108"/>
        </pc:sldMkLst>
        <pc:spChg chg="mod">
          <ac:chgData name="Grace Lee" userId="S::grace.lee@sydney.edu.au::fd145552-a10d-4a31-a438-f8736fd84277" providerId="AD" clId="Web-{2CD01E67-36B8-5975-B773-85561CC6ACFC}" dt="2021-09-08T00:48:09.319" v="151" actId="20577"/>
          <ac:spMkLst>
            <pc:docMk/>
            <pc:sldMk cId="1691795552" sldId="4108"/>
            <ac:spMk id="2" creationId="{594AAAD1-A302-415E-8929-53A6DDC5A801}"/>
          </ac:spMkLst>
        </pc:spChg>
      </pc:sldChg>
    </pc:docChg>
  </pc:docChgLst>
  <pc:docChgLst>
    <pc:chgData name="Grace Lee" userId="fd145552-a10d-4a31-a438-f8736fd84277" providerId="ADAL" clId="{7AD5128E-48EF-4094-91E0-6F934CF97793}"/>
    <pc:docChg chg="undo custSel addSld delSld modSld sldOrd">
      <pc:chgData name="Grace Lee" userId="fd145552-a10d-4a31-a438-f8736fd84277" providerId="ADAL" clId="{7AD5128E-48EF-4094-91E0-6F934CF97793}" dt="2021-10-12T00:15:54.123" v="2601" actId="20577"/>
      <pc:docMkLst>
        <pc:docMk/>
      </pc:docMkLst>
      <pc:sldChg chg="modSp mod">
        <pc:chgData name="Grace Lee" userId="fd145552-a10d-4a31-a438-f8736fd84277" providerId="ADAL" clId="{7AD5128E-48EF-4094-91E0-6F934CF97793}" dt="2021-10-12T00:15:54.123" v="2601" actId="20577"/>
        <pc:sldMkLst>
          <pc:docMk/>
          <pc:sldMk cId="1330355191" sldId="576"/>
        </pc:sldMkLst>
        <pc:graphicFrameChg chg="modGraphic">
          <ac:chgData name="Grace Lee" userId="fd145552-a10d-4a31-a438-f8736fd84277" providerId="ADAL" clId="{7AD5128E-48EF-4094-91E0-6F934CF97793}" dt="2021-10-12T00:15:54.123" v="2601" actId="20577"/>
          <ac:graphicFrameMkLst>
            <pc:docMk/>
            <pc:sldMk cId="1330355191" sldId="576"/>
            <ac:graphicFrameMk id="5" creationId="{1F6D69E8-098B-4675-AAE5-73A7D0391966}"/>
          </ac:graphicFrameMkLst>
        </pc:graphicFrameChg>
      </pc:sldChg>
      <pc:sldChg chg="addSp delSp del mod">
        <pc:chgData name="Grace Lee" userId="fd145552-a10d-4a31-a438-f8736fd84277" providerId="ADAL" clId="{7AD5128E-48EF-4094-91E0-6F934CF97793}" dt="2021-10-11T23:55:07.008" v="626" actId="47"/>
        <pc:sldMkLst>
          <pc:docMk/>
          <pc:sldMk cId="3729442319" sldId="3308"/>
        </pc:sldMkLst>
        <pc:picChg chg="add del">
          <ac:chgData name="Grace Lee" userId="fd145552-a10d-4a31-a438-f8736fd84277" providerId="ADAL" clId="{7AD5128E-48EF-4094-91E0-6F934CF97793}" dt="2021-10-11T23:55:05.402" v="625" actId="478"/>
          <ac:picMkLst>
            <pc:docMk/>
            <pc:sldMk cId="3729442319" sldId="3308"/>
            <ac:picMk id="6" creationId="{0D46A960-EA26-4342-A3E6-103D69CE0C86}"/>
          </ac:picMkLst>
        </pc:picChg>
      </pc:sldChg>
      <pc:sldChg chg="addSp modSp mod">
        <pc:chgData name="Grace Lee" userId="fd145552-a10d-4a31-a438-f8736fd84277" providerId="ADAL" clId="{7AD5128E-48EF-4094-91E0-6F934CF97793}" dt="2021-10-11T21:59:12.541" v="306" actId="207"/>
        <pc:sldMkLst>
          <pc:docMk/>
          <pc:sldMk cId="4043908164" sldId="4105"/>
        </pc:sldMkLst>
        <pc:spChg chg="add mod">
          <ac:chgData name="Grace Lee" userId="fd145552-a10d-4a31-a438-f8736fd84277" providerId="ADAL" clId="{7AD5128E-48EF-4094-91E0-6F934CF97793}" dt="2021-10-11T21:59:12.541" v="306" actId="207"/>
          <ac:spMkLst>
            <pc:docMk/>
            <pc:sldMk cId="4043908164" sldId="4105"/>
            <ac:spMk id="19" creationId="{9C6CEFB1-CBA8-4398-B503-3D8E82667A98}"/>
          </ac:spMkLst>
        </pc:spChg>
        <pc:spChg chg="mod">
          <ac:chgData name="Grace Lee" userId="fd145552-a10d-4a31-a438-f8736fd84277" providerId="ADAL" clId="{7AD5128E-48EF-4094-91E0-6F934CF97793}" dt="2021-10-11T21:58:58.183" v="271" actId="207"/>
          <ac:spMkLst>
            <pc:docMk/>
            <pc:sldMk cId="4043908164" sldId="4105"/>
            <ac:spMk id="67" creationId="{0F7CE110-6D83-8E47-A48C-994E1B2B49F2}"/>
          </ac:spMkLst>
        </pc:spChg>
        <pc:spChg chg="mod">
          <ac:chgData name="Grace Lee" userId="fd145552-a10d-4a31-a438-f8736fd84277" providerId="ADAL" clId="{7AD5128E-48EF-4094-91E0-6F934CF97793}" dt="2021-10-11T21:58:55.658" v="270" actId="207"/>
          <ac:spMkLst>
            <pc:docMk/>
            <pc:sldMk cId="4043908164" sldId="4105"/>
            <ac:spMk id="69" creationId="{22298092-8327-3444-886B-3937414AE4BE}"/>
          </ac:spMkLst>
        </pc:spChg>
        <pc:spChg chg="mod">
          <ac:chgData name="Grace Lee" userId="fd145552-a10d-4a31-a438-f8736fd84277" providerId="ADAL" clId="{7AD5128E-48EF-4094-91E0-6F934CF97793}" dt="2021-10-11T21:58:52.260" v="269" actId="207"/>
          <ac:spMkLst>
            <pc:docMk/>
            <pc:sldMk cId="4043908164" sldId="4105"/>
            <ac:spMk id="76" creationId="{F9D7A803-10EA-064F-BF6C-06B6B89F9189}"/>
          </ac:spMkLst>
        </pc:spChg>
        <pc:spChg chg="mod">
          <ac:chgData name="Grace Lee" userId="fd145552-a10d-4a31-a438-f8736fd84277" providerId="ADAL" clId="{7AD5128E-48EF-4094-91E0-6F934CF97793}" dt="2021-10-11T21:58:07.229" v="178" actId="1076"/>
          <ac:spMkLst>
            <pc:docMk/>
            <pc:sldMk cId="4043908164" sldId="4105"/>
            <ac:spMk id="79" creationId="{A5C271A3-F497-5F49-AF11-C4AF673F45EA}"/>
          </ac:spMkLst>
        </pc:spChg>
        <pc:grpChg chg="mod">
          <ac:chgData name="Grace Lee" userId="fd145552-a10d-4a31-a438-f8736fd84277" providerId="ADAL" clId="{7AD5128E-48EF-4094-91E0-6F934CF97793}" dt="2021-10-11T21:58:07.229" v="178" actId="1076"/>
          <ac:grpSpMkLst>
            <pc:docMk/>
            <pc:sldMk cId="4043908164" sldId="4105"/>
            <ac:grpSpMk id="52" creationId="{AF4181E4-0FD4-684C-9095-D24E8ACF3CA9}"/>
          </ac:grpSpMkLst>
        </pc:grpChg>
        <pc:grpChg chg="mod">
          <ac:chgData name="Grace Lee" userId="fd145552-a10d-4a31-a438-f8736fd84277" providerId="ADAL" clId="{7AD5128E-48EF-4094-91E0-6F934CF97793}" dt="2021-10-11T21:58:07.229" v="178" actId="1076"/>
          <ac:grpSpMkLst>
            <pc:docMk/>
            <pc:sldMk cId="4043908164" sldId="4105"/>
            <ac:grpSpMk id="61" creationId="{3F7A0C77-7479-0247-AE54-DF6E9F20CDCE}"/>
          </ac:grpSpMkLst>
        </pc:grpChg>
      </pc:sldChg>
      <pc:sldChg chg="delSp modSp mod">
        <pc:chgData name="Grace Lee" userId="fd145552-a10d-4a31-a438-f8736fd84277" providerId="ADAL" clId="{7AD5128E-48EF-4094-91E0-6F934CF97793}" dt="2021-10-11T22:22:12.713" v="619" actId="20577"/>
        <pc:sldMkLst>
          <pc:docMk/>
          <pc:sldMk cId="3388768461" sldId="4121"/>
        </pc:sldMkLst>
        <pc:spChg chg="mod">
          <ac:chgData name="Grace Lee" userId="fd145552-a10d-4a31-a438-f8736fd84277" providerId="ADAL" clId="{7AD5128E-48EF-4094-91E0-6F934CF97793}" dt="2021-10-11T22:00:12.154" v="415" actId="20577"/>
          <ac:spMkLst>
            <pc:docMk/>
            <pc:sldMk cId="3388768461" sldId="4121"/>
            <ac:spMk id="52" creationId="{31E02B73-E03A-C04A-8F77-57DE7CCB8A15}"/>
          </ac:spMkLst>
        </pc:spChg>
        <pc:spChg chg="del">
          <ac:chgData name="Grace Lee" userId="fd145552-a10d-4a31-a438-f8736fd84277" providerId="ADAL" clId="{7AD5128E-48EF-4094-91E0-6F934CF97793}" dt="2021-10-11T22:07:05.573" v="416" actId="478"/>
          <ac:spMkLst>
            <pc:docMk/>
            <pc:sldMk cId="3388768461" sldId="4121"/>
            <ac:spMk id="57" creationId="{B59C53E4-55DF-324D-BA47-CD633E8FF4D3}"/>
          </ac:spMkLst>
        </pc:spChg>
        <pc:spChg chg="mod">
          <ac:chgData name="Grace Lee" userId="fd145552-a10d-4a31-a438-f8736fd84277" providerId="ADAL" clId="{7AD5128E-48EF-4094-91E0-6F934CF97793}" dt="2021-10-11T22:22:12.713" v="619" actId="20577"/>
          <ac:spMkLst>
            <pc:docMk/>
            <pc:sldMk cId="3388768461" sldId="4121"/>
            <ac:spMk id="60" creationId="{CD9701E9-623F-1E4C-BC48-DD8ABC8E6605}"/>
          </ac:spMkLst>
        </pc:spChg>
        <pc:spChg chg="mod">
          <ac:chgData name="Grace Lee" userId="fd145552-a10d-4a31-a438-f8736fd84277" providerId="ADAL" clId="{7AD5128E-48EF-4094-91E0-6F934CF97793}" dt="2021-10-11T21:59:47.919" v="308" actId="20577"/>
          <ac:spMkLst>
            <pc:docMk/>
            <pc:sldMk cId="3388768461" sldId="4121"/>
            <ac:spMk id="142" creationId="{86B23B6A-5700-4425-B4D0-EAA428DDD848}"/>
          </ac:spMkLst>
        </pc:spChg>
        <pc:cxnChg chg="mod">
          <ac:chgData name="Grace Lee" userId="fd145552-a10d-4a31-a438-f8736fd84277" providerId="ADAL" clId="{7AD5128E-48EF-4094-91E0-6F934CF97793}" dt="2021-10-11T22:17:57.605" v="528" actId="14100"/>
          <ac:cxnSpMkLst>
            <pc:docMk/>
            <pc:sldMk cId="3388768461" sldId="4121"/>
            <ac:cxnSpMk id="138" creationId="{9959127E-055C-4B8D-AE54-60BEBE6FB27F}"/>
          </ac:cxnSpMkLst>
        </pc:cxnChg>
      </pc:sldChg>
      <pc:sldChg chg="delCm">
        <pc:chgData name="Grace Lee" userId="fd145552-a10d-4a31-a438-f8736fd84277" providerId="ADAL" clId="{7AD5128E-48EF-4094-91E0-6F934CF97793}" dt="2021-10-11T22:38:05.072" v="620" actId="1592"/>
        <pc:sldMkLst>
          <pc:docMk/>
          <pc:sldMk cId="1556166697" sldId="4127"/>
        </pc:sldMkLst>
      </pc:sldChg>
      <pc:sldChg chg="delCm">
        <pc:chgData name="Grace Lee" userId="fd145552-a10d-4a31-a438-f8736fd84277" providerId="ADAL" clId="{7AD5128E-48EF-4094-91E0-6F934CF97793}" dt="2021-10-11T21:53:04.822" v="3" actId="1592"/>
        <pc:sldMkLst>
          <pc:docMk/>
          <pc:sldMk cId="3245747096" sldId="4132"/>
        </pc:sldMkLst>
      </pc:sldChg>
      <pc:sldChg chg="delCm">
        <pc:chgData name="Grace Lee" userId="fd145552-a10d-4a31-a438-f8736fd84277" providerId="ADAL" clId="{7AD5128E-48EF-4094-91E0-6F934CF97793}" dt="2021-10-11T21:47:59.717" v="0" actId="1592"/>
        <pc:sldMkLst>
          <pc:docMk/>
          <pc:sldMk cId="959688536" sldId="4133"/>
        </pc:sldMkLst>
      </pc:sldChg>
      <pc:sldChg chg="del">
        <pc:chgData name="Grace Lee" userId="fd145552-a10d-4a31-a438-f8736fd84277" providerId="ADAL" clId="{7AD5128E-48EF-4094-91E0-6F934CF97793}" dt="2021-10-11T21:48:09.996" v="2" actId="47"/>
        <pc:sldMkLst>
          <pc:docMk/>
          <pc:sldMk cId="1974615656" sldId="4134"/>
        </pc:sldMkLst>
      </pc:sldChg>
      <pc:sldChg chg="del">
        <pc:chgData name="Grace Lee" userId="fd145552-a10d-4a31-a438-f8736fd84277" providerId="ADAL" clId="{7AD5128E-48EF-4094-91E0-6F934CF97793}" dt="2021-10-12T00:00:17.756" v="2037" actId="47"/>
        <pc:sldMkLst>
          <pc:docMk/>
          <pc:sldMk cId="486706463" sldId="4139"/>
        </pc:sldMkLst>
      </pc:sldChg>
      <pc:sldChg chg="add">
        <pc:chgData name="Grace Lee" userId="fd145552-a10d-4a31-a438-f8736fd84277" providerId="ADAL" clId="{7AD5128E-48EF-4094-91E0-6F934CF97793}" dt="2021-10-11T21:48:09.110" v="1"/>
        <pc:sldMkLst>
          <pc:docMk/>
          <pc:sldMk cId="369055727" sldId="4140"/>
        </pc:sldMkLst>
      </pc:sldChg>
      <pc:sldChg chg="add del">
        <pc:chgData name="Grace Lee" userId="fd145552-a10d-4a31-a438-f8736fd84277" providerId="ADAL" clId="{7AD5128E-48EF-4094-91E0-6F934CF97793}" dt="2021-10-12T00:00:20.445" v="2038" actId="47"/>
        <pc:sldMkLst>
          <pc:docMk/>
          <pc:sldMk cId="356819549" sldId="4141"/>
        </pc:sldMkLst>
      </pc:sldChg>
      <pc:sldChg chg="add del">
        <pc:chgData name="Grace Lee" userId="fd145552-a10d-4a31-a438-f8736fd84277" providerId="ADAL" clId="{7AD5128E-48EF-4094-91E0-6F934CF97793}" dt="2021-10-11T23:55:04.964" v="624" actId="2890"/>
        <pc:sldMkLst>
          <pc:docMk/>
          <pc:sldMk cId="864155926" sldId="4142"/>
        </pc:sldMkLst>
      </pc:sldChg>
      <pc:sldChg chg="addSp delSp modSp new mod ord">
        <pc:chgData name="Grace Lee" userId="fd145552-a10d-4a31-a438-f8736fd84277" providerId="ADAL" clId="{7AD5128E-48EF-4094-91E0-6F934CF97793}" dt="2021-10-12T00:10:16.560" v="2551" actId="20577"/>
        <pc:sldMkLst>
          <pc:docMk/>
          <pc:sldMk cId="2610545142" sldId="4142"/>
        </pc:sldMkLst>
        <pc:spChg chg="mod">
          <ac:chgData name="Grace Lee" userId="fd145552-a10d-4a31-a438-f8736fd84277" providerId="ADAL" clId="{7AD5128E-48EF-4094-91E0-6F934CF97793}" dt="2021-10-12T00:10:16.560" v="2551" actId="20577"/>
          <ac:spMkLst>
            <pc:docMk/>
            <pc:sldMk cId="2610545142" sldId="4142"/>
            <ac:spMk id="2" creationId="{A739DE6E-1586-4EC4-9EB1-6AB33C5858C3}"/>
          </ac:spMkLst>
        </pc:spChg>
        <pc:spChg chg="mod">
          <ac:chgData name="Grace Lee" userId="fd145552-a10d-4a31-a438-f8736fd84277" providerId="ADAL" clId="{7AD5128E-48EF-4094-91E0-6F934CF97793}" dt="2021-10-11T23:56:15.857" v="719" actId="20577"/>
          <ac:spMkLst>
            <pc:docMk/>
            <pc:sldMk cId="2610545142" sldId="4142"/>
            <ac:spMk id="3" creationId="{E005AC93-71BC-4275-88EC-058B82BC1C4E}"/>
          </ac:spMkLst>
        </pc:spChg>
        <pc:picChg chg="add del mod">
          <ac:chgData name="Grace Lee" userId="fd145552-a10d-4a31-a438-f8736fd84277" providerId="ADAL" clId="{7AD5128E-48EF-4094-91E0-6F934CF97793}" dt="2021-10-12T00:06:21.128" v="2202" actId="478"/>
          <ac:picMkLst>
            <pc:docMk/>
            <pc:sldMk cId="2610545142" sldId="4142"/>
            <ac:picMk id="5" creationId="{640991D9-0FBA-4190-8AA9-0C8B5B3A4E48}"/>
          </ac:picMkLst>
        </pc:picChg>
        <pc:picChg chg="add del">
          <ac:chgData name="Grace Lee" userId="fd145552-a10d-4a31-a438-f8736fd84277" providerId="ADAL" clId="{7AD5128E-48EF-4094-91E0-6F934CF97793}" dt="2021-10-12T00:06:31.435" v="2204" actId="478"/>
          <ac:picMkLst>
            <pc:docMk/>
            <pc:sldMk cId="2610545142" sldId="4142"/>
            <ac:picMk id="7" creationId="{D7F0ABC1-F73C-466C-AF5A-28635BF70156}"/>
          </ac:picMkLst>
        </pc:picChg>
        <pc:picChg chg="add mod">
          <ac:chgData name="Grace Lee" userId="fd145552-a10d-4a31-a438-f8736fd84277" providerId="ADAL" clId="{7AD5128E-48EF-4094-91E0-6F934CF97793}" dt="2021-10-12T00:09:30.376" v="2451" actId="1076"/>
          <ac:picMkLst>
            <pc:docMk/>
            <pc:sldMk cId="2610545142" sldId="4142"/>
            <ac:picMk id="9" creationId="{6B5DEDBA-36F3-411C-BB64-C1015AACDCB4}"/>
          </ac:picMkLst>
        </pc:picChg>
        <pc:picChg chg="add mod">
          <ac:chgData name="Grace Lee" userId="fd145552-a10d-4a31-a438-f8736fd84277" providerId="ADAL" clId="{7AD5128E-48EF-4094-91E0-6F934CF97793}" dt="2021-10-12T00:09:49.959" v="2481" actId="1076"/>
          <ac:picMkLst>
            <pc:docMk/>
            <pc:sldMk cId="2610545142" sldId="4142"/>
            <ac:picMk id="11" creationId="{5D406807-62CB-4359-A3C5-D1E0C0F51BDA}"/>
          </ac:picMkLst>
        </pc:picChg>
      </pc:sldChg>
    </pc:docChg>
  </pc:docChgLst>
  <pc:docChgLst>
    <pc:chgData name="Samuel Hockey" userId="S::samuel.hockey@sydney.edu.au::ad77122e-3c27-4726-adda-8390e9cb6924" providerId="AD" clId="Web-{92ABC828-0EAA-4704-8819-CB34AD598258}"/>
    <pc:docChg chg="addSld modSld">
      <pc:chgData name="Samuel Hockey" userId="S::samuel.hockey@sydney.edu.au::ad77122e-3c27-4726-adda-8390e9cb6924" providerId="AD" clId="Web-{92ABC828-0EAA-4704-8819-CB34AD598258}" dt="2021-09-13T21:06:09.494" v="2163"/>
      <pc:docMkLst>
        <pc:docMk/>
      </pc:docMkLst>
      <pc:sldChg chg="modSp">
        <pc:chgData name="Samuel Hockey" userId="S::samuel.hockey@sydney.edu.au::ad77122e-3c27-4726-adda-8390e9cb6924" providerId="AD" clId="Web-{92ABC828-0EAA-4704-8819-CB34AD598258}" dt="2021-09-13T20:23:34.188" v="2" actId="1076"/>
        <pc:sldMkLst>
          <pc:docMk/>
          <pc:sldMk cId="187938002" sldId="3307"/>
        </pc:sldMkLst>
        <pc:spChg chg="mod">
          <ac:chgData name="Samuel Hockey" userId="S::samuel.hockey@sydney.edu.au::ad77122e-3c27-4726-adda-8390e9cb6924" providerId="AD" clId="Web-{92ABC828-0EAA-4704-8819-CB34AD598258}" dt="2021-09-13T20:23:25.188" v="0" actId="1076"/>
          <ac:spMkLst>
            <pc:docMk/>
            <pc:sldMk cId="187938002" sldId="3307"/>
            <ac:spMk id="171" creationId="{F3656F8A-FF42-4AC4-8FF8-DC399A5E5F15}"/>
          </ac:spMkLst>
        </pc:spChg>
        <pc:spChg chg="mod">
          <ac:chgData name="Samuel Hockey" userId="S::samuel.hockey@sydney.edu.au::ad77122e-3c27-4726-adda-8390e9cb6924" providerId="AD" clId="Web-{92ABC828-0EAA-4704-8819-CB34AD598258}" dt="2021-09-13T20:23:34.188" v="2" actId="1076"/>
          <ac:spMkLst>
            <pc:docMk/>
            <pc:sldMk cId="187938002" sldId="3307"/>
            <ac:spMk id="183" creationId="{68FDE5F4-FA5B-491E-9DDB-6E4C466C4766}"/>
          </ac:spMkLst>
        </pc:spChg>
        <pc:spChg chg="mod">
          <ac:chgData name="Samuel Hockey" userId="S::samuel.hockey@sydney.edu.au::ad77122e-3c27-4726-adda-8390e9cb6924" providerId="AD" clId="Web-{92ABC828-0EAA-4704-8819-CB34AD598258}" dt="2021-09-13T20:23:28.610" v="1" actId="1076"/>
          <ac:spMkLst>
            <pc:docMk/>
            <pc:sldMk cId="187938002" sldId="3307"/>
            <ac:spMk id="187" creationId="{C5547091-31B6-4C3C-B5FA-2DFA40E76745}"/>
          </ac:spMkLst>
        </pc:spChg>
      </pc:sldChg>
      <pc:sldChg chg="modSp">
        <pc:chgData name="Samuel Hockey" userId="S::samuel.hockey@sydney.edu.au::ad77122e-3c27-4726-adda-8390e9cb6924" providerId="AD" clId="Web-{92ABC828-0EAA-4704-8819-CB34AD598258}" dt="2021-09-13T20:28:13.747" v="163"/>
        <pc:sldMkLst>
          <pc:docMk/>
          <pc:sldMk cId="3729442319" sldId="3308"/>
        </pc:sldMkLst>
        <pc:graphicFrameChg chg="mod modGraphic">
          <ac:chgData name="Samuel Hockey" userId="S::samuel.hockey@sydney.edu.au::ad77122e-3c27-4726-adda-8390e9cb6924" providerId="AD" clId="Web-{92ABC828-0EAA-4704-8819-CB34AD598258}" dt="2021-09-13T20:28:13.747" v="163"/>
          <ac:graphicFrameMkLst>
            <pc:docMk/>
            <pc:sldMk cId="3729442319" sldId="3308"/>
            <ac:graphicFrameMk id="5" creationId="{1F6D69E8-098B-4675-AAE5-73A7D0391966}"/>
          </ac:graphicFrameMkLst>
        </pc:graphicFrameChg>
      </pc:sldChg>
      <pc:sldChg chg="modSp">
        <pc:chgData name="Samuel Hockey" userId="S::samuel.hockey@sydney.edu.au::ad77122e-3c27-4726-adda-8390e9cb6924" providerId="AD" clId="Web-{92ABC828-0EAA-4704-8819-CB34AD598258}" dt="2021-09-13T20:58:18.920" v="1971"/>
        <pc:sldMkLst>
          <pc:docMk/>
          <pc:sldMk cId="2198890857" sldId="4102"/>
        </pc:sldMkLst>
        <pc:graphicFrameChg chg="mod modGraphic">
          <ac:chgData name="Samuel Hockey" userId="S::samuel.hockey@sydney.edu.au::ad77122e-3c27-4726-adda-8390e9cb6924" providerId="AD" clId="Web-{92ABC828-0EAA-4704-8819-CB34AD598258}" dt="2021-09-13T20:58:18.920" v="1971"/>
          <ac:graphicFrameMkLst>
            <pc:docMk/>
            <pc:sldMk cId="2198890857" sldId="4102"/>
            <ac:graphicFrameMk id="5" creationId="{1F6D69E8-098B-4675-AAE5-73A7D0391966}"/>
          </ac:graphicFrameMkLst>
        </pc:graphicFrameChg>
      </pc:sldChg>
      <pc:sldChg chg="modSp add replId">
        <pc:chgData name="Samuel Hockey" userId="S::samuel.hockey@sydney.edu.au::ad77122e-3c27-4726-adda-8390e9cb6924" providerId="AD" clId="Web-{92ABC828-0EAA-4704-8819-CB34AD598258}" dt="2021-09-13T20:51:20.035" v="1382"/>
        <pc:sldMkLst>
          <pc:docMk/>
          <pc:sldMk cId="4012996916" sldId="4120"/>
        </pc:sldMkLst>
        <pc:spChg chg="mod">
          <ac:chgData name="Samuel Hockey" userId="S::samuel.hockey@sydney.edu.au::ad77122e-3c27-4726-adda-8390e9cb6924" providerId="AD" clId="Web-{92ABC828-0EAA-4704-8819-CB34AD598258}" dt="2021-09-13T20:29:00.842" v="165" actId="20577"/>
          <ac:spMkLst>
            <pc:docMk/>
            <pc:sldMk cId="4012996916" sldId="4120"/>
            <ac:spMk id="3" creationId="{1C207EF0-D5F8-4C7D-9363-8246CDD5503A}"/>
          </ac:spMkLst>
        </pc:spChg>
        <pc:graphicFrameChg chg="mod modGraphic">
          <ac:chgData name="Samuel Hockey" userId="S::samuel.hockey@sydney.edu.au::ad77122e-3c27-4726-adda-8390e9cb6924" providerId="AD" clId="Web-{92ABC828-0EAA-4704-8819-CB34AD598258}" dt="2021-09-13T20:51:20.035" v="1382"/>
          <ac:graphicFrameMkLst>
            <pc:docMk/>
            <pc:sldMk cId="4012996916" sldId="4120"/>
            <ac:graphicFrameMk id="5" creationId="{1F6D69E8-098B-4675-AAE5-73A7D0391966}"/>
          </ac:graphicFrameMkLst>
        </pc:graphicFrameChg>
      </pc:sldChg>
      <pc:sldChg chg="modSp add replId">
        <pc:chgData name="Samuel Hockey" userId="S::samuel.hockey@sydney.edu.au::ad77122e-3c27-4726-adda-8390e9cb6924" providerId="AD" clId="Web-{92ABC828-0EAA-4704-8819-CB34AD598258}" dt="2021-09-13T21:06:09.494" v="2163"/>
        <pc:sldMkLst>
          <pc:docMk/>
          <pc:sldMk cId="928024666" sldId="4121"/>
        </pc:sldMkLst>
        <pc:graphicFrameChg chg="mod modGraphic">
          <ac:chgData name="Samuel Hockey" userId="S::samuel.hockey@sydney.edu.au::ad77122e-3c27-4726-adda-8390e9cb6924" providerId="AD" clId="Web-{92ABC828-0EAA-4704-8819-CB34AD598258}" dt="2021-09-13T21:06:09.494" v="2163"/>
          <ac:graphicFrameMkLst>
            <pc:docMk/>
            <pc:sldMk cId="928024666" sldId="4121"/>
            <ac:graphicFrameMk id="5" creationId="{1F6D69E8-098B-4675-AAE5-73A7D0391966}"/>
          </ac:graphicFrameMkLst>
        </pc:graphicFrameChg>
      </pc:sldChg>
    </pc:docChg>
  </pc:docChgLst>
  <pc:docChgLst>
    <pc:chgData name="Grace Lee" userId="fd145552-a10d-4a31-a438-f8736fd84277" providerId="ADAL" clId="{56835480-2BB5-4545-A32E-6CA68AA69734}"/>
    <pc:docChg chg="undo redo custSel addSld delSld modSld sldOrd delMainMaster">
      <pc:chgData name="Grace Lee" userId="fd145552-a10d-4a31-a438-f8736fd84277" providerId="ADAL" clId="{56835480-2BB5-4545-A32E-6CA68AA69734}" dt="2021-09-13T05:45:53.864" v="4295" actId="14100"/>
      <pc:docMkLst>
        <pc:docMk/>
      </pc:docMkLst>
      <pc:sldChg chg="modSp mod">
        <pc:chgData name="Grace Lee" userId="fd145552-a10d-4a31-a438-f8736fd84277" providerId="ADAL" clId="{56835480-2BB5-4545-A32E-6CA68AA69734}" dt="2021-09-13T05:35:06.493" v="4188" actId="20577"/>
        <pc:sldMkLst>
          <pc:docMk/>
          <pc:sldMk cId="1330355191" sldId="576"/>
        </pc:sldMkLst>
        <pc:graphicFrameChg chg="mod modGraphic">
          <ac:chgData name="Grace Lee" userId="fd145552-a10d-4a31-a438-f8736fd84277" providerId="ADAL" clId="{56835480-2BB5-4545-A32E-6CA68AA69734}" dt="2021-09-13T05:35:06.493" v="4188" actId="20577"/>
          <ac:graphicFrameMkLst>
            <pc:docMk/>
            <pc:sldMk cId="1330355191" sldId="576"/>
            <ac:graphicFrameMk id="5" creationId="{1F6D69E8-098B-4675-AAE5-73A7D0391966}"/>
          </ac:graphicFrameMkLst>
        </pc:graphicFrameChg>
      </pc:sldChg>
      <pc:sldChg chg="addSp delSp modSp mod ord">
        <pc:chgData name="Grace Lee" userId="fd145552-a10d-4a31-a438-f8736fd84277" providerId="ADAL" clId="{56835480-2BB5-4545-A32E-6CA68AA69734}" dt="2021-09-13T05:44:14.188" v="4294" actId="6549"/>
        <pc:sldMkLst>
          <pc:docMk/>
          <pc:sldMk cId="187938002" sldId="3307"/>
        </pc:sldMkLst>
        <pc:spChg chg="mod">
          <ac:chgData name="Grace Lee" userId="fd145552-a10d-4a31-a438-f8736fd84277" providerId="ADAL" clId="{56835480-2BB5-4545-A32E-6CA68AA69734}" dt="2021-09-13T04:02:36.473" v="1971" actId="1076"/>
          <ac:spMkLst>
            <pc:docMk/>
            <pc:sldMk cId="187938002" sldId="3307"/>
            <ac:spMk id="3" creationId="{3F736E9F-099F-6E49-8413-5352C763CACD}"/>
          </ac:spMkLst>
        </pc:spChg>
        <pc:spChg chg="del">
          <ac:chgData name="Grace Lee" userId="fd145552-a10d-4a31-a438-f8736fd84277" providerId="ADAL" clId="{56835480-2BB5-4545-A32E-6CA68AA69734}" dt="2021-09-13T01:28:33.665" v="35" actId="478"/>
          <ac:spMkLst>
            <pc:docMk/>
            <pc:sldMk cId="187938002" sldId="3307"/>
            <ac:spMk id="11" creationId="{53924CEB-4D7D-F241-8D0D-F765FB62291C}"/>
          </ac:spMkLst>
        </pc:spChg>
        <pc:spChg chg="mod">
          <ac:chgData name="Grace Lee" userId="fd145552-a10d-4a31-a438-f8736fd84277" providerId="ADAL" clId="{56835480-2BB5-4545-A32E-6CA68AA69734}" dt="2021-09-13T04:02:43.284" v="1988" actId="1036"/>
          <ac:spMkLst>
            <pc:docMk/>
            <pc:sldMk cId="187938002" sldId="3307"/>
            <ac:spMk id="12" creationId="{9F619023-99B5-D048-963C-2919297AAD8E}"/>
          </ac:spMkLst>
        </pc:spChg>
        <pc:spChg chg="mod">
          <ac:chgData name="Grace Lee" userId="fd145552-a10d-4a31-a438-f8736fd84277" providerId="ADAL" clId="{56835480-2BB5-4545-A32E-6CA68AA69734}" dt="2021-09-13T04:02:43.284" v="1988" actId="1036"/>
          <ac:spMkLst>
            <pc:docMk/>
            <pc:sldMk cId="187938002" sldId="3307"/>
            <ac:spMk id="14" creationId="{EE644C53-6D18-3B45-8ACC-5347164E1A9E}"/>
          </ac:spMkLst>
        </pc:spChg>
        <pc:spChg chg="add mod">
          <ac:chgData name="Grace Lee" userId="fd145552-a10d-4a31-a438-f8736fd84277" providerId="ADAL" clId="{56835480-2BB5-4545-A32E-6CA68AA69734}" dt="2021-09-13T04:02:43.284" v="1988" actId="1036"/>
          <ac:spMkLst>
            <pc:docMk/>
            <pc:sldMk cId="187938002" sldId="3307"/>
            <ac:spMk id="33" creationId="{13B1ABB1-D276-4877-8BAE-251F885C5B0D}"/>
          </ac:spMkLst>
        </pc:spChg>
        <pc:spChg chg="add mod">
          <ac:chgData name="Grace Lee" userId="fd145552-a10d-4a31-a438-f8736fd84277" providerId="ADAL" clId="{56835480-2BB5-4545-A32E-6CA68AA69734}" dt="2021-09-13T04:02:43.284" v="1988" actId="1036"/>
          <ac:spMkLst>
            <pc:docMk/>
            <pc:sldMk cId="187938002" sldId="3307"/>
            <ac:spMk id="34" creationId="{E665CCA3-EA18-4949-9A2F-234BF75534EC}"/>
          </ac:spMkLst>
        </pc:spChg>
        <pc:spChg chg="add del mod">
          <ac:chgData name="Grace Lee" userId="fd145552-a10d-4a31-a438-f8736fd84277" providerId="ADAL" clId="{56835480-2BB5-4545-A32E-6CA68AA69734}" dt="2021-09-13T02:03:59.740" v="841" actId="478"/>
          <ac:spMkLst>
            <pc:docMk/>
            <pc:sldMk cId="187938002" sldId="3307"/>
            <ac:spMk id="41" creationId="{D9046639-0FD4-41C4-A038-076748B61313}"/>
          </ac:spMkLst>
        </pc:spChg>
        <pc:spChg chg="add del mod">
          <ac:chgData name="Grace Lee" userId="fd145552-a10d-4a31-a438-f8736fd84277" providerId="ADAL" clId="{56835480-2BB5-4545-A32E-6CA68AA69734}" dt="2021-09-13T02:04:00.626" v="842" actId="478"/>
          <ac:spMkLst>
            <pc:docMk/>
            <pc:sldMk cId="187938002" sldId="3307"/>
            <ac:spMk id="42" creationId="{37A05409-0E4A-448B-8B71-939A4D6ED273}"/>
          </ac:spMkLst>
        </pc:spChg>
        <pc:spChg chg="add mod">
          <ac:chgData name="Grace Lee" userId="fd145552-a10d-4a31-a438-f8736fd84277" providerId="ADAL" clId="{56835480-2BB5-4545-A32E-6CA68AA69734}" dt="2021-09-13T04:02:43.284" v="1988" actId="1036"/>
          <ac:spMkLst>
            <pc:docMk/>
            <pc:sldMk cId="187938002" sldId="3307"/>
            <ac:spMk id="43" creationId="{7D43FE39-F0D3-4954-94D6-877CD290529C}"/>
          </ac:spMkLst>
        </pc:spChg>
        <pc:spChg chg="add mod">
          <ac:chgData name="Grace Lee" userId="fd145552-a10d-4a31-a438-f8736fd84277" providerId="ADAL" clId="{56835480-2BB5-4545-A32E-6CA68AA69734}" dt="2021-09-13T04:02:43.284" v="1988" actId="1036"/>
          <ac:spMkLst>
            <pc:docMk/>
            <pc:sldMk cId="187938002" sldId="3307"/>
            <ac:spMk id="44" creationId="{CA11516F-B663-47F7-9CB4-6E1B18A2CB7D}"/>
          </ac:spMkLst>
        </pc:spChg>
        <pc:spChg chg="mod">
          <ac:chgData name="Grace Lee" userId="fd145552-a10d-4a31-a438-f8736fd84277" providerId="ADAL" clId="{56835480-2BB5-4545-A32E-6CA68AA69734}" dt="2021-09-13T04:49:41.995" v="2637" actId="1076"/>
          <ac:spMkLst>
            <pc:docMk/>
            <pc:sldMk cId="187938002" sldId="3307"/>
            <ac:spMk id="45" creationId="{D5C3ED16-AD74-42CC-ABF5-155637BC7D6C}"/>
          </ac:spMkLst>
        </pc:spChg>
        <pc:spChg chg="add del mod">
          <ac:chgData name="Grace Lee" userId="fd145552-a10d-4a31-a438-f8736fd84277" providerId="ADAL" clId="{56835480-2BB5-4545-A32E-6CA68AA69734}" dt="2021-09-13T04:02:43.284" v="1988" actId="1036"/>
          <ac:spMkLst>
            <pc:docMk/>
            <pc:sldMk cId="187938002" sldId="3307"/>
            <ac:spMk id="46" creationId="{5958ABF2-247D-4ED1-82D8-E5A51F47A351}"/>
          </ac:spMkLst>
        </pc:spChg>
        <pc:spChg chg="add mod">
          <ac:chgData name="Grace Lee" userId="fd145552-a10d-4a31-a438-f8736fd84277" providerId="ADAL" clId="{56835480-2BB5-4545-A32E-6CA68AA69734}" dt="2021-09-13T04:02:43.284" v="1988" actId="1036"/>
          <ac:spMkLst>
            <pc:docMk/>
            <pc:sldMk cId="187938002" sldId="3307"/>
            <ac:spMk id="47" creationId="{0AF9B300-DEB3-4E6E-83FA-5563CD638822}"/>
          </ac:spMkLst>
        </pc:spChg>
        <pc:spChg chg="mod">
          <ac:chgData name="Grace Lee" userId="fd145552-a10d-4a31-a438-f8736fd84277" providerId="ADAL" clId="{56835480-2BB5-4545-A32E-6CA68AA69734}" dt="2021-09-13T04:02:43.284" v="1988" actId="1036"/>
          <ac:spMkLst>
            <pc:docMk/>
            <pc:sldMk cId="187938002" sldId="3307"/>
            <ac:spMk id="48" creationId="{CE1789F8-D90A-417B-B724-1C8CC2CAB633}"/>
          </ac:spMkLst>
        </pc:spChg>
        <pc:spChg chg="add del mod">
          <ac:chgData name="Grace Lee" userId="fd145552-a10d-4a31-a438-f8736fd84277" providerId="ADAL" clId="{56835480-2BB5-4545-A32E-6CA68AA69734}" dt="2021-09-13T01:59:04.454" v="771" actId="478"/>
          <ac:spMkLst>
            <pc:docMk/>
            <pc:sldMk cId="187938002" sldId="3307"/>
            <ac:spMk id="49" creationId="{2EE3184B-6BDE-4E29-A888-F5BB31A1B7CE}"/>
          </ac:spMkLst>
        </pc:spChg>
        <pc:spChg chg="add mod">
          <ac:chgData name="Grace Lee" userId="fd145552-a10d-4a31-a438-f8736fd84277" providerId="ADAL" clId="{56835480-2BB5-4545-A32E-6CA68AA69734}" dt="2021-09-13T04:02:43.284" v="1988" actId="1036"/>
          <ac:spMkLst>
            <pc:docMk/>
            <pc:sldMk cId="187938002" sldId="3307"/>
            <ac:spMk id="50" creationId="{A31F744C-0128-46AD-AC4B-4B41C48CEDF0}"/>
          </ac:spMkLst>
        </pc:spChg>
        <pc:spChg chg="add del mod">
          <ac:chgData name="Grace Lee" userId="fd145552-a10d-4a31-a438-f8736fd84277" providerId="ADAL" clId="{56835480-2BB5-4545-A32E-6CA68AA69734}" dt="2021-09-13T04:02:43.284" v="1988" actId="1036"/>
          <ac:spMkLst>
            <pc:docMk/>
            <pc:sldMk cId="187938002" sldId="3307"/>
            <ac:spMk id="51" creationId="{5D5FCFB2-456C-406F-8954-FD516F8433CE}"/>
          </ac:spMkLst>
        </pc:spChg>
        <pc:spChg chg="mod">
          <ac:chgData name="Grace Lee" userId="fd145552-a10d-4a31-a438-f8736fd84277" providerId="ADAL" clId="{56835480-2BB5-4545-A32E-6CA68AA69734}" dt="2021-09-13T04:02:43.284" v="1988" actId="1036"/>
          <ac:spMkLst>
            <pc:docMk/>
            <pc:sldMk cId="187938002" sldId="3307"/>
            <ac:spMk id="52" creationId="{D3911288-5557-40BC-9242-7FB0F239B2D3}"/>
          </ac:spMkLst>
        </pc:spChg>
        <pc:spChg chg="mod">
          <ac:chgData name="Grace Lee" userId="fd145552-a10d-4a31-a438-f8736fd84277" providerId="ADAL" clId="{56835480-2BB5-4545-A32E-6CA68AA69734}" dt="2021-09-13T04:02:43.284" v="1988" actId="1036"/>
          <ac:spMkLst>
            <pc:docMk/>
            <pc:sldMk cId="187938002" sldId="3307"/>
            <ac:spMk id="53" creationId="{E2049701-CA4D-4E98-BAB8-A7EFF1DDA945}"/>
          </ac:spMkLst>
        </pc:spChg>
        <pc:spChg chg="mod">
          <ac:chgData name="Grace Lee" userId="fd145552-a10d-4a31-a438-f8736fd84277" providerId="ADAL" clId="{56835480-2BB5-4545-A32E-6CA68AA69734}" dt="2021-09-13T04:02:43.284" v="1988" actId="1036"/>
          <ac:spMkLst>
            <pc:docMk/>
            <pc:sldMk cId="187938002" sldId="3307"/>
            <ac:spMk id="54" creationId="{B2962D8F-D897-4E77-BEF6-A9EB62576127}"/>
          </ac:spMkLst>
        </pc:spChg>
        <pc:spChg chg="add del mod">
          <ac:chgData name="Grace Lee" userId="fd145552-a10d-4a31-a438-f8736fd84277" providerId="ADAL" clId="{56835480-2BB5-4545-A32E-6CA68AA69734}" dt="2021-09-13T02:07:41.221" v="930" actId="478"/>
          <ac:spMkLst>
            <pc:docMk/>
            <pc:sldMk cId="187938002" sldId="3307"/>
            <ac:spMk id="55" creationId="{A0550490-56F0-4F5C-8528-43F28EB9EEA9}"/>
          </ac:spMkLst>
        </pc:spChg>
        <pc:spChg chg="add del mod">
          <ac:chgData name="Grace Lee" userId="fd145552-a10d-4a31-a438-f8736fd84277" providerId="ADAL" clId="{56835480-2BB5-4545-A32E-6CA68AA69734}" dt="2021-09-13T02:07:40.846" v="929" actId="478"/>
          <ac:spMkLst>
            <pc:docMk/>
            <pc:sldMk cId="187938002" sldId="3307"/>
            <ac:spMk id="56" creationId="{AC1541AE-5D0A-463A-8585-6E950FE6CFFB}"/>
          </ac:spMkLst>
        </pc:spChg>
        <pc:spChg chg="mod">
          <ac:chgData name="Grace Lee" userId="fd145552-a10d-4a31-a438-f8736fd84277" providerId="ADAL" clId="{56835480-2BB5-4545-A32E-6CA68AA69734}" dt="2021-09-13T04:02:43.284" v="1988" actId="1036"/>
          <ac:spMkLst>
            <pc:docMk/>
            <pc:sldMk cId="187938002" sldId="3307"/>
            <ac:spMk id="57" creationId="{FA2A4811-CACA-468B-8ADF-7842C0823E64}"/>
          </ac:spMkLst>
        </pc:spChg>
        <pc:spChg chg="add del mod">
          <ac:chgData name="Grace Lee" userId="fd145552-a10d-4a31-a438-f8736fd84277" providerId="ADAL" clId="{56835480-2BB5-4545-A32E-6CA68AA69734}" dt="2021-09-13T02:07:42.660" v="932" actId="478"/>
          <ac:spMkLst>
            <pc:docMk/>
            <pc:sldMk cId="187938002" sldId="3307"/>
            <ac:spMk id="58" creationId="{C1C88E44-1D59-4E38-B335-36B455BFAB81}"/>
          </ac:spMkLst>
        </pc:spChg>
        <pc:spChg chg="add del mod">
          <ac:chgData name="Grace Lee" userId="fd145552-a10d-4a31-a438-f8736fd84277" providerId="ADAL" clId="{56835480-2BB5-4545-A32E-6CA68AA69734}" dt="2021-09-13T02:07:42.270" v="931" actId="478"/>
          <ac:spMkLst>
            <pc:docMk/>
            <pc:sldMk cId="187938002" sldId="3307"/>
            <ac:spMk id="59" creationId="{9CD1996C-0861-4B7D-B477-A42001808AE9}"/>
          </ac:spMkLst>
        </pc:spChg>
        <pc:spChg chg="add del mod">
          <ac:chgData name="Grace Lee" userId="fd145552-a10d-4a31-a438-f8736fd84277" providerId="ADAL" clId="{56835480-2BB5-4545-A32E-6CA68AA69734}" dt="2021-09-13T02:07:43.726" v="934" actId="478"/>
          <ac:spMkLst>
            <pc:docMk/>
            <pc:sldMk cId="187938002" sldId="3307"/>
            <ac:spMk id="60" creationId="{3824A004-30B5-46DC-9822-6E30432D8D84}"/>
          </ac:spMkLst>
        </pc:spChg>
        <pc:spChg chg="add del mod">
          <ac:chgData name="Grace Lee" userId="fd145552-a10d-4a31-a438-f8736fd84277" providerId="ADAL" clId="{56835480-2BB5-4545-A32E-6CA68AA69734}" dt="2021-09-13T02:07:43.333" v="933" actId="478"/>
          <ac:spMkLst>
            <pc:docMk/>
            <pc:sldMk cId="187938002" sldId="3307"/>
            <ac:spMk id="61" creationId="{48E00AC3-5240-40CC-9C61-25D24070E933}"/>
          </ac:spMkLst>
        </pc:spChg>
        <pc:spChg chg="add del mod">
          <ac:chgData name="Grace Lee" userId="fd145552-a10d-4a31-a438-f8736fd84277" providerId="ADAL" clId="{56835480-2BB5-4545-A32E-6CA68AA69734}" dt="2021-09-13T01:58:15.241" v="705" actId="478"/>
          <ac:spMkLst>
            <pc:docMk/>
            <pc:sldMk cId="187938002" sldId="3307"/>
            <ac:spMk id="62" creationId="{600A1A08-DC28-4579-898C-0A18C498799E}"/>
          </ac:spMkLst>
        </pc:spChg>
        <pc:spChg chg="mod">
          <ac:chgData name="Grace Lee" userId="fd145552-a10d-4a31-a438-f8736fd84277" providerId="ADAL" clId="{56835480-2BB5-4545-A32E-6CA68AA69734}" dt="2021-09-13T04:02:43.284" v="1988" actId="1036"/>
          <ac:spMkLst>
            <pc:docMk/>
            <pc:sldMk cId="187938002" sldId="3307"/>
            <ac:spMk id="63" creationId="{A6CF363A-5E67-471D-96A1-BB99C4BF1B28}"/>
          </ac:spMkLst>
        </pc:spChg>
        <pc:spChg chg="mod">
          <ac:chgData name="Grace Lee" userId="fd145552-a10d-4a31-a438-f8736fd84277" providerId="ADAL" clId="{56835480-2BB5-4545-A32E-6CA68AA69734}" dt="2021-09-13T04:02:43.284" v="1988" actId="1036"/>
          <ac:spMkLst>
            <pc:docMk/>
            <pc:sldMk cId="187938002" sldId="3307"/>
            <ac:spMk id="64" creationId="{BAC3AD93-4EBD-4BE0-8DE9-83249CB83F1C}"/>
          </ac:spMkLst>
        </pc:spChg>
        <pc:spChg chg="add del mod">
          <ac:chgData name="Grace Lee" userId="fd145552-a10d-4a31-a438-f8736fd84277" providerId="ADAL" clId="{56835480-2BB5-4545-A32E-6CA68AA69734}" dt="2021-09-13T01:58:16.337" v="706" actId="478"/>
          <ac:spMkLst>
            <pc:docMk/>
            <pc:sldMk cId="187938002" sldId="3307"/>
            <ac:spMk id="65" creationId="{3DC1820B-3C85-4921-9F53-F9CC5BFC95C5}"/>
          </ac:spMkLst>
        </pc:spChg>
        <pc:spChg chg="add mod">
          <ac:chgData name="Grace Lee" userId="fd145552-a10d-4a31-a438-f8736fd84277" providerId="ADAL" clId="{56835480-2BB5-4545-A32E-6CA68AA69734}" dt="2021-09-13T02:25:57.888" v="1183" actId="571"/>
          <ac:spMkLst>
            <pc:docMk/>
            <pc:sldMk cId="187938002" sldId="3307"/>
            <ac:spMk id="65" creationId="{D49E510E-F89C-4380-A50D-C49AC71E71F8}"/>
          </ac:spMkLst>
        </pc:spChg>
        <pc:spChg chg="add del">
          <ac:chgData name="Grace Lee" userId="fd145552-a10d-4a31-a438-f8736fd84277" providerId="ADAL" clId="{56835480-2BB5-4545-A32E-6CA68AA69734}" dt="2021-09-13T02:31:32.449" v="1254" actId="22"/>
          <ac:spMkLst>
            <pc:docMk/>
            <pc:sldMk cId="187938002" sldId="3307"/>
            <ac:spMk id="66" creationId="{0C61F371-D137-48B6-A69B-9F3BBCCFA232}"/>
          </ac:spMkLst>
        </pc:spChg>
        <pc:spChg chg="add del mod">
          <ac:chgData name="Grace Lee" userId="fd145552-a10d-4a31-a438-f8736fd84277" providerId="ADAL" clId="{56835480-2BB5-4545-A32E-6CA68AA69734}" dt="2021-09-13T02:07:45.388" v="937" actId="478"/>
          <ac:spMkLst>
            <pc:docMk/>
            <pc:sldMk cId="187938002" sldId="3307"/>
            <ac:spMk id="66" creationId="{16CAD0E0-8A08-4DDA-93F9-EED1154C5187}"/>
          </ac:spMkLst>
        </pc:spChg>
        <pc:spChg chg="add del">
          <ac:chgData name="Grace Lee" userId="fd145552-a10d-4a31-a438-f8736fd84277" providerId="ADAL" clId="{56835480-2BB5-4545-A32E-6CA68AA69734}" dt="2021-09-13T02:31:38.351" v="1256" actId="22"/>
          <ac:spMkLst>
            <pc:docMk/>
            <pc:sldMk cId="187938002" sldId="3307"/>
            <ac:spMk id="67" creationId="{2525CBFA-01BE-4DFF-B16B-2B4CB62FC378}"/>
          </ac:spMkLst>
        </pc:spChg>
        <pc:spChg chg="add del mod">
          <ac:chgData name="Grace Lee" userId="fd145552-a10d-4a31-a438-f8736fd84277" providerId="ADAL" clId="{56835480-2BB5-4545-A32E-6CA68AA69734}" dt="2021-09-13T02:07:45.810" v="938" actId="478"/>
          <ac:spMkLst>
            <pc:docMk/>
            <pc:sldMk cId="187938002" sldId="3307"/>
            <ac:spMk id="67" creationId="{5A056C6C-C68A-42F4-A95D-09DA257839D5}"/>
          </ac:spMkLst>
        </pc:spChg>
        <pc:spChg chg="mod">
          <ac:chgData name="Grace Lee" userId="fd145552-a10d-4a31-a438-f8736fd84277" providerId="ADAL" clId="{56835480-2BB5-4545-A32E-6CA68AA69734}" dt="2021-09-13T05:44:14.188" v="4294" actId="6549"/>
          <ac:spMkLst>
            <pc:docMk/>
            <pc:sldMk cId="187938002" sldId="3307"/>
            <ac:spMk id="68" creationId="{24FDD7D9-55CB-4156-8D71-084078C8F69F}"/>
          </ac:spMkLst>
        </pc:spChg>
        <pc:spChg chg="add mod">
          <ac:chgData name="Grace Lee" userId="fd145552-a10d-4a31-a438-f8736fd84277" providerId="ADAL" clId="{56835480-2BB5-4545-A32E-6CA68AA69734}" dt="2021-09-13T04:02:43.284" v="1988" actId="1036"/>
          <ac:spMkLst>
            <pc:docMk/>
            <pc:sldMk cId="187938002" sldId="3307"/>
            <ac:spMk id="69" creationId="{BFAA5FC3-2BF1-406E-B12D-BC8781E2E86A}"/>
          </ac:spMkLst>
        </pc:spChg>
        <pc:spChg chg="add del mod">
          <ac:chgData name="Grace Lee" userId="fd145552-a10d-4a31-a438-f8736fd84277" providerId="ADAL" clId="{56835480-2BB5-4545-A32E-6CA68AA69734}" dt="2021-09-13T02:07:44.713" v="936" actId="478"/>
          <ac:spMkLst>
            <pc:docMk/>
            <pc:sldMk cId="187938002" sldId="3307"/>
            <ac:spMk id="69" creationId="{C618BA8D-F433-44F1-8300-3B93D66883CC}"/>
          </ac:spMkLst>
        </pc:spChg>
        <pc:spChg chg="add mod">
          <ac:chgData name="Grace Lee" userId="fd145552-a10d-4a31-a438-f8736fd84277" providerId="ADAL" clId="{56835480-2BB5-4545-A32E-6CA68AA69734}" dt="2021-09-13T02:32:13.114" v="1271" actId="571"/>
          <ac:spMkLst>
            <pc:docMk/>
            <pc:sldMk cId="187938002" sldId="3307"/>
            <ac:spMk id="70" creationId="{EE3CB674-B4DC-4005-8CC1-C6B5D3161127}"/>
          </ac:spMkLst>
        </pc:spChg>
        <pc:spChg chg="add del mod">
          <ac:chgData name="Grace Lee" userId="fd145552-a10d-4a31-a438-f8736fd84277" providerId="ADAL" clId="{56835480-2BB5-4545-A32E-6CA68AA69734}" dt="2021-09-13T02:07:44.300" v="935" actId="478"/>
          <ac:spMkLst>
            <pc:docMk/>
            <pc:sldMk cId="187938002" sldId="3307"/>
            <ac:spMk id="70" creationId="{F1310F0C-B9B3-4670-B45C-CAD1C38482C7}"/>
          </ac:spMkLst>
        </pc:spChg>
        <pc:spChg chg="del">
          <ac:chgData name="Grace Lee" userId="fd145552-a10d-4a31-a438-f8736fd84277" providerId="ADAL" clId="{56835480-2BB5-4545-A32E-6CA68AA69734}" dt="2021-09-13T02:38:08.286" v="1425" actId="478"/>
          <ac:spMkLst>
            <pc:docMk/>
            <pc:sldMk cId="187938002" sldId="3307"/>
            <ac:spMk id="71" creationId="{59A92EFB-C96C-4C2A-81C5-B077FA1A8546}"/>
          </ac:spMkLst>
        </pc:spChg>
        <pc:spChg chg="add mod">
          <ac:chgData name="Grace Lee" userId="fd145552-a10d-4a31-a438-f8736fd84277" providerId="ADAL" clId="{56835480-2BB5-4545-A32E-6CA68AA69734}" dt="2021-09-13T02:32:12.608" v="1270" actId="571"/>
          <ac:spMkLst>
            <pc:docMk/>
            <pc:sldMk cId="187938002" sldId="3307"/>
            <ac:spMk id="72" creationId="{12AE8B25-0E14-4F74-9072-7D871449AADB}"/>
          </ac:spMkLst>
        </pc:spChg>
        <pc:spChg chg="add del mod">
          <ac:chgData name="Grace Lee" userId="fd145552-a10d-4a31-a438-f8736fd84277" providerId="ADAL" clId="{56835480-2BB5-4545-A32E-6CA68AA69734}" dt="2021-09-13T01:57:09.807" v="594" actId="478"/>
          <ac:spMkLst>
            <pc:docMk/>
            <pc:sldMk cId="187938002" sldId="3307"/>
            <ac:spMk id="72" creationId="{751BB62E-CEE2-46D2-A09F-670B3CF5249F}"/>
          </ac:spMkLst>
        </pc:spChg>
        <pc:spChg chg="add del mod">
          <ac:chgData name="Grace Lee" userId="fd145552-a10d-4a31-a438-f8736fd84277" providerId="ADAL" clId="{56835480-2BB5-4545-A32E-6CA68AA69734}" dt="2021-09-13T01:57:15.074" v="595" actId="478"/>
          <ac:spMkLst>
            <pc:docMk/>
            <pc:sldMk cId="187938002" sldId="3307"/>
            <ac:spMk id="73" creationId="{B7FEB5F7-59CB-4CAA-A901-52D6915499CB}"/>
          </ac:spMkLst>
        </pc:spChg>
        <pc:spChg chg="add mod">
          <ac:chgData name="Grace Lee" userId="fd145552-a10d-4a31-a438-f8736fd84277" providerId="ADAL" clId="{56835480-2BB5-4545-A32E-6CA68AA69734}" dt="2021-09-13T04:02:43.284" v="1988" actId="1036"/>
          <ac:spMkLst>
            <pc:docMk/>
            <pc:sldMk cId="187938002" sldId="3307"/>
            <ac:spMk id="73" creationId="{D121DF87-1DBC-43CB-806F-942268B34984}"/>
          </ac:spMkLst>
        </pc:spChg>
        <pc:spChg chg="add del mod">
          <ac:chgData name="Grace Lee" userId="fd145552-a10d-4a31-a438-f8736fd84277" providerId="ADAL" clId="{56835480-2BB5-4545-A32E-6CA68AA69734}" dt="2021-09-13T02:38:15.875" v="1430" actId="478"/>
          <ac:spMkLst>
            <pc:docMk/>
            <pc:sldMk cId="187938002" sldId="3307"/>
            <ac:spMk id="74" creationId="{555D9C6F-872B-4D29-BBCD-5691E6FE745D}"/>
          </ac:spMkLst>
        </pc:spChg>
        <pc:spChg chg="add del mod">
          <ac:chgData name="Grace Lee" userId="fd145552-a10d-4a31-a438-f8736fd84277" providerId="ADAL" clId="{56835480-2BB5-4545-A32E-6CA68AA69734}" dt="2021-09-13T02:45:57.453" v="1437" actId="478"/>
          <ac:spMkLst>
            <pc:docMk/>
            <pc:sldMk cId="187938002" sldId="3307"/>
            <ac:spMk id="75" creationId="{030542CF-756B-449D-B431-4F6BE9B49272}"/>
          </ac:spMkLst>
        </pc:spChg>
        <pc:spChg chg="add del mod">
          <ac:chgData name="Grace Lee" userId="fd145552-a10d-4a31-a438-f8736fd84277" providerId="ADAL" clId="{56835480-2BB5-4545-A32E-6CA68AA69734}" dt="2021-09-13T02:05:09.413" v="859" actId="478"/>
          <ac:spMkLst>
            <pc:docMk/>
            <pc:sldMk cId="187938002" sldId="3307"/>
            <ac:spMk id="75" creationId="{AE1F5512-7472-4293-AEAC-517937640029}"/>
          </ac:spMkLst>
        </pc:spChg>
        <pc:spChg chg="add del mod">
          <ac:chgData name="Grace Lee" userId="fd145552-a10d-4a31-a438-f8736fd84277" providerId="ADAL" clId="{56835480-2BB5-4545-A32E-6CA68AA69734}" dt="2021-09-13T02:05:08.864" v="858" actId="478"/>
          <ac:spMkLst>
            <pc:docMk/>
            <pc:sldMk cId="187938002" sldId="3307"/>
            <ac:spMk id="76" creationId="{4B679F17-8795-46B9-908F-C471AFF0B3D5}"/>
          </ac:spMkLst>
        </pc:spChg>
        <pc:spChg chg="add mod">
          <ac:chgData name="Grace Lee" userId="fd145552-a10d-4a31-a438-f8736fd84277" providerId="ADAL" clId="{56835480-2BB5-4545-A32E-6CA68AA69734}" dt="2021-09-13T04:02:43.284" v="1988" actId="1036"/>
          <ac:spMkLst>
            <pc:docMk/>
            <pc:sldMk cId="187938002" sldId="3307"/>
            <ac:spMk id="76" creationId="{506AA956-83B2-49A7-BBEF-2B6AC420A805}"/>
          </ac:spMkLst>
        </pc:spChg>
        <pc:spChg chg="add del mod">
          <ac:chgData name="Grace Lee" userId="fd145552-a10d-4a31-a438-f8736fd84277" providerId="ADAL" clId="{56835480-2BB5-4545-A32E-6CA68AA69734}" dt="2021-09-13T02:05:08.367" v="857" actId="478"/>
          <ac:spMkLst>
            <pc:docMk/>
            <pc:sldMk cId="187938002" sldId="3307"/>
            <ac:spMk id="77" creationId="{403B9B0C-818D-4DB1-AFCF-1A05B0380BA8}"/>
          </ac:spMkLst>
        </pc:spChg>
        <pc:spChg chg="add mod">
          <ac:chgData name="Grace Lee" userId="fd145552-a10d-4a31-a438-f8736fd84277" providerId="ADAL" clId="{56835480-2BB5-4545-A32E-6CA68AA69734}" dt="2021-09-13T04:02:43.284" v="1988" actId="1036"/>
          <ac:spMkLst>
            <pc:docMk/>
            <pc:sldMk cId="187938002" sldId="3307"/>
            <ac:spMk id="77" creationId="{C61E376B-77C1-409B-83EB-264467C1DB14}"/>
          </ac:spMkLst>
        </pc:spChg>
        <pc:spChg chg="add del mod">
          <ac:chgData name="Grace Lee" userId="fd145552-a10d-4a31-a438-f8736fd84277" providerId="ADAL" clId="{56835480-2BB5-4545-A32E-6CA68AA69734}" dt="2021-09-13T02:05:07.059" v="856" actId="478"/>
          <ac:spMkLst>
            <pc:docMk/>
            <pc:sldMk cId="187938002" sldId="3307"/>
            <ac:spMk id="78" creationId="{04C6AD0B-604E-4CAF-B6CA-7DF35DA53ED1}"/>
          </ac:spMkLst>
        </pc:spChg>
        <pc:spChg chg="add mod">
          <ac:chgData name="Grace Lee" userId="fd145552-a10d-4a31-a438-f8736fd84277" providerId="ADAL" clId="{56835480-2BB5-4545-A32E-6CA68AA69734}" dt="2021-09-13T04:02:43.284" v="1988" actId="1036"/>
          <ac:spMkLst>
            <pc:docMk/>
            <pc:sldMk cId="187938002" sldId="3307"/>
            <ac:spMk id="78" creationId="{C9330A01-3CCE-4132-8472-47F2722AF91D}"/>
          </ac:spMkLst>
        </pc:spChg>
        <pc:spChg chg="add mod">
          <ac:chgData name="Grace Lee" userId="fd145552-a10d-4a31-a438-f8736fd84277" providerId="ADAL" clId="{56835480-2BB5-4545-A32E-6CA68AA69734}" dt="2021-09-13T04:28:22.926" v="2546" actId="1076"/>
          <ac:spMkLst>
            <pc:docMk/>
            <pc:sldMk cId="187938002" sldId="3307"/>
            <ac:spMk id="79" creationId="{82502245-459B-47CB-B032-0F07547370D2}"/>
          </ac:spMkLst>
        </pc:spChg>
        <pc:spChg chg="add del mod">
          <ac:chgData name="Grace Lee" userId="fd145552-a10d-4a31-a438-f8736fd84277" providerId="ADAL" clId="{56835480-2BB5-4545-A32E-6CA68AA69734}" dt="2021-09-13T02:05:16.663" v="863" actId="478"/>
          <ac:spMkLst>
            <pc:docMk/>
            <pc:sldMk cId="187938002" sldId="3307"/>
            <ac:spMk id="79" creationId="{F775F792-5295-41D7-B067-8BCEC6C3A093}"/>
          </ac:spMkLst>
        </pc:spChg>
        <pc:spChg chg="mod">
          <ac:chgData name="Grace Lee" userId="fd145552-a10d-4a31-a438-f8736fd84277" providerId="ADAL" clId="{56835480-2BB5-4545-A32E-6CA68AA69734}" dt="2021-09-13T04:02:43.284" v="1988" actId="1036"/>
          <ac:spMkLst>
            <pc:docMk/>
            <pc:sldMk cId="187938002" sldId="3307"/>
            <ac:spMk id="80" creationId="{85C8FBD3-427E-438E-8EEA-2643D9F29E92}"/>
          </ac:spMkLst>
        </pc:spChg>
        <pc:spChg chg="add mod">
          <ac:chgData name="Grace Lee" userId="fd145552-a10d-4a31-a438-f8736fd84277" providerId="ADAL" clId="{56835480-2BB5-4545-A32E-6CA68AA69734}" dt="2021-09-13T04:02:43.284" v="1988" actId="1036"/>
          <ac:spMkLst>
            <pc:docMk/>
            <pc:sldMk cId="187938002" sldId="3307"/>
            <ac:spMk id="81" creationId="{1970C673-2FFB-4BB5-B716-E360AD1E5706}"/>
          </ac:spMkLst>
        </pc:spChg>
        <pc:spChg chg="add del mod">
          <ac:chgData name="Grace Lee" userId="fd145552-a10d-4a31-a438-f8736fd84277" providerId="ADAL" clId="{56835480-2BB5-4545-A32E-6CA68AA69734}" dt="2021-09-13T02:05:40.840" v="876" actId="478"/>
          <ac:spMkLst>
            <pc:docMk/>
            <pc:sldMk cId="187938002" sldId="3307"/>
            <ac:spMk id="81" creationId="{EAC41232-A167-4C1C-93BC-4A5E74E3EF5D}"/>
          </ac:spMkLst>
        </pc:spChg>
        <pc:spChg chg="add del mod">
          <ac:chgData name="Grace Lee" userId="fd145552-a10d-4a31-a438-f8736fd84277" providerId="ADAL" clId="{56835480-2BB5-4545-A32E-6CA68AA69734}" dt="2021-09-13T02:46:32.673" v="1446" actId="478"/>
          <ac:spMkLst>
            <pc:docMk/>
            <pc:sldMk cId="187938002" sldId="3307"/>
            <ac:spMk id="82" creationId="{425A23D7-0FDC-43EE-980E-256941EA3E3B}"/>
          </ac:spMkLst>
        </pc:spChg>
        <pc:spChg chg="add del mod">
          <ac:chgData name="Grace Lee" userId="fd145552-a10d-4a31-a438-f8736fd84277" providerId="ADAL" clId="{56835480-2BB5-4545-A32E-6CA68AA69734}" dt="2021-09-13T02:05:40.392" v="875" actId="478"/>
          <ac:spMkLst>
            <pc:docMk/>
            <pc:sldMk cId="187938002" sldId="3307"/>
            <ac:spMk id="82" creationId="{47109CFF-BF7C-47CA-8E31-10C7B77E03FD}"/>
          </ac:spMkLst>
        </pc:spChg>
        <pc:spChg chg="add del mod">
          <ac:chgData name="Grace Lee" userId="fd145552-a10d-4a31-a438-f8736fd84277" providerId="ADAL" clId="{56835480-2BB5-4545-A32E-6CA68AA69734}" dt="2021-09-13T02:05:39.914" v="874" actId="478"/>
          <ac:spMkLst>
            <pc:docMk/>
            <pc:sldMk cId="187938002" sldId="3307"/>
            <ac:spMk id="83" creationId="{2E3BFC7C-9C02-4162-8483-3DEB5DE4EC31}"/>
          </ac:spMkLst>
        </pc:spChg>
        <pc:spChg chg="add mod">
          <ac:chgData name="Grace Lee" userId="fd145552-a10d-4a31-a438-f8736fd84277" providerId="ADAL" clId="{56835480-2BB5-4545-A32E-6CA68AA69734}" dt="2021-09-13T04:04:45.315" v="2069" actId="14100"/>
          <ac:spMkLst>
            <pc:docMk/>
            <pc:sldMk cId="187938002" sldId="3307"/>
            <ac:spMk id="83" creationId="{6CF9FFEC-7EC9-49CF-8EBB-91285658E3D3}"/>
          </ac:spMkLst>
        </pc:spChg>
        <pc:spChg chg="add del mod">
          <ac:chgData name="Grace Lee" userId="fd145552-a10d-4a31-a438-f8736fd84277" providerId="ADAL" clId="{56835480-2BB5-4545-A32E-6CA68AA69734}" dt="2021-09-13T02:05:39.430" v="873" actId="478"/>
          <ac:spMkLst>
            <pc:docMk/>
            <pc:sldMk cId="187938002" sldId="3307"/>
            <ac:spMk id="84" creationId="{21E7F069-409D-4FF0-A8C5-5386F1CDCEFD}"/>
          </ac:spMkLst>
        </pc:spChg>
        <pc:spChg chg="add del mod">
          <ac:chgData name="Grace Lee" userId="fd145552-a10d-4a31-a438-f8736fd84277" providerId="ADAL" clId="{56835480-2BB5-4545-A32E-6CA68AA69734}" dt="2021-09-13T02:46:58.798" v="1452" actId="478"/>
          <ac:spMkLst>
            <pc:docMk/>
            <pc:sldMk cId="187938002" sldId="3307"/>
            <ac:spMk id="84" creationId="{AA8BE8B5-8456-4D48-A05C-FD29F9016141}"/>
          </ac:spMkLst>
        </pc:spChg>
        <pc:spChg chg="add del mod">
          <ac:chgData name="Grace Lee" userId="fd145552-a10d-4a31-a438-f8736fd84277" providerId="ADAL" clId="{56835480-2BB5-4545-A32E-6CA68AA69734}" dt="2021-09-13T02:46:37.953" v="1447" actId="478"/>
          <ac:spMkLst>
            <pc:docMk/>
            <pc:sldMk cId="187938002" sldId="3307"/>
            <ac:spMk id="85" creationId="{342232DA-90DD-40F9-A9EE-E605D17BA965}"/>
          </ac:spMkLst>
        </pc:spChg>
        <pc:spChg chg="add del mod">
          <ac:chgData name="Grace Lee" userId="fd145552-a10d-4a31-a438-f8736fd84277" providerId="ADAL" clId="{56835480-2BB5-4545-A32E-6CA68AA69734}" dt="2021-09-13T02:05:44.554" v="880" actId="478"/>
          <ac:spMkLst>
            <pc:docMk/>
            <pc:sldMk cId="187938002" sldId="3307"/>
            <ac:spMk id="85" creationId="{857DD07A-D945-4D7C-BA5D-EF8727D20A8B}"/>
          </ac:spMkLst>
        </pc:spChg>
        <pc:spChg chg="add del mod">
          <ac:chgData name="Grace Lee" userId="fd145552-a10d-4a31-a438-f8736fd84277" providerId="ADAL" clId="{56835480-2BB5-4545-A32E-6CA68AA69734}" dt="2021-09-13T02:46:37.953" v="1447" actId="478"/>
          <ac:spMkLst>
            <pc:docMk/>
            <pc:sldMk cId="187938002" sldId="3307"/>
            <ac:spMk id="86" creationId="{96C2A4A8-1A80-422C-B489-564D1DE712DE}"/>
          </ac:spMkLst>
        </pc:spChg>
        <pc:spChg chg="add del mod">
          <ac:chgData name="Grace Lee" userId="fd145552-a10d-4a31-a438-f8736fd84277" providerId="ADAL" clId="{56835480-2BB5-4545-A32E-6CA68AA69734}" dt="2021-09-13T02:06:03.932" v="892" actId="478"/>
          <ac:spMkLst>
            <pc:docMk/>
            <pc:sldMk cId="187938002" sldId="3307"/>
            <ac:spMk id="86" creationId="{EAA4FA73-5E5D-4202-9B65-04113A88D156}"/>
          </ac:spMkLst>
        </pc:spChg>
        <pc:spChg chg="add del mod">
          <ac:chgData name="Grace Lee" userId="fd145552-a10d-4a31-a438-f8736fd84277" providerId="ADAL" clId="{56835480-2BB5-4545-A32E-6CA68AA69734}" dt="2021-09-13T02:46:40.534" v="1448" actId="478"/>
          <ac:spMkLst>
            <pc:docMk/>
            <pc:sldMk cId="187938002" sldId="3307"/>
            <ac:spMk id="87" creationId="{06804E67-84B8-437C-8AF3-D09D95C0CABD}"/>
          </ac:spMkLst>
        </pc:spChg>
        <pc:spChg chg="add del mod">
          <ac:chgData name="Grace Lee" userId="fd145552-a10d-4a31-a438-f8736fd84277" providerId="ADAL" clId="{56835480-2BB5-4545-A32E-6CA68AA69734}" dt="2021-09-13T02:06:01.671" v="891" actId="478"/>
          <ac:spMkLst>
            <pc:docMk/>
            <pc:sldMk cId="187938002" sldId="3307"/>
            <ac:spMk id="87" creationId="{C5506D96-AC67-4C1C-9E98-5C2165E8AC1E}"/>
          </ac:spMkLst>
        </pc:spChg>
        <pc:spChg chg="add del mod">
          <ac:chgData name="Grace Lee" userId="fd145552-a10d-4a31-a438-f8736fd84277" providerId="ADAL" clId="{56835480-2BB5-4545-A32E-6CA68AA69734}" dt="2021-09-13T02:46:40.534" v="1448" actId="478"/>
          <ac:spMkLst>
            <pc:docMk/>
            <pc:sldMk cId="187938002" sldId="3307"/>
            <ac:spMk id="88" creationId="{3D628844-8C40-4A21-A5BD-E50CF2113BC6}"/>
          </ac:spMkLst>
        </pc:spChg>
        <pc:spChg chg="add del mod">
          <ac:chgData name="Grace Lee" userId="fd145552-a10d-4a31-a438-f8736fd84277" providerId="ADAL" clId="{56835480-2BB5-4545-A32E-6CA68AA69734}" dt="2021-09-13T02:06:01.197" v="890" actId="478"/>
          <ac:spMkLst>
            <pc:docMk/>
            <pc:sldMk cId="187938002" sldId="3307"/>
            <ac:spMk id="88" creationId="{5E8178CE-4783-47F9-8982-32EA90D4DEA9}"/>
          </ac:spMkLst>
        </pc:spChg>
        <pc:spChg chg="add del mod">
          <ac:chgData name="Grace Lee" userId="fd145552-a10d-4a31-a438-f8736fd84277" providerId="ADAL" clId="{56835480-2BB5-4545-A32E-6CA68AA69734}" dt="2021-09-13T02:06:00.649" v="889" actId="478"/>
          <ac:spMkLst>
            <pc:docMk/>
            <pc:sldMk cId="187938002" sldId="3307"/>
            <ac:spMk id="89" creationId="{476D3AFB-1E27-4EF6-9BEC-17E5FF279CC0}"/>
          </ac:spMkLst>
        </pc:spChg>
        <pc:spChg chg="add del mod">
          <ac:chgData name="Grace Lee" userId="fd145552-a10d-4a31-a438-f8736fd84277" providerId="ADAL" clId="{56835480-2BB5-4545-A32E-6CA68AA69734}" dt="2021-09-13T02:46:40.534" v="1448" actId="478"/>
          <ac:spMkLst>
            <pc:docMk/>
            <pc:sldMk cId="187938002" sldId="3307"/>
            <ac:spMk id="89" creationId="{81625B26-20AC-4DF2-BAD4-CDC618F5B11E}"/>
          </ac:spMkLst>
        </pc:spChg>
        <pc:spChg chg="add del mod">
          <ac:chgData name="Grace Lee" userId="fd145552-a10d-4a31-a438-f8736fd84277" providerId="ADAL" clId="{56835480-2BB5-4545-A32E-6CA68AA69734}" dt="2021-09-13T02:46:51.415" v="1450" actId="478"/>
          <ac:spMkLst>
            <pc:docMk/>
            <pc:sldMk cId="187938002" sldId="3307"/>
            <ac:spMk id="90" creationId="{253DC599-FF2A-4932-B130-E81752ACA472}"/>
          </ac:spMkLst>
        </pc:spChg>
        <pc:spChg chg="add del mod">
          <ac:chgData name="Grace Lee" userId="fd145552-a10d-4a31-a438-f8736fd84277" providerId="ADAL" clId="{56835480-2BB5-4545-A32E-6CA68AA69734}" dt="2021-09-13T02:06:10.704" v="896" actId="478"/>
          <ac:spMkLst>
            <pc:docMk/>
            <pc:sldMk cId="187938002" sldId="3307"/>
            <ac:spMk id="90" creationId="{25E5A879-3644-4209-8521-5B0B52B32581}"/>
          </ac:spMkLst>
        </pc:spChg>
        <pc:spChg chg="add del mod">
          <ac:chgData name="Grace Lee" userId="fd145552-a10d-4a31-a438-f8736fd84277" providerId="ADAL" clId="{56835480-2BB5-4545-A32E-6CA68AA69734}" dt="2021-09-13T02:38:13.536" v="1429" actId="478"/>
          <ac:spMkLst>
            <pc:docMk/>
            <pc:sldMk cId="187938002" sldId="3307"/>
            <ac:spMk id="91" creationId="{83C49B92-4AE1-42D2-8E6D-BD5B17EAFBAC}"/>
          </ac:spMkLst>
        </pc:spChg>
        <pc:spChg chg="add del mod">
          <ac:chgData name="Grace Lee" userId="fd145552-a10d-4a31-a438-f8736fd84277" providerId="ADAL" clId="{56835480-2BB5-4545-A32E-6CA68AA69734}" dt="2021-09-13T02:38:12.394" v="1428" actId="478"/>
          <ac:spMkLst>
            <pc:docMk/>
            <pc:sldMk cId="187938002" sldId="3307"/>
            <ac:spMk id="92" creationId="{B997895C-5106-4137-BAC1-0ACBBD810BD4}"/>
          </ac:spMkLst>
        </pc:spChg>
        <pc:spChg chg="mod">
          <ac:chgData name="Grace Lee" userId="fd145552-a10d-4a31-a438-f8736fd84277" providerId="ADAL" clId="{56835480-2BB5-4545-A32E-6CA68AA69734}" dt="2021-09-13T04:02:43.284" v="1988" actId="1036"/>
          <ac:spMkLst>
            <pc:docMk/>
            <pc:sldMk cId="187938002" sldId="3307"/>
            <ac:spMk id="93" creationId="{BF9A3230-00EC-4629-977A-A8CCE79ACC91}"/>
          </ac:spMkLst>
        </pc:spChg>
        <pc:spChg chg="add del mod">
          <ac:chgData name="Grace Lee" userId="fd145552-a10d-4a31-a438-f8736fd84277" providerId="ADAL" clId="{56835480-2BB5-4545-A32E-6CA68AA69734}" dt="2021-09-13T02:38:11.047" v="1427" actId="478"/>
          <ac:spMkLst>
            <pc:docMk/>
            <pc:sldMk cId="187938002" sldId="3307"/>
            <ac:spMk id="94" creationId="{099FC928-4747-47F4-A3F8-70DD7924DAA3}"/>
          </ac:spMkLst>
        </pc:spChg>
        <pc:spChg chg="add del mod">
          <ac:chgData name="Grace Lee" userId="fd145552-a10d-4a31-a438-f8736fd84277" providerId="ADAL" clId="{56835480-2BB5-4545-A32E-6CA68AA69734}" dt="2021-09-13T02:38:09.838" v="1426" actId="478"/>
          <ac:spMkLst>
            <pc:docMk/>
            <pc:sldMk cId="187938002" sldId="3307"/>
            <ac:spMk id="95" creationId="{9D0764B2-1FD0-4312-9078-C1AEE17C9E23}"/>
          </ac:spMkLst>
        </pc:spChg>
        <pc:spChg chg="add mod">
          <ac:chgData name="Grace Lee" userId="fd145552-a10d-4a31-a438-f8736fd84277" providerId="ADAL" clId="{56835480-2BB5-4545-A32E-6CA68AA69734}" dt="2021-09-13T04:11:21.280" v="2116" actId="1035"/>
          <ac:spMkLst>
            <pc:docMk/>
            <pc:sldMk cId="187938002" sldId="3307"/>
            <ac:spMk id="96" creationId="{A000FC63-CB2D-4BBE-8DE3-C3D6114AF543}"/>
          </ac:spMkLst>
        </pc:spChg>
        <pc:spChg chg="add del mod">
          <ac:chgData name="Grace Lee" userId="fd145552-a10d-4a31-a438-f8736fd84277" providerId="ADAL" clId="{56835480-2BB5-4545-A32E-6CA68AA69734}" dt="2021-09-13T02:07:27.391" v="922" actId="478"/>
          <ac:spMkLst>
            <pc:docMk/>
            <pc:sldMk cId="187938002" sldId="3307"/>
            <ac:spMk id="97" creationId="{115A5CF9-CDF5-41D1-9907-534C331A54BA}"/>
          </ac:spMkLst>
        </pc:spChg>
        <pc:spChg chg="add del mod">
          <ac:chgData name="Grace Lee" userId="fd145552-a10d-4a31-a438-f8736fd84277" providerId="ADAL" clId="{56835480-2BB5-4545-A32E-6CA68AA69734}" dt="2021-09-13T02:46:28.344" v="1444" actId="478"/>
          <ac:spMkLst>
            <pc:docMk/>
            <pc:sldMk cId="187938002" sldId="3307"/>
            <ac:spMk id="97" creationId="{863B4478-DE9B-45D1-A808-1D85205DD14F}"/>
          </ac:spMkLst>
        </pc:spChg>
        <pc:spChg chg="add del mod">
          <ac:chgData name="Grace Lee" userId="fd145552-a10d-4a31-a438-f8736fd84277" providerId="ADAL" clId="{56835480-2BB5-4545-A32E-6CA68AA69734}" dt="2021-09-13T02:09:26.092" v="1099"/>
          <ac:spMkLst>
            <pc:docMk/>
            <pc:sldMk cId="187938002" sldId="3307"/>
            <ac:spMk id="98" creationId="{07EB92F1-35B7-473B-A579-F2748F9F3A41}"/>
          </ac:spMkLst>
        </pc:spChg>
        <pc:spChg chg="add del mod">
          <ac:chgData name="Grace Lee" userId="fd145552-a10d-4a31-a438-f8736fd84277" providerId="ADAL" clId="{56835480-2BB5-4545-A32E-6CA68AA69734}" dt="2021-09-13T02:46:29.646" v="1445" actId="478"/>
          <ac:spMkLst>
            <pc:docMk/>
            <pc:sldMk cId="187938002" sldId="3307"/>
            <ac:spMk id="98" creationId="{833D8FE6-7F6C-44F6-968E-903A37DEA164}"/>
          </ac:spMkLst>
        </pc:spChg>
        <pc:spChg chg="add del mod">
          <ac:chgData name="Grace Lee" userId="fd145552-a10d-4a31-a438-f8736fd84277" providerId="ADAL" clId="{56835480-2BB5-4545-A32E-6CA68AA69734}" dt="2021-09-13T02:46:56.896" v="1451" actId="478"/>
          <ac:spMkLst>
            <pc:docMk/>
            <pc:sldMk cId="187938002" sldId="3307"/>
            <ac:spMk id="99" creationId="{029D8471-ABBE-49FD-BB11-9F0F0241CF5E}"/>
          </ac:spMkLst>
        </pc:spChg>
        <pc:spChg chg="add del mod">
          <ac:chgData name="Grace Lee" userId="fd145552-a10d-4a31-a438-f8736fd84277" providerId="ADAL" clId="{56835480-2BB5-4545-A32E-6CA68AA69734}" dt="2021-09-13T02:09:26.092" v="1099"/>
          <ac:spMkLst>
            <pc:docMk/>
            <pc:sldMk cId="187938002" sldId="3307"/>
            <ac:spMk id="99" creationId="{F5E5D4A9-3893-4EA2-98D5-08496DD9DA2F}"/>
          </ac:spMkLst>
        </pc:spChg>
        <pc:spChg chg="add del mod">
          <ac:chgData name="Grace Lee" userId="fd145552-a10d-4a31-a438-f8736fd84277" providerId="ADAL" clId="{56835480-2BB5-4545-A32E-6CA68AA69734}" dt="2021-09-13T02:46:50.172" v="1449" actId="478"/>
          <ac:spMkLst>
            <pc:docMk/>
            <pc:sldMk cId="187938002" sldId="3307"/>
            <ac:spMk id="100" creationId="{DA766F8F-C16A-4B3E-8664-20A0205510C2}"/>
          </ac:spMkLst>
        </pc:spChg>
        <pc:spChg chg="add del mod">
          <ac:chgData name="Grace Lee" userId="fd145552-a10d-4a31-a438-f8736fd84277" providerId="ADAL" clId="{56835480-2BB5-4545-A32E-6CA68AA69734}" dt="2021-09-13T02:09:26.092" v="1099"/>
          <ac:spMkLst>
            <pc:docMk/>
            <pc:sldMk cId="187938002" sldId="3307"/>
            <ac:spMk id="100" creationId="{FDBCE92B-7EF4-4075-9A47-C816A01D99A8}"/>
          </ac:spMkLst>
        </pc:spChg>
        <pc:spChg chg="add del mod">
          <ac:chgData name="Grace Lee" userId="fd145552-a10d-4a31-a438-f8736fd84277" providerId="ADAL" clId="{56835480-2BB5-4545-A32E-6CA68AA69734}" dt="2021-09-13T02:46:26.989" v="1443" actId="478"/>
          <ac:spMkLst>
            <pc:docMk/>
            <pc:sldMk cId="187938002" sldId="3307"/>
            <ac:spMk id="101" creationId="{428FF143-1544-4278-B5A1-A57184A4E91A}"/>
          </ac:spMkLst>
        </pc:spChg>
        <pc:spChg chg="add del mod">
          <ac:chgData name="Grace Lee" userId="fd145552-a10d-4a31-a438-f8736fd84277" providerId="ADAL" clId="{56835480-2BB5-4545-A32E-6CA68AA69734}" dt="2021-09-13T02:09:26.092" v="1099"/>
          <ac:spMkLst>
            <pc:docMk/>
            <pc:sldMk cId="187938002" sldId="3307"/>
            <ac:spMk id="101" creationId="{4BCFBFA1-D4A6-4637-B6E8-2F9FC5A58FC1}"/>
          </ac:spMkLst>
        </pc:spChg>
        <pc:spChg chg="add del mod">
          <ac:chgData name="Grace Lee" userId="fd145552-a10d-4a31-a438-f8736fd84277" providerId="ADAL" clId="{56835480-2BB5-4545-A32E-6CA68AA69734}" dt="2021-09-13T02:46:25.476" v="1442" actId="478"/>
          <ac:spMkLst>
            <pc:docMk/>
            <pc:sldMk cId="187938002" sldId="3307"/>
            <ac:spMk id="102" creationId="{A2BB2D64-58FD-408A-A5F4-9B81ACB5270E}"/>
          </ac:spMkLst>
        </pc:spChg>
        <pc:spChg chg="add del mod">
          <ac:chgData name="Grace Lee" userId="fd145552-a10d-4a31-a438-f8736fd84277" providerId="ADAL" clId="{56835480-2BB5-4545-A32E-6CA68AA69734}" dt="2021-09-13T02:09:26.092" v="1099"/>
          <ac:spMkLst>
            <pc:docMk/>
            <pc:sldMk cId="187938002" sldId="3307"/>
            <ac:spMk id="102" creationId="{B4AA1E30-D2BE-42D9-85A2-542120E1017D}"/>
          </ac:spMkLst>
        </pc:spChg>
        <pc:spChg chg="add del mod">
          <ac:chgData name="Grace Lee" userId="fd145552-a10d-4a31-a438-f8736fd84277" providerId="ADAL" clId="{56835480-2BB5-4545-A32E-6CA68AA69734}" dt="2021-09-13T03:02:24.369" v="1694"/>
          <ac:spMkLst>
            <pc:docMk/>
            <pc:sldMk cId="187938002" sldId="3307"/>
            <ac:spMk id="103" creationId="{5B9E119E-9B03-458D-A877-87C2DFAE5815}"/>
          </ac:spMkLst>
        </pc:spChg>
        <pc:spChg chg="add del mod">
          <ac:chgData name="Grace Lee" userId="fd145552-a10d-4a31-a438-f8736fd84277" providerId="ADAL" clId="{56835480-2BB5-4545-A32E-6CA68AA69734}" dt="2021-09-13T02:09:26.092" v="1099"/>
          <ac:spMkLst>
            <pc:docMk/>
            <pc:sldMk cId="187938002" sldId="3307"/>
            <ac:spMk id="103" creationId="{7CB42531-29AF-4422-9C4D-452CC0128D71}"/>
          </ac:spMkLst>
        </pc:spChg>
        <pc:spChg chg="mod">
          <ac:chgData name="Grace Lee" userId="fd145552-a10d-4a31-a438-f8736fd84277" providerId="ADAL" clId="{56835480-2BB5-4545-A32E-6CA68AA69734}" dt="2021-09-13T04:02:43.284" v="1988" actId="1036"/>
          <ac:spMkLst>
            <pc:docMk/>
            <pc:sldMk cId="187938002" sldId="3307"/>
            <ac:spMk id="104" creationId="{F81F728A-F6E0-4035-B83C-178C94467706}"/>
          </ac:spMkLst>
        </pc:spChg>
        <pc:spChg chg="mod">
          <ac:chgData name="Grace Lee" userId="fd145552-a10d-4a31-a438-f8736fd84277" providerId="ADAL" clId="{56835480-2BB5-4545-A32E-6CA68AA69734}" dt="2021-09-13T04:02:43.284" v="1988" actId="1036"/>
          <ac:spMkLst>
            <pc:docMk/>
            <pc:sldMk cId="187938002" sldId="3307"/>
            <ac:spMk id="105" creationId="{46483DB8-79F9-4FBE-9B21-E97A274C2DEC}"/>
          </ac:spMkLst>
        </pc:spChg>
        <pc:spChg chg="mod">
          <ac:chgData name="Grace Lee" userId="fd145552-a10d-4a31-a438-f8736fd84277" providerId="ADAL" clId="{56835480-2BB5-4545-A32E-6CA68AA69734}" dt="2021-09-13T04:02:43.284" v="1988" actId="1036"/>
          <ac:spMkLst>
            <pc:docMk/>
            <pc:sldMk cId="187938002" sldId="3307"/>
            <ac:spMk id="106" creationId="{DDA53C12-4572-4125-91CB-0096DC97ACEE}"/>
          </ac:spMkLst>
        </pc:spChg>
        <pc:spChg chg="mod">
          <ac:chgData name="Grace Lee" userId="fd145552-a10d-4a31-a438-f8736fd84277" providerId="ADAL" clId="{56835480-2BB5-4545-A32E-6CA68AA69734}" dt="2021-09-13T04:02:43.284" v="1988" actId="1036"/>
          <ac:spMkLst>
            <pc:docMk/>
            <pc:sldMk cId="187938002" sldId="3307"/>
            <ac:spMk id="107" creationId="{548FE39C-1314-44EC-A0B3-37B35B05DB8B}"/>
          </ac:spMkLst>
        </pc:spChg>
        <pc:spChg chg="add del mod">
          <ac:chgData name="Grace Lee" userId="fd145552-a10d-4a31-a438-f8736fd84277" providerId="ADAL" clId="{56835480-2BB5-4545-A32E-6CA68AA69734}" dt="2021-09-13T02:09:26.092" v="1099"/>
          <ac:spMkLst>
            <pc:docMk/>
            <pc:sldMk cId="187938002" sldId="3307"/>
            <ac:spMk id="108" creationId="{0AD014FD-2596-495E-B965-421172C2EF8C}"/>
          </ac:spMkLst>
        </pc:spChg>
        <pc:spChg chg="add del mod">
          <ac:chgData name="Grace Lee" userId="fd145552-a10d-4a31-a438-f8736fd84277" providerId="ADAL" clId="{56835480-2BB5-4545-A32E-6CA68AA69734}" dt="2021-09-13T03:02:24.369" v="1694"/>
          <ac:spMkLst>
            <pc:docMk/>
            <pc:sldMk cId="187938002" sldId="3307"/>
            <ac:spMk id="108" creationId="{51F8FF30-A1BD-47A5-A127-E24ADB2006C0}"/>
          </ac:spMkLst>
        </pc:spChg>
        <pc:spChg chg="add del mod">
          <ac:chgData name="Grace Lee" userId="fd145552-a10d-4a31-a438-f8736fd84277" providerId="ADAL" clId="{56835480-2BB5-4545-A32E-6CA68AA69734}" dt="2021-09-13T03:02:24.369" v="1694"/>
          <ac:spMkLst>
            <pc:docMk/>
            <pc:sldMk cId="187938002" sldId="3307"/>
            <ac:spMk id="109" creationId="{16618CDC-556E-4C99-B406-A69BC127E2ED}"/>
          </ac:spMkLst>
        </pc:spChg>
        <pc:spChg chg="add del mod">
          <ac:chgData name="Grace Lee" userId="fd145552-a10d-4a31-a438-f8736fd84277" providerId="ADAL" clId="{56835480-2BB5-4545-A32E-6CA68AA69734}" dt="2021-09-13T02:09:26.092" v="1099"/>
          <ac:spMkLst>
            <pc:docMk/>
            <pc:sldMk cId="187938002" sldId="3307"/>
            <ac:spMk id="109" creationId="{96CEA697-5CAF-4D80-808E-95DAEAE09305}"/>
          </ac:spMkLst>
        </pc:spChg>
        <pc:spChg chg="mod">
          <ac:chgData name="Grace Lee" userId="fd145552-a10d-4a31-a438-f8736fd84277" providerId="ADAL" clId="{56835480-2BB5-4545-A32E-6CA68AA69734}" dt="2021-09-13T04:02:43.284" v="1988" actId="1036"/>
          <ac:spMkLst>
            <pc:docMk/>
            <pc:sldMk cId="187938002" sldId="3307"/>
            <ac:spMk id="110" creationId="{DA178DCD-074A-482D-856E-184518C9F5C8}"/>
          </ac:spMkLst>
        </pc:spChg>
        <pc:spChg chg="mod">
          <ac:chgData name="Grace Lee" userId="fd145552-a10d-4a31-a438-f8736fd84277" providerId="ADAL" clId="{56835480-2BB5-4545-A32E-6CA68AA69734}" dt="2021-09-13T04:02:43.284" v="1988" actId="1036"/>
          <ac:spMkLst>
            <pc:docMk/>
            <pc:sldMk cId="187938002" sldId="3307"/>
            <ac:spMk id="111" creationId="{1793323B-16EA-4D26-913D-D89B75512963}"/>
          </ac:spMkLst>
        </pc:spChg>
        <pc:spChg chg="add mod">
          <ac:chgData name="Grace Lee" userId="fd145552-a10d-4a31-a438-f8736fd84277" providerId="ADAL" clId="{56835480-2BB5-4545-A32E-6CA68AA69734}" dt="2021-09-13T04:02:43.284" v="1988" actId="1036"/>
          <ac:spMkLst>
            <pc:docMk/>
            <pc:sldMk cId="187938002" sldId="3307"/>
            <ac:spMk id="112" creationId="{46F678A2-6687-4DBF-997D-4B943CDC732C}"/>
          </ac:spMkLst>
        </pc:spChg>
        <pc:spChg chg="add del mod">
          <ac:chgData name="Grace Lee" userId="fd145552-a10d-4a31-a438-f8736fd84277" providerId="ADAL" clId="{56835480-2BB5-4545-A32E-6CA68AA69734}" dt="2021-09-13T02:09:26.092" v="1099"/>
          <ac:spMkLst>
            <pc:docMk/>
            <pc:sldMk cId="187938002" sldId="3307"/>
            <ac:spMk id="112" creationId="{8755C162-0625-45C3-B18F-2F651E1FE11E}"/>
          </ac:spMkLst>
        </pc:spChg>
        <pc:spChg chg="add mod">
          <ac:chgData name="Grace Lee" userId="fd145552-a10d-4a31-a438-f8736fd84277" providerId="ADAL" clId="{56835480-2BB5-4545-A32E-6CA68AA69734}" dt="2021-09-13T04:02:43.284" v="1988" actId="1036"/>
          <ac:spMkLst>
            <pc:docMk/>
            <pc:sldMk cId="187938002" sldId="3307"/>
            <ac:spMk id="113" creationId="{423CAA18-74F3-473B-A719-8E275B53711E}"/>
          </ac:spMkLst>
        </pc:spChg>
        <pc:spChg chg="add del mod">
          <ac:chgData name="Grace Lee" userId="fd145552-a10d-4a31-a438-f8736fd84277" providerId="ADAL" clId="{56835480-2BB5-4545-A32E-6CA68AA69734}" dt="2021-09-13T02:09:26.092" v="1099"/>
          <ac:spMkLst>
            <pc:docMk/>
            <pc:sldMk cId="187938002" sldId="3307"/>
            <ac:spMk id="113" creationId="{DFFE8C81-3C7D-48CC-8F33-1C5F968BBA6C}"/>
          </ac:spMkLst>
        </pc:spChg>
        <pc:spChg chg="add del mod">
          <ac:chgData name="Grace Lee" userId="fd145552-a10d-4a31-a438-f8736fd84277" providerId="ADAL" clId="{56835480-2BB5-4545-A32E-6CA68AA69734}" dt="2021-09-13T03:06:51.059" v="1757" actId="478"/>
          <ac:spMkLst>
            <pc:docMk/>
            <pc:sldMk cId="187938002" sldId="3307"/>
            <ac:spMk id="114" creationId="{53194B0E-594F-4514-A4B1-339B3CED9029}"/>
          </ac:spMkLst>
        </pc:spChg>
        <pc:spChg chg="add del mod">
          <ac:chgData name="Grace Lee" userId="fd145552-a10d-4a31-a438-f8736fd84277" providerId="ADAL" clId="{56835480-2BB5-4545-A32E-6CA68AA69734}" dt="2021-09-13T02:09:26.092" v="1099"/>
          <ac:spMkLst>
            <pc:docMk/>
            <pc:sldMk cId="187938002" sldId="3307"/>
            <ac:spMk id="114" creationId="{7940D0A2-826A-47E9-90C0-78816D316E7C}"/>
          </ac:spMkLst>
        </pc:spChg>
        <pc:spChg chg="add del mod">
          <ac:chgData name="Grace Lee" userId="fd145552-a10d-4a31-a438-f8736fd84277" providerId="ADAL" clId="{56835480-2BB5-4545-A32E-6CA68AA69734}" dt="2021-09-13T02:09:26.092" v="1099"/>
          <ac:spMkLst>
            <pc:docMk/>
            <pc:sldMk cId="187938002" sldId="3307"/>
            <ac:spMk id="115" creationId="{32763826-084F-4B40-96A6-977C933900E9}"/>
          </ac:spMkLst>
        </pc:spChg>
        <pc:spChg chg="add del mod">
          <ac:chgData name="Grace Lee" userId="fd145552-a10d-4a31-a438-f8736fd84277" providerId="ADAL" clId="{56835480-2BB5-4545-A32E-6CA68AA69734}" dt="2021-09-13T03:03:44.254" v="1716"/>
          <ac:spMkLst>
            <pc:docMk/>
            <pc:sldMk cId="187938002" sldId="3307"/>
            <ac:spMk id="115" creationId="{426356D9-FC74-4B94-9E27-0C304DBE7F99}"/>
          </ac:spMkLst>
        </pc:spChg>
        <pc:spChg chg="add del mod">
          <ac:chgData name="Grace Lee" userId="fd145552-a10d-4a31-a438-f8736fd84277" providerId="ADAL" clId="{56835480-2BB5-4545-A32E-6CA68AA69734}" dt="2021-09-13T03:03:44.254" v="1716"/>
          <ac:spMkLst>
            <pc:docMk/>
            <pc:sldMk cId="187938002" sldId="3307"/>
            <ac:spMk id="116" creationId="{830EE7D3-CB3E-48D4-9D94-CC6568B32DCD}"/>
          </ac:spMkLst>
        </pc:spChg>
        <pc:spChg chg="add del mod">
          <ac:chgData name="Grace Lee" userId="fd145552-a10d-4a31-a438-f8736fd84277" providerId="ADAL" clId="{56835480-2BB5-4545-A32E-6CA68AA69734}" dt="2021-09-13T02:09:26.092" v="1099"/>
          <ac:spMkLst>
            <pc:docMk/>
            <pc:sldMk cId="187938002" sldId="3307"/>
            <ac:spMk id="116" creationId="{D7CC97A2-2F61-430B-9023-4D26E593C071}"/>
          </ac:spMkLst>
        </pc:spChg>
        <pc:spChg chg="add del mod">
          <ac:chgData name="Grace Lee" userId="fd145552-a10d-4a31-a438-f8736fd84277" providerId="ADAL" clId="{56835480-2BB5-4545-A32E-6CA68AA69734}" dt="2021-09-13T02:09:26.092" v="1099"/>
          <ac:spMkLst>
            <pc:docMk/>
            <pc:sldMk cId="187938002" sldId="3307"/>
            <ac:spMk id="117" creationId="{AB6A37B2-A7A7-4BD4-9CFA-10FD5C862638}"/>
          </ac:spMkLst>
        </pc:spChg>
        <pc:spChg chg="add del mod">
          <ac:chgData name="Grace Lee" userId="fd145552-a10d-4a31-a438-f8736fd84277" providerId="ADAL" clId="{56835480-2BB5-4545-A32E-6CA68AA69734}" dt="2021-09-13T03:03:44.254" v="1716"/>
          <ac:spMkLst>
            <pc:docMk/>
            <pc:sldMk cId="187938002" sldId="3307"/>
            <ac:spMk id="117" creationId="{C1CC2D74-476B-4FAC-9651-2599946D4E8C}"/>
          </ac:spMkLst>
        </pc:spChg>
        <pc:spChg chg="add del mod">
          <ac:chgData name="Grace Lee" userId="fd145552-a10d-4a31-a438-f8736fd84277" providerId="ADAL" clId="{56835480-2BB5-4545-A32E-6CA68AA69734}" dt="2021-09-13T02:09:26.092" v="1099"/>
          <ac:spMkLst>
            <pc:docMk/>
            <pc:sldMk cId="187938002" sldId="3307"/>
            <ac:spMk id="118" creationId="{28517AF7-5042-48ED-A2ED-138AF6ACAF8F}"/>
          </ac:spMkLst>
        </pc:spChg>
        <pc:spChg chg="add del mod">
          <ac:chgData name="Grace Lee" userId="fd145552-a10d-4a31-a438-f8736fd84277" providerId="ADAL" clId="{56835480-2BB5-4545-A32E-6CA68AA69734}" dt="2021-09-13T03:17:43.691" v="1796" actId="478"/>
          <ac:spMkLst>
            <pc:docMk/>
            <pc:sldMk cId="187938002" sldId="3307"/>
            <ac:spMk id="118" creationId="{CA7F507C-724F-4729-A245-81470E3EB433}"/>
          </ac:spMkLst>
        </pc:spChg>
        <pc:spChg chg="add del mod">
          <ac:chgData name="Grace Lee" userId="fd145552-a10d-4a31-a438-f8736fd84277" providerId="ADAL" clId="{56835480-2BB5-4545-A32E-6CA68AA69734}" dt="2021-09-13T03:17:43.691" v="1796" actId="478"/>
          <ac:spMkLst>
            <pc:docMk/>
            <pc:sldMk cId="187938002" sldId="3307"/>
            <ac:spMk id="119" creationId="{116FB5C9-FDD9-4E88-8003-018149091A00}"/>
          </ac:spMkLst>
        </pc:spChg>
        <pc:spChg chg="add del mod">
          <ac:chgData name="Grace Lee" userId="fd145552-a10d-4a31-a438-f8736fd84277" providerId="ADAL" clId="{56835480-2BB5-4545-A32E-6CA68AA69734}" dt="2021-09-13T02:09:26.092" v="1099"/>
          <ac:spMkLst>
            <pc:docMk/>
            <pc:sldMk cId="187938002" sldId="3307"/>
            <ac:spMk id="119" creationId="{33C0E288-406E-464F-AE3B-2E0BCF503639}"/>
          </ac:spMkLst>
        </pc:spChg>
        <pc:spChg chg="add del mod">
          <ac:chgData name="Grace Lee" userId="fd145552-a10d-4a31-a438-f8736fd84277" providerId="ADAL" clId="{56835480-2BB5-4545-A32E-6CA68AA69734}" dt="2021-09-13T03:17:43.691" v="1796" actId="478"/>
          <ac:spMkLst>
            <pc:docMk/>
            <pc:sldMk cId="187938002" sldId="3307"/>
            <ac:spMk id="120" creationId="{1F344242-4896-4F27-AF23-EA4DBB368F91}"/>
          </ac:spMkLst>
        </pc:spChg>
        <pc:spChg chg="add del mod">
          <ac:chgData name="Grace Lee" userId="fd145552-a10d-4a31-a438-f8736fd84277" providerId="ADAL" clId="{56835480-2BB5-4545-A32E-6CA68AA69734}" dt="2021-09-13T02:09:26.092" v="1099"/>
          <ac:spMkLst>
            <pc:docMk/>
            <pc:sldMk cId="187938002" sldId="3307"/>
            <ac:spMk id="120" creationId="{CA59E2DC-6DF1-4B8E-9BE6-14953D2D6107}"/>
          </ac:spMkLst>
        </pc:spChg>
        <pc:spChg chg="add del mod">
          <ac:chgData name="Grace Lee" userId="fd145552-a10d-4a31-a438-f8736fd84277" providerId="ADAL" clId="{56835480-2BB5-4545-A32E-6CA68AA69734}" dt="2021-09-13T03:17:43.691" v="1796" actId="478"/>
          <ac:spMkLst>
            <pc:docMk/>
            <pc:sldMk cId="187938002" sldId="3307"/>
            <ac:spMk id="121" creationId="{2841609B-1BE6-4092-8A44-6B09F153D944}"/>
          </ac:spMkLst>
        </pc:spChg>
        <pc:spChg chg="add del mod">
          <ac:chgData name="Grace Lee" userId="fd145552-a10d-4a31-a438-f8736fd84277" providerId="ADAL" clId="{56835480-2BB5-4545-A32E-6CA68AA69734}" dt="2021-09-13T02:09:26.092" v="1099"/>
          <ac:spMkLst>
            <pc:docMk/>
            <pc:sldMk cId="187938002" sldId="3307"/>
            <ac:spMk id="121" creationId="{426A31D2-C483-4592-9F96-E091B6620D9A}"/>
          </ac:spMkLst>
        </pc:spChg>
        <pc:spChg chg="add mod">
          <ac:chgData name="Grace Lee" userId="fd145552-a10d-4a31-a438-f8736fd84277" providerId="ADAL" clId="{56835480-2BB5-4545-A32E-6CA68AA69734}" dt="2021-09-13T04:02:43.284" v="1988" actId="1036"/>
          <ac:spMkLst>
            <pc:docMk/>
            <pc:sldMk cId="187938002" sldId="3307"/>
            <ac:spMk id="122" creationId="{3C64D145-B45B-4A5C-B27C-BF927429E62D}"/>
          </ac:spMkLst>
        </pc:spChg>
        <pc:spChg chg="add del mod">
          <ac:chgData name="Grace Lee" userId="fd145552-a10d-4a31-a438-f8736fd84277" providerId="ADAL" clId="{56835480-2BB5-4545-A32E-6CA68AA69734}" dt="2021-09-13T02:09:24.915" v="1097"/>
          <ac:spMkLst>
            <pc:docMk/>
            <pc:sldMk cId="187938002" sldId="3307"/>
            <ac:spMk id="122" creationId="{C55000E5-54DB-42B9-8399-BDA8F7801013}"/>
          </ac:spMkLst>
        </pc:spChg>
        <pc:spChg chg="add del mod">
          <ac:chgData name="Grace Lee" userId="fd145552-a10d-4a31-a438-f8736fd84277" providerId="ADAL" clId="{56835480-2BB5-4545-A32E-6CA68AA69734}" dt="2021-09-13T02:09:23.181" v="1094"/>
          <ac:spMkLst>
            <pc:docMk/>
            <pc:sldMk cId="187938002" sldId="3307"/>
            <ac:spMk id="123" creationId="{B2590CD0-E8A1-42D3-8E54-33B320F74D9E}"/>
          </ac:spMkLst>
        </pc:spChg>
        <pc:spChg chg="add mod">
          <ac:chgData name="Grace Lee" userId="fd145552-a10d-4a31-a438-f8736fd84277" providerId="ADAL" clId="{56835480-2BB5-4545-A32E-6CA68AA69734}" dt="2021-09-13T05:03:19.888" v="3045" actId="20577"/>
          <ac:spMkLst>
            <pc:docMk/>
            <pc:sldMk cId="187938002" sldId="3307"/>
            <ac:spMk id="123" creationId="{D97A2707-B6E7-4A7E-B13A-B40B0C744AD1}"/>
          </ac:spMkLst>
        </pc:spChg>
        <pc:spChg chg="add del mod">
          <ac:chgData name="Grace Lee" userId="fd145552-a10d-4a31-a438-f8736fd84277" providerId="ADAL" clId="{56835480-2BB5-4545-A32E-6CA68AA69734}" dt="2021-09-13T02:09:18.655" v="1085"/>
          <ac:spMkLst>
            <pc:docMk/>
            <pc:sldMk cId="187938002" sldId="3307"/>
            <ac:spMk id="124" creationId="{2085EFD3-46C2-43B9-A6FE-E1EC83082509}"/>
          </ac:spMkLst>
        </pc:spChg>
        <pc:spChg chg="add mod">
          <ac:chgData name="Grace Lee" userId="fd145552-a10d-4a31-a438-f8736fd84277" providerId="ADAL" clId="{56835480-2BB5-4545-A32E-6CA68AA69734}" dt="2021-09-13T04:02:43.284" v="1988" actId="1036"/>
          <ac:spMkLst>
            <pc:docMk/>
            <pc:sldMk cId="187938002" sldId="3307"/>
            <ac:spMk id="124" creationId="{6132A3D0-8A5A-47A5-B4DF-C2E42CA4C01F}"/>
          </ac:spMkLst>
        </pc:spChg>
        <pc:spChg chg="add mod">
          <ac:chgData name="Grace Lee" userId="fd145552-a10d-4a31-a438-f8736fd84277" providerId="ADAL" clId="{56835480-2BB5-4545-A32E-6CA68AA69734}" dt="2021-09-13T04:02:43.284" v="1988" actId="1036"/>
          <ac:spMkLst>
            <pc:docMk/>
            <pc:sldMk cId="187938002" sldId="3307"/>
            <ac:spMk id="125" creationId="{19466186-3ACE-48B2-84E6-321305D29EBF}"/>
          </ac:spMkLst>
        </pc:spChg>
        <pc:spChg chg="add mod">
          <ac:chgData name="Grace Lee" userId="fd145552-a10d-4a31-a438-f8736fd84277" providerId="ADAL" clId="{56835480-2BB5-4545-A32E-6CA68AA69734}" dt="2021-09-13T04:02:43.284" v="1988" actId="1036"/>
          <ac:spMkLst>
            <pc:docMk/>
            <pc:sldMk cId="187938002" sldId="3307"/>
            <ac:spMk id="126" creationId="{2947F216-E876-41EF-B668-B2DAEBAA2E8E}"/>
          </ac:spMkLst>
        </pc:spChg>
        <pc:spChg chg="add mod">
          <ac:chgData name="Grace Lee" userId="fd145552-a10d-4a31-a438-f8736fd84277" providerId="ADAL" clId="{56835480-2BB5-4545-A32E-6CA68AA69734}" dt="2021-09-13T04:02:43.284" v="1988" actId="1036"/>
          <ac:spMkLst>
            <pc:docMk/>
            <pc:sldMk cId="187938002" sldId="3307"/>
            <ac:spMk id="127" creationId="{936F3A3E-49E0-42A2-8748-2F7D774A345D}"/>
          </ac:spMkLst>
        </pc:spChg>
        <pc:spChg chg="add del mod">
          <ac:chgData name="Grace Lee" userId="fd145552-a10d-4a31-a438-f8736fd84277" providerId="ADAL" clId="{56835480-2BB5-4545-A32E-6CA68AA69734}" dt="2021-09-13T04:02:43.284" v="1988" actId="1036"/>
          <ac:spMkLst>
            <pc:docMk/>
            <pc:sldMk cId="187938002" sldId="3307"/>
            <ac:spMk id="128" creationId="{413B379D-72C3-4BD0-94D4-6E70D5C21609}"/>
          </ac:spMkLst>
        </pc:spChg>
        <pc:spChg chg="add mod">
          <ac:chgData name="Grace Lee" userId="fd145552-a10d-4a31-a438-f8736fd84277" providerId="ADAL" clId="{56835480-2BB5-4545-A32E-6CA68AA69734}" dt="2021-09-13T04:02:43.284" v="1988" actId="1036"/>
          <ac:spMkLst>
            <pc:docMk/>
            <pc:sldMk cId="187938002" sldId="3307"/>
            <ac:spMk id="129" creationId="{FA223EBD-97A0-43D1-90D7-B90DDFFAC82A}"/>
          </ac:spMkLst>
        </pc:spChg>
        <pc:spChg chg="mod">
          <ac:chgData name="Grace Lee" userId="fd145552-a10d-4a31-a438-f8736fd84277" providerId="ADAL" clId="{56835480-2BB5-4545-A32E-6CA68AA69734}" dt="2021-09-13T04:02:43.284" v="1988" actId="1036"/>
          <ac:spMkLst>
            <pc:docMk/>
            <pc:sldMk cId="187938002" sldId="3307"/>
            <ac:spMk id="130" creationId="{A1937A8D-739D-47D2-8F3B-5D3DEEC0CBFE}"/>
          </ac:spMkLst>
        </pc:spChg>
        <pc:spChg chg="mod">
          <ac:chgData name="Grace Lee" userId="fd145552-a10d-4a31-a438-f8736fd84277" providerId="ADAL" clId="{56835480-2BB5-4545-A32E-6CA68AA69734}" dt="2021-09-13T04:02:43.284" v="1988" actId="1036"/>
          <ac:spMkLst>
            <pc:docMk/>
            <pc:sldMk cId="187938002" sldId="3307"/>
            <ac:spMk id="131" creationId="{50DF1E82-6ACA-4B66-B7D6-9690E79414D5}"/>
          </ac:spMkLst>
        </pc:spChg>
        <pc:spChg chg="add mod">
          <ac:chgData name="Grace Lee" userId="fd145552-a10d-4a31-a438-f8736fd84277" providerId="ADAL" clId="{56835480-2BB5-4545-A32E-6CA68AA69734}" dt="2021-09-13T04:02:43.284" v="1988" actId="1036"/>
          <ac:spMkLst>
            <pc:docMk/>
            <pc:sldMk cId="187938002" sldId="3307"/>
            <ac:spMk id="132" creationId="{7393E349-10BD-4486-B623-A0D748273765}"/>
          </ac:spMkLst>
        </pc:spChg>
        <pc:spChg chg="add mod">
          <ac:chgData name="Grace Lee" userId="fd145552-a10d-4a31-a438-f8736fd84277" providerId="ADAL" clId="{56835480-2BB5-4545-A32E-6CA68AA69734}" dt="2021-09-13T04:02:43.284" v="1988" actId="1036"/>
          <ac:spMkLst>
            <pc:docMk/>
            <pc:sldMk cId="187938002" sldId="3307"/>
            <ac:spMk id="133" creationId="{6D5F2BD9-90E5-4534-9DA8-7D6038BA4778}"/>
          </ac:spMkLst>
        </pc:spChg>
        <pc:spChg chg="add mod">
          <ac:chgData name="Grace Lee" userId="fd145552-a10d-4a31-a438-f8736fd84277" providerId="ADAL" clId="{56835480-2BB5-4545-A32E-6CA68AA69734}" dt="2021-09-13T04:02:43.284" v="1988" actId="1036"/>
          <ac:spMkLst>
            <pc:docMk/>
            <pc:sldMk cId="187938002" sldId="3307"/>
            <ac:spMk id="134" creationId="{66D1B34E-93CD-4AEE-A3EB-CFC645BAA956}"/>
          </ac:spMkLst>
        </pc:spChg>
        <pc:spChg chg="add del mod">
          <ac:chgData name="Grace Lee" userId="fd145552-a10d-4a31-a438-f8736fd84277" providerId="ADAL" clId="{56835480-2BB5-4545-A32E-6CA68AA69734}" dt="2021-09-13T02:24:58.273" v="1109" actId="478"/>
          <ac:spMkLst>
            <pc:docMk/>
            <pc:sldMk cId="187938002" sldId="3307"/>
            <ac:spMk id="135" creationId="{6B622376-4FCA-48B7-ACAA-12D10F68D805}"/>
          </ac:spMkLst>
        </pc:spChg>
        <pc:spChg chg="add mod">
          <ac:chgData name="Grace Lee" userId="fd145552-a10d-4a31-a438-f8736fd84277" providerId="ADAL" clId="{56835480-2BB5-4545-A32E-6CA68AA69734}" dt="2021-09-13T04:02:43.284" v="1988" actId="1036"/>
          <ac:spMkLst>
            <pc:docMk/>
            <pc:sldMk cId="187938002" sldId="3307"/>
            <ac:spMk id="136" creationId="{2F313FCC-1D52-4F98-88EE-F66379C630E8}"/>
          </ac:spMkLst>
        </pc:spChg>
        <pc:spChg chg="add mod">
          <ac:chgData name="Grace Lee" userId="fd145552-a10d-4a31-a438-f8736fd84277" providerId="ADAL" clId="{56835480-2BB5-4545-A32E-6CA68AA69734}" dt="2021-09-13T04:02:43.284" v="1988" actId="1036"/>
          <ac:spMkLst>
            <pc:docMk/>
            <pc:sldMk cId="187938002" sldId="3307"/>
            <ac:spMk id="137" creationId="{42A446C2-5ACE-4867-9439-7C3858B281F7}"/>
          </ac:spMkLst>
        </pc:spChg>
        <pc:spChg chg="add del mod">
          <ac:chgData name="Grace Lee" userId="fd145552-a10d-4a31-a438-f8736fd84277" providerId="ADAL" clId="{56835480-2BB5-4545-A32E-6CA68AA69734}" dt="2021-09-13T02:37:55.811" v="1420" actId="478"/>
          <ac:spMkLst>
            <pc:docMk/>
            <pc:sldMk cId="187938002" sldId="3307"/>
            <ac:spMk id="138" creationId="{CC1518EB-CA36-4E7A-8514-2E3FD107F9A2}"/>
          </ac:spMkLst>
        </pc:spChg>
        <pc:spChg chg="add del mod">
          <ac:chgData name="Grace Lee" userId="fd145552-a10d-4a31-a438-f8736fd84277" providerId="ADAL" clId="{56835480-2BB5-4545-A32E-6CA68AA69734}" dt="2021-09-13T02:37:57.281" v="1421" actId="478"/>
          <ac:spMkLst>
            <pc:docMk/>
            <pc:sldMk cId="187938002" sldId="3307"/>
            <ac:spMk id="139" creationId="{3FD69538-A3FA-437B-8413-E03A2FB334B4}"/>
          </ac:spMkLst>
        </pc:spChg>
        <pc:spChg chg="mod">
          <ac:chgData name="Grace Lee" userId="fd145552-a10d-4a31-a438-f8736fd84277" providerId="ADAL" clId="{56835480-2BB5-4545-A32E-6CA68AA69734}" dt="2021-09-13T04:02:43.284" v="1988" actId="1036"/>
          <ac:spMkLst>
            <pc:docMk/>
            <pc:sldMk cId="187938002" sldId="3307"/>
            <ac:spMk id="140" creationId="{2993D3FC-7E1C-4B15-8C2F-13E3FDEE4739}"/>
          </ac:spMkLst>
        </pc:spChg>
        <pc:spChg chg="add del mod">
          <ac:chgData name="Grace Lee" userId="fd145552-a10d-4a31-a438-f8736fd84277" providerId="ADAL" clId="{56835480-2BB5-4545-A32E-6CA68AA69734}" dt="2021-09-13T03:22:58.032" v="1961" actId="478"/>
          <ac:spMkLst>
            <pc:docMk/>
            <pc:sldMk cId="187938002" sldId="3307"/>
            <ac:spMk id="141" creationId="{A3305CE1-76F0-4F46-AD8A-EF1D6B3586E6}"/>
          </ac:spMkLst>
        </pc:spChg>
        <pc:spChg chg="del">
          <ac:chgData name="Grace Lee" userId="fd145552-a10d-4a31-a438-f8736fd84277" providerId="ADAL" clId="{56835480-2BB5-4545-A32E-6CA68AA69734}" dt="2021-09-13T02:07:10.265" v="917" actId="478"/>
          <ac:spMkLst>
            <pc:docMk/>
            <pc:sldMk cId="187938002" sldId="3307"/>
            <ac:spMk id="141" creationId="{E9E75851-735E-46B4-8F8D-910677E15ED0}"/>
          </ac:spMkLst>
        </pc:spChg>
        <pc:spChg chg="add del mod">
          <ac:chgData name="Grace Lee" userId="fd145552-a10d-4a31-a438-f8736fd84277" providerId="ADAL" clId="{56835480-2BB5-4545-A32E-6CA68AA69734}" dt="2021-09-13T02:37:59.924" v="1422" actId="478"/>
          <ac:spMkLst>
            <pc:docMk/>
            <pc:sldMk cId="187938002" sldId="3307"/>
            <ac:spMk id="142" creationId="{33F36856-C03E-4B95-BEC1-49359DEEB89D}"/>
          </ac:spMkLst>
        </pc:spChg>
        <pc:spChg chg="add del mod">
          <ac:chgData name="Grace Lee" userId="fd145552-a10d-4a31-a438-f8736fd84277" providerId="ADAL" clId="{56835480-2BB5-4545-A32E-6CA68AA69734}" dt="2021-09-13T02:38:01.104" v="1423" actId="478"/>
          <ac:spMkLst>
            <pc:docMk/>
            <pc:sldMk cId="187938002" sldId="3307"/>
            <ac:spMk id="143" creationId="{B6CD5469-4A5F-4DEB-8120-58EB30DBCFF0}"/>
          </ac:spMkLst>
        </pc:spChg>
        <pc:spChg chg="add del mod">
          <ac:chgData name="Grace Lee" userId="fd145552-a10d-4a31-a438-f8736fd84277" providerId="ADAL" clId="{56835480-2BB5-4545-A32E-6CA68AA69734}" dt="2021-09-13T02:38:02.344" v="1424" actId="478"/>
          <ac:spMkLst>
            <pc:docMk/>
            <pc:sldMk cId="187938002" sldId="3307"/>
            <ac:spMk id="144" creationId="{F21768C3-33DE-445C-850E-EE90F41113F4}"/>
          </ac:spMkLst>
        </pc:spChg>
        <pc:spChg chg="add del mod">
          <ac:chgData name="Grace Lee" userId="fd145552-a10d-4a31-a438-f8736fd84277" providerId="ADAL" clId="{56835480-2BB5-4545-A32E-6CA68AA69734}" dt="2021-09-13T02:24:57.310" v="1108" actId="478"/>
          <ac:spMkLst>
            <pc:docMk/>
            <pc:sldMk cId="187938002" sldId="3307"/>
            <ac:spMk id="145" creationId="{D34FEA2D-B7F3-4BCC-9717-4F330A08C465}"/>
          </ac:spMkLst>
        </pc:spChg>
        <pc:spChg chg="add del mod">
          <ac:chgData name="Grace Lee" userId="fd145552-a10d-4a31-a438-f8736fd84277" providerId="ADAL" clId="{56835480-2BB5-4545-A32E-6CA68AA69734}" dt="2021-09-13T04:08:37.175" v="2075"/>
          <ac:spMkLst>
            <pc:docMk/>
            <pc:sldMk cId="187938002" sldId="3307"/>
            <ac:spMk id="146" creationId="{F837E7C2-E4FC-4DF2-9DC1-9BCC7CE110E9}"/>
          </ac:spMkLst>
        </pc:spChg>
        <pc:spChg chg="add del mod">
          <ac:chgData name="Grace Lee" userId="fd145552-a10d-4a31-a438-f8736fd84277" providerId="ADAL" clId="{56835480-2BB5-4545-A32E-6CA68AA69734}" dt="2021-09-13T04:08:37.175" v="2075"/>
          <ac:spMkLst>
            <pc:docMk/>
            <pc:sldMk cId="187938002" sldId="3307"/>
            <ac:spMk id="147" creationId="{2A609ED8-3576-4195-85C7-959A6F2A2E80}"/>
          </ac:spMkLst>
        </pc:spChg>
        <pc:spChg chg="add del mod">
          <ac:chgData name="Grace Lee" userId="fd145552-a10d-4a31-a438-f8736fd84277" providerId="ADAL" clId="{56835480-2BB5-4545-A32E-6CA68AA69734}" dt="2021-09-13T04:08:37.175" v="2075"/>
          <ac:spMkLst>
            <pc:docMk/>
            <pc:sldMk cId="187938002" sldId="3307"/>
            <ac:spMk id="148" creationId="{69708382-3E9E-430F-9E49-89D71FBA8528}"/>
          </ac:spMkLst>
        </pc:spChg>
        <pc:spChg chg="add del mod">
          <ac:chgData name="Grace Lee" userId="fd145552-a10d-4a31-a438-f8736fd84277" providerId="ADAL" clId="{56835480-2BB5-4545-A32E-6CA68AA69734}" dt="2021-09-13T04:08:37.175" v="2075"/>
          <ac:spMkLst>
            <pc:docMk/>
            <pc:sldMk cId="187938002" sldId="3307"/>
            <ac:spMk id="149" creationId="{189E76B3-B2F2-4EE4-9973-95BE3CDD8488}"/>
          </ac:spMkLst>
        </pc:spChg>
        <pc:spChg chg="add del mod">
          <ac:chgData name="Grace Lee" userId="fd145552-a10d-4a31-a438-f8736fd84277" providerId="ADAL" clId="{56835480-2BB5-4545-A32E-6CA68AA69734}" dt="2021-09-13T04:08:37.175" v="2075"/>
          <ac:spMkLst>
            <pc:docMk/>
            <pc:sldMk cId="187938002" sldId="3307"/>
            <ac:spMk id="150" creationId="{6A9CDB6D-75E9-4D52-A93B-129F81856E0A}"/>
          </ac:spMkLst>
        </pc:spChg>
        <pc:spChg chg="add del mod">
          <ac:chgData name="Grace Lee" userId="fd145552-a10d-4a31-a438-f8736fd84277" providerId="ADAL" clId="{56835480-2BB5-4545-A32E-6CA68AA69734}" dt="2021-09-13T04:08:37.175" v="2075"/>
          <ac:spMkLst>
            <pc:docMk/>
            <pc:sldMk cId="187938002" sldId="3307"/>
            <ac:spMk id="151" creationId="{B343ACBC-B0B3-45A1-BF73-883B84D2A8F6}"/>
          </ac:spMkLst>
        </pc:spChg>
        <pc:spChg chg="add del mod">
          <ac:chgData name="Grace Lee" userId="fd145552-a10d-4a31-a438-f8736fd84277" providerId="ADAL" clId="{56835480-2BB5-4545-A32E-6CA68AA69734}" dt="2021-09-13T04:08:37.175" v="2075"/>
          <ac:spMkLst>
            <pc:docMk/>
            <pc:sldMk cId="187938002" sldId="3307"/>
            <ac:spMk id="152" creationId="{4A169D78-ADA7-4D82-A6DF-3BF6CA79619B}"/>
          </ac:spMkLst>
        </pc:spChg>
        <pc:spChg chg="add del mod">
          <ac:chgData name="Grace Lee" userId="fd145552-a10d-4a31-a438-f8736fd84277" providerId="ADAL" clId="{56835480-2BB5-4545-A32E-6CA68AA69734}" dt="2021-09-13T04:08:37.175" v="2075"/>
          <ac:spMkLst>
            <pc:docMk/>
            <pc:sldMk cId="187938002" sldId="3307"/>
            <ac:spMk id="153" creationId="{A07FFAB6-F172-4A64-9293-82521A82331F}"/>
          </ac:spMkLst>
        </pc:spChg>
        <pc:spChg chg="add del mod">
          <ac:chgData name="Grace Lee" userId="fd145552-a10d-4a31-a438-f8736fd84277" providerId="ADAL" clId="{56835480-2BB5-4545-A32E-6CA68AA69734}" dt="2021-09-13T04:08:37.175" v="2075"/>
          <ac:spMkLst>
            <pc:docMk/>
            <pc:sldMk cId="187938002" sldId="3307"/>
            <ac:spMk id="154" creationId="{CAB0B885-8D90-4401-BA8E-789C1D082CB8}"/>
          </ac:spMkLst>
        </pc:spChg>
        <pc:spChg chg="add del mod">
          <ac:chgData name="Grace Lee" userId="fd145552-a10d-4a31-a438-f8736fd84277" providerId="ADAL" clId="{56835480-2BB5-4545-A32E-6CA68AA69734}" dt="2021-09-13T04:08:37.175" v="2075"/>
          <ac:spMkLst>
            <pc:docMk/>
            <pc:sldMk cId="187938002" sldId="3307"/>
            <ac:spMk id="155" creationId="{7A01D545-6E07-402E-9E7D-EA1653F6FA45}"/>
          </ac:spMkLst>
        </pc:spChg>
        <pc:spChg chg="add del mod">
          <ac:chgData name="Grace Lee" userId="fd145552-a10d-4a31-a438-f8736fd84277" providerId="ADAL" clId="{56835480-2BB5-4545-A32E-6CA68AA69734}" dt="2021-09-13T04:08:37.175" v="2075"/>
          <ac:spMkLst>
            <pc:docMk/>
            <pc:sldMk cId="187938002" sldId="3307"/>
            <ac:spMk id="156" creationId="{87C2B29A-32C4-4638-81F5-3C86AEB6E5BE}"/>
          </ac:spMkLst>
        </pc:spChg>
        <pc:spChg chg="add del mod">
          <ac:chgData name="Grace Lee" userId="fd145552-a10d-4a31-a438-f8736fd84277" providerId="ADAL" clId="{56835480-2BB5-4545-A32E-6CA68AA69734}" dt="2021-09-13T04:08:37.175" v="2075"/>
          <ac:spMkLst>
            <pc:docMk/>
            <pc:sldMk cId="187938002" sldId="3307"/>
            <ac:spMk id="157" creationId="{50FFC709-4DC0-41E3-A23B-16428C098CAA}"/>
          </ac:spMkLst>
        </pc:spChg>
        <pc:spChg chg="add del mod">
          <ac:chgData name="Grace Lee" userId="fd145552-a10d-4a31-a438-f8736fd84277" providerId="ADAL" clId="{56835480-2BB5-4545-A32E-6CA68AA69734}" dt="2021-09-13T04:28:34.558" v="2552" actId="478"/>
          <ac:spMkLst>
            <pc:docMk/>
            <pc:sldMk cId="187938002" sldId="3307"/>
            <ac:spMk id="158" creationId="{7D835404-CA5B-4441-9F7D-011865B80EB1}"/>
          </ac:spMkLst>
        </pc:spChg>
        <pc:spChg chg="add mod">
          <ac:chgData name="Grace Lee" userId="fd145552-a10d-4a31-a438-f8736fd84277" providerId="ADAL" clId="{56835480-2BB5-4545-A32E-6CA68AA69734}" dt="2021-09-13T04:27:15.217" v="2534" actId="207"/>
          <ac:spMkLst>
            <pc:docMk/>
            <pc:sldMk cId="187938002" sldId="3307"/>
            <ac:spMk id="159" creationId="{768F0C11-6D59-4A7D-8A97-40F17D6A39E4}"/>
          </ac:spMkLst>
        </pc:spChg>
        <pc:spChg chg="add del mod">
          <ac:chgData name="Grace Lee" userId="fd145552-a10d-4a31-a438-f8736fd84277" providerId="ADAL" clId="{56835480-2BB5-4545-A32E-6CA68AA69734}" dt="2021-09-13T04:28:34.558" v="2552" actId="478"/>
          <ac:spMkLst>
            <pc:docMk/>
            <pc:sldMk cId="187938002" sldId="3307"/>
            <ac:spMk id="160" creationId="{D50AC208-3AC6-4964-A051-E1AE7738E386}"/>
          </ac:spMkLst>
        </pc:spChg>
        <pc:spChg chg="add del mod">
          <ac:chgData name="Grace Lee" userId="fd145552-a10d-4a31-a438-f8736fd84277" providerId="ADAL" clId="{56835480-2BB5-4545-A32E-6CA68AA69734}" dt="2021-09-13T04:28:34.558" v="2552" actId="478"/>
          <ac:spMkLst>
            <pc:docMk/>
            <pc:sldMk cId="187938002" sldId="3307"/>
            <ac:spMk id="161" creationId="{D6196FC8-95E1-489F-A6F8-7E0507854A91}"/>
          </ac:spMkLst>
        </pc:spChg>
        <pc:spChg chg="add del mod">
          <ac:chgData name="Grace Lee" userId="fd145552-a10d-4a31-a438-f8736fd84277" providerId="ADAL" clId="{56835480-2BB5-4545-A32E-6CA68AA69734}" dt="2021-09-13T04:10:48.232" v="2111" actId="1036"/>
          <ac:spMkLst>
            <pc:docMk/>
            <pc:sldMk cId="187938002" sldId="3307"/>
            <ac:spMk id="162" creationId="{290193BC-EAC3-4732-A4C6-E33D476B860B}"/>
          </ac:spMkLst>
        </pc:spChg>
        <pc:spChg chg="add del mod">
          <ac:chgData name="Grace Lee" userId="fd145552-a10d-4a31-a438-f8736fd84277" providerId="ADAL" clId="{56835480-2BB5-4545-A32E-6CA68AA69734}" dt="2021-09-13T04:28:34.558" v="2552" actId="478"/>
          <ac:spMkLst>
            <pc:docMk/>
            <pc:sldMk cId="187938002" sldId="3307"/>
            <ac:spMk id="163" creationId="{5A21A400-6CFB-424D-8D4F-C97082057988}"/>
          </ac:spMkLst>
        </pc:spChg>
        <pc:spChg chg="add del mod">
          <ac:chgData name="Grace Lee" userId="fd145552-a10d-4a31-a438-f8736fd84277" providerId="ADAL" clId="{56835480-2BB5-4545-A32E-6CA68AA69734}" dt="2021-09-13T04:13:55.097" v="2118"/>
          <ac:spMkLst>
            <pc:docMk/>
            <pc:sldMk cId="187938002" sldId="3307"/>
            <ac:spMk id="164" creationId="{7C4C8FBC-5239-4E0E-B531-9509B6905C92}"/>
          </ac:spMkLst>
        </pc:spChg>
        <pc:spChg chg="add del mod">
          <ac:chgData name="Grace Lee" userId="fd145552-a10d-4a31-a438-f8736fd84277" providerId="ADAL" clId="{56835480-2BB5-4545-A32E-6CA68AA69734}" dt="2021-09-13T04:13:55.097" v="2118"/>
          <ac:spMkLst>
            <pc:docMk/>
            <pc:sldMk cId="187938002" sldId="3307"/>
            <ac:spMk id="165" creationId="{DF2B2925-F8DD-46DB-B1BF-DEBEFA9F06F2}"/>
          </ac:spMkLst>
        </pc:spChg>
        <pc:spChg chg="add del mod">
          <ac:chgData name="Grace Lee" userId="fd145552-a10d-4a31-a438-f8736fd84277" providerId="ADAL" clId="{56835480-2BB5-4545-A32E-6CA68AA69734}" dt="2021-09-13T04:13:55.097" v="2118"/>
          <ac:spMkLst>
            <pc:docMk/>
            <pc:sldMk cId="187938002" sldId="3307"/>
            <ac:spMk id="166" creationId="{CA401256-0B87-4A7B-9F48-F9440127E7BC}"/>
          </ac:spMkLst>
        </pc:spChg>
        <pc:spChg chg="add del mod">
          <ac:chgData name="Grace Lee" userId="fd145552-a10d-4a31-a438-f8736fd84277" providerId="ADAL" clId="{56835480-2BB5-4545-A32E-6CA68AA69734}" dt="2021-09-13T04:13:55.097" v="2118"/>
          <ac:spMkLst>
            <pc:docMk/>
            <pc:sldMk cId="187938002" sldId="3307"/>
            <ac:spMk id="167" creationId="{9EE1069C-6444-4F69-9BB7-5080501B34AB}"/>
          </ac:spMkLst>
        </pc:spChg>
        <pc:spChg chg="add del mod">
          <ac:chgData name="Grace Lee" userId="fd145552-a10d-4a31-a438-f8736fd84277" providerId="ADAL" clId="{56835480-2BB5-4545-A32E-6CA68AA69734}" dt="2021-09-13T04:13:55.097" v="2118"/>
          <ac:spMkLst>
            <pc:docMk/>
            <pc:sldMk cId="187938002" sldId="3307"/>
            <ac:spMk id="168" creationId="{D72CCCF2-B105-4B2F-8861-6218BC1BD2B4}"/>
          </ac:spMkLst>
        </pc:spChg>
        <pc:spChg chg="add del mod">
          <ac:chgData name="Grace Lee" userId="fd145552-a10d-4a31-a438-f8736fd84277" providerId="ADAL" clId="{56835480-2BB5-4545-A32E-6CA68AA69734}" dt="2021-09-13T04:13:55.097" v="2118"/>
          <ac:spMkLst>
            <pc:docMk/>
            <pc:sldMk cId="187938002" sldId="3307"/>
            <ac:spMk id="169" creationId="{BB400EE4-DE31-4618-AA64-3A40BE697073}"/>
          </ac:spMkLst>
        </pc:spChg>
        <pc:spChg chg="add del mod">
          <ac:chgData name="Grace Lee" userId="fd145552-a10d-4a31-a438-f8736fd84277" providerId="ADAL" clId="{56835480-2BB5-4545-A32E-6CA68AA69734}" dt="2021-09-13T04:14:05.209" v="2120"/>
          <ac:spMkLst>
            <pc:docMk/>
            <pc:sldMk cId="187938002" sldId="3307"/>
            <ac:spMk id="170" creationId="{255201A1-9BF8-4005-83BA-0716E9342E47}"/>
          </ac:spMkLst>
        </pc:spChg>
        <pc:spChg chg="add mod">
          <ac:chgData name="Grace Lee" userId="fd145552-a10d-4a31-a438-f8736fd84277" providerId="ADAL" clId="{56835480-2BB5-4545-A32E-6CA68AA69734}" dt="2021-09-13T04:23:33.820" v="2430" actId="20577"/>
          <ac:spMkLst>
            <pc:docMk/>
            <pc:sldMk cId="187938002" sldId="3307"/>
            <ac:spMk id="171" creationId="{F3656F8A-FF42-4AC4-8FF8-DC399A5E5F15}"/>
          </ac:spMkLst>
        </pc:spChg>
        <pc:spChg chg="add del mod">
          <ac:chgData name="Grace Lee" userId="fd145552-a10d-4a31-a438-f8736fd84277" providerId="ADAL" clId="{56835480-2BB5-4545-A32E-6CA68AA69734}" dt="2021-09-13T04:27:49.136" v="2540" actId="478"/>
          <ac:spMkLst>
            <pc:docMk/>
            <pc:sldMk cId="187938002" sldId="3307"/>
            <ac:spMk id="172" creationId="{DEA693BE-499D-4A39-8759-0790AF579F83}"/>
          </ac:spMkLst>
        </pc:spChg>
        <pc:spChg chg="add mod">
          <ac:chgData name="Grace Lee" userId="fd145552-a10d-4a31-a438-f8736fd84277" providerId="ADAL" clId="{56835480-2BB5-4545-A32E-6CA68AA69734}" dt="2021-09-13T04:27:17.831" v="2535" actId="207"/>
          <ac:spMkLst>
            <pc:docMk/>
            <pc:sldMk cId="187938002" sldId="3307"/>
            <ac:spMk id="173" creationId="{855A9869-5715-4B04-AB7F-C080D898EDDB}"/>
          </ac:spMkLst>
        </pc:spChg>
        <pc:spChg chg="mod">
          <ac:chgData name="Grace Lee" userId="fd145552-a10d-4a31-a438-f8736fd84277" providerId="ADAL" clId="{56835480-2BB5-4545-A32E-6CA68AA69734}" dt="2021-09-13T04:02:43.284" v="1988" actId="1036"/>
          <ac:spMkLst>
            <pc:docMk/>
            <pc:sldMk cId="187938002" sldId="3307"/>
            <ac:spMk id="174" creationId="{712317E0-A6D2-404D-A1F4-2D883F388E56}"/>
          </ac:spMkLst>
        </pc:spChg>
        <pc:spChg chg="mod">
          <ac:chgData name="Grace Lee" userId="fd145552-a10d-4a31-a438-f8736fd84277" providerId="ADAL" clId="{56835480-2BB5-4545-A32E-6CA68AA69734}" dt="2021-09-13T04:02:43.284" v="1988" actId="1036"/>
          <ac:spMkLst>
            <pc:docMk/>
            <pc:sldMk cId="187938002" sldId="3307"/>
            <ac:spMk id="175" creationId="{54CC318E-92C2-4F45-9CB0-4287FE94A1EC}"/>
          </ac:spMkLst>
        </pc:spChg>
        <pc:spChg chg="add mod">
          <ac:chgData name="Grace Lee" userId="fd145552-a10d-4a31-a438-f8736fd84277" providerId="ADAL" clId="{56835480-2BB5-4545-A32E-6CA68AA69734}" dt="2021-09-13T04:26:49.112" v="2532" actId="1076"/>
          <ac:spMkLst>
            <pc:docMk/>
            <pc:sldMk cId="187938002" sldId="3307"/>
            <ac:spMk id="176" creationId="{646101B8-2165-4DBC-90DB-9DDCC8A59445}"/>
          </ac:spMkLst>
        </pc:spChg>
        <pc:spChg chg="del">
          <ac:chgData name="Grace Lee" userId="fd145552-a10d-4a31-a438-f8736fd84277" providerId="ADAL" clId="{56835480-2BB5-4545-A32E-6CA68AA69734}" dt="2021-09-13T01:27:58.396" v="29" actId="478"/>
          <ac:spMkLst>
            <pc:docMk/>
            <pc:sldMk cId="187938002" sldId="3307"/>
            <ac:spMk id="176" creationId="{946FEA16-97EE-492B-A8AE-F2AB6D8C96AA}"/>
          </ac:spMkLst>
        </pc:spChg>
        <pc:spChg chg="add mod">
          <ac:chgData name="Grace Lee" userId="fd145552-a10d-4a31-a438-f8736fd84277" providerId="ADAL" clId="{56835480-2BB5-4545-A32E-6CA68AA69734}" dt="2021-09-13T04:28:55.843" v="2555" actId="122"/>
          <ac:spMkLst>
            <pc:docMk/>
            <pc:sldMk cId="187938002" sldId="3307"/>
            <ac:spMk id="177" creationId="{144B2700-38E9-4746-A6EE-A1E56E7D46D8}"/>
          </ac:spMkLst>
        </pc:spChg>
        <pc:spChg chg="mod">
          <ac:chgData name="Grace Lee" userId="fd145552-a10d-4a31-a438-f8736fd84277" providerId="ADAL" clId="{56835480-2BB5-4545-A32E-6CA68AA69734}" dt="2021-09-13T04:02:43.284" v="1988" actId="1036"/>
          <ac:spMkLst>
            <pc:docMk/>
            <pc:sldMk cId="187938002" sldId="3307"/>
            <ac:spMk id="178" creationId="{581B84B5-D0C4-49FC-BA7E-AE210B5B26BA}"/>
          </ac:spMkLst>
        </pc:spChg>
        <pc:spChg chg="mod">
          <ac:chgData name="Grace Lee" userId="fd145552-a10d-4a31-a438-f8736fd84277" providerId="ADAL" clId="{56835480-2BB5-4545-A32E-6CA68AA69734}" dt="2021-09-13T04:02:43.284" v="1988" actId="1036"/>
          <ac:spMkLst>
            <pc:docMk/>
            <pc:sldMk cId="187938002" sldId="3307"/>
            <ac:spMk id="179" creationId="{A30FC82F-D841-4BFF-982E-7659A7C67531}"/>
          </ac:spMkLst>
        </pc:spChg>
        <pc:spChg chg="add del mod">
          <ac:chgData name="Grace Lee" userId="fd145552-a10d-4a31-a438-f8736fd84277" providerId="ADAL" clId="{56835480-2BB5-4545-A32E-6CA68AA69734}" dt="2021-09-13T04:27:47.277" v="2539" actId="478"/>
          <ac:spMkLst>
            <pc:docMk/>
            <pc:sldMk cId="187938002" sldId="3307"/>
            <ac:spMk id="180" creationId="{F46DC6A4-7BA0-4424-97BB-B064B874F2DA}"/>
          </ac:spMkLst>
        </pc:spChg>
        <pc:spChg chg="add mod">
          <ac:chgData name="Grace Lee" userId="fd145552-a10d-4a31-a438-f8736fd84277" providerId="ADAL" clId="{56835480-2BB5-4545-A32E-6CA68AA69734}" dt="2021-09-13T04:28:22.926" v="2546" actId="1076"/>
          <ac:spMkLst>
            <pc:docMk/>
            <pc:sldMk cId="187938002" sldId="3307"/>
            <ac:spMk id="181" creationId="{0DB9AC23-C002-4B83-B229-1E7EF7D5F228}"/>
          </ac:spMkLst>
        </pc:spChg>
        <pc:spChg chg="add mod">
          <ac:chgData name="Grace Lee" userId="fd145552-a10d-4a31-a438-f8736fd84277" providerId="ADAL" clId="{56835480-2BB5-4545-A32E-6CA68AA69734}" dt="2021-09-13T04:28:22.926" v="2546" actId="1076"/>
          <ac:spMkLst>
            <pc:docMk/>
            <pc:sldMk cId="187938002" sldId="3307"/>
            <ac:spMk id="182" creationId="{520FA9EF-5467-4792-9198-7DD78B0A7E2F}"/>
          </ac:spMkLst>
        </pc:spChg>
        <pc:spChg chg="add mod">
          <ac:chgData name="Grace Lee" userId="fd145552-a10d-4a31-a438-f8736fd84277" providerId="ADAL" clId="{56835480-2BB5-4545-A32E-6CA68AA69734}" dt="2021-09-13T04:28:22.926" v="2546" actId="1076"/>
          <ac:spMkLst>
            <pc:docMk/>
            <pc:sldMk cId="187938002" sldId="3307"/>
            <ac:spMk id="183" creationId="{68FDE5F4-FA5B-491E-9DDB-6E4C466C4766}"/>
          </ac:spMkLst>
        </pc:spChg>
        <pc:spChg chg="add del mod">
          <ac:chgData name="Grace Lee" userId="fd145552-a10d-4a31-a438-f8736fd84277" providerId="ADAL" clId="{56835480-2BB5-4545-A32E-6CA68AA69734}" dt="2021-09-13T04:28:25.570" v="2549" actId="478"/>
          <ac:spMkLst>
            <pc:docMk/>
            <pc:sldMk cId="187938002" sldId="3307"/>
            <ac:spMk id="184" creationId="{2B79D906-69F5-4054-BD39-C26527D4F82E}"/>
          </ac:spMkLst>
        </pc:spChg>
        <pc:spChg chg="add mod">
          <ac:chgData name="Grace Lee" userId="fd145552-a10d-4a31-a438-f8736fd84277" providerId="ADAL" clId="{56835480-2BB5-4545-A32E-6CA68AA69734}" dt="2021-09-13T04:28:28.584" v="2551" actId="207"/>
          <ac:spMkLst>
            <pc:docMk/>
            <pc:sldMk cId="187938002" sldId="3307"/>
            <ac:spMk id="185" creationId="{EEEAB960-1996-45C4-9187-27BE2A9C4A2E}"/>
          </ac:spMkLst>
        </pc:spChg>
        <pc:spChg chg="add mod">
          <ac:chgData name="Grace Lee" userId="fd145552-a10d-4a31-a438-f8736fd84277" providerId="ADAL" clId="{56835480-2BB5-4545-A32E-6CA68AA69734}" dt="2021-09-13T04:26:08.201" v="2530" actId="1076"/>
          <ac:spMkLst>
            <pc:docMk/>
            <pc:sldMk cId="187938002" sldId="3307"/>
            <ac:spMk id="186" creationId="{B456F411-1A95-455A-BDB1-AE61C8D56E85}"/>
          </ac:spMkLst>
        </pc:spChg>
        <pc:spChg chg="add mod">
          <ac:chgData name="Grace Lee" userId="fd145552-a10d-4a31-a438-f8736fd84277" providerId="ADAL" clId="{56835480-2BB5-4545-A32E-6CA68AA69734}" dt="2021-09-13T04:26:08.201" v="2530" actId="1076"/>
          <ac:spMkLst>
            <pc:docMk/>
            <pc:sldMk cId="187938002" sldId="3307"/>
            <ac:spMk id="187" creationId="{C5547091-31B6-4C3C-B5FA-2DFA40E76745}"/>
          </ac:spMkLst>
        </pc:spChg>
        <pc:spChg chg="add del mod">
          <ac:chgData name="Grace Lee" userId="fd145552-a10d-4a31-a438-f8736fd84277" providerId="ADAL" clId="{56835480-2BB5-4545-A32E-6CA68AA69734}" dt="2021-09-13T04:28:25.892" v="2550" actId="478"/>
          <ac:spMkLst>
            <pc:docMk/>
            <pc:sldMk cId="187938002" sldId="3307"/>
            <ac:spMk id="188" creationId="{908728F1-34B4-4150-9D16-09B0A6FBB668}"/>
          </ac:spMkLst>
        </pc:spChg>
        <pc:spChg chg="add mod">
          <ac:chgData name="Grace Lee" userId="fd145552-a10d-4a31-a438-f8736fd84277" providerId="ADAL" clId="{56835480-2BB5-4545-A32E-6CA68AA69734}" dt="2021-09-13T04:28:22.678" v="2545" actId="1076"/>
          <ac:spMkLst>
            <pc:docMk/>
            <pc:sldMk cId="187938002" sldId="3307"/>
            <ac:spMk id="189" creationId="{AEB2C093-0815-4D16-905B-69D2EDAF1FEE}"/>
          </ac:spMkLst>
        </pc:spChg>
        <pc:spChg chg="add mod">
          <ac:chgData name="Grace Lee" userId="fd145552-a10d-4a31-a438-f8736fd84277" providerId="ADAL" clId="{56835480-2BB5-4545-A32E-6CA68AA69734}" dt="2021-09-13T04:28:22.678" v="2545" actId="1076"/>
          <ac:spMkLst>
            <pc:docMk/>
            <pc:sldMk cId="187938002" sldId="3307"/>
            <ac:spMk id="190" creationId="{ADAD2512-4ACE-4FBE-B236-954614A28D12}"/>
          </ac:spMkLst>
        </pc:spChg>
        <pc:spChg chg="add mod">
          <ac:chgData name="Grace Lee" userId="fd145552-a10d-4a31-a438-f8736fd84277" providerId="ADAL" clId="{56835480-2BB5-4545-A32E-6CA68AA69734}" dt="2021-09-13T04:28:22.678" v="2545" actId="1076"/>
          <ac:spMkLst>
            <pc:docMk/>
            <pc:sldMk cId="187938002" sldId="3307"/>
            <ac:spMk id="191" creationId="{B7A99FBD-A908-4438-ADBE-8CD497A03857}"/>
          </ac:spMkLst>
        </pc:spChg>
        <pc:spChg chg="add del mod">
          <ac:chgData name="Grace Lee" userId="fd145552-a10d-4a31-a438-f8736fd84277" providerId="ADAL" clId="{56835480-2BB5-4545-A32E-6CA68AA69734}" dt="2021-09-13T04:26:53.988" v="2533" actId="478"/>
          <ac:spMkLst>
            <pc:docMk/>
            <pc:sldMk cId="187938002" sldId="3307"/>
            <ac:spMk id="192" creationId="{D36BBA5E-E8A0-455C-9D15-A9106C8EABD7}"/>
          </ac:spMkLst>
        </pc:spChg>
        <pc:spChg chg="add mod">
          <ac:chgData name="Grace Lee" userId="fd145552-a10d-4a31-a438-f8736fd84277" providerId="ADAL" clId="{56835480-2BB5-4545-A32E-6CA68AA69734}" dt="2021-09-13T04:25:35.777" v="2528" actId="1076"/>
          <ac:spMkLst>
            <pc:docMk/>
            <pc:sldMk cId="187938002" sldId="3307"/>
            <ac:spMk id="193" creationId="{6AA4CE63-9ED3-4390-A642-471C24E9AA1C}"/>
          </ac:spMkLst>
        </pc:spChg>
        <pc:spChg chg="add mod">
          <ac:chgData name="Grace Lee" userId="fd145552-a10d-4a31-a438-f8736fd84277" providerId="ADAL" clId="{56835480-2BB5-4545-A32E-6CA68AA69734}" dt="2021-09-13T04:25:35.777" v="2528" actId="1076"/>
          <ac:spMkLst>
            <pc:docMk/>
            <pc:sldMk cId="187938002" sldId="3307"/>
            <ac:spMk id="194" creationId="{9C653993-4942-4716-B2C2-1E619AEC9A89}"/>
          </ac:spMkLst>
        </pc:spChg>
        <pc:spChg chg="add mod">
          <ac:chgData name="Grace Lee" userId="fd145552-a10d-4a31-a438-f8736fd84277" providerId="ADAL" clId="{56835480-2BB5-4545-A32E-6CA68AA69734}" dt="2021-09-13T04:25:35.777" v="2528" actId="1076"/>
          <ac:spMkLst>
            <pc:docMk/>
            <pc:sldMk cId="187938002" sldId="3307"/>
            <ac:spMk id="195" creationId="{21716DA0-562D-48A8-B021-85005F063029}"/>
          </ac:spMkLst>
        </pc:spChg>
        <pc:picChg chg="add del mod">
          <ac:chgData name="Grace Lee" userId="fd145552-a10d-4a31-a438-f8736fd84277" providerId="ADAL" clId="{56835480-2BB5-4545-A32E-6CA68AA69734}" dt="2021-09-13T01:31:44.395" v="46" actId="478"/>
          <ac:picMkLst>
            <pc:docMk/>
            <pc:sldMk cId="187938002" sldId="3307"/>
            <ac:picMk id="4" creationId="{3E600959-F502-4AF3-82BB-613A6DEB60DC}"/>
          </ac:picMkLst>
        </pc:picChg>
        <pc:picChg chg="add mod">
          <ac:chgData name="Grace Lee" userId="fd145552-a10d-4a31-a438-f8736fd84277" providerId="ADAL" clId="{56835480-2BB5-4545-A32E-6CA68AA69734}" dt="2021-09-13T04:02:43.284" v="1988" actId="1036"/>
          <ac:picMkLst>
            <pc:docMk/>
            <pc:sldMk cId="187938002" sldId="3307"/>
            <ac:picMk id="6" creationId="{BC8612EB-7CA2-4DEE-BDEF-F8DDDF80D534}"/>
          </ac:picMkLst>
        </pc:picChg>
        <pc:picChg chg="add mod">
          <ac:chgData name="Grace Lee" userId="fd145552-a10d-4a31-a438-f8736fd84277" providerId="ADAL" clId="{56835480-2BB5-4545-A32E-6CA68AA69734}" dt="2021-09-13T04:02:43.284" v="1988" actId="1036"/>
          <ac:picMkLst>
            <pc:docMk/>
            <pc:sldMk cId="187938002" sldId="3307"/>
            <ac:picMk id="7" creationId="{7FB1E5D8-9C85-403E-885A-3F690338298A}"/>
          </ac:picMkLst>
        </pc:picChg>
        <pc:picChg chg="add mod">
          <ac:chgData name="Grace Lee" userId="fd145552-a10d-4a31-a438-f8736fd84277" providerId="ADAL" clId="{56835480-2BB5-4545-A32E-6CA68AA69734}" dt="2021-09-13T04:02:43.284" v="1988" actId="1036"/>
          <ac:picMkLst>
            <pc:docMk/>
            <pc:sldMk cId="187938002" sldId="3307"/>
            <ac:picMk id="8" creationId="{6595AECF-281B-402C-978D-232D26F9D20B}"/>
          </ac:picMkLst>
        </pc:picChg>
        <pc:picChg chg="add mod">
          <ac:chgData name="Grace Lee" userId="fd145552-a10d-4a31-a438-f8736fd84277" providerId="ADAL" clId="{56835480-2BB5-4545-A32E-6CA68AA69734}" dt="2021-09-13T04:02:43.284" v="1988" actId="1036"/>
          <ac:picMkLst>
            <pc:docMk/>
            <pc:sldMk cId="187938002" sldId="3307"/>
            <ac:picMk id="10" creationId="{B6A8F212-C495-45A6-BF2C-80AECC1DB4B5}"/>
          </ac:picMkLst>
        </pc:picChg>
      </pc:sldChg>
      <pc:sldChg chg="add del">
        <pc:chgData name="Grace Lee" userId="fd145552-a10d-4a31-a438-f8736fd84277" providerId="ADAL" clId="{56835480-2BB5-4545-A32E-6CA68AA69734}" dt="2021-09-13T05:21:50.853" v="3378" actId="47"/>
        <pc:sldMkLst>
          <pc:docMk/>
          <pc:sldMk cId="3756650979" sldId="3312"/>
        </pc:sldMkLst>
      </pc:sldChg>
      <pc:sldChg chg="add del">
        <pc:chgData name="Grace Lee" userId="fd145552-a10d-4a31-a438-f8736fd84277" providerId="ADAL" clId="{56835480-2BB5-4545-A32E-6CA68AA69734}" dt="2021-09-13T04:46:16.351" v="2617" actId="47"/>
        <pc:sldMkLst>
          <pc:docMk/>
          <pc:sldMk cId="3590060440" sldId="3315"/>
        </pc:sldMkLst>
      </pc:sldChg>
      <pc:sldChg chg="add del">
        <pc:chgData name="Grace Lee" userId="fd145552-a10d-4a31-a438-f8736fd84277" providerId="ADAL" clId="{56835480-2BB5-4545-A32E-6CA68AA69734}" dt="2021-09-13T05:08:02.505" v="3127" actId="47"/>
        <pc:sldMkLst>
          <pc:docMk/>
          <pc:sldMk cId="1871884465" sldId="4087"/>
        </pc:sldMkLst>
      </pc:sldChg>
      <pc:sldChg chg="add del">
        <pc:chgData name="Grace Lee" userId="fd145552-a10d-4a31-a438-f8736fd84277" providerId="ADAL" clId="{56835480-2BB5-4545-A32E-6CA68AA69734}" dt="2021-09-13T04:29:06.786" v="2556" actId="47"/>
        <pc:sldMkLst>
          <pc:docMk/>
          <pc:sldMk cId="4140844903" sldId="4103"/>
        </pc:sldMkLst>
      </pc:sldChg>
      <pc:sldChg chg="addSp delSp modSp add del mod">
        <pc:chgData name="Grace Lee" userId="fd145552-a10d-4a31-a438-f8736fd84277" providerId="ADAL" clId="{56835480-2BB5-4545-A32E-6CA68AA69734}" dt="2021-09-13T05:35:23.625" v="4190" actId="47"/>
        <pc:sldMkLst>
          <pc:docMk/>
          <pc:sldMk cId="1873900726" sldId="4118"/>
        </pc:sldMkLst>
        <pc:spChg chg="add del mod">
          <ac:chgData name="Grace Lee" userId="fd145552-a10d-4a31-a438-f8736fd84277" providerId="ADAL" clId="{56835480-2BB5-4545-A32E-6CA68AA69734}" dt="2021-09-13T04:46:20.856" v="2620"/>
          <ac:spMkLst>
            <pc:docMk/>
            <pc:sldMk cId="1873900726" sldId="4118"/>
            <ac:spMk id="4" creationId="{667F2D19-6990-453B-BEFD-D750CEE515D1}"/>
          </ac:spMkLst>
        </pc:spChg>
        <pc:spChg chg="add del mod">
          <ac:chgData name="Grace Lee" userId="fd145552-a10d-4a31-a438-f8736fd84277" providerId="ADAL" clId="{56835480-2BB5-4545-A32E-6CA68AA69734}" dt="2021-09-13T04:46:55.840" v="2627" actId="478"/>
          <ac:spMkLst>
            <pc:docMk/>
            <pc:sldMk cId="1873900726" sldId="4118"/>
            <ac:spMk id="6" creationId="{F57A06EF-4B4B-481A-A26C-58F00599E649}"/>
          </ac:spMkLst>
        </pc:spChg>
        <pc:graphicFrameChg chg="add del mod">
          <ac:chgData name="Grace Lee" userId="fd145552-a10d-4a31-a438-f8736fd84277" providerId="ADAL" clId="{56835480-2BB5-4545-A32E-6CA68AA69734}" dt="2021-09-13T04:46:58.701" v="2628" actId="478"/>
          <ac:graphicFrameMkLst>
            <pc:docMk/>
            <pc:sldMk cId="1873900726" sldId="4118"/>
            <ac:graphicFrameMk id="7" creationId="{DA28139A-7943-4B6B-BE4C-1CE1FFFECDD3}"/>
          </ac:graphicFrameMkLst>
        </pc:graphicFrameChg>
      </pc:sldChg>
      <pc:sldChg chg="addSp delSp modSp add mod ord">
        <pc:chgData name="Grace Lee" userId="fd145552-a10d-4a31-a438-f8736fd84277" providerId="ADAL" clId="{56835480-2BB5-4545-A32E-6CA68AA69734}" dt="2021-09-13T05:45:53.864" v="4295" actId="14100"/>
        <pc:sldMkLst>
          <pc:docMk/>
          <pc:sldMk cId="884396843" sldId="4119"/>
        </pc:sldMkLst>
        <pc:spChg chg="mod">
          <ac:chgData name="Grace Lee" userId="fd145552-a10d-4a31-a438-f8736fd84277" providerId="ADAL" clId="{56835480-2BB5-4545-A32E-6CA68AA69734}" dt="2021-09-13T04:51:17.822" v="2663" actId="2711"/>
          <ac:spMkLst>
            <pc:docMk/>
            <pc:sldMk cId="884396843" sldId="4119"/>
            <ac:spMk id="3" creationId="{3F736E9F-099F-6E49-8413-5352C763CACD}"/>
          </ac:spMkLst>
        </pc:spChg>
        <pc:spChg chg="del">
          <ac:chgData name="Grace Lee" userId="fd145552-a10d-4a31-a438-f8736fd84277" providerId="ADAL" clId="{56835480-2BB5-4545-A32E-6CA68AA69734}" dt="2021-09-13T04:48:46.499" v="2630" actId="478"/>
          <ac:spMkLst>
            <pc:docMk/>
            <pc:sldMk cId="884396843" sldId="4119"/>
            <ac:spMk id="12" creationId="{9F619023-99B5-D048-963C-2919297AAD8E}"/>
          </ac:spMkLst>
        </pc:spChg>
        <pc:spChg chg="del">
          <ac:chgData name="Grace Lee" userId="fd145552-a10d-4a31-a438-f8736fd84277" providerId="ADAL" clId="{56835480-2BB5-4545-A32E-6CA68AA69734}" dt="2021-09-13T04:48:46.499" v="2630" actId="478"/>
          <ac:spMkLst>
            <pc:docMk/>
            <pc:sldMk cId="884396843" sldId="4119"/>
            <ac:spMk id="14" creationId="{EE644C53-6D18-3B45-8ACC-5347164E1A9E}"/>
          </ac:spMkLst>
        </pc:spChg>
        <pc:spChg chg="del">
          <ac:chgData name="Grace Lee" userId="fd145552-a10d-4a31-a438-f8736fd84277" providerId="ADAL" clId="{56835480-2BB5-4545-A32E-6CA68AA69734}" dt="2021-09-13T04:43:43.732" v="2611" actId="478"/>
          <ac:spMkLst>
            <pc:docMk/>
            <pc:sldMk cId="884396843" sldId="4119"/>
            <ac:spMk id="33" creationId="{13B1ABB1-D276-4877-8BAE-251F885C5B0D}"/>
          </ac:spMkLst>
        </pc:spChg>
        <pc:spChg chg="del">
          <ac:chgData name="Grace Lee" userId="fd145552-a10d-4a31-a438-f8736fd84277" providerId="ADAL" clId="{56835480-2BB5-4545-A32E-6CA68AA69734}" dt="2021-09-13T04:43:43.732" v="2611" actId="478"/>
          <ac:spMkLst>
            <pc:docMk/>
            <pc:sldMk cId="884396843" sldId="4119"/>
            <ac:spMk id="34" creationId="{E665CCA3-EA18-4949-9A2F-234BF75534EC}"/>
          </ac:spMkLst>
        </pc:spChg>
        <pc:spChg chg="del">
          <ac:chgData name="Grace Lee" userId="fd145552-a10d-4a31-a438-f8736fd84277" providerId="ADAL" clId="{56835480-2BB5-4545-A32E-6CA68AA69734}" dt="2021-09-13T04:48:46.499" v="2630" actId="478"/>
          <ac:spMkLst>
            <pc:docMk/>
            <pc:sldMk cId="884396843" sldId="4119"/>
            <ac:spMk id="43" creationId="{7D43FE39-F0D3-4954-94D6-877CD290529C}"/>
          </ac:spMkLst>
        </pc:spChg>
        <pc:spChg chg="del">
          <ac:chgData name="Grace Lee" userId="fd145552-a10d-4a31-a438-f8736fd84277" providerId="ADAL" clId="{56835480-2BB5-4545-A32E-6CA68AA69734}" dt="2021-09-13T04:48:46.499" v="2630" actId="478"/>
          <ac:spMkLst>
            <pc:docMk/>
            <pc:sldMk cId="884396843" sldId="4119"/>
            <ac:spMk id="44" creationId="{CA11516F-B663-47F7-9CB4-6E1B18A2CB7D}"/>
          </ac:spMkLst>
        </pc:spChg>
        <pc:spChg chg="del">
          <ac:chgData name="Grace Lee" userId="fd145552-a10d-4a31-a438-f8736fd84277" providerId="ADAL" clId="{56835480-2BB5-4545-A32E-6CA68AA69734}" dt="2021-09-13T04:43:43.732" v="2611" actId="478"/>
          <ac:spMkLst>
            <pc:docMk/>
            <pc:sldMk cId="884396843" sldId="4119"/>
            <ac:spMk id="45" creationId="{D5C3ED16-AD74-42CC-ABF5-155637BC7D6C}"/>
          </ac:spMkLst>
        </pc:spChg>
        <pc:spChg chg="del">
          <ac:chgData name="Grace Lee" userId="fd145552-a10d-4a31-a438-f8736fd84277" providerId="ADAL" clId="{56835480-2BB5-4545-A32E-6CA68AA69734}" dt="2021-09-13T04:48:46.499" v="2630" actId="478"/>
          <ac:spMkLst>
            <pc:docMk/>
            <pc:sldMk cId="884396843" sldId="4119"/>
            <ac:spMk id="46" creationId="{5958ABF2-247D-4ED1-82D8-E5A51F47A351}"/>
          </ac:spMkLst>
        </pc:spChg>
        <pc:spChg chg="del">
          <ac:chgData name="Grace Lee" userId="fd145552-a10d-4a31-a438-f8736fd84277" providerId="ADAL" clId="{56835480-2BB5-4545-A32E-6CA68AA69734}" dt="2021-09-13T04:48:46.499" v="2630" actId="478"/>
          <ac:spMkLst>
            <pc:docMk/>
            <pc:sldMk cId="884396843" sldId="4119"/>
            <ac:spMk id="47" creationId="{0AF9B300-DEB3-4E6E-83FA-5563CD638822}"/>
          </ac:spMkLst>
        </pc:spChg>
        <pc:spChg chg="del">
          <ac:chgData name="Grace Lee" userId="fd145552-a10d-4a31-a438-f8736fd84277" providerId="ADAL" clId="{56835480-2BB5-4545-A32E-6CA68AA69734}" dt="2021-09-13T04:43:43.732" v="2611" actId="478"/>
          <ac:spMkLst>
            <pc:docMk/>
            <pc:sldMk cId="884396843" sldId="4119"/>
            <ac:spMk id="48" creationId="{CE1789F8-D90A-417B-B724-1C8CC2CAB633}"/>
          </ac:spMkLst>
        </pc:spChg>
        <pc:spChg chg="del">
          <ac:chgData name="Grace Lee" userId="fd145552-a10d-4a31-a438-f8736fd84277" providerId="ADAL" clId="{56835480-2BB5-4545-A32E-6CA68AA69734}" dt="2021-09-13T04:48:46.499" v="2630" actId="478"/>
          <ac:spMkLst>
            <pc:docMk/>
            <pc:sldMk cId="884396843" sldId="4119"/>
            <ac:spMk id="50" creationId="{A31F744C-0128-46AD-AC4B-4B41C48CEDF0}"/>
          </ac:spMkLst>
        </pc:spChg>
        <pc:spChg chg="del">
          <ac:chgData name="Grace Lee" userId="fd145552-a10d-4a31-a438-f8736fd84277" providerId="ADAL" clId="{56835480-2BB5-4545-A32E-6CA68AA69734}" dt="2021-09-13T04:48:46.499" v="2630" actId="478"/>
          <ac:spMkLst>
            <pc:docMk/>
            <pc:sldMk cId="884396843" sldId="4119"/>
            <ac:spMk id="51" creationId="{5D5FCFB2-456C-406F-8954-FD516F8433CE}"/>
          </ac:spMkLst>
        </pc:spChg>
        <pc:spChg chg="del">
          <ac:chgData name="Grace Lee" userId="fd145552-a10d-4a31-a438-f8736fd84277" providerId="ADAL" clId="{56835480-2BB5-4545-A32E-6CA68AA69734}" dt="2021-09-13T04:48:46.499" v="2630" actId="478"/>
          <ac:spMkLst>
            <pc:docMk/>
            <pc:sldMk cId="884396843" sldId="4119"/>
            <ac:spMk id="52" creationId="{D3911288-5557-40BC-9242-7FB0F239B2D3}"/>
          </ac:spMkLst>
        </pc:spChg>
        <pc:spChg chg="del">
          <ac:chgData name="Grace Lee" userId="fd145552-a10d-4a31-a438-f8736fd84277" providerId="ADAL" clId="{56835480-2BB5-4545-A32E-6CA68AA69734}" dt="2021-09-13T04:48:46.499" v="2630" actId="478"/>
          <ac:spMkLst>
            <pc:docMk/>
            <pc:sldMk cId="884396843" sldId="4119"/>
            <ac:spMk id="53" creationId="{E2049701-CA4D-4E98-BAB8-A7EFF1DDA945}"/>
          </ac:spMkLst>
        </pc:spChg>
        <pc:spChg chg="del">
          <ac:chgData name="Grace Lee" userId="fd145552-a10d-4a31-a438-f8736fd84277" providerId="ADAL" clId="{56835480-2BB5-4545-A32E-6CA68AA69734}" dt="2021-09-13T04:43:43.732" v="2611" actId="478"/>
          <ac:spMkLst>
            <pc:docMk/>
            <pc:sldMk cId="884396843" sldId="4119"/>
            <ac:spMk id="54" creationId="{B2962D8F-D897-4E77-BEF6-A9EB62576127}"/>
          </ac:spMkLst>
        </pc:spChg>
        <pc:spChg chg="del">
          <ac:chgData name="Grace Lee" userId="fd145552-a10d-4a31-a438-f8736fd84277" providerId="ADAL" clId="{56835480-2BB5-4545-A32E-6CA68AA69734}" dt="2021-09-13T04:43:43.732" v="2611" actId="478"/>
          <ac:spMkLst>
            <pc:docMk/>
            <pc:sldMk cId="884396843" sldId="4119"/>
            <ac:spMk id="57" creationId="{FA2A4811-CACA-468B-8ADF-7842C0823E64}"/>
          </ac:spMkLst>
        </pc:spChg>
        <pc:spChg chg="del">
          <ac:chgData name="Grace Lee" userId="fd145552-a10d-4a31-a438-f8736fd84277" providerId="ADAL" clId="{56835480-2BB5-4545-A32E-6CA68AA69734}" dt="2021-09-13T04:43:43.732" v="2611" actId="478"/>
          <ac:spMkLst>
            <pc:docMk/>
            <pc:sldMk cId="884396843" sldId="4119"/>
            <ac:spMk id="63" creationId="{A6CF363A-5E67-471D-96A1-BB99C4BF1B28}"/>
          </ac:spMkLst>
        </pc:spChg>
        <pc:spChg chg="del">
          <ac:chgData name="Grace Lee" userId="fd145552-a10d-4a31-a438-f8736fd84277" providerId="ADAL" clId="{56835480-2BB5-4545-A32E-6CA68AA69734}" dt="2021-09-13T04:48:46.499" v="2630" actId="478"/>
          <ac:spMkLst>
            <pc:docMk/>
            <pc:sldMk cId="884396843" sldId="4119"/>
            <ac:spMk id="64" creationId="{BAC3AD93-4EBD-4BE0-8DE9-83249CB83F1C}"/>
          </ac:spMkLst>
        </pc:spChg>
        <pc:spChg chg="del">
          <ac:chgData name="Grace Lee" userId="fd145552-a10d-4a31-a438-f8736fd84277" providerId="ADAL" clId="{56835480-2BB5-4545-A32E-6CA68AA69734}" dt="2021-09-13T04:48:46.499" v="2630" actId="478"/>
          <ac:spMkLst>
            <pc:docMk/>
            <pc:sldMk cId="884396843" sldId="4119"/>
            <ac:spMk id="68" creationId="{24FDD7D9-55CB-4156-8D71-084078C8F69F}"/>
          </ac:spMkLst>
        </pc:spChg>
        <pc:spChg chg="del">
          <ac:chgData name="Grace Lee" userId="fd145552-a10d-4a31-a438-f8736fd84277" providerId="ADAL" clId="{56835480-2BB5-4545-A32E-6CA68AA69734}" dt="2021-09-13T04:48:46.499" v="2630" actId="478"/>
          <ac:spMkLst>
            <pc:docMk/>
            <pc:sldMk cId="884396843" sldId="4119"/>
            <ac:spMk id="69" creationId="{BFAA5FC3-2BF1-406E-B12D-BC8781E2E86A}"/>
          </ac:spMkLst>
        </pc:spChg>
        <pc:spChg chg="del">
          <ac:chgData name="Grace Lee" userId="fd145552-a10d-4a31-a438-f8736fd84277" providerId="ADAL" clId="{56835480-2BB5-4545-A32E-6CA68AA69734}" dt="2021-09-13T04:48:46.499" v="2630" actId="478"/>
          <ac:spMkLst>
            <pc:docMk/>
            <pc:sldMk cId="884396843" sldId="4119"/>
            <ac:spMk id="73" creationId="{D121DF87-1DBC-43CB-806F-942268B34984}"/>
          </ac:spMkLst>
        </pc:spChg>
        <pc:spChg chg="del">
          <ac:chgData name="Grace Lee" userId="fd145552-a10d-4a31-a438-f8736fd84277" providerId="ADAL" clId="{56835480-2BB5-4545-A32E-6CA68AA69734}" dt="2021-09-13T04:48:46.499" v="2630" actId="478"/>
          <ac:spMkLst>
            <pc:docMk/>
            <pc:sldMk cId="884396843" sldId="4119"/>
            <ac:spMk id="76" creationId="{506AA956-83B2-49A7-BBEF-2B6AC420A805}"/>
          </ac:spMkLst>
        </pc:spChg>
        <pc:spChg chg="del">
          <ac:chgData name="Grace Lee" userId="fd145552-a10d-4a31-a438-f8736fd84277" providerId="ADAL" clId="{56835480-2BB5-4545-A32E-6CA68AA69734}" dt="2021-09-13T04:48:46.499" v="2630" actId="478"/>
          <ac:spMkLst>
            <pc:docMk/>
            <pc:sldMk cId="884396843" sldId="4119"/>
            <ac:spMk id="77" creationId="{C61E376B-77C1-409B-83EB-264467C1DB14}"/>
          </ac:spMkLst>
        </pc:spChg>
        <pc:spChg chg="del">
          <ac:chgData name="Grace Lee" userId="fd145552-a10d-4a31-a438-f8736fd84277" providerId="ADAL" clId="{56835480-2BB5-4545-A32E-6CA68AA69734}" dt="2021-09-13T04:48:46.499" v="2630" actId="478"/>
          <ac:spMkLst>
            <pc:docMk/>
            <pc:sldMk cId="884396843" sldId="4119"/>
            <ac:spMk id="78" creationId="{C9330A01-3CCE-4132-8472-47F2722AF91D}"/>
          </ac:spMkLst>
        </pc:spChg>
        <pc:spChg chg="del">
          <ac:chgData name="Grace Lee" userId="fd145552-a10d-4a31-a438-f8736fd84277" providerId="ADAL" clId="{56835480-2BB5-4545-A32E-6CA68AA69734}" dt="2021-09-13T04:48:46.499" v="2630" actId="478"/>
          <ac:spMkLst>
            <pc:docMk/>
            <pc:sldMk cId="884396843" sldId="4119"/>
            <ac:spMk id="79" creationId="{82502245-459B-47CB-B032-0F07547370D2}"/>
          </ac:spMkLst>
        </pc:spChg>
        <pc:spChg chg="del">
          <ac:chgData name="Grace Lee" userId="fd145552-a10d-4a31-a438-f8736fd84277" providerId="ADAL" clId="{56835480-2BB5-4545-A32E-6CA68AA69734}" dt="2021-09-13T04:48:46.499" v="2630" actId="478"/>
          <ac:spMkLst>
            <pc:docMk/>
            <pc:sldMk cId="884396843" sldId="4119"/>
            <ac:spMk id="80" creationId="{85C8FBD3-427E-438E-8EEA-2643D9F29E92}"/>
          </ac:spMkLst>
        </pc:spChg>
        <pc:spChg chg="del">
          <ac:chgData name="Grace Lee" userId="fd145552-a10d-4a31-a438-f8736fd84277" providerId="ADAL" clId="{56835480-2BB5-4545-A32E-6CA68AA69734}" dt="2021-09-13T04:48:46.499" v="2630" actId="478"/>
          <ac:spMkLst>
            <pc:docMk/>
            <pc:sldMk cId="884396843" sldId="4119"/>
            <ac:spMk id="81" creationId="{1970C673-2FFB-4BB5-B716-E360AD1E5706}"/>
          </ac:spMkLst>
        </pc:spChg>
        <pc:spChg chg="del">
          <ac:chgData name="Grace Lee" userId="fd145552-a10d-4a31-a438-f8736fd84277" providerId="ADAL" clId="{56835480-2BB5-4545-A32E-6CA68AA69734}" dt="2021-09-13T04:48:46.499" v="2630" actId="478"/>
          <ac:spMkLst>
            <pc:docMk/>
            <pc:sldMk cId="884396843" sldId="4119"/>
            <ac:spMk id="83" creationId="{6CF9FFEC-7EC9-49CF-8EBB-91285658E3D3}"/>
          </ac:spMkLst>
        </pc:spChg>
        <pc:spChg chg="add mod">
          <ac:chgData name="Grace Lee" userId="fd145552-a10d-4a31-a438-f8736fd84277" providerId="ADAL" clId="{56835480-2BB5-4545-A32E-6CA68AA69734}" dt="2021-09-13T05:37:57.795" v="4228" actId="1035"/>
          <ac:spMkLst>
            <pc:docMk/>
            <pc:sldMk cId="884396843" sldId="4119"/>
            <ac:spMk id="85" creationId="{C47DF526-2797-4792-8BE1-5AD5ED023296}"/>
          </ac:spMkLst>
        </pc:spChg>
        <pc:spChg chg="add mod">
          <ac:chgData name="Grace Lee" userId="fd145552-a10d-4a31-a438-f8736fd84277" providerId="ADAL" clId="{56835480-2BB5-4545-A32E-6CA68AA69734}" dt="2021-09-13T05:37:57.795" v="4228" actId="1035"/>
          <ac:spMkLst>
            <pc:docMk/>
            <pc:sldMk cId="884396843" sldId="4119"/>
            <ac:spMk id="86" creationId="{91FC40A4-A51E-491E-9B8B-06E1E1586D86}"/>
          </ac:spMkLst>
        </pc:spChg>
        <pc:spChg chg="add mod">
          <ac:chgData name="Grace Lee" userId="fd145552-a10d-4a31-a438-f8736fd84277" providerId="ADAL" clId="{56835480-2BB5-4545-A32E-6CA68AA69734}" dt="2021-09-13T05:37:57.795" v="4228" actId="1035"/>
          <ac:spMkLst>
            <pc:docMk/>
            <pc:sldMk cId="884396843" sldId="4119"/>
            <ac:spMk id="87" creationId="{B0FDE50E-4742-4FD5-985A-FAD1C60C9447}"/>
          </ac:spMkLst>
        </pc:spChg>
        <pc:spChg chg="add mod">
          <ac:chgData name="Grace Lee" userId="fd145552-a10d-4a31-a438-f8736fd84277" providerId="ADAL" clId="{56835480-2BB5-4545-A32E-6CA68AA69734}" dt="2021-09-13T05:37:57.795" v="4228" actId="1035"/>
          <ac:spMkLst>
            <pc:docMk/>
            <pc:sldMk cId="884396843" sldId="4119"/>
            <ac:spMk id="88" creationId="{17DD1B6A-4BAB-4C2F-BB59-7374CC25F347}"/>
          </ac:spMkLst>
        </pc:spChg>
        <pc:spChg chg="add mod">
          <ac:chgData name="Grace Lee" userId="fd145552-a10d-4a31-a438-f8736fd84277" providerId="ADAL" clId="{56835480-2BB5-4545-A32E-6CA68AA69734}" dt="2021-09-13T05:37:57.795" v="4228" actId="1035"/>
          <ac:spMkLst>
            <pc:docMk/>
            <pc:sldMk cId="884396843" sldId="4119"/>
            <ac:spMk id="89" creationId="{DB9D7741-0521-4EFC-A487-909D4316F516}"/>
          </ac:spMkLst>
        </pc:spChg>
        <pc:spChg chg="add mod">
          <ac:chgData name="Grace Lee" userId="fd145552-a10d-4a31-a438-f8736fd84277" providerId="ADAL" clId="{56835480-2BB5-4545-A32E-6CA68AA69734}" dt="2021-09-13T05:37:57.795" v="4228" actId="1035"/>
          <ac:spMkLst>
            <pc:docMk/>
            <pc:sldMk cId="884396843" sldId="4119"/>
            <ac:spMk id="90" creationId="{58C45246-94CA-4DCA-9AB3-E4AEA022B964}"/>
          </ac:spMkLst>
        </pc:spChg>
        <pc:spChg chg="add mod">
          <ac:chgData name="Grace Lee" userId="fd145552-a10d-4a31-a438-f8736fd84277" providerId="ADAL" clId="{56835480-2BB5-4545-A32E-6CA68AA69734}" dt="2021-09-13T05:37:57.795" v="4228" actId="1035"/>
          <ac:spMkLst>
            <pc:docMk/>
            <pc:sldMk cId="884396843" sldId="4119"/>
            <ac:spMk id="91" creationId="{CBBECDFD-4FDD-4694-91C5-510B31F8F324}"/>
          </ac:spMkLst>
        </pc:spChg>
        <pc:spChg chg="add mod">
          <ac:chgData name="Grace Lee" userId="fd145552-a10d-4a31-a438-f8736fd84277" providerId="ADAL" clId="{56835480-2BB5-4545-A32E-6CA68AA69734}" dt="2021-09-13T05:37:57.795" v="4228" actId="1035"/>
          <ac:spMkLst>
            <pc:docMk/>
            <pc:sldMk cId="884396843" sldId="4119"/>
            <ac:spMk id="92" creationId="{F803AAF6-CD73-4A4B-B968-C39DBA71447C}"/>
          </ac:spMkLst>
        </pc:spChg>
        <pc:spChg chg="del">
          <ac:chgData name="Grace Lee" userId="fd145552-a10d-4a31-a438-f8736fd84277" providerId="ADAL" clId="{56835480-2BB5-4545-A32E-6CA68AA69734}" dt="2021-09-13T04:48:46.499" v="2630" actId="478"/>
          <ac:spMkLst>
            <pc:docMk/>
            <pc:sldMk cId="884396843" sldId="4119"/>
            <ac:spMk id="93" creationId="{BF9A3230-00EC-4629-977A-A8CCE79ACC91}"/>
          </ac:spMkLst>
        </pc:spChg>
        <pc:spChg chg="add mod">
          <ac:chgData name="Grace Lee" userId="fd145552-a10d-4a31-a438-f8736fd84277" providerId="ADAL" clId="{56835480-2BB5-4545-A32E-6CA68AA69734}" dt="2021-09-13T05:37:57.795" v="4228" actId="1035"/>
          <ac:spMkLst>
            <pc:docMk/>
            <pc:sldMk cId="884396843" sldId="4119"/>
            <ac:spMk id="94" creationId="{6EF25402-CA98-4E30-8D3C-ADB64DF8C0F0}"/>
          </ac:spMkLst>
        </pc:spChg>
        <pc:spChg chg="add mod">
          <ac:chgData name="Grace Lee" userId="fd145552-a10d-4a31-a438-f8736fd84277" providerId="ADAL" clId="{56835480-2BB5-4545-A32E-6CA68AA69734}" dt="2021-09-13T05:37:57.795" v="4228" actId="1035"/>
          <ac:spMkLst>
            <pc:docMk/>
            <pc:sldMk cId="884396843" sldId="4119"/>
            <ac:spMk id="95" creationId="{5A04142E-B117-4114-8144-C49BC7C5357B}"/>
          </ac:spMkLst>
        </pc:spChg>
        <pc:spChg chg="del">
          <ac:chgData name="Grace Lee" userId="fd145552-a10d-4a31-a438-f8736fd84277" providerId="ADAL" clId="{56835480-2BB5-4545-A32E-6CA68AA69734}" dt="2021-09-13T04:48:46.499" v="2630" actId="478"/>
          <ac:spMkLst>
            <pc:docMk/>
            <pc:sldMk cId="884396843" sldId="4119"/>
            <ac:spMk id="96" creationId="{A000FC63-CB2D-4BBE-8DE3-C3D6114AF543}"/>
          </ac:spMkLst>
        </pc:spChg>
        <pc:spChg chg="add mod">
          <ac:chgData name="Grace Lee" userId="fd145552-a10d-4a31-a438-f8736fd84277" providerId="ADAL" clId="{56835480-2BB5-4545-A32E-6CA68AA69734}" dt="2021-09-13T05:37:57.795" v="4228" actId="1035"/>
          <ac:spMkLst>
            <pc:docMk/>
            <pc:sldMk cId="884396843" sldId="4119"/>
            <ac:spMk id="97" creationId="{92C73712-FAA8-4948-92B4-DA31886C5B49}"/>
          </ac:spMkLst>
        </pc:spChg>
        <pc:spChg chg="add mod">
          <ac:chgData name="Grace Lee" userId="fd145552-a10d-4a31-a438-f8736fd84277" providerId="ADAL" clId="{56835480-2BB5-4545-A32E-6CA68AA69734}" dt="2021-09-13T05:37:57.795" v="4228" actId="1035"/>
          <ac:spMkLst>
            <pc:docMk/>
            <pc:sldMk cId="884396843" sldId="4119"/>
            <ac:spMk id="98" creationId="{1881009A-AC4B-4615-BD56-7C2271DD3E1A}"/>
          </ac:spMkLst>
        </pc:spChg>
        <pc:spChg chg="add mod">
          <ac:chgData name="Grace Lee" userId="fd145552-a10d-4a31-a438-f8736fd84277" providerId="ADAL" clId="{56835480-2BB5-4545-A32E-6CA68AA69734}" dt="2021-09-13T05:37:57.795" v="4228" actId="1035"/>
          <ac:spMkLst>
            <pc:docMk/>
            <pc:sldMk cId="884396843" sldId="4119"/>
            <ac:spMk id="99" creationId="{FABCD218-6E14-4AB5-8317-0C49B6433658}"/>
          </ac:spMkLst>
        </pc:spChg>
        <pc:spChg chg="add mod">
          <ac:chgData name="Grace Lee" userId="fd145552-a10d-4a31-a438-f8736fd84277" providerId="ADAL" clId="{56835480-2BB5-4545-A32E-6CA68AA69734}" dt="2021-09-13T05:37:57.795" v="4228" actId="1035"/>
          <ac:spMkLst>
            <pc:docMk/>
            <pc:sldMk cId="884396843" sldId="4119"/>
            <ac:spMk id="100" creationId="{A0655893-0BF9-43AE-AB96-68995F31142A}"/>
          </ac:spMkLst>
        </pc:spChg>
        <pc:spChg chg="add mod">
          <ac:chgData name="Grace Lee" userId="fd145552-a10d-4a31-a438-f8736fd84277" providerId="ADAL" clId="{56835480-2BB5-4545-A32E-6CA68AA69734}" dt="2021-09-13T05:37:57.795" v="4228" actId="1035"/>
          <ac:spMkLst>
            <pc:docMk/>
            <pc:sldMk cId="884396843" sldId="4119"/>
            <ac:spMk id="101" creationId="{10498E5E-7735-4C23-952C-915CD73C0385}"/>
          </ac:spMkLst>
        </pc:spChg>
        <pc:spChg chg="add mod">
          <ac:chgData name="Grace Lee" userId="fd145552-a10d-4a31-a438-f8736fd84277" providerId="ADAL" clId="{56835480-2BB5-4545-A32E-6CA68AA69734}" dt="2021-09-13T05:37:57.795" v="4228" actId="1035"/>
          <ac:spMkLst>
            <pc:docMk/>
            <pc:sldMk cId="884396843" sldId="4119"/>
            <ac:spMk id="102" creationId="{D18C9A4A-48FC-4E7D-A8DB-100653C6540A}"/>
          </ac:spMkLst>
        </pc:spChg>
        <pc:spChg chg="add mod">
          <ac:chgData name="Grace Lee" userId="fd145552-a10d-4a31-a438-f8736fd84277" providerId="ADAL" clId="{56835480-2BB5-4545-A32E-6CA68AA69734}" dt="2021-09-13T05:37:57.795" v="4228" actId="1035"/>
          <ac:spMkLst>
            <pc:docMk/>
            <pc:sldMk cId="884396843" sldId="4119"/>
            <ac:spMk id="103" creationId="{8746DBF3-577F-4828-8DA1-843BDFF8B4A9}"/>
          </ac:spMkLst>
        </pc:spChg>
        <pc:spChg chg="del">
          <ac:chgData name="Grace Lee" userId="fd145552-a10d-4a31-a438-f8736fd84277" providerId="ADAL" clId="{56835480-2BB5-4545-A32E-6CA68AA69734}" dt="2021-09-13T04:48:46.499" v="2630" actId="478"/>
          <ac:spMkLst>
            <pc:docMk/>
            <pc:sldMk cId="884396843" sldId="4119"/>
            <ac:spMk id="104" creationId="{F81F728A-F6E0-4035-B83C-178C94467706}"/>
          </ac:spMkLst>
        </pc:spChg>
        <pc:spChg chg="del">
          <ac:chgData name="Grace Lee" userId="fd145552-a10d-4a31-a438-f8736fd84277" providerId="ADAL" clId="{56835480-2BB5-4545-A32E-6CA68AA69734}" dt="2021-09-13T04:48:46.499" v="2630" actId="478"/>
          <ac:spMkLst>
            <pc:docMk/>
            <pc:sldMk cId="884396843" sldId="4119"/>
            <ac:spMk id="105" creationId="{46483DB8-79F9-4FBE-9B21-E97A274C2DEC}"/>
          </ac:spMkLst>
        </pc:spChg>
        <pc:spChg chg="del">
          <ac:chgData name="Grace Lee" userId="fd145552-a10d-4a31-a438-f8736fd84277" providerId="ADAL" clId="{56835480-2BB5-4545-A32E-6CA68AA69734}" dt="2021-09-13T04:48:46.499" v="2630" actId="478"/>
          <ac:spMkLst>
            <pc:docMk/>
            <pc:sldMk cId="884396843" sldId="4119"/>
            <ac:spMk id="106" creationId="{DDA53C12-4572-4125-91CB-0096DC97ACEE}"/>
          </ac:spMkLst>
        </pc:spChg>
        <pc:spChg chg="del">
          <ac:chgData name="Grace Lee" userId="fd145552-a10d-4a31-a438-f8736fd84277" providerId="ADAL" clId="{56835480-2BB5-4545-A32E-6CA68AA69734}" dt="2021-09-13T04:48:46.499" v="2630" actId="478"/>
          <ac:spMkLst>
            <pc:docMk/>
            <pc:sldMk cId="884396843" sldId="4119"/>
            <ac:spMk id="107" creationId="{548FE39C-1314-44EC-A0B3-37B35B05DB8B}"/>
          </ac:spMkLst>
        </pc:spChg>
        <pc:spChg chg="add mod">
          <ac:chgData name="Grace Lee" userId="fd145552-a10d-4a31-a438-f8736fd84277" providerId="ADAL" clId="{56835480-2BB5-4545-A32E-6CA68AA69734}" dt="2021-09-13T05:37:57.795" v="4228" actId="1035"/>
          <ac:spMkLst>
            <pc:docMk/>
            <pc:sldMk cId="884396843" sldId="4119"/>
            <ac:spMk id="108" creationId="{501EA496-7C42-44F0-B647-2935D4331678}"/>
          </ac:spMkLst>
        </pc:spChg>
        <pc:spChg chg="add mod">
          <ac:chgData name="Grace Lee" userId="fd145552-a10d-4a31-a438-f8736fd84277" providerId="ADAL" clId="{56835480-2BB5-4545-A32E-6CA68AA69734}" dt="2021-09-13T05:37:57.795" v="4228" actId="1035"/>
          <ac:spMkLst>
            <pc:docMk/>
            <pc:sldMk cId="884396843" sldId="4119"/>
            <ac:spMk id="109" creationId="{467FB290-A875-4840-9875-ED489406C9F2}"/>
          </ac:spMkLst>
        </pc:spChg>
        <pc:spChg chg="del">
          <ac:chgData name="Grace Lee" userId="fd145552-a10d-4a31-a438-f8736fd84277" providerId="ADAL" clId="{56835480-2BB5-4545-A32E-6CA68AA69734}" dt="2021-09-13T04:48:46.499" v="2630" actId="478"/>
          <ac:spMkLst>
            <pc:docMk/>
            <pc:sldMk cId="884396843" sldId="4119"/>
            <ac:spMk id="110" creationId="{DA178DCD-074A-482D-856E-184518C9F5C8}"/>
          </ac:spMkLst>
        </pc:spChg>
        <pc:spChg chg="del">
          <ac:chgData name="Grace Lee" userId="fd145552-a10d-4a31-a438-f8736fd84277" providerId="ADAL" clId="{56835480-2BB5-4545-A32E-6CA68AA69734}" dt="2021-09-13T04:48:46.499" v="2630" actId="478"/>
          <ac:spMkLst>
            <pc:docMk/>
            <pc:sldMk cId="884396843" sldId="4119"/>
            <ac:spMk id="111" creationId="{1793323B-16EA-4D26-913D-D89B75512963}"/>
          </ac:spMkLst>
        </pc:spChg>
        <pc:spChg chg="del">
          <ac:chgData name="Grace Lee" userId="fd145552-a10d-4a31-a438-f8736fd84277" providerId="ADAL" clId="{56835480-2BB5-4545-A32E-6CA68AA69734}" dt="2021-09-13T04:43:43.732" v="2611" actId="478"/>
          <ac:spMkLst>
            <pc:docMk/>
            <pc:sldMk cId="884396843" sldId="4119"/>
            <ac:spMk id="112" creationId="{46F678A2-6687-4DBF-997D-4B943CDC732C}"/>
          </ac:spMkLst>
        </pc:spChg>
        <pc:spChg chg="del">
          <ac:chgData name="Grace Lee" userId="fd145552-a10d-4a31-a438-f8736fd84277" providerId="ADAL" clId="{56835480-2BB5-4545-A32E-6CA68AA69734}" dt="2021-09-13T04:43:43.732" v="2611" actId="478"/>
          <ac:spMkLst>
            <pc:docMk/>
            <pc:sldMk cId="884396843" sldId="4119"/>
            <ac:spMk id="113" creationId="{423CAA18-74F3-473B-A719-8E275B53711E}"/>
          </ac:spMkLst>
        </pc:spChg>
        <pc:spChg chg="add mod">
          <ac:chgData name="Grace Lee" userId="fd145552-a10d-4a31-a438-f8736fd84277" providerId="ADAL" clId="{56835480-2BB5-4545-A32E-6CA68AA69734}" dt="2021-09-13T05:37:57.795" v="4228" actId="1035"/>
          <ac:spMkLst>
            <pc:docMk/>
            <pc:sldMk cId="884396843" sldId="4119"/>
            <ac:spMk id="114" creationId="{A0541818-56FD-430F-BAAE-C3F0E547F923}"/>
          </ac:spMkLst>
        </pc:spChg>
        <pc:spChg chg="add mod">
          <ac:chgData name="Grace Lee" userId="fd145552-a10d-4a31-a438-f8736fd84277" providerId="ADAL" clId="{56835480-2BB5-4545-A32E-6CA68AA69734}" dt="2021-09-13T05:37:57.795" v="4228" actId="1035"/>
          <ac:spMkLst>
            <pc:docMk/>
            <pc:sldMk cId="884396843" sldId="4119"/>
            <ac:spMk id="115" creationId="{3A30BAD5-FEAF-47A8-BB90-E6BA645F90C7}"/>
          </ac:spMkLst>
        </pc:spChg>
        <pc:spChg chg="add mod">
          <ac:chgData name="Grace Lee" userId="fd145552-a10d-4a31-a438-f8736fd84277" providerId="ADAL" clId="{56835480-2BB5-4545-A32E-6CA68AA69734}" dt="2021-09-13T05:37:57.795" v="4228" actId="1035"/>
          <ac:spMkLst>
            <pc:docMk/>
            <pc:sldMk cId="884396843" sldId="4119"/>
            <ac:spMk id="116" creationId="{EBF52669-1F24-488D-B67E-3930E18BDFBE}"/>
          </ac:spMkLst>
        </pc:spChg>
        <pc:spChg chg="add mod">
          <ac:chgData name="Grace Lee" userId="fd145552-a10d-4a31-a438-f8736fd84277" providerId="ADAL" clId="{56835480-2BB5-4545-A32E-6CA68AA69734}" dt="2021-09-13T05:37:57.795" v="4228" actId="1035"/>
          <ac:spMkLst>
            <pc:docMk/>
            <pc:sldMk cId="884396843" sldId="4119"/>
            <ac:spMk id="117" creationId="{DA9C14B9-3DDB-4C9E-BFCA-1D1CA1E790AB}"/>
          </ac:spMkLst>
        </pc:spChg>
        <pc:spChg chg="add mod">
          <ac:chgData name="Grace Lee" userId="fd145552-a10d-4a31-a438-f8736fd84277" providerId="ADAL" clId="{56835480-2BB5-4545-A32E-6CA68AA69734}" dt="2021-09-13T05:37:57.795" v="4228" actId="1035"/>
          <ac:spMkLst>
            <pc:docMk/>
            <pc:sldMk cId="884396843" sldId="4119"/>
            <ac:spMk id="119" creationId="{368D9133-401D-44BB-BB14-98D2BDC0C2A8}"/>
          </ac:spMkLst>
        </pc:spChg>
        <pc:spChg chg="add mod">
          <ac:chgData name="Grace Lee" userId="fd145552-a10d-4a31-a438-f8736fd84277" providerId="ADAL" clId="{56835480-2BB5-4545-A32E-6CA68AA69734}" dt="2021-09-13T05:37:57.795" v="4228" actId="1035"/>
          <ac:spMkLst>
            <pc:docMk/>
            <pc:sldMk cId="884396843" sldId="4119"/>
            <ac:spMk id="120" creationId="{061E4784-FD6C-49F5-B0D1-98AD70D44DEC}"/>
          </ac:spMkLst>
        </pc:spChg>
        <pc:spChg chg="add mod">
          <ac:chgData name="Grace Lee" userId="fd145552-a10d-4a31-a438-f8736fd84277" providerId="ADAL" clId="{56835480-2BB5-4545-A32E-6CA68AA69734}" dt="2021-09-13T05:37:57.795" v="4228" actId="1035"/>
          <ac:spMkLst>
            <pc:docMk/>
            <pc:sldMk cId="884396843" sldId="4119"/>
            <ac:spMk id="121" creationId="{696935E0-1D76-4CF2-91FE-CE17F111B991}"/>
          </ac:spMkLst>
        </pc:spChg>
        <pc:spChg chg="del">
          <ac:chgData name="Grace Lee" userId="fd145552-a10d-4a31-a438-f8736fd84277" providerId="ADAL" clId="{56835480-2BB5-4545-A32E-6CA68AA69734}" dt="2021-09-13T04:43:43.732" v="2611" actId="478"/>
          <ac:spMkLst>
            <pc:docMk/>
            <pc:sldMk cId="884396843" sldId="4119"/>
            <ac:spMk id="122" creationId="{3C64D145-B45B-4A5C-B27C-BF927429E62D}"/>
          </ac:spMkLst>
        </pc:spChg>
        <pc:spChg chg="del">
          <ac:chgData name="Grace Lee" userId="fd145552-a10d-4a31-a438-f8736fd84277" providerId="ADAL" clId="{56835480-2BB5-4545-A32E-6CA68AA69734}" dt="2021-09-13T04:43:43.732" v="2611" actId="478"/>
          <ac:spMkLst>
            <pc:docMk/>
            <pc:sldMk cId="884396843" sldId="4119"/>
            <ac:spMk id="123" creationId="{D97A2707-B6E7-4A7E-B13A-B40B0C744AD1}"/>
          </ac:spMkLst>
        </pc:spChg>
        <pc:spChg chg="del">
          <ac:chgData name="Grace Lee" userId="fd145552-a10d-4a31-a438-f8736fd84277" providerId="ADAL" clId="{56835480-2BB5-4545-A32E-6CA68AA69734}" dt="2021-09-13T04:43:43.732" v="2611" actId="478"/>
          <ac:spMkLst>
            <pc:docMk/>
            <pc:sldMk cId="884396843" sldId="4119"/>
            <ac:spMk id="124" creationId="{6132A3D0-8A5A-47A5-B4DF-C2E42CA4C01F}"/>
          </ac:spMkLst>
        </pc:spChg>
        <pc:spChg chg="del">
          <ac:chgData name="Grace Lee" userId="fd145552-a10d-4a31-a438-f8736fd84277" providerId="ADAL" clId="{56835480-2BB5-4545-A32E-6CA68AA69734}" dt="2021-09-13T04:48:46.499" v="2630" actId="478"/>
          <ac:spMkLst>
            <pc:docMk/>
            <pc:sldMk cId="884396843" sldId="4119"/>
            <ac:spMk id="125" creationId="{19466186-3ACE-48B2-84E6-321305D29EBF}"/>
          </ac:spMkLst>
        </pc:spChg>
        <pc:spChg chg="del">
          <ac:chgData name="Grace Lee" userId="fd145552-a10d-4a31-a438-f8736fd84277" providerId="ADAL" clId="{56835480-2BB5-4545-A32E-6CA68AA69734}" dt="2021-09-13T04:48:46.499" v="2630" actId="478"/>
          <ac:spMkLst>
            <pc:docMk/>
            <pc:sldMk cId="884396843" sldId="4119"/>
            <ac:spMk id="126" creationId="{2947F216-E876-41EF-B668-B2DAEBAA2E8E}"/>
          </ac:spMkLst>
        </pc:spChg>
        <pc:spChg chg="del">
          <ac:chgData name="Grace Lee" userId="fd145552-a10d-4a31-a438-f8736fd84277" providerId="ADAL" clId="{56835480-2BB5-4545-A32E-6CA68AA69734}" dt="2021-09-13T04:48:46.499" v="2630" actId="478"/>
          <ac:spMkLst>
            <pc:docMk/>
            <pc:sldMk cId="884396843" sldId="4119"/>
            <ac:spMk id="127" creationId="{936F3A3E-49E0-42A2-8748-2F7D774A345D}"/>
          </ac:spMkLst>
        </pc:spChg>
        <pc:spChg chg="del">
          <ac:chgData name="Grace Lee" userId="fd145552-a10d-4a31-a438-f8736fd84277" providerId="ADAL" clId="{56835480-2BB5-4545-A32E-6CA68AA69734}" dt="2021-09-13T04:48:46.499" v="2630" actId="478"/>
          <ac:spMkLst>
            <pc:docMk/>
            <pc:sldMk cId="884396843" sldId="4119"/>
            <ac:spMk id="128" creationId="{413B379D-72C3-4BD0-94D4-6E70D5C21609}"/>
          </ac:spMkLst>
        </pc:spChg>
        <pc:spChg chg="del">
          <ac:chgData name="Grace Lee" userId="fd145552-a10d-4a31-a438-f8736fd84277" providerId="ADAL" clId="{56835480-2BB5-4545-A32E-6CA68AA69734}" dt="2021-09-13T04:48:46.499" v="2630" actId="478"/>
          <ac:spMkLst>
            <pc:docMk/>
            <pc:sldMk cId="884396843" sldId="4119"/>
            <ac:spMk id="129" creationId="{FA223EBD-97A0-43D1-90D7-B90DDFFAC82A}"/>
          </ac:spMkLst>
        </pc:spChg>
        <pc:spChg chg="del">
          <ac:chgData name="Grace Lee" userId="fd145552-a10d-4a31-a438-f8736fd84277" providerId="ADAL" clId="{56835480-2BB5-4545-A32E-6CA68AA69734}" dt="2021-09-13T04:48:46.499" v="2630" actId="478"/>
          <ac:spMkLst>
            <pc:docMk/>
            <pc:sldMk cId="884396843" sldId="4119"/>
            <ac:spMk id="130" creationId="{A1937A8D-739D-47D2-8F3B-5D3DEEC0CBFE}"/>
          </ac:spMkLst>
        </pc:spChg>
        <pc:spChg chg="del">
          <ac:chgData name="Grace Lee" userId="fd145552-a10d-4a31-a438-f8736fd84277" providerId="ADAL" clId="{56835480-2BB5-4545-A32E-6CA68AA69734}" dt="2021-09-13T04:48:46.499" v="2630" actId="478"/>
          <ac:spMkLst>
            <pc:docMk/>
            <pc:sldMk cId="884396843" sldId="4119"/>
            <ac:spMk id="131" creationId="{50DF1E82-6ACA-4B66-B7D6-9690E79414D5}"/>
          </ac:spMkLst>
        </pc:spChg>
        <pc:spChg chg="del">
          <ac:chgData name="Grace Lee" userId="fd145552-a10d-4a31-a438-f8736fd84277" providerId="ADAL" clId="{56835480-2BB5-4545-A32E-6CA68AA69734}" dt="2021-09-13T04:48:46.499" v="2630" actId="478"/>
          <ac:spMkLst>
            <pc:docMk/>
            <pc:sldMk cId="884396843" sldId="4119"/>
            <ac:spMk id="132" creationId="{7393E349-10BD-4486-B623-A0D748273765}"/>
          </ac:spMkLst>
        </pc:spChg>
        <pc:spChg chg="del">
          <ac:chgData name="Grace Lee" userId="fd145552-a10d-4a31-a438-f8736fd84277" providerId="ADAL" clId="{56835480-2BB5-4545-A32E-6CA68AA69734}" dt="2021-09-13T04:48:46.499" v="2630" actId="478"/>
          <ac:spMkLst>
            <pc:docMk/>
            <pc:sldMk cId="884396843" sldId="4119"/>
            <ac:spMk id="133" creationId="{6D5F2BD9-90E5-4534-9DA8-7D6038BA4778}"/>
          </ac:spMkLst>
        </pc:spChg>
        <pc:spChg chg="del">
          <ac:chgData name="Grace Lee" userId="fd145552-a10d-4a31-a438-f8736fd84277" providerId="ADAL" clId="{56835480-2BB5-4545-A32E-6CA68AA69734}" dt="2021-09-13T04:48:46.499" v="2630" actId="478"/>
          <ac:spMkLst>
            <pc:docMk/>
            <pc:sldMk cId="884396843" sldId="4119"/>
            <ac:spMk id="134" creationId="{66D1B34E-93CD-4AEE-A3EB-CFC645BAA956}"/>
          </ac:spMkLst>
        </pc:spChg>
        <pc:spChg chg="add del mod">
          <ac:chgData name="Grace Lee" userId="fd145552-a10d-4a31-a438-f8736fd84277" providerId="ADAL" clId="{56835480-2BB5-4545-A32E-6CA68AA69734}" dt="2021-09-13T04:50:58.382" v="2661" actId="478"/>
          <ac:spMkLst>
            <pc:docMk/>
            <pc:sldMk cId="884396843" sldId="4119"/>
            <ac:spMk id="135" creationId="{6D158885-3922-473F-AB9C-217BEE8F79DE}"/>
          </ac:spMkLst>
        </pc:spChg>
        <pc:spChg chg="del">
          <ac:chgData name="Grace Lee" userId="fd145552-a10d-4a31-a438-f8736fd84277" providerId="ADAL" clId="{56835480-2BB5-4545-A32E-6CA68AA69734}" dt="2021-09-13T04:48:46.499" v="2630" actId="478"/>
          <ac:spMkLst>
            <pc:docMk/>
            <pc:sldMk cId="884396843" sldId="4119"/>
            <ac:spMk id="136" creationId="{2F313FCC-1D52-4F98-88EE-F66379C630E8}"/>
          </ac:spMkLst>
        </pc:spChg>
        <pc:spChg chg="del">
          <ac:chgData name="Grace Lee" userId="fd145552-a10d-4a31-a438-f8736fd84277" providerId="ADAL" clId="{56835480-2BB5-4545-A32E-6CA68AA69734}" dt="2021-09-13T04:48:46.499" v="2630" actId="478"/>
          <ac:spMkLst>
            <pc:docMk/>
            <pc:sldMk cId="884396843" sldId="4119"/>
            <ac:spMk id="137" creationId="{42A446C2-5ACE-4867-9439-7C3858B281F7}"/>
          </ac:spMkLst>
        </pc:spChg>
        <pc:spChg chg="add del mod">
          <ac:chgData name="Grace Lee" userId="fd145552-a10d-4a31-a438-f8736fd84277" providerId="ADAL" clId="{56835480-2BB5-4545-A32E-6CA68AA69734}" dt="2021-09-13T05:09:25.060" v="3212"/>
          <ac:spMkLst>
            <pc:docMk/>
            <pc:sldMk cId="884396843" sldId="4119"/>
            <ac:spMk id="139" creationId="{1D055B2D-4629-4787-BE0E-0195A27D6D2D}"/>
          </ac:spMkLst>
        </pc:spChg>
        <pc:spChg chg="del">
          <ac:chgData name="Grace Lee" userId="fd145552-a10d-4a31-a438-f8736fd84277" providerId="ADAL" clId="{56835480-2BB5-4545-A32E-6CA68AA69734}" dt="2021-09-13T04:48:46.499" v="2630" actId="478"/>
          <ac:spMkLst>
            <pc:docMk/>
            <pc:sldMk cId="884396843" sldId="4119"/>
            <ac:spMk id="140" creationId="{2993D3FC-7E1C-4B15-8C2F-13E3FDEE4739}"/>
          </ac:spMkLst>
        </pc:spChg>
        <pc:spChg chg="add del mod">
          <ac:chgData name="Grace Lee" userId="fd145552-a10d-4a31-a438-f8736fd84277" providerId="ADAL" clId="{56835480-2BB5-4545-A32E-6CA68AA69734}" dt="2021-09-13T05:09:36.995" v="3215" actId="478"/>
          <ac:spMkLst>
            <pc:docMk/>
            <pc:sldMk cId="884396843" sldId="4119"/>
            <ac:spMk id="141" creationId="{1E750472-13CB-487E-B090-3C513C546687}"/>
          </ac:spMkLst>
        </pc:spChg>
        <pc:spChg chg="add mod">
          <ac:chgData name="Grace Lee" userId="fd145552-a10d-4a31-a438-f8736fd84277" providerId="ADAL" clId="{56835480-2BB5-4545-A32E-6CA68AA69734}" dt="2021-09-13T05:37:57.795" v="4228" actId="1035"/>
          <ac:spMkLst>
            <pc:docMk/>
            <pc:sldMk cId="884396843" sldId="4119"/>
            <ac:spMk id="142" creationId="{86B23B6A-5700-4425-B4D0-EAA428DDD848}"/>
          </ac:spMkLst>
        </pc:spChg>
        <pc:spChg chg="add del mod">
          <ac:chgData name="Grace Lee" userId="fd145552-a10d-4a31-a438-f8736fd84277" providerId="ADAL" clId="{56835480-2BB5-4545-A32E-6CA68AA69734}" dt="2021-09-13T05:10:12.497" v="3220" actId="478"/>
          <ac:spMkLst>
            <pc:docMk/>
            <pc:sldMk cId="884396843" sldId="4119"/>
            <ac:spMk id="143" creationId="{C9A7E380-826D-4255-B329-DBE3504ACFE6}"/>
          </ac:spMkLst>
        </pc:spChg>
        <pc:spChg chg="add mod ord">
          <ac:chgData name="Grace Lee" userId="fd145552-a10d-4a31-a438-f8736fd84277" providerId="ADAL" clId="{56835480-2BB5-4545-A32E-6CA68AA69734}" dt="2021-09-13T05:37:57.795" v="4228" actId="1035"/>
          <ac:spMkLst>
            <pc:docMk/>
            <pc:sldMk cId="884396843" sldId="4119"/>
            <ac:spMk id="144" creationId="{B745DD95-0352-4F89-A688-F1CCA35611CE}"/>
          </ac:spMkLst>
        </pc:spChg>
        <pc:spChg chg="add del mod">
          <ac:chgData name="Grace Lee" userId="fd145552-a10d-4a31-a438-f8736fd84277" providerId="ADAL" clId="{56835480-2BB5-4545-A32E-6CA68AA69734}" dt="2021-09-13T05:21:43.427" v="3377" actId="478"/>
          <ac:spMkLst>
            <pc:docMk/>
            <pc:sldMk cId="884396843" sldId="4119"/>
            <ac:spMk id="145" creationId="{2704CFF3-AC4C-4BBB-8BA0-0360948AE701}"/>
          </ac:spMkLst>
        </pc:spChg>
        <pc:spChg chg="add del mod">
          <ac:chgData name="Grace Lee" userId="fd145552-a10d-4a31-a438-f8736fd84277" providerId="ADAL" clId="{56835480-2BB5-4545-A32E-6CA68AA69734}" dt="2021-09-13T05:21:43.427" v="3377" actId="478"/>
          <ac:spMkLst>
            <pc:docMk/>
            <pc:sldMk cId="884396843" sldId="4119"/>
            <ac:spMk id="146" creationId="{0B3FFF25-2ED9-4AE5-959C-32662FF695BA}"/>
          </ac:spMkLst>
        </pc:spChg>
        <pc:spChg chg="add del mod">
          <ac:chgData name="Grace Lee" userId="fd145552-a10d-4a31-a438-f8736fd84277" providerId="ADAL" clId="{56835480-2BB5-4545-A32E-6CA68AA69734}" dt="2021-09-13T05:21:43.427" v="3377" actId="478"/>
          <ac:spMkLst>
            <pc:docMk/>
            <pc:sldMk cId="884396843" sldId="4119"/>
            <ac:spMk id="147" creationId="{9B76FA33-FAB5-472B-9254-1BC35AF9C01D}"/>
          </ac:spMkLst>
        </pc:spChg>
        <pc:spChg chg="add del mod">
          <ac:chgData name="Grace Lee" userId="fd145552-a10d-4a31-a438-f8736fd84277" providerId="ADAL" clId="{56835480-2BB5-4545-A32E-6CA68AA69734}" dt="2021-09-13T05:21:43.427" v="3377" actId="478"/>
          <ac:spMkLst>
            <pc:docMk/>
            <pc:sldMk cId="884396843" sldId="4119"/>
            <ac:spMk id="148" creationId="{B64B550F-1611-4BCC-8C75-D82C4301DC0B}"/>
          </ac:spMkLst>
        </pc:spChg>
        <pc:spChg chg="add del mod">
          <ac:chgData name="Grace Lee" userId="fd145552-a10d-4a31-a438-f8736fd84277" providerId="ADAL" clId="{56835480-2BB5-4545-A32E-6CA68AA69734}" dt="2021-09-13T05:21:43.427" v="3377" actId="478"/>
          <ac:spMkLst>
            <pc:docMk/>
            <pc:sldMk cId="884396843" sldId="4119"/>
            <ac:spMk id="149" creationId="{3E4C08A1-E60B-43F4-826B-D560EE8B27C0}"/>
          </ac:spMkLst>
        </pc:spChg>
        <pc:spChg chg="add del mod">
          <ac:chgData name="Grace Lee" userId="fd145552-a10d-4a31-a438-f8736fd84277" providerId="ADAL" clId="{56835480-2BB5-4545-A32E-6CA68AA69734}" dt="2021-09-13T05:21:43.427" v="3377" actId="478"/>
          <ac:spMkLst>
            <pc:docMk/>
            <pc:sldMk cId="884396843" sldId="4119"/>
            <ac:spMk id="150" creationId="{1E613C94-ECEF-48A4-8AB1-152CEB5B2F68}"/>
          </ac:spMkLst>
        </pc:spChg>
        <pc:spChg chg="add del mod">
          <ac:chgData name="Grace Lee" userId="fd145552-a10d-4a31-a438-f8736fd84277" providerId="ADAL" clId="{56835480-2BB5-4545-A32E-6CA68AA69734}" dt="2021-09-13T05:21:43.427" v="3377" actId="478"/>
          <ac:spMkLst>
            <pc:docMk/>
            <pc:sldMk cId="884396843" sldId="4119"/>
            <ac:spMk id="151" creationId="{FECB7183-3416-489E-AFF1-DA2A658EBDFB}"/>
          </ac:spMkLst>
        </pc:spChg>
        <pc:spChg chg="add del mod">
          <ac:chgData name="Grace Lee" userId="fd145552-a10d-4a31-a438-f8736fd84277" providerId="ADAL" clId="{56835480-2BB5-4545-A32E-6CA68AA69734}" dt="2021-09-13T05:21:43.427" v="3377" actId="478"/>
          <ac:spMkLst>
            <pc:docMk/>
            <pc:sldMk cId="884396843" sldId="4119"/>
            <ac:spMk id="152" creationId="{56E8D856-F6E8-4CB6-B41D-2406617A6ABE}"/>
          </ac:spMkLst>
        </pc:spChg>
        <pc:spChg chg="add del mod">
          <ac:chgData name="Grace Lee" userId="fd145552-a10d-4a31-a438-f8736fd84277" providerId="ADAL" clId="{56835480-2BB5-4545-A32E-6CA68AA69734}" dt="2021-09-13T05:21:43.427" v="3377" actId="478"/>
          <ac:spMkLst>
            <pc:docMk/>
            <pc:sldMk cId="884396843" sldId="4119"/>
            <ac:spMk id="153" creationId="{6B27FC8D-1B78-4F51-9BBC-608FAA934307}"/>
          </ac:spMkLst>
        </pc:spChg>
        <pc:spChg chg="add del mod">
          <ac:chgData name="Grace Lee" userId="fd145552-a10d-4a31-a438-f8736fd84277" providerId="ADAL" clId="{56835480-2BB5-4545-A32E-6CA68AA69734}" dt="2021-09-13T05:21:43.427" v="3377" actId="478"/>
          <ac:spMkLst>
            <pc:docMk/>
            <pc:sldMk cId="884396843" sldId="4119"/>
            <ac:spMk id="154" creationId="{91AB7E9F-FF25-4608-AB65-C1022270A4DC}"/>
          </ac:spMkLst>
        </pc:spChg>
        <pc:spChg chg="add del mod">
          <ac:chgData name="Grace Lee" userId="fd145552-a10d-4a31-a438-f8736fd84277" providerId="ADAL" clId="{56835480-2BB5-4545-A32E-6CA68AA69734}" dt="2021-09-13T05:21:43.427" v="3377" actId="478"/>
          <ac:spMkLst>
            <pc:docMk/>
            <pc:sldMk cId="884396843" sldId="4119"/>
            <ac:spMk id="155" creationId="{3F10402D-364C-44D8-B9FD-F3B8EA487C68}"/>
          </ac:spMkLst>
        </pc:spChg>
        <pc:spChg chg="add del mod">
          <ac:chgData name="Grace Lee" userId="fd145552-a10d-4a31-a438-f8736fd84277" providerId="ADAL" clId="{56835480-2BB5-4545-A32E-6CA68AA69734}" dt="2021-09-13T05:21:43.427" v="3377" actId="478"/>
          <ac:spMkLst>
            <pc:docMk/>
            <pc:sldMk cId="884396843" sldId="4119"/>
            <ac:spMk id="156" creationId="{418BF7B5-7863-4F57-9A85-24FFC450DE69}"/>
          </ac:spMkLst>
        </pc:spChg>
        <pc:spChg chg="add mod">
          <ac:chgData name="Grace Lee" userId="fd145552-a10d-4a31-a438-f8736fd84277" providerId="ADAL" clId="{56835480-2BB5-4545-A32E-6CA68AA69734}" dt="2021-09-13T05:37:57.795" v="4228" actId="1035"/>
          <ac:spMkLst>
            <pc:docMk/>
            <pc:sldMk cId="884396843" sldId="4119"/>
            <ac:spMk id="157" creationId="{06893DFC-B6A5-4FBB-BDF4-AA44EAABE7E3}"/>
          </ac:spMkLst>
        </pc:spChg>
        <pc:spChg chg="add mod">
          <ac:chgData name="Grace Lee" userId="fd145552-a10d-4a31-a438-f8736fd84277" providerId="ADAL" clId="{56835480-2BB5-4545-A32E-6CA68AA69734}" dt="2021-09-13T05:37:57.795" v="4228" actId="1035"/>
          <ac:spMkLst>
            <pc:docMk/>
            <pc:sldMk cId="884396843" sldId="4119"/>
            <ac:spMk id="158" creationId="{96A108F0-05A9-4E20-AFCC-278CDDD5E63B}"/>
          </ac:spMkLst>
        </pc:spChg>
        <pc:spChg chg="del">
          <ac:chgData name="Grace Lee" userId="fd145552-a10d-4a31-a438-f8736fd84277" providerId="ADAL" clId="{56835480-2BB5-4545-A32E-6CA68AA69734}" dt="2021-09-13T04:48:46.499" v="2630" actId="478"/>
          <ac:spMkLst>
            <pc:docMk/>
            <pc:sldMk cId="884396843" sldId="4119"/>
            <ac:spMk id="159" creationId="{768F0C11-6D59-4A7D-8A97-40F17D6A39E4}"/>
          </ac:spMkLst>
        </pc:spChg>
        <pc:spChg chg="add mod">
          <ac:chgData name="Grace Lee" userId="fd145552-a10d-4a31-a438-f8736fd84277" providerId="ADAL" clId="{56835480-2BB5-4545-A32E-6CA68AA69734}" dt="2021-09-13T05:45:53.864" v="4295" actId="14100"/>
          <ac:spMkLst>
            <pc:docMk/>
            <pc:sldMk cId="884396843" sldId="4119"/>
            <ac:spMk id="160" creationId="{B55DDE69-F86E-4D71-9687-8925CCB4D7F2}"/>
          </ac:spMkLst>
        </pc:spChg>
        <pc:spChg chg="add mod">
          <ac:chgData name="Grace Lee" userId="fd145552-a10d-4a31-a438-f8736fd84277" providerId="ADAL" clId="{56835480-2BB5-4545-A32E-6CA68AA69734}" dt="2021-09-13T05:38:22.642" v="4240" actId="20577"/>
          <ac:spMkLst>
            <pc:docMk/>
            <pc:sldMk cId="884396843" sldId="4119"/>
            <ac:spMk id="161" creationId="{AC1762C3-CC4A-4301-B38F-0B5298D577E7}"/>
          </ac:spMkLst>
        </pc:spChg>
        <pc:spChg chg="del">
          <ac:chgData name="Grace Lee" userId="fd145552-a10d-4a31-a438-f8736fd84277" providerId="ADAL" clId="{56835480-2BB5-4545-A32E-6CA68AA69734}" dt="2021-09-13T04:48:46.499" v="2630" actId="478"/>
          <ac:spMkLst>
            <pc:docMk/>
            <pc:sldMk cId="884396843" sldId="4119"/>
            <ac:spMk id="162" creationId="{290193BC-EAC3-4732-A4C6-E33D476B860B}"/>
          </ac:spMkLst>
        </pc:spChg>
        <pc:spChg chg="add del mod">
          <ac:chgData name="Grace Lee" userId="fd145552-a10d-4a31-a438-f8736fd84277" providerId="ADAL" clId="{56835480-2BB5-4545-A32E-6CA68AA69734}" dt="2021-09-13T05:23:39.332" v="3418" actId="478"/>
          <ac:spMkLst>
            <pc:docMk/>
            <pc:sldMk cId="884396843" sldId="4119"/>
            <ac:spMk id="163" creationId="{BDE18AEA-FAD8-4481-84D8-9C4E0A3EDB56}"/>
          </ac:spMkLst>
        </pc:spChg>
        <pc:spChg chg="add mod">
          <ac:chgData name="Grace Lee" userId="fd145552-a10d-4a31-a438-f8736fd84277" providerId="ADAL" clId="{56835480-2BB5-4545-A32E-6CA68AA69734}" dt="2021-09-13T05:38:14.010" v="4236" actId="20577"/>
          <ac:spMkLst>
            <pc:docMk/>
            <pc:sldMk cId="884396843" sldId="4119"/>
            <ac:spMk id="164" creationId="{5DA81733-574E-4FDA-AA2C-78E97A5E01DB}"/>
          </ac:spMkLst>
        </pc:spChg>
        <pc:spChg chg="add mod">
          <ac:chgData name="Grace Lee" userId="fd145552-a10d-4a31-a438-f8736fd84277" providerId="ADAL" clId="{56835480-2BB5-4545-A32E-6CA68AA69734}" dt="2021-09-13T05:37:57.795" v="4228" actId="1035"/>
          <ac:spMkLst>
            <pc:docMk/>
            <pc:sldMk cId="884396843" sldId="4119"/>
            <ac:spMk id="165" creationId="{4B5CE1D4-5B10-4858-B371-A534EF0E0F69}"/>
          </ac:spMkLst>
        </pc:spChg>
        <pc:spChg chg="add mod">
          <ac:chgData name="Grace Lee" userId="fd145552-a10d-4a31-a438-f8736fd84277" providerId="ADAL" clId="{56835480-2BB5-4545-A32E-6CA68AA69734}" dt="2021-09-13T05:43:12.934" v="4241" actId="14100"/>
          <ac:spMkLst>
            <pc:docMk/>
            <pc:sldMk cId="884396843" sldId="4119"/>
            <ac:spMk id="166" creationId="{65D220A9-BB24-4E64-8606-DA60378415CF}"/>
          </ac:spMkLst>
        </pc:spChg>
        <pc:spChg chg="add mod">
          <ac:chgData name="Grace Lee" userId="fd145552-a10d-4a31-a438-f8736fd84277" providerId="ADAL" clId="{56835480-2BB5-4545-A32E-6CA68AA69734}" dt="2021-09-13T05:37:57.795" v="4228" actId="1035"/>
          <ac:spMkLst>
            <pc:docMk/>
            <pc:sldMk cId="884396843" sldId="4119"/>
            <ac:spMk id="167" creationId="{0AB9F6D2-AE03-49A5-8CB9-B38D9393209C}"/>
          </ac:spMkLst>
        </pc:spChg>
        <pc:spChg chg="add mod">
          <ac:chgData name="Grace Lee" userId="fd145552-a10d-4a31-a438-f8736fd84277" providerId="ADAL" clId="{56835480-2BB5-4545-A32E-6CA68AA69734}" dt="2021-09-13T05:43:35.213" v="4246" actId="14100"/>
          <ac:spMkLst>
            <pc:docMk/>
            <pc:sldMk cId="884396843" sldId="4119"/>
            <ac:spMk id="168" creationId="{C4BE4A3D-E871-4C49-AF96-9546F533B1D6}"/>
          </ac:spMkLst>
        </pc:spChg>
        <pc:spChg chg="add mod">
          <ac:chgData name="Grace Lee" userId="fd145552-a10d-4a31-a438-f8736fd84277" providerId="ADAL" clId="{56835480-2BB5-4545-A32E-6CA68AA69734}" dt="2021-09-13T05:37:57.795" v="4228" actId="1035"/>
          <ac:spMkLst>
            <pc:docMk/>
            <pc:sldMk cId="884396843" sldId="4119"/>
            <ac:spMk id="169" creationId="{610C38A4-1A01-4E09-BE05-D906EF609248}"/>
          </ac:spMkLst>
        </pc:spChg>
        <pc:spChg chg="add mod">
          <ac:chgData name="Grace Lee" userId="fd145552-a10d-4a31-a438-f8736fd84277" providerId="ADAL" clId="{56835480-2BB5-4545-A32E-6CA68AA69734}" dt="2021-09-13T05:43:27.203" v="4243" actId="14100"/>
          <ac:spMkLst>
            <pc:docMk/>
            <pc:sldMk cId="884396843" sldId="4119"/>
            <ac:spMk id="170" creationId="{2C9A2D42-DA8E-41D1-9EB4-3AE6B777D288}"/>
          </ac:spMkLst>
        </pc:spChg>
        <pc:spChg chg="del">
          <ac:chgData name="Grace Lee" userId="fd145552-a10d-4a31-a438-f8736fd84277" providerId="ADAL" clId="{56835480-2BB5-4545-A32E-6CA68AA69734}" dt="2021-09-13T04:48:46.499" v="2630" actId="478"/>
          <ac:spMkLst>
            <pc:docMk/>
            <pc:sldMk cId="884396843" sldId="4119"/>
            <ac:spMk id="171" creationId="{F3656F8A-FF42-4AC4-8FF8-DC399A5E5F15}"/>
          </ac:spMkLst>
        </pc:spChg>
        <pc:spChg chg="add del mod">
          <ac:chgData name="Grace Lee" userId="fd145552-a10d-4a31-a438-f8736fd84277" providerId="ADAL" clId="{56835480-2BB5-4545-A32E-6CA68AA69734}" dt="2021-09-13T05:28:11.540" v="4010" actId="478"/>
          <ac:spMkLst>
            <pc:docMk/>
            <pc:sldMk cId="884396843" sldId="4119"/>
            <ac:spMk id="172" creationId="{6F40256C-3380-4228-B3F2-9B23B8E0157C}"/>
          </ac:spMkLst>
        </pc:spChg>
        <pc:spChg chg="del">
          <ac:chgData name="Grace Lee" userId="fd145552-a10d-4a31-a438-f8736fd84277" providerId="ADAL" clId="{56835480-2BB5-4545-A32E-6CA68AA69734}" dt="2021-09-13T04:48:46.499" v="2630" actId="478"/>
          <ac:spMkLst>
            <pc:docMk/>
            <pc:sldMk cId="884396843" sldId="4119"/>
            <ac:spMk id="173" creationId="{855A9869-5715-4B04-AB7F-C080D898EDDB}"/>
          </ac:spMkLst>
        </pc:spChg>
        <pc:spChg chg="del">
          <ac:chgData name="Grace Lee" userId="fd145552-a10d-4a31-a438-f8736fd84277" providerId="ADAL" clId="{56835480-2BB5-4545-A32E-6CA68AA69734}" dt="2021-09-13T04:48:46.499" v="2630" actId="478"/>
          <ac:spMkLst>
            <pc:docMk/>
            <pc:sldMk cId="884396843" sldId="4119"/>
            <ac:spMk id="174" creationId="{712317E0-A6D2-404D-A1F4-2D883F388E56}"/>
          </ac:spMkLst>
        </pc:spChg>
        <pc:spChg chg="del">
          <ac:chgData name="Grace Lee" userId="fd145552-a10d-4a31-a438-f8736fd84277" providerId="ADAL" clId="{56835480-2BB5-4545-A32E-6CA68AA69734}" dt="2021-09-13T04:48:46.499" v="2630" actId="478"/>
          <ac:spMkLst>
            <pc:docMk/>
            <pc:sldMk cId="884396843" sldId="4119"/>
            <ac:spMk id="175" creationId="{54CC318E-92C2-4F45-9CB0-4287FE94A1EC}"/>
          </ac:spMkLst>
        </pc:spChg>
        <pc:spChg chg="del">
          <ac:chgData name="Grace Lee" userId="fd145552-a10d-4a31-a438-f8736fd84277" providerId="ADAL" clId="{56835480-2BB5-4545-A32E-6CA68AA69734}" dt="2021-09-13T04:48:46.499" v="2630" actId="478"/>
          <ac:spMkLst>
            <pc:docMk/>
            <pc:sldMk cId="884396843" sldId="4119"/>
            <ac:spMk id="176" creationId="{646101B8-2165-4DBC-90DB-9DDCC8A59445}"/>
          </ac:spMkLst>
        </pc:spChg>
        <pc:spChg chg="del">
          <ac:chgData name="Grace Lee" userId="fd145552-a10d-4a31-a438-f8736fd84277" providerId="ADAL" clId="{56835480-2BB5-4545-A32E-6CA68AA69734}" dt="2021-09-13T04:48:46.499" v="2630" actId="478"/>
          <ac:spMkLst>
            <pc:docMk/>
            <pc:sldMk cId="884396843" sldId="4119"/>
            <ac:spMk id="177" creationId="{144B2700-38E9-4746-A6EE-A1E56E7D46D8}"/>
          </ac:spMkLst>
        </pc:spChg>
        <pc:spChg chg="del">
          <ac:chgData name="Grace Lee" userId="fd145552-a10d-4a31-a438-f8736fd84277" providerId="ADAL" clId="{56835480-2BB5-4545-A32E-6CA68AA69734}" dt="2021-09-13T04:43:46.109" v="2612" actId="478"/>
          <ac:spMkLst>
            <pc:docMk/>
            <pc:sldMk cId="884396843" sldId="4119"/>
            <ac:spMk id="178" creationId="{581B84B5-D0C4-49FC-BA7E-AE210B5B26BA}"/>
          </ac:spMkLst>
        </pc:spChg>
        <pc:spChg chg="del">
          <ac:chgData name="Grace Lee" userId="fd145552-a10d-4a31-a438-f8736fd84277" providerId="ADAL" clId="{56835480-2BB5-4545-A32E-6CA68AA69734}" dt="2021-09-13T04:43:43.732" v="2611" actId="478"/>
          <ac:spMkLst>
            <pc:docMk/>
            <pc:sldMk cId="884396843" sldId="4119"/>
            <ac:spMk id="179" creationId="{A30FC82F-D841-4BFF-982E-7659A7C67531}"/>
          </ac:spMkLst>
        </pc:spChg>
        <pc:spChg chg="add del mod">
          <ac:chgData name="Grace Lee" userId="fd145552-a10d-4a31-a438-f8736fd84277" providerId="ADAL" clId="{56835480-2BB5-4545-A32E-6CA68AA69734}" dt="2021-09-13T05:28:09.941" v="4009" actId="478"/>
          <ac:spMkLst>
            <pc:docMk/>
            <pc:sldMk cId="884396843" sldId="4119"/>
            <ac:spMk id="180" creationId="{5141D0B0-250D-4580-A78D-21C10874F00C}"/>
          </ac:spMkLst>
        </pc:spChg>
        <pc:spChg chg="del">
          <ac:chgData name="Grace Lee" userId="fd145552-a10d-4a31-a438-f8736fd84277" providerId="ADAL" clId="{56835480-2BB5-4545-A32E-6CA68AA69734}" dt="2021-09-13T04:48:46.499" v="2630" actId="478"/>
          <ac:spMkLst>
            <pc:docMk/>
            <pc:sldMk cId="884396843" sldId="4119"/>
            <ac:spMk id="181" creationId="{0DB9AC23-C002-4B83-B229-1E7EF7D5F228}"/>
          </ac:spMkLst>
        </pc:spChg>
        <pc:spChg chg="del">
          <ac:chgData name="Grace Lee" userId="fd145552-a10d-4a31-a438-f8736fd84277" providerId="ADAL" clId="{56835480-2BB5-4545-A32E-6CA68AA69734}" dt="2021-09-13T04:48:46.499" v="2630" actId="478"/>
          <ac:spMkLst>
            <pc:docMk/>
            <pc:sldMk cId="884396843" sldId="4119"/>
            <ac:spMk id="182" creationId="{520FA9EF-5467-4792-9198-7DD78B0A7E2F}"/>
          </ac:spMkLst>
        </pc:spChg>
        <pc:spChg chg="del">
          <ac:chgData name="Grace Lee" userId="fd145552-a10d-4a31-a438-f8736fd84277" providerId="ADAL" clId="{56835480-2BB5-4545-A32E-6CA68AA69734}" dt="2021-09-13T04:48:46.499" v="2630" actId="478"/>
          <ac:spMkLst>
            <pc:docMk/>
            <pc:sldMk cId="884396843" sldId="4119"/>
            <ac:spMk id="183" creationId="{68FDE5F4-FA5B-491E-9DDB-6E4C466C4766}"/>
          </ac:spMkLst>
        </pc:spChg>
        <pc:spChg chg="add del mod">
          <ac:chgData name="Grace Lee" userId="fd145552-a10d-4a31-a438-f8736fd84277" providerId="ADAL" clId="{56835480-2BB5-4545-A32E-6CA68AA69734}" dt="2021-09-13T05:28:15.027" v="4011" actId="478"/>
          <ac:spMkLst>
            <pc:docMk/>
            <pc:sldMk cId="884396843" sldId="4119"/>
            <ac:spMk id="184" creationId="{23DB0C5F-4132-46F9-BA6E-4BF70CD297B9}"/>
          </ac:spMkLst>
        </pc:spChg>
        <pc:spChg chg="del">
          <ac:chgData name="Grace Lee" userId="fd145552-a10d-4a31-a438-f8736fd84277" providerId="ADAL" clId="{56835480-2BB5-4545-A32E-6CA68AA69734}" dt="2021-09-13T04:48:46.499" v="2630" actId="478"/>
          <ac:spMkLst>
            <pc:docMk/>
            <pc:sldMk cId="884396843" sldId="4119"/>
            <ac:spMk id="185" creationId="{EEEAB960-1996-45C4-9187-27BE2A9C4A2E}"/>
          </ac:spMkLst>
        </pc:spChg>
        <pc:spChg chg="del">
          <ac:chgData name="Grace Lee" userId="fd145552-a10d-4a31-a438-f8736fd84277" providerId="ADAL" clId="{56835480-2BB5-4545-A32E-6CA68AA69734}" dt="2021-09-13T04:48:46.499" v="2630" actId="478"/>
          <ac:spMkLst>
            <pc:docMk/>
            <pc:sldMk cId="884396843" sldId="4119"/>
            <ac:spMk id="186" creationId="{B456F411-1A95-455A-BDB1-AE61C8D56E85}"/>
          </ac:spMkLst>
        </pc:spChg>
        <pc:spChg chg="del">
          <ac:chgData name="Grace Lee" userId="fd145552-a10d-4a31-a438-f8736fd84277" providerId="ADAL" clId="{56835480-2BB5-4545-A32E-6CA68AA69734}" dt="2021-09-13T04:48:46.499" v="2630" actId="478"/>
          <ac:spMkLst>
            <pc:docMk/>
            <pc:sldMk cId="884396843" sldId="4119"/>
            <ac:spMk id="187" creationId="{C5547091-31B6-4C3C-B5FA-2DFA40E76745}"/>
          </ac:spMkLst>
        </pc:spChg>
        <pc:spChg chg="add mod">
          <ac:chgData name="Grace Lee" userId="fd145552-a10d-4a31-a438-f8736fd84277" providerId="ADAL" clId="{56835480-2BB5-4545-A32E-6CA68AA69734}" dt="2021-09-13T05:37:57.795" v="4228" actId="1035"/>
          <ac:spMkLst>
            <pc:docMk/>
            <pc:sldMk cId="884396843" sldId="4119"/>
            <ac:spMk id="188" creationId="{59496B97-9D67-4C87-B80E-059DF95AB35C}"/>
          </ac:spMkLst>
        </pc:spChg>
        <pc:spChg chg="del">
          <ac:chgData name="Grace Lee" userId="fd145552-a10d-4a31-a438-f8736fd84277" providerId="ADAL" clId="{56835480-2BB5-4545-A32E-6CA68AA69734}" dt="2021-09-13T04:48:46.499" v="2630" actId="478"/>
          <ac:spMkLst>
            <pc:docMk/>
            <pc:sldMk cId="884396843" sldId="4119"/>
            <ac:spMk id="189" creationId="{AEB2C093-0815-4D16-905B-69D2EDAF1FEE}"/>
          </ac:spMkLst>
        </pc:spChg>
        <pc:spChg chg="del">
          <ac:chgData name="Grace Lee" userId="fd145552-a10d-4a31-a438-f8736fd84277" providerId="ADAL" clId="{56835480-2BB5-4545-A32E-6CA68AA69734}" dt="2021-09-13T04:48:46.499" v="2630" actId="478"/>
          <ac:spMkLst>
            <pc:docMk/>
            <pc:sldMk cId="884396843" sldId="4119"/>
            <ac:spMk id="190" creationId="{ADAD2512-4ACE-4FBE-B236-954614A28D12}"/>
          </ac:spMkLst>
        </pc:spChg>
        <pc:spChg chg="del">
          <ac:chgData name="Grace Lee" userId="fd145552-a10d-4a31-a438-f8736fd84277" providerId="ADAL" clId="{56835480-2BB5-4545-A32E-6CA68AA69734}" dt="2021-09-13T04:48:46.499" v="2630" actId="478"/>
          <ac:spMkLst>
            <pc:docMk/>
            <pc:sldMk cId="884396843" sldId="4119"/>
            <ac:spMk id="191" creationId="{B7A99FBD-A908-4438-ADBE-8CD497A03857}"/>
          </ac:spMkLst>
        </pc:spChg>
        <pc:spChg chg="add mod">
          <ac:chgData name="Grace Lee" userId="fd145552-a10d-4a31-a438-f8736fd84277" providerId="ADAL" clId="{56835480-2BB5-4545-A32E-6CA68AA69734}" dt="2021-09-13T05:43:40.033" v="4247" actId="14100"/>
          <ac:spMkLst>
            <pc:docMk/>
            <pc:sldMk cId="884396843" sldId="4119"/>
            <ac:spMk id="192" creationId="{62BE5660-F6EE-4B5A-B36F-456261ABC79B}"/>
          </ac:spMkLst>
        </pc:spChg>
        <pc:spChg chg="del">
          <ac:chgData name="Grace Lee" userId="fd145552-a10d-4a31-a438-f8736fd84277" providerId="ADAL" clId="{56835480-2BB5-4545-A32E-6CA68AA69734}" dt="2021-09-13T04:48:46.499" v="2630" actId="478"/>
          <ac:spMkLst>
            <pc:docMk/>
            <pc:sldMk cId="884396843" sldId="4119"/>
            <ac:spMk id="193" creationId="{6AA4CE63-9ED3-4390-A642-471C24E9AA1C}"/>
          </ac:spMkLst>
        </pc:spChg>
        <pc:spChg chg="del">
          <ac:chgData name="Grace Lee" userId="fd145552-a10d-4a31-a438-f8736fd84277" providerId="ADAL" clId="{56835480-2BB5-4545-A32E-6CA68AA69734}" dt="2021-09-13T04:48:46.499" v="2630" actId="478"/>
          <ac:spMkLst>
            <pc:docMk/>
            <pc:sldMk cId="884396843" sldId="4119"/>
            <ac:spMk id="194" creationId="{9C653993-4942-4716-B2C2-1E619AEC9A89}"/>
          </ac:spMkLst>
        </pc:spChg>
        <pc:spChg chg="del">
          <ac:chgData name="Grace Lee" userId="fd145552-a10d-4a31-a438-f8736fd84277" providerId="ADAL" clId="{56835480-2BB5-4545-A32E-6CA68AA69734}" dt="2021-09-13T04:48:46.499" v="2630" actId="478"/>
          <ac:spMkLst>
            <pc:docMk/>
            <pc:sldMk cId="884396843" sldId="4119"/>
            <ac:spMk id="195" creationId="{21716DA0-562D-48A8-B021-85005F063029}"/>
          </ac:spMkLst>
        </pc:spChg>
        <pc:spChg chg="add del mod">
          <ac:chgData name="Grace Lee" userId="fd145552-a10d-4a31-a438-f8736fd84277" providerId="ADAL" clId="{56835480-2BB5-4545-A32E-6CA68AA69734}" dt="2021-09-13T05:28:15.027" v="4011" actId="478"/>
          <ac:spMkLst>
            <pc:docMk/>
            <pc:sldMk cId="884396843" sldId="4119"/>
            <ac:spMk id="196" creationId="{3DC5A3FC-2059-4707-9CC1-89A8B1B9E111}"/>
          </ac:spMkLst>
        </pc:spChg>
        <pc:spChg chg="add mod">
          <ac:chgData name="Grace Lee" userId="fd145552-a10d-4a31-a438-f8736fd84277" providerId="ADAL" clId="{56835480-2BB5-4545-A32E-6CA68AA69734}" dt="2021-09-13T05:37:57.795" v="4228" actId="1035"/>
          <ac:spMkLst>
            <pc:docMk/>
            <pc:sldMk cId="884396843" sldId="4119"/>
            <ac:spMk id="197" creationId="{BB184485-17BB-4B5A-8486-75EDEB063387}"/>
          </ac:spMkLst>
        </pc:spChg>
        <pc:graphicFrameChg chg="add del mod">
          <ac:chgData name="Grace Lee" userId="fd145552-a10d-4a31-a438-f8736fd84277" providerId="ADAL" clId="{56835480-2BB5-4545-A32E-6CA68AA69734}" dt="2021-09-13T04:46:52.681" v="2626"/>
          <ac:graphicFrameMkLst>
            <pc:docMk/>
            <pc:sldMk cId="884396843" sldId="4119"/>
            <ac:graphicFrameMk id="84" creationId="{95320577-C3C9-4D6E-80E1-A8D970549429}"/>
          </ac:graphicFrameMkLst>
        </pc:graphicFrameChg>
        <pc:picChg chg="del">
          <ac:chgData name="Grace Lee" userId="fd145552-a10d-4a31-a438-f8736fd84277" providerId="ADAL" clId="{56835480-2BB5-4545-A32E-6CA68AA69734}" dt="2021-09-13T04:43:43.732" v="2611" actId="478"/>
          <ac:picMkLst>
            <pc:docMk/>
            <pc:sldMk cId="884396843" sldId="4119"/>
            <ac:picMk id="6" creationId="{BC8612EB-7CA2-4DEE-BDEF-F8DDDF80D534}"/>
          </ac:picMkLst>
        </pc:picChg>
        <pc:picChg chg="del">
          <ac:chgData name="Grace Lee" userId="fd145552-a10d-4a31-a438-f8736fd84277" providerId="ADAL" clId="{56835480-2BB5-4545-A32E-6CA68AA69734}" dt="2021-09-13T04:43:43.732" v="2611" actId="478"/>
          <ac:picMkLst>
            <pc:docMk/>
            <pc:sldMk cId="884396843" sldId="4119"/>
            <ac:picMk id="7" creationId="{7FB1E5D8-9C85-403E-885A-3F690338298A}"/>
          </ac:picMkLst>
        </pc:picChg>
        <pc:picChg chg="del">
          <ac:chgData name="Grace Lee" userId="fd145552-a10d-4a31-a438-f8736fd84277" providerId="ADAL" clId="{56835480-2BB5-4545-A32E-6CA68AA69734}" dt="2021-09-13T04:43:43.732" v="2611" actId="478"/>
          <ac:picMkLst>
            <pc:docMk/>
            <pc:sldMk cId="884396843" sldId="4119"/>
            <ac:picMk id="8" creationId="{6595AECF-281B-402C-978D-232D26F9D20B}"/>
          </ac:picMkLst>
        </pc:picChg>
        <pc:picChg chg="del">
          <ac:chgData name="Grace Lee" userId="fd145552-a10d-4a31-a438-f8736fd84277" providerId="ADAL" clId="{56835480-2BB5-4545-A32E-6CA68AA69734}" dt="2021-09-13T04:43:43.732" v="2611" actId="478"/>
          <ac:picMkLst>
            <pc:docMk/>
            <pc:sldMk cId="884396843" sldId="4119"/>
            <ac:picMk id="10" creationId="{B6A8F212-C495-45A6-BF2C-80AECC1DB4B5}"/>
          </ac:picMkLst>
        </pc:picChg>
        <pc:cxnChg chg="add mod">
          <ac:chgData name="Grace Lee" userId="fd145552-a10d-4a31-a438-f8736fd84277" providerId="ADAL" clId="{56835480-2BB5-4545-A32E-6CA68AA69734}" dt="2021-09-13T05:37:57.795" v="4228" actId="1035"/>
          <ac:cxnSpMkLst>
            <pc:docMk/>
            <pc:sldMk cId="884396843" sldId="4119"/>
            <ac:cxnSpMk id="118" creationId="{77306D67-E43A-4F45-856A-480F463CCEF5}"/>
          </ac:cxnSpMkLst>
        </pc:cxnChg>
        <pc:cxnChg chg="add mod">
          <ac:chgData name="Grace Lee" userId="fd145552-a10d-4a31-a438-f8736fd84277" providerId="ADAL" clId="{56835480-2BB5-4545-A32E-6CA68AA69734}" dt="2021-09-13T05:37:57.795" v="4228" actId="1035"/>
          <ac:cxnSpMkLst>
            <pc:docMk/>
            <pc:sldMk cId="884396843" sldId="4119"/>
            <ac:cxnSpMk id="138" creationId="{9959127E-055C-4B8D-AE54-60BEBE6FB27F}"/>
          </ac:cxnSpMkLst>
        </pc:cxnChg>
      </pc:sldChg>
      <pc:sldChg chg="addSp delSp modSp add del">
        <pc:chgData name="Grace Lee" userId="fd145552-a10d-4a31-a438-f8736fd84277" providerId="ADAL" clId="{56835480-2BB5-4545-A32E-6CA68AA69734}" dt="2021-09-13T04:29:07.242" v="2557" actId="47"/>
        <pc:sldMkLst>
          <pc:docMk/>
          <pc:sldMk cId="4107723228" sldId="4119"/>
        </pc:sldMkLst>
        <pc:spChg chg="add del mod">
          <ac:chgData name="Grace Lee" userId="fd145552-a10d-4a31-a438-f8736fd84277" providerId="ADAL" clId="{56835480-2BB5-4545-A32E-6CA68AA69734}" dt="2021-09-13T04:08:34.109" v="2073"/>
          <ac:spMkLst>
            <pc:docMk/>
            <pc:sldMk cId="4107723228" sldId="4119"/>
            <ac:spMk id="24" creationId="{107F196E-8534-4967-A897-AB9A0C55B5C8}"/>
          </ac:spMkLst>
        </pc:spChg>
        <pc:spChg chg="add del mod">
          <ac:chgData name="Grace Lee" userId="fd145552-a10d-4a31-a438-f8736fd84277" providerId="ADAL" clId="{56835480-2BB5-4545-A32E-6CA68AA69734}" dt="2021-09-13T04:08:34.109" v="2073"/>
          <ac:spMkLst>
            <pc:docMk/>
            <pc:sldMk cId="4107723228" sldId="4119"/>
            <ac:spMk id="25" creationId="{47008F34-9786-4D96-AD2F-8575BDB3916C}"/>
          </ac:spMkLst>
        </pc:spChg>
        <pc:spChg chg="add del mod">
          <ac:chgData name="Grace Lee" userId="fd145552-a10d-4a31-a438-f8736fd84277" providerId="ADAL" clId="{56835480-2BB5-4545-A32E-6CA68AA69734}" dt="2021-09-13T04:08:34.109" v="2073"/>
          <ac:spMkLst>
            <pc:docMk/>
            <pc:sldMk cId="4107723228" sldId="4119"/>
            <ac:spMk id="26" creationId="{BAE3A27D-38FE-4424-83E7-B98CDC91F1FC}"/>
          </ac:spMkLst>
        </pc:spChg>
        <pc:spChg chg="add del mod">
          <ac:chgData name="Grace Lee" userId="fd145552-a10d-4a31-a438-f8736fd84277" providerId="ADAL" clId="{56835480-2BB5-4545-A32E-6CA68AA69734}" dt="2021-09-13T04:08:34.109" v="2073"/>
          <ac:spMkLst>
            <pc:docMk/>
            <pc:sldMk cId="4107723228" sldId="4119"/>
            <ac:spMk id="27" creationId="{FF1FC85D-C433-4862-A30B-046AFF977341}"/>
          </ac:spMkLst>
        </pc:spChg>
        <pc:spChg chg="add del mod">
          <ac:chgData name="Grace Lee" userId="fd145552-a10d-4a31-a438-f8736fd84277" providerId="ADAL" clId="{56835480-2BB5-4545-A32E-6CA68AA69734}" dt="2021-09-13T04:08:34.109" v="2073"/>
          <ac:spMkLst>
            <pc:docMk/>
            <pc:sldMk cId="4107723228" sldId="4119"/>
            <ac:spMk id="28" creationId="{160DE6FE-120A-4A33-9E88-904F89A44088}"/>
          </ac:spMkLst>
        </pc:spChg>
        <pc:spChg chg="add del mod">
          <ac:chgData name="Grace Lee" userId="fd145552-a10d-4a31-a438-f8736fd84277" providerId="ADAL" clId="{56835480-2BB5-4545-A32E-6CA68AA69734}" dt="2021-09-13T04:08:34.109" v="2073"/>
          <ac:spMkLst>
            <pc:docMk/>
            <pc:sldMk cId="4107723228" sldId="4119"/>
            <ac:spMk id="29" creationId="{0E7E6929-90B0-4DBA-82FF-2B00FABAB7CF}"/>
          </ac:spMkLst>
        </pc:spChg>
        <pc:spChg chg="add del mod">
          <ac:chgData name="Grace Lee" userId="fd145552-a10d-4a31-a438-f8736fd84277" providerId="ADAL" clId="{56835480-2BB5-4545-A32E-6CA68AA69734}" dt="2021-09-13T04:08:34.109" v="2073"/>
          <ac:spMkLst>
            <pc:docMk/>
            <pc:sldMk cId="4107723228" sldId="4119"/>
            <ac:spMk id="30" creationId="{98A6DD01-BBD8-493C-BA5D-90F330006918}"/>
          </ac:spMkLst>
        </pc:spChg>
        <pc:spChg chg="add del mod">
          <ac:chgData name="Grace Lee" userId="fd145552-a10d-4a31-a438-f8736fd84277" providerId="ADAL" clId="{56835480-2BB5-4545-A32E-6CA68AA69734}" dt="2021-09-13T04:08:34.109" v="2073"/>
          <ac:spMkLst>
            <pc:docMk/>
            <pc:sldMk cId="4107723228" sldId="4119"/>
            <ac:spMk id="31" creationId="{74E9BC2A-3447-4B82-B4F3-BC102B217F28}"/>
          </ac:spMkLst>
        </pc:spChg>
        <pc:spChg chg="add del mod">
          <ac:chgData name="Grace Lee" userId="fd145552-a10d-4a31-a438-f8736fd84277" providerId="ADAL" clId="{56835480-2BB5-4545-A32E-6CA68AA69734}" dt="2021-09-13T04:08:34.109" v="2073"/>
          <ac:spMkLst>
            <pc:docMk/>
            <pc:sldMk cId="4107723228" sldId="4119"/>
            <ac:spMk id="32" creationId="{9B000C2A-5FEC-40C0-A51A-4E240431D915}"/>
          </ac:spMkLst>
        </pc:spChg>
        <pc:spChg chg="add del mod">
          <ac:chgData name="Grace Lee" userId="fd145552-a10d-4a31-a438-f8736fd84277" providerId="ADAL" clId="{56835480-2BB5-4545-A32E-6CA68AA69734}" dt="2021-09-13T04:08:34.109" v="2073"/>
          <ac:spMkLst>
            <pc:docMk/>
            <pc:sldMk cId="4107723228" sldId="4119"/>
            <ac:spMk id="33" creationId="{344B95B6-12FE-4226-8FE4-9D75475D35CA}"/>
          </ac:spMkLst>
        </pc:spChg>
        <pc:spChg chg="add del mod">
          <ac:chgData name="Grace Lee" userId="fd145552-a10d-4a31-a438-f8736fd84277" providerId="ADAL" clId="{56835480-2BB5-4545-A32E-6CA68AA69734}" dt="2021-09-13T04:08:34.109" v="2073"/>
          <ac:spMkLst>
            <pc:docMk/>
            <pc:sldMk cId="4107723228" sldId="4119"/>
            <ac:spMk id="34" creationId="{7B9F94FF-2B58-4567-99B8-ADDD2F23E5D9}"/>
          </ac:spMkLst>
        </pc:spChg>
        <pc:spChg chg="add del mod">
          <ac:chgData name="Grace Lee" userId="fd145552-a10d-4a31-a438-f8736fd84277" providerId="ADAL" clId="{56835480-2BB5-4545-A32E-6CA68AA69734}" dt="2021-09-13T04:08:34.109" v="2073"/>
          <ac:spMkLst>
            <pc:docMk/>
            <pc:sldMk cId="4107723228" sldId="4119"/>
            <ac:spMk id="35" creationId="{46CA8467-7718-4853-8FD0-F0A0E66C717B}"/>
          </ac:spMkLst>
        </pc:spChg>
      </pc:sldChg>
      <pc:sldChg chg="add">
        <pc:chgData name="Grace Lee" userId="fd145552-a10d-4a31-a438-f8736fd84277" providerId="ADAL" clId="{56835480-2BB5-4545-A32E-6CA68AA69734}" dt="2021-09-13T05:35:20.065" v="4189"/>
        <pc:sldMkLst>
          <pc:docMk/>
          <pc:sldMk cId="1721381198" sldId="4120"/>
        </pc:sldMkLst>
      </pc:sldChg>
      <pc:sldChg chg="del">
        <pc:chgData name="Grace Lee" userId="fd145552-a10d-4a31-a438-f8736fd84277" providerId="ADAL" clId="{56835480-2BB5-4545-A32E-6CA68AA69734}" dt="2021-09-13T04:46:17.513" v="2618" actId="47"/>
        <pc:sldMkLst>
          <pc:docMk/>
          <pc:sldMk cId="3632874242" sldId="4120"/>
        </pc:sldMkLst>
      </pc:sldChg>
      <pc:sldMasterChg chg="delSldLayout">
        <pc:chgData name="Grace Lee" userId="fd145552-a10d-4a31-a438-f8736fd84277" providerId="ADAL" clId="{56835480-2BB5-4545-A32E-6CA68AA69734}" dt="2021-09-13T04:29:07.242" v="2557" actId="47"/>
        <pc:sldMasterMkLst>
          <pc:docMk/>
          <pc:sldMasterMk cId="3216822255" sldId="2147483672"/>
        </pc:sldMasterMkLst>
        <pc:sldLayoutChg chg="del">
          <pc:chgData name="Grace Lee" userId="fd145552-a10d-4a31-a438-f8736fd84277" providerId="ADAL" clId="{56835480-2BB5-4545-A32E-6CA68AA69734}" dt="2021-09-13T04:29:07.242" v="2557" actId="47"/>
          <pc:sldLayoutMkLst>
            <pc:docMk/>
            <pc:sldMasterMk cId="3216822255" sldId="2147483672"/>
            <pc:sldLayoutMk cId="780034319" sldId="2147483758"/>
          </pc:sldLayoutMkLst>
        </pc:sldLayoutChg>
      </pc:sldMasterChg>
      <pc:sldMasterChg chg="del delSldLayout">
        <pc:chgData name="Grace Lee" userId="fd145552-a10d-4a31-a438-f8736fd84277" providerId="ADAL" clId="{56835480-2BB5-4545-A32E-6CA68AA69734}" dt="2021-09-13T04:46:17.513" v="2618" actId="47"/>
        <pc:sldMasterMkLst>
          <pc:docMk/>
          <pc:sldMasterMk cId="659910332" sldId="2147483758"/>
        </pc:sldMasterMkLst>
        <pc:sldLayoutChg chg="del">
          <pc:chgData name="Grace Lee" userId="fd145552-a10d-4a31-a438-f8736fd84277" providerId="ADAL" clId="{56835480-2BB5-4545-A32E-6CA68AA69734}" dt="2021-09-13T04:46:17.513" v="2618" actId="47"/>
          <pc:sldLayoutMkLst>
            <pc:docMk/>
            <pc:sldMasterMk cId="659910332" sldId="2147483758"/>
            <pc:sldLayoutMk cId="3717871966" sldId="2147483759"/>
          </pc:sldLayoutMkLst>
        </pc:sldLayoutChg>
      </pc:sldMasterChg>
    </pc:docChg>
  </pc:docChgLst>
  <pc:docChgLst>
    <pc:chgData name="Grace Lee" userId="fd145552-a10d-4a31-a438-f8736fd84277" providerId="ADAL" clId="{B16AA00A-12D3-4356-855A-AAECC1B3E2E6}"/>
    <pc:docChg chg="undo custSel modSld">
      <pc:chgData name="Grace Lee" userId="fd145552-a10d-4a31-a438-f8736fd84277" providerId="ADAL" clId="{B16AA00A-12D3-4356-855A-AAECC1B3E2E6}" dt="2023-04-14T03:41:44.847" v="77" actId="13926"/>
      <pc:docMkLst>
        <pc:docMk/>
      </pc:docMkLst>
      <pc:sldChg chg="modSp mod">
        <pc:chgData name="Grace Lee" userId="fd145552-a10d-4a31-a438-f8736fd84277" providerId="ADAL" clId="{B16AA00A-12D3-4356-855A-AAECC1B3E2E6}" dt="2023-04-14T03:39:37.483" v="20" actId="20577"/>
        <pc:sldMkLst>
          <pc:docMk/>
          <pc:sldMk cId="1330355191" sldId="576"/>
        </pc:sldMkLst>
        <pc:graphicFrameChg chg="modGraphic">
          <ac:chgData name="Grace Lee" userId="fd145552-a10d-4a31-a438-f8736fd84277" providerId="ADAL" clId="{B16AA00A-12D3-4356-855A-AAECC1B3E2E6}" dt="2023-04-14T03:39:37.483" v="20" actId="20577"/>
          <ac:graphicFrameMkLst>
            <pc:docMk/>
            <pc:sldMk cId="1330355191" sldId="576"/>
            <ac:graphicFrameMk id="5" creationId="{1F6D69E8-098B-4675-AAE5-73A7D0391966}"/>
          </ac:graphicFrameMkLst>
        </pc:graphicFrameChg>
      </pc:sldChg>
      <pc:sldChg chg="addSp delSp mod">
        <pc:chgData name="Grace Lee" userId="fd145552-a10d-4a31-a438-f8736fd84277" providerId="ADAL" clId="{B16AA00A-12D3-4356-855A-AAECC1B3E2E6}" dt="2023-04-14T03:41:25.197" v="74" actId="478"/>
        <pc:sldMkLst>
          <pc:docMk/>
          <pc:sldMk cId="352073150" sldId="3378"/>
        </pc:sldMkLst>
        <pc:spChg chg="add del">
          <ac:chgData name="Grace Lee" userId="fd145552-a10d-4a31-a438-f8736fd84277" providerId="ADAL" clId="{B16AA00A-12D3-4356-855A-AAECC1B3E2E6}" dt="2023-04-14T03:41:25.197" v="74" actId="478"/>
          <ac:spMkLst>
            <pc:docMk/>
            <pc:sldMk cId="352073150" sldId="3378"/>
            <ac:spMk id="58" creationId="{EA8514EB-4087-324B-93CD-C7EE542D49CE}"/>
          </ac:spMkLst>
        </pc:spChg>
      </pc:sldChg>
      <pc:sldChg chg="addSp delSp modSp mod">
        <pc:chgData name="Grace Lee" userId="fd145552-a10d-4a31-a438-f8736fd84277" providerId="ADAL" clId="{B16AA00A-12D3-4356-855A-AAECC1B3E2E6}" dt="2023-04-14T03:40:35.679" v="23"/>
        <pc:sldMkLst>
          <pc:docMk/>
          <pc:sldMk cId="884396843" sldId="4119"/>
        </pc:sldMkLst>
        <pc:spChg chg="add mod">
          <ac:chgData name="Grace Lee" userId="fd145552-a10d-4a31-a438-f8736fd84277" providerId="ADAL" clId="{B16AA00A-12D3-4356-855A-AAECC1B3E2E6}" dt="2023-04-14T03:40:35.679" v="23"/>
          <ac:spMkLst>
            <pc:docMk/>
            <pc:sldMk cId="884396843" sldId="4119"/>
            <ac:spMk id="2" creationId="{BC9C602D-B932-5FA5-4872-C3F15DB5A41B}"/>
          </ac:spMkLst>
        </pc:spChg>
        <pc:spChg chg="add mod">
          <ac:chgData name="Grace Lee" userId="fd145552-a10d-4a31-a438-f8736fd84277" providerId="ADAL" clId="{B16AA00A-12D3-4356-855A-AAECC1B3E2E6}" dt="2023-04-14T03:40:35.679" v="23"/>
          <ac:spMkLst>
            <pc:docMk/>
            <pc:sldMk cId="884396843" sldId="4119"/>
            <ac:spMk id="4" creationId="{50E44D17-1B30-0264-D63D-9C4E60B7EFE5}"/>
          </ac:spMkLst>
        </pc:spChg>
        <pc:spChg chg="add mod">
          <ac:chgData name="Grace Lee" userId="fd145552-a10d-4a31-a438-f8736fd84277" providerId="ADAL" clId="{B16AA00A-12D3-4356-855A-AAECC1B3E2E6}" dt="2023-04-14T03:40:35.679" v="23"/>
          <ac:spMkLst>
            <pc:docMk/>
            <pc:sldMk cId="884396843" sldId="4119"/>
            <ac:spMk id="5" creationId="{352C5CCE-3A79-5C64-583A-32681681BD8A}"/>
          </ac:spMkLst>
        </pc:spChg>
        <pc:spChg chg="add mod">
          <ac:chgData name="Grace Lee" userId="fd145552-a10d-4a31-a438-f8736fd84277" providerId="ADAL" clId="{B16AA00A-12D3-4356-855A-AAECC1B3E2E6}" dt="2023-04-14T03:40:35.679" v="23"/>
          <ac:spMkLst>
            <pc:docMk/>
            <pc:sldMk cId="884396843" sldId="4119"/>
            <ac:spMk id="6" creationId="{8C5ED8F4-CB75-B970-1AD0-0EE35179AAAB}"/>
          </ac:spMkLst>
        </pc:spChg>
        <pc:spChg chg="add mod">
          <ac:chgData name="Grace Lee" userId="fd145552-a10d-4a31-a438-f8736fd84277" providerId="ADAL" clId="{B16AA00A-12D3-4356-855A-AAECC1B3E2E6}" dt="2023-04-14T03:40:35.679" v="23"/>
          <ac:spMkLst>
            <pc:docMk/>
            <pc:sldMk cId="884396843" sldId="4119"/>
            <ac:spMk id="7" creationId="{5E92A92A-838B-84A1-CFEF-BCAA6A0BF3DC}"/>
          </ac:spMkLst>
        </pc:spChg>
        <pc:spChg chg="add mod">
          <ac:chgData name="Grace Lee" userId="fd145552-a10d-4a31-a438-f8736fd84277" providerId="ADAL" clId="{B16AA00A-12D3-4356-855A-AAECC1B3E2E6}" dt="2023-04-14T03:40:35.679" v="23"/>
          <ac:spMkLst>
            <pc:docMk/>
            <pc:sldMk cId="884396843" sldId="4119"/>
            <ac:spMk id="8" creationId="{F72004AE-73C5-DF37-F602-E1E34072CFB7}"/>
          </ac:spMkLst>
        </pc:spChg>
        <pc:spChg chg="add mod">
          <ac:chgData name="Grace Lee" userId="fd145552-a10d-4a31-a438-f8736fd84277" providerId="ADAL" clId="{B16AA00A-12D3-4356-855A-AAECC1B3E2E6}" dt="2023-04-14T03:40:35.679" v="23"/>
          <ac:spMkLst>
            <pc:docMk/>
            <pc:sldMk cId="884396843" sldId="4119"/>
            <ac:spMk id="9" creationId="{5C09211A-9370-7FA3-C70C-42F3C6953F4A}"/>
          </ac:spMkLst>
        </pc:spChg>
        <pc:spChg chg="add mod">
          <ac:chgData name="Grace Lee" userId="fd145552-a10d-4a31-a438-f8736fd84277" providerId="ADAL" clId="{B16AA00A-12D3-4356-855A-AAECC1B3E2E6}" dt="2023-04-14T03:40:35.679" v="23"/>
          <ac:spMkLst>
            <pc:docMk/>
            <pc:sldMk cId="884396843" sldId="4119"/>
            <ac:spMk id="10" creationId="{B06C883E-B722-BA21-DE1E-FF95BD0A7BFB}"/>
          </ac:spMkLst>
        </pc:spChg>
        <pc:spChg chg="add mod">
          <ac:chgData name="Grace Lee" userId="fd145552-a10d-4a31-a438-f8736fd84277" providerId="ADAL" clId="{B16AA00A-12D3-4356-855A-AAECC1B3E2E6}" dt="2023-04-14T03:40:35.679" v="23"/>
          <ac:spMkLst>
            <pc:docMk/>
            <pc:sldMk cId="884396843" sldId="4119"/>
            <ac:spMk id="11" creationId="{A98C26D0-1453-F917-28C3-CDE7D6F526AD}"/>
          </ac:spMkLst>
        </pc:spChg>
        <pc:spChg chg="add mod">
          <ac:chgData name="Grace Lee" userId="fd145552-a10d-4a31-a438-f8736fd84277" providerId="ADAL" clId="{B16AA00A-12D3-4356-855A-AAECC1B3E2E6}" dt="2023-04-14T03:40:35.679" v="23"/>
          <ac:spMkLst>
            <pc:docMk/>
            <pc:sldMk cId="884396843" sldId="4119"/>
            <ac:spMk id="12" creationId="{5E0E96DC-F57B-BB04-97C5-BFF82C762993}"/>
          </ac:spMkLst>
        </pc:spChg>
        <pc:spChg chg="add mod">
          <ac:chgData name="Grace Lee" userId="fd145552-a10d-4a31-a438-f8736fd84277" providerId="ADAL" clId="{B16AA00A-12D3-4356-855A-AAECC1B3E2E6}" dt="2023-04-14T03:40:35.679" v="23"/>
          <ac:spMkLst>
            <pc:docMk/>
            <pc:sldMk cId="884396843" sldId="4119"/>
            <ac:spMk id="13" creationId="{B9A522B5-64E5-6EB6-907E-CBD3F1782D95}"/>
          </ac:spMkLst>
        </pc:spChg>
        <pc:spChg chg="add mod">
          <ac:chgData name="Grace Lee" userId="fd145552-a10d-4a31-a438-f8736fd84277" providerId="ADAL" clId="{B16AA00A-12D3-4356-855A-AAECC1B3E2E6}" dt="2023-04-14T03:40:35.679" v="23"/>
          <ac:spMkLst>
            <pc:docMk/>
            <pc:sldMk cId="884396843" sldId="4119"/>
            <ac:spMk id="14" creationId="{1F72E1C6-5BF2-8275-DA20-4F38E4970B39}"/>
          </ac:spMkLst>
        </pc:spChg>
        <pc:spChg chg="add mod">
          <ac:chgData name="Grace Lee" userId="fd145552-a10d-4a31-a438-f8736fd84277" providerId="ADAL" clId="{B16AA00A-12D3-4356-855A-AAECC1B3E2E6}" dt="2023-04-14T03:40:35.679" v="23"/>
          <ac:spMkLst>
            <pc:docMk/>
            <pc:sldMk cId="884396843" sldId="4119"/>
            <ac:spMk id="15" creationId="{36D7B833-2F24-D1C6-757B-E17F612DB4E0}"/>
          </ac:spMkLst>
        </pc:spChg>
        <pc:spChg chg="add mod">
          <ac:chgData name="Grace Lee" userId="fd145552-a10d-4a31-a438-f8736fd84277" providerId="ADAL" clId="{B16AA00A-12D3-4356-855A-AAECC1B3E2E6}" dt="2023-04-14T03:40:35.679" v="23"/>
          <ac:spMkLst>
            <pc:docMk/>
            <pc:sldMk cId="884396843" sldId="4119"/>
            <ac:spMk id="16" creationId="{78036935-EF2B-9435-4213-EE4CC56FD284}"/>
          </ac:spMkLst>
        </pc:spChg>
        <pc:spChg chg="del">
          <ac:chgData name="Grace Lee" userId="fd145552-a10d-4a31-a438-f8736fd84277" providerId="ADAL" clId="{B16AA00A-12D3-4356-855A-AAECC1B3E2E6}" dt="2023-04-14T03:40:26.780" v="21" actId="478"/>
          <ac:spMkLst>
            <pc:docMk/>
            <pc:sldMk cId="884396843" sldId="4119"/>
            <ac:spMk id="157" creationId="{06893DFC-B6A5-4FBB-BDF4-AA44EAABE7E3}"/>
          </ac:spMkLst>
        </pc:spChg>
        <pc:spChg chg="del">
          <ac:chgData name="Grace Lee" userId="fd145552-a10d-4a31-a438-f8736fd84277" providerId="ADAL" clId="{B16AA00A-12D3-4356-855A-AAECC1B3E2E6}" dt="2023-04-14T03:40:26.780" v="21" actId="478"/>
          <ac:spMkLst>
            <pc:docMk/>
            <pc:sldMk cId="884396843" sldId="4119"/>
            <ac:spMk id="158" creationId="{96A108F0-05A9-4E20-AFCC-278CDDD5E63B}"/>
          </ac:spMkLst>
        </pc:spChg>
        <pc:spChg chg="del">
          <ac:chgData name="Grace Lee" userId="fd145552-a10d-4a31-a438-f8736fd84277" providerId="ADAL" clId="{B16AA00A-12D3-4356-855A-AAECC1B3E2E6}" dt="2023-04-14T03:40:27.902" v="22" actId="478"/>
          <ac:spMkLst>
            <pc:docMk/>
            <pc:sldMk cId="884396843" sldId="4119"/>
            <ac:spMk id="160" creationId="{B55DDE69-F86E-4D71-9687-8925CCB4D7F2}"/>
          </ac:spMkLst>
        </pc:spChg>
        <pc:spChg chg="del">
          <ac:chgData name="Grace Lee" userId="fd145552-a10d-4a31-a438-f8736fd84277" providerId="ADAL" clId="{B16AA00A-12D3-4356-855A-AAECC1B3E2E6}" dt="2023-04-14T03:40:26.780" v="21" actId="478"/>
          <ac:spMkLst>
            <pc:docMk/>
            <pc:sldMk cId="884396843" sldId="4119"/>
            <ac:spMk id="161" creationId="{AC1762C3-CC4A-4301-B38F-0B5298D577E7}"/>
          </ac:spMkLst>
        </pc:spChg>
        <pc:spChg chg="del">
          <ac:chgData name="Grace Lee" userId="fd145552-a10d-4a31-a438-f8736fd84277" providerId="ADAL" clId="{B16AA00A-12D3-4356-855A-AAECC1B3E2E6}" dt="2023-04-14T03:40:26.780" v="21" actId="478"/>
          <ac:spMkLst>
            <pc:docMk/>
            <pc:sldMk cId="884396843" sldId="4119"/>
            <ac:spMk id="164" creationId="{5DA81733-574E-4FDA-AA2C-78E97A5E01DB}"/>
          </ac:spMkLst>
        </pc:spChg>
        <pc:spChg chg="del">
          <ac:chgData name="Grace Lee" userId="fd145552-a10d-4a31-a438-f8736fd84277" providerId="ADAL" clId="{B16AA00A-12D3-4356-855A-AAECC1B3E2E6}" dt="2023-04-14T03:40:26.780" v="21" actId="478"/>
          <ac:spMkLst>
            <pc:docMk/>
            <pc:sldMk cId="884396843" sldId="4119"/>
            <ac:spMk id="165" creationId="{4B5CE1D4-5B10-4858-B371-A534EF0E0F69}"/>
          </ac:spMkLst>
        </pc:spChg>
        <pc:spChg chg="del">
          <ac:chgData name="Grace Lee" userId="fd145552-a10d-4a31-a438-f8736fd84277" providerId="ADAL" clId="{B16AA00A-12D3-4356-855A-AAECC1B3E2E6}" dt="2023-04-14T03:40:26.780" v="21" actId="478"/>
          <ac:spMkLst>
            <pc:docMk/>
            <pc:sldMk cId="884396843" sldId="4119"/>
            <ac:spMk id="166" creationId="{65D220A9-BB24-4E64-8606-DA60378415CF}"/>
          </ac:spMkLst>
        </pc:spChg>
        <pc:spChg chg="del">
          <ac:chgData name="Grace Lee" userId="fd145552-a10d-4a31-a438-f8736fd84277" providerId="ADAL" clId="{B16AA00A-12D3-4356-855A-AAECC1B3E2E6}" dt="2023-04-14T03:40:26.780" v="21" actId="478"/>
          <ac:spMkLst>
            <pc:docMk/>
            <pc:sldMk cId="884396843" sldId="4119"/>
            <ac:spMk id="167" creationId="{0AB9F6D2-AE03-49A5-8CB9-B38D9393209C}"/>
          </ac:spMkLst>
        </pc:spChg>
        <pc:spChg chg="del">
          <ac:chgData name="Grace Lee" userId="fd145552-a10d-4a31-a438-f8736fd84277" providerId="ADAL" clId="{B16AA00A-12D3-4356-855A-AAECC1B3E2E6}" dt="2023-04-14T03:40:26.780" v="21" actId="478"/>
          <ac:spMkLst>
            <pc:docMk/>
            <pc:sldMk cId="884396843" sldId="4119"/>
            <ac:spMk id="168" creationId="{C4BE4A3D-E871-4C49-AF96-9546F533B1D6}"/>
          </ac:spMkLst>
        </pc:spChg>
        <pc:spChg chg="del">
          <ac:chgData name="Grace Lee" userId="fd145552-a10d-4a31-a438-f8736fd84277" providerId="ADAL" clId="{B16AA00A-12D3-4356-855A-AAECC1B3E2E6}" dt="2023-04-14T03:40:26.780" v="21" actId="478"/>
          <ac:spMkLst>
            <pc:docMk/>
            <pc:sldMk cId="884396843" sldId="4119"/>
            <ac:spMk id="169" creationId="{610C38A4-1A01-4E09-BE05-D906EF609248}"/>
          </ac:spMkLst>
        </pc:spChg>
        <pc:spChg chg="del">
          <ac:chgData name="Grace Lee" userId="fd145552-a10d-4a31-a438-f8736fd84277" providerId="ADAL" clId="{B16AA00A-12D3-4356-855A-AAECC1B3E2E6}" dt="2023-04-14T03:40:26.780" v="21" actId="478"/>
          <ac:spMkLst>
            <pc:docMk/>
            <pc:sldMk cId="884396843" sldId="4119"/>
            <ac:spMk id="170" creationId="{2C9A2D42-DA8E-41D1-9EB4-3AE6B777D288}"/>
          </ac:spMkLst>
        </pc:spChg>
        <pc:spChg chg="del">
          <ac:chgData name="Grace Lee" userId="fd145552-a10d-4a31-a438-f8736fd84277" providerId="ADAL" clId="{B16AA00A-12D3-4356-855A-AAECC1B3E2E6}" dt="2023-04-14T03:40:26.780" v="21" actId="478"/>
          <ac:spMkLst>
            <pc:docMk/>
            <pc:sldMk cId="884396843" sldId="4119"/>
            <ac:spMk id="188" creationId="{59496B97-9D67-4C87-B80E-059DF95AB35C}"/>
          </ac:spMkLst>
        </pc:spChg>
        <pc:spChg chg="del">
          <ac:chgData name="Grace Lee" userId="fd145552-a10d-4a31-a438-f8736fd84277" providerId="ADAL" clId="{B16AA00A-12D3-4356-855A-AAECC1B3E2E6}" dt="2023-04-14T03:40:26.780" v="21" actId="478"/>
          <ac:spMkLst>
            <pc:docMk/>
            <pc:sldMk cId="884396843" sldId="4119"/>
            <ac:spMk id="192" creationId="{62BE5660-F6EE-4B5A-B36F-456261ABC79B}"/>
          </ac:spMkLst>
        </pc:spChg>
        <pc:spChg chg="del">
          <ac:chgData name="Grace Lee" userId="fd145552-a10d-4a31-a438-f8736fd84277" providerId="ADAL" clId="{B16AA00A-12D3-4356-855A-AAECC1B3E2E6}" dt="2023-04-14T03:40:26.780" v="21" actId="478"/>
          <ac:spMkLst>
            <pc:docMk/>
            <pc:sldMk cId="884396843" sldId="4119"/>
            <ac:spMk id="197" creationId="{BB184485-17BB-4B5A-8486-75EDEB063387}"/>
          </ac:spMkLst>
        </pc:spChg>
      </pc:sldChg>
      <pc:sldChg chg="modSp mod">
        <pc:chgData name="Grace Lee" userId="fd145552-a10d-4a31-a438-f8736fd84277" providerId="ADAL" clId="{B16AA00A-12D3-4356-855A-AAECC1B3E2E6}" dt="2023-04-14T03:41:11.083" v="70" actId="6549"/>
        <pc:sldMkLst>
          <pc:docMk/>
          <pc:sldMk cId="959688536" sldId="4133"/>
        </pc:sldMkLst>
        <pc:spChg chg="mod">
          <ac:chgData name="Grace Lee" userId="fd145552-a10d-4a31-a438-f8736fd84277" providerId="ADAL" clId="{B16AA00A-12D3-4356-855A-AAECC1B3E2E6}" dt="2023-04-14T03:41:11.083" v="70" actId="6549"/>
          <ac:spMkLst>
            <pc:docMk/>
            <pc:sldMk cId="959688536" sldId="4133"/>
            <ac:spMk id="2" creationId="{10A8E28A-2C2E-8C46-A78B-F1DBFA006299}"/>
          </ac:spMkLst>
        </pc:spChg>
      </pc:sldChg>
      <pc:sldChg chg="addSp delSp modSp mod">
        <pc:chgData name="Grace Lee" userId="fd145552-a10d-4a31-a438-f8736fd84277" providerId="ADAL" clId="{B16AA00A-12D3-4356-855A-AAECC1B3E2E6}" dt="2023-04-14T03:41:16.685" v="72"/>
        <pc:sldMkLst>
          <pc:docMk/>
          <pc:sldMk cId="369055727" sldId="4140"/>
        </pc:sldMkLst>
        <pc:graphicFrameChg chg="add mod">
          <ac:chgData name="Grace Lee" userId="fd145552-a10d-4a31-a438-f8736fd84277" providerId="ADAL" clId="{B16AA00A-12D3-4356-855A-AAECC1B3E2E6}" dt="2023-04-14T03:41:16.685" v="72"/>
          <ac:graphicFrameMkLst>
            <pc:docMk/>
            <pc:sldMk cId="369055727" sldId="4140"/>
            <ac:graphicFrameMk id="2" creationId="{BDD0BB5F-C0C4-9BCC-32A9-06A93694318B}"/>
          </ac:graphicFrameMkLst>
        </pc:graphicFrameChg>
        <pc:graphicFrameChg chg="del">
          <ac:chgData name="Grace Lee" userId="fd145552-a10d-4a31-a438-f8736fd84277" providerId="ADAL" clId="{B16AA00A-12D3-4356-855A-AAECC1B3E2E6}" dt="2023-04-14T03:41:16.353" v="71" actId="478"/>
          <ac:graphicFrameMkLst>
            <pc:docMk/>
            <pc:sldMk cId="369055727" sldId="4140"/>
            <ac:graphicFrameMk id="5" creationId="{1F6D69E8-098B-4675-AAE5-73A7D0391966}"/>
          </ac:graphicFrameMkLst>
        </pc:graphicFrameChg>
      </pc:sldChg>
      <pc:sldChg chg="modSp mod">
        <pc:chgData name="Grace Lee" userId="fd145552-a10d-4a31-a438-f8736fd84277" providerId="ADAL" clId="{B16AA00A-12D3-4356-855A-AAECC1B3E2E6}" dt="2023-04-14T03:41:44.847" v="77" actId="13926"/>
        <pc:sldMkLst>
          <pc:docMk/>
          <pc:sldMk cId="1215961269" sldId="4143"/>
        </pc:sldMkLst>
        <pc:graphicFrameChg chg="mod modGraphic">
          <ac:chgData name="Grace Lee" userId="fd145552-a10d-4a31-a438-f8736fd84277" providerId="ADAL" clId="{B16AA00A-12D3-4356-855A-AAECC1B3E2E6}" dt="2023-04-14T03:41:44.847" v="77" actId="13926"/>
          <ac:graphicFrameMkLst>
            <pc:docMk/>
            <pc:sldMk cId="1215961269" sldId="4143"/>
            <ac:graphicFrameMk id="2" creationId="{984D9918-6EAD-9542-8ED9-94B58ABB2D15}"/>
          </ac:graphicFrameMkLst>
        </pc:graphicFrameChg>
      </pc:sldChg>
    </pc:docChg>
  </pc:docChgLst>
  <pc:docChgLst>
    <pc:chgData name="Alexis Hutcheon" userId="ddef8b19-8dcf-422d-9735-b7eafcc40d59" providerId="ADAL" clId="{B3FE0267-32F2-BD41-B0DC-0A311E1A8F76}"/>
    <pc:docChg chg="custSel modSld">
      <pc:chgData name="Alexis Hutcheon" userId="ddef8b19-8dcf-422d-9735-b7eafcc40d59" providerId="ADAL" clId="{B3FE0267-32F2-BD41-B0DC-0A311E1A8F76}" dt="2021-09-15T05:29:22.224" v="27" actId="20577"/>
      <pc:docMkLst>
        <pc:docMk/>
      </pc:docMkLst>
      <pc:sldChg chg="modNotesTx">
        <pc:chgData name="Alexis Hutcheon" userId="ddef8b19-8dcf-422d-9735-b7eafcc40d59" providerId="ADAL" clId="{B3FE0267-32F2-BD41-B0DC-0A311E1A8F76}" dt="2021-09-15T05:01:51.248" v="25" actId="20577"/>
        <pc:sldMkLst>
          <pc:docMk/>
          <pc:sldMk cId="1051965027" sldId="4111"/>
        </pc:sldMkLst>
      </pc:sldChg>
      <pc:sldChg chg="addSp delSp modSp mod modNotesTx">
        <pc:chgData name="Alexis Hutcheon" userId="ddef8b19-8dcf-422d-9735-b7eafcc40d59" providerId="ADAL" clId="{B3FE0267-32F2-BD41-B0DC-0A311E1A8F76}" dt="2021-09-15T05:29:22.224" v="27" actId="20577"/>
        <pc:sldMkLst>
          <pc:docMk/>
          <pc:sldMk cId="1686120798" sldId="4112"/>
        </pc:sldMkLst>
        <pc:spChg chg="add del mod">
          <ac:chgData name="Alexis Hutcheon" userId="ddef8b19-8dcf-422d-9735-b7eafcc40d59" providerId="ADAL" clId="{B3FE0267-32F2-BD41-B0DC-0A311E1A8F76}" dt="2021-09-15T04:59:27.158" v="1" actId="931"/>
          <ac:spMkLst>
            <pc:docMk/>
            <pc:sldMk cId="1686120798" sldId="4112"/>
            <ac:spMk id="3" creationId="{D3B7360C-B198-8E4F-A284-830D2094456C}"/>
          </ac:spMkLst>
        </pc:spChg>
        <pc:spChg chg="add mod">
          <ac:chgData name="Alexis Hutcheon" userId="ddef8b19-8dcf-422d-9735-b7eafcc40d59" providerId="ADAL" clId="{B3FE0267-32F2-BD41-B0DC-0A311E1A8F76}" dt="2021-09-15T05:09:40.511" v="26" actId="767"/>
          <ac:spMkLst>
            <pc:docMk/>
            <pc:sldMk cId="1686120798" sldId="4112"/>
            <ac:spMk id="7" creationId="{4F44CD61-CF72-EA48-BC7A-1DC87126D75B}"/>
          </ac:spMkLst>
        </pc:spChg>
        <pc:picChg chg="del">
          <ac:chgData name="Alexis Hutcheon" userId="ddef8b19-8dcf-422d-9735-b7eafcc40d59" providerId="ADAL" clId="{B3FE0267-32F2-BD41-B0DC-0A311E1A8F76}" dt="2021-09-15T04:58:53.266" v="0" actId="478"/>
          <ac:picMkLst>
            <pc:docMk/>
            <pc:sldMk cId="1686120798" sldId="4112"/>
            <ac:picMk id="4" creationId="{1C1D117D-781D-47CF-9948-49F8C3FF3C1F}"/>
          </ac:picMkLst>
        </pc:picChg>
        <pc:picChg chg="add mod ord">
          <ac:chgData name="Alexis Hutcheon" userId="ddef8b19-8dcf-422d-9735-b7eafcc40d59" providerId="ADAL" clId="{B3FE0267-32F2-BD41-B0DC-0A311E1A8F76}" dt="2021-09-15T04:59:55.601" v="9" actId="14100"/>
          <ac:picMkLst>
            <pc:docMk/>
            <pc:sldMk cId="1686120798" sldId="4112"/>
            <ac:picMk id="6" creationId="{DB2D4295-9927-D246-8828-2868A69AA273}"/>
          </ac:picMkLst>
        </pc:picChg>
      </pc:sldChg>
    </pc:docChg>
  </pc:docChgLst>
  <pc:docChgLst>
    <pc:chgData name="Grace Lee" userId="S::grace.lee@sydney.edu.au::fd145552-a10d-4a31-a438-f8736fd84277" providerId="AD" clId="Web-{F94B4461-B821-7D38-E7B0-2209B19CA3FD}"/>
    <pc:docChg chg="modSld">
      <pc:chgData name="Grace Lee" userId="S::grace.lee@sydney.edu.au::fd145552-a10d-4a31-a438-f8736fd84277" providerId="AD" clId="Web-{F94B4461-B821-7D38-E7B0-2209B19CA3FD}" dt="2021-10-19T02:50:55.926" v="77" actId="1076"/>
      <pc:docMkLst>
        <pc:docMk/>
      </pc:docMkLst>
      <pc:sldChg chg="modSp">
        <pc:chgData name="Grace Lee" userId="S::grace.lee@sydney.edu.au::fd145552-a10d-4a31-a438-f8736fd84277" providerId="AD" clId="Web-{F94B4461-B821-7D38-E7B0-2209B19CA3FD}" dt="2021-10-19T02:50:55.926" v="77" actId="1076"/>
        <pc:sldMkLst>
          <pc:docMk/>
          <pc:sldMk cId="1215961269" sldId="4143"/>
        </pc:sldMkLst>
        <pc:spChg chg="mod">
          <ac:chgData name="Grace Lee" userId="S::grace.lee@sydney.edu.au::fd145552-a10d-4a31-a438-f8736fd84277" providerId="AD" clId="Web-{F94B4461-B821-7D38-E7B0-2209B19CA3FD}" dt="2021-10-19T02:50:55.926" v="77" actId="1076"/>
          <ac:spMkLst>
            <pc:docMk/>
            <pc:sldMk cId="1215961269" sldId="4143"/>
            <ac:spMk id="6" creationId="{AA352C3B-02E8-9C4D-AE08-2F72617D4067}"/>
          </ac:spMkLst>
        </pc:spChg>
      </pc:sldChg>
    </pc:docChg>
  </pc:docChgLst>
  <pc:docChgLst>
    <pc:chgData name="Grace Lee" userId="fd145552-a10d-4a31-a438-f8736fd84277" providerId="ADAL" clId="{0D2CDEE6-ADA1-CA48-B8B0-002F999C5295}"/>
    <pc:docChg chg="undo redo custSel addSld delSld modSld addMainMaster delMainMaster">
      <pc:chgData name="Grace Lee" userId="fd145552-a10d-4a31-a438-f8736fd84277" providerId="ADAL" clId="{0D2CDEE6-ADA1-CA48-B8B0-002F999C5295}" dt="2021-10-19T02:41:49.299" v="796" actId="1076"/>
      <pc:docMkLst>
        <pc:docMk/>
      </pc:docMkLst>
      <pc:sldChg chg="modSp mod">
        <pc:chgData name="Grace Lee" userId="fd145552-a10d-4a31-a438-f8736fd84277" providerId="ADAL" clId="{0D2CDEE6-ADA1-CA48-B8B0-002F999C5295}" dt="2021-10-19T02:36:37.973" v="267" actId="21"/>
        <pc:sldMkLst>
          <pc:docMk/>
          <pc:sldMk cId="706473041" sldId="4131"/>
        </pc:sldMkLst>
        <pc:spChg chg="mod">
          <ac:chgData name="Grace Lee" userId="fd145552-a10d-4a31-a438-f8736fd84277" providerId="ADAL" clId="{0D2CDEE6-ADA1-CA48-B8B0-002F999C5295}" dt="2021-10-19T02:36:37.973" v="267" actId="21"/>
          <ac:spMkLst>
            <pc:docMk/>
            <pc:sldMk cId="706473041" sldId="4131"/>
            <ac:spMk id="6" creationId="{AA352C3B-02E8-9C4D-AE08-2F72617D4067}"/>
          </ac:spMkLst>
        </pc:spChg>
      </pc:sldChg>
      <pc:sldChg chg="add del">
        <pc:chgData name="Grace Lee" userId="fd145552-a10d-4a31-a438-f8736fd84277" providerId="ADAL" clId="{0D2CDEE6-ADA1-CA48-B8B0-002F999C5295}" dt="2021-10-18T22:28:35.992" v="80" actId="2696"/>
        <pc:sldMkLst>
          <pc:docMk/>
          <pc:sldMk cId="2133253821" sldId="4135"/>
        </pc:sldMkLst>
      </pc:sldChg>
      <pc:sldChg chg="add del">
        <pc:chgData name="Grace Lee" userId="fd145552-a10d-4a31-a438-f8736fd84277" providerId="ADAL" clId="{0D2CDEE6-ADA1-CA48-B8B0-002F999C5295}" dt="2021-10-18T22:28:37.272" v="81" actId="2696"/>
        <pc:sldMkLst>
          <pc:docMk/>
          <pc:sldMk cId="115668497" sldId="4137"/>
        </pc:sldMkLst>
      </pc:sldChg>
      <pc:sldChg chg="modSp add mod">
        <pc:chgData name="Grace Lee" userId="fd145552-a10d-4a31-a438-f8736fd84277" providerId="ADAL" clId="{0D2CDEE6-ADA1-CA48-B8B0-002F999C5295}" dt="2021-10-19T02:41:49.299" v="796" actId="1076"/>
        <pc:sldMkLst>
          <pc:docMk/>
          <pc:sldMk cId="1215961269" sldId="4143"/>
        </pc:sldMkLst>
        <pc:spChg chg="mod">
          <ac:chgData name="Grace Lee" userId="fd145552-a10d-4a31-a438-f8736fd84277" providerId="ADAL" clId="{0D2CDEE6-ADA1-CA48-B8B0-002F999C5295}" dt="2021-10-19T02:41:49.299" v="796" actId="1076"/>
          <ac:spMkLst>
            <pc:docMk/>
            <pc:sldMk cId="1215961269" sldId="4143"/>
            <ac:spMk id="6" creationId="{AA352C3B-02E8-9C4D-AE08-2F72617D4067}"/>
          </ac:spMkLst>
        </pc:spChg>
      </pc:sldChg>
      <pc:sldMasterChg chg="add del addSldLayout delSldLayout">
        <pc:chgData name="Grace Lee" userId="fd145552-a10d-4a31-a438-f8736fd84277" providerId="ADAL" clId="{0D2CDEE6-ADA1-CA48-B8B0-002F999C5295}" dt="2021-10-18T22:28:37.272" v="81" actId="2696"/>
        <pc:sldMasterMkLst>
          <pc:docMk/>
          <pc:sldMasterMk cId="2995274554" sldId="2147483758"/>
        </pc:sldMasterMkLst>
        <pc:sldLayoutChg chg="add del">
          <pc:chgData name="Grace Lee" userId="fd145552-a10d-4a31-a438-f8736fd84277" providerId="ADAL" clId="{0D2CDEE6-ADA1-CA48-B8B0-002F999C5295}" dt="2021-10-18T22:28:37.272" v="81" actId="2696"/>
          <pc:sldLayoutMkLst>
            <pc:docMk/>
            <pc:sldMasterMk cId="2995274554" sldId="2147483758"/>
            <pc:sldLayoutMk cId="1377880784" sldId="2147483759"/>
          </pc:sldLayoutMkLst>
        </pc:sldLayoutChg>
      </pc:sldMasterChg>
    </pc:docChg>
  </pc:docChgLst>
  <pc:docChgLst>
    <pc:chgData name="Grace Lee" userId="S::grace.lee@sydney.edu.au::fd145552-a10d-4a31-a438-f8736fd84277" providerId="AD" clId="Web-{6F5648D3-A829-B579-E8C3-5376858D35EE}"/>
    <pc:docChg chg="delSld modSld">
      <pc:chgData name="Grace Lee" userId="S::grace.lee@sydney.edu.au::fd145552-a10d-4a31-a438-f8736fd84277" providerId="AD" clId="Web-{6F5648D3-A829-B579-E8C3-5376858D35EE}" dt="2021-09-13T13:05:38.050" v="4"/>
      <pc:docMkLst>
        <pc:docMk/>
      </pc:docMkLst>
      <pc:sldChg chg="modSp del">
        <pc:chgData name="Grace Lee" userId="S::grace.lee@sydney.edu.au::fd145552-a10d-4a31-a438-f8736fd84277" providerId="AD" clId="Web-{6F5648D3-A829-B579-E8C3-5376858D35EE}" dt="2021-09-13T13:05:38.050" v="4"/>
        <pc:sldMkLst>
          <pc:docMk/>
          <pc:sldMk cId="1721381198" sldId="4120"/>
        </pc:sldMkLst>
        <pc:graphicFrameChg chg="mod modGraphic">
          <ac:chgData name="Grace Lee" userId="S::grace.lee@sydney.edu.au::fd145552-a10d-4a31-a438-f8736fd84277" providerId="AD" clId="Web-{6F5648D3-A829-B579-E8C3-5376858D35EE}" dt="2021-09-13T13:05:34.206" v="3"/>
          <ac:graphicFrameMkLst>
            <pc:docMk/>
            <pc:sldMk cId="1721381198" sldId="4120"/>
            <ac:graphicFrameMk id="5" creationId="{1F6D69E8-098B-4675-AAE5-73A7D0391966}"/>
          </ac:graphicFrameMkLst>
        </pc:graphicFrameChg>
      </pc:sldChg>
    </pc:docChg>
  </pc:docChgLst>
  <pc:docChgLst>
    <pc:chgData name="Grace Lee" userId="S::grace.lee@sydney.edu.au::fd145552-a10d-4a31-a438-f8736fd84277" providerId="AD" clId="Web-{DEFAC372-1918-540A-4EAE-BEF037F52DFD}"/>
    <pc:docChg chg="modSld">
      <pc:chgData name="Grace Lee" userId="S::grace.lee@sydney.edu.au::fd145552-a10d-4a31-a438-f8736fd84277" providerId="AD" clId="Web-{DEFAC372-1918-540A-4EAE-BEF037F52DFD}" dt="2021-09-06T22:29:13.423" v="3" actId="20577"/>
      <pc:docMkLst>
        <pc:docMk/>
      </pc:docMkLst>
      <pc:sldChg chg="modSp">
        <pc:chgData name="Grace Lee" userId="S::grace.lee@sydney.edu.au::fd145552-a10d-4a31-a438-f8736fd84277" providerId="AD" clId="Web-{DEFAC372-1918-540A-4EAE-BEF037F52DFD}" dt="2021-09-06T22:29:13.423" v="3" actId="20577"/>
        <pc:sldMkLst>
          <pc:docMk/>
          <pc:sldMk cId="187938002" sldId="3307"/>
        </pc:sldMkLst>
        <pc:spChg chg="mod">
          <ac:chgData name="Grace Lee" userId="S::grace.lee@sydney.edu.au::fd145552-a10d-4a31-a438-f8736fd84277" providerId="AD" clId="Web-{DEFAC372-1918-540A-4EAE-BEF037F52DFD}" dt="2021-09-06T22:29:13.423" v="3" actId="20577"/>
          <ac:spMkLst>
            <pc:docMk/>
            <pc:sldMk cId="187938002" sldId="3307"/>
            <ac:spMk id="57" creationId="{FA2A4811-CACA-468B-8ADF-7842C0823E64}"/>
          </ac:spMkLst>
        </pc:spChg>
      </pc:sldChg>
    </pc:docChg>
  </pc:docChgLst>
  <pc:docChgLst>
    <pc:chgData name="Grace Lee" userId="S::grace.lee@sydney.edu.au::fd145552-a10d-4a31-a438-f8736fd84277" providerId="AD" clId="Web-{7C2251F8-5BBF-8AD1-7320-F2C72C8010F9}"/>
    <pc:docChg chg="addSld modSld">
      <pc:chgData name="Grace Lee" userId="S::grace.lee@sydney.edu.au::fd145552-a10d-4a31-a438-f8736fd84277" providerId="AD" clId="Web-{7C2251F8-5BBF-8AD1-7320-F2C72C8010F9}" dt="2021-09-10T01:27:57.416" v="70" actId="20577"/>
      <pc:docMkLst>
        <pc:docMk/>
      </pc:docMkLst>
      <pc:sldChg chg="addSp modSp add replId">
        <pc:chgData name="Grace Lee" userId="S::grace.lee@sydney.edu.au::fd145552-a10d-4a31-a438-f8736fd84277" providerId="AD" clId="Web-{7C2251F8-5BBF-8AD1-7320-F2C72C8010F9}" dt="2021-09-10T01:27:57.416" v="70" actId="20577"/>
        <pc:sldMkLst>
          <pc:docMk/>
          <pc:sldMk cId="2346699544" sldId="4110"/>
        </pc:sldMkLst>
        <pc:spChg chg="mod">
          <ac:chgData name="Grace Lee" userId="S::grace.lee@sydney.edu.au::fd145552-a10d-4a31-a438-f8736fd84277" providerId="AD" clId="Web-{7C2251F8-5BBF-8AD1-7320-F2C72C8010F9}" dt="2021-09-10T01:27:17.555" v="20" actId="20577"/>
          <ac:spMkLst>
            <pc:docMk/>
            <pc:sldMk cId="2346699544" sldId="4110"/>
            <ac:spMk id="3" creationId="{B354936E-C463-4D90-963C-698FEFB13AEA}"/>
          </ac:spMkLst>
        </pc:spChg>
        <pc:spChg chg="mod">
          <ac:chgData name="Grace Lee" userId="S::grace.lee@sydney.edu.au::fd145552-a10d-4a31-a438-f8736fd84277" providerId="AD" clId="Web-{7C2251F8-5BBF-8AD1-7320-F2C72C8010F9}" dt="2021-09-10T01:27:57.416" v="70" actId="20577"/>
          <ac:spMkLst>
            <pc:docMk/>
            <pc:sldMk cId="2346699544" sldId="4110"/>
            <ac:spMk id="5" creationId="{C333899F-F847-4571-9683-DCBDF5945307}"/>
          </ac:spMkLst>
        </pc:spChg>
        <pc:picChg chg="add mod">
          <ac:chgData name="Grace Lee" userId="S::grace.lee@sydney.edu.au::fd145552-a10d-4a31-a438-f8736fd84277" providerId="AD" clId="Web-{7C2251F8-5BBF-8AD1-7320-F2C72C8010F9}" dt="2021-09-10T01:27:51.150" v="55" actId="1076"/>
          <ac:picMkLst>
            <pc:docMk/>
            <pc:sldMk cId="2346699544" sldId="4110"/>
            <ac:picMk id="4" creationId="{5F89D757-303F-4B49-84A2-7D3B9D1ED389}"/>
          </ac:picMkLst>
        </pc:picChg>
      </pc:sldChg>
    </pc:docChg>
  </pc:docChgLst>
  <pc:docChgLst>
    <pc:chgData name="Grace" userId="fd145552-a10d-4a31-a438-f8736fd84277" providerId="ADAL" clId="{56835480-2BB5-4545-A32E-6CA68AA69734}"/>
    <pc:docChg chg="undo custSel addSld delSld modSld delMainMaster modMainMaster modNotesMaster">
      <pc:chgData name="Grace" userId="fd145552-a10d-4a31-a438-f8736fd84277" providerId="ADAL" clId="{56835480-2BB5-4545-A32E-6CA68AA69734}" dt="2021-09-02T04:28:15.578" v="10269" actId="1076"/>
      <pc:docMkLst>
        <pc:docMk/>
      </pc:docMkLst>
      <pc:sldChg chg="del">
        <pc:chgData name="Grace" userId="fd145552-a10d-4a31-a438-f8736fd84277" providerId="ADAL" clId="{56835480-2BB5-4545-A32E-6CA68AA69734}" dt="2021-09-01T06:49:02.282" v="0" actId="47"/>
        <pc:sldMkLst>
          <pc:docMk/>
          <pc:sldMk cId="109857222" sldId="256"/>
        </pc:sldMkLst>
      </pc:sldChg>
      <pc:sldChg chg="modSp del mod">
        <pc:chgData name="Grace" userId="fd145552-a10d-4a31-a438-f8736fd84277" providerId="ADAL" clId="{56835480-2BB5-4545-A32E-6CA68AA69734}" dt="2021-09-01T07:01:43.763" v="11" actId="47"/>
        <pc:sldMkLst>
          <pc:docMk/>
          <pc:sldMk cId="3955431827" sldId="275"/>
        </pc:sldMkLst>
        <pc:spChg chg="mod">
          <ac:chgData name="Grace" userId="fd145552-a10d-4a31-a438-f8736fd84277" providerId="ADAL" clId="{56835480-2BB5-4545-A32E-6CA68AA69734}" dt="2021-09-01T07:01:38.603" v="10"/>
          <ac:spMkLst>
            <pc:docMk/>
            <pc:sldMk cId="3955431827" sldId="275"/>
            <ac:spMk id="8" creationId="{00000000-0000-0000-0000-000000000000}"/>
          </ac:spMkLst>
        </pc:spChg>
        <pc:spChg chg="mod">
          <ac:chgData name="Grace" userId="fd145552-a10d-4a31-a438-f8736fd84277" providerId="ADAL" clId="{56835480-2BB5-4545-A32E-6CA68AA69734}" dt="2021-09-01T07:01:38.603" v="10"/>
          <ac:spMkLst>
            <pc:docMk/>
            <pc:sldMk cId="3955431827" sldId="275"/>
            <ac:spMk id="9" creationId="{00000000-0000-0000-0000-000000000000}"/>
          </ac:spMkLst>
        </pc:spChg>
        <pc:picChg chg="mod">
          <ac:chgData name="Grace" userId="fd145552-a10d-4a31-a438-f8736fd84277" providerId="ADAL" clId="{56835480-2BB5-4545-A32E-6CA68AA69734}" dt="2021-09-01T07:01:38.603" v="10"/>
          <ac:picMkLst>
            <pc:docMk/>
            <pc:sldMk cId="3955431827" sldId="275"/>
            <ac:picMk id="11" creationId="{00000000-0000-0000-0000-000000000000}"/>
          </ac:picMkLst>
        </pc:picChg>
      </pc:sldChg>
      <pc:sldChg chg="addSp modSp mod">
        <pc:chgData name="Grace" userId="fd145552-a10d-4a31-a438-f8736fd84277" providerId="ADAL" clId="{56835480-2BB5-4545-A32E-6CA68AA69734}" dt="2021-09-01T07:03:14.266" v="57" actId="1076"/>
        <pc:sldMkLst>
          <pc:docMk/>
          <pc:sldMk cId="4161985744" sldId="276"/>
        </pc:sldMkLst>
        <pc:spChg chg="add mod">
          <ac:chgData name="Grace" userId="fd145552-a10d-4a31-a438-f8736fd84277" providerId="ADAL" clId="{56835480-2BB5-4545-A32E-6CA68AA69734}" dt="2021-09-01T07:02:59.599" v="53" actId="14861"/>
          <ac:spMkLst>
            <pc:docMk/>
            <pc:sldMk cId="4161985744" sldId="276"/>
            <ac:spMk id="2" creationId="{FF9D599C-071B-4D38-86D4-1AD92CEC473A}"/>
          </ac:spMkLst>
        </pc:spChg>
        <pc:picChg chg="add mod">
          <ac:chgData name="Grace" userId="fd145552-a10d-4a31-a438-f8736fd84277" providerId="ADAL" clId="{56835480-2BB5-4545-A32E-6CA68AA69734}" dt="2021-09-01T07:03:14.266" v="57" actId="1076"/>
          <ac:picMkLst>
            <pc:docMk/>
            <pc:sldMk cId="4161985744" sldId="276"/>
            <ac:picMk id="4" creationId="{C0914225-1143-4043-B2DC-C9FF4712DAB6}"/>
          </ac:picMkLst>
        </pc:picChg>
      </pc:sldChg>
      <pc:sldChg chg="modSp del modNotes">
        <pc:chgData name="Grace" userId="fd145552-a10d-4a31-a438-f8736fd84277" providerId="ADAL" clId="{56835480-2BB5-4545-A32E-6CA68AA69734}" dt="2021-09-01T07:03:23.657" v="59" actId="47"/>
        <pc:sldMkLst>
          <pc:docMk/>
          <pc:sldMk cId="265612441" sldId="567"/>
        </pc:sldMkLst>
        <pc:spChg chg="mod">
          <ac:chgData name="Grace" userId="fd145552-a10d-4a31-a438-f8736fd84277" providerId="ADAL" clId="{56835480-2BB5-4545-A32E-6CA68AA69734}" dt="2021-09-01T07:01:38.603" v="10"/>
          <ac:spMkLst>
            <pc:docMk/>
            <pc:sldMk cId="265612441" sldId="567"/>
            <ac:spMk id="5" creationId="{7E93CFB2-EA0E-432B-B72D-38038DB51779}"/>
          </ac:spMkLst>
        </pc:spChg>
        <pc:graphicFrameChg chg="mod">
          <ac:chgData name="Grace" userId="fd145552-a10d-4a31-a438-f8736fd84277" providerId="ADAL" clId="{56835480-2BB5-4545-A32E-6CA68AA69734}" dt="2021-09-01T07:01:38.603" v="10"/>
          <ac:graphicFrameMkLst>
            <pc:docMk/>
            <pc:sldMk cId="265612441" sldId="567"/>
            <ac:graphicFrameMk id="4" creationId="{94FF61F7-8040-4552-9AFF-9214FB1A6FA0}"/>
          </ac:graphicFrameMkLst>
        </pc:graphicFrameChg>
      </pc:sldChg>
      <pc:sldChg chg="addSp modSp">
        <pc:chgData name="Grace" userId="fd145552-a10d-4a31-a438-f8736fd84277" providerId="ADAL" clId="{56835480-2BB5-4545-A32E-6CA68AA69734}" dt="2021-09-01T07:03:16.326" v="58"/>
        <pc:sldMkLst>
          <pc:docMk/>
          <pc:sldMk cId="1188846979" sldId="573"/>
        </pc:sldMkLst>
        <pc:spChg chg="add mod">
          <ac:chgData name="Grace" userId="fd145552-a10d-4a31-a438-f8736fd84277" providerId="ADAL" clId="{56835480-2BB5-4545-A32E-6CA68AA69734}" dt="2021-09-01T07:03:16.326" v="58"/>
          <ac:spMkLst>
            <pc:docMk/>
            <pc:sldMk cId="1188846979" sldId="573"/>
            <ac:spMk id="2" creationId="{FF839D94-B54A-422C-B108-8A4A6128B28C}"/>
          </ac:spMkLst>
        </pc:spChg>
        <pc:picChg chg="add mod">
          <ac:chgData name="Grace" userId="fd145552-a10d-4a31-a438-f8736fd84277" providerId="ADAL" clId="{56835480-2BB5-4545-A32E-6CA68AA69734}" dt="2021-09-01T07:03:16.326" v="58"/>
          <ac:picMkLst>
            <pc:docMk/>
            <pc:sldMk cId="1188846979" sldId="573"/>
            <ac:picMk id="3" creationId="{3C80669F-824D-4FF0-A351-0F0479B6D884}"/>
          </ac:picMkLst>
        </pc:picChg>
      </pc:sldChg>
      <pc:sldChg chg="addSp delSp modSp mod">
        <pc:chgData name="Grace" userId="fd145552-a10d-4a31-a438-f8736fd84277" providerId="ADAL" clId="{56835480-2BB5-4545-A32E-6CA68AA69734}" dt="2021-09-01T07:04:24.031" v="111" actId="478"/>
        <pc:sldMkLst>
          <pc:docMk/>
          <pc:sldMk cId="1171427570" sldId="574"/>
        </pc:sldMkLst>
        <pc:spChg chg="add del mod">
          <ac:chgData name="Grace" userId="fd145552-a10d-4a31-a438-f8736fd84277" providerId="ADAL" clId="{56835480-2BB5-4545-A32E-6CA68AA69734}" dt="2021-09-01T07:02:16.024" v="46" actId="478"/>
          <ac:spMkLst>
            <pc:docMk/>
            <pc:sldMk cId="1171427570" sldId="574"/>
            <ac:spMk id="3" creationId="{715EC55E-B084-4BBD-A93D-712D7EC47FAB}"/>
          </ac:spMkLst>
        </pc:spChg>
        <pc:spChg chg="add del mod">
          <ac:chgData name="Grace" userId="fd145552-a10d-4a31-a438-f8736fd84277" providerId="ADAL" clId="{56835480-2BB5-4545-A32E-6CA68AA69734}" dt="2021-09-01T07:04:24.031" v="111" actId="478"/>
          <ac:spMkLst>
            <pc:docMk/>
            <pc:sldMk cId="1171427570" sldId="574"/>
            <ac:spMk id="5" creationId="{23A49DC9-5269-4C10-87E8-6CF88D61A51E}"/>
          </ac:spMkLst>
        </pc:spChg>
        <pc:spChg chg="mod">
          <ac:chgData name="Grace" userId="fd145552-a10d-4a31-a438-f8736fd84277" providerId="ADAL" clId="{56835480-2BB5-4545-A32E-6CA68AA69734}" dt="2021-09-01T07:04:23.155" v="109" actId="20577"/>
          <ac:spMkLst>
            <pc:docMk/>
            <pc:sldMk cId="1171427570" sldId="574"/>
            <ac:spMk id="8" creationId="{00000000-0000-0000-0000-000000000000}"/>
          </ac:spMkLst>
        </pc:spChg>
        <pc:spChg chg="add del">
          <ac:chgData name="Grace" userId="fd145552-a10d-4a31-a438-f8736fd84277" providerId="ADAL" clId="{56835480-2BB5-4545-A32E-6CA68AA69734}" dt="2021-09-01T07:04:24.031" v="111" actId="478"/>
          <ac:spMkLst>
            <pc:docMk/>
            <pc:sldMk cId="1171427570" sldId="574"/>
            <ac:spMk id="9" creationId="{00000000-0000-0000-0000-000000000000}"/>
          </ac:spMkLst>
        </pc:spChg>
      </pc:sldChg>
      <pc:sldChg chg="addSp delSp modSp new del mod">
        <pc:chgData name="Grace" userId="fd145552-a10d-4a31-a438-f8736fd84277" providerId="ADAL" clId="{56835480-2BB5-4545-A32E-6CA68AA69734}" dt="2021-09-01T07:04:27.506" v="112" actId="47"/>
        <pc:sldMkLst>
          <pc:docMk/>
          <pc:sldMk cId="618620181" sldId="575"/>
        </pc:sldMkLst>
        <pc:spChg chg="mod">
          <ac:chgData name="Grace" userId="fd145552-a10d-4a31-a438-f8736fd84277" providerId="ADAL" clId="{56835480-2BB5-4545-A32E-6CA68AA69734}" dt="2021-09-01T07:03:44.030" v="78" actId="20577"/>
          <ac:spMkLst>
            <pc:docMk/>
            <pc:sldMk cId="618620181" sldId="575"/>
            <ac:spMk id="2" creationId="{6472EBBA-7F30-4230-AD5E-F3AF8DAC3BE9}"/>
          </ac:spMkLst>
        </pc:spChg>
        <pc:spChg chg="add del">
          <ac:chgData name="Grace" userId="fd145552-a10d-4a31-a438-f8736fd84277" providerId="ADAL" clId="{56835480-2BB5-4545-A32E-6CA68AA69734}" dt="2021-09-01T07:03:44.294" v="79" actId="478"/>
          <ac:spMkLst>
            <pc:docMk/>
            <pc:sldMk cId="618620181" sldId="575"/>
            <ac:spMk id="3" creationId="{B40A8D0D-B68C-48B6-98E2-CFDEB2EC0733}"/>
          </ac:spMkLst>
        </pc:spChg>
      </pc:sldChg>
      <pc:sldChg chg="addSp delSp modSp new mod">
        <pc:chgData name="Grace" userId="fd145552-a10d-4a31-a438-f8736fd84277" providerId="ADAL" clId="{56835480-2BB5-4545-A32E-6CA68AA69734}" dt="2021-09-01T22:43:36.774" v="988"/>
        <pc:sldMkLst>
          <pc:docMk/>
          <pc:sldMk cId="1330355191" sldId="576"/>
        </pc:sldMkLst>
        <pc:spChg chg="del">
          <ac:chgData name="Grace" userId="fd145552-a10d-4a31-a438-f8736fd84277" providerId="ADAL" clId="{56835480-2BB5-4545-A32E-6CA68AA69734}" dt="2021-09-01T07:04:29.499" v="113" actId="478"/>
          <ac:spMkLst>
            <pc:docMk/>
            <pc:sldMk cId="1330355191" sldId="576"/>
            <ac:spMk id="2" creationId="{0A14A8D3-25B1-4607-99C6-73F12F40B4EE}"/>
          </ac:spMkLst>
        </pc:spChg>
        <pc:spChg chg="mod">
          <ac:chgData name="Grace" userId="fd145552-a10d-4a31-a438-f8736fd84277" providerId="ADAL" clId="{56835480-2BB5-4545-A32E-6CA68AA69734}" dt="2021-09-01T07:03:53.761" v="87" actId="255"/>
          <ac:spMkLst>
            <pc:docMk/>
            <pc:sldMk cId="1330355191" sldId="576"/>
            <ac:spMk id="3" creationId="{1C207EF0-D5F8-4C7D-9363-8246CDD5503A}"/>
          </ac:spMkLst>
        </pc:spChg>
        <pc:spChg chg="add mod">
          <ac:chgData name="Grace" userId="fd145552-a10d-4a31-a438-f8736fd84277" providerId="ADAL" clId="{56835480-2BB5-4545-A32E-6CA68AA69734}" dt="2021-09-01T22:43:36.774" v="988"/>
          <ac:spMkLst>
            <pc:docMk/>
            <pc:sldMk cId="1330355191" sldId="576"/>
            <ac:spMk id="6" creationId="{3F736E9F-099F-6E49-8413-5352C763CACD}"/>
          </ac:spMkLst>
        </pc:spChg>
        <pc:spChg chg="add mod">
          <ac:chgData name="Grace" userId="fd145552-a10d-4a31-a438-f8736fd84277" providerId="ADAL" clId="{56835480-2BB5-4545-A32E-6CA68AA69734}" dt="2021-09-01T22:43:36.774" v="988"/>
          <ac:spMkLst>
            <pc:docMk/>
            <pc:sldMk cId="1330355191" sldId="576"/>
            <ac:spMk id="7" creationId="{E333F3FF-B79E-BE40-B783-ADB5618202DD}"/>
          </ac:spMkLst>
        </pc:spChg>
        <pc:spChg chg="add mod">
          <ac:chgData name="Grace" userId="fd145552-a10d-4a31-a438-f8736fd84277" providerId="ADAL" clId="{56835480-2BB5-4545-A32E-6CA68AA69734}" dt="2021-09-01T22:43:36.774" v="988"/>
          <ac:spMkLst>
            <pc:docMk/>
            <pc:sldMk cId="1330355191" sldId="576"/>
            <ac:spMk id="8" creationId="{E262FF1D-F7EE-174E-8F1F-8970480BF702}"/>
          </ac:spMkLst>
        </pc:spChg>
        <pc:spChg chg="add mod">
          <ac:chgData name="Grace" userId="fd145552-a10d-4a31-a438-f8736fd84277" providerId="ADAL" clId="{56835480-2BB5-4545-A32E-6CA68AA69734}" dt="2021-09-01T22:43:36.774" v="988"/>
          <ac:spMkLst>
            <pc:docMk/>
            <pc:sldMk cId="1330355191" sldId="576"/>
            <ac:spMk id="9" creationId="{1B9EF0F6-9A52-D149-AA60-164F75A37422}"/>
          </ac:spMkLst>
        </pc:spChg>
        <pc:spChg chg="add mod">
          <ac:chgData name="Grace" userId="fd145552-a10d-4a31-a438-f8736fd84277" providerId="ADAL" clId="{56835480-2BB5-4545-A32E-6CA68AA69734}" dt="2021-09-01T22:43:36.774" v="988"/>
          <ac:spMkLst>
            <pc:docMk/>
            <pc:sldMk cId="1330355191" sldId="576"/>
            <ac:spMk id="10" creationId="{1D62573D-EDBB-E84E-9782-09E0B2F508C0}"/>
          </ac:spMkLst>
        </pc:spChg>
        <pc:spChg chg="add mod">
          <ac:chgData name="Grace" userId="fd145552-a10d-4a31-a438-f8736fd84277" providerId="ADAL" clId="{56835480-2BB5-4545-A32E-6CA68AA69734}" dt="2021-09-01T22:43:36.774" v="988"/>
          <ac:spMkLst>
            <pc:docMk/>
            <pc:sldMk cId="1330355191" sldId="576"/>
            <ac:spMk id="11" creationId="{59CF35BA-084D-4949-A2A0-2E6687ECA264}"/>
          </ac:spMkLst>
        </pc:spChg>
        <pc:spChg chg="add mod">
          <ac:chgData name="Grace" userId="fd145552-a10d-4a31-a438-f8736fd84277" providerId="ADAL" clId="{56835480-2BB5-4545-A32E-6CA68AA69734}" dt="2021-09-01T22:43:36.774" v="988"/>
          <ac:spMkLst>
            <pc:docMk/>
            <pc:sldMk cId="1330355191" sldId="576"/>
            <ac:spMk id="12" creationId="{FE8DFC47-E1E0-7D4E-BB1E-FFB84E9F9DDF}"/>
          </ac:spMkLst>
        </pc:spChg>
        <pc:spChg chg="add mod">
          <ac:chgData name="Grace" userId="fd145552-a10d-4a31-a438-f8736fd84277" providerId="ADAL" clId="{56835480-2BB5-4545-A32E-6CA68AA69734}" dt="2021-09-01T22:43:36.774" v="988"/>
          <ac:spMkLst>
            <pc:docMk/>
            <pc:sldMk cId="1330355191" sldId="576"/>
            <ac:spMk id="13" creationId="{8222752D-BB13-8942-87E1-7A07B28965FC}"/>
          </ac:spMkLst>
        </pc:spChg>
        <pc:spChg chg="add mod">
          <ac:chgData name="Grace" userId="fd145552-a10d-4a31-a438-f8736fd84277" providerId="ADAL" clId="{56835480-2BB5-4545-A32E-6CA68AA69734}" dt="2021-09-01T22:43:36.774" v="988"/>
          <ac:spMkLst>
            <pc:docMk/>
            <pc:sldMk cId="1330355191" sldId="576"/>
            <ac:spMk id="14" creationId="{9E5D03F1-A122-E44B-AD4B-39BC92875066}"/>
          </ac:spMkLst>
        </pc:spChg>
        <pc:spChg chg="add mod">
          <ac:chgData name="Grace" userId="fd145552-a10d-4a31-a438-f8736fd84277" providerId="ADAL" clId="{56835480-2BB5-4545-A32E-6CA68AA69734}" dt="2021-09-01T22:43:36.774" v="988"/>
          <ac:spMkLst>
            <pc:docMk/>
            <pc:sldMk cId="1330355191" sldId="576"/>
            <ac:spMk id="15" creationId="{53924CEB-4D7D-F241-8D0D-F765FB62291C}"/>
          </ac:spMkLst>
        </pc:spChg>
        <pc:spChg chg="add mod">
          <ac:chgData name="Grace" userId="fd145552-a10d-4a31-a438-f8736fd84277" providerId="ADAL" clId="{56835480-2BB5-4545-A32E-6CA68AA69734}" dt="2021-09-01T22:43:36.774" v="988"/>
          <ac:spMkLst>
            <pc:docMk/>
            <pc:sldMk cId="1330355191" sldId="576"/>
            <ac:spMk id="16" creationId="{9F619023-99B5-D048-963C-2919297AAD8E}"/>
          </ac:spMkLst>
        </pc:spChg>
        <pc:spChg chg="add mod">
          <ac:chgData name="Grace" userId="fd145552-a10d-4a31-a438-f8736fd84277" providerId="ADAL" clId="{56835480-2BB5-4545-A32E-6CA68AA69734}" dt="2021-09-01T22:43:36.774" v="988"/>
          <ac:spMkLst>
            <pc:docMk/>
            <pc:sldMk cId="1330355191" sldId="576"/>
            <ac:spMk id="17" creationId="{7F2E6090-CD6F-E849-9E28-E64715761747}"/>
          </ac:spMkLst>
        </pc:spChg>
        <pc:spChg chg="add mod">
          <ac:chgData name="Grace" userId="fd145552-a10d-4a31-a438-f8736fd84277" providerId="ADAL" clId="{56835480-2BB5-4545-A32E-6CA68AA69734}" dt="2021-09-01T22:43:36.774" v="988"/>
          <ac:spMkLst>
            <pc:docMk/>
            <pc:sldMk cId="1330355191" sldId="576"/>
            <ac:spMk id="18" creationId="{EE644C53-6D18-3B45-8ACC-5347164E1A9E}"/>
          </ac:spMkLst>
        </pc:spChg>
        <pc:spChg chg="add mod">
          <ac:chgData name="Grace" userId="fd145552-a10d-4a31-a438-f8736fd84277" providerId="ADAL" clId="{56835480-2BB5-4545-A32E-6CA68AA69734}" dt="2021-09-01T22:43:36.774" v="988"/>
          <ac:spMkLst>
            <pc:docMk/>
            <pc:sldMk cId="1330355191" sldId="576"/>
            <ac:spMk id="19" creationId="{2A06BBD3-F9C8-734D-8310-8E4C9DE456CA}"/>
          </ac:spMkLst>
        </pc:spChg>
        <pc:spChg chg="add mod">
          <ac:chgData name="Grace" userId="fd145552-a10d-4a31-a438-f8736fd84277" providerId="ADAL" clId="{56835480-2BB5-4545-A32E-6CA68AA69734}" dt="2021-09-01T22:43:36.774" v="988"/>
          <ac:spMkLst>
            <pc:docMk/>
            <pc:sldMk cId="1330355191" sldId="576"/>
            <ac:spMk id="20" creationId="{5305061A-C390-384E-93A0-F3265B686A2B}"/>
          </ac:spMkLst>
        </pc:spChg>
        <pc:spChg chg="add mod">
          <ac:chgData name="Grace" userId="fd145552-a10d-4a31-a438-f8736fd84277" providerId="ADAL" clId="{56835480-2BB5-4545-A32E-6CA68AA69734}" dt="2021-09-01T22:43:36.774" v="988"/>
          <ac:spMkLst>
            <pc:docMk/>
            <pc:sldMk cId="1330355191" sldId="576"/>
            <ac:spMk id="21" creationId="{131A941F-9678-8040-AB77-60477D433B5F}"/>
          </ac:spMkLst>
        </pc:spChg>
        <pc:spChg chg="add mod">
          <ac:chgData name="Grace" userId="fd145552-a10d-4a31-a438-f8736fd84277" providerId="ADAL" clId="{56835480-2BB5-4545-A32E-6CA68AA69734}" dt="2021-09-01T22:43:36.774" v="988"/>
          <ac:spMkLst>
            <pc:docMk/>
            <pc:sldMk cId="1330355191" sldId="576"/>
            <ac:spMk id="24" creationId="{F9FE1841-152B-0945-BE3A-A44AB859C478}"/>
          </ac:spMkLst>
        </pc:spChg>
        <pc:spChg chg="add mod">
          <ac:chgData name="Grace" userId="fd145552-a10d-4a31-a438-f8736fd84277" providerId="ADAL" clId="{56835480-2BB5-4545-A32E-6CA68AA69734}" dt="2021-09-01T22:43:36.774" v="988"/>
          <ac:spMkLst>
            <pc:docMk/>
            <pc:sldMk cId="1330355191" sldId="576"/>
            <ac:spMk id="25" creationId="{586D0358-CD34-D249-9640-8D4BAE0D8E13}"/>
          </ac:spMkLst>
        </pc:spChg>
        <pc:spChg chg="add mod">
          <ac:chgData name="Grace" userId="fd145552-a10d-4a31-a438-f8736fd84277" providerId="ADAL" clId="{56835480-2BB5-4545-A32E-6CA68AA69734}" dt="2021-09-01T22:43:36.774" v="988"/>
          <ac:spMkLst>
            <pc:docMk/>
            <pc:sldMk cId="1330355191" sldId="576"/>
            <ac:spMk id="26" creationId="{CEC53E14-C966-904A-8681-BF5653853D5E}"/>
          </ac:spMkLst>
        </pc:spChg>
        <pc:spChg chg="add mod">
          <ac:chgData name="Grace" userId="fd145552-a10d-4a31-a438-f8736fd84277" providerId="ADAL" clId="{56835480-2BB5-4545-A32E-6CA68AA69734}" dt="2021-09-01T22:43:36.774" v="988"/>
          <ac:spMkLst>
            <pc:docMk/>
            <pc:sldMk cId="1330355191" sldId="576"/>
            <ac:spMk id="27" creationId="{8B1A09AF-2C7B-9049-8700-80EEE985A09B}"/>
          </ac:spMkLst>
        </pc:spChg>
        <pc:spChg chg="add mod">
          <ac:chgData name="Grace" userId="fd145552-a10d-4a31-a438-f8736fd84277" providerId="ADAL" clId="{56835480-2BB5-4545-A32E-6CA68AA69734}" dt="2021-09-01T22:43:36.774" v="988"/>
          <ac:spMkLst>
            <pc:docMk/>
            <pc:sldMk cId="1330355191" sldId="576"/>
            <ac:spMk id="28" creationId="{61692538-76A4-0C45-AD20-BC20513168A6}"/>
          </ac:spMkLst>
        </pc:spChg>
        <pc:spChg chg="add mod">
          <ac:chgData name="Grace" userId="fd145552-a10d-4a31-a438-f8736fd84277" providerId="ADAL" clId="{56835480-2BB5-4545-A32E-6CA68AA69734}" dt="2021-09-01T22:43:36.774" v="988"/>
          <ac:spMkLst>
            <pc:docMk/>
            <pc:sldMk cId="1330355191" sldId="576"/>
            <ac:spMk id="29" creationId="{E401E637-DD57-BC4F-9B78-1E912A948463}"/>
          </ac:spMkLst>
        </pc:spChg>
        <pc:spChg chg="add mod">
          <ac:chgData name="Grace" userId="fd145552-a10d-4a31-a438-f8736fd84277" providerId="ADAL" clId="{56835480-2BB5-4545-A32E-6CA68AA69734}" dt="2021-09-01T22:43:36.774" v="988"/>
          <ac:spMkLst>
            <pc:docMk/>
            <pc:sldMk cId="1330355191" sldId="576"/>
            <ac:spMk id="31" creationId="{C2E8756C-831B-3C4D-B20C-0AF2171DA544}"/>
          </ac:spMkLst>
        </pc:spChg>
        <pc:spChg chg="add mod">
          <ac:chgData name="Grace" userId="fd145552-a10d-4a31-a438-f8736fd84277" providerId="ADAL" clId="{56835480-2BB5-4545-A32E-6CA68AA69734}" dt="2021-09-01T22:43:36.774" v="988"/>
          <ac:spMkLst>
            <pc:docMk/>
            <pc:sldMk cId="1330355191" sldId="576"/>
            <ac:spMk id="32" creationId="{13F1BDD0-A71E-D54A-94E7-AB4849587FF9}"/>
          </ac:spMkLst>
        </pc:spChg>
        <pc:graphicFrameChg chg="add del modGraphic">
          <ac:chgData name="Grace" userId="fd145552-a10d-4a31-a438-f8736fd84277" providerId="ADAL" clId="{56835480-2BB5-4545-A32E-6CA68AA69734}" dt="2021-09-01T07:04:43.764" v="128" actId="478"/>
          <ac:graphicFrameMkLst>
            <pc:docMk/>
            <pc:sldMk cId="1330355191" sldId="576"/>
            <ac:graphicFrameMk id="4" creationId="{96F0DCD0-8930-4ED6-8E41-3E2AA4DE670B}"/>
          </ac:graphicFrameMkLst>
        </pc:graphicFrameChg>
        <pc:graphicFrameChg chg="add mod modGraphic">
          <ac:chgData name="Grace" userId="fd145552-a10d-4a31-a438-f8736fd84277" providerId="ADAL" clId="{56835480-2BB5-4545-A32E-6CA68AA69734}" dt="2021-09-01T22:23:37.481" v="983" actId="14734"/>
          <ac:graphicFrameMkLst>
            <pc:docMk/>
            <pc:sldMk cId="1330355191" sldId="576"/>
            <ac:graphicFrameMk id="5" creationId="{1F6D69E8-098B-4675-AAE5-73A7D0391966}"/>
          </ac:graphicFrameMkLst>
        </pc:graphicFrameChg>
        <pc:graphicFrameChg chg="add mod">
          <ac:chgData name="Grace" userId="fd145552-a10d-4a31-a438-f8736fd84277" providerId="ADAL" clId="{56835480-2BB5-4545-A32E-6CA68AA69734}" dt="2021-09-01T22:43:36.774" v="988"/>
          <ac:graphicFrameMkLst>
            <pc:docMk/>
            <pc:sldMk cId="1330355191" sldId="576"/>
            <ac:graphicFrameMk id="22" creationId="{52FE741A-DBEC-4E45-A216-F00F2125BE90}"/>
          </ac:graphicFrameMkLst>
        </pc:graphicFrameChg>
        <pc:graphicFrameChg chg="add mod">
          <ac:chgData name="Grace" userId="fd145552-a10d-4a31-a438-f8736fd84277" providerId="ADAL" clId="{56835480-2BB5-4545-A32E-6CA68AA69734}" dt="2021-09-01T22:43:36.774" v="988"/>
          <ac:graphicFrameMkLst>
            <pc:docMk/>
            <pc:sldMk cId="1330355191" sldId="576"/>
            <ac:graphicFrameMk id="23" creationId="{68AA83EE-2B9C-5249-9F15-FCC7A54F3FD0}"/>
          </ac:graphicFrameMkLst>
        </pc:graphicFrameChg>
        <pc:graphicFrameChg chg="add mod">
          <ac:chgData name="Grace" userId="fd145552-a10d-4a31-a438-f8736fd84277" providerId="ADAL" clId="{56835480-2BB5-4545-A32E-6CA68AA69734}" dt="2021-09-01T22:43:36.774" v="988"/>
          <ac:graphicFrameMkLst>
            <pc:docMk/>
            <pc:sldMk cId="1330355191" sldId="576"/>
            <ac:graphicFrameMk id="30" creationId="{86CA88D4-A4F9-E44A-AF28-9A2E644574F8}"/>
          </ac:graphicFrameMkLst>
        </pc:graphicFrameChg>
      </pc:sldChg>
      <pc:sldChg chg="addSp modSp new del">
        <pc:chgData name="Grace" userId="fd145552-a10d-4a31-a438-f8736fd84277" providerId="ADAL" clId="{56835480-2BB5-4545-A32E-6CA68AA69734}" dt="2021-09-01T22:43:45.116" v="990" actId="47"/>
        <pc:sldMkLst>
          <pc:docMk/>
          <pc:sldMk cId="907971304" sldId="577"/>
        </pc:sldMkLst>
        <pc:spChg chg="add mod">
          <ac:chgData name="Grace" userId="fd145552-a10d-4a31-a438-f8736fd84277" providerId="ADAL" clId="{56835480-2BB5-4545-A32E-6CA68AA69734}" dt="2021-09-01T22:43:31.696" v="986"/>
          <ac:spMkLst>
            <pc:docMk/>
            <pc:sldMk cId="907971304" sldId="577"/>
            <ac:spMk id="2" creationId="{3F736E9F-099F-6E49-8413-5352C763CACD}"/>
          </ac:spMkLst>
        </pc:spChg>
        <pc:spChg chg="add mod">
          <ac:chgData name="Grace" userId="fd145552-a10d-4a31-a438-f8736fd84277" providerId="ADAL" clId="{56835480-2BB5-4545-A32E-6CA68AA69734}" dt="2021-09-01T22:43:31.696" v="986"/>
          <ac:spMkLst>
            <pc:docMk/>
            <pc:sldMk cId="907971304" sldId="577"/>
            <ac:spMk id="3" creationId="{E333F3FF-B79E-BE40-B783-ADB5618202DD}"/>
          </ac:spMkLst>
        </pc:spChg>
        <pc:spChg chg="add mod">
          <ac:chgData name="Grace" userId="fd145552-a10d-4a31-a438-f8736fd84277" providerId="ADAL" clId="{56835480-2BB5-4545-A32E-6CA68AA69734}" dt="2021-09-01T22:43:31.696" v="986"/>
          <ac:spMkLst>
            <pc:docMk/>
            <pc:sldMk cId="907971304" sldId="577"/>
            <ac:spMk id="4" creationId="{E262FF1D-F7EE-174E-8F1F-8970480BF702}"/>
          </ac:spMkLst>
        </pc:spChg>
        <pc:spChg chg="add mod">
          <ac:chgData name="Grace" userId="fd145552-a10d-4a31-a438-f8736fd84277" providerId="ADAL" clId="{56835480-2BB5-4545-A32E-6CA68AA69734}" dt="2021-09-01T22:43:31.696" v="986"/>
          <ac:spMkLst>
            <pc:docMk/>
            <pc:sldMk cId="907971304" sldId="577"/>
            <ac:spMk id="5" creationId="{1B9EF0F6-9A52-D149-AA60-164F75A37422}"/>
          </ac:spMkLst>
        </pc:spChg>
        <pc:spChg chg="add mod">
          <ac:chgData name="Grace" userId="fd145552-a10d-4a31-a438-f8736fd84277" providerId="ADAL" clId="{56835480-2BB5-4545-A32E-6CA68AA69734}" dt="2021-09-01T22:43:31.696" v="986"/>
          <ac:spMkLst>
            <pc:docMk/>
            <pc:sldMk cId="907971304" sldId="577"/>
            <ac:spMk id="6" creationId="{1D62573D-EDBB-E84E-9782-09E0B2F508C0}"/>
          </ac:spMkLst>
        </pc:spChg>
        <pc:spChg chg="add mod">
          <ac:chgData name="Grace" userId="fd145552-a10d-4a31-a438-f8736fd84277" providerId="ADAL" clId="{56835480-2BB5-4545-A32E-6CA68AA69734}" dt="2021-09-01T22:43:31.696" v="986"/>
          <ac:spMkLst>
            <pc:docMk/>
            <pc:sldMk cId="907971304" sldId="577"/>
            <ac:spMk id="7" creationId="{59CF35BA-084D-4949-A2A0-2E6687ECA264}"/>
          </ac:spMkLst>
        </pc:spChg>
        <pc:spChg chg="add mod">
          <ac:chgData name="Grace" userId="fd145552-a10d-4a31-a438-f8736fd84277" providerId="ADAL" clId="{56835480-2BB5-4545-A32E-6CA68AA69734}" dt="2021-09-01T22:43:31.696" v="986"/>
          <ac:spMkLst>
            <pc:docMk/>
            <pc:sldMk cId="907971304" sldId="577"/>
            <ac:spMk id="8" creationId="{FE8DFC47-E1E0-7D4E-BB1E-FFB84E9F9DDF}"/>
          </ac:spMkLst>
        </pc:spChg>
        <pc:spChg chg="add mod">
          <ac:chgData name="Grace" userId="fd145552-a10d-4a31-a438-f8736fd84277" providerId="ADAL" clId="{56835480-2BB5-4545-A32E-6CA68AA69734}" dt="2021-09-01T22:43:31.696" v="986"/>
          <ac:spMkLst>
            <pc:docMk/>
            <pc:sldMk cId="907971304" sldId="577"/>
            <ac:spMk id="9" creationId="{8222752D-BB13-8942-87E1-7A07B28965FC}"/>
          </ac:spMkLst>
        </pc:spChg>
        <pc:spChg chg="add mod">
          <ac:chgData name="Grace" userId="fd145552-a10d-4a31-a438-f8736fd84277" providerId="ADAL" clId="{56835480-2BB5-4545-A32E-6CA68AA69734}" dt="2021-09-01T22:43:31.696" v="986"/>
          <ac:spMkLst>
            <pc:docMk/>
            <pc:sldMk cId="907971304" sldId="577"/>
            <ac:spMk id="10" creationId="{9E5D03F1-A122-E44B-AD4B-39BC92875066}"/>
          </ac:spMkLst>
        </pc:spChg>
        <pc:spChg chg="add mod">
          <ac:chgData name="Grace" userId="fd145552-a10d-4a31-a438-f8736fd84277" providerId="ADAL" clId="{56835480-2BB5-4545-A32E-6CA68AA69734}" dt="2021-09-01T22:43:31.696" v="986"/>
          <ac:spMkLst>
            <pc:docMk/>
            <pc:sldMk cId="907971304" sldId="577"/>
            <ac:spMk id="11" creationId="{53924CEB-4D7D-F241-8D0D-F765FB62291C}"/>
          </ac:spMkLst>
        </pc:spChg>
        <pc:spChg chg="add mod">
          <ac:chgData name="Grace" userId="fd145552-a10d-4a31-a438-f8736fd84277" providerId="ADAL" clId="{56835480-2BB5-4545-A32E-6CA68AA69734}" dt="2021-09-01T22:43:31.696" v="986"/>
          <ac:spMkLst>
            <pc:docMk/>
            <pc:sldMk cId="907971304" sldId="577"/>
            <ac:spMk id="12" creationId="{9F619023-99B5-D048-963C-2919297AAD8E}"/>
          </ac:spMkLst>
        </pc:spChg>
        <pc:spChg chg="add mod">
          <ac:chgData name="Grace" userId="fd145552-a10d-4a31-a438-f8736fd84277" providerId="ADAL" clId="{56835480-2BB5-4545-A32E-6CA68AA69734}" dt="2021-09-01T22:43:31.696" v="986"/>
          <ac:spMkLst>
            <pc:docMk/>
            <pc:sldMk cId="907971304" sldId="577"/>
            <ac:spMk id="13" creationId="{7F2E6090-CD6F-E849-9E28-E64715761747}"/>
          </ac:spMkLst>
        </pc:spChg>
        <pc:spChg chg="add mod">
          <ac:chgData name="Grace" userId="fd145552-a10d-4a31-a438-f8736fd84277" providerId="ADAL" clId="{56835480-2BB5-4545-A32E-6CA68AA69734}" dt="2021-09-01T22:43:31.696" v="986"/>
          <ac:spMkLst>
            <pc:docMk/>
            <pc:sldMk cId="907971304" sldId="577"/>
            <ac:spMk id="14" creationId="{EE644C53-6D18-3B45-8ACC-5347164E1A9E}"/>
          </ac:spMkLst>
        </pc:spChg>
        <pc:spChg chg="add mod">
          <ac:chgData name="Grace" userId="fd145552-a10d-4a31-a438-f8736fd84277" providerId="ADAL" clId="{56835480-2BB5-4545-A32E-6CA68AA69734}" dt="2021-09-01T22:43:31.696" v="986"/>
          <ac:spMkLst>
            <pc:docMk/>
            <pc:sldMk cId="907971304" sldId="577"/>
            <ac:spMk id="15" creationId="{2A06BBD3-F9C8-734D-8310-8E4C9DE456CA}"/>
          </ac:spMkLst>
        </pc:spChg>
        <pc:spChg chg="add mod">
          <ac:chgData name="Grace" userId="fd145552-a10d-4a31-a438-f8736fd84277" providerId="ADAL" clId="{56835480-2BB5-4545-A32E-6CA68AA69734}" dt="2021-09-01T22:43:31.696" v="986"/>
          <ac:spMkLst>
            <pc:docMk/>
            <pc:sldMk cId="907971304" sldId="577"/>
            <ac:spMk id="16" creationId="{5305061A-C390-384E-93A0-F3265B686A2B}"/>
          </ac:spMkLst>
        </pc:spChg>
        <pc:spChg chg="add mod">
          <ac:chgData name="Grace" userId="fd145552-a10d-4a31-a438-f8736fd84277" providerId="ADAL" clId="{56835480-2BB5-4545-A32E-6CA68AA69734}" dt="2021-09-01T22:43:31.696" v="986"/>
          <ac:spMkLst>
            <pc:docMk/>
            <pc:sldMk cId="907971304" sldId="577"/>
            <ac:spMk id="17" creationId="{131A941F-9678-8040-AB77-60477D433B5F}"/>
          </ac:spMkLst>
        </pc:spChg>
        <pc:spChg chg="add mod">
          <ac:chgData name="Grace" userId="fd145552-a10d-4a31-a438-f8736fd84277" providerId="ADAL" clId="{56835480-2BB5-4545-A32E-6CA68AA69734}" dt="2021-09-01T22:43:31.696" v="986"/>
          <ac:spMkLst>
            <pc:docMk/>
            <pc:sldMk cId="907971304" sldId="577"/>
            <ac:spMk id="20" creationId="{F9FE1841-152B-0945-BE3A-A44AB859C478}"/>
          </ac:spMkLst>
        </pc:spChg>
        <pc:spChg chg="add mod">
          <ac:chgData name="Grace" userId="fd145552-a10d-4a31-a438-f8736fd84277" providerId="ADAL" clId="{56835480-2BB5-4545-A32E-6CA68AA69734}" dt="2021-09-01T22:43:31.696" v="986"/>
          <ac:spMkLst>
            <pc:docMk/>
            <pc:sldMk cId="907971304" sldId="577"/>
            <ac:spMk id="21" creationId="{586D0358-CD34-D249-9640-8D4BAE0D8E13}"/>
          </ac:spMkLst>
        </pc:spChg>
        <pc:spChg chg="add mod">
          <ac:chgData name="Grace" userId="fd145552-a10d-4a31-a438-f8736fd84277" providerId="ADAL" clId="{56835480-2BB5-4545-A32E-6CA68AA69734}" dt="2021-09-01T22:43:31.696" v="986"/>
          <ac:spMkLst>
            <pc:docMk/>
            <pc:sldMk cId="907971304" sldId="577"/>
            <ac:spMk id="22" creationId="{CEC53E14-C966-904A-8681-BF5653853D5E}"/>
          </ac:spMkLst>
        </pc:spChg>
        <pc:spChg chg="add mod">
          <ac:chgData name="Grace" userId="fd145552-a10d-4a31-a438-f8736fd84277" providerId="ADAL" clId="{56835480-2BB5-4545-A32E-6CA68AA69734}" dt="2021-09-01T22:43:31.696" v="986"/>
          <ac:spMkLst>
            <pc:docMk/>
            <pc:sldMk cId="907971304" sldId="577"/>
            <ac:spMk id="23" creationId="{8B1A09AF-2C7B-9049-8700-80EEE985A09B}"/>
          </ac:spMkLst>
        </pc:spChg>
        <pc:spChg chg="add mod">
          <ac:chgData name="Grace" userId="fd145552-a10d-4a31-a438-f8736fd84277" providerId="ADAL" clId="{56835480-2BB5-4545-A32E-6CA68AA69734}" dt="2021-09-01T22:43:31.696" v="986"/>
          <ac:spMkLst>
            <pc:docMk/>
            <pc:sldMk cId="907971304" sldId="577"/>
            <ac:spMk id="24" creationId="{61692538-76A4-0C45-AD20-BC20513168A6}"/>
          </ac:spMkLst>
        </pc:spChg>
        <pc:spChg chg="add mod">
          <ac:chgData name="Grace" userId="fd145552-a10d-4a31-a438-f8736fd84277" providerId="ADAL" clId="{56835480-2BB5-4545-A32E-6CA68AA69734}" dt="2021-09-01T22:43:31.696" v="986"/>
          <ac:spMkLst>
            <pc:docMk/>
            <pc:sldMk cId="907971304" sldId="577"/>
            <ac:spMk id="25" creationId="{E401E637-DD57-BC4F-9B78-1E912A948463}"/>
          </ac:spMkLst>
        </pc:spChg>
        <pc:spChg chg="add mod">
          <ac:chgData name="Grace" userId="fd145552-a10d-4a31-a438-f8736fd84277" providerId="ADAL" clId="{56835480-2BB5-4545-A32E-6CA68AA69734}" dt="2021-09-01T22:43:31.696" v="986"/>
          <ac:spMkLst>
            <pc:docMk/>
            <pc:sldMk cId="907971304" sldId="577"/>
            <ac:spMk id="27" creationId="{C2E8756C-831B-3C4D-B20C-0AF2171DA544}"/>
          </ac:spMkLst>
        </pc:spChg>
        <pc:spChg chg="add mod">
          <ac:chgData name="Grace" userId="fd145552-a10d-4a31-a438-f8736fd84277" providerId="ADAL" clId="{56835480-2BB5-4545-A32E-6CA68AA69734}" dt="2021-09-01T22:43:31.696" v="986"/>
          <ac:spMkLst>
            <pc:docMk/>
            <pc:sldMk cId="907971304" sldId="577"/>
            <ac:spMk id="28" creationId="{13F1BDD0-A71E-D54A-94E7-AB4849587FF9}"/>
          </ac:spMkLst>
        </pc:spChg>
        <pc:graphicFrameChg chg="add mod">
          <ac:chgData name="Grace" userId="fd145552-a10d-4a31-a438-f8736fd84277" providerId="ADAL" clId="{56835480-2BB5-4545-A32E-6CA68AA69734}" dt="2021-09-01T22:43:31.696" v="986"/>
          <ac:graphicFrameMkLst>
            <pc:docMk/>
            <pc:sldMk cId="907971304" sldId="577"/>
            <ac:graphicFrameMk id="18" creationId="{52FE741A-DBEC-4E45-A216-F00F2125BE90}"/>
          </ac:graphicFrameMkLst>
        </pc:graphicFrameChg>
        <pc:graphicFrameChg chg="add mod">
          <ac:chgData name="Grace" userId="fd145552-a10d-4a31-a438-f8736fd84277" providerId="ADAL" clId="{56835480-2BB5-4545-A32E-6CA68AA69734}" dt="2021-09-01T22:43:31.696" v="986"/>
          <ac:graphicFrameMkLst>
            <pc:docMk/>
            <pc:sldMk cId="907971304" sldId="577"/>
            <ac:graphicFrameMk id="19" creationId="{68AA83EE-2B9C-5249-9F15-FCC7A54F3FD0}"/>
          </ac:graphicFrameMkLst>
        </pc:graphicFrameChg>
        <pc:graphicFrameChg chg="add mod">
          <ac:chgData name="Grace" userId="fd145552-a10d-4a31-a438-f8736fd84277" providerId="ADAL" clId="{56835480-2BB5-4545-A32E-6CA68AA69734}" dt="2021-09-01T22:43:31.696" v="986"/>
          <ac:graphicFrameMkLst>
            <pc:docMk/>
            <pc:sldMk cId="907971304" sldId="577"/>
            <ac:graphicFrameMk id="26" creationId="{86CA88D4-A4F9-E44A-AF28-9A2E644574F8}"/>
          </ac:graphicFrameMkLst>
        </pc:graphicFrameChg>
      </pc:sldChg>
      <pc:sldChg chg="new del">
        <pc:chgData name="Grace" userId="fd145552-a10d-4a31-a438-f8736fd84277" providerId="ADAL" clId="{56835480-2BB5-4545-A32E-6CA68AA69734}" dt="2021-09-01T07:12:38.709" v="321" actId="680"/>
        <pc:sldMkLst>
          <pc:docMk/>
          <pc:sldMk cId="2242308639" sldId="577"/>
        </pc:sldMkLst>
      </pc:sldChg>
      <pc:sldChg chg="addSp delSp modSp add mod">
        <pc:chgData name="Grace" userId="fd145552-a10d-4a31-a438-f8736fd84277" providerId="ADAL" clId="{56835480-2BB5-4545-A32E-6CA68AA69734}" dt="2021-09-01T23:20:11.335" v="2552" actId="478"/>
        <pc:sldMkLst>
          <pc:docMk/>
          <pc:sldMk cId="187938002" sldId="3307"/>
        </pc:sldMkLst>
        <pc:spChg chg="del mod">
          <ac:chgData name="Grace" userId="fd145552-a10d-4a31-a438-f8736fd84277" providerId="ADAL" clId="{56835480-2BB5-4545-A32E-6CA68AA69734}" dt="2021-09-01T23:20:04.536" v="2543" actId="478"/>
          <ac:spMkLst>
            <pc:docMk/>
            <pc:sldMk cId="187938002" sldId="3307"/>
            <ac:spMk id="2" creationId="{E262FF1D-F7EE-174E-8F1F-8970480BF702}"/>
          </ac:spMkLst>
        </pc:spChg>
        <pc:spChg chg="mod">
          <ac:chgData name="Grace" userId="fd145552-a10d-4a31-a438-f8736fd84277" providerId="ADAL" clId="{56835480-2BB5-4545-A32E-6CA68AA69734}" dt="2021-09-01T22:44:29.025" v="1051" actId="1076"/>
          <ac:spMkLst>
            <pc:docMk/>
            <pc:sldMk cId="187938002" sldId="3307"/>
            <ac:spMk id="3" creationId="{3F736E9F-099F-6E49-8413-5352C763CACD}"/>
          </ac:spMkLst>
        </pc:spChg>
        <pc:spChg chg="del mod">
          <ac:chgData name="Grace" userId="fd145552-a10d-4a31-a438-f8736fd84277" providerId="ADAL" clId="{56835480-2BB5-4545-A32E-6CA68AA69734}" dt="2021-09-01T22:44:37.479" v="1055" actId="478"/>
          <ac:spMkLst>
            <pc:docMk/>
            <pc:sldMk cId="187938002" sldId="3307"/>
            <ac:spMk id="4" creationId="{E333F3FF-B79E-BE40-B783-ADB5618202DD}"/>
          </ac:spMkLst>
        </pc:spChg>
        <pc:spChg chg="del mod">
          <ac:chgData name="Grace" userId="fd145552-a10d-4a31-a438-f8736fd84277" providerId="ADAL" clId="{56835480-2BB5-4545-A32E-6CA68AA69734}" dt="2021-09-01T23:20:09.970" v="2551" actId="478"/>
          <ac:spMkLst>
            <pc:docMk/>
            <pc:sldMk cId="187938002" sldId="3307"/>
            <ac:spMk id="5" creationId="{1B9EF0F6-9A52-D149-AA60-164F75A37422}"/>
          </ac:spMkLst>
        </pc:spChg>
        <pc:spChg chg="del mod">
          <ac:chgData name="Grace" userId="fd145552-a10d-4a31-a438-f8736fd84277" providerId="ADAL" clId="{56835480-2BB5-4545-A32E-6CA68AA69734}" dt="2021-09-01T23:20:08.612" v="2549" actId="478"/>
          <ac:spMkLst>
            <pc:docMk/>
            <pc:sldMk cId="187938002" sldId="3307"/>
            <ac:spMk id="6" creationId="{1D62573D-EDBB-E84E-9782-09E0B2F508C0}"/>
          </ac:spMkLst>
        </pc:spChg>
        <pc:spChg chg="del mod">
          <ac:chgData name="Grace" userId="fd145552-a10d-4a31-a438-f8736fd84277" providerId="ADAL" clId="{56835480-2BB5-4545-A32E-6CA68AA69734}" dt="2021-09-01T23:20:08.010" v="2548" actId="478"/>
          <ac:spMkLst>
            <pc:docMk/>
            <pc:sldMk cId="187938002" sldId="3307"/>
            <ac:spMk id="7" creationId="{59CF35BA-084D-4949-A2A0-2E6687ECA264}"/>
          </ac:spMkLst>
        </pc:spChg>
        <pc:spChg chg="del mod">
          <ac:chgData name="Grace" userId="fd145552-a10d-4a31-a438-f8736fd84277" providerId="ADAL" clId="{56835480-2BB5-4545-A32E-6CA68AA69734}" dt="2021-09-01T23:20:07.227" v="2547" actId="478"/>
          <ac:spMkLst>
            <pc:docMk/>
            <pc:sldMk cId="187938002" sldId="3307"/>
            <ac:spMk id="8" creationId="{FE8DFC47-E1E0-7D4E-BB1E-FFB84E9F9DDF}"/>
          </ac:spMkLst>
        </pc:spChg>
        <pc:spChg chg="del mod">
          <ac:chgData name="Grace" userId="fd145552-a10d-4a31-a438-f8736fd84277" providerId="ADAL" clId="{56835480-2BB5-4545-A32E-6CA68AA69734}" dt="2021-09-01T23:20:05.304" v="2544" actId="478"/>
          <ac:spMkLst>
            <pc:docMk/>
            <pc:sldMk cId="187938002" sldId="3307"/>
            <ac:spMk id="9" creationId="{8222752D-BB13-8942-87E1-7A07B28965FC}"/>
          </ac:spMkLst>
        </pc:spChg>
        <pc:spChg chg="del mod">
          <ac:chgData name="Grace" userId="fd145552-a10d-4a31-a438-f8736fd84277" providerId="ADAL" clId="{56835480-2BB5-4545-A32E-6CA68AA69734}" dt="2021-09-01T23:20:06.759" v="2546" actId="478"/>
          <ac:spMkLst>
            <pc:docMk/>
            <pc:sldMk cId="187938002" sldId="3307"/>
            <ac:spMk id="10" creationId="{9E5D03F1-A122-E44B-AD4B-39BC92875066}"/>
          </ac:spMkLst>
        </pc:spChg>
        <pc:spChg chg="mod">
          <ac:chgData name="Grace" userId="fd145552-a10d-4a31-a438-f8736fd84277" providerId="ADAL" clId="{56835480-2BB5-4545-A32E-6CA68AA69734}" dt="2021-09-01T22:52:53.409" v="1127" actId="1076"/>
          <ac:spMkLst>
            <pc:docMk/>
            <pc:sldMk cId="187938002" sldId="3307"/>
            <ac:spMk id="11" creationId="{53924CEB-4D7D-F241-8D0D-F765FB62291C}"/>
          </ac:spMkLst>
        </pc:spChg>
        <pc:spChg chg="mod">
          <ac:chgData name="Grace" userId="fd145552-a10d-4a31-a438-f8736fd84277" providerId="ADAL" clId="{56835480-2BB5-4545-A32E-6CA68AA69734}" dt="2021-09-01T22:52:53.409" v="1127" actId="1076"/>
          <ac:spMkLst>
            <pc:docMk/>
            <pc:sldMk cId="187938002" sldId="3307"/>
            <ac:spMk id="12" creationId="{9F619023-99B5-D048-963C-2919297AAD8E}"/>
          </ac:spMkLst>
        </pc:spChg>
        <pc:spChg chg="del mod">
          <ac:chgData name="Grace" userId="fd145552-a10d-4a31-a438-f8736fd84277" providerId="ADAL" clId="{56835480-2BB5-4545-A32E-6CA68AA69734}" dt="2021-09-01T23:20:06.426" v="2545" actId="478"/>
          <ac:spMkLst>
            <pc:docMk/>
            <pc:sldMk cId="187938002" sldId="3307"/>
            <ac:spMk id="13" creationId="{7F2E6090-CD6F-E849-9E28-E64715761747}"/>
          </ac:spMkLst>
        </pc:spChg>
        <pc:spChg chg="mod">
          <ac:chgData name="Grace" userId="fd145552-a10d-4a31-a438-f8736fd84277" providerId="ADAL" clId="{56835480-2BB5-4545-A32E-6CA68AA69734}" dt="2021-09-01T22:52:53.409" v="1127" actId="1076"/>
          <ac:spMkLst>
            <pc:docMk/>
            <pc:sldMk cId="187938002" sldId="3307"/>
            <ac:spMk id="14" creationId="{EE644C53-6D18-3B45-8ACC-5347164E1A9E}"/>
          </ac:spMkLst>
        </pc:spChg>
        <pc:spChg chg="del mod">
          <ac:chgData name="Grace" userId="fd145552-a10d-4a31-a438-f8736fd84277" providerId="ADAL" clId="{56835480-2BB5-4545-A32E-6CA68AA69734}" dt="2021-09-01T23:20:11.335" v="2552" actId="478"/>
          <ac:spMkLst>
            <pc:docMk/>
            <pc:sldMk cId="187938002" sldId="3307"/>
            <ac:spMk id="15" creationId="{2A06BBD3-F9C8-734D-8310-8E4C9DE456CA}"/>
          </ac:spMkLst>
        </pc:spChg>
        <pc:spChg chg="del mod">
          <ac:chgData name="Grace" userId="fd145552-a10d-4a31-a438-f8736fd84277" providerId="ADAL" clId="{56835480-2BB5-4545-A32E-6CA68AA69734}" dt="2021-09-01T23:20:11.335" v="2552" actId="478"/>
          <ac:spMkLst>
            <pc:docMk/>
            <pc:sldMk cId="187938002" sldId="3307"/>
            <ac:spMk id="16" creationId="{5305061A-C390-384E-93A0-F3265B686A2B}"/>
          </ac:spMkLst>
        </pc:spChg>
        <pc:spChg chg="del mod">
          <ac:chgData name="Grace" userId="fd145552-a10d-4a31-a438-f8736fd84277" providerId="ADAL" clId="{56835480-2BB5-4545-A32E-6CA68AA69734}" dt="2021-09-01T23:20:11.335" v="2552" actId="478"/>
          <ac:spMkLst>
            <pc:docMk/>
            <pc:sldMk cId="187938002" sldId="3307"/>
            <ac:spMk id="17" creationId="{131A941F-9678-8040-AB77-60477D433B5F}"/>
          </ac:spMkLst>
        </pc:spChg>
        <pc:spChg chg="del mod">
          <ac:chgData name="Grace" userId="fd145552-a10d-4a31-a438-f8736fd84277" providerId="ADAL" clId="{56835480-2BB5-4545-A32E-6CA68AA69734}" dt="2021-09-01T23:20:11.335" v="2552" actId="478"/>
          <ac:spMkLst>
            <pc:docMk/>
            <pc:sldMk cId="187938002" sldId="3307"/>
            <ac:spMk id="20" creationId="{F9FE1841-152B-0945-BE3A-A44AB859C478}"/>
          </ac:spMkLst>
        </pc:spChg>
        <pc:spChg chg="del mod">
          <ac:chgData name="Grace" userId="fd145552-a10d-4a31-a438-f8736fd84277" providerId="ADAL" clId="{56835480-2BB5-4545-A32E-6CA68AA69734}" dt="2021-09-01T23:20:11.335" v="2552" actId="478"/>
          <ac:spMkLst>
            <pc:docMk/>
            <pc:sldMk cId="187938002" sldId="3307"/>
            <ac:spMk id="21" creationId="{586D0358-CD34-D249-9640-8D4BAE0D8E13}"/>
          </ac:spMkLst>
        </pc:spChg>
        <pc:spChg chg="del mod">
          <ac:chgData name="Grace" userId="fd145552-a10d-4a31-a438-f8736fd84277" providerId="ADAL" clId="{56835480-2BB5-4545-A32E-6CA68AA69734}" dt="2021-09-01T23:20:11.335" v="2552" actId="478"/>
          <ac:spMkLst>
            <pc:docMk/>
            <pc:sldMk cId="187938002" sldId="3307"/>
            <ac:spMk id="22" creationId="{CEC53E14-C966-904A-8681-BF5653853D5E}"/>
          </ac:spMkLst>
        </pc:spChg>
        <pc:spChg chg="del mod">
          <ac:chgData name="Grace" userId="fd145552-a10d-4a31-a438-f8736fd84277" providerId="ADAL" clId="{56835480-2BB5-4545-A32E-6CA68AA69734}" dt="2021-09-01T23:20:11.335" v="2552" actId="478"/>
          <ac:spMkLst>
            <pc:docMk/>
            <pc:sldMk cId="187938002" sldId="3307"/>
            <ac:spMk id="23" creationId="{8B1A09AF-2C7B-9049-8700-80EEE985A09B}"/>
          </ac:spMkLst>
        </pc:spChg>
        <pc:spChg chg="del mod">
          <ac:chgData name="Grace" userId="fd145552-a10d-4a31-a438-f8736fd84277" providerId="ADAL" clId="{56835480-2BB5-4545-A32E-6CA68AA69734}" dt="2021-09-01T23:20:11.335" v="2552" actId="478"/>
          <ac:spMkLst>
            <pc:docMk/>
            <pc:sldMk cId="187938002" sldId="3307"/>
            <ac:spMk id="24" creationId="{61692538-76A4-0C45-AD20-BC20513168A6}"/>
          </ac:spMkLst>
        </pc:spChg>
        <pc:spChg chg="del mod">
          <ac:chgData name="Grace" userId="fd145552-a10d-4a31-a438-f8736fd84277" providerId="ADAL" clId="{56835480-2BB5-4545-A32E-6CA68AA69734}" dt="2021-09-01T23:20:11.335" v="2552" actId="478"/>
          <ac:spMkLst>
            <pc:docMk/>
            <pc:sldMk cId="187938002" sldId="3307"/>
            <ac:spMk id="25" creationId="{E401E637-DD57-BC4F-9B78-1E912A948463}"/>
          </ac:spMkLst>
        </pc:spChg>
        <pc:spChg chg="del mod">
          <ac:chgData name="Grace" userId="fd145552-a10d-4a31-a438-f8736fd84277" providerId="ADAL" clId="{56835480-2BB5-4545-A32E-6CA68AA69734}" dt="2021-09-01T23:20:11.335" v="2552" actId="478"/>
          <ac:spMkLst>
            <pc:docMk/>
            <pc:sldMk cId="187938002" sldId="3307"/>
            <ac:spMk id="27" creationId="{C2E8756C-831B-3C4D-B20C-0AF2171DA544}"/>
          </ac:spMkLst>
        </pc:spChg>
        <pc:spChg chg="del mod">
          <ac:chgData name="Grace" userId="fd145552-a10d-4a31-a438-f8736fd84277" providerId="ADAL" clId="{56835480-2BB5-4545-A32E-6CA68AA69734}" dt="2021-09-01T23:20:11.335" v="2552" actId="478"/>
          <ac:spMkLst>
            <pc:docMk/>
            <pc:sldMk cId="187938002" sldId="3307"/>
            <ac:spMk id="28" creationId="{13F1BDD0-A71E-D54A-94E7-AB4849587FF9}"/>
          </ac:spMkLst>
        </pc:spChg>
        <pc:spChg chg="add del mod">
          <ac:chgData name="Grace" userId="fd145552-a10d-4a31-a438-f8736fd84277" providerId="ADAL" clId="{56835480-2BB5-4545-A32E-6CA68AA69734}" dt="2021-09-01T22:44:30.213" v="1052" actId="478"/>
          <ac:spMkLst>
            <pc:docMk/>
            <pc:sldMk cId="187938002" sldId="3307"/>
            <ac:spMk id="29" creationId="{4FAB67C3-64F2-4C50-858A-7B7CE07C2147}"/>
          </ac:spMkLst>
        </pc:spChg>
        <pc:spChg chg="add del mod">
          <ac:chgData name="Grace" userId="fd145552-a10d-4a31-a438-f8736fd84277" providerId="ADAL" clId="{56835480-2BB5-4545-A32E-6CA68AA69734}" dt="2021-09-01T22:44:50.815" v="1057"/>
          <ac:spMkLst>
            <pc:docMk/>
            <pc:sldMk cId="187938002" sldId="3307"/>
            <ac:spMk id="30" creationId="{7BCF7A60-9BEB-4DE5-AFD0-058C5C4922E7}"/>
          </ac:spMkLst>
        </pc:spChg>
        <pc:spChg chg="add del mod">
          <ac:chgData name="Grace" userId="fd145552-a10d-4a31-a438-f8736fd84277" providerId="ADAL" clId="{56835480-2BB5-4545-A32E-6CA68AA69734}" dt="2021-09-01T22:44:50.815" v="1057"/>
          <ac:spMkLst>
            <pc:docMk/>
            <pc:sldMk cId="187938002" sldId="3307"/>
            <ac:spMk id="31" creationId="{A29729C2-A543-4F1C-8B13-C1261C1DE057}"/>
          </ac:spMkLst>
        </pc:spChg>
        <pc:spChg chg="add del mod">
          <ac:chgData name="Grace" userId="fd145552-a10d-4a31-a438-f8736fd84277" providerId="ADAL" clId="{56835480-2BB5-4545-A32E-6CA68AA69734}" dt="2021-09-01T22:44:50.815" v="1057"/>
          <ac:spMkLst>
            <pc:docMk/>
            <pc:sldMk cId="187938002" sldId="3307"/>
            <ac:spMk id="32" creationId="{86430EBC-EE1D-4CFB-A35D-0E3D1DAD4E30}"/>
          </ac:spMkLst>
        </pc:spChg>
        <pc:spChg chg="add del mod">
          <ac:chgData name="Grace" userId="fd145552-a10d-4a31-a438-f8736fd84277" providerId="ADAL" clId="{56835480-2BB5-4545-A32E-6CA68AA69734}" dt="2021-09-01T22:44:50.815" v="1057"/>
          <ac:spMkLst>
            <pc:docMk/>
            <pc:sldMk cId="187938002" sldId="3307"/>
            <ac:spMk id="33" creationId="{9F973B9E-12FB-4288-9614-4ED4AD4A29EC}"/>
          </ac:spMkLst>
        </pc:spChg>
        <pc:spChg chg="add del mod">
          <ac:chgData name="Grace" userId="fd145552-a10d-4a31-a438-f8736fd84277" providerId="ADAL" clId="{56835480-2BB5-4545-A32E-6CA68AA69734}" dt="2021-09-01T22:44:50.815" v="1057"/>
          <ac:spMkLst>
            <pc:docMk/>
            <pc:sldMk cId="187938002" sldId="3307"/>
            <ac:spMk id="34" creationId="{0BB22522-1963-4946-9FE4-A6CA284658AA}"/>
          </ac:spMkLst>
        </pc:spChg>
        <pc:spChg chg="add del mod">
          <ac:chgData name="Grace" userId="fd145552-a10d-4a31-a438-f8736fd84277" providerId="ADAL" clId="{56835480-2BB5-4545-A32E-6CA68AA69734}" dt="2021-09-01T22:44:50.815" v="1057"/>
          <ac:spMkLst>
            <pc:docMk/>
            <pc:sldMk cId="187938002" sldId="3307"/>
            <ac:spMk id="35" creationId="{6E241D77-7AF6-44B0-A340-4718A1D85EE4}"/>
          </ac:spMkLst>
        </pc:spChg>
        <pc:spChg chg="add del mod">
          <ac:chgData name="Grace" userId="fd145552-a10d-4a31-a438-f8736fd84277" providerId="ADAL" clId="{56835480-2BB5-4545-A32E-6CA68AA69734}" dt="2021-09-01T22:44:50.815" v="1057"/>
          <ac:spMkLst>
            <pc:docMk/>
            <pc:sldMk cId="187938002" sldId="3307"/>
            <ac:spMk id="36" creationId="{82052070-885E-400E-959F-0EF05DE6ACF2}"/>
          </ac:spMkLst>
        </pc:spChg>
        <pc:spChg chg="add del mod">
          <ac:chgData name="Grace" userId="fd145552-a10d-4a31-a438-f8736fd84277" providerId="ADAL" clId="{56835480-2BB5-4545-A32E-6CA68AA69734}" dt="2021-09-01T22:44:50.815" v="1057"/>
          <ac:spMkLst>
            <pc:docMk/>
            <pc:sldMk cId="187938002" sldId="3307"/>
            <ac:spMk id="37" creationId="{3BD7F4F8-85AD-438A-AD7E-2410DD1260BB}"/>
          </ac:spMkLst>
        </pc:spChg>
        <pc:spChg chg="add del mod">
          <ac:chgData name="Grace" userId="fd145552-a10d-4a31-a438-f8736fd84277" providerId="ADAL" clId="{56835480-2BB5-4545-A32E-6CA68AA69734}" dt="2021-09-01T22:44:50.815" v="1057"/>
          <ac:spMkLst>
            <pc:docMk/>
            <pc:sldMk cId="187938002" sldId="3307"/>
            <ac:spMk id="38" creationId="{35FA1D9A-2D9C-4E2F-9484-7B5CD4F482C8}"/>
          </ac:spMkLst>
        </pc:spChg>
        <pc:spChg chg="add del mod">
          <ac:chgData name="Grace" userId="fd145552-a10d-4a31-a438-f8736fd84277" providerId="ADAL" clId="{56835480-2BB5-4545-A32E-6CA68AA69734}" dt="2021-09-01T22:44:50.815" v="1057"/>
          <ac:spMkLst>
            <pc:docMk/>
            <pc:sldMk cId="187938002" sldId="3307"/>
            <ac:spMk id="39" creationId="{AF8D0018-43DF-40E7-8DB5-956C5F28F795}"/>
          </ac:spMkLst>
        </pc:spChg>
        <pc:spChg chg="add del mod">
          <ac:chgData name="Grace" userId="fd145552-a10d-4a31-a438-f8736fd84277" providerId="ADAL" clId="{56835480-2BB5-4545-A32E-6CA68AA69734}" dt="2021-09-01T22:44:50.815" v="1057"/>
          <ac:spMkLst>
            <pc:docMk/>
            <pc:sldMk cId="187938002" sldId="3307"/>
            <ac:spMk id="40" creationId="{FE4E02EE-BED6-40CB-9F41-02ED640D7013}"/>
          </ac:spMkLst>
        </pc:spChg>
        <pc:spChg chg="add del mod">
          <ac:chgData name="Grace" userId="fd145552-a10d-4a31-a438-f8736fd84277" providerId="ADAL" clId="{56835480-2BB5-4545-A32E-6CA68AA69734}" dt="2021-09-01T22:44:50.815" v="1057"/>
          <ac:spMkLst>
            <pc:docMk/>
            <pc:sldMk cId="187938002" sldId="3307"/>
            <ac:spMk id="41" creationId="{D069D868-A69B-4BE0-84E1-DFE05520A95F}"/>
          </ac:spMkLst>
        </pc:spChg>
        <pc:spChg chg="add del mod">
          <ac:chgData name="Grace" userId="fd145552-a10d-4a31-a438-f8736fd84277" providerId="ADAL" clId="{56835480-2BB5-4545-A32E-6CA68AA69734}" dt="2021-09-01T22:44:50.815" v="1057"/>
          <ac:spMkLst>
            <pc:docMk/>
            <pc:sldMk cId="187938002" sldId="3307"/>
            <ac:spMk id="42" creationId="{F2482259-A4E2-4F79-AA69-FB780507E0C9}"/>
          </ac:spMkLst>
        </pc:spChg>
        <pc:spChg chg="add del mod">
          <ac:chgData name="Grace" userId="fd145552-a10d-4a31-a438-f8736fd84277" providerId="ADAL" clId="{56835480-2BB5-4545-A32E-6CA68AA69734}" dt="2021-09-01T22:44:50.815" v="1057"/>
          <ac:spMkLst>
            <pc:docMk/>
            <pc:sldMk cId="187938002" sldId="3307"/>
            <ac:spMk id="43" creationId="{14162C2A-3D28-4C18-B27E-E618D1E6A380}"/>
          </ac:spMkLst>
        </pc:spChg>
        <pc:spChg chg="add del mod">
          <ac:chgData name="Grace" userId="fd145552-a10d-4a31-a438-f8736fd84277" providerId="ADAL" clId="{56835480-2BB5-4545-A32E-6CA68AA69734}" dt="2021-09-01T22:44:50.815" v="1057"/>
          <ac:spMkLst>
            <pc:docMk/>
            <pc:sldMk cId="187938002" sldId="3307"/>
            <ac:spMk id="44" creationId="{41217D16-5594-44BA-B4CD-8D8AFCF216F6}"/>
          </ac:spMkLst>
        </pc:spChg>
        <pc:spChg chg="add del mod">
          <ac:chgData name="Grace" userId="fd145552-a10d-4a31-a438-f8736fd84277" providerId="ADAL" clId="{56835480-2BB5-4545-A32E-6CA68AA69734}" dt="2021-09-01T22:52:36.588" v="1124" actId="207"/>
          <ac:spMkLst>
            <pc:docMk/>
            <pc:sldMk cId="187938002" sldId="3307"/>
            <ac:spMk id="45" creationId="{D5C3ED16-AD74-42CC-ABF5-155637BC7D6C}"/>
          </ac:spMkLst>
        </pc:spChg>
        <pc:spChg chg="add del mod">
          <ac:chgData name="Grace" userId="fd145552-a10d-4a31-a438-f8736fd84277" providerId="ADAL" clId="{56835480-2BB5-4545-A32E-6CA68AA69734}" dt="2021-09-01T22:52:20.022" v="1117" actId="478"/>
          <ac:spMkLst>
            <pc:docMk/>
            <pc:sldMk cId="187938002" sldId="3307"/>
            <ac:spMk id="46" creationId="{DF0CCE48-FD3C-4130-B6EB-AE34D6359DCD}"/>
          </ac:spMkLst>
        </pc:spChg>
        <pc:spChg chg="add del mod">
          <ac:chgData name="Grace" userId="fd145552-a10d-4a31-a438-f8736fd84277" providerId="ADAL" clId="{56835480-2BB5-4545-A32E-6CA68AA69734}" dt="2021-09-01T22:52:20.022" v="1117" actId="478"/>
          <ac:spMkLst>
            <pc:docMk/>
            <pc:sldMk cId="187938002" sldId="3307"/>
            <ac:spMk id="47" creationId="{3BAF3F55-EDA5-46D3-90CF-61EE4BC25BE1}"/>
          </ac:spMkLst>
        </pc:spChg>
        <pc:spChg chg="add mod">
          <ac:chgData name="Grace" userId="fd145552-a10d-4a31-a438-f8736fd84277" providerId="ADAL" clId="{56835480-2BB5-4545-A32E-6CA68AA69734}" dt="2021-09-01T22:46:13.549" v="1086" actId="2711"/>
          <ac:spMkLst>
            <pc:docMk/>
            <pc:sldMk cId="187938002" sldId="3307"/>
            <ac:spMk id="48" creationId="{CE1789F8-D90A-417B-B724-1C8CC2CAB633}"/>
          </ac:spMkLst>
        </pc:spChg>
        <pc:spChg chg="add del mod">
          <ac:chgData name="Grace" userId="fd145552-a10d-4a31-a438-f8736fd84277" providerId="ADAL" clId="{56835480-2BB5-4545-A32E-6CA68AA69734}" dt="2021-09-01T22:52:21.325" v="1118" actId="478"/>
          <ac:spMkLst>
            <pc:docMk/>
            <pc:sldMk cId="187938002" sldId="3307"/>
            <ac:spMk id="49" creationId="{8B498598-C0C8-49EB-8EF4-F469F6D79058}"/>
          </ac:spMkLst>
        </pc:spChg>
        <pc:spChg chg="add del mod">
          <ac:chgData name="Grace" userId="fd145552-a10d-4a31-a438-f8736fd84277" providerId="ADAL" clId="{56835480-2BB5-4545-A32E-6CA68AA69734}" dt="2021-09-01T22:52:20.022" v="1117" actId="478"/>
          <ac:spMkLst>
            <pc:docMk/>
            <pc:sldMk cId="187938002" sldId="3307"/>
            <ac:spMk id="50" creationId="{7655EB23-8530-47E0-9C9C-3B9B275A9741}"/>
          </ac:spMkLst>
        </pc:spChg>
        <pc:spChg chg="add del mod">
          <ac:chgData name="Grace" userId="fd145552-a10d-4a31-a438-f8736fd84277" providerId="ADAL" clId="{56835480-2BB5-4545-A32E-6CA68AA69734}" dt="2021-09-01T22:46:17.373" v="1087" actId="478"/>
          <ac:spMkLst>
            <pc:docMk/>
            <pc:sldMk cId="187938002" sldId="3307"/>
            <ac:spMk id="51" creationId="{87A6EB1B-3D09-4D5E-BFFB-03BDED0BD866}"/>
          </ac:spMkLst>
        </pc:spChg>
        <pc:spChg chg="add mod">
          <ac:chgData name="Grace" userId="fd145552-a10d-4a31-a438-f8736fd84277" providerId="ADAL" clId="{56835480-2BB5-4545-A32E-6CA68AA69734}" dt="2021-09-01T22:53:26.818" v="1137" actId="2711"/>
          <ac:spMkLst>
            <pc:docMk/>
            <pc:sldMk cId="187938002" sldId="3307"/>
            <ac:spMk id="52" creationId="{D3911288-5557-40BC-9242-7FB0F239B2D3}"/>
          </ac:spMkLst>
        </pc:spChg>
        <pc:spChg chg="add mod">
          <ac:chgData name="Grace" userId="fd145552-a10d-4a31-a438-f8736fd84277" providerId="ADAL" clId="{56835480-2BB5-4545-A32E-6CA68AA69734}" dt="2021-09-01T22:53:26.818" v="1137" actId="2711"/>
          <ac:spMkLst>
            <pc:docMk/>
            <pc:sldMk cId="187938002" sldId="3307"/>
            <ac:spMk id="53" creationId="{E2049701-CA4D-4E98-BAB8-A7EFF1DDA945}"/>
          </ac:spMkLst>
        </pc:spChg>
        <pc:spChg chg="add mod">
          <ac:chgData name="Grace" userId="fd145552-a10d-4a31-a438-f8736fd84277" providerId="ADAL" clId="{56835480-2BB5-4545-A32E-6CA68AA69734}" dt="2021-09-01T22:53:26.818" v="1137" actId="2711"/>
          <ac:spMkLst>
            <pc:docMk/>
            <pc:sldMk cId="187938002" sldId="3307"/>
            <ac:spMk id="54" creationId="{B2962D8F-D897-4E77-BEF6-A9EB62576127}"/>
          </ac:spMkLst>
        </pc:spChg>
        <pc:spChg chg="add del mod">
          <ac:chgData name="Grace" userId="fd145552-a10d-4a31-a438-f8736fd84277" providerId="ADAL" clId="{56835480-2BB5-4545-A32E-6CA68AA69734}" dt="2021-09-01T22:49:46.731" v="1112" actId="478"/>
          <ac:spMkLst>
            <pc:docMk/>
            <pc:sldMk cId="187938002" sldId="3307"/>
            <ac:spMk id="55" creationId="{A65A627D-0590-4984-9858-966152CDA826}"/>
          </ac:spMkLst>
        </pc:spChg>
        <pc:spChg chg="add del mod">
          <ac:chgData name="Grace" userId="fd145552-a10d-4a31-a438-f8736fd84277" providerId="ADAL" clId="{56835480-2BB5-4545-A32E-6CA68AA69734}" dt="2021-09-01T22:52:20.022" v="1117" actId="478"/>
          <ac:spMkLst>
            <pc:docMk/>
            <pc:sldMk cId="187938002" sldId="3307"/>
            <ac:spMk id="56" creationId="{8997042A-D10C-428F-BED9-8210B5F2F65A}"/>
          </ac:spMkLst>
        </pc:spChg>
        <pc:spChg chg="add mod">
          <ac:chgData name="Grace" userId="fd145552-a10d-4a31-a438-f8736fd84277" providerId="ADAL" clId="{56835480-2BB5-4545-A32E-6CA68AA69734}" dt="2021-09-01T22:49:39.761" v="1110" actId="1076"/>
          <ac:spMkLst>
            <pc:docMk/>
            <pc:sldMk cId="187938002" sldId="3307"/>
            <ac:spMk id="57" creationId="{FA2A4811-CACA-468B-8ADF-7842C0823E64}"/>
          </ac:spMkLst>
        </pc:spChg>
        <pc:spChg chg="add del mod">
          <ac:chgData name="Grace" userId="fd145552-a10d-4a31-a438-f8736fd84277" providerId="ADAL" clId="{56835480-2BB5-4545-A32E-6CA68AA69734}" dt="2021-09-01T22:52:20.022" v="1117" actId="478"/>
          <ac:spMkLst>
            <pc:docMk/>
            <pc:sldMk cId="187938002" sldId="3307"/>
            <ac:spMk id="58" creationId="{2FED89F3-E1BE-46BE-AD03-04E0294C361A}"/>
          </ac:spMkLst>
        </pc:spChg>
        <pc:spChg chg="add del mod">
          <ac:chgData name="Grace" userId="fd145552-a10d-4a31-a438-f8736fd84277" providerId="ADAL" clId="{56835480-2BB5-4545-A32E-6CA68AA69734}" dt="2021-09-01T22:52:20.022" v="1117" actId="478"/>
          <ac:spMkLst>
            <pc:docMk/>
            <pc:sldMk cId="187938002" sldId="3307"/>
            <ac:spMk id="59" creationId="{84C0B0FE-146D-4051-9A89-0761F0FA7B0D}"/>
          </ac:spMkLst>
        </pc:spChg>
        <pc:spChg chg="add del mod">
          <ac:chgData name="Grace" userId="fd145552-a10d-4a31-a438-f8736fd84277" providerId="ADAL" clId="{56835480-2BB5-4545-A32E-6CA68AA69734}" dt="2021-09-01T22:46:23.690" v="1091"/>
          <ac:spMkLst>
            <pc:docMk/>
            <pc:sldMk cId="187938002" sldId="3307"/>
            <ac:spMk id="60" creationId="{4FE8F783-F21D-47BD-A2D5-C49669B3E6A2}"/>
          </ac:spMkLst>
        </pc:spChg>
        <pc:spChg chg="add del mod">
          <ac:chgData name="Grace" userId="fd145552-a10d-4a31-a438-f8736fd84277" providerId="ADAL" clId="{56835480-2BB5-4545-A32E-6CA68AA69734}" dt="2021-09-01T22:46:23.690" v="1091"/>
          <ac:spMkLst>
            <pc:docMk/>
            <pc:sldMk cId="187938002" sldId="3307"/>
            <ac:spMk id="61" creationId="{FF66F0C7-4ED9-40DC-A1F3-791E23363BDB}"/>
          </ac:spMkLst>
        </pc:spChg>
        <pc:spChg chg="add del mod">
          <ac:chgData name="Grace" userId="fd145552-a10d-4a31-a438-f8736fd84277" providerId="ADAL" clId="{56835480-2BB5-4545-A32E-6CA68AA69734}" dt="2021-09-01T22:46:36.973" v="1097" actId="478"/>
          <ac:spMkLst>
            <pc:docMk/>
            <pc:sldMk cId="187938002" sldId="3307"/>
            <ac:spMk id="62" creationId="{CB00000B-9F34-4F2C-BABA-A5032A259E15}"/>
          </ac:spMkLst>
        </pc:spChg>
        <pc:spChg chg="add mod">
          <ac:chgData name="Grace" userId="fd145552-a10d-4a31-a438-f8736fd84277" providerId="ADAL" clId="{56835480-2BB5-4545-A32E-6CA68AA69734}" dt="2021-09-01T22:46:48.633" v="1099"/>
          <ac:spMkLst>
            <pc:docMk/>
            <pc:sldMk cId="187938002" sldId="3307"/>
            <ac:spMk id="63" creationId="{A6CF363A-5E67-471D-96A1-BB99C4BF1B28}"/>
          </ac:spMkLst>
        </pc:spChg>
        <pc:spChg chg="add mod">
          <ac:chgData name="Grace" userId="fd145552-a10d-4a31-a438-f8736fd84277" providerId="ADAL" clId="{56835480-2BB5-4545-A32E-6CA68AA69734}" dt="2021-09-01T23:01:31.793" v="1504" actId="14100"/>
          <ac:spMkLst>
            <pc:docMk/>
            <pc:sldMk cId="187938002" sldId="3307"/>
            <ac:spMk id="64" creationId="{BAC3AD93-4EBD-4BE0-8DE9-83249CB83F1C}"/>
          </ac:spMkLst>
        </pc:spChg>
        <pc:spChg chg="add del mod">
          <ac:chgData name="Grace" userId="fd145552-a10d-4a31-a438-f8736fd84277" providerId="ADAL" clId="{56835480-2BB5-4545-A32E-6CA68AA69734}" dt="2021-09-01T22:57:54.823" v="1229" actId="478"/>
          <ac:spMkLst>
            <pc:docMk/>
            <pc:sldMk cId="187938002" sldId="3307"/>
            <ac:spMk id="65" creationId="{B653ED4C-AD70-4933-8BBF-69EE7FBCF86F}"/>
          </ac:spMkLst>
        </pc:spChg>
        <pc:spChg chg="add del mod">
          <ac:chgData name="Grace" userId="fd145552-a10d-4a31-a438-f8736fd84277" providerId="ADAL" clId="{56835480-2BB5-4545-A32E-6CA68AA69734}" dt="2021-09-01T22:57:58.016" v="1230" actId="478"/>
          <ac:spMkLst>
            <pc:docMk/>
            <pc:sldMk cId="187938002" sldId="3307"/>
            <ac:spMk id="66" creationId="{98E8C3E8-821E-4B29-8C66-C1A5E93FE6FB}"/>
          </ac:spMkLst>
        </pc:spChg>
        <pc:spChg chg="add del mod">
          <ac:chgData name="Grace" userId="fd145552-a10d-4a31-a438-f8736fd84277" providerId="ADAL" clId="{56835480-2BB5-4545-A32E-6CA68AA69734}" dt="2021-09-01T22:58:01.692" v="1231" actId="478"/>
          <ac:spMkLst>
            <pc:docMk/>
            <pc:sldMk cId="187938002" sldId="3307"/>
            <ac:spMk id="67" creationId="{54FB55FD-9738-4D13-8C7B-3DAA8AE2CB1C}"/>
          </ac:spMkLst>
        </pc:spChg>
        <pc:spChg chg="add mod">
          <ac:chgData name="Grace" userId="fd145552-a10d-4a31-a438-f8736fd84277" providerId="ADAL" clId="{56835480-2BB5-4545-A32E-6CA68AA69734}" dt="2021-09-01T23:06:18.557" v="1750" actId="1036"/>
          <ac:spMkLst>
            <pc:docMk/>
            <pc:sldMk cId="187938002" sldId="3307"/>
            <ac:spMk id="68" creationId="{24FDD7D9-55CB-4156-8D71-084078C8F69F}"/>
          </ac:spMkLst>
        </pc:spChg>
        <pc:spChg chg="add del mod">
          <ac:chgData name="Grace" userId="fd145552-a10d-4a31-a438-f8736fd84277" providerId="ADAL" clId="{56835480-2BB5-4545-A32E-6CA68AA69734}" dt="2021-09-01T22:58:20.132" v="1238" actId="478"/>
          <ac:spMkLst>
            <pc:docMk/>
            <pc:sldMk cId="187938002" sldId="3307"/>
            <ac:spMk id="69" creationId="{51762752-6E1A-4524-AD0C-2C2B626088EA}"/>
          </ac:spMkLst>
        </pc:spChg>
        <pc:spChg chg="add del mod">
          <ac:chgData name="Grace" userId="fd145552-a10d-4a31-a438-f8736fd84277" providerId="ADAL" clId="{56835480-2BB5-4545-A32E-6CA68AA69734}" dt="2021-09-01T22:58:17.251" v="1237" actId="478"/>
          <ac:spMkLst>
            <pc:docMk/>
            <pc:sldMk cId="187938002" sldId="3307"/>
            <ac:spMk id="70" creationId="{6A331652-355D-473E-8225-56E16D6C3F25}"/>
          </ac:spMkLst>
        </pc:spChg>
        <pc:spChg chg="add mod">
          <ac:chgData name="Grace" userId="fd145552-a10d-4a31-a438-f8736fd84277" providerId="ADAL" clId="{56835480-2BB5-4545-A32E-6CA68AA69734}" dt="2021-09-01T22:53:26.818" v="1137" actId="2711"/>
          <ac:spMkLst>
            <pc:docMk/>
            <pc:sldMk cId="187938002" sldId="3307"/>
            <ac:spMk id="71" creationId="{59A92EFB-C96C-4C2A-81C5-B077FA1A8546}"/>
          </ac:spMkLst>
        </pc:spChg>
        <pc:spChg chg="add del mod">
          <ac:chgData name="Grace" userId="fd145552-a10d-4a31-a438-f8736fd84277" providerId="ADAL" clId="{56835480-2BB5-4545-A32E-6CA68AA69734}" dt="2021-09-01T23:18:11.513" v="2489" actId="478"/>
          <ac:spMkLst>
            <pc:docMk/>
            <pc:sldMk cId="187938002" sldId="3307"/>
            <ac:spMk id="72" creationId="{B71711AE-A756-4AE2-8C2C-2129E4ED3973}"/>
          </ac:spMkLst>
        </pc:spChg>
        <pc:spChg chg="add del mod">
          <ac:chgData name="Grace" userId="fd145552-a10d-4a31-a438-f8736fd84277" providerId="ADAL" clId="{56835480-2BB5-4545-A32E-6CA68AA69734}" dt="2021-09-01T23:18:05.730" v="2488" actId="478"/>
          <ac:spMkLst>
            <pc:docMk/>
            <pc:sldMk cId="187938002" sldId="3307"/>
            <ac:spMk id="73" creationId="{7741808B-CB67-481C-BEB4-DB4A89BBC16C}"/>
          </ac:spMkLst>
        </pc:spChg>
        <pc:spChg chg="add del mod">
          <ac:chgData name="Grace" userId="fd145552-a10d-4a31-a438-f8736fd84277" providerId="ADAL" clId="{56835480-2BB5-4545-A32E-6CA68AA69734}" dt="2021-09-01T22:54:42.034" v="1223" actId="478"/>
          <ac:spMkLst>
            <pc:docMk/>
            <pc:sldMk cId="187938002" sldId="3307"/>
            <ac:spMk id="74" creationId="{750ECA22-A058-434B-A0B6-7FF6B212DC13}"/>
          </ac:spMkLst>
        </pc:spChg>
        <pc:spChg chg="add del mod">
          <ac:chgData name="Grace" userId="fd145552-a10d-4a31-a438-f8736fd84277" providerId="ADAL" clId="{56835480-2BB5-4545-A32E-6CA68AA69734}" dt="2021-09-01T22:54:43.066" v="1224" actId="478"/>
          <ac:spMkLst>
            <pc:docMk/>
            <pc:sldMk cId="187938002" sldId="3307"/>
            <ac:spMk id="75" creationId="{A130CACC-18D4-44DB-A8A5-B53302425D96}"/>
          </ac:spMkLst>
        </pc:spChg>
        <pc:spChg chg="add del mod">
          <ac:chgData name="Grace" userId="fd145552-a10d-4a31-a438-f8736fd84277" providerId="ADAL" clId="{56835480-2BB5-4545-A32E-6CA68AA69734}" dt="2021-09-01T22:54:43.647" v="1225" actId="478"/>
          <ac:spMkLst>
            <pc:docMk/>
            <pc:sldMk cId="187938002" sldId="3307"/>
            <ac:spMk id="76" creationId="{F6D79F81-F0D8-4E58-AA30-97F58DCD1378}"/>
          </ac:spMkLst>
        </pc:spChg>
        <pc:spChg chg="add del mod">
          <ac:chgData name="Grace" userId="fd145552-a10d-4a31-a438-f8736fd84277" providerId="ADAL" clId="{56835480-2BB5-4545-A32E-6CA68AA69734}" dt="2021-09-01T23:00:43.283" v="1371" actId="478"/>
          <ac:spMkLst>
            <pc:docMk/>
            <pc:sldMk cId="187938002" sldId="3307"/>
            <ac:spMk id="77" creationId="{9090A4C1-7886-479B-A171-140E649400FD}"/>
          </ac:spMkLst>
        </pc:spChg>
        <pc:spChg chg="add del mod">
          <ac:chgData name="Grace" userId="fd145552-a10d-4a31-a438-f8736fd84277" providerId="ADAL" clId="{56835480-2BB5-4545-A32E-6CA68AA69734}" dt="2021-09-01T23:00:42.282" v="1370" actId="478"/>
          <ac:spMkLst>
            <pc:docMk/>
            <pc:sldMk cId="187938002" sldId="3307"/>
            <ac:spMk id="78" creationId="{BA123BE1-2A50-49E2-BA66-75ABF8FB07CF}"/>
          </ac:spMkLst>
        </pc:spChg>
        <pc:spChg chg="add del mod">
          <ac:chgData name="Grace" userId="fd145552-a10d-4a31-a438-f8736fd84277" providerId="ADAL" clId="{56835480-2BB5-4545-A32E-6CA68AA69734}" dt="2021-09-01T23:00:40.234" v="1369" actId="478"/>
          <ac:spMkLst>
            <pc:docMk/>
            <pc:sldMk cId="187938002" sldId="3307"/>
            <ac:spMk id="79" creationId="{B2C6DC8D-A2D4-4F60-A82B-E43F757CFD02}"/>
          </ac:spMkLst>
        </pc:spChg>
        <pc:spChg chg="add mod">
          <ac:chgData name="Grace" userId="fd145552-a10d-4a31-a438-f8736fd84277" providerId="ADAL" clId="{56835480-2BB5-4545-A32E-6CA68AA69734}" dt="2021-09-01T22:59:21.523" v="1363" actId="1076"/>
          <ac:spMkLst>
            <pc:docMk/>
            <pc:sldMk cId="187938002" sldId="3307"/>
            <ac:spMk id="80" creationId="{85C8FBD3-427E-438E-8EEA-2643D9F29E92}"/>
          </ac:spMkLst>
        </pc:spChg>
        <pc:spChg chg="add del mod">
          <ac:chgData name="Grace" userId="fd145552-a10d-4a31-a438-f8736fd84277" providerId="ADAL" clId="{56835480-2BB5-4545-A32E-6CA68AA69734}" dt="2021-09-01T22:54:11.246" v="1215"/>
          <ac:spMkLst>
            <pc:docMk/>
            <pc:sldMk cId="187938002" sldId="3307"/>
            <ac:spMk id="81" creationId="{923A1494-3815-4964-AE3C-E32737BF3D4A}"/>
          </ac:spMkLst>
        </pc:spChg>
        <pc:spChg chg="add del mod">
          <ac:chgData name="Grace" userId="fd145552-a10d-4a31-a438-f8736fd84277" providerId="ADAL" clId="{56835480-2BB5-4545-A32E-6CA68AA69734}" dt="2021-09-01T22:54:11.246" v="1215"/>
          <ac:spMkLst>
            <pc:docMk/>
            <pc:sldMk cId="187938002" sldId="3307"/>
            <ac:spMk id="82" creationId="{785792F7-783C-4A69-999A-42E8A0C84197}"/>
          </ac:spMkLst>
        </pc:spChg>
        <pc:spChg chg="add del mod">
          <ac:chgData name="Grace" userId="fd145552-a10d-4a31-a438-f8736fd84277" providerId="ADAL" clId="{56835480-2BB5-4545-A32E-6CA68AA69734}" dt="2021-09-01T22:54:11.246" v="1215"/>
          <ac:spMkLst>
            <pc:docMk/>
            <pc:sldMk cId="187938002" sldId="3307"/>
            <ac:spMk id="83" creationId="{35500D45-DC48-44D0-9224-975E7B887927}"/>
          </ac:spMkLst>
        </pc:spChg>
        <pc:spChg chg="add del mod">
          <ac:chgData name="Grace" userId="fd145552-a10d-4a31-a438-f8736fd84277" providerId="ADAL" clId="{56835480-2BB5-4545-A32E-6CA68AA69734}" dt="2021-09-01T22:54:11.246" v="1215"/>
          <ac:spMkLst>
            <pc:docMk/>
            <pc:sldMk cId="187938002" sldId="3307"/>
            <ac:spMk id="84" creationId="{DC940804-0577-42ED-B8E8-8BBEE59E104A}"/>
          </ac:spMkLst>
        </pc:spChg>
        <pc:spChg chg="add del mod">
          <ac:chgData name="Grace" userId="fd145552-a10d-4a31-a438-f8736fd84277" providerId="ADAL" clId="{56835480-2BB5-4545-A32E-6CA68AA69734}" dt="2021-09-01T22:54:11.246" v="1215"/>
          <ac:spMkLst>
            <pc:docMk/>
            <pc:sldMk cId="187938002" sldId="3307"/>
            <ac:spMk id="85" creationId="{C0DFC29B-131C-4684-B5AF-1FFCB48DAE04}"/>
          </ac:spMkLst>
        </pc:spChg>
        <pc:spChg chg="add del mod">
          <ac:chgData name="Grace" userId="fd145552-a10d-4a31-a438-f8736fd84277" providerId="ADAL" clId="{56835480-2BB5-4545-A32E-6CA68AA69734}" dt="2021-09-01T22:54:11.246" v="1215"/>
          <ac:spMkLst>
            <pc:docMk/>
            <pc:sldMk cId="187938002" sldId="3307"/>
            <ac:spMk id="86" creationId="{BC783F2E-6CF1-4088-BB68-681C6020AC3A}"/>
          </ac:spMkLst>
        </pc:spChg>
        <pc:spChg chg="add del mod">
          <ac:chgData name="Grace" userId="fd145552-a10d-4a31-a438-f8736fd84277" providerId="ADAL" clId="{56835480-2BB5-4545-A32E-6CA68AA69734}" dt="2021-09-01T23:07:47.426" v="1924" actId="478"/>
          <ac:spMkLst>
            <pc:docMk/>
            <pc:sldMk cId="187938002" sldId="3307"/>
            <ac:spMk id="87" creationId="{23783D10-2D40-471B-B9A1-203B2DD401D2}"/>
          </ac:spMkLst>
        </pc:spChg>
        <pc:spChg chg="add del mod">
          <ac:chgData name="Grace" userId="fd145552-a10d-4a31-a438-f8736fd84277" providerId="ADAL" clId="{56835480-2BB5-4545-A32E-6CA68AA69734}" dt="2021-09-01T23:19:16.598" v="2534" actId="478"/>
          <ac:spMkLst>
            <pc:docMk/>
            <pc:sldMk cId="187938002" sldId="3307"/>
            <ac:spMk id="88" creationId="{139B4AC3-4E82-49F8-83E5-A4AE82432C4E}"/>
          </ac:spMkLst>
        </pc:spChg>
        <pc:spChg chg="add del mod">
          <ac:chgData name="Grace" userId="fd145552-a10d-4a31-a438-f8736fd84277" providerId="ADAL" clId="{56835480-2BB5-4545-A32E-6CA68AA69734}" dt="2021-09-01T23:19:17.512" v="2536" actId="478"/>
          <ac:spMkLst>
            <pc:docMk/>
            <pc:sldMk cId="187938002" sldId="3307"/>
            <ac:spMk id="89" creationId="{E7F67EC3-09CE-40C2-AD5A-93E3B1676296}"/>
          </ac:spMkLst>
        </pc:spChg>
        <pc:spChg chg="add del mod">
          <ac:chgData name="Grace" userId="fd145552-a10d-4a31-a438-f8736fd84277" providerId="ADAL" clId="{56835480-2BB5-4545-A32E-6CA68AA69734}" dt="2021-09-01T23:07:47.926" v="1925" actId="478"/>
          <ac:spMkLst>
            <pc:docMk/>
            <pc:sldMk cId="187938002" sldId="3307"/>
            <ac:spMk id="90" creationId="{072E75E6-3C96-4455-ACE3-88A76306E3C6}"/>
          </ac:spMkLst>
        </pc:spChg>
        <pc:spChg chg="add del mod">
          <ac:chgData name="Grace" userId="fd145552-a10d-4a31-a438-f8736fd84277" providerId="ADAL" clId="{56835480-2BB5-4545-A32E-6CA68AA69734}" dt="2021-09-01T23:19:17.029" v="2535" actId="478"/>
          <ac:spMkLst>
            <pc:docMk/>
            <pc:sldMk cId="187938002" sldId="3307"/>
            <ac:spMk id="91" creationId="{E02D96A5-7298-426B-A986-A1F59124F6E7}"/>
          </ac:spMkLst>
        </pc:spChg>
        <pc:spChg chg="add del mod">
          <ac:chgData name="Grace" userId="fd145552-a10d-4a31-a438-f8736fd84277" providerId="ADAL" clId="{56835480-2BB5-4545-A32E-6CA68AA69734}" dt="2021-09-01T23:19:17.910" v="2537" actId="478"/>
          <ac:spMkLst>
            <pc:docMk/>
            <pc:sldMk cId="187938002" sldId="3307"/>
            <ac:spMk id="92" creationId="{09D83A85-24CF-4CC6-B10B-70D5FF2EB524}"/>
          </ac:spMkLst>
        </pc:spChg>
        <pc:spChg chg="add mod">
          <ac:chgData name="Grace" userId="fd145552-a10d-4a31-a438-f8736fd84277" providerId="ADAL" clId="{56835480-2BB5-4545-A32E-6CA68AA69734}" dt="2021-09-01T23:15:30.736" v="2411" actId="1076"/>
          <ac:spMkLst>
            <pc:docMk/>
            <pc:sldMk cId="187938002" sldId="3307"/>
            <ac:spMk id="93" creationId="{BF9A3230-00EC-4629-977A-A8CCE79ACC91}"/>
          </ac:spMkLst>
        </pc:spChg>
        <pc:spChg chg="add del mod">
          <ac:chgData name="Grace" userId="fd145552-a10d-4a31-a438-f8736fd84277" providerId="ADAL" clId="{56835480-2BB5-4545-A32E-6CA68AA69734}" dt="2021-09-01T23:07:46.518" v="1922" actId="478"/>
          <ac:spMkLst>
            <pc:docMk/>
            <pc:sldMk cId="187938002" sldId="3307"/>
            <ac:spMk id="94" creationId="{DDA7319C-A45F-4F1B-8F48-DD6C31A6ECB8}"/>
          </ac:spMkLst>
        </pc:spChg>
        <pc:spChg chg="add del mod">
          <ac:chgData name="Grace" userId="fd145552-a10d-4a31-a438-f8736fd84277" providerId="ADAL" clId="{56835480-2BB5-4545-A32E-6CA68AA69734}" dt="2021-09-01T23:07:46.942" v="1923" actId="478"/>
          <ac:spMkLst>
            <pc:docMk/>
            <pc:sldMk cId="187938002" sldId="3307"/>
            <ac:spMk id="95" creationId="{D43DA0D3-5EAC-431C-AEA6-DE2640B870D4}"/>
          </ac:spMkLst>
        </pc:spChg>
        <pc:spChg chg="add del mod">
          <ac:chgData name="Grace" userId="fd145552-a10d-4a31-a438-f8736fd84277" providerId="ADAL" clId="{56835480-2BB5-4545-A32E-6CA68AA69734}" dt="2021-09-01T23:07:41.380" v="1918" actId="478"/>
          <ac:spMkLst>
            <pc:docMk/>
            <pc:sldMk cId="187938002" sldId="3307"/>
            <ac:spMk id="96" creationId="{95AC17A0-24DA-44ED-9886-75A70A684ABF}"/>
          </ac:spMkLst>
        </pc:spChg>
        <pc:spChg chg="add del mod">
          <ac:chgData name="Grace" userId="fd145552-a10d-4a31-a438-f8736fd84277" providerId="ADAL" clId="{56835480-2BB5-4545-A32E-6CA68AA69734}" dt="2021-09-01T23:07:43.690" v="1919" actId="478"/>
          <ac:spMkLst>
            <pc:docMk/>
            <pc:sldMk cId="187938002" sldId="3307"/>
            <ac:spMk id="97" creationId="{996E61AE-D080-4C50-8ECC-6DDE36F492D6}"/>
          </ac:spMkLst>
        </pc:spChg>
        <pc:spChg chg="add del mod">
          <ac:chgData name="Grace" userId="fd145552-a10d-4a31-a438-f8736fd84277" providerId="ADAL" clId="{56835480-2BB5-4545-A32E-6CA68AA69734}" dt="2021-09-01T23:07:44.622" v="1920" actId="478"/>
          <ac:spMkLst>
            <pc:docMk/>
            <pc:sldMk cId="187938002" sldId="3307"/>
            <ac:spMk id="98" creationId="{3432E13A-BA26-4C6C-B944-7F4E3CC6A125}"/>
          </ac:spMkLst>
        </pc:spChg>
        <pc:spChg chg="add del mod">
          <ac:chgData name="Grace" userId="fd145552-a10d-4a31-a438-f8736fd84277" providerId="ADAL" clId="{56835480-2BB5-4545-A32E-6CA68AA69734}" dt="2021-09-01T23:07:45.619" v="1921" actId="478"/>
          <ac:spMkLst>
            <pc:docMk/>
            <pc:sldMk cId="187938002" sldId="3307"/>
            <ac:spMk id="99" creationId="{C0B1FC5B-05D6-42F8-BA2B-CC051BE8102D}"/>
          </ac:spMkLst>
        </pc:spChg>
        <pc:spChg chg="add mod">
          <ac:chgData name="Grace" userId="fd145552-a10d-4a31-a438-f8736fd84277" providerId="ADAL" clId="{56835480-2BB5-4545-A32E-6CA68AA69734}" dt="2021-09-01T23:07:14.469" v="1911" actId="571"/>
          <ac:spMkLst>
            <pc:docMk/>
            <pc:sldMk cId="187938002" sldId="3307"/>
            <ac:spMk id="100" creationId="{16FFB4EE-C290-4871-96B7-ECEE4C29A94B}"/>
          </ac:spMkLst>
        </pc:spChg>
        <pc:spChg chg="add mod">
          <ac:chgData name="Grace" userId="fd145552-a10d-4a31-a438-f8736fd84277" providerId="ADAL" clId="{56835480-2BB5-4545-A32E-6CA68AA69734}" dt="2021-09-01T23:07:14.469" v="1911" actId="571"/>
          <ac:spMkLst>
            <pc:docMk/>
            <pc:sldMk cId="187938002" sldId="3307"/>
            <ac:spMk id="101" creationId="{FBDD1A68-4A62-494D-A81B-2247D33A6189}"/>
          </ac:spMkLst>
        </pc:spChg>
        <pc:spChg chg="add del mod">
          <ac:chgData name="Grace" userId="fd145552-a10d-4a31-a438-f8736fd84277" providerId="ADAL" clId="{56835480-2BB5-4545-A32E-6CA68AA69734}" dt="2021-09-01T23:07:49.459" v="1926" actId="478"/>
          <ac:spMkLst>
            <pc:docMk/>
            <pc:sldMk cId="187938002" sldId="3307"/>
            <ac:spMk id="102" creationId="{617F669E-52C2-4E66-9A35-06F79D80EF4A}"/>
          </ac:spMkLst>
        </pc:spChg>
        <pc:spChg chg="add del mod">
          <ac:chgData name="Grace" userId="fd145552-a10d-4a31-a438-f8736fd84277" providerId="ADAL" clId="{56835480-2BB5-4545-A32E-6CA68AA69734}" dt="2021-09-01T23:07:49.842" v="1927" actId="478"/>
          <ac:spMkLst>
            <pc:docMk/>
            <pc:sldMk cId="187938002" sldId="3307"/>
            <ac:spMk id="103" creationId="{85DD7C38-6D86-43AE-9173-B0D1C060B148}"/>
          </ac:spMkLst>
        </pc:spChg>
        <pc:spChg chg="add mod">
          <ac:chgData name="Grace" userId="fd145552-a10d-4a31-a438-f8736fd84277" providerId="ADAL" clId="{56835480-2BB5-4545-A32E-6CA68AA69734}" dt="2021-09-01T23:08:54.416" v="1956" actId="1076"/>
          <ac:spMkLst>
            <pc:docMk/>
            <pc:sldMk cId="187938002" sldId="3307"/>
            <ac:spMk id="104" creationId="{F81F728A-F6E0-4035-B83C-178C94467706}"/>
          </ac:spMkLst>
        </pc:spChg>
        <pc:spChg chg="add mod">
          <ac:chgData name="Grace" userId="fd145552-a10d-4a31-a438-f8736fd84277" providerId="ADAL" clId="{56835480-2BB5-4545-A32E-6CA68AA69734}" dt="2021-09-01T23:17:10.262" v="2464" actId="14100"/>
          <ac:spMkLst>
            <pc:docMk/>
            <pc:sldMk cId="187938002" sldId="3307"/>
            <ac:spMk id="105" creationId="{46483DB8-79F9-4FBE-9B21-E97A274C2DEC}"/>
          </ac:spMkLst>
        </pc:spChg>
        <pc:spChg chg="add mod">
          <ac:chgData name="Grace" userId="fd145552-a10d-4a31-a438-f8736fd84277" providerId="ADAL" clId="{56835480-2BB5-4545-A32E-6CA68AA69734}" dt="2021-09-01T23:08:25.160" v="1941" actId="1076"/>
          <ac:spMkLst>
            <pc:docMk/>
            <pc:sldMk cId="187938002" sldId="3307"/>
            <ac:spMk id="106" creationId="{DDA53C12-4572-4125-91CB-0096DC97ACEE}"/>
          </ac:spMkLst>
        </pc:spChg>
        <pc:spChg chg="add mod">
          <ac:chgData name="Grace" userId="fd145552-a10d-4a31-a438-f8736fd84277" providerId="ADAL" clId="{56835480-2BB5-4545-A32E-6CA68AA69734}" dt="2021-09-01T23:17:36.100" v="2479" actId="207"/>
          <ac:spMkLst>
            <pc:docMk/>
            <pc:sldMk cId="187938002" sldId="3307"/>
            <ac:spMk id="107" creationId="{548FE39C-1314-44EC-A0B3-37B35B05DB8B}"/>
          </ac:spMkLst>
        </pc:spChg>
        <pc:spChg chg="add del mod">
          <ac:chgData name="Grace" userId="fd145552-a10d-4a31-a438-f8736fd84277" providerId="ADAL" clId="{56835480-2BB5-4545-A32E-6CA68AA69734}" dt="2021-09-01T23:07:57.684" v="1933"/>
          <ac:spMkLst>
            <pc:docMk/>
            <pc:sldMk cId="187938002" sldId="3307"/>
            <ac:spMk id="108" creationId="{1E651D2E-08FE-495D-98ED-DF3BAF29D698}"/>
          </ac:spMkLst>
        </pc:spChg>
        <pc:spChg chg="add del mod">
          <ac:chgData name="Grace" userId="fd145552-a10d-4a31-a438-f8736fd84277" providerId="ADAL" clId="{56835480-2BB5-4545-A32E-6CA68AA69734}" dt="2021-09-01T23:07:57.684" v="1933"/>
          <ac:spMkLst>
            <pc:docMk/>
            <pc:sldMk cId="187938002" sldId="3307"/>
            <ac:spMk id="109" creationId="{F9E14817-0005-4553-9117-B462009E354B}"/>
          </ac:spMkLst>
        </pc:spChg>
        <pc:spChg chg="add mod">
          <ac:chgData name="Grace" userId="fd145552-a10d-4a31-a438-f8736fd84277" providerId="ADAL" clId="{56835480-2BB5-4545-A32E-6CA68AA69734}" dt="2021-09-01T23:08:31.087" v="1942" actId="1076"/>
          <ac:spMkLst>
            <pc:docMk/>
            <pc:sldMk cId="187938002" sldId="3307"/>
            <ac:spMk id="110" creationId="{DA178DCD-074A-482D-856E-184518C9F5C8}"/>
          </ac:spMkLst>
        </pc:spChg>
        <pc:spChg chg="add mod">
          <ac:chgData name="Grace" userId="fd145552-a10d-4a31-a438-f8736fd84277" providerId="ADAL" clId="{56835480-2BB5-4545-A32E-6CA68AA69734}" dt="2021-09-01T23:17:39.880" v="2480" actId="207"/>
          <ac:spMkLst>
            <pc:docMk/>
            <pc:sldMk cId="187938002" sldId="3307"/>
            <ac:spMk id="111" creationId="{1793323B-16EA-4D26-913D-D89B75512963}"/>
          </ac:spMkLst>
        </pc:spChg>
        <pc:spChg chg="add del mod">
          <ac:chgData name="Grace" userId="fd145552-a10d-4a31-a438-f8736fd84277" providerId="ADAL" clId="{56835480-2BB5-4545-A32E-6CA68AA69734}" dt="2021-09-01T23:08:33.493" v="1943" actId="478"/>
          <ac:spMkLst>
            <pc:docMk/>
            <pc:sldMk cId="187938002" sldId="3307"/>
            <ac:spMk id="112" creationId="{16B43E42-C924-4E64-8B7D-3977E61CD693}"/>
          </ac:spMkLst>
        </pc:spChg>
        <pc:spChg chg="add del mod">
          <ac:chgData name="Grace" userId="fd145552-a10d-4a31-a438-f8736fd84277" providerId="ADAL" clId="{56835480-2BB5-4545-A32E-6CA68AA69734}" dt="2021-09-01T23:08:34.167" v="1944" actId="478"/>
          <ac:spMkLst>
            <pc:docMk/>
            <pc:sldMk cId="187938002" sldId="3307"/>
            <ac:spMk id="113" creationId="{1DF1567C-4B53-4C56-85DC-D1D6B9AD3D7D}"/>
          </ac:spMkLst>
        </pc:spChg>
        <pc:spChg chg="add del mod">
          <ac:chgData name="Grace" userId="fd145552-a10d-4a31-a438-f8736fd84277" providerId="ADAL" clId="{56835480-2BB5-4545-A32E-6CA68AA69734}" dt="2021-09-01T23:08:40.576" v="1948"/>
          <ac:spMkLst>
            <pc:docMk/>
            <pc:sldMk cId="187938002" sldId="3307"/>
            <ac:spMk id="114" creationId="{55398374-0343-4450-9E00-B806E1D8F85F}"/>
          </ac:spMkLst>
        </pc:spChg>
        <pc:spChg chg="add del mod">
          <ac:chgData name="Grace" userId="fd145552-a10d-4a31-a438-f8736fd84277" providerId="ADAL" clId="{56835480-2BB5-4545-A32E-6CA68AA69734}" dt="2021-09-01T23:08:40.576" v="1948"/>
          <ac:spMkLst>
            <pc:docMk/>
            <pc:sldMk cId="187938002" sldId="3307"/>
            <ac:spMk id="115" creationId="{B3DFBCA8-8321-4CAE-AB48-3AF214073055}"/>
          </ac:spMkLst>
        </pc:spChg>
        <pc:spChg chg="add del mod">
          <ac:chgData name="Grace" userId="fd145552-a10d-4a31-a438-f8736fd84277" providerId="ADAL" clId="{56835480-2BB5-4545-A32E-6CA68AA69734}" dt="2021-09-01T23:08:45.009" v="1951" actId="478"/>
          <ac:spMkLst>
            <pc:docMk/>
            <pc:sldMk cId="187938002" sldId="3307"/>
            <ac:spMk id="116" creationId="{A812ACAB-D61F-47C1-A346-C69F5901ED33}"/>
          </ac:spMkLst>
        </pc:spChg>
        <pc:spChg chg="add del mod">
          <ac:chgData name="Grace" userId="fd145552-a10d-4a31-a438-f8736fd84277" providerId="ADAL" clId="{56835480-2BB5-4545-A32E-6CA68AA69734}" dt="2021-09-01T23:08:45.009" v="1951" actId="478"/>
          <ac:spMkLst>
            <pc:docMk/>
            <pc:sldMk cId="187938002" sldId="3307"/>
            <ac:spMk id="117" creationId="{2A6ABEA9-3E71-4356-BDD7-DF20567A6925}"/>
          </ac:spMkLst>
        </pc:spChg>
        <pc:spChg chg="add del mod">
          <ac:chgData name="Grace" userId="fd145552-a10d-4a31-a438-f8736fd84277" providerId="ADAL" clId="{56835480-2BB5-4545-A32E-6CA68AA69734}" dt="2021-09-01T23:08:52.707" v="1954" actId="478"/>
          <ac:spMkLst>
            <pc:docMk/>
            <pc:sldMk cId="187938002" sldId="3307"/>
            <ac:spMk id="118" creationId="{1EB3026D-8477-402C-A840-752CA5EFBB01}"/>
          </ac:spMkLst>
        </pc:spChg>
        <pc:spChg chg="add del mod">
          <ac:chgData name="Grace" userId="fd145552-a10d-4a31-a438-f8736fd84277" providerId="ADAL" clId="{56835480-2BB5-4545-A32E-6CA68AA69734}" dt="2021-09-01T23:08:52.707" v="1954" actId="478"/>
          <ac:spMkLst>
            <pc:docMk/>
            <pc:sldMk cId="187938002" sldId="3307"/>
            <ac:spMk id="119" creationId="{B9939EF8-1D39-4D83-A3BD-14E064371BE0}"/>
          </ac:spMkLst>
        </pc:spChg>
        <pc:spChg chg="add del mod">
          <ac:chgData name="Grace" userId="fd145552-a10d-4a31-a438-f8736fd84277" providerId="ADAL" clId="{56835480-2BB5-4545-A32E-6CA68AA69734}" dt="2021-09-01T23:10:08.042" v="1969" actId="478"/>
          <ac:spMkLst>
            <pc:docMk/>
            <pc:sldMk cId="187938002" sldId="3307"/>
            <ac:spMk id="120" creationId="{AEA3FBB1-172B-4406-B893-82C21D7FCBEE}"/>
          </ac:spMkLst>
        </pc:spChg>
        <pc:spChg chg="add del mod">
          <ac:chgData name="Grace" userId="fd145552-a10d-4a31-a438-f8736fd84277" providerId="ADAL" clId="{56835480-2BB5-4545-A32E-6CA68AA69734}" dt="2021-09-01T23:10:07.450" v="1968" actId="478"/>
          <ac:spMkLst>
            <pc:docMk/>
            <pc:sldMk cId="187938002" sldId="3307"/>
            <ac:spMk id="121" creationId="{FFE2E697-0073-4F79-98AE-EC1B85713DCC}"/>
          </ac:spMkLst>
        </pc:spChg>
        <pc:spChg chg="add del mod">
          <ac:chgData name="Grace" userId="fd145552-a10d-4a31-a438-f8736fd84277" providerId="ADAL" clId="{56835480-2BB5-4545-A32E-6CA68AA69734}" dt="2021-09-01T23:10:55.302" v="1979" actId="478"/>
          <ac:spMkLst>
            <pc:docMk/>
            <pc:sldMk cId="187938002" sldId="3307"/>
            <ac:spMk id="122" creationId="{53594359-9D61-47C3-B988-8A0D6717FB1E}"/>
          </ac:spMkLst>
        </pc:spChg>
        <pc:spChg chg="add del mod">
          <ac:chgData name="Grace" userId="fd145552-a10d-4a31-a438-f8736fd84277" providerId="ADAL" clId="{56835480-2BB5-4545-A32E-6CA68AA69734}" dt="2021-09-01T23:10:55.302" v="1979" actId="478"/>
          <ac:spMkLst>
            <pc:docMk/>
            <pc:sldMk cId="187938002" sldId="3307"/>
            <ac:spMk id="123" creationId="{7B34FA83-37F5-4E15-A034-64D1ED3CAE96}"/>
          </ac:spMkLst>
        </pc:spChg>
        <pc:spChg chg="add del mod">
          <ac:chgData name="Grace" userId="fd145552-a10d-4a31-a438-f8736fd84277" providerId="ADAL" clId="{56835480-2BB5-4545-A32E-6CA68AA69734}" dt="2021-09-01T23:13:18.372" v="2314" actId="478"/>
          <ac:spMkLst>
            <pc:docMk/>
            <pc:sldMk cId="187938002" sldId="3307"/>
            <ac:spMk id="124" creationId="{48450E7A-D9AD-4767-B3E2-6531364CD614}"/>
          </ac:spMkLst>
        </pc:spChg>
        <pc:spChg chg="add del mod">
          <ac:chgData name="Grace" userId="fd145552-a10d-4a31-a438-f8736fd84277" providerId="ADAL" clId="{56835480-2BB5-4545-A32E-6CA68AA69734}" dt="2021-09-01T23:13:17.712" v="2313" actId="478"/>
          <ac:spMkLst>
            <pc:docMk/>
            <pc:sldMk cId="187938002" sldId="3307"/>
            <ac:spMk id="125" creationId="{4361F99F-043A-4DED-8E05-1C22516B3AA5}"/>
          </ac:spMkLst>
        </pc:spChg>
        <pc:spChg chg="add del mod">
          <ac:chgData name="Grace" userId="fd145552-a10d-4a31-a438-f8736fd84277" providerId="ADAL" clId="{56835480-2BB5-4545-A32E-6CA68AA69734}" dt="2021-09-01T23:11:10.396" v="2006" actId="478"/>
          <ac:spMkLst>
            <pc:docMk/>
            <pc:sldMk cId="187938002" sldId="3307"/>
            <ac:spMk id="126" creationId="{34C15E88-6A98-4329-8FFA-477CD45EC849}"/>
          </ac:spMkLst>
        </pc:spChg>
        <pc:spChg chg="add del mod">
          <ac:chgData name="Grace" userId="fd145552-a10d-4a31-a438-f8736fd84277" providerId="ADAL" clId="{56835480-2BB5-4545-A32E-6CA68AA69734}" dt="2021-09-01T23:11:08.515" v="2005" actId="478"/>
          <ac:spMkLst>
            <pc:docMk/>
            <pc:sldMk cId="187938002" sldId="3307"/>
            <ac:spMk id="127" creationId="{24D7EAA5-CEC7-40F4-973D-A0C51CFD7D27}"/>
          </ac:spMkLst>
        </pc:spChg>
        <pc:spChg chg="add del mod">
          <ac:chgData name="Grace" userId="fd145552-a10d-4a31-a438-f8736fd84277" providerId="ADAL" clId="{56835480-2BB5-4545-A32E-6CA68AA69734}" dt="2021-09-01T23:10:32.251" v="1974"/>
          <ac:spMkLst>
            <pc:docMk/>
            <pc:sldMk cId="187938002" sldId="3307"/>
            <ac:spMk id="128" creationId="{7A237CDA-19DB-49D5-8AE9-F3A7E84A6F1D}"/>
          </ac:spMkLst>
        </pc:spChg>
        <pc:spChg chg="add del mod">
          <ac:chgData name="Grace" userId="fd145552-a10d-4a31-a438-f8736fd84277" providerId="ADAL" clId="{56835480-2BB5-4545-A32E-6CA68AA69734}" dt="2021-09-01T23:10:32.251" v="1974"/>
          <ac:spMkLst>
            <pc:docMk/>
            <pc:sldMk cId="187938002" sldId="3307"/>
            <ac:spMk id="129" creationId="{93824914-102F-412E-980C-E41EA5B64745}"/>
          </ac:spMkLst>
        </pc:spChg>
        <pc:spChg chg="add mod">
          <ac:chgData name="Grace" userId="fd145552-a10d-4a31-a438-f8736fd84277" providerId="ADAL" clId="{56835480-2BB5-4545-A32E-6CA68AA69734}" dt="2021-09-01T23:13:23.340" v="2340" actId="1036"/>
          <ac:spMkLst>
            <pc:docMk/>
            <pc:sldMk cId="187938002" sldId="3307"/>
            <ac:spMk id="130" creationId="{A1937A8D-739D-47D2-8F3B-5D3DEEC0CBFE}"/>
          </ac:spMkLst>
        </pc:spChg>
        <pc:spChg chg="add mod">
          <ac:chgData name="Grace" userId="fd145552-a10d-4a31-a438-f8736fd84277" providerId="ADAL" clId="{56835480-2BB5-4545-A32E-6CA68AA69734}" dt="2021-09-01T23:17:59.673" v="2487" actId="207"/>
          <ac:spMkLst>
            <pc:docMk/>
            <pc:sldMk cId="187938002" sldId="3307"/>
            <ac:spMk id="131" creationId="{50DF1E82-6ACA-4B66-B7D6-9690E79414D5}"/>
          </ac:spMkLst>
        </pc:spChg>
        <pc:spChg chg="add del mod">
          <ac:chgData name="Grace" userId="fd145552-a10d-4a31-a438-f8736fd84277" providerId="ADAL" clId="{56835480-2BB5-4545-A32E-6CA68AA69734}" dt="2021-09-01T23:12:56.683" v="2275" actId="478"/>
          <ac:spMkLst>
            <pc:docMk/>
            <pc:sldMk cId="187938002" sldId="3307"/>
            <ac:spMk id="132" creationId="{9DAB8CA8-A75D-40E9-AC3F-D18EF28A80D5}"/>
          </ac:spMkLst>
        </pc:spChg>
        <pc:spChg chg="add del mod">
          <ac:chgData name="Grace" userId="fd145552-a10d-4a31-a438-f8736fd84277" providerId="ADAL" clId="{56835480-2BB5-4545-A32E-6CA68AA69734}" dt="2021-09-01T23:12:56.149" v="2274" actId="478"/>
          <ac:spMkLst>
            <pc:docMk/>
            <pc:sldMk cId="187938002" sldId="3307"/>
            <ac:spMk id="133" creationId="{4C0FC311-6B65-4E1A-B7EB-62D1CE097EBE}"/>
          </ac:spMkLst>
        </pc:spChg>
        <pc:spChg chg="add del mod">
          <ac:chgData name="Grace" userId="fd145552-a10d-4a31-a438-f8736fd84277" providerId="ADAL" clId="{56835480-2BB5-4545-A32E-6CA68AA69734}" dt="2021-09-01T23:18:56.685" v="2510" actId="478"/>
          <ac:spMkLst>
            <pc:docMk/>
            <pc:sldMk cId="187938002" sldId="3307"/>
            <ac:spMk id="134" creationId="{2DA0DAE7-7FC2-4538-8318-AEFC98B88956}"/>
          </ac:spMkLst>
        </pc:spChg>
        <pc:spChg chg="add del mod">
          <ac:chgData name="Grace" userId="fd145552-a10d-4a31-a438-f8736fd84277" providerId="ADAL" clId="{56835480-2BB5-4545-A32E-6CA68AA69734}" dt="2021-09-01T23:18:14.525" v="2490" actId="478"/>
          <ac:spMkLst>
            <pc:docMk/>
            <pc:sldMk cId="187938002" sldId="3307"/>
            <ac:spMk id="135" creationId="{08CF118F-4D78-4C27-B99C-E67B83CA7EA4}"/>
          </ac:spMkLst>
        </pc:spChg>
        <pc:spChg chg="add del mod">
          <ac:chgData name="Grace" userId="fd145552-a10d-4a31-a438-f8736fd84277" providerId="ADAL" clId="{56835480-2BB5-4545-A32E-6CA68AA69734}" dt="2021-09-01T23:11:47.138" v="2065" actId="21"/>
          <ac:spMkLst>
            <pc:docMk/>
            <pc:sldMk cId="187938002" sldId="3307"/>
            <ac:spMk id="136" creationId="{70B092A9-EE68-4AD8-91E5-F7677B71BC50}"/>
          </ac:spMkLst>
        </pc:spChg>
        <pc:spChg chg="add del mod">
          <ac:chgData name="Grace" userId="fd145552-a10d-4a31-a438-f8736fd84277" providerId="ADAL" clId="{56835480-2BB5-4545-A32E-6CA68AA69734}" dt="2021-09-01T23:11:47.138" v="2065" actId="21"/>
          <ac:spMkLst>
            <pc:docMk/>
            <pc:sldMk cId="187938002" sldId="3307"/>
            <ac:spMk id="137" creationId="{112E3F27-44A3-4F65-A2D8-4FC86E983641}"/>
          </ac:spMkLst>
        </pc:spChg>
        <pc:spChg chg="add del mod">
          <ac:chgData name="Grace" userId="fd145552-a10d-4a31-a438-f8736fd84277" providerId="ADAL" clId="{56835480-2BB5-4545-A32E-6CA68AA69734}" dt="2021-09-01T23:18:55.236" v="2508" actId="478"/>
          <ac:spMkLst>
            <pc:docMk/>
            <pc:sldMk cId="187938002" sldId="3307"/>
            <ac:spMk id="138" creationId="{AB3F61A9-5912-468A-BD17-FBD3B48D190C}"/>
          </ac:spMkLst>
        </pc:spChg>
        <pc:spChg chg="add del mod">
          <ac:chgData name="Grace" userId="fd145552-a10d-4a31-a438-f8736fd84277" providerId="ADAL" clId="{56835480-2BB5-4545-A32E-6CA68AA69734}" dt="2021-09-01T23:18:55.578" v="2509" actId="478"/>
          <ac:spMkLst>
            <pc:docMk/>
            <pc:sldMk cId="187938002" sldId="3307"/>
            <ac:spMk id="139" creationId="{36DA0C31-8224-4AFF-963F-417C2A3F05DC}"/>
          </ac:spMkLst>
        </pc:spChg>
        <pc:spChg chg="add mod">
          <ac:chgData name="Grace" userId="fd145552-a10d-4a31-a438-f8736fd84277" providerId="ADAL" clId="{56835480-2BB5-4545-A32E-6CA68AA69734}" dt="2021-09-01T23:13:06.017" v="2311" actId="1036"/>
          <ac:spMkLst>
            <pc:docMk/>
            <pc:sldMk cId="187938002" sldId="3307"/>
            <ac:spMk id="140" creationId="{2993D3FC-7E1C-4B15-8C2F-13E3FDEE4739}"/>
          </ac:spMkLst>
        </pc:spChg>
        <pc:spChg chg="add mod">
          <ac:chgData name="Grace" userId="fd145552-a10d-4a31-a438-f8736fd84277" providerId="ADAL" clId="{56835480-2BB5-4545-A32E-6CA68AA69734}" dt="2021-09-01T23:17:56.971" v="2486" actId="207"/>
          <ac:spMkLst>
            <pc:docMk/>
            <pc:sldMk cId="187938002" sldId="3307"/>
            <ac:spMk id="141" creationId="{E9E75851-735E-46B4-8F8D-910677E15ED0}"/>
          </ac:spMkLst>
        </pc:spChg>
        <pc:spChg chg="add del mod">
          <ac:chgData name="Grace" userId="fd145552-a10d-4a31-a438-f8736fd84277" providerId="ADAL" clId="{56835480-2BB5-4545-A32E-6CA68AA69734}" dt="2021-09-01T23:15:13.616" v="2401" actId="478"/>
          <ac:spMkLst>
            <pc:docMk/>
            <pc:sldMk cId="187938002" sldId="3307"/>
            <ac:spMk id="142" creationId="{22456EA7-9622-4AD6-95BB-93297226B102}"/>
          </ac:spMkLst>
        </pc:spChg>
        <pc:spChg chg="add del mod">
          <ac:chgData name="Grace" userId="fd145552-a10d-4a31-a438-f8736fd84277" providerId="ADAL" clId="{56835480-2BB5-4545-A32E-6CA68AA69734}" dt="2021-09-01T23:14:37.833" v="2371" actId="478"/>
          <ac:spMkLst>
            <pc:docMk/>
            <pc:sldMk cId="187938002" sldId="3307"/>
            <ac:spMk id="143" creationId="{A9CB454C-2E54-4A5B-8E20-2BFE5F42BB16}"/>
          </ac:spMkLst>
        </pc:spChg>
        <pc:spChg chg="add del mod">
          <ac:chgData name="Grace" userId="fd145552-a10d-4a31-a438-f8736fd84277" providerId="ADAL" clId="{56835480-2BB5-4545-A32E-6CA68AA69734}" dt="2021-09-01T23:14:37.426" v="2370" actId="478"/>
          <ac:spMkLst>
            <pc:docMk/>
            <pc:sldMk cId="187938002" sldId="3307"/>
            <ac:spMk id="144" creationId="{3D135F23-41AC-4C7C-9CD7-2DA6E2453D06}"/>
          </ac:spMkLst>
        </pc:spChg>
        <pc:spChg chg="add del mod">
          <ac:chgData name="Grace" userId="fd145552-a10d-4a31-a438-f8736fd84277" providerId="ADAL" clId="{56835480-2BB5-4545-A32E-6CA68AA69734}" dt="2021-09-01T23:14:37.031" v="2369" actId="478"/>
          <ac:spMkLst>
            <pc:docMk/>
            <pc:sldMk cId="187938002" sldId="3307"/>
            <ac:spMk id="145" creationId="{5F08B90B-CEBA-4D31-B790-39FBF9655809}"/>
          </ac:spMkLst>
        </pc:spChg>
        <pc:spChg chg="add del mod">
          <ac:chgData name="Grace" userId="fd145552-a10d-4a31-a438-f8736fd84277" providerId="ADAL" clId="{56835480-2BB5-4545-A32E-6CA68AA69734}" dt="2021-09-01T23:14:36.646" v="2368" actId="478"/>
          <ac:spMkLst>
            <pc:docMk/>
            <pc:sldMk cId="187938002" sldId="3307"/>
            <ac:spMk id="146" creationId="{34B3EE16-DB9C-415F-8148-89E0A9B237D4}"/>
          </ac:spMkLst>
        </pc:spChg>
        <pc:spChg chg="add del mod">
          <ac:chgData name="Grace" userId="fd145552-a10d-4a31-a438-f8736fd84277" providerId="ADAL" clId="{56835480-2BB5-4545-A32E-6CA68AA69734}" dt="2021-09-01T23:14:36.298" v="2367" actId="478"/>
          <ac:spMkLst>
            <pc:docMk/>
            <pc:sldMk cId="187938002" sldId="3307"/>
            <ac:spMk id="147" creationId="{EC3CB2F6-149C-40DE-90F5-F32B68427ECD}"/>
          </ac:spMkLst>
        </pc:spChg>
        <pc:spChg chg="add del mod">
          <ac:chgData name="Grace" userId="fd145552-a10d-4a31-a438-f8736fd84277" providerId="ADAL" clId="{56835480-2BB5-4545-A32E-6CA68AA69734}" dt="2021-09-01T23:14:35.918" v="2366" actId="478"/>
          <ac:spMkLst>
            <pc:docMk/>
            <pc:sldMk cId="187938002" sldId="3307"/>
            <ac:spMk id="148" creationId="{422DD377-A6B4-41B1-AAB3-2DD9B460260F}"/>
          </ac:spMkLst>
        </pc:spChg>
        <pc:spChg chg="add del mod">
          <ac:chgData name="Grace" userId="fd145552-a10d-4a31-a438-f8736fd84277" providerId="ADAL" clId="{56835480-2BB5-4545-A32E-6CA68AA69734}" dt="2021-09-01T23:15:13.281" v="2400" actId="478"/>
          <ac:spMkLst>
            <pc:docMk/>
            <pc:sldMk cId="187938002" sldId="3307"/>
            <ac:spMk id="149" creationId="{8120B1B6-DAC7-4102-996A-485D2B02C98B}"/>
          </ac:spMkLst>
        </pc:spChg>
        <pc:spChg chg="add del mod">
          <ac:chgData name="Grace" userId="fd145552-a10d-4a31-a438-f8736fd84277" providerId="ADAL" clId="{56835480-2BB5-4545-A32E-6CA68AA69734}" dt="2021-09-01T23:15:12.958" v="2399" actId="478"/>
          <ac:spMkLst>
            <pc:docMk/>
            <pc:sldMk cId="187938002" sldId="3307"/>
            <ac:spMk id="150" creationId="{85A1AA0E-9C49-4CF8-89F0-48D20228EEA8}"/>
          </ac:spMkLst>
        </pc:spChg>
        <pc:spChg chg="add del mod">
          <ac:chgData name="Grace" userId="fd145552-a10d-4a31-a438-f8736fd84277" providerId="ADAL" clId="{56835480-2BB5-4545-A32E-6CA68AA69734}" dt="2021-09-01T23:15:12.300" v="2398" actId="478"/>
          <ac:spMkLst>
            <pc:docMk/>
            <pc:sldMk cId="187938002" sldId="3307"/>
            <ac:spMk id="151" creationId="{B9954EF0-FF9F-4DC5-9F63-F2CFCB569AFD}"/>
          </ac:spMkLst>
        </pc:spChg>
        <pc:spChg chg="add del mod">
          <ac:chgData name="Grace" userId="fd145552-a10d-4a31-a438-f8736fd84277" providerId="ADAL" clId="{56835480-2BB5-4545-A32E-6CA68AA69734}" dt="2021-09-01T23:15:11.820" v="2397" actId="478"/>
          <ac:spMkLst>
            <pc:docMk/>
            <pc:sldMk cId="187938002" sldId="3307"/>
            <ac:spMk id="152" creationId="{464574F9-B799-4351-9DAE-84AE3F70C6E0}"/>
          </ac:spMkLst>
        </pc:spChg>
        <pc:spChg chg="add del mod">
          <ac:chgData name="Grace" userId="fd145552-a10d-4a31-a438-f8736fd84277" providerId="ADAL" clId="{56835480-2BB5-4545-A32E-6CA68AA69734}" dt="2021-09-01T23:15:11.422" v="2396" actId="478"/>
          <ac:spMkLst>
            <pc:docMk/>
            <pc:sldMk cId="187938002" sldId="3307"/>
            <ac:spMk id="153" creationId="{A33FEAEF-3C2E-4D4B-89E4-09E4D47852A0}"/>
          </ac:spMkLst>
        </pc:spChg>
        <pc:spChg chg="add del mod">
          <ac:chgData name="Grace" userId="fd145552-a10d-4a31-a438-f8736fd84277" providerId="ADAL" clId="{56835480-2BB5-4545-A32E-6CA68AA69734}" dt="2021-09-01T23:15:11.071" v="2395" actId="478"/>
          <ac:spMkLst>
            <pc:docMk/>
            <pc:sldMk cId="187938002" sldId="3307"/>
            <ac:spMk id="154" creationId="{99F3F7AD-B1C1-49AC-B254-459A6DE10C2C}"/>
          </ac:spMkLst>
        </pc:spChg>
        <pc:spChg chg="add del mod">
          <ac:chgData name="Grace" userId="fd145552-a10d-4a31-a438-f8736fd84277" providerId="ADAL" clId="{56835480-2BB5-4545-A32E-6CA68AA69734}" dt="2021-09-01T23:15:10.672" v="2394" actId="478"/>
          <ac:spMkLst>
            <pc:docMk/>
            <pc:sldMk cId="187938002" sldId="3307"/>
            <ac:spMk id="155" creationId="{0684EB27-3982-4CF6-8269-4261AF992BF4}"/>
          </ac:spMkLst>
        </pc:spChg>
        <pc:spChg chg="add del mod">
          <ac:chgData name="Grace" userId="fd145552-a10d-4a31-a438-f8736fd84277" providerId="ADAL" clId="{56835480-2BB5-4545-A32E-6CA68AA69734}" dt="2021-09-01T23:15:10.224" v="2393" actId="478"/>
          <ac:spMkLst>
            <pc:docMk/>
            <pc:sldMk cId="187938002" sldId="3307"/>
            <ac:spMk id="156" creationId="{9D65A7A1-E722-4144-9B83-10A161C2F92A}"/>
          </ac:spMkLst>
        </pc:spChg>
        <pc:spChg chg="add del mod">
          <ac:chgData name="Grace" userId="fd145552-a10d-4a31-a438-f8736fd84277" providerId="ADAL" clId="{56835480-2BB5-4545-A32E-6CA68AA69734}" dt="2021-09-01T23:15:53.427" v="2428" actId="478"/>
          <ac:spMkLst>
            <pc:docMk/>
            <pc:sldMk cId="187938002" sldId="3307"/>
            <ac:spMk id="157" creationId="{61AC6359-E5F6-43B8-84C8-8B2BCFF0AB40}"/>
          </ac:spMkLst>
        </pc:spChg>
        <pc:spChg chg="add del mod">
          <ac:chgData name="Grace" userId="fd145552-a10d-4a31-a438-f8736fd84277" providerId="ADAL" clId="{56835480-2BB5-4545-A32E-6CA68AA69734}" dt="2021-09-01T23:15:53.020" v="2427" actId="478"/>
          <ac:spMkLst>
            <pc:docMk/>
            <pc:sldMk cId="187938002" sldId="3307"/>
            <ac:spMk id="158" creationId="{5AEE379F-A862-4F60-A1E6-52DD70A1E7A8}"/>
          </ac:spMkLst>
        </pc:spChg>
        <pc:spChg chg="add del mod">
          <ac:chgData name="Grace" userId="fd145552-a10d-4a31-a438-f8736fd84277" providerId="ADAL" clId="{56835480-2BB5-4545-A32E-6CA68AA69734}" dt="2021-09-01T23:15:52.541" v="2426" actId="478"/>
          <ac:spMkLst>
            <pc:docMk/>
            <pc:sldMk cId="187938002" sldId="3307"/>
            <ac:spMk id="159" creationId="{0BFC8225-65BA-430D-82C6-3B9A9911DCDE}"/>
          </ac:spMkLst>
        </pc:spChg>
        <pc:spChg chg="add del mod">
          <ac:chgData name="Grace" userId="fd145552-a10d-4a31-a438-f8736fd84277" providerId="ADAL" clId="{56835480-2BB5-4545-A32E-6CA68AA69734}" dt="2021-09-01T23:15:51.688" v="2424" actId="478"/>
          <ac:spMkLst>
            <pc:docMk/>
            <pc:sldMk cId="187938002" sldId="3307"/>
            <ac:spMk id="160" creationId="{306DCFCF-A067-4477-9384-F120D48CCD43}"/>
          </ac:spMkLst>
        </pc:spChg>
        <pc:spChg chg="add del mod">
          <ac:chgData name="Grace" userId="fd145552-a10d-4a31-a438-f8736fd84277" providerId="ADAL" clId="{56835480-2BB5-4545-A32E-6CA68AA69734}" dt="2021-09-01T23:15:52.127" v="2425" actId="478"/>
          <ac:spMkLst>
            <pc:docMk/>
            <pc:sldMk cId="187938002" sldId="3307"/>
            <ac:spMk id="161" creationId="{417BC7E0-E745-4B86-B980-A52AE7B6EE77}"/>
          </ac:spMkLst>
        </pc:spChg>
        <pc:spChg chg="add del mod">
          <ac:chgData name="Grace" userId="fd145552-a10d-4a31-a438-f8736fd84277" providerId="ADAL" clId="{56835480-2BB5-4545-A32E-6CA68AA69734}" dt="2021-09-01T23:15:51.384" v="2423" actId="478"/>
          <ac:spMkLst>
            <pc:docMk/>
            <pc:sldMk cId="187938002" sldId="3307"/>
            <ac:spMk id="162" creationId="{B06F2A2F-C17F-4D34-A2C5-8D43F8BF284F}"/>
          </ac:spMkLst>
        </pc:spChg>
        <pc:spChg chg="add del mod">
          <ac:chgData name="Grace" userId="fd145552-a10d-4a31-a438-f8736fd84277" providerId="ADAL" clId="{56835480-2BB5-4545-A32E-6CA68AA69734}" dt="2021-09-01T23:15:50.860" v="2422" actId="478"/>
          <ac:spMkLst>
            <pc:docMk/>
            <pc:sldMk cId="187938002" sldId="3307"/>
            <ac:spMk id="163" creationId="{A4664AFE-428F-42F5-9DA7-8A8E167E7E87}"/>
          </ac:spMkLst>
        </pc:spChg>
        <pc:spChg chg="add del mod">
          <ac:chgData name="Grace" userId="fd145552-a10d-4a31-a438-f8736fd84277" providerId="ADAL" clId="{56835480-2BB5-4545-A32E-6CA68AA69734}" dt="2021-09-01T23:17:13.657" v="2465" actId="478"/>
          <ac:spMkLst>
            <pc:docMk/>
            <pc:sldMk cId="187938002" sldId="3307"/>
            <ac:spMk id="164" creationId="{06726DB0-2C65-492A-AEF7-2E5BC88D2BD7}"/>
          </ac:spMkLst>
        </pc:spChg>
        <pc:spChg chg="add del mod">
          <ac:chgData name="Grace" userId="fd145552-a10d-4a31-a438-f8736fd84277" providerId="ADAL" clId="{56835480-2BB5-4545-A32E-6CA68AA69734}" dt="2021-09-01T23:17:14.032" v="2466" actId="478"/>
          <ac:spMkLst>
            <pc:docMk/>
            <pc:sldMk cId="187938002" sldId="3307"/>
            <ac:spMk id="165" creationId="{7B987A86-EFB6-47B7-A886-EAD22373630E}"/>
          </ac:spMkLst>
        </pc:spChg>
        <pc:spChg chg="add del mod">
          <ac:chgData name="Grace" userId="fd145552-a10d-4a31-a438-f8736fd84277" providerId="ADAL" clId="{56835480-2BB5-4545-A32E-6CA68AA69734}" dt="2021-09-01T23:17:14.353" v="2467" actId="478"/>
          <ac:spMkLst>
            <pc:docMk/>
            <pc:sldMk cId="187938002" sldId="3307"/>
            <ac:spMk id="166" creationId="{19A5E353-FA4B-47BF-8427-6B8DE251097F}"/>
          </ac:spMkLst>
        </pc:spChg>
        <pc:spChg chg="add del mod">
          <ac:chgData name="Grace" userId="fd145552-a10d-4a31-a438-f8736fd84277" providerId="ADAL" clId="{56835480-2BB5-4545-A32E-6CA68AA69734}" dt="2021-09-01T23:17:14.730" v="2468" actId="478"/>
          <ac:spMkLst>
            <pc:docMk/>
            <pc:sldMk cId="187938002" sldId="3307"/>
            <ac:spMk id="167" creationId="{02342C2A-BBB0-4E9A-A452-128F598BF648}"/>
          </ac:spMkLst>
        </pc:spChg>
        <pc:spChg chg="add del mod">
          <ac:chgData name="Grace" userId="fd145552-a10d-4a31-a438-f8736fd84277" providerId="ADAL" clId="{56835480-2BB5-4545-A32E-6CA68AA69734}" dt="2021-09-01T23:17:15.113" v="2469" actId="478"/>
          <ac:spMkLst>
            <pc:docMk/>
            <pc:sldMk cId="187938002" sldId="3307"/>
            <ac:spMk id="168" creationId="{80B8986A-D3BF-4B89-A30E-2E286DDDB1F7}"/>
          </ac:spMkLst>
        </pc:spChg>
        <pc:spChg chg="add del mod">
          <ac:chgData name="Grace" userId="fd145552-a10d-4a31-a438-f8736fd84277" providerId="ADAL" clId="{56835480-2BB5-4545-A32E-6CA68AA69734}" dt="2021-09-01T23:17:15.529" v="2470" actId="478"/>
          <ac:spMkLst>
            <pc:docMk/>
            <pc:sldMk cId="187938002" sldId="3307"/>
            <ac:spMk id="169" creationId="{44F1F2B5-FBD0-43DF-A53D-5839EDCAA20A}"/>
          </ac:spMkLst>
        </pc:spChg>
        <pc:spChg chg="add del mod">
          <ac:chgData name="Grace" userId="fd145552-a10d-4a31-a438-f8736fd84277" providerId="ADAL" clId="{56835480-2BB5-4545-A32E-6CA68AA69734}" dt="2021-09-01T23:17:16.234" v="2471" actId="478"/>
          <ac:spMkLst>
            <pc:docMk/>
            <pc:sldMk cId="187938002" sldId="3307"/>
            <ac:spMk id="170" creationId="{4CE00069-BED2-4274-B8C6-37DF0E8F0727}"/>
          </ac:spMkLst>
        </pc:spChg>
        <pc:spChg chg="add del mod">
          <ac:chgData name="Grace" userId="fd145552-a10d-4a31-a438-f8736fd84277" providerId="ADAL" clId="{56835480-2BB5-4545-A32E-6CA68AA69734}" dt="2021-09-01T23:17:16.545" v="2472" actId="478"/>
          <ac:spMkLst>
            <pc:docMk/>
            <pc:sldMk cId="187938002" sldId="3307"/>
            <ac:spMk id="171" creationId="{8D2FBD68-DA43-42F0-8BFC-F148B82803F2}"/>
          </ac:spMkLst>
        </pc:spChg>
        <pc:spChg chg="add del mod">
          <ac:chgData name="Grace" userId="fd145552-a10d-4a31-a438-f8736fd84277" providerId="ADAL" clId="{56835480-2BB5-4545-A32E-6CA68AA69734}" dt="2021-09-01T23:17:16.859" v="2473" actId="478"/>
          <ac:spMkLst>
            <pc:docMk/>
            <pc:sldMk cId="187938002" sldId="3307"/>
            <ac:spMk id="172" creationId="{B8BF3DB1-9769-4EA1-9536-F8BDBD047247}"/>
          </ac:spMkLst>
        </pc:spChg>
        <pc:spChg chg="add del mod">
          <ac:chgData name="Grace" userId="fd145552-a10d-4a31-a438-f8736fd84277" providerId="ADAL" clId="{56835480-2BB5-4545-A32E-6CA68AA69734}" dt="2021-09-01T23:17:17.276" v="2474" actId="478"/>
          <ac:spMkLst>
            <pc:docMk/>
            <pc:sldMk cId="187938002" sldId="3307"/>
            <ac:spMk id="173" creationId="{E0840017-F445-4F2B-8A0B-205673D45A78}"/>
          </ac:spMkLst>
        </pc:spChg>
        <pc:spChg chg="add mod">
          <ac:chgData name="Grace" userId="fd145552-a10d-4a31-a438-f8736fd84277" providerId="ADAL" clId="{56835480-2BB5-4545-A32E-6CA68AA69734}" dt="2021-09-01T23:19:06.042" v="2533" actId="1036"/>
          <ac:spMkLst>
            <pc:docMk/>
            <pc:sldMk cId="187938002" sldId="3307"/>
            <ac:spMk id="174" creationId="{712317E0-A6D2-404D-A1F4-2D883F388E56}"/>
          </ac:spMkLst>
        </pc:spChg>
        <pc:spChg chg="add mod">
          <ac:chgData name="Grace" userId="fd145552-a10d-4a31-a438-f8736fd84277" providerId="ADAL" clId="{56835480-2BB5-4545-A32E-6CA68AA69734}" dt="2021-09-01T23:19:06.042" v="2533" actId="1036"/>
          <ac:spMkLst>
            <pc:docMk/>
            <pc:sldMk cId="187938002" sldId="3307"/>
            <ac:spMk id="175" creationId="{54CC318E-92C2-4F45-9CB0-4287FE94A1EC}"/>
          </ac:spMkLst>
        </pc:spChg>
        <pc:spChg chg="add mod">
          <ac:chgData name="Grace" userId="fd145552-a10d-4a31-a438-f8736fd84277" providerId="ADAL" clId="{56835480-2BB5-4545-A32E-6CA68AA69734}" dt="2021-09-01T23:19:54.269" v="2540" actId="14100"/>
          <ac:spMkLst>
            <pc:docMk/>
            <pc:sldMk cId="187938002" sldId="3307"/>
            <ac:spMk id="176" creationId="{946FEA16-97EE-492B-A8AE-F2AB6D8C96AA}"/>
          </ac:spMkLst>
        </pc:spChg>
        <pc:spChg chg="add del mod">
          <ac:chgData name="Grace" userId="fd145552-a10d-4a31-a438-f8736fd84277" providerId="ADAL" clId="{56835480-2BB5-4545-A32E-6CA68AA69734}" dt="2021-09-01T23:19:57.023" v="2541" actId="478"/>
          <ac:spMkLst>
            <pc:docMk/>
            <pc:sldMk cId="187938002" sldId="3307"/>
            <ac:spMk id="177" creationId="{6999CF8B-8545-483F-90B7-541944886119}"/>
          </ac:spMkLst>
        </pc:spChg>
        <pc:spChg chg="add mod">
          <ac:chgData name="Grace" userId="fd145552-a10d-4a31-a438-f8736fd84277" providerId="ADAL" clId="{56835480-2BB5-4545-A32E-6CA68AA69734}" dt="2021-09-01T23:19:50.736" v="2539" actId="1076"/>
          <ac:spMkLst>
            <pc:docMk/>
            <pc:sldMk cId="187938002" sldId="3307"/>
            <ac:spMk id="178" creationId="{581B84B5-D0C4-49FC-BA7E-AE210B5B26BA}"/>
          </ac:spMkLst>
        </pc:spChg>
        <pc:spChg chg="add mod">
          <ac:chgData name="Grace" userId="fd145552-a10d-4a31-a438-f8736fd84277" providerId="ADAL" clId="{56835480-2BB5-4545-A32E-6CA68AA69734}" dt="2021-09-01T23:19:50.736" v="2539" actId="1076"/>
          <ac:spMkLst>
            <pc:docMk/>
            <pc:sldMk cId="187938002" sldId="3307"/>
            <ac:spMk id="179" creationId="{A30FC82F-D841-4BFF-982E-7659A7C67531}"/>
          </ac:spMkLst>
        </pc:spChg>
        <pc:graphicFrameChg chg="del mod">
          <ac:chgData name="Grace" userId="fd145552-a10d-4a31-a438-f8736fd84277" providerId="ADAL" clId="{56835480-2BB5-4545-A32E-6CA68AA69734}" dt="2021-09-01T23:20:04.070" v="2542" actId="478"/>
          <ac:graphicFrameMkLst>
            <pc:docMk/>
            <pc:sldMk cId="187938002" sldId="3307"/>
            <ac:graphicFrameMk id="18" creationId="{52FE741A-DBEC-4E45-A216-F00F2125BE90}"/>
          </ac:graphicFrameMkLst>
        </pc:graphicFrameChg>
        <pc:graphicFrameChg chg="del mod">
          <ac:chgData name="Grace" userId="fd145552-a10d-4a31-a438-f8736fd84277" providerId="ADAL" clId="{56835480-2BB5-4545-A32E-6CA68AA69734}" dt="2021-09-01T23:20:09.102" v="2550" actId="478"/>
          <ac:graphicFrameMkLst>
            <pc:docMk/>
            <pc:sldMk cId="187938002" sldId="3307"/>
            <ac:graphicFrameMk id="19" creationId="{68AA83EE-2B9C-5249-9F15-FCC7A54F3FD0}"/>
          </ac:graphicFrameMkLst>
        </pc:graphicFrameChg>
        <pc:graphicFrameChg chg="del mod">
          <ac:chgData name="Grace" userId="fd145552-a10d-4a31-a438-f8736fd84277" providerId="ADAL" clId="{56835480-2BB5-4545-A32E-6CA68AA69734}" dt="2021-09-01T23:20:11.335" v="2552" actId="478"/>
          <ac:graphicFrameMkLst>
            <pc:docMk/>
            <pc:sldMk cId="187938002" sldId="3307"/>
            <ac:graphicFrameMk id="26" creationId="{86CA88D4-A4F9-E44A-AF28-9A2E644574F8}"/>
          </ac:graphicFrameMkLst>
        </pc:graphicFrameChg>
      </pc:sldChg>
      <pc:sldChg chg="modSp add del mod">
        <pc:chgData name="Grace" userId="fd145552-a10d-4a31-a438-f8736fd84277" providerId="ADAL" clId="{56835480-2BB5-4545-A32E-6CA68AA69734}" dt="2021-09-01T23:20:22.541" v="2553" actId="47"/>
        <pc:sldMkLst>
          <pc:docMk/>
          <pc:sldMk cId="529958981" sldId="3308"/>
        </pc:sldMkLst>
        <pc:spChg chg="mod">
          <ac:chgData name="Grace" userId="fd145552-a10d-4a31-a438-f8736fd84277" providerId="ADAL" clId="{56835480-2BB5-4545-A32E-6CA68AA69734}" dt="2021-09-01T22:46:46.419" v="1098" actId="1076"/>
          <ac:spMkLst>
            <pc:docMk/>
            <pc:sldMk cId="529958981" sldId="3308"/>
            <ac:spMk id="10" creationId="{661B25D5-24C8-AC49-844B-8D377F7E60D4}"/>
          </ac:spMkLst>
        </pc:spChg>
      </pc:sldChg>
      <pc:sldChg chg="modSp add mod">
        <pc:chgData name="Grace" userId="fd145552-a10d-4a31-a438-f8736fd84277" providerId="ADAL" clId="{56835480-2BB5-4545-A32E-6CA68AA69734}" dt="2021-09-02T00:28:13.504" v="2887" actId="20577"/>
        <pc:sldMkLst>
          <pc:docMk/>
          <pc:sldMk cId="3729442319" sldId="3308"/>
        </pc:sldMkLst>
        <pc:spChg chg="mod">
          <ac:chgData name="Grace" userId="fd145552-a10d-4a31-a438-f8736fd84277" providerId="ADAL" clId="{56835480-2BB5-4545-A32E-6CA68AA69734}" dt="2021-09-01T23:21:27.907" v="2621" actId="20577"/>
          <ac:spMkLst>
            <pc:docMk/>
            <pc:sldMk cId="3729442319" sldId="3308"/>
            <ac:spMk id="3" creationId="{1C207EF0-D5F8-4C7D-9363-8246CDD5503A}"/>
          </ac:spMkLst>
        </pc:spChg>
        <pc:graphicFrameChg chg="mod modGraphic">
          <ac:chgData name="Grace" userId="fd145552-a10d-4a31-a438-f8736fd84277" providerId="ADAL" clId="{56835480-2BB5-4545-A32E-6CA68AA69734}" dt="2021-09-02T00:28:13.504" v="2887" actId="20577"/>
          <ac:graphicFrameMkLst>
            <pc:docMk/>
            <pc:sldMk cId="3729442319" sldId="3308"/>
            <ac:graphicFrameMk id="5" creationId="{1F6D69E8-098B-4675-AAE5-73A7D0391966}"/>
          </ac:graphicFrameMkLst>
        </pc:graphicFrameChg>
      </pc:sldChg>
      <pc:sldChg chg="delSp modSp add del mod">
        <pc:chgData name="Grace" userId="fd145552-a10d-4a31-a438-f8736fd84277" providerId="ADAL" clId="{56835480-2BB5-4545-A32E-6CA68AA69734}" dt="2021-09-02T00:31:03.704" v="2925" actId="47"/>
        <pc:sldMkLst>
          <pc:docMk/>
          <pc:sldMk cId="1589055540" sldId="3309"/>
        </pc:sldMkLst>
        <pc:spChg chg="mod">
          <ac:chgData name="Grace" userId="fd145552-a10d-4a31-a438-f8736fd84277" providerId="ADAL" clId="{56835480-2BB5-4545-A32E-6CA68AA69734}" dt="2021-09-02T00:28:33.088" v="2919" actId="20577"/>
          <ac:spMkLst>
            <pc:docMk/>
            <pc:sldMk cId="1589055540" sldId="3309"/>
            <ac:spMk id="3" creationId="{3F736E9F-099F-6E49-8413-5352C763CACD}"/>
          </ac:spMkLst>
        </pc:spChg>
        <pc:spChg chg="del">
          <ac:chgData name="Grace" userId="fd145552-a10d-4a31-a438-f8736fd84277" providerId="ADAL" clId="{56835480-2BB5-4545-A32E-6CA68AA69734}" dt="2021-09-02T00:28:35.295" v="2920" actId="478"/>
          <ac:spMkLst>
            <pc:docMk/>
            <pc:sldMk cId="1589055540" sldId="3309"/>
            <ac:spMk id="11" creationId="{53924CEB-4D7D-F241-8D0D-F765FB62291C}"/>
          </ac:spMkLst>
        </pc:spChg>
        <pc:spChg chg="del">
          <ac:chgData name="Grace" userId="fd145552-a10d-4a31-a438-f8736fd84277" providerId="ADAL" clId="{56835480-2BB5-4545-A32E-6CA68AA69734}" dt="2021-09-02T00:28:35.295" v="2920" actId="478"/>
          <ac:spMkLst>
            <pc:docMk/>
            <pc:sldMk cId="1589055540" sldId="3309"/>
            <ac:spMk id="12" creationId="{9F619023-99B5-D048-963C-2919297AAD8E}"/>
          </ac:spMkLst>
        </pc:spChg>
        <pc:spChg chg="del">
          <ac:chgData name="Grace" userId="fd145552-a10d-4a31-a438-f8736fd84277" providerId="ADAL" clId="{56835480-2BB5-4545-A32E-6CA68AA69734}" dt="2021-09-02T00:28:35.295" v="2920" actId="478"/>
          <ac:spMkLst>
            <pc:docMk/>
            <pc:sldMk cId="1589055540" sldId="3309"/>
            <ac:spMk id="14" creationId="{EE644C53-6D18-3B45-8ACC-5347164E1A9E}"/>
          </ac:spMkLst>
        </pc:spChg>
        <pc:spChg chg="del">
          <ac:chgData name="Grace" userId="fd145552-a10d-4a31-a438-f8736fd84277" providerId="ADAL" clId="{56835480-2BB5-4545-A32E-6CA68AA69734}" dt="2021-09-02T00:28:35.295" v="2920" actId="478"/>
          <ac:spMkLst>
            <pc:docMk/>
            <pc:sldMk cId="1589055540" sldId="3309"/>
            <ac:spMk id="45" creationId="{D5C3ED16-AD74-42CC-ABF5-155637BC7D6C}"/>
          </ac:spMkLst>
        </pc:spChg>
        <pc:spChg chg="del">
          <ac:chgData name="Grace" userId="fd145552-a10d-4a31-a438-f8736fd84277" providerId="ADAL" clId="{56835480-2BB5-4545-A32E-6CA68AA69734}" dt="2021-09-02T00:28:35.295" v="2920" actId="478"/>
          <ac:spMkLst>
            <pc:docMk/>
            <pc:sldMk cId="1589055540" sldId="3309"/>
            <ac:spMk id="48" creationId="{CE1789F8-D90A-417B-B724-1C8CC2CAB633}"/>
          </ac:spMkLst>
        </pc:spChg>
        <pc:spChg chg="del">
          <ac:chgData name="Grace" userId="fd145552-a10d-4a31-a438-f8736fd84277" providerId="ADAL" clId="{56835480-2BB5-4545-A32E-6CA68AA69734}" dt="2021-09-02T00:28:35.295" v="2920" actId="478"/>
          <ac:spMkLst>
            <pc:docMk/>
            <pc:sldMk cId="1589055540" sldId="3309"/>
            <ac:spMk id="52" creationId="{D3911288-5557-40BC-9242-7FB0F239B2D3}"/>
          </ac:spMkLst>
        </pc:spChg>
        <pc:spChg chg="del">
          <ac:chgData name="Grace" userId="fd145552-a10d-4a31-a438-f8736fd84277" providerId="ADAL" clId="{56835480-2BB5-4545-A32E-6CA68AA69734}" dt="2021-09-02T00:28:35.295" v="2920" actId="478"/>
          <ac:spMkLst>
            <pc:docMk/>
            <pc:sldMk cId="1589055540" sldId="3309"/>
            <ac:spMk id="53" creationId="{E2049701-CA4D-4E98-BAB8-A7EFF1DDA945}"/>
          </ac:spMkLst>
        </pc:spChg>
        <pc:spChg chg="del">
          <ac:chgData name="Grace" userId="fd145552-a10d-4a31-a438-f8736fd84277" providerId="ADAL" clId="{56835480-2BB5-4545-A32E-6CA68AA69734}" dt="2021-09-02T00:28:35.295" v="2920" actId="478"/>
          <ac:spMkLst>
            <pc:docMk/>
            <pc:sldMk cId="1589055540" sldId="3309"/>
            <ac:spMk id="54" creationId="{B2962D8F-D897-4E77-BEF6-A9EB62576127}"/>
          </ac:spMkLst>
        </pc:spChg>
        <pc:spChg chg="del">
          <ac:chgData name="Grace" userId="fd145552-a10d-4a31-a438-f8736fd84277" providerId="ADAL" clId="{56835480-2BB5-4545-A32E-6CA68AA69734}" dt="2021-09-02T00:28:35.295" v="2920" actId="478"/>
          <ac:spMkLst>
            <pc:docMk/>
            <pc:sldMk cId="1589055540" sldId="3309"/>
            <ac:spMk id="57" creationId="{FA2A4811-CACA-468B-8ADF-7842C0823E64}"/>
          </ac:spMkLst>
        </pc:spChg>
        <pc:spChg chg="del">
          <ac:chgData name="Grace" userId="fd145552-a10d-4a31-a438-f8736fd84277" providerId="ADAL" clId="{56835480-2BB5-4545-A32E-6CA68AA69734}" dt="2021-09-02T00:28:35.295" v="2920" actId="478"/>
          <ac:spMkLst>
            <pc:docMk/>
            <pc:sldMk cId="1589055540" sldId="3309"/>
            <ac:spMk id="63" creationId="{A6CF363A-5E67-471D-96A1-BB99C4BF1B28}"/>
          </ac:spMkLst>
        </pc:spChg>
        <pc:spChg chg="del">
          <ac:chgData name="Grace" userId="fd145552-a10d-4a31-a438-f8736fd84277" providerId="ADAL" clId="{56835480-2BB5-4545-A32E-6CA68AA69734}" dt="2021-09-02T00:28:35.295" v="2920" actId="478"/>
          <ac:spMkLst>
            <pc:docMk/>
            <pc:sldMk cId="1589055540" sldId="3309"/>
            <ac:spMk id="64" creationId="{BAC3AD93-4EBD-4BE0-8DE9-83249CB83F1C}"/>
          </ac:spMkLst>
        </pc:spChg>
        <pc:spChg chg="del">
          <ac:chgData name="Grace" userId="fd145552-a10d-4a31-a438-f8736fd84277" providerId="ADAL" clId="{56835480-2BB5-4545-A32E-6CA68AA69734}" dt="2021-09-02T00:28:35.295" v="2920" actId="478"/>
          <ac:spMkLst>
            <pc:docMk/>
            <pc:sldMk cId="1589055540" sldId="3309"/>
            <ac:spMk id="68" creationId="{24FDD7D9-55CB-4156-8D71-084078C8F69F}"/>
          </ac:spMkLst>
        </pc:spChg>
        <pc:spChg chg="del">
          <ac:chgData name="Grace" userId="fd145552-a10d-4a31-a438-f8736fd84277" providerId="ADAL" clId="{56835480-2BB5-4545-A32E-6CA68AA69734}" dt="2021-09-02T00:28:35.295" v="2920" actId="478"/>
          <ac:spMkLst>
            <pc:docMk/>
            <pc:sldMk cId="1589055540" sldId="3309"/>
            <ac:spMk id="71" creationId="{59A92EFB-C96C-4C2A-81C5-B077FA1A8546}"/>
          </ac:spMkLst>
        </pc:spChg>
        <pc:spChg chg="del">
          <ac:chgData name="Grace" userId="fd145552-a10d-4a31-a438-f8736fd84277" providerId="ADAL" clId="{56835480-2BB5-4545-A32E-6CA68AA69734}" dt="2021-09-02T00:28:35.295" v="2920" actId="478"/>
          <ac:spMkLst>
            <pc:docMk/>
            <pc:sldMk cId="1589055540" sldId="3309"/>
            <ac:spMk id="80" creationId="{85C8FBD3-427E-438E-8EEA-2643D9F29E92}"/>
          </ac:spMkLst>
        </pc:spChg>
        <pc:spChg chg="del">
          <ac:chgData name="Grace" userId="fd145552-a10d-4a31-a438-f8736fd84277" providerId="ADAL" clId="{56835480-2BB5-4545-A32E-6CA68AA69734}" dt="2021-09-02T00:28:35.295" v="2920" actId="478"/>
          <ac:spMkLst>
            <pc:docMk/>
            <pc:sldMk cId="1589055540" sldId="3309"/>
            <ac:spMk id="93" creationId="{BF9A3230-00EC-4629-977A-A8CCE79ACC91}"/>
          </ac:spMkLst>
        </pc:spChg>
        <pc:spChg chg="del">
          <ac:chgData name="Grace" userId="fd145552-a10d-4a31-a438-f8736fd84277" providerId="ADAL" clId="{56835480-2BB5-4545-A32E-6CA68AA69734}" dt="2021-09-02T00:28:35.295" v="2920" actId="478"/>
          <ac:spMkLst>
            <pc:docMk/>
            <pc:sldMk cId="1589055540" sldId="3309"/>
            <ac:spMk id="104" creationId="{F81F728A-F6E0-4035-B83C-178C94467706}"/>
          </ac:spMkLst>
        </pc:spChg>
        <pc:spChg chg="del">
          <ac:chgData name="Grace" userId="fd145552-a10d-4a31-a438-f8736fd84277" providerId="ADAL" clId="{56835480-2BB5-4545-A32E-6CA68AA69734}" dt="2021-09-02T00:28:35.295" v="2920" actId="478"/>
          <ac:spMkLst>
            <pc:docMk/>
            <pc:sldMk cId="1589055540" sldId="3309"/>
            <ac:spMk id="105" creationId="{46483DB8-79F9-4FBE-9B21-E97A274C2DEC}"/>
          </ac:spMkLst>
        </pc:spChg>
        <pc:spChg chg="del">
          <ac:chgData name="Grace" userId="fd145552-a10d-4a31-a438-f8736fd84277" providerId="ADAL" clId="{56835480-2BB5-4545-A32E-6CA68AA69734}" dt="2021-09-02T00:28:35.295" v="2920" actId="478"/>
          <ac:spMkLst>
            <pc:docMk/>
            <pc:sldMk cId="1589055540" sldId="3309"/>
            <ac:spMk id="106" creationId="{DDA53C12-4572-4125-91CB-0096DC97ACEE}"/>
          </ac:spMkLst>
        </pc:spChg>
        <pc:spChg chg="del">
          <ac:chgData name="Grace" userId="fd145552-a10d-4a31-a438-f8736fd84277" providerId="ADAL" clId="{56835480-2BB5-4545-A32E-6CA68AA69734}" dt="2021-09-02T00:28:35.295" v="2920" actId="478"/>
          <ac:spMkLst>
            <pc:docMk/>
            <pc:sldMk cId="1589055540" sldId="3309"/>
            <ac:spMk id="107" creationId="{548FE39C-1314-44EC-A0B3-37B35B05DB8B}"/>
          </ac:spMkLst>
        </pc:spChg>
        <pc:spChg chg="del">
          <ac:chgData name="Grace" userId="fd145552-a10d-4a31-a438-f8736fd84277" providerId="ADAL" clId="{56835480-2BB5-4545-A32E-6CA68AA69734}" dt="2021-09-02T00:28:35.295" v="2920" actId="478"/>
          <ac:spMkLst>
            <pc:docMk/>
            <pc:sldMk cId="1589055540" sldId="3309"/>
            <ac:spMk id="110" creationId="{DA178DCD-074A-482D-856E-184518C9F5C8}"/>
          </ac:spMkLst>
        </pc:spChg>
        <pc:spChg chg="del">
          <ac:chgData name="Grace" userId="fd145552-a10d-4a31-a438-f8736fd84277" providerId="ADAL" clId="{56835480-2BB5-4545-A32E-6CA68AA69734}" dt="2021-09-02T00:28:35.295" v="2920" actId="478"/>
          <ac:spMkLst>
            <pc:docMk/>
            <pc:sldMk cId="1589055540" sldId="3309"/>
            <ac:spMk id="111" creationId="{1793323B-16EA-4D26-913D-D89B75512963}"/>
          </ac:spMkLst>
        </pc:spChg>
        <pc:spChg chg="del">
          <ac:chgData name="Grace" userId="fd145552-a10d-4a31-a438-f8736fd84277" providerId="ADAL" clId="{56835480-2BB5-4545-A32E-6CA68AA69734}" dt="2021-09-02T00:28:35.295" v="2920" actId="478"/>
          <ac:spMkLst>
            <pc:docMk/>
            <pc:sldMk cId="1589055540" sldId="3309"/>
            <ac:spMk id="130" creationId="{A1937A8D-739D-47D2-8F3B-5D3DEEC0CBFE}"/>
          </ac:spMkLst>
        </pc:spChg>
        <pc:spChg chg="del">
          <ac:chgData name="Grace" userId="fd145552-a10d-4a31-a438-f8736fd84277" providerId="ADAL" clId="{56835480-2BB5-4545-A32E-6CA68AA69734}" dt="2021-09-02T00:28:35.295" v="2920" actId="478"/>
          <ac:spMkLst>
            <pc:docMk/>
            <pc:sldMk cId="1589055540" sldId="3309"/>
            <ac:spMk id="131" creationId="{50DF1E82-6ACA-4B66-B7D6-9690E79414D5}"/>
          </ac:spMkLst>
        </pc:spChg>
        <pc:spChg chg="del">
          <ac:chgData name="Grace" userId="fd145552-a10d-4a31-a438-f8736fd84277" providerId="ADAL" clId="{56835480-2BB5-4545-A32E-6CA68AA69734}" dt="2021-09-02T00:28:35.295" v="2920" actId="478"/>
          <ac:spMkLst>
            <pc:docMk/>
            <pc:sldMk cId="1589055540" sldId="3309"/>
            <ac:spMk id="140" creationId="{2993D3FC-7E1C-4B15-8C2F-13E3FDEE4739}"/>
          </ac:spMkLst>
        </pc:spChg>
        <pc:spChg chg="del">
          <ac:chgData name="Grace" userId="fd145552-a10d-4a31-a438-f8736fd84277" providerId="ADAL" clId="{56835480-2BB5-4545-A32E-6CA68AA69734}" dt="2021-09-02T00:28:35.295" v="2920" actId="478"/>
          <ac:spMkLst>
            <pc:docMk/>
            <pc:sldMk cId="1589055540" sldId="3309"/>
            <ac:spMk id="141" creationId="{E9E75851-735E-46B4-8F8D-910677E15ED0}"/>
          </ac:spMkLst>
        </pc:spChg>
        <pc:spChg chg="del">
          <ac:chgData name="Grace" userId="fd145552-a10d-4a31-a438-f8736fd84277" providerId="ADAL" clId="{56835480-2BB5-4545-A32E-6CA68AA69734}" dt="2021-09-02T00:28:35.295" v="2920" actId="478"/>
          <ac:spMkLst>
            <pc:docMk/>
            <pc:sldMk cId="1589055540" sldId="3309"/>
            <ac:spMk id="174" creationId="{712317E0-A6D2-404D-A1F4-2D883F388E56}"/>
          </ac:spMkLst>
        </pc:spChg>
        <pc:spChg chg="del">
          <ac:chgData name="Grace" userId="fd145552-a10d-4a31-a438-f8736fd84277" providerId="ADAL" clId="{56835480-2BB5-4545-A32E-6CA68AA69734}" dt="2021-09-02T00:28:35.295" v="2920" actId="478"/>
          <ac:spMkLst>
            <pc:docMk/>
            <pc:sldMk cId="1589055540" sldId="3309"/>
            <ac:spMk id="175" creationId="{54CC318E-92C2-4F45-9CB0-4287FE94A1EC}"/>
          </ac:spMkLst>
        </pc:spChg>
        <pc:spChg chg="del">
          <ac:chgData name="Grace" userId="fd145552-a10d-4a31-a438-f8736fd84277" providerId="ADAL" clId="{56835480-2BB5-4545-A32E-6CA68AA69734}" dt="2021-09-02T00:28:35.295" v="2920" actId="478"/>
          <ac:spMkLst>
            <pc:docMk/>
            <pc:sldMk cId="1589055540" sldId="3309"/>
            <ac:spMk id="176" creationId="{946FEA16-97EE-492B-A8AE-F2AB6D8C96AA}"/>
          </ac:spMkLst>
        </pc:spChg>
        <pc:spChg chg="del">
          <ac:chgData name="Grace" userId="fd145552-a10d-4a31-a438-f8736fd84277" providerId="ADAL" clId="{56835480-2BB5-4545-A32E-6CA68AA69734}" dt="2021-09-02T00:28:35.295" v="2920" actId="478"/>
          <ac:spMkLst>
            <pc:docMk/>
            <pc:sldMk cId="1589055540" sldId="3309"/>
            <ac:spMk id="178" creationId="{581B84B5-D0C4-49FC-BA7E-AE210B5B26BA}"/>
          </ac:spMkLst>
        </pc:spChg>
        <pc:spChg chg="del">
          <ac:chgData name="Grace" userId="fd145552-a10d-4a31-a438-f8736fd84277" providerId="ADAL" clId="{56835480-2BB5-4545-A32E-6CA68AA69734}" dt="2021-09-02T00:28:35.295" v="2920" actId="478"/>
          <ac:spMkLst>
            <pc:docMk/>
            <pc:sldMk cId="1589055540" sldId="3309"/>
            <ac:spMk id="179" creationId="{A30FC82F-D841-4BFF-982E-7659A7C67531}"/>
          </ac:spMkLst>
        </pc:spChg>
      </pc:sldChg>
      <pc:sldChg chg="add del">
        <pc:chgData name="Grace" userId="fd145552-a10d-4a31-a438-f8736fd84277" providerId="ADAL" clId="{56835480-2BB5-4545-A32E-6CA68AA69734}" dt="2021-09-02T00:30:57.174" v="2923"/>
        <pc:sldMkLst>
          <pc:docMk/>
          <pc:sldMk cId="1000259476" sldId="3310"/>
        </pc:sldMkLst>
      </pc:sldChg>
      <pc:sldChg chg="del">
        <pc:chgData name="Grace" userId="fd145552-a10d-4a31-a438-f8736fd84277" providerId="ADAL" clId="{56835480-2BB5-4545-A32E-6CA68AA69734}" dt="2021-09-02T00:30:53.965" v="2921"/>
        <pc:sldMkLst>
          <pc:docMk/>
          <pc:sldMk cId="3216068765" sldId="3310"/>
        </pc:sldMkLst>
      </pc:sldChg>
      <pc:sldChg chg="addSp delSp modSp del">
        <pc:chgData name="Grace" userId="fd145552-a10d-4a31-a438-f8736fd84277" providerId="ADAL" clId="{56835480-2BB5-4545-A32E-6CA68AA69734}" dt="2021-09-01T23:20:25.511" v="2554" actId="47"/>
        <pc:sldMkLst>
          <pc:docMk/>
          <pc:sldMk cId="3504637971" sldId="3311"/>
        </pc:sldMkLst>
        <pc:spChg chg="add del mod">
          <ac:chgData name="Grace" userId="fd145552-a10d-4a31-a438-f8736fd84277" providerId="ADAL" clId="{56835480-2BB5-4545-A32E-6CA68AA69734}" dt="2021-09-01T22:52:43.430" v="1126"/>
          <ac:spMkLst>
            <pc:docMk/>
            <pc:sldMk cId="3504637971" sldId="3311"/>
            <ac:spMk id="56" creationId="{FE0BE28C-E1E9-4C52-B8DE-CD4607D841E5}"/>
          </ac:spMkLst>
        </pc:spChg>
        <pc:spChg chg="add mod">
          <ac:chgData name="Grace" userId="fd145552-a10d-4a31-a438-f8736fd84277" providerId="ADAL" clId="{56835480-2BB5-4545-A32E-6CA68AA69734}" dt="2021-09-01T22:54:03.173" v="1213" actId="571"/>
          <ac:spMkLst>
            <pc:docMk/>
            <pc:sldMk cId="3504637971" sldId="3311"/>
            <ac:spMk id="57" creationId="{C2E18C6E-757D-4A64-B9EC-A837D5672D37}"/>
          </ac:spMkLst>
        </pc:spChg>
        <pc:spChg chg="add mod">
          <ac:chgData name="Grace" userId="fd145552-a10d-4a31-a438-f8736fd84277" providerId="ADAL" clId="{56835480-2BB5-4545-A32E-6CA68AA69734}" dt="2021-09-01T22:54:03.173" v="1213" actId="571"/>
          <ac:spMkLst>
            <pc:docMk/>
            <pc:sldMk cId="3504637971" sldId="3311"/>
            <ac:spMk id="58" creationId="{BFA0AE51-0EED-4621-862C-1EC6151455C8}"/>
          </ac:spMkLst>
        </pc:spChg>
        <pc:spChg chg="add mod">
          <ac:chgData name="Grace" userId="fd145552-a10d-4a31-a438-f8736fd84277" providerId="ADAL" clId="{56835480-2BB5-4545-A32E-6CA68AA69734}" dt="2021-09-01T22:54:03.173" v="1213" actId="571"/>
          <ac:spMkLst>
            <pc:docMk/>
            <pc:sldMk cId="3504637971" sldId="3311"/>
            <ac:spMk id="59" creationId="{C0BFCDA1-226C-4FD8-B396-63E03DCBA031}"/>
          </ac:spMkLst>
        </pc:spChg>
        <pc:spChg chg="add mod">
          <ac:chgData name="Grace" userId="fd145552-a10d-4a31-a438-f8736fd84277" providerId="ADAL" clId="{56835480-2BB5-4545-A32E-6CA68AA69734}" dt="2021-09-01T22:54:03.173" v="1213" actId="571"/>
          <ac:spMkLst>
            <pc:docMk/>
            <pc:sldMk cId="3504637971" sldId="3311"/>
            <ac:spMk id="60" creationId="{2917C497-ADA5-412E-AE4B-68DA3F3A1915}"/>
          </ac:spMkLst>
        </pc:spChg>
        <pc:spChg chg="add mod">
          <ac:chgData name="Grace" userId="fd145552-a10d-4a31-a438-f8736fd84277" providerId="ADAL" clId="{56835480-2BB5-4545-A32E-6CA68AA69734}" dt="2021-09-01T22:54:03.173" v="1213" actId="571"/>
          <ac:spMkLst>
            <pc:docMk/>
            <pc:sldMk cId="3504637971" sldId="3311"/>
            <ac:spMk id="61" creationId="{59667B0E-4711-4FE5-BF9B-5EC6DAFCCA88}"/>
          </ac:spMkLst>
        </pc:spChg>
      </pc:sldChg>
      <pc:sldChg chg="addSp delSp modSp add mod">
        <pc:chgData name="Grace" userId="fd145552-a10d-4a31-a438-f8736fd84277" providerId="ADAL" clId="{56835480-2BB5-4545-A32E-6CA68AA69734}" dt="2021-09-02T01:41:54.462" v="4399" actId="20577"/>
        <pc:sldMkLst>
          <pc:docMk/>
          <pc:sldMk cId="55687339" sldId="4099"/>
        </pc:sldMkLst>
        <pc:spChg chg="mod">
          <ac:chgData name="Grace" userId="fd145552-a10d-4a31-a438-f8736fd84277" providerId="ADAL" clId="{56835480-2BB5-4545-A32E-6CA68AA69734}" dt="2021-09-02T00:33:10.792" v="3074" actId="1076"/>
          <ac:spMkLst>
            <pc:docMk/>
            <pc:sldMk cId="55687339" sldId="4099"/>
            <ac:spMk id="4" creationId="{73BACEFA-6F9D-4B4F-ADFB-4CE9355D085F}"/>
          </ac:spMkLst>
        </pc:spChg>
        <pc:spChg chg="mod">
          <ac:chgData name="Grace" userId="fd145552-a10d-4a31-a438-f8736fd84277" providerId="ADAL" clId="{56835480-2BB5-4545-A32E-6CA68AA69734}" dt="2021-09-02T01:38:28.995" v="4225" actId="20577"/>
          <ac:spMkLst>
            <pc:docMk/>
            <pc:sldMk cId="55687339" sldId="4099"/>
            <ac:spMk id="5" creationId="{0872CD3F-DC76-DA4C-A445-20BB3CC44BE5}"/>
          </ac:spMkLst>
        </pc:spChg>
        <pc:spChg chg="del mod">
          <ac:chgData name="Grace" userId="fd145552-a10d-4a31-a438-f8736fd84277" providerId="ADAL" clId="{56835480-2BB5-4545-A32E-6CA68AA69734}" dt="2021-09-02T00:32:41.608" v="3070" actId="478"/>
          <ac:spMkLst>
            <pc:docMk/>
            <pc:sldMk cId="55687339" sldId="4099"/>
            <ac:spMk id="6" creationId="{DC67B04E-F9AC-8740-8181-6518D8649372}"/>
          </ac:spMkLst>
        </pc:spChg>
        <pc:spChg chg="mod">
          <ac:chgData name="Grace" userId="fd145552-a10d-4a31-a438-f8736fd84277" providerId="ADAL" clId="{56835480-2BB5-4545-A32E-6CA68AA69734}" dt="2021-09-02T00:52:20.150" v="3724" actId="20577"/>
          <ac:spMkLst>
            <pc:docMk/>
            <pc:sldMk cId="55687339" sldId="4099"/>
            <ac:spMk id="7" creationId="{F489E4A2-8294-ED48-A0E3-25779C0A6D57}"/>
          </ac:spMkLst>
        </pc:spChg>
        <pc:spChg chg="mod">
          <ac:chgData name="Grace" userId="fd145552-a10d-4a31-a438-f8736fd84277" providerId="ADAL" clId="{56835480-2BB5-4545-A32E-6CA68AA69734}" dt="2021-09-02T01:41:54.462" v="4399" actId="20577"/>
          <ac:spMkLst>
            <pc:docMk/>
            <pc:sldMk cId="55687339" sldId="4099"/>
            <ac:spMk id="8" creationId="{3EA74568-F3FA-5242-B6D8-A9DFA74F07F4}"/>
          </ac:spMkLst>
        </pc:spChg>
        <pc:spChg chg="del mod">
          <ac:chgData name="Grace" userId="fd145552-a10d-4a31-a438-f8736fd84277" providerId="ADAL" clId="{56835480-2BB5-4545-A32E-6CA68AA69734}" dt="2021-09-02T00:47:49.194" v="3328" actId="478"/>
          <ac:spMkLst>
            <pc:docMk/>
            <pc:sldMk cId="55687339" sldId="4099"/>
            <ac:spMk id="9" creationId="{D9DB2374-2E88-B64B-AABC-3FFA178DEAA4}"/>
          </ac:spMkLst>
        </pc:spChg>
        <pc:spChg chg="del mod">
          <ac:chgData name="Grace" userId="fd145552-a10d-4a31-a438-f8736fd84277" providerId="ADAL" clId="{56835480-2BB5-4545-A32E-6CA68AA69734}" dt="2021-09-02T00:47:50.242" v="3329" actId="478"/>
          <ac:spMkLst>
            <pc:docMk/>
            <pc:sldMk cId="55687339" sldId="4099"/>
            <ac:spMk id="10" creationId="{F840C3D1-358F-664D-9BB3-2042F3C8584A}"/>
          </ac:spMkLst>
        </pc:spChg>
        <pc:spChg chg="del mod">
          <ac:chgData name="Grace" userId="fd145552-a10d-4a31-a438-f8736fd84277" providerId="ADAL" clId="{56835480-2BB5-4545-A32E-6CA68AA69734}" dt="2021-09-02T00:32:43.438" v="3071" actId="478"/>
          <ac:spMkLst>
            <pc:docMk/>
            <pc:sldMk cId="55687339" sldId="4099"/>
            <ac:spMk id="11" creationId="{3BB0F8B1-A17D-5847-810E-8671ECB0B028}"/>
          </ac:spMkLst>
        </pc:spChg>
        <pc:spChg chg="mod">
          <ac:chgData name="Grace" userId="fd145552-a10d-4a31-a438-f8736fd84277" providerId="ADAL" clId="{56835480-2BB5-4545-A32E-6CA68AA69734}" dt="2021-09-02T00:53:07.191" v="3747" actId="1076"/>
          <ac:spMkLst>
            <pc:docMk/>
            <pc:sldMk cId="55687339" sldId="4099"/>
            <ac:spMk id="12" creationId="{FE2C0543-0B10-6A4E-A802-9BB47BE17EC6}"/>
          </ac:spMkLst>
        </pc:spChg>
        <pc:spChg chg="del mod">
          <ac:chgData name="Grace" userId="fd145552-a10d-4a31-a438-f8736fd84277" providerId="ADAL" clId="{56835480-2BB5-4545-A32E-6CA68AA69734}" dt="2021-09-02T00:52:45.042" v="3740" actId="478"/>
          <ac:spMkLst>
            <pc:docMk/>
            <pc:sldMk cId="55687339" sldId="4099"/>
            <ac:spMk id="13" creationId="{E7A1F027-EEAA-E543-AEC2-1029FA5DF444}"/>
          </ac:spMkLst>
        </pc:spChg>
        <pc:spChg chg="del mod">
          <ac:chgData name="Grace" userId="fd145552-a10d-4a31-a438-f8736fd84277" providerId="ADAL" clId="{56835480-2BB5-4545-A32E-6CA68AA69734}" dt="2021-09-02T00:52:46.011" v="3741" actId="478"/>
          <ac:spMkLst>
            <pc:docMk/>
            <pc:sldMk cId="55687339" sldId="4099"/>
            <ac:spMk id="14" creationId="{8E9DA7E1-24B7-9C44-AAC2-29486945DBD8}"/>
          </ac:spMkLst>
        </pc:spChg>
        <pc:spChg chg="del mod">
          <ac:chgData name="Grace" userId="fd145552-a10d-4a31-a438-f8736fd84277" providerId="ADAL" clId="{56835480-2BB5-4545-A32E-6CA68AA69734}" dt="2021-09-02T00:52:46.908" v="3742" actId="478"/>
          <ac:spMkLst>
            <pc:docMk/>
            <pc:sldMk cId="55687339" sldId="4099"/>
            <ac:spMk id="15" creationId="{18AE4303-D0F7-9D4F-B98C-1E7AD52F5735}"/>
          </ac:spMkLst>
        </pc:spChg>
        <pc:spChg chg="add del mod">
          <ac:chgData name="Grace" userId="fd145552-a10d-4a31-a438-f8736fd84277" providerId="ADAL" clId="{56835480-2BB5-4545-A32E-6CA68AA69734}" dt="2021-09-02T00:47:48.045" v="3327" actId="478"/>
          <ac:spMkLst>
            <pc:docMk/>
            <pc:sldMk cId="55687339" sldId="4099"/>
            <ac:spMk id="16" creationId="{87F0BD83-C1CE-E64D-8D99-249D9C49E7BB}"/>
          </ac:spMkLst>
        </pc:spChg>
        <pc:spChg chg="mod">
          <ac:chgData name="Grace" userId="fd145552-a10d-4a31-a438-f8736fd84277" providerId="ADAL" clId="{56835480-2BB5-4545-A32E-6CA68AA69734}" dt="2021-09-02T01:29:09.548" v="4104" actId="1076"/>
          <ac:spMkLst>
            <pc:docMk/>
            <pc:sldMk cId="55687339" sldId="4099"/>
            <ac:spMk id="17" creationId="{CDF2A577-08CB-D346-9624-BD9D12C127DC}"/>
          </ac:spMkLst>
        </pc:spChg>
        <pc:spChg chg="add del mod">
          <ac:chgData name="Grace" userId="fd145552-a10d-4a31-a438-f8736fd84277" providerId="ADAL" clId="{56835480-2BB5-4545-A32E-6CA68AA69734}" dt="2021-09-02T00:37:39.850" v="3091" actId="21"/>
          <ac:spMkLst>
            <pc:docMk/>
            <pc:sldMk cId="55687339" sldId="4099"/>
            <ac:spMk id="18" creationId="{467894DC-5BD0-324D-9188-32E3ADED6CBA}"/>
          </ac:spMkLst>
        </pc:spChg>
        <pc:spChg chg="mod">
          <ac:chgData name="Grace" userId="fd145552-a10d-4a31-a438-f8736fd84277" providerId="ADAL" clId="{56835480-2BB5-4545-A32E-6CA68AA69734}" dt="2021-09-02T00:32:58.550" v="3072" actId="1076"/>
          <ac:spMkLst>
            <pc:docMk/>
            <pc:sldMk cId="55687339" sldId="4099"/>
            <ac:spMk id="19" creationId="{0AA73366-3A09-C04C-955C-E0EEFD6745A5}"/>
          </ac:spMkLst>
        </pc:spChg>
        <pc:spChg chg="mod">
          <ac:chgData name="Grace" userId="fd145552-a10d-4a31-a438-f8736fd84277" providerId="ADAL" clId="{56835480-2BB5-4545-A32E-6CA68AA69734}" dt="2021-09-02T00:32:58.550" v="3072" actId="1076"/>
          <ac:spMkLst>
            <pc:docMk/>
            <pc:sldMk cId="55687339" sldId="4099"/>
            <ac:spMk id="20" creationId="{1214E44B-7C5A-5E4D-9A78-2DA89479E32A}"/>
          </ac:spMkLst>
        </pc:spChg>
        <pc:spChg chg="mod">
          <ac:chgData name="Grace" userId="fd145552-a10d-4a31-a438-f8736fd84277" providerId="ADAL" clId="{56835480-2BB5-4545-A32E-6CA68AA69734}" dt="2021-09-02T00:32:58.550" v="3072" actId="1076"/>
          <ac:spMkLst>
            <pc:docMk/>
            <pc:sldMk cId="55687339" sldId="4099"/>
            <ac:spMk id="21" creationId="{FB4E85F6-620E-E742-B060-4AD19D91DC29}"/>
          </ac:spMkLst>
        </pc:spChg>
        <pc:spChg chg="mod">
          <ac:chgData name="Grace" userId="fd145552-a10d-4a31-a438-f8736fd84277" providerId="ADAL" clId="{56835480-2BB5-4545-A32E-6CA68AA69734}" dt="2021-09-02T00:32:58.550" v="3072" actId="1076"/>
          <ac:spMkLst>
            <pc:docMk/>
            <pc:sldMk cId="55687339" sldId="4099"/>
            <ac:spMk id="22" creationId="{AB19A81D-A07C-5F4A-86C9-3547A6AF0398}"/>
          </ac:spMkLst>
        </pc:spChg>
        <pc:spChg chg="del mod">
          <ac:chgData name="Grace" userId="fd145552-a10d-4a31-a438-f8736fd84277" providerId="ADAL" clId="{56835480-2BB5-4545-A32E-6CA68AA69734}" dt="2021-09-02T00:37:25.680" v="3075" actId="478"/>
          <ac:spMkLst>
            <pc:docMk/>
            <pc:sldMk cId="55687339" sldId="4099"/>
            <ac:spMk id="23" creationId="{0E95A1BC-D4E8-E341-A008-81479CD37FEC}"/>
          </ac:spMkLst>
        </pc:spChg>
        <pc:spChg chg="del mod">
          <ac:chgData name="Grace" userId="fd145552-a10d-4a31-a438-f8736fd84277" providerId="ADAL" clId="{56835480-2BB5-4545-A32E-6CA68AA69734}" dt="2021-09-02T00:37:36.924" v="3087" actId="478"/>
          <ac:spMkLst>
            <pc:docMk/>
            <pc:sldMk cId="55687339" sldId="4099"/>
            <ac:spMk id="24" creationId="{C8FBE384-2B60-6B48-81B6-AD87CB73288D}"/>
          </ac:spMkLst>
        </pc:spChg>
        <pc:spChg chg="del mod">
          <ac:chgData name="Grace" userId="fd145552-a10d-4a31-a438-f8736fd84277" providerId="ADAL" clId="{56835480-2BB5-4545-A32E-6CA68AA69734}" dt="2021-09-02T00:37:41.564" v="3092" actId="478"/>
          <ac:spMkLst>
            <pc:docMk/>
            <pc:sldMk cId="55687339" sldId="4099"/>
            <ac:spMk id="25" creationId="{97204F98-4ED4-1645-976B-C65DE5FB8B03}"/>
          </ac:spMkLst>
        </pc:spChg>
        <pc:spChg chg="del mod">
          <ac:chgData name="Grace" userId="fd145552-a10d-4a31-a438-f8736fd84277" providerId="ADAL" clId="{56835480-2BB5-4545-A32E-6CA68AA69734}" dt="2021-09-02T00:37:42.803" v="3094" actId="478"/>
          <ac:spMkLst>
            <pc:docMk/>
            <pc:sldMk cId="55687339" sldId="4099"/>
            <ac:spMk id="26" creationId="{374185C6-C86B-3549-8EF2-3FAE827BFBC6}"/>
          </ac:spMkLst>
        </pc:spChg>
        <pc:spChg chg="del mod">
          <ac:chgData name="Grace" userId="fd145552-a10d-4a31-a438-f8736fd84277" providerId="ADAL" clId="{56835480-2BB5-4545-A32E-6CA68AA69734}" dt="2021-09-02T00:37:31.031" v="3080" actId="478"/>
          <ac:spMkLst>
            <pc:docMk/>
            <pc:sldMk cId="55687339" sldId="4099"/>
            <ac:spMk id="27" creationId="{AF296C05-0D4C-2A4A-A977-E5620BD1C6E1}"/>
          </ac:spMkLst>
        </pc:spChg>
        <pc:spChg chg="del mod">
          <ac:chgData name="Grace" userId="fd145552-a10d-4a31-a438-f8736fd84277" providerId="ADAL" clId="{56835480-2BB5-4545-A32E-6CA68AA69734}" dt="2021-09-02T00:37:29.346" v="3078" actId="478"/>
          <ac:spMkLst>
            <pc:docMk/>
            <pc:sldMk cId="55687339" sldId="4099"/>
            <ac:spMk id="28" creationId="{C250585B-00BB-E947-BB72-5B73E5A65BE8}"/>
          </ac:spMkLst>
        </pc:spChg>
        <pc:spChg chg="del mod">
          <ac:chgData name="Grace" userId="fd145552-a10d-4a31-a438-f8736fd84277" providerId="ADAL" clId="{56835480-2BB5-4545-A32E-6CA68AA69734}" dt="2021-09-02T00:37:33.443" v="3083" actId="478"/>
          <ac:spMkLst>
            <pc:docMk/>
            <pc:sldMk cId="55687339" sldId="4099"/>
            <ac:spMk id="29" creationId="{87450E1B-73DC-1440-8799-89E8AAEE8C7B}"/>
          </ac:spMkLst>
        </pc:spChg>
        <pc:spChg chg="del mod">
          <ac:chgData name="Grace" userId="fd145552-a10d-4a31-a438-f8736fd84277" providerId="ADAL" clId="{56835480-2BB5-4545-A32E-6CA68AA69734}" dt="2021-09-02T00:37:34.357" v="3085" actId="478"/>
          <ac:spMkLst>
            <pc:docMk/>
            <pc:sldMk cId="55687339" sldId="4099"/>
            <ac:spMk id="30" creationId="{78476F29-5721-7F4F-B8E2-1B0571214847}"/>
          </ac:spMkLst>
        </pc:spChg>
        <pc:spChg chg="del mod">
          <ac:chgData name="Grace" userId="fd145552-a10d-4a31-a438-f8736fd84277" providerId="ADAL" clId="{56835480-2BB5-4545-A32E-6CA68AA69734}" dt="2021-09-02T00:37:36.012" v="3086" actId="478"/>
          <ac:spMkLst>
            <pc:docMk/>
            <pc:sldMk cId="55687339" sldId="4099"/>
            <ac:spMk id="31" creationId="{975D9C2F-938F-A24B-B6E5-AD8ECAB1A3FD}"/>
          </ac:spMkLst>
        </pc:spChg>
        <pc:spChg chg="del mod">
          <ac:chgData name="Grace" userId="fd145552-a10d-4a31-a438-f8736fd84277" providerId="ADAL" clId="{56835480-2BB5-4545-A32E-6CA68AA69734}" dt="2021-09-02T00:37:26.654" v="3077" actId="478"/>
          <ac:spMkLst>
            <pc:docMk/>
            <pc:sldMk cId="55687339" sldId="4099"/>
            <ac:spMk id="32" creationId="{AA69217F-55A4-8D41-9946-37FA1EEB980D}"/>
          </ac:spMkLst>
        </pc:spChg>
        <pc:spChg chg="del mod">
          <ac:chgData name="Grace" userId="fd145552-a10d-4a31-a438-f8736fd84277" providerId="ADAL" clId="{56835480-2BB5-4545-A32E-6CA68AA69734}" dt="2021-09-02T00:37:33.971" v="3084" actId="478"/>
          <ac:spMkLst>
            <pc:docMk/>
            <pc:sldMk cId="55687339" sldId="4099"/>
            <ac:spMk id="33" creationId="{39124568-06AA-6042-AE88-0C0B313DAC58}"/>
          </ac:spMkLst>
        </pc:spChg>
        <pc:spChg chg="del mod">
          <ac:chgData name="Grace" userId="fd145552-a10d-4a31-a438-f8736fd84277" providerId="ADAL" clId="{56835480-2BB5-4545-A32E-6CA68AA69734}" dt="2021-09-02T00:37:30.083" v="3079" actId="478"/>
          <ac:spMkLst>
            <pc:docMk/>
            <pc:sldMk cId="55687339" sldId="4099"/>
            <ac:spMk id="34" creationId="{BE03793E-90CF-A943-81CE-EF3BFDE028A8}"/>
          </ac:spMkLst>
        </pc:spChg>
        <pc:spChg chg="del mod">
          <ac:chgData name="Grace" userId="fd145552-a10d-4a31-a438-f8736fd84277" providerId="ADAL" clId="{56835480-2BB5-4545-A32E-6CA68AA69734}" dt="2021-09-02T00:37:32.048" v="3081" actId="478"/>
          <ac:spMkLst>
            <pc:docMk/>
            <pc:sldMk cId="55687339" sldId="4099"/>
            <ac:spMk id="35" creationId="{B8ADAC84-AE43-CA47-AAA1-2072C33B7FAE}"/>
          </ac:spMkLst>
        </pc:spChg>
        <pc:spChg chg="del mod">
          <ac:chgData name="Grace" userId="fd145552-a10d-4a31-a438-f8736fd84277" providerId="ADAL" clId="{56835480-2BB5-4545-A32E-6CA68AA69734}" dt="2021-09-02T00:37:32.791" v="3082" actId="478"/>
          <ac:spMkLst>
            <pc:docMk/>
            <pc:sldMk cId="55687339" sldId="4099"/>
            <ac:spMk id="36" creationId="{232E4F5D-192B-FD44-BFF0-E1E2245FA4D5}"/>
          </ac:spMkLst>
        </pc:spChg>
        <pc:spChg chg="del mod">
          <ac:chgData name="Grace" userId="fd145552-a10d-4a31-a438-f8736fd84277" providerId="ADAL" clId="{56835480-2BB5-4545-A32E-6CA68AA69734}" dt="2021-09-02T00:37:26.251" v="3076" actId="478"/>
          <ac:spMkLst>
            <pc:docMk/>
            <pc:sldMk cId="55687339" sldId="4099"/>
            <ac:spMk id="37" creationId="{EF17DBCD-0561-B14F-8CAA-C4E0E168F1AD}"/>
          </ac:spMkLst>
        </pc:spChg>
        <pc:spChg chg="add del mod">
          <ac:chgData name="Grace" userId="fd145552-a10d-4a31-a438-f8736fd84277" providerId="ADAL" clId="{56835480-2BB5-4545-A32E-6CA68AA69734}" dt="2021-09-02T00:50:38.182" v="3700" actId="478"/>
          <ac:spMkLst>
            <pc:docMk/>
            <pc:sldMk cId="55687339" sldId="4099"/>
            <ac:spMk id="38" creationId="{B90204AC-A9AD-1447-B051-28839B6AD01A}"/>
          </ac:spMkLst>
        </pc:spChg>
        <pc:spChg chg="add del mod">
          <ac:chgData name="Grace" userId="fd145552-a10d-4a31-a438-f8736fd84277" providerId="ADAL" clId="{56835480-2BB5-4545-A32E-6CA68AA69734}" dt="2021-09-02T00:50:38.863" v="3701" actId="478"/>
          <ac:spMkLst>
            <pc:docMk/>
            <pc:sldMk cId="55687339" sldId="4099"/>
            <ac:spMk id="39" creationId="{7C9657CF-FFB3-2343-9F6D-126A8F8412CC}"/>
          </ac:spMkLst>
        </pc:spChg>
        <pc:spChg chg="add del mod">
          <ac:chgData name="Grace" userId="fd145552-a10d-4a31-a438-f8736fd84277" providerId="ADAL" clId="{56835480-2BB5-4545-A32E-6CA68AA69734}" dt="2021-09-02T00:52:08.748" v="3722" actId="14100"/>
          <ac:spMkLst>
            <pc:docMk/>
            <pc:sldMk cId="55687339" sldId="4099"/>
            <ac:spMk id="40" creationId="{06151578-3498-8C48-9859-ED9A7A9B7CB6}"/>
          </ac:spMkLst>
        </pc:spChg>
        <pc:spChg chg="del mod">
          <ac:chgData name="Grace" userId="fd145552-a10d-4a31-a438-f8736fd84277" providerId="ADAL" clId="{56835480-2BB5-4545-A32E-6CA68AA69734}" dt="2021-09-02T00:52:23.375" v="3725" actId="478"/>
          <ac:spMkLst>
            <pc:docMk/>
            <pc:sldMk cId="55687339" sldId="4099"/>
            <ac:spMk id="41" creationId="{6AAB29AF-45AB-0840-86BC-A9DFDB5E38A6}"/>
          </ac:spMkLst>
        </pc:spChg>
        <pc:spChg chg="del mod">
          <ac:chgData name="Grace" userId="fd145552-a10d-4a31-a438-f8736fd84277" providerId="ADAL" clId="{56835480-2BB5-4545-A32E-6CA68AA69734}" dt="2021-09-02T00:52:24.393" v="3726" actId="478"/>
          <ac:spMkLst>
            <pc:docMk/>
            <pc:sldMk cId="55687339" sldId="4099"/>
            <ac:spMk id="42" creationId="{8855CA89-21F5-5842-A694-965A4C680DF3}"/>
          </ac:spMkLst>
        </pc:spChg>
        <pc:spChg chg="mod">
          <ac:chgData name="Grace" userId="fd145552-a10d-4a31-a438-f8736fd84277" providerId="ADAL" clId="{56835480-2BB5-4545-A32E-6CA68AA69734}" dt="2021-09-02T01:30:03.079" v="4170" actId="14100"/>
          <ac:spMkLst>
            <pc:docMk/>
            <pc:sldMk cId="55687339" sldId="4099"/>
            <ac:spMk id="43" creationId="{58C17794-AA99-284A-8875-E1F2FC31E2E3}"/>
          </ac:spMkLst>
        </pc:spChg>
        <pc:spChg chg="mod">
          <ac:chgData name="Grace" userId="fd145552-a10d-4a31-a438-f8736fd84277" providerId="ADAL" clId="{56835480-2BB5-4545-A32E-6CA68AA69734}" dt="2021-09-02T00:32:58.550" v="3072" actId="1076"/>
          <ac:spMkLst>
            <pc:docMk/>
            <pc:sldMk cId="55687339" sldId="4099"/>
            <ac:spMk id="44" creationId="{28C4FE9E-CE15-734C-88B8-CF5787BB200C}"/>
          </ac:spMkLst>
        </pc:spChg>
        <pc:spChg chg="del mod">
          <ac:chgData name="Grace" userId="fd145552-a10d-4a31-a438-f8736fd84277" providerId="ADAL" clId="{56835480-2BB5-4545-A32E-6CA68AA69734}" dt="2021-09-02T00:50:37.517" v="3699" actId="478"/>
          <ac:spMkLst>
            <pc:docMk/>
            <pc:sldMk cId="55687339" sldId="4099"/>
            <ac:spMk id="45" creationId="{A341B144-B24A-BB4F-86EC-191BC42E1D5E}"/>
          </ac:spMkLst>
        </pc:spChg>
        <pc:spChg chg="del mod">
          <ac:chgData name="Grace" userId="fd145552-a10d-4a31-a438-f8736fd84277" providerId="ADAL" clId="{56835480-2BB5-4545-A32E-6CA68AA69734}" dt="2021-09-02T00:50:43.928" v="3702" actId="478"/>
          <ac:spMkLst>
            <pc:docMk/>
            <pc:sldMk cId="55687339" sldId="4099"/>
            <ac:spMk id="46" creationId="{B72910C0-BF69-2340-B420-0CD998113D6F}"/>
          </ac:spMkLst>
        </pc:spChg>
        <pc:spChg chg="del mod">
          <ac:chgData name="Grace" userId="fd145552-a10d-4a31-a438-f8736fd84277" providerId="ADAL" clId="{56835480-2BB5-4545-A32E-6CA68AA69734}" dt="2021-09-02T00:50:45.445" v="3703" actId="478"/>
          <ac:spMkLst>
            <pc:docMk/>
            <pc:sldMk cId="55687339" sldId="4099"/>
            <ac:spMk id="47" creationId="{5A2880FC-CEB1-E44F-97A4-DBDC72C9622B}"/>
          </ac:spMkLst>
        </pc:spChg>
        <pc:spChg chg="mod">
          <ac:chgData name="Grace" userId="fd145552-a10d-4a31-a438-f8736fd84277" providerId="ADAL" clId="{56835480-2BB5-4545-A32E-6CA68AA69734}" dt="2021-09-02T00:32:58.550" v="3072" actId="1076"/>
          <ac:spMkLst>
            <pc:docMk/>
            <pc:sldMk cId="55687339" sldId="4099"/>
            <ac:spMk id="48" creationId="{9404629E-822B-244B-9CC3-56399CF077D2}"/>
          </ac:spMkLst>
        </pc:spChg>
        <pc:spChg chg="del mod">
          <ac:chgData name="Grace" userId="fd145552-a10d-4a31-a438-f8736fd84277" providerId="ADAL" clId="{56835480-2BB5-4545-A32E-6CA68AA69734}" dt="2021-09-02T01:29:21.970" v="4107" actId="478"/>
          <ac:spMkLst>
            <pc:docMk/>
            <pc:sldMk cId="55687339" sldId="4099"/>
            <ac:spMk id="49" creationId="{F04D260F-2C98-5048-97EA-B74FFE5D6F9D}"/>
          </ac:spMkLst>
        </pc:spChg>
        <pc:spChg chg="mod">
          <ac:chgData name="Grace" userId="fd145552-a10d-4a31-a438-f8736fd84277" providerId="ADAL" clId="{56835480-2BB5-4545-A32E-6CA68AA69734}" dt="2021-09-02T01:30:10.066" v="4182" actId="1036"/>
          <ac:spMkLst>
            <pc:docMk/>
            <pc:sldMk cId="55687339" sldId="4099"/>
            <ac:spMk id="50" creationId="{3DBDDE1E-FA4D-854C-8340-ACC7179EF695}"/>
          </ac:spMkLst>
        </pc:spChg>
        <pc:spChg chg="mod">
          <ac:chgData name="Grace" userId="fd145552-a10d-4a31-a438-f8736fd84277" providerId="ADAL" clId="{56835480-2BB5-4545-A32E-6CA68AA69734}" dt="2021-09-02T01:30:26.361" v="4188" actId="1076"/>
          <ac:spMkLst>
            <pc:docMk/>
            <pc:sldMk cId="55687339" sldId="4099"/>
            <ac:spMk id="51" creationId="{ABF8AF6A-CA06-A742-B17E-6D9DF22CC3E7}"/>
          </ac:spMkLst>
        </pc:spChg>
        <pc:spChg chg="add del mod">
          <ac:chgData name="Grace" userId="fd145552-a10d-4a31-a438-f8736fd84277" providerId="ADAL" clId="{56835480-2BB5-4545-A32E-6CA68AA69734}" dt="2021-09-02T00:31:51.681" v="2979" actId="478"/>
          <ac:spMkLst>
            <pc:docMk/>
            <pc:sldMk cId="55687339" sldId="4099"/>
            <ac:spMk id="52" creationId="{E824DFFC-7A1A-4082-8626-854AD66E556A}"/>
          </ac:spMkLst>
        </pc:spChg>
        <pc:spChg chg="add mod">
          <ac:chgData name="Grace" userId="fd145552-a10d-4a31-a438-f8736fd84277" providerId="ADAL" clId="{56835480-2BB5-4545-A32E-6CA68AA69734}" dt="2021-09-02T00:50:19.405" v="3692" actId="1076"/>
          <ac:spMkLst>
            <pc:docMk/>
            <pc:sldMk cId="55687339" sldId="4099"/>
            <ac:spMk id="53" creationId="{6DC96E80-C7D4-4EBA-9932-BF14C22365D6}"/>
          </ac:spMkLst>
        </pc:spChg>
        <pc:spChg chg="add mod">
          <ac:chgData name="Grace" userId="fd145552-a10d-4a31-a438-f8736fd84277" providerId="ADAL" clId="{56835480-2BB5-4545-A32E-6CA68AA69734}" dt="2021-09-02T00:50:19.405" v="3692" actId="1076"/>
          <ac:spMkLst>
            <pc:docMk/>
            <pc:sldMk cId="55687339" sldId="4099"/>
            <ac:spMk id="54" creationId="{20966284-2E31-45BD-A65C-E500A34DEA98}"/>
          </ac:spMkLst>
        </pc:spChg>
        <pc:spChg chg="add mod">
          <ac:chgData name="Grace" userId="fd145552-a10d-4a31-a438-f8736fd84277" providerId="ADAL" clId="{56835480-2BB5-4545-A32E-6CA68AA69734}" dt="2021-09-02T00:50:23.612" v="3694" actId="1076"/>
          <ac:spMkLst>
            <pc:docMk/>
            <pc:sldMk cId="55687339" sldId="4099"/>
            <ac:spMk id="55" creationId="{C65B820F-C94C-47B9-A757-C873C4656D6D}"/>
          </ac:spMkLst>
        </pc:spChg>
        <pc:spChg chg="add mod">
          <ac:chgData name="Grace" userId="fd145552-a10d-4a31-a438-f8736fd84277" providerId="ADAL" clId="{56835480-2BB5-4545-A32E-6CA68AA69734}" dt="2021-09-02T00:50:23.612" v="3694" actId="1076"/>
          <ac:spMkLst>
            <pc:docMk/>
            <pc:sldMk cId="55687339" sldId="4099"/>
            <ac:spMk id="56" creationId="{98D23327-E344-402E-AF2A-66EEAE768262}"/>
          </ac:spMkLst>
        </pc:spChg>
        <pc:spChg chg="add mod">
          <ac:chgData name="Grace" userId="fd145552-a10d-4a31-a438-f8736fd84277" providerId="ADAL" clId="{56835480-2BB5-4545-A32E-6CA68AA69734}" dt="2021-09-02T00:50:28.322" v="3696" actId="1076"/>
          <ac:spMkLst>
            <pc:docMk/>
            <pc:sldMk cId="55687339" sldId="4099"/>
            <ac:spMk id="57" creationId="{028BCC21-0271-4D24-BE5D-39A2E06A1750}"/>
          </ac:spMkLst>
        </pc:spChg>
        <pc:spChg chg="add mod">
          <ac:chgData name="Grace" userId="fd145552-a10d-4a31-a438-f8736fd84277" providerId="ADAL" clId="{56835480-2BB5-4545-A32E-6CA68AA69734}" dt="2021-09-02T00:50:28.322" v="3696" actId="1076"/>
          <ac:spMkLst>
            <pc:docMk/>
            <pc:sldMk cId="55687339" sldId="4099"/>
            <ac:spMk id="58" creationId="{EFF1E7A1-001E-454B-B506-0BAA36FC61D7}"/>
          </ac:spMkLst>
        </pc:spChg>
        <pc:spChg chg="add mod">
          <ac:chgData name="Grace" userId="fd145552-a10d-4a31-a438-f8736fd84277" providerId="ADAL" clId="{56835480-2BB5-4545-A32E-6CA68AA69734}" dt="2021-09-02T00:51:04.540" v="3709" actId="1076"/>
          <ac:spMkLst>
            <pc:docMk/>
            <pc:sldMk cId="55687339" sldId="4099"/>
            <ac:spMk id="59" creationId="{D8A4664C-531E-466C-8B4F-087D118EF51C}"/>
          </ac:spMkLst>
        </pc:spChg>
        <pc:spChg chg="add mod">
          <ac:chgData name="Grace" userId="fd145552-a10d-4a31-a438-f8736fd84277" providerId="ADAL" clId="{56835480-2BB5-4545-A32E-6CA68AA69734}" dt="2021-09-02T00:51:04.540" v="3709" actId="1076"/>
          <ac:spMkLst>
            <pc:docMk/>
            <pc:sldMk cId="55687339" sldId="4099"/>
            <ac:spMk id="60" creationId="{46110F5C-221D-4D8A-BB64-8D02A2C26E33}"/>
          </ac:spMkLst>
        </pc:spChg>
        <pc:spChg chg="add mod">
          <ac:chgData name="Grace" userId="fd145552-a10d-4a31-a438-f8736fd84277" providerId="ADAL" clId="{56835480-2BB5-4545-A32E-6CA68AA69734}" dt="2021-09-02T00:50:58.108" v="3706" actId="1076"/>
          <ac:spMkLst>
            <pc:docMk/>
            <pc:sldMk cId="55687339" sldId="4099"/>
            <ac:spMk id="61" creationId="{6220F981-2F6B-4FD5-8194-92970A9D9210}"/>
          </ac:spMkLst>
        </pc:spChg>
        <pc:spChg chg="add mod">
          <ac:chgData name="Grace" userId="fd145552-a10d-4a31-a438-f8736fd84277" providerId="ADAL" clId="{56835480-2BB5-4545-A32E-6CA68AA69734}" dt="2021-09-02T00:50:58.108" v="3706" actId="1076"/>
          <ac:spMkLst>
            <pc:docMk/>
            <pc:sldMk cId="55687339" sldId="4099"/>
            <ac:spMk id="62" creationId="{682238F5-2413-4964-968A-ACA45F28A1DA}"/>
          </ac:spMkLst>
        </pc:spChg>
        <pc:spChg chg="add mod">
          <ac:chgData name="Grace" userId="fd145552-a10d-4a31-a438-f8736fd84277" providerId="ADAL" clId="{56835480-2BB5-4545-A32E-6CA68AA69734}" dt="2021-09-02T00:51:10.316" v="3711" actId="1076"/>
          <ac:spMkLst>
            <pc:docMk/>
            <pc:sldMk cId="55687339" sldId="4099"/>
            <ac:spMk id="63" creationId="{2FEA7768-459E-4788-A455-A895DB0AC749}"/>
          </ac:spMkLst>
        </pc:spChg>
        <pc:spChg chg="add mod">
          <ac:chgData name="Grace" userId="fd145552-a10d-4a31-a438-f8736fd84277" providerId="ADAL" clId="{56835480-2BB5-4545-A32E-6CA68AA69734}" dt="2021-09-02T00:51:10.316" v="3711" actId="1076"/>
          <ac:spMkLst>
            <pc:docMk/>
            <pc:sldMk cId="55687339" sldId="4099"/>
            <ac:spMk id="64" creationId="{254AB6F3-89A1-4E1B-B11C-3C5F52E410A6}"/>
          </ac:spMkLst>
        </pc:spChg>
        <pc:spChg chg="add mod">
          <ac:chgData name="Grace" userId="fd145552-a10d-4a31-a438-f8736fd84277" providerId="ADAL" clId="{56835480-2BB5-4545-A32E-6CA68AA69734}" dt="2021-09-02T00:51:15.813" v="3713" actId="1076"/>
          <ac:spMkLst>
            <pc:docMk/>
            <pc:sldMk cId="55687339" sldId="4099"/>
            <ac:spMk id="65" creationId="{CB1FBF99-35F4-44A9-9D72-5FEA0559D9BF}"/>
          </ac:spMkLst>
        </pc:spChg>
        <pc:spChg chg="add mod">
          <ac:chgData name="Grace" userId="fd145552-a10d-4a31-a438-f8736fd84277" providerId="ADAL" clId="{56835480-2BB5-4545-A32E-6CA68AA69734}" dt="2021-09-02T00:51:15.813" v="3713" actId="1076"/>
          <ac:spMkLst>
            <pc:docMk/>
            <pc:sldMk cId="55687339" sldId="4099"/>
            <ac:spMk id="66" creationId="{897DE1CB-C62D-4B44-8A9C-13C59E127509}"/>
          </ac:spMkLst>
        </pc:spChg>
        <pc:spChg chg="add mod">
          <ac:chgData name="Grace" userId="fd145552-a10d-4a31-a438-f8736fd84277" providerId="ADAL" clId="{56835480-2BB5-4545-A32E-6CA68AA69734}" dt="2021-09-02T00:51:22.585" v="3716" actId="1076"/>
          <ac:spMkLst>
            <pc:docMk/>
            <pc:sldMk cId="55687339" sldId="4099"/>
            <ac:spMk id="67" creationId="{535F0882-C5C7-4680-A719-0A07A80D882B}"/>
          </ac:spMkLst>
        </pc:spChg>
        <pc:spChg chg="add mod">
          <ac:chgData name="Grace" userId="fd145552-a10d-4a31-a438-f8736fd84277" providerId="ADAL" clId="{56835480-2BB5-4545-A32E-6CA68AA69734}" dt="2021-09-02T00:51:22.585" v="3716" actId="1076"/>
          <ac:spMkLst>
            <pc:docMk/>
            <pc:sldMk cId="55687339" sldId="4099"/>
            <ac:spMk id="68" creationId="{9A49CD10-1D63-4FAC-9447-76A5C13EF15C}"/>
          </ac:spMkLst>
        </pc:spChg>
        <pc:spChg chg="add del mod">
          <ac:chgData name="Grace" userId="fd145552-a10d-4a31-a438-f8736fd84277" providerId="ADAL" clId="{56835480-2BB5-4545-A32E-6CA68AA69734}" dt="2021-09-02T00:52:06.657" v="3721" actId="478"/>
          <ac:spMkLst>
            <pc:docMk/>
            <pc:sldMk cId="55687339" sldId="4099"/>
            <ac:spMk id="69" creationId="{67457A1D-1EC5-4A4C-A4F9-1B59D6993DCC}"/>
          </ac:spMkLst>
        </pc:spChg>
        <pc:spChg chg="add mod">
          <ac:chgData name="Grace" userId="fd145552-a10d-4a31-a438-f8736fd84277" providerId="ADAL" clId="{56835480-2BB5-4545-A32E-6CA68AA69734}" dt="2021-09-02T00:51:37.178" v="3718" actId="1076"/>
          <ac:spMkLst>
            <pc:docMk/>
            <pc:sldMk cId="55687339" sldId="4099"/>
            <ac:spMk id="70" creationId="{BF74347B-75F3-4553-9F06-BA17F0465A9B}"/>
          </ac:spMkLst>
        </pc:spChg>
        <pc:spChg chg="add mod">
          <ac:chgData name="Grace" userId="fd145552-a10d-4a31-a438-f8736fd84277" providerId="ADAL" clId="{56835480-2BB5-4545-A32E-6CA68AA69734}" dt="2021-09-02T01:30:49.133" v="4195" actId="313"/>
          <ac:spMkLst>
            <pc:docMk/>
            <pc:sldMk cId="55687339" sldId="4099"/>
            <ac:spMk id="71" creationId="{BE40ADCA-1D2B-4CEB-803D-937EB95FF248}"/>
          </ac:spMkLst>
        </pc:spChg>
        <pc:spChg chg="add mod">
          <ac:chgData name="Grace" userId="fd145552-a10d-4a31-a438-f8736fd84277" providerId="ADAL" clId="{56835480-2BB5-4545-A32E-6CA68AA69734}" dt="2021-09-02T01:30:18.449" v="4187" actId="1036"/>
          <ac:spMkLst>
            <pc:docMk/>
            <pc:sldMk cId="55687339" sldId="4099"/>
            <ac:spMk id="72" creationId="{BE8C501C-64F1-4D88-98E2-3CF3C6C798B0}"/>
          </ac:spMkLst>
        </pc:spChg>
        <pc:spChg chg="add mod">
          <ac:chgData name="Grace" userId="fd145552-a10d-4a31-a438-f8736fd84277" providerId="ADAL" clId="{56835480-2BB5-4545-A32E-6CA68AA69734}" dt="2021-09-02T01:30:38.677" v="4190" actId="1076"/>
          <ac:spMkLst>
            <pc:docMk/>
            <pc:sldMk cId="55687339" sldId="4099"/>
            <ac:spMk id="73" creationId="{E9A4F349-00C1-4F61-B241-F08552B13677}"/>
          </ac:spMkLst>
        </pc:spChg>
        <pc:spChg chg="add mod">
          <ac:chgData name="Grace" userId="fd145552-a10d-4a31-a438-f8736fd84277" providerId="ADAL" clId="{56835480-2BB5-4545-A32E-6CA68AA69734}" dt="2021-09-02T01:30:38.677" v="4190" actId="1076"/>
          <ac:spMkLst>
            <pc:docMk/>
            <pc:sldMk cId="55687339" sldId="4099"/>
            <ac:spMk id="74" creationId="{692DD962-4E2E-42C7-8D0E-2C7403599DF8}"/>
          </ac:spMkLst>
        </pc:spChg>
        <pc:spChg chg="add mod">
          <ac:chgData name="Grace" userId="fd145552-a10d-4a31-a438-f8736fd84277" providerId="ADAL" clId="{56835480-2BB5-4545-A32E-6CA68AA69734}" dt="2021-09-02T01:30:42.802" v="4192" actId="1076"/>
          <ac:spMkLst>
            <pc:docMk/>
            <pc:sldMk cId="55687339" sldId="4099"/>
            <ac:spMk id="75" creationId="{D3D76CA0-06C6-4EE2-AD66-B32AC4836672}"/>
          </ac:spMkLst>
        </pc:spChg>
        <pc:spChg chg="add mod">
          <ac:chgData name="Grace" userId="fd145552-a10d-4a31-a438-f8736fd84277" providerId="ADAL" clId="{56835480-2BB5-4545-A32E-6CA68AA69734}" dt="2021-09-02T01:30:42.802" v="4192" actId="1076"/>
          <ac:spMkLst>
            <pc:docMk/>
            <pc:sldMk cId="55687339" sldId="4099"/>
            <ac:spMk id="76" creationId="{D86C25A9-3646-4C80-8719-49C32CE35419}"/>
          </ac:spMkLst>
        </pc:spChg>
        <pc:spChg chg="add mod">
          <ac:chgData name="Grace" userId="fd145552-a10d-4a31-a438-f8736fd84277" providerId="ADAL" clId="{56835480-2BB5-4545-A32E-6CA68AA69734}" dt="2021-09-02T01:30:47.475" v="4194" actId="1076"/>
          <ac:spMkLst>
            <pc:docMk/>
            <pc:sldMk cId="55687339" sldId="4099"/>
            <ac:spMk id="77" creationId="{90988F15-36D9-448E-AC80-DCA6FE9B3FB4}"/>
          </ac:spMkLst>
        </pc:spChg>
        <pc:spChg chg="add mod">
          <ac:chgData name="Grace" userId="fd145552-a10d-4a31-a438-f8736fd84277" providerId="ADAL" clId="{56835480-2BB5-4545-A32E-6CA68AA69734}" dt="2021-09-02T01:30:47.475" v="4194" actId="1076"/>
          <ac:spMkLst>
            <pc:docMk/>
            <pc:sldMk cId="55687339" sldId="4099"/>
            <ac:spMk id="78" creationId="{2BC42DF7-8C72-4FC7-9741-006F96ECED6C}"/>
          </ac:spMkLst>
        </pc:spChg>
        <pc:spChg chg="add del">
          <ac:chgData name="Grace" userId="fd145552-a10d-4a31-a438-f8736fd84277" providerId="ADAL" clId="{56835480-2BB5-4545-A32E-6CA68AA69734}" dt="2021-09-02T01:40:48.471" v="4227" actId="22"/>
          <ac:spMkLst>
            <pc:docMk/>
            <pc:sldMk cId="55687339" sldId="4099"/>
            <ac:spMk id="80" creationId="{18A204BB-5985-4687-97A4-937697EA9B58}"/>
          </ac:spMkLst>
        </pc:spChg>
        <pc:picChg chg="add mod">
          <ac:chgData name="Grace" userId="fd145552-a10d-4a31-a438-f8736fd84277" providerId="ADAL" clId="{56835480-2BB5-4545-A32E-6CA68AA69734}" dt="2021-09-02T00:38:00.432" v="3102" actId="1076"/>
          <ac:picMkLst>
            <pc:docMk/>
            <pc:sldMk cId="55687339" sldId="4099"/>
            <ac:picMk id="3" creationId="{219E936F-4829-49A3-ADAF-593AAFFF9442}"/>
          </ac:picMkLst>
        </pc:picChg>
      </pc:sldChg>
      <pc:sldChg chg="addSp delSp modSp add mod">
        <pc:chgData name="Grace" userId="fd145552-a10d-4a31-a438-f8736fd84277" providerId="ADAL" clId="{56835480-2BB5-4545-A32E-6CA68AA69734}" dt="2021-09-02T01:54:38.066" v="7223" actId="478"/>
        <pc:sldMkLst>
          <pc:docMk/>
          <pc:sldMk cId="2280266633" sldId="4100"/>
        </pc:sldMkLst>
        <pc:spChg chg="mod">
          <ac:chgData name="Grace" userId="fd145552-a10d-4a31-a438-f8736fd84277" providerId="ADAL" clId="{56835480-2BB5-4545-A32E-6CA68AA69734}" dt="2021-09-02T01:41:09.939" v="4269" actId="20577"/>
          <ac:spMkLst>
            <pc:docMk/>
            <pc:sldMk cId="2280266633" sldId="4100"/>
            <ac:spMk id="3" creationId="{1C207EF0-D5F8-4C7D-9363-8246CDD5503A}"/>
          </ac:spMkLst>
        </pc:spChg>
        <pc:graphicFrameChg chg="add del mod">
          <ac:chgData name="Grace" userId="fd145552-a10d-4a31-a438-f8736fd84277" providerId="ADAL" clId="{56835480-2BB5-4545-A32E-6CA68AA69734}" dt="2021-09-02T01:54:25.717" v="7194" actId="478"/>
          <ac:graphicFrameMkLst>
            <pc:docMk/>
            <pc:sldMk cId="2280266633" sldId="4100"/>
            <ac:graphicFrameMk id="4" creationId="{B2BD856A-9D8D-470A-8834-5C0FF15CDB10}"/>
          </ac:graphicFrameMkLst>
        </pc:graphicFrameChg>
        <pc:graphicFrameChg chg="mod modGraphic">
          <ac:chgData name="Grace" userId="fd145552-a10d-4a31-a438-f8736fd84277" providerId="ADAL" clId="{56835480-2BB5-4545-A32E-6CA68AA69734}" dt="2021-09-02T01:54:34.558" v="7222" actId="1076"/>
          <ac:graphicFrameMkLst>
            <pc:docMk/>
            <pc:sldMk cId="2280266633" sldId="4100"/>
            <ac:graphicFrameMk id="5" creationId="{1F6D69E8-098B-4675-AAE5-73A7D0391966}"/>
          </ac:graphicFrameMkLst>
        </pc:graphicFrameChg>
        <pc:graphicFrameChg chg="add del mod">
          <ac:chgData name="Grace" userId="fd145552-a10d-4a31-a438-f8736fd84277" providerId="ADAL" clId="{56835480-2BB5-4545-A32E-6CA68AA69734}" dt="2021-09-02T01:54:38.066" v="7223" actId="478"/>
          <ac:graphicFrameMkLst>
            <pc:docMk/>
            <pc:sldMk cId="2280266633" sldId="4100"/>
            <ac:graphicFrameMk id="6" creationId="{E123B8D5-41D9-457C-B50F-0D91E3A920DB}"/>
          </ac:graphicFrameMkLst>
        </pc:graphicFrameChg>
      </pc:sldChg>
      <pc:sldChg chg="add del">
        <pc:chgData name="Grace" userId="fd145552-a10d-4a31-a438-f8736fd84277" providerId="ADAL" clId="{56835480-2BB5-4545-A32E-6CA68AA69734}" dt="2021-09-02T01:40:56.028" v="4229"/>
        <pc:sldMkLst>
          <pc:docMk/>
          <pc:sldMk cId="3791988128" sldId="4100"/>
        </pc:sldMkLst>
      </pc:sldChg>
      <pc:sldChg chg="modSp add mod">
        <pc:chgData name="Grace" userId="fd145552-a10d-4a31-a438-f8736fd84277" providerId="ADAL" clId="{56835480-2BB5-4545-A32E-6CA68AA69734}" dt="2021-09-02T02:02:54.563" v="8735" actId="20577"/>
        <pc:sldMkLst>
          <pc:docMk/>
          <pc:sldMk cId="2675036270" sldId="4101"/>
        </pc:sldMkLst>
        <pc:spChg chg="mod">
          <ac:chgData name="Grace" userId="fd145552-a10d-4a31-a438-f8736fd84277" providerId="ADAL" clId="{56835480-2BB5-4545-A32E-6CA68AA69734}" dt="2021-09-02T02:02:54.563" v="8735" actId="20577"/>
          <ac:spMkLst>
            <pc:docMk/>
            <pc:sldMk cId="2675036270" sldId="4101"/>
            <ac:spMk id="3" creationId="{1C207EF0-D5F8-4C7D-9363-8246CDD5503A}"/>
          </ac:spMkLst>
        </pc:spChg>
        <pc:graphicFrameChg chg="mod modGraphic">
          <ac:chgData name="Grace" userId="fd145552-a10d-4a31-a438-f8736fd84277" providerId="ADAL" clId="{56835480-2BB5-4545-A32E-6CA68AA69734}" dt="2021-09-02T01:54:07.137" v="7187" actId="1076"/>
          <ac:graphicFrameMkLst>
            <pc:docMk/>
            <pc:sldMk cId="2675036270" sldId="4101"/>
            <ac:graphicFrameMk id="5" creationId="{1F6D69E8-098B-4675-AAE5-73A7D0391966}"/>
          </ac:graphicFrameMkLst>
        </pc:graphicFrameChg>
      </pc:sldChg>
      <pc:sldChg chg="modSp add mod">
        <pc:chgData name="Grace" userId="fd145552-a10d-4a31-a438-f8736fd84277" providerId="ADAL" clId="{56835480-2BB5-4545-A32E-6CA68AA69734}" dt="2021-09-02T02:02:58.340" v="8740" actId="20577"/>
        <pc:sldMkLst>
          <pc:docMk/>
          <pc:sldMk cId="2198890857" sldId="4102"/>
        </pc:sldMkLst>
        <pc:spChg chg="mod">
          <ac:chgData name="Grace" userId="fd145552-a10d-4a31-a438-f8736fd84277" providerId="ADAL" clId="{56835480-2BB5-4545-A32E-6CA68AA69734}" dt="2021-09-02T02:02:58.340" v="8740" actId="20577"/>
          <ac:spMkLst>
            <pc:docMk/>
            <pc:sldMk cId="2198890857" sldId="4102"/>
            <ac:spMk id="3" creationId="{1C207EF0-D5F8-4C7D-9363-8246CDD5503A}"/>
          </ac:spMkLst>
        </pc:spChg>
        <pc:graphicFrameChg chg="modGraphic">
          <ac:chgData name="Grace" userId="fd145552-a10d-4a31-a438-f8736fd84277" providerId="ADAL" clId="{56835480-2BB5-4545-A32E-6CA68AA69734}" dt="2021-09-02T02:02:11.772" v="8678" actId="20577"/>
          <ac:graphicFrameMkLst>
            <pc:docMk/>
            <pc:sldMk cId="2198890857" sldId="4102"/>
            <ac:graphicFrameMk id="5" creationId="{1F6D69E8-098B-4675-AAE5-73A7D0391966}"/>
          </ac:graphicFrameMkLst>
        </pc:graphicFrameChg>
      </pc:sldChg>
      <pc:sldChg chg="delSp modSp add del mod">
        <pc:chgData name="Grace" userId="fd145552-a10d-4a31-a438-f8736fd84277" providerId="ADAL" clId="{56835480-2BB5-4545-A32E-6CA68AA69734}" dt="2021-09-02T02:02:38.293" v="8690" actId="47"/>
        <pc:sldMkLst>
          <pc:docMk/>
          <pc:sldMk cId="3204199233" sldId="4103"/>
        </pc:sldMkLst>
        <pc:spChg chg="mod">
          <ac:chgData name="Grace" userId="fd145552-a10d-4a31-a438-f8736fd84277" providerId="ADAL" clId="{56835480-2BB5-4545-A32E-6CA68AA69734}" dt="2021-09-02T02:02:17.845" v="8687" actId="20577"/>
          <ac:spMkLst>
            <pc:docMk/>
            <pc:sldMk cId="3204199233" sldId="4103"/>
            <ac:spMk id="3" creationId="{1C207EF0-D5F8-4C7D-9363-8246CDD5503A}"/>
          </ac:spMkLst>
        </pc:spChg>
        <pc:graphicFrameChg chg="del">
          <ac:chgData name="Grace" userId="fd145552-a10d-4a31-a438-f8736fd84277" providerId="ADAL" clId="{56835480-2BB5-4545-A32E-6CA68AA69734}" dt="2021-09-02T02:02:21.543" v="8688" actId="478"/>
          <ac:graphicFrameMkLst>
            <pc:docMk/>
            <pc:sldMk cId="3204199233" sldId="4103"/>
            <ac:graphicFrameMk id="5" creationId="{1F6D69E8-098B-4675-AAE5-73A7D0391966}"/>
          </ac:graphicFrameMkLst>
        </pc:graphicFrameChg>
      </pc:sldChg>
      <pc:sldChg chg="addSp modSp new mod">
        <pc:chgData name="Grace" userId="fd145552-a10d-4a31-a438-f8736fd84277" providerId="ADAL" clId="{56835480-2BB5-4545-A32E-6CA68AA69734}" dt="2021-09-02T02:10:10.031" v="9768" actId="20578"/>
        <pc:sldMkLst>
          <pc:docMk/>
          <pc:sldMk cId="660037898" sldId="4104"/>
        </pc:sldMkLst>
        <pc:spChg chg="mod">
          <ac:chgData name="Grace" userId="fd145552-a10d-4a31-a438-f8736fd84277" providerId="ADAL" clId="{56835480-2BB5-4545-A32E-6CA68AA69734}" dt="2021-09-02T02:05:42.109" v="9476" actId="20577"/>
          <ac:spMkLst>
            <pc:docMk/>
            <pc:sldMk cId="660037898" sldId="4104"/>
            <ac:spMk id="2" creationId="{594AAAD1-A302-415E-8929-53A6DDC5A801}"/>
          </ac:spMkLst>
        </pc:spChg>
        <pc:spChg chg="mod">
          <ac:chgData name="Grace" userId="fd145552-a10d-4a31-a438-f8736fd84277" providerId="ADAL" clId="{56835480-2BB5-4545-A32E-6CA68AA69734}" dt="2021-09-02T02:02:42.841" v="8699" actId="255"/>
          <ac:spMkLst>
            <pc:docMk/>
            <pc:sldMk cId="660037898" sldId="4104"/>
            <ac:spMk id="3" creationId="{B354936E-C463-4D90-963C-698FEFB13AEA}"/>
          </ac:spMkLst>
        </pc:spChg>
        <pc:graphicFrameChg chg="add mod modGraphic">
          <ac:chgData name="Grace" userId="fd145552-a10d-4a31-a438-f8736fd84277" providerId="ADAL" clId="{56835480-2BB5-4545-A32E-6CA68AA69734}" dt="2021-09-02T02:10:10.031" v="9768" actId="20578"/>
          <ac:graphicFrameMkLst>
            <pc:docMk/>
            <pc:sldMk cId="660037898" sldId="4104"/>
            <ac:graphicFrameMk id="4" creationId="{34A6E8FD-61D1-453E-B833-42E2C191607B}"/>
          </ac:graphicFrameMkLst>
        </pc:graphicFrameChg>
      </pc:sldChg>
      <pc:sldChg chg="addSp delSp modSp add mod">
        <pc:chgData name="Grace" userId="fd145552-a10d-4a31-a438-f8736fd84277" providerId="ADAL" clId="{56835480-2BB5-4545-A32E-6CA68AA69734}" dt="2021-09-02T02:12:01.421" v="10063" actId="20577"/>
        <pc:sldMkLst>
          <pc:docMk/>
          <pc:sldMk cId="4043908164" sldId="4105"/>
        </pc:sldMkLst>
        <pc:spChg chg="mod">
          <ac:chgData name="Grace" userId="fd145552-a10d-4a31-a438-f8736fd84277" providerId="ADAL" clId="{56835480-2BB5-4545-A32E-6CA68AA69734}" dt="2021-09-02T02:10:53.327" v="9789" actId="20577"/>
          <ac:spMkLst>
            <pc:docMk/>
            <pc:sldMk cId="4043908164" sldId="4105"/>
            <ac:spMk id="2" creationId="{594AAAD1-A302-415E-8929-53A6DDC5A801}"/>
          </ac:spMkLst>
        </pc:spChg>
        <pc:spChg chg="mod">
          <ac:chgData name="Grace" userId="fd145552-a10d-4a31-a438-f8736fd84277" providerId="ADAL" clId="{56835480-2BB5-4545-A32E-6CA68AA69734}" dt="2021-09-02T02:10:58.024" v="9808" actId="20577"/>
          <ac:spMkLst>
            <pc:docMk/>
            <pc:sldMk cId="4043908164" sldId="4105"/>
            <ac:spMk id="3" creationId="{B354936E-C463-4D90-963C-698FEFB13AEA}"/>
          </ac:spMkLst>
        </pc:spChg>
        <pc:spChg chg="add mod">
          <ac:chgData name="Grace" userId="fd145552-a10d-4a31-a438-f8736fd84277" providerId="ADAL" clId="{56835480-2BB5-4545-A32E-6CA68AA69734}" dt="2021-09-02T02:12:01.421" v="10063" actId="20577"/>
          <ac:spMkLst>
            <pc:docMk/>
            <pc:sldMk cId="4043908164" sldId="4105"/>
            <ac:spMk id="5" creationId="{C333899F-F847-4571-9683-DCBDF5945307}"/>
          </ac:spMkLst>
        </pc:spChg>
        <pc:graphicFrameChg chg="del">
          <ac:chgData name="Grace" userId="fd145552-a10d-4a31-a438-f8736fd84277" providerId="ADAL" clId="{56835480-2BB5-4545-A32E-6CA68AA69734}" dt="2021-09-02T02:10:46.017" v="9777" actId="478"/>
          <ac:graphicFrameMkLst>
            <pc:docMk/>
            <pc:sldMk cId="4043908164" sldId="4105"/>
            <ac:graphicFrameMk id="4" creationId="{34A6E8FD-61D1-453E-B833-42E2C191607B}"/>
          </ac:graphicFrameMkLst>
        </pc:graphicFrameChg>
      </pc:sldChg>
      <pc:sldChg chg="modSp new del mod">
        <pc:chgData name="Grace" userId="fd145552-a10d-4a31-a438-f8736fd84277" providerId="ADAL" clId="{56835480-2BB5-4545-A32E-6CA68AA69734}" dt="2021-09-02T04:27:27.062" v="10152" actId="47"/>
        <pc:sldMkLst>
          <pc:docMk/>
          <pc:sldMk cId="3196533863" sldId="4106"/>
        </pc:sldMkLst>
        <pc:spChg chg="mod">
          <ac:chgData name="Grace" userId="fd145552-a10d-4a31-a438-f8736fd84277" providerId="ADAL" clId="{56835480-2BB5-4545-A32E-6CA68AA69734}" dt="2021-09-02T04:27:00.855" v="10150" actId="20577"/>
          <ac:spMkLst>
            <pc:docMk/>
            <pc:sldMk cId="3196533863" sldId="4106"/>
            <ac:spMk id="2" creationId="{6EA645B4-7637-436C-998C-81562802CF43}"/>
          </ac:spMkLst>
        </pc:spChg>
      </pc:sldChg>
      <pc:sldChg chg="delSp modSp add mod">
        <pc:chgData name="Grace" userId="fd145552-a10d-4a31-a438-f8736fd84277" providerId="ADAL" clId="{56835480-2BB5-4545-A32E-6CA68AA69734}" dt="2021-09-02T04:28:15.578" v="10269" actId="1076"/>
        <pc:sldMkLst>
          <pc:docMk/>
          <pc:sldMk cId="2210991997" sldId="4107"/>
        </pc:sldMkLst>
        <pc:spChg chg="mod">
          <ac:chgData name="Grace" userId="fd145552-a10d-4a31-a438-f8736fd84277" providerId="ADAL" clId="{56835480-2BB5-4545-A32E-6CA68AA69734}" dt="2021-09-02T04:28:15.578" v="10269" actId="1076"/>
          <ac:spMkLst>
            <pc:docMk/>
            <pc:sldMk cId="2210991997" sldId="4107"/>
            <ac:spMk id="3" creationId="{1C207EF0-D5F8-4C7D-9363-8246CDD5503A}"/>
          </ac:spMkLst>
        </pc:spChg>
        <pc:graphicFrameChg chg="del mod modGraphic">
          <ac:chgData name="Grace" userId="fd145552-a10d-4a31-a438-f8736fd84277" providerId="ADAL" clId="{56835480-2BB5-4545-A32E-6CA68AA69734}" dt="2021-09-02T04:27:57.862" v="10228" actId="478"/>
          <ac:graphicFrameMkLst>
            <pc:docMk/>
            <pc:sldMk cId="2210991997" sldId="4107"/>
            <ac:graphicFrameMk id="5" creationId="{1F6D69E8-098B-4675-AAE5-73A7D0391966}"/>
          </ac:graphicFrameMkLst>
        </pc:graphicFrameChg>
      </pc:sldChg>
      <pc:sldChg chg="modSp del mod">
        <pc:chgData name="Grace" userId="fd145552-a10d-4a31-a438-f8736fd84277" providerId="ADAL" clId="{56835480-2BB5-4545-A32E-6CA68AA69734}" dt="2021-09-01T06:50:50.428" v="4" actId="47"/>
        <pc:sldMkLst>
          <pc:docMk/>
          <pc:sldMk cId="1846164934" sldId="4113"/>
        </pc:sldMkLst>
        <pc:spChg chg="mod">
          <ac:chgData name="Grace" userId="fd145552-a10d-4a31-a438-f8736fd84277" providerId="ADAL" clId="{56835480-2BB5-4545-A32E-6CA68AA69734}" dt="2021-09-01T06:49:09.790" v="1" actId="14100"/>
          <ac:spMkLst>
            <pc:docMk/>
            <pc:sldMk cId="1846164934" sldId="4113"/>
            <ac:spMk id="2" creationId="{86621F8E-88C5-4808-832C-8AFD67D0343E}"/>
          </ac:spMkLst>
        </pc:spChg>
      </pc:sldChg>
      <pc:sldChg chg="del">
        <pc:chgData name="Grace" userId="fd145552-a10d-4a31-a438-f8736fd84277" providerId="ADAL" clId="{56835480-2BB5-4545-A32E-6CA68AA69734}" dt="2021-09-01T06:49:39.585" v="3"/>
        <pc:sldMkLst>
          <pc:docMk/>
          <pc:sldMk cId="2181493422" sldId="4114"/>
        </pc:sldMkLst>
      </pc:sldChg>
      <pc:sldChg chg="del">
        <pc:chgData name="Grace" userId="fd145552-a10d-4a31-a438-f8736fd84277" providerId="ADAL" clId="{56835480-2BB5-4545-A32E-6CA68AA69734}" dt="2021-09-01T06:49:35.434" v="2"/>
        <pc:sldMkLst>
          <pc:docMk/>
          <pc:sldMk cId="3612367257" sldId="4114"/>
        </pc:sldMkLst>
      </pc:sldChg>
      <pc:sldChg chg="del">
        <pc:chgData name="Grace" userId="fd145552-a10d-4a31-a438-f8736fd84277" providerId="ADAL" clId="{56835480-2BB5-4545-A32E-6CA68AA69734}" dt="2021-09-01T06:49:39.585" v="3"/>
        <pc:sldMkLst>
          <pc:docMk/>
          <pc:sldMk cId="328836670" sldId="4115"/>
        </pc:sldMkLst>
      </pc:sldChg>
      <pc:sldChg chg="del">
        <pc:chgData name="Grace" userId="fd145552-a10d-4a31-a438-f8736fd84277" providerId="ADAL" clId="{56835480-2BB5-4545-A32E-6CA68AA69734}" dt="2021-09-01T06:49:35.434" v="2"/>
        <pc:sldMkLst>
          <pc:docMk/>
          <pc:sldMk cId="3992121559" sldId="4115"/>
        </pc:sldMkLst>
      </pc:sldChg>
      <pc:sldChg chg="del">
        <pc:chgData name="Grace" userId="fd145552-a10d-4a31-a438-f8736fd84277" providerId="ADAL" clId="{56835480-2BB5-4545-A32E-6CA68AA69734}" dt="2021-09-01T06:49:35.434" v="2"/>
        <pc:sldMkLst>
          <pc:docMk/>
          <pc:sldMk cId="114819897" sldId="4116"/>
        </pc:sldMkLst>
      </pc:sldChg>
      <pc:sldChg chg="del">
        <pc:chgData name="Grace" userId="fd145552-a10d-4a31-a438-f8736fd84277" providerId="ADAL" clId="{56835480-2BB5-4545-A32E-6CA68AA69734}" dt="2021-09-01T06:49:39.585" v="3"/>
        <pc:sldMkLst>
          <pc:docMk/>
          <pc:sldMk cId="3878807398" sldId="4116"/>
        </pc:sldMkLst>
      </pc:sldChg>
      <pc:sldChg chg="del">
        <pc:chgData name="Grace" userId="fd145552-a10d-4a31-a438-f8736fd84277" providerId="ADAL" clId="{56835480-2BB5-4545-A32E-6CA68AA69734}" dt="2021-09-01T06:49:35.434" v="2"/>
        <pc:sldMkLst>
          <pc:docMk/>
          <pc:sldMk cId="2027250860" sldId="4117"/>
        </pc:sldMkLst>
      </pc:sldChg>
      <pc:sldChg chg="del">
        <pc:chgData name="Grace" userId="fd145552-a10d-4a31-a438-f8736fd84277" providerId="ADAL" clId="{56835480-2BB5-4545-A32E-6CA68AA69734}" dt="2021-09-01T06:49:39.585" v="3"/>
        <pc:sldMkLst>
          <pc:docMk/>
          <pc:sldMk cId="3556675765" sldId="4117"/>
        </pc:sldMkLst>
      </pc:sldChg>
      <pc:sldMasterChg chg="del delSldLayout">
        <pc:chgData name="Grace" userId="fd145552-a10d-4a31-a438-f8736fd84277" providerId="ADAL" clId="{56835480-2BB5-4545-A32E-6CA68AA69734}" dt="2021-09-01T06:49:02.282" v="0" actId="47"/>
        <pc:sldMasterMkLst>
          <pc:docMk/>
          <pc:sldMasterMk cId="2460954070" sldId="2147483660"/>
        </pc:sldMasterMkLst>
        <pc:sldLayoutChg chg="del">
          <pc:chgData name="Grace" userId="fd145552-a10d-4a31-a438-f8736fd84277" providerId="ADAL" clId="{56835480-2BB5-4545-A32E-6CA68AA69734}" dt="2021-09-01T06:49:02.282" v="0" actId="47"/>
          <pc:sldLayoutMkLst>
            <pc:docMk/>
            <pc:sldMasterMk cId="2460954070" sldId="2147483660"/>
            <pc:sldLayoutMk cId="2385387890" sldId="2147483661"/>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949138452" sldId="2147483662"/>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2591524520" sldId="2147483663"/>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1203092039" sldId="2147483664"/>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3733172339" sldId="2147483665"/>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3210312558" sldId="2147483666"/>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3146388984" sldId="2147483667"/>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3171841454" sldId="2147483668"/>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1718958274" sldId="2147483669"/>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2202905451" sldId="2147483670"/>
          </pc:sldLayoutMkLst>
        </pc:sldLayoutChg>
        <pc:sldLayoutChg chg="del">
          <pc:chgData name="Grace" userId="fd145552-a10d-4a31-a438-f8736fd84277" providerId="ADAL" clId="{56835480-2BB5-4545-A32E-6CA68AA69734}" dt="2021-09-01T06:49:02.282" v="0" actId="47"/>
          <pc:sldLayoutMkLst>
            <pc:docMk/>
            <pc:sldMasterMk cId="2460954070" sldId="2147483660"/>
            <pc:sldLayoutMk cId="3479445657" sldId="2147483671"/>
          </pc:sldLayoutMkLst>
        </pc:sldLayoutChg>
      </pc:sldMasterChg>
      <pc:sldMasterChg chg="modSp del delSldLayout modSldLayout">
        <pc:chgData name="Grace" userId="fd145552-a10d-4a31-a438-f8736fd84277" providerId="ADAL" clId="{56835480-2BB5-4545-A32E-6CA68AA69734}" dt="2021-09-01T07:01:43.763" v="11" actId="47"/>
        <pc:sldMasterMkLst>
          <pc:docMk/>
          <pc:sldMasterMk cId="4178710919" sldId="2147483709"/>
        </pc:sldMasterMkLst>
        <pc:spChg chg="mod">
          <ac:chgData name="Grace" userId="fd145552-a10d-4a31-a438-f8736fd84277" providerId="ADAL" clId="{56835480-2BB5-4545-A32E-6CA68AA69734}" dt="2021-09-01T07:01:38.603" v="10"/>
          <ac:spMkLst>
            <pc:docMk/>
            <pc:sldMasterMk cId="4178710919" sldId="2147483709"/>
            <ac:spMk id="3" creationId="{00000000-0000-0000-0000-000000000000}"/>
          </ac:spMkLst>
        </pc:spChg>
        <pc:spChg chg="mod">
          <ac:chgData name="Grace" userId="fd145552-a10d-4a31-a438-f8736fd84277" providerId="ADAL" clId="{56835480-2BB5-4545-A32E-6CA68AA69734}" dt="2021-09-01T07:01:38.603" v="10"/>
          <ac:spMkLst>
            <pc:docMk/>
            <pc:sldMasterMk cId="4178710919" sldId="2147483709"/>
            <ac:spMk id="11" creationId="{00000000-0000-0000-0000-000000000000}"/>
          </ac:spMkLst>
        </pc:spChg>
        <pc:spChg chg="mod">
          <ac:chgData name="Grace" userId="fd145552-a10d-4a31-a438-f8736fd84277" providerId="ADAL" clId="{56835480-2BB5-4545-A32E-6CA68AA69734}" dt="2021-09-01T07:01:38.603" v="10"/>
          <ac:spMkLst>
            <pc:docMk/>
            <pc:sldMasterMk cId="4178710919" sldId="2147483709"/>
            <ac:spMk id="12" creationId="{00000000-0000-0000-0000-000000000000}"/>
          </ac:spMkLst>
        </pc:spChg>
        <pc:spChg chg="mod">
          <ac:chgData name="Grace" userId="fd145552-a10d-4a31-a438-f8736fd84277" providerId="ADAL" clId="{56835480-2BB5-4545-A32E-6CA68AA69734}" dt="2021-09-01T07:01:38.603" v="10"/>
          <ac:spMkLst>
            <pc:docMk/>
            <pc:sldMasterMk cId="4178710919" sldId="2147483709"/>
            <ac:spMk id="1026" creationId="{00000000-0000-0000-0000-000000000000}"/>
          </ac:spMkLst>
        </pc:spChg>
        <pc:sldLayoutChg chg="modSp del">
          <pc:chgData name="Grace" userId="fd145552-a10d-4a31-a438-f8736fd84277" providerId="ADAL" clId="{56835480-2BB5-4545-A32E-6CA68AA69734}" dt="2021-09-01T07:01:43.763" v="11" actId="47"/>
          <pc:sldLayoutMkLst>
            <pc:docMk/>
            <pc:sldMasterMk cId="4178710919" sldId="2147483709"/>
            <pc:sldLayoutMk cId="3726524487" sldId="2147483710"/>
          </pc:sldLayoutMkLst>
          <pc:spChg chg="mod">
            <ac:chgData name="Grace" userId="fd145552-a10d-4a31-a438-f8736fd84277" providerId="ADAL" clId="{56835480-2BB5-4545-A32E-6CA68AA69734}" dt="2021-09-01T07:01:38.603" v="10"/>
            <ac:spMkLst>
              <pc:docMk/>
              <pc:sldMasterMk cId="4178710919" sldId="2147483709"/>
              <pc:sldLayoutMk cId="3726524487" sldId="2147483710"/>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726524487" sldId="2147483710"/>
              <ac:spMk id="7"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726524487" sldId="2147483710"/>
              <ac:spMk id="8"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726524487" sldId="2147483710"/>
              <ac:spMk id="14"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3726524487" sldId="2147483710"/>
              <ac:picMk id="9"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3536654825" sldId="2147483711"/>
          </pc:sldLayoutMkLst>
          <pc:spChg chg="mod">
            <ac:chgData name="Grace" userId="fd145552-a10d-4a31-a438-f8736fd84277" providerId="ADAL" clId="{56835480-2BB5-4545-A32E-6CA68AA69734}" dt="2021-09-01T07:01:38.603" v="10"/>
            <ac:spMkLst>
              <pc:docMk/>
              <pc:sldMasterMk cId="4178710919" sldId="2147483709"/>
              <pc:sldLayoutMk cId="3536654825" sldId="2147483711"/>
              <ac:spMk id="7"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536654825" sldId="2147483711"/>
              <ac:spMk id="8"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536654825" sldId="2147483711"/>
              <ac:spMk id="10"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3536654825" sldId="2147483711"/>
              <ac:picMk id="2"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3536654825" sldId="2147483711"/>
              <ac:picMk id="9"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3536654825" sldId="2147483711"/>
              <ac:picMk id="11"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2096411242" sldId="2147483712"/>
          </pc:sldLayoutMkLst>
          <pc:spChg chg="mod">
            <ac:chgData name="Grace" userId="fd145552-a10d-4a31-a438-f8736fd84277" providerId="ADAL" clId="{56835480-2BB5-4545-A32E-6CA68AA69734}" dt="2021-09-01T07:01:38.603" v="10"/>
            <ac:spMkLst>
              <pc:docMk/>
              <pc:sldMasterMk cId="4178710919" sldId="2147483709"/>
              <pc:sldLayoutMk cId="2096411242" sldId="2147483712"/>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096411242" sldId="2147483712"/>
              <ac:spMk id="7"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096411242" sldId="2147483712"/>
              <ac:spMk id="8"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2096411242" sldId="2147483712"/>
              <ac:picMk id="5"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2096411242" sldId="2147483712"/>
              <ac:picMk id="10"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149609524" sldId="2147483713"/>
          </pc:sldLayoutMkLst>
          <pc:spChg chg="mod">
            <ac:chgData name="Grace" userId="fd145552-a10d-4a31-a438-f8736fd84277" providerId="ADAL" clId="{56835480-2BB5-4545-A32E-6CA68AA69734}" dt="2021-09-01T07:01:38.603" v="10"/>
            <ac:spMkLst>
              <pc:docMk/>
              <pc:sldMasterMk cId="4178710919" sldId="2147483709"/>
              <pc:sldLayoutMk cId="149609524" sldId="2147483713"/>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49609524" sldId="2147483713"/>
              <ac:spMk id="7"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49609524" sldId="2147483713"/>
              <ac:spMk id="8"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149609524" sldId="2147483713"/>
              <ac:picMk id="9"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149609524" sldId="2147483713"/>
              <ac:picMk id="11"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202551394" sldId="2147483714"/>
          </pc:sldLayoutMkLst>
          <pc:spChg chg="mod">
            <ac:chgData name="Grace" userId="fd145552-a10d-4a31-a438-f8736fd84277" providerId="ADAL" clId="{56835480-2BB5-4545-A32E-6CA68AA69734}" dt="2021-09-01T07:01:38.603" v="10"/>
            <ac:spMkLst>
              <pc:docMk/>
              <pc:sldMasterMk cId="4178710919" sldId="2147483709"/>
              <pc:sldLayoutMk cId="202551394" sldId="2147483714"/>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02551394" sldId="2147483714"/>
              <ac:spMk id="7"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02551394" sldId="2147483714"/>
              <ac:spMk id="8"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202551394" sldId="2147483714"/>
              <ac:picMk id="2"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202551394" sldId="2147483714"/>
              <ac:picMk id="10"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2042212221" sldId="2147483715"/>
          </pc:sldLayoutMkLst>
          <pc:spChg chg="mod">
            <ac:chgData name="Grace" userId="fd145552-a10d-4a31-a438-f8736fd84277" providerId="ADAL" clId="{56835480-2BB5-4545-A32E-6CA68AA69734}" dt="2021-09-01T07:01:38.603" v="10"/>
            <ac:spMkLst>
              <pc:docMk/>
              <pc:sldMasterMk cId="4178710919" sldId="2147483709"/>
              <pc:sldLayoutMk cId="2042212221" sldId="2147483715"/>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042212221" sldId="2147483715"/>
              <ac:spMk id="12"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042212221" sldId="2147483715"/>
              <ac:spMk id="13"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2042212221" sldId="2147483715"/>
              <ac:picMk id="7"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3892010027" sldId="2147483716"/>
          </pc:sldLayoutMkLst>
          <pc:spChg chg="mod">
            <ac:chgData name="Grace" userId="fd145552-a10d-4a31-a438-f8736fd84277" providerId="ADAL" clId="{56835480-2BB5-4545-A32E-6CA68AA69734}" dt="2021-09-01T07:01:38.603" v="10"/>
            <ac:spMkLst>
              <pc:docMk/>
              <pc:sldMasterMk cId="4178710919" sldId="2147483709"/>
              <pc:sldLayoutMk cId="3892010027" sldId="2147483716"/>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892010027" sldId="2147483716"/>
              <ac:spMk id="8"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892010027" sldId="2147483716"/>
              <ac:spMk id="9"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892010027" sldId="2147483716"/>
              <ac:spMk id="14"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3892010027" sldId="2147483716"/>
              <ac:picMk id="7"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1700265458" sldId="2147483717"/>
          </pc:sldLayoutMkLst>
          <pc:spChg chg="mod">
            <ac:chgData name="Grace" userId="fd145552-a10d-4a31-a438-f8736fd84277" providerId="ADAL" clId="{56835480-2BB5-4545-A32E-6CA68AA69734}" dt="2021-09-01T07:01:38.603" v="10"/>
            <ac:spMkLst>
              <pc:docMk/>
              <pc:sldMasterMk cId="4178710919" sldId="2147483709"/>
              <pc:sldLayoutMk cId="1700265458" sldId="2147483717"/>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700265458" sldId="2147483717"/>
              <ac:spMk id="10"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700265458" sldId="2147483717"/>
              <ac:spMk id="11"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1700265458" sldId="2147483717"/>
              <ac:picMk id="6"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1700265458" sldId="2147483717"/>
              <ac:picMk id="7"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1051363576" sldId="2147483718"/>
          </pc:sldLayoutMkLst>
          <pc:spChg chg="mod">
            <ac:chgData name="Grace" userId="fd145552-a10d-4a31-a438-f8736fd84277" providerId="ADAL" clId="{56835480-2BB5-4545-A32E-6CA68AA69734}" dt="2021-09-01T07:01:38.603" v="10"/>
            <ac:spMkLst>
              <pc:docMk/>
              <pc:sldMasterMk cId="4178710919" sldId="2147483709"/>
              <pc:sldLayoutMk cId="1051363576" sldId="2147483718"/>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051363576" sldId="2147483718"/>
              <ac:spMk id="10"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051363576" sldId="2147483718"/>
              <ac:spMk id="11"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1051363576" sldId="2147483718"/>
              <ac:picMk id="6"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1051363576" sldId="2147483718"/>
              <ac:picMk id="7"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2194021123" sldId="2147483719"/>
          </pc:sldLayoutMkLst>
          <pc:spChg chg="mod">
            <ac:chgData name="Grace" userId="fd145552-a10d-4a31-a438-f8736fd84277" providerId="ADAL" clId="{56835480-2BB5-4545-A32E-6CA68AA69734}" dt="2021-09-01T07:01:38.603" v="10"/>
            <ac:spMkLst>
              <pc:docMk/>
              <pc:sldMasterMk cId="4178710919" sldId="2147483709"/>
              <pc:sldLayoutMk cId="2194021123" sldId="2147483719"/>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194021123" sldId="2147483719"/>
              <ac:spMk id="10"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194021123" sldId="2147483719"/>
              <ac:spMk id="11"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2194021123" sldId="2147483719"/>
              <ac:picMk id="6" creationId="{00000000-0000-0000-0000-000000000000}"/>
            </ac:picMkLst>
          </pc:picChg>
          <pc:picChg chg="mod">
            <ac:chgData name="Grace" userId="fd145552-a10d-4a31-a438-f8736fd84277" providerId="ADAL" clId="{56835480-2BB5-4545-A32E-6CA68AA69734}" dt="2021-09-01T07:01:38.603" v="10"/>
            <ac:picMkLst>
              <pc:docMk/>
              <pc:sldMasterMk cId="4178710919" sldId="2147483709"/>
              <pc:sldLayoutMk cId="2194021123" sldId="2147483719"/>
              <ac:picMk id="7"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3121668435" sldId="2147483720"/>
          </pc:sldLayoutMkLst>
          <pc:spChg chg="mod">
            <ac:chgData name="Grace" userId="fd145552-a10d-4a31-a438-f8736fd84277" providerId="ADAL" clId="{56835480-2BB5-4545-A32E-6CA68AA69734}" dt="2021-09-01T07:01:38.603" v="10"/>
            <ac:spMkLst>
              <pc:docMk/>
              <pc:sldMasterMk cId="4178710919" sldId="2147483709"/>
              <pc:sldLayoutMk cId="3121668435" sldId="2147483720"/>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121668435" sldId="2147483720"/>
              <ac:spMk id="10"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121668435" sldId="2147483720"/>
              <ac:spMk id="11"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3121668435" sldId="2147483720"/>
              <ac:picMk id="6" creationId="{00000000-0000-0000-0000-000000000000}"/>
            </ac:picMkLst>
          </pc:picChg>
        </pc:sldLayoutChg>
        <pc:sldLayoutChg chg="del">
          <pc:chgData name="Grace" userId="fd145552-a10d-4a31-a438-f8736fd84277" providerId="ADAL" clId="{56835480-2BB5-4545-A32E-6CA68AA69734}" dt="2021-09-01T07:01:43.763" v="11" actId="47"/>
          <pc:sldLayoutMkLst>
            <pc:docMk/>
            <pc:sldMasterMk cId="4178710919" sldId="2147483709"/>
            <pc:sldLayoutMk cId="731663526" sldId="2147483721"/>
          </pc:sldLayoutMkLst>
        </pc:sldLayoutChg>
        <pc:sldLayoutChg chg="modSp del">
          <pc:chgData name="Grace" userId="fd145552-a10d-4a31-a438-f8736fd84277" providerId="ADAL" clId="{56835480-2BB5-4545-A32E-6CA68AA69734}" dt="2021-09-01T07:01:43.763" v="11" actId="47"/>
          <pc:sldLayoutMkLst>
            <pc:docMk/>
            <pc:sldMasterMk cId="4178710919" sldId="2147483709"/>
            <pc:sldLayoutMk cId="219086793" sldId="2147483722"/>
          </pc:sldLayoutMkLst>
          <pc:spChg chg="mod">
            <ac:chgData name="Grace" userId="fd145552-a10d-4a31-a438-f8736fd84277" providerId="ADAL" clId="{56835480-2BB5-4545-A32E-6CA68AA69734}" dt="2021-09-01T07:01:38.603" v="10"/>
            <ac:spMkLst>
              <pc:docMk/>
              <pc:sldMasterMk cId="4178710919" sldId="2147483709"/>
              <pc:sldLayoutMk cId="219086793" sldId="2147483722"/>
              <ac:spMk id="3"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219086793" sldId="2147483722"/>
              <ac:spMk id="4" creationId="{00000000-0000-0000-0000-000000000000}"/>
            </ac:spMkLst>
          </pc:spChg>
        </pc:sldLayoutChg>
        <pc:sldLayoutChg chg="modSp del">
          <pc:chgData name="Grace" userId="fd145552-a10d-4a31-a438-f8736fd84277" providerId="ADAL" clId="{56835480-2BB5-4545-A32E-6CA68AA69734}" dt="2021-09-01T07:01:43.763" v="11" actId="47"/>
          <pc:sldLayoutMkLst>
            <pc:docMk/>
            <pc:sldMasterMk cId="4178710919" sldId="2147483709"/>
            <pc:sldLayoutMk cId="3206705883" sldId="2147483723"/>
          </pc:sldLayoutMkLst>
          <pc:spChg chg="mod">
            <ac:chgData name="Grace" userId="fd145552-a10d-4a31-a438-f8736fd84277" providerId="ADAL" clId="{56835480-2BB5-4545-A32E-6CA68AA69734}" dt="2021-09-01T07:01:38.603" v="10"/>
            <ac:spMkLst>
              <pc:docMk/>
              <pc:sldMasterMk cId="4178710919" sldId="2147483709"/>
              <pc:sldLayoutMk cId="3206705883" sldId="2147483723"/>
              <ac:spMk id="4"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206705883" sldId="2147483723"/>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206705883" sldId="2147483723"/>
              <ac:spMk id="9" creationId="{00000000-0000-0000-0000-000000000000}"/>
            </ac:spMkLst>
          </pc:spChg>
        </pc:sldLayoutChg>
        <pc:sldLayoutChg chg="modSp del">
          <pc:chgData name="Grace" userId="fd145552-a10d-4a31-a438-f8736fd84277" providerId="ADAL" clId="{56835480-2BB5-4545-A32E-6CA68AA69734}" dt="2021-09-01T07:01:43.763" v="11" actId="47"/>
          <pc:sldLayoutMkLst>
            <pc:docMk/>
            <pc:sldMasterMk cId="4178710919" sldId="2147483709"/>
            <pc:sldLayoutMk cId="1081166101" sldId="2147483724"/>
          </pc:sldLayoutMkLst>
          <pc:spChg chg="mod">
            <ac:chgData name="Grace" userId="fd145552-a10d-4a31-a438-f8736fd84277" providerId="ADAL" clId="{56835480-2BB5-4545-A32E-6CA68AA69734}" dt="2021-09-01T07:01:38.603" v="10"/>
            <ac:spMkLst>
              <pc:docMk/>
              <pc:sldMasterMk cId="4178710919" sldId="2147483709"/>
              <pc:sldLayoutMk cId="1081166101" sldId="2147483724"/>
              <ac:spMk id="4"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081166101" sldId="2147483724"/>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081166101" sldId="2147483724"/>
              <ac:spMk id="8" creationId="{00000000-0000-0000-0000-000000000000}"/>
            </ac:spMkLst>
          </pc:spChg>
        </pc:sldLayoutChg>
        <pc:sldLayoutChg chg="modSp del">
          <pc:chgData name="Grace" userId="fd145552-a10d-4a31-a438-f8736fd84277" providerId="ADAL" clId="{56835480-2BB5-4545-A32E-6CA68AA69734}" dt="2021-09-01T07:01:43.763" v="11" actId="47"/>
          <pc:sldLayoutMkLst>
            <pc:docMk/>
            <pc:sldMasterMk cId="4178710919" sldId="2147483709"/>
            <pc:sldLayoutMk cId="313811570" sldId="2147483725"/>
          </pc:sldLayoutMkLst>
          <pc:spChg chg="mod">
            <ac:chgData name="Grace" userId="fd145552-a10d-4a31-a438-f8736fd84277" providerId="ADAL" clId="{56835480-2BB5-4545-A32E-6CA68AA69734}" dt="2021-09-01T07:01:38.603" v="10"/>
            <ac:spMkLst>
              <pc:docMk/>
              <pc:sldMasterMk cId="4178710919" sldId="2147483709"/>
              <pc:sldLayoutMk cId="313811570" sldId="2147483725"/>
              <ac:spMk id="4"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13811570" sldId="2147483725"/>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13811570" sldId="2147483725"/>
              <ac:spMk id="8" creationId="{00000000-0000-0000-0000-000000000000}"/>
            </ac:spMkLst>
          </pc:spChg>
        </pc:sldLayoutChg>
        <pc:sldLayoutChg chg="del">
          <pc:chgData name="Grace" userId="fd145552-a10d-4a31-a438-f8736fd84277" providerId="ADAL" clId="{56835480-2BB5-4545-A32E-6CA68AA69734}" dt="2021-09-01T07:01:43.763" v="11" actId="47"/>
          <pc:sldLayoutMkLst>
            <pc:docMk/>
            <pc:sldMasterMk cId="4178710919" sldId="2147483709"/>
            <pc:sldLayoutMk cId="3013978440" sldId="2147483726"/>
          </pc:sldLayoutMkLst>
        </pc:sldLayoutChg>
        <pc:sldLayoutChg chg="del">
          <pc:chgData name="Grace" userId="fd145552-a10d-4a31-a438-f8736fd84277" providerId="ADAL" clId="{56835480-2BB5-4545-A32E-6CA68AA69734}" dt="2021-09-01T07:01:43.763" v="11" actId="47"/>
          <pc:sldLayoutMkLst>
            <pc:docMk/>
            <pc:sldMasterMk cId="4178710919" sldId="2147483709"/>
            <pc:sldLayoutMk cId="2691557549" sldId="2147483727"/>
          </pc:sldLayoutMkLst>
        </pc:sldLayoutChg>
        <pc:sldLayoutChg chg="del">
          <pc:chgData name="Grace" userId="fd145552-a10d-4a31-a438-f8736fd84277" providerId="ADAL" clId="{56835480-2BB5-4545-A32E-6CA68AA69734}" dt="2021-09-01T07:01:43.763" v="11" actId="47"/>
          <pc:sldLayoutMkLst>
            <pc:docMk/>
            <pc:sldMasterMk cId="4178710919" sldId="2147483709"/>
            <pc:sldLayoutMk cId="4053811644" sldId="2147483728"/>
          </pc:sldLayoutMkLst>
        </pc:sldLayoutChg>
        <pc:sldLayoutChg chg="modSp del">
          <pc:chgData name="Grace" userId="fd145552-a10d-4a31-a438-f8736fd84277" providerId="ADAL" clId="{56835480-2BB5-4545-A32E-6CA68AA69734}" dt="2021-09-01T07:01:43.763" v="11" actId="47"/>
          <pc:sldLayoutMkLst>
            <pc:docMk/>
            <pc:sldMasterMk cId="4178710919" sldId="2147483709"/>
            <pc:sldLayoutMk cId="3383184991" sldId="2147483729"/>
          </pc:sldLayoutMkLst>
          <pc:spChg chg="mod">
            <ac:chgData name="Grace" userId="fd145552-a10d-4a31-a438-f8736fd84277" providerId="ADAL" clId="{56835480-2BB5-4545-A32E-6CA68AA69734}" dt="2021-09-01T07:01:38.603" v="10"/>
            <ac:spMkLst>
              <pc:docMk/>
              <pc:sldMasterMk cId="4178710919" sldId="2147483709"/>
              <pc:sldLayoutMk cId="3383184991" sldId="2147483729"/>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383184991" sldId="2147483729"/>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383184991" sldId="2147483729"/>
              <ac:spMk id="7"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383184991" sldId="2147483729"/>
              <ac:spMk id="9"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3383184991" sldId="2147483729"/>
              <ac:picMk id="8"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3952739341" sldId="2147483730"/>
          </pc:sldLayoutMkLst>
          <pc:spChg chg="mod">
            <ac:chgData name="Grace" userId="fd145552-a10d-4a31-a438-f8736fd84277" providerId="ADAL" clId="{56835480-2BB5-4545-A32E-6CA68AA69734}" dt="2021-09-01T07:01:38.603" v="10"/>
            <ac:spMkLst>
              <pc:docMk/>
              <pc:sldMasterMk cId="4178710919" sldId="2147483709"/>
              <pc:sldLayoutMk cId="3952739341" sldId="2147483730"/>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952739341" sldId="2147483730"/>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3952739341" sldId="2147483730"/>
              <ac:spMk id="9"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3952739341" sldId="2147483730"/>
              <ac:picMk id="8"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688524828" sldId="2147483731"/>
          </pc:sldLayoutMkLst>
          <pc:spChg chg="mod">
            <ac:chgData name="Grace" userId="fd145552-a10d-4a31-a438-f8736fd84277" providerId="ADAL" clId="{56835480-2BB5-4545-A32E-6CA68AA69734}" dt="2021-09-01T07:01:38.603" v="10"/>
            <ac:spMkLst>
              <pc:docMk/>
              <pc:sldMasterMk cId="4178710919" sldId="2147483709"/>
              <pc:sldLayoutMk cId="688524828" sldId="2147483731"/>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688524828" sldId="2147483731"/>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688524828" sldId="2147483731"/>
              <ac:spMk id="9"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688524828" sldId="2147483731"/>
              <ac:picMk id="7" creationId="{00000000-0000-0000-0000-000000000000}"/>
            </ac:picMkLst>
          </pc:picChg>
        </pc:sldLayoutChg>
        <pc:sldLayoutChg chg="modSp del">
          <pc:chgData name="Grace" userId="fd145552-a10d-4a31-a438-f8736fd84277" providerId="ADAL" clId="{56835480-2BB5-4545-A32E-6CA68AA69734}" dt="2021-09-01T07:01:43.763" v="11" actId="47"/>
          <pc:sldLayoutMkLst>
            <pc:docMk/>
            <pc:sldMasterMk cId="4178710919" sldId="2147483709"/>
            <pc:sldLayoutMk cId="1819563338" sldId="2147483732"/>
          </pc:sldLayoutMkLst>
          <pc:spChg chg="mod">
            <ac:chgData name="Grace" userId="fd145552-a10d-4a31-a438-f8736fd84277" providerId="ADAL" clId="{56835480-2BB5-4545-A32E-6CA68AA69734}" dt="2021-09-01T07:01:38.603" v="10"/>
            <ac:spMkLst>
              <pc:docMk/>
              <pc:sldMasterMk cId="4178710919" sldId="2147483709"/>
              <pc:sldLayoutMk cId="1819563338" sldId="2147483732"/>
              <ac:spMk id="5"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819563338" sldId="2147483732"/>
              <ac:spMk id="6" creationId="{00000000-0000-0000-0000-000000000000}"/>
            </ac:spMkLst>
          </pc:spChg>
          <pc:spChg chg="mod">
            <ac:chgData name="Grace" userId="fd145552-a10d-4a31-a438-f8736fd84277" providerId="ADAL" clId="{56835480-2BB5-4545-A32E-6CA68AA69734}" dt="2021-09-01T07:01:38.603" v="10"/>
            <ac:spMkLst>
              <pc:docMk/>
              <pc:sldMasterMk cId="4178710919" sldId="2147483709"/>
              <pc:sldLayoutMk cId="1819563338" sldId="2147483732"/>
              <ac:spMk id="9" creationId="{00000000-0000-0000-0000-000000000000}"/>
            </ac:spMkLst>
          </pc:spChg>
          <pc:picChg chg="mod">
            <ac:chgData name="Grace" userId="fd145552-a10d-4a31-a438-f8736fd84277" providerId="ADAL" clId="{56835480-2BB5-4545-A32E-6CA68AA69734}" dt="2021-09-01T07:01:38.603" v="10"/>
            <ac:picMkLst>
              <pc:docMk/>
              <pc:sldMasterMk cId="4178710919" sldId="2147483709"/>
              <pc:sldLayoutMk cId="1819563338" sldId="2147483732"/>
              <ac:picMk id="8" creationId="{00000000-0000-0000-0000-000000000000}"/>
            </ac:picMkLst>
          </pc:picChg>
        </pc:sldLayoutChg>
      </pc:sldMasterChg>
      <pc:sldMasterChg chg="del delSldLayout">
        <pc:chgData name="Grace" userId="fd145552-a10d-4a31-a438-f8736fd84277" providerId="ADAL" clId="{56835480-2BB5-4545-A32E-6CA68AA69734}" dt="2021-09-01T23:20:25.511" v="2554" actId="47"/>
        <pc:sldMasterMkLst>
          <pc:docMk/>
          <pc:sldMasterMk cId="2769295756" sldId="2147483758"/>
        </pc:sldMasterMkLst>
        <pc:sldLayoutChg chg="del">
          <pc:chgData name="Grace" userId="fd145552-a10d-4a31-a438-f8736fd84277" providerId="ADAL" clId="{56835480-2BB5-4545-A32E-6CA68AA69734}" dt="2021-09-01T23:20:25.511" v="2554" actId="47"/>
          <pc:sldLayoutMkLst>
            <pc:docMk/>
            <pc:sldMasterMk cId="2769295756" sldId="2147483758"/>
            <pc:sldLayoutMk cId="2631654186" sldId="2147483759"/>
          </pc:sldLayoutMkLst>
        </pc:sldLayoutChg>
      </pc:sldMasterChg>
      <pc:sldMasterChg chg="modSp delSldLayout modSldLayout">
        <pc:chgData name="Grace" userId="fd145552-a10d-4a31-a438-f8736fd84277" providerId="ADAL" clId="{56835480-2BB5-4545-A32E-6CA68AA69734}" dt="2021-09-01T22:43:45.116" v="990" actId="47"/>
        <pc:sldMasterMkLst>
          <pc:docMk/>
          <pc:sldMasterMk cId="3216822255" sldId="2147483758"/>
        </pc:sldMasterMkLst>
        <pc:spChg chg="mod">
          <ac:chgData name="Grace" userId="fd145552-a10d-4a31-a438-f8736fd84277" providerId="ADAL" clId="{56835480-2BB5-4545-A32E-6CA68AA69734}" dt="2021-09-01T07:01:38.603" v="10"/>
          <ac:spMkLst>
            <pc:docMk/>
            <pc:sldMasterMk cId="3216822255" sldId="2147483758"/>
            <ac:spMk id="6" creationId="{B454F75B-D7A2-4B14-8535-B803517C2A15}"/>
          </ac:spMkLst>
        </pc:spChg>
        <pc:spChg chg="mod">
          <ac:chgData name="Grace" userId="fd145552-a10d-4a31-a438-f8736fd84277" providerId="ADAL" clId="{56835480-2BB5-4545-A32E-6CA68AA69734}" dt="2021-09-01T07:01:38.603" v="10"/>
          <ac:spMkLst>
            <pc:docMk/>
            <pc:sldMasterMk cId="3216822255" sldId="2147483758"/>
            <ac:spMk id="7" creationId="{BE9EF11D-F5BE-ED40-AB5F-104A2C9A67EF}"/>
          </ac:spMkLst>
        </pc:spChg>
        <pc:spChg chg="mod">
          <ac:chgData name="Grace" userId="fd145552-a10d-4a31-a438-f8736fd84277" providerId="ADAL" clId="{56835480-2BB5-4545-A32E-6CA68AA69734}" dt="2021-09-01T07:01:38.603" v="10"/>
          <ac:spMkLst>
            <pc:docMk/>
            <pc:sldMasterMk cId="3216822255" sldId="2147483758"/>
            <ac:spMk id="8" creationId="{31D8007C-8639-1A4A-A2BB-5F88DD41E22F}"/>
          </ac:spMkLst>
        </pc:spChg>
        <pc:spChg chg="mod">
          <ac:chgData name="Grace" userId="fd145552-a10d-4a31-a438-f8736fd84277" providerId="ADAL" clId="{56835480-2BB5-4545-A32E-6CA68AA69734}" dt="2021-09-01T07:01:38.603" v="10"/>
          <ac:spMkLst>
            <pc:docMk/>
            <pc:sldMasterMk cId="3216822255" sldId="2147483758"/>
            <ac:spMk id="12" creationId="{00000000-0000-0000-0000-000000000000}"/>
          </ac:spMkLst>
        </pc:spChg>
        <pc:sldLayoutChg chg="modSp">
          <pc:chgData name="Grace" userId="fd145552-a10d-4a31-a438-f8736fd84277" providerId="ADAL" clId="{56835480-2BB5-4545-A32E-6CA68AA69734}" dt="2021-09-01T07:01:38.603" v="10"/>
          <pc:sldLayoutMkLst>
            <pc:docMk/>
            <pc:sldMasterMk cId="3216822255" sldId="2147483672"/>
            <pc:sldLayoutMk cId="948191856" sldId="2147483673"/>
          </pc:sldLayoutMkLst>
          <pc:spChg chg="mod">
            <ac:chgData name="Grace" userId="fd145552-a10d-4a31-a438-f8736fd84277" providerId="ADAL" clId="{56835480-2BB5-4545-A32E-6CA68AA69734}" dt="2021-09-01T07:01:38.603" v="10"/>
            <ac:spMkLst>
              <pc:docMk/>
              <pc:sldMasterMk cId="3216822255" sldId="2147483672"/>
              <pc:sldLayoutMk cId="948191856" sldId="2147483673"/>
              <ac:spMk id="6" creationId="{82AB734E-09E2-4C5B-B359-F44C155BFDAF}"/>
            </ac:spMkLst>
          </pc:spChg>
          <pc:spChg chg="mod">
            <ac:chgData name="Grace" userId="fd145552-a10d-4a31-a438-f8736fd84277" providerId="ADAL" clId="{56835480-2BB5-4545-A32E-6CA68AA69734}" dt="2021-09-01T07:01:38.603" v="10"/>
            <ac:spMkLst>
              <pc:docMk/>
              <pc:sldMasterMk cId="3216822255" sldId="2147483672"/>
              <pc:sldLayoutMk cId="948191856" sldId="2147483673"/>
              <ac:spMk id="7"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948191856" sldId="2147483673"/>
              <ac:spMk id="8"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948191856" sldId="2147483673"/>
              <ac:spMk id="14" creationId="{00000000-0000-0000-0000-000000000000}"/>
            </ac:spMkLst>
          </pc:spChg>
          <pc:picChg chg="mod">
            <ac:chgData name="Grace" userId="fd145552-a10d-4a31-a438-f8736fd84277" providerId="ADAL" clId="{56835480-2BB5-4545-A32E-6CA68AA69734}" dt="2021-09-01T07:01:38.603" v="10"/>
            <ac:picMkLst>
              <pc:docMk/>
              <pc:sldMasterMk cId="3216822255" sldId="2147483672"/>
              <pc:sldLayoutMk cId="948191856" sldId="2147483673"/>
              <ac:picMk id="15" creationId="{FA42B4BB-E4AF-4E77-8720-34E6A0B4EC17}"/>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1290205806" sldId="2147483674"/>
          </pc:sldLayoutMkLst>
          <pc:spChg chg="mod">
            <ac:chgData name="Grace" userId="fd145552-a10d-4a31-a438-f8736fd84277" providerId="ADAL" clId="{56835480-2BB5-4545-A32E-6CA68AA69734}" dt="2021-09-01T07:01:38.603" v="10"/>
            <ac:spMkLst>
              <pc:docMk/>
              <pc:sldMasterMk cId="3216822255" sldId="2147483672"/>
              <pc:sldLayoutMk cId="1290205806" sldId="2147483674"/>
              <ac:spMk id="7" creationId="{B7BF95FE-2C8C-1143-AEE5-415586951E2F}"/>
            </ac:spMkLst>
          </pc:spChg>
          <pc:spChg chg="mod">
            <ac:chgData name="Grace" userId="fd145552-a10d-4a31-a438-f8736fd84277" providerId="ADAL" clId="{56835480-2BB5-4545-A32E-6CA68AA69734}" dt="2021-09-01T07:01:38.603" v="10"/>
            <ac:spMkLst>
              <pc:docMk/>
              <pc:sldMasterMk cId="3216822255" sldId="2147483672"/>
              <pc:sldLayoutMk cId="1290205806" sldId="2147483674"/>
              <ac:spMk id="9" creationId="{A93CB376-C0CB-ED45-B607-FE09FC31D218}"/>
            </ac:spMkLst>
          </pc:spChg>
          <pc:spChg chg="mod">
            <ac:chgData name="Grace" userId="fd145552-a10d-4a31-a438-f8736fd84277" providerId="ADAL" clId="{56835480-2BB5-4545-A32E-6CA68AA69734}" dt="2021-09-01T07:01:38.603" v="10"/>
            <ac:spMkLst>
              <pc:docMk/>
              <pc:sldMasterMk cId="3216822255" sldId="2147483672"/>
              <pc:sldLayoutMk cId="1290205806" sldId="2147483674"/>
              <ac:spMk id="12" creationId="{C6464A0A-2E52-4325-8E9A-4FE513E8B588}"/>
            </ac:spMkLst>
          </pc:spChg>
          <pc:picChg chg="mod">
            <ac:chgData name="Grace" userId="fd145552-a10d-4a31-a438-f8736fd84277" providerId="ADAL" clId="{56835480-2BB5-4545-A32E-6CA68AA69734}" dt="2021-09-01T07:01:38.603" v="10"/>
            <ac:picMkLst>
              <pc:docMk/>
              <pc:sldMasterMk cId="3216822255" sldId="2147483672"/>
              <pc:sldLayoutMk cId="1290205806" sldId="2147483674"/>
              <ac:picMk id="13" creationId="{63312DD7-C717-A94A-9B5F-6550C2610BB6}"/>
            </ac:picMkLst>
          </pc:picChg>
          <pc:picChg chg="mod">
            <ac:chgData name="Grace" userId="fd145552-a10d-4a31-a438-f8736fd84277" providerId="ADAL" clId="{56835480-2BB5-4545-A32E-6CA68AA69734}" dt="2021-09-01T07:01:38.603" v="10"/>
            <ac:picMkLst>
              <pc:docMk/>
              <pc:sldMasterMk cId="3216822255" sldId="2147483672"/>
              <pc:sldLayoutMk cId="1290205806" sldId="2147483674"/>
              <ac:picMk id="14" creationId="{B1AC6F61-871E-4989-A8F8-D68037365963}"/>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3964749844" sldId="2147483675"/>
          </pc:sldLayoutMkLst>
          <pc:spChg chg="mod">
            <ac:chgData name="Grace" userId="fd145552-a10d-4a31-a438-f8736fd84277" providerId="ADAL" clId="{56835480-2BB5-4545-A32E-6CA68AA69734}" dt="2021-09-01T07:01:38.603" v="10"/>
            <ac:spMkLst>
              <pc:docMk/>
              <pc:sldMasterMk cId="3216822255" sldId="2147483672"/>
              <pc:sldLayoutMk cId="3964749844" sldId="2147483675"/>
              <ac:spMk id="7" creationId="{01B2F048-E8FC-8A4E-8DDE-647F5445BFE9}"/>
            </ac:spMkLst>
          </pc:spChg>
          <pc:spChg chg="mod">
            <ac:chgData name="Grace" userId="fd145552-a10d-4a31-a438-f8736fd84277" providerId="ADAL" clId="{56835480-2BB5-4545-A32E-6CA68AA69734}" dt="2021-09-01T07:01:38.603" v="10"/>
            <ac:spMkLst>
              <pc:docMk/>
              <pc:sldMasterMk cId="3216822255" sldId="2147483672"/>
              <pc:sldLayoutMk cId="3964749844" sldId="2147483675"/>
              <ac:spMk id="11" creationId="{A0F5EAC1-9F73-5641-AB32-0ED689CDEEB3}"/>
            </ac:spMkLst>
          </pc:spChg>
          <pc:spChg chg="mod">
            <ac:chgData name="Grace" userId="fd145552-a10d-4a31-a438-f8736fd84277" providerId="ADAL" clId="{56835480-2BB5-4545-A32E-6CA68AA69734}" dt="2021-09-01T07:01:38.603" v="10"/>
            <ac:spMkLst>
              <pc:docMk/>
              <pc:sldMasterMk cId="3216822255" sldId="2147483672"/>
              <pc:sldLayoutMk cId="3964749844" sldId="2147483675"/>
              <ac:spMk id="12" creationId="{C6464A0A-2E52-4325-8E9A-4FE513E8B588}"/>
            </ac:spMkLst>
          </pc:spChg>
          <pc:picChg chg="mod">
            <ac:chgData name="Grace" userId="fd145552-a10d-4a31-a438-f8736fd84277" providerId="ADAL" clId="{56835480-2BB5-4545-A32E-6CA68AA69734}" dt="2021-09-01T07:01:38.603" v="10"/>
            <ac:picMkLst>
              <pc:docMk/>
              <pc:sldMasterMk cId="3216822255" sldId="2147483672"/>
              <pc:sldLayoutMk cId="3964749844" sldId="2147483675"/>
              <ac:picMk id="9" creationId="{FD846324-0975-4A42-9910-97B18EAE44BA}"/>
            </ac:picMkLst>
          </pc:picChg>
          <pc:picChg chg="mod">
            <ac:chgData name="Grace" userId="fd145552-a10d-4a31-a438-f8736fd84277" providerId="ADAL" clId="{56835480-2BB5-4545-A32E-6CA68AA69734}" dt="2021-09-01T07:01:38.603" v="10"/>
            <ac:picMkLst>
              <pc:docMk/>
              <pc:sldMasterMk cId="3216822255" sldId="2147483672"/>
              <pc:sldLayoutMk cId="3964749844" sldId="2147483675"/>
              <ac:picMk id="14" creationId="{B1AC6F61-871E-4989-A8F8-D68037365963}"/>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4275949818" sldId="2147483676"/>
          </pc:sldLayoutMkLst>
          <pc:spChg chg="mod">
            <ac:chgData name="Grace" userId="fd145552-a10d-4a31-a438-f8736fd84277" providerId="ADAL" clId="{56835480-2BB5-4545-A32E-6CA68AA69734}" dt="2021-09-01T07:01:38.603" v="10"/>
            <ac:spMkLst>
              <pc:docMk/>
              <pc:sldMasterMk cId="3216822255" sldId="2147483672"/>
              <pc:sldLayoutMk cId="4275949818" sldId="2147483676"/>
              <ac:spMk id="7" creationId="{81F9E4D6-F775-284D-ADC5-7A967F62816A}"/>
            </ac:spMkLst>
          </pc:spChg>
          <pc:spChg chg="mod">
            <ac:chgData name="Grace" userId="fd145552-a10d-4a31-a438-f8736fd84277" providerId="ADAL" clId="{56835480-2BB5-4545-A32E-6CA68AA69734}" dt="2021-09-01T07:01:38.603" v="10"/>
            <ac:spMkLst>
              <pc:docMk/>
              <pc:sldMasterMk cId="3216822255" sldId="2147483672"/>
              <pc:sldLayoutMk cId="4275949818" sldId="2147483676"/>
              <ac:spMk id="9" creationId="{B3D86596-91B6-7849-AB9A-968689EE4B5E}"/>
            </ac:spMkLst>
          </pc:spChg>
          <pc:spChg chg="mod">
            <ac:chgData name="Grace" userId="fd145552-a10d-4a31-a438-f8736fd84277" providerId="ADAL" clId="{56835480-2BB5-4545-A32E-6CA68AA69734}" dt="2021-09-01T07:01:38.603" v="10"/>
            <ac:spMkLst>
              <pc:docMk/>
              <pc:sldMasterMk cId="3216822255" sldId="2147483672"/>
              <pc:sldLayoutMk cId="4275949818" sldId="2147483676"/>
              <ac:spMk id="12" creationId="{C6464A0A-2E52-4325-8E9A-4FE513E8B588}"/>
            </ac:spMkLst>
          </pc:spChg>
          <pc:picChg chg="mod">
            <ac:chgData name="Grace" userId="fd145552-a10d-4a31-a438-f8736fd84277" providerId="ADAL" clId="{56835480-2BB5-4545-A32E-6CA68AA69734}" dt="2021-09-01T07:01:38.603" v="10"/>
            <ac:picMkLst>
              <pc:docMk/>
              <pc:sldMasterMk cId="3216822255" sldId="2147483672"/>
              <pc:sldLayoutMk cId="4275949818" sldId="2147483676"/>
              <ac:picMk id="11" creationId="{5B555A18-63E4-4E45-B51E-13C52CD37CCD}"/>
            </ac:picMkLst>
          </pc:picChg>
          <pc:picChg chg="mod">
            <ac:chgData name="Grace" userId="fd145552-a10d-4a31-a438-f8736fd84277" providerId="ADAL" clId="{56835480-2BB5-4545-A32E-6CA68AA69734}" dt="2021-09-01T07:01:38.603" v="10"/>
            <ac:picMkLst>
              <pc:docMk/>
              <pc:sldMasterMk cId="3216822255" sldId="2147483672"/>
              <pc:sldLayoutMk cId="4275949818" sldId="2147483676"/>
              <ac:picMk id="14" creationId="{B1AC6F61-871E-4989-A8F8-D68037365963}"/>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707706560" sldId="2147483677"/>
          </pc:sldLayoutMkLst>
          <pc:spChg chg="mod">
            <ac:chgData name="Grace" userId="fd145552-a10d-4a31-a438-f8736fd84277" providerId="ADAL" clId="{56835480-2BB5-4545-A32E-6CA68AA69734}" dt="2021-09-01T07:01:38.603" v="10"/>
            <ac:spMkLst>
              <pc:docMk/>
              <pc:sldMasterMk cId="3216822255" sldId="2147483672"/>
              <pc:sldLayoutMk cId="707706560" sldId="2147483677"/>
              <ac:spMk id="6" creationId="{B576A394-6B1F-4D42-AB9D-E8AC240619B4}"/>
            </ac:spMkLst>
          </pc:spChg>
          <pc:spChg chg="mod">
            <ac:chgData name="Grace" userId="fd145552-a10d-4a31-a438-f8736fd84277" providerId="ADAL" clId="{56835480-2BB5-4545-A32E-6CA68AA69734}" dt="2021-09-01T07:01:38.603" v="10"/>
            <ac:spMkLst>
              <pc:docMk/>
              <pc:sldMasterMk cId="3216822255" sldId="2147483672"/>
              <pc:sldLayoutMk cId="707706560" sldId="2147483677"/>
              <ac:spMk id="11" creationId="{AD8A8234-470B-6B4C-AD83-A953D38FF07F}"/>
            </ac:spMkLst>
          </pc:spChg>
          <pc:spChg chg="mod">
            <ac:chgData name="Grace" userId="fd145552-a10d-4a31-a438-f8736fd84277" providerId="ADAL" clId="{56835480-2BB5-4545-A32E-6CA68AA69734}" dt="2021-09-01T07:01:38.603" v="10"/>
            <ac:spMkLst>
              <pc:docMk/>
              <pc:sldMasterMk cId="3216822255" sldId="2147483672"/>
              <pc:sldLayoutMk cId="707706560" sldId="2147483677"/>
              <ac:spMk id="12" creationId="{E77678A9-BBDF-6240-A6E9-6AFE2E759E75}"/>
            </ac:spMkLst>
          </pc:spChg>
          <pc:picChg chg="mod">
            <ac:chgData name="Grace" userId="fd145552-a10d-4a31-a438-f8736fd84277" providerId="ADAL" clId="{56835480-2BB5-4545-A32E-6CA68AA69734}" dt="2021-09-01T07:01:38.603" v="10"/>
            <ac:picMkLst>
              <pc:docMk/>
              <pc:sldMasterMk cId="3216822255" sldId="2147483672"/>
              <pc:sldLayoutMk cId="707706560" sldId="2147483677"/>
              <ac:picMk id="9" creationId="{A196A5F0-0505-454C-9646-38C0888EAC78}"/>
            </ac:picMkLst>
          </pc:picChg>
          <pc:picChg chg="mod">
            <ac:chgData name="Grace" userId="fd145552-a10d-4a31-a438-f8736fd84277" providerId="ADAL" clId="{56835480-2BB5-4545-A32E-6CA68AA69734}" dt="2021-09-01T07:01:38.603" v="10"/>
            <ac:picMkLst>
              <pc:docMk/>
              <pc:sldMasterMk cId="3216822255" sldId="2147483672"/>
              <pc:sldLayoutMk cId="707706560" sldId="2147483677"/>
              <ac:picMk id="10" creationId="{1811C849-DF8E-4316-9166-B19E70AB3203}"/>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741817607" sldId="2147483678"/>
          </pc:sldLayoutMkLst>
          <pc:spChg chg="mod">
            <ac:chgData name="Grace" userId="fd145552-a10d-4a31-a438-f8736fd84277" providerId="ADAL" clId="{56835480-2BB5-4545-A32E-6CA68AA69734}" dt="2021-09-01T07:01:38.603" v="10"/>
            <ac:spMkLst>
              <pc:docMk/>
              <pc:sldMasterMk cId="3216822255" sldId="2147483672"/>
              <pc:sldLayoutMk cId="741817607" sldId="2147483678"/>
              <ac:spMk id="6" creationId="{B576A394-6B1F-4D42-AB9D-E8AC240619B4}"/>
            </ac:spMkLst>
          </pc:spChg>
          <pc:spChg chg="mod">
            <ac:chgData name="Grace" userId="fd145552-a10d-4a31-a438-f8736fd84277" providerId="ADAL" clId="{56835480-2BB5-4545-A32E-6CA68AA69734}" dt="2021-09-01T07:01:38.603" v="10"/>
            <ac:spMkLst>
              <pc:docMk/>
              <pc:sldMasterMk cId="3216822255" sldId="2147483672"/>
              <pc:sldLayoutMk cId="741817607" sldId="2147483678"/>
              <ac:spMk id="9" creationId="{193FD27B-FAA6-5146-83B6-51116F88C944}"/>
            </ac:spMkLst>
          </pc:spChg>
          <pc:spChg chg="mod">
            <ac:chgData name="Grace" userId="fd145552-a10d-4a31-a438-f8736fd84277" providerId="ADAL" clId="{56835480-2BB5-4545-A32E-6CA68AA69734}" dt="2021-09-01T07:01:38.603" v="10"/>
            <ac:spMkLst>
              <pc:docMk/>
              <pc:sldMasterMk cId="3216822255" sldId="2147483672"/>
              <pc:sldLayoutMk cId="741817607" sldId="2147483678"/>
              <ac:spMk id="11" creationId="{75385F31-8F09-6A45-AFFF-B72CD3787A00}"/>
            </ac:spMkLst>
          </pc:spChg>
          <pc:picChg chg="mod">
            <ac:chgData name="Grace" userId="fd145552-a10d-4a31-a438-f8736fd84277" providerId="ADAL" clId="{56835480-2BB5-4545-A32E-6CA68AA69734}" dt="2021-09-01T07:01:38.603" v="10"/>
            <ac:picMkLst>
              <pc:docMk/>
              <pc:sldMasterMk cId="3216822255" sldId="2147483672"/>
              <pc:sldLayoutMk cId="741817607" sldId="2147483678"/>
              <ac:picMk id="10" creationId="{1811C849-DF8E-4316-9166-B19E70AB3203}"/>
            </ac:picMkLst>
          </pc:picChg>
          <pc:picChg chg="mod">
            <ac:chgData name="Grace" userId="fd145552-a10d-4a31-a438-f8736fd84277" providerId="ADAL" clId="{56835480-2BB5-4545-A32E-6CA68AA69734}" dt="2021-09-01T07:01:38.603" v="10"/>
            <ac:picMkLst>
              <pc:docMk/>
              <pc:sldMasterMk cId="3216822255" sldId="2147483672"/>
              <pc:sldLayoutMk cId="741817607" sldId="2147483678"/>
              <ac:picMk id="14" creationId="{24F1E7D3-CFB1-DF4E-96E4-6210BAC6FB4A}"/>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141095947" sldId="2147483679"/>
          </pc:sldLayoutMkLst>
          <pc:spChg chg="mod">
            <ac:chgData name="Grace" userId="fd145552-a10d-4a31-a438-f8736fd84277" providerId="ADAL" clId="{56835480-2BB5-4545-A32E-6CA68AA69734}" dt="2021-09-01T07:01:38.603" v="10"/>
            <ac:spMkLst>
              <pc:docMk/>
              <pc:sldMasterMk cId="3216822255" sldId="2147483672"/>
              <pc:sldLayoutMk cId="2141095947" sldId="2147483679"/>
              <ac:spMk id="6" creationId="{B576A394-6B1F-4D42-AB9D-E8AC240619B4}"/>
            </ac:spMkLst>
          </pc:spChg>
          <pc:spChg chg="mod">
            <ac:chgData name="Grace" userId="fd145552-a10d-4a31-a438-f8736fd84277" providerId="ADAL" clId="{56835480-2BB5-4545-A32E-6CA68AA69734}" dt="2021-09-01T07:01:38.603" v="10"/>
            <ac:spMkLst>
              <pc:docMk/>
              <pc:sldMasterMk cId="3216822255" sldId="2147483672"/>
              <pc:sldLayoutMk cId="2141095947" sldId="2147483679"/>
              <ac:spMk id="9" creationId="{A30F13B7-229E-5241-B814-6E82C23DC922}"/>
            </ac:spMkLst>
          </pc:spChg>
          <pc:spChg chg="mod">
            <ac:chgData name="Grace" userId="fd145552-a10d-4a31-a438-f8736fd84277" providerId="ADAL" clId="{56835480-2BB5-4545-A32E-6CA68AA69734}" dt="2021-09-01T07:01:38.603" v="10"/>
            <ac:spMkLst>
              <pc:docMk/>
              <pc:sldMasterMk cId="3216822255" sldId="2147483672"/>
              <pc:sldLayoutMk cId="2141095947" sldId="2147483679"/>
              <ac:spMk id="12" creationId="{0FD801D8-52D3-ED4C-9286-C21422F9D5A9}"/>
            </ac:spMkLst>
          </pc:spChg>
          <pc:picChg chg="mod">
            <ac:chgData name="Grace" userId="fd145552-a10d-4a31-a438-f8736fd84277" providerId="ADAL" clId="{56835480-2BB5-4545-A32E-6CA68AA69734}" dt="2021-09-01T07:01:38.603" v="10"/>
            <ac:picMkLst>
              <pc:docMk/>
              <pc:sldMasterMk cId="3216822255" sldId="2147483672"/>
              <pc:sldLayoutMk cId="2141095947" sldId="2147483679"/>
              <ac:picMk id="10" creationId="{1811C849-DF8E-4316-9166-B19E70AB3203}"/>
            </ac:picMkLst>
          </pc:picChg>
          <pc:picChg chg="mod">
            <ac:chgData name="Grace" userId="fd145552-a10d-4a31-a438-f8736fd84277" providerId="ADAL" clId="{56835480-2BB5-4545-A32E-6CA68AA69734}" dt="2021-09-01T07:01:38.603" v="10"/>
            <ac:picMkLst>
              <pc:docMk/>
              <pc:sldMasterMk cId="3216822255" sldId="2147483672"/>
              <pc:sldLayoutMk cId="2141095947" sldId="2147483679"/>
              <ac:picMk id="11" creationId="{6448CA2D-2D83-6F40-B080-DAE168D45EFB}"/>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703272592" sldId="2147483680"/>
          </pc:sldLayoutMkLst>
          <pc:spChg chg="mod">
            <ac:chgData name="Grace" userId="fd145552-a10d-4a31-a438-f8736fd84277" providerId="ADAL" clId="{56835480-2BB5-4545-A32E-6CA68AA69734}" dt="2021-09-01T07:01:38.603" v="10"/>
            <ac:spMkLst>
              <pc:docMk/>
              <pc:sldMasterMk cId="3216822255" sldId="2147483672"/>
              <pc:sldLayoutMk cId="2703272592" sldId="2147483680"/>
              <ac:spMk id="6" creationId="{B576A394-6B1F-4D42-AB9D-E8AC240619B4}"/>
            </ac:spMkLst>
          </pc:spChg>
          <pc:spChg chg="mod">
            <ac:chgData name="Grace" userId="fd145552-a10d-4a31-a438-f8736fd84277" providerId="ADAL" clId="{56835480-2BB5-4545-A32E-6CA68AA69734}" dt="2021-09-01T07:01:38.603" v="10"/>
            <ac:spMkLst>
              <pc:docMk/>
              <pc:sldMasterMk cId="3216822255" sldId="2147483672"/>
              <pc:sldLayoutMk cId="2703272592" sldId="2147483680"/>
              <ac:spMk id="11" creationId="{4B7D9D05-70A7-7340-98E2-3EC55807DF76}"/>
            </ac:spMkLst>
          </pc:spChg>
          <pc:spChg chg="mod">
            <ac:chgData name="Grace" userId="fd145552-a10d-4a31-a438-f8736fd84277" providerId="ADAL" clId="{56835480-2BB5-4545-A32E-6CA68AA69734}" dt="2021-09-01T07:01:38.603" v="10"/>
            <ac:spMkLst>
              <pc:docMk/>
              <pc:sldMasterMk cId="3216822255" sldId="2147483672"/>
              <pc:sldLayoutMk cId="2703272592" sldId="2147483680"/>
              <ac:spMk id="12" creationId="{50464F8C-4239-7249-B7AD-71C0585F6180}"/>
            </ac:spMkLst>
          </pc:spChg>
          <pc:picChg chg="mod">
            <ac:chgData name="Grace" userId="fd145552-a10d-4a31-a438-f8736fd84277" providerId="ADAL" clId="{56835480-2BB5-4545-A32E-6CA68AA69734}" dt="2021-09-01T07:01:38.603" v="10"/>
            <ac:picMkLst>
              <pc:docMk/>
              <pc:sldMasterMk cId="3216822255" sldId="2147483672"/>
              <pc:sldLayoutMk cId="2703272592" sldId="2147483680"/>
              <ac:picMk id="9" creationId="{595D4B98-EC35-6E4E-B52D-B38B0E0CB2F5}"/>
            </ac:picMkLst>
          </pc:picChg>
          <pc:picChg chg="mod">
            <ac:chgData name="Grace" userId="fd145552-a10d-4a31-a438-f8736fd84277" providerId="ADAL" clId="{56835480-2BB5-4545-A32E-6CA68AA69734}" dt="2021-09-01T07:01:38.603" v="10"/>
            <ac:picMkLst>
              <pc:docMk/>
              <pc:sldMasterMk cId="3216822255" sldId="2147483672"/>
              <pc:sldLayoutMk cId="2703272592" sldId="2147483680"/>
              <ac:picMk id="10" creationId="{1811C849-DF8E-4316-9166-B19E70AB3203}"/>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506676800" sldId="2147483681"/>
          </pc:sldLayoutMkLst>
          <pc:spChg chg="mod">
            <ac:chgData name="Grace" userId="fd145552-a10d-4a31-a438-f8736fd84277" providerId="ADAL" clId="{56835480-2BB5-4545-A32E-6CA68AA69734}" dt="2021-09-01T07:01:38.603" v="10"/>
            <ac:spMkLst>
              <pc:docMk/>
              <pc:sldMasterMk cId="3216822255" sldId="2147483672"/>
              <pc:sldLayoutMk cId="2506676800" sldId="2147483681"/>
              <ac:spMk id="6" creationId="{B576A394-6B1F-4D42-AB9D-E8AC240619B4}"/>
            </ac:spMkLst>
          </pc:spChg>
          <pc:spChg chg="mod">
            <ac:chgData name="Grace" userId="fd145552-a10d-4a31-a438-f8736fd84277" providerId="ADAL" clId="{56835480-2BB5-4545-A32E-6CA68AA69734}" dt="2021-09-01T07:01:38.603" v="10"/>
            <ac:spMkLst>
              <pc:docMk/>
              <pc:sldMasterMk cId="3216822255" sldId="2147483672"/>
              <pc:sldLayoutMk cId="2506676800" sldId="2147483681"/>
              <ac:spMk id="9" creationId="{50535163-46A9-7748-B4B1-2CCCDB1A63E9}"/>
            </ac:spMkLst>
          </pc:spChg>
          <pc:spChg chg="mod">
            <ac:chgData name="Grace" userId="fd145552-a10d-4a31-a438-f8736fd84277" providerId="ADAL" clId="{56835480-2BB5-4545-A32E-6CA68AA69734}" dt="2021-09-01T07:01:38.603" v="10"/>
            <ac:spMkLst>
              <pc:docMk/>
              <pc:sldMasterMk cId="3216822255" sldId="2147483672"/>
              <pc:sldLayoutMk cId="2506676800" sldId="2147483681"/>
              <ac:spMk id="12" creationId="{C9A982C3-1052-544B-B943-34291F9E9BA1}"/>
            </ac:spMkLst>
          </pc:spChg>
          <pc:picChg chg="mod">
            <ac:chgData name="Grace" userId="fd145552-a10d-4a31-a438-f8736fd84277" providerId="ADAL" clId="{56835480-2BB5-4545-A32E-6CA68AA69734}" dt="2021-09-01T07:01:38.603" v="10"/>
            <ac:picMkLst>
              <pc:docMk/>
              <pc:sldMasterMk cId="3216822255" sldId="2147483672"/>
              <pc:sldLayoutMk cId="2506676800" sldId="2147483681"/>
              <ac:picMk id="10" creationId="{1811C849-DF8E-4316-9166-B19E70AB3203}"/>
            </ac:picMkLst>
          </pc:picChg>
          <pc:picChg chg="mod">
            <ac:chgData name="Grace" userId="fd145552-a10d-4a31-a438-f8736fd84277" providerId="ADAL" clId="{56835480-2BB5-4545-A32E-6CA68AA69734}" dt="2021-09-01T07:01:38.603" v="10"/>
            <ac:picMkLst>
              <pc:docMk/>
              <pc:sldMasterMk cId="3216822255" sldId="2147483672"/>
              <pc:sldLayoutMk cId="2506676800" sldId="2147483681"/>
              <ac:picMk id="11" creationId="{937BE605-3862-1545-9D7B-F5F181FA5E3D}"/>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4007171974" sldId="2147483682"/>
          </pc:sldLayoutMkLst>
          <pc:spChg chg="mod">
            <ac:chgData name="Grace" userId="fd145552-a10d-4a31-a438-f8736fd84277" providerId="ADAL" clId="{56835480-2BB5-4545-A32E-6CA68AA69734}" dt="2021-09-01T07:01:38.603" v="10"/>
            <ac:spMkLst>
              <pc:docMk/>
              <pc:sldMasterMk cId="3216822255" sldId="2147483672"/>
              <pc:sldLayoutMk cId="4007171974" sldId="2147483682"/>
              <ac:spMk id="7" creationId="{F7F5BF2A-AC4A-1A42-AAE5-EFA621B57D2A}"/>
            </ac:spMkLst>
          </pc:spChg>
          <pc:spChg chg="mod">
            <ac:chgData name="Grace" userId="fd145552-a10d-4a31-a438-f8736fd84277" providerId="ADAL" clId="{56835480-2BB5-4545-A32E-6CA68AA69734}" dt="2021-09-01T07:01:38.603" v="10"/>
            <ac:spMkLst>
              <pc:docMk/>
              <pc:sldMasterMk cId="3216822255" sldId="2147483672"/>
              <pc:sldLayoutMk cId="4007171974" sldId="2147483682"/>
              <ac:spMk id="10" creationId="{1F02D92F-5115-844C-A4E9-2F6FDB1AFB5F}"/>
            </ac:spMkLst>
          </pc:spChg>
          <pc:picChg chg="mod">
            <ac:chgData name="Grace" userId="fd145552-a10d-4a31-a438-f8736fd84277" providerId="ADAL" clId="{56835480-2BB5-4545-A32E-6CA68AA69734}" dt="2021-09-01T07:01:38.603" v="10"/>
            <ac:picMkLst>
              <pc:docMk/>
              <pc:sldMasterMk cId="3216822255" sldId="2147483672"/>
              <pc:sldLayoutMk cId="4007171974" sldId="2147483682"/>
              <ac:picMk id="9" creationId="{027F469D-BD18-954A-9A1A-8F1D6A382843}"/>
            </ac:picMkLst>
          </pc:picChg>
          <pc:picChg chg="mod">
            <ac:chgData name="Grace" userId="fd145552-a10d-4a31-a438-f8736fd84277" providerId="ADAL" clId="{56835480-2BB5-4545-A32E-6CA68AA69734}" dt="2021-09-01T07:01:38.603" v="10"/>
            <ac:picMkLst>
              <pc:docMk/>
              <pc:sldMasterMk cId="3216822255" sldId="2147483672"/>
              <pc:sldLayoutMk cId="4007171974" sldId="2147483682"/>
              <ac:picMk id="11" creationId="{01474F3C-BF30-4838-BE7E-29B6762A0306}"/>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1536964792" sldId="2147483683"/>
          </pc:sldLayoutMkLst>
          <pc:spChg chg="mod">
            <ac:chgData name="Grace" userId="fd145552-a10d-4a31-a438-f8736fd84277" providerId="ADAL" clId="{56835480-2BB5-4545-A32E-6CA68AA69734}" dt="2021-09-01T07:01:38.603" v="10"/>
            <ac:spMkLst>
              <pc:docMk/>
              <pc:sldMasterMk cId="3216822255" sldId="2147483672"/>
              <pc:sldLayoutMk cId="1536964792" sldId="2147483683"/>
              <ac:spMk id="7" creationId="{203B2E81-0B17-C14D-871B-CFD7397D6032}"/>
            </ac:spMkLst>
          </pc:spChg>
          <pc:spChg chg="mod">
            <ac:chgData name="Grace" userId="fd145552-a10d-4a31-a438-f8736fd84277" providerId="ADAL" clId="{56835480-2BB5-4545-A32E-6CA68AA69734}" dt="2021-09-01T07:01:38.603" v="10"/>
            <ac:spMkLst>
              <pc:docMk/>
              <pc:sldMasterMk cId="3216822255" sldId="2147483672"/>
              <pc:sldLayoutMk cId="1536964792" sldId="2147483683"/>
              <ac:spMk id="11" creationId="{ACABB86B-1F70-C340-B833-D9E64690EDEC}"/>
            </ac:spMkLst>
          </pc:spChg>
          <pc:picChg chg="mod">
            <ac:chgData name="Grace" userId="fd145552-a10d-4a31-a438-f8736fd84277" providerId="ADAL" clId="{56835480-2BB5-4545-A32E-6CA68AA69734}" dt="2021-09-01T07:01:38.603" v="10"/>
            <ac:picMkLst>
              <pc:docMk/>
              <pc:sldMasterMk cId="3216822255" sldId="2147483672"/>
              <pc:sldLayoutMk cId="1536964792" sldId="2147483683"/>
              <ac:picMk id="9" creationId="{D66EB99F-F155-5343-A51B-12DBD3DF7BF8}"/>
            </ac:picMkLst>
          </pc:picChg>
          <pc:picChg chg="mod">
            <ac:chgData name="Grace" userId="fd145552-a10d-4a31-a438-f8736fd84277" providerId="ADAL" clId="{56835480-2BB5-4545-A32E-6CA68AA69734}" dt="2021-09-01T07:01:38.603" v="10"/>
            <ac:picMkLst>
              <pc:docMk/>
              <pc:sldMasterMk cId="3216822255" sldId="2147483672"/>
              <pc:sldLayoutMk cId="1536964792" sldId="2147483683"/>
              <ac:picMk id="10" creationId="{B27217AD-F199-408C-87CD-6B9EAF72773E}"/>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465707793" sldId="2147483684"/>
          </pc:sldLayoutMkLst>
          <pc:spChg chg="mod">
            <ac:chgData name="Grace" userId="fd145552-a10d-4a31-a438-f8736fd84277" providerId="ADAL" clId="{56835480-2BB5-4545-A32E-6CA68AA69734}" dt="2021-09-01T07:01:38.603" v="10"/>
            <ac:spMkLst>
              <pc:docMk/>
              <pc:sldMasterMk cId="3216822255" sldId="2147483672"/>
              <pc:sldLayoutMk cId="465707793" sldId="2147483684"/>
              <ac:spMk id="9" creationId="{42004013-5879-D34C-BAFC-44A0C7C52987}"/>
            </ac:spMkLst>
          </pc:spChg>
          <pc:spChg chg="mod">
            <ac:chgData name="Grace" userId="fd145552-a10d-4a31-a438-f8736fd84277" providerId="ADAL" clId="{56835480-2BB5-4545-A32E-6CA68AA69734}" dt="2021-09-01T07:01:38.603" v="10"/>
            <ac:spMkLst>
              <pc:docMk/>
              <pc:sldMasterMk cId="3216822255" sldId="2147483672"/>
              <pc:sldLayoutMk cId="465707793" sldId="2147483684"/>
              <ac:spMk id="10" creationId="{2A5DF2FE-20A3-FD49-A928-C8B687FFB191}"/>
            </ac:spMkLst>
          </pc:spChg>
          <pc:picChg chg="mod">
            <ac:chgData name="Grace" userId="fd145552-a10d-4a31-a438-f8736fd84277" providerId="ADAL" clId="{56835480-2BB5-4545-A32E-6CA68AA69734}" dt="2021-09-01T07:01:38.603" v="10"/>
            <ac:picMkLst>
              <pc:docMk/>
              <pc:sldMasterMk cId="3216822255" sldId="2147483672"/>
              <pc:sldLayoutMk cId="465707793" sldId="2147483684"/>
              <ac:picMk id="6" creationId="{8EA2DDC0-E24B-44C0-A773-C0BEC90B3BA9}"/>
            </ac:picMkLst>
          </pc:picChg>
          <pc:picChg chg="mod">
            <ac:chgData name="Grace" userId="fd145552-a10d-4a31-a438-f8736fd84277" providerId="ADAL" clId="{56835480-2BB5-4545-A32E-6CA68AA69734}" dt="2021-09-01T07:01:38.603" v="10"/>
            <ac:picMkLst>
              <pc:docMk/>
              <pc:sldMasterMk cId="3216822255" sldId="2147483672"/>
              <pc:sldLayoutMk cId="465707793" sldId="2147483684"/>
              <ac:picMk id="8" creationId="{B624EB83-3DEF-5A40-82E3-BA7BE6E83D27}"/>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439833899" sldId="2147483685"/>
          </pc:sldLayoutMkLst>
          <pc:spChg chg="mod">
            <ac:chgData name="Grace" userId="fd145552-a10d-4a31-a438-f8736fd84277" providerId="ADAL" clId="{56835480-2BB5-4545-A32E-6CA68AA69734}" dt="2021-09-01T07:01:38.603" v="10"/>
            <ac:spMkLst>
              <pc:docMk/>
              <pc:sldMasterMk cId="3216822255" sldId="2147483672"/>
              <pc:sldLayoutMk cId="439833899" sldId="2147483685"/>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439833899" sldId="2147483685"/>
              <ac:spMk id="13" creationId="{EB285D19-A405-BB4C-B142-722A2913CE59}"/>
            </ac:spMkLst>
          </pc:spChg>
          <pc:spChg chg="mod">
            <ac:chgData name="Grace" userId="fd145552-a10d-4a31-a438-f8736fd84277" providerId="ADAL" clId="{56835480-2BB5-4545-A32E-6CA68AA69734}" dt="2021-09-01T07:01:38.603" v="10"/>
            <ac:spMkLst>
              <pc:docMk/>
              <pc:sldMasterMk cId="3216822255" sldId="2147483672"/>
              <pc:sldLayoutMk cId="439833899" sldId="2147483685"/>
              <ac:spMk id="14" creationId="{A1214D66-D55C-D44A-B441-B18BD72691C5}"/>
            </ac:spMkLst>
          </pc:spChg>
          <pc:picChg chg="mod">
            <ac:chgData name="Grace" userId="fd145552-a10d-4a31-a438-f8736fd84277" providerId="ADAL" clId="{56835480-2BB5-4545-A32E-6CA68AA69734}" dt="2021-09-01T07:01:38.603" v="10"/>
            <ac:picMkLst>
              <pc:docMk/>
              <pc:sldMasterMk cId="3216822255" sldId="2147483672"/>
              <pc:sldLayoutMk cId="439833899" sldId="2147483685"/>
              <ac:picMk id="8" creationId="{401895F3-6600-4703-81D0-F9299C9F68D8}"/>
            </ac:picMkLst>
          </pc:picChg>
          <pc:picChg chg="mod">
            <ac:chgData name="Grace" userId="fd145552-a10d-4a31-a438-f8736fd84277" providerId="ADAL" clId="{56835480-2BB5-4545-A32E-6CA68AA69734}" dt="2021-09-01T07:01:38.603" v="10"/>
            <ac:picMkLst>
              <pc:docMk/>
              <pc:sldMasterMk cId="3216822255" sldId="2147483672"/>
              <pc:sldLayoutMk cId="439833899" sldId="2147483685"/>
              <ac:picMk id="12" creationId="{0467D4D8-EE96-6644-B22D-704124139EC0}"/>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734797723" sldId="2147483686"/>
          </pc:sldLayoutMkLst>
          <pc:spChg chg="mod">
            <ac:chgData name="Grace" userId="fd145552-a10d-4a31-a438-f8736fd84277" providerId="ADAL" clId="{56835480-2BB5-4545-A32E-6CA68AA69734}" dt="2021-09-01T07:01:38.603" v="10"/>
            <ac:spMkLst>
              <pc:docMk/>
              <pc:sldMasterMk cId="3216822255" sldId="2147483672"/>
              <pc:sldLayoutMk cId="2734797723" sldId="2147483686"/>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2734797723" sldId="2147483686"/>
              <ac:spMk id="7" creationId="{BEBC78F8-9C19-E44F-8E6E-30B20C0A5958}"/>
            </ac:spMkLst>
          </pc:spChg>
          <pc:spChg chg="mod">
            <ac:chgData name="Grace" userId="fd145552-a10d-4a31-a438-f8736fd84277" providerId="ADAL" clId="{56835480-2BB5-4545-A32E-6CA68AA69734}" dt="2021-09-01T07:01:38.603" v="10"/>
            <ac:spMkLst>
              <pc:docMk/>
              <pc:sldMasterMk cId="3216822255" sldId="2147483672"/>
              <pc:sldLayoutMk cId="2734797723" sldId="2147483686"/>
              <ac:spMk id="9" creationId="{AE83AE87-8A18-7C49-B572-8BE1C3E84F8C}"/>
            </ac:spMkLst>
          </pc:spChg>
          <pc:picChg chg="mod">
            <ac:chgData name="Grace" userId="fd145552-a10d-4a31-a438-f8736fd84277" providerId="ADAL" clId="{56835480-2BB5-4545-A32E-6CA68AA69734}" dt="2021-09-01T07:01:38.603" v="10"/>
            <ac:picMkLst>
              <pc:docMk/>
              <pc:sldMasterMk cId="3216822255" sldId="2147483672"/>
              <pc:sldLayoutMk cId="2734797723" sldId="2147483686"/>
              <ac:picMk id="8" creationId="{E53D6B9D-DA9F-4DBB-A832-ADED78BEACFB}"/>
            </ac:picMkLst>
          </pc:picChg>
          <pc:picChg chg="mod">
            <ac:chgData name="Grace" userId="fd145552-a10d-4a31-a438-f8736fd84277" providerId="ADAL" clId="{56835480-2BB5-4545-A32E-6CA68AA69734}" dt="2021-09-01T07:01:38.603" v="10"/>
            <ac:picMkLst>
              <pc:docMk/>
              <pc:sldMasterMk cId="3216822255" sldId="2147483672"/>
              <pc:sldLayoutMk cId="2734797723" sldId="2147483686"/>
              <ac:picMk id="12" creationId="{FCCF841B-1E42-464B-9D7C-BCA3A89AB412}"/>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4118702393" sldId="2147483687"/>
          </pc:sldLayoutMkLst>
          <pc:spChg chg="mod">
            <ac:chgData name="Grace" userId="fd145552-a10d-4a31-a438-f8736fd84277" providerId="ADAL" clId="{56835480-2BB5-4545-A32E-6CA68AA69734}" dt="2021-09-01T07:01:38.603" v="10"/>
            <ac:spMkLst>
              <pc:docMk/>
              <pc:sldMasterMk cId="3216822255" sldId="2147483672"/>
              <pc:sldLayoutMk cId="4118702393" sldId="2147483687"/>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4118702393" sldId="2147483687"/>
              <ac:spMk id="7" creationId="{24AED201-B440-AA40-BBED-62B7C0D4050E}"/>
            </ac:spMkLst>
          </pc:spChg>
          <pc:spChg chg="mod">
            <ac:chgData name="Grace" userId="fd145552-a10d-4a31-a438-f8736fd84277" providerId="ADAL" clId="{56835480-2BB5-4545-A32E-6CA68AA69734}" dt="2021-09-01T07:01:38.603" v="10"/>
            <ac:spMkLst>
              <pc:docMk/>
              <pc:sldMasterMk cId="3216822255" sldId="2147483672"/>
              <pc:sldLayoutMk cId="4118702393" sldId="2147483687"/>
              <ac:spMk id="9" creationId="{333A7848-7DA9-D245-808E-38FA212DEB0C}"/>
            </ac:spMkLst>
          </pc:spChg>
          <pc:picChg chg="mod">
            <ac:chgData name="Grace" userId="fd145552-a10d-4a31-a438-f8736fd84277" providerId="ADAL" clId="{56835480-2BB5-4545-A32E-6CA68AA69734}" dt="2021-09-01T07:01:38.603" v="10"/>
            <ac:picMkLst>
              <pc:docMk/>
              <pc:sldMasterMk cId="3216822255" sldId="2147483672"/>
              <pc:sldLayoutMk cId="4118702393" sldId="2147483687"/>
              <ac:picMk id="8" creationId="{A9AC8E03-D9CF-4419-A394-1206FE31243F}"/>
            </ac:picMkLst>
          </pc:picChg>
          <pc:picChg chg="mod">
            <ac:chgData name="Grace" userId="fd145552-a10d-4a31-a438-f8736fd84277" providerId="ADAL" clId="{56835480-2BB5-4545-A32E-6CA68AA69734}" dt="2021-09-01T07:01:38.603" v="10"/>
            <ac:picMkLst>
              <pc:docMk/>
              <pc:sldMasterMk cId="3216822255" sldId="2147483672"/>
              <pc:sldLayoutMk cId="4118702393" sldId="2147483687"/>
              <ac:picMk id="12" creationId="{42387223-0769-BE44-9811-097FA9566948}"/>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548556812" sldId="2147483688"/>
          </pc:sldLayoutMkLst>
          <pc:spChg chg="mod">
            <ac:chgData name="Grace" userId="fd145552-a10d-4a31-a438-f8736fd84277" providerId="ADAL" clId="{56835480-2BB5-4545-A32E-6CA68AA69734}" dt="2021-09-01T07:01:38.603" v="10"/>
            <ac:spMkLst>
              <pc:docMk/>
              <pc:sldMasterMk cId="3216822255" sldId="2147483672"/>
              <pc:sldLayoutMk cId="548556812" sldId="2147483688"/>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548556812" sldId="2147483688"/>
              <ac:spMk id="7" creationId="{79388964-420B-BF4D-8DBF-CAFF1C3B6D02}"/>
            </ac:spMkLst>
          </pc:spChg>
          <pc:spChg chg="mod">
            <ac:chgData name="Grace" userId="fd145552-a10d-4a31-a438-f8736fd84277" providerId="ADAL" clId="{56835480-2BB5-4545-A32E-6CA68AA69734}" dt="2021-09-01T07:01:38.603" v="10"/>
            <ac:spMkLst>
              <pc:docMk/>
              <pc:sldMasterMk cId="3216822255" sldId="2147483672"/>
              <pc:sldLayoutMk cId="548556812" sldId="2147483688"/>
              <ac:spMk id="9" creationId="{7B539C16-E252-7E4A-9ABE-B5367A682FD7}"/>
            </ac:spMkLst>
          </pc:spChg>
          <pc:picChg chg="mod">
            <ac:chgData name="Grace" userId="fd145552-a10d-4a31-a438-f8736fd84277" providerId="ADAL" clId="{56835480-2BB5-4545-A32E-6CA68AA69734}" dt="2021-09-01T07:01:38.603" v="10"/>
            <ac:picMkLst>
              <pc:docMk/>
              <pc:sldMasterMk cId="3216822255" sldId="2147483672"/>
              <pc:sldLayoutMk cId="548556812" sldId="2147483688"/>
              <ac:picMk id="8" creationId="{A9AC8E03-D9CF-4419-A394-1206FE31243F}"/>
            </ac:picMkLst>
          </pc:picChg>
          <pc:picChg chg="mod">
            <ac:chgData name="Grace" userId="fd145552-a10d-4a31-a438-f8736fd84277" providerId="ADAL" clId="{56835480-2BB5-4545-A32E-6CA68AA69734}" dt="2021-09-01T07:01:38.603" v="10"/>
            <ac:picMkLst>
              <pc:docMk/>
              <pc:sldMasterMk cId="3216822255" sldId="2147483672"/>
              <pc:sldLayoutMk cId="548556812" sldId="2147483688"/>
              <ac:picMk id="14" creationId="{7656571C-9B67-0742-8350-6E56403548B3}"/>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3510585174" sldId="2147483689"/>
          </pc:sldLayoutMkLst>
          <pc:spChg chg="mod">
            <ac:chgData name="Grace" userId="fd145552-a10d-4a31-a438-f8736fd84277" providerId="ADAL" clId="{56835480-2BB5-4545-A32E-6CA68AA69734}" dt="2021-09-01T07:01:38.603" v="10"/>
            <ac:spMkLst>
              <pc:docMk/>
              <pc:sldMasterMk cId="3216822255" sldId="2147483672"/>
              <pc:sldLayoutMk cId="3510585174" sldId="2147483689"/>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3510585174" sldId="2147483689"/>
              <ac:spMk id="7" creationId="{977CE053-748F-F94F-9BDB-26FA721980F0}"/>
            </ac:spMkLst>
          </pc:spChg>
          <pc:spChg chg="mod">
            <ac:chgData name="Grace" userId="fd145552-a10d-4a31-a438-f8736fd84277" providerId="ADAL" clId="{56835480-2BB5-4545-A32E-6CA68AA69734}" dt="2021-09-01T07:01:38.603" v="10"/>
            <ac:spMkLst>
              <pc:docMk/>
              <pc:sldMasterMk cId="3216822255" sldId="2147483672"/>
              <pc:sldLayoutMk cId="3510585174" sldId="2147483689"/>
              <ac:spMk id="12" creationId="{0E3B84B9-155B-1140-B4BB-62BBD0E79340}"/>
            </ac:spMkLst>
          </pc:spChg>
          <pc:picChg chg="mod">
            <ac:chgData name="Grace" userId="fd145552-a10d-4a31-a438-f8736fd84277" providerId="ADAL" clId="{56835480-2BB5-4545-A32E-6CA68AA69734}" dt="2021-09-01T07:01:38.603" v="10"/>
            <ac:picMkLst>
              <pc:docMk/>
              <pc:sldMasterMk cId="3216822255" sldId="2147483672"/>
              <pc:sldLayoutMk cId="3510585174" sldId="2147483689"/>
              <ac:picMk id="8" creationId="{A9AC8E03-D9CF-4419-A394-1206FE31243F}"/>
            </ac:picMkLst>
          </pc:picChg>
          <pc:picChg chg="mod">
            <ac:chgData name="Grace" userId="fd145552-a10d-4a31-a438-f8736fd84277" providerId="ADAL" clId="{56835480-2BB5-4545-A32E-6CA68AA69734}" dt="2021-09-01T07:01:38.603" v="10"/>
            <ac:picMkLst>
              <pc:docMk/>
              <pc:sldMasterMk cId="3216822255" sldId="2147483672"/>
              <pc:sldLayoutMk cId="3510585174" sldId="2147483689"/>
              <ac:picMk id="9" creationId="{7085503F-3ACD-544D-A1FE-7E9AA2FB19F5}"/>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334161135" sldId="2147483690"/>
          </pc:sldLayoutMkLst>
          <pc:spChg chg="mod">
            <ac:chgData name="Grace" userId="fd145552-a10d-4a31-a438-f8736fd84277" providerId="ADAL" clId="{56835480-2BB5-4545-A32E-6CA68AA69734}" dt="2021-09-01T07:01:38.603" v="10"/>
            <ac:spMkLst>
              <pc:docMk/>
              <pc:sldMasterMk cId="3216822255" sldId="2147483672"/>
              <pc:sldLayoutMk cId="2334161135" sldId="2147483690"/>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2334161135" sldId="2147483690"/>
              <ac:spMk id="7" creationId="{64D4D538-7063-694D-BA0B-31A19B1A6FFC}"/>
            </ac:spMkLst>
          </pc:spChg>
          <pc:spChg chg="mod">
            <ac:chgData name="Grace" userId="fd145552-a10d-4a31-a438-f8736fd84277" providerId="ADAL" clId="{56835480-2BB5-4545-A32E-6CA68AA69734}" dt="2021-09-01T07:01:38.603" v="10"/>
            <ac:spMkLst>
              <pc:docMk/>
              <pc:sldMasterMk cId="3216822255" sldId="2147483672"/>
              <pc:sldLayoutMk cId="2334161135" sldId="2147483690"/>
              <ac:spMk id="9" creationId="{87BBF45E-241A-8C4F-B98D-2EDF716EC7E7}"/>
            </ac:spMkLst>
          </pc:spChg>
          <pc:picChg chg="mod">
            <ac:chgData name="Grace" userId="fd145552-a10d-4a31-a438-f8736fd84277" providerId="ADAL" clId="{56835480-2BB5-4545-A32E-6CA68AA69734}" dt="2021-09-01T07:01:38.603" v="10"/>
            <ac:picMkLst>
              <pc:docMk/>
              <pc:sldMasterMk cId="3216822255" sldId="2147483672"/>
              <pc:sldLayoutMk cId="2334161135" sldId="2147483690"/>
              <ac:picMk id="8" creationId="{A9AC8E03-D9CF-4419-A394-1206FE31243F}"/>
            </ac:picMkLst>
          </pc:picChg>
          <pc:picChg chg="mod">
            <ac:chgData name="Grace" userId="fd145552-a10d-4a31-a438-f8736fd84277" providerId="ADAL" clId="{56835480-2BB5-4545-A32E-6CA68AA69734}" dt="2021-09-01T07:01:38.603" v="10"/>
            <ac:picMkLst>
              <pc:docMk/>
              <pc:sldMasterMk cId="3216822255" sldId="2147483672"/>
              <pc:sldLayoutMk cId="2334161135" sldId="2147483690"/>
              <ac:picMk id="12" creationId="{61256C31-9270-B24B-8AE2-00346517F258}"/>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4210772849" sldId="2147483691"/>
          </pc:sldLayoutMkLst>
          <pc:spChg chg="mod">
            <ac:chgData name="Grace" userId="fd145552-a10d-4a31-a438-f8736fd84277" providerId="ADAL" clId="{56835480-2BB5-4545-A32E-6CA68AA69734}" dt="2021-09-01T07:01:38.603" v="10"/>
            <ac:spMkLst>
              <pc:docMk/>
              <pc:sldMasterMk cId="3216822255" sldId="2147483672"/>
              <pc:sldLayoutMk cId="4210772849" sldId="2147483691"/>
              <ac:spMk id="6"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4210772849" sldId="2147483691"/>
              <ac:spMk id="7" creationId="{610FA0CD-08FB-2E45-8180-D86BDB467B08}"/>
            </ac:spMkLst>
          </pc:spChg>
          <pc:spChg chg="mod">
            <ac:chgData name="Grace" userId="fd145552-a10d-4a31-a438-f8736fd84277" providerId="ADAL" clId="{56835480-2BB5-4545-A32E-6CA68AA69734}" dt="2021-09-01T07:01:38.603" v="10"/>
            <ac:spMkLst>
              <pc:docMk/>
              <pc:sldMasterMk cId="3216822255" sldId="2147483672"/>
              <pc:sldLayoutMk cId="4210772849" sldId="2147483691"/>
              <ac:spMk id="11" creationId="{8E33F84B-9A42-504F-9E05-1436C79D277E}"/>
            </ac:spMkLst>
          </pc:spChg>
          <pc:spChg chg="mod">
            <ac:chgData name="Grace" userId="fd145552-a10d-4a31-a438-f8736fd84277" providerId="ADAL" clId="{56835480-2BB5-4545-A32E-6CA68AA69734}" dt="2021-09-01T07:01:38.603" v="10"/>
            <ac:spMkLst>
              <pc:docMk/>
              <pc:sldMasterMk cId="3216822255" sldId="2147483672"/>
              <pc:sldLayoutMk cId="4210772849" sldId="2147483691"/>
              <ac:spMk id="14" creationId="{00000000-0000-0000-0000-000000000000}"/>
            </ac:spMkLst>
          </pc:spChg>
          <pc:picChg chg="mod">
            <ac:chgData name="Grace" userId="fd145552-a10d-4a31-a438-f8736fd84277" providerId="ADAL" clId="{56835480-2BB5-4545-A32E-6CA68AA69734}" dt="2021-09-01T07:01:38.603" v="10"/>
            <ac:picMkLst>
              <pc:docMk/>
              <pc:sldMasterMk cId="3216822255" sldId="2147483672"/>
              <pc:sldLayoutMk cId="4210772849" sldId="2147483691"/>
              <ac:picMk id="3" creationId="{771FAB5E-C09E-4106-9FD7-8CC30A4EE4BA}"/>
            </ac:picMkLst>
          </pc:picChg>
          <pc:picChg chg="mod">
            <ac:chgData name="Grace" userId="fd145552-a10d-4a31-a438-f8736fd84277" providerId="ADAL" clId="{56835480-2BB5-4545-A32E-6CA68AA69734}" dt="2021-09-01T07:01:38.603" v="10"/>
            <ac:picMkLst>
              <pc:docMk/>
              <pc:sldMasterMk cId="3216822255" sldId="2147483672"/>
              <pc:sldLayoutMk cId="4210772849" sldId="2147483691"/>
              <ac:picMk id="5" creationId="{2F65EEB9-0552-45C3-8818-F2C34C8C0846}"/>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238555346" sldId="2147483692"/>
          </pc:sldLayoutMkLst>
          <pc:spChg chg="mod">
            <ac:chgData name="Grace" userId="fd145552-a10d-4a31-a438-f8736fd84277" providerId="ADAL" clId="{56835480-2BB5-4545-A32E-6CA68AA69734}" dt="2021-09-01T07:01:38.603" v="10"/>
            <ac:spMkLst>
              <pc:docMk/>
              <pc:sldMasterMk cId="3216822255" sldId="2147483672"/>
              <pc:sldLayoutMk cId="2238555346" sldId="2147483692"/>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672"/>
              <pc:sldLayoutMk cId="2238555346" sldId="2147483692"/>
              <ac:spMk id="6" creationId="{63F1E73F-993F-2743-A4D6-C74AC29EA7CE}"/>
            </ac:spMkLst>
          </pc:spChg>
          <pc:spChg chg="mod">
            <ac:chgData name="Grace" userId="fd145552-a10d-4a31-a438-f8736fd84277" providerId="ADAL" clId="{56835480-2BB5-4545-A32E-6CA68AA69734}" dt="2021-09-01T07:01:38.603" v="10"/>
            <ac:spMkLst>
              <pc:docMk/>
              <pc:sldMasterMk cId="3216822255" sldId="2147483672"/>
              <pc:sldLayoutMk cId="2238555346" sldId="2147483692"/>
              <ac:spMk id="8" creationId="{F50306BA-4DCA-6643-9EAE-3C143CE3849A}"/>
            </ac:spMkLst>
          </pc:spChg>
          <pc:picChg chg="mod">
            <ac:chgData name="Grace" userId="fd145552-a10d-4a31-a438-f8736fd84277" providerId="ADAL" clId="{56835480-2BB5-4545-A32E-6CA68AA69734}" dt="2021-09-01T07:01:38.603" v="10"/>
            <ac:picMkLst>
              <pc:docMk/>
              <pc:sldMasterMk cId="3216822255" sldId="2147483672"/>
              <pc:sldLayoutMk cId="2238555346" sldId="2147483692"/>
              <ac:picMk id="7" creationId="{396E9556-837F-4DA9-91CD-BD19A69947B1}"/>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199262837" sldId="2147483696"/>
          </pc:sldLayoutMkLst>
          <pc:spChg chg="mod">
            <ac:chgData name="Grace" userId="fd145552-a10d-4a31-a438-f8736fd84277" providerId="ADAL" clId="{56835480-2BB5-4545-A32E-6CA68AA69734}" dt="2021-09-01T07:01:38.603" v="10"/>
            <ac:spMkLst>
              <pc:docMk/>
              <pc:sldMasterMk cId="3216822255" sldId="2147483672"/>
              <pc:sldLayoutMk cId="2199262837" sldId="2147483696"/>
              <ac:spMk id="2" creationId="{0C3010EE-5F8C-A141-9442-3FCFF7B6179C}"/>
            </ac:spMkLst>
          </pc:spChg>
          <pc:spChg chg="mod">
            <ac:chgData name="Grace" userId="fd145552-a10d-4a31-a438-f8736fd84277" providerId="ADAL" clId="{56835480-2BB5-4545-A32E-6CA68AA69734}" dt="2021-09-01T07:01:38.603" v="10"/>
            <ac:spMkLst>
              <pc:docMk/>
              <pc:sldMasterMk cId="3216822255" sldId="2147483672"/>
              <pc:sldLayoutMk cId="2199262837" sldId="2147483696"/>
              <ac:spMk id="7" creationId="{A194C734-8EA7-6747-9D5E-0095CB042E67}"/>
            </ac:spMkLst>
          </pc:spChg>
          <pc:spChg chg="mod">
            <ac:chgData name="Grace" userId="fd145552-a10d-4a31-a438-f8736fd84277" providerId="ADAL" clId="{56835480-2BB5-4545-A32E-6CA68AA69734}" dt="2021-09-01T07:01:38.603" v="10"/>
            <ac:spMkLst>
              <pc:docMk/>
              <pc:sldMasterMk cId="3216822255" sldId="2147483672"/>
              <pc:sldLayoutMk cId="2199262837" sldId="2147483696"/>
              <ac:spMk id="8" creationId="{BAEC2915-3116-4260-8EA9-AB20FD5A9A82}"/>
            </ac:spMkLst>
          </pc:spChg>
          <pc:picChg chg="mod">
            <ac:chgData name="Grace" userId="fd145552-a10d-4a31-a438-f8736fd84277" providerId="ADAL" clId="{56835480-2BB5-4545-A32E-6CA68AA69734}" dt="2021-09-01T07:01:38.603" v="10"/>
            <ac:picMkLst>
              <pc:docMk/>
              <pc:sldMasterMk cId="3216822255" sldId="2147483672"/>
              <pc:sldLayoutMk cId="2199262837" sldId="2147483696"/>
              <ac:picMk id="4" creationId="{1A15D4BB-E575-4B2E-89BF-6C78B456C7A2}"/>
            </ac:picMkLst>
          </pc:picChg>
          <pc:picChg chg="mod">
            <ac:chgData name="Grace" userId="fd145552-a10d-4a31-a438-f8736fd84277" providerId="ADAL" clId="{56835480-2BB5-4545-A32E-6CA68AA69734}" dt="2021-09-01T07:01:38.603" v="10"/>
            <ac:picMkLst>
              <pc:docMk/>
              <pc:sldMasterMk cId="3216822255" sldId="2147483672"/>
              <pc:sldLayoutMk cId="2199262837" sldId="2147483696"/>
              <ac:picMk id="6" creationId="{E39232D5-1425-45B1-B404-F0D4DE30EA7C}"/>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1044077540" sldId="2147483697"/>
          </pc:sldLayoutMkLst>
          <pc:spChg chg="mod">
            <ac:chgData name="Grace" userId="fd145552-a10d-4a31-a438-f8736fd84277" providerId="ADAL" clId="{56835480-2BB5-4545-A32E-6CA68AA69734}" dt="2021-09-01T07:01:38.603" v="10"/>
            <ac:spMkLst>
              <pc:docMk/>
              <pc:sldMasterMk cId="3216822255" sldId="2147483672"/>
              <pc:sldLayoutMk cId="1044077540" sldId="2147483697"/>
              <ac:spMk id="7" creationId="{A194C734-8EA7-6747-9D5E-0095CB042E67}"/>
            </ac:spMkLst>
          </pc:spChg>
          <pc:spChg chg="mod">
            <ac:chgData name="Grace" userId="fd145552-a10d-4a31-a438-f8736fd84277" providerId="ADAL" clId="{56835480-2BB5-4545-A32E-6CA68AA69734}" dt="2021-09-01T07:01:38.603" v="10"/>
            <ac:spMkLst>
              <pc:docMk/>
              <pc:sldMasterMk cId="3216822255" sldId="2147483672"/>
              <pc:sldLayoutMk cId="1044077540" sldId="2147483697"/>
              <ac:spMk id="8" creationId="{BAEC2915-3116-4260-8EA9-AB20FD5A9A82}"/>
            </ac:spMkLst>
          </pc:spChg>
          <pc:spChg chg="mod">
            <ac:chgData name="Grace" userId="fd145552-a10d-4a31-a438-f8736fd84277" providerId="ADAL" clId="{56835480-2BB5-4545-A32E-6CA68AA69734}" dt="2021-09-01T07:01:38.603" v="10"/>
            <ac:spMkLst>
              <pc:docMk/>
              <pc:sldMasterMk cId="3216822255" sldId="2147483672"/>
              <pc:sldLayoutMk cId="1044077540" sldId="2147483697"/>
              <ac:spMk id="9" creationId="{C67CDB5E-4D71-4272-9551-C21C89000749}"/>
            </ac:spMkLst>
          </pc:spChg>
          <pc:picChg chg="mod">
            <ac:chgData name="Grace" userId="fd145552-a10d-4a31-a438-f8736fd84277" providerId="ADAL" clId="{56835480-2BB5-4545-A32E-6CA68AA69734}" dt="2021-09-01T07:01:38.603" v="10"/>
            <ac:picMkLst>
              <pc:docMk/>
              <pc:sldMasterMk cId="3216822255" sldId="2147483672"/>
              <pc:sldLayoutMk cId="1044077540" sldId="2147483697"/>
              <ac:picMk id="4" creationId="{1A15D4BB-E575-4B2E-89BF-6C78B456C7A2}"/>
            </ac:picMkLst>
          </pc:picChg>
          <pc:picChg chg="mod">
            <ac:chgData name="Grace" userId="fd145552-a10d-4a31-a438-f8736fd84277" providerId="ADAL" clId="{56835480-2BB5-4545-A32E-6CA68AA69734}" dt="2021-09-01T07:01:38.603" v="10"/>
            <ac:picMkLst>
              <pc:docMk/>
              <pc:sldMasterMk cId="3216822255" sldId="2147483672"/>
              <pc:sldLayoutMk cId="1044077540" sldId="2147483697"/>
              <ac:picMk id="6" creationId="{E39232D5-1425-45B1-B404-F0D4DE30EA7C}"/>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3080657027" sldId="2147483704"/>
          </pc:sldLayoutMkLst>
          <pc:spChg chg="mod">
            <ac:chgData name="Grace" userId="fd145552-a10d-4a31-a438-f8736fd84277" providerId="ADAL" clId="{56835480-2BB5-4545-A32E-6CA68AA69734}" dt="2021-09-01T07:01:38.603" v="10"/>
            <ac:spMkLst>
              <pc:docMk/>
              <pc:sldMasterMk cId="3216822255" sldId="2147483672"/>
              <pc:sldLayoutMk cId="3080657027" sldId="2147483704"/>
              <ac:spMk id="6" creationId="{C4382753-51C7-0C46-B853-1DBA86E4E953}"/>
            </ac:spMkLst>
          </pc:spChg>
          <pc:spChg chg="mod">
            <ac:chgData name="Grace" userId="fd145552-a10d-4a31-a438-f8736fd84277" providerId="ADAL" clId="{56835480-2BB5-4545-A32E-6CA68AA69734}" dt="2021-09-01T07:01:38.603" v="10"/>
            <ac:spMkLst>
              <pc:docMk/>
              <pc:sldMasterMk cId="3216822255" sldId="2147483672"/>
              <pc:sldLayoutMk cId="3080657027" sldId="2147483704"/>
              <ac:spMk id="8" creationId="{F6164CB4-EC8E-0144-9230-9A41AA8066A6}"/>
            </ac:spMkLst>
          </pc:spChg>
          <pc:spChg chg="mod">
            <ac:chgData name="Grace" userId="fd145552-a10d-4a31-a438-f8736fd84277" providerId="ADAL" clId="{56835480-2BB5-4545-A32E-6CA68AA69734}" dt="2021-09-01T07:01:38.603" v="10"/>
            <ac:spMkLst>
              <pc:docMk/>
              <pc:sldMasterMk cId="3216822255" sldId="2147483672"/>
              <pc:sldLayoutMk cId="3080657027" sldId="2147483704"/>
              <ac:spMk id="10" creationId="{C7C3DC85-C5E4-9F4F-9A53-A30541465834}"/>
            </ac:spMkLst>
          </pc:spChg>
          <pc:picChg chg="mod">
            <ac:chgData name="Grace" userId="fd145552-a10d-4a31-a438-f8736fd84277" providerId="ADAL" clId="{56835480-2BB5-4545-A32E-6CA68AA69734}" dt="2021-09-01T07:01:38.603" v="10"/>
            <ac:picMkLst>
              <pc:docMk/>
              <pc:sldMasterMk cId="3216822255" sldId="2147483672"/>
              <pc:sldLayoutMk cId="3080657027" sldId="2147483704"/>
              <ac:picMk id="9" creationId="{C4F743E6-42C8-45D8-A63F-90FE0651F22C}"/>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1621695405" sldId="2147483705"/>
          </pc:sldLayoutMkLst>
          <pc:spChg chg="mod">
            <ac:chgData name="Grace" userId="fd145552-a10d-4a31-a438-f8736fd84277" providerId="ADAL" clId="{56835480-2BB5-4545-A32E-6CA68AA69734}" dt="2021-09-01T07:01:38.603" v="10"/>
            <ac:spMkLst>
              <pc:docMk/>
              <pc:sldMasterMk cId="3216822255" sldId="2147483672"/>
              <pc:sldLayoutMk cId="1621695405" sldId="2147483705"/>
              <ac:spMk id="7" creationId="{C20D03EA-04EC-3E4D-A8DD-25B0B1CFB907}"/>
            </ac:spMkLst>
          </pc:spChg>
          <pc:spChg chg="mod">
            <ac:chgData name="Grace" userId="fd145552-a10d-4a31-a438-f8736fd84277" providerId="ADAL" clId="{56835480-2BB5-4545-A32E-6CA68AA69734}" dt="2021-09-01T07:01:38.603" v="10"/>
            <ac:spMkLst>
              <pc:docMk/>
              <pc:sldMasterMk cId="3216822255" sldId="2147483672"/>
              <pc:sldLayoutMk cId="1621695405" sldId="2147483705"/>
              <ac:spMk id="8" creationId="{77BCA0C8-FD5B-AE4C-9999-548657AE139B}"/>
            </ac:spMkLst>
          </pc:spChg>
          <pc:spChg chg="mod">
            <ac:chgData name="Grace" userId="fd145552-a10d-4a31-a438-f8736fd84277" providerId="ADAL" clId="{56835480-2BB5-4545-A32E-6CA68AA69734}" dt="2021-09-01T07:01:38.603" v="10"/>
            <ac:spMkLst>
              <pc:docMk/>
              <pc:sldMasterMk cId="3216822255" sldId="2147483672"/>
              <pc:sldLayoutMk cId="1621695405" sldId="2147483705"/>
              <ac:spMk id="13" creationId="{CF277205-D819-0E49-850F-A3DCF077A5B8}"/>
            </ac:spMkLst>
          </pc:spChg>
          <pc:picChg chg="mod">
            <ac:chgData name="Grace" userId="fd145552-a10d-4a31-a438-f8736fd84277" providerId="ADAL" clId="{56835480-2BB5-4545-A32E-6CA68AA69734}" dt="2021-09-01T07:01:38.603" v="10"/>
            <ac:picMkLst>
              <pc:docMk/>
              <pc:sldMasterMk cId="3216822255" sldId="2147483672"/>
              <pc:sldLayoutMk cId="1621695405" sldId="2147483705"/>
              <ac:picMk id="9" creationId="{2C89BC04-6416-479F-AF58-1E9563CF6521}"/>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2751367391" sldId="2147483706"/>
          </pc:sldLayoutMkLst>
          <pc:spChg chg="mod">
            <ac:chgData name="Grace" userId="fd145552-a10d-4a31-a438-f8736fd84277" providerId="ADAL" clId="{56835480-2BB5-4545-A32E-6CA68AA69734}" dt="2021-09-01T07:01:38.603" v="10"/>
            <ac:spMkLst>
              <pc:docMk/>
              <pc:sldMasterMk cId="3216822255" sldId="2147483672"/>
              <pc:sldLayoutMk cId="2751367391" sldId="2147483706"/>
              <ac:spMk id="11" creationId="{21437180-96FB-744F-865F-A5F1DCF5F20E}"/>
            </ac:spMkLst>
          </pc:spChg>
          <pc:spChg chg="mod">
            <ac:chgData name="Grace" userId="fd145552-a10d-4a31-a438-f8736fd84277" providerId="ADAL" clId="{56835480-2BB5-4545-A32E-6CA68AA69734}" dt="2021-09-01T07:01:38.603" v="10"/>
            <ac:spMkLst>
              <pc:docMk/>
              <pc:sldMasterMk cId="3216822255" sldId="2147483672"/>
              <pc:sldLayoutMk cId="2751367391" sldId="2147483706"/>
              <ac:spMk id="13" creationId="{378A92A4-48B7-0340-8B92-C0F9AC1FDA6C}"/>
            </ac:spMkLst>
          </pc:spChg>
          <pc:spChg chg="mod">
            <ac:chgData name="Grace" userId="fd145552-a10d-4a31-a438-f8736fd84277" providerId="ADAL" clId="{56835480-2BB5-4545-A32E-6CA68AA69734}" dt="2021-09-01T07:01:38.603" v="10"/>
            <ac:spMkLst>
              <pc:docMk/>
              <pc:sldMasterMk cId="3216822255" sldId="2147483672"/>
              <pc:sldLayoutMk cId="2751367391" sldId="2147483706"/>
              <ac:spMk id="14" creationId="{55933010-02AF-864A-B29C-468E3DDEEA5E}"/>
            </ac:spMkLst>
          </pc:spChg>
          <pc:picChg chg="mod">
            <ac:chgData name="Grace" userId="fd145552-a10d-4a31-a438-f8736fd84277" providerId="ADAL" clId="{56835480-2BB5-4545-A32E-6CA68AA69734}" dt="2021-09-01T07:01:38.603" v="10"/>
            <ac:picMkLst>
              <pc:docMk/>
              <pc:sldMasterMk cId="3216822255" sldId="2147483672"/>
              <pc:sldLayoutMk cId="2751367391" sldId="2147483706"/>
              <ac:picMk id="7" creationId="{A8B4EEB1-42E3-41C0-B7C0-8A0DC6F52F0A}"/>
            </ac:picMkLst>
          </pc:picChg>
        </pc:sldLayoutChg>
        <pc:sldLayoutChg chg="modSp">
          <pc:chgData name="Grace" userId="fd145552-a10d-4a31-a438-f8736fd84277" providerId="ADAL" clId="{56835480-2BB5-4545-A32E-6CA68AA69734}" dt="2021-09-01T07:01:38.603" v="10"/>
          <pc:sldLayoutMkLst>
            <pc:docMk/>
            <pc:sldMasterMk cId="3216822255" sldId="2147483672"/>
            <pc:sldLayoutMk cId="1688171067" sldId="2147483707"/>
          </pc:sldLayoutMkLst>
          <pc:spChg chg="mod">
            <ac:chgData name="Grace" userId="fd145552-a10d-4a31-a438-f8736fd84277" providerId="ADAL" clId="{56835480-2BB5-4545-A32E-6CA68AA69734}" dt="2021-09-01T07:01:38.603" v="10"/>
            <ac:spMkLst>
              <pc:docMk/>
              <pc:sldMasterMk cId="3216822255" sldId="2147483672"/>
              <pc:sldLayoutMk cId="1688171067" sldId="2147483707"/>
              <ac:spMk id="10" creationId="{8B4E2EF0-9062-4F05-9A3B-77EF8F83B0CC}"/>
            </ac:spMkLst>
          </pc:spChg>
          <pc:spChg chg="mod">
            <ac:chgData name="Grace" userId="fd145552-a10d-4a31-a438-f8736fd84277" providerId="ADAL" clId="{56835480-2BB5-4545-A32E-6CA68AA69734}" dt="2021-09-01T07:01:38.603" v="10"/>
            <ac:spMkLst>
              <pc:docMk/>
              <pc:sldMasterMk cId="3216822255" sldId="2147483672"/>
              <pc:sldLayoutMk cId="1688171067" sldId="2147483707"/>
              <ac:spMk id="11" creationId="{ECB8694C-9422-48F7-87AC-E0ABCD95A092}"/>
            </ac:spMkLst>
          </pc:spChg>
          <pc:spChg chg="mod">
            <ac:chgData name="Grace" userId="fd145552-a10d-4a31-a438-f8736fd84277" providerId="ADAL" clId="{56835480-2BB5-4545-A32E-6CA68AA69734}" dt="2021-09-01T07:01:38.603" v="10"/>
            <ac:spMkLst>
              <pc:docMk/>
              <pc:sldMasterMk cId="3216822255" sldId="2147483672"/>
              <pc:sldLayoutMk cId="1688171067" sldId="2147483707"/>
              <ac:spMk id="14" creationId="{A9A5A20B-A3A8-0644-8A24-864C592BB1ED}"/>
            </ac:spMkLst>
          </pc:spChg>
          <pc:spChg chg="mod">
            <ac:chgData name="Grace" userId="fd145552-a10d-4a31-a438-f8736fd84277" providerId="ADAL" clId="{56835480-2BB5-4545-A32E-6CA68AA69734}" dt="2021-09-01T07:01:38.603" v="10"/>
            <ac:spMkLst>
              <pc:docMk/>
              <pc:sldMasterMk cId="3216822255" sldId="2147483672"/>
              <pc:sldLayoutMk cId="1688171067" sldId="2147483707"/>
              <ac:spMk id="19" creationId="{E6C428A3-703E-5B43-9CAA-334439257768}"/>
            </ac:spMkLst>
          </pc:spChg>
          <pc:spChg chg="mod">
            <ac:chgData name="Grace" userId="fd145552-a10d-4a31-a438-f8736fd84277" providerId="ADAL" clId="{56835480-2BB5-4545-A32E-6CA68AA69734}" dt="2021-09-01T07:01:38.603" v="10"/>
            <ac:spMkLst>
              <pc:docMk/>
              <pc:sldMasterMk cId="3216822255" sldId="2147483672"/>
              <pc:sldLayoutMk cId="1688171067" sldId="2147483707"/>
              <ac:spMk id="32" creationId="{AFDB2844-75A1-F046-B436-56BA099D686A}"/>
            </ac:spMkLst>
          </pc:spChg>
        </pc:sldLayoutChg>
        <pc:sldLayoutChg chg="del">
          <pc:chgData name="Grace" userId="fd145552-a10d-4a31-a438-f8736fd84277" providerId="ADAL" clId="{56835480-2BB5-4545-A32E-6CA68AA69734}" dt="2021-09-01T22:43:45.116" v="990" actId="47"/>
          <pc:sldLayoutMkLst>
            <pc:docMk/>
            <pc:sldMasterMk cId="3216822255" sldId="2147483758"/>
            <pc:sldLayoutMk cId="2984498153" sldId="2147483708"/>
          </pc:sldLayoutMkLst>
        </pc:sldLayoutChg>
        <pc:sldLayoutChg chg="modSp">
          <pc:chgData name="Grace" userId="fd145552-a10d-4a31-a438-f8736fd84277" providerId="ADAL" clId="{56835480-2BB5-4545-A32E-6CA68AA69734}" dt="2021-09-01T07:01:38.603" v="10"/>
          <pc:sldLayoutMkLst>
            <pc:docMk/>
            <pc:sldMasterMk cId="3216822255" sldId="2147483758"/>
            <pc:sldLayoutMk cId="1405924122" sldId="2147483759"/>
          </pc:sldLayoutMkLst>
          <pc:spChg chg="mod">
            <ac:chgData name="Grace" userId="fd145552-a10d-4a31-a438-f8736fd84277" providerId="ADAL" clId="{56835480-2BB5-4545-A32E-6CA68AA69734}" dt="2021-09-01T07:01:38.603" v="10"/>
            <ac:spMkLst>
              <pc:docMk/>
              <pc:sldMasterMk cId="3216822255" sldId="2147483758"/>
              <pc:sldLayoutMk cId="1405924122" sldId="2147483759"/>
              <ac:spMk id="3" creationId="{00000000-0000-0000-0000-000000000000}"/>
            </ac:spMkLst>
          </pc:spChg>
          <pc:spChg chg="mod">
            <ac:chgData name="Grace" userId="fd145552-a10d-4a31-a438-f8736fd84277" providerId="ADAL" clId="{56835480-2BB5-4545-A32E-6CA68AA69734}" dt="2021-09-01T07:01:38.603" v="10"/>
            <ac:spMkLst>
              <pc:docMk/>
              <pc:sldMasterMk cId="3216822255" sldId="2147483758"/>
              <pc:sldLayoutMk cId="1405924122" sldId="2147483759"/>
              <ac:spMk id="5" creationId="{63D16220-4F50-6A45-8A5C-0AB56F7CE96C}"/>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4006700652" sldId="2147483759"/>
          </pc:sldLayoutMkLst>
          <pc:spChg chg="mod">
            <ac:chgData name="Grace" userId="fd145552-a10d-4a31-a438-f8736fd84277" providerId="ADAL" clId="{56835480-2BB5-4545-A32E-6CA68AA69734}" dt="2021-09-01T07:01:38.603" v="10"/>
            <ac:spMkLst>
              <pc:docMk/>
              <pc:sldMasterMk cId="3216822255" sldId="2147483758"/>
              <pc:sldLayoutMk cId="4006700652" sldId="2147483759"/>
              <ac:spMk id="2" creationId="{2D683605-FFBB-DF40-9F65-A763316E8C46}"/>
            </ac:spMkLst>
          </pc:spChg>
          <pc:spChg chg="mod">
            <ac:chgData name="Grace" userId="fd145552-a10d-4a31-a438-f8736fd84277" providerId="ADAL" clId="{56835480-2BB5-4545-A32E-6CA68AA69734}" dt="2021-09-01T07:01:38.603" v="10"/>
            <ac:spMkLst>
              <pc:docMk/>
              <pc:sldMasterMk cId="3216822255" sldId="2147483758"/>
              <pc:sldLayoutMk cId="4006700652" sldId="2147483759"/>
              <ac:spMk id="3" creationId="{9E38F0D4-8996-1340-9692-21C5B4DC5D31}"/>
            </ac:spMkLst>
          </pc:spChg>
          <pc:graphicFrameChg chg="mod">
            <ac:chgData name="Grace" userId="fd145552-a10d-4a31-a438-f8736fd84277" providerId="ADAL" clId="{56835480-2BB5-4545-A32E-6CA68AA69734}" dt="2021-09-01T07:01:38.603" v="10"/>
            <ac:graphicFrameMkLst>
              <pc:docMk/>
              <pc:sldMasterMk cId="3216822255" sldId="2147483758"/>
              <pc:sldLayoutMk cId="4006700652" sldId="2147483759"/>
              <ac:graphicFrameMk id="4" creationId="{53F5080A-DFFE-664C-B514-2BB0E750C953}"/>
            </ac:graphicFrameMkLst>
          </pc:graphicFrameChg>
        </pc:sldLayoutChg>
        <pc:sldLayoutChg chg="modSp">
          <pc:chgData name="Grace" userId="fd145552-a10d-4a31-a438-f8736fd84277" providerId="ADAL" clId="{56835480-2BB5-4545-A32E-6CA68AA69734}" dt="2021-09-01T07:01:38.603" v="10"/>
          <pc:sldLayoutMkLst>
            <pc:docMk/>
            <pc:sldMasterMk cId="3216822255" sldId="2147483758"/>
            <pc:sldLayoutMk cId="4283350589" sldId="2147483760"/>
          </pc:sldLayoutMkLst>
          <pc:spChg chg="mod">
            <ac:chgData name="Grace" userId="fd145552-a10d-4a31-a438-f8736fd84277" providerId="ADAL" clId="{56835480-2BB5-4545-A32E-6CA68AA69734}" dt="2021-09-01T07:01:38.603" v="10"/>
            <ac:spMkLst>
              <pc:docMk/>
              <pc:sldMasterMk cId="3216822255" sldId="2147483758"/>
              <pc:sldLayoutMk cId="4283350589" sldId="2147483760"/>
              <ac:spMk id="5" creationId="{70A60416-C836-0E45-976A-13A986DE89E8}"/>
            </ac:spMkLst>
          </pc:spChg>
          <pc:spChg chg="mod">
            <ac:chgData name="Grace" userId="fd145552-a10d-4a31-a438-f8736fd84277" providerId="ADAL" clId="{56835480-2BB5-4545-A32E-6CA68AA69734}" dt="2021-09-01T07:01:38.603" v="10"/>
            <ac:spMkLst>
              <pc:docMk/>
              <pc:sldMasterMk cId="3216822255" sldId="2147483758"/>
              <pc:sldLayoutMk cId="4283350589" sldId="2147483760"/>
              <ac:spMk id="7" creationId="{8337E35D-E929-4CDD-AFA3-DDA5D95A9F9F}"/>
            </ac:spMkLst>
          </pc:spChg>
          <pc:spChg chg="mod">
            <ac:chgData name="Grace" userId="fd145552-a10d-4a31-a438-f8736fd84277" providerId="ADAL" clId="{56835480-2BB5-4545-A32E-6CA68AA69734}" dt="2021-09-01T07:01:38.603" v="10"/>
            <ac:spMkLst>
              <pc:docMk/>
              <pc:sldMasterMk cId="3216822255" sldId="2147483758"/>
              <pc:sldLayoutMk cId="4283350589" sldId="2147483760"/>
              <ac:spMk id="9" creationId="{DBCD8866-5C79-4769-B022-E56134A505BB}"/>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330668741" sldId="2147483761"/>
          </pc:sldLayoutMkLst>
          <pc:spChg chg="mod">
            <ac:chgData name="Grace" userId="fd145552-a10d-4a31-a438-f8736fd84277" providerId="ADAL" clId="{56835480-2BB5-4545-A32E-6CA68AA69734}" dt="2021-09-01T07:01:38.603" v="10"/>
            <ac:spMkLst>
              <pc:docMk/>
              <pc:sldMasterMk cId="3216822255" sldId="2147483758"/>
              <pc:sldLayoutMk cId="330668741" sldId="2147483761"/>
              <ac:spMk id="6" creationId="{00000000-0000-0000-0000-000000000000}"/>
            </ac:spMkLst>
          </pc:spChg>
          <pc:spChg chg="mod">
            <ac:chgData name="Grace" userId="fd145552-a10d-4a31-a438-f8736fd84277" providerId="ADAL" clId="{56835480-2BB5-4545-A32E-6CA68AA69734}" dt="2021-09-01T07:01:38.603" v="10"/>
            <ac:spMkLst>
              <pc:docMk/>
              <pc:sldMasterMk cId="3216822255" sldId="2147483758"/>
              <pc:sldLayoutMk cId="330668741" sldId="2147483761"/>
              <ac:spMk id="8" creationId="{6B9C7BF1-6F0E-974D-9D90-8D2E3B8614D2}"/>
            </ac:spMkLst>
          </pc:spChg>
          <pc:spChg chg="mod">
            <ac:chgData name="Grace" userId="fd145552-a10d-4a31-a438-f8736fd84277" providerId="ADAL" clId="{56835480-2BB5-4545-A32E-6CA68AA69734}" dt="2021-09-01T07:01:38.603" v="10"/>
            <ac:spMkLst>
              <pc:docMk/>
              <pc:sldMasterMk cId="3216822255" sldId="2147483758"/>
              <pc:sldLayoutMk cId="330668741" sldId="2147483761"/>
              <ac:spMk id="9" creationId="{1A6E8EBA-F725-4134-BDCE-9523A37EB37D}"/>
            </ac:spMkLst>
          </pc:spChg>
          <pc:spChg chg="mod">
            <ac:chgData name="Grace" userId="fd145552-a10d-4a31-a438-f8736fd84277" providerId="ADAL" clId="{56835480-2BB5-4545-A32E-6CA68AA69734}" dt="2021-09-01T07:01:38.603" v="10"/>
            <ac:spMkLst>
              <pc:docMk/>
              <pc:sldMasterMk cId="3216822255" sldId="2147483758"/>
              <pc:sldLayoutMk cId="330668741" sldId="2147483761"/>
              <ac:spMk id="10" creationId="{F396C485-F9F3-4645-B4AF-D94B2D375008}"/>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4184968977" sldId="2147483762"/>
          </pc:sldLayoutMkLst>
          <pc:spChg chg="mod">
            <ac:chgData name="Grace" userId="fd145552-a10d-4a31-a438-f8736fd84277" providerId="ADAL" clId="{56835480-2BB5-4545-A32E-6CA68AA69734}" dt="2021-09-01T07:01:38.603" v="10"/>
            <ac:spMkLst>
              <pc:docMk/>
              <pc:sldMasterMk cId="3216822255" sldId="2147483758"/>
              <pc:sldLayoutMk cId="4184968977" sldId="2147483762"/>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758"/>
              <pc:sldLayoutMk cId="4184968977" sldId="2147483762"/>
              <ac:spMk id="6" creationId="{9842CB90-B2C6-9F49-B023-F8F8398B98F1}"/>
            </ac:spMkLst>
          </pc:spChg>
          <pc:spChg chg="mod">
            <ac:chgData name="Grace" userId="fd145552-a10d-4a31-a438-f8736fd84277" providerId="ADAL" clId="{56835480-2BB5-4545-A32E-6CA68AA69734}" dt="2021-09-01T07:01:38.603" v="10"/>
            <ac:spMkLst>
              <pc:docMk/>
              <pc:sldMasterMk cId="3216822255" sldId="2147483758"/>
              <pc:sldLayoutMk cId="4184968977" sldId="2147483762"/>
              <ac:spMk id="9" creationId="{DCFEABC9-8CBC-4BFF-A091-0B1175D7A66C}"/>
            </ac:spMkLst>
          </pc:spChg>
          <pc:spChg chg="mod">
            <ac:chgData name="Grace" userId="fd145552-a10d-4a31-a438-f8736fd84277" providerId="ADAL" clId="{56835480-2BB5-4545-A32E-6CA68AA69734}" dt="2021-09-01T07:01:38.603" v="10"/>
            <ac:spMkLst>
              <pc:docMk/>
              <pc:sldMasterMk cId="3216822255" sldId="2147483758"/>
              <pc:sldLayoutMk cId="4184968977" sldId="2147483762"/>
              <ac:spMk id="10" creationId="{FC11E0B3-4BC6-4FDE-8A73-E95CF528DD93}"/>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32481541" sldId="2147483763"/>
          </pc:sldLayoutMkLst>
          <pc:spChg chg="mod">
            <ac:chgData name="Grace" userId="fd145552-a10d-4a31-a438-f8736fd84277" providerId="ADAL" clId="{56835480-2BB5-4545-A32E-6CA68AA69734}" dt="2021-09-01T07:01:38.603" v="10"/>
            <ac:spMkLst>
              <pc:docMk/>
              <pc:sldMasterMk cId="3216822255" sldId="2147483758"/>
              <pc:sldLayoutMk cId="32481541" sldId="2147483763"/>
              <ac:spMk id="6" creationId="{00000000-0000-0000-0000-000000000000}"/>
            </ac:spMkLst>
          </pc:spChg>
          <pc:spChg chg="mod">
            <ac:chgData name="Grace" userId="fd145552-a10d-4a31-a438-f8736fd84277" providerId="ADAL" clId="{56835480-2BB5-4545-A32E-6CA68AA69734}" dt="2021-09-01T07:01:38.603" v="10"/>
            <ac:spMkLst>
              <pc:docMk/>
              <pc:sldMasterMk cId="3216822255" sldId="2147483758"/>
              <pc:sldLayoutMk cId="32481541" sldId="2147483763"/>
              <ac:spMk id="7" creationId="{A9E197AB-B83A-F542-A11A-CDE4241E8C70}"/>
            </ac:spMkLst>
          </pc:spChg>
          <pc:spChg chg="mod">
            <ac:chgData name="Grace" userId="fd145552-a10d-4a31-a438-f8736fd84277" providerId="ADAL" clId="{56835480-2BB5-4545-A32E-6CA68AA69734}" dt="2021-09-01T07:01:38.603" v="10"/>
            <ac:spMkLst>
              <pc:docMk/>
              <pc:sldMasterMk cId="3216822255" sldId="2147483758"/>
              <pc:sldLayoutMk cId="32481541" sldId="2147483763"/>
              <ac:spMk id="8" creationId="{FDEF6A8B-FE55-424B-91EF-87F23AFF3A8E}"/>
            </ac:spMkLst>
          </pc:spChg>
          <pc:spChg chg="mod">
            <ac:chgData name="Grace" userId="fd145552-a10d-4a31-a438-f8736fd84277" providerId="ADAL" clId="{56835480-2BB5-4545-A32E-6CA68AA69734}" dt="2021-09-01T07:01:38.603" v="10"/>
            <ac:spMkLst>
              <pc:docMk/>
              <pc:sldMasterMk cId="3216822255" sldId="2147483758"/>
              <pc:sldLayoutMk cId="32481541" sldId="2147483763"/>
              <ac:spMk id="10" creationId="{FBDBDC34-494F-4FD9-8BD2-78F992CF9F94}"/>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2911226149" sldId="2147483764"/>
          </pc:sldLayoutMkLst>
          <pc:spChg chg="mod">
            <ac:chgData name="Grace" userId="fd145552-a10d-4a31-a438-f8736fd84277" providerId="ADAL" clId="{56835480-2BB5-4545-A32E-6CA68AA69734}" dt="2021-09-01T07:01:38.603" v="10"/>
            <ac:spMkLst>
              <pc:docMk/>
              <pc:sldMasterMk cId="3216822255" sldId="2147483758"/>
              <pc:sldLayoutMk cId="2911226149" sldId="2147483764"/>
              <ac:spMk id="4" creationId="{716DB442-97F9-2241-AE70-FE1000B8FF4F}"/>
            </ac:spMkLst>
          </pc:spChg>
          <pc:spChg chg="mod">
            <ac:chgData name="Grace" userId="fd145552-a10d-4a31-a438-f8736fd84277" providerId="ADAL" clId="{56835480-2BB5-4545-A32E-6CA68AA69734}" dt="2021-09-01T07:01:38.603" v="10"/>
            <ac:spMkLst>
              <pc:docMk/>
              <pc:sldMasterMk cId="3216822255" sldId="2147483758"/>
              <pc:sldLayoutMk cId="2911226149" sldId="2147483764"/>
              <ac:spMk id="5" creationId="{00000000-0000-0000-0000-000000000000}"/>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1105528143" sldId="2147483765"/>
          </pc:sldLayoutMkLst>
          <pc:spChg chg="mod">
            <ac:chgData name="Grace" userId="fd145552-a10d-4a31-a438-f8736fd84277" providerId="ADAL" clId="{56835480-2BB5-4545-A32E-6CA68AA69734}" dt="2021-09-01T07:01:38.603" v="10"/>
            <ac:spMkLst>
              <pc:docMk/>
              <pc:sldMasterMk cId="3216822255" sldId="2147483758"/>
              <pc:sldLayoutMk cId="1105528143" sldId="2147483765"/>
              <ac:spMk id="3" creationId="{861D717C-1AC4-394E-91B8-A016BB12DA1B}"/>
            </ac:spMkLst>
          </pc:spChg>
        </pc:sldLayoutChg>
        <pc:sldLayoutChg chg="modSp">
          <pc:chgData name="Grace" userId="fd145552-a10d-4a31-a438-f8736fd84277" providerId="ADAL" clId="{56835480-2BB5-4545-A32E-6CA68AA69734}" dt="2021-09-01T07:01:38.603" v="10"/>
          <pc:sldLayoutMkLst>
            <pc:docMk/>
            <pc:sldMasterMk cId="3216822255" sldId="2147483758"/>
            <pc:sldLayoutMk cId="3970704508" sldId="2147483766"/>
          </pc:sldLayoutMkLst>
          <pc:spChg chg="mod">
            <ac:chgData name="Grace" userId="fd145552-a10d-4a31-a438-f8736fd84277" providerId="ADAL" clId="{56835480-2BB5-4545-A32E-6CA68AA69734}" dt="2021-09-01T07:01:38.603" v="10"/>
            <ac:spMkLst>
              <pc:docMk/>
              <pc:sldMasterMk cId="3216822255" sldId="2147483758"/>
              <pc:sldLayoutMk cId="3970704508" sldId="2147483766"/>
              <ac:spMk id="5" creationId="{00000000-0000-0000-0000-000000000000}"/>
            </ac:spMkLst>
          </pc:spChg>
          <pc:spChg chg="mod">
            <ac:chgData name="Grace" userId="fd145552-a10d-4a31-a438-f8736fd84277" providerId="ADAL" clId="{56835480-2BB5-4545-A32E-6CA68AA69734}" dt="2021-09-01T07:01:38.603" v="10"/>
            <ac:spMkLst>
              <pc:docMk/>
              <pc:sldMasterMk cId="3216822255" sldId="2147483758"/>
              <pc:sldLayoutMk cId="3970704508" sldId="2147483766"/>
              <ac:spMk id="7" creationId="{00000000-0000-0000-0000-000000000000}"/>
            </ac:spMkLst>
          </pc:spChg>
          <pc:spChg chg="mod">
            <ac:chgData name="Grace" userId="fd145552-a10d-4a31-a438-f8736fd84277" providerId="ADAL" clId="{56835480-2BB5-4545-A32E-6CA68AA69734}" dt="2021-09-01T07:01:38.603" v="10"/>
            <ac:spMkLst>
              <pc:docMk/>
              <pc:sldMasterMk cId="3216822255" sldId="2147483758"/>
              <pc:sldLayoutMk cId="3970704508" sldId="2147483766"/>
              <ac:spMk id="10" creationId="{8AB9FAD1-F758-AF4C-BAD5-AFAD67046B97}"/>
            </ac:spMkLst>
          </pc:spChg>
          <pc:picChg chg="mod">
            <ac:chgData name="Grace" userId="fd145552-a10d-4a31-a438-f8736fd84277" providerId="ADAL" clId="{56835480-2BB5-4545-A32E-6CA68AA69734}" dt="2021-09-01T07:01:38.603" v="10"/>
            <ac:picMkLst>
              <pc:docMk/>
              <pc:sldMasterMk cId="3216822255" sldId="2147483758"/>
              <pc:sldLayoutMk cId="3970704508" sldId="2147483766"/>
              <ac:picMk id="8" creationId="{00000000-0000-0000-0000-000000000000}"/>
            </ac:picMkLst>
          </pc:picChg>
        </pc:sldLayoutChg>
      </pc:sldMasterChg>
    </pc:docChg>
  </pc:docChgLst>
  <pc:docChgLst>
    <pc:chgData name="Alexis Hutcheon" userId="S::alexis.hutcheon@sydney.edu.au::ddef8b19-8dcf-422d-9735-b7eafcc40d59" providerId="AD" clId="Web-{9C98EEBF-82E5-5459-3AC7-E35BDB77DACC}"/>
    <pc:docChg chg="addSld delSld modSld sldOrd addMainMaster">
      <pc:chgData name="Alexis Hutcheon" userId="S::alexis.hutcheon@sydney.edu.au::ddef8b19-8dcf-422d-9735-b7eafcc40d59" providerId="AD" clId="Web-{9C98EEBF-82E5-5459-3AC7-E35BDB77DACC}" dt="2021-09-12T23:23:20.684" v="105" actId="14100"/>
      <pc:docMkLst>
        <pc:docMk/>
      </pc:docMkLst>
      <pc:sldChg chg="addSp delSp modSp">
        <pc:chgData name="Alexis Hutcheon" userId="S::alexis.hutcheon@sydney.edu.au::ddef8b19-8dcf-422d-9735-b7eafcc40d59" providerId="AD" clId="Web-{9C98EEBF-82E5-5459-3AC7-E35BDB77DACC}" dt="2021-09-12T23:06:11.725" v="30"/>
        <pc:sldMkLst>
          <pc:docMk/>
          <pc:sldMk cId="187938002" sldId="3307"/>
        </pc:sldMkLst>
        <pc:spChg chg="add del mod">
          <ac:chgData name="Alexis Hutcheon" userId="S::alexis.hutcheon@sydney.edu.au::ddef8b19-8dcf-422d-9735-b7eafcc40d59" providerId="AD" clId="Web-{9C98EEBF-82E5-5459-3AC7-E35BDB77DACC}" dt="2021-09-12T23:06:11.725" v="30"/>
          <ac:spMkLst>
            <pc:docMk/>
            <pc:sldMk cId="187938002" sldId="3307"/>
            <ac:spMk id="4" creationId="{E28CEFCC-78AC-41BE-8D10-86E8206167AC}"/>
          </ac:spMkLst>
        </pc:spChg>
        <pc:spChg chg="add del">
          <ac:chgData name="Alexis Hutcheon" userId="S::alexis.hutcheon@sydney.edu.au::ddef8b19-8dcf-422d-9735-b7eafcc40d59" providerId="AD" clId="Web-{9C98EEBF-82E5-5459-3AC7-E35BDB77DACC}" dt="2021-09-12T23:06:08.397" v="28"/>
          <ac:spMkLst>
            <pc:docMk/>
            <pc:sldMk cId="187938002" sldId="3307"/>
            <ac:spMk id="5" creationId="{7EC55D8B-8091-49AA-B791-DB04406F16CC}"/>
          </ac:spMkLst>
        </pc:spChg>
        <pc:picChg chg="add del mod">
          <ac:chgData name="Alexis Hutcheon" userId="S::alexis.hutcheon@sydney.edu.au::ddef8b19-8dcf-422d-9735-b7eafcc40d59" providerId="AD" clId="Web-{9C98EEBF-82E5-5459-3AC7-E35BDB77DACC}" dt="2021-09-12T22:38:38.082" v="1"/>
          <ac:picMkLst>
            <pc:docMk/>
            <pc:sldMk cId="187938002" sldId="3307"/>
            <ac:picMk id="2" creationId="{5DF34FB1-64E1-48C8-980F-CDB0338269B1}"/>
          </ac:picMkLst>
        </pc:picChg>
      </pc:sldChg>
      <pc:sldChg chg="addSp delSp modSp new mod modClrScheme chgLayout">
        <pc:chgData name="Alexis Hutcheon" userId="S::alexis.hutcheon@sydney.edu.au::ddef8b19-8dcf-422d-9735-b7eafcc40d59" providerId="AD" clId="Web-{9C98EEBF-82E5-5459-3AC7-E35BDB77DACC}" dt="2021-09-12T23:23:20.684" v="105" actId="14100"/>
        <pc:sldMkLst>
          <pc:docMk/>
          <pc:sldMk cId="1051965027" sldId="4111"/>
        </pc:sldMkLst>
        <pc:spChg chg="add del mod">
          <ac:chgData name="Alexis Hutcheon" userId="S::alexis.hutcheon@sydney.edu.au::ddef8b19-8dcf-422d-9735-b7eafcc40d59" providerId="AD" clId="Web-{9C98EEBF-82E5-5459-3AC7-E35BDB77DACC}" dt="2021-09-12T23:14:12.157" v="47"/>
          <ac:spMkLst>
            <pc:docMk/>
            <pc:sldMk cId="1051965027" sldId="4111"/>
            <ac:spMk id="6" creationId="{A6F9F9F9-B924-4331-A2F4-2A892E663AE8}"/>
          </ac:spMkLst>
        </pc:spChg>
        <pc:spChg chg="add del mod">
          <ac:chgData name="Alexis Hutcheon" userId="S::alexis.hutcheon@sydney.edu.au::ddef8b19-8dcf-422d-9735-b7eafcc40d59" providerId="AD" clId="Web-{9C98EEBF-82E5-5459-3AC7-E35BDB77DACC}" dt="2021-09-12T23:14:35.595" v="51"/>
          <ac:spMkLst>
            <pc:docMk/>
            <pc:sldMk cId="1051965027" sldId="4111"/>
            <ac:spMk id="7" creationId="{A6F9F9F9-B924-4331-A2F4-2A892E663AE8}"/>
          </ac:spMkLst>
        </pc:spChg>
        <pc:spChg chg="add del mod">
          <ac:chgData name="Alexis Hutcheon" userId="S::alexis.hutcheon@sydney.edu.au::ddef8b19-8dcf-422d-9735-b7eafcc40d59" providerId="AD" clId="Web-{9C98EEBF-82E5-5459-3AC7-E35BDB77DACC}" dt="2021-09-12T23:13:50.828" v="43"/>
          <ac:spMkLst>
            <pc:docMk/>
            <pc:sldMk cId="1051965027" sldId="4111"/>
            <ac:spMk id="9" creationId="{690B5B5A-F90D-4F86-B92A-A06F013DC690}"/>
          </ac:spMkLst>
        </pc:spChg>
        <pc:picChg chg="add del mod">
          <ac:chgData name="Alexis Hutcheon" userId="S::alexis.hutcheon@sydney.edu.au::ddef8b19-8dcf-422d-9735-b7eafcc40d59" providerId="AD" clId="Web-{9C98EEBF-82E5-5459-3AC7-E35BDB77DACC}" dt="2021-09-12T23:08:02.962" v="39"/>
          <ac:picMkLst>
            <pc:docMk/>
            <pc:sldMk cId="1051965027" sldId="4111"/>
            <ac:picMk id="3" creationId="{C1555637-988E-4711-BFC1-05989FF4532B}"/>
          </ac:picMkLst>
        </pc:picChg>
        <pc:picChg chg="add mod">
          <ac:chgData name="Alexis Hutcheon" userId="S::alexis.hutcheon@sydney.edu.au::ddef8b19-8dcf-422d-9735-b7eafcc40d59" providerId="AD" clId="Web-{9C98EEBF-82E5-5459-3AC7-E35BDB77DACC}" dt="2021-09-12T23:23:20.684" v="105" actId="14100"/>
          <ac:picMkLst>
            <pc:docMk/>
            <pc:sldMk cId="1051965027" sldId="4111"/>
            <ac:picMk id="4" creationId="{F0DC7E57-F0EE-42A2-9C8E-8D8197227A3B}"/>
          </ac:picMkLst>
        </pc:picChg>
      </pc:sldChg>
      <pc:sldChg chg="new del">
        <pc:chgData name="Alexis Hutcheon" userId="S::alexis.hutcheon@sydney.edu.au::ddef8b19-8dcf-422d-9735-b7eafcc40d59" providerId="AD" clId="Web-{9C98EEBF-82E5-5459-3AC7-E35BDB77DACC}" dt="2021-09-12T23:05:22.880" v="17"/>
        <pc:sldMkLst>
          <pc:docMk/>
          <pc:sldMk cId="2771220384" sldId="4111"/>
        </pc:sldMkLst>
      </pc:sldChg>
      <pc:sldChg chg="add del">
        <pc:chgData name="Alexis Hutcheon" userId="S::alexis.hutcheon@sydney.edu.au::ddef8b19-8dcf-422d-9735-b7eafcc40d59" providerId="AD" clId="Web-{9C98EEBF-82E5-5459-3AC7-E35BDB77DACC}" dt="2021-09-12T23:07:59.180" v="38"/>
        <pc:sldMkLst>
          <pc:docMk/>
          <pc:sldMk cId="1220215274" sldId="4112"/>
        </pc:sldMkLst>
      </pc:sldChg>
      <pc:sldChg chg="addSp delSp modSp new">
        <pc:chgData name="Alexis Hutcheon" userId="S::alexis.hutcheon@sydney.edu.au::ddef8b19-8dcf-422d-9735-b7eafcc40d59" providerId="AD" clId="Web-{9C98EEBF-82E5-5459-3AC7-E35BDB77DACC}" dt="2021-09-12T23:23:06.762" v="101" actId="14100"/>
        <pc:sldMkLst>
          <pc:docMk/>
          <pc:sldMk cId="1686120798" sldId="4112"/>
        </pc:sldMkLst>
        <pc:spChg chg="del">
          <ac:chgData name="Alexis Hutcheon" userId="S::alexis.hutcheon@sydney.edu.au::ddef8b19-8dcf-422d-9735-b7eafcc40d59" providerId="AD" clId="Web-{9C98EEBF-82E5-5459-3AC7-E35BDB77DACC}" dt="2021-09-12T23:15:58.878" v="54"/>
          <ac:spMkLst>
            <pc:docMk/>
            <pc:sldMk cId="1686120798" sldId="4112"/>
            <ac:spMk id="2" creationId="{D79288CC-CAC7-4523-B3EA-06B49B7779E1}"/>
          </ac:spMkLst>
        </pc:spChg>
        <pc:spChg chg="del">
          <ac:chgData name="Alexis Hutcheon" userId="S::alexis.hutcheon@sydney.edu.au::ddef8b19-8dcf-422d-9735-b7eafcc40d59" providerId="AD" clId="Web-{9C98EEBF-82E5-5459-3AC7-E35BDB77DACC}" dt="2021-09-12T23:16:11.534" v="55"/>
          <ac:spMkLst>
            <pc:docMk/>
            <pc:sldMk cId="1686120798" sldId="4112"/>
            <ac:spMk id="3" creationId="{1CCFE88A-2988-403C-894C-5CD966D9CC57}"/>
          </ac:spMkLst>
        </pc:spChg>
        <pc:picChg chg="add mod ord">
          <ac:chgData name="Alexis Hutcheon" userId="S::alexis.hutcheon@sydney.edu.au::ddef8b19-8dcf-422d-9735-b7eafcc40d59" providerId="AD" clId="Web-{9C98EEBF-82E5-5459-3AC7-E35BDB77DACC}" dt="2021-09-12T23:23:06.762" v="101" actId="14100"/>
          <ac:picMkLst>
            <pc:docMk/>
            <pc:sldMk cId="1686120798" sldId="4112"/>
            <ac:picMk id="4" creationId="{1C1D117D-781D-47CF-9948-49F8C3FF3C1F}"/>
          </ac:picMkLst>
        </pc:picChg>
      </pc:sldChg>
      <pc:sldChg chg="new del">
        <pc:chgData name="Alexis Hutcheon" userId="S::alexis.hutcheon@sydney.edu.au::ddef8b19-8dcf-422d-9735-b7eafcc40d59" providerId="AD" clId="Web-{9C98EEBF-82E5-5459-3AC7-E35BDB77DACC}" dt="2021-09-12T23:05:18.068" v="16"/>
        <pc:sldMkLst>
          <pc:docMk/>
          <pc:sldMk cId="3392522831" sldId="4112"/>
        </pc:sldMkLst>
      </pc:sldChg>
      <pc:sldChg chg="new del">
        <pc:chgData name="Alexis Hutcheon" userId="S::alexis.hutcheon@sydney.edu.au::ddef8b19-8dcf-422d-9735-b7eafcc40d59" providerId="AD" clId="Web-{9C98EEBF-82E5-5459-3AC7-E35BDB77DACC}" dt="2021-09-12T23:05:14.271" v="15"/>
        <pc:sldMkLst>
          <pc:docMk/>
          <pc:sldMk cId="918555685" sldId="4113"/>
        </pc:sldMkLst>
      </pc:sldChg>
      <pc:sldChg chg="addSp delSp modSp new">
        <pc:chgData name="Alexis Hutcheon" userId="S::alexis.hutcheon@sydney.edu.au::ddef8b19-8dcf-422d-9735-b7eafcc40d59" providerId="AD" clId="Web-{9C98EEBF-82E5-5459-3AC7-E35BDB77DACC}" dt="2021-09-12T23:22:43.589" v="97" actId="14100"/>
        <pc:sldMkLst>
          <pc:docMk/>
          <pc:sldMk cId="4218932571" sldId="4113"/>
        </pc:sldMkLst>
        <pc:spChg chg="del">
          <ac:chgData name="Alexis Hutcheon" userId="S::alexis.hutcheon@sydney.edu.au::ddef8b19-8dcf-422d-9735-b7eafcc40d59" providerId="AD" clId="Web-{9C98EEBF-82E5-5459-3AC7-E35BDB77DACC}" dt="2021-09-12T23:16:42.535" v="59"/>
          <ac:spMkLst>
            <pc:docMk/>
            <pc:sldMk cId="4218932571" sldId="4113"/>
            <ac:spMk id="2" creationId="{C5AE32FC-C927-4653-90E7-97899DDE0FD4}"/>
          </ac:spMkLst>
        </pc:spChg>
        <pc:spChg chg="del">
          <ac:chgData name="Alexis Hutcheon" userId="S::alexis.hutcheon@sydney.edu.au::ddef8b19-8dcf-422d-9735-b7eafcc40d59" providerId="AD" clId="Web-{9C98EEBF-82E5-5459-3AC7-E35BDB77DACC}" dt="2021-09-12T23:16:44.863" v="60"/>
          <ac:spMkLst>
            <pc:docMk/>
            <pc:sldMk cId="4218932571" sldId="4113"/>
            <ac:spMk id="3" creationId="{F88530CF-B2BA-4EB0-8125-4BDAD48C4AD6}"/>
          </ac:spMkLst>
        </pc:spChg>
        <pc:picChg chg="add mod">
          <ac:chgData name="Alexis Hutcheon" userId="S::alexis.hutcheon@sydney.edu.au::ddef8b19-8dcf-422d-9735-b7eafcc40d59" providerId="AD" clId="Web-{9C98EEBF-82E5-5459-3AC7-E35BDB77DACC}" dt="2021-09-12T23:22:43.589" v="97" actId="14100"/>
          <ac:picMkLst>
            <pc:docMk/>
            <pc:sldMk cId="4218932571" sldId="4113"/>
            <ac:picMk id="4" creationId="{B61FD3D6-4B77-4C19-AAB4-3E5E442AC5B9}"/>
          </ac:picMkLst>
        </pc:picChg>
      </pc:sldChg>
      <pc:sldChg chg="new del">
        <pc:chgData name="Alexis Hutcheon" userId="S::alexis.hutcheon@sydney.edu.au::ddef8b19-8dcf-422d-9735-b7eafcc40d59" providerId="AD" clId="Web-{9C98EEBF-82E5-5459-3AC7-E35BDB77DACC}" dt="2021-09-12T23:05:25.849" v="18"/>
        <pc:sldMkLst>
          <pc:docMk/>
          <pc:sldMk cId="120272897" sldId="4114"/>
        </pc:sldMkLst>
      </pc:sldChg>
      <pc:sldChg chg="addSp delSp modSp new mod modClrScheme chgLayout">
        <pc:chgData name="Alexis Hutcheon" userId="S::alexis.hutcheon@sydney.edu.au::ddef8b19-8dcf-422d-9735-b7eafcc40d59" providerId="AD" clId="Web-{9C98EEBF-82E5-5459-3AC7-E35BDB77DACC}" dt="2021-09-12T23:22:31.136" v="95" actId="14100"/>
        <pc:sldMkLst>
          <pc:docMk/>
          <pc:sldMk cId="1633719534" sldId="4114"/>
        </pc:sldMkLst>
        <pc:spChg chg="del">
          <ac:chgData name="Alexis Hutcheon" userId="S::alexis.hutcheon@sydney.edu.au::ddef8b19-8dcf-422d-9735-b7eafcc40d59" providerId="AD" clId="Web-{9C98EEBF-82E5-5459-3AC7-E35BDB77DACC}" dt="2021-09-12T23:18:17.053" v="67"/>
          <ac:spMkLst>
            <pc:docMk/>
            <pc:sldMk cId="1633719534" sldId="4114"/>
            <ac:spMk id="2" creationId="{975C5794-0820-421C-A0F5-A116DCFEF0A8}"/>
          </ac:spMkLst>
        </pc:spChg>
        <pc:spChg chg="add del">
          <ac:chgData name="Alexis Hutcheon" userId="S::alexis.hutcheon@sydney.edu.au::ddef8b19-8dcf-422d-9735-b7eafcc40d59" providerId="AD" clId="Web-{9C98EEBF-82E5-5459-3AC7-E35BDB77DACC}" dt="2021-09-12T23:18:30.459" v="74"/>
          <ac:spMkLst>
            <pc:docMk/>
            <pc:sldMk cId="1633719534" sldId="4114"/>
            <ac:spMk id="3" creationId="{B98ADB01-E93C-4527-8BA3-8EA87646E329}"/>
          </ac:spMkLst>
        </pc:spChg>
        <pc:spChg chg="add del mod">
          <ac:chgData name="Alexis Hutcheon" userId="S::alexis.hutcheon@sydney.edu.au::ddef8b19-8dcf-422d-9735-b7eafcc40d59" providerId="AD" clId="Web-{9C98EEBF-82E5-5459-3AC7-E35BDB77DACC}" dt="2021-09-12T23:18:30.459" v="73"/>
          <ac:spMkLst>
            <pc:docMk/>
            <pc:sldMk cId="1633719534" sldId="4114"/>
            <ac:spMk id="9" creationId="{9141A383-7891-4E79-8F76-D7712617ADF6}"/>
          </ac:spMkLst>
        </pc:spChg>
        <pc:picChg chg="add mod ord">
          <ac:chgData name="Alexis Hutcheon" userId="S::alexis.hutcheon@sydney.edu.au::ddef8b19-8dcf-422d-9735-b7eafcc40d59" providerId="AD" clId="Web-{9C98EEBF-82E5-5459-3AC7-E35BDB77DACC}" dt="2021-09-12T23:22:31.136" v="95" actId="14100"/>
          <ac:picMkLst>
            <pc:docMk/>
            <pc:sldMk cId="1633719534" sldId="4114"/>
            <ac:picMk id="4" creationId="{2041D8D9-05E1-484F-9360-B3053AD0B943}"/>
          </ac:picMkLst>
        </pc:picChg>
      </pc:sldChg>
      <pc:sldChg chg="add del ord">
        <pc:chgData name="Alexis Hutcheon" userId="S::alexis.hutcheon@sydney.edu.au::ddef8b19-8dcf-422d-9735-b7eafcc40d59" providerId="AD" clId="Web-{9C98EEBF-82E5-5459-3AC7-E35BDB77DACC}" dt="2021-09-12T23:05:50.553" v="27"/>
        <pc:sldMkLst>
          <pc:docMk/>
          <pc:sldMk cId="242625184" sldId="4115"/>
        </pc:sldMkLst>
      </pc:sldChg>
      <pc:sldChg chg="addSp delSp modSp new">
        <pc:chgData name="Alexis Hutcheon" userId="S::alexis.hutcheon@sydney.edu.au::ddef8b19-8dcf-422d-9735-b7eafcc40d59" providerId="AD" clId="Web-{9C98EEBF-82E5-5459-3AC7-E35BDB77DACC}" dt="2021-09-12T23:22:14.214" v="92" actId="14100"/>
        <pc:sldMkLst>
          <pc:docMk/>
          <pc:sldMk cId="2849211460" sldId="4115"/>
        </pc:sldMkLst>
        <pc:spChg chg="del">
          <ac:chgData name="Alexis Hutcheon" userId="S::alexis.hutcheon@sydney.edu.au::ddef8b19-8dcf-422d-9735-b7eafcc40d59" providerId="AD" clId="Web-{9C98EEBF-82E5-5459-3AC7-E35BDB77DACC}" dt="2021-09-12T23:18:44.944" v="75"/>
          <ac:spMkLst>
            <pc:docMk/>
            <pc:sldMk cId="2849211460" sldId="4115"/>
            <ac:spMk id="2" creationId="{FAED6F22-9B7E-4852-B195-8A1AB64D9373}"/>
          </ac:spMkLst>
        </pc:spChg>
        <pc:spChg chg="del">
          <ac:chgData name="Alexis Hutcheon" userId="S::alexis.hutcheon@sydney.edu.au::ddef8b19-8dcf-422d-9735-b7eafcc40d59" providerId="AD" clId="Web-{9C98EEBF-82E5-5459-3AC7-E35BDB77DACC}" dt="2021-09-12T23:18:46.897" v="76"/>
          <ac:spMkLst>
            <pc:docMk/>
            <pc:sldMk cId="2849211460" sldId="4115"/>
            <ac:spMk id="3" creationId="{AC5955E6-046F-4A36-9B72-461B02775110}"/>
          </ac:spMkLst>
        </pc:spChg>
        <pc:spChg chg="add del mod">
          <ac:chgData name="Alexis Hutcheon" userId="S::alexis.hutcheon@sydney.edu.au::ddef8b19-8dcf-422d-9735-b7eafcc40d59" providerId="AD" clId="Web-{9C98EEBF-82E5-5459-3AC7-E35BDB77DACC}" dt="2021-09-12T23:20:13.274" v="79"/>
          <ac:spMkLst>
            <pc:docMk/>
            <pc:sldMk cId="2849211460" sldId="4115"/>
            <ac:spMk id="7" creationId="{CB1594E1-4DA8-4E5E-83FE-0EB7955F3717}"/>
          </ac:spMkLst>
        </pc:spChg>
        <pc:picChg chg="add del mod ord">
          <ac:chgData name="Alexis Hutcheon" userId="S::alexis.hutcheon@sydney.edu.au::ddef8b19-8dcf-422d-9735-b7eafcc40d59" providerId="AD" clId="Web-{9C98EEBF-82E5-5459-3AC7-E35BDB77DACC}" dt="2021-09-12T23:20:09.446" v="78"/>
          <ac:picMkLst>
            <pc:docMk/>
            <pc:sldMk cId="2849211460" sldId="4115"/>
            <ac:picMk id="4" creationId="{1618DC58-FBEB-41EB-9130-135F97EC5EB8}"/>
          </ac:picMkLst>
        </pc:picChg>
        <pc:picChg chg="add mod">
          <ac:chgData name="Alexis Hutcheon" userId="S::alexis.hutcheon@sydney.edu.au::ddef8b19-8dcf-422d-9735-b7eafcc40d59" providerId="AD" clId="Web-{9C98EEBF-82E5-5459-3AC7-E35BDB77DACC}" dt="2021-09-12T23:22:14.214" v="92" actId="14100"/>
          <ac:picMkLst>
            <pc:docMk/>
            <pc:sldMk cId="2849211460" sldId="4115"/>
            <ac:picMk id="5" creationId="{C02157F4-2AB6-468D-A055-8390A416C4E1}"/>
          </ac:picMkLst>
        </pc:picChg>
      </pc:sldChg>
      <pc:sldChg chg="add del ord">
        <pc:chgData name="Alexis Hutcheon" userId="S::alexis.hutcheon@sydney.edu.au::ddef8b19-8dcf-422d-9735-b7eafcc40d59" providerId="AD" clId="Web-{9C98EEBF-82E5-5459-3AC7-E35BDB77DACC}" dt="2021-09-12T23:05:50.553" v="26"/>
        <pc:sldMkLst>
          <pc:docMk/>
          <pc:sldMk cId="841694432" sldId="4116"/>
        </pc:sldMkLst>
      </pc:sldChg>
      <pc:sldChg chg="addSp delSp modSp new">
        <pc:chgData name="Alexis Hutcheon" userId="S::alexis.hutcheon@sydney.edu.au::ddef8b19-8dcf-422d-9735-b7eafcc40d59" providerId="AD" clId="Web-{9C98EEBF-82E5-5459-3AC7-E35BDB77DACC}" dt="2021-09-12T23:22:03.448" v="89" actId="14100"/>
        <pc:sldMkLst>
          <pc:docMk/>
          <pc:sldMk cId="3647176453" sldId="4116"/>
        </pc:sldMkLst>
        <pc:spChg chg="del">
          <ac:chgData name="Alexis Hutcheon" userId="S::alexis.hutcheon@sydney.edu.au::ddef8b19-8dcf-422d-9735-b7eafcc40d59" providerId="AD" clId="Web-{9C98EEBF-82E5-5459-3AC7-E35BDB77DACC}" dt="2021-09-12T23:20:33.024" v="80"/>
          <ac:spMkLst>
            <pc:docMk/>
            <pc:sldMk cId="3647176453" sldId="4116"/>
            <ac:spMk id="2" creationId="{00B6E861-B9A2-40A0-89B2-FA243E6D29D1}"/>
          </ac:spMkLst>
        </pc:spChg>
        <pc:spChg chg="del">
          <ac:chgData name="Alexis Hutcheon" userId="S::alexis.hutcheon@sydney.edu.au::ddef8b19-8dcf-422d-9735-b7eafcc40d59" providerId="AD" clId="Web-{9C98EEBF-82E5-5459-3AC7-E35BDB77DACC}" dt="2021-09-12T23:20:35.150" v="81"/>
          <ac:spMkLst>
            <pc:docMk/>
            <pc:sldMk cId="3647176453" sldId="4116"/>
            <ac:spMk id="3" creationId="{F58E8D60-96A5-4A7B-8598-15CC8F65F2D5}"/>
          </ac:spMkLst>
        </pc:spChg>
        <pc:picChg chg="add mod ord">
          <ac:chgData name="Alexis Hutcheon" userId="S::alexis.hutcheon@sydney.edu.au::ddef8b19-8dcf-422d-9735-b7eafcc40d59" providerId="AD" clId="Web-{9C98EEBF-82E5-5459-3AC7-E35BDB77DACC}" dt="2021-09-12T23:22:03.448" v="89" actId="14100"/>
          <ac:picMkLst>
            <pc:docMk/>
            <pc:sldMk cId="3647176453" sldId="4116"/>
            <ac:picMk id="4" creationId="{948BFF4E-0BC8-4245-9EAE-98410ED92292}"/>
          </ac:picMkLst>
        </pc:picChg>
      </pc:sldChg>
      <pc:sldChg chg="add del">
        <pc:chgData name="Alexis Hutcheon" userId="S::alexis.hutcheon@sydney.edu.au::ddef8b19-8dcf-422d-9735-b7eafcc40d59" providerId="AD" clId="Web-{9C98EEBF-82E5-5459-3AC7-E35BDB77DACC}" dt="2021-09-12T23:05:50.553" v="25"/>
        <pc:sldMkLst>
          <pc:docMk/>
          <pc:sldMk cId="3021087162" sldId="4117"/>
        </pc:sldMkLst>
      </pc:sldChg>
      <pc:sldChg chg="addSp delSp modSp new">
        <pc:chgData name="Alexis Hutcheon" userId="S::alexis.hutcheon@sydney.edu.au::ddef8b19-8dcf-422d-9735-b7eafcc40d59" providerId="AD" clId="Web-{9C98EEBF-82E5-5459-3AC7-E35BDB77DACC}" dt="2021-09-12T23:21:50.948" v="86" actId="14100"/>
        <pc:sldMkLst>
          <pc:docMk/>
          <pc:sldMk cId="3029657438" sldId="4117"/>
        </pc:sldMkLst>
        <pc:spChg chg="del">
          <ac:chgData name="Alexis Hutcheon" userId="S::alexis.hutcheon@sydney.edu.au::ddef8b19-8dcf-422d-9735-b7eafcc40d59" providerId="AD" clId="Web-{9C98EEBF-82E5-5459-3AC7-E35BDB77DACC}" dt="2021-09-12T23:21:06.634" v="82"/>
          <ac:spMkLst>
            <pc:docMk/>
            <pc:sldMk cId="3029657438" sldId="4117"/>
            <ac:spMk id="2" creationId="{CD1EE010-1A6B-4329-9C57-7836776E2883}"/>
          </ac:spMkLst>
        </pc:spChg>
        <pc:spChg chg="del">
          <ac:chgData name="Alexis Hutcheon" userId="S::alexis.hutcheon@sydney.edu.au::ddef8b19-8dcf-422d-9735-b7eafcc40d59" providerId="AD" clId="Web-{9C98EEBF-82E5-5459-3AC7-E35BDB77DACC}" dt="2021-09-12T23:21:09.604" v="83"/>
          <ac:spMkLst>
            <pc:docMk/>
            <pc:sldMk cId="3029657438" sldId="4117"/>
            <ac:spMk id="3" creationId="{10496489-7600-4FA6-81B9-7AECDD19AA52}"/>
          </ac:spMkLst>
        </pc:spChg>
        <pc:picChg chg="add mod ord">
          <ac:chgData name="Alexis Hutcheon" userId="S::alexis.hutcheon@sydney.edu.au::ddef8b19-8dcf-422d-9735-b7eafcc40d59" providerId="AD" clId="Web-{9C98EEBF-82E5-5459-3AC7-E35BDB77DACC}" dt="2021-09-12T23:21:50.948" v="86" actId="14100"/>
          <ac:picMkLst>
            <pc:docMk/>
            <pc:sldMk cId="3029657438" sldId="4117"/>
            <ac:picMk id="4" creationId="{13BA5F24-3C74-407A-86CB-6EB3E13D0ED6}"/>
          </ac:picMkLst>
        </pc:picChg>
      </pc:sldChg>
      <pc:sldChg chg="add del">
        <pc:chgData name="Alexis Hutcheon" userId="S::alexis.hutcheon@sydney.edu.au::ddef8b19-8dcf-422d-9735-b7eafcc40d59" providerId="AD" clId="Web-{9C98EEBF-82E5-5459-3AC7-E35BDB77DACC}" dt="2021-09-12T23:05:50.553" v="24"/>
        <pc:sldMkLst>
          <pc:docMk/>
          <pc:sldMk cId="2638812782" sldId="4118"/>
        </pc:sldMkLst>
      </pc:sldChg>
      <pc:sldChg chg="add del">
        <pc:chgData name="Alexis Hutcheon" userId="S::alexis.hutcheon@sydney.edu.au::ddef8b19-8dcf-422d-9735-b7eafcc40d59" providerId="AD" clId="Web-{9C98EEBF-82E5-5459-3AC7-E35BDB77DACC}" dt="2021-09-12T23:05:50.553" v="23"/>
        <pc:sldMkLst>
          <pc:docMk/>
          <pc:sldMk cId="4021926122" sldId="4119"/>
        </pc:sldMkLst>
      </pc:sldChg>
      <pc:sldChg chg="add del">
        <pc:chgData name="Alexis Hutcheon" userId="S::alexis.hutcheon@sydney.edu.au::ddef8b19-8dcf-422d-9735-b7eafcc40d59" providerId="AD" clId="Web-{9C98EEBF-82E5-5459-3AC7-E35BDB77DACC}" dt="2021-09-12T23:05:50.553" v="22"/>
        <pc:sldMkLst>
          <pc:docMk/>
          <pc:sldMk cId="1738751876" sldId="4120"/>
        </pc:sldMkLst>
      </pc:sldChg>
      <pc:sldChg chg="add del">
        <pc:chgData name="Alexis Hutcheon" userId="S::alexis.hutcheon@sydney.edu.au::ddef8b19-8dcf-422d-9735-b7eafcc40d59" providerId="AD" clId="Web-{9C98EEBF-82E5-5459-3AC7-E35BDB77DACC}" dt="2021-09-12T23:05:50.537" v="21"/>
        <pc:sldMkLst>
          <pc:docMk/>
          <pc:sldMk cId="57054266" sldId="4121"/>
        </pc:sldMkLst>
      </pc:sldChg>
      <pc:sldMasterChg chg="add addSldLayout">
        <pc:chgData name="Alexis Hutcheon" userId="S::alexis.hutcheon@sydney.edu.au::ddef8b19-8dcf-422d-9735-b7eafcc40d59" providerId="AD" clId="Web-{9C98EEBF-82E5-5459-3AC7-E35BDB77DACC}" dt="2021-09-12T23:04:39.067" v="8"/>
        <pc:sldMasterMkLst>
          <pc:docMk/>
          <pc:sldMasterMk cId="2199481654" sldId="2147483648"/>
        </pc:sldMasterMkLst>
        <pc:sldLayoutChg chg="add">
          <pc:chgData name="Alexis Hutcheon" userId="S::alexis.hutcheon@sydney.edu.au::ddef8b19-8dcf-422d-9735-b7eafcc40d59" providerId="AD" clId="Web-{9C98EEBF-82E5-5459-3AC7-E35BDB77DACC}" dt="2021-09-12T23:04:30.286" v="6"/>
          <pc:sldLayoutMkLst>
            <pc:docMk/>
            <pc:sldMasterMk cId="2199481654" sldId="2147483648"/>
            <pc:sldLayoutMk cId="2071318141" sldId="2147483649"/>
          </pc:sldLayoutMkLst>
        </pc:sldLayoutChg>
        <pc:sldLayoutChg chg="add">
          <pc:chgData name="Alexis Hutcheon" userId="S::alexis.hutcheon@sydney.edu.au::ddef8b19-8dcf-422d-9735-b7eafcc40d59" providerId="AD" clId="Web-{9C98EEBF-82E5-5459-3AC7-E35BDB77DACC}" dt="2021-09-12T23:04:39.067" v="8"/>
          <pc:sldLayoutMkLst>
            <pc:docMk/>
            <pc:sldMasterMk cId="2199481654" sldId="2147483648"/>
            <pc:sldLayoutMk cId="593882888" sldId="2147483650"/>
          </pc:sldLayoutMkLst>
        </pc:sldLayoutChg>
      </pc:sldMaster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88D92FF-1751-F44F-A3AB-C34DEDA5B360}" type="doc">
      <dgm:prSet loTypeId="urn:microsoft.com/office/officeart/2005/8/layout/hList1" loCatId="" qsTypeId="urn:microsoft.com/office/officeart/2005/8/quickstyle/simple1" qsCatId="simple" csTypeId="urn:microsoft.com/office/officeart/2005/8/colors/accent1_2" csCatId="accent1" phldr="1"/>
      <dgm:spPr/>
      <dgm:t>
        <a:bodyPr/>
        <a:lstStyle/>
        <a:p>
          <a:endParaRPr lang="en-GB"/>
        </a:p>
      </dgm:t>
    </dgm:pt>
    <dgm:pt modelId="{299FC5EB-642A-AE4E-88AF-70D5BF3E94D1}">
      <dgm:prSet phldrT="[Text]"/>
      <dgm:spPr/>
      <dgm:t>
        <a:bodyPr/>
        <a:lstStyle/>
        <a:p>
          <a:r>
            <a:rPr lang="en-GB" dirty="0"/>
            <a:t>OPTION 1</a:t>
          </a:r>
        </a:p>
      </dgm:t>
    </dgm:pt>
    <dgm:pt modelId="{18A0478E-3DC6-4949-A237-41F23191D447}" type="parTrans" cxnId="{81C948E7-BABF-7A44-91DC-6D806C77730D}">
      <dgm:prSet/>
      <dgm:spPr/>
      <dgm:t>
        <a:bodyPr/>
        <a:lstStyle/>
        <a:p>
          <a:endParaRPr lang="en-GB"/>
        </a:p>
      </dgm:t>
    </dgm:pt>
    <dgm:pt modelId="{823925B9-3B3D-B545-B4D1-48D401BEEDDF}" type="sibTrans" cxnId="{81C948E7-BABF-7A44-91DC-6D806C77730D}">
      <dgm:prSet/>
      <dgm:spPr/>
      <dgm:t>
        <a:bodyPr/>
        <a:lstStyle/>
        <a:p>
          <a:endParaRPr lang="en-GB"/>
        </a:p>
      </dgm:t>
    </dgm:pt>
    <dgm:pt modelId="{5A78ACD8-F69B-2B43-B238-99E6A9C8E02F}">
      <dgm:prSet phldrT="[Text]"/>
      <dgm:spPr/>
      <dgm:t>
        <a:bodyPr/>
        <a:lstStyle/>
        <a:p>
          <a:r>
            <a:rPr lang="en-GB" dirty="0"/>
            <a:t>Researcher comes to the Working Group to give an update</a:t>
          </a:r>
        </a:p>
      </dgm:t>
    </dgm:pt>
    <dgm:pt modelId="{08639D48-FC3F-6345-B9DF-0FC3EF25B534}" type="parTrans" cxnId="{4DD30DB1-6D0B-C240-9B72-E6C67637DC68}">
      <dgm:prSet/>
      <dgm:spPr/>
      <dgm:t>
        <a:bodyPr/>
        <a:lstStyle/>
        <a:p>
          <a:endParaRPr lang="en-GB"/>
        </a:p>
      </dgm:t>
    </dgm:pt>
    <dgm:pt modelId="{ED9891E1-2C66-FC4B-A6BE-4B8EBCAC8AF1}" type="sibTrans" cxnId="{4DD30DB1-6D0B-C240-9B72-E6C67637DC68}">
      <dgm:prSet/>
      <dgm:spPr/>
      <dgm:t>
        <a:bodyPr/>
        <a:lstStyle/>
        <a:p>
          <a:endParaRPr lang="en-GB"/>
        </a:p>
      </dgm:t>
    </dgm:pt>
    <dgm:pt modelId="{E0C0DC62-1D2C-0E40-8DC3-5046B4BC6F5C}">
      <dgm:prSet phldrT="[Text]"/>
      <dgm:spPr/>
      <dgm:t>
        <a:bodyPr/>
        <a:lstStyle/>
        <a:p>
          <a:r>
            <a:rPr lang="en-GB" dirty="0"/>
            <a:t>OPTION 2</a:t>
          </a:r>
        </a:p>
      </dgm:t>
    </dgm:pt>
    <dgm:pt modelId="{D365A309-AFD8-BC4F-B4FB-45EBC1F4B860}" type="parTrans" cxnId="{5ACED3A3-4047-A742-8805-44B3D392D9CD}">
      <dgm:prSet/>
      <dgm:spPr/>
      <dgm:t>
        <a:bodyPr/>
        <a:lstStyle/>
        <a:p>
          <a:endParaRPr lang="en-GB"/>
        </a:p>
      </dgm:t>
    </dgm:pt>
    <dgm:pt modelId="{310736DA-7F5D-B048-B4F3-C2F9525A498A}" type="sibTrans" cxnId="{5ACED3A3-4047-A742-8805-44B3D392D9CD}">
      <dgm:prSet/>
      <dgm:spPr/>
      <dgm:t>
        <a:bodyPr/>
        <a:lstStyle/>
        <a:p>
          <a:endParaRPr lang="en-GB"/>
        </a:p>
      </dgm:t>
    </dgm:pt>
    <dgm:pt modelId="{C82E33A3-2B16-C644-91C2-76810ECC0742}">
      <dgm:prSet phldrT="[Text]"/>
      <dgm:spPr/>
      <dgm:t>
        <a:bodyPr/>
        <a:lstStyle/>
        <a:p>
          <a:r>
            <a:rPr lang="en-GB" dirty="0"/>
            <a:t>Researcher to provide update online (e.g., via newsletter, Slack, etc)</a:t>
          </a:r>
        </a:p>
      </dgm:t>
    </dgm:pt>
    <dgm:pt modelId="{F313D289-8531-D849-AC0D-EFB002D473F5}" type="parTrans" cxnId="{D6066A99-EAC5-3342-B5C1-5ACB81E7BFBB}">
      <dgm:prSet/>
      <dgm:spPr/>
      <dgm:t>
        <a:bodyPr/>
        <a:lstStyle/>
        <a:p>
          <a:endParaRPr lang="en-GB"/>
        </a:p>
      </dgm:t>
    </dgm:pt>
    <dgm:pt modelId="{59E16632-6E80-1142-828F-D1D3C530F6E4}" type="sibTrans" cxnId="{D6066A99-EAC5-3342-B5C1-5ACB81E7BFBB}">
      <dgm:prSet/>
      <dgm:spPr/>
      <dgm:t>
        <a:bodyPr/>
        <a:lstStyle/>
        <a:p>
          <a:endParaRPr lang="en-GB"/>
        </a:p>
      </dgm:t>
    </dgm:pt>
    <dgm:pt modelId="{526570D6-89E6-5547-A51B-1A06055BFE07}">
      <dgm:prSet phldrT="[Text]"/>
      <dgm:spPr/>
      <dgm:t>
        <a:bodyPr/>
        <a:lstStyle/>
        <a:p>
          <a:r>
            <a:rPr lang="en-GB" dirty="0"/>
            <a:t>OPTION 3</a:t>
          </a:r>
        </a:p>
      </dgm:t>
    </dgm:pt>
    <dgm:pt modelId="{D6240542-495A-F041-AFAE-1998B6C06C9A}" type="parTrans" cxnId="{3D12715E-4618-2443-855C-B6E585BE129B}">
      <dgm:prSet/>
      <dgm:spPr/>
      <dgm:t>
        <a:bodyPr/>
        <a:lstStyle/>
        <a:p>
          <a:endParaRPr lang="en-GB"/>
        </a:p>
      </dgm:t>
    </dgm:pt>
    <dgm:pt modelId="{0D2614F5-661B-E14F-AAB5-EF279CC6BE23}" type="sibTrans" cxnId="{3D12715E-4618-2443-855C-B6E585BE129B}">
      <dgm:prSet/>
      <dgm:spPr/>
      <dgm:t>
        <a:bodyPr/>
        <a:lstStyle/>
        <a:p>
          <a:endParaRPr lang="en-GB"/>
        </a:p>
      </dgm:t>
    </dgm:pt>
    <dgm:pt modelId="{93F21042-88DF-3E49-8C0F-A6954E6B3C6D}">
      <dgm:prSet phldrT="[Text]"/>
      <dgm:spPr/>
      <dgm:t>
        <a:bodyPr/>
        <a:lstStyle/>
        <a:p>
          <a:r>
            <a:rPr lang="en-GB" dirty="0"/>
            <a:t>One of the group’s planning researchers (e.g. Alexis) to provide the Working Group with update</a:t>
          </a:r>
        </a:p>
      </dgm:t>
    </dgm:pt>
    <dgm:pt modelId="{A178E430-4660-A04E-8D48-1920B3AE1769}" type="parTrans" cxnId="{BA622EDC-7295-E642-AA9A-B99045E52204}">
      <dgm:prSet/>
      <dgm:spPr/>
      <dgm:t>
        <a:bodyPr/>
        <a:lstStyle/>
        <a:p>
          <a:endParaRPr lang="en-GB"/>
        </a:p>
      </dgm:t>
    </dgm:pt>
    <dgm:pt modelId="{C9964A12-4B80-B746-9CC8-B393570AA1BD}" type="sibTrans" cxnId="{BA622EDC-7295-E642-AA9A-B99045E52204}">
      <dgm:prSet/>
      <dgm:spPr/>
      <dgm:t>
        <a:bodyPr/>
        <a:lstStyle/>
        <a:p>
          <a:endParaRPr lang="en-GB"/>
        </a:p>
      </dgm:t>
    </dgm:pt>
    <dgm:pt modelId="{5C005721-96AA-CC4B-A415-2E3D7F766D04}" type="pres">
      <dgm:prSet presAssocID="{688D92FF-1751-F44F-A3AB-C34DEDA5B360}" presName="Name0" presStyleCnt="0">
        <dgm:presLayoutVars>
          <dgm:dir/>
          <dgm:animLvl val="lvl"/>
          <dgm:resizeHandles val="exact"/>
        </dgm:presLayoutVars>
      </dgm:prSet>
      <dgm:spPr/>
    </dgm:pt>
    <dgm:pt modelId="{028C213D-270F-5543-BDBA-395E0CADED2D}" type="pres">
      <dgm:prSet presAssocID="{299FC5EB-642A-AE4E-88AF-70D5BF3E94D1}" presName="composite" presStyleCnt="0"/>
      <dgm:spPr/>
    </dgm:pt>
    <dgm:pt modelId="{BB767443-EE09-0245-AB32-E1036D4877BF}" type="pres">
      <dgm:prSet presAssocID="{299FC5EB-642A-AE4E-88AF-70D5BF3E94D1}" presName="parTx" presStyleLbl="alignNode1" presStyleIdx="0" presStyleCnt="3">
        <dgm:presLayoutVars>
          <dgm:chMax val="0"/>
          <dgm:chPref val="0"/>
          <dgm:bulletEnabled val="1"/>
        </dgm:presLayoutVars>
      </dgm:prSet>
      <dgm:spPr/>
    </dgm:pt>
    <dgm:pt modelId="{566CE7BE-7E41-1A48-ACD4-8FAAD1139135}" type="pres">
      <dgm:prSet presAssocID="{299FC5EB-642A-AE4E-88AF-70D5BF3E94D1}" presName="desTx" presStyleLbl="alignAccFollowNode1" presStyleIdx="0" presStyleCnt="3">
        <dgm:presLayoutVars>
          <dgm:bulletEnabled val="1"/>
        </dgm:presLayoutVars>
      </dgm:prSet>
      <dgm:spPr/>
    </dgm:pt>
    <dgm:pt modelId="{2EEEBA17-BDDE-614E-8458-330146549735}" type="pres">
      <dgm:prSet presAssocID="{823925B9-3B3D-B545-B4D1-48D401BEEDDF}" presName="space" presStyleCnt="0"/>
      <dgm:spPr/>
    </dgm:pt>
    <dgm:pt modelId="{DA7C3D19-2537-B54C-840A-3CC9BB8867DE}" type="pres">
      <dgm:prSet presAssocID="{E0C0DC62-1D2C-0E40-8DC3-5046B4BC6F5C}" presName="composite" presStyleCnt="0"/>
      <dgm:spPr/>
    </dgm:pt>
    <dgm:pt modelId="{0D794AAA-89B3-4D45-866C-1A7A1E69519C}" type="pres">
      <dgm:prSet presAssocID="{E0C0DC62-1D2C-0E40-8DC3-5046B4BC6F5C}" presName="parTx" presStyleLbl="alignNode1" presStyleIdx="1" presStyleCnt="3">
        <dgm:presLayoutVars>
          <dgm:chMax val="0"/>
          <dgm:chPref val="0"/>
          <dgm:bulletEnabled val="1"/>
        </dgm:presLayoutVars>
      </dgm:prSet>
      <dgm:spPr/>
    </dgm:pt>
    <dgm:pt modelId="{5611FEB3-0595-0343-9FD0-0997986D7B5D}" type="pres">
      <dgm:prSet presAssocID="{E0C0DC62-1D2C-0E40-8DC3-5046B4BC6F5C}" presName="desTx" presStyleLbl="alignAccFollowNode1" presStyleIdx="1" presStyleCnt="3">
        <dgm:presLayoutVars>
          <dgm:bulletEnabled val="1"/>
        </dgm:presLayoutVars>
      </dgm:prSet>
      <dgm:spPr/>
    </dgm:pt>
    <dgm:pt modelId="{7914B44F-91C8-F84F-A525-9A393586AAAF}" type="pres">
      <dgm:prSet presAssocID="{310736DA-7F5D-B048-B4F3-C2F9525A498A}" presName="space" presStyleCnt="0"/>
      <dgm:spPr/>
    </dgm:pt>
    <dgm:pt modelId="{2117BD39-4317-7444-AB71-30CC8DAFB0D0}" type="pres">
      <dgm:prSet presAssocID="{526570D6-89E6-5547-A51B-1A06055BFE07}" presName="composite" presStyleCnt="0"/>
      <dgm:spPr/>
    </dgm:pt>
    <dgm:pt modelId="{8648A455-07B2-A04C-BEFE-5FAAE9A28F2A}" type="pres">
      <dgm:prSet presAssocID="{526570D6-89E6-5547-A51B-1A06055BFE07}" presName="parTx" presStyleLbl="alignNode1" presStyleIdx="2" presStyleCnt="3">
        <dgm:presLayoutVars>
          <dgm:chMax val="0"/>
          <dgm:chPref val="0"/>
          <dgm:bulletEnabled val="1"/>
        </dgm:presLayoutVars>
      </dgm:prSet>
      <dgm:spPr/>
    </dgm:pt>
    <dgm:pt modelId="{93760BC7-0363-EC4B-B6B1-6C7481819878}" type="pres">
      <dgm:prSet presAssocID="{526570D6-89E6-5547-A51B-1A06055BFE07}" presName="desTx" presStyleLbl="alignAccFollowNode1" presStyleIdx="2" presStyleCnt="3">
        <dgm:presLayoutVars>
          <dgm:bulletEnabled val="1"/>
        </dgm:presLayoutVars>
      </dgm:prSet>
      <dgm:spPr/>
    </dgm:pt>
  </dgm:ptLst>
  <dgm:cxnLst>
    <dgm:cxn modelId="{4790B102-CE99-6D48-87E6-281FF62D0915}" type="presOf" srcId="{299FC5EB-642A-AE4E-88AF-70D5BF3E94D1}" destId="{BB767443-EE09-0245-AB32-E1036D4877BF}" srcOrd="0" destOrd="0" presId="urn:microsoft.com/office/officeart/2005/8/layout/hList1"/>
    <dgm:cxn modelId="{4A603F30-C5F0-5D4A-8680-A2F62B9575F1}" type="presOf" srcId="{C82E33A3-2B16-C644-91C2-76810ECC0742}" destId="{5611FEB3-0595-0343-9FD0-0997986D7B5D}" srcOrd="0" destOrd="0" presId="urn:microsoft.com/office/officeart/2005/8/layout/hList1"/>
    <dgm:cxn modelId="{A4A1EB36-8BC6-8244-8B70-DD55F306FCDA}" type="presOf" srcId="{93F21042-88DF-3E49-8C0F-A6954E6B3C6D}" destId="{93760BC7-0363-EC4B-B6B1-6C7481819878}" srcOrd="0" destOrd="0" presId="urn:microsoft.com/office/officeart/2005/8/layout/hList1"/>
    <dgm:cxn modelId="{3D12715E-4618-2443-855C-B6E585BE129B}" srcId="{688D92FF-1751-F44F-A3AB-C34DEDA5B360}" destId="{526570D6-89E6-5547-A51B-1A06055BFE07}" srcOrd="2" destOrd="0" parTransId="{D6240542-495A-F041-AFAE-1998B6C06C9A}" sibTransId="{0D2614F5-661B-E14F-AAB5-EF279CC6BE23}"/>
    <dgm:cxn modelId="{96C31C57-CA64-D940-82B9-61AE5EE0BADF}" type="presOf" srcId="{5A78ACD8-F69B-2B43-B238-99E6A9C8E02F}" destId="{566CE7BE-7E41-1A48-ACD4-8FAAD1139135}" srcOrd="0" destOrd="0" presId="urn:microsoft.com/office/officeart/2005/8/layout/hList1"/>
    <dgm:cxn modelId="{D6066A99-EAC5-3342-B5C1-5ACB81E7BFBB}" srcId="{E0C0DC62-1D2C-0E40-8DC3-5046B4BC6F5C}" destId="{C82E33A3-2B16-C644-91C2-76810ECC0742}" srcOrd="0" destOrd="0" parTransId="{F313D289-8531-D849-AC0D-EFB002D473F5}" sibTransId="{59E16632-6E80-1142-828F-D1D3C530F6E4}"/>
    <dgm:cxn modelId="{5ACED3A3-4047-A742-8805-44B3D392D9CD}" srcId="{688D92FF-1751-F44F-A3AB-C34DEDA5B360}" destId="{E0C0DC62-1D2C-0E40-8DC3-5046B4BC6F5C}" srcOrd="1" destOrd="0" parTransId="{D365A309-AFD8-BC4F-B4FB-45EBC1F4B860}" sibTransId="{310736DA-7F5D-B048-B4F3-C2F9525A498A}"/>
    <dgm:cxn modelId="{999580B0-B027-524C-99BD-DDDFFE15A34D}" type="presOf" srcId="{E0C0DC62-1D2C-0E40-8DC3-5046B4BC6F5C}" destId="{0D794AAA-89B3-4D45-866C-1A7A1E69519C}" srcOrd="0" destOrd="0" presId="urn:microsoft.com/office/officeart/2005/8/layout/hList1"/>
    <dgm:cxn modelId="{4DD30DB1-6D0B-C240-9B72-E6C67637DC68}" srcId="{299FC5EB-642A-AE4E-88AF-70D5BF3E94D1}" destId="{5A78ACD8-F69B-2B43-B238-99E6A9C8E02F}" srcOrd="0" destOrd="0" parTransId="{08639D48-FC3F-6345-B9DF-0FC3EF25B534}" sibTransId="{ED9891E1-2C66-FC4B-A6BE-4B8EBCAC8AF1}"/>
    <dgm:cxn modelId="{ABF701C7-6BE7-5F49-91DF-84A6686166DE}" type="presOf" srcId="{526570D6-89E6-5547-A51B-1A06055BFE07}" destId="{8648A455-07B2-A04C-BEFE-5FAAE9A28F2A}" srcOrd="0" destOrd="0" presId="urn:microsoft.com/office/officeart/2005/8/layout/hList1"/>
    <dgm:cxn modelId="{BA622EDC-7295-E642-AA9A-B99045E52204}" srcId="{526570D6-89E6-5547-A51B-1A06055BFE07}" destId="{93F21042-88DF-3E49-8C0F-A6954E6B3C6D}" srcOrd="0" destOrd="0" parTransId="{A178E430-4660-A04E-8D48-1920B3AE1769}" sibTransId="{C9964A12-4B80-B746-9CC8-B393570AA1BD}"/>
    <dgm:cxn modelId="{81C948E7-BABF-7A44-91DC-6D806C77730D}" srcId="{688D92FF-1751-F44F-A3AB-C34DEDA5B360}" destId="{299FC5EB-642A-AE4E-88AF-70D5BF3E94D1}" srcOrd="0" destOrd="0" parTransId="{18A0478E-3DC6-4949-A237-41F23191D447}" sibTransId="{823925B9-3B3D-B545-B4D1-48D401BEEDDF}"/>
    <dgm:cxn modelId="{C3AFD6ED-FCEF-F849-B034-B0DA8B6AC597}" type="presOf" srcId="{688D92FF-1751-F44F-A3AB-C34DEDA5B360}" destId="{5C005721-96AA-CC4B-A415-2E3D7F766D04}" srcOrd="0" destOrd="0" presId="urn:microsoft.com/office/officeart/2005/8/layout/hList1"/>
    <dgm:cxn modelId="{9001C6FC-841C-8A4E-BD3D-0ADF3B5481C3}" type="presParOf" srcId="{5C005721-96AA-CC4B-A415-2E3D7F766D04}" destId="{028C213D-270F-5543-BDBA-395E0CADED2D}" srcOrd="0" destOrd="0" presId="urn:microsoft.com/office/officeart/2005/8/layout/hList1"/>
    <dgm:cxn modelId="{4D0E1D94-5EC4-854E-BC15-1DBA14A402A5}" type="presParOf" srcId="{028C213D-270F-5543-BDBA-395E0CADED2D}" destId="{BB767443-EE09-0245-AB32-E1036D4877BF}" srcOrd="0" destOrd="0" presId="urn:microsoft.com/office/officeart/2005/8/layout/hList1"/>
    <dgm:cxn modelId="{A1E18315-1624-F04B-9D8B-33A1FD66D09C}" type="presParOf" srcId="{028C213D-270F-5543-BDBA-395E0CADED2D}" destId="{566CE7BE-7E41-1A48-ACD4-8FAAD1139135}" srcOrd="1" destOrd="0" presId="urn:microsoft.com/office/officeart/2005/8/layout/hList1"/>
    <dgm:cxn modelId="{27605CE9-CFE1-CB4D-B697-CD111D438623}" type="presParOf" srcId="{5C005721-96AA-CC4B-A415-2E3D7F766D04}" destId="{2EEEBA17-BDDE-614E-8458-330146549735}" srcOrd="1" destOrd="0" presId="urn:microsoft.com/office/officeart/2005/8/layout/hList1"/>
    <dgm:cxn modelId="{61C55FFA-620F-9844-AA1A-88F12CD53868}" type="presParOf" srcId="{5C005721-96AA-CC4B-A415-2E3D7F766D04}" destId="{DA7C3D19-2537-B54C-840A-3CC9BB8867DE}" srcOrd="2" destOrd="0" presId="urn:microsoft.com/office/officeart/2005/8/layout/hList1"/>
    <dgm:cxn modelId="{B0270153-A36B-644D-AC67-A090D2B42D56}" type="presParOf" srcId="{DA7C3D19-2537-B54C-840A-3CC9BB8867DE}" destId="{0D794AAA-89B3-4D45-866C-1A7A1E69519C}" srcOrd="0" destOrd="0" presId="urn:microsoft.com/office/officeart/2005/8/layout/hList1"/>
    <dgm:cxn modelId="{9879ACCB-8985-F546-9FEE-0D49BC9F8F4B}" type="presParOf" srcId="{DA7C3D19-2537-B54C-840A-3CC9BB8867DE}" destId="{5611FEB3-0595-0343-9FD0-0997986D7B5D}" srcOrd="1" destOrd="0" presId="urn:microsoft.com/office/officeart/2005/8/layout/hList1"/>
    <dgm:cxn modelId="{ACA270DE-3E7A-F94D-96E2-01673E3342E8}" type="presParOf" srcId="{5C005721-96AA-CC4B-A415-2E3D7F766D04}" destId="{7914B44F-91C8-F84F-A525-9A393586AAAF}" srcOrd="3" destOrd="0" presId="urn:microsoft.com/office/officeart/2005/8/layout/hList1"/>
    <dgm:cxn modelId="{2326D764-B356-804E-9B11-3AA21C01B03D}" type="presParOf" srcId="{5C005721-96AA-CC4B-A415-2E3D7F766D04}" destId="{2117BD39-4317-7444-AB71-30CC8DAFB0D0}" srcOrd="4" destOrd="0" presId="urn:microsoft.com/office/officeart/2005/8/layout/hList1"/>
    <dgm:cxn modelId="{C1368F5A-EBA1-EC4D-BB9C-CB1D765E7662}" type="presParOf" srcId="{2117BD39-4317-7444-AB71-30CC8DAFB0D0}" destId="{8648A455-07B2-A04C-BEFE-5FAAE9A28F2A}" srcOrd="0" destOrd="0" presId="urn:microsoft.com/office/officeart/2005/8/layout/hList1"/>
    <dgm:cxn modelId="{C3097B59-79FA-FA4F-9CF0-4BFF56A55F6B}" type="presParOf" srcId="{2117BD39-4317-7444-AB71-30CC8DAFB0D0}" destId="{93760BC7-0363-EC4B-B6B1-6C7481819878}" srcOrd="1" destOrd="0" presId="urn:microsoft.com/office/officeart/2005/8/layout/hList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A5D9A408-9F42-954E-9533-247B8D2AC1A5}" type="doc">
      <dgm:prSet loTypeId="urn:microsoft.com/office/officeart/2005/8/layout/cycle5" loCatId="" qsTypeId="urn:microsoft.com/office/officeart/2005/8/quickstyle/simple1" qsCatId="simple" csTypeId="urn:microsoft.com/office/officeart/2005/8/colors/accent1_2" csCatId="accent1" phldr="1"/>
      <dgm:spPr/>
      <dgm:t>
        <a:bodyPr/>
        <a:lstStyle/>
        <a:p>
          <a:endParaRPr lang="en-GB"/>
        </a:p>
      </dgm:t>
    </dgm:pt>
    <dgm:pt modelId="{A18297FA-39DE-F046-AADF-44A9D6EA28E1}">
      <dgm:prSet phldrT="[Text]"/>
      <dgm:spPr/>
      <dgm:t>
        <a:bodyPr/>
        <a:lstStyle/>
        <a:p>
          <a:r>
            <a:rPr lang="en-GB" dirty="0"/>
            <a:t>Identify the topic</a:t>
          </a:r>
        </a:p>
      </dgm:t>
    </dgm:pt>
    <dgm:pt modelId="{4C3D318C-7550-6A46-9DC2-1DC50BBD345B}" type="parTrans" cxnId="{6ACE664C-C2A0-004F-9BFF-41B5ADA46048}">
      <dgm:prSet/>
      <dgm:spPr/>
      <dgm:t>
        <a:bodyPr/>
        <a:lstStyle/>
        <a:p>
          <a:endParaRPr lang="en-GB"/>
        </a:p>
      </dgm:t>
    </dgm:pt>
    <dgm:pt modelId="{43E137FF-92F4-4E41-B79D-52D977D6C099}" type="sibTrans" cxnId="{6ACE664C-C2A0-004F-9BFF-41B5ADA46048}">
      <dgm:prSet/>
      <dgm:spPr/>
      <dgm:t>
        <a:bodyPr/>
        <a:lstStyle/>
        <a:p>
          <a:endParaRPr lang="en-GB"/>
        </a:p>
      </dgm:t>
    </dgm:pt>
    <dgm:pt modelId="{775F3146-D841-DF44-A9BA-A58935E33788}">
      <dgm:prSet phldrT="[Text]"/>
      <dgm:spPr/>
      <dgm:t>
        <a:bodyPr/>
        <a:lstStyle/>
        <a:p>
          <a:r>
            <a:rPr lang="en-GB" dirty="0"/>
            <a:t>Seek funding</a:t>
          </a:r>
        </a:p>
      </dgm:t>
    </dgm:pt>
    <dgm:pt modelId="{715EE54C-716B-EE47-BAD7-4871A08663CD}" type="parTrans" cxnId="{577F466A-3450-D24C-A92E-27B956327618}">
      <dgm:prSet/>
      <dgm:spPr/>
      <dgm:t>
        <a:bodyPr/>
        <a:lstStyle/>
        <a:p>
          <a:endParaRPr lang="en-GB"/>
        </a:p>
      </dgm:t>
    </dgm:pt>
    <dgm:pt modelId="{3C05C41F-A01D-3F41-85A5-42ACD3217FE0}" type="sibTrans" cxnId="{577F466A-3450-D24C-A92E-27B956327618}">
      <dgm:prSet/>
      <dgm:spPr/>
      <dgm:t>
        <a:bodyPr/>
        <a:lstStyle/>
        <a:p>
          <a:endParaRPr lang="en-GB"/>
        </a:p>
      </dgm:t>
    </dgm:pt>
    <dgm:pt modelId="{C7391DB6-008B-1045-881A-500864D378BA}">
      <dgm:prSet phldrT="[Text]"/>
      <dgm:spPr/>
      <dgm:t>
        <a:bodyPr/>
        <a:lstStyle/>
        <a:p>
          <a:r>
            <a:rPr lang="en-GB" dirty="0"/>
            <a:t>Design the research project</a:t>
          </a:r>
        </a:p>
      </dgm:t>
    </dgm:pt>
    <dgm:pt modelId="{562F6C85-B65D-2549-AAF4-035CEA65435F}" type="parTrans" cxnId="{45093230-BD9A-454C-A79C-E09623B80812}">
      <dgm:prSet/>
      <dgm:spPr/>
      <dgm:t>
        <a:bodyPr/>
        <a:lstStyle/>
        <a:p>
          <a:endParaRPr lang="en-GB"/>
        </a:p>
      </dgm:t>
    </dgm:pt>
    <dgm:pt modelId="{A0B3E19E-6337-9348-A48D-F00006ABCD61}" type="sibTrans" cxnId="{45093230-BD9A-454C-A79C-E09623B80812}">
      <dgm:prSet/>
      <dgm:spPr/>
      <dgm:t>
        <a:bodyPr/>
        <a:lstStyle/>
        <a:p>
          <a:endParaRPr lang="en-GB"/>
        </a:p>
      </dgm:t>
    </dgm:pt>
    <dgm:pt modelId="{704B344C-9FAD-F04B-A961-D48B354C4D80}">
      <dgm:prSet phldrT="[Text]"/>
      <dgm:spPr/>
      <dgm:t>
        <a:bodyPr/>
        <a:lstStyle/>
        <a:p>
          <a:r>
            <a:rPr lang="en-GB" dirty="0"/>
            <a:t>Manage the research</a:t>
          </a:r>
        </a:p>
      </dgm:t>
    </dgm:pt>
    <dgm:pt modelId="{ACA6BB9A-2BB7-BD46-B3A5-AE2BA0F3B0F5}" type="parTrans" cxnId="{3BA596EF-0C47-E14A-AF30-43E63CBD553B}">
      <dgm:prSet/>
      <dgm:spPr/>
      <dgm:t>
        <a:bodyPr/>
        <a:lstStyle/>
        <a:p>
          <a:endParaRPr lang="en-GB"/>
        </a:p>
      </dgm:t>
    </dgm:pt>
    <dgm:pt modelId="{AA189D3C-72DF-1246-88CA-A852CE1FAC66}" type="sibTrans" cxnId="{3BA596EF-0C47-E14A-AF30-43E63CBD553B}">
      <dgm:prSet/>
      <dgm:spPr/>
      <dgm:t>
        <a:bodyPr/>
        <a:lstStyle/>
        <a:p>
          <a:endParaRPr lang="en-GB"/>
        </a:p>
      </dgm:t>
    </dgm:pt>
    <dgm:pt modelId="{E7CF490F-91DC-F846-A3A6-D3A2EF638F83}">
      <dgm:prSet phldrT="[Text]"/>
      <dgm:spPr/>
      <dgm:t>
        <a:bodyPr/>
        <a:lstStyle/>
        <a:p>
          <a:r>
            <a:rPr lang="en-GB" dirty="0"/>
            <a:t>Conduct the research</a:t>
          </a:r>
        </a:p>
      </dgm:t>
    </dgm:pt>
    <dgm:pt modelId="{2C1E0E50-55FC-4D43-A176-592EBF4A58F3}" type="parTrans" cxnId="{4D2CC224-19EC-BC49-86B7-5D57174F25D1}">
      <dgm:prSet/>
      <dgm:spPr/>
      <dgm:t>
        <a:bodyPr/>
        <a:lstStyle/>
        <a:p>
          <a:endParaRPr lang="en-GB"/>
        </a:p>
      </dgm:t>
    </dgm:pt>
    <dgm:pt modelId="{CAC3CACD-CDE9-AE45-9323-B3BDD4088AF3}" type="sibTrans" cxnId="{4D2CC224-19EC-BC49-86B7-5D57174F25D1}">
      <dgm:prSet/>
      <dgm:spPr/>
      <dgm:t>
        <a:bodyPr/>
        <a:lstStyle/>
        <a:p>
          <a:endParaRPr lang="en-GB"/>
        </a:p>
      </dgm:t>
    </dgm:pt>
    <dgm:pt modelId="{C11BB007-9F54-0348-BE82-3BC62D65DAC5}">
      <dgm:prSet phldrT="[Text]"/>
      <dgm:spPr/>
      <dgm:t>
        <a:bodyPr/>
        <a:lstStyle/>
        <a:p>
          <a:r>
            <a:rPr lang="en-GB" dirty="0"/>
            <a:t>Analyse and interpret findings</a:t>
          </a:r>
        </a:p>
      </dgm:t>
    </dgm:pt>
    <dgm:pt modelId="{65D93766-F6A7-7749-978E-C6718CCB749A}" type="parTrans" cxnId="{4BEA6609-D67E-1041-838E-F482D69CE42A}">
      <dgm:prSet/>
      <dgm:spPr/>
      <dgm:t>
        <a:bodyPr/>
        <a:lstStyle/>
        <a:p>
          <a:endParaRPr lang="en-GB"/>
        </a:p>
      </dgm:t>
    </dgm:pt>
    <dgm:pt modelId="{144BFC2F-3C36-144B-B257-CB4D7B30721D}" type="sibTrans" cxnId="{4BEA6609-D67E-1041-838E-F482D69CE42A}">
      <dgm:prSet/>
      <dgm:spPr/>
      <dgm:t>
        <a:bodyPr/>
        <a:lstStyle/>
        <a:p>
          <a:endParaRPr lang="en-GB"/>
        </a:p>
      </dgm:t>
    </dgm:pt>
    <dgm:pt modelId="{1FA61355-A77C-574C-8C0A-60C0FD4910FD}">
      <dgm:prSet phldrT="[Text]"/>
      <dgm:spPr/>
      <dgm:t>
        <a:bodyPr/>
        <a:lstStyle/>
        <a:p>
          <a:r>
            <a:rPr lang="en-GB" dirty="0"/>
            <a:t>Disseminate</a:t>
          </a:r>
        </a:p>
      </dgm:t>
    </dgm:pt>
    <dgm:pt modelId="{3CA8528F-6AC2-7C4A-812A-4F2767E7EA72}" type="parTrans" cxnId="{FF82827E-E08E-7B42-961F-EFA0AE610155}">
      <dgm:prSet/>
      <dgm:spPr/>
      <dgm:t>
        <a:bodyPr/>
        <a:lstStyle/>
        <a:p>
          <a:endParaRPr lang="en-GB"/>
        </a:p>
      </dgm:t>
    </dgm:pt>
    <dgm:pt modelId="{4A4D2591-61EC-4C41-8583-336875443AD1}" type="sibTrans" cxnId="{FF82827E-E08E-7B42-961F-EFA0AE610155}">
      <dgm:prSet/>
      <dgm:spPr/>
      <dgm:t>
        <a:bodyPr/>
        <a:lstStyle/>
        <a:p>
          <a:endParaRPr lang="en-GB"/>
        </a:p>
      </dgm:t>
    </dgm:pt>
    <dgm:pt modelId="{F8176310-E128-DC4B-B5FB-592CF890C5A7}">
      <dgm:prSet phldrT="[Text]"/>
      <dgm:spPr/>
      <dgm:t>
        <a:bodyPr/>
        <a:lstStyle/>
        <a:p>
          <a:r>
            <a:rPr lang="en-GB" dirty="0"/>
            <a:t>Evaluate</a:t>
          </a:r>
        </a:p>
      </dgm:t>
    </dgm:pt>
    <dgm:pt modelId="{EA2C3E9A-B1C9-F341-AF96-BB86805A44F0}" type="parTrans" cxnId="{DDFF6F67-2AE4-0C44-A5E5-41C1FDCF6778}">
      <dgm:prSet/>
      <dgm:spPr/>
      <dgm:t>
        <a:bodyPr/>
        <a:lstStyle/>
        <a:p>
          <a:endParaRPr lang="en-GB"/>
        </a:p>
      </dgm:t>
    </dgm:pt>
    <dgm:pt modelId="{85582E92-BAC4-2740-ABAC-EC352743D651}" type="sibTrans" cxnId="{DDFF6F67-2AE4-0C44-A5E5-41C1FDCF6778}">
      <dgm:prSet/>
      <dgm:spPr/>
      <dgm:t>
        <a:bodyPr/>
        <a:lstStyle/>
        <a:p>
          <a:endParaRPr lang="en-GB"/>
        </a:p>
      </dgm:t>
    </dgm:pt>
    <dgm:pt modelId="{093022C1-D630-5949-8474-739FBE5D876B}">
      <dgm:prSet phldrT="[Text]"/>
      <dgm:spPr/>
      <dgm:t>
        <a:bodyPr/>
        <a:lstStyle/>
        <a:p>
          <a:r>
            <a:rPr lang="en-GB" dirty="0"/>
            <a:t>Act on findings</a:t>
          </a:r>
        </a:p>
      </dgm:t>
    </dgm:pt>
    <dgm:pt modelId="{854D18CD-80A4-BF47-9C74-F86936DBEEAB}" type="parTrans" cxnId="{4ECDD128-239D-1542-9008-29EEF63A1C3D}">
      <dgm:prSet/>
      <dgm:spPr/>
      <dgm:t>
        <a:bodyPr/>
        <a:lstStyle/>
        <a:p>
          <a:endParaRPr lang="en-GB"/>
        </a:p>
      </dgm:t>
    </dgm:pt>
    <dgm:pt modelId="{EE99D27B-EDEF-EF48-96AC-ECC66E704C2E}" type="sibTrans" cxnId="{4ECDD128-239D-1542-9008-29EEF63A1C3D}">
      <dgm:prSet/>
      <dgm:spPr/>
      <dgm:t>
        <a:bodyPr/>
        <a:lstStyle/>
        <a:p>
          <a:endParaRPr lang="en-GB"/>
        </a:p>
      </dgm:t>
    </dgm:pt>
    <dgm:pt modelId="{BEFCDFDC-31B4-394F-B6DC-AEEEFC84A042}" type="pres">
      <dgm:prSet presAssocID="{A5D9A408-9F42-954E-9533-247B8D2AC1A5}" presName="cycle" presStyleCnt="0">
        <dgm:presLayoutVars>
          <dgm:dir/>
          <dgm:resizeHandles val="exact"/>
        </dgm:presLayoutVars>
      </dgm:prSet>
      <dgm:spPr/>
    </dgm:pt>
    <dgm:pt modelId="{D574BFB6-BEF1-8C4C-8B68-6F0C449AC879}" type="pres">
      <dgm:prSet presAssocID="{A18297FA-39DE-F046-AADF-44A9D6EA28E1}" presName="node" presStyleLbl="node1" presStyleIdx="0" presStyleCnt="9">
        <dgm:presLayoutVars>
          <dgm:bulletEnabled val="1"/>
        </dgm:presLayoutVars>
      </dgm:prSet>
      <dgm:spPr/>
    </dgm:pt>
    <dgm:pt modelId="{04741F94-04F5-944A-AA75-A52B581B08EB}" type="pres">
      <dgm:prSet presAssocID="{A18297FA-39DE-F046-AADF-44A9D6EA28E1}" presName="spNode" presStyleCnt="0"/>
      <dgm:spPr/>
    </dgm:pt>
    <dgm:pt modelId="{898433E3-2070-1F49-9809-E8CFFC177272}" type="pres">
      <dgm:prSet presAssocID="{43E137FF-92F4-4E41-B79D-52D977D6C099}" presName="sibTrans" presStyleLbl="sibTrans1D1" presStyleIdx="0" presStyleCnt="9"/>
      <dgm:spPr/>
    </dgm:pt>
    <dgm:pt modelId="{5F7A9264-01C6-C443-BFDE-FEF35C937F56}" type="pres">
      <dgm:prSet presAssocID="{775F3146-D841-DF44-A9BA-A58935E33788}" presName="node" presStyleLbl="node1" presStyleIdx="1" presStyleCnt="9">
        <dgm:presLayoutVars>
          <dgm:bulletEnabled val="1"/>
        </dgm:presLayoutVars>
      </dgm:prSet>
      <dgm:spPr/>
    </dgm:pt>
    <dgm:pt modelId="{B3EC3292-64F5-8642-B0CA-3A2250C83DEF}" type="pres">
      <dgm:prSet presAssocID="{775F3146-D841-DF44-A9BA-A58935E33788}" presName="spNode" presStyleCnt="0"/>
      <dgm:spPr/>
    </dgm:pt>
    <dgm:pt modelId="{B371DBB0-DEDB-914B-9AFF-7586E37A0CF6}" type="pres">
      <dgm:prSet presAssocID="{3C05C41F-A01D-3F41-85A5-42ACD3217FE0}" presName="sibTrans" presStyleLbl="sibTrans1D1" presStyleIdx="1" presStyleCnt="9"/>
      <dgm:spPr/>
    </dgm:pt>
    <dgm:pt modelId="{F039F0EB-D869-DF43-8B8E-C29408B796EB}" type="pres">
      <dgm:prSet presAssocID="{C7391DB6-008B-1045-881A-500864D378BA}" presName="node" presStyleLbl="node1" presStyleIdx="2" presStyleCnt="9">
        <dgm:presLayoutVars>
          <dgm:bulletEnabled val="1"/>
        </dgm:presLayoutVars>
      </dgm:prSet>
      <dgm:spPr/>
    </dgm:pt>
    <dgm:pt modelId="{681DBF75-0482-0B49-8C5C-FDCCB455E790}" type="pres">
      <dgm:prSet presAssocID="{C7391DB6-008B-1045-881A-500864D378BA}" presName="spNode" presStyleCnt="0"/>
      <dgm:spPr/>
    </dgm:pt>
    <dgm:pt modelId="{50EE490F-4F8E-9049-B615-10D6612BF852}" type="pres">
      <dgm:prSet presAssocID="{A0B3E19E-6337-9348-A48D-F00006ABCD61}" presName="sibTrans" presStyleLbl="sibTrans1D1" presStyleIdx="2" presStyleCnt="9"/>
      <dgm:spPr/>
    </dgm:pt>
    <dgm:pt modelId="{97452FB2-9725-6644-8F45-8091549EC3C6}" type="pres">
      <dgm:prSet presAssocID="{704B344C-9FAD-F04B-A961-D48B354C4D80}" presName="node" presStyleLbl="node1" presStyleIdx="3" presStyleCnt="9">
        <dgm:presLayoutVars>
          <dgm:bulletEnabled val="1"/>
        </dgm:presLayoutVars>
      </dgm:prSet>
      <dgm:spPr/>
    </dgm:pt>
    <dgm:pt modelId="{FE758242-03FB-CF43-80AD-996A0610A9E1}" type="pres">
      <dgm:prSet presAssocID="{704B344C-9FAD-F04B-A961-D48B354C4D80}" presName="spNode" presStyleCnt="0"/>
      <dgm:spPr/>
    </dgm:pt>
    <dgm:pt modelId="{454A1872-84E1-A440-9E23-9BA8B373C188}" type="pres">
      <dgm:prSet presAssocID="{AA189D3C-72DF-1246-88CA-A852CE1FAC66}" presName="sibTrans" presStyleLbl="sibTrans1D1" presStyleIdx="3" presStyleCnt="9"/>
      <dgm:spPr/>
    </dgm:pt>
    <dgm:pt modelId="{2EAB5438-31E8-064A-A4B0-3F2DE2B6D4E6}" type="pres">
      <dgm:prSet presAssocID="{E7CF490F-91DC-F846-A3A6-D3A2EF638F83}" presName="node" presStyleLbl="node1" presStyleIdx="4" presStyleCnt="9">
        <dgm:presLayoutVars>
          <dgm:bulletEnabled val="1"/>
        </dgm:presLayoutVars>
      </dgm:prSet>
      <dgm:spPr/>
    </dgm:pt>
    <dgm:pt modelId="{A56C7289-B605-8C48-A7ED-788D64A3C1B3}" type="pres">
      <dgm:prSet presAssocID="{E7CF490F-91DC-F846-A3A6-D3A2EF638F83}" presName="spNode" presStyleCnt="0"/>
      <dgm:spPr/>
    </dgm:pt>
    <dgm:pt modelId="{592DEB87-05BA-314E-9E5D-A0994FBB9BE7}" type="pres">
      <dgm:prSet presAssocID="{CAC3CACD-CDE9-AE45-9323-B3BDD4088AF3}" presName="sibTrans" presStyleLbl="sibTrans1D1" presStyleIdx="4" presStyleCnt="9"/>
      <dgm:spPr/>
    </dgm:pt>
    <dgm:pt modelId="{B61B4333-12E9-EA4E-96BE-541075F519B1}" type="pres">
      <dgm:prSet presAssocID="{C11BB007-9F54-0348-BE82-3BC62D65DAC5}" presName="node" presStyleLbl="node1" presStyleIdx="5" presStyleCnt="9">
        <dgm:presLayoutVars>
          <dgm:bulletEnabled val="1"/>
        </dgm:presLayoutVars>
      </dgm:prSet>
      <dgm:spPr/>
    </dgm:pt>
    <dgm:pt modelId="{1999164E-B41C-E748-984D-D95DF71999F3}" type="pres">
      <dgm:prSet presAssocID="{C11BB007-9F54-0348-BE82-3BC62D65DAC5}" presName="spNode" presStyleCnt="0"/>
      <dgm:spPr/>
    </dgm:pt>
    <dgm:pt modelId="{1DCD3E9D-C78C-A144-B7E8-BE98F083AEB6}" type="pres">
      <dgm:prSet presAssocID="{144BFC2F-3C36-144B-B257-CB4D7B30721D}" presName="sibTrans" presStyleLbl="sibTrans1D1" presStyleIdx="5" presStyleCnt="9"/>
      <dgm:spPr/>
    </dgm:pt>
    <dgm:pt modelId="{18BCA952-D167-F945-8867-AD4C9D2398AB}" type="pres">
      <dgm:prSet presAssocID="{1FA61355-A77C-574C-8C0A-60C0FD4910FD}" presName="node" presStyleLbl="node1" presStyleIdx="6" presStyleCnt="9">
        <dgm:presLayoutVars>
          <dgm:bulletEnabled val="1"/>
        </dgm:presLayoutVars>
      </dgm:prSet>
      <dgm:spPr/>
    </dgm:pt>
    <dgm:pt modelId="{B4417D4B-F281-1143-84C1-686D272378B4}" type="pres">
      <dgm:prSet presAssocID="{1FA61355-A77C-574C-8C0A-60C0FD4910FD}" presName="spNode" presStyleCnt="0"/>
      <dgm:spPr/>
    </dgm:pt>
    <dgm:pt modelId="{B9ABB65A-E4F9-2446-9DC0-16FA01C2810E}" type="pres">
      <dgm:prSet presAssocID="{4A4D2591-61EC-4C41-8583-336875443AD1}" presName="sibTrans" presStyleLbl="sibTrans1D1" presStyleIdx="6" presStyleCnt="9"/>
      <dgm:spPr/>
    </dgm:pt>
    <dgm:pt modelId="{BBB9B9B7-392F-044F-9D6F-255404CF4C1D}" type="pres">
      <dgm:prSet presAssocID="{F8176310-E128-DC4B-B5FB-592CF890C5A7}" presName="node" presStyleLbl="node1" presStyleIdx="7" presStyleCnt="9">
        <dgm:presLayoutVars>
          <dgm:bulletEnabled val="1"/>
        </dgm:presLayoutVars>
      </dgm:prSet>
      <dgm:spPr/>
    </dgm:pt>
    <dgm:pt modelId="{82579739-B1E5-3A4D-916A-92CDD6F5EEAF}" type="pres">
      <dgm:prSet presAssocID="{F8176310-E128-DC4B-B5FB-592CF890C5A7}" presName="spNode" presStyleCnt="0"/>
      <dgm:spPr/>
    </dgm:pt>
    <dgm:pt modelId="{24E638AC-505A-804E-9219-145CB4495339}" type="pres">
      <dgm:prSet presAssocID="{85582E92-BAC4-2740-ABAC-EC352743D651}" presName="sibTrans" presStyleLbl="sibTrans1D1" presStyleIdx="7" presStyleCnt="9"/>
      <dgm:spPr/>
    </dgm:pt>
    <dgm:pt modelId="{99EB3913-8B6E-E34E-9628-DAC25591E971}" type="pres">
      <dgm:prSet presAssocID="{093022C1-D630-5949-8474-739FBE5D876B}" presName="node" presStyleLbl="node1" presStyleIdx="8" presStyleCnt="9">
        <dgm:presLayoutVars>
          <dgm:bulletEnabled val="1"/>
        </dgm:presLayoutVars>
      </dgm:prSet>
      <dgm:spPr/>
    </dgm:pt>
    <dgm:pt modelId="{AA8F755A-9E3C-FE40-B5A1-AF38A3824191}" type="pres">
      <dgm:prSet presAssocID="{093022C1-D630-5949-8474-739FBE5D876B}" presName="spNode" presStyleCnt="0"/>
      <dgm:spPr/>
    </dgm:pt>
    <dgm:pt modelId="{D8F8ADA8-351A-B544-A873-AEA3C0755809}" type="pres">
      <dgm:prSet presAssocID="{EE99D27B-EDEF-EF48-96AC-ECC66E704C2E}" presName="sibTrans" presStyleLbl="sibTrans1D1" presStyleIdx="8" presStyleCnt="9"/>
      <dgm:spPr/>
    </dgm:pt>
  </dgm:ptLst>
  <dgm:cxnLst>
    <dgm:cxn modelId="{EC4F9300-DE6A-EB4B-9CE3-571589414EBE}" type="presOf" srcId="{CAC3CACD-CDE9-AE45-9323-B3BDD4088AF3}" destId="{592DEB87-05BA-314E-9E5D-A0994FBB9BE7}" srcOrd="0" destOrd="0" presId="urn:microsoft.com/office/officeart/2005/8/layout/cycle5"/>
    <dgm:cxn modelId="{4BEA6609-D67E-1041-838E-F482D69CE42A}" srcId="{A5D9A408-9F42-954E-9533-247B8D2AC1A5}" destId="{C11BB007-9F54-0348-BE82-3BC62D65DAC5}" srcOrd="5" destOrd="0" parTransId="{65D93766-F6A7-7749-978E-C6718CCB749A}" sibTransId="{144BFC2F-3C36-144B-B257-CB4D7B30721D}"/>
    <dgm:cxn modelId="{590BAB09-0784-1A42-8B0A-2AD21B2EE8E6}" type="presOf" srcId="{704B344C-9FAD-F04B-A961-D48B354C4D80}" destId="{97452FB2-9725-6644-8F45-8091549EC3C6}" srcOrd="0" destOrd="0" presId="urn:microsoft.com/office/officeart/2005/8/layout/cycle5"/>
    <dgm:cxn modelId="{235ABD10-7E44-684C-B18B-B7F5CCBE7FC3}" type="presOf" srcId="{A0B3E19E-6337-9348-A48D-F00006ABCD61}" destId="{50EE490F-4F8E-9049-B615-10D6612BF852}" srcOrd="0" destOrd="0" presId="urn:microsoft.com/office/officeart/2005/8/layout/cycle5"/>
    <dgm:cxn modelId="{C3235C1A-47E1-FA40-8900-8EDB3093E471}" type="presOf" srcId="{43E137FF-92F4-4E41-B79D-52D977D6C099}" destId="{898433E3-2070-1F49-9809-E8CFFC177272}" srcOrd="0" destOrd="0" presId="urn:microsoft.com/office/officeart/2005/8/layout/cycle5"/>
    <dgm:cxn modelId="{55F5301B-1D94-CB4C-90D1-AB09AF8E4255}" type="presOf" srcId="{775F3146-D841-DF44-A9BA-A58935E33788}" destId="{5F7A9264-01C6-C443-BFDE-FEF35C937F56}" srcOrd="0" destOrd="0" presId="urn:microsoft.com/office/officeart/2005/8/layout/cycle5"/>
    <dgm:cxn modelId="{4D2CC224-19EC-BC49-86B7-5D57174F25D1}" srcId="{A5D9A408-9F42-954E-9533-247B8D2AC1A5}" destId="{E7CF490F-91DC-F846-A3A6-D3A2EF638F83}" srcOrd="4" destOrd="0" parTransId="{2C1E0E50-55FC-4D43-A176-592EBF4A58F3}" sibTransId="{CAC3CACD-CDE9-AE45-9323-B3BDD4088AF3}"/>
    <dgm:cxn modelId="{4ECDD128-239D-1542-9008-29EEF63A1C3D}" srcId="{A5D9A408-9F42-954E-9533-247B8D2AC1A5}" destId="{093022C1-D630-5949-8474-739FBE5D876B}" srcOrd="8" destOrd="0" parTransId="{854D18CD-80A4-BF47-9C74-F86936DBEEAB}" sibTransId="{EE99D27B-EDEF-EF48-96AC-ECC66E704C2E}"/>
    <dgm:cxn modelId="{45093230-BD9A-454C-A79C-E09623B80812}" srcId="{A5D9A408-9F42-954E-9533-247B8D2AC1A5}" destId="{C7391DB6-008B-1045-881A-500864D378BA}" srcOrd="2" destOrd="0" parTransId="{562F6C85-B65D-2549-AAF4-035CEA65435F}" sibTransId="{A0B3E19E-6337-9348-A48D-F00006ABCD61}"/>
    <dgm:cxn modelId="{570B5A36-FEE3-E040-8E3F-8DB65D2E5276}" type="presOf" srcId="{85582E92-BAC4-2740-ABAC-EC352743D651}" destId="{24E638AC-505A-804E-9219-145CB4495339}" srcOrd="0" destOrd="0" presId="urn:microsoft.com/office/officeart/2005/8/layout/cycle5"/>
    <dgm:cxn modelId="{0D3DBC3B-F96A-654A-A7CB-E13CFCE3ED08}" type="presOf" srcId="{AA189D3C-72DF-1246-88CA-A852CE1FAC66}" destId="{454A1872-84E1-A440-9E23-9BA8B373C188}" srcOrd="0" destOrd="0" presId="urn:microsoft.com/office/officeart/2005/8/layout/cycle5"/>
    <dgm:cxn modelId="{03EC9040-9411-2E48-8632-A9F18DE09AA9}" type="presOf" srcId="{3C05C41F-A01D-3F41-85A5-42ACD3217FE0}" destId="{B371DBB0-DEDB-914B-9AFF-7586E37A0CF6}" srcOrd="0" destOrd="0" presId="urn:microsoft.com/office/officeart/2005/8/layout/cycle5"/>
    <dgm:cxn modelId="{4EDBB645-F288-6749-8846-4F1E2D82303C}" type="presOf" srcId="{A5D9A408-9F42-954E-9533-247B8D2AC1A5}" destId="{BEFCDFDC-31B4-394F-B6DC-AEEEFC84A042}" srcOrd="0" destOrd="0" presId="urn:microsoft.com/office/officeart/2005/8/layout/cycle5"/>
    <dgm:cxn modelId="{DDFF6F67-2AE4-0C44-A5E5-41C1FDCF6778}" srcId="{A5D9A408-9F42-954E-9533-247B8D2AC1A5}" destId="{F8176310-E128-DC4B-B5FB-592CF890C5A7}" srcOrd="7" destOrd="0" parTransId="{EA2C3E9A-B1C9-F341-AF96-BB86805A44F0}" sibTransId="{85582E92-BAC4-2740-ABAC-EC352743D651}"/>
    <dgm:cxn modelId="{577F466A-3450-D24C-A92E-27B956327618}" srcId="{A5D9A408-9F42-954E-9533-247B8D2AC1A5}" destId="{775F3146-D841-DF44-A9BA-A58935E33788}" srcOrd="1" destOrd="0" parTransId="{715EE54C-716B-EE47-BAD7-4871A08663CD}" sibTransId="{3C05C41F-A01D-3F41-85A5-42ACD3217FE0}"/>
    <dgm:cxn modelId="{6ACE664C-C2A0-004F-9BFF-41B5ADA46048}" srcId="{A5D9A408-9F42-954E-9533-247B8D2AC1A5}" destId="{A18297FA-39DE-F046-AADF-44A9D6EA28E1}" srcOrd="0" destOrd="0" parTransId="{4C3D318C-7550-6A46-9DC2-1DC50BBD345B}" sibTransId="{43E137FF-92F4-4E41-B79D-52D977D6C099}"/>
    <dgm:cxn modelId="{EC6F6771-4F32-A54B-BC29-B3FD92F3BF40}" type="presOf" srcId="{EE99D27B-EDEF-EF48-96AC-ECC66E704C2E}" destId="{D8F8ADA8-351A-B544-A873-AEA3C0755809}" srcOrd="0" destOrd="0" presId="urn:microsoft.com/office/officeart/2005/8/layout/cycle5"/>
    <dgm:cxn modelId="{7FB57878-7494-ED45-95EC-5714925AFF27}" type="presOf" srcId="{C11BB007-9F54-0348-BE82-3BC62D65DAC5}" destId="{B61B4333-12E9-EA4E-96BE-541075F519B1}" srcOrd="0" destOrd="0" presId="urn:microsoft.com/office/officeart/2005/8/layout/cycle5"/>
    <dgm:cxn modelId="{09616E7B-CB8C-9044-8314-4A92E123C0CE}" type="presOf" srcId="{E7CF490F-91DC-F846-A3A6-D3A2EF638F83}" destId="{2EAB5438-31E8-064A-A4B0-3F2DE2B6D4E6}" srcOrd="0" destOrd="0" presId="urn:microsoft.com/office/officeart/2005/8/layout/cycle5"/>
    <dgm:cxn modelId="{FF82827E-E08E-7B42-961F-EFA0AE610155}" srcId="{A5D9A408-9F42-954E-9533-247B8D2AC1A5}" destId="{1FA61355-A77C-574C-8C0A-60C0FD4910FD}" srcOrd="6" destOrd="0" parTransId="{3CA8528F-6AC2-7C4A-812A-4F2767E7EA72}" sibTransId="{4A4D2591-61EC-4C41-8583-336875443AD1}"/>
    <dgm:cxn modelId="{3F85B383-5260-3840-9860-14B4EACF1AA9}" type="presOf" srcId="{093022C1-D630-5949-8474-739FBE5D876B}" destId="{99EB3913-8B6E-E34E-9628-DAC25591E971}" srcOrd="0" destOrd="0" presId="urn:microsoft.com/office/officeart/2005/8/layout/cycle5"/>
    <dgm:cxn modelId="{9E4E8585-0343-334B-9109-C295C9E11DBC}" type="presOf" srcId="{A18297FA-39DE-F046-AADF-44A9D6EA28E1}" destId="{D574BFB6-BEF1-8C4C-8B68-6F0C449AC879}" srcOrd="0" destOrd="0" presId="urn:microsoft.com/office/officeart/2005/8/layout/cycle5"/>
    <dgm:cxn modelId="{DD132989-162D-104F-A1D1-FB88A665DF31}" type="presOf" srcId="{1FA61355-A77C-574C-8C0A-60C0FD4910FD}" destId="{18BCA952-D167-F945-8867-AD4C9D2398AB}" srcOrd="0" destOrd="0" presId="urn:microsoft.com/office/officeart/2005/8/layout/cycle5"/>
    <dgm:cxn modelId="{10E35E9C-FA10-4E4E-9AA0-1B05F950A98D}" type="presOf" srcId="{4A4D2591-61EC-4C41-8583-336875443AD1}" destId="{B9ABB65A-E4F9-2446-9DC0-16FA01C2810E}" srcOrd="0" destOrd="0" presId="urn:microsoft.com/office/officeart/2005/8/layout/cycle5"/>
    <dgm:cxn modelId="{4B9903EC-829D-E94C-BE8F-83F86D15CC89}" type="presOf" srcId="{144BFC2F-3C36-144B-B257-CB4D7B30721D}" destId="{1DCD3E9D-C78C-A144-B7E8-BE98F083AEB6}" srcOrd="0" destOrd="0" presId="urn:microsoft.com/office/officeart/2005/8/layout/cycle5"/>
    <dgm:cxn modelId="{3BA596EF-0C47-E14A-AF30-43E63CBD553B}" srcId="{A5D9A408-9F42-954E-9533-247B8D2AC1A5}" destId="{704B344C-9FAD-F04B-A961-D48B354C4D80}" srcOrd="3" destOrd="0" parTransId="{ACA6BB9A-2BB7-BD46-B3A5-AE2BA0F3B0F5}" sibTransId="{AA189D3C-72DF-1246-88CA-A852CE1FAC66}"/>
    <dgm:cxn modelId="{987088F0-0B28-8246-8B89-01F276488EBF}" type="presOf" srcId="{F8176310-E128-DC4B-B5FB-592CF890C5A7}" destId="{BBB9B9B7-392F-044F-9D6F-255404CF4C1D}" srcOrd="0" destOrd="0" presId="urn:microsoft.com/office/officeart/2005/8/layout/cycle5"/>
    <dgm:cxn modelId="{7BDA0FF6-33EF-FB4C-B9E1-F3DEF1E45A91}" type="presOf" srcId="{C7391DB6-008B-1045-881A-500864D378BA}" destId="{F039F0EB-D869-DF43-8B8E-C29408B796EB}" srcOrd="0" destOrd="0" presId="urn:microsoft.com/office/officeart/2005/8/layout/cycle5"/>
    <dgm:cxn modelId="{1831DE0A-E8BD-D04A-9A5E-ECBC57F727CF}" type="presParOf" srcId="{BEFCDFDC-31B4-394F-B6DC-AEEEFC84A042}" destId="{D574BFB6-BEF1-8C4C-8B68-6F0C449AC879}" srcOrd="0" destOrd="0" presId="urn:microsoft.com/office/officeart/2005/8/layout/cycle5"/>
    <dgm:cxn modelId="{82411476-1682-2E40-9D93-6A28D00DAC6D}" type="presParOf" srcId="{BEFCDFDC-31B4-394F-B6DC-AEEEFC84A042}" destId="{04741F94-04F5-944A-AA75-A52B581B08EB}" srcOrd="1" destOrd="0" presId="urn:microsoft.com/office/officeart/2005/8/layout/cycle5"/>
    <dgm:cxn modelId="{9EFADA66-8FDA-C248-9D2C-AF28220955AF}" type="presParOf" srcId="{BEFCDFDC-31B4-394F-B6DC-AEEEFC84A042}" destId="{898433E3-2070-1F49-9809-E8CFFC177272}" srcOrd="2" destOrd="0" presId="urn:microsoft.com/office/officeart/2005/8/layout/cycle5"/>
    <dgm:cxn modelId="{4EF40AE6-40E9-244B-96D9-377521C40AC8}" type="presParOf" srcId="{BEFCDFDC-31B4-394F-B6DC-AEEEFC84A042}" destId="{5F7A9264-01C6-C443-BFDE-FEF35C937F56}" srcOrd="3" destOrd="0" presId="urn:microsoft.com/office/officeart/2005/8/layout/cycle5"/>
    <dgm:cxn modelId="{775197DB-F50D-F345-B9EA-68D620D60F1F}" type="presParOf" srcId="{BEFCDFDC-31B4-394F-B6DC-AEEEFC84A042}" destId="{B3EC3292-64F5-8642-B0CA-3A2250C83DEF}" srcOrd="4" destOrd="0" presId="urn:microsoft.com/office/officeart/2005/8/layout/cycle5"/>
    <dgm:cxn modelId="{BC4443C3-E50D-1541-B20A-A5EEDB7B6824}" type="presParOf" srcId="{BEFCDFDC-31B4-394F-B6DC-AEEEFC84A042}" destId="{B371DBB0-DEDB-914B-9AFF-7586E37A0CF6}" srcOrd="5" destOrd="0" presId="urn:microsoft.com/office/officeart/2005/8/layout/cycle5"/>
    <dgm:cxn modelId="{CBAC1E2B-FF68-A443-8D4D-0D400DEB757F}" type="presParOf" srcId="{BEFCDFDC-31B4-394F-B6DC-AEEEFC84A042}" destId="{F039F0EB-D869-DF43-8B8E-C29408B796EB}" srcOrd="6" destOrd="0" presId="urn:microsoft.com/office/officeart/2005/8/layout/cycle5"/>
    <dgm:cxn modelId="{42A54530-49F4-4C4C-95BA-59015D6999AF}" type="presParOf" srcId="{BEFCDFDC-31B4-394F-B6DC-AEEEFC84A042}" destId="{681DBF75-0482-0B49-8C5C-FDCCB455E790}" srcOrd="7" destOrd="0" presId="urn:microsoft.com/office/officeart/2005/8/layout/cycle5"/>
    <dgm:cxn modelId="{73690491-E452-6B48-949A-19100563189D}" type="presParOf" srcId="{BEFCDFDC-31B4-394F-B6DC-AEEEFC84A042}" destId="{50EE490F-4F8E-9049-B615-10D6612BF852}" srcOrd="8" destOrd="0" presId="urn:microsoft.com/office/officeart/2005/8/layout/cycle5"/>
    <dgm:cxn modelId="{8AFEE76F-FCC5-8548-9FA7-5811512060D3}" type="presParOf" srcId="{BEFCDFDC-31B4-394F-B6DC-AEEEFC84A042}" destId="{97452FB2-9725-6644-8F45-8091549EC3C6}" srcOrd="9" destOrd="0" presId="urn:microsoft.com/office/officeart/2005/8/layout/cycle5"/>
    <dgm:cxn modelId="{7C90763D-4629-3640-B572-896CE5C4841C}" type="presParOf" srcId="{BEFCDFDC-31B4-394F-B6DC-AEEEFC84A042}" destId="{FE758242-03FB-CF43-80AD-996A0610A9E1}" srcOrd="10" destOrd="0" presId="urn:microsoft.com/office/officeart/2005/8/layout/cycle5"/>
    <dgm:cxn modelId="{B5C6B902-3EFC-BE47-AD1C-90F92ABEA431}" type="presParOf" srcId="{BEFCDFDC-31B4-394F-B6DC-AEEEFC84A042}" destId="{454A1872-84E1-A440-9E23-9BA8B373C188}" srcOrd="11" destOrd="0" presId="urn:microsoft.com/office/officeart/2005/8/layout/cycle5"/>
    <dgm:cxn modelId="{78DF2DCB-5BE8-924C-BEBB-BFB554781215}" type="presParOf" srcId="{BEFCDFDC-31B4-394F-B6DC-AEEEFC84A042}" destId="{2EAB5438-31E8-064A-A4B0-3F2DE2B6D4E6}" srcOrd="12" destOrd="0" presId="urn:microsoft.com/office/officeart/2005/8/layout/cycle5"/>
    <dgm:cxn modelId="{2A748B38-0F02-4C47-A7FC-FF91DBE6CE5A}" type="presParOf" srcId="{BEFCDFDC-31B4-394F-B6DC-AEEEFC84A042}" destId="{A56C7289-B605-8C48-A7ED-788D64A3C1B3}" srcOrd="13" destOrd="0" presId="urn:microsoft.com/office/officeart/2005/8/layout/cycle5"/>
    <dgm:cxn modelId="{B1B9F60A-AF58-5647-8B81-5B55AFC50257}" type="presParOf" srcId="{BEFCDFDC-31B4-394F-B6DC-AEEEFC84A042}" destId="{592DEB87-05BA-314E-9E5D-A0994FBB9BE7}" srcOrd="14" destOrd="0" presId="urn:microsoft.com/office/officeart/2005/8/layout/cycle5"/>
    <dgm:cxn modelId="{B8D6194E-3E1D-404E-948F-E125F159BCFE}" type="presParOf" srcId="{BEFCDFDC-31B4-394F-B6DC-AEEEFC84A042}" destId="{B61B4333-12E9-EA4E-96BE-541075F519B1}" srcOrd="15" destOrd="0" presId="urn:microsoft.com/office/officeart/2005/8/layout/cycle5"/>
    <dgm:cxn modelId="{AA57E3D1-7870-BE4D-AF16-DE0BA18C1593}" type="presParOf" srcId="{BEFCDFDC-31B4-394F-B6DC-AEEEFC84A042}" destId="{1999164E-B41C-E748-984D-D95DF71999F3}" srcOrd="16" destOrd="0" presId="urn:microsoft.com/office/officeart/2005/8/layout/cycle5"/>
    <dgm:cxn modelId="{5A04BEA7-6011-484E-A897-D17743D411E5}" type="presParOf" srcId="{BEFCDFDC-31B4-394F-B6DC-AEEEFC84A042}" destId="{1DCD3E9D-C78C-A144-B7E8-BE98F083AEB6}" srcOrd="17" destOrd="0" presId="urn:microsoft.com/office/officeart/2005/8/layout/cycle5"/>
    <dgm:cxn modelId="{532DBB0A-E9F4-6F47-8546-D0F2AEE952AF}" type="presParOf" srcId="{BEFCDFDC-31B4-394F-B6DC-AEEEFC84A042}" destId="{18BCA952-D167-F945-8867-AD4C9D2398AB}" srcOrd="18" destOrd="0" presId="urn:microsoft.com/office/officeart/2005/8/layout/cycle5"/>
    <dgm:cxn modelId="{98CCD086-05EB-0F44-BD12-3121E72B74B0}" type="presParOf" srcId="{BEFCDFDC-31B4-394F-B6DC-AEEEFC84A042}" destId="{B4417D4B-F281-1143-84C1-686D272378B4}" srcOrd="19" destOrd="0" presId="urn:microsoft.com/office/officeart/2005/8/layout/cycle5"/>
    <dgm:cxn modelId="{A1546A76-203A-F547-A33D-8E2280C08198}" type="presParOf" srcId="{BEFCDFDC-31B4-394F-B6DC-AEEEFC84A042}" destId="{B9ABB65A-E4F9-2446-9DC0-16FA01C2810E}" srcOrd="20" destOrd="0" presId="urn:microsoft.com/office/officeart/2005/8/layout/cycle5"/>
    <dgm:cxn modelId="{45B031A7-FF07-4F40-AB00-2F7C6074BD30}" type="presParOf" srcId="{BEFCDFDC-31B4-394F-B6DC-AEEEFC84A042}" destId="{BBB9B9B7-392F-044F-9D6F-255404CF4C1D}" srcOrd="21" destOrd="0" presId="urn:microsoft.com/office/officeart/2005/8/layout/cycle5"/>
    <dgm:cxn modelId="{68C44E0C-0A9E-4348-B3D7-1EC71869C7D2}" type="presParOf" srcId="{BEFCDFDC-31B4-394F-B6DC-AEEEFC84A042}" destId="{82579739-B1E5-3A4D-916A-92CDD6F5EEAF}" srcOrd="22" destOrd="0" presId="urn:microsoft.com/office/officeart/2005/8/layout/cycle5"/>
    <dgm:cxn modelId="{E05515A9-7339-B14A-A56E-A596F2403275}" type="presParOf" srcId="{BEFCDFDC-31B4-394F-B6DC-AEEEFC84A042}" destId="{24E638AC-505A-804E-9219-145CB4495339}" srcOrd="23" destOrd="0" presId="urn:microsoft.com/office/officeart/2005/8/layout/cycle5"/>
    <dgm:cxn modelId="{339B0992-B7BC-8845-A86F-37B19FF16ADC}" type="presParOf" srcId="{BEFCDFDC-31B4-394F-B6DC-AEEEFC84A042}" destId="{99EB3913-8B6E-E34E-9628-DAC25591E971}" srcOrd="24" destOrd="0" presId="urn:microsoft.com/office/officeart/2005/8/layout/cycle5"/>
    <dgm:cxn modelId="{DE516299-D6DA-D948-B7D2-5954CEC1DB28}" type="presParOf" srcId="{BEFCDFDC-31B4-394F-B6DC-AEEEFC84A042}" destId="{AA8F755A-9E3C-FE40-B5A1-AF38A3824191}" srcOrd="25" destOrd="0" presId="urn:microsoft.com/office/officeart/2005/8/layout/cycle5"/>
    <dgm:cxn modelId="{42A4CD3D-362C-424B-8D14-6831D8DE3C71}" type="presParOf" srcId="{BEFCDFDC-31B4-394F-B6DC-AEEEFC84A042}" destId="{D8F8ADA8-351A-B544-A873-AEA3C0755809}" srcOrd="26" destOrd="0" presId="urn:microsoft.com/office/officeart/2005/8/layout/cycle5"/>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A5D9A408-9F42-954E-9533-247B8D2AC1A5}" type="doc">
      <dgm:prSet loTypeId="urn:microsoft.com/office/officeart/2005/8/layout/cycle5" loCatId="" qsTypeId="urn:microsoft.com/office/officeart/2005/8/quickstyle/simple1" qsCatId="simple" csTypeId="urn:microsoft.com/office/officeart/2005/8/colors/accent1_2" csCatId="accent1" phldr="1"/>
      <dgm:spPr/>
      <dgm:t>
        <a:bodyPr/>
        <a:lstStyle/>
        <a:p>
          <a:endParaRPr lang="en-GB"/>
        </a:p>
      </dgm:t>
    </dgm:pt>
    <dgm:pt modelId="{A18297FA-39DE-F046-AADF-44A9D6EA28E1}">
      <dgm:prSet phldrT="[Text]"/>
      <dgm:spPr/>
      <dgm:t>
        <a:bodyPr/>
        <a:lstStyle/>
        <a:p>
          <a:r>
            <a:rPr lang="en-GB" dirty="0"/>
            <a:t>Identify the topic</a:t>
          </a:r>
        </a:p>
      </dgm:t>
    </dgm:pt>
    <dgm:pt modelId="{4C3D318C-7550-6A46-9DC2-1DC50BBD345B}" type="parTrans" cxnId="{6ACE664C-C2A0-004F-9BFF-41B5ADA46048}">
      <dgm:prSet/>
      <dgm:spPr/>
      <dgm:t>
        <a:bodyPr/>
        <a:lstStyle/>
        <a:p>
          <a:endParaRPr lang="en-GB"/>
        </a:p>
      </dgm:t>
    </dgm:pt>
    <dgm:pt modelId="{43E137FF-92F4-4E41-B79D-52D977D6C099}" type="sibTrans" cxnId="{6ACE664C-C2A0-004F-9BFF-41B5ADA46048}">
      <dgm:prSet/>
      <dgm:spPr/>
      <dgm:t>
        <a:bodyPr/>
        <a:lstStyle/>
        <a:p>
          <a:endParaRPr lang="en-GB"/>
        </a:p>
      </dgm:t>
    </dgm:pt>
    <dgm:pt modelId="{775F3146-D841-DF44-A9BA-A58935E33788}">
      <dgm:prSet phldrT="[Text]"/>
      <dgm:spPr/>
      <dgm:t>
        <a:bodyPr/>
        <a:lstStyle/>
        <a:p>
          <a:r>
            <a:rPr lang="en-GB" dirty="0"/>
            <a:t>Seek funding</a:t>
          </a:r>
        </a:p>
      </dgm:t>
    </dgm:pt>
    <dgm:pt modelId="{715EE54C-716B-EE47-BAD7-4871A08663CD}" type="parTrans" cxnId="{577F466A-3450-D24C-A92E-27B956327618}">
      <dgm:prSet/>
      <dgm:spPr/>
      <dgm:t>
        <a:bodyPr/>
        <a:lstStyle/>
        <a:p>
          <a:endParaRPr lang="en-GB"/>
        </a:p>
      </dgm:t>
    </dgm:pt>
    <dgm:pt modelId="{3C05C41F-A01D-3F41-85A5-42ACD3217FE0}" type="sibTrans" cxnId="{577F466A-3450-D24C-A92E-27B956327618}">
      <dgm:prSet/>
      <dgm:spPr/>
      <dgm:t>
        <a:bodyPr/>
        <a:lstStyle/>
        <a:p>
          <a:endParaRPr lang="en-GB"/>
        </a:p>
      </dgm:t>
    </dgm:pt>
    <dgm:pt modelId="{C7391DB6-008B-1045-881A-500864D378BA}">
      <dgm:prSet phldrT="[Text]"/>
      <dgm:spPr/>
      <dgm:t>
        <a:bodyPr/>
        <a:lstStyle/>
        <a:p>
          <a:r>
            <a:rPr lang="en-GB" dirty="0"/>
            <a:t>Design the research project</a:t>
          </a:r>
        </a:p>
      </dgm:t>
    </dgm:pt>
    <dgm:pt modelId="{562F6C85-B65D-2549-AAF4-035CEA65435F}" type="parTrans" cxnId="{45093230-BD9A-454C-A79C-E09623B80812}">
      <dgm:prSet/>
      <dgm:spPr/>
      <dgm:t>
        <a:bodyPr/>
        <a:lstStyle/>
        <a:p>
          <a:endParaRPr lang="en-GB"/>
        </a:p>
      </dgm:t>
    </dgm:pt>
    <dgm:pt modelId="{A0B3E19E-6337-9348-A48D-F00006ABCD61}" type="sibTrans" cxnId="{45093230-BD9A-454C-A79C-E09623B80812}">
      <dgm:prSet/>
      <dgm:spPr/>
      <dgm:t>
        <a:bodyPr/>
        <a:lstStyle/>
        <a:p>
          <a:endParaRPr lang="en-GB"/>
        </a:p>
      </dgm:t>
    </dgm:pt>
    <dgm:pt modelId="{704B344C-9FAD-F04B-A961-D48B354C4D80}">
      <dgm:prSet phldrT="[Text]"/>
      <dgm:spPr/>
      <dgm:t>
        <a:bodyPr/>
        <a:lstStyle/>
        <a:p>
          <a:r>
            <a:rPr lang="en-GB" dirty="0"/>
            <a:t>Manage the research</a:t>
          </a:r>
        </a:p>
      </dgm:t>
    </dgm:pt>
    <dgm:pt modelId="{ACA6BB9A-2BB7-BD46-B3A5-AE2BA0F3B0F5}" type="parTrans" cxnId="{3BA596EF-0C47-E14A-AF30-43E63CBD553B}">
      <dgm:prSet/>
      <dgm:spPr/>
      <dgm:t>
        <a:bodyPr/>
        <a:lstStyle/>
        <a:p>
          <a:endParaRPr lang="en-GB"/>
        </a:p>
      </dgm:t>
    </dgm:pt>
    <dgm:pt modelId="{AA189D3C-72DF-1246-88CA-A852CE1FAC66}" type="sibTrans" cxnId="{3BA596EF-0C47-E14A-AF30-43E63CBD553B}">
      <dgm:prSet/>
      <dgm:spPr/>
      <dgm:t>
        <a:bodyPr/>
        <a:lstStyle/>
        <a:p>
          <a:endParaRPr lang="en-GB"/>
        </a:p>
      </dgm:t>
    </dgm:pt>
    <dgm:pt modelId="{E7CF490F-91DC-F846-A3A6-D3A2EF638F83}">
      <dgm:prSet phldrT="[Text]"/>
      <dgm:spPr/>
      <dgm:t>
        <a:bodyPr/>
        <a:lstStyle/>
        <a:p>
          <a:r>
            <a:rPr lang="en-GB" dirty="0"/>
            <a:t>Conduct the research</a:t>
          </a:r>
        </a:p>
      </dgm:t>
    </dgm:pt>
    <dgm:pt modelId="{2C1E0E50-55FC-4D43-A176-592EBF4A58F3}" type="parTrans" cxnId="{4D2CC224-19EC-BC49-86B7-5D57174F25D1}">
      <dgm:prSet/>
      <dgm:spPr/>
      <dgm:t>
        <a:bodyPr/>
        <a:lstStyle/>
        <a:p>
          <a:endParaRPr lang="en-GB"/>
        </a:p>
      </dgm:t>
    </dgm:pt>
    <dgm:pt modelId="{CAC3CACD-CDE9-AE45-9323-B3BDD4088AF3}" type="sibTrans" cxnId="{4D2CC224-19EC-BC49-86B7-5D57174F25D1}">
      <dgm:prSet/>
      <dgm:spPr/>
      <dgm:t>
        <a:bodyPr/>
        <a:lstStyle/>
        <a:p>
          <a:endParaRPr lang="en-GB"/>
        </a:p>
      </dgm:t>
    </dgm:pt>
    <dgm:pt modelId="{C11BB007-9F54-0348-BE82-3BC62D65DAC5}">
      <dgm:prSet phldrT="[Text]"/>
      <dgm:spPr/>
      <dgm:t>
        <a:bodyPr/>
        <a:lstStyle/>
        <a:p>
          <a:r>
            <a:rPr lang="en-GB" dirty="0"/>
            <a:t>Analyse and interpret findings</a:t>
          </a:r>
        </a:p>
      </dgm:t>
    </dgm:pt>
    <dgm:pt modelId="{65D93766-F6A7-7749-978E-C6718CCB749A}" type="parTrans" cxnId="{4BEA6609-D67E-1041-838E-F482D69CE42A}">
      <dgm:prSet/>
      <dgm:spPr/>
      <dgm:t>
        <a:bodyPr/>
        <a:lstStyle/>
        <a:p>
          <a:endParaRPr lang="en-GB"/>
        </a:p>
      </dgm:t>
    </dgm:pt>
    <dgm:pt modelId="{144BFC2F-3C36-144B-B257-CB4D7B30721D}" type="sibTrans" cxnId="{4BEA6609-D67E-1041-838E-F482D69CE42A}">
      <dgm:prSet/>
      <dgm:spPr/>
      <dgm:t>
        <a:bodyPr/>
        <a:lstStyle/>
        <a:p>
          <a:endParaRPr lang="en-GB"/>
        </a:p>
      </dgm:t>
    </dgm:pt>
    <dgm:pt modelId="{1FA61355-A77C-574C-8C0A-60C0FD4910FD}">
      <dgm:prSet phldrT="[Text]"/>
      <dgm:spPr/>
      <dgm:t>
        <a:bodyPr/>
        <a:lstStyle/>
        <a:p>
          <a:r>
            <a:rPr lang="en-GB" dirty="0"/>
            <a:t>Disseminate</a:t>
          </a:r>
        </a:p>
      </dgm:t>
    </dgm:pt>
    <dgm:pt modelId="{3CA8528F-6AC2-7C4A-812A-4F2767E7EA72}" type="parTrans" cxnId="{FF82827E-E08E-7B42-961F-EFA0AE610155}">
      <dgm:prSet/>
      <dgm:spPr/>
      <dgm:t>
        <a:bodyPr/>
        <a:lstStyle/>
        <a:p>
          <a:endParaRPr lang="en-GB"/>
        </a:p>
      </dgm:t>
    </dgm:pt>
    <dgm:pt modelId="{4A4D2591-61EC-4C41-8583-336875443AD1}" type="sibTrans" cxnId="{FF82827E-E08E-7B42-961F-EFA0AE610155}">
      <dgm:prSet/>
      <dgm:spPr/>
      <dgm:t>
        <a:bodyPr/>
        <a:lstStyle/>
        <a:p>
          <a:endParaRPr lang="en-GB"/>
        </a:p>
      </dgm:t>
    </dgm:pt>
    <dgm:pt modelId="{F8176310-E128-DC4B-B5FB-592CF890C5A7}">
      <dgm:prSet phldrT="[Text]"/>
      <dgm:spPr/>
      <dgm:t>
        <a:bodyPr/>
        <a:lstStyle/>
        <a:p>
          <a:r>
            <a:rPr lang="en-GB" dirty="0"/>
            <a:t>Evaluate</a:t>
          </a:r>
        </a:p>
      </dgm:t>
    </dgm:pt>
    <dgm:pt modelId="{EA2C3E9A-B1C9-F341-AF96-BB86805A44F0}" type="parTrans" cxnId="{DDFF6F67-2AE4-0C44-A5E5-41C1FDCF6778}">
      <dgm:prSet/>
      <dgm:spPr/>
      <dgm:t>
        <a:bodyPr/>
        <a:lstStyle/>
        <a:p>
          <a:endParaRPr lang="en-GB"/>
        </a:p>
      </dgm:t>
    </dgm:pt>
    <dgm:pt modelId="{85582E92-BAC4-2740-ABAC-EC352743D651}" type="sibTrans" cxnId="{DDFF6F67-2AE4-0C44-A5E5-41C1FDCF6778}">
      <dgm:prSet/>
      <dgm:spPr/>
      <dgm:t>
        <a:bodyPr/>
        <a:lstStyle/>
        <a:p>
          <a:endParaRPr lang="en-GB"/>
        </a:p>
      </dgm:t>
    </dgm:pt>
    <dgm:pt modelId="{093022C1-D630-5949-8474-739FBE5D876B}">
      <dgm:prSet phldrT="[Text]"/>
      <dgm:spPr/>
      <dgm:t>
        <a:bodyPr/>
        <a:lstStyle/>
        <a:p>
          <a:r>
            <a:rPr lang="en-GB" dirty="0"/>
            <a:t>Act on findings</a:t>
          </a:r>
        </a:p>
      </dgm:t>
    </dgm:pt>
    <dgm:pt modelId="{854D18CD-80A4-BF47-9C74-F86936DBEEAB}" type="parTrans" cxnId="{4ECDD128-239D-1542-9008-29EEF63A1C3D}">
      <dgm:prSet/>
      <dgm:spPr/>
      <dgm:t>
        <a:bodyPr/>
        <a:lstStyle/>
        <a:p>
          <a:endParaRPr lang="en-GB"/>
        </a:p>
      </dgm:t>
    </dgm:pt>
    <dgm:pt modelId="{EE99D27B-EDEF-EF48-96AC-ECC66E704C2E}" type="sibTrans" cxnId="{4ECDD128-239D-1542-9008-29EEF63A1C3D}">
      <dgm:prSet/>
      <dgm:spPr/>
      <dgm:t>
        <a:bodyPr/>
        <a:lstStyle/>
        <a:p>
          <a:endParaRPr lang="en-GB"/>
        </a:p>
      </dgm:t>
    </dgm:pt>
    <dgm:pt modelId="{BEFCDFDC-31B4-394F-B6DC-AEEEFC84A042}" type="pres">
      <dgm:prSet presAssocID="{A5D9A408-9F42-954E-9533-247B8D2AC1A5}" presName="cycle" presStyleCnt="0">
        <dgm:presLayoutVars>
          <dgm:dir/>
          <dgm:resizeHandles val="exact"/>
        </dgm:presLayoutVars>
      </dgm:prSet>
      <dgm:spPr/>
    </dgm:pt>
    <dgm:pt modelId="{D574BFB6-BEF1-8C4C-8B68-6F0C449AC879}" type="pres">
      <dgm:prSet presAssocID="{A18297FA-39DE-F046-AADF-44A9D6EA28E1}" presName="node" presStyleLbl="node1" presStyleIdx="0" presStyleCnt="9">
        <dgm:presLayoutVars>
          <dgm:bulletEnabled val="1"/>
        </dgm:presLayoutVars>
      </dgm:prSet>
      <dgm:spPr/>
    </dgm:pt>
    <dgm:pt modelId="{04741F94-04F5-944A-AA75-A52B581B08EB}" type="pres">
      <dgm:prSet presAssocID="{A18297FA-39DE-F046-AADF-44A9D6EA28E1}" presName="spNode" presStyleCnt="0"/>
      <dgm:spPr/>
    </dgm:pt>
    <dgm:pt modelId="{898433E3-2070-1F49-9809-E8CFFC177272}" type="pres">
      <dgm:prSet presAssocID="{43E137FF-92F4-4E41-B79D-52D977D6C099}" presName="sibTrans" presStyleLbl="sibTrans1D1" presStyleIdx="0" presStyleCnt="9"/>
      <dgm:spPr/>
    </dgm:pt>
    <dgm:pt modelId="{5F7A9264-01C6-C443-BFDE-FEF35C937F56}" type="pres">
      <dgm:prSet presAssocID="{775F3146-D841-DF44-A9BA-A58935E33788}" presName="node" presStyleLbl="node1" presStyleIdx="1" presStyleCnt="9">
        <dgm:presLayoutVars>
          <dgm:bulletEnabled val="1"/>
        </dgm:presLayoutVars>
      </dgm:prSet>
      <dgm:spPr/>
    </dgm:pt>
    <dgm:pt modelId="{B3EC3292-64F5-8642-B0CA-3A2250C83DEF}" type="pres">
      <dgm:prSet presAssocID="{775F3146-D841-DF44-A9BA-A58935E33788}" presName="spNode" presStyleCnt="0"/>
      <dgm:spPr/>
    </dgm:pt>
    <dgm:pt modelId="{B371DBB0-DEDB-914B-9AFF-7586E37A0CF6}" type="pres">
      <dgm:prSet presAssocID="{3C05C41F-A01D-3F41-85A5-42ACD3217FE0}" presName="sibTrans" presStyleLbl="sibTrans1D1" presStyleIdx="1" presStyleCnt="9"/>
      <dgm:spPr/>
    </dgm:pt>
    <dgm:pt modelId="{F039F0EB-D869-DF43-8B8E-C29408B796EB}" type="pres">
      <dgm:prSet presAssocID="{C7391DB6-008B-1045-881A-500864D378BA}" presName="node" presStyleLbl="node1" presStyleIdx="2" presStyleCnt="9">
        <dgm:presLayoutVars>
          <dgm:bulletEnabled val="1"/>
        </dgm:presLayoutVars>
      </dgm:prSet>
      <dgm:spPr/>
    </dgm:pt>
    <dgm:pt modelId="{681DBF75-0482-0B49-8C5C-FDCCB455E790}" type="pres">
      <dgm:prSet presAssocID="{C7391DB6-008B-1045-881A-500864D378BA}" presName="spNode" presStyleCnt="0"/>
      <dgm:spPr/>
    </dgm:pt>
    <dgm:pt modelId="{50EE490F-4F8E-9049-B615-10D6612BF852}" type="pres">
      <dgm:prSet presAssocID="{A0B3E19E-6337-9348-A48D-F00006ABCD61}" presName="sibTrans" presStyleLbl="sibTrans1D1" presStyleIdx="2" presStyleCnt="9"/>
      <dgm:spPr/>
    </dgm:pt>
    <dgm:pt modelId="{97452FB2-9725-6644-8F45-8091549EC3C6}" type="pres">
      <dgm:prSet presAssocID="{704B344C-9FAD-F04B-A961-D48B354C4D80}" presName="node" presStyleLbl="node1" presStyleIdx="3" presStyleCnt="9">
        <dgm:presLayoutVars>
          <dgm:bulletEnabled val="1"/>
        </dgm:presLayoutVars>
      </dgm:prSet>
      <dgm:spPr/>
    </dgm:pt>
    <dgm:pt modelId="{FE758242-03FB-CF43-80AD-996A0610A9E1}" type="pres">
      <dgm:prSet presAssocID="{704B344C-9FAD-F04B-A961-D48B354C4D80}" presName="spNode" presStyleCnt="0"/>
      <dgm:spPr/>
    </dgm:pt>
    <dgm:pt modelId="{454A1872-84E1-A440-9E23-9BA8B373C188}" type="pres">
      <dgm:prSet presAssocID="{AA189D3C-72DF-1246-88CA-A852CE1FAC66}" presName="sibTrans" presStyleLbl="sibTrans1D1" presStyleIdx="3" presStyleCnt="9"/>
      <dgm:spPr/>
    </dgm:pt>
    <dgm:pt modelId="{2EAB5438-31E8-064A-A4B0-3F2DE2B6D4E6}" type="pres">
      <dgm:prSet presAssocID="{E7CF490F-91DC-F846-A3A6-D3A2EF638F83}" presName="node" presStyleLbl="node1" presStyleIdx="4" presStyleCnt="9">
        <dgm:presLayoutVars>
          <dgm:bulletEnabled val="1"/>
        </dgm:presLayoutVars>
      </dgm:prSet>
      <dgm:spPr/>
    </dgm:pt>
    <dgm:pt modelId="{A56C7289-B605-8C48-A7ED-788D64A3C1B3}" type="pres">
      <dgm:prSet presAssocID="{E7CF490F-91DC-F846-A3A6-D3A2EF638F83}" presName="spNode" presStyleCnt="0"/>
      <dgm:spPr/>
    </dgm:pt>
    <dgm:pt modelId="{592DEB87-05BA-314E-9E5D-A0994FBB9BE7}" type="pres">
      <dgm:prSet presAssocID="{CAC3CACD-CDE9-AE45-9323-B3BDD4088AF3}" presName="sibTrans" presStyleLbl="sibTrans1D1" presStyleIdx="4" presStyleCnt="9"/>
      <dgm:spPr/>
    </dgm:pt>
    <dgm:pt modelId="{B61B4333-12E9-EA4E-96BE-541075F519B1}" type="pres">
      <dgm:prSet presAssocID="{C11BB007-9F54-0348-BE82-3BC62D65DAC5}" presName="node" presStyleLbl="node1" presStyleIdx="5" presStyleCnt="9">
        <dgm:presLayoutVars>
          <dgm:bulletEnabled val="1"/>
        </dgm:presLayoutVars>
      </dgm:prSet>
      <dgm:spPr/>
    </dgm:pt>
    <dgm:pt modelId="{1999164E-B41C-E748-984D-D95DF71999F3}" type="pres">
      <dgm:prSet presAssocID="{C11BB007-9F54-0348-BE82-3BC62D65DAC5}" presName="spNode" presStyleCnt="0"/>
      <dgm:spPr/>
    </dgm:pt>
    <dgm:pt modelId="{1DCD3E9D-C78C-A144-B7E8-BE98F083AEB6}" type="pres">
      <dgm:prSet presAssocID="{144BFC2F-3C36-144B-B257-CB4D7B30721D}" presName="sibTrans" presStyleLbl="sibTrans1D1" presStyleIdx="5" presStyleCnt="9"/>
      <dgm:spPr/>
    </dgm:pt>
    <dgm:pt modelId="{18BCA952-D167-F945-8867-AD4C9D2398AB}" type="pres">
      <dgm:prSet presAssocID="{1FA61355-A77C-574C-8C0A-60C0FD4910FD}" presName="node" presStyleLbl="node1" presStyleIdx="6" presStyleCnt="9">
        <dgm:presLayoutVars>
          <dgm:bulletEnabled val="1"/>
        </dgm:presLayoutVars>
      </dgm:prSet>
      <dgm:spPr/>
    </dgm:pt>
    <dgm:pt modelId="{B4417D4B-F281-1143-84C1-686D272378B4}" type="pres">
      <dgm:prSet presAssocID="{1FA61355-A77C-574C-8C0A-60C0FD4910FD}" presName="spNode" presStyleCnt="0"/>
      <dgm:spPr/>
    </dgm:pt>
    <dgm:pt modelId="{B9ABB65A-E4F9-2446-9DC0-16FA01C2810E}" type="pres">
      <dgm:prSet presAssocID="{4A4D2591-61EC-4C41-8583-336875443AD1}" presName="sibTrans" presStyleLbl="sibTrans1D1" presStyleIdx="6" presStyleCnt="9"/>
      <dgm:spPr/>
    </dgm:pt>
    <dgm:pt modelId="{BBB9B9B7-392F-044F-9D6F-255404CF4C1D}" type="pres">
      <dgm:prSet presAssocID="{F8176310-E128-DC4B-B5FB-592CF890C5A7}" presName="node" presStyleLbl="node1" presStyleIdx="7" presStyleCnt="9">
        <dgm:presLayoutVars>
          <dgm:bulletEnabled val="1"/>
        </dgm:presLayoutVars>
      </dgm:prSet>
      <dgm:spPr/>
    </dgm:pt>
    <dgm:pt modelId="{82579739-B1E5-3A4D-916A-92CDD6F5EEAF}" type="pres">
      <dgm:prSet presAssocID="{F8176310-E128-DC4B-B5FB-592CF890C5A7}" presName="spNode" presStyleCnt="0"/>
      <dgm:spPr/>
    </dgm:pt>
    <dgm:pt modelId="{24E638AC-505A-804E-9219-145CB4495339}" type="pres">
      <dgm:prSet presAssocID="{85582E92-BAC4-2740-ABAC-EC352743D651}" presName="sibTrans" presStyleLbl="sibTrans1D1" presStyleIdx="7" presStyleCnt="9"/>
      <dgm:spPr/>
    </dgm:pt>
    <dgm:pt modelId="{99EB3913-8B6E-E34E-9628-DAC25591E971}" type="pres">
      <dgm:prSet presAssocID="{093022C1-D630-5949-8474-739FBE5D876B}" presName="node" presStyleLbl="node1" presStyleIdx="8" presStyleCnt="9">
        <dgm:presLayoutVars>
          <dgm:bulletEnabled val="1"/>
        </dgm:presLayoutVars>
      </dgm:prSet>
      <dgm:spPr/>
    </dgm:pt>
    <dgm:pt modelId="{AA8F755A-9E3C-FE40-B5A1-AF38A3824191}" type="pres">
      <dgm:prSet presAssocID="{093022C1-D630-5949-8474-739FBE5D876B}" presName="spNode" presStyleCnt="0"/>
      <dgm:spPr/>
    </dgm:pt>
    <dgm:pt modelId="{D8F8ADA8-351A-B544-A873-AEA3C0755809}" type="pres">
      <dgm:prSet presAssocID="{EE99D27B-EDEF-EF48-96AC-ECC66E704C2E}" presName="sibTrans" presStyleLbl="sibTrans1D1" presStyleIdx="8" presStyleCnt="9"/>
      <dgm:spPr/>
    </dgm:pt>
  </dgm:ptLst>
  <dgm:cxnLst>
    <dgm:cxn modelId="{EC4F9300-DE6A-EB4B-9CE3-571589414EBE}" type="presOf" srcId="{CAC3CACD-CDE9-AE45-9323-B3BDD4088AF3}" destId="{592DEB87-05BA-314E-9E5D-A0994FBB9BE7}" srcOrd="0" destOrd="0" presId="urn:microsoft.com/office/officeart/2005/8/layout/cycle5"/>
    <dgm:cxn modelId="{4BEA6609-D67E-1041-838E-F482D69CE42A}" srcId="{A5D9A408-9F42-954E-9533-247B8D2AC1A5}" destId="{C11BB007-9F54-0348-BE82-3BC62D65DAC5}" srcOrd="5" destOrd="0" parTransId="{65D93766-F6A7-7749-978E-C6718CCB749A}" sibTransId="{144BFC2F-3C36-144B-B257-CB4D7B30721D}"/>
    <dgm:cxn modelId="{590BAB09-0784-1A42-8B0A-2AD21B2EE8E6}" type="presOf" srcId="{704B344C-9FAD-F04B-A961-D48B354C4D80}" destId="{97452FB2-9725-6644-8F45-8091549EC3C6}" srcOrd="0" destOrd="0" presId="urn:microsoft.com/office/officeart/2005/8/layout/cycle5"/>
    <dgm:cxn modelId="{235ABD10-7E44-684C-B18B-B7F5CCBE7FC3}" type="presOf" srcId="{A0B3E19E-6337-9348-A48D-F00006ABCD61}" destId="{50EE490F-4F8E-9049-B615-10D6612BF852}" srcOrd="0" destOrd="0" presId="urn:microsoft.com/office/officeart/2005/8/layout/cycle5"/>
    <dgm:cxn modelId="{C3235C1A-47E1-FA40-8900-8EDB3093E471}" type="presOf" srcId="{43E137FF-92F4-4E41-B79D-52D977D6C099}" destId="{898433E3-2070-1F49-9809-E8CFFC177272}" srcOrd="0" destOrd="0" presId="urn:microsoft.com/office/officeart/2005/8/layout/cycle5"/>
    <dgm:cxn modelId="{55F5301B-1D94-CB4C-90D1-AB09AF8E4255}" type="presOf" srcId="{775F3146-D841-DF44-A9BA-A58935E33788}" destId="{5F7A9264-01C6-C443-BFDE-FEF35C937F56}" srcOrd="0" destOrd="0" presId="urn:microsoft.com/office/officeart/2005/8/layout/cycle5"/>
    <dgm:cxn modelId="{4D2CC224-19EC-BC49-86B7-5D57174F25D1}" srcId="{A5D9A408-9F42-954E-9533-247B8D2AC1A5}" destId="{E7CF490F-91DC-F846-A3A6-D3A2EF638F83}" srcOrd="4" destOrd="0" parTransId="{2C1E0E50-55FC-4D43-A176-592EBF4A58F3}" sibTransId="{CAC3CACD-CDE9-AE45-9323-B3BDD4088AF3}"/>
    <dgm:cxn modelId="{4ECDD128-239D-1542-9008-29EEF63A1C3D}" srcId="{A5D9A408-9F42-954E-9533-247B8D2AC1A5}" destId="{093022C1-D630-5949-8474-739FBE5D876B}" srcOrd="8" destOrd="0" parTransId="{854D18CD-80A4-BF47-9C74-F86936DBEEAB}" sibTransId="{EE99D27B-EDEF-EF48-96AC-ECC66E704C2E}"/>
    <dgm:cxn modelId="{45093230-BD9A-454C-A79C-E09623B80812}" srcId="{A5D9A408-9F42-954E-9533-247B8D2AC1A5}" destId="{C7391DB6-008B-1045-881A-500864D378BA}" srcOrd="2" destOrd="0" parTransId="{562F6C85-B65D-2549-AAF4-035CEA65435F}" sibTransId="{A0B3E19E-6337-9348-A48D-F00006ABCD61}"/>
    <dgm:cxn modelId="{570B5A36-FEE3-E040-8E3F-8DB65D2E5276}" type="presOf" srcId="{85582E92-BAC4-2740-ABAC-EC352743D651}" destId="{24E638AC-505A-804E-9219-145CB4495339}" srcOrd="0" destOrd="0" presId="urn:microsoft.com/office/officeart/2005/8/layout/cycle5"/>
    <dgm:cxn modelId="{0D3DBC3B-F96A-654A-A7CB-E13CFCE3ED08}" type="presOf" srcId="{AA189D3C-72DF-1246-88CA-A852CE1FAC66}" destId="{454A1872-84E1-A440-9E23-9BA8B373C188}" srcOrd="0" destOrd="0" presId="urn:microsoft.com/office/officeart/2005/8/layout/cycle5"/>
    <dgm:cxn modelId="{03EC9040-9411-2E48-8632-A9F18DE09AA9}" type="presOf" srcId="{3C05C41F-A01D-3F41-85A5-42ACD3217FE0}" destId="{B371DBB0-DEDB-914B-9AFF-7586E37A0CF6}" srcOrd="0" destOrd="0" presId="urn:microsoft.com/office/officeart/2005/8/layout/cycle5"/>
    <dgm:cxn modelId="{4EDBB645-F288-6749-8846-4F1E2D82303C}" type="presOf" srcId="{A5D9A408-9F42-954E-9533-247B8D2AC1A5}" destId="{BEFCDFDC-31B4-394F-B6DC-AEEEFC84A042}" srcOrd="0" destOrd="0" presId="urn:microsoft.com/office/officeart/2005/8/layout/cycle5"/>
    <dgm:cxn modelId="{DDFF6F67-2AE4-0C44-A5E5-41C1FDCF6778}" srcId="{A5D9A408-9F42-954E-9533-247B8D2AC1A5}" destId="{F8176310-E128-DC4B-B5FB-592CF890C5A7}" srcOrd="7" destOrd="0" parTransId="{EA2C3E9A-B1C9-F341-AF96-BB86805A44F0}" sibTransId="{85582E92-BAC4-2740-ABAC-EC352743D651}"/>
    <dgm:cxn modelId="{577F466A-3450-D24C-A92E-27B956327618}" srcId="{A5D9A408-9F42-954E-9533-247B8D2AC1A5}" destId="{775F3146-D841-DF44-A9BA-A58935E33788}" srcOrd="1" destOrd="0" parTransId="{715EE54C-716B-EE47-BAD7-4871A08663CD}" sibTransId="{3C05C41F-A01D-3F41-85A5-42ACD3217FE0}"/>
    <dgm:cxn modelId="{6ACE664C-C2A0-004F-9BFF-41B5ADA46048}" srcId="{A5D9A408-9F42-954E-9533-247B8D2AC1A5}" destId="{A18297FA-39DE-F046-AADF-44A9D6EA28E1}" srcOrd="0" destOrd="0" parTransId="{4C3D318C-7550-6A46-9DC2-1DC50BBD345B}" sibTransId="{43E137FF-92F4-4E41-B79D-52D977D6C099}"/>
    <dgm:cxn modelId="{EC6F6771-4F32-A54B-BC29-B3FD92F3BF40}" type="presOf" srcId="{EE99D27B-EDEF-EF48-96AC-ECC66E704C2E}" destId="{D8F8ADA8-351A-B544-A873-AEA3C0755809}" srcOrd="0" destOrd="0" presId="urn:microsoft.com/office/officeart/2005/8/layout/cycle5"/>
    <dgm:cxn modelId="{7FB57878-7494-ED45-95EC-5714925AFF27}" type="presOf" srcId="{C11BB007-9F54-0348-BE82-3BC62D65DAC5}" destId="{B61B4333-12E9-EA4E-96BE-541075F519B1}" srcOrd="0" destOrd="0" presId="urn:microsoft.com/office/officeart/2005/8/layout/cycle5"/>
    <dgm:cxn modelId="{09616E7B-CB8C-9044-8314-4A92E123C0CE}" type="presOf" srcId="{E7CF490F-91DC-F846-A3A6-D3A2EF638F83}" destId="{2EAB5438-31E8-064A-A4B0-3F2DE2B6D4E6}" srcOrd="0" destOrd="0" presId="urn:microsoft.com/office/officeart/2005/8/layout/cycle5"/>
    <dgm:cxn modelId="{FF82827E-E08E-7B42-961F-EFA0AE610155}" srcId="{A5D9A408-9F42-954E-9533-247B8D2AC1A5}" destId="{1FA61355-A77C-574C-8C0A-60C0FD4910FD}" srcOrd="6" destOrd="0" parTransId="{3CA8528F-6AC2-7C4A-812A-4F2767E7EA72}" sibTransId="{4A4D2591-61EC-4C41-8583-336875443AD1}"/>
    <dgm:cxn modelId="{3F85B383-5260-3840-9860-14B4EACF1AA9}" type="presOf" srcId="{093022C1-D630-5949-8474-739FBE5D876B}" destId="{99EB3913-8B6E-E34E-9628-DAC25591E971}" srcOrd="0" destOrd="0" presId="urn:microsoft.com/office/officeart/2005/8/layout/cycle5"/>
    <dgm:cxn modelId="{9E4E8585-0343-334B-9109-C295C9E11DBC}" type="presOf" srcId="{A18297FA-39DE-F046-AADF-44A9D6EA28E1}" destId="{D574BFB6-BEF1-8C4C-8B68-6F0C449AC879}" srcOrd="0" destOrd="0" presId="urn:microsoft.com/office/officeart/2005/8/layout/cycle5"/>
    <dgm:cxn modelId="{DD132989-162D-104F-A1D1-FB88A665DF31}" type="presOf" srcId="{1FA61355-A77C-574C-8C0A-60C0FD4910FD}" destId="{18BCA952-D167-F945-8867-AD4C9D2398AB}" srcOrd="0" destOrd="0" presId="urn:microsoft.com/office/officeart/2005/8/layout/cycle5"/>
    <dgm:cxn modelId="{10E35E9C-FA10-4E4E-9AA0-1B05F950A98D}" type="presOf" srcId="{4A4D2591-61EC-4C41-8583-336875443AD1}" destId="{B9ABB65A-E4F9-2446-9DC0-16FA01C2810E}" srcOrd="0" destOrd="0" presId="urn:microsoft.com/office/officeart/2005/8/layout/cycle5"/>
    <dgm:cxn modelId="{4B9903EC-829D-E94C-BE8F-83F86D15CC89}" type="presOf" srcId="{144BFC2F-3C36-144B-B257-CB4D7B30721D}" destId="{1DCD3E9D-C78C-A144-B7E8-BE98F083AEB6}" srcOrd="0" destOrd="0" presId="urn:microsoft.com/office/officeart/2005/8/layout/cycle5"/>
    <dgm:cxn modelId="{3BA596EF-0C47-E14A-AF30-43E63CBD553B}" srcId="{A5D9A408-9F42-954E-9533-247B8D2AC1A5}" destId="{704B344C-9FAD-F04B-A961-D48B354C4D80}" srcOrd="3" destOrd="0" parTransId="{ACA6BB9A-2BB7-BD46-B3A5-AE2BA0F3B0F5}" sibTransId="{AA189D3C-72DF-1246-88CA-A852CE1FAC66}"/>
    <dgm:cxn modelId="{987088F0-0B28-8246-8B89-01F276488EBF}" type="presOf" srcId="{F8176310-E128-DC4B-B5FB-592CF890C5A7}" destId="{BBB9B9B7-392F-044F-9D6F-255404CF4C1D}" srcOrd="0" destOrd="0" presId="urn:microsoft.com/office/officeart/2005/8/layout/cycle5"/>
    <dgm:cxn modelId="{7BDA0FF6-33EF-FB4C-B9E1-F3DEF1E45A91}" type="presOf" srcId="{C7391DB6-008B-1045-881A-500864D378BA}" destId="{F039F0EB-D869-DF43-8B8E-C29408B796EB}" srcOrd="0" destOrd="0" presId="urn:microsoft.com/office/officeart/2005/8/layout/cycle5"/>
    <dgm:cxn modelId="{1831DE0A-E8BD-D04A-9A5E-ECBC57F727CF}" type="presParOf" srcId="{BEFCDFDC-31B4-394F-B6DC-AEEEFC84A042}" destId="{D574BFB6-BEF1-8C4C-8B68-6F0C449AC879}" srcOrd="0" destOrd="0" presId="urn:microsoft.com/office/officeart/2005/8/layout/cycle5"/>
    <dgm:cxn modelId="{82411476-1682-2E40-9D93-6A28D00DAC6D}" type="presParOf" srcId="{BEFCDFDC-31B4-394F-B6DC-AEEEFC84A042}" destId="{04741F94-04F5-944A-AA75-A52B581B08EB}" srcOrd="1" destOrd="0" presId="urn:microsoft.com/office/officeart/2005/8/layout/cycle5"/>
    <dgm:cxn modelId="{9EFADA66-8FDA-C248-9D2C-AF28220955AF}" type="presParOf" srcId="{BEFCDFDC-31B4-394F-B6DC-AEEEFC84A042}" destId="{898433E3-2070-1F49-9809-E8CFFC177272}" srcOrd="2" destOrd="0" presId="urn:microsoft.com/office/officeart/2005/8/layout/cycle5"/>
    <dgm:cxn modelId="{4EF40AE6-40E9-244B-96D9-377521C40AC8}" type="presParOf" srcId="{BEFCDFDC-31B4-394F-B6DC-AEEEFC84A042}" destId="{5F7A9264-01C6-C443-BFDE-FEF35C937F56}" srcOrd="3" destOrd="0" presId="urn:microsoft.com/office/officeart/2005/8/layout/cycle5"/>
    <dgm:cxn modelId="{775197DB-F50D-F345-B9EA-68D620D60F1F}" type="presParOf" srcId="{BEFCDFDC-31B4-394F-B6DC-AEEEFC84A042}" destId="{B3EC3292-64F5-8642-B0CA-3A2250C83DEF}" srcOrd="4" destOrd="0" presId="urn:microsoft.com/office/officeart/2005/8/layout/cycle5"/>
    <dgm:cxn modelId="{BC4443C3-E50D-1541-B20A-A5EEDB7B6824}" type="presParOf" srcId="{BEFCDFDC-31B4-394F-B6DC-AEEEFC84A042}" destId="{B371DBB0-DEDB-914B-9AFF-7586E37A0CF6}" srcOrd="5" destOrd="0" presId="urn:microsoft.com/office/officeart/2005/8/layout/cycle5"/>
    <dgm:cxn modelId="{CBAC1E2B-FF68-A443-8D4D-0D400DEB757F}" type="presParOf" srcId="{BEFCDFDC-31B4-394F-B6DC-AEEEFC84A042}" destId="{F039F0EB-D869-DF43-8B8E-C29408B796EB}" srcOrd="6" destOrd="0" presId="urn:microsoft.com/office/officeart/2005/8/layout/cycle5"/>
    <dgm:cxn modelId="{42A54530-49F4-4C4C-95BA-59015D6999AF}" type="presParOf" srcId="{BEFCDFDC-31B4-394F-B6DC-AEEEFC84A042}" destId="{681DBF75-0482-0B49-8C5C-FDCCB455E790}" srcOrd="7" destOrd="0" presId="urn:microsoft.com/office/officeart/2005/8/layout/cycle5"/>
    <dgm:cxn modelId="{73690491-E452-6B48-949A-19100563189D}" type="presParOf" srcId="{BEFCDFDC-31B4-394F-B6DC-AEEEFC84A042}" destId="{50EE490F-4F8E-9049-B615-10D6612BF852}" srcOrd="8" destOrd="0" presId="urn:microsoft.com/office/officeart/2005/8/layout/cycle5"/>
    <dgm:cxn modelId="{8AFEE76F-FCC5-8548-9FA7-5811512060D3}" type="presParOf" srcId="{BEFCDFDC-31B4-394F-B6DC-AEEEFC84A042}" destId="{97452FB2-9725-6644-8F45-8091549EC3C6}" srcOrd="9" destOrd="0" presId="urn:microsoft.com/office/officeart/2005/8/layout/cycle5"/>
    <dgm:cxn modelId="{7C90763D-4629-3640-B572-896CE5C4841C}" type="presParOf" srcId="{BEFCDFDC-31B4-394F-B6DC-AEEEFC84A042}" destId="{FE758242-03FB-CF43-80AD-996A0610A9E1}" srcOrd="10" destOrd="0" presId="urn:microsoft.com/office/officeart/2005/8/layout/cycle5"/>
    <dgm:cxn modelId="{B5C6B902-3EFC-BE47-AD1C-90F92ABEA431}" type="presParOf" srcId="{BEFCDFDC-31B4-394F-B6DC-AEEEFC84A042}" destId="{454A1872-84E1-A440-9E23-9BA8B373C188}" srcOrd="11" destOrd="0" presId="urn:microsoft.com/office/officeart/2005/8/layout/cycle5"/>
    <dgm:cxn modelId="{78DF2DCB-5BE8-924C-BEBB-BFB554781215}" type="presParOf" srcId="{BEFCDFDC-31B4-394F-B6DC-AEEEFC84A042}" destId="{2EAB5438-31E8-064A-A4B0-3F2DE2B6D4E6}" srcOrd="12" destOrd="0" presId="urn:microsoft.com/office/officeart/2005/8/layout/cycle5"/>
    <dgm:cxn modelId="{2A748B38-0F02-4C47-A7FC-FF91DBE6CE5A}" type="presParOf" srcId="{BEFCDFDC-31B4-394F-B6DC-AEEEFC84A042}" destId="{A56C7289-B605-8C48-A7ED-788D64A3C1B3}" srcOrd="13" destOrd="0" presId="urn:microsoft.com/office/officeart/2005/8/layout/cycle5"/>
    <dgm:cxn modelId="{B1B9F60A-AF58-5647-8B81-5B55AFC50257}" type="presParOf" srcId="{BEFCDFDC-31B4-394F-B6DC-AEEEFC84A042}" destId="{592DEB87-05BA-314E-9E5D-A0994FBB9BE7}" srcOrd="14" destOrd="0" presId="urn:microsoft.com/office/officeart/2005/8/layout/cycle5"/>
    <dgm:cxn modelId="{B8D6194E-3E1D-404E-948F-E125F159BCFE}" type="presParOf" srcId="{BEFCDFDC-31B4-394F-B6DC-AEEEFC84A042}" destId="{B61B4333-12E9-EA4E-96BE-541075F519B1}" srcOrd="15" destOrd="0" presId="urn:microsoft.com/office/officeart/2005/8/layout/cycle5"/>
    <dgm:cxn modelId="{AA57E3D1-7870-BE4D-AF16-DE0BA18C1593}" type="presParOf" srcId="{BEFCDFDC-31B4-394F-B6DC-AEEEFC84A042}" destId="{1999164E-B41C-E748-984D-D95DF71999F3}" srcOrd="16" destOrd="0" presId="urn:microsoft.com/office/officeart/2005/8/layout/cycle5"/>
    <dgm:cxn modelId="{5A04BEA7-6011-484E-A897-D17743D411E5}" type="presParOf" srcId="{BEFCDFDC-31B4-394F-B6DC-AEEEFC84A042}" destId="{1DCD3E9D-C78C-A144-B7E8-BE98F083AEB6}" srcOrd="17" destOrd="0" presId="urn:microsoft.com/office/officeart/2005/8/layout/cycle5"/>
    <dgm:cxn modelId="{532DBB0A-E9F4-6F47-8546-D0F2AEE952AF}" type="presParOf" srcId="{BEFCDFDC-31B4-394F-B6DC-AEEEFC84A042}" destId="{18BCA952-D167-F945-8867-AD4C9D2398AB}" srcOrd="18" destOrd="0" presId="urn:microsoft.com/office/officeart/2005/8/layout/cycle5"/>
    <dgm:cxn modelId="{98CCD086-05EB-0F44-BD12-3121E72B74B0}" type="presParOf" srcId="{BEFCDFDC-31B4-394F-B6DC-AEEEFC84A042}" destId="{B4417D4B-F281-1143-84C1-686D272378B4}" srcOrd="19" destOrd="0" presId="urn:microsoft.com/office/officeart/2005/8/layout/cycle5"/>
    <dgm:cxn modelId="{A1546A76-203A-F547-A33D-8E2280C08198}" type="presParOf" srcId="{BEFCDFDC-31B4-394F-B6DC-AEEEFC84A042}" destId="{B9ABB65A-E4F9-2446-9DC0-16FA01C2810E}" srcOrd="20" destOrd="0" presId="urn:microsoft.com/office/officeart/2005/8/layout/cycle5"/>
    <dgm:cxn modelId="{45B031A7-FF07-4F40-AB00-2F7C6074BD30}" type="presParOf" srcId="{BEFCDFDC-31B4-394F-B6DC-AEEEFC84A042}" destId="{BBB9B9B7-392F-044F-9D6F-255404CF4C1D}" srcOrd="21" destOrd="0" presId="urn:microsoft.com/office/officeart/2005/8/layout/cycle5"/>
    <dgm:cxn modelId="{68C44E0C-0A9E-4348-B3D7-1EC71869C7D2}" type="presParOf" srcId="{BEFCDFDC-31B4-394F-B6DC-AEEEFC84A042}" destId="{82579739-B1E5-3A4D-916A-92CDD6F5EEAF}" srcOrd="22" destOrd="0" presId="urn:microsoft.com/office/officeart/2005/8/layout/cycle5"/>
    <dgm:cxn modelId="{E05515A9-7339-B14A-A56E-A596F2403275}" type="presParOf" srcId="{BEFCDFDC-31B4-394F-B6DC-AEEEFC84A042}" destId="{24E638AC-505A-804E-9219-145CB4495339}" srcOrd="23" destOrd="0" presId="urn:microsoft.com/office/officeart/2005/8/layout/cycle5"/>
    <dgm:cxn modelId="{339B0992-B7BC-8845-A86F-37B19FF16ADC}" type="presParOf" srcId="{BEFCDFDC-31B4-394F-B6DC-AEEEFC84A042}" destId="{99EB3913-8B6E-E34E-9628-DAC25591E971}" srcOrd="24" destOrd="0" presId="urn:microsoft.com/office/officeart/2005/8/layout/cycle5"/>
    <dgm:cxn modelId="{DE516299-D6DA-D948-B7D2-5954CEC1DB28}" type="presParOf" srcId="{BEFCDFDC-31B4-394F-B6DC-AEEEFC84A042}" destId="{AA8F755A-9E3C-FE40-B5A1-AF38A3824191}" srcOrd="25" destOrd="0" presId="urn:microsoft.com/office/officeart/2005/8/layout/cycle5"/>
    <dgm:cxn modelId="{42A4CD3D-362C-424B-8D14-6831D8DE3C71}" type="presParOf" srcId="{BEFCDFDC-31B4-394F-B6DC-AEEEFC84A042}" destId="{D8F8ADA8-351A-B544-A873-AEA3C0755809}" srcOrd="26" destOrd="0" presId="urn:microsoft.com/office/officeart/2005/8/layout/cycle5"/>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A5D9A408-9F42-954E-9533-247B8D2AC1A5}" type="doc">
      <dgm:prSet loTypeId="urn:microsoft.com/office/officeart/2005/8/layout/cycle5" loCatId="" qsTypeId="urn:microsoft.com/office/officeart/2005/8/quickstyle/simple1" qsCatId="simple" csTypeId="urn:microsoft.com/office/officeart/2005/8/colors/accent1_2" csCatId="accent1" phldr="1"/>
      <dgm:spPr/>
      <dgm:t>
        <a:bodyPr/>
        <a:lstStyle/>
        <a:p>
          <a:endParaRPr lang="en-GB"/>
        </a:p>
      </dgm:t>
    </dgm:pt>
    <dgm:pt modelId="{A18297FA-39DE-F046-AADF-44A9D6EA28E1}">
      <dgm:prSet phldrT="[Text]"/>
      <dgm:spPr/>
      <dgm:t>
        <a:bodyPr/>
        <a:lstStyle/>
        <a:p>
          <a:r>
            <a:rPr lang="en-GB" dirty="0"/>
            <a:t>Identify the topic</a:t>
          </a:r>
        </a:p>
      </dgm:t>
    </dgm:pt>
    <dgm:pt modelId="{4C3D318C-7550-6A46-9DC2-1DC50BBD345B}" type="parTrans" cxnId="{6ACE664C-C2A0-004F-9BFF-41B5ADA46048}">
      <dgm:prSet/>
      <dgm:spPr/>
      <dgm:t>
        <a:bodyPr/>
        <a:lstStyle/>
        <a:p>
          <a:endParaRPr lang="en-GB"/>
        </a:p>
      </dgm:t>
    </dgm:pt>
    <dgm:pt modelId="{43E137FF-92F4-4E41-B79D-52D977D6C099}" type="sibTrans" cxnId="{6ACE664C-C2A0-004F-9BFF-41B5ADA46048}">
      <dgm:prSet/>
      <dgm:spPr/>
      <dgm:t>
        <a:bodyPr/>
        <a:lstStyle/>
        <a:p>
          <a:endParaRPr lang="en-GB"/>
        </a:p>
      </dgm:t>
    </dgm:pt>
    <dgm:pt modelId="{775F3146-D841-DF44-A9BA-A58935E33788}">
      <dgm:prSet phldrT="[Text]"/>
      <dgm:spPr/>
      <dgm:t>
        <a:bodyPr/>
        <a:lstStyle/>
        <a:p>
          <a:r>
            <a:rPr lang="en-GB" dirty="0"/>
            <a:t>Seek funding</a:t>
          </a:r>
        </a:p>
      </dgm:t>
    </dgm:pt>
    <dgm:pt modelId="{715EE54C-716B-EE47-BAD7-4871A08663CD}" type="parTrans" cxnId="{577F466A-3450-D24C-A92E-27B956327618}">
      <dgm:prSet/>
      <dgm:spPr/>
      <dgm:t>
        <a:bodyPr/>
        <a:lstStyle/>
        <a:p>
          <a:endParaRPr lang="en-GB"/>
        </a:p>
      </dgm:t>
    </dgm:pt>
    <dgm:pt modelId="{3C05C41F-A01D-3F41-85A5-42ACD3217FE0}" type="sibTrans" cxnId="{577F466A-3450-D24C-A92E-27B956327618}">
      <dgm:prSet/>
      <dgm:spPr/>
      <dgm:t>
        <a:bodyPr/>
        <a:lstStyle/>
        <a:p>
          <a:endParaRPr lang="en-GB"/>
        </a:p>
      </dgm:t>
    </dgm:pt>
    <dgm:pt modelId="{C7391DB6-008B-1045-881A-500864D378BA}">
      <dgm:prSet phldrT="[Text]"/>
      <dgm:spPr/>
      <dgm:t>
        <a:bodyPr/>
        <a:lstStyle/>
        <a:p>
          <a:r>
            <a:rPr lang="en-GB" dirty="0"/>
            <a:t>Design the research project</a:t>
          </a:r>
        </a:p>
      </dgm:t>
    </dgm:pt>
    <dgm:pt modelId="{562F6C85-B65D-2549-AAF4-035CEA65435F}" type="parTrans" cxnId="{45093230-BD9A-454C-A79C-E09623B80812}">
      <dgm:prSet/>
      <dgm:spPr/>
      <dgm:t>
        <a:bodyPr/>
        <a:lstStyle/>
        <a:p>
          <a:endParaRPr lang="en-GB"/>
        </a:p>
      </dgm:t>
    </dgm:pt>
    <dgm:pt modelId="{A0B3E19E-6337-9348-A48D-F00006ABCD61}" type="sibTrans" cxnId="{45093230-BD9A-454C-A79C-E09623B80812}">
      <dgm:prSet/>
      <dgm:spPr/>
      <dgm:t>
        <a:bodyPr/>
        <a:lstStyle/>
        <a:p>
          <a:endParaRPr lang="en-GB"/>
        </a:p>
      </dgm:t>
    </dgm:pt>
    <dgm:pt modelId="{704B344C-9FAD-F04B-A961-D48B354C4D80}">
      <dgm:prSet phldrT="[Text]"/>
      <dgm:spPr/>
      <dgm:t>
        <a:bodyPr/>
        <a:lstStyle/>
        <a:p>
          <a:r>
            <a:rPr lang="en-GB" dirty="0"/>
            <a:t>Manage the research</a:t>
          </a:r>
        </a:p>
      </dgm:t>
    </dgm:pt>
    <dgm:pt modelId="{ACA6BB9A-2BB7-BD46-B3A5-AE2BA0F3B0F5}" type="parTrans" cxnId="{3BA596EF-0C47-E14A-AF30-43E63CBD553B}">
      <dgm:prSet/>
      <dgm:spPr/>
      <dgm:t>
        <a:bodyPr/>
        <a:lstStyle/>
        <a:p>
          <a:endParaRPr lang="en-GB"/>
        </a:p>
      </dgm:t>
    </dgm:pt>
    <dgm:pt modelId="{AA189D3C-72DF-1246-88CA-A852CE1FAC66}" type="sibTrans" cxnId="{3BA596EF-0C47-E14A-AF30-43E63CBD553B}">
      <dgm:prSet/>
      <dgm:spPr/>
      <dgm:t>
        <a:bodyPr/>
        <a:lstStyle/>
        <a:p>
          <a:endParaRPr lang="en-GB"/>
        </a:p>
      </dgm:t>
    </dgm:pt>
    <dgm:pt modelId="{E7CF490F-91DC-F846-A3A6-D3A2EF638F83}">
      <dgm:prSet phldrT="[Text]"/>
      <dgm:spPr/>
      <dgm:t>
        <a:bodyPr/>
        <a:lstStyle/>
        <a:p>
          <a:r>
            <a:rPr lang="en-GB" dirty="0"/>
            <a:t>Conduct the research</a:t>
          </a:r>
        </a:p>
      </dgm:t>
    </dgm:pt>
    <dgm:pt modelId="{2C1E0E50-55FC-4D43-A176-592EBF4A58F3}" type="parTrans" cxnId="{4D2CC224-19EC-BC49-86B7-5D57174F25D1}">
      <dgm:prSet/>
      <dgm:spPr/>
      <dgm:t>
        <a:bodyPr/>
        <a:lstStyle/>
        <a:p>
          <a:endParaRPr lang="en-GB"/>
        </a:p>
      </dgm:t>
    </dgm:pt>
    <dgm:pt modelId="{CAC3CACD-CDE9-AE45-9323-B3BDD4088AF3}" type="sibTrans" cxnId="{4D2CC224-19EC-BC49-86B7-5D57174F25D1}">
      <dgm:prSet/>
      <dgm:spPr/>
      <dgm:t>
        <a:bodyPr/>
        <a:lstStyle/>
        <a:p>
          <a:endParaRPr lang="en-GB"/>
        </a:p>
      </dgm:t>
    </dgm:pt>
    <dgm:pt modelId="{C11BB007-9F54-0348-BE82-3BC62D65DAC5}">
      <dgm:prSet phldrT="[Text]"/>
      <dgm:spPr/>
      <dgm:t>
        <a:bodyPr/>
        <a:lstStyle/>
        <a:p>
          <a:r>
            <a:rPr lang="en-GB" dirty="0"/>
            <a:t>Analyse and interpret findings</a:t>
          </a:r>
        </a:p>
      </dgm:t>
    </dgm:pt>
    <dgm:pt modelId="{65D93766-F6A7-7749-978E-C6718CCB749A}" type="parTrans" cxnId="{4BEA6609-D67E-1041-838E-F482D69CE42A}">
      <dgm:prSet/>
      <dgm:spPr/>
      <dgm:t>
        <a:bodyPr/>
        <a:lstStyle/>
        <a:p>
          <a:endParaRPr lang="en-GB"/>
        </a:p>
      </dgm:t>
    </dgm:pt>
    <dgm:pt modelId="{144BFC2F-3C36-144B-B257-CB4D7B30721D}" type="sibTrans" cxnId="{4BEA6609-D67E-1041-838E-F482D69CE42A}">
      <dgm:prSet/>
      <dgm:spPr/>
      <dgm:t>
        <a:bodyPr/>
        <a:lstStyle/>
        <a:p>
          <a:endParaRPr lang="en-GB"/>
        </a:p>
      </dgm:t>
    </dgm:pt>
    <dgm:pt modelId="{1FA61355-A77C-574C-8C0A-60C0FD4910FD}">
      <dgm:prSet phldrT="[Text]"/>
      <dgm:spPr/>
      <dgm:t>
        <a:bodyPr/>
        <a:lstStyle/>
        <a:p>
          <a:r>
            <a:rPr lang="en-GB" dirty="0"/>
            <a:t>Disseminate</a:t>
          </a:r>
        </a:p>
      </dgm:t>
    </dgm:pt>
    <dgm:pt modelId="{3CA8528F-6AC2-7C4A-812A-4F2767E7EA72}" type="parTrans" cxnId="{FF82827E-E08E-7B42-961F-EFA0AE610155}">
      <dgm:prSet/>
      <dgm:spPr/>
      <dgm:t>
        <a:bodyPr/>
        <a:lstStyle/>
        <a:p>
          <a:endParaRPr lang="en-GB"/>
        </a:p>
      </dgm:t>
    </dgm:pt>
    <dgm:pt modelId="{4A4D2591-61EC-4C41-8583-336875443AD1}" type="sibTrans" cxnId="{FF82827E-E08E-7B42-961F-EFA0AE610155}">
      <dgm:prSet/>
      <dgm:spPr/>
      <dgm:t>
        <a:bodyPr/>
        <a:lstStyle/>
        <a:p>
          <a:endParaRPr lang="en-GB"/>
        </a:p>
      </dgm:t>
    </dgm:pt>
    <dgm:pt modelId="{F8176310-E128-DC4B-B5FB-592CF890C5A7}">
      <dgm:prSet phldrT="[Text]"/>
      <dgm:spPr/>
      <dgm:t>
        <a:bodyPr/>
        <a:lstStyle/>
        <a:p>
          <a:r>
            <a:rPr lang="en-GB" dirty="0"/>
            <a:t>Evaluate</a:t>
          </a:r>
        </a:p>
      </dgm:t>
    </dgm:pt>
    <dgm:pt modelId="{EA2C3E9A-B1C9-F341-AF96-BB86805A44F0}" type="parTrans" cxnId="{DDFF6F67-2AE4-0C44-A5E5-41C1FDCF6778}">
      <dgm:prSet/>
      <dgm:spPr/>
      <dgm:t>
        <a:bodyPr/>
        <a:lstStyle/>
        <a:p>
          <a:endParaRPr lang="en-GB"/>
        </a:p>
      </dgm:t>
    </dgm:pt>
    <dgm:pt modelId="{85582E92-BAC4-2740-ABAC-EC352743D651}" type="sibTrans" cxnId="{DDFF6F67-2AE4-0C44-A5E5-41C1FDCF6778}">
      <dgm:prSet/>
      <dgm:spPr/>
      <dgm:t>
        <a:bodyPr/>
        <a:lstStyle/>
        <a:p>
          <a:endParaRPr lang="en-GB"/>
        </a:p>
      </dgm:t>
    </dgm:pt>
    <dgm:pt modelId="{093022C1-D630-5949-8474-739FBE5D876B}">
      <dgm:prSet phldrT="[Text]"/>
      <dgm:spPr/>
      <dgm:t>
        <a:bodyPr/>
        <a:lstStyle/>
        <a:p>
          <a:r>
            <a:rPr lang="en-GB" dirty="0"/>
            <a:t>Act on findings</a:t>
          </a:r>
        </a:p>
      </dgm:t>
    </dgm:pt>
    <dgm:pt modelId="{854D18CD-80A4-BF47-9C74-F86936DBEEAB}" type="parTrans" cxnId="{4ECDD128-239D-1542-9008-29EEF63A1C3D}">
      <dgm:prSet/>
      <dgm:spPr/>
      <dgm:t>
        <a:bodyPr/>
        <a:lstStyle/>
        <a:p>
          <a:endParaRPr lang="en-GB"/>
        </a:p>
      </dgm:t>
    </dgm:pt>
    <dgm:pt modelId="{EE99D27B-EDEF-EF48-96AC-ECC66E704C2E}" type="sibTrans" cxnId="{4ECDD128-239D-1542-9008-29EEF63A1C3D}">
      <dgm:prSet/>
      <dgm:spPr/>
      <dgm:t>
        <a:bodyPr/>
        <a:lstStyle/>
        <a:p>
          <a:endParaRPr lang="en-GB"/>
        </a:p>
      </dgm:t>
    </dgm:pt>
    <dgm:pt modelId="{BEFCDFDC-31B4-394F-B6DC-AEEEFC84A042}" type="pres">
      <dgm:prSet presAssocID="{A5D9A408-9F42-954E-9533-247B8D2AC1A5}" presName="cycle" presStyleCnt="0">
        <dgm:presLayoutVars>
          <dgm:dir/>
          <dgm:resizeHandles val="exact"/>
        </dgm:presLayoutVars>
      </dgm:prSet>
      <dgm:spPr/>
    </dgm:pt>
    <dgm:pt modelId="{D574BFB6-BEF1-8C4C-8B68-6F0C449AC879}" type="pres">
      <dgm:prSet presAssocID="{A18297FA-39DE-F046-AADF-44A9D6EA28E1}" presName="node" presStyleLbl="node1" presStyleIdx="0" presStyleCnt="9">
        <dgm:presLayoutVars>
          <dgm:bulletEnabled val="1"/>
        </dgm:presLayoutVars>
      </dgm:prSet>
      <dgm:spPr/>
    </dgm:pt>
    <dgm:pt modelId="{04741F94-04F5-944A-AA75-A52B581B08EB}" type="pres">
      <dgm:prSet presAssocID="{A18297FA-39DE-F046-AADF-44A9D6EA28E1}" presName="spNode" presStyleCnt="0"/>
      <dgm:spPr/>
    </dgm:pt>
    <dgm:pt modelId="{898433E3-2070-1F49-9809-E8CFFC177272}" type="pres">
      <dgm:prSet presAssocID="{43E137FF-92F4-4E41-B79D-52D977D6C099}" presName="sibTrans" presStyleLbl="sibTrans1D1" presStyleIdx="0" presStyleCnt="9"/>
      <dgm:spPr/>
    </dgm:pt>
    <dgm:pt modelId="{5F7A9264-01C6-C443-BFDE-FEF35C937F56}" type="pres">
      <dgm:prSet presAssocID="{775F3146-D841-DF44-A9BA-A58935E33788}" presName="node" presStyleLbl="node1" presStyleIdx="1" presStyleCnt="9">
        <dgm:presLayoutVars>
          <dgm:bulletEnabled val="1"/>
        </dgm:presLayoutVars>
      </dgm:prSet>
      <dgm:spPr/>
    </dgm:pt>
    <dgm:pt modelId="{B3EC3292-64F5-8642-B0CA-3A2250C83DEF}" type="pres">
      <dgm:prSet presAssocID="{775F3146-D841-DF44-A9BA-A58935E33788}" presName="spNode" presStyleCnt="0"/>
      <dgm:spPr/>
    </dgm:pt>
    <dgm:pt modelId="{B371DBB0-DEDB-914B-9AFF-7586E37A0CF6}" type="pres">
      <dgm:prSet presAssocID="{3C05C41F-A01D-3F41-85A5-42ACD3217FE0}" presName="sibTrans" presStyleLbl="sibTrans1D1" presStyleIdx="1" presStyleCnt="9"/>
      <dgm:spPr/>
    </dgm:pt>
    <dgm:pt modelId="{F039F0EB-D869-DF43-8B8E-C29408B796EB}" type="pres">
      <dgm:prSet presAssocID="{C7391DB6-008B-1045-881A-500864D378BA}" presName="node" presStyleLbl="node1" presStyleIdx="2" presStyleCnt="9">
        <dgm:presLayoutVars>
          <dgm:bulletEnabled val="1"/>
        </dgm:presLayoutVars>
      </dgm:prSet>
      <dgm:spPr/>
    </dgm:pt>
    <dgm:pt modelId="{681DBF75-0482-0B49-8C5C-FDCCB455E790}" type="pres">
      <dgm:prSet presAssocID="{C7391DB6-008B-1045-881A-500864D378BA}" presName="spNode" presStyleCnt="0"/>
      <dgm:spPr/>
    </dgm:pt>
    <dgm:pt modelId="{50EE490F-4F8E-9049-B615-10D6612BF852}" type="pres">
      <dgm:prSet presAssocID="{A0B3E19E-6337-9348-A48D-F00006ABCD61}" presName="sibTrans" presStyleLbl="sibTrans1D1" presStyleIdx="2" presStyleCnt="9"/>
      <dgm:spPr/>
    </dgm:pt>
    <dgm:pt modelId="{97452FB2-9725-6644-8F45-8091549EC3C6}" type="pres">
      <dgm:prSet presAssocID="{704B344C-9FAD-F04B-A961-D48B354C4D80}" presName="node" presStyleLbl="node1" presStyleIdx="3" presStyleCnt="9">
        <dgm:presLayoutVars>
          <dgm:bulletEnabled val="1"/>
        </dgm:presLayoutVars>
      </dgm:prSet>
      <dgm:spPr/>
    </dgm:pt>
    <dgm:pt modelId="{FE758242-03FB-CF43-80AD-996A0610A9E1}" type="pres">
      <dgm:prSet presAssocID="{704B344C-9FAD-F04B-A961-D48B354C4D80}" presName="spNode" presStyleCnt="0"/>
      <dgm:spPr/>
    </dgm:pt>
    <dgm:pt modelId="{454A1872-84E1-A440-9E23-9BA8B373C188}" type="pres">
      <dgm:prSet presAssocID="{AA189D3C-72DF-1246-88CA-A852CE1FAC66}" presName="sibTrans" presStyleLbl="sibTrans1D1" presStyleIdx="3" presStyleCnt="9"/>
      <dgm:spPr/>
    </dgm:pt>
    <dgm:pt modelId="{2EAB5438-31E8-064A-A4B0-3F2DE2B6D4E6}" type="pres">
      <dgm:prSet presAssocID="{E7CF490F-91DC-F846-A3A6-D3A2EF638F83}" presName="node" presStyleLbl="node1" presStyleIdx="4" presStyleCnt="9">
        <dgm:presLayoutVars>
          <dgm:bulletEnabled val="1"/>
        </dgm:presLayoutVars>
      </dgm:prSet>
      <dgm:spPr/>
    </dgm:pt>
    <dgm:pt modelId="{A56C7289-B605-8C48-A7ED-788D64A3C1B3}" type="pres">
      <dgm:prSet presAssocID="{E7CF490F-91DC-F846-A3A6-D3A2EF638F83}" presName="spNode" presStyleCnt="0"/>
      <dgm:spPr/>
    </dgm:pt>
    <dgm:pt modelId="{592DEB87-05BA-314E-9E5D-A0994FBB9BE7}" type="pres">
      <dgm:prSet presAssocID="{CAC3CACD-CDE9-AE45-9323-B3BDD4088AF3}" presName="sibTrans" presStyleLbl="sibTrans1D1" presStyleIdx="4" presStyleCnt="9"/>
      <dgm:spPr/>
    </dgm:pt>
    <dgm:pt modelId="{B61B4333-12E9-EA4E-96BE-541075F519B1}" type="pres">
      <dgm:prSet presAssocID="{C11BB007-9F54-0348-BE82-3BC62D65DAC5}" presName="node" presStyleLbl="node1" presStyleIdx="5" presStyleCnt="9">
        <dgm:presLayoutVars>
          <dgm:bulletEnabled val="1"/>
        </dgm:presLayoutVars>
      </dgm:prSet>
      <dgm:spPr/>
    </dgm:pt>
    <dgm:pt modelId="{1999164E-B41C-E748-984D-D95DF71999F3}" type="pres">
      <dgm:prSet presAssocID="{C11BB007-9F54-0348-BE82-3BC62D65DAC5}" presName="spNode" presStyleCnt="0"/>
      <dgm:spPr/>
    </dgm:pt>
    <dgm:pt modelId="{1DCD3E9D-C78C-A144-B7E8-BE98F083AEB6}" type="pres">
      <dgm:prSet presAssocID="{144BFC2F-3C36-144B-B257-CB4D7B30721D}" presName="sibTrans" presStyleLbl="sibTrans1D1" presStyleIdx="5" presStyleCnt="9"/>
      <dgm:spPr/>
    </dgm:pt>
    <dgm:pt modelId="{18BCA952-D167-F945-8867-AD4C9D2398AB}" type="pres">
      <dgm:prSet presAssocID="{1FA61355-A77C-574C-8C0A-60C0FD4910FD}" presName="node" presStyleLbl="node1" presStyleIdx="6" presStyleCnt="9">
        <dgm:presLayoutVars>
          <dgm:bulletEnabled val="1"/>
        </dgm:presLayoutVars>
      </dgm:prSet>
      <dgm:spPr/>
    </dgm:pt>
    <dgm:pt modelId="{B4417D4B-F281-1143-84C1-686D272378B4}" type="pres">
      <dgm:prSet presAssocID="{1FA61355-A77C-574C-8C0A-60C0FD4910FD}" presName="spNode" presStyleCnt="0"/>
      <dgm:spPr/>
    </dgm:pt>
    <dgm:pt modelId="{B9ABB65A-E4F9-2446-9DC0-16FA01C2810E}" type="pres">
      <dgm:prSet presAssocID="{4A4D2591-61EC-4C41-8583-336875443AD1}" presName="sibTrans" presStyleLbl="sibTrans1D1" presStyleIdx="6" presStyleCnt="9"/>
      <dgm:spPr/>
    </dgm:pt>
    <dgm:pt modelId="{BBB9B9B7-392F-044F-9D6F-255404CF4C1D}" type="pres">
      <dgm:prSet presAssocID="{F8176310-E128-DC4B-B5FB-592CF890C5A7}" presName="node" presStyleLbl="node1" presStyleIdx="7" presStyleCnt="9">
        <dgm:presLayoutVars>
          <dgm:bulletEnabled val="1"/>
        </dgm:presLayoutVars>
      </dgm:prSet>
      <dgm:spPr/>
    </dgm:pt>
    <dgm:pt modelId="{82579739-B1E5-3A4D-916A-92CDD6F5EEAF}" type="pres">
      <dgm:prSet presAssocID="{F8176310-E128-DC4B-B5FB-592CF890C5A7}" presName="spNode" presStyleCnt="0"/>
      <dgm:spPr/>
    </dgm:pt>
    <dgm:pt modelId="{24E638AC-505A-804E-9219-145CB4495339}" type="pres">
      <dgm:prSet presAssocID="{85582E92-BAC4-2740-ABAC-EC352743D651}" presName="sibTrans" presStyleLbl="sibTrans1D1" presStyleIdx="7" presStyleCnt="9"/>
      <dgm:spPr/>
    </dgm:pt>
    <dgm:pt modelId="{99EB3913-8B6E-E34E-9628-DAC25591E971}" type="pres">
      <dgm:prSet presAssocID="{093022C1-D630-5949-8474-739FBE5D876B}" presName="node" presStyleLbl="node1" presStyleIdx="8" presStyleCnt="9">
        <dgm:presLayoutVars>
          <dgm:bulletEnabled val="1"/>
        </dgm:presLayoutVars>
      </dgm:prSet>
      <dgm:spPr/>
    </dgm:pt>
    <dgm:pt modelId="{AA8F755A-9E3C-FE40-B5A1-AF38A3824191}" type="pres">
      <dgm:prSet presAssocID="{093022C1-D630-5949-8474-739FBE5D876B}" presName="spNode" presStyleCnt="0"/>
      <dgm:spPr/>
    </dgm:pt>
    <dgm:pt modelId="{D8F8ADA8-351A-B544-A873-AEA3C0755809}" type="pres">
      <dgm:prSet presAssocID="{EE99D27B-EDEF-EF48-96AC-ECC66E704C2E}" presName="sibTrans" presStyleLbl="sibTrans1D1" presStyleIdx="8" presStyleCnt="9"/>
      <dgm:spPr/>
    </dgm:pt>
  </dgm:ptLst>
  <dgm:cxnLst>
    <dgm:cxn modelId="{EC4F9300-DE6A-EB4B-9CE3-571589414EBE}" type="presOf" srcId="{CAC3CACD-CDE9-AE45-9323-B3BDD4088AF3}" destId="{592DEB87-05BA-314E-9E5D-A0994FBB9BE7}" srcOrd="0" destOrd="0" presId="urn:microsoft.com/office/officeart/2005/8/layout/cycle5"/>
    <dgm:cxn modelId="{4BEA6609-D67E-1041-838E-F482D69CE42A}" srcId="{A5D9A408-9F42-954E-9533-247B8D2AC1A5}" destId="{C11BB007-9F54-0348-BE82-3BC62D65DAC5}" srcOrd="5" destOrd="0" parTransId="{65D93766-F6A7-7749-978E-C6718CCB749A}" sibTransId="{144BFC2F-3C36-144B-B257-CB4D7B30721D}"/>
    <dgm:cxn modelId="{590BAB09-0784-1A42-8B0A-2AD21B2EE8E6}" type="presOf" srcId="{704B344C-9FAD-F04B-A961-D48B354C4D80}" destId="{97452FB2-9725-6644-8F45-8091549EC3C6}" srcOrd="0" destOrd="0" presId="urn:microsoft.com/office/officeart/2005/8/layout/cycle5"/>
    <dgm:cxn modelId="{235ABD10-7E44-684C-B18B-B7F5CCBE7FC3}" type="presOf" srcId="{A0B3E19E-6337-9348-A48D-F00006ABCD61}" destId="{50EE490F-4F8E-9049-B615-10D6612BF852}" srcOrd="0" destOrd="0" presId="urn:microsoft.com/office/officeart/2005/8/layout/cycle5"/>
    <dgm:cxn modelId="{C3235C1A-47E1-FA40-8900-8EDB3093E471}" type="presOf" srcId="{43E137FF-92F4-4E41-B79D-52D977D6C099}" destId="{898433E3-2070-1F49-9809-E8CFFC177272}" srcOrd="0" destOrd="0" presId="urn:microsoft.com/office/officeart/2005/8/layout/cycle5"/>
    <dgm:cxn modelId="{55F5301B-1D94-CB4C-90D1-AB09AF8E4255}" type="presOf" srcId="{775F3146-D841-DF44-A9BA-A58935E33788}" destId="{5F7A9264-01C6-C443-BFDE-FEF35C937F56}" srcOrd="0" destOrd="0" presId="urn:microsoft.com/office/officeart/2005/8/layout/cycle5"/>
    <dgm:cxn modelId="{4D2CC224-19EC-BC49-86B7-5D57174F25D1}" srcId="{A5D9A408-9F42-954E-9533-247B8D2AC1A5}" destId="{E7CF490F-91DC-F846-A3A6-D3A2EF638F83}" srcOrd="4" destOrd="0" parTransId="{2C1E0E50-55FC-4D43-A176-592EBF4A58F3}" sibTransId="{CAC3CACD-CDE9-AE45-9323-B3BDD4088AF3}"/>
    <dgm:cxn modelId="{4ECDD128-239D-1542-9008-29EEF63A1C3D}" srcId="{A5D9A408-9F42-954E-9533-247B8D2AC1A5}" destId="{093022C1-D630-5949-8474-739FBE5D876B}" srcOrd="8" destOrd="0" parTransId="{854D18CD-80A4-BF47-9C74-F86936DBEEAB}" sibTransId="{EE99D27B-EDEF-EF48-96AC-ECC66E704C2E}"/>
    <dgm:cxn modelId="{45093230-BD9A-454C-A79C-E09623B80812}" srcId="{A5D9A408-9F42-954E-9533-247B8D2AC1A5}" destId="{C7391DB6-008B-1045-881A-500864D378BA}" srcOrd="2" destOrd="0" parTransId="{562F6C85-B65D-2549-AAF4-035CEA65435F}" sibTransId="{A0B3E19E-6337-9348-A48D-F00006ABCD61}"/>
    <dgm:cxn modelId="{570B5A36-FEE3-E040-8E3F-8DB65D2E5276}" type="presOf" srcId="{85582E92-BAC4-2740-ABAC-EC352743D651}" destId="{24E638AC-505A-804E-9219-145CB4495339}" srcOrd="0" destOrd="0" presId="urn:microsoft.com/office/officeart/2005/8/layout/cycle5"/>
    <dgm:cxn modelId="{0D3DBC3B-F96A-654A-A7CB-E13CFCE3ED08}" type="presOf" srcId="{AA189D3C-72DF-1246-88CA-A852CE1FAC66}" destId="{454A1872-84E1-A440-9E23-9BA8B373C188}" srcOrd="0" destOrd="0" presId="urn:microsoft.com/office/officeart/2005/8/layout/cycle5"/>
    <dgm:cxn modelId="{03EC9040-9411-2E48-8632-A9F18DE09AA9}" type="presOf" srcId="{3C05C41F-A01D-3F41-85A5-42ACD3217FE0}" destId="{B371DBB0-DEDB-914B-9AFF-7586E37A0CF6}" srcOrd="0" destOrd="0" presId="urn:microsoft.com/office/officeart/2005/8/layout/cycle5"/>
    <dgm:cxn modelId="{4EDBB645-F288-6749-8846-4F1E2D82303C}" type="presOf" srcId="{A5D9A408-9F42-954E-9533-247B8D2AC1A5}" destId="{BEFCDFDC-31B4-394F-B6DC-AEEEFC84A042}" srcOrd="0" destOrd="0" presId="urn:microsoft.com/office/officeart/2005/8/layout/cycle5"/>
    <dgm:cxn modelId="{DDFF6F67-2AE4-0C44-A5E5-41C1FDCF6778}" srcId="{A5D9A408-9F42-954E-9533-247B8D2AC1A5}" destId="{F8176310-E128-DC4B-B5FB-592CF890C5A7}" srcOrd="7" destOrd="0" parTransId="{EA2C3E9A-B1C9-F341-AF96-BB86805A44F0}" sibTransId="{85582E92-BAC4-2740-ABAC-EC352743D651}"/>
    <dgm:cxn modelId="{577F466A-3450-D24C-A92E-27B956327618}" srcId="{A5D9A408-9F42-954E-9533-247B8D2AC1A5}" destId="{775F3146-D841-DF44-A9BA-A58935E33788}" srcOrd="1" destOrd="0" parTransId="{715EE54C-716B-EE47-BAD7-4871A08663CD}" sibTransId="{3C05C41F-A01D-3F41-85A5-42ACD3217FE0}"/>
    <dgm:cxn modelId="{6ACE664C-C2A0-004F-9BFF-41B5ADA46048}" srcId="{A5D9A408-9F42-954E-9533-247B8D2AC1A5}" destId="{A18297FA-39DE-F046-AADF-44A9D6EA28E1}" srcOrd="0" destOrd="0" parTransId="{4C3D318C-7550-6A46-9DC2-1DC50BBD345B}" sibTransId="{43E137FF-92F4-4E41-B79D-52D977D6C099}"/>
    <dgm:cxn modelId="{EC6F6771-4F32-A54B-BC29-B3FD92F3BF40}" type="presOf" srcId="{EE99D27B-EDEF-EF48-96AC-ECC66E704C2E}" destId="{D8F8ADA8-351A-B544-A873-AEA3C0755809}" srcOrd="0" destOrd="0" presId="urn:microsoft.com/office/officeart/2005/8/layout/cycle5"/>
    <dgm:cxn modelId="{7FB57878-7494-ED45-95EC-5714925AFF27}" type="presOf" srcId="{C11BB007-9F54-0348-BE82-3BC62D65DAC5}" destId="{B61B4333-12E9-EA4E-96BE-541075F519B1}" srcOrd="0" destOrd="0" presId="urn:microsoft.com/office/officeart/2005/8/layout/cycle5"/>
    <dgm:cxn modelId="{09616E7B-CB8C-9044-8314-4A92E123C0CE}" type="presOf" srcId="{E7CF490F-91DC-F846-A3A6-D3A2EF638F83}" destId="{2EAB5438-31E8-064A-A4B0-3F2DE2B6D4E6}" srcOrd="0" destOrd="0" presId="urn:microsoft.com/office/officeart/2005/8/layout/cycle5"/>
    <dgm:cxn modelId="{FF82827E-E08E-7B42-961F-EFA0AE610155}" srcId="{A5D9A408-9F42-954E-9533-247B8D2AC1A5}" destId="{1FA61355-A77C-574C-8C0A-60C0FD4910FD}" srcOrd="6" destOrd="0" parTransId="{3CA8528F-6AC2-7C4A-812A-4F2767E7EA72}" sibTransId="{4A4D2591-61EC-4C41-8583-336875443AD1}"/>
    <dgm:cxn modelId="{3F85B383-5260-3840-9860-14B4EACF1AA9}" type="presOf" srcId="{093022C1-D630-5949-8474-739FBE5D876B}" destId="{99EB3913-8B6E-E34E-9628-DAC25591E971}" srcOrd="0" destOrd="0" presId="urn:microsoft.com/office/officeart/2005/8/layout/cycle5"/>
    <dgm:cxn modelId="{9E4E8585-0343-334B-9109-C295C9E11DBC}" type="presOf" srcId="{A18297FA-39DE-F046-AADF-44A9D6EA28E1}" destId="{D574BFB6-BEF1-8C4C-8B68-6F0C449AC879}" srcOrd="0" destOrd="0" presId="urn:microsoft.com/office/officeart/2005/8/layout/cycle5"/>
    <dgm:cxn modelId="{DD132989-162D-104F-A1D1-FB88A665DF31}" type="presOf" srcId="{1FA61355-A77C-574C-8C0A-60C0FD4910FD}" destId="{18BCA952-D167-F945-8867-AD4C9D2398AB}" srcOrd="0" destOrd="0" presId="urn:microsoft.com/office/officeart/2005/8/layout/cycle5"/>
    <dgm:cxn modelId="{10E35E9C-FA10-4E4E-9AA0-1B05F950A98D}" type="presOf" srcId="{4A4D2591-61EC-4C41-8583-336875443AD1}" destId="{B9ABB65A-E4F9-2446-9DC0-16FA01C2810E}" srcOrd="0" destOrd="0" presId="urn:microsoft.com/office/officeart/2005/8/layout/cycle5"/>
    <dgm:cxn modelId="{4B9903EC-829D-E94C-BE8F-83F86D15CC89}" type="presOf" srcId="{144BFC2F-3C36-144B-B257-CB4D7B30721D}" destId="{1DCD3E9D-C78C-A144-B7E8-BE98F083AEB6}" srcOrd="0" destOrd="0" presId="urn:microsoft.com/office/officeart/2005/8/layout/cycle5"/>
    <dgm:cxn modelId="{3BA596EF-0C47-E14A-AF30-43E63CBD553B}" srcId="{A5D9A408-9F42-954E-9533-247B8D2AC1A5}" destId="{704B344C-9FAD-F04B-A961-D48B354C4D80}" srcOrd="3" destOrd="0" parTransId="{ACA6BB9A-2BB7-BD46-B3A5-AE2BA0F3B0F5}" sibTransId="{AA189D3C-72DF-1246-88CA-A852CE1FAC66}"/>
    <dgm:cxn modelId="{987088F0-0B28-8246-8B89-01F276488EBF}" type="presOf" srcId="{F8176310-E128-DC4B-B5FB-592CF890C5A7}" destId="{BBB9B9B7-392F-044F-9D6F-255404CF4C1D}" srcOrd="0" destOrd="0" presId="urn:microsoft.com/office/officeart/2005/8/layout/cycle5"/>
    <dgm:cxn modelId="{7BDA0FF6-33EF-FB4C-B9E1-F3DEF1E45A91}" type="presOf" srcId="{C7391DB6-008B-1045-881A-500864D378BA}" destId="{F039F0EB-D869-DF43-8B8E-C29408B796EB}" srcOrd="0" destOrd="0" presId="urn:microsoft.com/office/officeart/2005/8/layout/cycle5"/>
    <dgm:cxn modelId="{1831DE0A-E8BD-D04A-9A5E-ECBC57F727CF}" type="presParOf" srcId="{BEFCDFDC-31B4-394F-B6DC-AEEEFC84A042}" destId="{D574BFB6-BEF1-8C4C-8B68-6F0C449AC879}" srcOrd="0" destOrd="0" presId="urn:microsoft.com/office/officeart/2005/8/layout/cycle5"/>
    <dgm:cxn modelId="{82411476-1682-2E40-9D93-6A28D00DAC6D}" type="presParOf" srcId="{BEFCDFDC-31B4-394F-B6DC-AEEEFC84A042}" destId="{04741F94-04F5-944A-AA75-A52B581B08EB}" srcOrd="1" destOrd="0" presId="urn:microsoft.com/office/officeart/2005/8/layout/cycle5"/>
    <dgm:cxn modelId="{9EFADA66-8FDA-C248-9D2C-AF28220955AF}" type="presParOf" srcId="{BEFCDFDC-31B4-394F-B6DC-AEEEFC84A042}" destId="{898433E3-2070-1F49-9809-E8CFFC177272}" srcOrd="2" destOrd="0" presId="urn:microsoft.com/office/officeart/2005/8/layout/cycle5"/>
    <dgm:cxn modelId="{4EF40AE6-40E9-244B-96D9-377521C40AC8}" type="presParOf" srcId="{BEFCDFDC-31B4-394F-B6DC-AEEEFC84A042}" destId="{5F7A9264-01C6-C443-BFDE-FEF35C937F56}" srcOrd="3" destOrd="0" presId="urn:microsoft.com/office/officeart/2005/8/layout/cycle5"/>
    <dgm:cxn modelId="{775197DB-F50D-F345-B9EA-68D620D60F1F}" type="presParOf" srcId="{BEFCDFDC-31B4-394F-B6DC-AEEEFC84A042}" destId="{B3EC3292-64F5-8642-B0CA-3A2250C83DEF}" srcOrd="4" destOrd="0" presId="urn:microsoft.com/office/officeart/2005/8/layout/cycle5"/>
    <dgm:cxn modelId="{BC4443C3-E50D-1541-B20A-A5EEDB7B6824}" type="presParOf" srcId="{BEFCDFDC-31B4-394F-B6DC-AEEEFC84A042}" destId="{B371DBB0-DEDB-914B-9AFF-7586E37A0CF6}" srcOrd="5" destOrd="0" presId="urn:microsoft.com/office/officeart/2005/8/layout/cycle5"/>
    <dgm:cxn modelId="{CBAC1E2B-FF68-A443-8D4D-0D400DEB757F}" type="presParOf" srcId="{BEFCDFDC-31B4-394F-B6DC-AEEEFC84A042}" destId="{F039F0EB-D869-DF43-8B8E-C29408B796EB}" srcOrd="6" destOrd="0" presId="urn:microsoft.com/office/officeart/2005/8/layout/cycle5"/>
    <dgm:cxn modelId="{42A54530-49F4-4C4C-95BA-59015D6999AF}" type="presParOf" srcId="{BEFCDFDC-31B4-394F-B6DC-AEEEFC84A042}" destId="{681DBF75-0482-0B49-8C5C-FDCCB455E790}" srcOrd="7" destOrd="0" presId="urn:microsoft.com/office/officeart/2005/8/layout/cycle5"/>
    <dgm:cxn modelId="{73690491-E452-6B48-949A-19100563189D}" type="presParOf" srcId="{BEFCDFDC-31B4-394F-B6DC-AEEEFC84A042}" destId="{50EE490F-4F8E-9049-B615-10D6612BF852}" srcOrd="8" destOrd="0" presId="urn:microsoft.com/office/officeart/2005/8/layout/cycle5"/>
    <dgm:cxn modelId="{8AFEE76F-FCC5-8548-9FA7-5811512060D3}" type="presParOf" srcId="{BEFCDFDC-31B4-394F-B6DC-AEEEFC84A042}" destId="{97452FB2-9725-6644-8F45-8091549EC3C6}" srcOrd="9" destOrd="0" presId="urn:microsoft.com/office/officeart/2005/8/layout/cycle5"/>
    <dgm:cxn modelId="{7C90763D-4629-3640-B572-896CE5C4841C}" type="presParOf" srcId="{BEFCDFDC-31B4-394F-B6DC-AEEEFC84A042}" destId="{FE758242-03FB-CF43-80AD-996A0610A9E1}" srcOrd="10" destOrd="0" presId="urn:microsoft.com/office/officeart/2005/8/layout/cycle5"/>
    <dgm:cxn modelId="{B5C6B902-3EFC-BE47-AD1C-90F92ABEA431}" type="presParOf" srcId="{BEFCDFDC-31B4-394F-B6DC-AEEEFC84A042}" destId="{454A1872-84E1-A440-9E23-9BA8B373C188}" srcOrd="11" destOrd="0" presId="urn:microsoft.com/office/officeart/2005/8/layout/cycle5"/>
    <dgm:cxn modelId="{78DF2DCB-5BE8-924C-BEBB-BFB554781215}" type="presParOf" srcId="{BEFCDFDC-31B4-394F-B6DC-AEEEFC84A042}" destId="{2EAB5438-31E8-064A-A4B0-3F2DE2B6D4E6}" srcOrd="12" destOrd="0" presId="urn:microsoft.com/office/officeart/2005/8/layout/cycle5"/>
    <dgm:cxn modelId="{2A748B38-0F02-4C47-A7FC-FF91DBE6CE5A}" type="presParOf" srcId="{BEFCDFDC-31B4-394F-B6DC-AEEEFC84A042}" destId="{A56C7289-B605-8C48-A7ED-788D64A3C1B3}" srcOrd="13" destOrd="0" presId="urn:microsoft.com/office/officeart/2005/8/layout/cycle5"/>
    <dgm:cxn modelId="{B1B9F60A-AF58-5647-8B81-5B55AFC50257}" type="presParOf" srcId="{BEFCDFDC-31B4-394F-B6DC-AEEEFC84A042}" destId="{592DEB87-05BA-314E-9E5D-A0994FBB9BE7}" srcOrd="14" destOrd="0" presId="urn:microsoft.com/office/officeart/2005/8/layout/cycle5"/>
    <dgm:cxn modelId="{B8D6194E-3E1D-404E-948F-E125F159BCFE}" type="presParOf" srcId="{BEFCDFDC-31B4-394F-B6DC-AEEEFC84A042}" destId="{B61B4333-12E9-EA4E-96BE-541075F519B1}" srcOrd="15" destOrd="0" presId="urn:microsoft.com/office/officeart/2005/8/layout/cycle5"/>
    <dgm:cxn modelId="{AA57E3D1-7870-BE4D-AF16-DE0BA18C1593}" type="presParOf" srcId="{BEFCDFDC-31B4-394F-B6DC-AEEEFC84A042}" destId="{1999164E-B41C-E748-984D-D95DF71999F3}" srcOrd="16" destOrd="0" presId="urn:microsoft.com/office/officeart/2005/8/layout/cycle5"/>
    <dgm:cxn modelId="{5A04BEA7-6011-484E-A897-D17743D411E5}" type="presParOf" srcId="{BEFCDFDC-31B4-394F-B6DC-AEEEFC84A042}" destId="{1DCD3E9D-C78C-A144-B7E8-BE98F083AEB6}" srcOrd="17" destOrd="0" presId="urn:microsoft.com/office/officeart/2005/8/layout/cycle5"/>
    <dgm:cxn modelId="{532DBB0A-E9F4-6F47-8546-D0F2AEE952AF}" type="presParOf" srcId="{BEFCDFDC-31B4-394F-B6DC-AEEEFC84A042}" destId="{18BCA952-D167-F945-8867-AD4C9D2398AB}" srcOrd="18" destOrd="0" presId="urn:microsoft.com/office/officeart/2005/8/layout/cycle5"/>
    <dgm:cxn modelId="{98CCD086-05EB-0F44-BD12-3121E72B74B0}" type="presParOf" srcId="{BEFCDFDC-31B4-394F-B6DC-AEEEFC84A042}" destId="{B4417D4B-F281-1143-84C1-686D272378B4}" srcOrd="19" destOrd="0" presId="urn:microsoft.com/office/officeart/2005/8/layout/cycle5"/>
    <dgm:cxn modelId="{A1546A76-203A-F547-A33D-8E2280C08198}" type="presParOf" srcId="{BEFCDFDC-31B4-394F-B6DC-AEEEFC84A042}" destId="{B9ABB65A-E4F9-2446-9DC0-16FA01C2810E}" srcOrd="20" destOrd="0" presId="urn:microsoft.com/office/officeart/2005/8/layout/cycle5"/>
    <dgm:cxn modelId="{45B031A7-FF07-4F40-AB00-2F7C6074BD30}" type="presParOf" srcId="{BEFCDFDC-31B4-394F-B6DC-AEEEFC84A042}" destId="{BBB9B9B7-392F-044F-9D6F-255404CF4C1D}" srcOrd="21" destOrd="0" presId="urn:microsoft.com/office/officeart/2005/8/layout/cycle5"/>
    <dgm:cxn modelId="{68C44E0C-0A9E-4348-B3D7-1EC71869C7D2}" type="presParOf" srcId="{BEFCDFDC-31B4-394F-B6DC-AEEEFC84A042}" destId="{82579739-B1E5-3A4D-916A-92CDD6F5EEAF}" srcOrd="22" destOrd="0" presId="urn:microsoft.com/office/officeart/2005/8/layout/cycle5"/>
    <dgm:cxn modelId="{E05515A9-7339-B14A-A56E-A596F2403275}" type="presParOf" srcId="{BEFCDFDC-31B4-394F-B6DC-AEEEFC84A042}" destId="{24E638AC-505A-804E-9219-145CB4495339}" srcOrd="23" destOrd="0" presId="urn:microsoft.com/office/officeart/2005/8/layout/cycle5"/>
    <dgm:cxn modelId="{339B0992-B7BC-8845-A86F-37B19FF16ADC}" type="presParOf" srcId="{BEFCDFDC-31B4-394F-B6DC-AEEEFC84A042}" destId="{99EB3913-8B6E-E34E-9628-DAC25591E971}" srcOrd="24" destOrd="0" presId="urn:microsoft.com/office/officeart/2005/8/layout/cycle5"/>
    <dgm:cxn modelId="{DE516299-D6DA-D948-B7D2-5954CEC1DB28}" type="presParOf" srcId="{BEFCDFDC-31B4-394F-B6DC-AEEEFC84A042}" destId="{AA8F755A-9E3C-FE40-B5A1-AF38A3824191}" srcOrd="25" destOrd="0" presId="urn:microsoft.com/office/officeart/2005/8/layout/cycle5"/>
    <dgm:cxn modelId="{42A4CD3D-362C-424B-8D14-6831D8DE3C71}" type="presParOf" srcId="{BEFCDFDC-31B4-394F-B6DC-AEEEFC84A042}" destId="{D8F8ADA8-351A-B544-A873-AEA3C0755809}" srcOrd="26" destOrd="0" presId="urn:microsoft.com/office/officeart/2005/8/layout/cycle5"/>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A5D9A408-9F42-954E-9533-247B8D2AC1A5}" type="doc">
      <dgm:prSet loTypeId="urn:microsoft.com/office/officeart/2005/8/layout/cycle5" loCatId="" qsTypeId="urn:microsoft.com/office/officeart/2005/8/quickstyle/simple1" qsCatId="simple" csTypeId="urn:microsoft.com/office/officeart/2005/8/colors/accent1_2" csCatId="accent1" phldr="1"/>
      <dgm:spPr/>
      <dgm:t>
        <a:bodyPr/>
        <a:lstStyle/>
        <a:p>
          <a:endParaRPr lang="en-GB"/>
        </a:p>
      </dgm:t>
    </dgm:pt>
    <dgm:pt modelId="{A18297FA-39DE-F046-AADF-44A9D6EA28E1}">
      <dgm:prSet phldrT="[Text]"/>
      <dgm:spPr/>
      <dgm:t>
        <a:bodyPr/>
        <a:lstStyle/>
        <a:p>
          <a:r>
            <a:rPr lang="en-GB" dirty="0"/>
            <a:t>Identify the topic</a:t>
          </a:r>
        </a:p>
      </dgm:t>
    </dgm:pt>
    <dgm:pt modelId="{4C3D318C-7550-6A46-9DC2-1DC50BBD345B}" type="parTrans" cxnId="{6ACE664C-C2A0-004F-9BFF-41B5ADA46048}">
      <dgm:prSet/>
      <dgm:spPr/>
      <dgm:t>
        <a:bodyPr/>
        <a:lstStyle/>
        <a:p>
          <a:endParaRPr lang="en-GB"/>
        </a:p>
      </dgm:t>
    </dgm:pt>
    <dgm:pt modelId="{43E137FF-92F4-4E41-B79D-52D977D6C099}" type="sibTrans" cxnId="{6ACE664C-C2A0-004F-9BFF-41B5ADA46048}">
      <dgm:prSet/>
      <dgm:spPr/>
      <dgm:t>
        <a:bodyPr/>
        <a:lstStyle/>
        <a:p>
          <a:endParaRPr lang="en-GB"/>
        </a:p>
      </dgm:t>
    </dgm:pt>
    <dgm:pt modelId="{775F3146-D841-DF44-A9BA-A58935E33788}">
      <dgm:prSet phldrT="[Text]"/>
      <dgm:spPr/>
      <dgm:t>
        <a:bodyPr/>
        <a:lstStyle/>
        <a:p>
          <a:r>
            <a:rPr lang="en-GB" dirty="0"/>
            <a:t>Seek funding</a:t>
          </a:r>
        </a:p>
      </dgm:t>
    </dgm:pt>
    <dgm:pt modelId="{715EE54C-716B-EE47-BAD7-4871A08663CD}" type="parTrans" cxnId="{577F466A-3450-D24C-A92E-27B956327618}">
      <dgm:prSet/>
      <dgm:spPr/>
      <dgm:t>
        <a:bodyPr/>
        <a:lstStyle/>
        <a:p>
          <a:endParaRPr lang="en-GB"/>
        </a:p>
      </dgm:t>
    </dgm:pt>
    <dgm:pt modelId="{3C05C41F-A01D-3F41-85A5-42ACD3217FE0}" type="sibTrans" cxnId="{577F466A-3450-D24C-A92E-27B956327618}">
      <dgm:prSet/>
      <dgm:spPr/>
      <dgm:t>
        <a:bodyPr/>
        <a:lstStyle/>
        <a:p>
          <a:endParaRPr lang="en-GB"/>
        </a:p>
      </dgm:t>
    </dgm:pt>
    <dgm:pt modelId="{C7391DB6-008B-1045-881A-500864D378BA}">
      <dgm:prSet phldrT="[Text]"/>
      <dgm:spPr/>
      <dgm:t>
        <a:bodyPr/>
        <a:lstStyle/>
        <a:p>
          <a:r>
            <a:rPr lang="en-GB" dirty="0"/>
            <a:t>Design the research project</a:t>
          </a:r>
        </a:p>
      </dgm:t>
    </dgm:pt>
    <dgm:pt modelId="{562F6C85-B65D-2549-AAF4-035CEA65435F}" type="parTrans" cxnId="{45093230-BD9A-454C-A79C-E09623B80812}">
      <dgm:prSet/>
      <dgm:spPr/>
      <dgm:t>
        <a:bodyPr/>
        <a:lstStyle/>
        <a:p>
          <a:endParaRPr lang="en-GB"/>
        </a:p>
      </dgm:t>
    </dgm:pt>
    <dgm:pt modelId="{A0B3E19E-6337-9348-A48D-F00006ABCD61}" type="sibTrans" cxnId="{45093230-BD9A-454C-A79C-E09623B80812}">
      <dgm:prSet/>
      <dgm:spPr/>
      <dgm:t>
        <a:bodyPr/>
        <a:lstStyle/>
        <a:p>
          <a:endParaRPr lang="en-GB"/>
        </a:p>
      </dgm:t>
    </dgm:pt>
    <dgm:pt modelId="{704B344C-9FAD-F04B-A961-D48B354C4D80}">
      <dgm:prSet phldrT="[Text]"/>
      <dgm:spPr/>
      <dgm:t>
        <a:bodyPr/>
        <a:lstStyle/>
        <a:p>
          <a:r>
            <a:rPr lang="en-GB" dirty="0"/>
            <a:t>Manage the research</a:t>
          </a:r>
        </a:p>
      </dgm:t>
    </dgm:pt>
    <dgm:pt modelId="{ACA6BB9A-2BB7-BD46-B3A5-AE2BA0F3B0F5}" type="parTrans" cxnId="{3BA596EF-0C47-E14A-AF30-43E63CBD553B}">
      <dgm:prSet/>
      <dgm:spPr/>
      <dgm:t>
        <a:bodyPr/>
        <a:lstStyle/>
        <a:p>
          <a:endParaRPr lang="en-GB"/>
        </a:p>
      </dgm:t>
    </dgm:pt>
    <dgm:pt modelId="{AA189D3C-72DF-1246-88CA-A852CE1FAC66}" type="sibTrans" cxnId="{3BA596EF-0C47-E14A-AF30-43E63CBD553B}">
      <dgm:prSet/>
      <dgm:spPr/>
      <dgm:t>
        <a:bodyPr/>
        <a:lstStyle/>
        <a:p>
          <a:endParaRPr lang="en-GB"/>
        </a:p>
      </dgm:t>
    </dgm:pt>
    <dgm:pt modelId="{E7CF490F-91DC-F846-A3A6-D3A2EF638F83}">
      <dgm:prSet phldrT="[Text]"/>
      <dgm:spPr/>
      <dgm:t>
        <a:bodyPr/>
        <a:lstStyle/>
        <a:p>
          <a:r>
            <a:rPr lang="en-GB" dirty="0"/>
            <a:t>Conduct the research</a:t>
          </a:r>
        </a:p>
      </dgm:t>
    </dgm:pt>
    <dgm:pt modelId="{2C1E0E50-55FC-4D43-A176-592EBF4A58F3}" type="parTrans" cxnId="{4D2CC224-19EC-BC49-86B7-5D57174F25D1}">
      <dgm:prSet/>
      <dgm:spPr/>
      <dgm:t>
        <a:bodyPr/>
        <a:lstStyle/>
        <a:p>
          <a:endParaRPr lang="en-GB"/>
        </a:p>
      </dgm:t>
    </dgm:pt>
    <dgm:pt modelId="{CAC3CACD-CDE9-AE45-9323-B3BDD4088AF3}" type="sibTrans" cxnId="{4D2CC224-19EC-BC49-86B7-5D57174F25D1}">
      <dgm:prSet/>
      <dgm:spPr/>
      <dgm:t>
        <a:bodyPr/>
        <a:lstStyle/>
        <a:p>
          <a:endParaRPr lang="en-GB"/>
        </a:p>
      </dgm:t>
    </dgm:pt>
    <dgm:pt modelId="{C11BB007-9F54-0348-BE82-3BC62D65DAC5}">
      <dgm:prSet phldrT="[Text]"/>
      <dgm:spPr/>
      <dgm:t>
        <a:bodyPr/>
        <a:lstStyle/>
        <a:p>
          <a:r>
            <a:rPr lang="en-GB" dirty="0"/>
            <a:t>Analyse and interpret findings</a:t>
          </a:r>
        </a:p>
      </dgm:t>
    </dgm:pt>
    <dgm:pt modelId="{65D93766-F6A7-7749-978E-C6718CCB749A}" type="parTrans" cxnId="{4BEA6609-D67E-1041-838E-F482D69CE42A}">
      <dgm:prSet/>
      <dgm:spPr/>
      <dgm:t>
        <a:bodyPr/>
        <a:lstStyle/>
        <a:p>
          <a:endParaRPr lang="en-GB"/>
        </a:p>
      </dgm:t>
    </dgm:pt>
    <dgm:pt modelId="{144BFC2F-3C36-144B-B257-CB4D7B30721D}" type="sibTrans" cxnId="{4BEA6609-D67E-1041-838E-F482D69CE42A}">
      <dgm:prSet/>
      <dgm:spPr/>
      <dgm:t>
        <a:bodyPr/>
        <a:lstStyle/>
        <a:p>
          <a:endParaRPr lang="en-GB"/>
        </a:p>
      </dgm:t>
    </dgm:pt>
    <dgm:pt modelId="{1FA61355-A77C-574C-8C0A-60C0FD4910FD}">
      <dgm:prSet phldrT="[Text]"/>
      <dgm:spPr/>
      <dgm:t>
        <a:bodyPr/>
        <a:lstStyle/>
        <a:p>
          <a:r>
            <a:rPr lang="en-GB" dirty="0"/>
            <a:t>Disseminate</a:t>
          </a:r>
        </a:p>
      </dgm:t>
    </dgm:pt>
    <dgm:pt modelId="{3CA8528F-6AC2-7C4A-812A-4F2767E7EA72}" type="parTrans" cxnId="{FF82827E-E08E-7B42-961F-EFA0AE610155}">
      <dgm:prSet/>
      <dgm:spPr/>
      <dgm:t>
        <a:bodyPr/>
        <a:lstStyle/>
        <a:p>
          <a:endParaRPr lang="en-GB"/>
        </a:p>
      </dgm:t>
    </dgm:pt>
    <dgm:pt modelId="{4A4D2591-61EC-4C41-8583-336875443AD1}" type="sibTrans" cxnId="{FF82827E-E08E-7B42-961F-EFA0AE610155}">
      <dgm:prSet/>
      <dgm:spPr/>
      <dgm:t>
        <a:bodyPr/>
        <a:lstStyle/>
        <a:p>
          <a:endParaRPr lang="en-GB"/>
        </a:p>
      </dgm:t>
    </dgm:pt>
    <dgm:pt modelId="{F8176310-E128-DC4B-B5FB-592CF890C5A7}">
      <dgm:prSet phldrT="[Text]"/>
      <dgm:spPr/>
      <dgm:t>
        <a:bodyPr/>
        <a:lstStyle/>
        <a:p>
          <a:r>
            <a:rPr lang="en-GB" dirty="0"/>
            <a:t>Evaluate</a:t>
          </a:r>
        </a:p>
      </dgm:t>
    </dgm:pt>
    <dgm:pt modelId="{EA2C3E9A-B1C9-F341-AF96-BB86805A44F0}" type="parTrans" cxnId="{DDFF6F67-2AE4-0C44-A5E5-41C1FDCF6778}">
      <dgm:prSet/>
      <dgm:spPr/>
      <dgm:t>
        <a:bodyPr/>
        <a:lstStyle/>
        <a:p>
          <a:endParaRPr lang="en-GB"/>
        </a:p>
      </dgm:t>
    </dgm:pt>
    <dgm:pt modelId="{85582E92-BAC4-2740-ABAC-EC352743D651}" type="sibTrans" cxnId="{DDFF6F67-2AE4-0C44-A5E5-41C1FDCF6778}">
      <dgm:prSet/>
      <dgm:spPr/>
      <dgm:t>
        <a:bodyPr/>
        <a:lstStyle/>
        <a:p>
          <a:endParaRPr lang="en-GB"/>
        </a:p>
      </dgm:t>
    </dgm:pt>
    <dgm:pt modelId="{093022C1-D630-5949-8474-739FBE5D876B}">
      <dgm:prSet phldrT="[Text]"/>
      <dgm:spPr/>
      <dgm:t>
        <a:bodyPr/>
        <a:lstStyle/>
        <a:p>
          <a:r>
            <a:rPr lang="en-GB" dirty="0"/>
            <a:t>Act on findings</a:t>
          </a:r>
        </a:p>
      </dgm:t>
    </dgm:pt>
    <dgm:pt modelId="{854D18CD-80A4-BF47-9C74-F86936DBEEAB}" type="parTrans" cxnId="{4ECDD128-239D-1542-9008-29EEF63A1C3D}">
      <dgm:prSet/>
      <dgm:spPr/>
      <dgm:t>
        <a:bodyPr/>
        <a:lstStyle/>
        <a:p>
          <a:endParaRPr lang="en-GB"/>
        </a:p>
      </dgm:t>
    </dgm:pt>
    <dgm:pt modelId="{EE99D27B-EDEF-EF48-96AC-ECC66E704C2E}" type="sibTrans" cxnId="{4ECDD128-239D-1542-9008-29EEF63A1C3D}">
      <dgm:prSet/>
      <dgm:spPr/>
      <dgm:t>
        <a:bodyPr/>
        <a:lstStyle/>
        <a:p>
          <a:endParaRPr lang="en-GB"/>
        </a:p>
      </dgm:t>
    </dgm:pt>
    <dgm:pt modelId="{BEFCDFDC-31B4-394F-B6DC-AEEEFC84A042}" type="pres">
      <dgm:prSet presAssocID="{A5D9A408-9F42-954E-9533-247B8D2AC1A5}" presName="cycle" presStyleCnt="0">
        <dgm:presLayoutVars>
          <dgm:dir/>
          <dgm:resizeHandles val="exact"/>
        </dgm:presLayoutVars>
      </dgm:prSet>
      <dgm:spPr/>
    </dgm:pt>
    <dgm:pt modelId="{D574BFB6-BEF1-8C4C-8B68-6F0C449AC879}" type="pres">
      <dgm:prSet presAssocID="{A18297FA-39DE-F046-AADF-44A9D6EA28E1}" presName="node" presStyleLbl="node1" presStyleIdx="0" presStyleCnt="9">
        <dgm:presLayoutVars>
          <dgm:bulletEnabled val="1"/>
        </dgm:presLayoutVars>
      </dgm:prSet>
      <dgm:spPr/>
    </dgm:pt>
    <dgm:pt modelId="{04741F94-04F5-944A-AA75-A52B581B08EB}" type="pres">
      <dgm:prSet presAssocID="{A18297FA-39DE-F046-AADF-44A9D6EA28E1}" presName="spNode" presStyleCnt="0"/>
      <dgm:spPr/>
    </dgm:pt>
    <dgm:pt modelId="{898433E3-2070-1F49-9809-E8CFFC177272}" type="pres">
      <dgm:prSet presAssocID="{43E137FF-92F4-4E41-B79D-52D977D6C099}" presName="sibTrans" presStyleLbl="sibTrans1D1" presStyleIdx="0" presStyleCnt="9"/>
      <dgm:spPr/>
    </dgm:pt>
    <dgm:pt modelId="{5F7A9264-01C6-C443-BFDE-FEF35C937F56}" type="pres">
      <dgm:prSet presAssocID="{775F3146-D841-DF44-A9BA-A58935E33788}" presName="node" presStyleLbl="node1" presStyleIdx="1" presStyleCnt="9">
        <dgm:presLayoutVars>
          <dgm:bulletEnabled val="1"/>
        </dgm:presLayoutVars>
      </dgm:prSet>
      <dgm:spPr/>
    </dgm:pt>
    <dgm:pt modelId="{B3EC3292-64F5-8642-B0CA-3A2250C83DEF}" type="pres">
      <dgm:prSet presAssocID="{775F3146-D841-DF44-A9BA-A58935E33788}" presName="spNode" presStyleCnt="0"/>
      <dgm:spPr/>
    </dgm:pt>
    <dgm:pt modelId="{B371DBB0-DEDB-914B-9AFF-7586E37A0CF6}" type="pres">
      <dgm:prSet presAssocID="{3C05C41F-A01D-3F41-85A5-42ACD3217FE0}" presName="sibTrans" presStyleLbl="sibTrans1D1" presStyleIdx="1" presStyleCnt="9"/>
      <dgm:spPr/>
    </dgm:pt>
    <dgm:pt modelId="{F039F0EB-D869-DF43-8B8E-C29408B796EB}" type="pres">
      <dgm:prSet presAssocID="{C7391DB6-008B-1045-881A-500864D378BA}" presName="node" presStyleLbl="node1" presStyleIdx="2" presStyleCnt="9">
        <dgm:presLayoutVars>
          <dgm:bulletEnabled val="1"/>
        </dgm:presLayoutVars>
      </dgm:prSet>
      <dgm:spPr/>
    </dgm:pt>
    <dgm:pt modelId="{681DBF75-0482-0B49-8C5C-FDCCB455E790}" type="pres">
      <dgm:prSet presAssocID="{C7391DB6-008B-1045-881A-500864D378BA}" presName="spNode" presStyleCnt="0"/>
      <dgm:spPr/>
    </dgm:pt>
    <dgm:pt modelId="{50EE490F-4F8E-9049-B615-10D6612BF852}" type="pres">
      <dgm:prSet presAssocID="{A0B3E19E-6337-9348-A48D-F00006ABCD61}" presName="sibTrans" presStyleLbl="sibTrans1D1" presStyleIdx="2" presStyleCnt="9"/>
      <dgm:spPr/>
    </dgm:pt>
    <dgm:pt modelId="{97452FB2-9725-6644-8F45-8091549EC3C6}" type="pres">
      <dgm:prSet presAssocID="{704B344C-9FAD-F04B-A961-D48B354C4D80}" presName="node" presStyleLbl="node1" presStyleIdx="3" presStyleCnt="9">
        <dgm:presLayoutVars>
          <dgm:bulletEnabled val="1"/>
        </dgm:presLayoutVars>
      </dgm:prSet>
      <dgm:spPr/>
    </dgm:pt>
    <dgm:pt modelId="{FE758242-03FB-CF43-80AD-996A0610A9E1}" type="pres">
      <dgm:prSet presAssocID="{704B344C-9FAD-F04B-A961-D48B354C4D80}" presName="spNode" presStyleCnt="0"/>
      <dgm:spPr/>
    </dgm:pt>
    <dgm:pt modelId="{454A1872-84E1-A440-9E23-9BA8B373C188}" type="pres">
      <dgm:prSet presAssocID="{AA189D3C-72DF-1246-88CA-A852CE1FAC66}" presName="sibTrans" presStyleLbl="sibTrans1D1" presStyleIdx="3" presStyleCnt="9"/>
      <dgm:spPr/>
    </dgm:pt>
    <dgm:pt modelId="{2EAB5438-31E8-064A-A4B0-3F2DE2B6D4E6}" type="pres">
      <dgm:prSet presAssocID="{E7CF490F-91DC-F846-A3A6-D3A2EF638F83}" presName="node" presStyleLbl="node1" presStyleIdx="4" presStyleCnt="9">
        <dgm:presLayoutVars>
          <dgm:bulletEnabled val="1"/>
        </dgm:presLayoutVars>
      </dgm:prSet>
      <dgm:spPr/>
    </dgm:pt>
    <dgm:pt modelId="{A56C7289-B605-8C48-A7ED-788D64A3C1B3}" type="pres">
      <dgm:prSet presAssocID="{E7CF490F-91DC-F846-A3A6-D3A2EF638F83}" presName="spNode" presStyleCnt="0"/>
      <dgm:spPr/>
    </dgm:pt>
    <dgm:pt modelId="{592DEB87-05BA-314E-9E5D-A0994FBB9BE7}" type="pres">
      <dgm:prSet presAssocID="{CAC3CACD-CDE9-AE45-9323-B3BDD4088AF3}" presName="sibTrans" presStyleLbl="sibTrans1D1" presStyleIdx="4" presStyleCnt="9"/>
      <dgm:spPr/>
    </dgm:pt>
    <dgm:pt modelId="{B61B4333-12E9-EA4E-96BE-541075F519B1}" type="pres">
      <dgm:prSet presAssocID="{C11BB007-9F54-0348-BE82-3BC62D65DAC5}" presName="node" presStyleLbl="node1" presStyleIdx="5" presStyleCnt="9">
        <dgm:presLayoutVars>
          <dgm:bulletEnabled val="1"/>
        </dgm:presLayoutVars>
      </dgm:prSet>
      <dgm:spPr/>
    </dgm:pt>
    <dgm:pt modelId="{1999164E-B41C-E748-984D-D95DF71999F3}" type="pres">
      <dgm:prSet presAssocID="{C11BB007-9F54-0348-BE82-3BC62D65DAC5}" presName="spNode" presStyleCnt="0"/>
      <dgm:spPr/>
    </dgm:pt>
    <dgm:pt modelId="{1DCD3E9D-C78C-A144-B7E8-BE98F083AEB6}" type="pres">
      <dgm:prSet presAssocID="{144BFC2F-3C36-144B-B257-CB4D7B30721D}" presName="sibTrans" presStyleLbl="sibTrans1D1" presStyleIdx="5" presStyleCnt="9"/>
      <dgm:spPr/>
    </dgm:pt>
    <dgm:pt modelId="{18BCA952-D167-F945-8867-AD4C9D2398AB}" type="pres">
      <dgm:prSet presAssocID="{1FA61355-A77C-574C-8C0A-60C0FD4910FD}" presName="node" presStyleLbl="node1" presStyleIdx="6" presStyleCnt="9">
        <dgm:presLayoutVars>
          <dgm:bulletEnabled val="1"/>
        </dgm:presLayoutVars>
      </dgm:prSet>
      <dgm:spPr/>
    </dgm:pt>
    <dgm:pt modelId="{B4417D4B-F281-1143-84C1-686D272378B4}" type="pres">
      <dgm:prSet presAssocID="{1FA61355-A77C-574C-8C0A-60C0FD4910FD}" presName="spNode" presStyleCnt="0"/>
      <dgm:spPr/>
    </dgm:pt>
    <dgm:pt modelId="{B9ABB65A-E4F9-2446-9DC0-16FA01C2810E}" type="pres">
      <dgm:prSet presAssocID="{4A4D2591-61EC-4C41-8583-336875443AD1}" presName="sibTrans" presStyleLbl="sibTrans1D1" presStyleIdx="6" presStyleCnt="9"/>
      <dgm:spPr/>
    </dgm:pt>
    <dgm:pt modelId="{BBB9B9B7-392F-044F-9D6F-255404CF4C1D}" type="pres">
      <dgm:prSet presAssocID="{F8176310-E128-DC4B-B5FB-592CF890C5A7}" presName="node" presStyleLbl="node1" presStyleIdx="7" presStyleCnt="9">
        <dgm:presLayoutVars>
          <dgm:bulletEnabled val="1"/>
        </dgm:presLayoutVars>
      </dgm:prSet>
      <dgm:spPr/>
    </dgm:pt>
    <dgm:pt modelId="{82579739-B1E5-3A4D-916A-92CDD6F5EEAF}" type="pres">
      <dgm:prSet presAssocID="{F8176310-E128-DC4B-B5FB-592CF890C5A7}" presName="spNode" presStyleCnt="0"/>
      <dgm:spPr/>
    </dgm:pt>
    <dgm:pt modelId="{24E638AC-505A-804E-9219-145CB4495339}" type="pres">
      <dgm:prSet presAssocID="{85582E92-BAC4-2740-ABAC-EC352743D651}" presName="sibTrans" presStyleLbl="sibTrans1D1" presStyleIdx="7" presStyleCnt="9"/>
      <dgm:spPr/>
    </dgm:pt>
    <dgm:pt modelId="{99EB3913-8B6E-E34E-9628-DAC25591E971}" type="pres">
      <dgm:prSet presAssocID="{093022C1-D630-5949-8474-739FBE5D876B}" presName="node" presStyleLbl="node1" presStyleIdx="8" presStyleCnt="9">
        <dgm:presLayoutVars>
          <dgm:bulletEnabled val="1"/>
        </dgm:presLayoutVars>
      </dgm:prSet>
      <dgm:spPr/>
    </dgm:pt>
    <dgm:pt modelId="{AA8F755A-9E3C-FE40-B5A1-AF38A3824191}" type="pres">
      <dgm:prSet presAssocID="{093022C1-D630-5949-8474-739FBE5D876B}" presName="spNode" presStyleCnt="0"/>
      <dgm:spPr/>
    </dgm:pt>
    <dgm:pt modelId="{D8F8ADA8-351A-B544-A873-AEA3C0755809}" type="pres">
      <dgm:prSet presAssocID="{EE99D27B-EDEF-EF48-96AC-ECC66E704C2E}" presName="sibTrans" presStyleLbl="sibTrans1D1" presStyleIdx="8" presStyleCnt="9"/>
      <dgm:spPr/>
    </dgm:pt>
  </dgm:ptLst>
  <dgm:cxnLst>
    <dgm:cxn modelId="{EC4F9300-DE6A-EB4B-9CE3-571589414EBE}" type="presOf" srcId="{CAC3CACD-CDE9-AE45-9323-B3BDD4088AF3}" destId="{592DEB87-05BA-314E-9E5D-A0994FBB9BE7}" srcOrd="0" destOrd="0" presId="urn:microsoft.com/office/officeart/2005/8/layout/cycle5"/>
    <dgm:cxn modelId="{4BEA6609-D67E-1041-838E-F482D69CE42A}" srcId="{A5D9A408-9F42-954E-9533-247B8D2AC1A5}" destId="{C11BB007-9F54-0348-BE82-3BC62D65DAC5}" srcOrd="5" destOrd="0" parTransId="{65D93766-F6A7-7749-978E-C6718CCB749A}" sibTransId="{144BFC2F-3C36-144B-B257-CB4D7B30721D}"/>
    <dgm:cxn modelId="{590BAB09-0784-1A42-8B0A-2AD21B2EE8E6}" type="presOf" srcId="{704B344C-9FAD-F04B-A961-D48B354C4D80}" destId="{97452FB2-9725-6644-8F45-8091549EC3C6}" srcOrd="0" destOrd="0" presId="urn:microsoft.com/office/officeart/2005/8/layout/cycle5"/>
    <dgm:cxn modelId="{235ABD10-7E44-684C-B18B-B7F5CCBE7FC3}" type="presOf" srcId="{A0B3E19E-6337-9348-A48D-F00006ABCD61}" destId="{50EE490F-4F8E-9049-B615-10D6612BF852}" srcOrd="0" destOrd="0" presId="urn:microsoft.com/office/officeart/2005/8/layout/cycle5"/>
    <dgm:cxn modelId="{C3235C1A-47E1-FA40-8900-8EDB3093E471}" type="presOf" srcId="{43E137FF-92F4-4E41-B79D-52D977D6C099}" destId="{898433E3-2070-1F49-9809-E8CFFC177272}" srcOrd="0" destOrd="0" presId="urn:microsoft.com/office/officeart/2005/8/layout/cycle5"/>
    <dgm:cxn modelId="{55F5301B-1D94-CB4C-90D1-AB09AF8E4255}" type="presOf" srcId="{775F3146-D841-DF44-A9BA-A58935E33788}" destId="{5F7A9264-01C6-C443-BFDE-FEF35C937F56}" srcOrd="0" destOrd="0" presId="urn:microsoft.com/office/officeart/2005/8/layout/cycle5"/>
    <dgm:cxn modelId="{4D2CC224-19EC-BC49-86B7-5D57174F25D1}" srcId="{A5D9A408-9F42-954E-9533-247B8D2AC1A5}" destId="{E7CF490F-91DC-F846-A3A6-D3A2EF638F83}" srcOrd="4" destOrd="0" parTransId="{2C1E0E50-55FC-4D43-A176-592EBF4A58F3}" sibTransId="{CAC3CACD-CDE9-AE45-9323-B3BDD4088AF3}"/>
    <dgm:cxn modelId="{4ECDD128-239D-1542-9008-29EEF63A1C3D}" srcId="{A5D9A408-9F42-954E-9533-247B8D2AC1A5}" destId="{093022C1-D630-5949-8474-739FBE5D876B}" srcOrd="8" destOrd="0" parTransId="{854D18CD-80A4-BF47-9C74-F86936DBEEAB}" sibTransId="{EE99D27B-EDEF-EF48-96AC-ECC66E704C2E}"/>
    <dgm:cxn modelId="{45093230-BD9A-454C-A79C-E09623B80812}" srcId="{A5D9A408-9F42-954E-9533-247B8D2AC1A5}" destId="{C7391DB6-008B-1045-881A-500864D378BA}" srcOrd="2" destOrd="0" parTransId="{562F6C85-B65D-2549-AAF4-035CEA65435F}" sibTransId="{A0B3E19E-6337-9348-A48D-F00006ABCD61}"/>
    <dgm:cxn modelId="{570B5A36-FEE3-E040-8E3F-8DB65D2E5276}" type="presOf" srcId="{85582E92-BAC4-2740-ABAC-EC352743D651}" destId="{24E638AC-505A-804E-9219-145CB4495339}" srcOrd="0" destOrd="0" presId="urn:microsoft.com/office/officeart/2005/8/layout/cycle5"/>
    <dgm:cxn modelId="{0D3DBC3B-F96A-654A-A7CB-E13CFCE3ED08}" type="presOf" srcId="{AA189D3C-72DF-1246-88CA-A852CE1FAC66}" destId="{454A1872-84E1-A440-9E23-9BA8B373C188}" srcOrd="0" destOrd="0" presId="urn:microsoft.com/office/officeart/2005/8/layout/cycle5"/>
    <dgm:cxn modelId="{03EC9040-9411-2E48-8632-A9F18DE09AA9}" type="presOf" srcId="{3C05C41F-A01D-3F41-85A5-42ACD3217FE0}" destId="{B371DBB0-DEDB-914B-9AFF-7586E37A0CF6}" srcOrd="0" destOrd="0" presId="urn:microsoft.com/office/officeart/2005/8/layout/cycle5"/>
    <dgm:cxn modelId="{4EDBB645-F288-6749-8846-4F1E2D82303C}" type="presOf" srcId="{A5D9A408-9F42-954E-9533-247B8D2AC1A5}" destId="{BEFCDFDC-31B4-394F-B6DC-AEEEFC84A042}" srcOrd="0" destOrd="0" presId="urn:microsoft.com/office/officeart/2005/8/layout/cycle5"/>
    <dgm:cxn modelId="{DDFF6F67-2AE4-0C44-A5E5-41C1FDCF6778}" srcId="{A5D9A408-9F42-954E-9533-247B8D2AC1A5}" destId="{F8176310-E128-DC4B-B5FB-592CF890C5A7}" srcOrd="7" destOrd="0" parTransId="{EA2C3E9A-B1C9-F341-AF96-BB86805A44F0}" sibTransId="{85582E92-BAC4-2740-ABAC-EC352743D651}"/>
    <dgm:cxn modelId="{577F466A-3450-D24C-A92E-27B956327618}" srcId="{A5D9A408-9F42-954E-9533-247B8D2AC1A5}" destId="{775F3146-D841-DF44-A9BA-A58935E33788}" srcOrd="1" destOrd="0" parTransId="{715EE54C-716B-EE47-BAD7-4871A08663CD}" sibTransId="{3C05C41F-A01D-3F41-85A5-42ACD3217FE0}"/>
    <dgm:cxn modelId="{6ACE664C-C2A0-004F-9BFF-41B5ADA46048}" srcId="{A5D9A408-9F42-954E-9533-247B8D2AC1A5}" destId="{A18297FA-39DE-F046-AADF-44A9D6EA28E1}" srcOrd="0" destOrd="0" parTransId="{4C3D318C-7550-6A46-9DC2-1DC50BBD345B}" sibTransId="{43E137FF-92F4-4E41-B79D-52D977D6C099}"/>
    <dgm:cxn modelId="{EC6F6771-4F32-A54B-BC29-B3FD92F3BF40}" type="presOf" srcId="{EE99D27B-EDEF-EF48-96AC-ECC66E704C2E}" destId="{D8F8ADA8-351A-B544-A873-AEA3C0755809}" srcOrd="0" destOrd="0" presId="urn:microsoft.com/office/officeart/2005/8/layout/cycle5"/>
    <dgm:cxn modelId="{7FB57878-7494-ED45-95EC-5714925AFF27}" type="presOf" srcId="{C11BB007-9F54-0348-BE82-3BC62D65DAC5}" destId="{B61B4333-12E9-EA4E-96BE-541075F519B1}" srcOrd="0" destOrd="0" presId="urn:microsoft.com/office/officeart/2005/8/layout/cycle5"/>
    <dgm:cxn modelId="{09616E7B-CB8C-9044-8314-4A92E123C0CE}" type="presOf" srcId="{E7CF490F-91DC-F846-A3A6-D3A2EF638F83}" destId="{2EAB5438-31E8-064A-A4B0-3F2DE2B6D4E6}" srcOrd="0" destOrd="0" presId="urn:microsoft.com/office/officeart/2005/8/layout/cycle5"/>
    <dgm:cxn modelId="{FF82827E-E08E-7B42-961F-EFA0AE610155}" srcId="{A5D9A408-9F42-954E-9533-247B8D2AC1A5}" destId="{1FA61355-A77C-574C-8C0A-60C0FD4910FD}" srcOrd="6" destOrd="0" parTransId="{3CA8528F-6AC2-7C4A-812A-4F2767E7EA72}" sibTransId="{4A4D2591-61EC-4C41-8583-336875443AD1}"/>
    <dgm:cxn modelId="{3F85B383-5260-3840-9860-14B4EACF1AA9}" type="presOf" srcId="{093022C1-D630-5949-8474-739FBE5D876B}" destId="{99EB3913-8B6E-E34E-9628-DAC25591E971}" srcOrd="0" destOrd="0" presId="urn:microsoft.com/office/officeart/2005/8/layout/cycle5"/>
    <dgm:cxn modelId="{9E4E8585-0343-334B-9109-C295C9E11DBC}" type="presOf" srcId="{A18297FA-39DE-F046-AADF-44A9D6EA28E1}" destId="{D574BFB6-BEF1-8C4C-8B68-6F0C449AC879}" srcOrd="0" destOrd="0" presId="urn:microsoft.com/office/officeart/2005/8/layout/cycle5"/>
    <dgm:cxn modelId="{DD132989-162D-104F-A1D1-FB88A665DF31}" type="presOf" srcId="{1FA61355-A77C-574C-8C0A-60C0FD4910FD}" destId="{18BCA952-D167-F945-8867-AD4C9D2398AB}" srcOrd="0" destOrd="0" presId="urn:microsoft.com/office/officeart/2005/8/layout/cycle5"/>
    <dgm:cxn modelId="{10E35E9C-FA10-4E4E-9AA0-1B05F950A98D}" type="presOf" srcId="{4A4D2591-61EC-4C41-8583-336875443AD1}" destId="{B9ABB65A-E4F9-2446-9DC0-16FA01C2810E}" srcOrd="0" destOrd="0" presId="urn:microsoft.com/office/officeart/2005/8/layout/cycle5"/>
    <dgm:cxn modelId="{4B9903EC-829D-E94C-BE8F-83F86D15CC89}" type="presOf" srcId="{144BFC2F-3C36-144B-B257-CB4D7B30721D}" destId="{1DCD3E9D-C78C-A144-B7E8-BE98F083AEB6}" srcOrd="0" destOrd="0" presId="urn:microsoft.com/office/officeart/2005/8/layout/cycle5"/>
    <dgm:cxn modelId="{3BA596EF-0C47-E14A-AF30-43E63CBD553B}" srcId="{A5D9A408-9F42-954E-9533-247B8D2AC1A5}" destId="{704B344C-9FAD-F04B-A961-D48B354C4D80}" srcOrd="3" destOrd="0" parTransId="{ACA6BB9A-2BB7-BD46-B3A5-AE2BA0F3B0F5}" sibTransId="{AA189D3C-72DF-1246-88CA-A852CE1FAC66}"/>
    <dgm:cxn modelId="{987088F0-0B28-8246-8B89-01F276488EBF}" type="presOf" srcId="{F8176310-E128-DC4B-B5FB-592CF890C5A7}" destId="{BBB9B9B7-392F-044F-9D6F-255404CF4C1D}" srcOrd="0" destOrd="0" presId="urn:microsoft.com/office/officeart/2005/8/layout/cycle5"/>
    <dgm:cxn modelId="{7BDA0FF6-33EF-FB4C-B9E1-F3DEF1E45A91}" type="presOf" srcId="{C7391DB6-008B-1045-881A-500864D378BA}" destId="{F039F0EB-D869-DF43-8B8E-C29408B796EB}" srcOrd="0" destOrd="0" presId="urn:microsoft.com/office/officeart/2005/8/layout/cycle5"/>
    <dgm:cxn modelId="{1831DE0A-E8BD-D04A-9A5E-ECBC57F727CF}" type="presParOf" srcId="{BEFCDFDC-31B4-394F-B6DC-AEEEFC84A042}" destId="{D574BFB6-BEF1-8C4C-8B68-6F0C449AC879}" srcOrd="0" destOrd="0" presId="urn:microsoft.com/office/officeart/2005/8/layout/cycle5"/>
    <dgm:cxn modelId="{82411476-1682-2E40-9D93-6A28D00DAC6D}" type="presParOf" srcId="{BEFCDFDC-31B4-394F-B6DC-AEEEFC84A042}" destId="{04741F94-04F5-944A-AA75-A52B581B08EB}" srcOrd="1" destOrd="0" presId="urn:microsoft.com/office/officeart/2005/8/layout/cycle5"/>
    <dgm:cxn modelId="{9EFADA66-8FDA-C248-9D2C-AF28220955AF}" type="presParOf" srcId="{BEFCDFDC-31B4-394F-B6DC-AEEEFC84A042}" destId="{898433E3-2070-1F49-9809-E8CFFC177272}" srcOrd="2" destOrd="0" presId="urn:microsoft.com/office/officeart/2005/8/layout/cycle5"/>
    <dgm:cxn modelId="{4EF40AE6-40E9-244B-96D9-377521C40AC8}" type="presParOf" srcId="{BEFCDFDC-31B4-394F-B6DC-AEEEFC84A042}" destId="{5F7A9264-01C6-C443-BFDE-FEF35C937F56}" srcOrd="3" destOrd="0" presId="urn:microsoft.com/office/officeart/2005/8/layout/cycle5"/>
    <dgm:cxn modelId="{775197DB-F50D-F345-B9EA-68D620D60F1F}" type="presParOf" srcId="{BEFCDFDC-31B4-394F-B6DC-AEEEFC84A042}" destId="{B3EC3292-64F5-8642-B0CA-3A2250C83DEF}" srcOrd="4" destOrd="0" presId="urn:microsoft.com/office/officeart/2005/8/layout/cycle5"/>
    <dgm:cxn modelId="{BC4443C3-E50D-1541-B20A-A5EEDB7B6824}" type="presParOf" srcId="{BEFCDFDC-31B4-394F-B6DC-AEEEFC84A042}" destId="{B371DBB0-DEDB-914B-9AFF-7586E37A0CF6}" srcOrd="5" destOrd="0" presId="urn:microsoft.com/office/officeart/2005/8/layout/cycle5"/>
    <dgm:cxn modelId="{CBAC1E2B-FF68-A443-8D4D-0D400DEB757F}" type="presParOf" srcId="{BEFCDFDC-31B4-394F-B6DC-AEEEFC84A042}" destId="{F039F0EB-D869-DF43-8B8E-C29408B796EB}" srcOrd="6" destOrd="0" presId="urn:microsoft.com/office/officeart/2005/8/layout/cycle5"/>
    <dgm:cxn modelId="{42A54530-49F4-4C4C-95BA-59015D6999AF}" type="presParOf" srcId="{BEFCDFDC-31B4-394F-B6DC-AEEEFC84A042}" destId="{681DBF75-0482-0B49-8C5C-FDCCB455E790}" srcOrd="7" destOrd="0" presId="urn:microsoft.com/office/officeart/2005/8/layout/cycle5"/>
    <dgm:cxn modelId="{73690491-E452-6B48-949A-19100563189D}" type="presParOf" srcId="{BEFCDFDC-31B4-394F-B6DC-AEEEFC84A042}" destId="{50EE490F-4F8E-9049-B615-10D6612BF852}" srcOrd="8" destOrd="0" presId="urn:microsoft.com/office/officeart/2005/8/layout/cycle5"/>
    <dgm:cxn modelId="{8AFEE76F-FCC5-8548-9FA7-5811512060D3}" type="presParOf" srcId="{BEFCDFDC-31B4-394F-B6DC-AEEEFC84A042}" destId="{97452FB2-9725-6644-8F45-8091549EC3C6}" srcOrd="9" destOrd="0" presId="urn:microsoft.com/office/officeart/2005/8/layout/cycle5"/>
    <dgm:cxn modelId="{7C90763D-4629-3640-B572-896CE5C4841C}" type="presParOf" srcId="{BEFCDFDC-31B4-394F-B6DC-AEEEFC84A042}" destId="{FE758242-03FB-CF43-80AD-996A0610A9E1}" srcOrd="10" destOrd="0" presId="urn:microsoft.com/office/officeart/2005/8/layout/cycle5"/>
    <dgm:cxn modelId="{B5C6B902-3EFC-BE47-AD1C-90F92ABEA431}" type="presParOf" srcId="{BEFCDFDC-31B4-394F-B6DC-AEEEFC84A042}" destId="{454A1872-84E1-A440-9E23-9BA8B373C188}" srcOrd="11" destOrd="0" presId="urn:microsoft.com/office/officeart/2005/8/layout/cycle5"/>
    <dgm:cxn modelId="{78DF2DCB-5BE8-924C-BEBB-BFB554781215}" type="presParOf" srcId="{BEFCDFDC-31B4-394F-B6DC-AEEEFC84A042}" destId="{2EAB5438-31E8-064A-A4B0-3F2DE2B6D4E6}" srcOrd="12" destOrd="0" presId="urn:microsoft.com/office/officeart/2005/8/layout/cycle5"/>
    <dgm:cxn modelId="{2A748B38-0F02-4C47-A7FC-FF91DBE6CE5A}" type="presParOf" srcId="{BEFCDFDC-31B4-394F-B6DC-AEEEFC84A042}" destId="{A56C7289-B605-8C48-A7ED-788D64A3C1B3}" srcOrd="13" destOrd="0" presId="urn:microsoft.com/office/officeart/2005/8/layout/cycle5"/>
    <dgm:cxn modelId="{B1B9F60A-AF58-5647-8B81-5B55AFC50257}" type="presParOf" srcId="{BEFCDFDC-31B4-394F-B6DC-AEEEFC84A042}" destId="{592DEB87-05BA-314E-9E5D-A0994FBB9BE7}" srcOrd="14" destOrd="0" presId="urn:microsoft.com/office/officeart/2005/8/layout/cycle5"/>
    <dgm:cxn modelId="{B8D6194E-3E1D-404E-948F-E125F159BCFE}" type="presParOf" srcId="{BEFCDFDC-31B4-394F-B6DC-AEEEFC84A042}" destId="{B61B4333-12E9-EA4E-96BE-541075F519B1}" srcOrd="15" destOrd="0" presId="urn:microsoft.com/office/officeart/2005/8/layout/cycle5"/>
    <dgm:cxn modelId="{AA57E3D1-7870-BE4D-AF16-DE0BA18C1593}" type="presParOf" srcId="{BEFCDFDC-31B4-394F-B6DC-AEEEFC84A042}" destId="{1999164E-B41C-E748-984D-D95DF71999F3}" srcOrd="16" destOrd="0" presId="urn:microsoft.com/office/officeart/2005/8/layout/cycle5"/>
    <dgm:cxn modelId="{5A04BEA7-6011-484E-A897-D17743D411E5}" type="presParOf" srcId="{BEFCDFDC-31B4-394F-B6DC-AEEEFC84A042}" destId="{1DCD3E9D-C78C-A144-B7E8-BE98F083AEB6}" srcOrd="17" destOrd="0" presId="urn:microsoft.com/office/officeart/2005/8/layout/cycle5"/>
    <dgm:cxn modelId="{532DBB0A-E9F4-6F47-8546-D0F2AEE952AF}" type="presParOf" srcId="{BEFCDFDC-31B4-394F-B6DC-AEEEFC84A042}" destId="{18BCA952-D167-F945-8867-AD4C9D2398AB}" srcOrd="18" destOrd="0" presId="urn:microsoft.com/office/officeart/2005/8/layout/cycle5"/>
    <dgm:cxn modelId="{98CCD086-05EB-0F44-BD12-3121E72B74B0}" type="presParOf" srcId="{BEFCDFDC-31B4-394F-B6DC-AEEEFC84A042}" destId="{B4417D4B-F281-1143-84C1-686D272378B4}" srcOrd="19" destOrd="0" presId="urn:microsoft.com/office/officeart/2005/8/layout/cycle5"/>
    <dgm:cxn modelId="{A1546A76-203A-F547-A33D-8E2280C08198}" type="presParOf" srcId="{BEFCDFDC-31B4-394F-B6DC-AEEEFC84A042}" destId="{B9ABB65A-E4F9-2446-9DC0-16FA01C2810E}" srcOrd="20" destOrd="0" presId="urn:microsoft.com/office/officeart/2005/8/layout/cycle5"/>
    <dgm:cxn modelId="{45B031A7-FF07-4F40-AB00-2F7C6074BD30}" type="presParOf" srcId="{BEFCDFDC-31B4-394F-B6DC-AEEEFC84A042}" destId="{BBB9B9B7-392F-044F-9D6F-255404CF4C1D}" srcOrd="21" destOrd="0" presId="urn:microsoft.com/office/officeart/2005/8/layout/cycle5"/>
    <dgm:cxn modelId="{68C44E0C-0A9E-4348-B3D7-1EC71869C7D2}" type="presParOf" srcId="{BEFCDFDC-31B4-394F-B6DC-AEEEFC84A042}" destId="{82579739-B1E5-3A4D-916A-92CDD6F5EEAF}" srcOrd="22" destOrd="0" presId="urn:microsoft.com/office/officeart/2005/8/layout/cycle5"/>
    <dgm:cxn modelId="{E05515A9-7339-B14A-A56E-A596F2403275}" type="presParOf" srcId="{BEFCDFDC-31B4-394F-B6DC-AEEEFC84A042}" destId="{24E638AC-505A-804E-9219-145CB4495339}" srcOrd="23" destOrd="0" presId="urn:microsoft.com/office/officeart/2005/8/layout/cycle5"/>
    <dgm:cxn modelId="{339B0992-B7BC-8845-A86F-37B19FF16ADC}" type="presParOf" srcId="{BEFCDFDC-31B4-394F-B6DC-AEEEFC84A042}" destId="{99EB3913-8B6E-E34E-9628-DAC25591E971}" srcOrd="24" destOrd="0" presId="urn:microsoft.com/office/officeart/2005/8/layout/cycle5"/>
    <dgm:cxn modelId="{DE516299-D6DA-D948-B7D2-5954CEC1DB28}" type="presParOf" srcId="{BEFCDFDC-31B4-394F-B6DC-AEEEFC84A042}" destId="{AA8F755A-9E3C-FE40-B5A1-AF38A3824191}" srcOrd="25" destOrd="0" presId="urn:microsoft.com/office/officeart/2005/8/layout/cycle5"/>
    <dgm:cxn modelId="{42A4CD3D-362C-424B-8D14-6831D8DE3C71}" type="presParOf" srcId="{BEFCDFDC-31B4-394F-B6DC-AEEEFC84A042}" destId="{D8F8ADA8-351A-B544-A873-AEA3C0755809}" srcOrd="26" destOrd="0" presId="urn:microsoft.com/office/officeart/2005/8/layout/cycle5"/>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A5D9A408-9F42-954E-9533-247B8D2AC1A5}" type="doc">
      <dgm:prSet loTypeId="urn:microsoft.com/office/officeart/2005/8/layout/cycle5" loCatId="" qsTypeId="urn:microsoft.com/office/officeart/2005/8/quickstyle/simple1" qsCatId="simple" csTypeId="urn:microsoft.com/office/officeart/2005/8/colors/accent1_2" csCatId="accent1" phldr="1"/>
      <dgm:spPr/>
      <dgm:t>
        <a:bodyPr/>
        <a:lstStyle/>
        <a:p>
          <a:endParaRPr lang="en-GB"/>
        </a:p>
      </dgm:t>
    </dgm:pt>
    <dgm:pt modelId="{A18297FA-39DE-F046-AADF-44A9D6EA28E1}">
      <dgm:prSet phldrT="[Text]"/>
      <dgm:spPr/>
      <dgm:t>
        <a:bodyPr/>
        <a:lstStyle/>
        <a:p>
          <a:r>
            <a:rPr lang="en-GB" dirty="0"/>
            <a:t>Identify the topic</a:t>
          </a:r>
        </a:p>
      </dgm:t>
    </dgm:pt>
    <dgm:pt modelId="{4C3D318C-7550-6A46-9DC2-1DC50BBD345B}" type="parTrans" cxnId="{6ACE664C-C2A0-004F-9BFF-41B5ADA46048}">
      <dgm:prSet/>
      <dgm:spPr/>
      <dgm:t>
        <a:bodyPr/>
        <a:lstStyle/>
        <a:p>
          <a:endParaRPr lang="en-GB"/>
        </a:p>
      </dgm:t>
    </dgm:pt>
    <dgm:pt modelId="{43E137FF-92F4-4E41-B79D-52D977D6C099}" type="sibTrans" cxnId="{6ACE664C-C2A0-004F-9BFF-41B5ADA46048}">
      <dgm:prSet/>
      <dgm:spPr/>
      <dgm:t>
        <a:bodyPr/>
        <a:lstStyle/>
        <a:p>
          <a:endParaRPr lang="en-GB"/>
        </a:p>
      </dgm:t>
    </dgm:pt>
    <dgm:pt modelId="{775F3146-D841-DF44-A9BA-A58935E33788}">
      <dgm:prSet phldrT="[Text]"/>
      <dgm:spPr/>
      <dgm:t>
        <a:bodyPr/>
        <a:lstStyle/>
        <a:p>
          <a:r>
            <a:rPr lang="en-GB" dirty="0"/>
            <a:t>Seek funding</a:t>
          </a:r>
        </a:p>
      </dgm:t>
    </dgm:pt>
    <dgm:pt modelId="{715EE54C-716B-EE47-BAD7-4871A08663CD}" type="parTrans" cxnId="{577F466A-3450-D24C-A92E-27B956327618}">
      <dgm:prSet/>
      <dgm:spPr/>
      <dgm:t>
        <a:bodyPr/>
        <a:lstStyle/>
        <a:p>
          <a:endParaRPr lang="en-GB"/>
        </a:p>
      </dgm:t>
    </dgm:pt>
    <dgm:pt modelId="{3C05C41F-A01D-3F41-85A5-42ACD3217FE0}" type="sibTrans" cxnId="{577F466A-3450-D24C-A92E-27B956327618}">
      <dgm:prSet/>
      <dgm:spPr/>
      <dgm:t>
        <a:bodyPr/>
        <a:lstStyle/>
        <a:p>
          <a:endParaRPr lang="en-GB"/>
        </a:p>
      </dgm:t>
    </dgm:pt>
    <dgm:pt modelId="{C7391DB6-008B-1045-881A-500864D378BA}">
      <dgm:prSet phldrT="[Text]"/>
      <dgm:spPr/>
      <dgm:t>
        <a:bodyPr/>
        <a:lstStyle/>
        <a:p>
          <a:r>
            <a:rPr lang="en-GB" dirty="0"/>
            <a:t>Design the research project</a:t>
          </a:r>
        </a:p>
      </dgm:t>
    </dgm:pt>
    <dgm:pt modelId="{562F6C85-B65D-2549-AAF4-035CEA65435F}" type="parTrans" cxnId="{45093230-BD9A-454C-A79C-E09623B80812}">
      <dgm:prSet/>
      <dgm:spPr/>
      <dgm:t>
        <a:bodyPr/>
        <a:lstStyle/>
        <a:p>
          <a:endParaRPr lang="en-GB"/>
        </a:p>
      </dgm:t>
    </dgm:pt>
    <dgm:pt modelId="{A0B3E19E-6337-9348-A48D-F00006ABCD61}" type="sibTrans" cxnId="{45093230-BD9A-454C-A79C-E09623B80812}">
      <dgm:prSet/>
      <dgm:spPr/>
      <dgm:t>
        <a:bodyPr/>
        <a:lstStyle/>
        <a:p>
          <a:endParaRPr lang="en-GB"/>
        </a:p>
      </dgm:t>
    </dgm:pt>
    <dgm:pt modelId="{704B344C-9FAD-F04B-A961-D48B354C4D80}">
      <dgm:prSet phldrT="[Text]"/>
      <dgm:spPr/>
      <dgm:t>
        <a:bodyPr/>
        <a:lstStyle/>
        <a:p>
          <a:r>
            <a:rPr lang="en-GB" dirty="0"/>
            <a:t>Manage the research</a:t>
          </a:r>
        </a:p>
      </dgm:t>
    </dgm:pt>
    <dgm:pt modelId="{ACA6BB9A-2BB7-BD46-B3A5-AE2BA0F3B0F5}" type="parTrans" cxnId="{3BA596EF-0C47-E14A-AF30-43E63CBD553B}">
      <dgm:prSet/>
      <dgm:spPr/>
      <dgm:t>
        <a:bodyPr/>
        <a:lstStyle/>
        <a:p>
          <a:endParaRPr lang="en-GB"/>
        </a:p>
      </dgm:t>
    </dgm:pt>
    <dgm:pt modelId="{AA189D3C-72DF-1246-88CA-A852CE1FAC66}" type="sibTrans" cxnId="{3BA596EF-0C47-E14A-AF30-43E63CBD553B}">
      <dgm:prSet/>
      <dgm:spPr/>
      <dgm:t>
        <a:bodyPr/>
        <a:lstStyle/>
        <a:p>
          <a:endParaRPr lang="en-GB"/>
        </a:p>
      </dgm:t>
    </dgm:pt>
    <dgm:pt modelId="{E7CF490F-91DC-F846-A3A6-D3A2EF638F83}">
      <dgm:prSet phldrT="[Text]"/>
      <dgm:spPr/>
      <dgm:t>
        <a:bodyPr/>
        <a:lstStyle/>
        <a:p>
          <a:r>
            <a:rPr lang="en-GB" dirty="0"/>
            <a:t>Conduct the research</a:t>
          </a:r>
        </a:p>
      </dgm:t>
    </dgm:pt>
    <dgm:pt modelId="{2C1E0E50-55FC-4D43-A176-592EBF4A58F3}" type="parTrans" cxnId="{4D2CC224-19EC-BC49-86B7-5D57174F25D1}">
      <dgm:prSet/>
      <dgm:spPr/>
      <dgm:t>
        <a:bodyPr/>
        <a:lstStyle/>
        <a:p>
          <a:endParaRPr lang="en-GB"/>
        </a:p>
      </dgm:t>
    </dgm:pt>
    <dgm:pt modelId="{CAC3CACD-CDE9-AE45-9323-B3BDD4088AF3}" type="sibTrans" cxnId="{4D2CC224-19EC-BC49-86B7-5D57174F25D1}">
      <dgm:prSet/>
      <dgm:spPr/>
      <dgm:t>
        <a:bodyPr/>
        <a:lstStyle/>
        <a:p>
          <a:endParaRPr lang="en-GB"/>
        </a:p>
      </dgm:t>
    </dgm:pt>
    <dgm:pt modelId="{C11BB007-9F54-0348-BE82-3BC62D65DAC5}">
      <dgm:prSet phldrT="[Text]"/>
      <dgm:spPr/>
      <dgm:t>
        <a:bodyPr/>
        <a:lstStyle/>
        <a:p>
          <a:r>
            <a:rPr lang="en-GB" dirty="0"/>
            <a:t>Analyse and interpret findings</a:t>
          </a:r>
        </a:p>
      </dgm:t>
    </dgm:pt>
    <dgm:pt modelId="{65D93766-F6A7-7749-978E-C6718CCB749A}" type="parTrans" cxnId="{4BEA6609-D67E-1041-838E-F482D69CE42A}">
      <dgm:prSet/>
      <dgm:spPr/>
      <dgm:t>
        <a:bodyPr/>
        <a:lstStyle/>
        <a:p>
          <a:endParaRPr lang="en-GB"/>
        </a:p>
      </dgm:t>
    </dgm:pt>
    <dgm:pt modelId="{144BFC2F-3C36-144B-B257-CB4D7B30721D}" type="sibTrans" cxnId="{4BEA6609-D67E-1041-838E-F482D69CE42A}">
      <dgm:prSet/>
      <dgm:spPr/>
      <dgm:t>
        <a:bodyPr/>
        <a:lstStyle/>
        <a:p>
          <a:endParaRPr lang="en-GB"/>
        </a:p>
      </dgm:t>
    </dgm:pt>
    <dgm:pt modelId="{1FA61355-A77C-574C-8C0A-60C0FD4910FD}">
      <dgm:prSet phldrT="[Text]"/>
      <dgm:spPr/>
      <dgm:t>
        <a:bodyPr/>
        <a:lstStyle/>
        <a:p>
          <a:r>
            <a:rPr lang="en-GB" dirty="0"/>
            <a:t>Disseminate</a:t>
          </a:r>
        </a:p>
      </dgm:t>
    </dgm:pt>
    <dgm:pt modelId="{3CA8528F-6AC2-7C4A-812A-4F2767E7EA72}" type="parTrans" cxnId="{FF82827E-E08E-7B42-961F-EFA0AE610155}">
      <dgm:prSet/>
      <dgm:spPr/>
      <dgm:t>
        <a:bodyPr/>
        <a:lstStyle/>
        <a:p>
          <a:endParaRPr lang="en-GB"/>
        </a:p>
      </dgm:t>
    </dgm:pt>
    <dgm:pt modelId="{4A4D2591-61EC-4C41-8583-336875443AD1}" type="sibTrans" cxnId="{FF82827E-E08E-7B42-961F-EFA0AE610155}">
      <dgm:prSet/>
      <dgm:spPr/>
      <dgm:t>
        <a:bodyPr/>
        <a:lstStyle/>
        <a:p>
          <a:endParaRPr lang="en-GB"/>
        </a:p>
      </dgm:t>
    </dgm:pt>
    <dgm:pt modelId="{F8176310-E128-DC4B-B5FB-592CF890C5A7}">
      <dgm:prSet phldrT="[Text]"/>
      <dgm:spPr/>
      <dgm:t>
        <a:bodyPr/>
        <a:lstStyle/>
        <a:p>
          <a:r>
            <a:rPr lang="en-GB" dirty="0">
              <a:solidFill>
                <a:schemeClr val="bg1"/>
              </a:solidFill>
            </a:rPr>
            <a:t>Evaluate</a:t>
          </a:r>
        </a:p>
      </dgm:t>
    </dgm:pt>
    <dgm:pt modelId="{EA2C3E9A-B1C9-F341-AF96-BB86805A44F0}" type="parTrans" cxnId="{DDFF6F67-2AE4-0C44-A5E5-41C1FDCF6778}">
      <dgm:prSet/>
      <dgm:spPr/>
      <dgm:t>
        <a:bodyPr/>
        <a:lstStyle/>
        <a:p>
          <a:endParaRPr lang="en-GB"/>
        </a:p>
      </dgm:t>
    </dgm:pt>
    <dgm:pt modelId="{85582E92-BAC4-2740-ABAC-EC352743D651}" type="sibTrans" cxnId="{DDFF6F67-2AE4-0C44-A5E5-41C1FDCF6778}">
      <dgm:prSet/>
      <dgm:spPr/>
      <dgm:t>
        <a:bodyPr/>
        <a:lstStyle/>
        <a:p>
          <a:endParaRPr lang="en-GB"/>
        </a:p>
      </dgm:t>
    </dgm:pt>
    <dgm:pt modelId="{093022C1-D630-5949-8474-739FBE5D876B}">
      <dgm:prSet phldrT="[Text]"/>
      <dgm:spPr/>
      <dgm:t>
        <a:bodyPr/>
        <a:lstStyle/>
        <a:p>
          <a:r>
            <a:rPr lang="en-GB" dirty="0"/>
            <a:t>Act on findings</a:t>
          </a:r>
        </a:p>
      </dgm:t>
    </dgm:pt>
    <dgm:pt modelId="{854D18CD-80A4-BF47-9C74-F86936DBEEAB}" type="parTrans" cxnId="{4ECDD128-239D-1542-9008-29EEF63A1C3D}">
      <dgm:prSet/>
      <dgm:spPr/>
      <dgm:t>
        <a:bodyPr/>
        <a:lstStyle/>
        <a:p>
          <a:endParaRPr lang="en-GB"/>
        </a:p>
      </dgm:t>
    </dgm:pt>
    <dgm:pt modelId="{EE99D27B-EDEF-EF48-96AC-ECC66E704C2E}" type="sibTrans" cxnId="{4ECDD128-239D-1542-9008-29EEF63A1C3D}">
      <dgm:prSet/>
      <dgm:spPr/>
      <dgm:t>
        <a:bodyPr/>
        <a:lstStyle/>
        <a:p>
          <a:endParaRPr lang="en-GB"/>
        </a:p>
      </dgm:t>
    </dgm:pt>
    <dgm:pt modelId="{BEFCDFDC-31B4-394F-B6DC-AEEEFC84A042}" type="pres">
      <dgm:prSet presAssocID="{A5D9A408-9F42-954E-9533-247B8D2AC1A5}" presName="cycle" presStyleCnt="0">
        <dgm:presLayoutVars>
          <dgm:dir/>
          <dgm:resizeHandles val="exact"/>
        </dgm:presLayoutVars>
      </dgm:prSet>
      <dgm:spPr/>
    </dgm:pt>
    <dgm:pt modelId="{D574BFB6-BEF1-8C4C-8B68-6F0C449AC879}" type="pres">
      <dgm:prSet presAssocID="{A18297FA-39DE-F046-AADF-44A9D6EA28E1}" presName="node" presStyleLbl="node1" presStyleIdx="0" presStyleCnt="9">
        <dgm:presLayoutVars>
          <dgm:bulletEnabled val="1"/>
        </dgm:presLayoutVars>
      </dgm:prSet>
      <dgm:spPr/>
    </dgm:pt>
    <dgm:pt modelId="{04741F94-04F5-944A-AA75-A52B581B08EB}" type="pres">
      <dgm:prSet presAssocID="{A18297FA-39DE-F046-AADF-44A9D6EA28E1}" presName="spNode" presStyleCnt="0"/>
      <dgm:spPr/>
    </dgm:pt>
    <dgm:pt modelId="{898433E3-2070-1F49-9809-E8CFFC177272}" type="pres">
      <dgm:prSet presAssocID="{43E137FF-92F4-4E41-B79D-52D977D6C099}" presName="sibTrans" presStyleLbl="sibTrans1D1" presStyleIdx="0" presStyleCnt="9"/>
      <dgm:spPr/>
    </dgm:pt>
    <dgm:pt modelId="{5F7A9264-01C6-C443-BFDE-FEF35C937F56}" type="pres">
      <dgm:prSet presAssocID="{775F3146-D841-DF44-A9BA-A58935E33788}" presName="node" presStyleLbl="node1" presStyleIdx="1" presStyleCnt="9">
        <dgm:presLayoutVars>
          <dgm:bulletEnabled val="1"/>
        </dgm:presLayoutVars>
      </dgm:prSet>
      <dgm:spPr/>
    </dgm:pt>
    <dgm:pt modelId="{B3EC3292-64F5-8642-B0CA-3A2250C83DEF}" type="pres">
      <dgm:prSet presAssocID="{775F3146-D841-DF44-A9BA-A58935E33788}" presName="spNode" presStyleCnt="0"/>
      <dgm:spPr/>
    </dgm:pt>
    <dgm:pt modelId="{B371DBB0-DEDB-914B-9AFF-7586E37A0CF6}" type="pres">
      <dgm:prSet presAssocID="{3C05C41F-A01D-3F41-85A5-42ACD3217FE0}" presName="sibTrans" presStyleLbl="sibTrans1D1" presStyleIdx="1" presStyleCnt="9"/>
      <dgm:spPr/>
    </dgm:pt>
    <dgm:pt modelId="{F039F0EB-D869-DF43-8B8E-C29408B796EB}" type="pres">
      <dgm:prSet presAssocID="{C7391DB6-008B-1045-881A-500864D378BA}" presName="node" presStyleLbl="node1" presStyleIdx="2" presStyleCnt="9">
        <dgm:presLayoutVars>
          <dgm:bulletEnabled val="1"/>
        </dgm:presLayoutVars>
      </dgm:prSet>
      <dgm:spPr/>
    </dgm:pt>
    <dgm:pt modelId="{681DBF75-0482-0B49-8C5C-FDCCB455E790}" type="pres">
      <dgm:prSet presAssocID="{C7391DB6-008B-1045-881A-500864D378BA}" presName="spNode" presStyleCnt="0"/>
      <dgm:spPr/>
    </dgm:pt>
    <dgm:pt modelId="{50EE490F-4F8E-9049-B615-10D6612BF852}" type="pres">
      <dgm:prSet presAssocID="{A0B3E19E-6337-9348-A48D-F00006ABCD61}" presName="sibTrans" presStyleLbl="sibTrans1D1" presStyleIdx="2" presStyleCnt="9"/>
      <dgm:spPr/>
    </dgm:pt>
    <dgm:pt modelId="{97452FB2-9725-6644-8F45-8091549EC3C6}" type="pres">
      <dgm:prSet presAssocID="{704B344C-9FAD-F04B-A961-D48B354C4D80}" presName="node" presStyleLbl="node1" presStyleIdx="3" presStyleCnt="9">
        <dgm:presLayoutVars>
          <dgm:bulletEnabled val="1"/>
        </dgm:presLayoutVars>
      </dgm:prSet>
      <dgm:spPr/>
    </dgm:pt>
    <dgm:pt modelId="{FE758242-03FB-CF43-80AD-996A0610A9E1}" type="pres">
      <dgm:prSet presAssocID="{704B344C-9FAD-F04B-A961-D48B354C4D80}" presName="spNode" presStyleCnt="0"/>
      <dgm:spPr/>
    </dgm:pt>
    <dgm:pt modelId="{454A1872-84E1-A440-9E23-9BA8B373C188}" type="pres">
      <dgm:prSet presAssocID="{AA189D3C-72DF-1246-88CA-A852CE1FAC66}" presName="sibTrans" presStyleLbl="sibTrans1D1" presStyleIdx="3" presStyleCnt="9"/>
      <dgm:spPr/>
    </dgm:pt>
    <dgm:pt modelId="{2EAB5438-31E8-064A-A4B0-3F2DE2B6D4E6}" type="pres">
      <dgm:prSet presAssocID="{E7CF490F-91DC-F846-A3A6-D3A2EF638F83}" presName="node" presStyleLbl="node1" presStyleIdx="4" presStyleCnt="9">
        <dgm:presLayoutVars>
          <dgm:bulletEnabled val="1"/>
        </dgm:presLayoutVars>
      </dgm:prSet>
      <dgm:spPr/>
    </dgm:pt>
    <dgm:pt modelId="{A56C7289-B605-8C48-A7ED-788D64A3C1B3}" type="pres">
      <dgm:prSet presAssocID="{E7CF490F-91DC-F846-A3A6-D3A2EF638F83}" presName="spNode" presStyleCnt="0"/>
      <dgm:spPr/>
    </dgm:pt>
    <dgm:pt modelId="{592DEB87-05BA-314E-9E5D-A0994FBB9BE7}" type="pres">
      <dgm:prSet presAssocID="{CAC3CACD-CDE9-AE45-9323-B3BDD4088AF3}" presName="sibTrans" presStyleLbl="sibTrans1D1" presStyleIdx="4" presStyleCnt="9"/>
      <dgm:spPr/>
    </dgm:pt>
    <dgm:pt modelId="{B61B4333-12E9-EA4E-96BE-541075F519B1}" type="pres">
      <dgm:prSet presAssocID="{C11BB007-9F54-0348-BE82-3BC62D65DAC5}" presName="node" presStyleLbl="node1" presStyleIdx="5" presStyleCnt="9">
        <dgm:presLayoutVars>
          <dgm:bulletEnabled val="1"/>
        </dgm:presLayoutVars>
      </dgm:prSet>
      <dgm:spPr/>
    </dgm:pt>
    <dgm:pt modelId="{1999164E-B41C-E748-984D-D95DF71999F3}" type="pres">
      <dgm:prSet presAssocID="{C11BB007-9F54-0348-BE82-3BC62D65DAC5}" presName="spNode" presStyleCnt="0"/>
      <dgm:spPr/>
    </dgm:pt>
    <dgm:pt modelId="{1DCD3E9D-C78C-A144-B7E8-BE98F083AEB6}" type="pres">
      <dgm:prSet presAssocID="{144BFC2F-3C36-144B-B257-CB4D7B30721D}" presName="sibTrans" presStyleLbl="sibTrans1D1" presStyleIdx="5" presStyleCnt="9"/>
      <dgm:spPr/>
    </dgm:pt>
    <dgm:pt modelId="{18BCA952-D167-F945-8867-AD4C9D2398AB}" type="pres">
      <dgm:prSet presAssocID="{1FA61355-A77C-574C-8C0A-60C0FD4910FD}" presName="node" presStyleLbl="node1" presStyleIdx="6" presStyleCnt="9">
        <dgm:presLayoutVars>
          <dgm:bulletEnabled val="1"/>
        </dgm:presLayoutVars>
      </dgm:prSet>
      <dgm:spPr/>
    </dgm:pt>
    <dgm:pt modelId="{B4417D4B-F281-1143-84C1-686D272378B4}" type="pres">
      <dgm:prSet presAssocID="{1FA61355-A77C-574C-8C0A-60C0FD4910FD}" presName="spNode" presStyleCnt="0"/>
      <dgm:spPr/>
    </dgm:pt>
    <dgm:pt modelId="{B9ABB65A-E4F9-2446-9DC0-16FA01C2810E}" type="pres">
      <dgm:prSet presAssocID="{4A4D2591-61EC-4C41-8583-336875443AD1}" presName="sibTrans" presStyleLbl="sibTrans1D1" presStyleIdx="6" presStyleCnt="9"/>
      <dgm:spPr/>
    </dgm:pt>
    <dgm:pt modelId="{BBB9B9B7-392F-044F-9D6F-255404CF4C1D}" type="pres">
      <dgm:prSet presAssocID="{F8176310-E128-DC4B-B5FB-592CF890C5A7}" presName="node" presStyleLbl="node1" presStyleIdx="7" presStyleCnt="9">
        <dgm:presLayoutVars>
          <dgm:bulletEnabled val="1"/>
        </dgm:presLayoutVars>
      </dgm:prSet>
      <dgm:spPr/>
    </dgm:pt>
    <dgm:pt modelId="{82579739-B1E5-3A4D-916A-92CDD6F5EEAF}" type="pres">
      <dgm:prSet presAssocID="{F8176310-E128-DC4B-B5FB-592CF890C5A7}" presName="spNode" presStyleCnt="0"/>
      <dgm:spPr/>
    </dgm:pt>
    <dgm:pt modelId="{24E638AC-505A-804E-9219-145CB4495339}" type="pres">
      <dgm:prSet presAssocID="{85582E92-BAC4-2740-ABAC-EC352743D651}" presName="sibTrans" presStyleLbl="sibTrans1D1" presStyleIdx="7" presStyleCnt="9"/>
      <dgm:spPr/>
    </dgm:pt>
    <dgm:pt modelId="{99EB3913-8B6E-E34E-9628-DAC25591E971}" type="pres">
      <dgm:prSet presAssocID="{093022C1-D630-5949-8474-739FBE5D876B}" presName="node" presStyleLbl="node1" presStyleIdx="8" presStyleCnt="9">
        <dgm:presLayoutVars>
          <dgm:bulletEnabled val="1"/>
        </dgm:presLayoutVars>
      </dgm:prSet>
      <dgm:spPr/>
    </dgm:pt>
    <dgm:pt modelId="{AA8F755A-9E3C-FE40-B5A1-AF38A3824191}" type="pres">
      <dgm:prSet presAssocID="{093022C1-D630-5949-8474-739FBE5D876B}" presName="spNode" presStyleCnt="0"/>
      <dgm:spPr/>
    </dgm:pt>
    <dgm:pt modelId="{D8F8ADA8-351A-B544-A873-AEA3C0755809}" type="pres">
      <dgm:prSet presAssocID="{EE99D27B-EDEF-EF48-96AC-ECC66E704C2E}" presName="sibTrans" presStyleLbl="sibTrans1D1" presStyleIdx="8" presStyleCnt="9"/>
      <dgm:spPr/>
    </dgm:pt>
  </dgm:ptLst>
  <dgm:cxnLst>
    <dgm:cxn modelId="{EC4F9300-DE6A-EB4B-9CE3-571589414EBE}" type="presOf" srcId="{CAC3CACD-CDE9-AE45-9323-B3BDD4088AF3}" destId="{592DEB87-05BA-314E-9E5D-A0994FBB9BE7}" srcOrd="0" destOrd="0" presId="urn:microsoft.com/office/officeart/2005/8/layout/cycle5"/>
    <dgm:cxn modelId="{4BEA6609-D67E-1041-838E-F482D69CE42A}" srcId="{A5D9A408-9F42-954E-9533-247B8D2AC1A5}" destId="{C11BB007-9F54-0348-BE82-3BC62D65DAC5}" srcOrd="5" destOrd="0" parTransId="{65D93766-F6A7-7749-978E-C6718CCB749A}" sibTransId="{144BFC2F-3C36-144B-B257-CB4D7B30721D}"/>
    <dgm:cxn modelId="{590BAB09-0784-1A42-8B0A-2AD21B2EE8E6}" type="presOf" srcId="{704B344C-9FAD-F04B-A961-D48B354C4D80}" destId="{97452FB2-9725-6644-8F45-8091549EC3C6}" srcOrd="0" destOrd="0" presId="urn:microsoft.com/office/officeart/2005/8/layout/cycle5"/>
    <dgm:cxn modelId="{235ABD10-7E44-684C-B18B-B7F5CCBE7FC3}" type="presOf" srcId="{A0B3E19E-6337-9348-A48D-F00006ABCD61}" destId="{50EE490F-4F8E-9049-B615-10D6612BF852}" srcOrd="0" destOrd="0" presId="urn:microsoft.com/office/officeart/2005/8/layout/cycle5"/>
    <dgm:cxn modelId="{C3235C1A-47E1-FA40-8900-8EDB3093E471}" type="presOf" srcId="{43E137FF-92F4-4E41-B79D-52D977D6C099}" destId="{898433E3-2070-1F49-9809-E8CFFC177272}" srcOrd="0" destOrd="0" presId="urn:microsoft.com/office/officeart/2005/8/layout/cycle5"/>
    <dgm:cxn modelId="{55F5301B-1D94-CB4C-90D1-AB09AF8E4255}" type="presOf" srcId="{775F3146-D841-DF44-A9BA-A58935E33788}" destId="{5F7A9264-01C6-C443-BFDE-FEF35C937F56}" srcOrd="0" destOrd="0" presId="urn:microsoft.com/office/officeart/2005/8/layout/cycle5"/>
    <dgm:cxn modelId="{4D2CC224-19EC-BC49-86B7-5D57174F25D1}" srcId="{A5D9A408-9F42-954E-9533-247B8D2AC1A5}" destId="{E7CF490F-91DC-F846-A3A6-D3A2EF638F83}" srcOrd="4" destOrd="0" parTransId="{2C1E0E50-55FC-4D43-A176-592EBF4A58F3}" sibTransId="{CAC3CACD-CDE9-AE45-9323-B3BDD4088AF3}"/>
    <dgm:cxn modelId="{4ECDD128-239D-1542-9008-29EEF63A1C3D}" srcId="{A5D9A408-9F42-954E-9533-247B8D2AC1A5}" destId="{093022C1-D630-5949-8474-739FBE5D876B}" srcOrd="8" destOrd="0" parTransId="{854D18CD-80A4-BF47-9C74-F86936DBEEAB}" sibTransId="{EE99D27B-EDEF-EF48-96AC-ECC66E704C2E}"/>
    <dgm:cxn modelId="{45093230-BD9A-454C-A79C-E09623B80812}" srcId="{A5D9A408-9F42-954E-9533-247B8D2AC1A5}" destId="{C7391DB6-008B-1045-881A-500864D378BA}" srcOrd="2" destOrd="0" parTransId="{562F6C85-B65D-2549-AAF4-035CEA65435F}" sibTransId="{A0B3E19E-6337-9348-A48D-F00006ABCD61}"/>
    <dgm:cxn modelId="{570B5A36-FEE3-E040-8E3F-8DB65D2E5276}" type="presOf" srcId="{85582E92-BAC4-2740-ABAC-EC352743D651}" destId="{24E638AC-505A-804E-9219-145CB4495339}" srcOrd="0" destOrd="0" presId="urn:microsoft.com/office/officeart/2005/8/layout/cycle5"/>
    <dgm:cxn modelId="{0D3DBC3B-F96A-654A-A7CB-E13CFCE3ED08}" type="presOf" srcId="{AA189D3C-72DF-1246-88CA-A852CE1FAC66}" destId="{454A1872-84E1-A440-9E23-9BA8B373C188}" srcOrd="0" destOrd="0" presId="urn:microsoft.com/office/officeart/2005/8/layout/cycle5"/>
    <dgm:cxn modelId="{03EC9040-9411-2E48-8632-A9F18DE09AA9}" type="presOf" srcId="{3C05C41F-A01D-3F41-85A5-42ACD3217FE0}" destId="{B371DBB0-DEDB-914B-9AFF-7586E37A0CF6}" srcOrd="0" destOrd="0" presId="urn:microsoft.com/office/officeart/2005/8/layout/cycle5"/>
    <dgm:cxn modelId="{4EDBB645-F288-6749-8846-4F1E2D82303C}" type="presOf" srcId="{A5D9A408-9F42-954E-9533-247B8D2AC1A5}" destId="{BEFCDFDC-31B4-394F-B6DC-AEEEFC84A042}" srcOrd="0" destOrd="0" presId="urn:microsoft.com/office/officeart/2005/8/layout/cycle5"/>
    <dgm:cxn modelId="{DDFF6F67-2AE4-0C44-A5E5-41C1FDCF6778}" srcId="{A5D9A408-9F42-954E-9533-247B8D2AC1A5}" destId="{F8176310-E128-DC4B-B5FB-592CF890C5A7}" srcOrd="7" destOrd="0" parTransId="{EA2C3E9A-B1C9-F341-AF96-BB86805A44F0}" sibTransId="{85582E92-BAC4-2740-ABAC-EC352743D651}"/>
    <dgm:cxn modelId="{577F466A-3450-D24C-A92E-27B956327618}" srcId="{A5D9A408-9F42-954E-9533-247B8D2AC1A5}" destId="{775F3146-D841-DF44-A9BA-A58935E33788}" srcOrd="1" destOrd="0" parTransId="{715EE54C-716B-EE47-BAD7-4871A08663CD}" sibTransId="{3C05C41F-A01D-3F41-85A5-42ACD3217FE0}"/>
    <dgm:cxn modelId="{6ACE664C-C2A0-004F-9BFF-41B5ADA46048}" srcId="{A5D9A408-9F42-954E-9533-247B8D2AC1A5}" destId="{A18297FA-39DE-F046-AADF-44A9D6EA28E1}" srcOrd="0" destOrd="0" parTransId="{4C3D318C-7550-6A46-9DC2-1DC50BBD345B}" sibTransId="{43E137FF-92F4-4E41-B79D-52D977D6C099}"/>
    <dgm:cxn modelId="{EC6F6771-4F32-A54B-BC29-B3FD92F3BF40}" type="presOf" srcId="{EE99D27B-EDEF-EF48-96AC-ECC66E704C2E}" destId="{D8F8ADA8-351A-B544-A873-AEA3C0755809}" srcOrd="0" destOrd="0" presId="urn:microsoft.com/office/officeart/2005/8/layout/cycle5"/>
    <dgm:cxn modelId="{7FB57878-7494-ED45-95EC-5714925AFF27}" type="presOf" srcId="{C11BB007-9F54-0348-BE82-3BC62D65DAC5}" destId="{B61B4333-12E9-EA4E-96BE-541075F519B1}" srcOrd="0" destOrd="0" presId="urn:microsoft.com/office/officeart/2005/8/layout/cycle5"/>
    <dgm:cxn modelId="{09616E7B-CB8C-9044-8314-4A92E123C0CE}" type="presOf" srcId="{E7CF490F-91DC-F846-A3A6-D3A2EF638F83}" destId="{2EAB5438-31E8-064A-A4B0-3F2DE2B6D4E6}" srcOrd="0" destOrd="0" presId="urn:microsoft.com/office/officeart/2005/8/layout/cycle5"/>
    <dgm:cxn modelId="{FF82827E-E08E-7B42-961F-EFA0AE610155}" srcId="{A5D9A408-9F42-954E-9533-247B8D2AC1A5}" destId="{1FA61355-A77C-574C-8C0A-60C0FD4910FD}" srcOrd="6" destOrd="0" parTransId="{3CA8528F-6AC2-7C4A-812A-4F2767E7EA72}" sibTransId="{4A4D2591-61EC-4C41-8583-336875443AD1}"/>
    <dgm:cxn modelId="{3F85B383-5260-3840-9860-14B4EACF1AA9}" type="presOf" srcId="{093022C1-D630-5949-8474-739FBE5D876B}" destId="{99EB3913-8B6E-E34E-9628-DAC25591E971}" srcOrd="0" destOrd="0" presId="urn:microsoft.com/office/officeart/2005/8/layout/cycle5"/>
    <dgm:cxn modelId="{9E4E8585-0343-334B-9109-C295C9E11DBC}" type="presOf" srcId="{A18297FA-39DE-F046-AADF-44A9D6EA28E1}" destId="{D574BFB6-BEF1-8C4C-8B68-6F0C449AC879}" srcOrd="0" destOrd="0" presId="urn:microsoft.com/office/officeart/2005/8/layout/cycle5"/>
    <dgm:cxn modelId="{DD132989-162D-104F-A1D1-FB88A665DF31}" type="presOf" srcId="{1FA61355-A77C-574C-8C0A-60C0FD4910FD}" destId="{18BCA952-D167-F945-8867-AD4C9D2398AB}" srcOrd="0" destOrd="0" presId="urn:microsoft.com/office/officeart/2005/8/layout/cycle5"/>
    <dgm:cxn modelId="{10E35E9C-FA10-4E4E-9AA0-1B05F950A98D}" type="presOf" srcId="{4A4D2591-61EC-4C41-8583-336875443AD1}" destId="{B9ABB65A-E4F9-2446-9DC0-16FA01C2810E}" srcOrd="0" destOrd="0" presId="urn:microsoft.com/office/officeart/2005/8/layout/cycle5"/>
    <dgm:cxn modelId="{4B9903EC-829D-E94C-BE8F-83F86D15CC89}" type="presOf" srcId="{144BFC2F-3C36-144B-B257-CB4D7B30721D}" destId="{1DCD3E9D-C78C-A144-B7E8-BE98F083AEB6}" srcOrd="0" destOrd="0" presId="urn:microsoft.com/office/officeart/2005/8/layout/cycle5"/>
    <dgm:cxn modelId="{3BA596EF-0C47-E14A-AF30-43E63CBD553B}" srcId="{A5D9A408-9F42-954E-9533-247B8D2AC1A5}" destId="{704B344C-9FAD-F04B-A961-D48B354C4D80}" srcOrd="3" destOrd="0" parTransId="{ACA6BB9A-2BB7-BD46-B3A5-AE2BA0F3B0F5}" sibTransId="{AA189D3C-72DF-1246-88CA-A852CE1FAC66}"/>
    <dgm:cxn modelId="{987088F0-0B28-8246-8B89-01F276488EBF}" type="presOf" srcId="{F8176310-E128-DC4B-B5FB-592CF890C5A7}" destId="{BBB9B9B7-392F-044F-9D6F-255404CF4C1D}" srcOrd="0" destOrd="0" presId="urn:microsoft.com/office/officeart/2005/8/layout/cycle5"/>
    <dgm:cxn modelId="{7BDA0FF6-33EF-FB4C-B9E1-F3DEF1E45A91}" type="presOf" srcId="{C7391DB6-008B-1045-881A-500864D378BA}" destId="{F039F0EB-D869-DF43-8B8E-C29408B796EB}" srcOrd="0" destOrd="0" presId="urn:microsoft.com/office/officeart/2005/8/layout/cycle5"/>
    <dgm:cxn modelId="{1831DE0A-E8BD-D04A-9A5E-ECBC57F727CF}" type="presParOf" srcId="{BEFCDFDC-31B4-394F-B6DC-AEEEFC84A042}" destId="{D574BFB6-BEF1-8C4C-8B68-6F0C449AC879}" srcOrd="0" destOrd="0" presId="urn:microsoft.com/office/officeart/2005/8/layout/cycle5"/>
    <dgm:cxn modelId="{82411476-1682-2E40-9D93-6A28D00DAC6D}" type="presParOf" srcId="{BEFCDFDC-31B4-394F-B6DC-AEEEFC84A042}" destId="{04741F94-04F5-944A-AA75-A52B581B08EB}" srcOrd="1" destOrd="0" presId="urn:microsoft.com/office/officeart/2005/8/layout/cycle5"/>
    <dgm:cxn modelId="{9EFADA66-8FDA-C248-9D2C-AF28220955AF}" type="presParOf" srcId="{BEFCDFDC-31B4-394F-B6DC-AEEEFC84A042}" destId="{898433E3-2070-1F49-9809-E8CFFC177272}" srcOrd="2" destOrd="0" presId="urn:microsoft.com/office/officeart/2005/8/layout/cycle5"/>
    <dgm:cxn modelId="{4EF40AE6-40E9-244B-96D9-377521C40AC8}" type="presParOf" srcId="{BEFCDFDC-31B4-394F-B6DC-AEEEFC84A042}" destId="{5F7A9264-01C6-C443-BFDE-FEF35C937F56}" srcOrd="3" destOrd="0" presId="urn:microsoft.com/office/officeart/2005/8/layout/cycle5"/>
    <dgm:cxn modelId="{775197DB-F50D-F345-B9EA-68D620D60F1F}" type="presParOf" srcId="{BEFCDFDC-31B4-394F-B6DC-AEEEFC84A042}" destId="{B3EC3292-64F5-8642-B0CA-3A2250C83DEF}" srcOrd="4" destOrd="0" presId="urn:microsoft.com/office/officeart/2005/8/layout/cycle5"/>
    <dgm:cxn modelId="{BC4443C3-E50D-1541-B20A-A5EEDB7B6824}" type="presParOf" srcId="{BEFCDFDC-31B4-394F-B6DC-AEEEFC84A042}" destId="{B371DBB0-DEDB-914B-9AFF-7586E37A0CF6}" srcOrd="5" destOrd="0" presId="urn:microsoft.com/office/officeart/2005/8/layout/cycle5"/>
    <dgm:cxn modelId="{CBAC1E2B-FF68-A443-8D4D-0D400DEB757F}" type="presParOf" srcId="{BEFCDFDC-31B4-394F-B6DC-AEEEFC84A042}" destId="{F039F0EB-D869-DF43-8B8E-C29408B796EB}" srcOrd="6" destOrd="0" presId="urn:microsoft.com/office/officeart/2005/8/layout/cycle5"/>
    <dgm:cxn modelId="{42A54530-49F4-4C4C-95BA-59015D6999AF}" type="presParOf" srcId="{BEFCDFDC-31B4-394F-B6DC-AEEEFC84A042}" destId="{681DBF75-0482-0B49-8C5C-FDCCB455E790}" srcOrd="7" destOrd="0" presId="urn:microsoft.com/office/officeart/2005/8/layout/cycle5"/>
    <dgm:cxn modelId="{73690491-E452-6B48-949A-19100563189D}" type="presParOf" srcId="{BEFCDFDC-31B4-394F-B6DC-AEEEFC84A042}" destId="{50EE490F-4F8E-9049-B615-10D6612BF852}" srcOrd="8" destOrd="0" presId="urn:microsoft.com/office/officeart/2005/8/layout/cycle5"/>
    <dgm:cxn modelId="{8AFEE76F-FCC5-8548-9FA7-5811512060D3}" type="presParOf" srcId="{BEFCDFDC-31B4-394F-B6DC-AEEEFC84A042}" destId="{97452FB2-9725-6644-8F45-8091549EC3C6}" srcOrd="9" destOrd="0" presId="urn:microsoft.com/office/officeart/2005/8/layout/cycle5"/>
    <dgm:cxn modelId="{7C90763D-4629-3640-B572-896CE5C4841C}" type="presParOf" srcId="{BEFCDFDC-31B4-394F-B6DC-AEEEFC84A042}" destId="{FE758242-03FB-CF43-80AD-996A0610A9E1}" srcOrd="10" destOrd="0" presId="urn:microsoft.com/office/officeart/2005/8/layout/cycle5"/>
    <dgm:cxn modelId="{B5C6B902-3EFC-BE47-AD1C-90F92ABEA431}" type="presParOf" srcId="{BEFCDFDC-31B4-394F-B6DC-AEEEFC84A042}" destId="{454A1872-84E1-A440-9E23-9BA8B373C188}" srcOrd="11" destOrd="0" presId="urn:microsoft.com/office/officeart/2005/8/layout/cycle5"/>
    <dgm:cxn modelId="{78DF2DCB-5BE8-924C-BEBB-BFB554781215}" type="presParOf" srcId="{BEFCDFDC-31B4-394F-B6DC-AEEEFC84A042}" destId="{2EAB5438-31E8-064A-A4B0-3F2DE2B6D4E6}" srcOrd="12" destOrd="0" presId="urn:microsoft.com/office/officeart/2005/8/layout/cycle5"/>
    <dgm:cxn modelId="{2A748B38-0F02-4C47-A7FC-FF91DBE6CE5A}" type="presParOf" srcId="{BEFCDFDC-31B4-394F-B6DC-AEEEFC84A042}" destId="{A56C7289-B605-8C48-A7ED-788D64A3C1B3}" srcOrd="13" destOrd="0" presId="urn:microsoft.com/office/officeart/2005/8/layout/cycle5"/>
    <dgm:cxn modelId="{B1B9F60A-AF58-5647-8B81-5B55AFC50257}" type="presParOf" srcId="{BEFCDFDC-31B4-394F-B6DC-AEEEFC84A042}" destId="{592DEB87-05BA-314E-9E5D-A0994FBB9BE7}" srcOrd="14" destOrd="0" presId="urn:microsoft.com/office/officeart/2005/8/layout/cycle5"/>
    <dgm:cxn modelId="{B8D6194E-3E1D-404E-948F-E125F159BCFE}" type="presParOf" srcId="{BEFCDFDC-31B4-394F-B6DC-AEEEFC84A042}" destId="{B61B4333-12E9-EA4E-96BE-541075F519B1}" srcOrd="15" destOrd="0" presId="urn:microsoft.com/office/officeart/2005/8/layout/cycle5"/>
    <dgm:cxn modelId="{AA57E3D1-7870-BE4D-AF16-DE0BA18C1593}" type="presParOf" srcId="{BEFCDFDC-31B4-394F-B6DC-AEEEFC84A042}" destId="{1999164E-B41C-E748-984D-D95DF71999F3}" srcOrd="16" destOrd="0" presId="urn:microsoft.com/office/officeart/2005/8/layout/cycle5"/>
    <dgm:cxn modelId="{5A04BEA7-6011-484E-A897-D17743D411E5}" type="presParOf" srcId="{BEFCDFDC-31B4-394F-B6DC-AEEEFC84A042}" destId="{1DCD3E9D-C78C-A144-B7E8-BE98F083AEB6}" srcOrd="17" destOrd="0" presId="urn:microsoft.com/office/officeart/2005/8/layout/cycle5"/>
    <dgm:cxn modelId="{532DBB0A-E9F4-6F47-8546-D0F2AEE952AF}" type="presParOf" srcId="{BEFCDFDC-31B4-394F-B6DC-AEEEFC84A042}" destId="{18BCA952-D167-F945-8867-AD4C9D2398AB}" srcOrd="18" destOrd="0" presId="urn:microsoft.com/office/officeart/2005/8/layout/cycle5"/>
    <dgm:cxn modelId="{98CCD086-05EB-0F44-BD12-3121E72B74B0}" type="presParOf" srcId="{BEFCDFDC-31B4-394F-B6DC-AEEEFC84A042}" destId="{B4417D4B-F281-1143-84C1-686D272378B4}" srcOrd="19" destOrd="0" presId="urn:microsoft.com/office/officeart/2005/8/layout/cycle5"/>
    <dgm:cxn modelId="{A1546A76-203A-F547-A33D-8E2280C08198}" type="presParOf" srcId="{BEFCDFDC-31B4-394F-B6DC-AEEEFC84A042}" destId="{B9ABB65A-E4F9-2446-9DC0-16FA01C2810E}" srcOrd="20" destOrd="0" presId="urn:microsoft.com/office/officeart/2005/8/layout/cycle5"/>
    <dgm:cxn modelId="{45B031A7-FF07-4F40-AB00-2F7C6074BD30}" type="presParOf" srcId="{BEFCDFDC-31B4-394F-B6DC-AEEEFC84A042}" destId="{BBB9B9B7-392F-044F-9D6F-255404CF4C1D}" srcOrd="21" destOrd="0" presId="urn:microsoft.com/office/officeart/2005/8/layout/cycle5"/>
    <dgm:cxn modelId="{68C44E0C-0A9E-4348-B3D7-1EC71869C7D2}" type="presParOf" srcId="{BEFCDFDC-31B4-394F-B6DC-AEEEFC84A042}" destId="{82579739-B1E5-3A4D-916A-92CDD6F5EEAF}" srcOrd="22" destOrd="0" presId="urn:microsoft.com/office/officeart/2005/8/layout/cycle5"/>
    <dgm:cxn modelId="{E05515A9-7339-B14A-A56E-A596F2403275}" type="presParOf" srcId="{BEFCDFDC-31B4-394F-B6DC-AEEEFC84A042}" destId="{24E638AC-505A-804E-9219-145CB4495339}" srcOrd="23" destOrd="0" presId="urn:microsoft.com/office/officeart/2005/8/layout/cycle5"/>
    <dgm:cxn modelId="{339B0992-B7BC-8845-A86F-37B19FF16ADC}" type="presParOf" srcId="{BEFCDFDC-31B4-394F-B6DC-AEEEFC84A042}" destId="{99EB3913-8B6E-E34E-9628-DAC25591E971}" srcOrd="24" destOrd="0" presId="urn:microsoft.com/office/officeart/2005/8/layout/cycle5"/>
    <dgm:cxn modelId="{DE516299-D6DA-D948-B7D2-5954CEC1DB28}" type="presParOf" srcId="{BEFCDFDC-31B4-394F-B6DC-AEEEFC84A042}" destId="{AA8F755A-9E3C-FE40-B5A1-AF38A3824191}" srcOrd="25" destOrd="0" presId="urn:microsoft.com/office/officeart/2005/8/layout/cycle5"/>
    <dgm:cxn modelId="{42A4CD3D-362C-424B-8D14-6831D8DE3C71}" type="presParOf" srcId="{BEFCDFDC-31B4-394F-B6DC-AEEEFC84A042}" destId="{D8F8ADA8-351A-B544-A873-AEA3C0755809}" srcOrd="26" destOrd="0" presId="urn:microsoft.com/office/officeart/2005/8/layout/cycle5"/>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B767443-EE09-0245-AB32-E1036D4877BF}">
      <dsp:nvSpPr>
        <dsp:cNvPr id="0" name=""/>
        <dsp:cNvSpPr/>
      </dsp:nvSpPr>
      <dsp:spPr>
        <a:xfrm>
          <a:off x="2585" y="235584"/>
          <a:ext cx="2520457" cy="662400"/>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3576" tIns="93472" rIns="163576" bIns="93472" numCol="1" spcCol="1270" anchor="ctr" anchorCtr="0">
          <a:noAutofit/>
        </a:bodyPr>
        <a:lstStyle/>
        <a:p>
          <a:pPr marL="0" lvl="0" indent="0" algn="ctr" defTabSz="1022350">
            <a:lnSpc>
              <a:spcPct val="90000"/>
            </a:lnSpc>
            <a:spcBef>
              <a:spcPct val="0"/>
            </a:spcBef>
            <a:spcAft>
              <a:spcPct val="35000"/>
            </a:spcAft>
            <a:buNone/>
          </a:pPr>
          <a:r>
            <a:rPr lang="en-GB" sz="2300" kern="1200" dirty="0"/>
            <a:t>OPTION 1</a:t>
          </a:r>
        </a:p>
      </dsp:txBody>
      <dsp:txXfrm>
        <a:off x="2585" y="235584"/>
        <a:ext cx="2520457" cy="662400"/>
      </dsp:txXfrm>
    </dsp:sp>
    <dsp:sp modelId="{566CE7BE-7E41-1A48-ACD4-8FAAD1139135}">
      <dsp:nvSpPr>
        <dsp:cNvPr id="0" name=""/>
        <dsp:cNvSpPr/>
      </dsp:nvSpPr>
      <dsp:spPr>
        <a:xfrm>
          <a:off x="2585" y="897984"/>
          <a:ext cx="2520457" cy="2320211"/>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22682" tIns="122682" rIns="163576" bIns="184023" numCol="1" spcCol="1270" anchor="t" anchorCtr="0">
          <a:noAutofit/>
        </a:bodyPr>
        <a:lstStyle/>
        <a:p>
          <a:pPr marL="228600" lvl="1" indent="-228600" algn="l" defTabSz="1022350">
            <a:lnSpc>
              <a:spcPct val="90000"/>
            </a:lnSpc>
            <a:spcBef>
              <a:spcPct val="0"/>
            </a:spcBef>
            <a:spcAft>
              <a:spcPct val="15000"/>
            </a:spcAft>
            <a:buChar char="•"/>
          </a:pPr>
          <a:r>
            <a:rPr lang="en-GB" sz="2300" kern="1200" dirty="0"/>
            <a:t>Researcher comes to the Working Group to give an update</a:t>
          </a:r>
        </a:p>
      </dsp:txBody>
      <dsp:txXfrm>
        <a:off x="2585" y="897984"/>
        <a:ext cx="2520457" cy="2320211"/>
      </dsp:txXfrm>
    </dsp:sp>
    <dsp:sp modelId="{0D794AAA-89B3-4D45-866C-1A7A1E69519C}">
      <dsp:nvSpPr>
        <dsp:cNvPr id="0" name=""/>
        <dsp:cNvSpPr/>
      </dsp:nvSpPr>
      <dsp:spPr>
        <a:xfrm>
          <a:off x="2875906" y="235584"/>
          <a:ext cx="2520457" cy="662400"/>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3576" tIns="93472" rIns="163576" bIns="93472" numCol="1" spcCol="1270" anchor="ctr" anchorCtr="0">
          <a:noAutofit/>
        </a:bodyPr>
        <a:lstStyle/>
        <a:p>
          <a:pPr marL="0" lvl="0" indent="0" algn="ctr" defTabSz="1022350">
            <a:lnSpc>
              <a:spcPct val="90000"/>
            </a:lnSpc>
            <a:spcBef>
              <a:spcPct val="0"/>
            </a:spcBef>
            <a:spcAft>
              <a:spcPct val="35000"/>
            </a:spcAft>
            <a:buNone/>
          </a:pPr>
          <a:r>
            <a:rPr lang="en-GB" sz="2300" kern="1200" dirty="0"/>
            <a:t>OPTION 2</a:t>
          </a:r>
        </a:p>
      </dsp:txBody>
      <dsp:txXfrm>
        <a:off x="2875906" y="235584"/>
        <a:ext cx="2520457" cy="662400"/>
      </dsp:txXfrm>
    </dsp:sp>
    <dsp:sp modelId="{5611FEB3-0595-0343-9FD0-0997986D7B5D}">
      <dsp:nvSpPr>
        <dsp:cNvPr id="0" name=""/>
        <dsp:cNvSpPr/>
      </dsp:nvSpPr>
      <dsp:spPr>
        <a:xfrm>
          <a:off x="2875906" y="897984"/>
          <a:ext cx="2520457" cy="2320211"/>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22682" tIns="122682" rIns="163576" bIns="184023" numCol="1" spcCol="1270" anchor="t" anchorCtr="0">
          <a:noAutofit/>
        </a:bodyPr>
        <a:lstStyle/>
        <a:p>
          <a:pPr marL="228600" lvl="1" indent="-228600" algn="l" defTabSz="1022350">
            <a:lnSpc>
              <a:spcPct val="90000"/>
            </a:lnSpc>
            <a:spcBef>
              <a:spcPct val="0"/>
            </a:spcBef>
            <a:spcAft>
              <a:spcPct val="15000"/>
            </a:spcAft>
            <a:buChar char="•"/>
          </a:pPr>
          <a:r>
            <a:rPr lang="en-GB" sz="2300" kern="1200" dirty="0"/>
            <a:t>Researcher to provide update online (e.g., via newsletter, Slack, etc)</a:t>
          </a:r>
        </a:p>
      </dsp:txBody>
      <dsp:txXfrm>
        <a:off x="2875906" y="897984"/>
        <a:ext cx="2520457" cy="2320211"/>
      </dsp:txXfrm>
    </dsp:sp>
    <dsp:sp modelId="{8648A455-07B2-A04C-BEFE-5FAAE9A28F2A}">
      <dsp:nvSpPr>
        <dsp:cNvPr id="0" name=""/>
        <dsp:cNvSpPr/>
      </dsp:nvSpPr>
      <dsp:spPr>
        <a:xfrm>
          <a:off x="5749227" y="235584"/>
          <a:ext cx="2520457" cy="662400"/>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3576" tIns="93472" rIns="163576" bIns="93472" numCol="1" spcCol="1270" anchor="ctr" anchorCtr="0">
          <a:noAutofit/>
        </a:bodyPr>
        <a:lstStyle/>
        <a:p>
          <a:pPr marL="0" lvl="0" indent="0" algn="ctr" defTabSz="1022350">
            <a:lnSpc>
              <a:spcPct val="90000"/>
            </a:lnSpc>
            <a:spcBef>
              <a:spcPct val="0"/>
            </a:spcBef>
            <a:spcAft>
              <a:spcPct val="35000"/>
            </a:spcAft>
            <a:buNone/>
          </a:pPr>
          <a:r>
            <a:rPr lang="en-GB" sz="2300" kern="1200" dirty="0"/>
            <a:t>OPTION 3</a:t>
          </a:r>
        </a:p>
      </dsp:txBody>
      <dsp:txXfrm>
        <a:off x="5749227" y="235584"/>
        <a:ext cx="2520457" cy="662400"/>
      </dsp:txXfrm>
    </dsp:sp>
    <dsp:sp modelId="{93760BC7-0363-EC4B-B6B1-6C7481819878}">
      <dsp:nvSpPr>
        <dsp:cNvPr id="0" name=""/>
        <dsp:cNvSpPr/>
      </dsp:nvSpPr>
      <dsp:spPr>
        <a:xfrm>
          <a:off x="5749227" y="897984"/>
          <a:ext cx="2520457" cy="2320211"/>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22682" tIns="122682" rIns="163576" bIns="184023" numCol="1" spcCol="1270" anchor="t" anchorCtr="0">
          <a:noAutofit/>
        </a:bodyPr>
        <a:lstStyle/>
        <a:p>
          <a:pPr marL="228600" lvl="1" indent="-228600" algn="l" defTabSz="1022350">
            <a:lnSpc>
              <a:spcPct val="90000"/>
            </a:lnSpc>
            <a:spcBef>
              <a:spcPct val="0"/>
            </a:spcBef>
            <a:spcAft>
              <a:spcPct val="15000"/>
            </a:spcAft>
            <a:buChar char="•"/>
          </a:pPr>
          <a:r>
            <a:rPr lang="en-GB" sz="2300" kern="1200" dirty="0"/>
            <a:t>One of the group’s planning researchers (e.g. Alexis) to provide the Working Group with update</a:t>
          </a:r>
        </a:p>
      </dsp:txBody>
      <dsp:txXfrm>
        <a:off x="5749227" y="897984"/>
        <a:ext cx="2520457" cy="2320211"/>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574BFB6-BEF1-8C4C-8B68-6F0C449AC879}">
      <dsp:nvSpPr>
        <dsp:cNvPr id="0" name=""/>
        <dsp:cNvSpPr/>
      </dsp:nvSpPr>
      <dsp:spPr>
        <a:xfrm>
          <a:off x="3342286" y="1648"/>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Identify the topic</a:t>
          </a:r>
        </a:p>
      </dsp:txBody>
      <dsp:txXfrm>
        <a:off x="3373265" y="32627"/>
        <a:ext cx="914356" cy="572646"/>
      </dsp:txXfrm>
    </dsp:sp>
    <dsp:sp modelId="{898433E3-2070-1F49-9809-E8CFFC177272}">
      <dsp:nvSpPr>
        <dsp:cNvPr id="0" name=""/>
        <dsp:cNvSpPr/>
      </dsp:nvSpPr>
      <dsp:spPr>
        <a:xfrm>
          <a:off x="1394059" y="318950"/>
          <a:ext cx="4872769" cy="4872769"/>
        </a:xfrm>
        <a:custGeom>
          <a:avLst/>
          <a:gdLst/>
          <a:ahLst/>
          <a:cxnLst/>
          <a:rect l="0" t="0" r="0" b="0"/>
          <a:pathLst>
            <a:path>
              <a:moveTo>
                <a:pt x="3046557" y="77643"/>
              </a:moveTo>
              <a:arcTo wR="2436384" hR="2436384" stAng="17070219" swAng="532653"/>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5F7A9264-01C6-C443-BFDE-FEF35C937F56}">
      <dsp:nvSpPr>
        <dsp:cNvPr id="0" name=""/>
        <dsp:cNvSpPr/>
      </dsp:nvSpPr>
      <dsp:spPr>
        <a:xfrm>
          <a:off x="4908364" y="571653"/>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Seek funding</a:t>
          </a:r>
        </a:p>
      </dsp:txBody>
      <dsp:txXfrm>
        <a:off x="4939343" y="602632"/>
        <a:ext cx="914356" cy="572646"/>
      </dsp:txXfrm>
    </dsp:sp>
    <dsp:sp modelId="{B371DBB0-DEDB-914B-9AFF-7586E37A0CF6}">
      <dsp:nvSpPr>
        <dsp:cNvPr id="0" name=""/>
        <dsp:cNvSpPr/>
      </dsp:nvSpPr>
      <dsp:spPr>
        <a:xfrm>
          <a:off x="1394059" y="318950"/>
          <a:ext cx="4872769" cy="4872769"/>
        </a:xfrm>
        <a:custGeom>
          <a:avLst/>
          <a:gdLst/>
          <a:ahLst/>
          <a:cxnLst/>
          <a:rect l="0" t="0" r="0" b="0"/>
          <a:pathLst>
            <a:path>
              <a:moveTo>
                <a:pt x="4428526" y="1033765"/>
              </a:moveTo>
              <a:arcTo wR="2436384" hR="2436384" stAng="19491093" swAng="787552"/>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F039F0EB-D869-DF43-8B8E-C29408B796EB}">
      <dsp:nvSpPr>
        <dsp:cNvPr id="0" name=""/>
        <dsp:cNvSpPr/>
      </dsp:nvSpPr>
      <dsp:spPr>
        <a:xfrm>
          <a:off x="5741657" y="2014959"/>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Design the research project</a:t>
          </a:r>
        </a:p>
      </dsp:txBody>
      <dsp:txXfrm>
        <a:off x="5772636" y="2045938"/>
        <a:ext cx="914356" cy="572646"/>
      </dsp:txXfrm>
    </dsp:sp>
    <dsp:sp modelId="{50EE490F-4F8E-9049-B615-10D6612BF852}">
      <dsp:nvSpPr>
        <dsp:cNvPr id="0" name=""/>
        <dsp:cNvSpPr/>
      </dsp:nvSpPr>
      <dsp:spPr>
        <a:xfrm>
          <a:off x="1394059" y="318950"/>
          <a:ext cx="4872769" cy="4872769"/>
        </a:xfrm>
        <a:custGeom>
          <a:avLst/>
          <a:gdLst/>
          <a:ahLst/>
          <a:cxnLst/>
          <a:rect l="0" t="0" r="0" b="0"/>
          <a:pathLst>
            <a:path>
              <a:moveTo>
                <a:pt x="4870782" y="2534748"/>
              </a:moveTo>
              <a:arcTo wR="2436384" hR="2436384" stAng="21738830" swAng="875117"/>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97452FB2-9725-6644-8F45-8091549EC3C6}">
      <dsp:nvSpPr>
        <dsp:cNvPr id="0" name=""/>
        <dsp:cNvSpPr/>
      </dsp:nvSpPr>
      <dsp:spPr>
        <a:xfrm>
          <a:off x="5452257" y="3656225"/>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Manage the research</a:t>
          </a:r>
        </a:p>
      </dsp:txBody>
      <dsp:txXfrm>
        <a:off x="5483236" y="3687204"/>
        <a:ext cx="914356" cy="572646"/>
      </dsp:txXfrm>
    </dsp:sp>
    <dsp:sp modelId="{454A1872-84E1-A440-9E23-9BA8B373C188}">
      <dsp:nvSpPr>
        <dsp:cNvPr id="0" name=""/>
        <dsp:cNvSpPr/>
      </dsp:nvSpPr>
      <dsp:spPr>
        <a:xfrm>
          <a:off x="1394059" y="318950"/>
          <a:ext cx="4872769" cy="4872769"/>
        </a:xfrm>
        <a:custGeom>
          <a:avLst/>
          <a:gdLst/>
          <a:ahLst/>
          <a:cxnLst/>
          <a:rect l="0" t="0" r="0" b="0"/>
          <a:pathLst>
            <a:path>
              <a:moveTo>
                <a:pt x="4227790" y="4087697"/>
              </a:moveTo>
              <a:arcTo wR="2436384" hR="2436384" stAng="2560187" swAng="652919"/>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2EAB5438-31E8-064A-A4B0-3F2DE2B6D4E6}">
      <dsp:nvSpPr>
        <dsp:cNvPr id="0" name=""/>
        <dsp:cNvSpPr/>
      </dsp:nvSpPr>
      <dsp:spPr>
        <a:xfrm>
          <a:off x="4175579" y="4727485"/>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Conduct the research</a:t>
          </a:r>
        </a:p>
      </dsp:txBody>
      <dsp:txXfrm>
        <a:off x="4206558" y="4758464"/>
        <a:ext cx="914356" cy="572646"/>
      </dsp:txXfrm>
    </dsp:sp>
    <dsp:sp modelId="{592DEB87-05BA-314E-9E5D-A0994FBB9BE7}">
      <dsp:nvSpPr>
        <dsp:cNvPr id="0" name=""/>
        <dsp:cNvSpPr/>
      </dsp:nvSpPr>
      <dsp:spPr>
        <a:xfrm>
          <a:off x="1394059" y="318950"/>
          <a:ext cx="4872769" cy="4872769"/>
        </a:xfrm>
        <a:custGeom>
          <a:avLst/>
          <a:gdLst/>
          <a:ahLst/>
          <a:cxnLst/>
          <a:rect l="0" t="0" r="0" b="0"/>
          <a:pathLst>
            <a:path>
              <a:moveTo>
                <a:pt x="2644377" y="4863875"/>
              </a:moveTo>
              <a:arcTo wR="2436384" hR="2436384" stAng="5106164" swAng="587672"/>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B61B4333-12E9-EA4E-96BE-541075F519B1}">
      <dsp:nvSpPr>
        <dsp:cNvPr id="0" name=""/>
        <dsp:cNvSpPr/>
      </dsp:nvSpPr>
      <dsp:spPr>
        <a:xfrm>
          <a:off x="2508994" y="4727485"/>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Analyse and interpret findings</a:t>
          </a:r>
        </a:p>
      </dsp:txBody>
      <dsp:txXfrm>
        <a:off x="2539973" y="4758464"/>
        <a:ext cx="914356" cy="572646"/>
      </dsp:txXfrm>
    </dsp:sp>
    <dsp:sp modelId="{1DCD3E9D-C78C-A144-B7E8-BE98F083AEB6}">
      <dsp:nvSpPr>
        <dsp:cNvPr id="0" name=""/>
        <dsp:cNvSpPr/>
      </dsp:nvSpPr>
      <dsp:spPr>
        <a:xfrm>
          <a:off x="1394059" y="318950"/>
          <a:ext cx="4872769" cy="4872769"/>
        </a:xfrm>
        <a:custGeom>
          <a:avLst/>
          <a:gdLst/>
          <a:ahLst/>
          <a:cxnLst/>
          <a:rect l="0" t="0" r="0" b="0"/>
          <a:pathLst>
            <a:path>
              <a:moveTo>
                <a:pt x="988937" y="4396197"/>
              </a:moveTo>
              <a:arcTo wR="2436384" hR="2436384" stAng="7586894" swAng="652919"/>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18BCA952-D167-F945-8867-AD4C9D2398AB}">
      <dsp:nvSpPr>
        <dsp:cNvPr id="0" name=""/>
        <dsp:cNvSpPr/>
      </dsp:nvSpPr>
      <dsp:spPr>
        <a:xfrm>
          <a:off x="1232315" y="3656225"/>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Disseminate</a:t>
          </a:r>
        </a:p>
      </dsp:txBody>
      <dsp:txXfrm>
        <a:off x="1263294" y="3687204"/>
        <a:ext cx="914356" cy="572646"/>
      </dsp:txXfrm>
    </dsp:sp>
    <dsp:sp modelId="{B9ABB65A-E4F9-2446-9DC0-16FA01C2810E}">
      <dsp:nvSpPr>
        <dsp:cNvPr id="0" name=""/>
        <dsp:cNvSpPr/>
      </dsp:nvSpPr>
      <dsp:spPr>
        <a:xfrm>
          <a:off x="1394059" y="318950"/>
          <a:ext cx="4872769" cy="4872769"/>
        </a:xfrm>
        <a:custGeom>
          <a:avLst/>
          <a:gdLst/>
          <a:ahLst/>
          <a:cxnLst/>
          <a:rect l="0" t="0" r="0" b="0"/>
          <a:pathLst>
            <a:path>
              <a:moveTo>
                <a:pt x="105207" y="3144611"/>
              </a:moveTo>
              <a:arcTo wR="2436384" hR="2436384" stAng="9786053" swAng="875117"/>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BBB9B9B7-392F-044F-9D6F-255404CF4C1D}">
      <dsp:nvSpPr>
        <dsp:cNvPr id="0" name=""/>
        <dsp:cNvSpPr/>
      </dsp:nvSpPr>
      <dsp:spPr>
        <a:xfrm>
          <a:off x="942916" y="2014959"/>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Evaluate</a:t>
          </a:r>
        </a:p>
      </dsp:txBody>
      <dsp:txXfrm>
        <a:off x="973895" y="2045938"/>
        <a:ext cx="914356" cy="572646"/>
      </dsp:txXfrm>
    </dsp:sp>
    <dsp:sp modelId="{24E638AC-505A-804E-9219-145CB4495339}">
      <dsp:nvSpPr>
        <dsp:cNvPr id="0" name=""/>
        <dsp:cNvSpPr/>
      </dsp:nvSpPr>
      <dsp:spPr>
        <a:xfrm>
          <a:off x="1394059" y="318950"/>
          <a:ext cx="4872769" cy="4872769"/>
        </a:xfrm>
        <a:custGeom>
          <a:avLst/>
          <a:gdLst/>
          <a:ahLst/>
          <a:cxnLst/>
          <a:rect l="0" t="0" r="0" b="0"/>
          <a:pathLst>
            <a:path>
              <a:moveTo>
                <a:pt x="177768" y="1522808"/>
              </a:moveTo>
              <a:arcTo wR="2436384" hR="2436384" stAng="12121355" swAng="787552"/>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99EB3913-8B6E-E34E-9628-DAC25591E971}">
      <dsp:nvSpPr>
        <dsp:cNvPr id="0" name=""/>
        <dsp:cNvSpPr/>
      </dsp:nvSpPr>
      <dsp:spPr>
        <a:xfrm>
          <a:off x="1776208" y="571653"/>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Act on findings</a:t>
          </a:r>
        </a:p>
      </dsp:txBody>
      <dsp:txXfrm>
        <a:off x="1807187" y="602632"/>
        <a:ext cx="914356" cy="572646"/>
      </dsp:txXfrm>
    </dsp:sp>
    <dsp:sp modelId="{D8F8ADA8-351A-B544-A873-AEA3C0755809}">
      <dsp:nvSpPr>
        <dsp:cNvPr id="0" name=""/>
        <dsp:cNvSpPr/>
      </dsp:nvSpPr>
      <dsp:spPr>
        <a:xfrm>
          <a:off x="1394059" y="318950"/>
          <a:ext cx="4872769" cy="4872769"/>
        </a:xfrm>
        <a:custGeom>
          <a:avLst/>
          <a:gdLst/>
          <a:ahLst/>
          <a:cxnLst/>
          <a:rect l="0" t="0" r="0" b="0"/>
          <a:pathLst>
            <a:path>
              <a:moveTo>
                <a:pt x="1469513" y="200064"/>
              </a:moveTo>
              <a:arcTo wR="2436384" hR="2436384" stAng="14797128" swAng="532653"/>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574BFB6-BEF1-8C4C-8B68-6F0C449AC879}">
      <dsp:nvSpPr>
        <dsp:cNvPr id="0" name=""/>
        <dsp:cNvSpPr/>
      </dsp:nvSpPr>
      <dsp:spPr>
        <a:xfrm>
          <a:off x="2797207" y="2368"/>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Identify the topic</a:t>
          </a:r>
        </a:p>
      </dsp:txBody>
      <dsp:txXfrm>
        <a:off x="2824740" y="29901"/>
        <a:ext cx="812651" cy="508950"/>
      </dsp:txXfrm>
    </dsp:sp>
    <dsp:sp modelId="{898433E3-2070-1F49-9809-E8CFFC177272}">
      <dsp:nvSpPr>
        <dsp:cNvPr id="0" name=""/>
        <dsp:cNvSpPr/>
      </dsp:nvSpPr>
      <dsp:spPr>
        <a:xfrm>
          <a:off x="1067060" y="284376"/>
          <a:ext cx="4328010" cy="4328010"/>
        </a:xfrm>
        <a:custGeom>
          <a:avLst/>
          <a:gdLst/>
          <a:ahLst/>
          <a:cxnLst/>
          <a:rect l="0" t="0" r="0" b="0"/>
          <a:pathLst>
            <a:path>
              <a:moveTo>
                <a:pt x="2706103" y="68999"/>
              </a:moveTo>
              <a:arcTo wR="2164005" hR="2164005" stAng="17070451" swAng="531995"/>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5F7A9264-01C6-C443-BFDE-FEF35C937F56}">
      <dsp:nvSpPr>
        <dsp:cNvPr id="0" name=""/>
        <dsp:cNvSpPr/>
      </dsp:nvSpPr>
      <dsp:spPr>
        <a:xfrm>
          <a:off x="4188202" y="508649"/>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Seek funding</a:t>
          </a:r>
        </a:p>
      </dsp:txBody>
      <dsp:txXfrm>
        <a:off x="4215735" y="536182"/>
        <a:ext cx="812651" cy="508950"/>
      </dsp:txXfrm>
    </dsp:sp>
    <dsp:sp modelId="{B371DBB0-DEDB-914B-9AFF-7586E37A0CF6}">
      <dsp:nvSpPr>
        <dsp:cNvPr id="0" name=""/>
        <dsp:cNvSpPr/>
      </dsp:nvSpPr>
      <dsp:spPr>
        <a:xfrm>
          <a:off x="1067060" y="284376"/>
          <a:ext cx="4328010" cy="4328010"/>
        </a:xfrm>
        <a:custGeom>
          <a:avLst/>
          <a:gdLst/>
          <a:ahLst/>
          <a:cxnLst/>
          <a:rect l="0" t="0" r="0" b="0"/>
          <a:pathLst>
            <a:path>
              <a:moveTo>
                <a:pt x="3933518" y="918316"/>
              </a:moveTo>
              <a:arcTo wR="2164005" hR="2164005" stAng="19491331" swAng="787146"/>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F039F0EB-D869-DF43-8B8E-C29408B796EB}">
      <dsp:nvSpPr>
        <dsp:cNvPr id="0" name=""/>
        <dsp:cNvSpPr/>
      </dsp:nvSpPr>
      <dsp:spPr>
        <a:xfrm>
          <a:off x="4928336" y="1790597"/>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Design the research project</a:t>
          </a:r>
        </a:p>
      </dsp:txBody>
      <dsp:txXfrm>
        <a:off x="4955869" y="1818130"/>
        <a:ext cx="812651" cy="508950"/>
      </dsp:txXfrm>
    </dsp:sp>
    <dsp:sp modelId="{50EE490F-4F8E-9049-B615-10D6612BF852}">
      <dsp:nvSpPr>
        <dsp:cNvPr id="0" name=""/>
        <dsp:cNvSpPr/>
      </dsp:nvSpPr>
      <dsp:spPr>
        <a:xfrm>
          <a:off x="1067060" y="284376"/>
          <a:ext cx="4328010" cy="4328010"/>
        </a:xfrm>
        <a:custGeom>
          <a:avLst/>
          <a:gdLst/>
          <a:ahLst/>
          <a:cxnLst/>
          <a:rect l="0" t="0" r="0" b="0"/>
          <a:pathLst>
            <a:path>
              <a:moveTo>
                <a:pt x="4326241" y="2251479"/>
              </a:moveTo>
              <a:arcTo wR="2164005" hR="2164005" stAng="21738999" swAng="874757"/>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97452FB2-9725-6644-8F45-8091549EC3C6}">
      <dsp:nvSpPr>
        <dsp:cNvPr id="0" name=""/>
        <dsp:cNvSpPr/>
      </dsp:nvSpPr>
      <dsp:spPr>
        <a:xfrm>
          <a:off x="4671290" y="3248375"/>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Manage the research</a:t>
          </a:r>
        </a:p>
      </dsp:txBody>
      <dsp:txXfrm>
        <a:off x="4698823" y="3275908"/>
        <a:ext cx="812651" cy="508950"/>
      </dsp:txXfrm>
    </dsp:sp>
    <dsp:sp modelId="{454A1872-84E1-A440-9E23-9BA8B373C188}">
      <dsp:nvSpPr>
        <dsp:cNvPr id="0" name=""/>
        <dsp:cNvSpPr/>
      </dsp:nvSpPr>
      <dsp:spPr>
        <a:xfrm>
          <a:off x="1067060" y="284376"/>
          <a:ext cx="4328010" cy="4328010"/>
        </a:xfrm>
        <a:custGeom>
          <a:avLst/>
          <a:gdLst/>
          <a:ahLst/>
          <a:cxnLst/>
          <a:rect l="0" t="0" r="0" b="0"/>
          <a:pathLst>
            <a:path>
              <a:moveTo>
                <a:pt x="3755056" y="3630795"/>
              </a:moveTo>
              <a:arcTo wR="2164005" hR="2164005" stAng="2560378" swAng="652381"/>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2EAB5438-31E8-064A-A4B0-3F2DE2B6D4E6}">
      <dsp:nvSpPr>
        <dsp:cNvPr id="0" name=""/>
        <dsp:cNvSpPr/>
      </dsp:nvSpPr>
      <dsp:spPr>
        <a:xfrm>
          <a:off x="3537340" y="4199873"/>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Conduct the research</a:t>
          </a:r>
        </a:p>
      </dsp:txBody>
      <dsp:txXfrm>
        <a:off x="3564873" y="4227406"/>
        <a:ext cx="812651" cy="508950"/>
      </dsp:txXfrm>
    </dsp:sp>
    <dsp:sp modelId="{592DEB87-05BA-314E-9E5D-A0994FBB9BE7}">
      <dsp:nvSpPr>
        <dsp:cNvPr id="0" name=""/>
        <dsp:cNvSpPr/>
      </dsp:nvSpPr>
      <dsp:spPr>
        <a:xfrm>
          <a:off x="1067060" y="284376"/>
          <a:ext cx="4328010" cy="4328010"/>
        </a:xfrm>
        <a:custGeom>
          <a:avLst/>
          <a:gdLst/>
          <a:ahLst/>
          <a:cxnLst/>
          <a:rect l="0" t="0" r="0" b="0"/>
          <a:pathLst>
            <a:path>
              <a:moveTo>
                <a:pt x="2348577" y="4320124"/>
              </a:moveTo>
              <a:arcTo wR="2164005" hR="2164005" stAng="5106432" swAng="587137"/>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B61B4333-12E9-EA4E-96BE-541075F519B1}">
      <dsp:nvSpPr>
        <dsp:cNvPr id="0" name=""/>
        <dsp:cNvSpPr/>
      </dsp:nvSpPr>
      <dsp:spPr>
        <a:xfrm>
          <a:off x="2057073" y="4199873"/>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Analyse and interpret findings</a:t>
          </a:r>
        </a:p>
      </dsp:txBody>
      <dsp:txXfrm>
        <a:off x="2084606" y="4227406"/>
        <a:ext cx="812651" cy="508950"/>
      </dsp:txXfrm>
    </dsp:sp>
    <dsp:sp modelId="{1DCD3E9D-C78C-A144-B7E8-BE98F083AEB6}">
      <dsp:nvSpPr>
        <dsp:cNvPr id="0" name=""/>
        <dsp:cNvSpPr/>
      </dsp:nvSpPr>
      <dsp:spPr>
        <a:xfrm>
          <a:off x="1067060" y="284376"/>
          <a:ext cx="4328010" cy="4328010"/>
        </a:xfrm>
        <a:custGeom>
          <a:avLst/>
          <a:gdLst/>
          <a:ahLst/>
          <a:cxnLst/>
          <a:rect l="0" t="0" r="0" b="0"/>
          <a:pathLst>
            <a:path>
              <a:moveTo>
                <a:pt x="878202" y="3904588"/>
              </a:moveTo>
              <a:arcTo wR="2164005" hR="2164005" stAng="7587240" swAng="652381"/>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18BCA952-D167-F945-8867-AD4C9D2398AB}">
      <dsp:nvSpPr>
        <dsp:cNvPr id="0" name=""/>
        <dsp:cNvSpPr/>
      </dsp:nvSpPr>
      <dsp:spPr>
        <a:xfrm>
          <a:off x="923123" y="3248375"/>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Disseminate</a:t>
          </a:r>
        </a:p>
      </dsp:txBody>
      <dsp:txXfrm>
        <a:off x="950656" y="3275908"/>
        <a:ext cx="812651" cy="508950"/>
      </dsp:txXfrm>
    </dsp:sp>
    <dsp:sp modelId="{B9ABB65A-E4F9-2446-9DC0-16FA01C2810E}">
      <dsp:nvSpPr>
        <dsp:cNvPr id="0" name=""/>
        <dsp:cNvSpPr/>
      </dsp:nvSpPr>
      <dsp:spPr>
        <a:xfrm>
          <a:off x="1067060" y="284376"/>
          <a:ext cx="4328010" cy="4328010"/>
        </a:xfrm>
        <a:custGeom>
          <a:avLst/>
          <a:gdLst/>
          <a:ahLst/>
          <a:cxnLst/>
          <a:rect l="0" t="0" r="0" b="0"/>
          <a:pathLst>
            <a:path>
              <a:moveTo>
                <a:pt x="93411" y="2792939"/>
              </a:moveTo>
              <a:arcTo wR="2164005" hR="2164005" stAng="9786244" swAng="874757"/>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BBB9B9B7-392F-044F-9D6F-255404CF4C1D}">
      <dsp:nvSpPr>
        <dsp:cNvPr id="0" name=""/>
        <dsp:cNvSpPr/>
      </dsp:nvSpPr>
      <dsp:spPr>
        <a:xfrm>
          <a:off x="666077" y="1790597"/>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Evaluate</a:t>
          </a:r>
        </a:p>
      </dsp:txBody>
      <dsp:txXfrm>
        <a:off x="693610" y="1818130"/>
        <a:ext cx="812651" cy="508950"/>
      </dsp:txXfrm>
    </dsp:sp>
    <dsp:sp modelId="{24E638AC-505A-804E-9219-145CB4495339}">
      <dsp:nvSpPr>
        <dsp:cNvPr id="0" name=""/>
        <dsp:cNvSpPr/>
      </dsp:nvSpPr>
      <dsp:spPr>
        <a:xfrm>
          <a:off x="1067060" y="284376"/>
          <a:ext cx="4328010" cy="4328010"/>
        </a:xfrm>
        <a:custGeom>
          <a:avLst/>
          <a:gdLst/>
          <a:ahLst/>
          <a:cxnLst/>
          <a:rect l="0" t="0" r="0" b="0"/>
          <a:pathLst>
            <a:path>
              <a:moveTo>
                <a:pt x="157933" y="1352465"/>
              </a:moveTo>
              <a:arcTo wR="2164005" hR="2164005" stAng="12121523" swAng="787146"/>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99EB3913-8B6E-E34E-9628-DAC25591E971}">
      <dsp:nvSpPr>
        <dsp:cNvPr id="0" name=""/>
        <dsp:cNvSpPr/>
      </dsp:nvSpPr>
      <dsp:spPr>
        <a:xfrm>
          <a:off x="1406211" y="508649"/>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Act on findings</a:t>
          </a:r>
        </a:p>
      </dsp:txBody>
      <dsp:txXfrm>
        <a:off x="1433744" y="536182"/>
        <a:ext cx="812651" cy="508950"/>
      </dsp:txXfrm>
    </dsp:sp>
    <dsp:sp modelId="{D8F8ADA8-351A-B544-A873-AEA3C0755809}">
      <dsp:nvSpPr>
        <dsp:cNvPr id="0" name=""/>
        <dsp:cNvSpPr/>
      </dsp:nvSpPr>
      <dsp:spPr>
        <a:xfrm>
          <a:off x="1067060" y="284376"/>
          <a:ext cx="4328010" cy="4328010"/>
        </a:xfrm>
        <a:custGeom>
          <a:avLst/>
          <a:gdLst/>
          <a:ahLst/>
          <a:cxnLst/>
          <a:rect l="0" t="0" r="0" b="0"/>
          <a:pathLst>
            <a:path>
              <a:moveTo>
                <a:pt x="1305473" y="177591"/>
              </a:moveTo>
              <a:arcTo wR="2164005" hR="2164005" stAng="14797554" swAng="531995"/>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574BFB6-BEF1-8C4C-8B68-6F0C449AC879}">
      <dsp:nvSpPr>
        <dsp:cNvPr id="0" name=""/>
        <dsp:cNvSpPr/>
      </dsp:nvSpPr>
      <dsp:spPr>
        <a:xfrm>
          <a:off x="3342286" y="1648"/>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Identify the topic</a:t>
          </a:r>
        </a:p>
      </dsp:txBody>
      <dsp:txXfrm>
        <a:off x="3373265" y="32627"/>
        <a:ext cx="914356" cy="572646"/>
      </dsp:txXfrm>
    </dsp:sp>
    <dsp:sp modelId="{898433E3-2070-1F49-9809-E8CFFC177272}">
      <dsp:nvSpPr>
        <dsp:cNvPr id="0" name=""/>
        <dsp:cNvSpPr/>
      </dsp:nvSpPr>
      <dsp:spPr>
        <a:xfrm>
          <a:off x="1394059" y="318950"/>
          <a:ext cx="4872769" cy="4872769"/>
        </a:xfrm>
        <a:custGeom>
          <a:avLst/>
          <a:gdLst/>
          <a:ahLst/>
          <a:cxnLst/>
          <a:rect l="0" t="0" r="0" b="0"/>
          <a:pathLst>
            <a:path>
              <a:moveTo>
                <a:pt x="3046557" y="77643"/>
              </a:moveTo>
              <a:arcTo wR="2436384" hR="2436384" stAng="17070219" swAng="532653"/>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5F7A9264-01C6-C443-BFDE-FEF35C937F56}">
      <dsp:nvSpPr>
        <dsp:cNvPr id="0" name=""/>
        <dsp:cNvSpPr/>
      </dsp:nvSpPr>
      <dsp:spPr>
        <a:xfrm>
          <a:off x="4908364" y="571653"/>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Seek funding</a:t>
          </a:r>
        </a:p>
      </dsp:txBody>
      <dsp:txXfrm>
        <a:off x="4939343" y="602632"/>
        <a:ext cx="914356" cy="572646"/>
      </dsp:txXfrm>
    </dsp:sp>
    <dsp:sp modelId="{B371DBB0-DEDB-914B-9AFF-7586E37A0CF6}">
      <dsp:nvSpPr>
        <dsp:cNvPr id="0" name=""/>
        <dsp:cNvSpPr/>
      </dsp:nvSpPr>
      <dsp:spPr>
        <a:xfrm>
          <a:off x="1394059" y="318950"/>
          <a:ext cx="4872769" cy="4872769"/>
        </a:xfrm>
        <a:custGeom>
          <a:avLst/>
          <a:gdLst/>
          <a:ahLst/>
          <a:cxnLst/>
          <a:rect l="0" t="0" r="0" b="0"/>
          <a:pathLst>
            <a:path>
              <a:moveTo>
                <a:pt x="4428526" y="1033765"/>
              </a:moveTo>
              <a:arcTo wR="2436384" hR="2436384" stAng="19491093" swAng="787552"/>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F039F0EB-D869-DF43-8B8E-C29408B796EB}">
      <dsp:nvSpPr>
        <dsp:cNvPr id="0" name=""/>
        <dsp:cNvSpPr/>
      </dsp:nvSpPr>
      <dsp:spPr>
        <a:xfrm>
          <a:off x="5741657" y="2014959"/>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Design the research project</a:t>
          </a:r>
        </a:p>
      </dsp:txBody>
      <dsp:txXfrm>
        <a:off x="5772636" y="2045938"/>
        <a:ext cx="914356" cy="572646"/>
      </dsp:txXfrm>
    </dsp:sp>
    <dsp:sp modelId="{50EE490F-4F8E-9049-B615-10D6612BF852}">
      <dsp:nvSpPr>
        <dsp:cNvPr id="0" name=""/>
        <dsp:cNvSpPr/>
      </dsp:nvSpPr>
      <dsp:spPr>
        <a:xfrm>
          <a:off x="1394059" y="318950"/>
          <a:ext cx="4872769" cy="4872769"/>
        </a:xfrm>
        <a:custGeom>
          <a:avLst/>
          <a:gdLst/>
          <a:ahLst/>
          <a:cxnLst/>
          <a:rect l="0" t="0" r="0" b="0"/>
          <a:pathLst>
            <a:path>
              <a:moveTo>
                <a:pt x="4870782" y="2534748"/>
              </a:moveTo>
              <a:arcTo wR="2436384" hR="2436384" stAng="21738830" swAng="875117"/>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97452FB2-9725-6644-8F45-8091549EC3C6}">
      <dsp:nvSpPr>
        <dsp:cNvPr id="0" name=""/>
        <dsp:cNvSpPr/>
      </dsp:nvSpPr>
      <dsp:spPr>
        <a:xfrm>
          <a:off x="5452257" y="3656225"/>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Manage the research</a:t>
          </a:r>
        </a:p>
      </dsp:txBody>
      <dsp:txXfrm>
        <a:off x="5483236" y="3687204"/>
        <a:ext cx="914356" cy="572646"/>
      </dsp:txXfrm>
    </dsp:sp>
    <dsp:sp modelId="{454A1872-84E1-A440-9E23-9BA8B373C188}">
      <dsp:nvSpPr>
        <dsp:cNvPr id="0" name=""/>
        <dsp:cNvSpPr/>
      </dsp:nvSpPr>
      <dsp:spPr>
        <a:xfrm>
          <a:off x="1394059" y="318950"/>
          <a:ext cx="4872769" cy="4872769"/>
        </a:xfrm>
        <a:custGeom>
          <a:avLst/>
          <a:gdLst/>
          <a:ahLst/>
          <a:cxnLst/>
          <a:rect l="0" t="0" r="0" b="0"/>
          <a:pathLst>
            <a:path>
              <a:moveTo>
                <a:pt x="4227790" y="4087697"/>
              </a:moveTo>
              <a:arcTo wR="2436384" hR="2436384" stAng="2560187" swAng="652919"/>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2EAB5438-31E8-064A-A4B0-3F2DE2B6D4E6}">
      <dsp:nvSpPr>
        <dsp:cNvPr id="0" name=""/>
        <dsp:cNvSpPr/>
      </dsp:nvSpPr>
      <dsp:spPr>
        <a:xfrm>
          <a:off x="4175579" y="4727485"/>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Conduct the research</a:t>
          </a:r>
        </a:p>
      </dsp:txBody>
      <dsp:txXfrm>
        <a:off x="4206558" y="4758464"/>
        <a:ext cx="914356" cy="572646"/>
      </dsp:txXfrm>
    </dsp:sp>
    <dsp:sp modelId="{592DEB87-05BA-314E-9E5D-A0994FBB9BE7}">
      <dsp:nvSpPr>
        <dsp:cNvPr id="0" name=""/>
        <dsp:cNvSpPr/>
      </dsp:nvSpPr>
      <dsp:spPr>
        <a:xfrm>
          <a:off x="1394059" y="318950"/>
          <a:ext cx="4872769" cy="4872769"/>
        </a:xfrm>
        <a:custGeom>
          <a:avLst/>
          <a:gdLst/>
          <a:ahLst/>
          <a:cxnLst/>
          <a:rect l="0" t="0" r="0" b="0"/>
          <a:pathLst>
            <a:path>
              <a:moveTo>
                <a:pt x="2644377" y="4863875"/>
              </a:moveTo>
              <a:arcTo wR="2436384" hR="2436384" stAng="5106164" swAng="587672"/>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B61B4333-12E9-EA4E-96BE-541075F519B1}">
      <dsp:nvSpPr>
        <dsp:cNvPr id="0" name=""/>
        <dsp:cNvSpPr/>
      </dsp:nvSpPr>
      <dsp:spPr>
        <a:xfrm>
          <a:off x="2508994" y="4727485"/>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Analyse and interpret findings</a:t>
          </a:r>
        </a:p>
      </dsp:txBody>
      <dsp:txXfrm>
        <a:off x="2539973" y="4758464"/>
        <a:ext cx="914356" cy="572646"/>
      </dsp:txXfrm>
    </dsp:sp>
    <dsp:sp modelId="{1DCD3E9D-C78C-A144-B7E8-BE98F083AEB6}">
      <dsp:nvSpPr>
        <dsp:cNvPr id="0" name=""/>
        <dsp:cNvSpPr/>
      </dsp:nvSpPr>
      <dsp:spPr>
        <a:xfrm>
          <a:off x="1394059" y="318950"/>
          <a:ext cx="4872769" cy="4872769"/>
        </a:xfrm>
        <a:custGeom>
          <a:avLst/>
          <a:gdLst/>
          <a:ahLst/>
          <a:cxnLst/>
          <a:rect l="0" t="0" r="0" b="0"/>
          <a:pathLst>
            <a:path>
              <a:moveTo>
                <a:pt x="988937" y="4396197"/>
              </a:moveTo>
              <a:arcTo wR="2436384" hR="2436384" stAng="7586894" swAng="652919"/>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18BCA952-D167-F945-8867-AD4C9D2398AB}">
      <dsp:nvSpPr>
        <dsp:cNvPr id="0" name=""/>
        <dsp:cNvSpPr/>
      </dsp:nvSpPr>
      <dsp:spPr>
        <a:xfrm>
          <a:off x="1232315" y="3656225"/>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Disseminate</a:t>
          </a:r>
        </a:p>
      </dsp:txBody>
      <dsp:txXfrm>
        <a:off x="1263294" y="3687204"/>
        <a:ext cx="914356" cy="572646"/>
      </dsp:txXfrm>
    </dsp:sp>
    <dsp:sp modelId="{B9ABB65A-E4F9-2446-9DC0-16FA01C2810E}">
      <dsp:nvSpPr>
        <dsp:cNvPr id="0" name=""/>
        <dsp:cNvSpPr/>
      </dsp:nvSpPr>
      <dsp:spPr>
        <a:xfrm>
          <a:off x="1394059" y="318950"/>
          <a:ext cx="4872769" cy="4872769"/>
        </a:xfrm>
        <a:custGeom>
          <a:avLst/>
          <a:gdLst/>
          <a:ahLst/>
          <a:cxnLst/>
          <a:rect l="0" t="0" r="0" b="0"/>
          <a:pathLst>
            <a:path>
              <a:moveTo>
                <a:pt x="105207" y="3144611"/>
              </a:moveTo>
              <a:arcTo wR="2436384" hR="2436384" stAng="9786053" swAng="875117"/>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BBB9B9B7-392F-044F-9D6F-255404CF4C1D}">
      <dsp:nvSpPr>
        <dsp:cNvPr id="0" name=""/>
        <dsp:cNvSpPr/>
      </dsp:nvSpPr>
      <dsp:spPr>
        <a:xfrm>
          <a:off x="942916" y="2014959"/>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Evaluate</a:t>
          </a:r>
        </a:p>
      </dsp:txBody>
      <dsp:txXfrm>
        <a:off x="973895" y="2045938"/>
        <a:ext cx="914356" cy="572646"/>
      </dsp:txXfrm>
    </dsp:sp>
    <dsp:sp modelId="{24E638AC-505A-804E-9219-145CB4495339}">
      <dsp:nvSpPr>
        <dsp:cNvPr id="0" name=""/>
        <dsp:cNvSpPr/>
      </dsp:nvSpPr>
      <dsp:spPr>
        <a:xfrm>
          <a:off x="1394059" y="318950"/>
          <a:ext cx="4872769" cy="4872769"/>
        </a:xfrm>
        <a:custGeom>
          <a:avLst/>
          <a:gdLst/>
          <a:ahLst/>
          <a:cxnLst/>
          <a:rect l="0" t="0" r="0" b="0"/>
          <a:pathLst>
            <a:path>
              <a:moveTo>
                <a:pt x="177768" y="1522808"/>
              </a:moveTo>
              <a:arcTo wR="2436384" hR="2436384" stAng="12121355" swAng="787552"/>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99EB3913-8B6E-E34E-9628-DAC25591E971}">
      <dsp:nvSpPr>
        <dsp:cNvPr id="0" name=""/>
        <dsp:cNvSpPr/>
      </dsp:nvSpPr>
      <dsp:spPr>
        <a:xfrm>
          <a:off x="1776208" y="571653"/>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Act on findings</a:t>
          </a:r>
        </a:p>
      </dsp:txBody>
      <dsp:txXfrm>
        <a:off x="1807187" y="602632"/>
        <a:ext cx="914356" cy="572646"/>
      </dsp:txXfrm>
    </dsp:sp>
    <dsp:sp modelId="{D8F8ADA8-351A-B544-A873-AEA3C0755809}">
      <dsp:nvSpPr>
        <dsp:cNvPr id="0" name=""/>
        <dsp:cNvSpPr/>
      </dsp:nvSpPr>
      <dsp:spPr>
        <a:xfrm>
          <a:off x="1394059" y="318950"/>
          <a:ext cx="4872769" cy="4872769"/>
        </a:xfrm>
        <a:custGeom>
          <a:avLst/>
          <a:gdLst/>
          <a:ahLst/>
          <a:cxnLst/>
          <a:rect l="0" t="0" r="0" b="0"/>
          <a:pathLst>
            <a:path>
              <a:moveTo>
                <a:pt x="1469513" y="200064"/>
              </a:moveTo>
              <a:arcTo wR="2436384" hR="2436384" stAng="14797128" swAng="532653"/>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574BFB6-BEF1-8C4C-8B68-6F0C449AC879}">
      <dsp:nvSpPr>
        <dsp:cNvPr id="0" name=""/>
        <dsp:cNvSpPr/>
      </dsp:nvSpPr>
      <dsp:spPr>
        <a:xfrm>
          <a:off x="3342286" y="1648"/>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Identify the topic</a:t>
          </a:r>
        </a:p>
      </dsp:txBody>
      <dsp:txXfrm>
        <a:off x="3373265" y="32627"/>
        <a:ext cx="914356" cy="572646"/>
      </dsp:txXfrm>
    </dsp:sp>
    <dsp:sp modelId="{898433E3-2070-1F49-9809-E8CFFC177272}">
      <dsp:nvSpPr>
        <dsp:cNvPr id="0" name=""/>
        <dsp:cNvSpPr/>
      </dsp:nvSpPr>
      <dsp:spPr>
        <a:xfrm>
          <a:off x="1394059" y="318950"/>
          <a:ext cx="4872769" cy="4872769"/>
        </a:xfrm>
        <a:custGeom>
          <a:avLst/>
          <a:gdLst/>
          <a:ahLst/>
          <a:cxnLst/>
          <a:rect l="0" t="0" r="0" b="0"/>
          <a:pathLst>
            <a:path>
              <a:moveTo>
                <a:pt x="3046557" y="77643"/>
              </a:moveTo>
              <a:arcTo wR="2436384" hR="2436384" stAng="17070219" swAng="532653"/>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5F7A9264-01C6-C443-BFDE-FEF35C937F56}">
      <dsp:nvSpPr>
        <dsp:cNvPr id="0" name=""/>
        <dsp:cNvSpPr/>
      </dsp:nvSpPr>
      <dsp:spPr>
        <a:xfrm>
          <a:off x="4908364" y="571653"/>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Seek funding</a:t>
          </a:r>
        </a:p>
      </dsp:txBody>
      <dsp:txXfrm>
        <a:off x="4939343" y="602632"/>
        <a:ext cx="914356" cy="572646"/>
      </dsp:txXfrm>
    </dsp:sp>
    <dsp:sp modelId="{B371DBB0-DEDB-914B-9AFF-7586E37A0CF6}">
      <dsp:nvSpPr>
        <dsp:cNvPr id="0" name=""/>
        <dsp:cNvSpPr/>
      </dsp:nvSpPr>
      <dsp:spPr>
        <a:xfrm>
          <a:off x="1394059" y="318950"/>
          <a:ext cx="4872769" cy="4872769"/>
        </a:xfrm>
        <a:custGeom>
          <a:avLst/>
          <a:gdLst/>
          <a:ahLst/>
          <a:cxnLst/>
          <a:rect l="0" t="0" r="0" b="0"/>
          <a:pathLst>
            <a:path>
              <a:moveTo>
                <a:pt x="4428526" y="1033765"/>
              </a:moveTo>
              <a:arcTo wR="2436384" hR="2436384" stAng="19491093" swAng="787552"/>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F039F0EB-D869-DF43-8B8E-C29408B796EB}">
      <dsp:nvSpPr>
        <dsp:cNvPr id="0" name=""/>
        <dsp:cNvSpPr/>
      </dsp:nvSpPr>
      <dsp:spPr>
        <a:xfrm>
          <a:off x="5741657" y="2014959"/>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Design the research project</a:t>
          </a:r>
        </a:p>
      </dsp:txBody>
      <dsp:txXfrm>
        <a:off x="5772636" y="2045938"/>
        <a:ext cx="914356" cy="572646"/>
      </dsp:txXfrm>
    </dsp:sp>
    <dsp:sp modelId="{50EE490F-4F8E-9049-B615-10D6612BF852}">
      <dsp:nvSpPr>
        <dsp:cNvPr id="0" name=""/>
        <dsp:cNvSpPr/>
      </dsp:nvSpPr>
      <dsp:spPr>
        <a:xfrm>
          <a:off x="1394059" y="318950"/>
          <a:ext cx="4872769" cy="4872769"/>
        </a:xfrm>
        <a:custGeom>
          <a:avLst/>
          <a:gdLst/>
          <a:ahLst/>
          <a:cxnLst/>
          <a:rect l="0" t="0" r="0" b="0"/>
          <a:pathLst>
            <a:path>
              <a:moveTo>
                <a:pt x="4870782" y="2534748"/>
              </a:moveTo>
              <a:arcTo wR="2436384" hR="2436384" stAng="21738830" swAng="875117"/>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97452FB2-9725-6644-8F45-8091549EC3C6}">
      <dsp:nvSpPr>
        <dsp:cNvPr id="0" name=""/>
        <dsp:cNvSpPr/>
      </dsp:nvSpPr>
      <dsp:spPr>
        <a:xfrm>
          <a:off x="5452257" y="3656225"/>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Manage the research</a:t>
          </a:r>
        </a:p>
      </dsp:txBody>
      <dsp:txXfrm>
        <a:off x="5483236" y="3687204"/>
        <a:ext cx="914356" cy="572646"/>
      </dsp:txXfrm>
    </dsp:sp>
    <dsp:sp modelId="{454A1872-84E1-A440-9E23-9BA8B373C188}">
      <dsp:nvSpPr>
        <dsp:cNvPr id="0" name=""/>
        <dsp:cNvSpPr/>
      </dsp:nvSpPr>
      <dsp:spPr>
        <a:xfrm>
          <a:off x="1394059" y="318950"/>
          <a:ext cx="4872769" cy="4872769"/>
        </a:xfrm>
        <a:custGeom>
          <a:avLst/>
          <a:gdLst/>
          <a:ahLst/>
          <a:cxnLst/>
          <a:rect l="0" t="0" r="0" b="0"/>
          <a:pathLst>
            <a:path>
              <a:moveTo>
                <a:pt x="4227790" y="4087697"/>
              </a:moveTo>
              <a:arcTo wR="2436384" hR="2436384" stAng="2560187" swAng="652919"/>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2EAB5438-31E8-064A-A4B0-3F2DE2B6D4E6}">
      <dsp:nvSpPr>
        <dsp:cNvPr id="0" name=""/>
        <dsp:cNvSpPr/>
      </dsp:nvSpPr>
      <dsp:spPr>
        <a:xfrm>
          <a:off x="4175579" y="4727485"/>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Conduct the research</a:t>
          </a:r>
        </a:p>
      </dsp:txBody>
      <dsp:txXfrm>
        <a:off x="4206558" y="4758464"/>
        <a:ext cx="914356" cy="572646"/>
      </dsp:txXfrm>
    </dsp:sp>
    <dsp:sp modelId="{592DEB87-05BA-314E-9E5D-A0994FBB9BE7}">
      <dsp:nvSpPr>
        <dsp:cNvPr id="0" name=""/>
        <dsp:cNvSpPr/>
      </dsp:nvSpPr>
      <dsp:spPr>
        <a:xfrm>
          <a:off x="1394059" y="318950"/>
          <a:ext cx="4872769" cy="4872769"/>
        </a:xfrm>
        <a:custGeom>
          <a:avLst/>
          <a:gdLst/>
          <a:ahLst/>
          <a:cxnLst/>
          <a:rect l="0" t="0" r="0" b="0"/>
          <a:pathLst>
            <a:path>
              <a:moveTo>
                <a:pt x="2644377" y="4863875"/>
              </a:moveTo>
              <a:arcTo wR="2436384" hR="2436384" stAng="5106164" swAng="587672"/>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B61B4333-12E9-EA4E-96BE-541075F519B1}">
      <dsp:nvSpPr>
        <dsp:cNvPr id="0" name=""/>
        <dsp:cNvSpPr/>
      </dsp:nvSpPr>
      <dsp:spPr>
        <a:xfrm>
          <a:off x="2508994" y="4727485"/>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Analyse and interpret findings</a:t>
          </a:r>
        </a:p>
      </dsp:txBody>
      <dsp:txXfrm>
        <a:off x="2539973" y="4758464"/>
        <a:ext cx="914356" cy="572646"/>
      </dsp:txXfrm>
    </dsp:sp>
    <dsp:sp modelId="{1DCD3E9D-C78C-A144-B7E8-BE98F083AEB6}">
      <dsp:nvSpPr>
        <dsp:cNvPr id="0" name=""/>
        <dsp:cNvSpPr/>
      </dsp:nvSpPr>
      <dsp:spPr>
        <a:xfrm>
          <a:off x="1394059" y="318950"/>
          <a:ext cx="4872769" cy="4872769"/>
        </a:xfrm>
        <a:custGeom>
          <a:avLst/>
          <a:gdLst/>
          <a:ahLst/>
          <a:cxnLst/>
          <a:rect l="0" t="0" r="0" b="0"/>
          <a:pathLst>
            <a:path>
              <a:moveTo>
                <a:pt x="988937" y="4396197"/>
              </a:moveTo>
              <a:arcTo wR="2436384" hR="2436384" stAng="7586894" swAng="652919"/>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18BCA952-D167-F945-8867-AD4C9D2398AB}">
      <dsp:nvSpPr>
        <dsp:cNvPr id="0" name=""/>
        <dsp:cNvSpPr/>
      </dsp:nvSpPr>
      <dsp:spPr>
        <a:xfrm>
          <a:off x="1232315" y="3656225"/>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Disseminate</a:t>
          </a:r>
        </a:p>
      </dsp:txBody>
      <dsp:txXfrm>
        <a:off x="1263294" y="3687204"/>
        <a:ext cx="914356" cy="572646"/>
      </dsp:txXfrm>
    </dsp:sp>
    <dsp:sp modelId="{B9ABB65A-E4F9-2446-9DC0-16FA01C2810E}">
      <dsp:nvSpPr>
        <dsp:cNvPr id="0" name=""/>
        <dsp:cNvSpPr/>
      </dsp:nvSpPr>
      <dsp:spPr>
        <a:xfrm>
          <a:off x="1394059" y="318950"/>
          <a:ext cx="4872769" cy="4872769"/>
        </a:xfrm>
        <a:custGeom>
          <a:avLst/>
          <a:gdLst/>
          <a:ahLst/>
          <a:cxnLst/>
          <a:rect l="0" t="0" r="0" b="0"/>
          <a:pathLst>
            <a:path>
              <a:moveTo>
                <a:pt x="105207" y="3144611"/>
              </a:moveTo>
              <a:arcTo wR="2436384" hR="2436384" stAng="9786053" swAng="875117"/>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BBB9B9B7-392F-044F-9D6F-255404CF4C1D}">
      <dsp:nvSpPr>
        <dsp:cNvPr id="0" name=""/>
        <dsp:cNvSpPr/>
      </dsp:nvSpPr>
      <dsp:spPr>
        <a:xfrm>
          <a:off x="942916" y="2014959"/>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Evaluate</a:t>
          </a:r>
        </a:p>
      </dsp:txBody>
      <dsp:txXfrm>
        <a:off x="973895" y="2045938"/>
        <a:ext cx="914356" cy="572646"/>
      </dsp:txXfrm>
    </dsp:sp>
    <dsp:sp modelId="{24E638AC-505A-804E-9219-145CB4495339}">
      <dsp:nvSpPr>
        <dsp:cNvPr id="0" name=""/>
        <dsp:cNvSpPr/>
      </dsp:nvSpPr>
      <dsp:spPr>
        <a:xfrm>
          <a:off x="1394059" y="318950"/>
          <a:ext cx="4872769" cy="4872769"/>
        </a:xfrm>
        <a:custGeom>
          <a:avLst/>
          <a:gdLst/>
          <a:ahLst/>
          <a:cxnLst/>
          <a:rect l="0" t="0" r="0" b="0"/>
          <a:pathLst>
            <a:path>
              <a:moveTo>
                <a:pt x="177768" y="1522808"/>
              </a:moveTo>
              <a:arcTo wR="2436384" hR="2436384" stAng="12121355" swAng="787552"/>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99EB3913-8B6E-E34E-9628-DAC25591E971}">
      <dsp:nvSpPr>
        <dsp:cNvPr id="0" name=""/>
        <dsp:cNvSpPr/>
      </dsp:nvSpPr>
      <dsp:spPr>
        <a:xfrm>
          <a:off x="1776208" y="571653"/>
          <a:ext cx="976314" cy="634604"/>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GB" sz="1200" kern="1200" dirty="0"/>
            <a:t>Act on findings</a:t>
          </a:r>
        </a:p>
      </dsp:txBody>
      <dsp:txXfrm>
        <a:off x="1807187" y="602632"/>
        <a:ext cx="914356" cy="572646"/>
      </dsp:txXfrm>
    </dsp:sp>
    <dsp:sp modelId="{D8F8ADA8-351A-B544-A873-AEA3C0755809}">
      <dsp:nvSpPr>
        <dsp:cNvPr id="0" name=""/>
        <dsp:cNvSpPr/>
      </dsp:nvSpPr>
      <dsp:spPr>
        <a:xfrm>
          <a:off x="1394059" y="318950"/>
          <a:ext cx="4872769" cy="4872769"/>
        </a:xfrm>
        <a:custGeom>
          <a:avLst/>
          <a:gdLst/>
          <a:ahLst/>
          <a:cxnLst/>
          <a:rect l="0" t="0" r="0" b="0"/>
          <a:pathLst>
            <a:path>
              <a:moveTo>
                <a:pt x="1469513" y="200064"/>
              </a:moveTo>
              <a:arcTo wR="2436384" hR="2436384" stAng="14797128" swAng="532653"/>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574BFB6-BEF1-8C4C-8B68-6F0C449AC879}">
      <dsp:nvSpPr>
        <dsp:cNvPr id="0" name=""/>
        <dsp:cNvSpPr/>
      </dsp:nvSpPr>
      <dsp:spPr>
        <a:xfrm>
          <a:off x="2797207" y="2368"/>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Identify the topic</a:t>
          </a:r>
        </a:p>
      </dsp:txBody>
      <dsp:txXfrm>
        <a:off x="2824740" y="29901"/>
        <a:ext cx="812651" cy="508950"/>
      </dsp:txXfrm>
    </dsp:sp>
    <dsp:sp modelId="{898433E3-2070-1F49-9809-E8CFFC177272}">
      <dsp:nvSpPr>
        <dsp:cNvPr id="0" name=""/>
        <dsp:cNvSpPr/>
      </dsp:nvSpPr>
      <dsp:spPr>
        <a:xfrm>
          <a:off x="1067060" y="284376"/>
          <a:ext cx="4328010" cy="4328010"/>
        </a:xfrm>
        <a:custGeom>
          <a:avLst/>
          <a:gdLst/>
          <a:ahLst/>
          <a:cxnLst/>
          <a:rect l="0" t="0" r="0" b="0"/>
          <a:pathLst>
            <a:path>
              <a:moveTo>
                <a:pt x="2706103" y="68999"/>
              </a:moveTo>
              <a:arcTo wR="2164005" hR="2164005" stAng="17070451" swAng="531995"/>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5F7A9264-01C6-C443-BFDE-FEF35C937F56}">
      <dsp:nvSpPr>
        <dsp:cNvPr id="0" name=""/>
        <dsp:cNvSpPr/>
      </dsp:nvSpPr>
      <dsp:spPr>
        <a:xfrm>
          <a:off x="4188202" y="508649"/>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Seek funding</a:t>
          </a:r>
        </a:p>
      </dsp:txBody>
      <dsp:txXfrm>
        <a:off x="4215735" y="536182"/>
        <a:ext cx="812651" cy="508950"/>
      </dsp:txXfrm>
    </dsp:sp>
    <dsp:sp modelId="{B371DBB0-DEDB-914B-9AFF-7586E37A0CF6}">
      <dsp:nvSpPr>
        <dsp:cNvPr id="0" name=""/>
        <dsp:cNvSpPr/>
      </dsp:nvSpPr>
      <dsp:spPr>
        <a:xfrm>
          <a:off x="1067060" y="284376"/>
          <a:ext cx="4328010" cy="4328010"/>
        </a:xfrm>
        <a:custGeom>
          <a:avLst/>
          <a:gdLst/>
          <a:ahLst/>
          <a:cxnLst/>
          <a:rect l="0" t="0" r="0" b="0"/>
          <a:pathLst>
            <a:path>
              <a:moveTo>
                <a:pt x="3933518" y="918316"/>
              </a:moveTo>
              <a:arcTo wR="2164005" hR="2164005" stAng="19491331" swAng="787146"/>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F039F0EB-D869-DF43-8B8E-C29408B796EB}">
      <dsp:nvSpPr>
        <dsp:cNvPr id="0" name=""/>
        <dsp:cNvSpPr/>
      </dsp:nvSpPr>
      <dsp:spPr>
        <a:xfrm>
          <a:off x="4928336" y="1790597"/>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Design the research project</a:t>
          </a:r>
        </a:p>
      </dsp:txBody>
      <dsp:txXfrm>
        <a:off x="4955869" y="1818130"/>
        <a:ext cx="812651" cy="508950"/>
      </dsp:txXfrm>
    </dsp:sp>
    <dsp:sp modelId="{50EE490F-4F8E-9049-B615-10D6612BF852}">
      <dsp:nvSpPr>
        <dsp:cNvPr id="0" name=""/>
        <dsp:cNvSpPr/>
      </dsp:nvSpPr>
      <dsp:spPr>
        <a:xfrm>
          <a:off x="1067060" y="284376"/>
          <a:ext cx="4328010" cy="4328010"/>
        </a:xfrm>
        <a:custGeom>
          <a:avLst/>
          <a:gdLst/>
          <a:ahLst/>
          <a:cxnLst/>
          <a:rect l="0" t="0" r="0" b="0"/>
          <a:pathLst>
            <a:path>
              <a:moveTo>
                <a:pt x="4326241" y="2251479"/>
              </a:moveTo>
              <a:arcTo wR="2164005" hR="2164005" stAng="21738999" swAng="874757"/>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97452FB2-9725-6644-8F45-8091549EC3C6}">
      <dsp:nvSpPr>
        <dsp:cNvPr id="0" name=""/>
        <dsp:cNvSpPr/>
      </dsp:nvSpPr>
      <dsp:spPr>
        <a:xfrm>
          <a:off x="4671290" y="3248375"/>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Manage the research</a:t>
          </a:r>
        </a:p>
      </dsp:txBody>
      <dsp:txXfrm>
        <a:off x="4698823" y="3275908"/>
        <a:ext cx="812651" cy="508950"/>
      </dsp:txXfrm>
    </dsp:sp>
    <dsp:sp modelId="{454A1872-84E1-A440-9E23-9BA8B373C188}">
      <dsp:nvSpPr>
        <dsp:cNvPr id="0" name=""/>
        <dsp:cNvSpPr/>
      </dsp:nvSpPr>
      <dsp:spPr>
        <a:xfrm>
          <a:off x="1067060" y="284376"/>
          <a:ext cx="4328010" cy="4328010"/>
        </a:xfrm>
        <a:custGeom>
          <a:avLst/>
          <a:gdLst/>
          <a:ahLst/>
          <a:cxnLst/>
          <a:rect l="0" t="0" r="0" b="0"/>
          <a:pathLst>
            <a:path>
              <a:moveTo>
                <a:pt x="3755056" y="3630795"/>
              </a:moveTo>
              <a:arcTo wR="2164005" hR="2164005" stAng="2560378" swAng="652381"/>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2EAB5438-31E8-064A-A4B0-3F2DE2B6D4E6}">
      <dsp:nvSpPr>
        <dsp:cNvPr id="0" name=""/>
        <dsp:cNvSpPr/>
      </dsp:nvSpPr>
      <dsp:spPr>
        <a:xfrm>
          <a:off x="3537340" y="4199873"/>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Conduct the research</a:t>
          </a:r>
        </a:p>
      </dsp:txBody>
      <dsp:txXfrm>
        <a:off x="3564873" y="4227406"/>
        <a:ext cx="812651" cy="508950"/>
      </dsp:txXfrm>
    </dsp:sp>
    <dsp:sp modelId="{592DEB87-05BA-314E-9E5D-A0994FBB9BE7}">
      <dsp:nvSpPr>
        <dsp:cNvPr id="0" name=""/>
        <dsp:cNvSpPr/>
      </dsp:nvSpPr>
      <dsp:spPr>
        <a:xfrm>
          <a:off x="1067060" y="284376"/>
          <a:ext cx="4328010" cy="4328010"/>
        </a:xfrm>
        <a:custGeom>
          <a:avLst/>
          <a:gdLst/>
          <a:ahLst/>
          <a:cxnLst/>
          <a:rect l="0" t="0" r="0" b="0"/>
          <a:pathLst>
            <a:path>
              <a:moveTo>
                <a:pt x="2348577" y="4320124"/>
              </a:moveTo>
              <a:arcTo wR="2164005" hR="2164005" stAng="5106432" swAng="587137"/>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B61B4333-12E9-EA4E-96BE-541075F519B1}">
      <dsp:nvSpPr>
        <dsp:cNvPr id="0" name=""/>
        <dsp:cNvSpPr/>
      </dsp:nvSpPr>
      <dsp:spPr>
        <a:xfrm>
          <a:off x="2057073" y="4199873"/>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Analyse and interpret findings</a:t>
          </a:r>
        </a:p>
      </dsp:txBody>
      <dsp:txXfrm>
        <a:off x="2084606" y="4227406"/>
        <a:ext cx="812651" cy="508950"/>
      </dsp:txXfrm>
    </dsp:sp>
    <dsp:sp modelId="{1DCD3E9D-C78C-A144-B7E8-BE98F083AEB6}">
      <dsp:nvSpPr>
        <dsp:cNvPr id="0" name=""/>
        <dsp:cNvSpPr/>
      </dsp:nvSpPr>
      <dsp:spPr>
        <a:xfrm>
          <a:off x="1067060" y="284376"/>
          <a:ext cx="4328010" cy="4328010"/>
        </a:xfrm>
        <a:custGeom>
          <a:avLst/>
          <a:gdLst/>
          <a:ahLst/>
          <a:cxnLst/>
          <a:rect l="0" t="0" r="0" b="0"/>
          <a:pathLst>
            <a:path>
              <a:moveTo>
                <a:pt x="878202" y="3904588"/>
              </a:moveTo>
              <a:arcTo wR="2164005" hR="2164005" stAng="7587240" swAng="652381"/>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18BCA952-D167-F945-8867-AD4C9D2398AB}">
      <dsp:nvSpPr>
        <dsp:cNvPr id="0" name=""/>
        <dsp:cNvSpPr/>
      </dsp:nvSpPr>
      <dsp:spPr>
        <a:xfrm>
          <a:off x="923123" y="3248375"/>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Disseminate</a:t>
          </a:r>
        </a:p>
      </dsp:txBody>
      <dsp:txXfrm>
        <a:off x="950656" y="3275908"/>
        <a:ext cx="812651" cy="508950"/>
      </dsp:txXfrm>
    </dsp:sp>
    <dsp:sp modelId="{B9ABB65A-E4F9-2446-9DC0-16FA01C2810E}">
      <dsp:nvSpPr>
        <dsp:cNvPr id="0" name=""/>
        <dsp:cNvSpPr/>
      </dsp:nvSpPr>
      <dsp:spPr>
        <a:xfrm>
          <a:off x="1067060" y="284376"/>
          <a:ext cx="4328010" cy="4328010"/>
        </a:xfrm>
        <a:custGeom>
          <a:avLst/>
          <a:gdLst/>
          <a:ahLst/>
          <a:cxnLst/>
          <a:rect l="0" t="0" r="0" b="0"/>
          <a:pathLst>
            <a:path>
              <a:moveTo>
                <a:pt x="93411" y="2792939"/>
              </a:moveTo>
              <a:arcTo wR="2164005" hR="2164005" stAng="9786244" swAng="874757"/>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BBB9B9B7-392F-044F-9D6F-255404CF4C1D}">
      <dsp:nvSpPr>
        <dsp:cNvPr id="0" name=""/>
        <dsp:cNvSpPr/>
      </dsp:nvSpPr>
      <dsp:spPr>
        <a:xfrm>
          <a:off x="666077" y="1790597"/>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solidFill>
                <a:schemeClr val="bg1"/>
              </a:solidFill>
            </a:rPr>
            <a:t>Evaluate</a:t>
          </a:r>
        </a:p>
      </dsp:txBody>
      <dsp:txXfrm>
        <a:off x="693610" y="1818130"/>
        <a:ext cx="812651" cy="508950"/>
      </dsp:txXfrm>
    </dsp:sp>
    <dsp:sp modelId="{24E638AC-505A-804E-9219-145CB4495339}">
      <dsp:nvSpPr>
        <dsp:cNvPr id="0" name=""/>
        <dsp:cNvSpPr/>
      </dsp:nvSpPr>
      <dsp:spPr>
        <a:xfrm>
          <a:off x="1067060" y="284376"/>
          <a:ext cx="4328010" cy="4328010"/>
        </a:xfrm>
        <a:custGeom>
          <a:avLst/>
          <a:gdLst/>
          <a:ahLst/>
          <a:cxnLst/>
          <a:rect l="0" t="0" r="0" b="0"/>
          <a:pathLst>
            <a:path>
              <a:moveTo>
                <a:pt x="157933" y="1352465"/>
              </a:moveTo>
              <a:arcTo wR="2164005" hR="2164005" stAng="12121523" swAng="787146"/>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99EB3913-8B6E-E34E-9628-DAC25591E971}">
      <dsp:nvSpPr>
        <dsp:cNvPr id="0" name=""/>
        <dsp:cNvSpPr/>
      </dsp:nvSpPr>
      <dsp:spPr>
        <a:xfrm>
          <a:off x="1406211" y="508649"/>
          <a:ext cx="867717" cy="564016"/>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ctr" defTabSz="488950">
            <a:lnSpc>
              <a:spcPct val="90000"/>
            </a:lnSpc>
            <a:spcBef>
              <a:spcPct val="0"/>
            </a:spcBef>
            <a:spcAft>
              <a:spcPct val="35000"/>
            </a:spcAft>
            <a:buNone/>
          </a:pPr>
          <a:r>
            <a:rPr lang="en-GB" sz="1100" kern="1200" dirty="0"/>
            <a:t>Act on findings</a:t>
          </a:r>
        </a:p>
      </dsp:txBody>
      <dsp:txXfrm>
        <a:off x="1433744" y="536182"/>
        <a:ext cx="812651" cy="508950"/>
      </dsp:txXfrm>
    </dsp:sp>
    <dsp:sp modelId="{D8F8ADA8-351A-B544-A873-AEA3C0755809}">
      <dsp:nvSpPr>
        <dsp:cNvPr id="0" name=""/>
        <dsp:cNvSpPr/>
      </dsp:nvSpPr>
      <dsp:spPr>
        <a:xfrm>
          <a:off x="1067060" y="284376"/>
          <a:ext cx="4328010" cy="4328010"/>
        </a:xfrm>
        <a:custGeom>
          <a:avLst/>
          <a:gdLst/>
          <a:ahLst/>
          <a:cxnLst/>
          <a:rect l="0" t="0" r="0" b="0"/>
          <a:pathLst>
            <a:path>
              <a:moveTo>
                <a:pt x="1305473" y="177591"/>
              </a:moveTo>
              <a:arcTo wR="2164005" hR="2164005" stAng="14797554" swAng="531995"/>
            </a:path>
          </a:pathLst>
        </a:custGeom>
        <a:noFill/>
        <a:ln w="9525"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Tree>
</dsp:drawing>
</file>

<file path=ppt/diagrams/layout1.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cycle5">
  <dgm:title val=""/>
  <dgm:desc val=""/>
  <dgm:catLst>
    <dgm:cat type="cycle" pri="3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hoose name="Name9">
      <dgm:if name="Name10" func="var" arg="dir" op="equ" val="norm">
        <dgm:constrLst>
          <dgm:constr type="w" for="ch" forName="node" refType="w"/>
          <dgm:constr type="w" for="ch" ptType="sibTrans" refType="w" refFor="ch" refForName="node" op="equ" fact="0.3"/>
          <dgm:constr type="diam" for="ch" ptType="sibTrans" refType="diam" op="equ"/>
          <dgm:constr type="sibSp" refType="w" refFor="ch" refForName="node" op="equ" fact="0.15"/>
          <dgm:constr type="w" for="ch" forName="spNode" refType="sibSp" fact="1.6"/>
          <dgm:constr type="primFontSz" for="ch" forName="node" op="equ" val="65"/>
        </dgm:constrLst>
      </dgm:if>
      <dgm:else name="Name11">
        <dgm:constrLst>
          <dgm:constr type="w" for="ch" forName="node" refType="w"/>
          <dgm:constr type="w" for="ch" ptType="sibTrans" refType="w" refFor="ch" refForName="node" op="equ" fact="0.3"/>
          <dgm:constr type="diam" for="ch" ptType="sibTrans" refType="diam" fact="-1"/>
          <dgm:constr type="diam" for="ch" refType="diam" op="equ" fact="-1"/>
          <dgm:constr type="sibSp" refType="w" refFor="ch" refForName="node" op="equ" fact="0.15"/>
          <dgm:constr type="w" for="ch" forName="spNode" refType="sibSp" fact="1.6"/>
          <dgm:constr type="primFontSz" for="ch" forName="node" op="equ" val="65"/>
        </dgm:constrLst>
      </dgm:else>
    </dgm:choose>
    <dgm:ruleLst/>
    <dgm:forEach name="Name12" axis="ch" ptType="node">
      <dgm:layoutNode name="node">
        <dgm:varLst>
          <dgm:bulletEnabled val="1"/>
        </dgm:varLst>
        <dgm:alg type="tx"/>
        <dgm:shape xmlns:r="http://schemas.openxmlformats.org/officeDocument/2006/relationships" type="roundRect" r:blip="">
          <dgm:adjLst/>
        </dgm:shape>
        <dgm:presOf axis="desOrSelf" ptType="node"/>
        <dgm:constrLst>
          <dgm:constr type="h" refType="w" fact="0.6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3">
        <dgm:if name="Name14" axis="par ch" ptType="doc node" func="cnt" op="gt" val="1">
          <dgm:layoutNode name="spNode">
            <dgm:alg type="sp"/>
            <dgm:shape xmlns:r="http://schemas.openxmlformats.org/officeDocument/2006/relationships" r:blip="">
              <dgm:adjLst/>
            </dgm:shape>
            <dgm:presOf/>
            <dgm:constrLst>
              <dgm:constr type="h" refType="w"/>
            </dgm:constrLst>
            <dgm:ruleLst/>
          </dgm:layoutNode>
          <dgm:forEach name="Name15" axis="followSib" ptType="sibTrans" hideLastTrans="0" cnt="1">
            <dgm:layoutNode name="sibTrans">
              <dgm:alg type="conn">
                <dgm:param type="dim" val="1D"/>
                <dgm:param type="connRout" val="curve"/>
                <dgm:param type="begPts" val="radial"/>
                <dgm:param type="endPts" val="radial"/>
              </dgm:alg>
              <dgm:shape xmlns:r="http://schemas.openxmlformats.org/officeDocument/2006/relationships" type="conn" r:blip="">
                <dgm:adjLst/>
              </dgm:shape>
              <dgm:presOf axis="self"/>
              <dgm:constrLst>
                <dgm:constr type="h" refType="w" fact="0.65"/>
                <dgm:constr type="connDist"/>
                <dgm:constr type="begPad" refType="connDist" fact="0.2"/>
                <dgm:constr type="endPad" refType="connDist" fact="0.2"/>
              </dgm:constrLst>
              <dgm:ruleLst/>
            </dgm:layoutNode>
          </dgm:forEach>
        </dgm:if>
        <dgm:else name="Name16"/>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cycle5">
  <dgm:title val=""/>
  <dgm:desc val=""/>
  <dgm:catLst>
    <dgm:cat type="cycle" pri="3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hoose name="Name9">
      <dgm:if name="Name10" func="var" arg="dir" op="equ" val="norm">
        <dgm:constrLst>
          <dgm:constr type="w" for="ch" forName="node" refType="w"/>
          <dgm:constr type="w" for="ch" ptType="sibTrans" refType="w" refFor="ch" refForName="node" op="equ" fact="0.3"/>
          <dgm:constr type="diam" for="ch" ptType="sibTrans" refType="diam" op="equ"/>
          <dgm:constr type="sibSp" refType="w" refFor="ch" refForName="node" op="equ" fact="0.15"/>
          <dgm:constr type="w" for="ch" forName="spNode" refType="sibSp" fact="1.6"/>
          <dgm:constr type="primFontSz" for="ch" forName="node" op="equ" val="65"/>
        </dgm:constrLst>
      </dgm:if>
      <dgm:else name="Name11">
        <dgm:constrLst>
          <dgm:constr type="w" for="ch" forName="node" refType="w"/>
          <dgm:constr type="w" for="ch" ptType="sibTrans" refType="w" refFor="ch" refForName="node" op="equ" fact="0.3"/>
          <dgm:constr type="diam" for="ch" ptType="sibTrans" refType="diam" fact="-1"/>
          <dgm:constr type="diam" for="ch" refType="diam" op="equ" fact="-1"/>
          <dgm:constr type="sibSp" refType="w" refFor="ch" refForName="node" op="equ" fact="0.15"/>
          <dgm:constr type="w" for="ch" forName="spNode" refType="sibSp" fact="1.6"/>
          <dgm:constr type="primFontSz" for="ch" forName="node" op="equ" val="65"/>
        </dgm:constrLst>
      </dgm:else>
    </dgm:choose>
    <dgm:ruleLst/>
    <dgm:forEach name="Name12" axis="ch" ptType="node">
      <dgm:layoutNode name="node">
        <dgm:varLst>
          <dgm:bulletEnabled val="1"/>
        </dgm:varLst>
        <dgm:alg type="tx"/>
        <dgm:shape xmlns:r="http://schemas.openxmlformats.org/officeDocument/2006/relationships" type="roundRect" r:blip="">
          <dgm:adjLst/>
        </dgm:shape>
        <dgm:presOf axis="desOrSelf" ptType="node"/>
        <dgm:constrLst>
          <dgm:constr type="h" refType="w" fact="0.6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3">
        <dgm:if name="Name14" axis="par ch" ptType="doc node" func="cnt" op="gt" val="1">
          <dgm:layoutNode name="spNode">
            <dgm:alg type="sp"/>
            <dgm:shape xmlns:r="http://schemas.openxmlformats.org/officeDocument/2006/relationships" r:blip="">
              <dgm:adjLst/>
            </dgm:shape>
            <dgm:presOf/>
            <dgm:constrLst>
              <dgm:constr type="h" refType="w"/>
            </dgm:constrLst>
            <dgm:ruleLst/>
          </dgm:layoutNode>
          <dgm:forEach name="Name15" axis="followSib" ptType="sibTrans" hideLastTrans="0" cnt="1">
            <dgm:layoutNode name="sibTrans">
              <dgm:alg type="conn">
                <dgm:param type="dim" val="1D"/>
                <dgm:param type="connRout" val="curve"/>
                <dgm:param type="begPts" val="radial"/>
                <dgm:param type="endPts" val="radial"/>
              </dgm:alg>
              <dgm:shape xmlns:r="http://schemas.openxmlformats.org/officeDocument/2006/relationships" type="conn" r:blip="">
                <dgm:adjLst/>
              </dgm:shape>
              <dgm:presOf axis="self"/>
              <dgm:constrLst>
                <dgm:constr type="h" refType="w" fact="0.65"/>
                <dgm:constr type="connDist"/>
                <dgm:constr type="begPad" refType="connDist" fact="0.2"/>
                <dgm:constr type="endPad" refType="connDist" fact="0.2"/>
              </dgm:constrLst>
              <dgm:ruleLst/>
            </dgm:layoutNode>
          </dgm:forEach>
        </dgm:if>
        <dgm:else name="Name16"/>
      </dgm:choose>
    </dgm:forEach>
  </dgm:layoutNode>
</dgm:layoutDef>
</file>

<file path=ppt/diagrams/layout4.xml><?xml version="1.0" encoding="utf-8"?>
<dgm:layoutDef xmlns:dgm="http://schemas.openxmlformats.org/drawingml/2006/diagram" xmlns:a="http://schemas.openxmlformats.org/drawingml/2006/main" uniqueId="urn:microsoft.com/office/officeart/2005/8/layout/cycle5">
  <dgm:title val=""/>
  <dgm:desc val=""/>
  <dgm:catLst>
    <dgm:cat type="cycle" pri="3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hoose name="Name9">
      <dgm:if name="Name10" func="var" arg="dir" op="equ" val="norm">
        <dgm:constrLst>
          <dgm:constr type="w" for="ch" forName="node" refType="w"/>
          <dgm:constr type="w" for="ch" ptType="sibTrans" refType="w" refFor="ch" refForName="node" op="equ" fact="0.3"/>
          <dgm:constr type="diam" for="ch" ptType="sibTrans" refType="diam" op="equ"/>
          <dgm:constr type="sibSp" refType="w" refFor="ch" refForName="node" op="equ" fact="0.15"/>
          <dgm:constr type="w" for="ch" forName="spNode" refType="sibSp" fact="1.6"/>
          <dgm:constr type="primFontSz" for="ch" forName="node" op="equ" val="65"/>
        </dgm:constrLst>
      </dgm:if>
      <dgm:else name="Name11">
        <dgm:constrLst>
          <dgm:constr type="w" for="ch" forName="node" refType="w"/>
          <dgm:constr type="w" for="ch" ptType="sibTrans" refType="w" refFor="ch" refForName="node" op="equ" fact="0.3"/>
          <dgm:constr type="diam" for="ch" ptType="sibTrans" refType="diam" fact="-1"/>
          <dgm:constr type="diam" for="ch" refType="diam" op="equ" fact="-1"/>
          <dgm:constr type="sibSp" refType="w" refFor="ch" refForName="node" op="equ" fact="0.15"/>
          <dgm:constr type="w" for="ch" forName="spNode" refType="sibSp" fact="1.6"/>
          <dgm:constr type="primFontSz" for="ch" forName="node" op="equ" val="65"/>
        </dgm:constrLst>
      </dgm:else>
    </dgm:choose>
    <dgm:ruleLst/>
    <dgm:forEach name="Name12" axis="ch" ptType="node">
      <dgm:layoutNode name="node">
        <dgm:varLst>
          <dgm:bulletEnabled val="1"/>
        </dgm:varLst>
        <dgm:alg type="tx"/>
        <dgm:shape xmlns:r="http://schemas.openxmlformats.org/officeDocument/2006/relationships" type="roundRect" r:blip="">
          <dgm:adjLst/>
        </dgm:shape>
        <dgm:presOf axis="desOrSelf" ptType="node"/>
        <dgm:constrLst>
          <dgm:constr type="h" refType="w" fact="0.6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3">
        <dgm:if name="Name14" axis="par ch" ptType="doc node" func="cnt" op="gt" val="1">
          <dgm:layoutNode name="spNode">
            <dgm:alg type="sp"/>
            <dgm:shape xmlns:r="http://schemas.openxmlformats.org/officeDocument/2006/relationships" r:blip="">
              <dgm:adjLst/>
            </dgm:shape>
            <dgm:presOf/>
            <dgm:constrLst>
              <dgm:constr type="h" refType="w"/>
            </dgm:constrLst>
            <dgm:ruleLst/>
          </dgm:layoutNode>
          <dgm:forEach name="Name15" axis="followSib" ptType="sibTrans" hideLastTrans="0" cnt="1">
            <dgm:layoutNode name="sibTrans">
              <dgm:alg type="conn">
                <dgm:param type="dim" val="1D"/>
                <dgm:param type="connRout" val="curve"/>
                <dgm:param type="begPts" val="radial"/>
                <dgm:param type="endPts" val="radial"/>
              </dgm:alg>
              <dgm:shape xmlns:r="http://schemas.openxmlformats.org/officeDocument/2006/relationships" type="conn" r:blip="">
                <dgm:adjLst/>
              </dgm:shape>
              <dgm:presOf axis="self"/>
              <dgm:constrLst>
                <dgm:constr type="h" refType="w" fact="0.65"/>
                <dgm:constr type="connDist"/>
                <dgm:constr type="begPad" refType="connDist" fact="0.2"/>
                <dgm:constr type="endPad" refType="connDist" fact="0.2"/>
              </dgm:constrLst>
              <dgm:ruleLst/>
            </dgm:layoutNode>
          </dgm:forEach>
        </dgm:if>
        <dgm:else name="Name16"/>
      </dgm:choose>
    </dgm:forEach>
  </dgm:layoutNode>
</dgm:layoutDef>
</file>

<file path=ppt/diagrams/layout5.xml><?xml version="1.0" encoding="utf-8"?>
<dgm:layoutDef xmlns:dgm="http://schemas.openxmlformats.org/drawingml/2006/diagram" xmlns:a="http://schemas.openxmlformats.org/drawingml/2006/main" uniqueId="urn:microsoft.com/office/officeart/2005/8/layout/cycle5">
  <dgm:title val=""/>
  <dgm:desc val=""/>
  <dgm:catLst>
    <dgm:cat type="cycle" pri="3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hoose name="Name9">
      <dgm:if name="Name10" func="var" arg="dir" op="equ" val="norm">
        <dgm:constrLst>
          <dgm:constr type="w" for="ch" forName="node" refType="w"/>
          <dgm:constr type="w" for="ch" ptType="sibTrans" refType="w" refFor="ch" refForName="node" op="equ" fact="0.3"/>
          <dgm:constr type="diam" for="ch" ptType="sibTrans" refType="diam" op="equ"/>
          <dgm:constr type="sibSp" refType="w" refFor="ch" refForName="node" op="equ" fact="0.15"/>
          <dgm:constr type="w" for="ch" forName="spNode" refType="sibSp" fact="1.6"/>
          <dgm:constr type="primFontSz" for="ch" forName="node" op="equ" val="65"/>
        </dgm:constrLst>
      </dgm:if>
      <dgm:else name="Name11">
        <dgm:constrLst>
          <dgm:constr type="w" for="ch" forName="node" refType="w"/>
          <dgm:constr type="w" for="ch" ptType="sibTrans" refType="w" refFor="ch" refForName="node" op="equ" fact="0.3"/>
          <dgm:constr type="diam" for="ch" ptType="sibTrans" refType="diam" fact="-1"/>
          <dgm:constr type="diam" for="ch" refType="diam" op="equ" fact="-1"/>
          <dgm:constr type="sibSp" refType="w" refFor="ch" refForName="node" op="equ" fact="0.15"/>
          <dgm:constr type="w" for="ch" forName="spNode" refType="sibSp" fact="1.6"/>
          <dgm:constr type="primFontSz" for="ch" forName="node" op="equ" val="65"/>
        </dgm:constrLst>
      </dgm:else>
    </dgm:choose>
    <dgm:ruleLst/>
    <dgm:forEach name="Name12" axis="ch" ptType="node">
      <dgm:layoutNode name="node">
        <dgm:varLst>
          <dgm:bulletEnabled val="1"/>
        </dgm:varLst>
        <dgm:alg type="tx"/>
        <dgm:shape xmlns:r="http://schemas.openxmlformats.org/officeDocument/2006/relationships" type="roundRect" r:blip="">
          <dgm:adjLst/>
        </dgm:shape>
        <dgm:presOf axis="desOrSelf" ptType="node"/>
        <dgm:constrLst>
          <dgm:constr type="h" refType="w" fact="0.6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3">
        <dgm:if name="Name14" axis="par ch" ptType="doc node" func="cnt" op="gt" val="1">
          <dgm:layoutNode name="spNode">
            <dgm:alg type="sp"/>
            <dgm:shape xmlns:r="http://schemas.openxmlformats.org/officeDocument/2006/relationships" r:blip="">
              <dgm:adjLst/>
            </dgm:shape>
            <dgm:presOf/>
            <dgm:constrLst>
              <dgm:constr type="h" refType="w"/>
            </dgm:constrLst>
            <dgm:ruleLst/>
          </dgm:layoutNode>
          <dgm:forEach name="Name15" axis="followSib" ptType="sibTrans" hideLastTrans="0" cnt="1">
            <dgm:layoutNode name="sibTrans">
              <dgm:alg type="conn">
                <dgm:param type="dim" val="1D"/>
                <dgm:param type="connRout" val="curve"/>
                <dgm:param type="begPts" val="radial"/>
                <dgm:param type="endPts" val="radial"/>
              </dgm:alg>
              <dgm:shape xmlns:r="http://schemas.openxmlformats.org/officeDocument/2006/relationships" type="conn" r:blip="">
                <dgm:adjLst/>
              </dgm:shape>
              <dgm:presOf axis="self"/>
              <dgm:constrLst>
                <dgm:constr type="h" refType="w" fact="0.65"/>
                <dgm:constr type="connDist"/>
                <dgm:constr type="begPad" refType="connDist" fact="0.2"/>
                <dgm:constr type="endPad" refType="connDist" fact="0.2"/>
              </dgm:constrLst>
              <dgm:ruleLst/>
            </dgm:layoutNode>
          </dgm:forEach>
        </dgm:if>
        <dgm:else name="Name16"/>
      </dgm:choose>
    </dgm:forEach>
  </dgm:layoutNode>
</dgm:layoutDef>
</file>

<file path=ppt/diagrams/layout6.xml><?xml version="1.0" encoding="utf-8"?>
<dgm:layoutDef xmlns:dgm="http://schemas.openxmlformats.org/drawingml/2006/diagram" xmlns:a="http://schemas.openxmlformats.org/drawingml/2006/main" uniqueId="urn:microsoft.com/office/officeart/2005/8/layout/cycle5">
  <dgm:title val=""/>
  <dgm:desc val=""/>
  <dgm:catLst>
    <dgm:cat type="cycle" pri="3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hoose name="Name9">
      <dgm:if name="Name10" func="var" arg="dir" op="equ" val="norm">
        <dgm:constrLst>
          <dgm:constr type="w" for="ch" forName="node" refType="w"/>
          <dgm:constr type="w" for="ch" ptType="sibTrans" refType="w" refFor="ch" refForName="node" op="equ" fact="0.3"/>
          <dgm:constr type="diam" for="ch" ptType="sibTrans" refType="diam" op="equ"/>
          <dgm:constr type="sibSp" refType="w" refFor="ch" refForName="node" op="equ" fact="0.15"/>
          <dgm:constr type="w" for="ch" forName="spNode" refType="sibSp" fact="1.6"/>
          <dgm:constr type="primFontSz" for="ch" forName="node" op="equ" val="65"/>
        </dgm:constrLst>
      </dgm:if>
      <dgm:else name="Name11">
        <dgm:constrLst>
          <dgm:constr type="w" for="ch" forName="node" refType="w"/>
          <dgm:constr type="w" for="ch" ptType="sibTrans" refType="w" refFor="ch" refForName="node" op="equ" fact="0.3"/>
          <dgm:constr type="diam" for="ch" ptType="sibTrans" refType="diam" fact="-1"/>
          <dgm:constr type="diam" for="ch" refType="diam" op="equ" fact="-1"/>
          <dgm:constr type="sibSp" refType="w" refFor="ch" refForName="node" op="equ" fact="0.15"/>
          <dgm:constr type="w" for="ch" forName="spNode" refType="sibSp" fact="1.6"/>
          <dgm:constr type="primFontSz" for="ch" forName="node" op="equ" val="65"/>
        </dgm:constrLst>
      </dgm:else>
    </dgm:choose>
    <dgm:ruleLst/>
    <dgm:forEach name="Name12" axis="ch" ptType="node">
      <dgm:layoutNode name="node">
        <dgm:varLst>
          <dgm:bulletEnabled val="1"/>
        </dgm:varLst>
        <dgm:alg type="tx"/>
        <dgm:shape xmlns:r="http://schemas.openxmlformats.org/officeDocument/2006/relationships" type="roundRect" r:blip="">
          <dgm:adjLst/>
        </dgm:shape>
        <dgm:presOf axis="desOrSelf" ptType="node"/>
        <dgm:constrLst>
          <dgm:constr type="h" refType="w" fact="0.6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3">
        <dgm:if name="Name14" axis="par ch" ptType="doc node" func="cnt" op="gt" val="1">
          <dgm:layoutNode name="spNode">
            <dgm:alg type="sp"/>
            <dgm:shape xmlns:r="http://schemas.openxmlformats.org/officeDocument/2006/relationships" r:blip="">
              <dgm:adjLst/>
            </dgm:shape>
            <dgm:presOf/>
            <dgm:constrLst>
              <dgm:constr type="h" refType="w"/>
            </dgm:constrLst>
            <dgm:ruleLst/>
          </dgm:layoutNode>
          <dgm:forEach name="Name15" axis="followSib" ptType="sibTrans" hideLastTrans="0" cnt="1">
            <dgm:layoutNode name="sibTrans">
              <dgm:alg type="conn">
                <dgm:param type="dim" val="1D"/>
                <dgm:param type="connRout" val="curve"/>
                <dgm:param type="begPts" val="radial"/>
                <dgm:param type="endPts" val="radial"/>
              </dgm:alg>
              <dgm:shape xmlns:r="http://schemas.openxmlformats.org/officeDocument/2006/relationships" type="conn" r:blip="">
                <dgm:adjLst/>
              </dgm:shape>
              <dgm:presOf axis="self"/>
              <dgm:constrLst>
                <dgm:constr type="h" refType="w" fact="0.65"/>
                <dgm:constr type="connDist"/>
                <dgm:constr type="begPad" refType="connDist" fact="0.2"/>
                <dgm:constr type="endPad" refType="connDist" fact="0.2"/>
              </dgm:constrLst>
              <dgm:ruleLst/>
            </dgm:layoutNode>
          </dgm:forEach>
        </dgm:if>
        <dgm:else name="Name16"/>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ECF2D10-651A-4662-8B80-106ED0B93A1F}" type="datetimeFigureOut">
              <a:rPr lang="en-AU" smtClean="0"/>
              <a:t>14/04/2023</a:t>
            </a:fld>
            <a:endParaRPr lang="en-AU"/>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4F9460A-25CF-433D-B71D-16A281903785}" type="slidenum">
              <a:rPr lang="en-AU" smtClean="0"/>
              <a:t>‹#›</a:t>
            </a:fld>
            <a:endParaRPr lang="en-AU"/>
          </a:p>
        </p:txBody>
      </p:sp>
    </p:spTree>
    <p:extLst>
      <p:ext uri="{BB962C8B-B14F-4D97-AF65-F5344CB8AC3E}">
        <p14:creationId xmlns:p14="http://schemas.microsoft.com/office/powerpoint/2010/main" val="29587854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ing NSW – Consumer Education research course. How to use your lived experience and engage in mental health services. </a:t>
            </a:r>
          </a:p>
        </p:txBody>
      </p:sp>
      <p:sp>
        <p:nvSpPr>
          <p:cNvPr id="4" name="Slide Number Placeholder 3"/>
          <p:cNvSpPr>
            <a:spLocks noGrp="1"/>
          </p:cNvSpPr>
          <p:nvPr>
            <p:ph type="sldNum" sz="quarter" idx="5"/>
          </p:nvPr>
        </p:nvSpPr>
        <p:spPr/>
        <p:txBody>
          <a:bodyPr/>
          <a:lstStyle/>
          <a:p>
            <a:fld id="{54F9460A-25CF-433D-B71D-16A281903785}" type="slidenum">
              <a:rPr lang="en-AU" smtClean="0"/>
              <a:t>5</a:t>
            </a:fld>
            <a:endParaRPr lang="en-AU"/>
          </a:p>
        </p:txBody>
      </p:sp>
    </p:spTree>
    <p:extLst>
      <p:ext uri="{BB962C8B-B14F-4D97-AF65-F5344CB8AC3E}">
        <p14:creationId xmlns:p14="http://schemas.microsoft.com/office/powerpoint/2010/main" val="18455061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5"/>
          </p:nvPr>
        </p:nvSpPr>
        <p:spPr/>
        <p:txBody>
          <a:bodyPr/>
          <a:lstStyle/>
          <a:p>
            <a:fld id="{54F9460A-25CF-433D-B71D-16A281903785}" type="slidenum">
              <a:rPr lang="en-AU" smtClean="0"/>
              <a:t>6</a:t>
            </a:fld>
            <a:endParaRPr lang="en-AU"/>
          </a:p>
        </p:txBody>
      </p:sp>
    </p:spTree>
    <p:extLst>
      <p:ext uri="{BB962C8B-B14F-4D97-AF65-F5344CB8AC3E}">
        <p14:creationId xmlns:p14="http://schemas.microsoft.com/office/powerpoint/2010/main" val="264926433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a:p>
        </p:txBody>
      </p:sp>
      <p:sp>
        <p:nvSpPr>
          <p:cNvPr id="4" name="Slide Number Placeholder 3"/>
          <p:cNvSpPr>
            <a:spLocks noGrp="1"/>
          </p:cNvSpPr>
          <p:nvPr>
            <p:ph type="sldNum" sz="quarter" idx="5"/>
          </p:nvPr>
        </p:nvSpPr>
        <p:spPr/>
        <p:txBody>
          <a:bodyPr/>
          <a:lstStyle/>
          <a:p>
            <a:fld id="{54F9460A-25CF-433D-B71D-16A281903785}" type="slidenum">
              <a:rPr lang="en-AU" smtClean="0"/>
              <a:t>7</a:t>
            </a:fld>
            <a:endParaRPr lang="en-AU"/>
          </a:p>
        </p:txBody>
      </p:sp>
    </p:spTree>
    <p:extLst>
      <p:ext uri="{BB962C8B-B14F-4D97-AF65-F5344CB8AC3E}">
        <p14:creationId xmlns:p14="http://schemas.microsoft.com/office/powerpoint/2010/main" val="370196701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4F9460A-25CF-433D-B71D-16A281903785}" type="slidenum">
              <a:rPr lang="en-AU" smtClean="0"/>
              <a:t>9</a:t>
            </a:fld>
            <a:endParaRPr lang="en-AU"/>
          </a:p>
        </p:txBody>
      </p:sp>
    </p:spTree>
    <p:extLst>
      <p:ext uri="{BB962C8B-B14F-4D97-AF65-F5344CB8AC3E}">
        <p14:creationId xmlns:p14="http://schemas.microsoft.com/office/powerpoint/2010/main" val="429392180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4F9460A-25CF-433D-B71D-16A281903785}" type="slidenum">
              <a:rPr lang="en-AU" smtClean="0"/>
              <a:t>10</a:t>
            </a:fld>
            <a:endParaRPr lang="en-AU"/>
          </a:p>
        </p:txBody>
      </p:sp>
    </p:spTree>
    <p:extLst>
      <p:ext uri="{BB962C8B-B14F-4D97-AF65-F5344CB8AC3E}">
        <p14:creationId xmlns:p14="http://schemas.microsoft.com/office/powerpoint/2010/main" val="2311413803"/>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3" Type="http://schemas.openxmlformats.org/officeDocument/2006/relationships/image" Target="../media/image18.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image" Target="../media/image19.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image" Target="../media/image19.jpeg"/><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image" Target="../media/image19.jpeg"/><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1.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Master" Target="../slideMasters/slideMaster1.xml"/></Relationships>
</file>

<file path=ppt/slideLayouts/_rels/slideLayout32.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Master" Target="../slideMasters/slideMaster1.xml"/></Relationships>
</file>

<file path=ppt/slideLayouts/_rels/slideLayout33.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Master" Target="../slideMasters/slideMaster1.xml"/></Relationships>
</file>

<file path=ppt/slideLayouts/_rels/slideLayout34.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Master" Target="../slideMasters/slideMaster1.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7.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Master" Target="../slideMasters/slideMaster2.xml"/></Relationships>
</file>

<file path=ppt/slideLayouts/_rels/slideLayout38.xml.rels><?xml version="1.0" encoding="UTF-8" standalone="yes"?>
<Relationships xmlns="http://schemas.openxmlformats.org/package/2006/relationships"><Relationship Id="rId3" Type="http://schemas.openxmlformats.org/officeDocument/2006/relationships/image" Target="../media/image26.jpeg"/><Relationship Id="rId2" Type="http://schemas.openxmlformats.org/officeDocument/2006/relationships/image" Target="../media/image25.jpeg"/><Relationship Id="rId1" Type="http://schemas.openxmlformats.org/officeDocument/2006/relationships/slideMaster" Target="../slideMasters/slideMaster2.xml"/><Relationship Id="rId5" Type="http://schemas.openxmlformats.org/officeDocument/2006/relationships/image" Target="../media/image24.emf"/><Relationship Id="rId4" Type="http://schemas.openxmlformats.org/officeDocument/2006/relationships/image" Target="../media/image27.jpeg"/></Relationships>
</file>

<file path=ppt/slideLayouts/_rels/slideLayout39.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28.jpeg"/><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29.jpeg"/><Relationship Id="rId1" Type="http://schemas.openxmlformats.org/officeDocument/2006/relationships/slideMaster" Target="../slideMasters/slideMaster2.xml"/></Relationships>
</file>

<file path=ppt/slideLayouts/_rels/slideLayout41.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30.jpeg"/><Relationship Id="rId1" Type="http://schemas.openxmlformats.org/officeDocument/2006/relationships/slideMaster" Target="../slideMasters/slideMaster2.xml"/></Relationships>
</file>

<file path=ppt/slideLayouts/_rels/slideLayout42.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Master" Target="../slideMasters/slideMaster2.xml"/></Relationships>
</file>

<file path=ppt/slideLayouts/_rels/slideLayout43.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Master" Target="../slideMasters/slideMaster2.xml"/></Relationships>
</file>

<file path=ppt/slideLayouts/_rels/slideLayout44.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31.jpeg"/><Relationship Id="rId1" Type="http://schemas.openxmlformats.org/officeDocument/2006/relationships/slideMaster" Target="../slideMasters/slideMaster2.xml"/></Relationships>
</file>

<file path=ppt/slideLayouts/_rels/slideLayout45.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32.jpeg"/><Relationship Id="rId1" Type="http://schemas.openxmlformats.org/officeDocument/2006/relationships/slideMaster" Target="../slideMasters/slideMaster2.xml"/></Relationships>
</file>

<file path=ppt/slideLayouts/_rels/slideLayout46.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33.jpeg"/><Relationship Id="rId1" Type="http://schemas.openxmlformats.org/officeDocument/2006/relationships/slideMaster" Target="../slideMasters/slideMaster2.xml"/></Relationships>
</file>

<file path=ppt/slideLayouts/_rels/slideLayout47.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Master" Target="../slideMasters/slideMaster2.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6.xml.rels><?xml version="1.0" encoding="UTF-8" standalone="yes"?>
<Relationships xmlns="http://schemas.openxmlformats.org/package/2006/relationships"><Relationship Id="rId2" Type="http://schemas.openxmlformats.org/officeDocument/2006/relationships/image" Target="../media/image34.png"/><Relationship Id="rId1" Type="http://schemas.openxmlformats.org/officeDocument/2006/relationships/slideMaster" Target="../slideMasters/slideMaster2.xml"/></Relationships>
</file>

<file path=ppt/slideLayouts/_rels/slideLayout57.xml.rels><?xml version="1.0" encoding="UTF-8" standalone="yes"?>
<Relationships xmlns="http://schemas.openxmlformats.org/package/2006/relationships"><Relationship Id="rId2" Type="http://schemas.openxmlformats.org/officeDocument/2006/relationships/image" Target="../media/image35.emf"/><Relationship Id="rId1" Type="http://schemas.openxmlformats.org/officeDocument/2006/relationships/slideMaster" Target="../slideMasters/slideMaster2.xml"/></Relationships>
</file>

<file path=ppt/slideLayouts/_rels/slideLayout58.xml.rels><?xml version="1.0" encoding="UTF-8" standalone="yes"?>
<Relationships xmlns="http://schemas.openxmlformats.org/package/2006/relationships"><Relationship Id="rId2" Type="http://schemas.openxmlformats.org/officeDocument/2006/relationships/image" Target="../media/image35.emf"/><Relationship Id="rId1" Type="http://schemas.openxmlformats.org/officeDocument/2006/relationships/slideMaster" Target="../slideMasters/slideMaster2.xml"/></Relationships>
</file>

<file path=ppt/slideLayouts/_rels/slideLayout59.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 Red option 1 (add own image)">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82AB734E-09E2-4C5B-B359-F44C155BFDAF}"/>
              </a:ext>
            </a:extLst>
          </p:cNvPr>
          <p:cNvSpPr/>
          <p:nvPr userDrawn="1"/>
        </p:nvSpPr>
        <p:spPr>
          <a:xfrm>
            <a:off x="0"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sp>
        <p:nvSpPr>
          <p:cNvPr id="14" name="Picture Placeholder 13"/>
          <p:cNvSpPr>
            <a:spLocks noGrp="1"/>
          </p:cNvSpPr>
          <p:nvPr>
            <p:ph type="pic" sz="quarter" idx="12"/>
          </p:nvPr>
        </p:nvSpPr>
        <p:spPr>
          <a:xfrm>
            <a:off x="4587878" y="0"/>
            <a:ext cx="4556125" cy="6858000"/>
          </a:xfrm>
          <a:prstGeom prst="rect">
            <a:avLst/>
          </a:prstGeom>
          <a:solidFill>
            <a:schemeClr val="bg1">
              <a:lumMod val="85000"/>
            </a:schemeClr>
          </a:solidFill>
        </p:spPr>
        <p:txBody>
          <a:bodyPr anchor="ctr" anchorCtr="0"/>
          <a:lstStyle>
            <a:lvl1pPr marL="0" indent="0" algn="ctr">
              <a:buNone/>
              <a:defRPr/>
            </a:lvl1pPr>
          </a:lstStyle>
          <a:p>
            <a:pPr lvl="0"/>
            <a:r>
              <a:rPr lang="en-US" noProof="0"/>
              <a:t>Click icon to add picture</a:t>
            </a:r>
          </a:p>
        </p:txBody>
      </p:sp>
      <p:sp>
        <p:nvSpPr>
          <p:cNvPr id="7" name="Title 8"/>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8" name="Text Placeholder 4"/>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pic>
        <p:nvPicPr>
          <p:cNvPr id="15" name="Picture 14" descr="A close up of a logo&#10;&#10;Description automatically generated">
            <a:extLst>
              <a:ext uri="{FF2B5EF4-FFF2-40B4-BE49-F238E27FC236}">
                <a16:creationId xmlns:a16="http://schemas.microsoft.com/office/drawing/2014/main" id="{FA42B4BB-E4AF-4E77-8720-34E6A0B4EC17}"/>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spTree>
    <p:extLst>
      <p:ext uri="{BB962C8B-B14F-4D97-AF65-F5344CB8AC3E}">
        <p14:creationId xmlns:p14="http://schemas.microsoft.com/office/powerpoint/2010/main" val="9481918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1_Title slide – Red option 4">
    <p:spTree>
      <p:nvGrpSpPr>
        <p:cNvPr id="1" name=""/>
        <p:cNvGrpSpPr/>
        <p:nvPr/>
      </p:nvGrpSpPr>
      <p:grpSpPr>
        <a:xfrm>
          <a:off x="0" y="0"/>
          <a:ext cx="0" cy="0"/>
          <a:chOff x="0" y="0"/>
          <a:chExt cx="0" cy="0"/>
        </a:xfrm>
      </p:grpSpPr>
      <p:pic>
        <p:nvPicPr>
          <p:cNvPr id="11" name="Picture 10" descr="A close up of a logo&#10;&#10;Description automatically generated">
            <a:extLst>
              <a:ext uri="{FF2B5EF4-FFF2-40B4-BE49-F238E27FC236}">
                <a16:creationId xmlns:a16="http://schemas.microsoft.com/office/drawing/2014/main" id="{01474F3C-BF30-4838-BE7E-29B6762A0306}"/>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9" name="Picture 8" descr="A picture containing wooden, indoor, building, floor&#10;&#10;Description automatically generated">
            <a:extLst>
              <a:ext uri="{FF2B5EF4-FFF2-40B4-BE49-F238E27FC236}">
                <a16:creationId xmlns:a16="http://schemas.microsoft.com/office/drawing/2014/main" id="{027F469D-BD18-954A-9A1A-8F1D6A382843}"/>
              </a:ext>
            </a:extLst>
          </p:cNvPr>
          <p:cNvPicPr>
            <a:picLocks noChangeAspect="1"/>
          </p:cNvPicPr>
          <p:nvPr userDrawn="1"/>
        </p:nvPicPr>
        <p:blipFill>
          <a:blip r:embed="rId3" cstate="email">
            <a:extLst>
              <a:ext uri="{28A0092B-C50C-407E-A947-70E740481C1C}">
                <a14:useLocalDpi xmlns:a14="http://schemas.microsoft.com/office/drawing/2010/main"/>
              </a:ext>
            </a:extLst>
          </a:blip>
          <a:stretch>
            <a:fillRect/>
          </a:stretch>
        </p:blipFill>
        <p:spPr>
          <a:xfrm>
            <a:off x="4572328" y="0"/>
            <a:ext cx="4575572" cy="6858000"/>
          </a:xfrm>
          <a:prstGeom prst="rect">
            <a:avLst/>
          </a:prstGeom>
        </p:spPr>
      </p:pic>
      <p:sp>
        <p:nvSpPr>
          <p:cNvPr id="7" name="Title 8">
            <a:extLst>
              <a:ext uri="{FF2B5EF4-FFF2-40B4-BE49-F238E27FC236}">
                <a16:creationId xmlns:a16="http://schemas.microsoft.com/office/drawing/2014/main" id="{F7F5BF2A-AC4A-1A42-AAE5-EFA621B57D2A}"/>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10" name="Text Placeholder 4">
            <a:extLst>
              <a:ext uri="{FF2B5EF4-FFF2-40B4-BE49-F238E27FC236}">
                <a16:creationId xmlns:a16="http://schemas.microsoft.com/office/drawing/2014/main" id="{1F02D92F-5115-844C-A4E9-2F6FDB1AFB5F}"/>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0071719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2_Title slide – Red option 4">
    <p:spTree>
      <p:nvGrpSpPr>
        <p:cNvPr id="1" name=""/>
        <p:cNvGrpSpPr/>
        <p:nvPr/>
      </p:nvGrpSpPr>
      <p:grpSpPr>
        <a:xfrm>
          <a:off x="0" y="0"/>
          <a:ext cx="0" cy="0"/>
          <a:chOff x="0" y="0"/>
          <a:chExt cx="0" cy="0"/>
        </a:xfrm>
      </p:grpSpPr>
      <p:pic>
        <p:nvPicPr>
          <p:cNvPr id="10" name="Picture 9" descr="A close up of a logo&#10;&#10;Description automatically generated">
            <a:extLst>
              <a:ext uri="{FF2B5EF4-FFF2-40B4-BE49-F238E27FC236}">
                <a16:creationId xmlns:a16="http://schemas.microsoft.com/office/drawing/2014/main" id="{B27217AD-F199-408C-87CD-6B9EAF72773E}"/>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9" name="Picture 8" descr="A close up of a device&#10;&#10;Description automatically generated">
            <a:extLst>
              <a:ext uri="{FF2B5EF4-FFF2-40B4-BE49-F238E27FC236}">
                <a16:creationId xmlns:a16="http://schemas.microsoft.com/office/drawing/2014/main" id="{D66EB99F-F155-5343-A51B-12DBD3DF7BF8}"/>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567772" y="2"/>
            <a:ext cx="4576227" cy="6875645"/>
          </a:xfrm>
          <a:prstGeom prst="rect">
            <a:avLst/>
          </a:prstGeom>
        </p:spPr>
      </p:pic>
      <p:sp>
        <p:nvSpPr>
          <p:cNvPr id="7" name="Title 8">
            <a:extLst>
              <a:ext uri="{FF2B5EF4-FFF2-40B4-BE49-F238E27FC236}">
                <a16:creationId xmlns:a16="http://schemas.microsoft.com/office/drawing/2014/main" id="{203B2E81-0B17-C14D-871B-CFD7397D6032}"/>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11" name="Text Placeholder 4">
            <a:extLst>
              <a:ext uri="{FF2B5EF4-FFF2-40B4-BE49-F238E27FC236}">
                <a16:creationId xmlns:a16="http://schemas.microsoft.com/office/drawing/2014/main" id="{ACABB86B-1F70-C340-B833-D9E64690EDEC}"/>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153696479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itle slide – Red option 5 (no image)">
    <p:spTree>
      <p:nvGrpSpPr>
        <p:cNvPr id="1" name=""/>
        <p:cNvGrpSpPr/>
        <p:nvPr/>
      </p:nvGrpSpPr>
      <p:grpSpPr>
        <a:xfrm>
          <a:off x="0" y="0"/>
          <a:ext cx="0" cy="0"/>
          <a:chOff x="0" y="0"/>
          <a:chExt cx="0" cy="0"/>
        </a:xfrm>
      </p:grpSpPr>
      <p:pic>
        <p:nvPicPr>
          <p:cNvPr id="6" name="Picture 5" descr="A close up of a logo&#10;&#10;Description automatically generated">
            <a:extLst>
              <a:ext uri="{FF2B5EF4-FFF2-40B4-BE49-F238E27FC236}">
                <a16:creationId xmlns:a16="http://schemas.microsoft.com/office/drawing/2014/main" id="{8EA2DDC0-E24B-44C0-A773-C0BEC90B3BA9}"/>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8" name="Picture 7" descr="A large brick building with many windows&#10;&#10;Description automatically generated">
            <a:extLst>
              <a:ext uri="{FF2B5EF4-FFF2-40B4-BE49-F238E27FC236}">
                <a16:creationId xmlns:a16="http://schemas.microsoft.com/office/drawing/2014/main" id="{B624EB83-3DEF-5A40-82E3-BA7BE6E83D27}"/>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567773" y="-1"/>
            <a:ext cx="4576228" cy="6855115"/>
          </a:xfrm>
          <a:prstGeom prst="rect">
            <a:avLst/>
          </a:prstGeom>
        </p:spPr>
      </p:pic>
      <p:sp>
        <p:nvSpPr>
          <p:cNvPr id="9" name="Title 8">
            <a:extLst>
              <a:ext uri="{FF2B5EF4-FFF2-40B4-BE49-F238E27FC236}">
                <a16:creationId xmlns:a16="http://schemas.microsoft.com/office/drawing/2014/main" id="{42004013-5879-D34C-BAFC-44A0C7C52987}"/>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10" name="Text Placeholder 4">
            <a:extLst>
              <a:ext uri="{FF2B5EF4-FFF2-40B4-BE49-F238E27FC236}">
                <a16:creationId xmlns:a16="http://schemas.microsoft.com/office/drawing/2014/main" id="{2A5DF2FE-20A3-FD49-A928-C8B687FFB191}"/>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65707793"/>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Title slide – White option 2">
    <p:spTree>
      <p:nvGrpSpPr>
        <p:cNvPr id="1" name=""/>
        <p:cNvGrpSpPr/>
        <p:nvPr/>
      </p:nvGrpSpPr>
      <p:grpSpPr>
        <a:xfrm>
          <a:off x="0" y="0"/>
          <a:ext cx="0" cy="0"/>
          <a:chOff x="0" y="0"/>
          <a:chExt cx="0" cy="0"/>
        </a:xfrm>
      </p:grpSpPr>
      <p:sp>
        <p:nvSpPr>
          <p:cNvPr id="5" name="Rectangle 4"/>
          <p:cNvSpPr/>
          <p:nvPr userDrawn="1"/>
        </p:nvSpPr>
        <p:spPr>
          <a:xfrm>
            <a:off x="0" y="-147667"/>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8" name="Picture 7" descr="A close up of a logo&#10;&#10;Description automatically generated">
            <a:extLst>
              <a:ext uri="{FF2B5EF4-FFF2-40B4-BE49-F238E27FC236}">
                <a16:creationId xmlns:a16="http://schemas.microsoft.com/office/drawing/2014/main" id="{401895F3-6600-4703-81D0-F9299C9F68D8}"/>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2" name="Picture 11" descr="An old stone building&#10;&#10;Description automatically generated">
            <a:extLst>
              <a:ext uri="{FF2B5EF4-FFF2-40B4-BE49-F238E27FC236}">
                <a16:creationId xmlns:a16="http://schemas.microsoft.com/office/drawing/2014/main" id="{0467D4D8-EE96-6644-B22D-704124139EC0}"/>
              </a:ext>
            </a:extLst>
          </p:cNvPr>
          <p:cNvPicPr>
            <a:picLocks noChangeAspect="1"/>
          </p:cNvPicPr>
          <p:nvPr userDrawn="1"/>
        </p:nvPicPr>
        <p:blipFill>
          <a:blip r:embed="rId3" cstate="email">
            <a:extLst>
              <a:ext uri="{28A0092B-C50C-407E-A947-70E740481C1C}">
                <a14:useLocalDpi xmlns:a14="http://schemas.microsoft.com/office/drawing/2010/main"/>
              </a:ext>
            </a:extLst>
          </a:blip>
          <a:stretch>
            <a:fillRect/>
          </a:stretch>
        </p:blipFill>
        <p:spPr>
          <a:xfrm rot="16200000">
            <a:off x="3663952" y="1422401"/>
            <a:ext cx="6019798" cy="4013199"/>
          </a:xfrm>
          <a:prstGeom prst="rect">
            <a:avLst/>
          </a:prstGeom>
        </p:spPr>
      </p:pic>
      <p:sp>
        <p:nvSpPr>
          <p:cNvPr id="13" name="Title 8">
            <a:extLst>
              <a:ext uri="{FF2B5EF4-FFF2-40B4-BE49-F238E27FC236}">
                <a16:creationId xmlns:a16="http://schemas.microsoft.com/office/drawing/2014/main" id="{EB285D19-A405-BB4C-B142-722A2913CE59}"/>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14" name="Text Placeholder 4">
            <a:extLst>
              <a:ext uri="{FF2B5EF4-FFF2-40B4-BE49-F238E27FC236}">
                <a16:creationId xmlns:a16="http://schemas.microsoft.com/office/drawing/2014/main" id="{A1214D66-D55C-D44A-B441-B18BD72691C5}"/>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39833899"/>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Title slide – White option 3">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8" name="Picture 7" descr="A close up of a logo&#10;&#10;Description automatically generated">
            <a:extLst>
              <a:ext uri="{FF2B5EF4-FFF2-40B4-BE49-F238E27FC236}">
                <a16:creationId xmlns:a16="http://schemas.microsoft.com/office/drawing/2014/main" id="{E53D6B9D-DA9F-4DBB-A832-ADED78BEACFB}"/>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2" name="Picture 11" descr="A picture containing building, indoor, wall&#10;&#10;Description automatically generated">
            <a:extLst>
              <a:ext uri="{FF2B5EF4-FFF2-40B4-BE49-F238E27FC236}">
                <a16:creationId xmlns:a16="http://schemas.microsoft.com/office/drawing/2014/main" id="{FCCF841B-1E42-464B-9D7C-BCA3A89AB412}"/>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625030" y="358212"/>
            <a:ext cx="4055421" cy="6077514"/>
          </a:xfrm>
          <a:prstGeom prst="rect">
            <a:avLst/>
          </a:prstGeom>
        </p:spPr>
      </p:pic>
      <p:sp>
        <p:nvSpPr>
          <p:cNvPr id="7" name="Title 8">
            <a:extLst>
              <a:ext uri="{FF2B5EF4-FFF2-40B4-BE49-F238E27FC236}">
                <a16:creationId xmlns:a16="http://schemas.microsoft.com/office/drawing/2014/main" id="{BEBC78F8-9C19-E44F-8E6E-30B20C0A5958}"/>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9" name="Text Placeholder 4">
            <a:extLst>
              <a:ext uri="{FF2B5EF4-FFF2-40B4-BE49-F238E27FC236}">
                <a16:creationId xmlns:a16="http://schemas.microsoft.com/office/drawing/2014/main" id="{AE83AE87-8A18-7C49-B572-8BE1C3E84F8C}"/>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73479772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Title slide – White option 4">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8" name="Picture 7" descr="A close up of a logo&#10;&#10;Description automatically generated">
            <a:extLst>
              <a:ext uri="{FF2B5EF4-FFF2-40B4-BE49-F238E27FC236}">
                <a16:creationId xmlns:a16="http://schemas.microsoft.com/office/drawing/2014/main" id="{A9AC8E03-D9CF-4419-A394-1206FE31243F}"/>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2" name="Picture 11" descr="A person standing in front of a building&#10;&#10;Description automatically generated">
            <a:extLst>
              <a:ext uri="{FF2B5EF4-FFF2-40B4-BE49-F238E27FC236}">
                <a16:creationId xmlns:a16="http://schemas.microsoft.com/office/drawing/2014/main" id="{42387223-0769-BE44-9811-097FA9566948}"/>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572001" y="419102"/>
            <a:ext cx="4108451" cy="6019798"/>
          </a:xfrm>
          <a:prstGeom prst="rect">
            <a:avLst/>
          </a:prstGeom>
        </p:spPr>
      </p:pic>
      <p:sp>
        <p:nvSpPr>
          <p:cNvPr id="7" name="Title 8">
            <a:extLst>
              <a:ext uri="{FF2B5EF4-FFF2-40B4-BE49-F238E27FC236}">
                <a16:creationId xmlns:a16="http://schemas.microsoft.com/office/drawing/2014/main" id="{24AED201-B440-AA40-BBED-62B7C0D4050E}"/>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9" name="Text Placeholder 4">
            <a:extLst>
              <a:ext uri="{FF2B5EF4-FFF2-40B4-BE49-F238E27FC236}">
                <a16:creationId xmlns:a16="http://schemas.microsoft.com/office/drawing/2014/main" id="{333A7848-7DA9-D245-808E-38FA212DEB0C}"/>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11870239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1_Title slide – White option 4">
    <p:spTree>
      <p:nvGrpSpPr>
        <p:cNvPr id="1" name=""/>
        <p:cNvGrpSpPr/>
        <p:nvPr/>
      </p:nvGrpSpPr>
      <p:grpSpPr>
        <a:xfrm>
          <a:off x="0" y="0"/>
          <a:ext cx="0" cy="0"/>
          <a:chOff x="0" y="0"/>
          <a:chExt cx="0" cy="0"/>
        </a:xfrm>
      </p:grpSpPr>
      <p:sp>
        <p:nvSpPr>
          <p:cNvPr id="5" name="Rectangle 4"/>
          <p:cNvSpPr/>
          <p:nvPr/>
        </p:nvSpPr>
        <p:spPr>
          <a:xfrm>
            <a:off x="0" y="159026"/>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8" name="Picture 7" descr="A close up of a logo&#10;&#10;Description automatically generated">
            <a:extLst>
              <a:ext uri="{FF2B5EF4-FFF2-40B4-BE49-F238E27FC236}">
                <a16:creationId xmlns:a16="http://schemas.microsoft.com/office/drawing/2014/main" id="{A9AC8E03-D9CF-4419-A394-1206FE31243F}"/>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4" name="Picture 13" descr="A sign on the side of a building&#10;&#10;Description automatically generated">
            <a:extLst>
              <a:ext uri="{FF2B5EF4-FFF2-40B4-BE49-F238E27FC236}">
                <a16:creationId xmlns:a16="http://schemas.microsoft.com/office/drawing/2014/main" id="{7656571C-9B67-0742-8350-6E56403548B3}"/>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571999" y="419101"/>
            <a:ext cx="4108452" cy="6019797"/>
          </a:xfrm>
          <a:prstGeom prst="rect">
            <a:avLst/>
          </a:prstGeom>
        </p:spPr>
      </p:pic>
      <p:sp>
        <p:nvSpPr>
          <p:cNvPr id="7" name="Title 8">
            <a:extLst>
              <a:ext uri="{FF2B5EF4-FFF2-40B4-BE49-F238E27FC236}">
                <a16:creationId xmlns:a16="http://schemas.microsoft.com/office/drawing/2014/main" id="{79388964-420B-BF4D-8DBF-CAFF1C3B6D02}"/>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9" name="Text Placeholder 4">
            <a:extLst>
              <a:ext uri="{FF2B5EF4-FFF2-40B4-BE49-F238E27FC236}">
                <a16:creationId xmlns:a16="http://schemas.microsoft.com/office/drawing/2014/main" id="{7B539C16-E252-7E4A-9ABE-B5367A682FD7}"/>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54855681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2_Title slide – White option 4">
    <p:spTree>
      <p:nvGrpSpPr>
        <p:cNvPr id="1" name=""/>
        <p:cNvGrpSpPr/>
        <p:nvPr/>
      </p:nvGrpSpPr>
      <p:grpSpPr>
        <a:xfrm>
          <a:off x="0" y="0"/>
          <a:ext cx="0" cy="0"/>
          <a:chOff x="0" y="0"/>
          <a:chExt cx="0" cy="0"/>
        </a:xfrm>
      </p:grpSpPr>
      <p:sp>
        <p:nvSpPr>
          <p:cNvPr id="5" name="Rectangle 4"/>
          <p:cNvSpPr/>
          <p:nvPr userDrawn="1"/>
        </p:nvSpPr>
        <p:spPr>
          <a:xfrm>
            <a:off x="0" y="159026"/>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8" name="Picture 7" descr="A close up of a logo&#10;&#10;Description automatically generated">
            <a:extLst>
              <a:ext uri="{FF2B5EF4-FFF2-40B4-BE49-F238E27FC236}">
                <a16:creationId xmlns:a16="http://schemas.microsoft.com/office/drawing/2014/main" id="{A9AC8E03-D9CF-4419-A394-1206FE31243F}"/>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9" name="Picture 8" descr="A picture containing indoor, cabinet, wall&#10;&#10;Description automatically generated">
            <a:extLst>
              <a:ext uri="{FF2B5EF4-FFF2-40B4-BE49-F238E27FC236}">
                <a16:creationId xmlns:a16="http://schemas.microsoft.com/office/drawing/2014/main" id="{7085503F-3ACD-544D-A1FE-7E9AA2FB19F5}"/>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571999" y="419101"/>
            <a:ext cx="4108453" cy="6019797"/>
          </a:xfrm>
          <a:prstGeom prst="rect">
            <a:avLst/>
          </a:prstGeom>
        </p:spPr>
      </p:pic>
      <p:sp>
        <p:nvSpPr>
          <p:cNvPr id="7" name="Title 8">
            <a:extLst>
              <a:ext uri="{FF2B5EF4-FFF2-40B4-BE49-F238E27FC236}">
                <a16:creationId xmlns:a16="http://schemas.microsoft.com/office/drawing/2014/main" id="{977CE053-748F-F94F-9BDB-26FA721980F0}"/>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12" name="Text Placeholder 4">
            <a:extLst>
              <a:ext uri="{FF2B5EF4-FFF2-40B4-BE49-F238E27FC236}">
                <a16:creationId xmlns:a16="http://schemas.microsoft.com/office/drawing/2014/main" id="{0E3B84B9-155B-1140-B4BB-62BBD0E79340}"/>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51058517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3_Title slide – White option 4">
    <p:spTree>
      <p:nvGrpSpPr>
        <p:cNvPr id="1" name=""/>
        <p:cNvGrpSpPr/>
        <p:nvPr/>
      </p:nvGrpSpPr>
      <p:grpSpPr>
        <a:xfrm>
          <a:off x="0" y="0"/>
          <a:ext cx="0" cy="0"/>
          <a:chOff x="0" y="0"/>
          <a:chExt cx="0" cy="0"/>
        </a:xfrm>
      </p:grpSpPr>
      <p:sp>
        <p:nvSpPr>
          <p:cNvPr id="5" name="Rectangle 4"/>
          <p:cNvSpPr/>
          <p:nvPr/>
        </p:nvSpPr>
        <p:spPr>
          <a:xfrm>
            <a:off x="0" y="159026"/>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8" name="Picture 7" descr="A close up of a logo&#10;&#10;Description automatically generated">
            <a:extLst>
              <a:ext uri="{FF2B5EF4-FFF2-40B4-BE49-F238E27FC236}">
                <a16:creationId xmlns:a16="http://schemas.microsoft.com/office/drawing/2014/main" id="{A9AC8E03-D9CF-4419-A394-1206FE31243F}"/>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2" name="Picture 11" descr="A view of a city&#10;&#10;Description automatically generated">
            <a:extLst>
              <a:ext uri="{FF2B5EF4-FFF2-40B4-BE49-F238E27FC236}">
                <a16:creationId xmlns:a16="http://schemas.microsoft.com/office/drawing/2014/main" id="{61256C31-9270-B24B-8AE2-00346517F258}"/>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l="-2285"/>
          <a:stretch/>
        </p:blipFill>
        <p:spPr>
          <a:xfrm>
            <a:off x="4467498" y="419101"/>
            <a:ext cx="4285956" cy="6279875"/>
          </a:xfrm>
          <a:prstGeom prst="rect">
            <a:avLst/>
          </a:prstGeom>
        </p:spPr>
      </p:pic>
      <p:sp>
        <p:nvSpPr>
          <p:cNvPr id="7" name="Title 8">
            <a:extLst>
              <a:ext uri="{FF2B5EF4-FFF2-40B4-BE49-F238E27FC236}">
                <a16:creationId xmlns:a16="http://schemas.microsoft.com/office/drawing/2014/main" id="{64D4D538-7063-694D-BA0B-31A19B1A6FFC}"/>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9" name="Text Placeholder 4">
            <a:extLst>
              <a:ext uri="{FF2B5EF4-FFF2-40B4-BE49-F238E27FC236}">
                <a16:creationId xmlns:a16="http://schemas.microsoft.com/office/drawing/2014/main" id="{87BBF45E-241A-8C4F-B98D-2EDF716EC7E7}"/>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33416113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Title slide – White option 1 (add own image)">
    <p:spTree>
      <p:nvGrpSpPr>
        <p:cNvPr id="1" name=""/>
        <p:cNvGrpSpPr/>
        <p:nvPr/>
      </p:nvGrpSpPr>
      <p:grpSpPr>
        <a:xfrm>
          <a:off x="0" y="0"/>
          <a:ext cx="0" cy="0"/>
          <a:chOff x="0" y="0"/>
          <a:chExt cx="0" cy="0"/>
        </a:xfrm>
      </p:grpSpPr>
      <p:sp>
        <p:nvSpPr>
          <p:cNvPr id="6" name="Rectangle 5"/>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sp>
        <p:nvSpPr>
          <p:cNvPr id="14" name="Picture Placeholder 13"/>
          <p:cNvSpPr>
            <a:spLocks noGrp="1"/>
          </p:cNvSpPr>
          <p:nvPr>
            <p:ph type="pic" sz="quarter" idx="12"/>
          </p:nvPr>
        </p:nvSpPr>
        <p:spPr>
          <a:xfrm>
            <a:off x="4587877" y="418357"/>
            <a:ext cx="4150358" cy="6017555"/>
          </a:xfrm>
          <a:prstGeom prst="rect">
            <a:avLst/>
          </a:prstGeom>
          <a:solidFill>
            <a:schemeClr val="bg1">
              <a:lumMod val="85000"/>
            </a:schemeClr>
          </a:solidFill>
          <a:ln>
            <a:noFill/>
          </a:ln>
        </p:spPr>
        <p:txBody>
          <a:bodyPr anchor="ctr" anchorCtr="0"/>
          <a:lstStyle>
            <a:lvl1pPr marL="0" indent="0" algn="ctr">
              <a:buNone/>
              <a:defRPr/>
            </a:lvl1pPr>
          </a:lstStyle>
          <a:p>
            <a:pPr lvl="0"/>
            <a:r>
              <a:rPr lang="en-US" noProof="0"/>
              <a:t>Click icon to add picture</a:t>
            </a:r>
          </a:p>
        </p:txBody>
      </p:sp>
      <p:sp>
        <p:nvSpPr>
          <p:cNvPr id="7" name="Title 8">
            <a:extLst>
              <a:ext uri="{FF2B5EF4-FFF2-40B4-BE49-F238E27FC236}">
                <a16:creationId xmlns:a16="http://schemas.microsoft.com/office/drawing/2014/main" id="{610FA0CD-08FB-2E45-8180-D86BDB467B08}"/>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11" name="Text Placeholder 4">
            <a:extLst>
              <a:ext uri="{FF2B5EF4-FFF2-40B4-BE49-F238E27FC236}">
                <a16:creationId xmlns:a16="http://schemas.microsoft.com/office/drawing/2014/main" id="{8E33F84B-9A42-504F-9E05-1436C79D277E}"/>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pic>
        <p:nvPicPr>
          <p:cNvPr id="3" name="Picture 2">
            <a:extLst>
              <a:ext uri="{FF2B5EF4-FFF2-40B4-BE49-F238E27FC236}">
                <a16:creationId xmlns:a16="http://schemas.microsoft.com/office/drawing/2014/main" id="{771FAB5E-C09E-4106-9FD7-8CC30A4EE4BA}"/>
              </a:ext>
            </a:extLst>
          </p:cNvPr>
          <p:cNvPicPr>
            <a:picLocks noChangeAspect="1"/>
          </p:cNvPicPr>
          <p:nvPr userDrawn="1"/>
        </p:nvPicPr>
        <p:blipFill>
          <a:blip r:embed="rId2"/>
          <a:stretch>
            <a:fillRect/>
          </a:stretch>
        </p:blipFill>
        <p:spPr>
          <a:xfrm>
            <a:off x="542239" y="5535867"/>
            <a:ext cx="1311500" cy="704840"/>
          </a:xfrm>
          <a:prstGeom prst="rect">
            <a:avLst/>
          </a:prstGeom>
        </p:spPr>
      </p:pic>
      <p:pic>
        <p:nvPicPr>
          <p:cNvPr id="5" name="Picture 4">
            <a:extLst>
              <a:ext uri="{FF2B5EF4-FFF2-40B4-BE49-F238E27FC236}">
                <a16:creationId xmlns:a16="http://schemas.microsoft.com/office/drawing/2014/main" id="{2F65EEB9-0552-45C3-8818-F2C34C8C0846}"/>
              </a:ext>
            </a:extLst>
          </p:cNvPr>
          <p:cNvPicPr>
            <a:picLocks noChangeAspect="1"/>
          </p:cNvPicPr>
          <p:nvPr userDrawn="1"/>
        </p:nvPicPr>
        <p:blipFill>
          <a:blip r:embed="rId3"/>
          <a:stretch>
            <a:fillRect/>
          </a:stretch>
        </p:blipFill>
        <p:spPr>
          <a:xfrm>
            <a:off x="2110857" y="5394115"/>
            <a:ext cx="957545" cy="960343"/>
          </a:xfrm>
          <a:prstGeom prst="rect">
            <a:avLst/>
          </a:prstGeom>
        </p:spPr>
      </p:pic>
    </p:spTree>
    <p:extLst>
      <p:ext uri="{BB962C8B-B14F-4D97-AF65-F5344CB8AC3E}">
        <p14:creationId xmlns:p14="http://schemas.microsoft.com/office/powerpoint/2010/main" val="42107728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slide – Red option 2">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C6464A0A-2E52-4325-8E9A-4FE513E8B588}"/>
              </a:ext>
            </a:extLst>
          </p:cNvPr>
          <p:cNvSpPr/>
          <p:nvPr userDrawn="1"/>
        </p:nvSpPr>
        <p:spPr>
          <a:xfrm>
            <a:off x="0"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4" name="Picture 13" descr="A close up of a logo&#10;&#10;Description automatically generated">
            <a:extLst>
              <a:ext uri="{FF2B5EF4-FFF2-40B4-BE49-F238E27FC236}">
                <a16:creationId xmlns:a16="http://schemas.microsoft.com/office/drawing/2014/main" id="{B1AC6F61-871E-4989-A8F8-D6803736596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3" name="Picture 12" descr="A view of a city street&#10;&#10;Description automatically generated">
            <a:extLst>
              <a:ext uri="{FF2B5EF4-FFF2-40B4-BE49-F238E27FC236}">
                <a16:creationId xmlns:a16="http://schemas.microsoft.com/office/drawing/2014/main" id="{63312DD7-C717-A94A-9B5F-6550C2610BB6}"/>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567774" y="-1"/>
            <a:ext cx="4576227" cy="6858000"/>
          </a:xfrm>
          <a:prstGeom prst="rect">
            <a:avLst/>
          </a:prstGeom>
        </p:spPr>
      </p:pic>
      <p:sp>
        <p:nvSpPr>
          <p:cNvPr id="7" name="Title 8">
            <a:extLst>
              <a:ext uri="{FF2B5EF4-FFF2-40B4-BE49-F238E27FC236}">
                <a16:creationId xmlns:a16="http://schemas.microsoft.com/office/drawing/2014/main" id="{B7BF95FE-2C8C-1143-AEE5-415586951E2F}"/>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9" name="Text Placeholder 4">
            <a:extLst>
              <a:ext uri="{FF2B5EF4-FFF2-40B4-BE49-F238E27FC236}">
                <a16:creationId xmlns:a16="http://schemas.microsoft.com/office/drawing/2014/main" id="{A93CB376-C0CB-ED45-B607-FE09FC31D218}"/>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129020580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Title slide – White option 5 (no image)">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7" name="Picture 6" descr="A close up of a logo&#10;&#10;Description automatically generated">
            <a:extLst>
              <a:ext uri="{FF2B5EF4-FFF2-40B4-BE49-F238E27FC236}">
                <a16:creationId xmlns:a16="http://schemas.microsoft.com/office/drawing/2014/main" id="{396E9556-837F-4DA9-91CD-BD19A69947B1}"/>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sp>
        <p:nvSpPr>
          <p:cNvPr id="6" name="Title 8">
            <a:extLst>
              <a:ext uri="{FF2B5EF4-FFF2-40B4-BE49-F238E27FC236}">
                <a16:creationId xmlns:a16="http://schemas.microsoft.com/office/drawing/2014/main" id="{63F1E73F-993F-2743-A4D6-C74AC29EA7CE}"/>
              </a:ext>
            </a:extLst>
          </p:cNvPr>
          <p:cNvSpPr>
            <a:spLocks noGrp="1"/>
          </p:cNvSpPr>
          <p:nvPr>
            <p:ph type="title"/>
          </p:nvPr>
        </p:nvSpPr>
        <p:spPr>
          <a:xfrm>
            <a:off x="366942" y="588356"/>
            <a:ext cx="3963817" cy="1322972"/>
          </a:xfrm>
          <a:prstGeom prst="rect">
            <a:avLst/>
          </a:prstGeom>
        </p:spPr>
        <p:txBody>
          <a:bodyPr anchor="t"/>
          <a:lstStyle>
            <a:lvl1pPr>
              <a:defRPr sz="2250">
                <a:solidFill>
                  <a:srgbClr val="E64626"/>
                </a:solidFill>
                <a:latin typeface="+mj-lt"/>
                <a:cs typeface="Arial" panose="020B0604020202020204" pitchFamily="34" charset="0"/>
              </a:defRPr>
            </a:lvl1pPr>
          </a:lstStyle>
          <a:p>
            <a:r>
              <a:rPr lang="en-US"/>
              <a:t>Click to edit Master title style</a:t>
            </a:r>
          </a:p>
        </p:txBody>
      </p:sp>
      <p:sp>
        <p:nvSpPr>
          <p:cNvPr id="8" name="Text Placeholder 4">
            <a:extLst>
              <a:ext uri="{FF2B5EF4-FFF2-40B4-BE49-F238E27FC236}">
                <a16:creationId xmlns:a16="http://schemas.microsoft.com/office/drawing/2014/main" id="{F50306BA-4DCA-6643-9EAE-3C143CE3849A}"/>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238555346"/>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683605-FFBB-DF40-9F65-A763316E8C46}"/>
              </a:ext>
            </a:extLst>
          </p:cNvPr>
          <p:cNvSpPr>
            <a:spLocks noGrp="1"/>
          </p:cNvSpPr>
          <p:nvPr>
            <p:ph type="title"/>
          </p:nvPr>
        </p:nvSpPr>
        <p:spPr>
          <a:xfrm>
            <a:off x="358776" y="501653"/>
            <a:ext cx="8426450" cy="647183"/>
          </a:xfrm>
        </p:spPr>
        <p:txBody>
          <a:bodyPr/>
          <a:lstStyle/>
          <a:p>
            <a:r>
              <a:rPr lang="en-US"/>
              <a:t>Click to edit Master title style</a:t>
            </a:r>
          </a:p>
        </p:txBody>
      </p:sp>
      <p:sp>
        <p:nvSpPr>
          <p:cNvPr id="3" name="Content Placeholder 2">
            <a:extLst>
              <a:ext uri="{FF2B5EF4-FFF2-40B4-BE49-F238E27FC236}">
                <a16:creationId xmlns:a16="http://schemas.microsoft.com/office/drawing/2014/main" id="{9E38F0D4-8996-1340-9692-21C5B4DC5D31}"/>
              </a:ext>
            </a:extLst>
          </p:cNvPr>
          <p:cNvSpPr>
            <a:spLocks noGrp="1"/>
          </p:cNvSpPr>
          <p:nvPr>
            <p:ph idx="1"/>
          </p:nvPr>
        </p:nvSpPr>
        <p:spPr>
          <a:xfrm>
            <a:off x="358776" y="1358904"/>
            <a:ext cx="8426449" cy="4767263"/>
          </a:xfrm>
        </p:spPr>
        <p:txBody>
          <a:bodyPr>
            <a:noAutofit/>
          </a:bodyPr>
          <a:lstStyle>
            <a:lvl1pPr fontAlgn="auto">
              <a:spcAft>
                <a:spcPts val="0"/>
              </a:spcAft>
              <a:buFont typeface="Lucida Grande"/>
              <a:buChar char="–"/>
              <a:defRPr sz="1800" b="0"/>
            </a:lvl1pPr>
          </a:lstStyle>
          <a:p>
            <a:pPr fontAlgn="auto">
              <a:spcAft>
                <a:spcPts val="0"/>
              </a:spcAft>
              <a:defRPr/>
            </a:pPr>
            <a:endParaRPr lang="en-US">
              <a:solidFill>
                <a:prstClr val="black"/>
              </a:solidFill>
              <a:ea typeface="+mn-ea"/>
            </a:endParaRPr>
          </a:p>
        </p:txBody>
      </p:sp>
      <p:graphicFrame>
        <p:nvGraphicFramePr>
          <p:cNvPr id="4" name="Table 3">
            <a:extLst>
              <a:ext uri="{FF2B5EF4-FFF2-40B4-BE49-F238E27FC236}">
                <a16:creationId xmlns:a16="http://schemas.microsoft.com/office/drawing/2014/main" id="{53F5080A-DFFE-664C-B514-2BB0E750C953}"/>
              </a:ext>
            </a:extLst>
          </p:cNvPr>
          <p:cNvGraphicFramePr>
            <a:graphicFrameLocks noGrp="1"/>
          </p:cNvGraphicFramePr>
          <p:nvPr userDrawn="1">
            <p:extLst>
              <p:ext uri="{D42A27DB-BD31-4B8C-83A1-F6EECF244321}">
                <p14:modId xmlns:p14="http://schemas.microsoft.com/office/powerpoint/2010/main" val="4074493993"/>
              </p:ext>
            </p:extLst>
          </p:nvPr>
        </p:nvGraphicFramePr>
        <p:xfrm>
          <a:off x="358774" y="3326481"/>
          <a:ext cx="8426448" cy="2799685"/>
        </p:xfrm>
        <a:graphic>
          <a:graphicData uri="http://schemas.openxmlformats.org/drawingml/2006/table">
            <a:tbl>
              <a:tblPr firstRow="1" bandRow="1">
                <a:tableStyleId>{0660B408-B3CF-4A94-85FC-2B1E0A45F4A2}</a:tableStyleId>
              </a:tblPr>
              <a:tblGrid>
                <a:gridCol w="2808816">
                  <a:extLst>
                    <a:ext uri="{9D8B030D-6E8A-4147-A177-3AD203B41FA5}">
                      <a16:colId xmlns:a16="http://schemas.microsoft.com/office/drawing/2014/main" val="20000"/>
                    </a:ext>
                  </a:extLst>
                </a:gridCol>
                <a:gridCol w="2808816">
                  <a:extLst>
                    <a:ext uri="{9D8B030D-6E8A-4147-A177-3AD203B41FA5}">
                      <a16:colId xmlns:a16="http://schemas.microsoft.com/office/drawing/2014/main" val="20001"/>
                    </a:ext>
                  </a:extLst>
                </a:gridCol>
                <a:gridCol w="2808816">
                  <a:extLst>
                    <a:ext uri="{9D8B030D-6E8A-4147-A177-3AD203B41FA5}">
                      <a16:colId xmlns:a16="http://schemas.microsoft.com/office/drawing/2014/main" val="20002"/>
                    </a:ext>
                  </a:extLst>
                </a:gridCol>
              </a:tblGrid>
              <a:tr h="559937">
                <a:tc>
                  <a:txBody>
                    <a:bodyPr/>
                    <a:lstStyle/>
                    <a:p>
                      <a:r>
                        <a:rPr lang="en-US" sz="2400">
                          <a:latin typeface="Tw Cen MT"/>
                          <a:cs typeface="Tw Cen MT"/>
                        </a:rPr>
                        <a:t>Heading</a:t>
                      </a:r>
                      <a:r>
                        <a:rPr lang="en-US" sz="2400" baseline="0">
                          <a:latin typeface="Tw Cen MT"/>
                          <a:cs typeface="Tw Cen MT"/>
                        </a:rPr>
                        <a:t> 1</a:t>
                      </a:r>
                      <a:endParaRPr lang="en-US" sz="2400">
                        <a:latin typeface="Tw Cen MT"/>
                        <a:cs typeface="Tw Cen MT"/>
                      </a:endParaRPr>
                    </a:p>
                  </a:txBody>
                  <a:tcPr marL="68580" marR="68580">
                    <a:lnB w="6350" cap="flat" cmpd="sng" algn="ctr">
                      <a:solidFill>
                        <a:srgbClr val="F05133"/>
                      </a:solidFill>
                      <a:prstDash val="solid"/>
                      <a:round/>
                      <a:headEnd type="none" w="med" len="med"/>
                      <a:tailEnd type="none" w="med" len="med"/>
                    </a:lnB>
                    <a:solidFill>
                      <a:schemeClr val="accent1"/>
                    </a:solidFill>
                  </a:tcPr>
                </a:tc>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2400">
                          <a:latin typeface="Tw Cen MT"/>
                          <a:cs typeface="Tw Cen MT"/>
                        </a:rPr>
                        <a:t>Heading</a:t>
                      </a:r>
                      <a:r>
                        <a:rPr lang="en-US" sz="2400" baseline="0">
                          <a:latin typeface="Tw Cen MT"/>
                          <a:cs typeface="Tw Cen MT"/>
                        </a:rPr>
                        <a:t> 2</a:t>
                      </a:r>
                      <a:endParaRPr lang="en-US" sz="2400">
                        <a:latin typeface="Tw Cen MT"/>
                        <a:cs typeface="Tw Cen MT"/>
                      </a:endParaRPr>
                    </a:p>
                  </a:txBody>
                  <a:tcPr marL="68580" marR="68580">
                    <a:lnB w="6350" cap="flat" cmpd="sng" algn="ctr">
                      <a:solidFill>
                        <a:srgbClr val="F05133"/>
                      </a:solidFill>
                      <a:prstDash val="solid"/>
                      <a:round/>
                      <a:headEnd type="none" w="med" len="med"/>
                      <a:tailEnd type="none" w="med" len="med"/>
                    </a:lnB>
                    <a:solidFill>
                      <a:schemeClr val="accent1"/>
                    </a:solidFill>
                  </a:tcPr>
                </a:tc>
                <a:tc>
                  <a: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2400">
                          <a:latin typeface="Tw Cen MT"/>
                          <a:cs typeface="Tw Cen MT"/>
                        </a:rPr>
                        <a:t>Heading</a:t>
                      </a:r>
                      <a:r>
                        <a:rPr lang="en-US" sz="2400" baseline="0">
                          <a:latin typeface="Tw Cen MT"/>
                          <a:cs typeface="Tw Cen MT"/>
                        </a:rPr>
                        <a:t> 3</a:t>
                      </a:r>
                      <a:endParaRPr lang="en-US" sz="2400">
                        <a:latin typeface="Tw Cen MT"/>
                        <a:cs typeface="Tw Cen MT"/>
                      </a:endParaRPr>
                    </a:p>
                  </a:txBody>
                  <a:tcPr marL="68580" marR="68580">
                    <a:lnB w="6350" cap="flat" cmpd="sng" algn="ctr">
                      <a:solidFill>
                        <a:srgbClr val="F05133"/>
                      </a:solidFill>
                      <a:prstDash val="solid"/>
                      <a:round/>
                      <a:headEnd type="none" w="med" len="med"/>
                      <a:tailEnd type="none" w="med" len="med"/>
                    </a:lnB>
                    <a:solidFill>
                      <a:schemeClr val="accent1"/>
                    </a:solidFill>
                  </a:tcPr>
                </a:tc>
                <a:extLst>
                  <a:ext uri="{0D108BD9-81ED-4DB2-BD59-A6C34878D82A}">
                    <a16:rowId xmlns:a16="http://schemas.microsoft.com/office/drawing/2014/main" val="10000"/>
                  </a:ext>
                </a:extLst>
              </a:tr>
              <a:tr h="559937">
                <a:tc>
                  <a:txBody>
                    <a:bodyPr/>
                    <a:lstStyle/>
                    <a:p>
                      <a:pPr marL="0" marR="0" indent="0" algn="l" defTabSz="457187" rtl="0" eaLnBrk="1" fontAlgn="auto" latinLnBrk="0" hangingPunct="1">
                        <a:lnSpc>
                          <a:spcPct val="100000"/>
                        </a:lnSpc>
                        <a:spcBef>
                          <a:spcPts val="0"/>
                        </a:spcBef>
                        <a:spcAft>
                          <a:spcPts val="0"/>
                        </a:spcAft>
                        <a:buClrTx/>
                        <a:buSzTx/>
                        <a:buFontTx/>
                        <a:buNone/>
                        <a:tabLst/>
                        <a:defRPr/>
                      </a:pPr>
                      <a:r>
                        <a:rPr lang="en-US" sz="2400">
                          <a:latin typeface="Tw Cen MT"/>
                          <a:cs typeface="Tw Cen MT"/>
                        </a:rPr>
                        <a:t>Body</a:t>
                      </a:r>
                      <a:r>
                        <a:rPr lang="en-US" sz="2400" baseline="0">
                          <a:latin typeface="Tw Cen MT"/>
                          <a:cs typeface="Tw Cen MT"/>
                        </a:rPr>
                        <a:t> copy</a:t>
                      </a:r>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tc>
                  <a:txBody>
                    <a:bodyPr/>
                    <a:lstStyle/>
                    <a:p>
                      <a:pPr marL="0" marR="0" indent="0" algn="l" defTabSz="457187" rtl="0" eaLnBrk="1" fontAlgn="auto" latinLnBrk="0" hangingPunct="1">
                        <a:lnSpc>
                          <a:spcPct val="100000"/>
                        </a:lnSpc>
                        <a:spcBef>
                          <a:spcPts val="0"/>
                        </a:spcBef>
                        <a:spcAft>
                          <a:spcPts val="0"/>
                        </a:spcAft>
                        <a:buClrTx/>
                        <a:buSzTx/>
                        <a:buFontTx/>
                        <a:buNone/>
                        <a:tabLst/>
                        <a:defRPr/>
                      </a:pPr>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tc>
                  <a:txBody>
                    <a:bodyPr/>
                    <a:lstStyle/>
                    <a:p>
                      <a:pPr marL="0" marR="0" indent="0" algn="l" defTabSz="457187" rtl="0" eaLnBrk="1" fontAlgn="auto" latinLnBrk="0" hangingPunct="1">
                        <a:lnSpc>
                          <a:spcPct val="100000"/>
                        </a:lnSpc>
                        <a:spcBef>
                          <a:spcPts val="0"/>
                        </a:spcBef>
                        <a:spcAft>
                          <a:spcPts val="0"/>
                        </a:spcAft>
                        <a:buClrTx/>
                        <a:buSzTx/>
                        <a:buFontTx/>
                        <a:buNone/>
                        <a:tabLst/>
                        <a:defRPr/>
                      </a:pPr>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extLst>
                  <a:ext uri="{0D108BD9-81ED-4DB2-BD59-A6C34878D82A}">
                    <a16:rowId xmlns:a16="http://schemas.microsoft.com/office/drawing/2014/main" val="10001"/>
                  </a:ext>
                </a:extLst>
              </a:tr>
              <a:tr h="559937">
                <a:tc>
                  <a:txBody>
                    <a:bodyPr/>
                    <a:lstStyle/>
                    <a:p>
                      <a:r>
                        <a:rPr lang="en-US" sz="2400">
                          <a:latin typeface="Tw Cen MT"/>
                          <a:cs typeface="Tw Cen MT"/>
                        </a:rPr>
                        <a:t>xxx</a:t>
                      </a: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tc>
                  <a:txBody>
                    <a:bodyPr/>
                    <a:lstStyle/>
                    <a:p>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tc>
                  <a:txBody>
                    <a:bodyPr/>
                    <a:lstStyle/>
                    <a:p>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extLst>
                  <a:ext uri="{0D108BD9-81ED-4DB2-BD59-A6C34878D82A}">
                    <a16:rowId xmlns:a16="http://schemas.microsoft.com/office/drawing/2014/main" val="10002"/>
                  </a:ext>
                </a:extLst>
              </a:tr>
              <a:tr h="559937">
                <a:tc>
                  <a:txBody>
                    <a:bodyPr/>
                    <a:lstStyle/>
                    <a:p>
                      <a:r>
                        <a:rPr lang="en-US" sz="2400">
                          <a:latin typeface="Tw Cen MT"/>
                          <a:cs typeface="Tw Cen MT"/>
                        </a:rPr>
                        <a:t>xxx</a:t>
                      </a: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tc>
                  <a:txBody>
                    <a:bodyPr/>
                    <a:lstStyle/>
                    <a:p>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tc>
                  <a:txBody>
                    <a:bodyPr/>
                    <a:lstStyle/>
                    <a:p>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lnB w="6350" cap="flat" cmpd="sng" algn="ctr">
                      <a:solidFill>
                        <a:srgbClr val="F05133"/>
                      </a:solidFill>
                      <a:prstDash val="solid"/>
                      <a:round/>
                      <a:headEnd type="none" w="med" len="med"/>
                      <a:tailEnd type="none" w="med" len="med"/>
                    </a:lnB>
                  </a:tcPr>
                </a:tc>
                <a:extLst>
                  <a:ext uri="{0D108BD9-81ED-4DB2-BD59-A6C34878D82A}">
                    <a16:rowId xmlns:a16="http://schemas.microsoft.com/office/drawing/2014/main" val="10003"/>
                  </a:ext>
                </a:extLst>
              </a:tr>
              <a:tr h="559937">
                <a:tc>
                  <a:txBody>
                    <a:bodyPr/>
                    <a:lstStyle/>
                    <a:p>
                      <a:r>
                        <a:rPr lang="en-US" sz="2400">
                          <a:latin typeface="Tw Cen MT"/>
                          <a:cs typeface="Tw Cen MT"/>
                        </a:rPr>
                        <a:t>xxx</a:t>
                      </a:r>
                    </a:p>
                  </a:txBody>
                  <a:tcPr marL="68580" marR="68580">
                    <a:lnT w="6350" cap="flat" cmpd="sng" algn="ctr">
                      <a:solidFill>
                        <a:srgbClr val="F05133"/>
                      </a:solidFill>
                      <a:prstDash val="solid"/>
                      <a:round/>
                      <a:headEnd type="none" w="med" len="med"/>
                      <a:tailEnd type="none" w="med" len="med"/>
                    </a:lnT>
                  </a:tcPr>
                </a:tc>
                <a:tc>
                  <a:txBody>
                    <a:bodyPr/>
                    <a:lstStyle/>
                    <a:p>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tcPr>
                </a:tc>
                <a:tc>
                  <a:txBody>
                    <a:bodyPr/>
                    <a:lstStyle/>
                    <a:p>
                      <a:endParaRPr lang="en-US" sz="2400">
                        <a:latin typeface="Tw Cen MT"/>
                        <a:cs typeface="Tw Cen MT"/>
                      </a:endParaRPr>
                    </a:p>
                  </a:txBody>
                  <a:tcPr marL="68580" marR="68580">
                    <a:lnT w="6350" cap="flat" cmpd="sng" algn="ctr">
                      <a:solidFill>
                        <a:srgbClr val="F05133"/>
                      </a:solidFill>
                      <a:prstDash val="solid"/>
                      <a:round/>
                      <a:headEnd type="none" w="med" len="med"/>
                      <a:tailEnd type="none" w="med" len="med"/>
                    </a:lnT>
                  </a:tcPr>
                </a:tc>
                <a:extLst>
                  <a:ext uri="{0D108BD9-81ED-4DB2-BD59-A6C34878D82A}">
                    <a16:rowId xmlns:a16="http://schemas.microsoft.com/office/drawing/2014/main" val="10004"/>
                  </a:ext>
                </a:extLst>
              </a:tr>
            </a:tbl>
          </a:graphicData>
        </a:graphic>
      </p:graphicFrame>
    </p:spTree>
    <p:extLst>
      <p:ext uri="{BB962C8B-B14F-4D97-AF65-F5344CB8AC3E}">
        <p14:creationId xmlns:p14="http://schemas.microsoft.com/office/powerpoint/2010/main" val="4006700652"/>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a:xfrm>
            <a:off x="358777" y="1358904"/>
            <a:ext cx="8328025" cy="4767263"/>
          </a:xfrm>
          <a:prstGeom prst="rect">
            <a:avLst/>
          </a:prstGeom>
        </p:spPr>
        <p:txBody>
          <a:bodyPr/>
          <a:lstStyle>
            <a:lvl1pPr>
              <a:lnSpc>
                <a:spcPct val="90000"/>
              </a:lnSpc>
              <a:defRPr/>
            </a:lvl1pPr>
            <a:lvl2pPr marL="417910" indent="-160735">
              <a:lnSpc>
                <a:spcPct val="90000"/>
              </a:lnSpc>
              <a:buFont typeface="Lucida Grande"/>
              <a:buChar char="–"/>
              <a:defRPr sz="1800"/>
            </a:lvl2pPr>
            <a:lvl3pPr>
              <a:lnSpc>
                <a:spcPct val="90000"/>
              </a:lnSpc>
              <a:defRPr sz="1800"/>
            </a:lvl3pPr>
          </a:lstStyle>
          <a:p>
            <a:pPr lvl="0"/>
            <a:r>
              <a:rPr lang="en-US"/>
              <a:t>Click to edit Master text styles</a:t>
            </a:r>
          </a:p>
          <a:p>
            <a:pPr lvl="1"/>
            <a:r>
              <a:rPr lang="en-US"/>
              <a:t>Second level</a:t>
            </a:r>
          </a:p>
          <a:p>
            <a:pPr lvl="2"/>
            <a:r>
              <a:rPr lang="en-US"/>
              <a:t>Third level</a:t>
            </a:r>
          </a:p>
        </p:txBody>
      </p:sp>
      <p:sp>
        <p:nvSpPr>
          <p:cNvPr id="5" name="Title Placeholder 1">
            <a:extLst>
              <a:ext uri="{FF2B5EF4-FFF2-40B4-BE49-F238E27FC236}">
                <a16:creationId xmlns:a16="http://schemas.microsoft.com/office/drawing/2014/main" id="{63D16220-4F50-6A45-8A5C-0AB56F7CE96C}"/>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0" tIns="0" rIns="0" bIns="0" numCol="1" anchor="t" anchorCtr="0" compatLnSpc="1">
            <a:prstTxWarp prst="textNoShape">
              <a:avLst/>
            </a:prstTxWarp>
          </a:bodyPr>
          <a:lstStyle/>
          <a:p>
            <a:pPr lvl="0"/>
            <a:r>
              <a:rPr lang="en-US"/>
              <a:t>Insert slide title </a:t>
            </a:r>
          </a:p>
        </p:txBody>
      </p:sp>
    </p:spTree>
    <p:extLst>
      <p:ext uri="{BB962C8B-B14F-4D97-AF65-F5344CB8AC3E}">
        <p14:creationId xmlns:p14="http://schemas.microsoft.com/office/powerpoint/2010/main" val="1405924122"/>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Title and Two Content ">
    <p:spTree>
      <p:nvGrpSpPr>
        <p:cNvPr id="1" name=""/>
        <p:cNvGrpSpPr/>
        <p:nvPr/>
      </p:nvGrpSpPr>
      <p:grpSpPr>
        <a:xfrm>
          <a:off x="0" y="0"/>
          <a:ext cx="0" cy="0"/>
          <a:chOff x="0" y="0"/>
          <a:chExt cx="0" cy="0"/>
        </a:xfrm>
      </p:grpSpPr>
      <p:sp>
        <p:nvSpPr>
          <p:cNvPr id="5" name="Title Placeholder 1">
            <a:extLst>
              <a:ext uri="{FF2B5EF4-FFF2-40B4-BE49-F238E27FC236}">
                <a16:creationId xmlns:a16="http://schemas.microsoft.com/office/drawing/2014/main" id="{70A60416-C836-0E45-976A-13A986DE89E8}"/>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0" tIns="0" rIns="0" bIns="0" numCol="1" anchor="t" anchorCtr="0" compatLnSpc="1">
            <a:prstTxWarp prst="textNoShape">
              <a:avLst/>
            </a:prstTxWarp>
          </a:bodyPr>
          <a:lstStyle/>
          <a:p>
            <a:pPr lvl="0"/>
            <a:r>
              <a:rPr lang="en-US"/>
              <a:t>Insert slide title</a:t>
            </a:r>
          </a:p>
        </p:txBody>
      </p:sp>
      <p:sp>
        <p:nvSpPr>
          <p:cNvPr id="7" name="Content Placeholder 2">
            <a:extLst>
              <a:ext uri="{FF2B5EF4-FFF2-40B4-BE49-F238E27FC236}">
                <a16:creationId xmlns:a16="http://schemas.microsoft.com/office/drawing/2014/main" id="{8337E35D-E929-4CDD-AFA3-DDA5D95A9F9F}"/>
              </a:ext>
            </a:extLst>
          </p:cNvPr>
          <p:cNvSpPr>
            <a:spLocks noGrp="1"/>
          </p:cNvSpPr>
          <p:nvPr>
            <p:ph sz="half" idx="10"/>
          </p:nvPr>
        </p:nvSpPr>
        <p:spPr>
          <a:xfrm>
            <a:off x="358775" y="1359927"/>
            <a:ext cx="4038600" cy="4525963"/>
          </a:xfrm>
          <a:prstGeom prst="rect">
            <a:avLst/>
          </a:prstGeom>
        </p:spPr>
        <p:txBody>
          <a:bodyPr>
            <a:normAutofit/>
          </a:bodyPr>
          <a:lstStyle>
            <a:lvl1pPr>
              <a:defRPr sz="1800"/>
            </a:lvl1pPr>
            <a:lvl2pPr>
              <a:defRPr sz="1800"/>
            </a:lvl2pPr>
            <a:lvl3pPr>
              <a:defRPr sz="1800"/>
            </a:lvl3pPr>
            <a:lvl4pPr>
              <a:defRPr sz="1125"/>
            </a:lvl4pPr>
            <a:lvl5pPr>
              <a:defRPr sz="1125"/>
            </a:lvl5pPr>
            <a:lvl6pPr>
              <a:defRPr sz="1013"/>
            </a:lvl6pPr>
            <a:lvl7pPr>
              <a:defRPr sz="1013"/>
            </a:lvl7pPr>
            <a:lvl8pPr>
              <a:defRPr sz="1013"/>
            </a:lvl8pPr>
            <a:lvl9pPr>
              <a:defRPr sz="1013"/>
            </a:lvl9pPr>
          </a:lstStyle>
          <a:p>
            <a:pPr lvl="0"/>
            <a:r>
              <a:rPr lang="en-US"/>
              <a:t>Click to edit Master text styles</a:t>
            </a:r>
          </a:p>
          <a:p>
            <a:pPr lvl="1"/>
            <a:r>
              <a:rPr lang="en-US"/>
              <a:t>Second level</a:t>
            </a:r>
          </a:p>
          <a:p>
            <a:pPr lvl="2"/>
            <a:r>
              <a:rPr lang="en-US"/>
              <a:t>Third level</a:t>
            </a:r>
          </a:p>
        </p:txBody>
      </p:sp>
      <p:sp>
        <p:nvSpPr>
          <p:cNvPr id="9" name="Content Placeholder 3">
            <a:extLst>
              <a:ext uri="{FF2B5EF4-FFF2-40B4-BE49-F238E27FC236}">
                <a16:creationId xmlns:a16="http://schemas.microsoft.com/office/drawing/2014/main" id="{DBCD8866-5C79-4769-B022-E56134A505BB}"/>
              </a:ext>
            </a:extLst>
          </p:cNvPr>
          <p:cNvSpPr>
            <a:spLocks noGrp="1"/>
          </p:cNvSpPr>
          <p:nvPr>
            <p:ph sz="half" idx="11"/>
          </p:nvPr>
        </p:nvSpPr>
        <p:spPr>
          <a:xfrm>
            <a:off x="4746625" y="1359927"/>
            <a:ext cx="4038600" cy="4525963"/>
          </a:xfrm>
          <a:prstGeom prst="rect">
            <a:avLst/>
          </a:prstGeom>
        </p:spPr>
        <p:txBody>
          <a:bodyPr>
            <a:normAutofit/>
          </a:bodyPr>
          <a:lstStyle>
            <a:lvl1pPr>
              <a:defRPr sz="1800"/>
            </a:lvl1pPr>
            <a:lvl2pPr>
              <a:defRPr sz="1800"/>
            </a:lvl2pPr>
            <a:lvl3pPr>
              <a:defRPr sz="1800"/>
            </a:lvl3pPr>
            <a:lvl4pPr>
              <a:defRPr sz="1125"/>
            </a:lvl4pPr>
            <a:lvl5pPr>
              <a:defRPr sz="1125"/>
            </a:lvl5pPr>
            <a:lvl6pPr>
              <a:defRPr sz="1013"/>
            </a:lvl6pPr>
            <a:lvl7pPr>
              <a:defRPr sz="1013"/>
            </a:lvl7pPr>
            <a:lvl8pPr>
              <a:defRPr sz="1013"/>
            </a:lvl8pPr>
            <a:lvl9pPr>
              <a:defRPr sz="1013"/>
            </a:lvl9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283350589"/>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userDrawn="1">
  <p:cSld name="Acknowledgement of Country">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A194C734-8EA7-6747-9D5E-0095CB042E67}"/>
              </a:ext>
            </a:extLst>
          </p:cNvPr>
          <p:cNvSpPr/>
          <p:nvPr userDrawn="1"/>
        </p:nvSpPr>
        <p:spPr>
          <a:xfrm>
            <a:off x="3" y="0"/>
            <a:ext cx="9143999"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sp>
        <p:nvSpPr>
          <p:cNvPr id="8" name="Rectangle 7">
            <a:extLst>
              <a:ext uri="{FF2B5EF4-FFF2-40B4-BE49-F238E27FC236}">
                <a16:creationId xmlns:a16="http://schemas.microsoft.com/office/drawing/2014/main" id="{BAEC2915-3116-4260-8EA9-AB20FD5A9A82}"/>
              </a:ext>
            </a:extLst>
          </p:cNvPr>
          <p:cNvSpPr/>
          <p:nvPr userDrawn="1"/>
        </p:nvSpPr>
        <p:spPr>
          <a:xfrm>
            <a:off x="3" y="5394962"/>
            <a:ext cx="9143998" cy="1479665"/>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AU" sz="1350"/>
          </a:p>
        </p:txBody>
      </p:sp>
      <p:sp>
        <p:nvSpPr>
          <p:cNvPr id="2" name="Rectangle 1">
            <a:extLst>
              <a:ext uri="{FF2B5EF4-FFF2-40B4-BE49-F238E27FC236}">
                <a16:creationId xmlns:a16="http://schemas.microsoft.com/office/drawing/2014/main" id="{0C3010EE-5F8C-A141-9442-3FCFF7B6179C}"/>
              </a:ext>
            </a:extLst>
          </p:cNvPr>
          <p:cNvSpPr/>
          <p:nvPr userDrawn="1"/>
        </p:nvSpPr>
        <p:spPr>
          <a:xfrm>
            <a:off x="1946107" y="2005026"/>
            <a:ext cx="5874569" cy="1200329"/>
          </a:xfrm>
          <a:prstGeom prst="rect">
            <a:avLst/>
          </a:prstGeom>
        </p:spPr>
        <p:txBody>
          <a:bodyPr wrap="square">
            <a:spAutoFit/>
          </a:bodyPr>
          <a:lstStyle/>
          <a:p>
            <a:pPr algn="ctr"/>
            <a:r>
              <a:rPr lang="en-AU" sz="1800" b="0" i="0">
                <a:solidFill>
                  <a:schemeClr val="bg1"/>
                </a:solidFill>
                <a:effectLst/>
                <a:latin typeface="Tw Cen MT" panose="020B0602020104020603" pitchFamily="34" charset="0"/>
              </a:rPr>
              <a:t>We acknowledge the tradition of custodianship and law of the Country on which we stand today. </a:t>
            </a:r>
            <a:br>
              <a:rPr lang="en-AU" sz="1800" b="0" i="0">
                <a:solidFill>
                  <a:schemeClr val="bg1"/>
                </a:solidFill>
                <a:effectLst/>
                <a:latin typeface="Tw Cen MT" panose="020B0602020104020603" pitchFamily="34" charset="0"/>
              </a:rPr>
            </a:br>
            <a:r>
              <a:rPr lang="en-AU" sz="1800" b="0" i="0">
                <a:solidFill>
                  <a:schemeClr val="bg1"/>
                </a:solidFill>
                <a:effectLst/>
                <a:latin typeface="Tw Cen MT" panose="020B0602020104020603" pitchFamily="34" charset="0"/>
              </a:rPr>
              <a:t>We pay our respects to those who have cared and continue to care for Country.</a:t>
            </a:r>
          </a:p>
        </p:txBody>
      </p:sp>
      <p:pic>
        <p:nvPicPr>
          <p:cNvPr id="4" name="Picture 3">
            <a:extLst>
              <a:ext uri="{FF2B5EF4-FFF2-40B4-BE49-F238E27FC236}">
                <a16:creationId xmlns:a16="http://schemas.microsoft.com/office/drawing/2014/main" id="{1A15D4BB-E575-4B2E-89BF-6C78B456C7A2}"/>
              </a:ext>
            </a:extLst>
          </p:cNvPr>
          <p:cNvPicPr>
            <a:picLocks noChangeAspect="1"/>
          </p:cNvPicPr>
          <p:nvPr userDrawn="1"/>
        </p:nvPicPr>
        <p:blipFill>
          <a:blip r:embed="rId2"/>
          <a:stretch>
            <a:fillRect/>
          </a:stretch>
        </p:blipFill>
        <p:spPr>
          <a:xfrm>
            <a:off x="2708565" y="5586375"/>
            <a:ext cx="1730432" cy="929986"/>
          </a:xfrm>
          <a:prstGeom prst="rect">
            <a:avLst/>
          </a:prstGeom>
        </p:spPr>
      </p:pic>
      <p:pic>
        <p:nvPicPr>
          <p:cNvPr id="6" name="Picture 5">
            <a:extLst>
              <a:ext uri="{FF2B5EF4-FFF2-40B4-BE49-F238E27FC236}">
                <a16:creationId xmlns:a16="http://schemas.microsoft.com/office/drawing/2014/main" id="{E39232D5-1425-45B1-B404-F0D4DE30EA7C}"/>
              </a:ext>
            </a:extLst>
          </p:cNvPr>
          <p:cNvPicPr>
            <a:picLocks noChangeAspect="1"/>
          </p:cNvPicPr>
          <p:nvPr userDrawn="1"/>
        </p:nvPicPr>
        <p:blipFill>
          <a:blip r:embed="rId3"/>
          <a:stretch>
            <a:fillRect/>
          </a:stretch>
        </p:blipFill>
        <p:spPr>
          <a:xfrm>
            <a:off x="5633922" y="5597175"/>
            <a:ext cx="916508" cy="919186"/>
          </a:xfrm>
          <a:prstGeom prst="rect">
            <a:avLst/>
          </a:prstGeom>
        </p:spPr>
      </p:pic>
    </p:spTree>
    <p:extLst>
      <p:ext uri="{BB962C8B-B14F-4D97-AF65-F5344CB8AC3E}">
        <p14:creationId xmlns:p14="http://schemas.microsoft.com/office/powerpoint/2010/main" val="2199262837"/>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1_Acknowledgement of lived expereince">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A194C734-8EA7-6747-9D5E-0095CB042E67}"/>
              </a:ext>
            </a:extLst>
          </p:cNvPr>
          <p:cNvSpPr/>
          <p:nvPr userDrawn="1"/>
        </p:nvSpPr>
        <p:spPr>
          <a:xfrm>
            <a:off x="3" y="0"/>
            <a:ext cx="9143999"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sp>
        <p:nvSpPr>
          <p:cNvPr id="8" name="Rectangle 7">
            <a:extLst>
              <a:ext uri="{FF2B5EF4-FFF2-40B4-BE49-F238E27FC236}">
                <a16:creationId xmlns:a16="http://schemas.microsoft.com/office/drawing/2014/main" id="{BAEC2915-3116-4260-8EA9-AB20FD5A9A82}"/>
              </a:ext>
            </a:extLst>
          </p:cNvPr>
          <p:cNvSpPr/>
          <p:nvPr userDrawn="1"/>
        </p:nvSpPr>
        <p:spPr>
          <a:xfrm>
            <a:off x="3" y="5394962"/>
            <a:ext cx="9143998" cy="1479665"/>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AU" sz="1350"/>
          </a:p>
        </p:txBody>
      </p:sp>
      <p:pic>
        <p:nvPicPr>
          <p:cNvPr id="4" name="Picture 3">
            <a:extLst>
              <a:ext uri="{FF2B5EF4-FFF2-40B4-BE49-F238E27FC236}">
                <a16:creationId xmlns:a16="http://schemas.microsoft.com/office/drawing/2014/main" id="{1A15D4BB-E575-4B2E-89BF-6C78B456C7A2}"/>
              </a:ext>
            </a:extLst>
          </p:cNvPr>
          <p:cNvPicPr>
            <a:picLocks noChangeAspect="1"/>
          </p:cNvPicPr>
          <p:nvPr userDrawn="1"/>
        </p:nvPicPr>
        <p:blipFill>
          <a:blip r:embed="rId2"/>
          <a:stretch>
            <a:fillRect/>
          </a:stretch>
        </p:blipFill>
        <p:spPr>
          <a:xfrm>
            <a:off x="2708565" y="5586375"/>
            <a:ext cx="1730432" cy="929986"/>
          </a:xfrm>
          <a:prstGeom prst="rect">
            <a:avLst/>
          </a:prstGeom>
        </p:spPr>
      </p:pic>
      <p:pic>
        <p:nvPicPr>
          <p:cNvPr id="6" name="Picture 5">
            <a:extLst>
              <a:ext uri="{FF2B5EF4-FFF2-40B4-BE49-F238E27FC236}">
                <a16:creationId xmlns:a16="http://schemas.microsoft.com/office/drawing/2014/main" id="{E39232D5-1425-45B1-B404-F0D4DE30EA7C}"/>
              </a:ext>
            </a:extLst>
          </p:cNvPr>
          <p:cNvPicPr>
            <a:picLocks noChangeAspect="1"/>
          </p:cNvPicPr>
          <p:nvPr userDrawn="1"/>
        </p:nvPicPr>
        <p:blipFill>
          <a:blip r:embed="rId3"/>
          <a:stretch>
            <a:fillRect/>
          </a:stretch>
        </p:blipFill>
        <p:spPr>
          <a:xfrm>
            <a:off x="5633922" y="5597175"/>
            <a:ext cx="916508" cy="919186"/>
          </a:xfrm>
          <a:prstGeom prst="rect">
            <a:avLst/>
          </a:prstGeom>
        </p:spPr>
      </p:pic>
      <p:sp>
        <p:nvSpPr>
          <p:cNvPr id="9" name="Rectangle 8">
            <a:extLst>
              <a:ext uri="{FF2B5EF4-FFF2-40B4-BE49-F238E27FC236}">
                <a16:creationId xmlns:a16="http://schemas.microsoft.com/office/drawing/2014/main" id="{C67CDB5E-4D71-4272-9551-C21C89000749}"/>
              </a:ext>
            </a:extLst>
          </p:cNvPr>
          <p:cNvSpPr/>
          <p:nvPr userDrawn="1"/>
        </p:nvSpPr>
        <p:spPr>
          <a:xfrm>
            <a:off x="2003366" y="2005026"/>
            <a:ext cx="5817309" cy="1754326"/>
          </a:xfrm>
          <a:prstGeom prst="rect">
            <a:avLst/>
          </a:prstGeom>
        </p:spPr>
        <p:txBody>
          <a:bodyPr wrap="square">
            <a:spAutoFit/>
          </a:bodyPr>
          <a:lstStyle/>
          <a:p>
            <a:pPr algn="ctr"/>
            <a:r>
              <a:rPr lang="en-AU" sz="1800" b="0" i="0" kern="1200">
                <a:solidFill>
                  <a:schemeClr val="bg1"/>
                </a:solidFill>
                <a:effectLst/>
                <a:latin typeface="Tw Cen MT" panose="020B0602020104020603" pitchFamily="34" charset="0"/>
                <a:ea typeface="ＭＳ Ｐゴシック" charset="0"/>
                <a:cs typeface="ＭＳ Ｐゴシック" charset="0"/>
              </a:rPr>
              <a:t>We acknowledge people, families and carers with lived experience of mental illness and a lived experience of suicide, and recognise their valuable contributions in helping shape the work that we do.</a:t>
            </a:r>
          </a:p>
          <a:p>
            <a:br>
              <a:rPr lang="en-AU" sz="1800" b="0" i="0" u="none" strike="noStrike" kern="1200">
                <a:solidFill>
                  <a:schemeClr val="tx1"/>
                </a:solidFill>
                <a:effectLst/>
                <a:latin typeface="Arial" charset="0"/>
                <a:ea typeface="ＭＳ Ｐゴシック" charset="0"/>
                <a:cs typeface="ＭＳ Ｐゴシック" charset="0"/>
              </a:rPr>
            </a:br>
            <a:endParaRPr lang="en-AU" sz="1800" b="0" i="0">
              <a:solidFill>
                <a:schemeClr val="bg1"/>
              </a:solidFill>
              <a:effectLst/>
              <a:latin typeface="Tw Cen MT" panose="020B0602020104020603" pitchFamily="34" charset="0"/>
            </a:endParaRPr>
          </a:p>
        </p:txBody>
      </p:sp>
    </p:spTree>
    <p:extLst>
      <p:ext uri="{BB962C8B-B14F-4D97-AF65-F5344CB8AC3E}">
        <p14:creationId xmlns:p14="http://schemas.microsoft.com/office/powerpoint/2010/main" val="1044077540"/>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Title, Content and Image">
    <p:spTree>
      <p:nvGrpSpPr>
        <p:cNvPr id="1" name=""/>
        <p:cNvGrpSpPr/>
        <p:nvPr/>
      </p:nvGrpSpPr>
      <p:grpSpPr>
        <a:xfrm>
          <a:off x="0" y="0"/>
          <a:ext cx="0" cy="0"/>
          <a:chOff x="0" y="0"/>
          <a:chExt cx="0" cy="0"/>
        </a:xfrm>
      </p:grpSpPr>
      <p:sp>
        <p:nvSpPr>
          <p:cNvPr id="6" name="Picture Placeholder 5"/>
          <p:cNvSpPr>
            <a:spLocks noGrp="1"/>
          </p:cNvSpPr>
          <p:nvPr>
            <p:ph type="pic" sz="quarter" idx="10"/>
          </p:nvPr>
        </p:nvSpPr>
        <p:spPr>
          <a:xfrm>
            <a:off x="358775" y="1360488"/>
            <a:ext cx="4038600" cy="4525400"/>
          </a:xfrm>
          <a:prstGeom prst="rect">
            <a:avLst/>
          </a:prstGeom>
        </p:spPr>
        <p:txBody>
          <a:bodyPr/>
          <a:lstStyle>
            <a:lvl1pPr marL="0" indent="0">
              <a:buNone/>
              <a:defRPr/>
            </a:lvl1pPr>
          </a:lstStyle>
          <a:p>
            <a:pPr lvl="0"/>
            <a:r>
              <a:rPr lang="en-US" noProof="0"/>
              <a:t>Click icon to add picture</a:t>
            </a:r>
          </a:p>
        </p:txBody>
      </p:sp>
      <p:sp>
        <p:nvSpPr>
          <p:cNvPr id="8" name="Text Placeholder 2">
            <a:extLst>
              <a:ext uri="{FF2B5EF4-FFF2-40B4-BE49-F238E27FC236}">
                <a16:creationId xmlns:a16="http://schemas.microsoft.com/office/drawing/2014/main" id="{6B9C7BF1-6F0E-974D-9D90-8D2E3B8614D2}"/>
              </a:ext>
            </a:extLst>
          </p:cNvPr>
          <p:cNvSpPr>
            <a:spLocks noGrp="1"/>
          </p:cNvSpPr>
          <p:nvPr>
            <p:ph type="body" sz="quarter" idx="13" hasCustomPrompt="1"/>
          </p:nvPr>
        </p:nvSpPr>
        <p:spPr>
          <a:xfrm>
            <a:off x="360001" y="5939717"/>
            <a:ext cx="8326801" cy="416632"/>
          </a:xfrm>
        </p:spPr>
        <p:txBody>
          <a:bodyPr lIns="0" tIns="0" rIns="0" bIns="0"/>
          <a:lstStyle>
            <a:lvl1pPr marL="0" indent="0">
              <a:buNone/>
              <a:defRPr sz="750"/>
            </a:lvl1pPr>
          </a:lstStyle>
          <a:p>
            <a:pPr lvl="0"/>
            <a:r>
              <a:rPr lang="en-US"/>
              <a:t>* Include source</a:t>
            </a:r>
          </a:p>
        </p:txBody>
      </p:sp>
      <p:sp>
        <p:nvSpPr>
          <p:cNvPr id="9" name="Title Placeholder 1">
            <a:extLst>
              <a:ext uri="{FF2B5EF4-FFF2-40B4-BE49-F238E27FC236}">
                <a16:creationId xmlns:a16="http://schemas.microsoft.com/office/drawing/2014/main" id="{1A6E8EBA-F725-4134-BDCE-9523A37EB37D}"/>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0" tIns="0" rIns="0" bIns="0" numCol="1" anchor="t" anchorCtr="0" compatLnSpc="1">
            <a:prstTxWarp prst="textNoShape">
              <a:avLst/>
            </a:prstTxWarp>
          </a:bodyPr>
          <a:lstStyle/>
          <a:p>
            <a:pPr lvl="0"/>
            <a:r>
              <a:rPr lang="en-US"/>
              <a:t>Insert slide title</a:t>
            </a:r>
          </a:p>
        </p:txBody>
      </p:sp>
      <p:sp>
        <p:nvSpPr>
          <p:cNvPr id="10" name="Content Placeholder 3">
            <a:extLst>
              <a:ext uri="{FF2B5EF4-FFF2-40B4-BE49-F238E27FC236}">
                <a16:creationId xmlns:a16="http://schemas.microsoft.com/office/drawing/2014/main" id="{F396C485-F9F3-4645-B4AF-D94B2D375008}"/>
              </a:ext>
            </a:extLst>
          </p:cNvPr>
          <p:cNvSpPr>
            <a:spLocks noGrp="1"/>
          </p:cNvSpPr>
          <p:nvPr>
            <p:ph sz="half" idx="14"/>
          </p:nvPr>
        </p:nvSpPr>
        <p:spPr>
          <a:xfrm>
            <a:off x="4746625" y="1359927"/>
            <a:ext cx="4038600" cy="4525963"/>
          </a:xfrm>
          <a:prstGeom prst="rect">
            <a:avLst/>
          </a:prstGeom>
        </p:spPr>
        <p:txBody>
          <a:bodyPr>
            <a:normAutofit/>
          </a:bodyPr>
          <a:lstStyle>
            <a:lvl1pPr>
              <a:defRPr sz="1800"/>
            </a:lvl1pPr>
            <a:lvl2pPr>
              <a:defRPr sz="1800"/>
            </a:lvl2pPr>
            <a:lvl3pPr>
              <a:defRPr sz="1800"/>
            </a:lvl3pPr>
            <a:lvl4pPr>
              <a:defRPr sz="1125"/>
            </a:lvl4pPr>
            <a:lvl5pPr>
              <a:defRPr sz="1125"/>
            </a:lvl5pPr>
            <a:lvl6pPr>
              <a:defRPr sz="1013"/>
            </a:lvl6pPr>
            <a:lvl7pPr>
              <a:defRPr sz="1013"/>
            </a:lvl7pPr>
            <a:lvl8pPr>
              <a:defRPr sz="1013"/>
            </a:lvl8pPr>
            <a:lvl9pPr>
              <a:defRPr sz="1013"/>
            </a:lvl9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30668741"/>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userDrawn="1">
  <p:cSld name="Title, Content and Table">
    <p:spTree>
      <p:nvGrpSpPr>
        <p:cNvPr id="1" name=""/>
        <p:cNvGrpSpPr/>
        <p:nvPr/>
      </p:nvGrpSpPr>
      <p:grpSpPr>
        <a:xfrm>
          <a:off x="0" y="0"/>
          <a:ext cx="0" cy="0"/>
          <a:chOff x="0" y="0"/>
          <a:chExt cx="0" cy="0"/>
        </a:xfrm>
      </p:grpSpPr>
      <p:sp>
        <p:nvSpPr>
          <p:cNvPr id="5" name="Table Placeholder 4"/>
          <p:cNvSpPr>
            <a:spLocks noGrp="1"/>
          </p:cNvSpPr>
          <p:nvPr>
            <p:ph type="tbl" sz="quarter" idx="12"/>
          </p:nvPr>
        </p:nvSpPr>
        <p:spPr>
          <a:xfrm>
            <a:off x="358775" y="1360491"/>
            <a:ext cx="4038600" cy="4525399"/>
          </a:xfrm>
          <a:prstGeom prst="rect">
            <a:avLst/>
          </a:prstGeom>
        </p:spPr>
        <p:txBody>
          <a:bodyPr/>
          <a:lstStyle>
            <a:lvl1pPr marL="0" indent="0">
              <a:buNone/>
              <a:defRPr/>
            </a:lvl1pPr>
          </a:lstStyle>
          <a:p>
            <a:pPr lvl="0"/>
            <a:r>
              <a:rPr lang="en-US" noProof="0"/>
              <a:t>Click icon to add table</a:t>
            </a:r>
          </a:p>
        </p:txBody>
      </p:sp>
      <p:sp>
        <p:nvSpPr>
          <p:cNvPr id="6" name="Title Placeholder 1">
            <a:extLst>
              <a:ext uri="{FF2B5EF4-FFF2-40B4-BE49-F238E27FC236}">
                <a16:creationId xmlns:a16="http://schemas.microsoft.com/office/drawing/2014/main" id="{9842CB90-B2C6-9F49-B023-F8F8398B98F1}"/>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0" tIns="0" rIns="0" bIns="0" numCol="1" anchor="t" anchorCtr="0" compatLnSpc="1">
            <a:prstTxWarp prst="textNoShape">
              <a:avLst/>
            </a:prstTxWarp>
          </a:bodyPr>
          <a:lstStyle/>
          <a:p>
            <a:pPr lvl="0"/>
            <a:r>
              <a:rPr lang="en-US"/>
              <a:t>Insert slide title</a:t>
            </a:r>
          </a:p>
        </p:txBody>
      </p:sp>
      <p:sp>
        <p:nvSpPr>
          <p:cNvPr id="9" name="Text Placeholder 2">
            <a:extLst>
              <a:ext uri="{FF2B5EF4-FFF2-40B4-BE49-F238E27FC236}">
                <a16:creationId xmlns:a16="http://schemas.microsoft.com/office/drawing/2014/main" id="{DCFEABC9-8CBC-4BFF-A091-0B1175D7A66C}"/>
              </a:ext>
            </a:extLst>
          </p:cNvPr>
          <p:cNvSpPr>
            <a:spLocks noGrp="1"/>
          </p:cNvSpPr>
          <p:nvPr>
            <p:ph type="body" sz="quarter" idx="13" hasCustomPrompt="1"/>
          </p:nvPr>
        </p:nvSpPr>
        <p:spPr>
          <a:xfrm>
            <a:off x="360001" y="5939717"/>
            <a:ext cx="8326801" cy="416632"/>
          </a:xfrm>
        </p:spPr>
        <p:txBody>
          <a:bodyPr lIns="0" tIns="0" rIns="0" bIns="0"/>
          <a:lstStyle>
            <a:lvl1pPr marL="0" indent="0">
              <a:buNone/>
              <a:defRPr sz="750"/>
            </a:lvl1pPr>
          </a:lstStyle>
          <a:p>
            <a:pPr lvl="0"/>
            <a:r>
              <a:rPr lang="en-US"/>
              <a:t>* Include source</a:t>
            </a:r>
          </a:p>
        </p:txBody>
      </p:sp>
      <p:sp>
        <p:nvSpPr>
          <p:cNvPr id="10" name="Content Placeholder 3">
            <a:extLst>
              <a:ext uri="{FF2B5EF4-FFF2-40B4-BE49-F238E27FC236}">
                <a16:creationId xmlns:a16="http://schemas.microsoft.com/office/drawing/2014/main" id="{FC11E0B3-4BC6-4FDE-8A73-E95CF528DD93}"/>
              </a:ext>
            </a:extLst>
          </p:cNvPr>
          <p:cNvSpPr>
            <a:spLocks noGrp="1"/>
          </p:cNvSpPr>
          <p:nvPr>
            <p:ph sz="half" idx="14"/>
          </p:nvPr>
        </p:nvSpPr>
        <p:spPr>
          <a:xfrm>
            <a:off x="4746625" y="1359927"/>
            <a:ext cx="4038600" cy="4525963"/>
          </a:xfrm>
          <a:prstGeom prst="rect">
            <a:avLst/>
          </a:prstGeom>
        </p:spPr>
        <p:txBody>
          <a:bodyPr>
            <a:normAutofit/>
          </a:bodyPr>
          <a:lstStyle>
            <a:lvl1pPr>
              <a:defRPr sz="1800"/>
            </a:lvl1pPr>
            <a:lvl2pPr>
              <a:defRPr sz="1800"/>
            </a:lvl2pPr>
            <a:lvl3pPr>
              <a:defRPr sz="1800"/>
            </a:lvl3pPr>
            <a:lvl4pPr>
              <a:defRPr sz="1125"/>
            </a:lvl4pPr>
            <a:lvl5pPr>
              <a:defRPr sz="1125"/>
            </a:lvl5pPr>
            <a:lvl6pPr>
              <a:defRPr sz="1013"/>
            </a:lvl6pPr>
            <a:lvl7pPr>
              <a:defRPr sz="1013"/>
            </a:lvl7pPr>
            <a:lvl8pPr>
              <a:defRPr sz="1013"/>
            </a:lvl8pPr>
            <a:lvl9pPr>
              <a:defRPr sz="1013"/>
            </a:lvl9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184968977"/>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preserve="1" userDrawn="1">
  <p:cSld name="Title, Content and Chart">
    <p:spTree>
      <p:nvGrpSpPr>
        <p:cNvPr id="1" name=""/>
        <p:cNvGrpSpPr/>
        <p:nvPr/>
      </p:nvGrpSpPr>
      <p:grpSpPr>
        <a:xfrm>
          <a:off x="0" y="0"/>
          <a:ext cx="0" cy="0"/>
          <a:chOff x="0" y="0"/>
          <a:chExt cx="0" cy="0"/>
        </a:xfrm>
      </p:grpSpPr>
      <p:sp>
        <p:nvSpPr>
          <p:cNvPr id="6" name="Chart Placeholder 5"/>
          <p:cNvSpPr>
            <a:spLocks noGrp="1"/>
          </p:cNvSpPr>
          <p:nvPr>
            <p:ph type="chart" sz="quarter" idx="13"/>
          </p:nvPr>
        </p:nvSpPr>
        <p:spPr>
          <a:xfrm>
            <a:off x="358775" y="1360491"/>
            <a:ext cx="4038600" cy="4525399"/>
          </a:xfrm>
          <a:prstGeom prst="rect">
            <a:avLst/>
          </a:prstGeom>
        </p:spPr>
        <p:txBody>
          <a:bodyPr/>
          <a:lstStyle>
            <a:lvl1pPr marL="0" marR="0" indent="0" algn="l" defTabSz="257175" rtl="0" eaLnBrk="1" fontAlgn="auto" latinLnBrk="0" hangingPunct="1">
              <a:lnSpc>
                <a:spcPct val="100000"/>
              </a:lnSpc>
              <a:spcBef>
                <a:spcPct val="20000"/>
              </a:spcBef>
              <a:spcAft>
                <a:spcPts val="0"/>
              </a:spcAft>
              <a:buClrTx/>
              <a:buSzTx/>
              <a:buFont typeface="Lucida Grande"/>
              <a:buNone/>
              <a:tabLst/>
              <a:defRPr/>
            </a:lvl1pPr>
          </a:lstStyle>
          <a:p>
            <a:pPr lvl="0"/>
            <a:r>
              <a:rPr lang="en-US" noProof="0"/>
              <a:t>Click icon to add chart</a:t>
            </a:r>
          </a:p>
        </p:txBody>
      </p:sp>
      <p:sp>
        <p:nvSpPr>
          <p:cNvPr id="7" name="Title Placeholder 1">
            <a:extLst>
              <a:ext uri="{FF2B5EF4-FFF2-40B4-BE49-F238E27FC236}">
                <a16:creationId xmlns:a16="http://schemas.microsoft.com/office/drawing/2014/main" id="{A9E197AB-B83A-F542-A11A-CDE4241E8C70}"/>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0" tIns="0" rIns="0" bIns="0" numCol="1" anchor="t" anchorCtr="0" compatLnSpc="1">
            <a:prstTxWarp prst="textNoShape">
              <a:avLst/>
            </a:prstTxWarp>
          </a:bodyPr>
          <a:lstStyle/>
          <a:p>
            <a:pPr lvl="0"/>
            <a:r>
              <a:rPr lang="en-US"/>
              <a:t>Insert slide title</a:t>
            </a:r>
          </a:p>
        </p:txBody>
      </p:sp>
      <p:sp>
        <p:nvSpPr>
          <p:cNvPr id="8" name="Text Placeholder 2">
            <a:extLst>
              <a:ext uri="{FF2B5EF4-FFF2-40B4-BE49-F238E27FC236}">
                <a16:creationId xmlns:a16="http://schemas.microsoft.com/office/drawing/2014/main" id="{FDEF6A8B-FE55-424B-91EF-87F23AFF3A8E}"/>
              </a:ext>
            </a:extLst>
          </p:cNvPr>
          <p:cNvSpPr>
            <a:spLocks noGrp="1"/>
          </p:cNvSpPr>
          <p:nvPr>
            <p:ph type="body" sz="quarter" idx="14" hasCustomPrompt="1"/>
          </p:nvPr>
        </p:nvSpPr>
        <p:spPr>
          <a:xfrm>
            <a:off x="360001" y="5939717"/>
            <a:ext cx="8326801" cy="416632"/>
          </a:xfrm>
        </p:spPr>
        <p:txBody>
          <a:bodyPr lIns="0" tIns="0" rIns="0" bIns="0"/>
          <a:lstStyle>
            <a:lvl1pPr marL="0" indent="0">
              <a:buNone/>
              <a:defRPr sz="750"/>
            </a:lvl1pPr>
          </a:lstStyle>
          <a:p>
            <a:pPr lvl="0"/>
            <a:r>
              <a:rPr lang="en-US"/>
              <a:t>* Include source</a:t>
            </a:r>
          </a:p>
        </p:txBody>
      </p:sp>
      <p:sp>
        <p:nvSpPr>
          <p:cNvPr id="10" name="Content Placeholder 3">
            <a:extLst>
              <a:ext uri="{FF2B5EF4-FFF2-40B4-BE49-F238E27FC236}">
                <a16:creationId xmlns:a16="http://schemas.microsoft.com/office/drawing/2014/main" id="{FBDBDC34-494F-4FD9-8BD2-78F992CF9F94}"/>
              </a:ext>
            </a:extLst>
          </p:cNvPr>
          <p:cNvSpPr>
            <a:spLocks noGrp="1"/>
          </p:cNvSpPr>
          <p:nvPr>
            <p:ph sz="half" idx="15"/>
          </p:nvPr>
        </p:nvSpPr>
        <p:spPr>
          <a:xfrm>
            <a:off x="4746625" y="1359927"/>
            <a:ext cx="4038600" cy="4525963"/>
          </a:xfrm>
          <a:prstGeom prst="rect">
            <a:avLst/>
          </a:prstGeom>
        </p:spPr>
        <p:txBody>
          <a:bodyPr/>
          <a:lstStyle>
            <a:lvl1pPr>
              <a:defRPr sz="1800"/>
            </a:lvl1pPr>
            <a:lvl2pPr>
              <a:defRPr sz="1800"/>
            </a:lvl2pPr>
            <a:lvl3pPr>
              <a:defRPr sz="1800"/>
            </a:lvl3pPr>
            <a:lvl4pPr>
              <a:defRPr sz="1125"/>
            </a:lvl4pPr>
            <a:lvl5pPr>
              <a:defRPr sz="1125"/>
            </a:lvl5pPr>
            <a:lvl6pPr>
              <a:defRPr sz="1013"/>
            </a:lvl6pPr>
            <a:lvl7pPr>
              <a:defRPr sz="1013"/>
            </a:lvl7pPr>
            <a:lvl8pPr>
              <a:defRPr sz="1013"/>
            </a:lvl8pPr>
            <a:lvl9pPr>
              <a:defRPr sz="1013"/>
            </a:lvl9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248154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preserve="1" userDrawn="1">
  <p:cSld name="Title and Image">
    <p:spTree>
      <p:nvGrpSpPr>
        <p:cNvPr id="1" name=""/>
        <p:cNvGrpSpPr/>
        <p:nvPr/>
      </p:nvGrpSpPr>
      <p:grpSpPr>
        <a:xfrm>
          <a:off x="0" y="0"/>
          <a:ext cx="0" cy="0"/>
          <a:chOff x="0" y="0"/>
          <a:chExt cx="0" cy="0"/>
        </a:xfrm>
      </p:grpSpPr>
      <p:sp>
        <p:nvSpPr>
          <p:cNvPr id="5" name="Picture Placeholder 4"/>
          <p:cNvSpPr>
            <a:spLocks noGrp="1"/>
          </p:cNvSpPr>
          <p:nvPr>
            <p:ph type="pic" sz="quarter" idx="10"/>
          </p:nvPr>
        </p:nvSpPr>
        <p:spPr>
          <a:xfrm>
            <a:off x="358774" y="1358904"/>
            <a:ext cx="8426450" cy="4767263"/>
          </a:xfrm>
          <a:prstGeom prst="rect">
            <a:avLst/>
          </a:prstGeom>
        </p:spPr>
        <p:txBody>
          <a:bodyPr anchor="ctr" anchorCtr="1"/>
          <a:lstStyle>
            <a:lvl1pPr marL="0" indent="0" algn="ctr">
              <a:buNone/>
              <a:defRPr baseline="0"/>
            </a:lvl1pPr>
          </a:lstStyle>
          <a:p>
            <a:pPr lvl="0"/>
            <a:r>
              <a:rPr lang="en-US" noProof="0"/>
              <a:t>Click icon to add picture</a:t>
            </a:r>
          </a:p>
        </p:txBody>
      </p:sp>
      <p:sp>
        <p:nvSpPr>
          <p:cNvPr id="4" name="Title Placeholder 1">
            <a:extLst>
              <a:ext uri="{FF2B5EF4-FFF2-40B4-BE49-F238E27FC236}">
                <a16:creationId xmlns:a16="http://schemas.microsoft.com/office/drawing/2014/main" id="{716DB442-97F9-2241-AE70-FE1000B8FF4F}"/>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0" tIns="0" rIns="0" bIns="0" numCol="1" anchor="t" anchorCtr="0" compatLnSpc="1">
            <a:prstTxWarp prst="textNoShape">
              <a:avLst/>
            </a:prstTxWarp>
          </a:bodyPr>
          <a:lstStyle/>
          <a:p>
            <a:pPr lvl="0"/>
            <a:r>
              <a:rPr lang="en-US"/>
              <a:t>Insert slide title</a:t>
            </a:r>
          </a:p>
        </p:txBody>
      </p:sp>
    </p:spTree>
    <p:extLst>
      <p:ext uri="{BB962C8B-B14F-4D97-AF65-F5344CB8AC3E}">
        <p14:creationId xmlns:p14="http://schemas.microsoft.com/office/powerpoint/2010/main" val="29112261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1_Title slide – Red option 2">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C6464A0A-2E52-4325-8E9A-4FE513E8B588}"/>
              </a:ext>
            </a:extLst>
          </p:cNvPr>
          <p:cNvSpPr/>
          <p:nvPr userDrawn="1"/>
        </p:nvSpPr>
        <p:spPr>
          <a:xfrm>
            <a:off x="1"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4" name="Picture 13" descr="A close up of a logo&#10;&#10;Description automatically generated">
            <a:extLst>
              <a:ext uri="{FF2B5EF4-FFF2-40B4-BE49-F238E27FC236}">
                <a16:creationId xmlns:a16="http://schemas.microsoft.com/office/drawing/2014/main" id="{B1AC6F61-871E-4989-A8F8-D6803736596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9" name="Picture 8" descr="A picture containing outdoor, tree, sky, grass&#10;&#10;Description automatically generated">
            <a:extLst>
              <a:ext uri="{FF2B5EF4-FFF2-40B4-BE49-F238E27FC236}">
                <a16:creationId xmlns:a16="http://schemas.microsoft.com/office/drawing/2014/main" id="{FD846324-0975-4A42-9910-97B18EAE44BA}"/>
              </a:ext>
            </a:extLst>
          </p:cNvPr>
          <p:cNvPicPr>
            <a:picLocks noChangeAspect="1"/>
          </p:cNvPicPr>
          <p:nvPr userDrawn="1"/>
        </p:nvPicPr>
        <p:blipFill>
          <a:blip r:embed="rId3" cstate="email">
            <a:extLst>
              <a:ext uri="{28A0092B-C50C-407E-A947-70E740481C1C}">
                <a14:useLocalDpi xmlns:a14="http://schemas.microsoft.com/office/drawing/2010/main"/>
              </a:ext>
            </a:extLst>
          </a:blip>
          <a:stretch>
            <a:fillRect/>
          </a:stretch>
        </p:blipFill>
        <p:spPr>
          <a:xfrm>
            <a:off x="4567772" y="0"/>
            <a:ext cx="4567509" cy="6858000"/>
          </a:xfrm>
          <a:prstGeom prst="rect">
            <a:avLst/>
          </a:prstGeom>
        </p:spPr>
      </p:pic>
      <p:sp>
        <p:nvSpPr>
          <p:cNvPr id="7" name="Title 8">
            <a:extLst>
              <a:ext uri="{FF2B5EF4-FFF2-40B4-BE49-F238E27FC236}">
                <a16:creationId xmlns:a16="http://schemas.microsoft.com/office/drawing/2014/main" id="{01B2F048-E8FC-8A4E-8DDE-647F5445BFE9}"/>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11" name="Text Placeholder 4">
            <a:extLst>
              <a:ext uri="{FF2B5EF4-FFF2-40B4-BE49-F238E27FC236}">
                <a16:creationId xmlns:a16="http://schemas.microsoft.com/office/drawing/2014/main" id="{A0F5EAC1-9F73-5641-AB32-0ED689CDEEB3}"/>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964749844"/>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userDrawn="1">
  <p:cSld name="Title Only">
    <p:spTree>
      <p:nvGrpSpPr>
        <p:cNvPr id="1" name=""/>
        <p:cNvGrpSpPr/>
        <p:nvPr/>
      </p:nvGrpSpPr>
      <p:grpSpPr>
        <a:xfrm>
          <a:off x="0" y="0"/>
          <a:ext cx="0" cy="0"/>
          <a:chOff x="0" y="0"/>
          <a:chExt cx="0" cy="0"/>
        </a:xfrm>
      </p:grpSpPr>
      <p:sp>
        <p:nvSpPr>
          <p:cNvPr id="3" name="Title Placeholder 1">
            <a:extLst>
              <a:ext uri="{FF2B5EF4-FFF2-40B4-BE49-F238E27FC236}">
                <a16:creationId xmlns:a16="http://schemas.microsoft.com/office/drawing/2014/main" id="{861D717C-1AC4-394E-91B8-A016BB12DA1B}"/>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0" tIns="0" rIns="0" bIns="0" numCol="1" anchor="t" anchorCtr="0" compatLnSpc="1">
            <a:prstTxWarp prst="textNoShape">
              <a:avLst/>
            </a:prstTxWarp>
          </a:bodyPr>
          <a:lstStyle/>
          <a:p>
            <a:pPr lvl="0"/>
            <a:r>
              <a:rPr lang="en-US"/>
              <a:t>Insert slide title</a:t>
            </a:r>
          </a:p>
        </p:txBody>
      </p:sp>
    </p:spTree>
    <p:extLst>
      <p:ext uri="{BB962C8B-B14F-4D97-AF65-F5344CB8AC3E}">
        <p14:creationId xmlns:p14="http://schemas.microsoft.com/office/powerpoint/2010/main" val="1105528143"/>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preserve="1" userDrawn="1">
  <p:cSld name="Section Divider - Option 1">
    <p:spTree>
      <p:nvGrpSpPr>
        <p:cNvPr id="1" name=""/>
        <p:cNvGrpSpPr/>
        <p:nvPr/>
      </p:nvGrpSpPr>
      <p:grpSpPr>
        <a:xfrm>
          <a:off x="0" y="0"/>
          <a:ext cx="0" cy="0"/>
          <a:chOff x="0" y="0"/>
          <a:chExt cx="0" cy="0"/>
        </a:xfrm>
      </p:grpSpPr>
      <p:pic>
        <p:nvPicPr>
          <p:cNvPr id="8" name="Picture 7" descr="USY_MB1_PMS_1_Colour_Reversed_Logo.png"/>
          <p:cNvPicPr>
            <a:picLocks noChangeAspect="1"/>
          </p:cNvPicPr>
          <p:nvPr/>
        </p:nvPicPr>
        <p:blipFill>
          <a:blip r:embed="rId2" cstate="email">
            <a:extLst>
              <a:ext uri="{28A0092B-C50C-407E-A947-70E740481C1C}">
                <a14:useLocalDpi xmlns:a14="http://schemas.microsoft.com/office/drawing/2010/main"/>
              </a:ext>
            </a:extLst>
          </a:blip>
          <a:srcRect/>
          <a:stretch>
            <a:fillRect/>
          </a:stretch>
        </p:blipFill>
        <p:spPr bwMode="auto">
          <a:xfrm>
            <a:off x="454026" y="5905503"/>
            <a:ext cx="1536700" cy="5302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5" name="Text Placeholder 4"/>
          <p:cNvSpPr>
            <a:spLocks noGrp="1"/>
          </p:cNvSpPr>
          <p:nvPr>
            <p:ph type="body" sz="quarter" idx="11"/>
          </p:nvPr>
        </p:nvSpPr>
        <p:spPr>
          <a:xfrm>
            <a:off x="358776" y="1173220"/>
            <a:ext cx="8426450" cy="647183"/>
          </a:xfrm>
          <a:prstGeom prst="rect">
            <a:avLst/>
          </a:prstGeom>
          <a:noFill/>
        </p:spPr>
        <p:txBody>
          <a:bodyPr/>
          <a:lstStyle>
            <a:lvl1pPr marL="0" indent="0">
              <a:lnSpc>
                <a:spcPct val="90000"/>
              </a:lnSpc>
              <a:buNone/>
              <a:defRPr sz="1800">
                <a:solidFill>
                  <a:schemeClr val="tx1"/>
                </a:solidFill>
              </a:defRPr>
            </a:lvl1pPr>
            <a:lvl2pPr marL="257175" indent="0">
              <a:buNone/>
              <a:defRPr/>
            </a:lvl2pPr>
            <a:lvl3pPr marL="514350" indent="0">
              <a:buNone/>
              <a:defRPr/>
            </a:lvl3pPr>
            <a:lvl4pPr marL="771525" indent="0">
              <a:buNone/>
              <a:defRPr/>
            </a:lvl4pPr>
            <a:lvl5pPr marL="1028700" indent="0">
              <a:buNone/>
              <a:defRPr/>
            </a:lvl5pPr>
          </a:lstStyle>
          <a:p>
            <a:pPr lvl="0"/>
            <a:r>
              <a:rPr lang="en-US"/>
              <a:t>Click to edit Master text styles</a:t>
            </a:r>
          </a:p>
        </p:txBody>
      </p:sp>
      <p:sp>
        <p:nvSpPr>
          <p:cNvPr id="7" name="Picture Placeholder 13"/>
          <p:cNvSpPr>
            <a:spLocks noGrp="1"/>
          </p:cNvSpPr>
          <p:nvPr>
            <p:ph type="pic" sz="quarter" idx="12"/>
          </p:nvPr>
        </p:nvSpPr>
        <p:spPr>
          <a:xfrm>
            <a:off x="358776" y="1820402"/>
            <a:ext cx="8426450" cy="4535949"/>
          </a:xfrm>
          <a:prstGeom prst="rect">
            <a:avLst/>
          </a:prstGeom>
          <a:solidFill>
            <a:srgbClr val="D9D9D9"/>
          </a:solidFill>
        </p:spPr>
        <p:txBody>
          <a:bodyPr anchor="ctr" anchorCtr="0"/>
          <a:lstStyle>
            <a:lvl1pPr marL="0" indent="0" algn="ctr">
              <a:buNone/>
              <a:defRPr/>
            </a:lvl1pPr>
          </a:lstStyle>
          <a:p>
            <a:pPr lvl="0"/>
            <a:r>
              <a:rPr lang="en-US" noProof="0"/>
              <a:t>Click icon to add picture</a:t>
            </a:r>
          </a:p>
        </p:txBody>
      </p:sp>
      <p:sp>
        <p:nvSpPr>
          <p:cNvPr id="10" name="Title Placeholder 1">
            <a:extLst>
              <a:ext uri="{FF2B5EF4-FFF2-40B4-BE49-F238E27FC236}">
                <a16:creationId xmlns:a16="http://schemas.microsoft.com/office/drawing/2014/main" id="{8AB9FAD1-F758-AF4C-BAD5-AFAD67046B97}"/>
              </a:ext>
            </a:extLst>
          </p:cNvPr>
          <p:cNvSpPr>
            <a:spLocks noGrp="1"/>
          </p:cNvSpPr>
          <p:nvPr>
            <p:ph type="title" hasCustomPrompt="1"/>
          </p:nvPr>
        </p:nvSpPr>
        <p:spPr bwMode="auto">
          <a:xfrm>
            <a:off x="358776" y="501653"/>
            <a:ext cx="8426450" cy="6471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0" tIns="0" rIns="0" bIns="0" numCol="1" anchor="t" anchorCtr="0" compatLnSpc="1">
            <a:prstTxWarp prst="textNoShape">
              <a:avLst/>
            </a:prstTxWarp>
          </a:bodyPr>
          <a:lstStyle/>
          <a:p>
            <a:pPr lvl="0"/>
            <a:r>
              <a:rPr lang="en-US"/>
              <a:t>Insert slide title</a:t>
            </a:r>
          </a:p>
        </p:txBody>
      </p:sp>
    </p:spTree>
    <p:extLst>
      <p:ext uri="{BB962C8B-B14F-4D97-AF65-F5344CB8AC3E}">
        <p14:creationId xmlns:p14="http://schemas.microsoft.com/office/powerpoint/2010/main" val="397070450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preserve="1" userDrawn="1">
  <p:cSld name="1_Section Divider - Option 2">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C4382753-51C7-0C46-B853-1DBA86E4E953}"/>
              </a:ext>
            </a:extLst>
          </p:cNvPr>
          <p:cNvSpPr/>
          <p:nvPr userDrawn="1"/>
        </p:nvSpPr>
        <p:spPr>
          <a:xfrm>
            <a:off x="0" y="0"/>
            <a:ext cx="9144000" cy="6858000"/>
          </a:xfrm>
          <a:prstGeom prst="rect">
            <a:avLst/>
          </a:prstGeom>
          <a:solidFill>
            <a:schemeClr val="tx2"/>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sp>
        <p:nvSpPr>
          <p:cNvPr id="8" name="Title 8">
            <a:extLst>
              <a:ext uri="{FF2B5EF4-FFF2-40B4-BE49-F238E27FC236}">
                <a16:creationId xmlns:a16="http://schemas.microsoft.com/office/drawing/2014/main" id="{F6164CB4-EC8E-0144-9230-9A41AA8066A6}"/>
              </a:ext>
            </a:extLst>
          </p:cNvPr>
          <p:cNvSpPr>
            <a:spLocks noGrp="1"/>
          </p:cNvSpPr>
          <p:nvPr>
            <p:ph type="title" hasCustomPrompt="1"/>
          </p:nvPr>
        </p:nvSpPr>
        <p:spPr>
          <a:xfrm>
            <a:off x="381885" y="1617084"/>
            <a:ext cx="8407184" cy="708607"/>
          </a:xfrm>
        </p:spPr>
        <p:txBody>
          <a:bodyPr anchor="t"/>
          <a:lstStyle>
            <a:lvl1pPr algn="l">
              <a:defRPr sz="2250">
                <a:solidFill>
                  <a:schemeClr val="bg1"/>
                </a:solidFill>
              </a:defRPr>
            </a:lvl1pPr>
          </a:lstStyle>
          <a:p>
            <a:r>
              <a:rPr lang="en-US"/>
              <a:t>Title heading here</a:t>
            </a:r>
          </a:p>
        </p:txBody>
      </p:sp>
      <p:sp>
        <p:nvSpPr>
          <p:cNvPr id="10" name="Text Placeholder 4">
            <a:extLst>
              <a:ext uri="{FF2B5EF4-FFF2-40B4-BE49-F238E27FC236}">
                <a16:creationId xmlns:a16="http://schemas.microsoft.com/office/drawing/2014/main" id="{C7C3DC85-C5E4-9F4F-9A53-A30541465834}"/>
              </a:ext>
            </a:extLst>
          </p:cNvPr>
          <p:cNvSpPr>
            <a:spLocks noGrp="1"/>
          </p:cNvSpPr>
          <p:nvPr>
            <p:ph type="body" sz="quarter" idx="13" hasCustomPrompt="1"/>
          </p:nvPr>
        </p:nvSpPr>
        <p:spPr>
          <a:xfrm>
            <a:off x="382767" y="2469571"/>
            <a:ext cx="8406302" cy="708607"/>
          </a:xfrm>
        </p:spPr>
        <p:txBody>
          <a:bodyPr lIns="0" tIns="0" rIns="0" bIns="0"/>
          <a:lstStyle>
            <a:lvl1pPr marL="0" indent="0" algn="l">
              <a:lnSpc>
                <a:spcPct val="90000"/>
              </a:lnSpc>
              <a:buNone/>
              <a:defRPr sz="1800">
                <a:solidFill>
                  <a:schemeClr val="bg1"/>
                </a:solidFill>
              </a:defRPr>
            </a:lvl1pPr>
            <a:lvl2pPr marL="342900" indent="0">
              <a:buNone/>
              <a:defRPr/>
            </a:lvl2pPr>
            <a:lvl3pPr marL="685800" indent="0">
              <a:buNone/>
              <a:defRPr/>
            </a:lvl3pPr>
            <a:lvl4pPr marL="1028700" indent="0">
              <a:buNone/>
              <a:defRPr/>
            </a:lvl4pPr>
            <a:lvl5pPr marL="1371600" indent="0">
              <a:buNone/>
              <a:defRPr/>
            </a:lvl5pPr>
          </a:lstStyle>
          <a:p>
            <a:pPr lvl="0"/>
            <a:r>
              <a:rPr lang="en-US"/>
              <a:t>Presented by</a:t>
            </a:r>
          </a:p>
        </p:txBody>
      </p:sp>
      <p:pic>
        <p:nvPicPr>
          <p:cNvPr id="9" name="Picture 8">
            <a:extLst>
              <a:ext uri="{FF2B5EF4-FFF2-40B4-BE49-F238E27FC236}">
                <a16:creationId xmlns:a16="http://schemas.microsoft.com/office/drawing/2014/main" id="{C4F743E6-42C8-45D8-A63F-90FE0651F22C}"/>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70801" y="5540400"/>
            <a:ext cx="1515237" cy="520700"/>
          </a:xfrm>
          <a:prstGeom prst="rect">
            <a:avLst/>
          </a:prstGeom>
        </p:spPr>
      </p:pic>
    </p:spTree>
    <p:extLst>
      <p:ext uri="{BB962C8B-B14F-4D97-AF65-F5344CB8AC3E}">
        <p14:creationId xmlns:p14="http://schemas.microsoft.com/office/powerpoint/2010/main" val="3080657027"/>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preserve="1" userDrawn="1">
  <p:cSld name="Section Divider - Option 3">
    <p:spTree>
      <p:nvGrpSpPr>
        <p:cNvPr id="1" name=""/>
        <p:cNvGrpSpPr/>
        <p:nvPr/>
      </p:nvGrpSpPr>
      <p:grpSpPr>
        <a:xfrm>
          <a:off x="0" y="0"/>
          <a:ext cx="0" cy="0"/>
          <a:chOff x="0" y="0"/>
          <a:chExt cx="0" cy="0"/>
        </a:xfrm>
      </p:grpSpPr>
      <p:sp>
        <p:nvSpPr>
          <p:cNvPr id="13" name="Rectangle 12">
            <a:extLst>
              <a:ext uri="{FF2B5EF4-FFF2-40B4-BE49-F238E27FC236}">
                <a16:creationId xmlns:a16="http://schemas.microsoft.com/office/drawing/2014/main" id="{CF277205-D819-0E49-850F-A3DCF077A5B8}"/>
              </a:ext>
            </a:extLst>
          </p:cNvPr>
          <p:cNvSpPr/>
          <p:nvPr userDrawn="1"/>
        </p:nvSpPr>
        <p:spPr>
          <a:xfrm>
            <a:off x="0" y="0"/>
            <a:ext cx="9144000" cy="6858000"/>
          </a:xfrm>
          <a:prstGeom prst="rect">
            <a:avLst/>
          </a:prstGeom>
          <a:solidFill>
            <a:srgbClr val="FFB800"/>
          </a:solidFill>
          <a:ln w="9525" cap="flat" cmpd="sng" algn="ctr">
            <a:noFill/>
            <a:prstDash val="solid"/>
          </a:ln>
          <a:effectLst/>
        </p:spPr>
        <p:txBody>
          <a:bodyPr anchor="ctr"/>
          <a:lstStyle/>
          <a:p>
            <a:pPr marL="0" marR="0" lvl="0" indent="0" algn="ctr" defTabSz="685800"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prstClr val="white"/>
              </a:solidFill>
              <a:effectLst/>
              <a:uLnTx/>
              <a:uFillTx/>
              <a:latin typeface="Arial" panose="020B0604020202020204"/>
              <a:ea typeface="+mn-ea"/>
              <a:cs typeface="+mn-cs"/>
            </a:endParaRPr>
          </a:p>
        </p:txBody>
      </p:sp>
      <p:sp>
        <p:nvSpPr>
          <p:cNvPr id="7" name="Title 8">
            <a:extLst>
              <a:ext uri="{FF2B5EF4-FFF2-40B4-BE49-F238E27FC236}">
                <a16:creationId xmlns:a16="http://schemas.microsoft.com/office/drawing/2014/main" id="{C20D03EA-04EC-3E4D-A8DD-25B0B1CFB907}"/>
              </a:ext>
            </a:extLst>
          </p:cNvPr>
          <p:cNvSpPr>
            <a:spLocks noGrp="1"/>
          </p:cNvSpPr>
          <p:nvPr>
            <p:ph type="title" hasCustomPrompt="1"/>
          </p:nvPr>
        </p:nvSpPr>
        <p:spPr>
          <a:xfrm>
            <a:off x="381885" y="1617084"/>
            <a:ext cx="8407184" cy="708607"/>
          </a:xfrm>
        </p:spPr>
        <p:txBody>
          <a:bodyPr anchor="t"/>
          <a:lstStyle>
            <a:lvl1pPr algn="l">
              <a:defRPr sz="2250">
                <a:solidFill>
                  <a:schemeClr val="tx1"/>
                </a:solidFill>
              </a:defRPr>
            </a:lvl1pPr>
          </a:lstStyle>
          <a:p>
            <a:r>
              <a:rPr lang="en-US"/>
              <a:t>Title heading here</a:t>
            </a:r>
          </a:p>
        </p:txBody>
      </p:sp>
      <p:sp>
        <p:nvSpPr>
          <p:cNvPr id="8" name="Text Placeholder 4">
            <a:extLst>
              <a:ext uri="{FF2B5EF4-FFF2-40B4-BE49-F238E27FC236}">
                <a16:creationId xmlns:a16="http://schemas.microsoft.com/office/drawing/2014/main" id="{77BCA0C8-FD5B-AE4C-9999-548657AE139B}"/>
              </a:ext>
            </a:extLst>
          </p:cNvPr>
          <p:cNvSpPr>
            <a:spLocks noGrp="1"/>
          </p:cNvSpPr>
          <p:nvPr>
            <p:ph type="body" sz="quarter" idx="13" hasCustomPrompt="1"/>
          </p:nvPr>
        </p:nvSpPr>
        <p:spPr>
          <a:xfrm>
            <a:off x="382767" y="2469567"/>
            <a:ext cx="8406302" cy="710400"/>
          </a:xfrm>
        </p:spPr>
        <p:txBody>
          <a:bodyPr lIns="0" tIns="0" rIns="0" bIns="0"/>
          <a:lstStyle>
            <a:lvl1pPr marL="0" indent="0" algn="l">
              <a:lnSpc>
                <a:spcPct val="90000"/>
              </a:lnSpc>
              <a:buNone/>
              <a:defRPr sz="1800">
                <a:solidFill>
                  <a:srgbClr val="000000"/>
                </a:solidFill>
              </a:defRPr>
            </a:lvl1pPr>
            <a:lvl2pPr marL="342900" indent="0">
              <a:buNone/>
              <a:defRPr/>
            </a:lvl2pPr>
            <a:lvl3pPr marL="685800" indent="0">
              <a:buNone/>
              <a:defRPr/>
            </a:lvl3pPr>
            <a:lvl4pPr marL="1028700" indent="0">
              <a:buNone/>
              <a:defRPr/>
            </a:lvl4pPr>
            <a:lvl5pPr marL="1371600" indent="0">
              <a:buNone/>
              <a:defRPr/>
            </a:lvl5pPr>
          </a:lstStyle>
          <a:p>
            <a:pPr lvl="0"/>
            <a:r>
              <a:rPr lang="en-US"/>
              <a:t>Presented by</a:t>
            </a:r>
          </a:p>
        </p:txBody>
      </p:sp>
      <p:pic>
        <p:nvPicPr>
          <p:cNvPr id="9" name="Picture 8" descr="A close up of a logo&#10;&#10;Description automatically generated">
            <a:extLst>
              <a:ext uri="{FF2B5EF4-FFF2-40B4-BE49-F238E27FC236}">
                <a16:creationId xmlns:a16="http://schemas.microsoft.com/office/drawing/2014/main" id="{2C89BC04-6416-479F-AF58-1E9563CF6521}"/>
              </a:ext>
            </a:extLst>
          </p:cNvPr>
          <p:cNvPicPr>
            <a:picLocks noChangeAspect="1"/>
          </p:cNvPicPr>
          <p:nvPr userDrawn="1"/>
        </p:nvPicPr>
        <p:blipFill rotWithShape="1">
          <a:blip r:embed="rId2" cstate="email">
            <a:extLst>
              <a:ext uri="{28A0092B-C50C-407E-A947-70E740481C1C}">
                <a14:useLocalDpi xmlns:a14="http://schemas.microsoft.com/office/drawing/2010/main"/>
              </a:ext>
            </a:extLst>
          </a:blip>
          <a:srcRect/>
          <a:stretch/>
        </p:blipFill>
        <p:spPr>
          <a:xfrm>
            <a:off x="340770" y="5540402"/>
            <a:ext cx="1561864" cy="549253"/>
          </a:xfrm>
          <a:prstGeom prst="rect">
            <a:avLst/>
          </a:prstGeom>
        </p:spPr>
      </p:pic>
    </p:spTree>
    <p:extLst>
      <p:ext uri="{BB962C8B-B14F-4D97-AF65-F5344CB8AC3E}">
        <p14:creationId xmlns:p14="http://schemas.microsoft.com/office/powerpoint/2010/main" val="1621695405"/>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preserve="1" userDrawn="1">
  <p:cSld name="Section Divider - Option 4">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21437180-96FB-744F-865F-A5F1DCF5F20E}"/>
              </a:ext>
            </a:extLst>
          </p:cNvPr>
          <p:cNvSpPr/>
          <p:nvPr userDrawn="1"/>
        </p:nvSpPr>
        <p:spPr>
          <a:xfrm>
            <a:off x="0" y="0"/>
            <a:ext cx="9144000" cy="6858000"/>
          </a:xfrm>
          <a:prstGeom prst="rect">
            <a:avLst/>
          </a:prstGeom>
          <a:solidFill>
            <a:srgbClr val="343433"/>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350"/>
          </a:p>
        </p:txBody>
      </p:sp>
      <p:sp>
        <p:nvSpPr>
          <p:cNvPr id="13" name="Title 8">
            <a:extLst>
              <a:ext uri="{FF2B5EF4-FFF2-40B4-BE49-F238E27FC236}">
                <a16:creationId xmlns:a16="http://schemas.microsoft.com/office/drawing/2014/main" id="{378A92A4-48B7-0340-8B92-C0F9AC1FDA6C}"/>
              </a:ext>
            </a:extLst>
          </p:cNvPr>
          <p:cNvSpPr>
            <a:spLocks noGrp="1"/>
          </p:cNvSpPr>
          <p:nvPr>
            <p:ph type="title" hasCustomPrompt="1"/>
          </p:nvPr>
        </p:nvSpPr>
        <p:spPr>
          <a:xfrm>
            <a:off x="381885" y="1617084"/>
            <a:ext cx="8407184" cy="708607"/>
          </a:xfrm>
        </p:spPr>
        <p:txBody>
          <a:bodyPr anchor="t"/>
          <a:lstStyle>
            <a:lvl1pPr algn="l">
              <a:defRPr sz="2250">
                <a:solidFill>
                  <a:schemeClr val="bg1"/>
                </a:solidFill>
              </a:defRPr>
            </a:lvl1pPr>
          </a:lstStyle>
          <a:p>
            <a:r>
              <a:rPr lang="en-US"/>
              <a:t>Title heading here</a:t>
            </a:r>
          </a:p>
        </p:txBody>
      </p:sp>
      <p:sp>
        <p:nvSpPr>
          <p:cNvPr id="14" name="Text Placeholder 4">
            <a:extLst>
              <a:ext uri="{FF2B5EF4-FFF2-40B4-BE49-F238E27FC236}">
                <a16:creationId xmlns:a16="http://schemas.microsoft.com/office/drawing/2014/main" id="{55933010-02AF-864A-B29C-468E3DDEEA5E}"/>
              </a:ext>
            </a:extLst>
          </p:cNvPr>
          <p:cNvSpPr>
            <a:spLocks noGrp="1"/>
          </p:cNvSpPr>
          <p:nvPr>
            <p:ph type="body" sz="quarter" idx="13" hasCustomPrompt="1"/>
          </p:nvPr>
        </p:nvSpPr>
        <p:spPr>
          <a:xfrm>
            <a:off x="382767" y="2469571"/>
            <a:ext cx="8406302" cy="708607"/>
          </a:xfrm>
        </p:spPr>
        <p:txBody>
          <a:bodyPr lIns="0" tIns="0" rIns="0" bIns="0"/>
          <a:lstStyle>
            <a:lvl1pPr marL="0" indent="0" algn="l">
              <a:lnSpc>
                <a:spcPct val="90000"/>
              </a:lnSpc>
              <a:buNone/>
              <a:defRPr sz="1800">
                <a:solidFill>
                  <a:schemeClr val="bg1"/>
                </a:solidFill>
              </a:defRPr>
            </a:lvl1pPr>
            <a:lvl2pPr marL="342900" indent="0">
              <a:buNone/>
              <a:defRPr/>
            </a:lvl2pPr>
            <a:lvl3pPr marL="685800" indent="0">
              <a:buNone/>
              <a:defRPr/>
            </a:lvl3pPr>
            <a:lvl4pPr marL="1028700" indent="0">
              <a:buNone/>
              <a:defRPr/>
            </a:lvl4pPr>
            <a:lvl5pPr marL="1371600" indent="0">
              <a:buNone/>
              <a:defRPr/>
            </a:lvl5pPr>
          </a:lstStyle>
          <a:p>
            <a:pPr lvl="0"/>
            <a:r>
              <a:rPr lang="en-US"/>
              <a:t>Presented by</a:t>
            </a:r>
          </a:p>
        </p:txBody>
      </p:sp>
      <p:pic>
        <p:nvPicPr>
          <p:cNvPr id="7" name="Picture 6">
            <a:extLst>
              <a:ext uri="{FF2B5EF4-FFF2-40B4-BE49-F238E27FC236}">
                <a16:creationId xmlns:a16="http://schemas.microsoft.com/office/drawing/2014/main" id="{A8B4EEB1-42E3-41C0-B7C0-8A0DC6F52F0A}"/>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370801" y="5540400"/>
            <a:ext cx="1515237" cy="520700"/>
          </a:xfrm>
          <a:prstGeom prst="rect">
            <a:avLst/>
          </a:prstGeom>
        </p:spPr>
      </p:pic>
    </p:spTree>
    <p:extLst>
      <p:ext uri="{BB962C8B-B14F-4D97-AF65-F5344CB8AC3E}">
        <p14:creationId xmlns:p14="http://schemas.microsoft.com/office/powerpoint/2010/main" val="2751367391"/>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userDrawn="1">
  <p:cSld name="Double heading and text boxes">
    <p:spTree>
      <p:nvGrpSpPr>
        <p:cNvPr id="1" name=""/>
        <p:cNvGrpSpPr/>
        <p:nvPr/>
      </p:nvGrpSpPr>
      <p:grpSpPr>
        <a:xfrm>
          <a:off x="0" y="0"/>
          <a:ext cx="0" cy="0"/>
          <a:chOff x="0" y="0"/>
          <a:chExt cx="0" cy="0"/>
        </a:xfrm>
      </p:grpSpPr>
      <p:sp>
        <p:nvSpPr>
          <p:cNvPr id="32" name="Text Placeholder 3">
            <a:extLst>
              <a:ext uri="{FF2B5EF4-FFF2-40B4-BE49-F238E27FC236}">
                <a16:creationId xmlns:a16="http://schemas.microsoft.com/office/drawing/2014/main" id="{AFDB2844-75A1-F046-B436-56BA099D686A}"/>
              </a:ext>
            </a:extLst>
          </p:cNvPr>
          <p:cNvSpPr>
            <a:spLocks noGrp="1"/>
          </p:cNvSpPr>
          <p:nvPr>
            <p:ph type="body" sz="quarter" idx="10" hasCustomPrompt="1"/>
          </p:nvPr>
        </p:nvSpPr>
        <p:spPr>
          <a:xfrm>
            <a:off x="359733" y="1324803"/>
            <a:ext cx="8425492" cy="740833"/>
          </a:xfrm>
        </p:spPr>
        <p:txBody>
          <a:bodyPr lIns="0" tIns="0" rIns="0" bIns="0"/>
          <a:lstStyle>
            <a:lvl1pPr marL="0" indent="0">
              <a:buNone/>
              <a:defRPr>
                <a:solidFill>
                  <a:srgbClr val="343433"/>
                </a:solidFill>
              </a:defRPr>
            </a:lvl1pPr>
          </a:lstStyle>
          <a:p>
            <a:pPr lvl="0"/>
            <a:r>
              <a:rPr lang="en-US"/>
              <a:t>Intro copy here</a:t>
            </a:r>
          </a:p>
        </p:txBody>
      </p:sp>
      <p:sp>
        <p:nvSpPr>
          <p:cNvPr id="2" name="Title 1">
            <a:extLst>
              <a:ext uri="{FF2B5EF4-FFF2-40B4-BE49-F238E27FC236}">
                <a16:creationId xmlns:a16="http://schemas.microsoft.com/office/drawing/2014/main" id="{FEB964E3-FECD-244F-9F6D-E57C8736B6CF}"/>
              </a:ext>
            </a:extLst>
          </p:cNvPr>
          <p:cNvSpPr>
            <a:spLocks noGrp="1"/>
          </p:cNvSpPr>
          <p:nvPr>
            <p:ph type="title"/>
          </p:nvPr>
        </p:nvSpPr>
        <p:spPr/>
        <p:txBody>
          <a:bodyPr/>
          <a:lstStyle/>
          <a:p>
            <a:r>
              <a:rPr lang="en-US"/>
              <a:t>Click to edit Master title style</a:t>
            </a:r>
          </a:p>
        </p:txBody>
      </p:sp>
      <p:sp>
        <p:nvSpPr>
          <p:cNvPr id="14" name="Text Placeholder 3">
            <a:extLst>
              <a:ext uri="{FF2B5EF4-FFF2-40B4-BE49-F238E27FC236}">
                <a16:creationId xmlns:a16="http://schemas.microsoft.com/office/drawing/2014/main" id="{A9A5A20B-A3A8-0644-8A24-864C592BB1ED}"/>
              </a:ext>
            </a:extLst>
          </p:cNvPr>
          <p:cNvSpPr>
            <a:spLocks noGrp="1"/>
          </p:cNvSpPr>
          <p:nvPr>
            <p:ph type="body" sz="quarter" idx="17" hasCustomPrompt="1"/>
          </p:nvPr>
        </p:nvSpPr>
        <p:spPr>
          <a:xfrm>
            <a:off x="2527512" y="3924303"/>
            <a:ext cx="1920240" cy="1894417"/>
          </a:xfrm>
        </p:spPr>
        <p:txBody>
          <a:bodyPr/>
          <a:lstStyle/>
          <a:p>
            <a:pPr lvl="0"/>
            <a:r>
              <a:rPr lang="en-US"/>
              <a:t>Insert text</a:t>
            </a:r>
          </a:p>
        </p:txBody>
      </p:sp>
      <p:sp>
        <p:nvSpPr>
          <p:cNvPr id="19" name="Text Placeholder 3">
            <a:extLst>
              <a:ext uri="{FF2B5EF4-FFF2-40B4-BE49-F238E27FC236}">
                <a16:creationId xmlns:a16="http://schemas.microsoft.com/office/drawing/2014/main" id="{E6C428A3-703E-5B43-9CAA-334439257768}"/>
              </a:ext>
            </a:extLst>
          </p:cNvPr>
          <p:cNvSpPr>
            <a:spLocks noGrp="1"/>
          </p:cNvSpPr>
          <p:nvPr>
            <p:ph type="body" sz="quarter" idx="18" hasCustomPrompt="1"/>
          </p:nvPr>
        </p:nvSpPr>
        <p:spPr>
          <a:xfrm>
            <a:off x="4696249" y="3924303"/>
            <a:ext cx="1920240" cy="1894417"/>
          </a:xfrm>
        </p:spPr>
        <p:txBody>
          <a:bodyPr/>
          <a:lstStyle/>
          <a:p>
            <a:pPr lvl="0"/>
            <a:r>
              <a:rPr lang="en-US"/>
              <a:t>Insert text</a:t>
            </a:r>
          </a:p>
        </p:txBody>
      </p:sp>
      <p:sp>
        <p:nvSpPr>
          <p:cNvPr id="10" name="Text Placeholder 3">
            <a:extLst>
              <a:ext uri="{FF2B5EF4-FFF2-40B4-BE49-F238E27FC236}">
                <a16:creationId xmlns:a16="http://schemas.microsoft.com/office/drawing/2014/main" id="{8B4E2EF0-9062-4F05-9A3B-77EF8F83B0CC}"/>
              </a:ext>
            </a:extLst>
          </p:cNvPr>
          <p:cNvSpPr>
            <a:spLocks noGrp="1"/>
          </p:cNvSpPr>
          <p:nvPr>
            <p:ph type="body" sz="quarter" idx="19" hasCustomPrompt="1"/>
          </p:nvPr>
        </p:nvSpPr>
        <p:spPr>
          <a:xfrm>
            <a:off x="6864985" y="3924303"/>
            <a:ext cx="1920240" cy="1894417"/>
          </a:xfrm>
        </p:spPr>
        <p:txBody>
          <a:bodyPr/>
          <a:lstStyle/>
          <a:p>
            <a:pPr lvl="0"/>
            <a:r>
              <a:rPr lang="en-US"/>
              <a:t>Insert text</a:t>
            </a:r>
          </a:p>
        </p:txBody>
      </p:sp>
      <p:sp>
        <p:nvSpPr>
          <p:cNvPr id="11" name="Text Placeholder 3">
            <a:extLst>
              <a:ext uri="{FF2B5EF4-FFF2-40B4-BE49-F238E27FC236}">
                <a16:creationId xmlns:a16="http://schemas.microsoft.com/office/drawing/2014/main" id="{ECB8694C-9422-48F7-87AC-E0ABCD95A092}"/>
              </a:ext>
            </a:extLst>
          </p:cNvPr>
          <p:cNvSpPr>
            <a:spLocks noGrp="1"/>
          </p:cNvSpPr>
          <p:nvPr>
            <p:ph type="body" sz="quarter" idx="20" hasCustomPrompt="1"/>
          </p:nvPr>
        </p:nvSpPr>
        <p:spPr>
          <a:xfrm>
            <a:off x="358775" y="3924303"/>
            <a:ext cx="1920240" cy="1894417"/>
          </a:xfrm>
        </p:spPr>
        <p:txBody>
          <a:bodyPr/>
          <a:lstStyle/>
          <a:p>
            <a:pPr lvl="0"/>
            <a:r>
              <a:rPr lang="en-US"/>
              <a:t>Insert text</a:t>
            </a:r>
          </a:p>
        </p:txBody>
      </p:sp>
    </p:spTree>
    <p:extLst>
      <p:ext uri="{BB962C8B-B14F-4D97-AF65-F5344CB8AC3E}">
        <p14:creationId xmlns:p14="http://schemas.microsoft.com/office/powerpoint/2010/main" val="1688171067"/>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2160" userDrawn="1">
          <p15:clr>
            <a:srgbClr val="FBAE40"/>
          </p15:clr>
        </p15:guide>
      </p15:sldGuideLst>
    </p:ext>
  </p:extLst>
</p:sldLayout>
</file>

<file path=ppt/slideLayouts/slideLayout36.xml><?xml version="1.0" encoding="utf-8"?>
<p:sldLayout xmlns:a="http://schemas.openxmlformats.org/drawingml/2006/main" xmlns:r="http://schemas.openxmlformats.org/officeDocument/2006/relationships" xmlns:p="http://schemas.openxmlformats.org/presentationml/2006/main" userDrawn="1">
  <p:cSld name="Default Slide">
    <p:spTree>
      <p:nvGrpSpPr>
        <p:cNvPr id="1" name=""/>
        <p:cNvGrpSpPr/>
        <p:nvPr/>
      </p:nvGrpSpPr>
      <p:grpSpPr>
        <a:xfrm>
          <a:off x="0" y="0"/>
          <a:ext cx="0" cy="0"/>
          <a:chOff x="0" y="0"/>
          <a:chExt cx="0" cy="0"/>
        </a:xfrm>
      </p:grpSpPr>
    </p:spTree>
    <p:extLst>
      <p:ext uri="{BB962C8B-B14F-4D97-AF65-F5344CB8AC3E}">
        <p14:creationId xmlns:p14="http://schemas.microsoft.com/office/powerpoint/2010/main" val="2979983897"/>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preserve="1" userDrawn="1">
  <p:cSld name="Title slide – Red option 1 (add own image)">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gradFill>
            <a:gsLst>
              <a:gs pos="99000">
                <a:srgbClr val="E64626"/>
              </a:gs>
              <a:gs pos="100000">
                <a:schemeClr val="accent1">
                  <a:tint val="50000"/>
                  <a:shade val="100000"/>
                  <a:satMod val="350000"/>
                </a:schemeClr>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4" name="Picture Placeholder 13"/>
          <p:cNvSpPr>
            <a:spLocks noGrp="1"/>
          </p:cNvSpPr>
          <p:nvPr>
            <p:ph type="pic" sz="quarter" idx="12"/>
          </p:nvPr>
        </p:nvSpPr>
        <p:spPr>
          <a:xfrm>
            <a:off x="4587875" y="0"/>
            <a:ext cx="4556125" cy="6858000"/>
          </a:xfrm>
          <a:solidFill>
            <a:schemeClr val="bg1">
              <a:lumMod val="85000"/>
            </a:schemeClr>
          </a:solidFill>
        </p:spPr>
        <p:txBody>
          <a:bodyPr anchor="ctr" anchorCtr="0"/>
          <a:lstStyle>
            <a:lvl1pPr marL="0" indent="0" algn="ctr">
              <a:buNone/>
              <a:defRPr/>
            </a:lvl1pPr>
          </a:lstStyle>
          <a:p>
            <a:pPr lvl="0"/>
            <a:r>
              <a:rPr lang="en-US" noProof="0"/>
              <a:t>Click icon to add picture</a:t>
            </a:r>
          </a:p>
        </p:txBody>
      </p:sp>
      <p:sp>
        <p:nvSpPr>
          <p:cNvPr id="7" name="Title 8"/>
          <p:cNvSpPr>
            <a:spLocks noGrp="1"/>
          </p:cNvSpPr>
          <p:nvPr>
            <p:ph type="title"/>
          </p:nvPr>
        </p:nvSpPr>
        <p:spPr>
          <a:xfrm>
            <a:off x="381884" y="1797599"/>
            <a:ext cx="3948874" cy="1322972"/>
          </a:xfrm>
        </p:spPr>
        <p:txBody>
          <a:bodyPr anchor="t"/>
          <a:lstStyle>
            <a:lvl1pPr>
              <a:defRPr sz="2800">
                <a:solidFill>
                  <a:schemeClr val="bg1"/>
                </a:solidFill>
              </a:defRPr>
            </a:lvl1pPr>
          </a:lstStyle>
          <a:p>
            <a:r>
              <a:rPr lang="en-US"/>
              <a:t>Click to edit Master title style</a:t>
            </a:r>
          </a:p>
        </p:txBody>
      </p:sp>
      <p:sp>
        <p:nvSpPr>
          <p:cNvPr id="8"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9" name="Picture 8" descr="Uni-Sydney-logo-lockup-mono-BMC.eps"/>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3692726771"/>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preserve="1" userDrawn="1">
  <p:cSld name="Title slide – Red option 2">
    <p:spTree>
      <p:nvGrpSpPr>
        <p:cNvPr id="1" name=""/>
        <p:cNvGrpSpPr/>
        <p:nvPr/>
      </p:nvGrpSpPr>
      <p:grpSpPr>
        <a:xfrm>
          <a:off x="0" y="0"/>
          <a:ext cx="0" cy="0"/>
          <a:chOff x="0" y="0"/>
          <a:chExt cx="0" cy="0"/>
        </a:xfrm>
      </p:grpSpPr>
      <p:sp>
        <p:nvSpPr>
          <p:cNvPr id="7" name="Rectangle 6"/>
          <p:cNvSpPr/>
          <p:nvPr userDrawn="1"/>
        </p:nvSpPr>
        <p:spPr>
          <a:xfrm>
            <a:off x="0" y="1"/>
            <a:ext cx="9144001" cy="6858000"/>
          </a:xfrm>
          <a:prstGeom prst="rect">
            <a:avLst/>
          </a:prstGeom>
          <a:gradFill>
            <a:gsLst>
              <a:gs pos="99000">
                <a:srgbClr val="E64626"/>
              </a:gs>
              <a:gs pos="100000">
                <a:schemeClr val="accent1">
                  <a:tint val="50000"/>
                  <a:shade val="100000"/>
                  <a:satMod val="350000"/>
                </a:schemeClr>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9" name="Picture 6"/>
          <p:cNvPicPr>
            <a:picLocks noChangeAspect="1"/>
          </p:cNvPicPr>
          <p:nvPr userDrawn="1"/>
        </p:nvPicPr>
        <p:blipFill>
          <a:blip r:embed="rId2">
            <a:extLst>
              <a:ext uri="{28A0092B-C50C-407E-A947-70E740481C1C}">
                <a14:useLocalDpi xmlns:a14="http://schemas.microsoft.com/office/drawing/2010/main"/>
              </a:ext>
            </a:extLst>
          </a:blip>
          <a:stretch>
            <a:fillRect/>
          </a:stretch>
        </p:blipFill>
        <p:spPr bwMode="auto">
          <a:xfrm>
            <a:off x="4571344" y="0"/>
            <a:ext cx="4581600" cy="6872400"/>
          </a:xfrm>
          <a:prstGeom prst="rect">
            <a:avLst/>
          </a:prstGeom>
          <a:blipFill rotWithShape="1">
            <a:blip r:embed="rId3" cstate="screen">
              <a:extLst>
                <a:ext uri="{28A0092B-C50C-407E-A947-70E740481C1C}">
                  <a14:useLocalDpi xmlns:a14="http://schemas.microsoft.com/office/drawing/2010/main"/>
                </a:ext>
              </a:extLst>
            </a:blip>
            <a:stretch>
              <a:fillRect/>
            </a:stretch>
          </a:blipFill>
          <a:ln>
            <a:noFill/>
          </a:ln>
        </p:spPr>
      </p:pic>
      <p:pic>
        <p:nvPicPr>
          <p:cNvPr id="2" name="Picture 1" descr="269F7152-Edit.jpg"/>
          <p:cNvPicPr>
            <a:picLocks noChangeAspect="1"/>
          </p:cNvPicPr>
          <p:nvPr userDrawn="1"/>
        </p:nvPicPr>
        <p:blipFill rotWithShape="1">
          <a:blip r:embed="rId4">
            <a:extLst>
              <a:ext uri="{28A0092B-C50C-407E-A947-70E740481C1C}">
                <a14:useLocalDpi xmlns:a14="http://schemas.microsoft.com/office/drawing/2010/main" val="0"/>
              </a:ext>
            </a:extLst>
          </a:blip>
          <a:srcRect l="28075" r="27248"/>
          <a:stretch/>
        </p:blipFill>
        <p:spPr>
          <a:xfrm>
            <a:off x="4571344" y="-1"/>
            <a:ext cx="4581600" cy="6875925"/>
          </a:xfrm>
          <a:prstGeom prst="rect">
            <a:avLst/>
          </a:prstGeom>
        </p:spPr>
      </p:pic>
      <p:sp>
        <p:nvSpPr>
          <p:cNvPr id="8" name="Title 8"/>
          <p:cNvSpPr>
            <a:spLocks noGrp="1"/>
          </p:cNvSpPr>
          <p:nvPr>
            <p:ph type="title"/>
          </p:nvPr>
        </p:nvSpPr>
        <p:spPr>
          <a:xfrm>
            <a:off x="381884" y="1797599"/>
            <a:ext cx="3948874" cy="1322972"/>
          </a:xfrm>
        </p:spPr>
        <p:txBody>
          <a:bodyPr anchor="t"/>
          <a:lstStyle>
            <a:lvl1pPr>
              <a:defRPr sz="2800">
                <a:solidFill>
                  <a:schemeClr val="bg1"/>
                </a:solidFill>
              </a:defRPr>
            </a:lvl1pPr>
          </a:lstStyle>
          <a:p>
            <a:r>
              <a:rPr lang="en-US"/>
              <a:t>Click to edit Master title style</a:t>
            </a:r>
          </a:p>
        </p:txBody>
      </p:sp>
      <p:sp>
        <p:nvSpPr>
          <p:cNvPr id="10"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11" name="Picture 10" descr="Uni-Sydney-logo-lockup-mono-BMC.eps"/>
          <p:cNvPicPr>
            <a:picLocks noChangeAspect="1"/>
          </p:cNvPicPr>
          <p:nvPr userDrawn="1"/>
        </p:nvPicPr>
        <p:blipFill>
          <a:blip r:embed="rId5">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1996819521"/>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preserve="1" userDrawn="1">
  <p:cSld name="Title slide – Red option 4">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gradFill>
            <a:gsLst>
              <a:gs pos="99000">
                <a:srgbClr val="E64626"/>
              </a:gs>
              <a:gs pos="100000">
                <a:schemeClr val="accent1">
                  <a:tint val="50000"/>
                  <a:shade val="100000"/>
                  <a:satMod val="350000"/>
                </a:schemeClr>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5" name="Picture 6"/>
          <p:cNvPicPr>
            <a:picLocks noChangeAspect="1"/>
          </p:cNvPicPr>
          <p:nvPr/>
        </p:nvPicPr>
        <p:blipFill>
          <a:blip r:embed="rId2" cstate="screen">
            <a:extLst>
              <a:ext uri="{28A0092B-C50C-407E-A947-70E740481C1C}">
                <a14:useLocalDpi xmlns:a14="http://schemas.microsoft.com/office/drawing/2010/main"/>
              </a:ext>
            </a:extLst>
          </a:blip>
          <a:srcRect/>
          <a:stretch>
            <a:fillRect/>
          </a:stretch>
        </p:blipFill>
        <p:spPr bwMode="auto">
          <a:xfrm>
            <a:off x="4545013" y="0"/>
            <a:ext cx="4598987" cy="68580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7" name="Title 8"/>
          <p:cNvSpPr>
            <a:spLocks noGrp="1"/>
          </p:cNvSpPr>
          <p:nvPr>
            <p:ph type="title"/>
          </p:nvPr>
        </p:nvSpPr>
        <p:spPr>
          <a:xfrm>
            <a:off x="381884" y="1797599"/>
            <a:ext cx="3948874" cy="1322972"/>
          </a:xfrm>
        </p:spPr>
        <p:txBody>
          <a:bodyPr anchor="t"/>
          <a:lstStyle>
            <a:lvl1pPr>
              <a:defRPr sz="2800">
                <a:solidFill>
                  <a:schemeClr val="bg1"/>
                </a:solidFill>
              </a:defRPr>
            </a:lvl1pPr>
          </a:lstStyle>
          <a:p>
            <a:r>
              <a:rPr lang="en-US"/>
              <a:t>Click to edit Master title style</a:t>
            </a:r>
          </a:p>
        </p:txBody>
      </p:sp>
      <p:sp>
        <p:nvSpPr>
          <p:cNvPr id="8"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10" name="Picture 9" descr="Uni-Sydney-logo-lockup-mono-BMC.eps"/>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4259690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2_Title slide – Red option 2">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C6464A0A-2E52-4325-8E9A-4FE513E8B588}"/>
              </a:ext>
            </a:extLst>
          </p:cNvPr>
          <p:cNvSpPr/>
          <p:nvPr userDrawn="1"/>
        </p:nvSpPr>
        <p:spPr>
          <a:xfrm>
            <a:off x="1"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4" name="Picture 13" descr="A close up of a logo&#10;&#10;Description automatically generated">
            <a:extLst>
              <a:ext uri="{FF2B5EF4-FFF2-40B4-BE49-F238E27FC236}">
                <a16:creationId xmlns:a16="http://schemas.microsoft.com/office/drawing/2014/main" id="{B1AC6F61-871E-4989-A8F8-D6803736596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1" name="Picture 10" descr="A picture containing building, outdoor&#10;&#10;Description automatically generated">
            <a:extLst>
              <a:ext uri="{FF2B5EF4-FFF2-40B4-BE49-F238E27FC236}">
                <a16:creationId xmlns:a16="http://schemas.microsoft.com/office/drawing/2014/main" id="{5B555A18-63E4-4E45-B51E-13C52CD37CCD}"/>
              </a:ext>
            </a:extLst>
          </p:cNvPr>
          <p:cNvPicPr>
            <a:picLocks noChangeAspect="1"/>
          </p:cNvPicPr>
          <p:nvPr userDrawn="1"/>
        </p:nvPicPr>
        <p:blipFill>
          <a:blip r:embed="rId3" cstate="email">
            <a:extLst>
              <a:ext uri="{28A0092B-C50C-407E-A947-70E740481C1C}">
                <a14:useLocalDpi xmlns:a14="http://schemas.microsoft.com/office/drawing/2010/main"/>
              </a:ext>
            </a:extLst>
          </a:blip>
          <a:stretch>
            <a:fillRect/>
          </a:stretch>
        </p:blipFill>
        <p:spPr>
          <a:xfrm>
            <a:off x="4572000" y="0"/>
            <a:ext cx="4572000" cy="6858000"/>
          </a:xfrm>
          <a:prstGeom prst="rect">
            <a:avLst/>
          </a:prstGeom>
        </p:spPr>
      </p:pic>
      <p:sp>
        <p:nvSpPr>
          <p:cNvPr id="7" name="Title 8">
            <a:extLst>
              <a:ext uri="{FF2B5EF4-FFF2-40B4-BE49-F238E27FC236}">
                <a16:creationId xmlns:a16="http://schemas.microsoft.com/office/drawing/2014/main" id="{81F9E4D6-F775-284D-ADC5-7A967F62816A}"/>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9" name="Text Placeholder 4">
            <a:extLst>
              <a:ext uri="{FF2B5EF4-FFF2-40B4-BE49-F238E27FC236}">
                <a16:creationId xmlns:a16="http://schemas.microsoft.com/office/drawing/2014/main" id="{B3D86596-91B6-7849-AB9A-968689EE4B5E}"/>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4275949818"/>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preserve="1" userDrawn="1">
  <p:cSld name="1_Title slide – Red option 4">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gradFill>
            <a:gsLst>
              <a:gs pos="99000">
                <a:srgbClr val="E64626"/>
              </a:gs>
              <a:gs pos="100000">
                <a:schemeClr val="accent1">
                  <a:tint val="50000"/>
                  <a:shade val="100000"/>
                  <a:satMod val="350000"/>
                </a:schemeClr>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9" name="Picture 6"/>
          <p:cNvPicPr>
            <a:picLocks noChangeAspect="1"/>
          </p:cNvPicPr>
          <p:nvPr userDrawn="1"/>
        </p:nvPicPr>
        <p:blipFill rotWithShape="1">
          <a:blip r:embed="rId2">
            <a:extLst>
              <a:ext uri="{28A0092B-C50C-407E-A947-70E740481C1C}">
                <a14:useLocalDpi xmlns:a14="http://schemas.microsoft.com/office/drawing/2010/main" val="0"/>
              </a:ext>
            </a:extLst>
          </a:blip>
          <a:srcRect l="13060" r="38627"/>
          <a:stretch/>
        </p:blipFill>
        <p:spPr bwMode="auto">
          <a:xfrm>
            <a:off x="4546600" y="-8711"/>
            <a:ext cx="4597400" cy="6875258"/>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7" name="Title 8"/>
          <p:cNvSpPr>
            <a:spLocks noGrp="1"/>
          </p:cNvSpPr>
          <p:nvPr>
            <p:ph type="title"/>
          </p:nvPr>
        </p:nvSpPr>
        <p:spPr>
          <a:xfrm>
            <a:off x="381884" y="1797599"/>
            <a:ext cx="3948874" cy="1322972"/>
          </a:xfrm>
        </p:spPr>
        <p:txBody>
          <a:bodyPr anchor="t"/>
          <a:lstStyle>
            <a:lvl1pPr>
              <a:defRPr sz="2800">
                <a:solidFill>
                  <a:schemeClr val="bg1"/>
                </a:solidFill>
              </a:defRPr>
            </a:lvl1pPr>
          </a:lstStyle>
          <a:p>
            <a:r>
              <a:rPr lang="en-US"/>
              <a:t>Click to edit Master title style</a:t>
            </a:r>
          </a:p>
        </p:txBody>
      </p:sp>
      <p:sp>
        <p:nvSpPr>
          <p:cNvPr id="8"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11" name="Picture 10" descr="Uni-Sydney-logo-lockup-mono-BMC.eps"/>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199532890"/>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preserve="1" userDrawn="1">
  <p:cSld name="2_Title slide – Red option 4">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gradFill>
            <a:gsLst>
              <a:gs pos="99000">
                <a:srgbClr val="E64626"/>
              </a:gs>
              <a:gs pos="100000">
                <a:schemeClr val="accent1">
                  <a:tint val="50000"/>
                  <a:shade val="100000"/>
                  <a:satMod val="350000"/>
                </a:schemeClr>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2" name="Picture 1" descr="269F8271-Edit.jpg"/>
          <p:cNvPicPr>
            <a:picLocks noChangeAspect="1"/>
          </p:cNvPicPr>
          <p:nvPr userDrawn="1"/>
        </p:nvPicPr>
        <p:blipFill rotWithShape="1">
          <a:blip r:embed="rId2">
            <a:extLst>
              <a:ext uri="{28A0092B-C50C-407E-A947-70E740481C1C}">
                <a14:useLocalDpi xmlns:a14="http://schemas.microsoft.com/office/drawing/2010/main" val="0"/>
              </a:ext>
            </a:extLst>
          </a:blip>
          <a:srcRect l="27099" r="28483"/>
          <a:stretch/>
        </p:blipFill>
        <p:spPr>
          <a:xfrm>
            <a:off x="4546600" y="0"/>
            <a:ext cx="4597399" cy="6898609"/>
          </a:xfrm>
          <a:prstGeom prst="rect">
            <a:avLst/>
          </a:prstGeom>
        </p:spPr>
      </p:pic>
      <p:sp>
        <p:nvSpPr>
          <p:cNvPr id="7" name="Title 8"/>
          <p:cNvSpPr>
            <a:spLocks noGrp="1"/>
          </p:cNvSpPr>
          <p:nvPr>
            <p:ph type="title"/>
          </p:nvPr>
        </p:nvSpPr>
        <p:spPr>
          <a:xfrm>
            <a:off x="381884" y="1797599"/>
            <a:ext cx="3948874" cy="1322972"/>
          </a:xfrm>
        </p:spPr>
        <p:txBody>
          <a:bodyPr anchor="t"/>
          <a:lstStyle>
            <a:lvl1pPr>
              <a:defRPr sz="2800">
                <a:solidFill>
                  <a:schemeClr val="bg1"/>
                </a:solidFill>
              </a:defRPr>
            </a:lvl1pPr>
          </a:lstStyle>
          <a:p>
            <a:r>
              <a:rPr lang="en-US"/>
              <a:t>Click to edit Master title style</a:t>
            </a:r>
          </a:p>
        </p:txBody>
      </p:sp>
      <p:sp>
        <p:nvSpPr>
          <p:cNvPr id="8"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10" name="Picture 9" descr="Uni-Sydney-logo-lockup-mono-BMC.eps"/>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1874015495"/>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preserve="1" userDrawn="1">
  <p:cSld name="Title slide – Red option 5 (no image)">
    <p:spTree>
      <p:nvGrpSpPr>
        <p:cNvPr id="1" name=""/>
        <p:cNvGrpSpPr/>
        <p:nvPr/>
      </p:nvGrpSpPr>
      <p:grpSpPr>
        <a:xfrm>
          <a:off x="0" y="0"/>
          <a:ext cx="0" cy="0"/>
          <a:chOff x="0" y="0"/>
          <a:chExt cx="0" cy="0"/>
        </a:xfrm>
      </p:grpSpPr>
      <p:sp>
        <p:nvSpPr>
          <p:cNvPr id="5" name="Rectangle 4"/>
          <p:cNvSpPr/>
          <p:nvPr userDrawn="1"/>
        </p:nvSpPr>
        <p:spPr>
          <a:xfrm>
            <a:off x="0" y="1"/>
            <a:ext cx="9144001" cy="6858000"/>
          </a:xfrm>
          <a:prstGeom prst="rect">
            <a:avLst/>
          </a:prstGeom>
          <a:gradFill>
            <a:gsLst>
              <a:gs pos="99000">
                <a:srgbClr val="E64626"/>
              </a:gs>
              <a:gs pos="100000">
                <a:schemeClr val="accent1">
                  <a:tint val="50000"/>
                  <a:shade val="100000"/>
                  <a:satMod val="350000"/>
                </a:schemeClr>
              </a:gs>
            </a:gsLst>
          </a:gra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2" name="Title 8"/>
          <p:cNvSpPr>
            <a:spLocks noGrp="1"/>
          </p:cNvSpPr>
          <p:nvPr>
            <p:ph type="title"/>
          </p:nvPr>
        </p:nvSpPr>
        <p:spPr>
          <a:xfrm>
            <a:off x="381884" y="1797599"/>
            <a:ext cx="3948874" cy="1322972"/>
          </a:xfrm>
        </p:spPr>
        <p:txBody>
          <a:bodyPr anchor="t"/>
          <a:lstStyle>
            <a:lvl1pPr>
              <a:defRPr sz="2800">
                <a:solidFill>
                  <a:schemeClr val="bg1"/>
                </a:solidFill>
              </a:defRPr>
            </a:lvl1pPr>
          </a:lstStyle>
          <a:p>
            <a:r>
              <a:rPr lang="en-US"/>
              <a:t>Click to edit Master title style</a:t>
            </a:r>
          </a:p>
        </p:txBody>
      </p:sp>
      <p:sp>
        <p:nvSpPr>
          <p:cNvPr id="13"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7" name="Picture 6" descr="Uni-Sydney-logo-lockup-mono-BMC.eps"/>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1072916107"/>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preserve="1" userDrawn="1">
  <p:cSld name="Title slide – White option 1 (add own image)">
    <p:spTree>
      <p:nvGrpSpPr>
        <p:cNvPr id="1" name=""/>
        <p:cNvGrpSpPr/>
        <p:nvPr/>
      </p:nvGrpSpPr>
      <p:grpSpPr>
        <a:xfrm>
          <a:off x="0" y="0"/>
          <a:ext cx="0" cy="0"/>
          <a:chOff x="0" y="0"/>
          <a:chExt cx="0" cy="0"/>
        </a:xfrm>
      </p:grpSpPr>
      <p:sp>
        <p:nvSpPr>
          <p:cNvPr id="6" name="Rectangle 5"/>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Picture Placeholder 13"/>
          <p:cNvSpPr>
            <a:spLocks noGrp="1"/>
          </p:cNvSpPr>
          <p:nvPr>
            <p:ph type="pic" sz="quarter" idx="12"/>
          </p:nvPr>
        </p:nvSpPr>
        <p:spPr>
          <a:xfrm>
            <a:off x="4587876" y="418354"/>
            <a:ext cx="4150358" cy="6017555"/>
          </a:xfrm>
          <a:solidFill>
            <a:schemeClr val="bg1">
              <a:lumMod val="85000"/>
            </a:schemeClr>
          </a:solidFill>
          <a:ln>
            <a:noFill/>
          </a:ln>
        </p:spPr>
        <p:txBody>
          <a:bodyPr anchor="ctr" anchorCtr="0"/>
          <a:lstStyle>
            <a:lvl1pPr marL="0" indent="0" algn="ctr">
              <a:buNone/>
              <a:defRPr/>
            </a:lvl1pPr>
          </a:lstStyle>
          <a:p>
            <a:pPr lvl="0"/>
            <a:r>
              <a:rPr lang="en-US" noProof="0"/>
              <a:t>Click icon to add picture</a:t>
            </a:r>
          </a:p>
        </p:txBody>
      </p:sp>
      <p:sp>
        <p:nvSpPr>
          <p:cNvPr id="8" name="Title 8"/>
          <p:cNvSpPr>
            <a:spLocks noGrp="1"/>
          </p:cNvSpPr>
          <p:nvPr>
            <p:ph type="title"/>
          </p:nvPr>
        </p:nvSpPr>
        <p:spPr>
          <a:xfrm>
            <a:off x="381884" y="1797599"/>
            <a:ext cx="3948874" cy="1322972"/>
          </a:xfrm>
        </p:spPr>
        <p:txBody>
          <a:bodyPr anchor="t"/>
          <a:lstStyle>
            <a:lvl1pPr>
              <a:defRPr sz="2800">
                <a:solidFill>
                  <a:schemeClr val="accent1"/>
                </a:solidFill>
              </a:defRPr>
            </a:lvl1pPr>
          </a:lstStyle>
          <a:p>
            <a:r>
              <a:rPr lang="en-US"/>
              <a:t>Click to edit Master title style</a:t>
            </a:r>
          </a:p>
        </p:txBody>
      </p:sp>
      <p:sp>
        <p:nvSpPr>
          <p:cNvPr id="9"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7" name="Picture 6" descr="Uni-Sydney-logo-lockup-mono-BMC.eps"/>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3472798097"/>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preserve="1" userDrawn="1">
  <p:cSld name="Title slide – White option 2">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pic>
        <p:nvPicPr>
          <p:cNvPr id="6" name="Picture Placeholder 4"/>
          <p:cNvPicPr>
            <a:picLocks noChangeAspect="1"/>
          </p:cNvPicPr>
          <p:nvPr/>
        </p:nvPicPr>
        <p:blipFill>
          <a:blip r:embed="rId2" cstate="screen">
            <a:extLst>
              <a:ext uri="{28A0092B-C50C-407E-A947-70E740481C1C}">
                <a14:useLocalDpi xmlns:a14="http://schemas.microsoft.com/office/drawing/2010/main"/>
              </a:ext>
            </a:extLst>
          </a:blip>
          <a:srcRect/>
          <a:stretch>
            <a:fillRect/>
          </a:stretch>
        </p:blipFill>
        <p:spPr bwMode="auto">
          <a:xfrm>
            <a:off x="4645025" y="419100"/>
            <a:ext cx="4035425" cy="60166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10" name="Title 8"/>
          <p:cNvSpPr>
            <a:spLocks noGrp="1"/>
          </p:cNvSpPr>
          <p:nvPr>
            <p:ph type="title"/>
          </p:nvPr>
        </p:nvSpPr>
        <p:spPr>
          <a:xfrm>
            <a:off x="381884" y="1797599"/>
            <a:ext cx="3948874" cy="1322972"/>
          </a:xfrm>
        </p:spPr>
        <p:txBody>
          <a:bodyPr anchor="t"/>
          <a:lstStyle>
            <a:lvl1pPr>
              <a:defRPr sz="2800">
                <a:solidFill>
                  <a:schemeClr val="accent1"/>
                </a:solidFill>
              </a:defRPr>
            </a:lvl1pPr>
          </a:lstStyle>
          <a:p>
            <a:r>
              <a:rPr lang="en-US"/>
              <a:t>Click to edit Master title style</a:t>
            </a:r>
          </a:p>
        </p:txBody>
      </p:sp>
      <p:sp>
        <p:nvSpPr>
          <p:cNvPr id="11"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7" name="Picture 6" descr="Uni-Sydney-logo-lockup-mono-BMC.eps"/>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3773391798"/>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preserve="1" userDrawn="1">
  <p:cSld name="Title slide – White option 3">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pic>
        <p:nvPicPr>
          <p:cNvPr id="6" name="Picture Placeholder 4"/>
          <p:cNvPicPr>
            <a:picLocks noChangeAspect="1"/>
          </p:cNvPicPr>
          <p:nvPr/>
        </p:nvPicPr>
        <p:blipFill>
          <a:blip r:embed="rId2" cstate="screen">
            <a:extLst>
              <a:ext uri="{28A0092B-C50C-407E-A947-70E740481C1C}">
                <a14:useLocalDpi xmlns:a14="http://schemas.microsoft.com/office/drawing/2010/main"/>
              </a:ext>
            </a:extLst>
          </a:blip>
          <a:srcRect/>
          <a:stretch>
            <a:fillRect/>
          </a:stretch>
        </p:blipFill>
        <p:spPr bwMode="auto">
          <a:xfrm>
            <a:off x="4645025" y="419100"/>
            <a:ext cx="4035425" cy="60166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10" name="Title 8"/>
          <p:cNvSpPr>
            <a:spLocks noGrp="1"/>
          </p:cNvSpPr>
          <p:nvPr>
            <p:ph type="title"/>
          </p:nvPr>
        </p:nvSpPr>
        <p:spPr>
          <a:xfrm>
            <a:off x="381884" y="1797599"/>
            <a:ext cx="3948874" cy="1322972"/>
          </a:xfrm>
        </p:spPr>
        <p:txBody>
          <a:bodyPr anchor="t"/>
          <a:lstStyle>
            <a:lvl1pPr>
              <a:defRPr sz="2800">
                <a:solidFill>
                  <a:schemeClr val="accent1"/>
                </a:solidFill>
              </a:defRPr>
            </a:lvl1pPr>
          </a:lstStyle>
          <a:p>
            <a:r>
              <a:rPr lang="en-US"/>
              <a:t>Click to edit Master title style</a:t>
            </a:r>
          </a:p>
        </p:txBody>
      </p:sp>
      <p:sp>
        <p:nvSpPr>
          <p:cNvPr id="11"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7" name="Picture 6" descr="Uni-Sydney-logo-lockup-mono-BMC.eps"/>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2571762477"/>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preserve="1" userDrawn="1">
  <p:cSld name="Title slide – White option 4">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pic>
        <p:nvPicPr>
          <p:cNvPr id="6" name="Picture Placeholder 4"/>
          <p:cNvPicPr>
            <a:picLocks noChangeAspect="1"/>
          </p:cNvPicPr>
          <p:nvPr/>
        </p:nvPicPr>
        <p:blipFill>
          <a:blip r:embed="rId2" cstate="screen">
            <a:extLst>
              <a:ext uri="{28A0092B-C50C-407E-A947-70E740481C1C}">
                <a14:useLocalDpi xmlns:a14="http://schemas.microsoft.com/office/drawing/2010/main"/>
              </a:ext>
            </a:extLst>
          </a:blip>
          <a:srcRect/>
          <a:stretch>
            <a:fillRect/>
          </a:stretch>
        </p:blipFill>
        <p:spPr bwMode="auto">
          <a:xfrm>
            <a:off x="4645025" y="419100"/>
            <a:ext cx="4035425" cy="60166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10" name="Title 8"/>
          <p:cNvSpPr>
            <a:spLocks noGrp="1"/>
          </p:cNvSpPr>
          <p:nvPr>
            <p:ph type="title"/>
          </p:nvPr>
        </p:nvSpPr>
        <p:spPr>
          <a:xfrm>
            <a:off x="381884" y="1797599"/>
            <a:ext cx="3948874" cy="1322972"/>
          </a:xfrm>
        </p:spPr>
        <p:txBody>
          <a:bodyPr anchor="t"/>
          <a:lstStyle>
            <a:lvl1pPr>
              <a:defRPr sz="2800">
                <a:solidFill>
                  <a:schemeClr val="accent1"/>
                </a:solidFill>
              </a:defRPr>
            </a:lvl1pPr>
          </a:lstStyle>
          <a:p>
            <a:r>
              <a:rPr lang="en-US"/>
              <a:t>Click to edit Master title style</a:t>
            </a:r>
          </a:p>
        </p:txBody>
      </p:sp>
      <p:sp>
        <p:nvSpPr>
          <p:cNvPr id="11"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7" name="Picture 6" descr="Uni-Sydney-logo-lockup-mono-BMC.eps"/>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23945628"/>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preserve="1" userDrawn="1">
  <p:cSld name="Title slide – White option 5 (no image)">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0" name="Title 8"/>
          <p:cNvSpPr>
            <a:spLocks noGrp="1"/>
          </p:cNvSpPr>
          <p:nvPr>
            <p:ph type="title"/>
          </p:nvPr>
        </p:nvSpPr>
        <p:spPr>
          <a:xfrm>
            <a:off x="381884" y="1797599"/>
            <a:ext cx="3948874" cy="1322972"/>
          </a:xfrm>
        </p:spPr>
        <p:txBody>
          <a:bodyPr anchor="t"/>
          <a:lstStyle>
            <a:lvl1pPr>
              <a:defRPr sz="2800">
                <a:solidFill>
                  <a:schemeClr val="accent1"/>
                </a:solidFill>
              </a:defRPr>
            </a:lvl1pPr>
          </a:lstStyle>
          <a:p>
            <a:r>
              <a:rPr lang="en-US"/>
              <a:t>Click to edit Master title style</a:t>
            </a:r>
          </a:p>
        </p:txBody>
      </p:sp>
      <p:sp>
        <p:nvSpPr>
          <p:cNvPr id="11" name="Text Placeholder 4"/>
          <p:cNvSpPr>
            <a:spLocks noGrp="1"/>
          </p:cNvSpPr>
          <p:nvPr>
            <p:ph type="body" sz="quarter" idx="11"/>
          </p:nvPr>
        </p:nvSpPr>
        <p:spPr>
          <a:xfrm>
            <a:off x="366941" y="3360968"/>
            <a:ext cx="3963817" cy="852488"/>
          </a:xfrm>
        </p:spPr>
        <p:txBody>
          <a:bodyPr>
            <a:noAutofit/>
          </a:bodyPr>
          <a:lstStyle>
            <a:lvl1pPr marL="0" indent="0">
              <a:lnSpc>
                <a:spcPct val="90000"/>
              </a:lnSpc>
              <a:buNone/>
              <a:defRPr sz="1600"/>
            </a:lvl1pPr>
            <a:lvl2pPr marL="457200" indent="0">
              <a:buNone/>
              <a:defRPr sz="1600"/>
            </a:lvl2pPr>
            <a:lvl3pPr marL="914400" indent="0">
              <a:buNone/>
              <a:defRPr sz="1600"/>
            </a:lvl3pPr>
            <a:lvl4pPr marL="1371600" indent="0">
              <a:buNone/>
              <a:defRPr/>
            </a:lvl4pPr>
            <a:lvl5pPr marL="1828800" indent="0">
              <a:buNone/>
              <a:defRPr/>
            </a:lvl5pPr>
          </a:lstStyle>
          <a:p>
            <a:pPr lvl="0"/>
            <a:r>
              <a:rPr lang="en-US"/>
              <a:t>Edit Master text styles</a:t>
            </a:r>
          </a:p>
          <a:p>
            <a:pPr lvl="1"/>
            <a:r>
              <a:rPr lang="en-US"/>
              <a:t>Second level</a:t>
            </a:r>
          </a:p>
          <a:p>
            <a:pPr lvl="2"/>
            <a:r>
              <a:rPr lang="en-US"/>
              <a:t>Third level</a:t>
            </a:r>
          </a:p>
        </p:txBody>
      </p:sp>
      <p:pic>
        <p:nvPicPr>
          <p:cNvPr id="6" name="Picture 5" descr="Uni-Sydney-logo-lockup-mono-BMC.eps"/>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2119075376"/>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
        <p:nvSpPr>
          <p:cNvPr id="3" name="Content Placeholder 2"/>
          <p:cNvSpPr>
            <a:spLocks noGrp="1"/>
          </p:cNvSpPr>
          <p:nvPr>
            <p:ph idx="1"/>
          </p:nvPr>
        </p:nvSpPr>
        <p:spPr/>
        <p:txBody>
          <a:bodyPr/>
          <a:lstStyle>
            <a:lvl1pPr>
              <a:lnSpc>
                <a:spcPct val="90000"/>
              </a:lnSpc>
              <a:defRPr/>
            </a:lvl1pPr>
            <a:lvl2pPr marL="742950" indent="-285750">
              <a:lnSpc>
                <a:spcPct val="90000"/>
              </a:lnSpc>
              <a:buFont typeface="Lucida Grande"/>
              <a:buChar char="–"/>
              <a:defRPr/>
            </a:lvl2pPr>
            <a:lvl3pPr>
              <a:lnSpc>
                <a:spcPct val="90000"/>
              </a:lnSpc>
              <a:defRPr/>
            </a:lvl3pPr>
          </a:lstStyle>
          <a:p>
            <a:pPr lvl="0"/>
            <a:r>
              <a:rPr lang="en-US"/>
              <a:t>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256118440"/>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type="twoObj" preserve="1">
  <p:cSld name="Title and Two Content ">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
        <p:nvSpPr>
          <p:cNvPr id="3" name="Content Placeholder 2"/>
          <p:cNvSpPr>
            <a:spLocks noGrp="1"/>
          </p:cNvSpPr>
          <p:nvPr>
            <p:ph sz="half" idx="1"/>
          </p:nvPr>
        </p:nvSpPr>
        <p:spPr>
          <a:xfrm>
            <a:off x="457200" y="1359925"/>
            <a:ext cx="4038600" cy="4525963"/>
          </a:xfrm>
        </p:spPr>
        <p:txBody>
          <a:bodyPr>
            <a:normAutofit/>
          </a:bodyPr>
          <a:lstStyle>
            <a:lvl1pPr>
              <a:defRPr sz="2400"/>
            </a:lvl1pPr>
            <a:lvl2pPr>
              <a:defRPr sz="2400"/>
            </a:lvl2pPr>
            <a:lvl3pPr>
              <a:defRPr sz="2400"/>
            </a:lvl3pPr>
            <a:lvl4pPr>
              <a:defRPr sz="2000"/>
            </a:lvl4pPr>
            <a:lvl5pPr>
              <a:defRPr sz="20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p:txBody>
      </p:sp>
      <p:sp>
        <p:nvSpPr>
          <p:cNvPr id="4" name="Content Placeholder 3"/>
          <p:cNvSpPr>
            <a:spLocks noGrp="1"/>
          </p:cNvSpPr>
          <p:nvPr>
            <p:ph sz="half" idx="2"/>
          </p:nvPr>
        </p:nvSpPr>
        <p:spPr>
          <a:xfrm>
            <a:off x="4648200" y="1359925"/>
            <a:ext cx="4038600" cy="4525963"/>
          </a:xfrm>
        </p:spPr>
        <p:txBody>
          <a:bodyPr>
            <a:normAutofit/>
          </a:bodyPr>
          <a:lstStyle>
            <a:lvl1pPr>
              <a:defRPr sz="2400"/>
            </a:lvl1pPr>
            <a:lvl2pPr>
              <a:defRPr sz="2400"/>
            </a:lvl2pPr>
            <a:lvl3pPr>
              <a:defRPr sz="2400"/>
            </a:lvl3pPr>
            <a:lvl4pPr>
              <a:defRPr sz="2000"/>
            </a:lvl4pPr>
            <a:lvl5pPr>
              <a:defRPr sz="20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0350388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itle slide – Red option 4">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576A394-6B1F-4D42-AB9D-E8AC240619B4}"/>
              </a:ext>
            </a:extLst>
          </p:cNvPr>
          <p:cNvSpPr/>
          <p:nvPr userDrawn="1"/>
        </p:nvSpPr>
        <p:spPr>
          <a:xfrm>
            <a:off x="1"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0" name="Picture 9" descr="A close up of a logo&#10;&#10;Description automatically generated">
            <a:extLst>
              <a:ext uri="{FF2B5EF4-FFF2-40B4-BE49-F238E27FC236}">
                <a16:creationId xmlns:a16="http://schemas.microsoft.com/office/drawing/2014/main" id="{1811C849-DF8E-4316-9166-B19E70AB320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9" name="Picture 8" descr="A picture containing wall, indoor, ceiling, floor&#10;&#10;Description automatically generated">
            <a:extLst>
              <a:ext uri="{FF2B5EF4-FFF2-40B4-BE49-F238E27FC236}">
                <a16:creationId xmlns:a16="http://schemas.microsoft.com/office/drawing/2014/main" id="{A196A5F0-0505-454C-9646-38C0888EAC78}"/>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453338" y="0"/>
            <a:ext cx="4708429" cy="6858000"/>
          </a:xfrm>
          <a:prstGeom prst="rect">
            <a:avLst/>
          </a:prstGeom>
        </p:spPr>
      </p:pic>
      <p:sp>
        <p:nvSpPr>
          <p:cNvPr id="11" name="Title 8">
            <a:extLst>
              <a:ext uri="{FF2B5EF4-FFF2-40B4-BE49-F238E27FC236}">
                <a16:creationId xmlns:a16="http://schemas.microsoft.com/office/drawing/2014/main" id="{AD8A8234-470B-6B4C-AD83-A953D38FF07F}"/>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12" name="Text Placeholder 4">
            <a:extLst>
              <a:ext uri="{FF2B5EF4-FFF2-40B4-BE49-F238E27FC236}">
                <a16:creationId xmlns:a16="http://schemas.microsoft.com/office/drawing/2014/main" id="{E77678A9-BBDF-6240-A6E9-6AFE2E759E75}"/>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707706560"/>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preserve="1" userDrawn="1">
  <p:cSld name="Title, Content and Image">
    <p:spTree>
      <p:nvGrpSpPr>
        <p:cNvPr id="1" name=""/>
        <p:cNvGrpSpPr/>
        <p:nvPr/>
      </p:nvGrpSpPr>
      <p:grpSpPr>
        <a:xfrm>
          <a:off x="0" y="0"/>
          <a:ext cx="0" cy="0"/>
          <a:chOff x="0" y="0"/>
          <a:chExt cx="0" cy="0"/>
        </a:xfrm>
      </p:grpSpPr>
      <p:sp>
        <p:nvSpPr>
          <p:cNvPr id="9" name="Text Placeholder 7"/>
          <p:cNvSpPr>
            <a:spLocks noGrp="1"/>
          </p:cNvSpPr>
          <p:nvPr>
            <p:ph type="body" sz="quarter" idx="12"/>
          </p:nvPr>
        </p:nvSpPr>
        <p:spPr>
          <a:xfrm>
            <a:off x="457200" y="5491163"/>
            <a:ext cx="4038600" cy="537602"/>
          </a:xfrm>
        </p:spPr>
        <p:txBody>
          <a:bodyPr lIns="0" tIns="72000" rIns="72000">
            <a:noAutofit/>
          </a:bodyPr>
          <a:lstStyle>
            <a:lvl1pPr marL="0" marR="0" indent="0" algn="l" defTabSz="457200" rtl="0" eaLnBrk="1" fontAlgn="auto" latinLnBrk="0" hangingPunct="1">
              <a:lnSpc>
                <a:spcPct val="100000"/>
              </a:lnSpc>
              <a:spcBef>
                <a:spcPct val="20000"/>
              </a:spcBef>
              <a:spcAft>
                <a:spcPts val="0"/>
              </a:spcAft>
              <a:buClrTx/>
              <a:buSzTx/>
              <a:buFont typeface="Lucida Grande"/>
              <a:buNone/>
              <a:tabLst/>
              <a:defRPr sz="1100"/>
            </a:lvl1pPr>
            <a:lvl2pPr>
              <a:defRPr sz="1100"/>
            </a:lvl2pPr>
            <a:lvl3pPr>
              <a:defRPr sz="1100"/>
            </a:lvl3pPr>
            <a:lvl4pPr>
              <a:defRPr sz="1100"/>
            </a:lvl4pPr>
            <a:lvl5pPr>
              <a:defRPr sz="1100"/>
            </a:lvl5pPr>
          </a:lstStyle>
          <a:p>
            <a:pPr lvl="0"/>
            <a:r>
              <a:rPr lang="en-US"/>
              <a:t>Edit Master text styles</a:t>
            </a:r>
          </a:p>
          <a:p>
            <a:pPr lvl="1"/>
            <a:r>
              <a:rPr lang="en-US"/>
              <a:t>Second level</a:t>
            </a:r>
          </a:p>
          <a:p>
            <a:pPr lvl="2"/>
            <a:r>
              <a:rPr lang="en-US"/>
              <a:t>Third level</a:t>
            </a:r>
          </a:p>
        </p:txBody>
      </p:sp>
      <p:sp>
        <p:nvSpPr>
          <p:cNvPr id="6" name="Picture Placeholder 5"/>
          <p:cNvSpPr>
            <a:spLocks noGrp="1"/>
          </p:cNvSpPr>
          <p:nvPr>
            <p:ph type="pic" sz="quarter" idx="10"/>
          </p:nvPr>
        </p:nvSpPr>
        <p:spPr>
          <a:xfrm>
            <a:off x="457200" y="1360488"/>
            <a:ext cx="4038600" cy="4130394"/>
          </a:xfrm>
        </p:spPr>
        <p:txBody>
          <a:bodyPr/>
          <a:lstStyle>
            <a:lvl1pPr marL="0" indent="0">
              <a:buNone/>
              <a:defRPr/>
            </a:lvl1pPr>
          </a:lstStyle>
          <a:p>
            <a:pPr lvl="0"/>
            <a:r>
              <a:rPr lang="en-US" noProof="0"/>
              <a:t>Click icon to add picture</a:t>
            </a:r>
          </a:p>
        </p:txBody>
      </p:sp>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
        <p:nvSpPr>
          <p:cNvPr id="4" name="Content Placeholder 3"/>
          <p:cNvSpPr>
            <a:spLocks noGrp="1"/>
          </p:cNvSpPr>
          <p:nvPr>
            <p:ph sz="half" idx="2"/>
          </p:nvPr>
        </p:nvSpPr>
        <p:spPr>
          <a:xfrm>
            <a:off x="4648200" y="1359925"/>
            <a:ext cx="4038600" cy="4525963"/>
          </a:xfrm>
        </p:spPr>
        <p:txBody>
          <a:bodyPr>
            <a:normAutofit/>
          </a:bodyPr>
          <a:lstStyle>
            <a:lvl1pPr>
              <a:defRPr sz="2400"/>
            </a:lvl1pPr>
            <a:lvl2pPr>
              <a:defRPr sz="2400"/>
            </a:lvl2pPr>
            <a:lvl3pPr>
              <a:defRPr sz="2400"/>
            </a:lvl3pPr>
            <a:lvl4pPr>
              <a:defRPr sz="2000"/>
            </a:lvl4pPr>
            <a:lvl5pPr>
              <a:defRPr sz="20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149590626"/>
      </p:ext>
    </p:extLst>
  </p:cSld>
  <p:clrMapOvr>
    <a:masterClrMapping/>
  </p:clrMapOvr>
</p:sldLayout>
</file>

<file path=ppt/slideLayouts/slideLayout51.xml><?xml version="1.0" encoding="utf-8"?>
<p:sldLayout xmlns:a="http://schemas.openxmlformats.org/drawingml/2006/main" xmlns:r="http://schemas.openxmlformats.org/officeDocument/2006/relationships" xmlns:p="http://schemas.openxmlformats.org/presentationml/2006/main" preserve="1" userDrawn="1">
  <p:cSld name="Title, Content and Table">
    <p:spTree>
      <p:nvGrpSpPr>
        <p:cNvPr id="1" name=""/>
        <p:cNvGrpSpPr/>
        <p:nvPr/>
      </p:nvGrpSpPr>
      <p:grpSpPr>
        <a:xfrm>
          <a:off x="0" y="0"/>
          <a:ext cx="0" cy="0"/>
          <a:chOff x="0" y="0"/>
          <a:chExt cx="0" cy="0"/>
        </a:xfrm>
      </p:grpSpPr>
      <p:sp>
        <p:nvSpPr>
          <p:cNvPr id="5" name="Table Placeholder 4"/>
          <p:cNvSpPr>
            <a:spLocks noGrp="1"/>
          </p:cNvSpPr>
          <p:nvPr>
            <p:ph type="tbl" sz="quarter" idx="12"/>
          </p:nvPr>
        </p:nvSpPr>
        <p:spPr>
          <a:xfrm>
            <a:off x="457200" y="1360488"/>
            <a:ext cx="4038600" cy="4130675"/>
          </a:xfrm>
        </p:spPr>
        <p:txBody>
          <a:bodyPr/>
          <a:lstStyle>
            <a:lvl1pPr marL="0" indent="0">
              <a:buNone/>
              <a:defRPr/>
            </a:lvl1pPr>
          </a:lstStyle>
          <a:p>
            <a:pPr lvl="0"/>
            <a:r>
              <a:rPr lang="en-US" noProof="0"/>
              <a:t>Click icon to add table</a:t>
            </a:r>
          </a:p>
        </p:txBody>
      </p:sp>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
        <p:nvSpPr>
          <p:cNvPr id="4" name="Content Placeholder 3"/>
          <p:cNvSpPr>
            <a:spLocks noGrp="1"/>
          </p:cNvSpPr>
          <p:nvPr>
            <p:ph sz="half" idx="2"/>
          </p:nvPr>
        </p:nvSpPr>
        <p:spPr>
          <a:xfrm>
            <a:off x="4648200" y="1359925"/>
            <a:ext cx="4038600" cy="4525963"/>
          </a:xfrm>
        </p:spPr>
        <p:txBody>
          <a:bodyPr>
            <a:normAutofit/>
          </a:bodyPr>
          <a:lstStyle>
            <a:lvl1pPr>
              <a:defRPr sz="2400"/>
            </a:lvl1pPr>
            <a:lvl2pPr>
              <a:defRPr sz="2400"/>
            </a:lvl2pPr>
            <a:lvl3pPr>
              <a:defRPr sz="2400"/>
            </a:lvl3pPr>
            <a:lvl4pPr>
              <a:defRPr sz="2000"/>
            </a:lvl4pPr>
            <a:lvl5pPr>
              <a:defRPr sz="20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p:txBody>
      </p:sp>
      <p:sp>
        <p:nvSpPr>
          <p:cNvPr id="8" name="Text Placeholder 7"/>
          <p:cNvSpPr>
            <a:spLocks noGrp="1"/>
          </p:cNvSpPr>
          <p:nvPr>
            <p:ph type="body" sz="quarter" idx="11"/>
          </p:nvPr>
        </p:nvSpPr>
        <p:spPr>
          <a:xfrm>
            <a:off x="457200" y="5491163"/>
            <a:ext cx="4038600" cy="537602"/>
          </a:xfrm>
        </p:spPr>
        <p:txBody>
          <a:bodyPr lIns="0" tIns="72000" rIns="72000">
            <a:noAutofit/>
          </a:bodyPr>
          <a:lstStyle>
            <a:lvl1pPr marL="0" marR="0" indent="0" algn="l" defTabSz="457200" rtl="0" eaLnBrk="1" fontAlgn="auto" latinLnBrk="0" hangingPunct="1">
              <a:lnSpc>
                <a:spcPct val="100000"/>
              </a:lnSpc>
              <a:spcBef>
                <a:spcPct val="20000"/>
              </a:spcBef>
              <a:spcAft>
                <a:spcPts val="0"/>
              </a:spcAft>
              <a:buClrTx/>
              <a:buSzTx/>
              <a:buFont typeface="Lucida Grande"/>
              <a:buNone/>
              <a:tabLst/>
              <a:defRPr sz="1100"/>
            </a:lvl1pPr>
            <a:lvl2pPr>
              <a:defRPr sz="1100"/>
            </a:lvl2pPr>
            <a:lvl3pPr>
              <a:defRPr sz="1100"/>
            </a:lvl3pPr>
            <a:lvl4pPr>
              <a:defRPr sz="1100"/>
            </a:lvl4pPr>
            <a:lvl5pPr>
              <a:defRPr sz="1100"/>
            </a:lvl5pPr>
          </a:lstStyle>
          <a:p>
            <a:pPr lvl="0"/>
            <a:r>
              <a:rPr lang="en-US"/>
              <a:t>Edit Master text styles</a:t>
            </a:r>
          </a:p>
          <a:p>
            <a:pPr lvl="1"/>
            <a:r>
              <a:rPr lang="en-US"/>
              <a:t>Second level</a:t>
            </a:r>
          </a:p>
          <a:p>
            <a:pPr lvl="2"/>
            <a:r>
              <a:rPr lang="en-US"/>
              <a:t>Third level</a:t>
            </a:r>
          </a:p>
        </p:txBody>
      </p:sp>
    </p:spTree>
    <p:extLst>
      <p:ext uri="{BB962C8B-B14F-4D97-AF65-F5344CB8AC3E}">
        <p14:creationId xmlns:p14="http://schemas.microsoft.com/office/powerpoint/2010/main" val="1548815589"/>
      </p:ext>
    </p:extLst>
  </p:cSld>
  <p:clrMapOvr>
    <a:masterClrMapping/>
  </p:clrMapOvr>
</p:sldLayout>
</file>

<file path=ppt/slideLayouts/slideLayout52.xml><?xml version="1.0" encoding="utf-8"?>
<p:sldLayout xmlns:a="http://schemas.openxmlformats.org/drawingml/2006/main" xmlns:r="http://schemas.openxmlformats.org/officeDocument/2006/relationships" xmlns:p="http://schemas.openxmlformats.org/presentationml/2006/main" preserve="1" userDrawn="1">
  <p:cSld name="Title, Content and Chart">
    <p:spTree>
      <p:nvGrpSpPr>
        <p:cNvPr id="1" name=""/>
        <p:cNvGrpSpPr/>
        <p:nvPr/>
      </p:nvGrpSpPr>
      <p:grpSpPr>
        <a:xfrm>
          <a:off x="0" y="0"/>
          <a:ext cx="0" cy="0"/>
          <a:chOff x="0" y="0"/>
          <a:chExt cx="0" cy="0"/>
        </a:xfrm>
      </p:grpSpPr>
      <p:sp>
        <p:nvSpPr>
          <p:cNvPr id="6" name="Chart Placeholder 5"/>
          <p:cNvSpPr>
            <a:spLocks noGrp="1"/>
          </p:cNvSpPr>
          <p:nvPr>
            <p:ph type="chart" sz="quarter" idx="13"/>
          </p:nvPr>
        </p:nvSpPr>
        <p:spPr>
          <a:xfrm>
            <a:off x="457200" y="1360488"/>
            <a:ext cx="4038600" cy="4130675"/>
          </a:xfrm>
        </p:spPr>
        <p:txBody>
          <a:bodyPr/>
          <a:lstStyle>
            <a:lvl1pPr marL="0" marR="0" indent="0" algn="l" defTabSz="457200" rtl="0" eaLnBrk="1" fontAlgn="auto" latinLnBrk="0" hangingPunct="1">
              <a:lnSpc>
                <a:spcPct val="100000"/>
              </a:lnSpc>
              <a:spcBef>
                <a:spcPct val="20000"/>
              </a:spcBef>
              <a:spcAft>
                <a:spcPts val="0"/>
              </a:spcAft>
              <a:buClrTx/>
              <a:buSzTx/>
              <a:buFont typeface="Lucida Grande"/>
              <a:buNone/>
              <a:tabLst/>
              <a:defRPr/>
            </a:lvl1pPr>
          </a:lstStyle>
          <a:p>
            <a:pPr lvl="0"/>
            <a:r>
              <a:rPr lang="en-US" noProof="0"/>
              <a:t>Click icon to add chart</a:t>
            </a:r>
          </a:p>
        </p:txBody>
      </p:sp>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
        <p:nvSpPr>
          <p:cNvPr id="4" name="Content Placeholder 3"/>
          <p:cNvSpPr>
            <a:spLocks noGrp="1"/>
          </p:cNvSpPr>
          <p:nvPr>
            <p:ph sz="half" idx="2"/>
          </p:nvPr>
        </p:nvSpPr>
        <p:spPr>
          <a:xfrm>
            <a:off x="4648200" y="1359925"/>
            <a:ext cx="4038600" cy="4525963"/>
          </a:xfrm>
        </p:spPr>
        <p:txBody>
          <a:bodyPr/>
          <a:lstStyle>
            <a:lvl1pPr>
              <a:defRPr sz="2000"/>
            </a:lvl1pPr>
            <a:lvl2pPr>
              <a:defRPr sz="2000"/>
            </a:lvl2pPr>
            <a:lvl3pPr>
              <a:defRPr sz="2000"/>
            </a:lvl3pPr>
            <a:lvl4pPr>
              <a:defRPr sz="2000"/>
            </a:lvl4pPr>
            <a:lvl5pPr>
              <a:defRPr sz="20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p:txBody>
      </p:sp>
      <p:sp>
        <p:nvSpPr>
          <p:cNvPr id="8" name="Text Placeholder 7"/>
          <p:cNvSpPr>
            <a:spLocks noGrp="1"/>
          </p:cNvSpPr>
          <p:nvPr>
            <p:ph type="body" sz="quarter" idx="11"/>
          </p:nvPr>
        </p:nvSpPr>
        <p:spPr>
          <a:xfrm>
            <a:off x="457200" y="5491163"/>
            <a:ext cx="4038600" cy="537602"/>
          </a:xfrm>
        </p:spPr>
        <p:txBody>
          <a:bodyPr lIns="0" tIns="72000" rIns="72000">
            <a:noAutofit/>
          </a:bodyPr>
          <a:lstStyle>
            <a:lvl1pPr marL="0" marR="0" indent="0" algn="l" defTabSz="457200" rtl="0" eaLnBrk="1" fontAlgn="auto" latinLnBrk="0" hangingPunct="1">
              <a:lnSpc>
                <a:spcPct val="100000"/>
              </a:lnSpc>
              <a:spcBef>
                <a:spcPct val="20000"/>
              </a:spcBef>
              <a:spcAft>
                <a:spcPts val="0"/>
              </a:spcAft>
              <a:buClrTx/>
              <a:buSzTx/>
              <a:buFont typeface="Lucida Grande"/>
              <a:buNone/>
              <a:tabLst/>
              <a:defRPr sz="1100"/>
            </a:lvl1pPr>
            <a:lvl2pPr>
              <a:defRPr sz="1100"/>
            </a:lvl2pPr>
            <a:lvl3pPr>
              <a:defRPr sz="1100"/>
            </a:lvl3pPr>
            <a:lvl4pPr>
              <a:defRPr sz="1100"/>
            </a:lvl4pPr>
            <a:lvl5pPr>
              <a:defRPr sz="1100"/>
            </a:lvl5pPr>
          </a:lstStyle>
          <a:p>
            <a:pPr lvl="0"/>
            <a:r>
              <a:rPr lang="en-US"/>
              <a:t>Edit Master text styles</a:t>
            </a:r>
          </a:p>
          <a:p>
            <a:pPr lvl="1"/>
            <a:r>
              <a:rPr lang="en-US"/>
              <a:t>Second level</a:t>
            </a:r>
          </a:p>
          <a:p>
            <a:pPr lvl="2"/>
            <a:r>
              <a:rPr lang="en-US"/>
              <a:t>Third level</a:t>
            </a:r>
          </a:p>
        </p:txBody>
      </p:sp>
    </p:spTree>
    <p:extLst>
      <p:ext uri="{BB962C8B-B14F-4D97-AF65-F5344CB8AC3E}">
        <p14:creationId xmlns:p14="http://schemas.microsoft.com/office/powerpoint/2010/main" val="1735912939"/>
      </p:ext>
    </p:extLst>
  </p:cSld>
  <p:clrMapOvr>
    <a:masterClrMapping/>
  </p:clrMapOvr>
</p:sldLayout>
</file>

<file path=ppt/slideLayouts/slideLayout53.xml><?xml version="1.0" encoding="utf-8"?>
<p:sldLayout xmlns:a="http://schemas.openxmlformats.org/drawingml/2006/main" xmlns:r="http://schemas.openxmlformats.org/officeDocument/2006/relationships" xmlns:p="http://schemas.openxmlformats.org/presentationml/2006/main" preserve="1" userDrawn="1">
  <p:cSld name="Title and Image">
    <p:spTree>
      <p:nvGrpSpPr>
        <p:cNvPr id="1" name=""/>
        <p:cNvGrpSpPr/>
        <p:nvPr/>
      </p:nvGrpSpPr>
      <p:grpSpPr>
        <a:xfrm>
          <a:off x="0" y="0"/>
          <a:ext cx="0" cy="0"/>
          <a:chOff x="0" y="0"/>
          <a:chExt cx="0" cy="0"/>
        </a:xfrm>
      </p:grpSpPr>
      <p:sp>
        <p:nvSpPr>
          <p:cNvPr id="5" name="Picture Placeholder 4"/>
          <p:cNvSpPr>
            <a:spLocks noGrp="1"/>
          </p:cNvSpPr>
          <p:nvPr>
            <p:ph type="pic" sz="quarter" idx="10"/>
          </p:nvPr>
        </p:nvSpPr>
        <p:spPr/>
        <p:txBody>
          <a:bodyPr anchor="ctr" anchorCtr="1"/>
          <a:lstStyle>
            <a:lvl1pPr marL="0" indent="0" algn="ctr">
              <a:buNone/>
              <a:defRPr baseline="0"/>
            </a:lvl1pPr>
          </a:lstStyle>
          <a:p>
            <a:pPr lvl="0"/>
            <a:r>
              <a:rPr lang="en-US" noProof="0"/>
              <a:t>Click icon to add picture</a:t>
            </a:r>
          </a:p>
        </p:txBody>
      </p:sp>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Tree>
    <p:extLst>
      <p:ext uri="{BB962C8B-B14F-4D97-AF65-F5344CB8AC3E}">
        <p14:creationId xmlns:p14="http://schemas.microsoft.com/office/powerpoint/2010/main" val="485818396"/>
      </p:ext>
    </p:extLst>
  </p:cSld>
  <p:clrMapOvr>
    <a:masterClrMapping/>
  </p:clrMapOvr>
</p:sldLayout>
</file>

<file path=ppt/slideLayouts/slideLayout5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1"/>
                </a:solidFill>
              </a:defRPr>
            </a:lvl1pPr>
          </a:lstStyle>
          <a:p>
            <a:r>
              <a:rPr lang="en-US"/>
              <a:t>Click to edit Master title style</a:t>
            </a:r>
          </a:p>
        </p:txBody>
      </p:sp>
    </p:spTree>
    <p:extLst>
      <p:ext uri="{BB962C8B-B14F-4D97-AF65-F5344CB8AC3E}">
        <p14:creationId xmlns:p14="http://schemas.microsoft.com/office/powerpoint/2010/main" val="4085308544"/>
      </p:ext>
    </p:extLst>
  </p:cSld>
  <p:clrMapOvr>
    <a:masterClrMapping/>
  </p:clrMapOvr>
</p:sldLayout>
</file>

<file path=ppt/slideLayouts/slideLayout5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406984422"/>
      </p:ext>
    </p:extLst>
  </p:cSld>
  <p:clrMapOvr>
    <a:masterClrMapping/>
  </p:clrMapOvr>
</p:sldLayout>
</file>

<file path=ppt/slideLayouts/slideLayout56.xml><?xml version="1.0" encoding="utf-8"?>
<p:sldLayout xmlns:a="http://schemas.openxmlformats.org/drawingml/2006/main" xmlns:r="http://schemas.openxmlformats.org/officeDocument/2006/relationships" xmlns:p="http://schemas.openxmlformats.org/presentationml/2006/main" preserve="1" userDrawn="1">
  <p:cSld name="Section Divider - Option 1">
    <p:spTree>
      <p:nvGrpSpPr>
        <p:cNvPr id="1" name=""/>
        <p:cNvGrpSpPr/>
        <p:nvPr/>
      </p:nvGrpSpPr>
      <p:grpSpPr>
        <a:xfrm>
          <a:off x="0" y="0"/>
          <a:ext cx="0" cy="0"/>
          <a:chOff x="0" y="0"/>
          <a:chExt cx="0" cy="0"/>
        </a:xfrm>
      </p:grpSpPr>
      <p:sp>
        <p:nvSpPr>
          <p:cNvPr id="6" name="Rectangle 5"/>
          <p:cNvSpPr/>
          <p:nvPr userDrawn="1"/>
        </p:nvSpPr>
        <p:spPr>
          <a:xfrm>
            <a:off x="0" y="0"/>
            <a:ext cx="9144000" cy="6858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solidFill>
                <a:schemeClr val="bg1"/>
              </a:solidFill>
            </a:endParaRPr>
          </a:p>
        </p:txBody>
      </p:sp>
      <p:pic>
        <p:nvPicPr>
          <p:cNvPr id="8" name="Picture 7" descr="USY_MB1_PMS_1_Colour_Reversed_Logo.png"/>
          <p:cNvPicPr>
            <a:picLocks noChangeAspect="1"/>
          </p:cNvPicPr>
          <p:nvPr/>
        </p:nvPicPr>
        <p:blipFill>
          <a:blip r:embed="rId2" cstate="screen">
            <a:extLst>
              <a:ext uri="{28A0092B-C50C-407E-A947-70E740481C1C}">
                <a14:useLocalDpi xmlns:a14="http://schemas.microsoft.com/office/drawing/2010/main"/>
              </a:ext>
            </a:extLst>
          </a:blip>
          <a:srcRect/>
          <a:stretch>
            <a:fillRect/>
          </a:stretch>
        </p:blipFill>
        <p:spPr bwMode="auto">
          <a:xfrm>
            <a:off x="454025" y="5905500"/>
            <a:ext cx="1536700" cy="5302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9" name="Title 8"/>
          <p:cNvSpPr>
            <a:spLocks noGrp="1"/>
          </p:cNvSpPr>
          <p:nvPr>
            <p:ph type="title"/>
          </p:nvPr>
        </p:nvSpPr>
        <p:spPr>
          <a:xfrm>
            <a:off x="381884" y="348302"/>
            <a:ext cx="8388586" cy="443577"/>
          </a:xfrm>
        </p:spPr>
        <p:txBody>
          <a:bodyPr anchor="t"/>
          <a:lstStyle>
            <a:lvl1pPr>
              <a:defRPr sz="2800" baseline="0">
                <a:solidFill>
                  <a:schemeClr val="accent1"/>
                </a:solidFill>
              </a:defRPr>
            </a:lvl1pPr>
          </a:lstStyle>
          <a:p>
            <a:r>
              <a:rPr lang="en-US"/>
              <a:t>Click to edit Master title style</a:t>
            </a:r>
          </a:p>
        </p:txBody>
      </p:sp>
      <p:sp>
        <p:nvSpPr>
          <p:cNvPr id="5" name="Text Placeholder 4"/>
          <p:cNvSpPr>
            <a:spLocks noGrp="1"/>
          </p:cNvSpPr>
          <p:nvPr>
            <p:ph type="body" sz="quarter" idx="11"/>
          </p:nvPr>
        </p:nvSpPr>
        <p:spPr>
          <a:xfrm>
            <a:off x="382765" y="799353"/>
            <a:ext cx="8387705" cy="852488"/>
          </a:xfrm>
        </p:spPr>
        <p:txBody>
          <a:bodyPr/>
          <a:lstStyle>
            <a:lvl1pPr marL="0" indent="0">
              <a:lnSpc>
                <a:spcPct val="90000"/>
              </a:lnSpc>
              <a:buNone/>
              <a:defRPr sz="2400">
                <a:solidFill>
                  <a:schemeClr val="tx1"/>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a:t>Edit Master text styles</a:t>
            </a:r>
          </a:p>
        </p:txBody>
      </p:sp>
      <p:sp>
        <p:nvSpPr>
          <p:cNvPr id="7" name="Picture Placeholder 13"/>
          <p:cNvSpPr>
            <a:spLocks noGrp="1"/>
          </p:cNvSpPr>
          <p:nvPr>
            <p:ph type="pic" sz="quarter" idx="12"/>
          </p:nvPr>
        </p:nvSpPr>
        <p:spPr>
          <a:xfrm>
            <a:off x="454455" y="1800412"/>
            <a:ext cx="8226486" cy="4635496"/>
          </a:xfrm>
          <a:solidFill>
            <a:srgbClr val="D9D9D9"/>
          </a:solidFill>
        </p:spPr>
        <p:txBody>
          <a:bodyPr anchor="ctr" anchorCtr="0"/>
          <a:lstStyle>
            <a:lvl1pPr marL="0" indent="0" algn="ctr">
              <a:buNone/>
              <a:defRPr/>
            </a:lvl1pPr>
          </a:lstStyle>
          <a:p>
            <a:pPr lvl="0"/>
            <a:r>
              <a:rPr lang="en-US" noProof="0"/>
              <a:t>Click icon to add picture</a:t>
            </a:r>
          </a:p>
        </p:txBody>
      </p:sp>
    </p:spTree>
    <p:extLst>
      <p:ext uri="{BB962C8B-B14F-4D97-AF65-F5344CB8AC3E}">
        <p14:creationId xmlns:p14="http://schemas.microsoft.com/office/powerpoint/2010/main" val="2708874329"/>
      </p:ext>
    </p:extLst>
  </p:cSld>
  <p:clrMapOvr>
    <a:masterClrMapping/>
  </p:clrMapOvr>
</p:sldLayout>
</file>

<file path=ppt/slideLayouts/slideLayout57.xml><?xml version="1.0" encoding="utf-8"?>
<p:sldLayout xmlns:a="http://schemas.openxmlformats.org/drawingml/2006/main" xmlns:r="http://schemas.openxmlformats.org/officeDocument/2006/relationships" xmlns:p="http://schemas.openxmlformats.org/presentationml/2006/main" preserve="1" userDrawn="1">
  <p:cSld name="1_Section Divider - Option 2">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solidFill>
            <a:srgbClr val="0148A4"/>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rgbClr val="FFB800"/>
              </a:solidFill>
            </a:endParaRPr>
          </a:p>
        </p:txBody>
      </p:sp>
      <p:sp>
        <p:nvSpPr>
          <p:cNvPr id="9" name="Title 8"/>
          <p:cNvSpPr>
            <a:spLocks noGrp="1"/>
          </p:cNvSpPr>
          <p:nvPr>
            <p:ph type="title"/>
          </p:nvPr>
        </p:nvSpPr>
        <p:spPr>
          <a:xfrm>
            <a:off x="381884" y="1797599"/>
            <a:ext cx="3948874" cy="443577"/>
          </a:xfrm>
        </p:spPr>
        <p:txBody>
          <a:bodyPr anchor="t"/>
          <a:lstStyle>
            <a:lvl1pPr>
              <a:defRPr baseline="0">
                <a:solidFill>
                  <a:schemeClr val="bg1"/>
                </a:solidFill>
              </a:defRPr>
            </a:lvl1pPr>
          </a:lstStyle>
          <a:p>
            <a:r>
              <a:rPr lang="en-US"/>
              <a:t>Click to edit Master title style</a:t>
            </a:r>
          </a:p>
        </p:txBody>
      </p:sp>
      <p:sp>
        <p:nvSpPr>
          <p:cNvPr id="5" name="Text Placeholder 4"/>
          <p:cNvSpPr>
            <a:spLocks noGrp="1"/>
          </p:cNvSpPr>
          <p:nvPr>
            <p:ph type="body" sz="quarter" idx="11"/>
          </p:nvPr>
        </p:nvSpPr>
        <p:spPr>
          <a:xfrm>
            <a:off x="382766" y="2248650"/>
            <a:ext cx="3947992" cy="852488"/>
          </a:xfrm>
        </p:spPr>
        <p:txBody>
          <a:bodyPr/>
          <a:lstStyle>
            <a:lvl1pPr marL="0" indent="0">
              <a:lnSpc>
                <a:spcPct val="90000"/>
              </a:lnSpc>
              <a:buNone/>
              <a:defRPr sz="2400">
                <a:solidFill>
                  <a:schemeClr val="bg1"/>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a:t>Edit Master text styles</a:t>
            </a:r>
          </a:p>
        </p:txBody>
      </p:sp>
      <p:pic>
        <p:nvPicPr>
          <p:cNvPr id="8" name="Picture 7"/>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723180"/>
            <a:ext cx="1565468" cy="793655"/>
          </a:xfrm>
          <a:prstGeom prst="rect">
            <a:avLst/>
          </a:prstGeom>
        </p:spPr>
      </p:pic>
    </p:spTree>
    <p:extLst>
      <p:ext uri="{BB962C8B-B14F-4D97-AF65-F5344CB8AC3E}">
        <p14:creationId xmlns:p14="http://schemas.microsoft.com/office/powerpoint/2010/main" val="914695799"/>
      </p:ext>
    </p:extLst>
  </p:cSld>
  <p:clrMapOvr>
    <a:masterClrMapping/>
  </p:clrMapOvr>
</p:sldLayout>
</file>

<file path=ppt/slideLayouts/slideLayout58.xml><?xml version="1.0" encoding="utf-8"?>
<p:sldLayout xmlns:a="http://schemas.openxmlformats.org/drawingml/2006/main" xmlns:r="http://schemas.openxmlformats.org/officeDocument/2006/relationships" xmlns:p="http://schemas.openxmlformats.org/presentationml/2006/main" preserve="1" userDrawn="1">
  <p:cSld name="Section Divider - Option 3">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solidFill>
            <a:srgbClr val="424242"/>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rgbClr val="FFB800"/>
              </a:solidFill>
            </a:endParaRPr>
          </a:p>
        </p:txBody>
      </p:sp>
      <p:sp>
        <p:nvSpPr>
          <p:cNvPr id="9" name="Title 8"/>
          <p:cNvSpPr>
            <a:spLocks noGrp="1"/>
          </p:cNvSpPr>
          <p:nvPr>
            <p:ph type="title"/>
          </p:nvPr>
        </p:nvSpPr>
        <p:spPr>
          <a:xfrm>
            <a:off x="381884" y="1797599"/>
            <a:ext cx="3948874" cy="443577"/>
          </a:xfrm>
        </p:spPr>
        <p:txBody>
          <a:bodyPr anchor="t"/>
          <a:lstStyle>
            <a:lvl1pPr>
              <a:defRPr baseline="0">
                <a:solidFill>
                  <a:schemeClr val="tx1"/>
                </a:solidFill>
              </a:defRPr>
            </a:lvl1pPr>
          </a:lstStyle>
          <a:p>
            <a:r>
              <a:rPr lang="en-US"/>
              <a:t>Click to edit Master title style</a:t>
            </a:r>
          </a:p>
        </p:txBody>
      </p:sp>
      <p:sp>
        <p:nvSpPr>
          <p:cNvPr id="5" name="Text Placeholder 4"/>
          <p:cNvSpPr>
            <a:spLocks noGrp="1"/>
          </p:cNvSpPr>
          <p:nvPr>
            <p:ph type="body" sz="quarter" idx="11"/>
          </p:nvPr>
        </p:nvSpPr>
        <p:spPr>
          <a:xfrm>
            <a:off x="382766" y="2248650"/>
            <a:ext cx="3947992" cy="852488"/>
          </a:xfrm>
        </p:spPr>
        <p:txBody>
          <a:bodyPr/>
          <a:lstStyle>
            <a:lvl1pPr marL="0" indent="0">
              <a:lnSpc>
                <a:spcPct val="90000"/>
              </a:lnSpc>
              <a:buNone/>
              <a:defRPr sz="2400">
                <a:solidFill>
                  <a:schemeClr val="tx1"/>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a:t>Edit Master text styles</a:t>
            </a:r>
          </a:p>
        </p:txBody>
      </p:sp>
      <p:pic>
        <p:nvPicPr>
          <p:cNvPr id="7" name="Picture 6"/>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723180"/>
            <a:ext cx="1565468" cy="793655"/>
          </a:xfrm>
          <a:prstGeom prst="rect">
            <a:avLst/>
          </a:prstGeom>
        </p:spPr>
      </p:pic>
    </p:spTree>
    <p:extLst>
      <p:ext uri="{BB962C8B-B14F-4D97-AF65-F5344CB8AC3E}">
        <p14:creationId xmlns:p14="http://schemas.microsoft.com/office/powerpoint/2010/main" val="2269376326"/>
      </p:ext>
    </p:extLst>
  </p:cSld>
  <p:clrMapOvr>
    <a:masterClrMapping/>
  </p:clrMapOvr>
</p:sldLayout>
</file>

<file path=ppt/slideLayouts/slideLayout59.xml><?xml version="1.0" encoding="utf-8"?>
<p:sldLayout xmlns:a="http://schemas.openxmlformats.org/drawingml/2006/main" xmlns:r="http://schemas.openxmlformats.org/officeDocument/2006/relationships" xmlns:p="http://schemas.openxmlformats.org/presentationml/2006/main" preserve="1" userDrawn="1">
  <p:cSld name="Section Divider - Option 4">
    <p:spTree>
      <p:nvGrpSpPr>
        <p:cNvPr id="1" name=""/>
        <p:cNvGrpSpPr/>
        <p:nvPr/>
      </p:nvGrpSpPr>
      <p:grpSpPr>
        <a:xfrm>
          <a:off x="0" y="0"/>
          <a:ext cx="0" cy="0"/>
          <a:chOff x="0" y="0"/>
          <a:chExt cx="0" cy="0"/>
        </a:xfrm>
      </p:grpSpPr>
      <p:sp>
        <p:nvSpPr>
          <p:cNvPr id="6" name="Rectangle 5"/>
          <p:cNvSpPr/>
          <p:nvPr userDrawn="1"/>
        </p:nvSpPr>
        <p:spPr>
          <a:xfrm>
            <a:off x="0" y="1"/>
            <a:ext cx="9144001" cy="6858000"/>
          </a:xfrm>
          <a:prstGeom prst="rect">
            <a:avLst/>
          </a:prstGeom>
          <a:solidFill>
            <a:srgbClr val="FFB800"/>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rgbClr val="FFB800"/>
              </a:solidFill>
            </a:endParaRPr>
          </a:p>
        </p:txBody>
      </p:sp>
      <p:sp>
        <p:nvSpPr>
          <p:cNvPr id="9" name="Title 8"/>
          <p:cNvSpPr>
            <a:spLocks noGrp="1"/>
          </p:cNvSpPr>
          <p:nvPr>
            <p:ph type="title"/>
          </p:nvPr>
        </p:nvSpPr>
        <p:spPr>
          <a:xfrm>
            <a:off x="381884" y="1797599"/>
            <a:ext cx="3948874" cy="443577"/>
          </a:xfrm>
        </p:spPr>
        <p:txBody>
          <a:bodyPr anchor="t"/>
          <a:lstStyle>
            <a:lvl1pPr>
              <a:defRPr baseline="0">
                <a:solidFill>
                  <a:schemeClr val="bg1"/>
                </a:solidFill>
              </a:defRPr>
            </a:lvl1pPr>
          </a:lstStyle>
          <a:p>
            <a:r>
              <a:rPr lang="en-US"/>
              <a:t>Click to edit Master title style</a:t>
            </a:r>
          </a:p>
        </p:txBody>
      </p:sp>
      <p:sp>
        <p:nvSpPr>
          <p:cNvPr id="5" name="Text Placeholder 4"/>
          <p:cNvSpPr>
            <a:spLocks noGrp="1"/>
          </p:cNvSpPr>
          <p:nvPr>
            <p:ph type="body" sz="quarter" idx="11"/>
          </p:nvPr>
        </p:nvSpPr>
        <p:spPr>
          <a:xfrm>
            <a:off x="382766" y="2248650"/>
            <a:ext cx="3947992" cy="852488"/>
          </a:xfrm>
        </p:spPr>
        <p:txBody>
          <a:bodyPr/>
          <a:lstStyle>
            <a:lvl1pPr marL="0" indent="0">
              <a:lnSpc>
                <a:spcPct val="90000"/>
              </a:lnSpc>
              <a:buNone/>
              <a:defRPr sz="2400">
                <a:solidFill>
                  <a:schemeClr val="bg1"/>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a:t>Edit Master text styles</a:t>
            </a:r>
          </a:p>
        </p:txBody>
      </p:sp>
      <p:pic>
        <p:nvPicPr>
          <p:cNvPr id="8" name="Picture 7" descr="Uni-Sydney-logo-lockup-mono-BMC.eps"/>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457970" y="5699516"/>
            <a:ext cx="1565468" cy="840984"/>
          </a:xfrm>
          <a:prstGeom prst="rect">
            <a:avLst/>
          </a:prstGeom>
        </p:spPr>
      </p:pic>
    </p:spTree>
    <p:extLst>
      <p:ext uri="{BB962C8B-B14F-4D97-AF65-F5344CB8AC3E}">
        <p14:creationId xmlns:p14="http://schemas.microsoft.com/office/powerpoint/2010/main" val="3519259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4_Title slide – Red option 4">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576A394-6B1F-4D42-AB9D-E8AC240619B4}"/>
              </a:ext>
            </a:extLst>
          </p:cNvPr>
          <p:cNvSpPr/>
          <p:nvPr userDrawn="1"/>
        </p:nvSpPr>
        <p:spPr>
          <a:xfrm>
            <a:off x="0" y="17364"/>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0" name="Picture 9" descr="A close up of a logo&#10;&#10;Description automatically generated">
            <a:extLst>
              <a:ext uri="{FF2B5EF4-FFF2-40B4-BE49-F238E27FC236}">
                <a16:creationId xmlns:a16="http://schemas.microsoft.com/office/drawing/2014/main" id="{1811C849-DF8E-4316-9166-B19E70AB320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4" name="Picture 13" descr="A view of a large building&#10;&#10;Description automatically generated">
            <a:extLst>
              <a:ext uri="{FF2B5EF4-FFF2-40B4-BE49-F238E27FC236}">
                <a16:creationId xmlns:a16="http://schemas.microsoft.com/office/drawing/2014/main" id="{24F1E7D3-CFB1-DF4E-96E4-6210BAC6FB4A}"/>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453334" y="0"/>
            <a:ext cx="4690665" cy="6875364"/>
          </a:xfrm>
          <a:prstGeom prst="rect">
            <a:avLst/>
          </a:prstGeom>
        </p:spPr>
      </p:pic>
      <p:sp>
        <p:nvSpPr>
          <p:cNvPr id="9" name="Title 8">
            <a:extLst>
              <a:ext uri="{FF2B5EF4-FFF2-40B4-BE49-F238E27FC236}">
                <a16:creationId xmlns:a16="http://schemas.microsoft.com/office/drawing/2014/main" id="{193FD27B-FAA6-5146-83B6-51116F88C944}"/>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11" name="Text Placeholder 4">
            <a:extLst>
              <a:ext uri="{FF2B5EF4-FFF2-40B4-BE49-F238E27FC236}">
                <a16:creationId xmlns:a16="http://schemas.microsoft.com/office/drawing/2014/main" id="{75385F31-8F09-6A45-AFFF-B72CD3787A00}"/>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7418176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5_Title slide – Red option 4">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576A394-6B1F-4D42-AB9D-E8AC240619B4}"/>
              </a:ext>
            </a:extLst>
          </p:cNvPr>
          <p:cNvSpPr/>
          <p:nvPr userDrawn="1"/>
        </p:nvSpPr>
        <p:spPr>
          <a:xfrm>
            <a:off x="1"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0" name="Picture 9" descr="A close up of a logo&#10;&#10;Description automatically generated">
            <a:extLst>
              <a:ext uri="{FF2B5EF4-FFF2-40B4-BE49-F238E27FC236}">
                <a16:creationId xmlns:a16="http://schemas.microsoft.com/office/drawing/2014/main" id="{1811C849-DF8E-4316-9166-B19E70AB320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1" name="Picture 10" descr="A view of a large window&#10;&#10;Description automatically generated">
            <a:extLst>
              <a:ext uri="{FF2B5EF4-FFF2-40B4-BE49-F238E27FC236}">
                <a16:creationId xmlns:a16="http://schemas.microsoft.com/office/drawing/2014/main" id="{6448CA2D-2D83-6F40-B080-DAE168D45EFB}"/>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467666" y="606"/>
            <a:ext cx="4680103" cy="6857394"/>
          </a:xfrm>
          <a:prstGeom prst="rect">
            <a:avLst/>
          </a:prstGeom>
        </p:spPr>
      </p:pic>
      <p:sp>
        <p:nvSpPr>
          <p:cNvPr id="9" name="Title 8">
            <a:extLst>
              <a:ext uri="{FF2B5EF4-FFF2-40B4-BE49-F238E27FC236}">
                <a16:creationId xmlns:a16="http://schemas.microsoft.com/office/drawing/2014/main" id="{A30F13B7-229E-5241-B814-6E82C23DC922}"/>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12" name="Text Placeholder 4">
            <a:extLst>
              <a:ext uri="{FF2B5EF4-FFF2-40B4-BE49-F238E27FC236}">
                <a16:creationId xmlns:a16="http://schemas.microsoft.com/office/drawing/2014/main" id="{0FD801D8-52D3-ED4C-9286-C21422F9D5A9}"/>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1410959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6_Title slide – Red option 4">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576A394-6B1F-4D42-AB9D-E8AC240619B4}"/>
              </a:ext>
            </a:extLst>
          </p:cNvPr>
          <p:cNvSpPr/>
          <p:nvPr userDrawn="1"/>
        </p:nvSpPr>
        <p:spPr>
          <a:xfrm>
            <a:off x="0"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0" name="Picture 9" descr="A close up of a logo&#10;&#10;Description automatically generated">
            <a:extLst>
              <a:ext uri="{FF2B5EF4-FFF2-40B4-BE49-F238E27FC236}">
                <a16:creationId xmlns:a16="http://schemas.microsoft.com/office/drawing/2014/main" id="{1811C849-DF8E-4316-9166-B19E70AB320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9" name="Picture 8" descr="A bench in front of a building&#10;&#10;Description automatically generated">
            <a:extLst>
              <a:ext uri="{FF2B5EF4-FFF2-40B4-BE49-F238E27FC236}">
                <a16:creationId xmlns:a16="http://schemas.microsoft.com/office/drawing/2014/main" id="{595D4B98-EC35-6E4E-B52D-B38B0E0CB2F5}"/>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b="-2283"/>
          <a:stretch/>
        </p:blipFill>
        <p:spPr>
          <a:xfrm>
            <a:off x="4467664" y="0"/>
            <a:ext cx="4676336" cy="7014504"/>
          </a:xfrm>
          <a:prstGeom prst="rect">
            <a:avLst/>
          </a:prstGeom>
        </p:spPr>
      </p:pic>
      <p:sp>
        <p:nvSpPr>
          <p:cNvPr id="11" name="Title 8">
            <a:extLst>
              <a:ext uri="{FF2B5EF4-FFF2-40B4-BE49-F238E27FC236}">
                <a16:creationId xmlns:a16="http://schemas.microsoft.com/office/drawing/2014/main" id="{4B7D9D05-70A7-7340-98E2-3EC55807DF76}"/>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12" name="Text Placeholder 4">
            <a:extLst>
              <a:ext uri="{FF2B5EF4-FFF2-40B4-BE49-F238E27FC236}">
                <a16:creationId xmlns:a16="http://schemas.microsoft.com/office/drawing/2014/main" id="{50464F8C-4239-7249-B7AD-71C0585F6180}"/>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7032725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7_Title slide – Red option 4">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576A394-6B1F-4D42-AB9D-E8AC240619B4}"/>
              </a:ext>
            </a:extLst>
          </p:cNvPr>
          <p:cNvSpPr/>
          <p:nvPr userDrawn="1"/>
        </p:nvSpPr>
        <p:spPr>
          <a:xfrm>
            <a:off x="1" y="0"/>
            <a:ext cx="4587876" cy="6858000"/>
          </a:xfrm>
          <a:prstGeom prst="rect">
            <a:avLst/>
          </a:prstGeom>
          <a:solidFill>
            <a:srgbClr val="E64626"/>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a:p>
        </p:txBody>
      </p:sp>
      <p:pic>
        <p:nvPicPr>
          <p:cNvPr id="10" name="Picture 9" descr="A close up of a logo&#10;&#10;Description automatically generated">
            <a:extLst>
              <a:ext uri="{FF2B5EF4-FFF2-40B4-BE49-F238E27FC236}">
                <a16:creationId xmlns:a16="http://schemas.microsoft.com/office/drawing/2014/main" id="{1811C849-DF8E-4316-9166-B19E70AB3203}"/>
              </a:ext>
            </a:extLst>
          </p:cNvPr>
          <p:cNvPicPr>
            <a:picLocks noChangeAspect="1"/>
          </p:cNvPicPr>
          <p:nvPr userDrawn="1"/>
        </p:nvPicPr>
        <p:blipFill>
          <a:blip r:embed="rId2" cstate="email">
            <a:extLst>
              <a:ext uri="{28A0092B-C50C-407E-A947-70E740481C1C}">
                <a14:useLocalDpi xmlns:a14="http://schemas.microsoft.com/office/drawing/2010/main"/>
              </a:ext>
            </a:extLst>
          </a:blip>
          <a:stretch>
            <a:fillRect/>
          </a:stretch>
        </p:blipFill>
        <p:spPr>
          <a:xfrm>
            <a:off x="194038" y="5145627"/>
            <a:ext cx="1874520" cy="874776"/>
          </a:xfrm>
          <a:prstGeom prst="rect">
            <a:avLst/>
          </a:prstGeom>
        </p:spPr>
      </p:pic>
      <p:pic>
        <p:nvPicPr>
          <p:cNvPr id="11" name="Picture 10" descr="A close up of a brick building&#10;&#10;Description automatically generated">
            <a:extLst>
              <a:ext uri="{FF2B5EF4-FFF2-40B4-BE49-F238E27FC236}">
                <a16:creationId xmlns:a16="http://schemas.microsoft.com/office/drawing/2014/main" id="{937BE605-3862-1545-9D7B-F5F181FA5E3D}"/>
              </a:ext>
            </a:extLst>
          </p:cNvPr>
          <p:cNvPicPr>
            <a:picLocks noChangeAspect="1"/>
          </p:cNvPicPr>
          <p:nvPr userDrawn="1"/>
        </p:nvPicPr>
        <p:blipFill rotWithShape="1">
          <a:blip r:embed="rId3" cstate="email">
            <a:extLst>
              <a:ext uri="{28A0092B-C50C-407E-A947-70E740481C1C}">
                <a14:useLocalDpi xmlns:a14="http://schemas.microsoft.com/office/drawing/2010/main"/>
              </a:ext>
            </a:extLst>
          </a:blip>
          <a:srcRect/>
          <a:stretch/>
        </p:blipFill>
        <p:spPr>
          <a:xfrm>
            <a:off x="4467664" y="-1"/>
            <a:ext cx="4694049" cy="6858001"/>
          </a:xfrm>
          <a:prstGeom prst="rect">
            <a:avLst/>
          </a:prstGeom>
        </p:spPr>
      </p:pic>
      <p:sp>
        <p:nvSpPr>
          <p:cNvPr id="9" name="Title 8">
            <a:extLst>
              <a:ext uri="{FF2B5EF4-FFF2-40B4-BE49-F238E27FC236}">
                <a16:creationId xmlns:a16="http://schemas.microsoft.com/office/drawing/2014/main" id="{50535163-46A9-7748-B4B1-2CCCDB1A63E9}"/>
              </a:ext>
            </a:extLst>
          </p:cNvPr>
          <p:cNvSpPr>
            <a:spLocks noGrp="1"/>
          </p:cNvSpPr>
          <p:nvPr>
            <p:ph type="title"/>
          </p:nvPr>
        </p:nvSpPr>
        <p:spPr>
          <a:xfrm>
            <a:off x="381885" y="588356"/>
            <a:ext cx="3948874" cy="1322972"/>
          </a:xfrm>
          <a:prstGeom prst="rect">
            <a:avLst/>
          </a:prstGeom>
        </p:spPr>
        <p:txBody>
          <a:bodyPr anchor="t"/>
          <a:lstStyle>
            <a:lvl1pPr>
              <a:defRPr sz="2250">
                <a:solidFill>
                  <a:schemeClr val="bg1"/>
                </a:solidFill>
                <a:latin typeface="+mj-lt"/>
                <a:cs typeface="Arial" panose="020B0604020202020204" pitchFamily="34" charset="0"/>
              </a:defRPr>
            </a:lvl1pPr>
          </a:lstStyle>
          <a:p>
            <a:r>
              <a:rPr lang="en-US"/>
              <a:t>Click to edit Master title style</a:t>
            </a:r>
          </a:p>
        </p:txBody>
      </p:sp>
      <p:sp>
        <p:nvSpPr>
          <p:cNvPr id="12" name="Text Placeholder 4">
            <a:extLst>
              <a:ext uri="{FF2B5EF4-FFF2-40B4-BE49-F238E27FC236}">
                <a16:creationId xmlns:a16="http://schemas.microsoft.com/office/drawing/2014/main" id="{C9A982C3-1052-544B-B943-34291F9E9BA1}"/>
              </a:ext>
            </a:extLst>
          </p:cNvPr>
          <p:cNvSpPr>
            <a:spLocks noGrp="1"/>
          </p:cNvSpPr>
          <p:nvPr>
            <p:ph type="body" sz="quarter" idx="11"/>
          </p:nvPr>
        </p:nvSpPr>
        <p:spPr>
          <a:xfrm>
            <a:off x="366942" y="1963248"/>
            <a:ext cx="3963817" cy="3023356"/>
          </a:xfrm>
          <a:prstGeom prst="rect">
            <a:avLst/>
          </a:prstGeom>
        </p:spPr>
        <p:txBody>
          <a:bodyPr>
            <a:noAutofit/>
          </a:bodyPr>
          <a:lstStyle>
            <a:lvl1pPr marL="0" indent="0">
              <a:lnSpc>
                <a:spcPct val="90000"/>
              </a:lnSpc>
              <a:buNone/>
              <a:defRPr sz="1800"/>
            </a:lvl1pPr>
            <a:lvl2pPr marL="257175" indent="0">
              <a:buNone/>
              <a:defRPr sz="1800"/>
            </a:lvl2pPr>
            <a:lvl3pPr marL="514350" indent="0">
              <a:buNone/>
              <a:defRPr sz="1800"/>
            </a:lvl3pPr>
            <a:lvl4pPr marL="771525" indent="0">
              <a:buNone/>
              <a:defRPr/>
            </a:lvl4pPr>
            <a:lvl5pPr marL="1028700" indent="0">
              <a:buNone/>
              <a:defRPr/>
            </a:lvl5pPr>
          </a:lstStyle>
          <a:p>
            <a:pPr lvl="0"/>
            <a:r>
              <a:rPr lang="en-US"/>
              <a:t>Click to edit Master text styles</a:t>
            </a:r>
          </a:p>
          <a:p>
            <a:pPr lvl="1"/>
            <a:r>
              <a:rPr lang="en-US"/>
              <a:t>Second level</a:t>
            </a:r>
          </a:p>
          <a:p>
            <a:pPr lvl="2"/>
            <a:r>
              <a:rPr lang="en-US"/>
              <a:t>Third level</a:t>
            </a:r>
          </a:p>
        </p:txBody>
      </p:sp>
    </p:spTree>
    <p:extLst>
      <p:ext uri="{BB962C8B-B14F-4D97-AF65-F5344CB8AC3E}">
        <p14:creationId xmlns:p14="http://schemas.microsoft.com/office/powerpoint/2010/main" val="2506676800"/>
      </p:ext>
    </p:extLst>
  </p:cSld>
  <p:clrMapOvr>
    <a:masterClrMapping/>
  </p:clrMapOvr>
</p:sldLayout>
</file>

<file path=ppt/slideMasters/_rels/slideMaster1.xml.rels><?xml version="1.0" encoding="UTF-8" standalone="yes"?>
<Relationships xmlns="http://schemas.openxmlformats.org/package/2006/relationships"><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21" Type="http://schemas.openxmlformats.org/officeDocument/2006/relationships/slideLayout" Target="../slideLayouts/slideLayout21.xml"/><Relationship Id="rId34" Type="http://schemas.openxmlformats.org/officeDocument/2006/relationships/slideLayout" Target="../slideLayouts/slideLayout34.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33" Type="http://schemas.openxmlformats.org/officeDocument/2006/relationships/slideLayout" Target="../slideLayouts/slideLayout33.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29" Type="http://schemas.openxmlformats.org/officeDocument/2006/relationships/slideLayout" Target="../slideLayouts/slideLayout29.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32" Type="http://schemas.openxmlformats.org/officeDocument/2006/relationships/slideLayout" Target="../slideLayouts/slideLayout32.xml"/><Relationship Id="rId37" Type="http://schemas.openxmlformats.org/officeDocument/2006/relationships/theme" Target="../theme/theme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slideLayout" Target="../slideLayouts/slideLayout28.xml"/><Relationship Id="rId36" Type="http://schemas.openxmlformats.org/officeDocument/2006/relationships/slideLayout" Target="../slideLayouts/slideLayout36.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31" Type="http://schemas.openxmlformats.org/officeDocument/2006/relationships/slideLayout" Target="../slideLayouts/slideLayout3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 Id="rId30" Type="http://schemas.openxmlformats.org/officeDocument/2006/relationships/slideLayout" Target="../slideLayouts/slideLayout30.xml"/><Relationship Id="rId35" Type="http://schemas.openxmlformats.org/officeDocument/2006/relationships/slideLayout" Target="../slideLayouts/slideLayout35.xml"/><Relationship Id="rId8" Type="http://schemas.openxmlformats.org/officeDocument/2006/relationships/slideLayout" Target="../slideLayouts/slideLayout8.xml"/><Relationship Id="rId3" Type="http://schemas.openxmlformats.org/officeDocument/2006/relationships/slideLayout" Target="../slideLayouts/slideLayout3.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44.xml"/><Relationship Id="rId13" Type="http://schemas.openxmlformats.org/officeDocument/2006/relationships/slideLayout" Target="../slideLayouts/slideLayout49.xml"/><Relationship Id="rId18" Type="http://schemas.openxmlformats.org/officeDocument/2006/relationships/slideLayout" Target="../slideLayouts/slideLayout54.xml"/><Relationship Id="rId3" Type="http://schemas.openxmlformats.org/officeDocument/2006/relationships/slideLayout" Target="../slideLayouts/slideLayout39.xml"/><Relationship Id="rId21" Type="http://schemas.openxmlformats.org/officeDocument/2006/relationships/slideLayout" Target="../slideLayouts/slideLayout57.xml"/><Relationship Id="rId7" Type="http://schemas.openxmlformats.org/officeDocument/2006/relationships/slideLayout" Target="../slideLayouts/slideLayout43.xml"/><Relationship Id="rId12" Type="http://schemas.openxmlformats.org/officeDocument/2006/relationships/slideLayout" Target="../slideLayouts/slideLayout48.xml"/><Relationship Id="rId17" Type="http://schemas.openxmlformats.org/officeDocument/2006/relationships/slideLayout" Target="../slideLayouts/slideLayout53.xml"/><Relationship Id="rId2" Type="http://schemas.openxmlformats.org/officeDocument/2006/relationships/slideLayout" Target="../slideLayouts/slideLayout38.xml"/><Relationship Id="rId16" Type="http://schemas.openxmlformats.org/officeDocument/2006/relationships/slideLayout" Target="../slideLayouts/slideLayout52.xml"/><Relationship Id="rId20" Type="http://schemas.openxmlformats.org/officeDocument/2006/relationships/slideLayout" Target="../slideLayouts/slideLayout56.xml"/><Relationship Id="rId1" Type="http://schemas.openxmlformats.org/officeDocument/2006/relationships/slideLayout" Target="../slideLayouts/slideLayout37.xml"/><Relationship Id="rId6" Type="http://schemas.openxmlformats.org/officeDocument/2006/relationships/slideLayout" Target="../slideLayouts/slideLayout42.xml"/><Relationship Id="rId11" Type="http://schemas.openxmlformats.org/officeDocument/2006/relationships/slideLayout" Target="../slideLayouts/slideLayout47.xml"/><Relationship Id="rId24" Type="http://schemas.openxmlformats.org/officeDocument/2006/relationships/theme" Target="../theme/theme2.xml"/><Relationship Id="rId5" Type="http://schemas.openxmlformats.org/officeDocument/2006/relationships/slideLayout" Target="../slideLayouts/slideLayout41.xml"/><Relationship Id="rId15" Type="http://schemas.openxmlformats.org/officeDocument/2006/relationships/slideLayout" Target="../slideLayouts/slideLayout51.xml"/><Relationship Id="rId23" Type="http://schemas.openxmlformats.org/officeDocument/2006/relationships/slideLayout" Target="../slideLayouts/slideLayout59.xml"/><Relationship Id="rId10" Type="http://schemas.openxmlformats.org/officeDocument/2006/relationships/slideLayout" Target="../slideLayouts/slideLayout46.xml"/><Relationship Id="rId19" Type="http://schemas.openxmlformats.org/officeDocument/2006/relationships/slideLayout" Target="../slideLayouts/slideLayout55.xml"/><Relationship Id="rId4" Type="http://schemas.openxmlformats.org/officeDocument/2006/relationships/slideLayout" Target="../slideLayouts/slideLayout40.xml"/><Relationship Id="rId9" Type="http://schemas.openxmlformats.org/officeDocument/2006/relationships/slideLayout" Target="../slideLayouts/slideLayout45.xml"/><Relationship Id="rId14" Type="http://schemas.openxmlformats.org/officeDocument/2006/relationships/slideLayout" Target="../slideLayouts/slideLayout50.xml"/><Relationship Id="rId22" Type="http://schemas.openxmlformats.org/officeDocument/2006/relationships/slideLayout" Target="../slideLayouts/slideLayout58.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alpha val="0"/>
          </a:schemeClr>
        </a:solidFill>
        <a:effectLst/>
      </p:bgPr>
    </p:bg>
    <p:spTree>
      <p:nvGrpSpPr>
        <p:cNvPr id="1" name=""/>
        <p:cNvGrpSpPr/>
        <p:nvPr/>
      </p:nvGrpSpPr>
      <p:grpSpPr>
        <a:xfrm>
          <a:off x="0" y="0"/>
          <a:ext cx="0" cy="0"/>
          <a:chOff x="0" y="0"/>
          <a:chExt cx="0" cy="0"/>
        </a:xfrm>
      </p:grpSpPr>
      <p:sp>
        <p:nvSpPr>
          <p:cNvPr id="12" name="Slide Number Placeholder 5"/>
          <p:cNvSpPr txBox="1">
            <a:spLocks/>
          </p:cNvSpPr>
          <p:nvPr/>
        </p:nvSpPr>
        <p:spPr>
          <a:xfrm>
            <a:off x="6629400" y="6356353"/>
            <a:ext cx="2133600" cy="365125"/>
          </a:xfrm>
          <a:prstGeom prst="rect">
            <a:avLst/>
          </a:prstGeom>
        </p:spPr>
        <p:txBody>
          <a:bodyPr anchor="ctr"/>
          <a:lstStyle>
            <a:defPPr>
              <a:defRPr lang="en-US"/>
            </a:defPPr>
            <a:lvl1pPr marL="0" algn="r" defTabSz="457200" rtl="0" eaLnBrk="1" latinLnBrk="0" hangingPunct="1">
              <a:defRPr sz="900" kern="1200">
                <a:solidFill>
                  <a:schemeClr val="tx1"/>
                </a:solidFill>
                <a:latin typeface="Tw Cen MT"/>
                <a:ea typeface="+mn-ea"/>
                <a:cs typeface="Tw Cen MT"/>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fontAlgn="auto">
              <a:spcBef>
                <a:spcPts val="0"/>
              </a:spcBef>
              <a:spcAft>
                <a:spcPts val="0"/>
              </a:spcAft>
              <a:defRPr/>
            </a:pPr>
            <a:r>
              <a:rPr lang="en-US" sz="506"/>
              <a:t>Page </a:t>
            </a:r>
            <a:fld id="{3B11C02F-2186-5E4E-90C0-5210A150EF90}" type="slidenum">
              <a:rPr lang="en-US" sz="506" smtClean="0"/>
              <a:pPr fontAlgn="auto">
                <a:spcBef>
                  <a:spcPts val="0"/>
                </a:spcBef>
                <a:spcAft>
                  <a:spcPts val="0"/>
                </a:spcAft>
                <a:defRPr/>
              </a:pPr>
              <a:t>‹#›</a:t>
            </a:fld>
            <a:endParaRPr lang="en-US" sz="506"/>
          </a:p>
        </p:txBody>
      </p:sp>
      <p:sp>
        <p:nvSpPr>
          <p:cNvPr id="6" name="Date Placeholder 3">
            <a:extLst>
              <a:ext uri="{FF2B5EF4-FFF2-40B4-BE49-F238E27FC236}">
                <a16:creationId xmlns:a16="http://schemas.microsoft.com/office/drawing/2014/main" id="{B454F75B-D7A2-4B14-8535-B803517C2A15}"/>
              </a:ext>
            </a:extLst>
          </p:cNvPr>
          <p:cNvSpPr txBox="1">
            <a:spLocks/>
          </p:cNvSpPr>
          <p:nvPr userDrawn="1"/>
        </p:nvSpPr>
        <p:spPr>
          <a:xfrm>
            <a:off x="381000" y="6356353"/>
            <a:ext cx="2133600" cy="366183"/>
          </a:xfrm>
          <a:prstGeom prst="rect">
            <a:avLst/>
          </a:prstGeom>
        </p:spPr>
        <p:txBody>
          <a:bodyPr anchor="ctr"/>
          <a:lstStyle>
            <a:defPPr>
              <a:defRPr lang="en-US"/>
            </a:defPPr>
            <a:lvl1pPr marL="0" algn="l" defTabSz="457200" rtl="0" eaLnBrk="1" latinLnBrk="0" hangingPunct="1">
              <a:defRPr lang="en-US" sz="900" b="0" i="0" u="none" strike="noStrike" kern="1200" baseline="0" smtClean="0">
                <a:solidFill>
                  <a:schemeClr val="tx1"/>
                </a:solidFill>
                <a:latin typeface="Tw Cen MT"/>
                <a:ea typeface="+mn-ea"/>
                <a:cs typeface="Tw Cen MT"/>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fontAlgn="auto">
              <a:spcBef>
                <a:spcPts val="0"/>
              </a:spcBef>
              <a:spcAft>
                <a:spcPts val="0"/>
              </a:spcAft>
              <a:defRPr/>
            </a:pPr>
            <a:r>
              <a:rPr sz="675">
                <a:latin typeface="Arial" panose="020B0604020202020204" pitchFamily="34" charset="0"/>
                <a:cs typeface="Arial" panose="020B0604020202020204" pitchFamily="34" charset="0"/>
              </a:rPr>
              <a:t>The </a:t>
            </a:r>
            <a:r>
              <a:rPr lang="en-AU" sz="675">
                <a:latin typeface="Arial" panose="020B0604020202020204" pitchFamily="34" charset="0"/>
                <a:cs typeface="Arial" panose="020B0604020202020204" pitchFamily="34" charset="0"/>
              </a:rPr>
              <a:t>University of Sydney</a:t>
            </a:r>
            <a:endParaRPr sz="675">
              <a:latin typeface="Arial" panose="020B0604020202020204" pitchFamily="34" charset="0"/>
              <a:cs typeface="Arial" panose="020B0604020202020204" pitchFamily="34" charset="0"/>
            </a:endParaRPr>
          </a:p>
        </p:txBody>
      </p:sp>
      <p:sp>
        <p:nvSpPr>
          <p:cNvPr id="7" name="Title Placeholder 1">
            <a:extLst>
              <a:ext uri="{FF2B5EF4-FFF2-40B4-BE49-F238E27FC236}">
                <a16:creationId xmlns:a16="http://schemas.microsoft.com/office/drawing/2014/main" id="{BE9EF11D-F5BE-ED40-AB5F-104A2C9A67EF}"/>
              </a:ext>
            </a:extLst>
          </p:cNvPr>
          <p:cNvSpPr>
            <a:spLocks noGrp="1"/>
          </p:cNvSpPr>
          <p:nvPr>
            <p:ph type="title"/>
          </p:nvPr>
        </p:nvSpPr>
        <p:spPr bwMode="auto">
          <a:xfrm>
            <a:off x="358776" y="501653"/>
            <a:ext cx="8426450" cy="64718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0" tIns="0" rIns="0" bIns="0" numCol="1" anchor="t" anchorCtr="0" compatLnSpc="1">
            <a:prstTxWarp prst="textNoShape">
              <a:avLst/>
            </a:prstTxWarp>
          </a:bodyPr>
          <a:lstStyle/>
          <a:p>
            <a:pPr lvl="0"/>
            <a:r>
              <a:rPr lang="en-US"/>
              <a:t>Insert title here</a:t>
            </a:r>
          </a:p>
        </p:txBody>
      </p:sp>
      <p:sp>
        <p:nvSpPr>
          <p:cNvPr id="8" name="Text Placeholder 2">
            <a:extLst>
              <a:ext uri="{FF2B5EF4-FFF2-40B4-BE49-F238E27FC236}">
                <a16:creationId xmlns:a16="http://schemas.microsoft.com/office/drawing/2014/main" id="{31D8007C-8639-1A4A-A2BB-5F88DD41E22F}"/>
              </a:ext>
            </a:extLst>
          </p:cNvPr>
          <p:cNvSpPr>
            <a:spLocks noGrp="1"/>
          </p:cNvSpPr>
          <p:nvPr>
            <p:ph type="body" idx="1"/>
          </p:nvPr>
        </p:nvSpPr>
        <p:spPr bwMode="auto">
          <a:xfrm>
            <a:off x="358777" y="1387444"/>
            <a:ext cx="4589253" cy="488603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91440" tIns="45720" rIns="91440" bIns="45720" numCol="1" anchor="t" anchorCtr="0" compatLnSpc="1">
            <a:prstTxWarp prst="textNoShape">
              <a:avLst/>
            </a:prstTxWarp>
          </a:bodyPr>
          <a:lstStyle/>
          <a:p>
            <a:pPr lvl="0"/>
            <a:r>
              <a:rPr lang="en-US"/>
              <a:t>Sub-heading Bold… 24pt</a:t>
            </a:r>
          </a:p>
          <a:p>
            <a:pPr lvl="0"/>
            <a:r>
              <a:rPr lang="en-US"/>
              <a:t>Add body copy </a:t>
            </a:r>
          </a:p>
        </p:txBody>
      </p:sp>
    </p:spTree>
    <p:extLst>
      <p:ext uri="{BB962C8B-B14F-4D97-AF65-F5344CB8AC3E}">
        <p14:creationId xmlns:p14="http://schemas.microsoft.com/office/powerpoint/2010/main" val="321682225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 id="2147483684" r:id="rId12"/>
    <p:sldLayoutId id="2147483685" r:id="rId13"/>
    <p:sldLayoutId id="2147483686" r:id="rId14"/>
    <p:sldLayoutId id="2147483687" r:id="rId15"/>
    <p:sldLayoutId id="2147483688" r:id="rId16"/>
    <p:sldLayoutId id="2147483689" r:id="rId17"/>
    <p:sldLayoutId id="2147483690" r:id="rId18"/>
    <p:sldLayoutId id="2147483691" r:id="rId19"/>
    <p:sldLayoutId id="2147483692" r:id="rId20"/>
    <p:sldLayoutId id="2147483693" r:id="rId21"/>
    <p:sldLayoutId id="2147483694" r:id="rId22"/>
    <p:sldLayoutId id="2147483695" r:id="rId23"/>
    <p:sldLayoutId id="2147483696" r:id="rId24"/>
    <p:sldLayoutId id="2147483697" r:id="rId25"/>
    <p:sldLayoutId id="2147483698" r:id="rId26"/>
    <p:sldLayoutId id="2147483699" r:id="rId27"/>
    <p:sldLayoutId id="2147483700" r:id="rId28"/>
    <p:sldLayoutId id="2147483701" r:id="rId29"/>
    <p:sldLayoutId id="2147483702" r:id="rId30"/>
    <p:sldLayoutId id="2147483703" r:id="rId31"/>
    <p:sldLayoutId id="2147483704" r:id="rId32"/>
    <p:sldLayoutId id="2147483705" r:id="rId33"/>
    <p:sldLayoutId id="2147483706" r:id="rId34"/>
    <p:sldLayoutId id="2147483707" r:id="rId35"/>
    <p:sldLayoutId id="2147483757" r:id="rId36"/>
  </p:sldLayoutIdLst>
  <p:txStyles>
    <p:titleStyle>
      <a:lvl1pPr algn="l" defTabSz="257175" rtl="0" eaLnBrk="1" fontAlgn="base" hangingPunct="1">
        <a:spcBef>
          <a:spcPct val="0"/>
        </a:spcBef>
        <a:spcAft>
          <a:spcPct val="0"/>
        </a:spcAft>
        <a:defRPr sz="2250" b="1" kern="1200">
          <a:solidFill>
            <a:schemeClr val="accent1"/>
          </a:solidFill>
          <a:latin typeface="Tw Cen MT"/>
          <a:ea typeface="ＭＳ Ｐゴシック" charset="0"/>
          <a:cs typeface="Tw Cen MT"/>
        </a:defRPr>
      </a:lvl1pPr>
      <a:lvl2pPr algn="l" defTabSz="257175" rtl="0" eaLnBrk="1" fontAlgn="base" hangingPunct="1">
        <a:spcBef>
          <a:spcPct val="0"/>
        </a:spcBef>
        <a:spcAft>
          <a:spcPct val="0"/>
        </a:spcAft>
        <a:defRPr sz="1350" b="1">
          <a:solidFill>
            <a:schemeClr val="accent1"/>
          </a:solidFill>
          <a:latin typeface="Tw Cen MT" charset="0"/>
          <a:ea typeface="ＭＳ Ｐゴシック" charset="0"/>
        </a:defRPr>
      </a:lvl2pPr>
      <a:lvl3pPr algn="l" defTabSz="257175" rtl="0" eaLnBrk="1" fontAlgn="base" hangingPunct="1">
        <a:spcBef>
          <a:spcPct val="0"/>
        </a:spcBef>
        <a:spcAft>
          <a:spcPct val="0"/>
        </a:spcAft>
        <a:defRPr sz="1350" b="1">
          <a:solidFill>
            <a:schemeClr val="accent1"/>
          </a:solidFill>
          <a:latin typeface="Tw Cen MT" charset="0"/>
          <a:ea typeface="ＭＳ Ｐゴシック" charset="0"/>
        </a:defRPr>
      </a:lvl3pPr>
      <a:lvl4pPr algn="l" defTabSz="257175" rtl="0" eaLnBrk="1" fontAlgn="base" hangingPunct="1">
        <a:spcBef>
          <a:spcPct val="0"/>
        </a:spcBef>
        <a:spcAft>
          <a:spcPct val="0"/>
        </a:spcAft>
        <a:defRPr sz="1350" b="1">
          <a:solidFill>
            <a:schemeClr val="accent1"/>
          </a:solidFill>
          <a:latin typeface="Tw Cen MT" charset="0"/>
          <a:ea typeface="ＭＳ Ｐゴシック" charset="0"/>
        </a:defRPr>
      </a:lvl4pPr>
      <a:lvl5pPr algn="l" defTabSz="257175" rtl="0" eaLnBrk="1" fontAlgn="base" hangingPunct="1">
        <a:spcBef>
          <a:spcPct val="0"/>
        </a:spcBef>
        <a:spcAft>
          <a:spcPct val="0"/>
        </a:spcAft>
        <a:defRPr sz="1350" b="1">
          <a:solidFill>
            <a:schemeClr val="accent1"/>
          </a:solidFill>
          <a:latin typeface="Tw Cen MT" charset="0"/>
          <a:ea typeface="ＭＳ Ｐゴシック" charset="0"/>
        </a:defRPr>
      </a:lvl5pPr>
      <a:lvl6pPr marL="257175" algn="l" defTabSz="257175" rtl="0" eaLnBrk="1" fontAlgn="base" hangingPunct="1">
        <a:spcBef>
          <a:spcPct val="0"/>
        </a:spcBef>
        <a:spcAft>
          <a:spcPct val="0"/>
        </a:spcAft>
        <a:defRPr sz="1350" b="1">
          <a:solidFill>
            <a:schemeClr val="accent1"/>
          </a:solidFill>
          <a:latin typeface="Tw Cen MT" charset="0"/>
          <a:ea typeface="ＭＳ Ｐゴシック" charset="0"/>
        </a:defRPr>
      </a:lvl6pPr>
      <a:lvl7pPr marL="514350" algn="l" defTabSz="257175" rtl="0" eaLnBrk="1" fontAlgn="base" hangingPunct="1">
        <a:spcBef>
          <a:spcPct val="0"/>
        </a:spcBef>
        <a:spcAft>
          <a:spcPct val="0"/>
        </a:spcAft>
        <a:defRPr sz="1350" b="1">
          <a:solidFill>
            <a:schemeClr val="accent1"/>
          </a:solidFill>
          <a:latin typeface="Tw Cen MT" charset="0"/>
          <a:ea typeface="ＭＳ Ｐゴシック" charset="0"/>
        </a:defRPr>
      </a:lvl7pPr>
      <a:lvl8pPr marL="771525" algn="l" defTabSz="257175" rtl="0" eaLnBrk="1" fontAlgn="base" hangingPunct="1">
        <a:spcBef>
          <a:spcPct val="0"/>
        </a:spcBef>
        <a:spcAft>
          <a:spcPct val="0"/>
        </a:spcAft>
        <a:defRPr sz="1350" b="1">
          <a:solidFill>
            <a:schemeClr val="accent1"/>
          </a:solidFill>
          <a:latin typeface="Tw Cen MT" charset="0"/>
          <a:ea typeface="ＭＳ Ｐゴシック" charset="0"/>
        </a:defRPr>
      </a:lvl8pPr>
      <a:lvl9pPr marL="1028700" algn="l" defTabSz="257175" rtl="0" eaLnBrk="1" fontAlgn="base" hangingPunct="1">
        <a:spcBef>
          <a:spcPct val="0"/>
        </a:spcBef>
        <a:spcAft>
          <a:spcPct val="0"/>
        </a:spcAft>
        <a:defRPr sz="1350" b="1">
          <a:solidFill>
            <a:schemeClr val="accent1"/>
          </a:solidFill>
          <a:latin typeface="Tw Cen MT" charset="0"/>
          <a:ea typeface="ＭＳ Ｐゴシック" charset="0"/>
        </a:defRPr>
      </a:lvl9pPr>
    </p:titleStyle>
    <p:bodyStyle>
      <a:lvl1pPr marL="192881" indent="-192881" algn="l" defTabSz="257175" rtl="0" eaLnBrk="1" fontAlgn="base" hangingPunct="1">
        <a:spcBef>
          <a:spcPct val="20000"/>
        </a:spcBef>
        <a:spcAft>
          <a:spcPct val="0"/>
        </a:spcAft>
        <a:buFont typeface="Lucida Grande" charset="0"/>
        <a:buChar char="–"/>
        <a:defRPr sz="1800" b="1" kern="1200">
          <a:solidFill>
            <a:schemeClr val="tx1"/>
          </a:solidFill>
          <a:latin typeface="Tw Cen MT"/>
          <a:ea typeface="ＭＳ Ｐゴシック" charset="0"/>
          <a:cs typeface="Tw Cen MT"/>
        </a:defRPr>
      </a:lvl1pPr>
      <a:lvl2pPr marL="417910" indent="-160735"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2pPr>
      <a:lvl3pPr marL="642938"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3pPr>
      <a:lvl4pPr marL="900113"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4pPr>
      <a:lvl5pPr marL="1157288"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5pPr>
      <a:lvl6pPr marL="1414463" indent="-128588" algn="l" defTabSz="257175" rtl="0" eaLnBrk="1" latinLnBrk="0" hangingPunct="1">
        <a:spcBef>
          <a:spcPct val="20000"/>
        </a:spcBef>
        <a:buFont typeface="Arial"/>
        <a:buChar char="•"/>
        <a:defRPr sz="1125" kern="1200">
          <a:solidFill>
            <a:schemeClr val="tx1"/>
          </a:solidFill>
          <a:latin typeface="+mn-lt"/>
          <a:ea typeface="+mn-ea"/>
          <a:cs typeface="+mn-cs"/>
        </a:defRPr>
      </a:lvl6pPr>
      <a:lvl7pPr marL="1671638" indent="-128588" algn="l" defTabSz="257175" rtl="0" eaLnBrk="1" latinLnBrk="0" hangingPunct="1">
        <a:spcBef>
          <a:spcPct val="20000"/>
        </a:spcBef>
        <a:buFont typeface="Arial"/>
        <a:buChar char="•"/>
        <a:defRPr sz="1125" kern="1200">
          <a:solidFill>
            <a:schemeClr val="tx1"/>
          </a:solidFill>
          <a:latin typeface="+mn-lt"/>
          <a:ea typeface="+mn-ea"/>
          <a:cs typeface="+mn-cs"/>
        </a:defRPr>
      </a:lvl7pPr>
      <a:lvl8pPr marL="1928813" indent="-128588" algn="l" defTabSz="257175" rtl="0" eaLnBrk="1" latinLnBrk="0" hangingPunct="1">
        <a:spcBef>
          <a:spcPct val="20000"/>
        </a:spcBef>
        <a:buFont typeface="Arial"/>
        <a:buChar char="•"/>
        <a:defRPr sz="1125" kern="1200">
          <a:solidFill>
            <a:schemeClr val="tx1"/>
          </a:solidFill>
          <a:latin typeface="+mn-lt"/>
          <a:ea typeface="+mn-ea"/>
          <a:cs typeface="+mn-cs"/>
        </a:defRPr>
      </a:lvl8pPr>
      <a:lvl9pPr marL="2185988" indent="-128588" algn="l" defTabSz="257175" rtl="0" eaLnBrk="1" latinLnBrk="0" hangingPunct="1">
        <a:spcBef>
          <a:spcPct val="20000"/>
        </a:spcBef>
        <a:buFont typeface="Arial"/>
        <a:buChar char="•"/>
        <a:defRPr sz="1125" kern="1200">
          <a:solidFill>
            <a:schemeClr val="tx1"/>
          </a:solidFill>
          <a:latin typeface="+mn-lt"/>
          <a:ea typeface="+mn-ea"/>
          <a:cs typeface="+mn-cs"/>
        </a:defRPr>
      </a:lvl9pPr>
    </p:bodyStyle>
    <p:otherStyle>
      <a:defPPr>
        <a:defRPr lang="en-US"/>
      </a:defPPr>
      <a:lvl1pPr marL="0" algn="l" defTabSz="257175" rtl="0" eaLnBrk="1" latinLnBrk="0" hangingPunct="1">
        <a:defRPr sz="1013" kern="1200">
          <a:solidFill>
            <a:schemeClr val="tx1"/>
          </a:solidFill>
          <a:latin typeface="+mn-lt"/>
          <a:ea typeface="+mn-ea"/>
          <a:cs typeface="+mn-cs"/>
        </a:defRPr>
      </a:lvl1pPr>
      <a:lvl2pPr marL="257175" algn="l" defTabSz="257175" rtl="0" eaLnBrk="1" latinLnBrk="0" hangingPunct="1">
        <a:defRPr sz="1013" kern="1200">
          <a:solidFill>
            <a:schemeClr val="tx1"/>
          </a:solidFill>
          <a:latin typeface="+mn-lt"/>
          <a:ea typeface="+mn-ea"/>
          <a:cs typeface="+mn-cs"/>
        </a:defRPr>
      </a:lvl2pPr>
      <a:lvl3pPr marL="514350" algn="l" defTabSz="257175" rtl="0" eaLnBrk="1" latinLnBrk="0" hangingPunct="1">
        <a:defRPr sz="1013" kern="1200">
          <a:solidFill>
            <a:schemeClr val="tx1"/>
          </a:solidFill>
          <a:latin typeface="+mn-lt"/>
          <a:ea typeface="+mn-ea"/>
          <a:cs typeface="+mn-cs"/>
        </a:defRPr>
      </a:lvl3pPr>
      <a:lvl4pPr marL="771525" algn="l" defTabSz="257175" rtl="0" eaLnBrk="1" latinLnBrk="0" hangingPunct="1">
        <a:defRPr sz="1013" kern="1200">
          <a:solidFill>
            <a:schemeClr val="tx1"/>
          </a:solidFill>
          <a:latin typeface="+mn-lt"/>
          <a:ea typeface="+mn-ea"/>
          <a:cs typeface="+mn-cs"/>
        </a:defRPr>
      </a:lvl4pPr>
      <a:lvl5pPr marL="1028700" algn="l" defTabSz="257175" rtl="0" eaLnBrk="1" latinLnBrk="0" hangingPunct="1">
        <a:defRPr sz="1013" kern="1200">
          <a:solidFill>
            <a:schemeClr val="tx1"/>
          </a:solidFill>
          <a:latin typeface="+mn-lt"/>
          <a:ea typeface="+mn-ea"/>
          <a:cs typeface="+mn-cs"/>
        </a:defRPr>
      </a:lvl5pPr>
      <a:lvl6pPr marL="1285875" algn="l" defTabSz="257175" rtl="0" eaLnBrk="1" latinLnBrk="0" hangingPunct="1">
        <a:defRPr sz="1013" kern="1200">
          <a:solidFill>
            <a:schemeClr val="tx1"/>
          </a:solidFill>
          <a:latin typeface="+mn-lt"/>
          <a:ea typeface="+mn-ea"/>
          <a:cs typeface="+mn-cs"/>
        </a:defRPr>
      </a:lvl6pPr>
      <a:lvl7pPr marL="1543050" algn="l" defTabSz="257175" rtl="0" eaLnBrk="1" latinLnBrk="0" hangingPunct="1">
        <a:defRPr sz="1013" kern="1200">
          <a:solidFill>
            <a:schemeClr val="tx1"/>
          </a:solidFill>
          <a:latin typeface="+mn-lt"/>
          <a:ea typeface="+mn-ea"/>
          <a:cs typeface="+mn-cs"/>
        </a:defRPr>
      </a:lvl7pPr>
      <a:lvl8pPr marL="1800225" algn="l" defTabSz="257175" rtl="0" eaLnBrk="1" latinLnBrk="0" hangingPunct="1">
        <a:defRPr sz="1013" kern="1200">
          <a:solidFill>
            <a:schemeClr val="tx1"/>
          </a:solidFill>
          <a:latin typeface="+mn-lt"/>
          <a:ea typeface="+mn-ea"/>
          <a:cs typeface="+mn-cs"/>
        </a:defRPr>
      </a:lvl8pPr>
      <a:lvl9pPr marL="2057400" algn="l" defTabSz="257175" rtl="0" eaLnBrk="1" latinLnBrk="0" hangingPunct="1">
        <a:defRPr sz="1013"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57200" y="117475"/>
            <a:ext cx="8229600" cy="11430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91440" tIns="45720" rIns="91440" bIns="45720" numCol="1" anchor="ctr" anchorCtr="0" compatLnSpc="1">
            <a:prstTxWarp prst="textNoShape">
              <a:avLst/>
            </a:prstTxWarp>
          </a:bodyPr>
          <a:lstStyle/>
          <a:p>
            <a:pPr lvl="0"/>
            <a:r>
              <a:rPr lang="en-US"/>
              <a:t>Insert slide title here… 28pt</a:t>
            </a:r>
          </a:p>
        </p:txBody>
      </p:sp>
      <p:sp>
        <p:nvSpPr>
          <p:cNvPr id="3" name="Text Placeholder 2"/>
          <p:cNvSpPr>
            <a:spLocks noGrp="1"/>
          </p:cNvSpPr>
          <p:nvPr>
            <p:ph type="body" idx="1"/>
          </p:nvPr>
        </p:nvSpPr>
        <p:spPr>
          <a:xfrm>
            <a:off x="457200" y="1358900"/>
            <a:ext cx="8229600" cy="4767263"/>
          </a:xfrm>
          <a:prstGeom prst="rect">
            <a:avLst/>
          </a:prstGeom>
        </p:spPr>
        <p:txBody>
          <a:bodyPr vert="horz" lIns="91440" tIns="45720" rIns="91440" bIns="45720" rtlCol="0">
            <a:normAutofit/>
          </a:bodyPr>
          <a:lstStyle/>
          <a:p>
            <a:r>
              <a:rPr lang="en-US"/>
              <a:t>Sub-heading Bold… 24pt</a:t>
            </a:r>
          </a:p>
          <a:p>
            <a:pPr lvl="0"/>
            <a:r>
              <a:rPr lang="en-US"/>
              <a:t>Add body copy </a:t>
            </a:r>
          </a:p>
          <a:p>
            <a:r>
              <a:rPr lang="en-US"/>
              <a:t>Add bullet point</a:t>
            </a:r>
          </a:p>
          <a:p>
            <a:r>
              <a:rPr lang="en-US"/>
              <a:t>Add bullet point</a:t>
            </a:r>
          </a:p>
        </p:txBody>
      </p:sp>
      <p:sp>
        <p:nvSpPr>
          <p:cNvPr id="11" name="Date Placeholder 3"/>
          <p:cNvSpPr txBox="1">
            <a:spLocks/>
          </p:cNvSpPr>
          <p:nvPr/>
        </p:nvSpPr>
        <p:spPr>
          <a:xfrm>
            <a:off x="381000" y="6356350"/>
            <a:ext cx="5878286" cy="365125"/>
          </a:xfrm>
          <a:prstGeom prst="rect">
            <a:avLst/>
          </a:prstGeom>
        </p:spPr>
        <p:txBody>
          <a:bodyPr anchor="ctr"/>
          <a:lstStyle>
            <a:defPPr>
              <a:defRPr lang="en-US"/>
            </a:defPPr>
            <a:lvl1pPr marL="0" algn="l" defTabSz="457200" rtl="0" eaLnBrk="1" latinLnBrk="0" hangingPunct="1">
              <a:defRPr lang="en-US" sz="900" b="0" i="0" u="none" strike="noStrike" kern="1200" baseline="0" smtClean="0">
                <a:solidFill>
                  <a:schemeClr val="tx1"/>
                </a:solidFill>
                <a:latin typeface="Tw Cen MT"/>
                <a:ea typeface="+mn-ea"/>
                <a:cs typeface="Tw Cen MT"/>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fontAlgn="auto">
              <a:spcBef>
                <a:spcPts val="0"/>
              </a:spcBef>
              <a:spcAft>
                <a:spcPts val="0"/>
              </a:spcAft>
              <a:defRPr/>
            </a:pPr>
            <a:r>
              <a:rPr lang="en-US"/>
              <a:t>Brain and Mind Centre</a:t>
            </a:r>
          </a:p>
        </p:txBody>
      </p:sp>
      <p:sp>
        <p:nvSpPr>
          <p:cNvPr id="12" name="Slide Number Placeholder 5"/>
          <p:cNvSpPr txBox="1">
            <a:spLocks/>
          </p:cNvSpPr>
          <p:nvPr/>
        </p:nvSpPr>
        <p:spPr>
          <a:xfrm>
            <a:off x="6629400" y="6356350"/>
            <a:ext cx="2133600" cy="365125"/>
          </a:xfrm>
          <a:prstGeom prst="rect">
            <a:avLst/>
          </a:prstGeom>
        </p:spPr>
        <p:txBody>
          <a:bodyPr anchor="ctr"/>
          <a:lstStyle>
            <a:defPPr>
              <a:defRPr lang="en-US"/>
            </a:defPPr>
            <a:lvl1pPr marL="0" algn="r" defTabSz="457200" rtl="0" eaLnBrk="1" latinLnBrk="0" hangingPunct="1">
              <a:defRPr sz="900" kern="1200">
                <a:solidFill>
                  <a:schemeClr val="tx1"/>
                </a:solidFill>
                <a:latin typeface="Tw Cen MT"/>
                <a:ea typeface="+mn-ea"/>
                <a:cs typeface="Tw Cen MT"/>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fontAlgn="auto">
              <a:spcBef>
                <a:spcPts val="0"/>
              </a:spcBef>
              <a:spcAft>
                <a:spcPts val="0"/>
              </a:spcAft>
              <a:defRPr/>
            </a:pPr>
            <a:r>
              <a:rPr lang="en-US"/>
              <a:t>Page </a:t>
            </a:r>
            <a:fld id="{3B11C02F-2186-5E4E-90C0-5210A150EF90}" type="slidenum">
              <a:rPr lang="en-US" smtClean="0"/>
              <a:pPr fontAlgn="auto">
                <a:spcBef>
                  <a:spcPts val="0"/>
                </a:spcBef>
                <a:spcAft>
                  <a:spcPts val="0"/>
                </a:spcAft>
                <a:defRPr/>
              </a:pPr>
              <a:t>‹#›</a:t>
            </a:fld>
            <a:endParaRPr lang="en-US"/>
          </a:p>
        </p:txBody>
      </p:sp>
    </p:spTree>
    <p:extLst>
      <p:ext uri="{BB962C8B-B14F-4D97-AF65-F5344CB8AC3E}">
        <p14:creationId xmlns:p14="http://schemas.microsoft.com/office/powerpoint/2010/main" val="3599983672"/>
      </p:ext>
    </p:extLst>
  </p:cSld>
  <p:clrMap bg1="lt1" tx1="dk1" bg2="lt2" tx2="dk2" accent1="accent1" accent2="accent2" accent3="accent3" accent4="accent4" accent5="accent5" accent6="accent6" hlink="hlink" folHlink="folHlink"/>
  <p:sldLayoutIdLst>
    <p:sldLayoutId id="2147483734" r:id="rId1"/>
    <p:sldLayoutId id="2147483735" r:id="rId2"/>
    <p:sldLayoutId id="2147483736" r:id="rId3"/>
    <p:sldLayoutId id="2147483737" r:id="rId4"/>
    <p:sldLayoutId id="2147483738" r:id="rId5"/>
    <p:sldLayoutId id="2147483739" r:id="rId6"/>
    <p:sldLayoutId id="2147483740" r:id="rId7"/>
    <p:sldLayoutId id="2147483741" r:id="rId8"/>
    <p:sldLayoutId id="2147483742" r:id="rId9"/>
    <p:sldLayoutId id="2147483743" r:id="rId10"/>
    <p:sldLayoutId id="2147483744" r:id="rId11"/>
    <p:sldLayoutId id="2147483745" r:id="rId12"/>
    <p:sldLayoutId id="2147483746" r:id="rId13"/>
    <p:sldLayoutId id="2147483747" r:id="rId14"/>
    <p:sldLayoutId id="2147483748" r:id="rId15"/>
    <p:sldLayoutId id="2147483749" r:id="rId16"/>
    <p:sldLayoutId id="2147483750" r:id="rId17"/>
    <p:sldLayoutId id="2147483751" r:id="rId18"/>
    <p:sldLayoutId id="2147483752" r:id="rId19"/>
    <p:sldLayoutId id="2147483753" r:id="rId20"/>
    <p:sldLayoutId id="2147483754" r:id="rId21"/>
    <p:sldLayoutId id="2147483755" r:id="rId22"/>
    <p:sldLayoutId id="2147483756" r:id="rId23"/>
  </p:sldLayoutIdLst>
  <p:txStyles>
    <p:titleStyle>
      <a:lvl1pPr algn="l" defTabSz="457200" rtl="0" eaLnBrk="1" fontAlgn="base" hangingPunct="1">
        <a:spcBef>
          <a:spcPct val="0"/>
        </a:spcBef>
        <a:spcAft>
          <a:spcPct val="0"/>
        </a:spcAft>
        <a:defRPr sz="2800" b="1" kern="1200">
          <a:solidFill>
            <a:schemeClr val="accent1"/>
          </a:solidFill>
          <a:latin typeface="Tw Cen MT"/>
          <a:ea typeface="ＭＳ Ｐゴシック" charset="0"/>
          <a:cs typeface="Tw Cen MT"/>
        </a:defRPr>
      </a:lvl1pPr>
      <a:lvl2pPr algn="l" defTabSz="457200" rtl="0" eaLnBrk="1" fontAlgn="base" hangingPunct="1">
        <a:spcBef>
          <a:spcPct val="0"/>
        </a:spcBef>
        <a:spcAft>
          <a:spcPct val="0"/>
        </a:spcAft>
        <a:defRPr sz="2400" b="1">
          <a:solidFill>
            <a:schemeClr val="accent1"/>
          </a:solidFill>
          <a:latin typeface="Tw Cen MT" charset="0"/>
          <a:ea typeface="ＭＳ Ｐゴシック" charset="0"/>
        </a:defRPr>
      </a:lvl2pPr>
      <a:lvl3pPr algn="l" defTabSz="457200" rtl="0" eaLnBrk="1" fontAlgn="base" hangingPunct="1">
        <a:spcBef>
          <a:spcPct val="0"/>
        </a:spcBef>
        <a:spcAft>
          <a:spcPct val="0"/>
        </a:spcAft>
        <a:defRPr sz="2400" b="1">
          <a:solidFill>
            <a:schemeClr val="accent1"/>
          </a:solidFill>
          <a:latin typeface="Tw Cen MT" charset="0"/>
          <a:ea typeface="ＭＳ Ｐゴシック" charset="0"/>
        </a:defRPr>
      </a:lvl3pPr>
      <a:lvl4pPr algn="l" defTabSz="457200" rtl="0" eaLnBrk="1" fontAlgn="base" hangingPunct="1">
        <a:spcBef>
          <a:spcPct val="0"/>
        </a:spcBef>
        <a:spcAft>
          <a:spcPct val="0"/>
        </a:spcAft>
        <a:defRPr sz="2400" b="1">
          <a:solidFill>
            <a:schemeClr val="accent1"/>
          </a:solidFill>
          <a:latin typeface="Tw Cen MT" charset="0"/>
          <a:ea typeface="ＭＳ Ｐゴシック" charset="0"/>
        </a:defRPr>
      </a:lvl4pPr>
      <a:lvl5pPr algn="l" defTabSz="457200" rtl="0" eaLnBrk="1" fontAlgn="base" hangingPunct="1">
        <a:spcBef>
          <a:spcPct val="0"/>
        </a:spcBef>
        <a:spcAft>
          <a:spcPct val="0"/>
        </a:spcAft>
        <a:defRPr sz="2400" b="1">
          <a:solidFill>
            <a:schemeClr val="accent1"/>
          </a:solidFill>
          <a:latin typeface="Tw Cen MT" charset="0"/>
          <a:ea typeface="ＭＳ Ｐゴシック" charset="0"/>
        </a:defRPr>
      </a:lvl5pPr>
      <a:lvl6pPr marL="457200" algn="l" defTabSz="457200" rtl="0" eaLnBrk="1" fontAlgn="base" hangingPunct="1">
        <a:spcBef>
          <a:spcPct val="0"/>
        </a:spcBef>
        <a:spcAft>
          <a:spcPct val="0"/>
        </a:spcAft>
        <a:defRPr sz="2400" b="1">
          <a:solidFill>
            <a:schemeClr val="accent1"/>
          </a:solidFill>
          <a:latin typeface="Tw Cen MT" charset="0"/>
          <a:ea typeface="ＭＳ Ｐゴシック" charset="0"/>
        </a:defRPr>
      </a:lvl6pPr>
      <a:lvl7pPr marL="914400" algn="l" defTabSz="457200" rtl="0" eaLnBrk="1" fontAlgn="base" hangingPunct="1">
        <a:spcBef>
          <a:spcPct val="0"/>
        </a:spcBef>
        <a:spcAft>
          <a:spcPct val="0"/>
        </a:spcAft>
        <a:defRPr sz="2400" b="1">
          <a:solidFill>
            <a:schemeClr val="accent1"/>
          </a:solidFill>
          <a:latin typeface="Tw Cen MT" charset="0"/>
          <a:ea typeface="ＭＳ Ｐゴシック" charset="0"/>
        </a:defRPr>
      </a:lvl7pPr>
      <a:lvl8pPr marL="1371600" algn="l" defTabSz="457200" rtl="0" eaLnBrk="1" fontAlgn="base" hangingPunct="1">
        <a:spcBef>
          <a:spcPct val="0"/>
        </a:spcBef>
        <a:spcAft>
          <a:spcPct val="0"/>
        </a:spcAft>
        <a:defRPr sz="2400" b="1">
          <a:solidFill>
            <a:schemeClr val="accent1"/>
          </a:solidFill>
          <a:latin typeface="Tw Cen MT" charset="0"/>
          <a:ea typeface="ＭＳ Ｐゴシック" charset="0"/>
        </a:defRPr>
      </a:lvl8pPr>
      <a:lvl9pPr marL="1828800" algn="l" defTabSz="457200" rtl="0" eaLnBrk="1" fontAlgn="base" hangingPunct="1">
        <a:spcBef>
          <a:spcPct val="0"/>
        </a:spcBef>
        <a:spcAft>
          <a:spcPct val="0"/>
        </a:spcAft>
        <a:defRPr sz="2400" b="1">
          <a:solidFill>
            <a:schemeClr val="accent1"/>
          </a:solidFill>
          <a:latin typeface="Tw Cen MT" charset="0"/>
          <a:ea typeface="ＭＳ Ｐゴシック" charset="0"/>
        </a:defRPr>
      </a:lvl9pPr>
    </p:titleStyle>
    <p:bodyStyle>
      <a:lvl1pPr marL="342900" indent="-342900" algn="l" defTabSz="457200" rtl="0" eaLnBrk="1" fontAlgn="base" hangingPunct="1">
        <a:spcBef>
          <a:spcPct val="20000"/>
        </a:spcBef>
        <a:spcAft>
          <a:spcPct val="0"/>
        </a:spcAft>
        <a:buFont typeface="Lucida Grande" charset="0"/>
        <a:buChar char="–"/>
        <a:defRPr sz="2400" kern="1200">
          <a:solidFill>
            <a:schemeClr val="tx1"/>
          </a:solidFill>
          <a:latin typeface="Tw Cen MT"/>
          <a:ea typeface="ＭＳ Ｐゴシック" charset="0"/>
          <a:cs typeface="Tw Cen MT"/>
        </a:defRPr>
      </a:lvl1pPr>
      <a:lvl2pPr marL="742950" indent="-285750" algn="l" defTabSz="457200" rtl="0" eaLnBrk="1" fontAlgn="base" hangingPunct="1">
        <a:spcBef>
          <a:spcPct val="20000"/>
        </a:spcBef>
        <a:spcAft>
          <a:spcPct val="0"/>
        </a:spcAft>
        <a:buFont typeface="Arial" charset="0"/>
        <a:buChar char="–"/>
        <a:defRPr sz="2000" kern="1200">
          <a:solidFill>
            <a:schemeClr val="tx1"/>
          </a:solidFill>
          <a:latin typeface="Tw Cen MT"/>
          <a:ea typeface="ＭＳ Ｐゴシック" charset="0"/>
          <a:cs typeface="Tw Cen MT"/>
        </a:defRPr>
      </a:lvl2pPr>
      <a:lvl3pPr marL="1143000" indent="-228600" algn="l" defTabSz="457200" rtl="0" eaLnBrk="1" fontAlgn="base" hangingPunct="1">
        <a:spcBef>
          <a:spcPct val="20000"/>
        </a:spcBef>
        <a:spcAft>
          <a:spcPct val="0"/>
        </a:spcAft>
        <a:buFont typeface="Arial" charset="0"/>
        <a:buChar char="•"/>
        <a:defRPr sz="2000" kern="1200">
          <a:solidFill>
            <a:schemeClr val="tx1"/>
          </a:solidFill>
          <a:latin typeface="Tw Cen MT"/>
          <a:ea typeface="ＭＳ Ｐゴシック" charset="0"/>
          <a:cs typeface="Tw Cen MT"/>
        </a:defRPr>
      </a:lvl3pPr>
      <a:lvl4pPr marL="1600200" indent="-228600" algn="l" defTabSz="457200" rtl="0" eaLnBrk="1" fontAlgn="base" hangingPunct="1">
        <a:spcBef>
          <a:spcPct val="20000"/>
        </a:spcBef>
        <a:spcAft>
          <a:spcPct val="0"/>
        </a:spcAft>
        <a:buFont typeface="Arial" charset="0"/>
        <a:buChar char="–"/>
        <a:defRPr sz="2000" kern="1200">
          <a:solidFill>
            <a:schemeClr val="tx1"/>
          </a:solidFill>
          <a:latin typeface="Tw Cen MT"/>
          <a:ea typeface="ＭＳ Ｐゴシック" charset="0"/>
          <a:cs typeface="Tw Cen MT"/>
        </a:defRPr>
      </a:lvl4pPr>
      <a:lvl5pPr marL="2057400" indent="-228600" algn="l" defTabSz="457200" rtl="0" eaLnBrk="1" fontAlgn="base" hangingPunct="1">
        <a:spcBef>
          <a:spcPct val="20000"/>
        </a:spcBef>
        <a:spcAft>
          <a:spcPct val="0"/>
        </a:spcAft>
        <a:buFont typeface="Arial" charset="0"/>
        <a:buChar char="»"/>
        <a:defRPr sz="2000" kern="1200">
          <a:solidFill>
            <a:schemeClr val="tx1"/>
          </a:solidFill>
          <a:latin typeface="Tw Cen MT"/>
          <a:ea typeface="ＭＳ Ｐゴシック" charset="0"/>
          <a:cs typeface="Tw Cen MT"/>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36.jpeg"/><Relationship Id="rId1" Type="http://schemas.openxmlformats.org/officeDocument/2006/relationships/slideLayout" Target="../slideLayouts/slideLayout43.xml"/></Relationships>
</file>

<file path=ppt/slides/_rels/slide10.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notesSlide" Target="../notesSlides/notesSlide5.xml"/><Relationship Id="rId1" Type="http://schemas.openxmlformats.org/officeDocument/2006/relationships/slideLayout" Target="../slideLayouts/slideLayout22.xml"/></Relationships>
</file>

<file path=ppt/slides/_rels/slide11.xml.rels><?xml version="1.0" encoding="UTF-8" standalone="yes"?>
<Relationships xmlns="http://schemas.openxmlformats.org/package/2006/relationships"><Relationship Id="rId2" Type="http://schemas.openxmlformats.org/officeDocument/2006/relationships/image" Target="../media/image40.png"/><Relationship Id="rId1" Type="http://schemas.openxmlformats.org/officeDocument/2006/relationships/slideLayout" Target="../slideLayouts/slideLayout2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2.xml"/></Relationships>
</file>

<file path=ppt/slides/_rels/slide14.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image" Target="../media/image41.png"/><Relationship Id="rId1" Type="http://schemas.openxmlformats.org/officeDocument/2006/relationships/slideLayout" Target="../slideLayouts/slideLayout22.xml"/></Relationships>
</file>

<file path=ppt/slides/_rels/slide15.xml.rels><?xml version="1.0" encoding="UTF-8" standalone="yes"?>
<Relationships xmlns="http://schemas.openxmlformats.org/package/2006/relationships"><Relationship Id="rId3" Type="http://schemas.openxmlformats.org/officeDocument/2006/relationships/diagramLayout" Target="../diagrams/layout2.xml"/><Relationship Id="rId2" Type="http://schemas.openxmlformats.org/officeDocument/2006/relationships/diagramData" Target="../diagrams/data2.xml"/><Relationship Id="rId1" Type="http://schemas.openxmlformats.org/officeDocument/2006/relationships/slideLayout" Target="../slideLayouts/slideLayout36.xml"/><Relationship Id="rId6" Type="http://schemas.microsoft.com/office/2007/relationships/diagramDrawing" Target="../diagrams/drawing2.xml"/><Relationship Id="rId5" Type="http://schemas.openxmlformats.org/officeDocument/2006/relationships/diagramColors" Target="../diagrams/colors2.xml"/><Relationship Id="rId4" Type="http://schemas.openxmlformats.org/officeDocument/2006/relationships/diagramQuickStyle" Target="../diagrams/quickStyle2.xml"/></Relationships>
</file>

<file path=ppt/slides/_rels/slide16.xml.rels><?xml version="1.0" encoding="UTF-8" standalone="yes"?>
<Relationships xmlns="http://schemas.openxmlformats.org/package/2006/relationships"><Relationship Id="rId3" Type="http://schemas.openxmlformats.org/officeDocument/2006/relationships/diagramLayout" Target="../diagrams/layout3.xml"/><Relationship Id="rId2" Type="http://schemas.openxmlformats.org/officeDocument/2006/relationships/diagramData" Target="../diagrams/data3.xml"/><Relationship Id="rId1" Type="http://schemas.openxmlformats.org/officeDocument/2006/relationships/slideLayout" Target="../slideLayouts/slideLayout36.xml"/><Relationship Id="rId6" Type="http://schemas.microsoft.com/office/2007/relationships/diagramDrawing" Target="../diagrams/drawing3.xml"/><Relationship Id="rId5" Type="http://schemas.openxmlformats.org/officeDocument/2006/relationships/diagramColors" Target="../diagrams/colors3.xml"/><Relationship Id="rId4" Type="http://schemas.openxmlformats.org/officeDocument/2006/relationships/diagramQuickStyle" Target="../diagrams/quickStyle3.xml"/></Relationships>
</file>

<file path=ppt/slides/_rels/slide17.xml.rels><?xml version="1.0" encoding="UTF-8" standalone="yes"?>
<Relationships xmlns="http://schemas.openxmlformats.org/package/2006/relationships"><Relationship Id="rId3" Type="http://schemas.openxmlformats.org/officeDocument/2006/relationships/diagramLayout" Target="../diagrams/layout4.xml"/><Relationship Id="rId2" Type="http://schemas.openxmlformats.org/officeDocument/2006/relationships/diagramData" Target="../diagrams/data4.xml"/><Relationship Id="rId1" Type="http://schemas.openxmlformats.org/officeDocument/2006/relationships/slideLayout" Target="../slideLayouts/slideLayout36.xml"/><Relationship Id="rId6" Type="http://schemas.microsoft.com/office/2007/relationships/diagramDrawing" Target="../diagrams/drawing4.xml"/><Relationship Id="rId5" Type="http://schemas.openxmlformats.org/officeDocument/2006/relationships/diagramColors" Target="../diagrams/colors4.xml"/><Relationship Id="rId4" Type="http://schemas.openxmlformats.org/officeDocument/2006/relationships/diagramQuickStyle" Target="../diagrams/quickStyle4.xml"/></Relationships>
</file>

<file path=ppt/slides/_rels/slide18.xml.rels><?xml version="1.0" encoding="UTF-8" standalone="yes"?>
<Relationships xmlns="http://schemas.openxmlformats.org/package/2006/relationships"><Relationship Id="rId3" Type="http://schemas.openxmlformats.org/officeDocument/2006/relationships/diagramLayout" Target="../diagrams/layout5.xml"/><Relationship Id="rId2" Type="http://schemas.openxmlformats.org/officeDocument/2006/relationships/diagramData" Target="../diagrams/data5.xml"/><Relationship Id="rId1" Type="http://schemas.openxmlformats.org/officeDocument/2006/relationships/slideLayout" Target="../slideLayouts/slideLayout36.xml"/><Relationship Id="rId6" Type="http://schemas.microsoft.com/office/2007/relationships/diagramDrawing" Target="../diagrams/drawing5.xml"/><Relationship Id="rId5" Type="http://schemas.openxmlformats.org/officeDocument/2006/relationships/diagramColors" Target="../diagrams/colors5.xml"/><Relationship Id="rId4" Type="http://schemas.openxmlformats.org/officeDocument/2006/relationships/diagramQuickStyle" Target="../diagrams/quickStyle5.xml"/></Relationships>
</file>

<file path=ppt/slides/_rels/slide19.xml.rels><?xml version="1.0" encoding="UTF-8" standalone="yes"?>
<Relationships xmlns="http://schemas.openxmlformats.org/package/2006/relationships"><Relationship Id="rId3" Type="http://schemas.openxmlformats.org/officeDocument/2006/relationships/diagramLayout" Target="../diagrams/layout6.xml"/><Relationship Id="rId2" Type="http://schemas.openxmlformats.org/officeDocument/2006/relationships/diagramData" Target="../diagrams/data6.xml"/><Relationship Id="rId1" Type="http://schemas.openxmlformats.org/officeDocument/2006/relationships/slideLayout" Target="../slideLayouts/slideLayout36.xml"/><Relationship Id="rId6" Type="http://schemas.microsoft.com/office/2007/relationships/diagramDrawing" Target="../diagrams/drawing6.xml"/><Relationship Id="rId5" Type="http://schemas.openxmlformats.org/officeDocument/2006/relationships/diagramColors" Target="../diagrams/colors6.xml"/><Relationship Id="rId4" Type="http://schemas.openxmlformats.org/officeDocument/2006/relationships/diagramQuickStyle" Target="../diagrams/quickStyle6.xml"/></Relationships>
</file>

<file path=ppt/slides/_rels/slide2.xml.rels><?xml version="1.0" encoding="UTF-8" standalone="yes"?>
<Relationships xmlns="http://schemas.openxmlformats.org/package/2006/relationships"><Relationship Id="rId2" Type="http://schemas.openxmlformats.org/officeDocument/2006/relationships/image" Target="../media/image37.png"/><Relationship Id="rId1" Type="http://schemas.openxmlformats.org/officeDocument/2006/relationships/slideLayout" Target="../slideLayouts/slideLayout24.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2.xml"/></Relationships>
</file>

<file path=ppt/slides/_rels/slide3.xml.rels><?xml version="1.0" encoding="UTF-8" standalone="yes"?>
<Relationships xmlns="http://schemas.openxmlformats.org/package/2006/relationships"><Relationship Id="rId2" Type="http://schemas.openxmlformats.org/officeDocument/2006/relationships/image" Target="../media/image37.png"/><Relationship Id="rId1" Type="http://schemas.openxmlformats.org/officeDocument/2006/relationships/slideLayout" Target="../slideLayouts/slideLayout25.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6.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6.xml"/></Relationships>
</file>

<file path=ppt/slides/_rels/slide8.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9.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4.xml"/><Relationship Id="rId1" Type="http://schemas.openxmlformats.org/officeDocument/2006/relationships/slideLayout" Target="../slideLayouts/slideLayout2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Placeholder 10"/>
          <p:cNvPicPr>
            <a:picLocks noGrp="1" noChangeAspect="1"/>
          </p:cNvPicPr>
          <p:nvPr>
            <p:ph type="pic" sz="quarter" idx="12"/>
          </p:nvPr>
        </p:nvPicPr>
        <p:blipFill>
          <a:blip r:embed="rId2">
            <a:extLst>
              <a:ext uri="{28A0092B-C50C-407E-A947-70E740481C1C}">
                <a14:useLocalDpi xmlns:a14="http://schemas.microsoft.com/office/drawing/2010/main" val="0"/>
              </a:ext>
            </a:extLst>
          </a:blip>
          <a:stretch>
            <a:fillRect/>
          </a:stretch>
        </p:blipFill>
        <p:spPr>
          <a:xfrm>
            <a:off x="4587876" y="495176"/>
            <a:ext cx="4150358" cy="5863910"/>
          </a:xfrm>
        </p:spPr>
      </p:pic>
      <p:sp>
        <p:nvSpPr>
          <p:cNvPr id="8" name="Title 7"/>
          <p:cNvSpPr>
            <a:spLocks noGrp="1"/>
          </p:cNvSpPr>
          <p:nvPr>
            <p:ph type="title"/>
          </p:nvPr>
        </p:nvSpPr>
        <p:spPr>
          <a:xfrm>
            <a:off x="381884" y="2223843"/>
            <a:ext cx="3948874" cy="1322972"/>
          </a:xfrm>
        </p:spPr>
        <p:txBody>
          <a:bodyPr/>
          <a:lstStyle/>
          <a:p>
            <a:pPr algn="ctr"/>
            <a:r>
              <a:rPr lang="en-AU" sz="5400"/>
              <a:t>WELCOME.. </a:t>
            </a:r>
          </a:p>
        </p:txBody>
      </p:sp>
      <p:sp>
        <p:nvSpPr>
          <p:cNvPr id="9" name="Text Placeholder 8"/>
          <p:cNvSpPr>
            <a:spLocks noGrp="1"/>
          </p:cNvSpPr>
          <p:nvPr>
            <p:ph type="body" sz="quarter" idx="11"/>
          </p:nvPr>
        </p:nvSpPr>
        <p:spPr>
          <a:xfrm>
            <a:off x="381884" y="3240979"/>
            <a:ext cx="3963817" cy="852488"/>
          </a:xfrm>
        </p:spPr>
        <p:txBody>
          <a:bodyPr/>
          <a:lstStyle/>
          <a:p>
            <a:pPr algn="ctr"/>
            <a:r>
              <a:rPr lang="en-AU" sz="1800" b="1">
                <a:solidFill>
                  <a:srgbClr val="E64626"/>
                </a:solidFill>
              </a:rPr>
              <a:t>TO THE BMC LIVED EXPERIENCE WORKING GROUP </a:t>
            </a:r>
          </a:p>
        </p:txBody>
      </p:sp>
    </p:spTree>
    <p:extLst>
      <p:ext uri="{BB962C8B-B14F-4D97-AF65-F5344CB8AC3E}">
        <p14:creationId xmlns:p14="http://schemas.microsoft.com/office/powerpoint/2010/main" val="117142757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Content Placeholder 5" descr="Graphical user interface, text, application, email&#10;&#10;Description automatically generated">
            <a:extLst>
              <a:ext uri="{FF2B5EF4-FFF2-40B4-BE49-F238E27FC236}">
                <a16:creationId xmlns:a16="http://schemas.microsoft.com/office/drawing/2014/main" id="{DB2D4295-9927-D246-8828-2868A69AA273}"/>
              </a:ext>
            </a:extLst>
          </p:cNvPr>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7840" y="731520"/>
            <a:ext cx="9136159" cy="4990010"/>
          </a:xfrm>
        </p:spPr>
      </p:pic>
      <p:sp>
        <p:nvSpPr>
          <p:cNvPr id="7" name="TextBox 6">
            <a:extLst>
              <a:ext uri="{FF2B5EF4-FFF2-40B4-BE49-F238E27FC236}">
                <a16:creationId xmlns:a16="http://schemas.microsoft.com/office/drawing/2014/main" id="{4F44CD61-CF72-EA48-BC7A-1DC87126D75B}"/>
              </a:ext>
            </a:extLst>
          </p:cNvPr>
          <p:cNvSpPr txBox="1"/>
          <p:nvPr/>
        </p:nvSpPr>
        <p:spPr>
          <a:xfrm>
            <a:off x="339634" y="-1463040"/>
            <a:ext cx="184731" cy="369332"/>
          </a:xfrm>
          <a:prstGeom prst="rect">
            <a:avLst/>
          </a:prstGeom>
          <a:noFill/>
        </p:spPr>
        <p:txBody>
          <a:bodyPr wrap="none" rtlCol="0">
            <a:spAutoFit/>
          </a:bodyPr>
          <a:lstStyle/>
          <a:p>
            <a:endParaRPr lang="en-US"/>
          </a:p>
        </p:txBody>
      </p:sp>
    </p:spTree>
    <p:extLst>
      <p:ext uri="{BB962C8B-B14F-4D97-AF65-F5344CB8AC3E}">
        <p14:creationId xmlns:p14="http://schemas.microsoft.com/office/powerpoint/2010/main" val="168612079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Graphical user interface, text, application, email&#10;&#10;Description automatically generated">
            <a:extLst>
              <a:ext uri="{FF2B5EF4-FFF2-40B4-BE49-F238E27FC236}">
                <a16:creationId xmlns:a16="http://schemas.microsoft.com/office/drawing/2014/main" id="{B61FD3D6-4B77-4C19-AAB4-3E5E442AC5B9}"/>
              </a:ext>
            </a:extLst>
          </p:cNvPr>
          <p:cNvPicPr>
            <a:picLocks noChangeAspect="1"/>
          </p:cNvPicPr>
          <p:nvPr/>
        </p:nvPicPr>
        <p:blipFill>
          <a:blip r:embed="rId2"/>
          <a:stretch>
            <a:fillRect/>
          </a:stretch>
        </p:blipFill>
        <p:spPr>
          <a:xfrm>
            <a:off x="-3090" y="657325"/>
            <a:ext cx="9136813" cy="5041700"/>
          </a:xfrm>
          <a:prstGeom prst="rect">
            <a:avLst/>
          </a:prstGeom>
          <a:noFill/>
        </p:spPr>
      </p:pic>
    </p:spTree>
    <p:extLst>
      <p:ext uri="{BB962C8B-B14F-4D97-AF65-F5344CB8AC3E}">
        <p14:creationId xmlns:p14="http://schemas.microsoft.com/office/powerpoint/2010/main" val="42189325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10A8E28A-2C2E-8C46-A78B-F1DBFA006299}"/>
              </a:ext>
            </a:extLst>
          </p:cNvPr>
          <p:cNvSpPr>
            <a:spLocks noGrp="1"/>
          </p:cNvSpPr>
          <p:nvPr>
            <p:ph idx="1"/>
          </p:nvPr>
        </p:nvSpPr>
        <p:spPr>
          <a:xfrm>
            <a:off x="358777" y="1661532"/>
            <a:ext cx="8328025" cy="4464635"/>
          </a:xfrm>
        </p:spPr>
        <p:txBody>
          <a:bodyPr/>
          <a:lstStyle/>
          <a:p>
            <a:r>
              <a:rPr lang="en-US" b="0" dirty="0"/>
              <a:t>As suggested by YOUR suggestions, let’s review and update OUR Terms of Reference!</a:t>
            </a:r>
            <a:endParaRPr lang="en-US" dirty="0"/>
          </a:p>
        </p:txBody>
      </p:sp>
      <p:sp>
        <p:nvSpPr>
          <p:cNvPr id="3" name="Title 2">
            <a:extLst>
              <a:ext uri="{FF2B5EF4-FFF2-40B4-BE49-F238E27FC236}">
                <a16:creationId xmlns:a16="http://schemas.microsoft.com/office/drawing/2014/main" id="{16E5470B-D93B-2F40-82D9-834BC150C9F3}"/>
              </a:ext>
            </a:extLst>
          </p:cNvPr>
          <p:cNvSpPr>
            <a:spLocks noGrp="1"/>
          </p:cNvSpPr>
          <p:nvPr>
            <p:ph type="title"/>
          </p:nvPr>
        </p:nvSpPr>
        <p:spPr/>
        <p:txBody>
          <a:bodyPr/>
          <a:lstStyle/>
          <a:p>
            <a:r>
              <a:rPr lang="en-US" sz="3000" dirty="0"/>
              <a:t>ACTIVITY – TERMS OF REFERENCE</a:t>
            </a:r>
          </a:p>
        </p:txBody>
      </p:sp>
    </p:spTree>
    <p:extLst>
      <p:ext uri="{BB962C8B-B14F-4D97-AF65-F5344CB8AC3E}">
        <p14:creationId xmlns:p14="http://schemas.microsoft.com/office/powerpoint/2010/main" val="95968853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C207EF0-D5F8-4C7D-9363-8246CDD5503A}"/>
              </a:ext>
            </a:extLst>
          </p:cNvPr>
          <p:cNvSpPr>
            <a:spLocks noGrp="1"/>
          </p:cNvSpPr>
          <p:nvPr>
            <p:ph type="title"/>
          </p:nvPr>
        </p:nvSpPr>
        <p:spPr/>
        <p:txBody>
          <a:bodyPr/>
          <a:lstStyle/>
          <a:p>
            <a:r>
              <a:rPr lang="en-US" sz="3000"/>
              <a:t>AGENDA</a:t>
            </a:r>
            <a:endParaRPr lang="en-AU" sz="3000"/>
          </a:p>
        </p:txBody>
      </p:sp>
      <p:graphicFrame>
        <p:nvGraphicFramePr>
          <p:cNvPr id="2" name="Table 5">
            <a:extLst>
              <a:ext uri="{FF2B5EF4-FFF2-40B4-BE49-F238E27FC236}">
                <a16:creationId xmlns:a16="http://schemas.microsoft.com/office/drawing/2014/main" id="{BDD0BB5F-C0C4-9BCC-32A9-06A93694318B}"/>
              </a:ext>
            </a:extLst>
          </p:cNvPr>
          <p:cNvGraphicFramePr>
            <a:graphicFrameLocks noGrp="1"/>
          </p:cNvGraphicFramePr>
          <p:nvPr>
            <p:extLst>
              <p:ext uri="{D42A27DB-BD31-4B8C-83A1-F6EECF244321}">
                <p14:modId xmlns:p14="http://schemas.microsoft.com/office/powerpoint/2010/main" val="1825989426"/>
              </p:ext>
            </p:extLst>
          </p:nvPr>
        </p:nvGraphicFramePr>
        <p:xfrm>
          <a:off x="931177" y="1279555"/>
          <a:ext cx="7281644" cy="3662680"/>
        </p:xfrm>
        <a:graphic>
          <a:graphicData uri="http://schemas.openxmlformats.org/drawingml/2006/table">
            <a:tbl>
              <a:tblPr firstRow="1" bandRow="1">
                <a:tableStyleId>{5C22544A-7EE6-4342-B048-85BDC9FD1C3A}</a:tableStyleId>
              </a:tblPr>
              <a:tblGrid>
                <a:gridCol w="4597168">
                  <a:extLst>
                    <a:ext uri="{9D8B030D-6E8A-4147-A177-3AD203B41FA5}">
                      <a16:colId xmlns:a16="http://schemas.microsoft.com/office/drawing/2014/main" val="1063796124"/>
                    </a:ext>
                  </a:extLst>
                </a:gridCol>
                <a:gridCol w="1426127">
                  <a:extLst>
                    <a:ext uri="{9D8B030D-6E8A-4147-A177-3AD203B41FA5}">
                      <a16:colId xmlns:a16="http://schemas.microsoft.com/office/drawing/2014/main" val="2208106103"/>
                    </a:ext>
                  </a:extLst>
                </a:gridCol>
                <a:gridCol w="1258349">
                  <a:extLst>
                    <a:ext uri="{9D8B030D-6E8A-4147-A177-3AD203B41FA5}">
                      <a16:colId xmlns:a16="http://schemas.microsoft.com/office/drawing/2014/main" val="871386756"/>
                    </a:ext>
                  </a:extLst>
                </a:gridCol>
              </a:tblGrid>
              <a:tr h="370840">
                <a:tc>
                  <a:txBody>
                    <a:bodyPr/>
                    <a:lstStyle/>
                    <a:p>
                      <a:r>
                        <a:rPr lang="en-US" sz="2000"/>
                        <a:t>ITEM</a:t>
                      </a:r>
                      <a:endParaRPr lang="en-AU" sz="2000"/>
                    </a:p>
                  </a:txBody>
                  <a:tcPr/>
                </a:tc>
                <a:tc>
                  <a:txBody>
                    <a:bodyPr/>
                    <a:lstStyle/>
                    <a:p>
                      <a:r>
                        <a:rPr lang="en-US" sz="2000"/>
                        <a:t>LEAD</a:t>
                      </a:r>
                      <a:endParaRPr lang="en-AU" sz="2000"/>
                    </a:p>
                  </a:txBody>
                  <a:tcPr/>
                </a:tc>
                <a:tc>
                  <a:txBody>
                    <a:bodyPr/>
                    <a:lstStyle/>
                    <a:p>
                      <a:r>
                        <a:rPr lang="en-US" sz="2000"/>
                        <a:t>FINISH BY</a:t>
                      </a:r>
                      <a:endParaRPr lang="en-AU" sz="2000"/>
                    </a:p>
                  </a:txBody>
                  <a:tcPr/>
                </a:tc>
                <a:extLst>
                  <a:ext uri="{0D108BD9-81ED-4DB2-BD59-A6C34878D82A}">
                    <a16:rowId xmlns:a16="http://schemas.microsoft.com/office/drawing/2014/main" val="3114398745"/>
                  </a:ext>
                </a:extLst>
              </a:tr>
              <a:tr h="370840">
                <a:tc>
                  <a:txBody>
                    <a:bodyPr/>
                    <a:lstStyle/>
                    <a:p>
                      <a:r>
                        <a:rPr lang="en-US" sz="1600" b="1" dirty="0"/>
                        <a:t>PRE-BRIEF</a:t>
                      </a:r>
                    </a:p>
                    <a:p>
                      <a:r>
                        <a:rPr lang="en-US" sz="1600" b="0" dirty="0"/>
                        <a:t>-Introducing today’s session</a:t>
                      </a:r>
                      <a:endParaRPr lang="en-AU" sz="1600" b="0" dirty="0"/>
                    </a:p>
                  </a:txBody>
                  <a:tcPr/>
                </a:tc>
                <a:tc>
                  <a:txBody>
                    <a:bodyPr/>
                    <a:lstStyle/>
                    <a:p>
                      <a:r>
                        <a:rPr lang="en-AU" sz="1600" dirty="0"/>
                        <a:t>SJH</a:t>
                      </a:r>
                    </a:p>
                  </a:txBody>
                  <a:tcPr/>
                </a:tc>
                <a:tc>
                  <a:txBody>
                    <a:bodyPr/>
                    <a:lstStyle/>
                    <a:p>
                      <a:r>
                        <a:rPr lang="en-AU" sz="1600" dirty="0"/>
                        <a:t>4:45</a:t>
                      </a:r>
                    </a:p>
                  </a:txBody>
                  <a:tcPr/>
                </a:tc>
                <a:extLst>
                  <a:ext uri="{0D108BD9-81ED-4DB2-BD59-A6C34878D82A}">
                    <a16:rowId xmlns:a16="http://schemas.microsoft.com/office/drawing/2014/main" val="1469886913"/>
                  </a:ext>
                </a:extLst>
              </a:tr>
              <a:tr h="370840">
                <a:tc>
                  <a:txBody>
                    <a:bodyPr/>
                    <a:lstStyle/>
                    <a:p>
                      <a:r>
                        <a:rPr lang="en-US" sz="1600" b="1" dirty="0"/>
                        <a:t>UPDATE</a:t>
                      </a:r>
                    </a:p>
                    <a:p>
                      <a:r>
                        <a:rPr lang="en-US" sz="1600" b="0" dirty="0"/>
                        <a:t>-How we will incorporate feedback to improve </a:t>
                      </a:r>
                      <a:endParaRPr lang="en-AU" sz="1600" b="0" dirty="0"/>
                    </a:p>
                  </a:txBody>
                  <a:tcPr/>
                </a:tc>
                <a:tc>
                  <a:txBody>
                    <a:bodyPr/>
                    <a:lstStyle/>
                    <a:p>
                      <a:r>
                        <a:rPr lang="en-US" sz="1600" dirty="0"/>
                        <a:t>CYJS</a:t>
                      </a:r>
                      <a:endParaRPr lang="en-AU" sz="1600" dirty="0"/>
                    </a:p>
                  </a:txBody>
                  <a:tcPr/>
                </a:tc>
                <a:tc>
                  <a:txBody>
                    <a:bodyPr/>
                    <a:lstStyle/>
                    <a:p>
                      <a:r>
                        <a:rPr lang="en-US" sz="1600" dirty="0"/>
                        <a:t>05:15</a:t>
                      </a:r>
                      <a:endParaRPr lang="en-AU" sz="1600" dirty="0"/>
                    </a:p>
                  </a:txBody>
                  <a:tcPr/>
                </a:tc>
                <a:extLst>
                  <a:ext uri="{0D108BD9-81ED-4DB2-BD59-A6C34878D82A}">
                    <a16:rowId xmlns:a16="http://schemas.microsoft.com/office/drawing/2014/main" val="1069944501"/>
                  </a:ext>
                </a:extLst>
              </a:tr>
              <a:tr h="370840">
                <a:tc>
                  <a:txBody>
                    <a:bodyPr/>
                    <a:lstStyle/>
                    <a:p>
                      <a:r>
                        <a:rPr lang="en-US" sz="1600" b="1" dirty="0"/>
                        <a:t>REVIEW</a:t>
                      </a:r>
                    </a:p>
                    <a:p>
                      <a:r>
                        <a:rPr lang="en-US" sz="1600" b="0" dirty="0"/>
                        <a:t>-Terms of Reference </a:t>
                      </a:r>
                      <a:endParaRPr lang="en-AU" sz="1600" b="0" dirty="0"/>
                    </a:p>
                  </a:txBody>
                  <a:tcPr/>
                </a:tc>
                <a:tc>
                  <a:txBody>
                    <a:bodyPr/>
                    <a:lstStyle/>
                    <a:p>
                      <a:r>
                        <a:rPr lang="en-US" sz="1600" dirty="0"/>
                        <a:t>AH</a:t>
                      </a:r>
                      <a:endParaRPr lang="en-AU" sz="1600" dirty="0"/>
                    </a:p>
                  </a:txBody>
                  <a:tcPr/>
                </a:tc>
                <a:tc>
                  <a:txBody>
                    <a:bodyPr/>
                    <a:lstStyle/>
                    <a:p>
                      <a:r>
                        <a:rPr lang="en-US" sz="1600" dirty="0"/>
                        <a:t>06:00</a:t>
                      </a:r>
                      <a:endParaRPr lang="en-AU" sz="1600" dirty="0"/>
                    </a:p>
                  </a:txBody>
                  <a:tcPr/>
                </a:tc>
                <a:extLst>
                  <a:ext uri="{0D108BD9-81ED-4DB2-BD59-A6C34878D82A}">
                    <a16:rowId xmlns:a16="http://schemas.microsoft.com/office/drawing/2014/main" val="3804914577"/>
                  </a:ext>
                </a:extLst>
              </a:tr>
              <a:tr h="370840">
                <a:tc gridSpan="2">
                  <a:txBody>
                    <a:bodyPr/>
                    <a:lstStyle/>
                    <a:p>
                      <a:pPr algn="ctr"/>
                      <a:r>
                        <a:rPr lang="en-US" sz="1600" b="1" dirty="0">
                          <a:solidFill>
                            <a:schemeClr val="bg1"/>
                          </a:solidFill>
                        </a:rPr>
                        <a:t>SHORT BREAK</a:t>
                      </a:r>
                      <a:endParaRPr lang="en-AU" sz="1600" b="1" dirty="0">
                        <a:solidFill>
                          <a:schemeClr val="bg1"/>
                        </a:solidFill>
                      </a:endParaRPr>
                    </a:p>
                  </a:txBody>
                  <a:tcPr>
                    <a:solidFill>
                      <a:schemeClr val="accent1"/>
                    </a:solidFill>
                  </a:tcPr>
                </a:tc>
                <a:tc hMerge="1">
                  <a:txBody>
                    <a:bodyPr/>
                    <a:lstStyle/>
                    <a:p>
                      <a:pPr algn="ctr"/>
                      <a:endParaRPr lang="en-AU" sz="1600" b="1">
                        <a:solidFill>
                          <a:schemeClr val="bg1"/>
                        </a:solidFill>
                      </a:endParaRPr>
                    </a:p>
                  </a:txBody>
                  <a:tcPr>
                    <a:solidFill>
                      <a:schemeClr val="accent1"/>
                    </a:solidFill>
                  </a:tcPr>
                </a:tc>
                <a:tc>
                  <a:txBody>
                    <a:bodyPr/>
                    <a:lstStyle/>
                    <a:p>
                      <a:r>
                        <a:rPr lang="en-US" sz="1600" dirty="0">
                          <a:solidFill>
                            <a:schemeClr val="bg1"/>
                          </a:solidFill>
                        </a:rPr>
                        <a:t>6:05</a:t>
                      </a:r>
                      <a:endParaRPr lang="en-AU" sz="1600" dirty="0">
                        <a:solidFill>
                          <a:schemeClr val="bg1"/>
                        </a:solidFill>
                      </a:endParaRPr>
                    </a:p>
                  </a:txBody>
                  <a:tcPr>
                    <a:solidFill>
                      <a:schemeClr val="accent1"/>
                    </a:solidFill>
                  </a:tcPr>
                </a:tc>
                <a:extLst>
                  <a:ext uri="{0D108BD9-81ED-4DB2-BD59-A6C34878D82A}">
                    <a16:rowId xmlns:a16="http://schemas.microsoft.com/office/drawing/2014/main" val="4230905109"/>
                  </a:ext>
                </a:extLst>
              </a:tr>
              <a:tr h="370840">
                <a:tc>
                  <a:txBody>
                    <a:bodyPr/>
                    <a:lstStyle/>
                    <a:p>
                      <a:r>
                        <a:rPr lang="en-US" sz="1600" b="1" dirty="0"/>
                        <a:t>LEARN</a:t>
                      </a:r>
                    </a:p>
                    <a:p>
                      <a:r>
                        <a:rPr lang="en-US" sz="1600" b="0" dirty="0"/>
                        <a:t>-Research cycle ‘crash course’</a:t>
                      </a:r>
                    </a:p>
                  </a:txBody>
                  <a:tcPr/>
                </a:tc>
                <a:tc>
                  <a:txBody>
                    <a:bodyPr/>
                    <a:lstStyle/>
                    <a:p>
                      <a:r>
                        <a:rPr lang="en-US" sz="1600" dirty="0"/>
                        <a:t>GYL</a:t>
                      </a:r>
                      <a:endParaRPr lang="en-AU" sz="1600" dirty="0"/>
                    </a:p>
                  </a:txBody>
                  <a:tcPr/>
                </a:tc>
                <a:tc>
                  <a:txBody>
                    <a:bodyPr/>
                    <a:lstStyle/>
                    <a:p>
                      <a:r>
                        <a:rPr lang="en-US" sz="1600" dirty="0"/>
                        <a:t>07:00</a:t>
                      </a:r>
                      <a:endParaRPr lang="en-AU" sz="1600" dirty="0"/>
                    </a:p>
                  </a:txBody>
                  <a:tcPr/>
                </a:tc>
                <a:extLst>
                  <a:ext uri="{0D108BD9-81ED-4DB2-BD59-A6C34878D82A}">
                    <a16:rowId xmlns:a16="http://schemas.microsoft.com/office/drawing/2014/main" val="685965204"/>
                  </a:ext>
                </a:extLst>
              </a:tr>
              <a:tr h="370840">
                <a:tc>
                  <a:txBody>
                    <a:bodyPr/>
                    <a:lstStyle/>
                    <a:p>
                      <a:r>
                        <a:rPr lang="en-US" sz="1600" b="1" dirty="0"/>
                        <a:t>DE-BRIEF &amp; DINNER</a:t>
                      </a:r>
                    </a:p>
                    <a:p>
                      <a:r>
                        <a:rPr lang="en-US" sz="1600" b="0" dirty="0"/>
                        <a:t>-How did the group find today’s session?</a:t>
                      </a:r>
                    </a:p>
                  </a:txBody>
                  <a:tcPr/>
                </a:tc>
                <a:tc>
                  <a:txBody>
                    <a:bodyPr/>
                    <a:lstStyle/>
                    <a:p>
                      <a:r>
                        <a:rPr lang="en-AU" sz="1600" dirty="0"/>
                        <a:t>SH</a:t>
                      </a:r>
                    </a:p>
                  </a:txBody>
                  <a:tcPr/>
                </a:tc>
                <a:tc>
                  <a:txBody>
                    <a:bodyPr/>
                    <a:lstStyle/>
                    <a:p>
                      <a:r>
                        <a:rPr lang="en-AU" sz="1600" dirty="0"/>
                        <a:t>7:30</a:t>
                      </a:r>
                    </a:p>
                  </a:txBody>
                  <a:tcPr/>
                </a:tc>
                <a:extLst>
                  <a:ext uri="{0D108BD9-81ED-4DB2-BD59-A6C34878D82A}">
                    <a16:rowId xmlns:a16="http://schemas.microsoft.com/office/drawing/2014/main" val="3169887069"/>
                  </a:ext>
                </a:extLst>
              </a:tr>
            </a:tbl>
          </a:graphicData>
        </a:graphic>
      </p:graphicFrame>
    </p:spTree>
    <p:extLst>
      <p:ext uri="{BB962C8B-B14F-4D97-AF65-F5344CB8AC3E}">
        <p14:creationId xmlns:p14="http://schemas.microsoft.com/office/powerpoint/2010/main" val="36905572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A739DE6E-1586-4EC4-9EB1-6AB33C5858C3}"/>
              </a:ext>
            </a:extLst>
          </p:cNvPr>
          <p:cNvSpPr>
            <a:spLocks noGrp="1"/>
          </p:cNvSpPr>
          <p:nvPr>
            <p:ph idx="1"/>
          </p:nvPr>
        </p:nvSpPr>
        <p:spPr/>
        <p:txBody>
          <a:bodyPr/>
          <a:lstStyle/>
          <a:p>
            <a:r>
              <a:rPr lang="en-US" dirty="0"/>
              <a:t>Ethics: </a:t>
            </a:r>
            <a:r>
              <a:rPr lang="en-US" b="0" dirty="0"/>
              <a:t>Refers to research ethics. All research studies that collect and report on data (through academic papers) must be approved by an ethics committee. All research must be conducted according to what has been approved by the ethics committee. </a:t>
            </a:r>
          </a:p>
          <a:p>
            <a:endParaRPr lang="en-US" b="0" dirty="0"/>
          </a:p>
          <a:p>
            <a:pPr marL="0" indent="0">
              <a:buNone/>
            </a:pPr>
            <a:endParaRPr lang="en-US" dirty="0"/>
          </a:p>
          <a:p>
            <a:pPr marL="0" indent="0">
              <a:buNone/>
            </a:pPr>
            <a:endParaRPr lang="en-US" dirty="0"/>
          </a:p>
          <a:p>
            <a:r>
              <a:rPr lang="en-US" dirty="0"/>
              <a:t>Funding: </a:t>
            </a:r>
            <a:r>
              <a:rPr lang="en-US" b="0" dirty="0"/>
              <a:t>Refers to research funding. There are various sources of funding, such as through donations or by applying for various funding opportunities (called ‘grants’). Funding is highly competitive. </a:t>
            </a:r>
          </a:p>
          <a:p>
            <a:pPr marL="0" indent="0">
              <a:buNone/>
            </a:pPr>
            <a:endParaRPr lang="en-US" dirty="0"/>
          </a:p>
          <a:p>
            <a:r>
              <a:rPr lang="en-US" dirty="0"/>
              <a:t>Academic paper: </a:t>
            </a:r>
            <a:r>
              <a:rPr lang="en-US" b="0" dirty="0"/>
              <a:t>Is the most common form of reporting data, and is an important outcome for researchers in University-settings. </a:t>
            </a:r>
            <a:r>
              <a:rPr lang="en-AU" b="0" dirty="0"/>
              <a:t>The first person listed on the academic paper usually writes the paper from start to finish, with support from other authors. The last person is the most senior author. </a:t>
            </a:r>
          </a:p>
          <a:p>
            <a:endParaRPr lang="en-US" b="0" dirty="0"/>
          </a:p>
        </p:txBody>
      </p:sp>
      <p:sp>
        <p:nvSpPr>
          <p:cNvPr id="3" name="Title 2">
            <a:extLst>
              <a:ext uri="{FF2B5EF4-FFF2-40B4-BE49-F238E27FC236}">
                <a16:creationId xmlns:a16="http://schemas.microsoft.com/office/drawing/2014/main" id="{E005AC93-71BC-4275-88EC-058B82BC1C4E}"/>
              </a:ext>
            </a:extLst>
          </p:cNvPr>
          <p:cNvSpPr>
            <a:spLocks noGrp="1"/>
          </p:cNvSpPr>
          <p:nvPr>
            <p:ph type="title"/>
          </p:nvPr>
        </p:nvSpPr>
        <p:spPr/>
        <p:txBody>
          <a:bodyPr/>
          <a:lstStyle/>
          <a:p>
            <a:r>
              <a:rPr lang="en-US" dirty="0"/>
              <a:t>COMMON TERMS AND/OR ROLES </a:t>
            </a:r>
            <a:endParaRPr lang="en-AU" dirty="0"/>
          </a:p>
        </p:txBody>
      </p:sp>
      <p:pic>
        <p:nvPicPr>
          <p:cNvPr id="9" name="Picture 8">
            <a:extLst>
              <a:ext uri="{FF2B5EF4-FFF2-40B4-BE49-F238E27FC236}">
                <a16:creationId xmlns:a16="http://schemas.microsoft.com/office/drawing/2014/main" id="{6B5DEDBA-36F3-411C-BB64-C1015AACDCB4}"/>
              </a:ext>
            </a:extLst>
          </p:cNvPr>
          <p:cNvPicPr>
            <a:picLocks noChangeAspect="1"/>
          </p:cNvPicPr>
          <p:nvPr/>
        </p:nvPicPr>
        <p:blipFill>
          <a:blip r:embed="rId2"/>
          <a:stretch>
            <a:fillRect/>
          </a:stretch>
        </p:blipFill>
        <p:spPr>
          <a:xfrm>
            <a:off x="1638300" y="2181958"/>
            <a:ext cx="5867400" cy="781050"/>
          </a:xfrm>
          <a:prstGeom prst="rect">
            <a:avLst/>
          </a:prstGeom>
        </p:spPr>
      </p:pic>
      <p:pic>
        <p:nvPicPr>
          <p:cNvPr id="11" name="Picture 10">
            <a:extLst>
              <a:ext uri="{FF2B5EF4-FFF2-40B4-BE49-F238E27FC236}">
                <a16:creationId xmlns:a16="http://schemas.microsoft.com/office/drawing/2014/main" id="{5D406807-62CB-4359-A3C5-D1E0C0F51BDA}"/>
              </a:ext>
            </a:extLst>
          </p:cNvPr>
          <p:cNvPicPr>
            <a:picLocks noChangeAspect="1"/>
          </p:cNvPicPr>
          <p:nvPr/>
        </p:nvPicPr>
        <p:blipFill>
          <a:blip r:embed="rId3"/>
          <a:stretch>
            <a:fillRect/>
          </a:stretch>
        </p:blipFill>
        <p:spPr>
          <a:xfrm>
            <a:off x="1990725" y="5309342"/>
            <a:ext cx="5162550" cy="876300"/>
          </a:xfrm>
          <a:prstGeom prst="rect">
            <a:avLst/>
          </a:prstGeom>
        </p:spPr>
      </p:pic>
    </p:spTree>
    <p:extLst>
      <p:ext uri="{BB962C8B-B14F-4D97-AF65-F5344CB8AC3E}">
        <p14:creationId xmlns:p14="http://schemas.microsoft.com/office/powerpoint/2010/main" val="261054514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a:extLst>
              <a:ext uri="{FF2B5EF4-FFF2-40B4-BE49-F238E27FC236}">
                <a16:creationId xmlns:a16="http://schemas.microsoft.com/office/drawing/2014/main" id="{984D9918-6EAD-9542-8ED9-94B58ABB2D15}"/>
              </a:ext>
            </a:extLst>
          </p:cNvPr>
          <p:cNvGraphicFramePr/>
          <p:nvPr>
            <p:extLst>
              <p:ext uri="{D42A27DB-BD31-4B8C-83A1-F6EECF244321}">
                <p14:modId xmlns:p14="http://schemas.microsoft.com/office/powerpoint/2010/main" val="686046257"/>
              </p:ext>
            </p:extLst>
          </p:nvPr>
        </p:nvGraphicFramePr>
        <p:xfrm>
          <a:off x="741556" y="653235"/>
          <a:ext cx="7660888" cy="5363738"/>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58" name="TextBox 57">
            <a:extLst>
              <a:ext uri="{FF2B5EF4-FFF2-40B4-BE49-F238E27FC236}">
                <a16:creationId xmlns:a16="http://schemas.microsoft.com/office/drawing/2014/main" id="{EA8514EB-4087-324B-93CD-C7EE542D49CE}"/>
              </a:ext>
            </a:extLst>
          </p:cNvPr>
          <p:cNvSpPr txBox="1"/>
          <p:nvPr/>
        </p:nvSpPr>
        <p:spPr>
          <a:xfrm>
            <a:off x="3289610" y="6016973"/>
            <a:ext cx="4572000" cy="276999"/>
          </a:xfrm>
          <a:prstGeom prst="rect">
            <a:avLst/>
          </a:prstGeom>
          <a:noFill/>
        </p:spPr>
        <p:txBody>
          <a:bodyPr wrap="square">
            <a:spAutoFit/>
          </a:bodyPr>
          <a:lstStyle/>
          <a:p>
            <a:pPr algn="r"/>
            <a:r>
              <a:rPr lang="en-AU" sz="1200" b="0" i="1" u="none" strike="noStrike" dirty="0">
                <a:solidFill>
                  <a:srgbClr val="000000"/>
                </a:solidFill>
                <a:effectLst/>
                <a:latin typeface="Tw Cen MT" panose="020B0602020104020603" pitchFamily="34" charset="77"/>
              </a:rPr>
              <a:t>(Hemming, 2021) </a:t>
            </a:r>
            <a:endParaRPr lang="en-US" sz="1200" i="1" dirty="0">
              <a:latin typeface="Tw Cen MT" panose="020B0602020104020603" pitchFamily="34" charset="77"/>
            </a:endParaRPr>
          </a:p>
        </p:txBody>
      </p:sp>
    </p:spTree>
    <p:extLst>
      <p:ext uri="{BB962C8B-B14F-4D97-AF65-F5344CB8AC3E}">
        <p14:creationId xmlns:p14="http://schemas.microsoft.com/office/powerpoint/2010/main" val="35207315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a:extLst>
              <a:ext uri="{FF2B5EF4-FFF2-40B4-BE49-F238E27FC236}">
                <a16:creationId xmlns:a16="http://schemas.microsoft.com/office/drawing/2014/main" id="{984D9918-6EAD-9542-8ED9-94B58ABB2D15}"/>
              </a:ext>
            </a:extLst>
          </p:cNvPr>
          <p:cNvGraphicFramePr/>
          <p:nvPr>
            <p:extLst>
              <p:ext uri="{D42A27DB-BD31-4B8C-83A1-F6EECF244321}">
                <p14:modId xmlns:p14="http://schemas.microsoft.com/office/powerpoint/2010/main" val="682224347"/>
              </p:ext>
            </p:extLst>
          </p:nvPr>
        </p:nvGraphicFramePr>
        <p:xfrm>
          <a:off x="3002466" y="894557"/>
          <a:ext cx="6462132" cy="4766258"/>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6" name="Content Placeholder 1">
            <a:extLst>
              <a:ext uri="{FF2B5EF4-FFF2-40B4-BE49-F238E27FC236}">
                <a16:creationId xmlns:a16="http://schemas.microsoft.com/office/drawing/2014/main" id="{AA352C3B-02E8-9C4D-AE08-2F72617D4067}"/>
              </a:ext>
            </a:extLst>
          </p:cNvPr>
          <p:cNvSpPr txBox="1">
            <a:spLocks/>
          </p:cNvSpPr>
          <p:nvPr/>
        </p:nvSpPr>
        <p:spPr>
          <a:xfrm>
            <a:off x="213812" y="2184094"/>
            <a:ext cx="3399184" cy="2187184"/>
          </a:xfrm>
          <a:prstGeom prst="rect">
            <a:avLst/>
          </a:prstGeom>
        </p:spPr>
        <p:txBody>
          <a:bodyPr/>
          <a:lstStyle>
            <a:lvl1pPr marL="192881" indent="-192881" algn="l" defTabSz="257175" rtl="0" eaLnBrk="1" fontAlgn="base" hangingPunct="1">
              <a:spcBef>
                <a:spcPct val="20000"/>
              </a:spcBef>
              <a:spcAft>
                <a:spcPct val="0"/>
              </a:spcAft>
              <a:buFont typeface="Lucida Grande" charset="0"/>
              <a:buChar char="–"/>
              <a:defRPr sz="1800" b="1" kern="1200">
                <a:solidFill>
                  <a:schemeClr val="tx1"/>
                </a:solidFill>
                <a:latin typeface="Tw Cen MT"/>
                <a:ea typeface="ＭＳ Ｐゴシック" charset="0"/>
                <a:cs typeface="Tw Cen MT"/>
              </a:defRPr>
            </a:lvl1pPr>
            <a:lvl2pPr marL="417910" indent="-160735"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2pPr>
            <a:lvl3pPr marL="642938"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3pPr>
            <a:lvl4pPr marL="900113"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4pPr>
            <a:lvl5pPr marL="1157288"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5pPr>
            <a:lvl6pPr marL="1414463" indent="-128588" algn="l" defTabSz="257175" rtl="0" eaLnBrk="1" latinLnBrk="0" hangingPunct="1">
              <a:spcBef>
                <a:spcPct val="20000"/>
              </a:spcBef>
              <a:buFont typeface="Arial"/>
              <a:buChar char="•"/>
              <a:defRPr sz="1125" kern="1200">
                <a:solidFill>
                  <a:schemeClr val="tx1"/>
                </a:solidFill>
                <a:latin typeface="+mn-lt"/>
                <a:ea typeface="+mn-ea"/>
                <a:cs typeface="+mn-cs"/>
              </a:defRPr>
            </a:lvl6pPr>
            <a:lvl7pPr marL="1671638" indent="-128588" algn="l" defTabSz="257175" rtl="0" eaLnBrk="1" latinLnBrk="0" hangingPunct="1">
              <a:spcBef>
                <a:spcPct val="20000"/>
              </a:spcBef>
              <a:buFont typeface="Arial"/>
              <a:buChar char="•"/>
              <a:defRPr sz="1125" kern="1200">
                <a:solidFill>
                  <a:schemeClr val="tx1"/>
                </a:solidFill>
                <a:latin typeface="+mn-lt"/>
                <a:ea typeface="+mn-ea"/>
                <a:cs typeface="+mn-cs"/>
              </a:defRPr>
            </a:lvl7pPr>
            <a:lvl8pPr marL="1928813" indent="-128588" algn="l" defTabSz="257175" rtl="0" eaLnBrk="1" latinLnBrk="0" hangingPunct="1">
              <a:spcBef>
                <a:spcPct val="20000"/>
              </a:spcBef>
              <a:buFont typeface="Arial"/>
              <a:buChar char="•"/>
              <a:defRPr sz="1125" kern="1200">
                <a:solidFill>
                  <a:schemeClr val="tx1"/>
                </a:solidFill>
                <a:latin typeface="+mn-lt"/>
                <a:ea typeface="+mn-ea"/>
                <a:cs typeface="+mn-cs"/>
              </a:defRPr>
            </a:lvl8pPr>
            <a:lvl9pPr marL="2185988" indent="-128588" algn="l" defTabSz="257175" rtl="0" eaLnBrk="1" latinLnBrk="0" hangingPunct="1">
              <a:spcBef>
                <a:spcPct val="20000"/>
              </a:spcBef>
              <a:buFont typeface="Arial"/>
              <a:buChar char="•"/>
              <a:defRPr sz="1125" kern="1200">
                <a:solidFill>
                  <a:schemeClr val="tx1"/>
                </a:solidFill>
                <a:latin typeface="+mn-lt"/>
                <a:ea typeface="+mn-ea"/>
                <a:cs typeface="+mn-cs"/>
              </a:defRPr>
            </a:lvl9pPr>
          </a:lstStyle>
          <a:p>
            <a:r>
              <a:rPr lang="en-US" b="0" dirty="0"/>
              <a:t>Does this research cycle match up to the Working Group’s thinking?</a:t>
            </a:r>
          </a:p>
          <a:p>
            <a:endParaRPr lang="en-US" b="0" dirty="0"/>
          </a:p>
          <a:p>
            <a:r>
              <a:rPr lang="en-US" b="0" dirty="0"/>
              <a:t>Is there anything about the research cycle (wording) you would change?</a:t>
            </a:r>
          </a:p>
          <a:p>
            <a:endParaRPr lang="en-US" b="0" dirty="0"/>
          </a:p>
          <a:p>
            <a:endParaRPr lang="en-US" b="0" dirty="0"/>
          </a:p>
          <a:p>
            <a:endParaRPr lang="en-US" b="0" dirty="0"/>
          </a:p>
          <a:p>
            <a:endParaRPr lang="en-US" b="0" dirty="0"/>
          </a:p>
          <a:p>
            <a:endParaRPr lang="en-US" b="0" dirty="0"/>
          </a:p>
          <a:p>
            <a:endParaRPr lang="en-US" b="0" dirty="0"/>
          </a:p>
        </p:txBody>
      </p:sp>
    </p:spTree>
    <p:extLst>
      <p:ext uri="{BB962C8B-B14F-4D97-AF65-F5344CB8AC3E}">
        <p14:creationId xmlns:p14="http://schemas.microsoft.com/office/powerpoint/2010/main" val="70647304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a:extLst>
              <a:ext uri="{FF2B5EF4-FFF2-40B4-BE49-F238E27FC236}">
                <a16:creationId xmlns:a16="http://schemas.microsoft.com/office/drawing/2014/main" id="{984D9918-6EAD-9542-8ED9-94B58ABB2D15}"/>
              </a:ext>
            </a:extLst>
          </p:cNvPr>
          <p:cNvGraphicFramePr/>
          <p:nvPr/>
        </p:nvGraphicFramePr>
        <p:xfrm>
          <a:off x="741556" y="653235"/>
          <a:ext cx="7660888" cy="5363738"/>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3" name="TextBox 2">
            <a:extLst>
              <a:ext uri="{FF2B5EF4-FFF2-40B4-BE49-F238E27FC236}">
                <a16:creationId xmlns:a16="http://schemas.microsoft.com/office/drawing/2014/main" id="{C10B68D8-BD11-0249-8EEB-172735B374A5}"/>
              </a:ext>
            </a:extLst>
          </p:cNvPr>
          <p:cNvSpPr txBox="1"/>
          <p:nvPr/>
        </p:nvSpPr>
        <p:spPr>
          <a:xfrm>
            <a:off x="7465742" y="2627218"/>
            <a:ext cx="1678258" cy="707886"/>
          </a:xfrm>
          <a:prstGeom prst="rect">
            <a:avLst/>
          </a:prstGeom>
          <a:noFill/>
        </p:spPr>
        <p:txBody>
          <a:bodyPr wrap="square" rtlCol="0">
            <a:spAutoFit/>
          </a:bodyPr>
          <a:lstStyle/>
          <a:p>
            <a:r>
              <a:rPr lang="en-US" sz="1000" b="1" dirty="0"/>
              <a:t>Ethics approval:</a:t>
            </a:r>
          </a:p>
          <a:p>
            <a:pPr marL="171450" indent="-171450">
              <a:buFont typeface="Arial" panose="020B0604020202020204" pitchFamily="34" charset="0"/>
              <a:buChar char="•"/>
            </a:pPr>
            <a:r>
              <a:rPr lang="en-US" sz="1000" i="1" dirty="0"/>
              <a:t>Writing: 2-3 months</a:t>
            </a:r>
          </a:p>
          <a:p>
            <a:pPr marL="171450" indent="-171450">
              <a:buFont typeface="Arial" panose="020B0604020202020204" pitchFamily="34" charset="0"/>
              <a:buChar char="•"/>
            </a:pPr>
            <a:r>
              <a:rPr lang="en-US" sz="1000" i="1" dirty="0"/>
              <a:t>Approval waiting: 1-2 months</a:t>
            </a:r>
          </a:p>
        </p:txBody>
      </p:sp>
      <p:sp>
        <p:nvSpPr>
          <p:cNvPr id="5" name="TextBox 4">
            <a:extLst>
              <a:ext uri="{FF2B5EF4-FFF2-40B4-BE49-F238E27FC236}">
                <a16:creationId xmlns:a16="http://schemas.microsoft.com/office/drawing/2014/main" id="{AFD3CF87-D796-7842-A2F5-3120E6F95A03}"/>
              </a:ext>
            </a:extLst>
          </p:cNvPr>
          <p:cNvSpPr txBox="1"/>
          <p:nvPr/>
        </p:nvSpPr>
        <p:spPr>
          <a:xfrm>
            <a:off x="6356196" y="5309087"/>
            <a:ext cx="2241394" cy="553998"/>
          </a:xfrm>
          <a:prstGeom prst="rect">
            <a:avLst/>
          </a:prstGeom>
          <a:noFill/>
        </p:spPr>
        <p:txBody>
          <a:bodyPr wrap="square" rtlCol="0">
            <a:spAutoFit/>
          </a:bodyPr>
          <a:lstStyle/>
          <a:p>
            <a:r>
              <a:rPr lang="en-US" sz="1000" b="1" dirty="0"/>
              <a:t>All research conduct and management must be aligned to the ethics approval.</a:t>
            </a:r>
          </a:p>
          <a:p>
            <a:r>
              <a:rPr lang="en-US" sz="1000" b="1" i="1" dirty="0"/>
              <a:t>Modifications to ethics project: </a:t>
            </a:r>
            <a:r>
              <a:rPr lang="en-US" sz="1000" i="1" dirty="0"/>
              <a:t>1-2 months</a:t>
            </a:r>
          </a:p>
        </p:txBody>
      </p:sp>
      <p:sp>
        <p:nvSpPr>
          <p:cNvPr id="6" name="TextBox 5">
            <a:extLst>
              <a:ext uri="{FF2B5EF4-FFF2-40B4-BE49-F238E27FC236}">
                <a16:creationId xmlns:a16="http://schemas.microsoft.com/office/drawing/2014/main" id="{A204035F-152F-E141-8C4C-630724564BEA}"/>
              </a:ext>
            </a:extLst>
          </p:cNvPr>
          <p:cNvSpPr txBox="1"/>
          <p:nvPr/>
        </p:nvSpPr>
        <p:spPr>
          <a:xfrm>
            <a:off x="6626613" y="1229598"/>
            <a:ext cx="1678258" cy="553998"/>
          </a:xfrm>
          <a:prstGeom prst="rect">
            <a:avLst/>
          </a:prstGeom>
          <a:noFill/>
        </p:spPr>
        <p:txBody>
          <a:bodyPr wrap="square" rtlCol="0">
            <a:spAutoFit/>
          </a:bodyPr>
          <a:lstStyle/>
          <a:p>
            <a:r>
              <a:rPr lang="en-US" sz="1000" b="1" dirty="0"/>
              <a:t>Depending on the type of funding, approval can take more than one year!</a:t>
            </a:r>
            <a:endParaRPr lang="en-US" sz="1000" b="1" i="1" dirty="0"/>
          </a:p>
        </p:txBody>
      </p:sp>
      <p:sp>
        <p:nvSpPr>
          <p:cNvPr id="7" name="TextBox 6">
            <a:extLst>
              <a:ext uri="{FF2B5EF4-FFF2-40B4-BE49-F238E27FC236}">
                <a16:creationId xmlns:a16="http://schemas.microsoft.com/office/drawing/2014/main" id="{4A37C264-5939-6F43-8714-0DA2245C186E}"/>
              </a:ext>
            </a:extLst>
          </p:cNvPr>
          <p:cNvSpPr txBox="1"/>
          <p:nvPr/>
        </p:nvSpPr>
        <p:spPr>
          <a:xfrm>
            <a:off x="453484" y="5227311"/>
            <a:ext cx="2241394" cy="707886"/>
          </a:xfrm>
          <a:prstGeom prst="rect">
            <a:avLst/>
          </a:prstGeom>
          <a:noFill/>
        </p:spPr>
        <p:txBody>
          <a:bodyPr wrap="square" rtlCol="0">
            <a:spAutoFit/>
          </a:bodyPr>
          <a:lstStyle/>
          <a:p>
            <a:r>
              <a:rPr lang="en-US" sz="1000" b="1" dirty="0"/>
              <a:t>Submitting an academic paper:</a:t>
            </a:r>
          </a:p>
          <a:p>
            <a:pPr marL="171450" indent="-171450">
              <a:buFont typeface="Arial" panose="020B0604020202020204" pitchFamily="34" charset="0"/>
              <a:buChar char="•"/>
            </a:pPr>
            <a:r>
              <a:rPr lang="en-US" sz="1000" i="1" dirty="0"/>
              <a:t>Writing and submitting: 2-3 months</a:t>
            </a:r>
          </a:p>
          <a:p>
            <a:pPr marL="171450" indent="-171450">
              <a:buFont typeface="Arial" panose="020B0604020202020204" pitchFamily="34" charset="0"/>
              <a:buChar char="•"/>
            </a:pPr>
            <a:r>
              <a:rPr lang="en-US" sz="1000" i="1" dirty="0"/>
              <a:t>Approval: 3-12 months</a:t>
            </a:r>
          </a:p>
          <a:p>
            <a:pPr marL="171450" indent="-171450">
              <a:buFont typeface="Arial" panose="020B0604020202020204" pitchFamily="34" charset="0"/>
              <a:buChar char="•"/>
            </a:pPr>
            <a:r>
              <a:rPr lang="en-US" sz="1000" i="1" dirty="0"/>
              <a:t>Publication review: 1-3 months</a:t>
            </a:r>
          </a:p>
        </p:txBody>
      </p:sp>
    </p:spTree>
    <p:extLst>
      <p:ext uri="{BB962C8B-B14F-4D97-AF65-F5344CB8AC3E}">
        <p14:creationId xmlns:p14="http://schemas.microsoft.com/office/powerpoint/2010/main" val="3276266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a:extLst>
              <a:ext uri="{FF2B5EF4-FFF2-40B4-BE49-F238E27FC236}">
                <a16:creationId xmlns:a16="http://schemas.microsoft.com/office/drawing/2014/main" id="{984D9918-6EAD-9542-8ED9-94B58ABB2D15}"/>
              </a:ext>
            </a:extLst>
          </p:cNvPr>
          <p:cNvGraphicFramePr/>
          <p:nvPr/>
        </p:nvGraphicFramePr>
        <p:xfrm>
          <a:off x="741556" y="653235"/>
          <a:ext cx="7660888" cy="5363738"/>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3" name="TextBox 2">
            <a:extLst>
              <a:ext uri="{FF2B5EF4-FFF2-40B4-BE49-F238E27FC236}">
                <a16:creationId xmlns:a16="http://schemas.microsoft.com/office/drawing/2014/main" id="{C10B68D8-BD11-0249-8EEB-172735B374A5}"/>
              </a:ext>
            </a:extLst>
          </p:cNvPr>
          <p:cNvSpPr txBox="1"/>
          <p:nvPr/>
        </p:nvSpPr>
        <p:spPr>
          <a:xfrm>
            <a:off x="7465742" y="2676510"/>
            <a:ext cx="1678258" cy="707886"/>
          </a:xfrm>
          <a:prstGeom prst="rect">
            <a:avLst/>
          </a:prstGeom>
          <a:noFill/>
        </p:spPr>
        <p:txBody>
          <a:bodyPr wrap="square" rtlCol="0">
            <a:spAutoFit/>
          </a:bodyPr>
          <a:lstStyle/>
          <a:p>
            <a:r>
              <a:rPr lang="en-US" sz="1000" b="1" dirty="0"/>
              <a:t>Grace’s survey review</a:t>
            </a:r>
          </a:p>
          <a:p>
            <a:endParaRPr lang="en-US" sz="1000" b="1" dirty="0"/>
          </a:p>
          <a:p>
            <a:r>
              <a:rPr lang="en-US" sz="1000" b="1" dirty="0"/>
              <a:t>Haley’s BMC Youth Model training study review</a:t>
            </a:r>
            <a:endParaRPr lang="en-US" sz="1000" dirty="0"/>
          </a:p>
        </p:txBody>
      </p:sp>
      <p:sp>
        <p:nvSpPr>
          <p:cNvPr id="5" name="TextBox 4">
            <a:extLst>
              <a:ext uri="{FF2B5EF4-FFF2-40B4-BE49-F238E27FC236}">
                <a16:creationId xmlns:a16="http://schemas.microsoft.com/office/drawing/2014/main" id="{AFD3CF87-D796-7842-A2F5-3120E6F95A03}"/>
              </a:ext>
            </a:extLst>
          </p:cNvPr>
          <p:cNvSpPr txBox="1"/>
          <p:nvPr/>
        </p:nvSpPr>
        <p:spPr>
          <a:xfrm>
            <a:off x="6356196" y="5309087"/>
            <a:ext cx="2241394" cy="246221"/>
          </a:xfrm>
          <a:prstGeom prst="rect">
            <a:avLst/>
          </a:prstGeom>
          <a:noFill/>
        </p:spPr>
        <p:txBody>
          <a:bodyPr wrap="square" rtlCol="0">
            <a:spAutoFit/>
          </a:bodyPr>
          <a:lstStyle/>
          <a:p>
            <a:r>
              <a:rPr lang="en-US" sz="1000" b="1" dirty="0"/>
              <a:t>Chloe’s psychoeducation study review </a:t>
            </a:r>
            <a:endParaRPr lang="en-US" sz="1000" i="1" dirty="0"/>
          </a:p>
        </p:txBody>
      </p:sp>
      <p:sp>
        <p:nvSpPr>
          <p:cNvPr id="8" name="TextBox 7">
            <a:extLst>
              <a:ext uri="{FF2B5EF4-FFF2-40B4-BE49-F238E27FC236}">
                <a16:creationId xmlns:a16="http://schemas.microsoft.com/office/drawing/2014/main" id="{4EA0BFD3-0C3E-C74D-93C9-06A319E1A376}"/>
              </a:ext>
            </a:extLst>
          </p:cNvPr>
          <p:cNvSpPr txBox="1"/>
          <p:nvPr/>
        </p:nvSpPr>
        <p:spPr>
          <a:xfrm>
            <a:off x="546410" y="4605075"/>
            <a:ext cx="1678258" cy="246221"/>
          </a:xfrm>
          <a:prstGeom prst="rect">
            <a:avLst/>
          </a:prstGeom>
          <a:noFill/>
        </p:spPr>
        <p:txBody>
          <a:bodyPr wrap="square" rtlCol="0">
            <a:spAutoFit/>
          </a:bodyPr>
          <a:lstStyle/>
          <a:p>
            <a:r>
              <a:rPr lang="en-US" sz="1000" b="1" dirty="0"/>
              <a:t>Grace’s academic paper</a:t>
            </a:r>
            <a:endParaRPr lang="en-US" sz="1000" i="1" dirty="0"/>
          </a:p>
        </p:txBody>
      </p:sp>
    </p:spTree>
    <p:extLst>
      <p:ext uri="{BB962C8B-B14F-4D97-AF65-F5344CB8AC3E}">
        <p14:creationId xmlns:p14="http://schemas.microsoft.com/office/powerpoint/2010/main" val="97103875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a:extLst>
              <a:ext uri="{FF2B5EF4-FFF2-40B4-BE49-F238E27FC236}">
                <a16:creationId xmlns:a16="http://schemas.microsoft.com/office/drawing/2014/main" id="{984D9918-6EAD-9542-8ED9-94B58ABB2D15}"/>
              </a:ext>
            </a:extLst>
          </p:cNvPr>
          <p:cNvGraphicFramePr/>
          <p:nvPr>
            <p:extLst>
              <p:ext uri="{D42A27DB-BD31-4B8C-83A1-F6EECF244321}">
                <p14:modId xmlns:p14="http://schemas.microsoft.com/office/powerpoint/2010/main" val="3954036026"/>
              </p:ext>
            </p:extLst>
          </p:nvPr>
        </p:nvGraphicFramePr>
        <p:xfrm>
          <a:off x="3002466" y="894557"/>
          <a:ext cx="6462132" cy="4766258"/>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6" name="Content Placeholder 1">
            <a:extLst>
              <a:ext uri="{FF2B5EF4-FFF2-40B4-BE49-F238E27FC236}">
                <a16:creationId xmlns:a16="http://schemas.microsoft.com/office/drawing/2014/main" id="{AA352C3B-02E8-9C4D-AE08-2F72617D4067}"/>
              </a:ext>
            </a:extLst>
          </p:cNvPr>
          <p:cNvSpPr txBox="1">
            <a:spLocks/>
          </p:cNvSpPr>
          <p:nvPr/>
        </p:nvSpPr>
        <p:spPr>
          <a:xfrm>
            <a:off x="226170" y="1031163"/>
            <a:ext cx="3399184" cy="3561799"/>
          </a:xfrm>
          <a:prstGeom prst="rect">
            <a:avLst/>
          </a:prstGeom>
        </p:spPr>
        <p:txBody>
          <a:bodyPr lIns="91440" tIns="45720" rIns="91440" bIns="45720" anchor="t"/>
          <a:lstStyle>
            <a:lvl1pPr marL="192881" indent="-192881" algn="l" defTabSz="257175" rtl="0" eaLnBrk="1" fontAlgn="base" hangingPunct="1">
              <a:spcBef>
                <a:spcPct val="20000"/>
              </a:spcBef>
              <a:spcAft>
                <a:spcPct val="0"/>
              </a:spcAft>
              <a:buFont typeface="Lucida Grande" charset="0"/>
              <a:buChar char="–"/>
              <a:defRPr sz="1800" b="1" kern="1200">
                <a:solidFill>
                  <a:schemeClr val="tx1"/>
                </a:solidFill>
                <a:latin typeface="Tw Cen MT"/>
                <a:ea typeface="ＭＳ Ｐゴシック" charset="0"/>
                <a:cs typeface="Tw Cen MT"/>
              </a:defRPr>
            </a:lvl1pPr>
            <a:lvl2pPr marL="417910" indent="-160735"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2pPr>
            <a:lvl3pPr marL="642938"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3pPr>
            <a:lvl4pPr marL="900113"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4pPr>
            <a:lvl5pPr marL="1157288" indent="-128588" algn="l" defTabSz="257175" rtl="0" eaLnBrk="1" fontAlgn="base" hangingPunct="1">
              <a:spcBef>
                <a:spcPct val="20000"/>
              </a:spcBef>
              <a:spcAft>
                <a:spcPct val="0"/>
              </a:spcAft>
              <a:buFont typeface="Arial" charset="0"/>
              <a:buChar char="»"/>
              <a:defRPr sz="1125" kern="1200">
                <a:solidFill>
                  <a:schemeClr val="tx1"/>
                </a:solidFill>
                <a:latin typeface="Tw Cen MT"/>
                <a:ea typeface="ＭＳ Ｐゴシック" charset="0"/>
                <a:cs typeface="Tw Cen MT"/>
              </a:defRPr>
            </a:lvl5pPr>
            <a:lvl6pPr marL="1414463" indent="-128588" algn="l" defTabSz="257175" rtl="0" eaLnBrk="1" latinLnBrk="0" hangingPunct="1">
              <a:spcBef>
                <a:spcPct val="20000"/>
              </a:spcBef>
              <a:buFont typeface="Arial"/>
              <a:buChar char="•"/>
              <a:defRPr sz="1125" kern="1200">
                <a:solidFill>
                  <a:schemeClr val="tx1"/>
                </a:solidFill>
                <a:latin typeface="+mn-lt"/>
                <a:ea typeface="+mn-ea"/>
                <a:cs typeface="+mn-cs"/>
              </a:defRPr>
            </a:lvl6pPr>
            <a:lvl7pPr marL="1671638" indent="-128588" algn="l" defTabSz="257175" rtl="0" eaLnBrk="1" latinLnBrk="0" hangingPunct="1">
              <a:spcBef>
                <a:spcPct val="20000"/>
              </a:spcBef>
              <a:buFont typeface="Arial"/>
              <a:buChar char="•"/>
              <a:defRPr sz="1125" kern="1200">
                <a:solidFill>
                  <a:schemeClr val="tx1"/>
                </a:solidFill>
                <a:latin typeface="+mn-lt"/>
                <a:ea typeface="+mn-ea"/>
                <a:cs typeface="+mn-cs"/>
              </a:defRPr>
            </a:lvl7pPr>
            <a:lvl8pPr marL="1928813" indent="-128588" algn="l" defTabSz="257175" rtl="0" eaLnBrk="1" latinLnBrk="0" hangingPunct="1">
              <a:spcBef>
                <a:spcPct val="20000"/>
              </a:spcBef>
              <a:buFont typeface="Arial"/>
              <a:buChar char="•"/>
              <a:defRPr sz="1125" kern="1200">
                <a:solidFill>
                  <a:schemeClr val="tx1"/>
                </a:solidFill>
                <a:latin typeface="+mn-lt"/>
                <a:ea typeface="+mn-ea"/>
                <a:cs typeface="+mn-cs"/>
              </a:defRPr>
            </a:lvl8pPr>
            <a:lvl9pPr marL="2185988" indent="-128588" algn="l" defTabSz="257175" rtl="0" eaLnBrk="1" latinLnBrk="0" hangingPunct="1">
              <a:spcBef>
                <a:spcPct val="20000"/>
              </a:spcBef>
              <a:buFont typeface="Arial"/>
              <a:buChar char="•"/>
              <a:defRPr sz="1125" kern="1200">
                <a:solidFill>
                  <a:schemeClr val="tx1"/>
                </a:solidFill>
                <a:latin typeface="+mn-lt"/>
                <a:ea typeface="+mn-ea"/>
                <a:cs typeface="+mn-cs"/>
              </a:defRPr>
            </a:lvl9pPr>
          </a:lstStyle>
          <a:p>
            <a:pPr marL="192405" indent="-192405"/>
            <a:r>
              <a:rPr lang="en-US" b="0" dirty="0">
                <a:ea typeface="ＭＳ Ｐゴシック"/>
              </a:rPr>
              <a:t>Are there any other questions/comments about the research cycle?</a:t>
            </a:r>
            <a:endParaRPr lang="en-US" dirty="0">
              <a:ea typeface="ＭＳ Ｐゴシック"/>
            </a:endParaRPr>
          </a:p>
          <a:p>
            <a:pPr marL="192405" indent="-192405"/>
            <a:r>
              <a:rPr lang="en-US" b="0" dirty="0"/>
              <a:t>Is there an area within the research cycle that the Group is most interested in?</a:t>
            </a:r>
          </a:p>
          <a:p>
            <a:pPr marL="417830" lvl="1" indent="-160655"/>
            <a:r>
              <a:rPr lang="en-US" sz="1100" dirty="0">
                <a:ea typeface="ＭＳ Ｐゴシック"/>
              </a:rPr>
              <a:t>Where does lived experience sit in the research cycle?</a:t>
            </a:r>
            <a:endParaRPr lang="en-US" sz="1100" b="0" dirty="0">
              <a:ea typeface="ＭＳ Ｐゴシック"/>
            </a:endParaRPr>
          </a:p>
          <a:p>
            <a:pPr marL="192405" indent="-192405"/>
            <a:r>
              <a:rPr lang="en-US" b="0" dirty="0"/>
              <a:t>Considering administrative barriers, how can lived experience meaningfully contribute to research?</a:t>
            </a:r>
          </a:p>
          <a:p>
            <a:pPr marL="417830" lvl="1" indent="-160655"/>
            <a:r>
              <a:rPr lang="en-US" dirty="0"/>
              <a:t>What is meaningful to lived experience researchers?</a:t>
            </a:r>
            <a:endParaRPr lang="en-US" b="0" dirty="0"/>
          </a:p>
          <a:p>
            <a:pPr marL="417830" lvl="1" indent="-160655"/>
            <a:r>
              <a:rPr lang="en-US" sz="1100" dirty="0">
                <a:ea typeface="ＭＳ Ｐゴシック"/>
              </a:rPr>
              <a:t>How do we do this practically? </a:t>
            </a:r>
          </a:p>
          <a:p>
            <a:pPr marL="192405" indent="-192405"/>
            <a:r>
              <a:rPr lang="en-US" b="0" dirty="0"/>
              <a:t>Do the research cycles align with lived experience priorities?</a:t>
            </a:r>
          </a:p>
          <a:p>
            <a:pPr marL="417830" lvl="1" indent="-160655"/>
            <a:r>
              <a:rPr lang="en-US" dirty="0"/>
              <a:t>What are lived experience priorities?</a:t>
            </a:r>
          </a:p>
          <a:p>
            <a:pPr marL="417830" lvl="1" indent="-160655"/>
            <a:endParaRPr lang="en-US" sz="1100" b="0" dirty="0"/>
          </a:p>
          <a:p>
            <a:pPr marL="417830" lvl="1" indent="-160655"/>
            <a:endParaRPr lang="en-US" dirty="0"/>
          </a:p>
        </p:txBody>
      </p:sp>
    </p:spTree>
    <p:extLst>
      <p:ext uri="{BB962C8B-B14F-4D97-AF65-F5344CB8AC3E}">
        <p14:creationId xmlns:p14="http://schemas.microsoft.com/office/powerpoint/2010/main" val="12159612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FF9D599C-071B-4D38-86D4-1AD92CEC473A}"/>
              </a:ext>
            </a:extLst>
          </p:cNvPr>
          <p:cNvSpPr/>
          <p:nvPr/>
        </p:nvSpPr>
        <p:spPr>
          <a:xfrm>
            <a:off x="2567031" y="5519956"/>
            <a:ext cx="4295163" cy="114090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AU"/>
          </a:p>
        </p:txBody>
      </p:sp>
      <p:pic>
        <p:nvPicPr>
          <p:cNvPr id="4" name="Picture 3">
            <a:extLst>
              <a:ext uri="{FF2B5EF4-FFF2-40B4-BE49-F238E27FC236}">
                <a16:creationId xmlns:a16="http://schemas.microsoft.com/office/drawing/2014/main" id="{C0914225-1143-4043-B2DC-C9FF4712DAB6}"/>
              </a:ext>
            </a:extLst>
          </p:cNvPr>
          <p:cNvPicPr>
            <a:picLocks noChangeAspect="1"/>
          </p:cNvPicPr>
          <p:nvPr/>
        </p:nvPicPr>
        <p:blipFill>
          <a:blip r:embed="rId2"/>
          <a:stretch>
            <a:fillRect/>
          </a:stretch>
        </p:blipFill>
        <p:spPr>
          <a:xfrm>
            <a:off x="3530367" y="5529711"/>
            <a:ext cx="2083266" cy="1131148"/>
          </a:xfrm>
          <a:prstGeom prst="rect">
            <a:avLst/>
          </a:prstGeom>
        </p:spPr>
      </p:pic>
    </p:spTree>
    <p:extLst>
      <p:ext uri="{BB962C8B-B14F-4D97-AF65-F5344CB8AC3E}">
        <p14:creationId xmlns:p14="http://schemas.microsoft.com/office/powerpoint/2010/main" val="416198574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10A8E28A-2C2E-8C46-A78B-F1DBFA006299}"/>
              </a:ext>
            </a:extLst>
          </p:cNvPr>
          <p:cNvSpPr>
            <a:spLocks noGrp="1"/>
          </p:cNvSpPr>
          <p:nvPr>
            <p:ph idx="1"/>
          </p:nvPr>
        </p:nvSpPr>
        <p:spPr>
          <a:xfrm>
            <a:off x="358777" y="1661532"/>
            <a:ext cx="8328025" cy="4464635"/>
          </a:xfrm>
        </p:spPr>
        <p:txBody>
          <a:bodyPr/>
          <a:lstStyle/>
          <a:p>
            <a:r>
              <a:rPr lang="en-US" b="0" dirty="0"/>
              <a:t>How did you find today’s session?</a:t>
            </a:r>
          </a:p>
          <a:p>
            <a:r>
              <a:rPr lang="en-US" b="0" dirty="0"/>
              <a:t>What are things that are different about today’s session that you liked?</a:t>
            </a:r>
          </a:p>
          <a:p>
            <a:r>
              <a:rPr lang="en-US" b="0" dirty="0"/>
              <a:t>What are things that you would like to see improve?</a:t>
            </a:r>
          </a:p>
          <a:p>
            <a:r>
              <a:rPr lang="en-US" b="0" dirty="0"/>
              <a:t>How can we improve?</a:t>
            </a:r>
          </a:p>
          <a:p>
            <a:r>
              <a:rPr lang="en-US" b="0" dirty="0"/>
              <a:t>Any other comments?</a:t>
            </a:r>
          </a:p>
        </p:txBody>
      </p:sp>
      <p:sp>
        <p:nvSpPr>
          <p:cNvPr id="3" name="Title 2">
            <a:extLst>
              <a:ext uri="{FF2B5EF4-FFF2-40B4-BE49-F238E27FC236}">
                <a16:creationId xmlns:a16="http://schemas.microsoft.com/office/drawing/2014/main" id="{16E5470B-D93B-2F40-82D9-834BC150C9F3}"/>
              </a:ext>
            </a:extLst>
          </p:cNvPr>
          <p:cNvSpPr>
            <a:spLocks noGrp="1"/>
          </p:cNvSpPr>
          <p:nvPr>
            <p:ph type="title"/>
          </p:nvPr>
        </p:nvSpPr>
        <p:spPr/>
        <p:txBody>
          <a:bodyPr/>
          <a:lstStyle/>
          <a:p>
            <a:r>
              <a:rPr lang="en-US" sz="3000" dirty="0"/>
              <a:t>DEBRIEF</a:t>
            </a:r>
          </a:p>
        </p:txBody>
      </p:sp>
    </p:spTree>
    <p:extLst>
      <p:ext uri="{BB962C8B-B14F-4D97-AF65-F5344CB8AC3E}">
        <p14:creationId xmlns:p14="http://schemas.microsoft.com/office/powerpoint/2010/main" val="324574709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C207EF0-D5F8-4C7D-9363-8246CDD5503A}"/>
              </a:ext>
            </a:extLst>
          </p:cNvPr>
          <p:cNvSpPr>
            <a:spLocks noGrp="1"/>
          </p:cNvSpPr>
          <p:nvPr>
            <p:ph type="title"/>
          </p:nvPr>
        </p:nvSpPr>
        <p:spPr>
          <a:xfrm>
            <a:off x="358775" y="2419229"/>
            <a:ext cx="8426450" cy="647183"/>
          </a:xfrm>
        </p:spPr>
        <p:txBody>
          <a:bodyPr/>
          <a:lstStyle/>
          <a:p>
            <a:pPr algn="ctr"/>
            <a:r>
              <a:rPr lang="en-US" sz="3000" dirty="0"/>
              <a:t>QUESTIONS AND/OR FEEDBACK? </a:t>
            </a:r>
            <a:r>
              <a:rPr lang="en-US" sz="3000" dirty="0">
                <a:sym typeface="Wingdings" pitchFamily="2" charset="2"/>
              </a:rPr>
              <a:t></a:t>
            </a:r>
            <a:endParaRPr lang="en-AU" sz="3000" dirty="0"/>
          </a:p>
        </p:txBody>
      </p:sp>
    </p:spTree>
    <p:extLst>
      <p:ext uri="{BB962C8B-B14F-4D97-AF65-F5344CB8AC3E}">
        <p14:creationId xmlns:p14="http://schemas.microsoft.com/office/powerpoint/2010/main" val="221099199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FF839D94-B54A-422C-B108-8A4A6128B28C}"/>
              </a:ext>
            </a:extLst>
          </p:cNvPr>
          <p:cNvSpPr/>
          <p:nvPr/>
        </p:nvSpPr>
        <p:spPr>
          <a:xfrm>
            <a:off x="2567031" y="5519956"/>
            <a:ext cx="4295163" cy="114090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AU"/>
          </a:p>
        </p:txBody>
      </p:sp>
      <p:pic>
        <p:nvPicPr>
          <p:cNvPr id="3" name="Picture 2">
            <a:extLst>
              <a:ext uri="{FF2B5EF4-FFF2-40B4-BE49-F238E27FC236}">
                <a16:creationId xmlns:a16="http://schemas.microsoft.com/office/drawing/2014/main" id="{3C80669F-824D-4FF0-A351-0F0479B6D884}"/>
              </a:ext>
            </a:extLst>
          </p:cNvPr>
          <p:cNvPicPr>
            <a:picLocks noChangeAspect="1"/>
          </p:cNvPicPr>
          <p:nvPr/>
        </p:nvPicPr>
        <p:blipFill>
          <a:blip r:embed="rId2"/>
          <a:stretch>
            <a:fillRect/>
          </a:stretch>
        </p:blipFill>
        <p:spPr>
          <a:xfrm>
            <a:off x="3530367" y="5529711"/>
            <a:ext cx="2083266" cy="1131148"/>
          </a:xfrm>
          <a:prstGeom prst="rect">
            <a:avLst/>
          </a:prstGeom>
        </p:spPr>
      </p:pic>
    </p:spTree>
    <p:extLst>
      <p:ext uri="{BB962C8B-B14F-4D97-AF65-F5344CB8AC3E}">
        <p14:creationId xmlns:p14="http://schemas.microsoft.com/office/powerpoint/2010/main" val="11888469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C207EF0-D5F8-4C7D-9363-8246CDD5503A}"/>
              </a:ext>
            </a:extLst>
          </p:cNvPr>
          <p:cNvSpPr>
            <a:spLocks noGrp="1"/>
          </p:cNvSpPr>
          <p:nvPr>
            <p:ph type="title"/>
          </p:nvPr>
        </p:nvSpPr>
        <p:spPr/>
        <p:txBody>
          <a:bodyPr/>
          <a:lstStyle/>
          <a:p>
            <a:r>
              <a:rPr lang="en-US" sz="3000"/>
              <a:t>AGENDA</a:t>
            </a:r>
            <a:endParaRPr lang="en-AU" sz="3000"/>
          </a:p>
        </p:txBody>
      </p:sp>
      <p:graphicFrame>
        <p:nvGraphicFramePr>
          <p:cNvPr id="5" name="Table 5">
            <a:extLst>
              <a:ext uri="{FF2B5EF4-FFF2-40B4-BE49-F238E27FC236}">
                <a16:creationId xmlns:a16="http://schemas.microsoft.com/office/drawing/2014/main" id="{1F6D69E8-098B-4675-AAE5-73A7D0391966}"/>
              </a:ext>
            </a:extLst>
          </p:cNvPr>
          <p:cNvGraphicFramePr>
            <a:graphicFrameLocks noGrp="1"/>
          </p:cNvGraphicFramePr>
          <p:nvPr>
            <p:extLst>
              <p:ext uri="{D42A27DB-BD31-4B8C-83A1-F6EECF244321}">
                <p14:modId xmlns:p14="http://schemas.microsoft.com/office/powerpoint/2010/main" val="2945247476"/>
              </p:ext>
            </p:extLst>
          </p:nvPr>
        </p:nvGraphicFramePr>
        <p:xfrm>
          <a:off x="931177" y="1279555"/>
          <a:ext cx="7281644" cy="3662680"/>
        </p:xfrm>
        <a:graphic>
          <a:graphicData uri="http://schemas.openxmlformats.org/drawingml/2006/table">
            <a:tbl>
              <a:tblPr firstRow="1" bandRow="1">
                <a:tableStyleId>{5C22544A-7EE6-4342-B048-85BDC9FD1C3A}</a:tableStyleId>
              </a:tblPr>
              <a:tblGrid>
                <a:gridCol w="4597168">
                  <a:extLst>
                    <a:ext uri="{9D8B030D-6E8A-4147-A177-3AD203B41FA5}">
                      <a16:colId xmlns:a16="http://schemas.microsoft.com/office/drawing/2014/main" val="1063796124"/>
                    </a:ext>
                  </a:extLst>
                </a:gridCol>
                <a:gridCol w="1426127">
                  <a:extLst>
                    <a:ext uri="{9D8B030D-6E8A-4147-A177-3AD203B41FA5}">
                      <a16:colId xmlns:a16="http://schemas.microsoft.com/office/drawing/2014/main" val="2208106103"/>
                    </a:ext>
                  </a:extLst>
                </a:gridCol>
                <a:gridCol w="1258349">
                  <a:extLst>
                    <a:ext uri="{9D8B030D-6E8A-4147-A177-3AD203B41FA5}">
                      <a16:colId xmlns:a16="http://schemas.microsoft.com/office/drawing/2014/main" val="871386756"/>
                    </a:ext>
                  </a:extLst>
                </a:gridCol>
              </a:tblGrid>
              <a:tr h="370840">
                <a:tc>
                  <a:txBody>
                    <a:bodyPr/>
                    <a:lstStyle/>
                    <a:p>
                      <a:r>
                        <a:rPr lang="en-US" sz="2000" dirty="0"/>
                        <a:t>ITEM</a:t>
                      </a:r>
                      <a:endParaRPr lang="en-AU" sz="2000" dirty="0"/>
                    </a:p>
                  </a:txBody>
                  <a:tcPr/>
                </a:tc>
                <a:tc>
                  <a:txBody>
                    <a:bodyPr/>
                    <a:lstStyle/>
                    <a:p>
                      <a:r>
                        <a:rPr lang="en-US" sz="2000"/>
                        <a:t>LEAD</a:t>
                      </a:r>
                      <a:endParaRPr lang="en-AU" sz="2000"/>
                    </a:p>
                  </a:txBody>
                  <a:tcPr/>
                </a:tc>
                <a:tc>
                  <a:txBody>
                    <a:bodyPr/>
                    <a:lstStyle/>
                    <a:p>
                      <a:r>
                        <a:rPr lang="en-US" sz="2000"/>
                        <a:t>FINISH BY</a:t>
                      </a:r>
                      <a:endParaRPr lang="en-AU" sz="2000"/>
                    </a:p>
                  </a:txBody>
                  <a:tcPr/>
                </a:tc>
                <a:extLst>
                  <a:ext uri="{0D108BD9-81ED-4DB2-BD59-A6C34878D82A}">
                    <a16:rowId xmlns:a16="http://schemas.microsoft.com/office/drawing/2014/main" val="3114398745"/>
                  </a:ext>
                </a:extLst>
              </a:tr>
              <a:tr h="370840">
                <a:tc>
                  <a:txBody>
                    <a:bodyPr/>
                    <a:lstStyle/>
                    <a:p>
                      <a:r>
                        <a:rPr lang="en-US" sz="1600" b="1" dirty="0"/>
                        <a:t>PRE-BRIEF</a:t>
                      </a:r>
                    </a:p>
                    <a:p>
                      <a:r>
                        <a:rPr lang="en-US" sz="1600" b="0" dirty="0"/>
                        <a:t>-Introducing today’s session</a:t>
                      </a:r>
                      <a:endParaRPr lang="en-AU" sz="1600" b="0" dirty="0"/>
                    </a:p>
                  </a:txBody>
                  <a:tcPr/>
                </a:tc>
                <a:tc>
                  <a:txBody>
                    <a:bodyPr/>
                    <a:lstStyle/>
                    <a:p>
                      <a:r>
                        <a:rPr lang="en-AU" sz="1600" dirty="0"/>
                        <a:t>SJH</a:t>
                      </a:r>
                    </a:p>
                  </a:txBody>
                  <a:tcPr/>
                </a:tc>
                <a:tc>
                  <a:txBody>
                    <a:bodyPr/>
                    <a:lstStyle/>
                    <a:p>
                      <a:r>
                        <a:rPr lang="en-AU" sz="1600" dirty="0"/>
                        <a:t>4:45</a:t>
                      </a:r>
                    </a:p>
                  </a:txBody>
                  <a:tcPr/>
                </a:tc>
                <a:extLst>
                  <a:ext uri="{0D108BD9-81ED-4DB2-BD59-A6C34878D82A}">
                    <a16:rowId xmlns:a16="http://schemas.microsoft.com/office/drawing/2014/main" val="1469886913"/>
                  </a:ext>
                </a:extLst>
              </a:tr>
              <a:tr h="370840">
                <a:tc>
                  <a:txBody>
                    <a:bodyPr/>
                    <a:lstStyle/>
                    <a:p>
                      <a:r>
                        <a:rPr lang="en-US" sz="1600" b="1" dirty="0"/>
                        <a:t>UPDATE</a:t>
                      </a:r>
                    </a:p>
                    <a:p>
                      <a:r>
                        <a:rPr lang="en-US" sz="1600" b="0" dirty="0"/>
                        <a:t>-How we will incorporate feedback to improve </a:t>
                      </a:r>
                      <a:endParaRPr lang="en-AU" sz="1600" b="0" dirty="0"/>
                    </a:p>
                  </a:txBody>
                  <a:tcPr/>
                </a:tc>
                <a:tc>
                  <a:txBody>
                    <a:bodyPr/>
                    <a:lstStyle/>
                    <a:p>
                      <a:r>
                        <a:rPr lang="en-US" sz="1600" dirty="0"/>
                        <a:t>CYJS</a:t>
                      </a:r>
                      <a:endParaRPr lang="en-AU" sz="1600" dirty="0"/>
                    </a:p>
                  </a:txBody>
                  <a:tcPr/>
                </a:tc>
                <a:tc>
                  <a:txBody>
                    <a:bodyPr/>
                    <a:lstStyle/>
                    <a:p>
                      <a:r>
                        <a:rPr lang="en-US" sz="1600" dirty="0"/>
                        <a:t>05:15</a:t>
                      </a:r>
                      <a:endParaRPr lang="en-AU" sz="1600" dirty="0"/>
                    </a:p>
                  </a:txBody>
                  <a:tcPr/>
                </a:tc>
                <a:extLst>
                  <a:ext uri="{0D108BD9-81ED-4DB2-BD59-A6C34878D82A}">
                    <a16:rowId xmlns:a16="http://schemas.microsoft.com/office/drawing/2014/main" val="1069944501"/>
                  </a:ext>
                </a:extLst>
              </a:tr>
              <a:tr h="370840">
                <a:tc>
                  <a:txBody>
                    <a:bodyPr/>
                    <a:lstStyle/>
                    <a:p>
                      <a:r>
                        <a:rPr lang="en-US" sz="1600" b="1" dirty="0"/>
                        <a:t>REVIEW</a:t>
                      </a:r>
                    </a:p>
                    <a:p>
                      <a:r>
                        <a:rPr lang="en-US" sz="1600" b="0" dirty="0"/>
                        <a:t>-Terms of Reference </a:t>
                      </a:r>
                      <a:endParaRPr lang="en-AU" sz="1600" b="0" dirty="0"/>
                    </a:p>
                  </a:txBody>
                  <a:tcPr/>
                </a:tc>
                <a:tc>
                  <a:txBody>
                    <a:bodyPr/>
                    <a:lstStyle/>
                    <a:p>
                      <a:r>
                        <a:rPr lang="en-US" sz="1600" dirty="0"/>
                        <a:t>AH</a:t>
                      </a:r>
                      <a:endParaRPr lang="en-AU" sz="1600" dirty="0"/>
                    </a:p>
                  </a:txBody>
                  <a:tcPr/>
                </a:tc>
                <a:tc>
                  <a:txBody>
                    <a:bodyPr/>
                    <a:lstStyle/>
                    <a:p>
                      <a:r>
                        <a:rPr lang="en-US" sz="1600" dirty="0"/>
                        <a:t>06:00</a:t>
                      </a:r>
                      <a:endParaRPr lang="en-AU" sz="1600" dirty="0"/>
                    </a:p>
                  </a:txBody>
                  <a:tcPr/>
                </a:tc>
                <a:extLst>
                  <a:ext uri="{0D108BD9-81ED-4DB2-BD59-A6C34878D82A}">
                    <a16:rowId xmlns:a16="http://schemas.microsoft.com/office/drawing/2014/main" val="3804914577"/>
                  </a:ext>
                </a:extLst>
              </a:tr>
              <a:tr h="370840">
                <a:tc gridSpan="2">
                  <a:txBody>
                    <a:bodyPr/>
                    <a:lstStyle/>
                    <a:p>
                      <a:pPr algn="ctr"/>
                      <a:r>
                        <a:rPr lang="en-US" sz="1600" b="1" dirty="0">
                          <a:solidFill>
                            <a:schemeClr val="bg1"/>
                          </a:solidFill>
                        </a:rPr>
                        <a:t>SHORT BREAK</a:t>
                      </a:r>
                      <a:endParaRPr lang="en-AU" sz="1600" b="1" dirty="0">
                        <a:solidFill>
                          <a:schemeClr val="bg1"/>
                        </a:solidFill>
                      </a:endParaRPr>
                    </a:p>
                  </a:txBody>
                  <a:tcPr>
                    <a:solidFill>
                      <a:schemeClr val="accent1"/>
                    </a:solidFill>
                  </a:tcPr>
                </a:tc>
                <a:tc hMerge="1">
                  <a:txBody>
                    <a:bodyPr/>
                    <a:lstStyle/>
                    <a:p>
                      <a:pPr algn="ctr"/>
                      <a:endParaRPr lang="en-AU" sz="1600" b="1">
                        <a:solidFill>
                          <a:schemeClr val="bg1"/>
                        </a:solidFill>
                      </a:endParaRPr>
                    </a:p>
                  </a:txBody>
                  <a:tcPr>
                    <a:solidFill>
                      <a:schemeClr val="accent1"/>
                    </a:solidFill>
                  </a:tcPr>
                </a:tc>
                <a:tc>
                  <a:txBody>
                    <a:bodyPr/>
                    <a:lstStyle/>
                    <a:p>
                      <a:r>
                        <a:rPr lang="en-US" sz="1600" dirty="0">
                          <a:solidFill>
                            <a:schemeClr val="bg1"/>
                          </a:solidFill>
                        </a:rPr>
                        <a:t>6:05</a:t>
                      </a:r>
                      <a:endParaRPr lang="en-AU" sz="1600" dirty="0">
                        <a:solidFill>
                          <a:schemeClr val="bg1"/>
                        </a:solidFill>
                      </a:endParaRPr>
                    </a:p>
                  </a:txBody>
                  <a:tcPr>
                    <a:solidFill>
                      <a:schemeClr val="accent1"/>
                    </a:solidFill>
                  </a:tcPr>
                </a:tc>
                <a:extLst>
                  <a:ext uri="{0D108BD9-81ED-4DB2-BD59-A6C34878D82A}">
                    <a16:rowId xmlns:a16="http://schemas.microsoft.com/office/drawing/2014/main" val="4230905109"/>
                  </a:ext>
                </a:extLst>
              </a:tr>
              <a:tr h="370840">
                <a:tc>
                  <a:txBody>
                    <a:bodyPr/>
                    <a:lstStyle/>
                    <a:p>
                      <a:r>
                        <a:rPr lang="en-US" sz="1600" b="1" dirty="0"/>
                        <a:t>LEARN</a:t>
                      </a:r>
                    </a:p>
                    <a:p>
                      <a:r>
                        <a:rPr lang="en-US" sz="1600" b="0" dirty="0"/>
                        <a:t>-Research cycle ‘crash course’</a:t>
                      </a:r>
                    </a:p>
                  </a:txBody>
                  <a:tcPr/>
                </a:tc>
                <a:tc>
                  <a:txBody>
                    <a:bodyPr/>
                    <a:lstStyle/>
                    <a:p>
                      <a:r>
                        <a:rPr lang="en-US" sz="1600" dirty="0"/>
                        <a:t>GYL</a:t>
                      </a:r>
                      <a:endParaRPr lang="en-AU" sz="1600" dirty="0"/>
                    </a:p>
                  </a:txBody>
                  <a:tcPr/>
                </a:tc>
                <a:tc>
                  <a:txBody>
                    <a:bodyPr/>
                    <a:lstStyle/>
                    <a:p>
                      <a:r>
                        <a:rPr lang="en-US" sz="1600" dirty="0"/>
                        <a:t>07:00</a:t>
                      </a:r>
                      <a:endParaRPr lang="en-AU" sz="1600" dirty="0"/>
                    </a:p>
                  </a:txBody>
                  <a:tcPr/>
                </a:tc>
                <a:extLst>
                  <a:ext uri="{0D108BD9-81ED-4DB2-BD59-A6C34878D82A}">
                    <a16:rowId xmlns:a16="http://schemas.microsoft.com/office/drawing/2014/main" val="685965204"/>
                  </a:ext>
                </a:extLst>
              </a:tr>
              <a:tr h="370840">
                <a:tc>
                  <a:txBody>
                    <a:bodyPr/>
                    <a:lstStyle/>
                    <a:p>
                      <a:r>
                        <a:rPr lang="en-US" sz="1600" b="1" dirty="0"/>
                        <a:t>DE-BRIEF &amp; DINNER</a:t>
                      </a:r>
                    </a:p>
                    <a:p>
                      <a:r>
                        <a:rPr lang="en-US" sz="1600" b="0" dirty="0"/>
                        <a:t>-How did the group find today’s session?</a:t>
                      </a:r>
                    </a:p>
                  </a:txBody>
                  <a:tcPr/>
                </a:tc>
                <a:tc>
                  <a:txBody>
                    <a:bodyPr/>
                    <a:lstStyle/>
                    <a:p>
                      <a:r>
                        <a:rPr lang="en-AU" sz="1600" dirty="0"/>
                        <a:t>SH</a:t>
                      </a:r>
                    </a:p>
                  </a:txBody>
                  <a:tcPr/>
                </a:tc>
                <a:tc>
                  <a:txBody>
                    <a:bodyPr/>
                    <a:lstStyle/>
                    <a:p>
                      <a:r>
                        <a:rPr lang="en-AU" sz="1600" dirty="0"/>
                        <a:t>7:30</a:t>
                      </a:r>
                    </a:p>
                  </a:txBody>
                  <a:tcPr/>
                </a:tc>
                <a:extLst>
                  <a:ext uri="{0D108BD9-81ED-4DB2-BD59-A6C34878D82A}">
                    <a16:rowId xmlns:a16="http://schemas.microsoft.com/office/drawing/2014/main" val="3169887069"/>
                  </a:ext>
                </a:extLst>
              </a:tr>
            </a:tbl>
          </a:graphicData>
        </a:graphic>
      </p:graphicFrame>
    </p:spTree>
    <p:extLst>
      <p:ext uri="{BB962C8B-B14F-4D97-AF65-F5344CB8AC3E}">
        <p14:creationId xmlns:p14="http://schemas.microsoft.com/office/powerpoint/2010/main" val="13303551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B354936E-C463-4D90-963C-698FEFB13AEA}"/>
              </a:ext>
            </a:extLst>
          </p:cNvPr>
          <p:cNvSpPr>
            <a:spLocks noGrp="1"/>
          </p:cNvSpPr>
          <p:nvPr>
            <p:ph type="title"/>
          </p:nvPr>
        </p:nvSpPr>
        <p:spPr/>
        <p:txBody>
          <a:bodyPr/>
          <a:lstStyle/>
          <a:p>
            <a:r>
              <a:rPr lang="en-US" sz="3000" dirty="0"/>
              <a:t>UPDATE – WHAT ARE OUR GOALS?</a:t>
            </a:r>
            <a:endParaRPr lang="en-AU" sz="3000" dirty="0"/>
          </a:p>
        </p:txBody>
      </p:sp>
      <p:grpSp>
        <p:nvGrpSpPr>
          <p:cNvPr id="52" name="Group 51">
            <a:extLst>
              <a:ext uri="{FF2B5EF4-FFF2-40B4-BE49-F238E27FC236}">
                <a16:creationId xmlns:a16="http://schemas.microsoft.com/office/drawing/2014/main" id="{AF4181E4-0FD4-684C-9095-D24E8ACF3CA9}"/>
              </a:ext>
            </a:extLst>
          </p:cNvPr>
          <p:cNvGrpSpPr/>
          <p:nvPr/>
        </p:nvGrpSpPr>
        <p:grpSpPr>
          <a:xfrm>
            <a:off x="3075651" y="1758031"/>
            <a:ext cx="2166681" cy="3374456"/>
            <a:chOff x="8600713" y="2551178"/>
            <a:chExt cx="5776310" cy="8996207"/>
          </a:xfrm>
        </p:grpSpPr>
        <p:sp>
          <p:nvSpPr>
            <p:cNvPr id="53" name="Freeform 52">
              <a:extLst>
                <a:ext uri="{FF2B5EF4-FFF2-40B4-BE49-F238E27FC236}">
                  <a16:creationId xmlns:a16="http://schemas.microsoft.com/office/drawing/2014/main" id="{10F7C89A-6778-BD46-A6F1-89039C10E5FE}"/>
                </a:ext>
              </a:extLst>
            </p:cNvPr>
            <p:cNvSpPr/>
            <p:nvPr/>
          </p:nvSpPr>
          <p:spPr>
            <a:xfrm>
              <a:off x="8600713" y="2551178"/>
              <a:ext cx="5167940" cy="3196181"/>
            </a:xfrm>
            <a:custGeom>
              <a:avLst/>
              <a:gdLst>
                <a:gd name="connsiteX0" fmla="*/ 4498643 w 5167941"/>
                <a:gd name="connsiteY0" fmla="*/ 0 h 3196182"/>
                <a:gd name="connsiteX1" fmla="*/ 5167941 w 5167941"/>
                <a:gd name="connsiteY1" fmla="*/ 2045974 h 3196182"/>
                <a:gd name="connsiteX2" fmla="*/ 433798 w 5167941"/>
                <a:gd name="connsiteY2" fmla="*/ 3196182 h 3196182"/>
                <a:gd name="connsiteX3" fmla="*/ 0 w 5167941"/>
                <a:gd name="connsiteY3" fmla="*/ 1870104 h 3196182"/>
              </a:gdLst>
              <a:ahLst/>
              <a:cxnLst>
                <a:cxn ang="0">
                  <a:pos x="connsiteX0" y="connsiteY0"/>
                </a:cxn>
                <a:cxn ang="0">
                  <a:pos x="connsiteX1" y="connsiteY1"/>
                </a:cxn>
                <a:cxn ang="0">
                  <a:pos x="connsiteX2" y="connsiteY2"/>
                </a:cxn>
                <a:cxn ang="0">
                  <a:pos x="connsiteX3" y="connsiteY3"/>
                </a:cxn>
              </a:cxnLst>
              <a:rect l="l" t="t" r="r" b="b"/>
              <a:pathLst>
                <a:path w="5167941" h="3196182">
                  <a:moveTo>
                    <a:pt x="4498643" y="0"/>
                  </a:moveTo>
                  <a:lnTo>
                    <a:pt x="5167941" y="2045974"/>
                  </a:lnTo>
                  <a:lnTo>
                    <a:pt x="433798" y="3196182"/>
                  </a:lnTo>
                  <a:lnTo>
                    <a:pt x="0" y="1870104"/>
                  </a:lnTo>
                  <a:close/>
                </a:path>
              </a:pathLst>
            </a:custGeom>
            <a:solidFill>
              <a:schemeClr val="accent3"/>
            </a:solidFill>
            <a:ln w="12700" cap="flat" cmpd="sng" algn="ctr">
              <a:noFill/>
              <a:prstDash val="solid"/>
              <a:miter lim="800000"/>
            </a:ln>
            <a:effectLst/>
          </p:spPr>
          <p:txBody>
            <a:bodyPr wrap="square" rtlCol="0" anchor="ctr">
              <a:noAutofit/>
            </a:bodyPr>
            <a:lstStyle/>
            <a:p>
              <a:pPr marL="0" marR="0" lvl="0" indent="0" algn="ctr"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FFFFFF"/>
                </a:solidFill>
                <a:effectLst/>
                <a:uLnTx/>
                <a:uFillTx/>
                <a:latin typeface="Tw Cen MT" panose="020B0602020104020603" pitchFamily="34" charset="77"/>
              </a:endParaRPr>
            </a:p>
          </p:txBody>
        </p:sp>
        <p:sp>
          <p:nvSpPr>
            <p:cNvPr id="54" name="Freeform 53">
              <a:extLst>
                <a:ext uri="{FF2B5EF4-FFF2-40B4-BE49-F238E27FC236}">
                  <a16:creationId xmlns:a16="http://schemas.microsoft.com/office/drawing/2014/main" id="{A03734DB-8179-A84C-8891-079083BEFFE9}"/>
                </a:ext>
              </a:extLst>
            </p:cNvPr>
            <p:cNvSpPr/>
            <p:nvPr/>
          </p:nvSpPr>
          <p:spPr>
            <a:xfrm>
              <a:off x="9407951" y="5827485"/>
              <a:ext cx="4953477" cy="2148902"/>
            </a:xfrm>
            <a:custGeom>
              <a:avLst/>
              <a:gdLst>
                <a:gd name="connsiteX0" fmla="*/ 4826251 w 4953476"/>
                <a:gd name="connsiteY0" fmla="*/ 0 h 2148902"/>
                <a:gd name="connsiteX1" fmla="*/ 4953476 w 4953476"/>
                <a:gd name="connsiteY1" fmla="*/ 2148902 h 2148902"/>
                <a:gd name="connsiteX2" fmla="*/ 82459 w 4953476"/>
                <a:gd name="connsiteY2" fmla="*/ 2057906 h 2148902"/>
                <a:gd name="connsiteX3" fmla="*/ 0 w 4953476"/>
                <a:gd name="connsiteY3" fmla="*/ 665116 h 2148902"/>
              </a:gdLst>
              <a:ahLst/>
              <a:cxnLst>
                <a:cxn ang="0">
                  <a:pos x="connsiteX0" y="connsiteY0"/>
                </a:cxn>
                <a:cxn ang="0">
                  <a:pos x="connsiteX1" y="connsiteY1"/>
                </a:cxn>
                <a:cxn ang="0">
                  <a:pos x="connsiteX2" y="connsiteY2"/>
                </a:cxn>
                <a:cxn ang="0">
                  <a:pos x="connsiteX3" y="connsiteY3"/>
                </a:cxn>
              </a:cxnLst>
              <a:rect l="l" t="t" r="r" b="b"/>
              <a:pathLst>
                <a:path w="4953476" h="2148902">
                  <a:moveTo>
                    <a:pt x="4826251" y="0"/>
                  </a:moveTo>
                  <a:lnTo>
                    <a:pt x="4953476" y="2148902"/>
                  </a:lnTo>
                  <a:lnTo>
                    <a:pt x="82459" y="2057906"/>
                  </a:lnTo>
                  <a:lnTo>
                    <a:pt x="0" y="665116"/>
                  </a:lnTo>
                  <a:close/>
                </a:path>
              </a:pathLst>
            </a:custGeom>
            <a:solidFill>
              <a:srgbClr val="009F94"/>
            </a:solidFill>
            <a:ln w="12700" cap="flat" cmpd="sng" algn="ctr">
              <a:noFill/>
              <a:prstDash val="solid"/>
              <a:miter lim="800000"/>
            </a:ln>
            <a:effectLst/>
          </p:spPr>
          <p:txBody>
            <a:bodyPr wrap="square" rtlCol="0" anchor="ctr">
              <a:noAutofit/>
            </a:bodyPr>
            <a:lstStyle/>
            <a:p>
              <a:pPr marL="0" marR="0" lvl="0" indent="0" algn="ctr"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FFFFFF"/>
                </a:solidFill>
                <a:effectLst/>
                <a:uLnTx/>
                <a:uFillTx/>
                <a:latin typeface="Tw Cen MT" panose="020B0602020104020603" pitchFamily="34" charset="77"/>
              </a:endParaRPr>
            </a:p>
          </p:txBody>
        </p:sp>
        <p:sp>
          <p:nvSpPr>
            <p:cNvPr id="55" name="Freeform 54">
              <a:extLst>
                <a:ext uri="{FF2B5EF4-FFF2-40B4-BE49-F238E27FC236}">
                  <a16:creationId xmlns:a16="http://schemas.microsoft.com/office/drawing/2014/main" id="{792A54F5-D676-7B44-8129-7C3AFA8CFD55}"/>
                </a:ext>
              </a:extLst>
            </p:cNvPr>
            <p:cNvSpPr/>
            <p:nvPr/>
          </p:nvSpPr>
          <p:spPr>
            <a:xfrm>
              <a:off x="9313165" y="9084248"/>
              <a:ext cx="5063858" cy="2463137"/>
            </a:xfrm>
            <a:custGeom>
              <a:avLst/>
              <a:gdLst>
                <a:gd name="connsiteX0" fmla="*/ 203418 w 5063858"/>
                <a:gd name="connsiteY0" fmla="*/ 0 h 2463137"/>
                <a:gd name="connsiteX1" fmla="*/ 5063858 w 5063858"/>
                <a:gd name="connsiteY1" fmla="*/ 333474 h 2463137"/>
                <a:gd name="connsiteX2" fmla="*/ 4750010 w 5063858"/>
                <a:gd name="connsiteY2" fmla="*/ 2463137 h 2463137"/>
                <a:gd name="connsiteX3" fmla="*/ 0 w 5063858"/>
                <a:gd name="connsiteY3" fmla="*/ 1380321 h 2463137"/>
              </a:gdLst>
              <a:ahLst/>
              <a:cxnLst>
                <a:cxn ang="0">
                  <a:pos x="connsiteX0" y="connsiteY0"/>
                </a:cxn>
                <a:cxn ang="0">
                  <a:pos x="connsiteX1" y="connsiteY1"/>
                </a:cxn>
                <a:cxn ang="0">
                  <a:pos x="connsiteX2" y="connsiteY2"/>
                </a:cxn>
                <a:cxn ang="0">
                  <a:pos x="connsiteX3" y="connsiteY3"/>
                </a:cxn>
              </a:cxnLst>
              <a:rect l="l" t="t" r="r" b="b"/>
              <a:pathLst>
                <a:path w="5063858" h="2463137">
                  <a:moveTo>
                    <a:pt x="203418" y="0"/>
                  </a:moveTo>
                  <a:lnTo>
                    <a:pt x="5063858" y="333474"/>
                  </a:lnTo>
                  <a:lnTo>
                    <a:pt x="4750010" y="2463137"/>
                  </a:lnTo>
                  <a:lnTo>
                    <a:pt x="0" y="1380321"/>
                  </a:lnTo>
                  <a:close/>
                </a:path>
              </a:pathLst>
            </a:custGeom>
            <a:solidFill>
              <a:srgbClr val="2FAA46"/>
            </a:solidFill>
            <a:ln w="12700" cap="flat" cmpd="sng" algn="ctr">
              <a:noFill/>
              <a:prstDash val="solid"/>
              <a:miter lim="800000"/>
            </a:ln>
            <a:effectLst/>
          </p:spPr>
          <p:txBody>
            <a:bodyPr wrap="square" rtlCol="0" anchor="ctr">
              <a:noAutofit/>
            </a:bodyPr>
            <a:lstStyle/>
            <a:p>
              <a:pPr marL="0" marR="0" lvl="0" indent="0" algn="ctr"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FFFFFF"/>
                </a:solidFill>
                <a:effectLst/>
                <a:uLnTx/>
                <a:uFillTx/>
                <a:latin typeface="Tw Cen MT" panose="020B0602020104020603" pitchFamily="34" charset="77"/>
              </a:endParaRPr>
            </a:p>
          </p:txBody>
        </p:sp>
        <p:sp>
          <p:nvSpPr>
            <p:cNvPr id="57" name="Freeform 56">
              <a:extLst>
                <a:ext uri="{FF2B5EF4-FFF2-40B4-BE49-F238E27FC236}">
                  <a16:creationId xmlns:a16="http://schemas.microsoft.com/office/drawing/2014/main" id="{F03B7DCD-8868-9D4D-9ADE-E6796E91FD78}"/>
                </a:ext>
              </a:extLst>
            </p:cNvPr>
            <p:cNvSpPr>
              <a:spLocks noChangeArrowheads="1"/>
            </p:cNvSpPr>
            <p:nvPr/>
          </p:nvSpPr>
          <p:spPr bwMode="auto">
            <a:xfrm>
              <a:off x="11884689" y="3108705"/>
              <a:ext cx="1330541" cy="1225233"/>
            </a:xfrm>
            <a:custGeom>
              <a:avLst/>
              <a:gdLst>
                <a:gd name="connsiteX0" fmla="*/ 444116 w 556182"/>
                <a:gd name="connsiteY0" fmla="*/ 383978 h 512161"/>
                <a:gd name="connsiteX1" fmla="*/ 452152 w 556182"/>
                <a:gd name="connsiteY1" fmla="*/ 391592 h 512161"/>
                <a:gd name="connsiteX2" fmla="*/ 444116 w 556182"/>
                <a:gd name="connsiteY2" fmla="*/ 399628 h 512161"/>
                <a:gd name="connsiteX3" fmla="*/ 436502 w 556182"/>
                <a:gd name="connsiteY3" fmla="*/ 391592 h 512161"/>
                <a:gd name="connsiteX4" fmla="*/ 444116 w 556182"/>
                <a:gd name="connsiteY4" fmla="*/ 383978 h 512161"/>
                <a:gd name="connsiteX5" fmla="*/ 112355 w 556182"/>
                <a:gd name="connsiteY5" fmla="*/ 383978 h 512161"/>
                <a:gd name="connsiteX6" fmla="*/ 119969 w 556182"/>
                <a:gd name="connsiteY6" fmla="*/ 391592 h 512161"/>
                <a:gd name="connsiteX7" fmla="*/ 112355 w 556182"/>
                <a:gd name="connsiteY7" fmla="*/ 399628 h 512161"/>
                <a:gd name="connsiteX8" fmla="*/ 104319 w 556182"/>
                <a:gd name="connsiteY8" fmla="*/ 391592 h 512161"/>
                <a:gd name="connsiteX9" fmla="*/ 112355 w 556182"/>
                <a:gd name="connsiteY9" fmla="*/ 383978 h 512161"/>
                <a:gd name="connsiteX10" fmla="*/ 434805 w 556182"/>
                <a:gd name="connsiteY10" fmla="*/ 377406 h 512161"/>
                <a:gd name="connsiteX11" fmla="*/ 431159 w 556182"/>
                <a:gd name="connsiteY11" fmla="*/ 379834 h 512161"/>
                <a:gd name="connsiteX12" fmla="*/ 427918 w 556182"/>
                <a:gd name="connsiteY12" fmla="*/ 399663 h 512161"/>
                <a:gd name="connsiteX13" fmla="*/ 538908 w 556182"/>
                <a:gd name="connsiteY13" fmla="*/ 415445 h 512161"/>
                <a:gd name="connsiteX14" fmla="*/ 541743 w 556182"/>
                <a:gd name="connsiteY14" fmla="*/ 397235 h 512161"/>
                <a:gd name="connsiteX15" fmla="*/ 539313 w 556182"/>
                <a:gd name="connsiteY15" fmla="*/ 393593 h 512161"/>
                <a:gd name="connsiteX16" fmla="*/ 121279 w 556182"/>
                <a:gd name="connsiteY16" fmla="*/ 377406 h 512161"/>
                <a:gd name="connsiteX17" fmla="*/ 16771 w 556182"/>
                <a:gd name="connsiteY17" fmla="*/ 393593 h 512161"/>
                <a:gd name="connsiteX18" fmla="*/ 14341 w 556182"/>
                <a:gd name="connsiteY18" fmla="*/ 397235 h 512161"/>
                <a:gd name="connsiteX19" fmla="*/ 16771 w 556182"/>
                <a:gd name="connsiteY19" fmla="*/ 415445 h 512161"/>
                <a:gd name="connsiteX20" fmla="*/ 128166 w 556182"/>
                <a:gd name="connsiteY20" fmla="*/ 399663 h 512161"/>
                <a:gd name="connsiteX21" fmla="*/ 124925 w 556182"/>
                <a:gd name="connsiteY21" fmla="*/ 379834 h 512161"/>
                <a:gd name="connsiteX22" fmla="*/ 123710 w 556182"/>
                <a:gd name="connsiteY22" fmla="*/ 377811 h 512161"/>
                <a:gd name="connsiteX23" fmla="*/ 121279 w 556182"/>
                <a:gd name="connsiteY23" fmla="*/ 377406 h 512161"/>
                <a:gd name="connsiteX24" fmla="*/ 499211 w 556182"/>
                <a:gd name="connsiteY24" fmla="*/ 222419 h 512161"/>
                <a:gd name="connsiteX25" fmla="*/ 499211 w 556182"/>
                <a:gd name="connsiteY25" fmla="*/ 283928 h 512161"/>
                <a:gd name="connsiteX26" fmla="*/ 499211 w 556182"/>
                <a:gd name="connsiteY26" fmla="*/ 288379 h 512161"/>
                <a:gd name="connsiteX27" fmla="*/ 495565 w 556182"/>
                <a:gd name="connsiteY27" fmla="*/ 301733 h 512161"/>
                <a:gd name="connsiteX28" fmla="*/ 480578 w 556182"/>
                <a:gd name="connsiteY28" fmla="*/ 307803 h 512161"/>
                <a:gd name="connsiteX29" fmla="*/ 467615 w 556182"/>
                <a:gd name="connsiteY29" fmla="*/ 297687 h 512161"/>
                <a:gd name="connsiteX30" fmla="*/ 463970 w 556182"/>
                <a:gd name="connsiteY30" fmla="*/ 288784 h 512161"/>
                <a:gd name="connsiteX31" fmla="*/ 446147 w 556182"/>
                <a:gd name="connsiteY31" fmla="*/ 279881 h 512161"/>
                <a:gd name="connsiteX32" fmla="*/ 436020 w 556182"/>
                <a:gd name="connsiteY32" fmla="*/ 293235 h 512161"/>
                <a:gd name="connsiteX33" fmla="*/ 436020 w 556182"/>
                <a:gd name="connsiteY33" fmla="*/ 294449 h 512161"/>
                <a:gd name="connsiteX34" fmla="*/ 440881 w 556182"/>
                <a:gd name="connsiteY34" fmla="*/ 363648 h 512161"/>
                <a:gd name="connsiteX35" fmla="*/ 528376 w 556182"/>
                <a:gd name="connsiteY35" fmla="*/ 377406 h 512161"/>
                <a:gd name="connsiteX36" fmla="*/ 533237 w 556182"/>
                <a:gd name="connsiteY36" fmla="*/ 299305 h 512161"/>
                <a:gd name="connsiteX37" fmla="*/ 532832 w 556182"/>
                <a:gd name="connsiteY37" fmla="*/ 290807 h 512161"/>
                <a:gd name="connsiteX38" fmla="*/ 532022 w 556182"/>
                <a:gd name="connsiteY38" fmla="*/ 288784 h 512161"/>
                <a:gd name="connsiteX39" fmla="*/ 56873 w 556182"/>
                <a:gd name="connsiteY39" fmla="*/ 222014 h 512161"/>
                <a:gd name="connsiteX40" fmla="*/ 23657 w 556182"/>
                <a:gd name="connsiteY40" fmla="*/ 288784 h 512161"/>
                <a:gd name="connsiteX41" fmla="*/ 23252 w 556182"/>
                <a:gd name="connsiteY41" fmla="*/ 290403 h 512161"/>
                <a:gd name="connsiteX42" fmla="*/ 22442 w 556182"/>
                <a:gd name="connsiteY42" fmla="*/ 299305 h 512161"/>
                <a:gd name="connsiteX43" fmla="*/ 27708 w 556182"/>
                <a:gd name="connsiteY43" fmla="*/ 377406 h 512161"/>
                <a:gd name="connsiteX44" fmla="*/ 115203 w 556182"/>
                <a:gd name="connsiteY44" fmla="*/ 363648 h 512161"/>
                <a:gd name="connsiteX45" fmla="*/ 120064 w 556182"/>
                <a:gd name="connsiteY45" fmla="*/ 292831 h 512161"/>
                <a:gd name="connsiteX46" fmla="*/ 109937 w 556182"/>
                <a:gd name="connsiteY46" fmla="*/ 279881 h 512161"/>
                <a:gd name="connsiteX47" fmla="*/ 91709 w 556182"/>
                <a:gd name="connsiteY47" fmla="*/ 288784 h 512161"/>
                <a:gd name="connsiteX48" fmla="*/ 88063 w 556182"/>
                <a:gd name="connsiteY48" fmla="*/ 297687 h 512161"/>
                <a:gd name="connsiteX49" fmla="*/ 75101 w 556182"/>
                <a:gd name="connsiteY49" fmla="*/ 307803 h 512161"/>
                <a:gd name="connsiteX50" fmla="*/ 60519 w 556182"/>
                <a:gd name="connsiteY50" fmla="*/ 301733 h 512161"/>
                <a:gd name="connsiteX51" fmla="*/ 57278 w 556182"/>
                <a:gd name="connsiteY51" fmla="*/ 287165 h 512161"/>
                <a:gd name="connsiteX52" fmla="*/ 56873 w 556182"/>
                <a:gd name="connsiteY52" fmla="*/ 283928 h 512161"/>
                <a:gd name="connsiteX53" fmla="*/ 420222 w 556182"/>
                <a:gd name="connsiteY53" fmla="*/ 126108 h 512161"/>
                <a:gd name="connsiteX54" fmla="*/ 402399 w 556182"/>
                <a:gd name="connsiteY54" fmla="*/ 131773 h 512161"/>
                <a:gd name="connsiteX55" fmla="*/ 395108 w 556182"/>
                <a:gd name="connsiteY55" fmla="*/ 148769 h 512161"/>
                <a:gd name="connsiteX56" fmla="*/ 400779 w 556182"/>
                <a:gd name="connsiteY56" fmla="*/ 163742 h 512161"/>
                <a:gd name="connsiteX57" fmla="*/ 401994 w 556182"/>
                <a:gd name="connsiteY57" fmla="*/ 171430 h 512161"/>
                <a:gd name="connsiteX58" fmla="*/ 395108 w 556182"/>
                <a:gd name="connsiteY58" fmla="*/ 175882 h 512161"/>
                <a:gd name="connsiteX59" fmla="*/ 356626 w 556182"/>
                <a:gd name="connsiteY59" fmla="*/ 175882 h 512161"/>
                <a:gd name="connsiteX60" fmla="*/ 350145 w 556182"/>
                <a:gd name="connsiteY60" fmla="*/ 182356 h 512161"/>
                <a:gd name="connsiteX61" fmla="*/ 350145 w 556182"/>
                <a:gd name="connsiteY61" fmla="*/ 196924 h 512161"/>
                <a:gd name="connsiteX62" fmla="*/ 350145 w 556182"/>
                <a:gd name="connsiteY62" fmla="*/ 211088 h 512161"/>
                <a:gd name="connsiteX63" fmla="*/ 345689 w 556182"/>
                <a:gd name="connsiteY63" fmla="*/ 217563 h 512161"/>
                <a:gd name="connsiteX64" fmla="*/ 337993 w 556182"/>
                <a:gd name="connsiteY64" fmla="*/ 216349 h 512161"/>
                <a:gd name="connsiteX65" fmla="*/ 330296 w 556182"/>
                <a:gd name="connsiteY65" fmla="*/ 211897 h 512161"/>
                <a:gd name="connsiteX66" fmla="*/ 329486 w 556182"/>
                <a:gd name="connsiteY66" fmla="*/ 211492 h 512161"/>
                <a:gd name="connsiteX67" fmla="*/ 325030 w 556182"/>
                <a:gd name="connsiteY67" fmla="*/ 210683 h 512161"/>
                <a:gd name="connsiteX68" fmla="*/ 324625 w 556182"/>
                <a:gd name="connsiteY68" fmla="*/ 210683 h 512161"/>
                <a:gd name="connsiteX69" fmla="*/ 320169 w 556182"/>
                <a:gd name="connsiteY69" fmla="*/ 210683 h 512161"/>
                <a:gd name="connsiteX70" fmla="*/ 300321 w 556182"/>
                <a:gd name="connsiteY70" fmla="*/ 230512 h 512161"/>
                <a:gd name="connsiteX71" fmla="*/ 305992 w 556182"/>
                <a:gd name="connsiteY71" fmla="*/ 248317 h 512161"/>
                <a:gd name="connsiteX72" fmla="*/ 309233 w 556182"/>
                <a:gd name="connsiteY72" fmla="*/ 251150 h 512161"/>
                <a:gd name="connsiteX73" fmla="*/ 310043 w 556182"/>
                <a:gd name="connsiteY73" fmla="*/ 251959 h 512161"/>
                <a:gd name="connsiteX74" fmla="*/ 312878 w 556182"/>
                <a:gd name="connsiteY74" fmla="*/ 253173 h 512161"/>
                <a:gd name="connsiteX75" fmla="*/ 313688 w 556182"/>
                <a:gd name="connsiteY75" fmla="*/ 253983 h 512161"/>
                <a:gd name="connsiteX76" fmla="*/ 317739 w 556182"/>
                <a:gd name="connsiteY76" fmla="*/ 255197 h 512161"/>
                <a:gd name="connsiteX77" fmla="*/ 319359 w 556182"/>
                <a:gd name="connsiteY77" fmla="*/ 255601 h 512161"/>
                <a:gd name="connsiteX78" fmla="*/ 321790 w 556182"/>
                <a:gd name="connsiteY78" fmla="*/ 255601 h 512161"/>
                <a:gd name="connsiteX79" fmla="*/ 323410 w 556182"/>
                <a:gd name="connsiteY79" fmla="*/ 255601 h 512161"/>
                <a:gd name="connsiteX80" fmla="*/ 325435 w 556182"/>
                <a:gd name="connsiteY80" fmla="*/ 255601 h 512161"/>
                <a:gd name="connsiteX81" fmla="*/ 328271 w 556182"/>
                <a:gd name="connsiteY81" fmla="*/ 255197 h 512161"/>
                <a:gd name="connsiteX82" fmla="*/ 337993 w 556182"/>
                <a:gd name="connsiteY82" fmla="*/ 250341 h 512161"/>
                <a:gd name="connsiteX83" fmla="*/ 345689 w 556182"/>
                <a:gd name="connsiteY83" fmla="*/ 249127 h 512161"/>
                <a:gd name="connsiteX84" fmla="*/ 350145 w 556182"/>
                <a:gd name="connsiteY84" fmla="*/ 255601 h 512161"/>
                <a:gd name="connsiteX85" fmla="*/ 350145 w 556182"/>
                <a:gd name="connsiteY85" fmla="*/ 269360 h 512161"/>
                <a:gd name="connsiteX86" fmla="*/ 350145 w 556182"/>
                <a:gd name="connsiteY86" fmla="*/ 283928 h 512161"/>
                <a:gd name="connsiteX87" fmla="*/ 356626 w 556182"/>
                <a:gd name="connsiteY87" fmla="*/ 290807 h 512161"/>
                <a:gd name="connsiteX88" fmla="*/ 380930 w 556182"/>
                <a:gd name="connsiteY88" fmla="*/ 290807 h 512161"/>
                <a:gd name="connsiteX89" fmla="*/ 380525 w 556182"/>
                <a:gd name="connsiteY89" fmla="*/ 284333 h 512161"/>
                <a:gd name="connsiteX90" fmla="*/ 380525 w 556182"/>
                <a:gd name="connsiteY90" fmla="*/ 277858 h 512161"/>
                <a:gd name="connsiteX91" fmla="*/ 392677 w 556182"/>
                <a:gd name="connsiteY91" fmla="*/ 250341 h 512161"/>
                <a:gd name="connsiteX92" fmla="*/ 421842 w 556182"/>
                <a:gd name="connsiteY92" fmla="*/ 241033 h 512161"/>
                <a:gd name="connsiteX93" fmla="*/ 452223 w 556182"/>
                <a:gd name="connsiteY93" fmla="*/ 265313 h 512161"/>
                <a:gd name="connsiteX94" fmla="*/ 477337 w 556182"/>
                <a:gd name="connsiteY94" fmla="*/ 283523 h 512161"/>
                <a:gd name="connsiteX95" fmla="*/ 480173 w 556182"/>
                <a:gd name="connsiteY95" fmla="*/ 290807 h 512161"/>
                <a:gd name="connsiteX96" fmla="*/ 485033 w 556182"/>
                <a:gd name="connsiteY96" fmla="*/ 283928 h 512161"/>
                <a:gd name="connsiteX97" fmla="*/ 485033 w 556182"/>
                <a:gd name="connsiteY97" fmla="*/ 182356 h 512161"/>
                <a:gd name="connsiteX98" fmla="*/ 478552 w 556182"/>
                <a:gd name="connsiteY98" fmla="*/ 175882 h 512161"/>
                <a:gd name="connsiteX99" fmla="*/ 439665 w 556182"/>
                <a:gd name="connsiteY99" fmla="*/ 175882 h 512161"/>
                <a:gd name="connsiteX100" fmla="*/ 433184 w 556182"/>
                <a:gd name="connsiteY100" fmla="*/ 171430 h 512161"/>
                <a:gd name="connsiteX101" fmla="*/ 434399 w 556182"/>
                <a:gd name="connsiteY101" fmla="*/ 163742 h 512161"/>
                <a:gd name="connsiteX102" fmla="*/ 440070 w 556182"/>
                <a:gd name="connsiteY102" fmla="*/ 145936 h 512161"/>
                <a:gd name="connsiteX103" fmla="*/ 420222 w 556182"/>
                <a:gd name="connsiteY103" fmla="*/ 126108 h 512161"/>
                <a:gd name="connsiteX104" fmla="*/ 275612 w 556182"/>
                <a:gd name="connsiteY104" fmla="*/ 126108 h 512161"/>
                <a:gd name="connsiteX105" fmla="*/ 255763 w 556182"/>
                <a:gd name="connsiteY105" fmla="*/ 145936 h 512161"/>
                <a:gd name="connsiteX106" fmla="*/ 261434 w 556182"/>
                <a:gd name="connsiteY106" fmla="*/ 163742 h 512161"/>
                <a:gd name="connsiteX107" fmla="*/ 262649 w 556182"/>
                <a:gd name="connsiteY107" fmla="*/ 171430 h 512161"/>
                <a:gd name="connsiteX108" fmla="*/ 255763 w 556182"/>
                <a:gd name="connsiteY108" fmla="*/ 175882 h 512161"/>
                <a:gd name="connsiteX109" fmla="*/ 227003 w 556182"/>
                <a:gd name="connsiteY109" fmla="*/ 175882 h 512161"/>
                <a:gd name="connsiteX110" fmla="*/ 220522 w 556182"/>
                <a:gd name="connsiteY110" fmla="*/ 182356 h 512161"/>
                <a:gd name="connsiteX111" fmla="*/ 220522 w 556182"/>
                <a:gd name="connsiteY111" fmla="*/ 196924 h 512161"/>
                <a:gd name="connsiteX112" fmla="*/ 223357 w 556182"/>
                <a:gd name="connsiteY112" fmla="*/ 197329 h 512161"/>
                <a:gd name="connsiteX113" fmla="*/ 224167 w 556182"/>
                <a:gd name="connsiteY113" fmla="*/ 197329 h 512161"/>
                <a:gd name="connsiteX114" fmla="*/ 225383 w 556182"/>
                <a:gd name="connsiteY114" fmla="*/ 197329 h 512161"/>
                <a:gd name="connsiteX115" fmla="*/ 228218 w 556182"/>
                <a:gd name="connsiteY115" fmla="*/ 196520 h 512161"/>
                <a:gd name="connsiteX116" fmla="*/ 229433 w 556182"/>
                <a:gd name="connsiteY116" fmla="*/ 196115 h 512161"/>
                <a:gd name="connsiteX117" fmla="*/ 232674 w 556182"/>
                <a:gd name="connsiteY117" fmla="*/ 196115 h 512161"/>
                <a:gd name="connsiteX118" fmla="*/ 233484 w 556182"/>
                <a:gd name="connsiteY118" fmla="*/ 196115 h 512161"/>
                <a:gd name="connsiteX119" fmla="*/ 237535 w 556182"/>
                <a:gd name="connsiteY119" fmla="*/ 196115 h 512161"/>
                <a:gd name="connsiteX120" fmla="*/ 270346 w 556182"/>
                <a:gd name="connsiteY120" fmla="*/ 228893 h 512161"/>
                <a:gd name="connsiteX121" fmla="*/ 261029 w 556182"/>
                <a:gd name="connsiteY121" fmla="*/ 258029 h 512161"/>
                <a:gd name="connsiteX122" fmla="*/ 257788 w 556182"/>
                <a:gd name="connsiteY122" fmla="*/ 261267 h 512161"/>
                <a:gd name="connsiteX123" fmla="*/ 256573 w 556182"/>
                <a:gd name="connsiteY123" fmla="*/ 261671 h 512161"/>
                <a:gd name="connsiteX124" fmla="*/ 253332 w 556182"/>
                <a:gd name="connsiteY124" fmla="*/ 264099 h 512161"/>
                <a:gd name="connsiteX125" fmla="*/ 252927 w 556182"/>
                <a:gd name="connsiteY125" fmla="*/ 264504 h 512161"/>
                <a:gd name="connsiteX126" fmla="*/ 238750 w 556182"/>
                <a:gd name="connsiteY126" fmla="*/ 269765 h 512161"/>
                <a:gd name="connsiteX127" fmla="*/ 233484 w 556182"/>
                <a:gd name="connsiteY127" fmla="*/ 270169 h 512161"/>
                <a:gd name="connsiteX128" fmla="*/ 229028 w 556182"/>
                <a:gd name="connsiteY128" fmla="*/ 269765 h 512161"/>
                <a:gd name="connsiteX129" fmla="*/ 228218 w 556182"/>
                <a:gd name="connsiteY129" fmla="*/ 269765 h 512161"/>
                <a:gd name="connsiteX130" fmla="*/ 223357 w 556182"/>
                <a:gd name="connsiteY130" fmla="*/ 268955 h 512161"/>
                <a:gd name="connsiteX131" fmla="*/ 220522 w 556182"/>
                <a:gd name="connsiteY131" fmla="*/ 269360 h 512161"/>
                <a:gd name="connsiteX132" fmla="*/ 220522 w 556182"/>
                <a:gd name="connsiteY132" fmla="*/ 283928 h 512161"/>
                <a:gd name="connsiteX133" fmla="*/ 227003 w 556182"/>
                <a:gd name="connsiteY133" fmla="*/ 290807 h 512161"/>
                <a:gd name="connsiteX134" fmla="*/ 255763 w 556182"/>
                <a:gd name="connsiteY134" fmla="*/ 290807 h 512161"/>
                <a:gd name="connsiteX135" fmla="*/ 262649 w 556182"/>
                <a:gd name="connsiteY135" fmla="*/ 295259 h 512161"/>
                <a:gd name="connsiteX136" fmla="*/ 261434 w 556182"/>
                <a:gd name="connsiteY136" fmla="*/ 302947 h 512161"/>
                <a:gd name="connsiteX137" fmla="*/ 255763 w 556182"/>
                <a:gd name="connsiteY137" fmla="*/ 320348 h 512161"/>
                <a:gd name="connsiteX138" fmla="*/ 275612 w 556182"/>
                <a:gd name="connsiteY138" fmla="*/ 340177 h 512161"/>
                <a:gd name="connsiteX139" fmla="*/ 293030 w 556182"/>
                <a:gd name="connsiteY139" fmla="*/ 334511 h 512161"/>
                <a:gd name="connsiteX140" fmla="*/ 300726 w 556182"/>
                <a:gd name="connsiteY140" fmla="*/ 317920 h 512161"/>
                <a:gd name="connsiteX141" fmla="*/ 295055 w 556182"/>
                <a:gd name="connsiteY141" fmla="*/ 302947 h 512161"/>
                <a:gd name="connsiteX142" fmla="*/ 293840 w 556182"/>
                <a:gd name="connsiteY142" fmla="*/ 295259 h 512161"/>
                <a:gd name="connsiteX143" fmla="*/ 300321 w 556182"/>
                <a:gd name="connsiteY143" fmla="*/ 290807 h 512161"/>
                <a:gd name="connsiteX144" fmla="*/ 329081 w 556182"/>
                <a:gd name="connsiteY144" fmla="*/ 290807 h 512161"/>
                <a:gd name="connsiteX145" fmla="*/ 335562 w 556182"/>
                <a:gd name="connsiteY145" fmla="*/ 284333 h 512161"/>
                <a:gd name="connsiteX146" fmla="*/ 335562 w 556182"/>
                <a:gd name="connsiteY146" fmla="*/ 283928 h 512161"/>
                <a:gd name="connsiteX147" fmla="*/ 335562 w 556182"/>
                <a:gd name="connsiteY147" fmla="*/ 269360 h 512161"/>
                <a:gd name="connsiteX148" fmla="*/ 333132 w 556182"/>
                <a:gd name="connsiteY148" fmla="*/ 268955 h 512161"/>
                <a:gd name="connsiteX149" fmla="*/ 327866 w 556182"/>
                <a:gd name="connsiteY149" fmla="*/ 269765 h 512161"/>
                <a:gd name="connsiteX150" fmla="*/ 327461 w 556182"/>
                <a:gd name="connsiteY150" fmla="*/ 269765 h 512161"/>
                <a:gd name="connsiteX151" fmla="*/ 323005 w 556182"/>
                <a:gd name="connsiteY151" fmla="*/ 270169 h 512161"/>
                <a:gd name="connsiteX152" fmla="*/ 317334 w 556182"/>
                <a:gd name="connsiteY152" fmla="*/ 269765 h 512161"/>
                <a:gd name="connsiteX153" fmla="*/ 303562 w 556182"/>
                <a:gd name="connsiteY153" fmla="*/ 264504 h 512161"/>
                <a:gd name="connsiteX154" fmla="*/ 302751 w 556182"/>
                <a:gd name="connsiteY154" fmla="*/ 264099 h 512161"/>
                <a:gd name="connsiteX155" fmla="*/ 299511 w 556182"/>
                <a:gd name="connsiteY155" fmla="*/ 261671 h 512161"/>
                <a:gd name="connsiteX156" fmla="*/ 299106 w 556182"/>
                <a:gd name="connsiteY156" fmla="*/ 261267 h 512161"/>
                <a:gd name="connsiteX157" fmla="*/ 295460 w 556182"/>
                <a:gd name="connsiteY157" fmla="*/ 258029 h 512161"/>
                <a:gd name="connsiteX158" fmla="*/ 286143 w 556182"/>
                <a:gd name="connsiteY158" fmla="*/ 228893 h 512161"/>
                <a:gd name="connsiteX159" fmla="*/ 318549 w 556182"/>
                <a:gd name="connsiteY159" fmla="*/ 196115 h 512161"/>
                <a:gd name="connsiteX160" fmla="*/ 322600 w 556182"/>
                <a:gd name="connsiteY160" fmla="*/ 196115 h 512161"/>
                <a:gd name="connsiteX161" fmla="*/ 323815 w 556182"/>
                <a:gd name="connsiteY161" fmla="*/ 196115 h 512161"/>
                <a:gd name="connsiteX162" fmla="*/ 327056 w 556182"/>
                <a:gd name="connsiteY162" fmla="*/ 196115 h 512161"/>
                <a:gd name="connsiteX163" fmla="*/ 328271 w 556182"/>
                <a:gd name="connsiteY163" fmla="*/ 196520 h 512161"/>
                <a:gd name="connsiteX164" fmla="*/ 330701 w 556182"/>
                <a:gd name="connsiteY164" fmla="*/ 197329 h 512161"/>
                <a:gd name="connsiteX165" fmla="*/ 331917 w 556182"/>
                <a:gd name="connsiteY165" fmla="*/ 197329 h 512161"/>
                <a:gd name="connsiteX166" fmla="*/ 333132 w 556182"/>
                <a:gd name="connsiteY166" fmla="*/ 197329 h 512161"/>
                <a:gd name="connsiteX167" fmla="*/ 335562 w 556182"/>
                <a:gd name="connsiteY167" fmla="*/ 196924 h 512161"/>
                <a:gd name="connsiteX168" fmla="*/ 335562 w 556182"/>
                <a:gd name="connsiteY168" fmla="*/ 182356 h 512161"/>
                <a:gd name="connsiteX169" fmla="*/ 329081 w 556182"/>
                <a:gd name="connsiteY169" fmla="*/ 175882 h 512161"/>
                <a:gd name="connsiteX170" fmla="*/ 300321 w 556182"/>
                <a:gd name="connsiteY170" fmla="*/ 175882 h 512161"/>
                <a:gd name="connsiteX171" fmla="*/ 293840 w 556182"/>
                <a:gd name="connsiteY171" fmla="*/ 171430 h 512161"/>
                <a:gd name="connsiteX172" fmla="*/ 295055 w 556182"/>
                <a:gd name="connsiteY172" fmla="*/ 163742 h 512161"/>
                <a:gd name="connsiteX173" fmla="*/ 300726 w 556182"/>
                <a:gd name="connsiteY173" fmla="*/ 148769 h 512161"/>
                <a:gd name="connsiteX174" fmla="*/ 293030 w 556182"/>
                <a:gd name="connsiteY174" fmla="*/ 131773 h 512161"/>
                <a:gd name="connsiteX175" fmla="*/ 275612 w 556182"/>
                <a:gd name="connsiteY175" fmla="*/ 126108 h 512161"/>
                <a:gd name="connsiteX176" fmla="*/ 136267 w 556182"/>
                <a:gd name="connsiteY176" fmla="*/ 126108 h 512161"/>
                <a:gd name="connsiteX177" fmla="*/ 116418 w 556182"/>
                <a:gd name="connsiteY177" fmla="*/ 145936 h 512161"/>
                <a:gd name="connsiteX178" fmla="*/ 121684 w 556182"/>
                <a:gd name="connsiteY178" fmla="*/ 163742 h 512161"/>
                <a:gd name="connsiteX179" fmla="*/ 122900 w 556182"/>
                <a:gd name="connsiteY179" fmla="*/ 171430 h 512161"/>
                <a:gd name="connsiteX180" fmla="*/ 116418 w 556182"/>
                <a:gd name="connsiteY180" fmla="*/ 175882 h 512161"/>
                <a:gd name="connsiteX181" fmla="*/ 77532 w 556182"/>
                <a:gd name="connsiteY181" fmla="*/ 175882 h 512161"/>
                <a:gd name="connsiteX182" fmla="*/ 71456 w 556182"/>
                <a:gd name="connsiteY182" fmla="*/ 182356 h 512161"/>
                <a:gd name="connsiteX183" fmla="*/ 71456 w 556182"/>
                <a:gd name="connsiteY183" fmla="*/ 283928 h 512161"/>
                <a:gd name="connsiteX184" fmla="*/ 75911 w 556182"/>
                <a:gd name="connsiteY184" fmla="*/ 289593 h 512161"/>
                <a:gd name="connsiteX185" fmla="*/ 78747 w 556182"/>
                <a:gd name="connsiteY185" fmla="*/ 283523 h 512161"/>
                <a:gd name="connsiteX186" fmla="*/ 103861 w 556182"/>
                <a:gd name="connsiteY186" fmla="*/ 265313 h 512161"/>
                <a:gd name="connsiteX187" fmla="*/ 134647 w 556182"/>
                <a:gd name="connsiteY187" fmla="*/ 240224 h 512161"/>
                <a:gd name="connsiteX188" fmla="*/ 163407 w 556182"/>
                <a:gd name="connsiteY188" fmla="*/ 249531 h 512161"/>
                <a:gd name="connsiteX189" fmla="*/ 175559 w 556182"/>
                <a:gd name="connsiteY189" fmla="*/ 277049 h 512161"/>
                <a:gd name="connsiteX190" fmla="*/ 175559 w 556182"/>
                <a:gd name="connsiteY190" fmla="*/ 283523 h 512161"/>
                <a:gd name="connsiteX191" fmla="*/ 175559 w 556182"/>
                <a:gd name="connsiteY191" fmla="*/ 289593 h 512161"/>
                <a:gd name="connsiteX192" fmla="*/ 199863 w 556182"/>
                <a:gd name="connsiteY192" fmla="*/ 289593 h 512161"/>
                <a:gd name="connsiteX193" fmla="*/ 206344 w 556182"/>
                <a:gd name="connsiteY193" fmla="*/ 283928 h 512161"/>
                <a:gd name="connsiteX194" fmla="*/ 206344 w 556182"/>
                <a:gd name="connsiteY194" fmla="*/ 269360 h 512161"/>
                <a:gd name="connsiteX195" fmla="*/ 206344 w 556182"/>
                <a:gd name="connsiteY195" fmla="*/ 255601 h 512161"/>
                <a:gd name="connsiteX196" fmla="*/ 210395 w 556182"/>
                <a:gd name="connsiteY196" fmla="*/ 249127 h 512161"/>
                <a:gd name="connsiteX197" fmla="*/ 218091 w 556182"/>
                <a:gd name="connsiteY197" fmla="*/ 250341 h 512161"/>
                <a:gd name="connsiteX198" fmla="*/ 227813 w 556182"/>
                <a:gd name="connsiteY198" fmla="*/ 254792 h 512161"/>
                <a:gd name="connsiteX199" fmla="*/ 230648 w 556182"/>
                <a:gd name="connsiteY199" fmla="*/ 255601 h 512161"/>
                <a:gd name="connsiteX200" fmla="*/ 232674 w 556182"/>
                <a:gd name="connsiteY200" fmla="*/ 255601 h 512161"/>
                <a:gd name="connsiteX201" fmla="*/ 234294 w 556182"/>
                <a:gd name="connsiteY201" fmla="*/ 255601 h 512161"/>
                <a:gd name="connsiteX202" fmla="*/ 237130 w 556182"/>
                <a:gd name="connsiteY202" fmla="*/ 255601 h 512161"/>
                <a:gd name="connsiteX203" fmla="*/ 238750 w 556182"/>
                <a:gd name="connsiteY203" fmla="*/ 255197 h 512161"/>
                <a:gd name="connsiteX204" fmla="*/ 242396 w 556182"/>
                <a:gd name="connsiteY204" fmla="*/ 253983 h 512161"/>
                <a:gd name="connsiteX205" fmla="*/ 243611 w 556182"/>
                <a:gd name="connsiteY205" fmla="*/ 253173 h 512161"/>
                <a:gd name="connsiteX206" fmla="*/ 246041 w 556182"/>
                <a:gd name="connsiteY206" fmla="*/ 251959 h 512161"/>
                <a:gd name="connsiteX207" fmla="*/ 247256 w 556182"/>
                <a:gd name="connsiteY207" fmla="*/ 251150 h 512161"/>
                <a:gd name="connsiteX208" fmla="*/ 250092 w 556182"/>
                <a:gd name="connsiteY208" fmla="*/ 248317 h 512161"/>
                <a:gd name="connsiteX209" fmla="*/ 255763 w 556182"/>
                <a:gd name="connsiteY209" fmla="*/ 230512 h 512161"/>
                <a:gd name="connsiteX210" fmla="*/ 236319 w 556182"/>
                <a:gd name="connsiteY210" fmla="*/ 210683 h 512161"/>
                <a:gd name="connsiteX211" fmla="*/ 231459 w 556182"/>
                <a:gd name="connsiteY211" fmla="*/ 210683 h 512161"/>
                <a:gd name="connsiteX212" fmla="*/ 231054 w 556182"/>
                <a:gd name="connsiteY212" fmla="*/ 210683 h 512161"/>
                <a:gd name="connsiteX213" fmla="*/ 227003 w 556182"/>
                <a:gd name="connsiteY213" fmla="*/ 211492 h 512161"/>
                <a:gd name="connsiteX214" fmla="*/ 226193 w 556182"/>
                <a:gd name="connsiteY214" fmla="*/ 211897 h 512161"/>
                <a:gd name="connsiteX215" fmla="*/ 218091 w 556182"/>
                <a:gd name="connsiteY215" fmla="*/ 216349 h 512161"/>
                <a:gd name="connsiteX216" fmla="*/ 210395 w 556182"/>
                <a:gd name="connsiteY216" fmla="*/ 217563 h 512161"/>
                <a:gd name="connsiteX217" fmla="*/ 206344 w 556182"/>
                <a:gd name="connsiteY217" fmla="*/ 211088 h 512161"/>
                <a:gd name="connsiteX218" fmla="*/ 206344 w 556182"/>
                <a:gd name="connsiteY218" fmla="*/ 196924 h 512161"/>
                <a:gd name="connsiteX219" fmla="*/ 206344 w 556182"/>
                <a:gd name="connsiteY219" fmla="*/ 182356 h 512161"/>
                <a:gd name="connsiteX220" fmla="*/ 199863 w 556182"/>
                <a:gd name="connsiteY220" fmla="*/ 175882 h 512161"/>
                <a:gd name="connsiteX221" fmla="*/ 160976 w 556182"/>
                <a:gd name="connsiteY221" fmla="*/ 175882 h 512161"/>
                <a:gd name="connsiteX222" fmla="*/ 154495 w 556182"/>
                <a:gd name="connsiteY222" fmla="*/ 171430 h 512161"/>
                <a:gd name="connsiteX223" fmla="*/ 155710 w 556182"/>
                <a:gd name="connsiteY223" fmla="*/ 163742 h 512161"/>
                <a:gd name="connsiteX224" fmla="*/ 161381 w 556182"/>
                <a:gd name="connsiteY224" fmla="*/ 148769 h 512161"/>
                <a:gd name="connsiteX225" fmla="*/ 153685 w 556182"/>
                <a:gd name="connsiteY225" fmla="*/ 131773 h 512161"/>
                <a:gd name="connsiteX226" fmla="*/ 136267 w 556182"/>
                <a:gd name="connsiteY226" fmla="*/ 126108 h 512161"/>
                <a:gd name="connsiteX227" fmla="*/ 134647 w 556182"/>
                <a:gd name="connsiteY227" fmla="*/ 111944 h 512161"/>
                <a:gd name="connsiteX228" fmla="*/ 163407 w 556182"/>
                <a:gd name="connsiteY228" fmla="*/ 121252 h 512161"/>
                <a:gd name="connsiteX229" fmla="*/ 175559 w 556182"/>
                <a:gd name="connsiteY229" fmla="*/ 148769 h 512161"/>
                <a:gd name="connsiteX230" fmla="*/ 173533 w 556182"/>
                <a:gd name="connsiteY230" fmla="*/ 161314 h 512161"/>
                <a:gd name="connsiteX231" fmla="*/ 199863 w 556182"/>
                <a:gd name="connsiteY231" fmla="*/ 161314 h 512161"/>
                <a:gd name="connsiteX232" fmla="*/ 213230 w 556182"/>
                <a:gd name="connsiteY232" fmla="*/ 166574 h 512161"/>
                <a:gd name="connsiteX233" fmla="*/ 227003 w 556182"/>
                <a:gd name="connsiteY233" fmla="*/ 161314 h 512161"/>
                <a:gd name="connsiteX234" fmla="*/ 243611 w 556182"/>
                <a:gd name="connsiteY234" fmla="*/ 161314 h 512161"/>
                <a:gd name="connsiteX235" fmla="*/ 241180 w 556182"/>
                <a:gd name="connsiteY235" fmla="*/ 144318 h 512161"/>
                <a:gd name="connsiteX236" fmla="*/ 273991 w 556182"/>
                <a:gd name="connsiteY236" fmla="*/ 111944 h 512161"/>
                <a:gd name="connsiteX237" fmla="*/ 302751 w 556182"/>
                <a:gd name="connsiteY237" fmla="*/ 121252 h 512161"/>
                <a:gd name="connsiteX238" fmla="*/ 314904 w 556182"/>
                <a:gd name="connsiteY238" fmla="*/ 148769 h 512161"/>
                <a:gd name="connsiteX239" fmla="*/ 312878 w 556182"/>
                <a:gd name="connsiteY239" fmla="*/ 161314 h 512161"/>
                <a:gd name="connsiteX240" fmla="*/ 329081 w 556182"/>
                <a:gd name="connsiteY240" fmla="*/ 161314 h 512161"/>
                <a:gd name="connsiteX241" fmla="*/ 342853 w 556182"/>
                <a:gd name="connsiteY241" fmla="*/ 166574 h 512161"/>
                <a:gd name="connsiteX242" fmla="*/ 356626 w 556182"/>
                <a:gd name="connsiteY242" fmla="*/ 161314 h 512161"/>
                <a:gd name="connsiteX243" fmla="*/ 382955 w 556182"/>
                <a:gd name="connsiteY243" fmla="*/ 161314 h 512161"/>
                <a:gd name="connsiteX244" fmla="*/ 380525 w 556182"/>
                <a:gd name="connsiteY244" fmla="*/ 148769 h 512161"/>
                <a:gd name="connsiteX245" fmla="*/ 392677 w 556182"/>
                <a:gd name="connsiteY245" fmla="*/ 121252 h 512161"/>
                <a:gd name="connsiteX246" fmla="*/ 421842 w 556182"/>
                <a:gd name="connsiteY246" fmla="*/ 111944 h 512161"/>
                <a:gd name="connsiteX247" fmla="*/ 454248 w 556182"/>
                <a:gd name="connsiteY247" fmla="*/ 144318 h 512161"/>
                <a:gd name="connsiteX248" fmla="*/ 452223 w 556182"/>
                <a:gd name="connsiteY248" fmla="*/ 161314 h 512161"/>
                <a:gd name="connsiteX249" fmla="*/ 478552 w 556182"/>
                <a:gd name="connsiteY249" fmla="*/ 161314 h 512161"/>
                <a:gd name="connsiteX250" fmla="*/ 499211 w 556182"/>
                <a:gd name="connsiteY250" fmla="*/ 182356 h 512161"/>
                <a:gd name="connsiteX251" fmla="*/ 499211 w 556182"/>
                <a:gd name="connsiteY251" fmla="*/ 201376 h 512161"/>
                <a:gd name="connsiteX252" fmla="*/ 510958 w 556182"/>
                <a:gd name="connsiteY252" fmla="*/ 213516 h 512161"/>
                <a:gd name="connsiteX253" fmla="*/ 544984 w 556182"/>
                <a:gd name="connsiteY253" fmla="*/ 282309 h 512161"/>
                <a:gd name="connsiteX254" fmla="*/ 546604 w 556182"/>
                <a:gd name="connsiteY254" fmla="*/ 286761 h 512161"/>
                <a:gd name="connsiteX255" fmla="*/ 547819 w 556182"/>
                <a:gd name="connsiteY255" fmla="*/ 300519 h 512161"/>
                <a:gd name="connsiteX256" fmla="*/ 542148 w 556182"/>
                <a:gd name="connsiteY256" fmla="*/ 379834 h 512161"/>
                <a:gd name="connsiteX257" fmla="*/ 555921 w 556182"/>
                <a:gd name="connsiteY257" fmla="*/ 399663 h 512161"/>
                <a:gd name="connsiteX258" fmla="*/ 539313 w 556182"/>
                <a:gd name="connsiteY258" fmla="*/ 506091 h 512161"/>
                <a:gd name="connsiteX259" fmla="*/ 532022 w 556182"/>
                <a:gd name="connsiteY259" fmla="*/ 512161 h 512161"/>
                <a:gd name="connsiteX260" fmla="*/ 530806 w 556182"/>
                <a:gd name="connsiteY260" fmla="*/ 512161 h 512161"/>
                <a:gd name="connsiteX261" fmla="*/ 524730 w 556182"/>
                <a:gd name="connsiteY261" fmla="*/ 503663 h 512161"/>
                <a:gd name="connsiteX262" fmla="*/ 536882 w 556182"/>
                <a:gd name="connsiteY262" fmla="*/ 429204 h 512161"/>
                <a:gd name="connsiteX263" fmla="*/ 425893 w 556182"/>
                <a:gd name="connsiteY263" fmla="*/ 413826 h 512161"/>
                <a:gd name="connsiteX264" fmla="*/ 415361 w 556182"/>
                <a:gd name="connsiteY264" fmla="*/ 482215 h 512161"/>
                <a:gd name="connsiteX265" fmla="*/ 406855 w 556182"/>
                <a:gd name="connsiteY265" fmla="*/ 488285 h 512161"/>
                <a:gd name="connsiteX266" fmla="*/ 401184 w 556182"/>
                <a:gd name="connsiteY266" fmla="*/ 480192 h 512161"/>
                <a:gd name="connsiteX267" fmla="*/ 416981 w 556182"/>
                <a:gd name="connsiteY267" fmla="*/ 377406 h 512161"/>
                <a:gd name="connsiteX268" fmla="*/ 424273 w 556182"/>
                <a:gd name="connsiteY268" fmla="*/ 366076 h 512161"/>
                <a:gd name="connsiteX269" fmla="*/ 426703 w 556182"/>
                <a:gd name="connsiteY269" fmla="*/ 364457 h 512161"/>
                <a:gd name="connsiteX270" fmla="*/ 421842 w 556182"/>
                <a:gd name="connsiteY270" fmla="*/ 295663 h 512161"/>
                <a:gd name="connsiteX271" fmla="*/ 421842 w 556182"/>
                <a:gd name="connsiteY271" fmla="*/ 293235 h 512161"/>
                <a:gd name="connsiteX272" fmla="*/ 438045 w 556182"/>
                <a:gd name="connsiteY272" fmla="*/ 267741 h 512161"/>
                <a:gd name="connsiteX273" fmla="*/ 420222 w 556182"/>
                <a:gd name="connsiteY273" fmla="*/ 255601 h 512161"/>
                <a:gd name="connsiteX274" fmla="*/ 402399 w 556182"/>
                <a:gd name="connsiteY274" fmla="*/ 261267 h 512161"/>
                <a:gd name="connsiteX275" fmla="*/ 395108 w 556182"/>
                <a:gd name="connsiteY275" fmla="*/ 277858 h 512161"/>
                <a:gd name="connsiteX276" fmla="*/ 395108 w 556182"/>
                <a:gd name="connsiteY276" fmla="*/ 283523 h 512161"/>
                <a:gd name="connsiteX277" fmla="*/ 395108 w 556182"/>
                <a:gd name="connsiteY277" fmla="*/ 294045 h 512161"/>
                <a:gd name="connsiteX278" fmla="*/ 382145 w 556182"/>
                <a:gd name="connsiteY278" fmla="*/ 304971 h 512161"/>
                <a:gd name="connsiteX279" fmla="*/ 356626 w 556182"/>
                <a:gd name="connsiteY279" fmla="*/ 304971 h 512161"/>
                <a:gd name="connsiteX280" fmla="*/ 342853 w 556182"/>
                <a:gd name="connsiteY280" fmla="*/ 299710 h 512161"/>
                <a:gd name="connsiteX281" fmla="*/ 329081 w 556182"/>
                <a:gd name="connsiteY281" fmla="*/ 305375 h 512161"/>
                <a:gd name="connsiteX282" fmla="*/ 312878 w 556182"/>
                <a:gd name="connsiteY282" fmla="*/ 305375 h 512161"/>
                <a:gd name="connsiteX283" fmla="*/ 314904 w 556182"/>
                <a:gd name="connsiteY283" fmla="*/ 317920 h 512161"/>
                <a:gd name="connsiteX284" fmla="*/ 302751 w 556182"/>
                <a:gd name="connsiteY284" fmla="*/ 345437 h 512161"/>
                <a:gd name="connsiteX285" fmla="*/ 278042 w 556182"/>
                <a:gd name="connsiteY285" fmla="*/ 354745 h 512161"/>
                <a:gd name="connsiteX286" fmla="*/ 273991 w 556182"/>
                <a:gd name="connsiteY286" fmla="*/ 354745 h 512161"/>
                <a:gd name="connsiteX287" fmla="*/ 241180 w 556182"/>
                <a:gd name="connsiteY287" fmla="*/ 322371 h 512161"/>
                <a:gd name="connsiteX288" fmla="*/ 243611 w 556182"/>
                <a:gd name="connsiteY288" fmla="*/ 305375 h 512161"/>
                <a:gd name="connsiteX289" fmla="*/ 227003 w 556182"/>
                <a:gd name="connsiteY289" fmla="*/ 305375 h 512161"/>
                <a:gd name="connsiteX290" fmla="*/ 212825 w 556182"/>
                <a:gd name="connsiteY290" fmla="*/ 299305 h 512161"/>
                <a:gd name="connsiteX291" fmla="*/ 199863 w 556182"/>
                <a:gd name="connsiteY291" fmla="*/ 304161 h 512161"/>
                <a:gd name="connsiteX292" fmla="*/ 171103 w 556182"/>
                <a:gd name="connsiteY292" fmla="*/ 304161 h 512161"/>
                <a:gd name="connsiteX293" fmla="*/ 167457 w 556182"/>
                <a:gd name="connsiteY293" fmla="*/ 302947 h 512161"/>
                <a:gd name="connsiteX294" fmla="*/ 160976 w 556182"/>
                <a:gd name="connsiteY294" fmla="*/ 294045 h 512161"/>
                <a:gd name="connsiteX295" fmla="*/ 160976 w 556182"/>
                <a:gd name="connsiteY295" fmla="*/ 283119 h 512161"/>
                <a:gd name="connsiteX296" fmla="*/ 161381 w 556182"/>
                <a:gd name="connsiteY296" fmla="*/ 277049 h 512161"/>
                <a:gd name="connsiteX297" fmla="*/ 153685 w 556182"/>
                <a:gd name="connsiteY297" fmla="*/ 260457 h 512161"/>
                <a:gd name="connsiteX298" fmla="*/ 136267 w 556182"/>
                <a:gd name="connsiteY298" fmla="*/ 254387 h 512161"/>
                <a:gd name="connsiteX299" fmla="*/ 118039 w 556182"/>
                <a:gd name="connsiteY299" fmla="*/ 267741 h 512161"/>
                <a:gd name="connsiteX300" fmla="*/ 134242 w 556182"/>
                <a:gd name="connsiteY300" fmla="*/ 292831 h 512161"/>
                <a:gd name="connsiteX301" fmla="*/ 133837 w 556182"/>
                <a:gd name="connsiteY301" fmla="*/ 295663 h 512161"/>
                <a:gd name="connsiteX302" fmla="*/ 129381 w 556182"/>
                <a:gd name="connsiteY302" fmla="*/ 364457 h 512161"/>
                <a:gd name="connsiteX303" fmla="*/ 132216 w 556182"/>
                <a:gd name="connsiteY303" fmla="*/ 366076 h 512161"/>
                <a:gd name="connsiteX304" fmla="*/ 139102 w 556182"/>
                <a:gd name="connsiteY304" fmla="*/ 377406 h 512161"/>
                <a:gd name="connsiteX305" fmla="*/ 154900 w 556182"/>
                <a:gd name="connsiteY305" fmla="*/ 480192 h 512161"/>
                <a:gd name="connsiteX306" fmla="*/ 149229 w 556182"/>
                <a:gd name="connsiteY306" fmla="*/ 488285 h 512161"/>
                <a:gd name="connsiteX307" fmla="*/ 141128 w 556182"/>
                <a:gd name="connsiteY307" fmla="*/ 482215 h 512161"/>
                <a:gd name="connsiteX308" fmla="*/ 130191 w 556182"/>
                <a:gd name="connsiteY308" fmla="*/ 413826 h 512161"/>
                <a:gd name="connsiteX309" fmla="*/ 19201 w 556182"/>
                <a:gd name="connsiteY309" fmla="*/ 429204 h 512161"/>
                <a:gd name="connsiteX310" fmla="*/ 30138 w 556182"/>
                <a:gd name="connsiteY310" fmla="*/ 504067 h 512161"/>
                <a:gd name="connsiteX311" fmla="*/ 24062 w 556182"/>
                <a:gd name="connsiteY311" fmla="*/ 512161 h 512161"/>
                <a:gd name="connsiteX312" fmla="*/ 22847 w 556182"/>
                <a:gd name="connsiteY312" fmla="*/ 512161 h 512161"/>
                <a:gd name="connsiteX313" fmla="*/ 15556 w 556182"/>
                <a:gd name="connsiteY313" fmla="*/ 506091 h 512161"/>
                <a:gd name="connsiteX314" fmla="*/ 163 w 556182"/>
                <a:gd name="connsiteY314" fmla="*/ 399663 h 512161"/>
                <a:gd name="connsiteX315" fmla="*/ 13530 w 556182"/>
                <a:gd name="connsiteY315" fmla="*/ 379834 h 512161"/>
                <a:gd name="connsiteX316" fmla="*/ 8265 w 556182"/>
                <a:gd name="connsiteY316" fmla="*/ 300519 h 512161"/>
                <a:gd name="connsiteX317" fmla="*/ 9480 w 556182"/>
                <a:gd name="connsiteY317" fmla="*/ 286761 h 512161"/>
                <a:gd name="connsiteX318" fmla="*/ 10695 w 556182"/>
                <a:gd name="connsiteY318" fmla="*/ 282309 h 512161"/>
                <a:gd name="connsiteX319" fmla="*/ 45126 w 556182"/>
                <a:gd name="connsiteY319" fmla="*/ 213516 h 512161"/>
                <a:gd name="connsiteX320" fmla="*/ 56873 w 556182"/>
                <a:gd name="connsiteY320" fmla="*/ 201376 h 512161"/>
                <a:gd name="connsiteX321" fmla="*/ 56873 w 556182"/>
                <a:gd name="connsiteY321" fmla="*/ 182356 h 512161"/>
                <a:gd name="connsiteX322" fmla="*/ 77532 w 556182"/>
                <a:gd name="connsiteY322" fmla="*/ 161314 h 512161"/>
                <a:gd name="connsiteX323" fmla="*/ 104266 w 556182"/>
                <a:gd name="connsiteY323" fmla="*/ 161314 h 512161"/>
                <a:gd name="connsiteX324" fmla="*/ 101836 w 556182"/>
                <a:gd name="connsiteY324" fmla="*/ 144318 h 512161"/>
                <a:gd name="connsiteX325" fmla="*/ 134647 w 556182"/>
                <a:gd name="connsiteY325" fmla="*/ 111944 h 512161"/>
                <a:gd name="connsiteX326" fmla="*/ 207696 w 556182"/>
                <a:gd name="connsiteY326" fmla="*/ 76796 h 512161"/>
                <a:gd name="connsiteX327" fmla="*/ 215067 w 556182"/>
                <a:gd name="connsiteY327" fmla="*/ 84168 h 512161"/>
                <a:gd name="connsiteX328" fmla="*/ 215067 w 556182"/>
                <a:gd name="connsiteY328" fmla="*/ 101367 h 512161"/>
                <a:gd name="connsiteX329" fmla="*/ 232267 w 556182"/>
                <a:gd name="connsiteY329" fmla="*/ 101367 h 512161"/>
                <a:gd name="connsiteX330" fmla="*/ 239638 w 556182"/>
                <a:gd name="connsiteY330" fmla="*/ 108738 h 512161"/>
                <a:gd name="connsiteX331" fmla="*/ 232267 w 556182"/>
                <a:gd name="connsiteY331" fmla="*/ 116110 h 512161"/>
                <a:gd name="connsiteX332" fmla="*/ 215067 w 556182"/>
                <a:gd name="connsiteY332" fmla="*/ 116110 h 512161"/>
                <a:gd name="connsiteX333" fmla="*/ 215067 w 556182"/>
                <a:gd name="connsiteY333" fmla="*/ 133309 h 512161"/>
                <a:gd name="connsiteX334" fmla="*/ 207696 w 556182"/>
                <a:gd name="connsiteY334" fmla="*/ 140681 h 512161"/>
                <a:gd name="connsiteX335" fmla="*/ 200325 w 556182"/>
                <a:gd name="connsiteY335" fmla="*/ 133309 h 512161"/>
                <a:gd name="connsiteX336" fmla="*/ 200325 w 556182"/>
                <a:gd name="connsiteY336" fmla="*/ 116110 h 512161"/>
                <a:gd name="connsiteX337" fmla="*/ 183125 w 556182"/>
                <a:gd name="connsiteY337" fmla="*/ 116110 h 512161"/>
                <a:gd name="connsiteX338" fmla="*/ 175754 w 556182"/>
                <a:gd name="connsiteY338" fmla="*/ 108738 h 512161"/>
                <a:gd name="connsiteX339" fmla="*/ 183125 w 556182"/>
                <a:gd name="connsiteY339" fmla="*/ 101367 h 512161"/>
                <a:gd name="connsiteX340" fmla="*/ 200325 w 556182"/>
                <a:gd name="connsiteY340" fmla="*/ 101367 h 512161"/>
                <a:gd name="connsiteX341" fmla="*/ 200325 w 556182"/>
                <a:gd name="connsiteY341" fmla="*/ 84168 h 512161"/>
                <a:gd name="connsiteX342" fmla="*/ 207696 w 556182"/>
                <a:gd name="connsiteY342" fmla="*/ 76796 h 512161"/>
                <a:gd name="connsiteX343" fmla="*/ 354144 w 556182"/>
                <a:gd name="connsiteY343" fmla="*/ 51795 h 512161"/>
                <a:gd name="connsiteX344" fmla="*/ 361130 w 556182"/>
                <a:gd name="connsiteY344" fmla="*/ 58572 h 512161"/>
                <a:gd name="connsiteX345" fmla="*/ 361130 w 556182"/>
                <a:gd name="connsiteY345" fmla="*/ 66944 h 512161"/>
                <a:gd name="connsiteX346" fmla="*/ 369759 w 556182"/>
                <a:gd name="connsiteY346" fmla="*/ 66944 h 512161"/>
                <a:gd name="connsiteX347" fmla="*/ 377156 w 556182"/>
                <a:gd name="connsiteY347" fmla="*/ 73721 h 512161"/>
                <a:gd name="connsiteX348" fmla="*/ 369759 w 556182"/>
                <a:gd name="connsiteY348" fmla="*/ 80498 h 512161"/>
                <a:gd name="connsiteX349" fmla="*/ 361130 w 556182"/>
                <a:gd name="connsiteY349" fmla="*/ 80498 h 512161"/>
                <a:gd name="connsiteX350" fmla="*/ 361130 w 556182"/>
                <a:gd name="connsiteY350" fmla="*/ 88869 h 512161"/>
                <a:gd name="connsiteX351" fmla="*/ 354144 w 556182"/>
                <a:gd name="connsiteY351" fmla="*/ 96045 h 512161"/>
                <a:gd name="connsiteX352" fmla="*/ 346747 w 556182"/>
                <a:gd name="connsiteY352" fmla="*/ 88869 h 512161"/>
                <a:gd name="connsiteX353" fmla="*/ 346747 w 556182"/>
                <a:gd name="connsiteY353" fmla="*/ 80498 h 512161"/>
                <a:gd name="connsiteX354" fmla="*/ 338117 w 556182"/>
                <a:gd name="connsiteY354" fmla="*/ 80498 h 512161"/>
                <a:gd name="connsiteX355" fmla="*/ 331131 w 556182"/>
                <a:gd name="connsiteY355" fmla="*/ 73721 h 512161"/>
                <a:gd name="connsiteX356" fmla="*/ 338117 w 556182"/>
                <a:gd name="connsiteY356" fmla="*/ 66944 h 512161"/>
                <a:gd name="connsiteX357" fmla="*/ 346747 w 556182"/>
                <a:gd name="connsiteY357" fmla="*/ 66944 h 512161"/>
                <a:gd name="connsiteX358" fmla="*/ 346747 w 556182"/>
                <a:gd name="connsiteY358" fmla="*/ 58572 h 512161"/>
                <a:gd name="connsiteX359" fmla="*/ 354144 w 556182"/>
                <a:gd name="connsiteY359" fmla="*/ 51795 h 512161"/>
                <a:gd name="connsiteX360" fmla="*/ 278923 w 556182"/>
                <a:gd name="connsiteY360" fmla="*/ 0 h 512161"/>
                <a:gd name="connsiteX361" fmla="*/ 286399 w 556182"/>
                <a:gd name="connsiteY361" fmla="*/ 7390 h 512161"/>
                <a:gd name="connsiteX362" fmla="*/ 286399 w 556182"/>
                <a:gd name="connsiteY362" fmla="*/ 10675 h 512161"/>
                <a:gd name="connsiteX363" fmla="*/ 289307 w 556182"/>
                <a:gd name="connsiteY363" fmla="*/ 10675 h 512161"/>
                <a:gd name="connsiteX364" fmla="*/ 296783 w 556182"/>
                <a:gd name="connsiteY364" fmla="*/ 18065 h 512161"/>
                <a:gd name="connsiteX365" fmla="*/ 289307 w 556182"/>
                <a:gd name="connsiteY365" fmla="*/ 25045 h 512161"/>
                <a:gd name="connsiteX366" fmla="*/ 286399 w 556182"/>
                <a:gd name="connsiteY366" fmla="*/ 25045 h 512161"/>
                <a:gd name="connsiteX367" fmla="*/ 286399 w 556182"/>
                <a:gd name="connsiteY367" fmla="*/ 27919 h 512161"/>
                <a:gd name="connsiteX368" fmla="*/ 278923 w 556182"/>
                <a:gd name="connsiteY368" fmla="*/ 35309 h 512161"/>
                <a:gd name="connsiteX369" fmla="*/ 271863 w 556182"/>
                <a:gd name="connsiteY369" fmla="*/ 27919 h 512161"/>
                <a:gd name="connsiteX370" fmla="*/ 271863 w 556182"/>
                <a:gd name="connsiteY370" fmla="*/ 25045 h 512161"/>
                <a:gd name="connsiteX371" fmla="*/ 268540 w 556182"/>
                <a:gd name="connsiteY371" fmla="*/ 25045 h 512161"/>
                <a:gd name="connsiteX372" fmla="*/ 261479 w 556182"/>
                <a:gd name="connsiteY372" fmla="*/ 18065 h 512161"/>
                <a:gd name="connsiteX373" fmla="*/ 268540 w 556182"/>
                <a:gd name="connsiteY373" fmla="*/ 10675 h 512161"/>
                <a:gd name="connsiteX374" fmla="*/ 271863 w 556182"/>
                <a:gd name="connsiteY374" fmla="*/ 10675 h 512161"/>
                <a:gd name="connsiteX375" fmla="*/ 271863 w 556182"/>
                <a:gd name="connsiteY375" fmla="*/ 7390 h 512161"/>
                <a:gd name="connsiteX376" fmla="*/ 278923 w 556182"/>
                <a:gd name="connsiteY376" fmla="*/ 0 h 51216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 ang="0">
                  <a:pos x="connsiteX215" y="connsiteY215"/>
                </a:cxn>
                <a:cxn ang="0">
                  <a:pos x="connsiteX216" y="connsiteY216"/>
                </a:cxn>
                <a:cxn ang="0">
                  <a:pos x="connsiteX217" y="connsiteY217"/>
                </a:cxn>
                <a:cxn ang="0">
                  <a:pos x="connsiteX218" y="connsiteY218"/>
                </a:cxn>
                <a:cxn ang="0">
                  <a:pos x="connsiteX219" y="connsiteY219"/>
                </a:cxn>
                <a:cxn ang="0">
                  <a:pos x="connsiteX220" y="connsiteY220"/>
                </a:cxn>
                <a:cxn ang="0">
                  <a:pos x="connsiteX221" y="connsiteY221"/>
                </a:cxn>
                <a:cxn ang="0">
                  <a:pos x="connsiteX222" y="connsiteY222"/>
                </a:cxn>
                <a:cxn ang="0">
                  <a:pos x="connsiteX223" y="connsiteY223"/>
                </a:cxn>
                <a:cxn ang="0">
                  <a:pos x="connsiteX224" y="connsiteY224"/>
                </a:cxn>
                <a:cxn ang="0">
                  <a:pos x="connsiteX225" y="connsiteY225"/>
                </a:cxn>
                <a:cxn ang="0">
                  <a:pos x="connsiteX226" y="connsiteY226"/>
                </a:cxn>
                <a:cxn ang="0">
                  <a:pos x="connsiteX227" y="connsiteY227"/>
                </a:cxn>
                <a:cxn ang="0">
                  <a:pos x="connsiteX228" y="connsiteY228"/>
                </a:cxn>
                <a:cxn ang="0">
                  <a:pos x="connsiteX229" y="connsiteY229"/>
                </a:cxn>
                <a:cxn ang="0">
                  <a:pos x="connsiteX230" y="connsiteY230"/>
                </a:cxn>
                <a:cxn ang="0">
                  <a:pos x="connsiteX231" y="connsiteY231"/>
                </a:cxn>
                <a:cxn ang="0">
                  <a:pos x="connsiteX232" y="connsiteY232"/>
                </a:cxn>
                <a:cxn ang="0">
                  <a:pos x="connsiteX233" y="connsiteY233"/>
                </a:cxn>
                <a:cxn ang="0">
                  <a:pos x="connsiteX234" y="connsiteY234"/>
                </a:cxn>
                <a:cxn ang="0">
                  <a:pos x="connsiteX235" y="connsiteY235"/>
                </a:cxn>
                <a:cxn ang="0">
                  <a:pos x="connsiteX236" y="connsiteY236"/>
                </a:cxn>
                <a:cxn ang="0">
                  <a:pos x="connsiteX237" y="connsiteY237"/>
                </a:cxn>
                <a:cxn ang="0">
                  <a:pos x="connsiteX238" y="connsiteY238"/>
                </a:cxn>
                <a:cxn ang="0">
                  <a:pos x="connsiteX239" y="connsiteY239"/>
                </a:cxn>
                <a:cxn ang="0">
                  <a:pos x="connsiteX240" y="connsiteY240"/>
                </a:cxn>
                <a:cxn ang="0">
                  <a:pos x="connsiteX241" y="connsiteY241"/>
                </a:cxn>
                <a:cxn ang="0">
                  <a:pos x="connsiteX242" y="connsiteY242"/>
                </a:cxn>
                <a:cxn ang="0">
                  <a:pos x="connsiteX243" y="connsiteY243"/>
                </a:cxn>
                <a:cxn ang="0">
                  <a:pos x="connsiteX244" y="connsiteY244"/>
                </a:cxn>
                <a:cxn ang="0">
                  <a:pos x="connsiteX245" y="connsiteY245"/>
                </a:cxn>
                <a:cxn ang="0">
                  <a:pos x="connsiteX246" y="connsiteY246"/>
                </a:cxn>
                <a:cxn ang="0">
                  <a:pos x="connsiteX247" y="connsiteY247"/>
                </a:cxn>
                <a:cxn ang="0">
                  <a:pos x="connsiteX248" y="connsiteY248"/>
                </a:cxn>
                <a:cxn ang="0">
                  <a:pos x="connsiteX249" y="connsiteY249"/>
                </a:cxn>
                <a:cxn ang="0">
                  <a:pos x="connsiteX250" y="connsiteY250"/>
                </a:cxn>
                <a:cxn ang="0">
                  <a:pos x="connsiteX251" y="connsiteY251"/>
                </a:cxn>
                <a:cxn ang="0">
                  <a:pos x="connsiteX252" y="connsiteY252"/>
                </a:cxn>
                <a:cxn ang="0">
                  <a:pos x="connsiteX253" y="connsiteY253"/>
                </a:cxn>
                <a:cxn ang="0">
                  <a:pos x="connsiteX254" y="connsiteY254"/>
                </a:cxn>
                <a:cxn ang="0">
                  <a:pos x="connsiteX255" y="connsiteY255"/>
                </a:cxn>
                <a:cxn ang="0">
                  <a:pos x="connsiteX256" y="connsiteY256"/>
                </a:cxn>
                <a:cxn ang="0">
                  <a:pos x="connsiteX257" y="connsiteY257"/>
                </a:cxn>
                <a:cxn ang="0">
                  <a:pos x="connsiteX258" y="connsiteY258"/>
                </a:cxn>
                <a:cxn ang="0">
                  <a:pos x="connsiteX259" y="connsiteY259"/>
                </a:cxn>
                <a:cxn ang="0">
                  <a:pos x="connsiteX260" y="connsiteY260"/>
                </a:cxn>
                <a:cxn ang="0">
                  <a:pos x="connsiteX261" y="connsiteY261"/>
                </a:cxn>
                <a:cxn ang="0">
                  <a:pos x="connsiteX262" y="connsiteY262"/>
                </a:cxn>
                <a:cxn ang="0">
                  <a:pos x="connsiteX263" y="connsiteY263"/>
                </a:cxn>
                <a:cxn ang="0">
                  <a:pos x="connsiteX264" y="connsiteY264"/>
                </a:cxn>
                <a:cxn ang="0">
                  <a:pos x="connsiteX265" y="connsiteY265"/>
                </a:cxn>
                <a:cxn ang="0">
                  <a:pos x="connsiteX266" y="connsiteY266"/>
                </a:cxn>
                <a:cxn ang="0">
                  <a:pos x="connsiteX267" y="connsiteY267"/>
                </a:cxn>
                <a:cxn ang="0">
                  <a:pos x="connsiteX268" y="connsiteY268"/>
                </a:cxn>
                <a:cxn ang="0">
                  <a:pos x="connsiteX269" y="connsiteY269"/>
                </a:cxn>
                <a:cxn ang="0">
                  <a:pos x="connsiteX270" y="connsiteY270"/>
                </a:cxn>
                <a:cxn ang="0">
                  <a:pos x="connsiteX271" y="connsiteY271"/>
                </a:cxn>
                <a:cxn ang="0">
                  <a:pos x="connsiteX272" y="connsiteY272"/>
                </a:cxn>
                <a:cxn ang="0">
                  <a:pos x="connsiteX273" y="connsiteY273"/>
                </a:cxn>
                <a:cxn ang="0">
                  <a:pos x="connsiteX274" y="connsiteY274"/>
                </a:cxn>
                <a:cxn ang="0">
                  <a:pos x="connsiteX275" y="connsiteY275"/>
                </a:cxn>
                <a:cxn ang="0">
                  <a:pos x="connsiteX276" y="connsiteY276"/>
                </a:cxn>
                <a:cxn ang="0">
                  <a:pos x="connsiteX277" y="connsiteY277"/>
                </a:cxn>
                <a:cxn ang="0">
                  <a:pos x="connsiteX278" y="connsiteY278"/>
                </a:cxn>
                <a:cxn ang="0">
                  <a:pos x="connsiteX279" y="connsiteY279"/>
                </a:cxn>
                <a:cxn ang="0">
                  <a:pos x="connsiteX280" y="connsiteY280"/>
                </a:cxn>
                <a:cxn ang="0">
                  <a:pos x="connsiteX281" y="connsiteY281"/>
                </a:cxn>
                <a:cxn ang="0">
                  <a:pos x="connsiteX282" y="connsiteY282"/>
                </a:cxn>
                <a:cxn ang="0">
                  <a:pos x="connsiteX283" y="connsiteY283"/>
                </a:cxn>
                <a:cxn ang="0">
                  <a:pos x="connsiteX284" y="connsiteY284"/>
                </a:cxn>
                <a:cxn ang="0">
                  <a:pos x="connsiteX285" y="connsiteY285"/>
                </a:cxn>
                <a:cxn ang="0">
                  <a:pos x="connsiteX286" y="connsiteY286"/>
                </a:cxn>
                <a:cxn ang="0">
                  <a:pos x="connsiteX287" y="connsiteY287"/>
                </a:cxn>
                <a:cxn ang="0">
                  <a:pos x="connsiteX288" y="connsiteY288"/>
                </a:cxn>
                <a:cxn ang="0">
                  <a:pos x="connsiteX289" y="connsiteY289"/>
                </a:cxn>
                <a:cxn ang="0">
                  <a:pos x="connsiteX290" y="connsiteY290"/>
                </a:cxn>
                <a:cxn ang="0">
                  <a:pos x="connsiteX291" y="connsiteY291"/>
                </a:cxn>
                <a:cxn ang="0">
                  <a:pos x="connsiteX292" y="connsiteY292"/>
                </a:cxn>
                <a:cxn ang="0">
                  <a:pos x="connsiteX293" y="connsiteY293"/>
                </a:cxn>
                <a:cxn ang="0">
                  <a:pos x="connsiteX294" y="connsiteY294"/>
                </a:cxn>
                <a:cxn ang="0">
                  <a:pos x="connsiteX295" y="connsiteY295"/>
                </a:cxn>
                <a:cxn ang="0">
                  <a:pos x="connsiteX296" y="connsiteY296"/>
                </a:cxn>
                <a:cxn ang="0">
                  <a:pos x="connsiteX297" y="connsiteY297"/>
                </a:cxn>
                <a:cxn ang="0">
                  <a:pos x="connsiteX298" y="connsiteY298"/>
                </a:cxn>
                <a:cxn ang="0">
                  <a:pos x="connsiteX299" y="connsiteY299"/>
                </a:cxn>
                <a:cxn ang="0">
                  <a:pos x="connsiteX300" y="connsiteY300"/>
                </a:cxn>
                <a:cxn ang="0">
                  <a:pos x="connsiteX301" y="connsiteY301"/>
                </a:cxn>
                <a:cxn ang="0">
                  <a:pos x="connsiteX302" y="connsiteY302"/>
                </a:cxn>
                <a:cxn ang="0">
                  <a:pos x="connsiteX303" y="connsiteY303"/>
                </a:cxn>
                <a:cxn ang="0">
                  <a:pos x="connsiteX304" y="connsiteY304"/>
                </a:cxn>
                <a:cxn ang="0">
                  <a:pos x="connsiteX305" y="connsiteY305"/>
                </a:cxn>
                <a:cxn ang="0">
                  <a:pos x="connsiteX306" y="connsiteY306"/>
                </a:cxn>
                <a:cxn ang="0">
                  <a:pos x="connsiteX307" y="connsiteY307"/>
                </a:cxn>
                <a:cxn ang="0">
                  <a:pos x="connsiteX308" y="connsiteY308"/>
                </a:cxn>
                <a:cxn ang="0">
                  <a:pos x="connsiteX309" y="connsiteY309"/>
                </a:cxn>
                <a:cxn ang="0">
                  <a:pos x="connsiteX310" y="connsiteY310"/>
                </a:cxn>
                <a:cxn ang="0">
                  <a:pos x="connsiteX311" y="connsiteY311"/>
                </a:cxn>
                <a:cxn ang="0">
                  <a:pos x="connsiteX312" y="connsiteY312"/>
                </a:cxn>
                <a:cxn ang="0">
                  <a:pos x="connsiteX313" y="connsiteY313"/>
                </a:cxn>
                <a:cxn ang="0">
                  <a:pos x="connsiteX314" y="connsiteY314"/>
                </a:cxn>
                <a:cxn ang="0">
                  <a:pos x="connsiteX315" y="connsiteY315"/>
                </a:cxn>
                <a:cxn ang="0">
                  <a:pos x="connsiteX316" y="connsiteY316"/>
                </a:cxn>
                <a:cxn ang="0">
                  <a:pos x="connsiteX317" y="connsiteY317"/>
                </a:cxn>
                <a:cxn ang="0">
                  <a:pos x="connsiteX318" y="connsiteY318"/>
                </a:cxn>
                <a:cxn ang="0">
                  <a:pos x="connsiteX319" y="connsiteY319"/>
                </a:cxn>
                <a:cxn ang="0">
                  <a:pos x="connsiteX320" y="connsiteY320"/>
                </a:cxn>
                <a:cxn ang="0">
                  <a:pos x="connsiteX321" y="connsiteY321"/>
                </a:cxn>
                <a:cxn ang="0">
                  <a:pos x="connsiteX322" y="connsiteY322"/>
                </a:cxn>
                <a:cxn ang="0">
                  <a:pos x="connsiteX323" y="connsiteY323"/>
                </a:cxn>
                <a:cxn ang="0">
                  <a:pos x="connsiteX324" y="connsiteY324"/>
                </a:cxn>
                <a:cxn ang="0">
                  <a:pos x="connsiteX325" y="connsiteY325"/>
                </a:cxn>
                <a:cxn ang="0">
                  <a:pos x="connsiteX326" y="connsiteY326"/>
                </a:cxn>
                <a:cxn ang="0">
                  <a:pos x="connsiteX327" y="connsiteY327"/>
                </a:cxn>
                <a:cxn ang="0">
                  <a:pos x="connsiteX328" y="connsiteY328"/>
                </a:cxn>
                <a:cxn ang="0">
                  <a:pos x="connsiteX329" y="connsiteY329"/>
                </a:cxn>
                <a:cxn ang="0">
                  <a:pos x="connsiteX330" y="connsiteY330"/>
                </a:cxn>
                <a:cxn ang="0">
                  <a:pos x="connsiteX331" y="connsiteY331"/>
                </a:cxn>
                <a:cxn ang="0">
                  <a:pos x="connsiteX332" y="connsiteY332"/>
                </a:cxn>
                <a:cxn ang="0">
                  <a:pos x="connsiteX333" y="connsiteY333"/>
                </a:cxn>
                <a:cxn ang="0">
                  <a:pos x="connsiteX334" y="connsiteY334"/>
                </a:cxn>
                <a:cxn ang="0">
                  <a:pos x="connsiteX335" y="connsiteY335"/>
                </a:cxn>
                <a:cxn ang="0">
                  <a:pos x="connsiteX336" y="connsiteY336"/>
                </a:cxn>
                <a:cxn ang="0">
                  <a:pos x="connsiteX337" y="connsiteY337"/>
                </a:cxn>
                <a:cxn ang="0">
                  <a:pos x="connsiteX338" y="connsiteY338"/>
                </a:cxn>
                <a:cxn ang="0">
                  <a:pos x="connsiteX339" y="connsiteY339"/>
                </a:cxn>
                <a:cxn ang="0">
                  <a:pos x="connsiteX340" y="connsiteY340"/>
                </a:cxn>
                <a:cxn ang="0">
                  <a:pos x="connsiteX341" y="connsiteY341"/>
                </a:cxn>
                <a:cxn ang="0">
                  <a:pos x="connsiteX342" y="connsiteY342"/>
                </a:cxn>
                <a:cxn ang="0">
                  <a:pos x="connsiteX343" y="connsiteY343"/>
                </a:cxn>
                <a:cxn ang="0">
                  <a:pos x="connsiteX344" y="connsiteY344"/>
                </a:cxn>
                <a:cxn ang="0">
                  <a:pos x="connsiteX345" y="connsiteY345"/>
                </a:cxn>
                <a:cxn ang="0">
                  <a:pos x="connsiteX346" y="connsiteY346"/>
                </a:cxn>
                <a:cxn ang="0">
                  <a:pos x="connsiteX347" y="connsiteY347"/>
                </a:cxn>
                <a:cxn ang="0">
                  <a:pos x="connsiteX348" y="connsiteY348"/>
                </a:cxn>
                <a:cxn ang="0">
                  <a:pos x="connsiteX349" y="connsiteY349"/>
                </a:cxn>
                <a:cxn ang="0">
                  <a:pos x="connsiteX350" y="connsiteY350"/>
                </a:cxn>
                <a:cxn ang="0">
                  <a:pos x="connsiteX351" y="connsiteY351"/>
                </a:cxn>
                <a:cxn ang="0">
                  <a:pos x="connsiteX352" y="connsiteY352"/>
                </a:cxn>
                <a:cxn ang="0">
                  <a:pos x="connsiteX353" y="connsiteY353"/>
                </a:cxn>
                <a:cxn ang="0">
                  <a:pos x="connsiteX354" y="connsiteY354"/>
                </a:cxn>
                <a:cxn ang="0">
                  <a:pos x="connsiteX355" y="connsiteY355"/>
                </a:cxn>
                <a:cxn ang="0">
                  <a:pos x="connsiteX356" y="connsiteY356"/>
                </a:cxn>
                <a:cxn ang="0">
                  <a:pos x="connsiteX357" y="connsiteY357"/>
                </a:cxn>
                <a:cxn ang="0">
                  <a:pos x="connsiteX358" y="connsiteY358"/>
                </a:cxn>
                <a:cxn ang="0">
                  <a:pos x="connsiteX359" y="connsiteY359"/>
                </a:cxn>
                <a:cxn ang="0">
                  <a:pos x="connsiteX360" y="connsiteY360"/>
                </a:cxn>
                <a:cxn ang="0">
                  <a:pos x="connsiteX361" y="connsiteY361"/>
                </a:cxn>
                <a:cxn ang="0">
                  <a:pos x="connsiteX362" y="connsiteY362"/>
                </a:cxn>
                <a:cxn ang="0">
                  <a:pos x="connsiteX363" y="connsiteY363"/>
                </a:cxn>
                <a:cxn ang="0">
                  <a:pos x="connsiteX364" y="connsiteY364"/>
                </a:cxn>
                <a:cxn ang="0">
                  <a:pos x="connsiteX365" y="connsiteY365"/>
                </a:cxn>
                <a:cxn ang="0">
                  <a:pos x="connsiteX366" y="connsiteY366"/>
                </a:cxn>
                <a:cxn ang="0">
                  <a:pos x="connsiteX367" y="connsiteY367"/>
                </a:cxn>
                <a:cxn ang="0">
                  <a:pos x="connsiteX368" y="connsiteY368"/>
                </a:cxn>
                <a:cxn ang="0">
                  <a:pos x="connsiteX369" y="connsiteY369"/>
                </a:cxn>
                <a:cxn ang="0">
                  <a:pos x="connsiteX370" y="connsiteY370"/>
                </a:cxn>
                <a:cxn ang="0">
                  <a:pos x="connsiteX371" y="connsiteY371"/>
                </a:cxn>
                <a:cxn ang="0">
                  <a:pos x="connsiteX372" y="connsiteY372"/>
                </a:cxn>
                <a:cxn ang="0">
                  <a:pos x="connsiteX373" y="connsiteY373"/>
                </a:cxn>
                <a:cxn ang="0">
                  <a:pos x="connsiteX374" y="connsiteY374"/>
                </a:cxn>
                <a:cxn ang="0">
                  <a:pos x="connsiteX375" y="connsiteY375"/>
                </a:cxn>
                <a:cxn ang="0">
                  <a:pos x="connsiteX376" y="connsiteY376"/>
                </a:cxn>
              </a:cxnLst>
              <a:rect l="l" t="t" r="r" b="b"/>
              <a:pathLst>
                <a:path w="556182" h="512161">
                  <a:moveTo>
                    <a:pt x="444116" y="383978"/>
                  </a:moveTo>
                  <a:cubicBezTo>
                    <a:pt x="448345" y="383978"/>
                    <a:pt x="452152" y="387785"/>
                    <a:pt x="452152" y="391592"/>
                  </a:cubicBezTo>
                  <a:cubicBezTo>
                    <a:pt x="452152" y="396244"/>
                    <a:pt x="448345" y="399628"/>
                    <a:pt x="444116" y="399628"/>
                  </a:cubicBezTo>
                  <a:cubicBezTo>
                    <a:pt x="439886" y="399628"/>
                    <a:pt x="436502" y="396244"/>
                    <a:pt x="436502" y="391592"/>
                  </a:cubicBezTo>
                  <a:cubicBezTo>
                    <a:pt x="436502" y="387785"/>
                    <a:pt x="439886" y="383978"/>
                    <a:pt x="444116" y="383978"/>
                  </a:cubicBezTo>
                  <a:close/>
                  <a:moveTo>
                    <a:pt x="112355" y="383978"/>
                  </a:moveTo>
                  <a:cubicBezTo>
                    <a:pt x="116585" y="383978"/>
                    <a:pt x="119969" y="387785"/>
                    <a:pt x="119969" y="391592"/>
                  </a:cubicBezTo>
                  <a:cubicBezTo>
                    <a:pt x="119969" y="396244"/>
                    <a:pt x="116585" y="399628"/>
                    <a:pt x="112355" y="399628"/>
                  </a:cubicBezTo>
                  <a:cubicBezTo>
                    <a:pt x="108126" y="399628"/>
                    <a:pt x="104319" y="396244"/>
                    <a:pt x="104319" y="391592"/>
                  </a:cubicBezTo>
                  <a:cubicBezTo>
                    <a:pt x="104319" y="387785"/>
                    <a:pt x="108126" y="383978"/>
                    <a:pt x="112355" y="383978"/>
                  </a:cubicBezTo>
                  <a:close/>
                  <a:moveTo>
                    <a:pt x="434805" y="377406"/>
                  </a:moveTo>
                  <a:cubicBezTo>
                    <a:pt x="433184" y="377002"/>
                    <a:pt x="431564" y="378216"/>
                    <a:pt x="431159" y="379834"/>
                  </a:cubicBezTo>
                  <a:lnTo>
                    <a:pt x="427918" y="399663"/>
                  </a:lnTo>
                  <a:lnTo>
                    <a:pt x="538908" y="415445"/>
                  </a:lnTo>
                  <a:lnTo>
                    <a:pt x="541743" y="397235"/>
                  </a:lnTo>
                  <a:cubicBezTo>
                    <a:pt x="542148" y="395616"/>
                    <a:pt x="540933" y="393998"/>
                    <a:pt x="539313" y="393593"/>
                  </a:cubicBezTo>
                  <a:close/>
                  <a:moveTo>
                    <a:pt x="121279" y="377406"/>
                  </a:moveTo>
                  <a:lnTo>
                    <a:pt x="16771" y="393593"/>
                  </a:lnTo>
                  <a:cubicBezTo>
                    <a:pt x="15151" y="393998"/>
                    <a:pt x="13936" y="395616"/>
                    <a:pt x="14341" y="397235"/>
                  </a:cubicBezTo>
                  <a:lnTo>
                    <a:pt x="16771" y="415445"/>
                  </a:lnTo>
                  <a:lnTo>
                    <a:pt x="128166" y="399663"/>
                  </a:lnTo>
                  <a:lnTo>
                    <a:pt x="124925" y="379834"/>
                  </a:lnTo>
                  <a:cubicBezTo>
                    <a:pt x="124520" y="379025"/>
                    <a:pt x="123710" y="378216"/>
                    <a:pt x="123710" y="377811"/>
                  </a:cubicBezTo>
                  <a:cubicBezTo>
                    <a:pt x="123305" y="377406"/>
                    <a:pt x="122495" y="377002"/>
                    <a:pt x="121279" y="377406"/>
                  </a:cubicBezTo>
                  <a:close/>
                  <a:moveTo>
                    <a:pt x="499211" y="222419"/>
                  </a:moveTo>
                  <a:lnTo>
                    <a:pt x="499211" y="283928"/>
                  </a:lnTo>
                  <a:cubicBezTo>
                    <a:pt x="499211" y="285547"/>
                    <a:pt x="499211" y="286761"/>
                    <a:pt x="499211" y="288379"/>
                  </a:cubicBezTo>
                  <a:cubicBezTo>
                    <a:pt x="500021" y="292831"/>
                    <a:pt x="499211" y="298091"/>
                    <a:pt x="495565" y="301733"/>
                  </a:cubicBezTo>
                  <a:cubicBezTo>
                    <a:pt x="491920" y="306185"/>
                    <a:pt x="486249" y="308208"/>
                    <a:pt x="480578" y="307803"/>
                  </a:cubicBezTo>
                  <a:cubicBezTo>
                    <a:pt x="474907" y="306589"/>
                    <a:pt x="470046" y="302947"/>
                    <a:pt x="467615" y="297687"/>
                  </a:cubicBezTo>
                  <a:lnTo>
                    <a:pt x="463970" y="288784"/>
                  </a:lnTo>
                  <a:cubicBezTo>
                    <a:pt x="461134" y="281500"/>
                    <a:pt x="453033" y="277453"/>
                    <a:pt x="446147" y="279881"/>
                  </a:cubicBezTo>
                  <a:cubicBezTo>
                    <a:pt x="440476" y="281905"/>
                    <a:pt x="436020" y="287165"/>
                    <a:pt x="436020" y="293235"/>
                  </a:cubicBezTo>
                  <a:lnTo>
                    <a:pt x="436020" y="294449"/>
                  </a:lnTo>
                  <a:lnTo>
                    <a:pt x="440881" y="363648"/>
                  </a:lnTo>
                  <a:lnTo>
                    <a:pt x="528376" y="377406"/>
                  </a:lnTo>
                  <a:lnTo>
                    <a:pt x="533237" y="299305"/>
                  </a:lnTo>
                  <a:cubicBezTo>
                    <a:pt x="533642" y="296068"/>
                    <a:pt x="533237" y="293235"/>
                    <a:pt x="532832" y="290807"/>
                  </a:cubicBezTo>
                  <a:cubicBezTo>
                    <a:pt x="532832" y="289593"/>
                    <a:pt x="532427" y="289593"/>
                    <a:pt x="532022" y="288784"/>
                  </a:cubicBezTo>
                  <a:close/>
                  <a:moveTo>
                    <a:pt x="56873" y="222014"/>
                  </a:moveTo>
                  <a:lnTo>
                    <a:pt x="23657" y="288784"/>
                  </a:lnTo>
                  <a:cubicBezTo>
                    <a:pt x="23657" y="289593"/>
                    <a:pt x="23252" y="289593"/>
                    <a:pt x="23252" y="290403"/>
                  </a:cubicBezTo>
                  <a:cubicBezTo>
                    <a:pt x="22442" y="293235"/>
                    <a:pt x="22442" y="296068"/>
                    <a:pt x="22442" y="299305"/>
                  </a:cubicBezTo>
                  <a:lnTo>
                    <a:pt x="27708" y="377406"/>
                  </a:lnTo>
                  <a:lnTo>
                    <a:pt x="115203" y="363648"/>
                  </a:lnTo>
                  <a:lnTo>
                    <a:pt x="120064" y="292831"/>
                  </a:lnTo>
                  <a:cubicBezTo>
                    <a:pt x="119659" y="287165"/>
                    <a:pt x="115608" y="281905"/>
                    <a:pt x="109937" y="279881"/>
                  </a:cubicBezTo>
                  <a:cubicBezTo>
                    <a:pt x="103051" y="277453"/>
                    <a:pt x="94950" y="281500"/>
                    <a:pt x="91709" y="288784"/>
                  </a:cubicBezTo>
                  <a:lnTo>
                    <a:pt x="88063" y="297687"/>
                  </a:lnTo>
                  <a:cubicBezTo>
                    <a:pt x="86038" y="302947"/>
                    <a:pt x="81177" y="306589"/>
                    <a:pt x="75101" y="307803"/>
                  </a:cubicBezTo>
                  <a:cubicBezTo>
                    <a:pt x="69430" y="308208"/>
                    <a:pt x="64164" y="306185"/>
                    <a:pt x="60519" y="301733"/>
                  </a:cubicBezTo>
                  <a:cubicBezTo>
                    <a:pt x="56873" y="297687"/>
                    <a:pt x="56063" y="292021"/>
                    <a:pt x="57278" y="287165"/>
                  </a:cubicBezTo>
                  <a:cubicBezTo>
                    <a:pt x="56873" y="285951"/>
                    <a:pt x="56873" y="285142"/>
                    <a:pt x="56873" y="283928"/>
                  </a:cubicBezTo>
                  <a:close/>
                  <a:moveTo>
                    <a:pt x="420222" y="126108"/>
                  </a:moveTo>
                  <a:cubicBezTo>
                    <a:pt x="413336" y="125298"/>
                    <a:pt x="407260" y="127322"/>
                    <a:pt x="402399" y="131773"/>
                  </a:cubicBezTo>
                  <a:cubicBezTo>
                    <a:pt x="397538" y="135820"/>
                    <a:pt x="395108" y="142294"/>
                    <a:pt x="395108" y="148769"/>
                  </a:cubicBezTo>
                  <a:cubicBezTo>
                    <a:pt x="395108" y="154030"/>
                    <a:pt x="397133" y="159695"/>
                    <a:pt x="400779" y="163742"/>
                  </a:cubicBezTo>
                  <a:cubicBezTo>
                    <a:pt x="402399" y="165765"/>
                    <a:pt x="403209" y="168598"/>
                    <a:pt x="401994" y="171430"/>
                  </a:cubicBezTo>
                  <a:cubicBezTo>
                    <a:pt x="400779" y="173858"/>
                    <a:pt x="398348" y="175882"/>
                    <a:pt x="395108" y="175882"/>
                  </a:cubicBezTo>
                  <a:lnTo>
                    <a:pt x="356626" y="175882"/>
                  </a:lnTo>
                  <a:cubicBezTo>
                    <a:pt x="352980" y="175882"/>
                    <a:pt x="350145" y="178714"/>
                    <a:pt x="350145" y="182356"/>
                  </a:cubicBezTo>
                  <a:lnTo>
                    <a:pt x="350145" y="196924"/>
                  </a:lnTo>
                  <a:lnTo>
                    <a:pt x="350145" y="211088"/>
                  </a:lnTo>
                  <a:cubicBezTo>
                    <a:pt x="350145" y="213921"/>
                    <a:pt x="348524" y="216349"/>
                    <a:pt x="345689" y="217563"/>
                  </a:cubicBezTo>
                  <a:cubicBezTo>
                    <a:pt x="343259" y="218372"/>
                    <a:pt x="340423" y="217967"/>
                    <a:pt x="337993" y="216349"/>
                  </a:cubicBezTo>
                  <a:cubicBezTo>
                    <a:pt x="335562" y="214325"/>
                    <a:pt x="333132" y="212706"/>
                    <a:pt x="330296" y="211897"/>
                  </a:cubicBezTo>
                  <a:cubicBezTo>
                    <a:pt x="329891" y="211492"/>
                    <a:pt x="329486" y="211492"/>
                    <a:pt x="329486" y="211492"/>
                  </a:cubicBezTo>
                  <a:cubicBezTo>
                    <a:pt x="327866" y="211088"/>
                    <a:pt x="326651" y="210683"/>
                    <a:pt x="325030" y="210683"/>
                  </a:cubicBezTo>
                  <a:cubicBezTo>
                    <a:pt x="325030" y="210683"/>
                    <a:pt x="325030" y="210683"/>
                    <a:pt x="324625" y="210683"/>
                  </a:cubicBezTo>
                  <a:cubicBezTo>
                    <a:pt x="323410" y="210278"/>
                    <a:pt x="321790" y="210278"/>
                    <a:pt x="320169" y="210683"/>
                  </a:cubicBezTo>
                  <a:cubicBezTo>
                    <a:pt x="310043" y="211897"/>
                    <a:pt x="301536" y="220395"/>
                    <a:pt x="300321" y="230512"/>
                  </a:cubicBezTo>
                  <a:cubicBezTo>
                    <a:pt x="299511" y="237391"/>
                    <a:pt x="301536" y="243461"/>
                    <a:pt x="305992" y="248317"/>
                  </a:cubicBezTo>
                  <a:cubicBezTo>
                    <a:pt x="306802" y="249531"/>
                    <a:pt x="308017" y="250341"/>
                    <a:pt x="309233" y="251150"/>
                  </a:cubicBezTo>
                  <a:cubicBezTo>
                    <a:pt x="309638" y="251555"/>
                    <a:pt x="310043" y="251959"/>
                    <a:pt x="310043" y="251959"/>
                  </a:cubicBezTo>
                  <a:cubicBezTo>
                    <a:pt x="311258" y="252364"/>
                    <a:pt x="312068" y="253173"/>
                    <a:pt x="312878" y="253173"/>
                  </a:cubicBezTo>
                  <a:cubicBezTo>
                    <a:pt x="313283" y="253578"/>
                    <a:pt x="313688" y="253578"/>
                    <a:pt x="313688" y="253983"/>
                  </a:cubicBezTo>
                  <a:cubicBezTo>
                    <a:pt x="314904" y="254387"/>
                    <a:pt x="316119" y="254792"/>
                    <a:pt x="317739" y="255197"/>
                  </a:cubicBezTo>
                  <a:cubicBezTo>
                    <a:pt x="318144" y="255601"/>
                    <a:pt x="318549" y="255601"/>
                    <a:pt x="319359" y="255601"/>
                  </a:cubicBezTo>
                  <a:cubicBezTo>
                    <a:pt x="319764" y="255601"/>
                    <a:pt x="320980" y="255601"/>
                    <a:pt x="321790" y="255601"/>
                  </a:cubicBezTo>
                  <a:cubicBezTo>
                    <a:pt x="322195" y="255601"/>
                    <a:pt x="323005" y="256006"/>
                    <a:pt x="323410" y="255601"/>
                  </a:cubicBezTo>
                  <a:cubicBezTo>
                    <a:pt x="324220" y="255601"/>
                    <a:pt x="324625" y="255601"/>
                    <a:pt x="325435" y="255601"/>
                  </a:cubicBezTo>
                  <a:cubicBezTo>
                    <a:pt x="326651" y="255601"/>
                    <a:pt x="327461" y="255601"/>
                    <a:pt x="328271" y="255197"/>
                  </a:cubicBezTo>
                  <a:cubicBezTo>
                    <a:pt x="331917" y="254387"/>
                    <a:pt x="335562" y="252364"/>
                    <a:pt x="337993" y="250341"/>
                  </a:cubicBezTo>
                  <a:cubicBezTo>
                    <a:pt x="340423" y="248317"/>
                    <a:pt x="343259" y="247508"/>
                    <a:pt x="345689" y="249127"/>
                  </a:cubicBezTo>
                  <a:cubicBezTo>
                    <a:pt x="348524" y="249936"/>
                    <a:pt x="350145" y="252364"/>
                    <a:pt x="350145" y="255601"/>
                  </a:cubicBezTo>
                  <a:lnTo>
                    <a:pt x="350145" y="269360"/>
                  </a:lnTo>
                  <a:lnTo>
                    <a:pt x="350145" y="283928"/>
                  </a:lnTo>
                  <a:cubicBezTo>
                    <a:pt x="350145" y="287570"/>
                    <a:pt x="352980" y="290807"/>
                    <a:pt x="356626" y="290807"/>
                  </a:cubicBezTo>
                  <a:lnTo>
                    <a:pt x="380930" y="290807"/>
                  </a:lnTo>
                  <a:cubicBezTo>
                    <a:pt x="380930" y="289189"/>
                    <a:pt x="380525" y="286356"/>
                    <a:pt x="380525" y="284333"/>
                  </a:cubicBezTo>
                  <a:cubicBezTo>
                    <a:pt x="380525" y="281905"/>
                    <a:pt x="380525" y="279477"/>
                    <a:pt x="380525" y="277858"/>
                  </a:cubicBezTo>
                  <a:cubicBezTo>
                    <a:pt x="380525" y="267741"/>
                    <a:pt x="385386" y="257220"/>
                    <a:pt x="392677" y="250341"/>
                  </a:cubicBezTo>
                  <a:cubicBezTo>
                    <a:pt x="400779" y="243461"/>
                    <a:pt x="410905" y="239819"/>
                    <a:pt x="421842" y="241033"/>
                  </a:cubicBezTo>
                  <a:cubicBezTo>
                    <a:pt x="435615" y="242652"/>
                    <a:pt x="447362" y="251959"/>
                    <a:pt x="452223" y="265313"/>
                  </a:cubicBezTo>
                  <a:cubicBezTo>
                    <a:pt x="462754" y="266123"/>
                    <a:pt x="472881" y="272597"/>
                    <a:pt x="477337" y="283523"/>
                  </a:cubicBezTo>
                  <a:lnTo>
                    <a:pt x="480173" y="290807"/>
                  </a:lnTo>
                  <a:cubicBezTo>
                    <a:pt x="483008" y="289593"/>
                    <a:pt x="485033" y="287165"/>
                    <a:pt x="485033" y="283928"/>
                  </a:cubicBezTo>
                  <a:lnTo>
                    <a:pt x="485033" y="182356"/>
                  </a:lnTo>
                  <a:cubicBezTo>
                    <a:pt x="485033" y="178714"/>
                    <a:pt x="482198" y="175882"/>
                    <a:pt x="478552" y="175882"/>
                  </a:cubicBezTo>
                  <a:lnTo>
                    <a:pt x="439665" y="175882"/>
                  </a:lnTo>
                  <a:cubicBezTo>
                    <a:pt x="436830" y="175882"/>
                    <a:pt x="434399" y="173858"/>
                    <a:pt x="433184" y="171430"/>
                  </a:cubicBezTo>
                  <a:cubicBezTo>
                    <a:pt x="432374" y="168598"/>
                    <a:pt x="432374" y="165765"/>
                    <a:pt x="434399" y="163742"/>
                  </a:cubicBezTo>
                  <a:cubicBezTo>
                    <a:pt x="438855" y="158886"/>
                    <a:pt x="440881" y="152816"/>
                    <a:pt x="440070" y="145936"/>
                  </a:cubicBezTo>
                  <a:cubicBezTo>
                    <a:pt x="438855" y="135820"/>
                    <a:pt x="430349" y="127322"/>
                    <a:pt x="420222" y="126108"/>
                  </a:cubicBezTo>
                  <a:close/>
                  <a:moveTo>
                    <a:pt x="275612" y="126108"/>
                  </a:moveTo>
                  <a:cubicBezTo>
                    <a:pt x="265485" y="127322"/>
                    <a:pt x="256978" y="135820"/>
                    <a:pt x="255763" y="145936"/>
                  </a:cubicBezTo>
                  <a:cubicBezTo>
                    <a:pt x="254953" y="152816"/>
                    <a:pt x="256978" y="158886"/>
                    <a:pt x="261434" y="163742"/>
                  </a:cubicBezTo>
                  <a:cubicBezTo>
                    <a:pt x="263054" y="165765"/>
                    <a:pt x="263865" y="168598"/>
                    <a:pt x="262649" y="171430"/>
                  </a:cubicBezTo>
                  <a:cubicBezTo>
                    <a:pt x="261434" y="173858"/>
                    <a:pt x="259003" y="175882"/>
                    <a:pt x="255763" y="175882"/>
                  </a:cubicBezTo>
                  <a:lnTo>
                    <a:pt x="227003" y="175882"/>
                  </a:lnTo>
                  <a:cubicBezTo>
                    <a:pt x="223762" y="175882"/>
                    <a:pt x="220522" y="178714"/>
                    <a:pt x="220522" y="182356"/>
                  </a:cubicBezTo>
                  <a:lnTo>
                    <a:pt x="220522" y="196924"/>
                  </a:lnTo>
                  <a:cubicBezTo>
                    <a:pt x="221332" y="196924"/>
                    <a:pt x="222547" y="197329"/>
                    <a:pt x="223357" y="197329"/>
                  </a:cubicBezTo>
                  <a:cubicBezTo>
                    <a:pt x="223762" y="197329"/>
                    <a:pt x="224167" y="197329"/>
                    <a:pt x="224167" y="197329"/>
                  </a:cubicBezTo>
                  <a:cubicBezTo>
                    <a:pt x="224572" y="197329"/>
                    <a:pt x="224977" y="197329"/>
                    <a:pt x="225383" y="197329"/>
                  </a:cubicBezTo>
                  <a:cubicBezTo>
                    <a:pt x="226598" y="196924"/>
                    <a:pt x="227408" y="196520"/>
                    <a:pt x="228218" y="196520"/>
                  </a:cubicBezTo>
                  <a:cubicBezTo>
                    <a:pt x="229028" y="196520"/>
                    <a:pt x="229028" y="196520"/>
                    <a:pt x="229433" y="196115"/>
                  </a:cubicBezTo>
                  <a:cubicBezTo>
                    <a:pt x="230243" y="196115"/>
                    <a:pt x="231459" y="196115"/>
                    <a:pt x="232674" y="196115"/>
                  </a:cubicBezTo>
                  <a:cubicBezTo>
                    <a:pt x="232674" y="196115"/>
                    <a:pt x="233079" y="196115"/>
                    <a:pt x="233484" y="196115"/>
                  </a:cubicBezTo>
                  <a:cubicBezTo>
                    <a:pt x="235104" y="196115"/>
                    <a:pt x="236319" y="196115"/>
                    <a:pt x="237535" y="196115"/>
                  </a:cubicBezTo>
                  <a:cubicBezTo>
                    <a:pt x="254548" y="198543"/>
                    <a:pt x="268320" y="211897"/>
                    <a:pt x="270346" y="228893"/>
                  </a:cubicBezTo>
                  <a:cubicBezTo>
                    <a:pt x="271561" y="239819"/>
                    <a:pt x="267915" y="250341"/>
                    <a:pt x="261029" y="258029"/>
                  </a:cubicBezTo>
                  <a:cubicBezTo>
                    <a:pt x="259814" y="259243"/>
                    <a:pt x="258598" y="260457"/>
                    <a:pt x="257788" y="261267"/>
                  </a:cubicBezTo>
                  <a:cubicBezTo>
                    <a:pt x="257383" y="261671"/>
                    <a:pt x="256978" y="261671"/>
                    <a:pt x="256573" y="261671"/>
                  </a:cubicBezTo>
                  <a:cubicBezTo>
                    <a:pt x="255763" y="262885"/>
                    <a:pt x="254548" y="263695"/>
                    <a:pt x="253332" y="264099"/>
                  </a:cubicBezTo>
                  <a:cubicBezTo>
                    <a:pt x="253332" y="264099"/>
                    <a:pt x="253332" y="264504"/>
                    <a:pt x="252927" y="264504"/>
                  </a:cubicBezTo>
                  <a:cubicBezTo>
                    <a:pt x="248472" y="267337"/>
                    <a:pt x="243611" y="268955"/>
                    <a:pt x="238750" y="269765"/>
                  </a:cubicBezTo>
                  <a:cubicBezTo>
                    <a:pt x="237130" y="270169"/>
                    <a:pt x="235104" y="270169"/>
                    <a:pt x="233484" y="270169"/>
                  </a:cubicBezTo>
                  <a:cubicBezTo>
                    <a:pt x="231864" y="270169"/>
                    <a:pt x="230243" y="270169"/>
                    <a:pt x="229028" y="269765"/>
                  </a:cubicBezTo>
                  <a:cubicBezTo>
                    <a:pt x="228623" y="269765"/>
                    <a:pt x="228623" y="269765"/>
                    <a:pt x="228218" y="269765"/>
                  </a:cubicBezTo>
                  <a:cubicBezTo>
                    <a:pt x="226598" y="269765"/>
                    <a:pt x="224977" y="269360"/>
                    <a:pt x="223357" y="268955"/>
                  </a:cubicBezTo>
                  <a:cubicBezTo>
                    <a:pt x="222547" y="268955"/>
                    <a:pt x="221332" y="269360"/>
                    <a:pt x="220522" y="269360"/>
                  </a:cubicBezTo>
                  <a:lnTo>
                    <a:pt x="220522" y="283928"/>
                  </a:lnTo>
                  <a:cubicBezTo>
                    <a:pt x="220522" y="287975"/>
                    <a:pt x="223762" y="290807"/>
                    <a:pt x="227003" y="290807"/>
                  </a:cubicBezTo>
                  <a:lnTo>
                    <a:pt x="255763" y="290807"/>
                  </a:lnTo>
                  <a:cubicBezTo>
                    <a:pt x="259003" y="290807"/>
                    <a:pt x="261434" y="292426"/>
                    <a:pt x="262649" y="295259"/>
                  </a:cubicBezTo>
                  <a:cubicBezTo>
                    <a:pt x="263865" y="297687"/>
                    <a:pt x="263054" y="300519"/>
                    <a:pt x="261434" y="302947"/>
                  </a:cubicBezTo>
                  <a:cubicBezTo>
                    <a:pt x="256978" y="307803"/>
                    <a:pt x="254953" y="313873"/>
                    <a:pt x="255763" y="320348"/>
                  </a:cubicBezTo>
                  <a:cubicBezTo>
                    <a:pt x="256978" y="330869"/>
                    <a:pt x="265485" y="338963"/>
                    <a:pt x="275612" y="340177"/>
                  </a:cubicBezTo>
                  <a:cubicBezTo>
                    <a:pt x="282093" y="340986"/>
                    <a:pt x="288169" y="338963"/>
                    <a:pt x="293030" y="334511"/>
                  </a:cubicBezTo>
                  <a:cubicBezTo>
                    <a:pt x="297891" y="330465"/>
                    <a:pt x="300726" y="324395"/>
                    <a:pt x="300726" y="317920"/>
                  </a:cubicBezTo>
                  <a:cubicBezTo>
                    <a:pt x="300726" y="312255"/>
                    <a:pt x="299106" y="306994"/>
                    <a:pt x="295055" y="302947"/>
                  </a:cubicBezTo>
                  <a:cubicBezTo>
                    <a:pt x="293030" y="300519"/>
                    <a:pt x="292625" y="297687"/>
                    <a:pt x="293840" y="295259"/>
                  </a:cubicBezTo>
                  <a:cubicBezTo>
                    <a:pt x="295055" y="292426"/>
                    <a:pt x="297891" y="290807"/>
                    <a:pt x="300321" y="290807"/>
                  </a:cubicBezTo>
                  <a:lnTo>
                    <a:pt x="329081" y="290807"/>
                  </a:lnTo>
                  <a:cubicBezTo>
                    <a:pt x="333132" y="290807"/>
                    <a:pt x="335562" y="287975"/>
                    <a:pt x="335562" y="284333"/>
                  </a:cubicBezTo>
                  <a:lnTo>
                    <a:pt x="335562" y="283928"/>
                  </a:lnTo>
                  <a:lnTo>
                    <a:pt x="335562" y="269360"/>
                  </a:lnTo>
                  <a:cubicBezTo>
                    <a:pt x="334752" y="269360"/>
                    <a:pt x="333942" y="268955"/>
                    <a:pt x="333132" y="268955"/>
                  </a:cubicBezTo>
                  <a:cubicBezTo>
                    <a:pt x="331106" y="269360"/>
                    <a:pt x="329486" y="269765"/>
                    <a:pt x="327866" y="269765"/>
                  </a:cubicBezTo>
                  <a:lnTo>
                    <a:pt x="327461" y="269765"/>
                  </a:lnTo>
                  <a:cubicBezTo>
                    <a:pt x="325840" y="270169"/>
                    <a:pt x="324625" y="270169"/>
                    <a:pt x="323005" y="270169"/>
                  </a:cubicBezTo>
                  <a:cubicBezTo>
                    <a:pt x="320980" y="270169"/>
                    <a:pt x="319359" y="270169"/>
                    <a:pt x="317334" y="269765"/>
                  </a:cubicBezTo>
                  <a:cubicBezTo>
                    <a:pt x="312473" y="268955"/>
                    <a:pt x="307612" y="267337"/>
                    <a:pt x="303562" y="264504"/>
                  </a:cubicBezTo>
                  <a:cubicBezTo>
                    <a:pt x="303156" y="264504"/>
                    <a:pt x="303156" y="264099"/>
                    <a:pt x="302751" y="264099"/>
                  </a:cubicBezTo>
                  <a:cubicBezTo>
                    <a:pt x="301536" y="263695"/>
                    <a:pt x="300726" y="262885"/>
                    <a:pt x="299511" y="261671"/>
                  </a:cubicBezTo>
                  <a:cubicBezTo>
                    <a:pt x="299511" y="261671"/>
                    <a:pt x="299106" y="261671"/>
                    <a:pt x="299106" y="261267"/>
                  </a:cubicBezTo>
                  <a:cubicBezTo>
                    <a:pt x="297891" y="260457"/>
                    <a:pt x="296675" y="259243"/>
                    <a:pt x="295460" y="258029"/>
                  </a:cubicBezTo>
                  <a:cubicBezTo>
                    <a:pt x="288169" y="250341"/>
                    <a:pt x="284928" y="239819"/>
                    <a:pt x="286143" y="228893"/>
                  </a:cubicBezTo>
                  <a:cubicBezTo>
                    <a:pt x="288169" y="211897"/>
                    <a:pt x="301536" y="198543"/>
                    <a:pt x="318549" y="196115"/>
                  </a:cubicBezTo>
                  <a:cubicBezTo>
                    <a:pt x="319764" y="196115"/>
                    <a:pt x="321385" y="196115"/>
                    <a:pt x="322600" y="196115"/>
                  </a:cubicBezTo>
                  <a:cubicBezTo>
                    <a:pt x="323410" y="196115"/>
                    <a:pt x="323410" y="196115"/>
                    <a:pt x="323815" y="196115"/>
                  </a:cubicBezTo>
                  <a:cubicBezTo>
                    <a:pt x="324625" y="196115"/>
                    <a:pt x="325840" y="196115"/>
                    <a:pt x="327056" y="196115"/>
                  </a:cubicBezTo>
                  <a:cubicBezTo>
                    <a:pt x="327056" y="196520"/>
                    <a:pt x="327461" y="196520"/>
                    <a:pt x="328271" y="196520"/>
                  </a:cubicBezTo>
                  <a:cubicBezTo>
                    <a:pt x="329081" y="196520"/>
                    <a:pt x="329891" y="196924"/>
                    <a:pt x="330701" y="197329"/>
                  </a:cubicBezTo>
                  <a:cubicBezTo>
                    <a:pt x="331106" y="197329"/>
                    <a:pt x="331917" y="197329"/>
                    <a:pt x="331917" y="197329"/>
                  </a:cubicBezTo>
                  <a:cubicBezTo>
                    <a:pt x="332322" y="197329"/>
                    <a:pt x="332727" y="197329"/>
                    <a:pt x="333132" y="197329"/>
                  </a:cubicBezTo>
                  <a:cubicBezTo>
                    <a:pt x="333942" y="197329"/>
                    <a:pt x="334752" y="196924"/>
                    <a:pt x="335562" y="196924"/>
                  </a:cubicBezTo>
                  <a:lnTo>
                    <a:pt x="335562" y="182356"/>
                  </a:lnTo>
                  <a:cubicBezTo>
                    <a:pt x="335562" y="178714"/>
                    <a:pt x="333132" y="175882"/>
                    <a:pt x="329081" y="175882"/>
                  </a:cubicBezTo>
                  <a:lnTo>
                    <a:pt x="300321" y="175882"/>
                  </a:lnTo>
                  <a:cubicBezTo>
                    <a:pt x="297891" y="175882"/>
                    <a:pt x="295055" y="173858"/>
                    <a:pt x="293840" y="171430"/>
                  </a:cubicBezTo>
                  <a:cubicBezTo>
                    <a:pt x="292625" y="168598"/>
                    <a:pt x="293030" y="165765"/>
                    <a:pt x="295055" y="163742"/>
                  </a:cubicBezTo>
                  <a:cubicBezTo>
                    <a:pt x="299106" y="159695"/>
                    <a:pt x="300726" y="154030"/>
                    <a:pt x="300726" y="148769"/>
                  </a:cubicBezTo>
                  <a:cubicBezTo>
                    <a:pt x="300726" y="142294"/>
                    <a:pt x="297891" y="135820"/>
                    <a:pt x="293030" y="131773"/>
                  </a:cubicBezTo>
                  <a:cubicBezTo>
                    <a:pt x="288169" y="127322"/>
                    <a:pt x="282093" y="125298"/>
                    <a:pt x="275612" y="126108"/>
                  </a:cubicBezTo>
                  <a:close/>
                  <a:moveTo>
                    <a:pt x="136267" y="126108"/>
                  </a:moveTo>
                  <a:cubicBezTo>
                    <a:pt x="125735" y="127322"/>
                    <a:pt x="117634" y="135820"/>
                    <a:pt x="116418" y="145936"/>
                  </a:cubicBezTo>
                  <a:cubicBezTo>
                    <a:pt x="115203" y="152816"/>
                    <a:pt x="117634" y="158886"/>
                    <a:pt x="121684" y="163742"/>
                  </a:cubicBezTo>
                  <a:cubicBezTo>
                    <a:pt x="123710" y="165765"/>
                    <a:pt x="124115" y="168598"/>
                    <a:pt x="122900" y="171430"/>
                  </a:cubicBezTo>
                  <a:cubicBezTo>
                    <a:pt x="122089" y="173858"/>
                    <a:pt x="119254" y="175882"/>
                    <a:pt x="116418" y="175882"/>
                  </a:cubicBezTo>
                  <a:lnTo>
                    <a:pt x="77532" y="175882"/>
                  </a:lnTo>
                  <a:cubicBezTo>
                    <a:pt x="73886" y="175882"/>
                    <a:pt x="71456" y="178714"/>
                    <a:pt x="71456" y="182356"/>
                  </a:cubicBezTo>
                  <a:lnTo>
                    <a:pt x="71456" y="283928"/>
                  </a:lnTo>
                  <a:cubicBezTo>
                    <a:pt x="71456" y="285951"/>
                    <a:pt x="72266" y="288784"/>
                    <a:pt x="75911" y="289593"/>
                  </a:cubicBezTo>
                  <a:lnTo>
                    <a:pt x="78747" y="283523"/>
                  </a:lnTo>
                  <a:cubicBezTo>
                    <a:pt x="83203" y="272597"/>
                    <a:pt x="93329" y="266123"/>
                    <a:pt x="103861" y="265313"/>
                  </a:cubicBezTo>
                  <a:cubicBezTo>
                    <a:pt x="108317" y="251959"/>
                    <a:pt x="120064" y="241843"/>
                    <a:pt x="134647" y="240224"/>
                  </a:cubicBezTo>
                  <a:cubicBezTo>
                    <a:pt x="145179" y="239010"/>
                    <a:pt x="155710" y="242247"/>
                    <a:pt x="163407" y="249531"/>
                  </a:cubicBezTo>
                  <a:cubicBezTo>
                    <a:pt x="171103" y="256411"/>
                    <a:pt x="175559" y="266527"/>
                    <a:pt x="175559" y="277049"/>
                  </a:cubicBezTo>
                  <a:cubicBezTo>
                    <a:pt x="175559" y="278667"/>
                    <a:pt x="175559" y="281095"/>
                    <a:pt x="175559" y="283523"/>
                  </a:cubicBezTo>
                  <a:cubicBezTo>
                    <a:pt x="175559" y="285547"/>
                    <a:pt x="175559" y="288379"/>
                    <a:pt x="175559" y="289593"/>
                  </a:cubicBezTo>
                  <a:lnTo>
                    <a:pt x="199863" y="289593"/>
                  </a:lnTo>
                  <a:cubicBezTo>
                    <a:pt x="202294" y="289593"/>
                    <a:pt x="206344" y="285951"/>
                    <a:pt x="206344" y="283928"/>
                  </a:cubicBezTo>
                  <a:lnTo>
                    <a:pt x="206344" y="269360"/>
                  </a:lnTo>
                  <a:lnTo>
                    <a:pt x="206344" y="255601"/>
                  </a:lnTo>
                  <a:cubicBezTo>
                    <a:pt x="206344" y="252364"/>
                    <a:pt x="207965" y="249936"/>
                    <a:pt x="210395" y="249127"/>
                  </a:cubicBezTo>
                  <a:cubicBezTo>
                    <a:pt x="213230" y="247508"/>
                    <a:pt x="216066" y="248317"/>
                    <a:pt x="218091" y="250341"/>
                  </a:cubicBezTo>
                  <a:cubicBezTo>
                    <a:pt x="220927" y="252364"/>
                    <a:pt x="224167" y="254387"/>
                    <a:pt x="227813" y="254792"/>
                  </a:cubicBezTo>
                  <a:cubicBezTo>
                    <a:pt x="229028" y="255601"/>
                    <a:pt x="229838" y="255601"/>
                    <a:pt x="230648" y="255601"/>
                  </a:cubicBezTo>
                  <a:cubicBezTo>
                    <a:pt x="231459" y="255601"/>
                    <a:pt x="232269" y="255601"/>
                    <a:pt x="232674" y="255601"/>
                  </a:cubicBezTo>
                  <a:cubicBezTo>
                    <a:pt x="233484" y="256006"/>
                    <a:pt x="233889" y="255601"/>
                    <a:pt x="234294" y="255601"/>
                  </a:cubicBezTo>
                  <a:cubicBezTo>
                    <a:pt x="235104" y="255601"/>
                    <a:pt x="236319" y="255601"/>
                    <a:pt x="237130" y="255601"/>
                  </a:cubicBezTo>
                  <a:cubicBezTo>
                    <a:pt x="237535" y="255601"/>
                    <a:pt x="238345" y="255601"/>
                    <a:pt x="238750" y="255197"/>
                  </a:cubicBezTo>
                  <a:cubicBezTo>
                    <a:pt x="239965" y="254792"/>
                    <a:pt x="241180" y="254387"/>
                    <a:pt x="242396" y="253983"/>
                  </a:cubicBezTo>
                  <a:cubicBezTo>
                    <a:pt x="242396" y="253578"/>
                    <a:pt x="243206" y="253578"/>
                    <a:pt x="243611" y="253173"/>
                  </a:cubicBezTo>
                  <a:cubicBezTo>
                    <a:pt x="244421" y="253173"/>
                    <a:pt x="245231" y="252364"/>
                    <a:pt x="246041" y="251959"/>
                  </a:cubicBezTo>
                  <a:cubicBezTo>
                    <a:pt x="246446" y="251959"/>
                    <a:pt x="246851" y="251555"/>
                    <a:pt x="247256" y="251150"/>
                  </a:cubicBezTo>
                  <a:cubicBezTo>
                    <a:pt x="248472" y="250341"/>
                    <a:pt x="249282" y="249531"/>
                    <a:pt x="250092" y="248317"/>
                  </a:cubicBezTo>
                  <a:cubicBezTo>
                    <a:pt x="254548" y="243461"/>
                    <a:pt x="256573" y="237391"/>
                    <a:pt x="255763" y="230512"/>
                  </a:cubicBezTo>
                  <a:cubicBezTo>
                    <a:pt x="254953" y="220395"/>
                    <a:pt x="246446" y="211897"/>
                    <a:pt x="236319" y="210683"/>
                  </a:cubicBezTo>
                  <a:cubicBezTo>
                    <a:pt x="234294" y="210278"/>
                    <a:pt x="232674" y="210278"/>
                    <a:pt x="231459" y="210683"/>
                  </a:cubicBezTo>
                  <a:cubicBezTo>
                    <a:pt x="231459" y="210683"/>
                    <a:pt x="231459" y="210683"/>
                    <a:pt x="231054" y="210683"/>
                  </a:cubicBezTo>
                  <a:cubicBezTo>
                    <a:pt x="229838" y="210683"/>
                    <a:pt x="228623" y="211088"/>
                    <a:pt x="227003" y="211492"/>
                  </a:cubicBezTo>
                  <a:cubicBezTo>
                    <a:pt x="226598" y="211492"/>
                    <a:pt x="226598" y="211492"/>
                    <a:pt x="226193" y="211897"/>
                  </a:cubicBezTo>
                  <a:cubicBezTo>
                    <a:pt x="223357" y="212706"/>
                    <a:pt x="220522" y="214325"/>
                    <a:pt x="218091" y="216349"/>
                  </a:cubicBezTo>
                  <a:cubicBezTo>
                    <a:pt x="216066" y="217967"/>
                    <a:pt x="213230" y="218372"/>
                    <a:pt x="210395" y="217563"/>
                  </a:cubicBezTo>
                  <a:cubicBezTo>
                    <a:pt x="207965" y="216349"/>
                    <a:pt x="206344" y="213921"/>
                    <a:pt x="206344" y="211088"/>
                  </a:cubicBezTo>
                  <a:lnTo>
                    <a:pt x="206344" y="196924"/>
                  </a:lnTo>
                  <a:lnTo>
                    <a:pt x="206344" y="182356"/>
                  </a:lnTo>
                  <a:cubicBezTo>
                    <a:pt x="206344" y="178714"/>
                    <a:pt x="203509" y="175882"/>
                    <a:pt x="199863" y="175882"/>
                  </a:cubicBezTo>
                  <a:lnTo>
                    <a:pt x="160976" y="175882"/>
                  </a:lnTo>
                  <a:cubicBezTo>
                    <a:pt x="158141" y="175882"/>
                    <a:pt x="155710" y="173858"/>
                    <a:pt x="154495" y="171430"/>
                  </a:cubicBezTo>
                  <a:cubicBezTo>
                    <a:pt x="153280" y="168598"/>
                    <a:pt x="153685" y="165765"/>
                    <a:pt x="155710" y="163742"/>
                  </a:cubicBezTo>
                  <a:cubicBezTo>
                    <a:pt x="159356" y="159695"/>
                    <a:pt x="161381" y="154030"/>
                    <a:pt x="161381" y="148769"/>
                  </a:cubicBezTo>
                  <a:cubicBezTo>
                    <a:pt x="161381" y="142294"/>
                    <a:pt x="158546" y="135820"/>
                    <a:pt x="153685" y="131773"/>
                  </a:cubicBezTo>
                  <a:cubicBezTo>
                    <a:pt x="148824" y="127322"/>
                    <a:pt x="143153" y="125298"/>
                    <a:pt x="136267" y="126108"/>
                  </a:cubicBezTo>
                  <a:close/>
                  <a:moveTo>
                    <a:pt x="134647" y="111944"/>
                  </a:moveTo>
                  <a:cubicBezTo>
                    <a:pt x="145179" y="110730"/>
                    <a:pt x="155710" y="113968"/>
                    <a:pt x="163407" y="121252"/>
                  </a:cubicBezTo>
                  <a:cubicBezTo>
                    <a:pt x="171103" y="128131"/>
                    <a:pt x="175559" y="138248"/>
                    <a:pt x="175559" y="148769"/>
                  </a:cubicBezTo>
                  <a:cubicBezTo>
                    <a:pt x="175559" y="152816"/>
                    <a:pt x="175154" y="157267"/>
                    <a:pt x="173533" y="161314"/>
                  </a:cubicBezTo>
                  <a:lnTo>
                    <a:pt x="199863" y="161314"/>
                  </a:lnTo>
                  <a:cubicBezTo>
                    <a:pt x="204724" y="161314"/>
                    <a:pt x="209585" y="163337"/>
                    <a:pt x="213230" y="166574"/>
                  </a:cubicBezTo>
                  <a:cubicBezTo>
                    <a:pt x="217281" y="163337"/>
                    <a:pt x="221737" y="161314"/>
                    <a:pt x="227003" y="161314"/>
                  </a:cubicBezTo>
                  <a:lnTo>
                    <a:pt x="243611" y="161314"/>
                  </a:lnTo>
                  <a:cubicBezTo>
                    <a:pt x="241180" y="156053"/>
                    <a:pt x="240775" y="150388"/>
                    <a:pt x="241180" y="144318"/>
                  </a:cubicBezTo>
                  <a:cubicBezTo>
                    <a:pt x="243206" y="127322"/>
                    <a:pt x="256978" y="113968"/>
                    <a:pt x="273991" y="111944"/>
                  </a:cubicBezTo>
                  <a:cubicBezTo>
                    <a:pt x="284523" y="110730"/>
                    <a:pt x="295055" y="113968"/>
                    <a:pt x="302751" y="121252"/>
                  </a:cubicBezTo>
                  <a:cubicBezTo>
                    <a:pt x="310853" y="128131"/>
                    <a:pt x="314904" y="138248"/>
                    <a:pt x="314904" y="148769"/>
                  </a:cubicBezTo>
                  <a:cubicBezTo>
                    <a:pt x="314904" y="152816"/>
                    <a:pt x="314498" y="157267"/>
                    <a:pt x="312878" y="161314"/>
                  </a:cubicBezTo>
                  <a:lnTo>
                    <a:pt x="329081" y="161314"/>
                  </a:lnTo>
                  <a:cubicBezTo>
                    <a:pt x="334347" y="161314"/>
                    <a:pt x="339208" y="163337"/>
                    <a:pt x="342853" y="166574"/>
                  </a:cubicBezTo>
                  <a:cubicBezTo>
                    <a:pt x="346499" y="163337"/>
                    <a:pt x="351360" y="161314"/>
                    <a:pt x="356626" y="161314"/>
                  </a:cubicBezTo>
                  <a:lnTo>
                    <a:pt x="382955" y="161314"/>
                  </a:lnTo>
                  <a:cubicBezTo>
                    <a:pt x="381335" y="157267"/>
                    <a:pt x="380525" y="152816"/>
                    <a:pt x="380525" y="148769"/>
                  </a:cubicBezTo>
                  <a:cubicBezTo>
                    <a:pt x="380525" y="138248"/>
                    <a:pt x="385386" y="128131"/>
                    <a:pt x="392677" y="121252"/>
                  </a:cubicBezTo>
                  <a:cubicBezTo>
                    <a:pt x="400779" y="113968"/>
                    <a:pt x="410905" y="110730"/>
                    <a:pt x="421842" y="111944"/>
                  </a:cubicBezTo>
                  <a:cubicBezTo>
                    <a:pt x="438450" y="113968"/>
                    <a:pt x="452223" y="127322"/>
                    <a:pt x="454248" y="144318"/>
                  </a:cubicBezTo>
                  <a:cubicBezTo>
                    <a:pt x="455058" y="150388"/>
                    <a:pt x="454248" y="156053"/>
                    <a:pt x="452223" y="161314"/>
                  </a:cubicBezTo>
                  <a:lnTo>
                    <a:pt x="478552" y="161314"/>
                  </a:lnTo>
                  <a:cubicBezTo>
                    <a:pt x="489894" y="161314"/>
                    <a:pt x="499211" y="171026"/>
                    <a:pt x="499211" y="182356"/>
                  </a:cubicBezTo>
                  <a:lnTo>
                    <a:pt x="499211" y="201376"/>
                  </a:lnTo>
                  <a:cubicBezTo>
                    <a:pt x="504072" y="204208"/>
                    <a:pt x="508122" y="208255"/>
                    <a:pt x="510958" y="213516"/>
                  </a:cubicBezTo>
                  <a:lnTo>
                    <a:pt x="544984" y="282309"/>
                  </a:lnTo>
                  <a:cubicBezTo>
                    <a:pt x="545794" y="283523"/>
                    <a:pt x="546199" y="284737"/>
                    <a:pt x="546604" y="286761"/>
                  </a:cubicBezTo>
                  <a:cubicBezTo>
                    <a:pt x="547819" y="290807"/>
                    <a:pt x="547819" y="295259"/>
                    <a:pt x="547819" y="300519"/>
                  </a:cubicBezTo>
                  <a:lnTo>
                    <a:pt x="542148" y="379834"/>
                  </a:lnTo>
                  <a:cubicBezTo>
                    <a:pt x="551465" y="381858"/>
                    <a:pt x="557541" y="390356"/>
                    <a:pt x="555921" y="399663"/>
                  </a:cubicBezTo>
                  <a:lnTo>
                    <a:pt x="539313" y="506091"/>
                  </a:lnTo>
                  <a:cubicBezTo>
                    <a:pt x="538503" y="509733"/>
                    <a:pt x="535667" y="512161"/>
                    <a:pt x="532022" y="512161"/>
                  </a:cubicBezTo>
                  <a:cubicBezTo>
                    <a:pt x="531617" y="512161"/>
                    <a:pt x="531211" y="512161"/>
                    <a:pt x="530806" y="512161"/>
                  </a:cubicBezTo>
                  <a:cubicBezTo>
                    <a:pt x="527161" y="511351"/>
                    <a:pt x="524325" y="507709"/>
                    <a:pt x="524730" y="503663"/>
                  </a:cubicBezTo>
                  <a:lnTo>
                    <a:pt x="536882" y="429204"/>
                  </a:lnTo>
                  <a:lnTo>
                    <a:pt x="425893" y="413826"/>
                  </a:lnTo>
                  <a:lnTo>
                    <a:pt x="415361" y="482215"/>
                  </a:lnTo>
                  <a:cubicBezTo>
                    <a:pt x="414551" y="486262"/>
                    <a:pt x="410905" y="489095"/>
                    <a:pt x="406855" y="488285"/>
                  </a:cubicBezTo>
                  <a:cubicBezTo>
                    <a:pt x="402804" y="487881"/>
                    <a:pt x="400374" y="484238"/>
                    <a:pt x="401184" y="480192"/>
                  </a:cubicBezTo>
                  <a:lnTo>
                    <a:pt x="416981" y="377406"/>
                  </a:lnTo>
                  <a:cubicBezTo>
                    <a:pt x="418197" y="372955"/>
                    <a:pt x="420627" y="368908"/>
                    <a:pt x="424273" y="366076"/>
                  </a:cubicBezTo>
                  <a:cubicBezTo>
                    <a:pt x="425083" y="365671"/>
                    <a:pt x="425893" y="365266"/>
                    <a:pt x="426703" y="364457"/>
                  </a:cubicBezTo>
                  <a:lnTo>
                    <a:pt x="421842" y="295663"/>
                  </a:lnTo>
                  <a:cubicBezTo>
                    <a:pt x="421842" y="294854"/>
                    <a:pt x="421842" y="293235"/>
                    <a:pt x="421842" y="293235"/>
                  </a:cubicBezTo>
                  <a:cubicBezTo>
                    <a:pt x="422247" y="282309"/>
                    <a:pt x="428728" y="272597"/>
                    <a:pt x="438045" y="267741"/>
                  </a:cubicBezTo>
                  <a:cubicBezTo>
                    <a:pt x="434805" y="261267"/>
                    <a:pt x="427513" y="256006"/>
                    <a:pt x="420222" y="255601"/>
                  </a:cubicBezTo>
                  <a:cubicBezTo>
                    <a:pt x="413336" y="254387"/>
                    <a:pt x="407260" y="256815"/>
                    <a:pt x="402399" y="261267"/>
                  </a:cubicBezTo>
                  <a:cubicBezTo>
                    <a:pt x="397538" y="265313"/>
                    <a:pt x="395108" y="271383"/>
                    <a:pt x="395108" y="277858"/>
                  </a:cubicBezTo>
                  <a:cubicBezTo>
                    <a:pt x="395108" y="279072"/>
                    <a:pt x="395108" y="281500"/>
                    <a:pt x="395108" y="283523"/>
                  </a:cubicBezTo>
                  <a:cubicBezTo>
                    <a:pt x="395108" y="289593"/>
                    <a:pt x="395513" y="292426"/>
                    <a:pt x="395108" y="294045"/>
                  </a:cubicBezTo>
                  <a:cubicBezTo>
                    <a:pt x="393892" y="300519"/>
                    <a:pt x="388626" y="304971"/>
                    <a:pt x="382145" y="304971"/>
                  </a:cubicBezTo>
                  <a:lnTo>
                    <a:pt x="356626" y="304971"/>
                  </a:lnTo>
                  <a:cubicBezTo>
                    <a:pt x="351360" y="304971"/>
                    <a:pt x="346499" y="302947"/>
                    <a:pt x="342853" y="299710"/>
                  </a:cubicBezTo>
                  <a:cubicBezTo>
                    <a:pt x="339208" y="302947"/>
                    <a:pt x="334347" y="305375"/>
                    <a:pt x="329081" y="305375"/>
                  </a:cubicBezTo>
                  <a:lnTo>
                    <a:pt x="312878" y="305375"/>
                  </a:lnTo>
                  <a:cubicBezTo>
                    <a:pt x="314498" y="309017"/>
                    <a:pt x="314904" y="313469"/>
                    <a:pt x="314904" y="317920"/>
                  </a:cubicBezTo>
                  <a:cubicBezTo>
                    <a:pt x="314904" y="328441"/>
                    <a:pt x="310853" y="338153"/>
                    <a:pt x="302751" y="345437"/>
                  </a:cubicBezTo>
                  <a:cubicBezTo>
                    <a:pt x="296270" y="351508"/>
                    <a:pt x="287359" y="354745"/>
                    <a:pt x="278042" y="354745"/>
                  </a:cubicBezTo>
                  <a:cubicBezTo>
                    <a:pt x="276827" y="354745"/>
                    <a:pt x="275207" y="354745"/>
                    <a:pt x="273991" y="354745"/>
                  </a:cubicBezTo>
                  <a:cubicBezTo>
                    <a:pt x="256978" y="352722"/>
                    <a:pt x="243206" y="338963"/>
                    <a:pt x="241180" y="322371"/>
                  </a:cubicBezTo>
                  <a:cubicBezTo>
                    <a:pt x="240775" y="316301"/>
                    <a:pt x="241180" y="310231"/>
                    <a:pt x="243611" y="305375"/>
                  </a:cubicBezTo>
                  <a:lnTo>
                    <a:pt x="227003" y="305375"/>
                  </a:lnTo>
                  <a:cubicBezTo>
                    <a:pt x="221332" y="305375"/>
                    <a:pt x="216471" y="302947"/>
                    <a:pt x="212825" y="299305"/>
                  </a:cubicBezTo>
                  <a:cubicBezTo>
                    <a:pt x="208775" y="302138"/>
                    <a:pt x="204319" y="304161"/>
                    <a:pt x="199863" y="304161"/>
                  </a:cubicBezTo>
                  <a:lnTo>
                    <a:pt x="171103" y="304161"/>
                  </a:lnTo>
                  <a:cubicBezTo>
                    <a:pt x="169888" y="304161"/>
                    <a:pt x="168673" y="303757"/>
                    <a:pt x="167457" y="302947"/>
                  </a:cubicBezTo>
                  <a:cubicBezTo>
                    <a:pt x="164217" y="301329"/>
                    <a:pt x="161786" y="298091"/>
                    <a:pt x="160976" y="294045"/>
                  </a:cubicBezTo>
                  <a:cubicBezTo>
                    <a:pt x="160976" y="292426"/>
                    <a:pt x="160976" y="289593"/>
                    <a:pt x="160976" y="283119"/>
                  </a:cubicBezTo>
                  <a:cubicBezTo>
                    <a:pt x="161381" y="280691"/>
                    <a:pt x="161381" y="278667"/>
                    <a:pt x="161381" y="277049"/>
                  </a:cubicBezTo>
                  <a:cubicBezTo>
                    <a:pt x="161381" y="270574"/>
                    <a:pt x="158546" y="264504"/>
                    <a:pt x="153685" y="260457"/>
                  </a:cubicBezTo>
                  <a:cubicBezTo>
                    <a:pt x="148824" y="255601"/>
                    <a:pt x="143153" y="253578"/>
                    <a:pt x="136267" y="254387"/>
                  </a:cubicBezTo>
                  <a:cubicBezTo>
                    <a:pt x="128166" y="255601"/>
                    <a:pt x="121279" y="260457"/>
                    <a:pt x="118039" y="267741"/>
                  </a:cubicBezTo>
                  <a:cubicBezTo>
                    <a:pt x="127760" y="272597"/>
                    <a:pt x="133837" y="282309"/>
                    <a:pt x="134242" y="292831"/>
                  </a:cubicBezTo>
                  <a:cubicBezTo>
                    <a:pt x="134242" y="293235"/>
                    <a:pt x="134242" y="294854"/>
                    <a:pt x="133837" y="295663"/>
                  </a:cubicBezTo>
                  <a:lnTo>
                    <a:pt x="129381" y="364457"/>
                  </a:lnTo>
                  <a:cubicBezTo>
                    <a:pt x="130191" y="365266"/>
                    <a:pt x="131001" y="365671"/>
                    <a:pt x="132216" y="366076"/>
                  </a:cubicBezTo>
                  <a:cubicBezTo>
                    <a:pt x="135862" y="368908"/>
                    <a:pt x="138292" y="372955"/>
                    <a:pt x="139102" y="377406"/>
                  </a:cubicBezTo>
                  <a:lnTo>
                    <a:pt x="154900" y="480192"/>
                  </a:lnTo>
                  <a:cubicBezTo>
                    <a:pt x="155710" y="484238"/>
                    <a:pt x="152875" y="487881"/>
                    <a:pt x="149229" y="488285"/>
                  </a:cubicBezTo>
                  <a:cubicBezTo>
                    <a:pt x="145584" y="489095"/>
                    <a:pt x="141938" y="486262"/>
                    <a:pt x="141128" y="482215"/>
                  </a:cubicBezTo>
                  <a:lnTo>
                    <a:pt x="130191" y="413826"/>
                  </a:lnTo>
                  <a:lnTo>
                    <a:pt x="19201" y="429204"/>
                  </a:lnTo>
                  <a:lnTo>
                    <a:pt x="30138" y="504067"/>
                  </a:lnTo>
                  <a:cubicBezTo>
                    <a:pt x="30138" y="507709"/>
                    <a:pt x="27708" y="511351"/>
                    <a:pt x="24062" y="512161"/>
                  </a:cubicBezTo>
                  <a:cubicBezTo>
                    <a:pt x="23657" y="512161"/>
                    <a:pt x="22847" y="512161"/>
                    <a:pt x="22847" y="512161"/>
                  </a:cubicBezTo>
                  <a:cubicBezTo>
                    <a:pt x="19201" y="512161"/>
                    <a:pt x="16366" y="509733"/>
                    <a:pt x="15556" y="506091"/>
                  </a:cubicBezTo>
                  <a:lnTo>
                    <a:pt x="163" y="399663"/>
                  </a:lnTo>
                  <a:cubicBezTo>
                    <a:pt x="-1052" y="390356"/>
                    <a:pt x="4619" y="381858"/>
                    <a:pt x="13530" y="379834"/>
                  </a:cubicBezTo>
                  <a:lnTo>
                    <a:pt x="8265" y="300519"/>
                  </a:lnTo>
                  <a:cubicBezTo>
                    <a:pt x="7859" y="295259"/>
                    <a:pt x="8265" y="290807"/>
                    <a:pt x="9480" y="286761"/>
                  </a:cubicBezTo>
                  <a:cubicBezTo>
                    <a:pt x="9480" y="284737"/>
                    <a:pt x="10290" y="283523"/>
                    <a:pt x="10695" y="282309"/>
                  </a:cubicBezTo>
                  <a:lnTo>
                    <a:pt x="45126" y="213516"/>
                  </a:lnTo>
                  <a:cubicBezTo>
                    <a:pt x="47556" y="208255"/>
                    <a:pt x="52012" y="204208"/>
                    <a:pt x="56873" y="201376"/>
                  </a:cubicBezTo>
                  <a:lnTo>
                    <a:pt x="56873" y="182356"/>
                  </a:lnTo>
                  <a:cubicBezTo>
                    <a:pt x="56873" y="171026"/>
                    <a:pt x="66595" y="161314"/>
                    <a:pt x="77532" y="161314"/>
                  </a:cubicBezTo>
                  <a:lnTo>
                    <a:pt x="104266" y="161314"/>
                  </a:lnTo>
                  <a:cubicBezTo>
                    <a:pt x="101836" y="156053"/>
                    <a:pt x="101431" y="150388"/>
                    <a:pt x="101836" y="144318"/>
                  </a:cubicBezTo>
                  <a:cubicBezTo>
                    <a:pt x="104266" y="127322"/>
                    <a:pt x="117634" y="113968"/>
                    <a:pt x="134647" y="111944"/>
                  </a:cubicBezTo>
                  <a:close/>
                  <a:moveTo>
                    <a:pt x="207696" y="76796"/>
                  </a:moveTo>
                  <a:cubicBezTo>
                    <a:pt x="211382" y="76796"/>
                    <a:pt x="215067" y="80072"/>
                    <a:pt x="215067" y="84168"/>
                  </a:cubicBezTo>
                  <a:lnTo>
                    <a:pt x="215067" y="101367"/>
                  </a:lnTo>
                  <a:lnTo>
                    <a:pt x="232267" y="101367"/>
                  </a:lnTo>
                  <a:cubicBezTo>
                    <a:pt x="236362" y="101367"/>
                    <a:pt x="239638" y="105053"/>
                    <a:pt x="239638" y="108738"/>
                  </a:cubicBezTo>
                  <a:cubicBezTo>
                    <a:pt x="239638" y="112834"/>
                    <a:pt x="236362" y="116110"/>
                    <a:pt x="232267" y="116110"/>
                  </a:cubicBezTo>
                  <a:lnTo>
                    <a:pt x="215067" y="116110"/>
                  </a:lnTo>
                  <a:lnTo>
                    <a:pt x="215067" y="133309"/>
                  </a:lnTo>
                  <a:cubicBezTo>
                    <a:pt x="215067" y="137405"/>
                    <a:pt x="211382" y="140681"/>
                    <a:pt x="207696" y="140681"/>
                  </a:cubicBezTo>
                  <a:cubicBezTo>
                    <a:pt x="203601" y="140681"/>
                    <a:pt x="200325" y="137405"/>
                    <a:pt x="200325" y="133309"/>
                  </a:cubicBezTo>
                  <a:lnTo>
                    <a:pt x="200325" y="116110"/>
                  </a:lnTo>
                  <a:lnTo>
                    <a:pt x="183125" y="116110"/>
                  </a:lnTo>
                  <a:cubicBezTo>
                    <a:pt x="179030" y="116110"/>
                    <a:pt x="175754" y="112834"/>
                    <a:pt x="175754" y="108738"/>
                  </a:cubicBezTo>
                  <a:cubicBezTo>
                    <a:pt x="175754" y="105053"/>
                    <a:pt x="179030" y="101367"/>
                    <a:pt x="183125" y="101367"/>
                  </a:cubicBezTo>
                  <a:lnTo>
                    <a:pt x="200325" y="101367"/>
                  </a:lnTo>
                  <a:lnTo>
                    <a:pt x="200325" y="84168"/>
                  </a:lnTo>
                  <a:cubicBezTo>
                    <a:pt x="200325" y="80072"/>
                    <a:pt x="203601" y="76796"/>
                    <a:pt x="207696" y="76796"/>
                  </a:cubicBezTo>
                  <a:close/>
                  <a:moveTo>
                    <a:pt x="354144" y="51795"/>
                  </a:moveTo>
                  <a:cubicBezTo>
                    <a:pt x="358253" y="51795"/>
                    <a:pt x="361130" y="54586"/>
                    <a:pt x="361130" y="58572"/>
                  </a:cubicBezTo>
                  <a:lnTo>
                    <a:pt x="361130" y="66944"/>
                  </a:lnTo>
                  <a:lnTo>
                    <a:pt x="369759" y="66944"/>
                  </a:lnTo>
                  <a:cubicBezTo>
                    <a:pt x="373458" y="66944"/>
                    <a:pt x="377156" y="69734"/>
                    <a:pt x="377156" y="73721"/>
                  </a:cubicBezTo>
                  <a:cubicBezTo>
                    <a:pt x="377156" y="77707"/>
                    <a:pt x="373458" y="80498"/>
                    <a:pt x="369759" y="80498"/>
                  </a:cubicBezTo>
                  <a:lnTo>
                    <a:pt x="361130" y="80498"/>
                  </a:lnTo>
                  <a:lnTo>
                    <a:pt x="361130" y="88869"/>
                  </a:lnTo>
                  <a:cubicBezTo>
                    <a:pt x="361130" y="92855"/>
                    <a:pt x="358253" y="96045"/>
                    <a:pt x="354144" y="96045"/>
                  </a:cubicBezTo>
                  <a:cubicBezTo>
                    <a:pt x="350034" y="96045"/>
                    <a:pt x="346747" y="92855"/>
                    <a:pt x="346747" y="88869"/>
                  </a:cubicBezTo>
                  <a:lnTo>
                    <a:pt x="346747" y="80498"/>
                  </a:lnTo>
                  <a:lnTo>
                    <a:pt x="338117" y="80498"/>
                  </a:lnTo>
                  <a:cubicBezTo>
                    <a:pt x="334008" y="80498"/>
                    <a:pt x="331131" y="77707"/>
                    <a:pt x="331131" y="73721"/>
                  </a:cubicBezTo>
                  <a:cubicBezTo>
                    <a:pt x="331131" y="69734"/>
                    <a:pt x="334008" y="66944"/>
                    <a:pt x="338117" y="66944"/>
                  </a:cubicBezTo>
                  <a:lnTo>
                    <a:pt x="346747" y="66944"/>
                  </a:lnTo>
                  <a:lnTo>
                    <a:pt x="346747" y="58572"/>
                  </a:lnTo>
                  <a:cubicBezTo>
                    <a:pt x="346747" y="54586"/>
                    <a:pt x="350034" y="51795"/>
                    <a:pt x="354144" y="51795"/>
                  </a:cubicBezTo>
                  <a:close/>
                  <a:moveTo>
                    <a:pt x="278923" y="0"/>
                  </a:moveTo>
                  <a:cubicBezTo>
                    <a:pt x="283077" y="0"/>
                    <a:pt x="286399" y="3285"/>
                    <a:pt x="286399" y="7390"/>
                  </a:cubicBezTo>
                  <a:lnTo>
                    <a:pt x="286399" y="10675"/>
                  </a:lnTo>
                  <a:lnTo>
                    <a:pt x="289307" y="10675"/>
                  </a:lnTo>
                  <a:cubicBezTo>
                    <a:pt x="293460" y="10675"/>
                    <a:pt x="296783" y="13959"/>
                    <a:pt x="296783" y="18065"/>
                  </a:cubicBezTo>
                  <a:cubicBezTo>
                    <a:pt x="296783" y="21760"/>
                    <a:pt x="293460" y="25045"/>
                    <a:pt x="289307" y="25045"/>
                  </a:cubicBezTo>
                  <a:lnTo>
                    <a:pt x="286399" y="25045"/>
                  </a:lnTo>
                  <a:lnTo>
                    <a:pt x="286399" y="27919"/>
                  </a:lnTo>
                  <a:cubicBezTo>
                    <a:pt x="286399" y="32024"/>
                    <a:pt x="283077" y="35309"/>
                    <a:pt x="278923" y="35309"/>
                  </a:cubicBezTo>
                  <a:cubicBezTo>
                    <a:pt x="274770" y="35309"/>
                    <a:pt x="271863" y="32024"/>
                    <a:pt x="271863" y="27919"/>
                  </a:cubicBezTo>
                  <a:lnTo>
                    <a:pt x="271863" y="25045"/>
                  </a:lnTo>
                  <a:lnTo>
                    <a:pt x="268540" y="25045"/>
                  </a:lnTo>
                  <a:cubicBezTo>
                    <a:pt x="264802" y="25045"/>
                    <a:pt x="261479" y="21760"/>
                    <a:pt x="261479" y="18065"/>
                  </a:cubicBezTo>
                  <a:cubicBezTo>
                    <a:pt x="261479" y="13959"/>
                    <a:pt x="264802" y="10675"/>
                    <a:pt x="268540" y="10675"/>
                  </a:cubicBezTo>
                  <a:lnTo>
                    <a:pt x="271863" y="10675"/>
                  </a:lnTo>
                  <a:lnTo>
                    <a:pt x="271863" y="7390"/>
                  </a:lnTo>
                  <a:cubicBezTo>
                    <a:pt x="271863" y="3285"/>
                    <a:pt x="274770" y="0"/>
                    <a:pt x="278923" y="0"/>
                  </a:cubicBezTo>
                  <a:close/>
                </a:path>
              </a:pathLst>
            </a:custGeom>
            <a:solidFill>
              <a:srgbClr val="FFFFFF"/>
            </a:solidFill>
            <a:ln>
              <a:noFill/>
            </a:ln>
            <a:effectLst/>
          </p:spPr>
          <p:txBody>
            <a:bodyPr wrap="square" anchor="ctr">
              <a:noAutofit/>
            </a:bodyP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272" b="0" i="0" u="none" strike="noStrike" kern="0" cap="none" spc="0" normalizeH="0" baseline="0" noProof="0">
                <a:ln>
                  <a:noFill/>
                </a:ln>
                <a:solidFill>
                  <a:srgbClr val="272727"/>
                </a:solidFill>
                <a:effectLst/>
                <a:uLnTx/>
                <a:uFillTx/>
                <a:latin typeface="Tw Cen MT" panose="020B0602020104020603" pitchFamily="34" charset="77"/>
              </a:endParaRPr>
            </a:p>
          </p:txBody>
        </p:sp>
        <p:sp>
          <p:nvSpPr>
            <p:cNvPr id="58" name="Freeform 57">
              <a:extLst>
                <a:ext uri="{FF2B5EF4-FFF2-40B4-BE49-F238E27FC236}">
                  <a16:creationId xmlns:a16="http://schemas.microsoft.com/office/drawing/2014/main" id="{DB1AF0C3-4614-E743-970F-76904E67EA91}"/>
                </a:ext>
              </a:extLst>
            </p:cNvPr>
            <p:cNvSpPr>
              <a:spLocks noChangeArrowheads="1"/>
            </p:cNvSpPr>
            <p:nvPr/>
          </p:nvSpPr>
          <p:spPr bwMode="auto">
            <a:xfrm>
              <a:off x="12702300" y="6263283"/>
              <a:ext cx="1237171" cy="1207243"/>
            </a:xfrm>
            <a:custGeom>
              <a:avLst/>
              <a:gdLst>
                <a:gd name="connsiteX0" fmla="*/ 375077 w 517152"/>
                <a:gd name="connsiteY0" fmla="*/ 398262 h 504641"/>
                <a:gd name="connsiteX1" fmla="*/ 386006 w 517152"/>
                <a:gd name="connsiteY1" fmla="*/ 398262 h 504641"/>
                <a:gd name="connsiteX2" fmla="*/ 400173 w 517152"/>
                <a:gd name="connsiteY2" fmla="*/ 406818 h 504641"/>
                <a:gd name="connsiteX3" fmla="*/ 409483 w 517152"/>
                <a:gd name="connsiteY3" fmla="*/ 422708 h 504641"/>
                <a:gd name="connsiteX4" fmla="*/ 421221 w 517152"/>
                <a:gd name="connsiteY4" fmla="*/ 429635 h 504641"/>
                <a:gd name="connsiteX5" fmla="*/ 432959 w 517152"/>
                <a:gd name="connsiteY5" fmla="*/ 422708 h 504641"/>
                <a:gd name="connsiteX6" fmla="*/ 442269 w 517152"/>
                <a:gd name="connsiteY6" fmla="*/ 406818 h 504641"/>
                <a:gd name="connsiteX7" fmla="*/ 456436 w 517152"/>
                <a:gd name="connsiteY7" fmla="*/ 398262 h 504641"/>
                <a:gd name="connsiteX8" fmla="*/ 467770 w 517152"/>
                <a:gd name="connsiteY8" fmla="*/ 398262 h 504641"/>
                <a:gd name="connsiteX9" fmla="*/ 512295 w 517152"/>
                <a:gd name="connsiteY9" fmla="*/ 440636 h 504641"/>
                <a:gd name="connsiteX10" fmla="*/ 517152 w 517152"/>
                <a:gd name="connsiteY10" fmla="*/ 496862 h 504641"/>
                <a:gd name="connsiteX11" fmla="*/ 510676 w 517152"/>
                <a:gd name="connsiteY11" fmla="*/ 504603 h 504641"/>
                <a:gd name="connsiteX12" fmla="*/ 502985 w 517152"/>
                <a:gd name="connsiteY12" fmla="*/ 498084 h 504641"/>
                <a:gd name="connsiteX13" fmla="*/ 498128 w 517152"/>
                <a:gd name="connsiteY13" fmla="*/ 442265 h 504641"/>
                <a:gd name="connsiteX14" fmla="*/ 467770 w 517152"/>
                <a:gd name="connsiteY14" fmla="*/ 412930 h 504641"/>
                <a:gd name="connsiteX15" fmla="*/ 456436 w 517152"/>
                <a:gd name="connsiteY15" fmla="*/ 412930 h 504641"/>
                <a:gd name="connsiteX16" fmla="*/ 454412 w 517152"/>
                <a:gd name="connsiteY16" fmla="*/ 414152 h 504641"/>
                <a:gd name="connsiteX17" fmla="*/ 445507 w 517152"/>
                <a:gd name="connsiteY17" fmla="*/ 430042 h 504641"/>
                <a:gd name="connsiteX18" fmla="*/ 421221 w 517152"/>
                <a:gd name="connsiteY18" fmla="*/ 443895 h 504641"/>
                <a:gd name="connsiteX19" fmla="*/ 397339 w 517152"/>
                <a:gd name="connsiteY19" fmla="*/ 430042 h 504641"/>
                <a:gd name="connsiteX20" fmla="*/ 387625 w 517152"/>
                <a:gd name="connsiteY20" fmla="*/ 414152 h 504641"/>
                <a:gd name="connsiteX21" fmla="*/ 386006 w 517152"/>
                <a:gd name="connsiteY21" fmla="*/ 412930 h 504641"/>
                <a:gd name="connsiteX22" fmla="*/ 375077 w 517152"/>
                <a:gd name="connsiteY22" fmla="*/ 412930 h 504641"/>
                <a:gd name="connsiteX23" fmla="*/ 344314 w 517152"/>
                <a:gd name="connsiteY23" fmla="*/ 427598 h 504641"/>
                <a:gd name="connsiteX24" fmla="*/ 337838 w 517152"/>
                <a:gd name="connsiteY24" fmla="*/ 435746 h 504641"/>
                <a:gd name="connsiteX25" fmla="*/ 298170 w 517152"/>
                <a:gd name="connsiteY25" fmla="*/ 501344 h 504641"/>
                <a:gd name="connsiteX26" fmla="*/ 292098 w 517152"/>
                <a:gd name="connsiteY26" fmla="*/ 504603 h 504641"/>
                <a:gd name="connsiteX27" fmla="*/ 288051 w 517152"/>
                <a:gd name="connsiteY27" fmla="*/ 503788 h 504641"/>
                <a:gd name="connsiteX28" fmla="*/ 285622 w 517152"/>
                <a:gd name="connsiteY28" fmla="*/ 494010 h 504641"/>
                <a:gd name="connsiteX29" fmla="*/ 326909 w 517152"/>
                <a:gd name="connsiteY29" fmla="*/ 426783 h 504641"/>
                <a:gd name="connsiteX30" fmla="*/ 332980 w 517152"/>
                <a:gd name="connsiteY30" fmla="*/ 418634 h 504641"/>
                <a:gd name="connsiteX31" fmla="*/ 375077 w 517152"/>
                <a:gd name="connsiteY31" fmla="*/ 398262 h 504641"/>
                <a:gd name="connsiteX32" fmla="*/ 49015 w 517152"/>
                <a:gd name="connsiteY32" fmla="*/ 398262 h 504641"/>
                <a:gd name="connsiteX33" fmla="*/ 60754 w 517152"/>
                <a:gd name="connsiteY33" fmla="*/ 398262 h 504641"/>
                <a:gd name="connsiteX34" fmla="*/ 74516 w 517152"/>
                <a:gd name="connsiteY34" fmla="*/ 406818 h 504641"/>
                <a:gd name="connsiteX35" fmla="*/ 84231 w 517152"/>
                <a:gd name="connsiteY35" fmla="*/ 422708 h 504641"/>
                <a:gd name="connsiteX36" fmla="*/ 95969 w 517152"/>
                <a:gd name="connsiteY36" fmla="*/ 429635 h 504641"/>
                <a:gd name="connsiteX37" fmla="*/ 107303 w 517152"/>
                <a:gd name="connsiteY37" fmla="*/ 422708 h 504641"/>
                <a:gd name="connsiteX38" fmla="*/ 116612 w 517152"/>
                <a:gd name="connsiteY38" fmla="*/ 406818 h 504641"/>
                <a:gd name="connsiteX39" fmla="*/ 131184 w 517152"/>
                <a:gd name="connsiteY39" fmla="*/ 398262 h 504641"/>
                <a:gd name="connsiteX40" fmla="*/ 142113 w 517152"/>
                <a:gd name="connsiteY40" fmla="*/ 398262 h 504641"/>
                <a:gd name="connsiteX41" fmla="*/ 183805 w 517152"/>
                <a:gd name="connsiteY41" fmla="*/ 418634 h 504641"/>
                <a:gd name="connsiteX42" fmla="*/ 190281 w 517152"/>
                <a:gd name="connsiteY42" fmla="*/ 426783 h 504641"/>
                <a:gd name="connsiteX43" fmla="*/ 231163 w 517152"/>
                <a:gd name="connsiteY43" fmla="*/ 494010 h 504641"/>
                <a:gd name="connsiteX44" fmla="*/ 228735 w 517152"/>
                <a:gd name="connsiteY44" fmla="*/ 503788 h 504641"/>
                <a:gd name="connsiteX45" fmla="*/ 225092 w 517152"/>
                <a:gd name="connsiteY45" fmla="*/ 504603 h 504641"/>
                <a:gd name="connsiteX46" fmla="*/ 219020 w 517152"/>
                <a:gd name="connsiteY46" fmla="*/ 501344 h 504641"/>
                <a:gd name="connsiteX47" fmla="*/ 178948 w 517152"/>
                <a:gd name="connsiteY47" fmla="*/ 435746 h 504641"/>
                <a:gd name="connsiteX48" fmla="*/ 172471 w 517152"/>
                <a:gd name="connsiteY48" fmla="*/ 427598 h 504641"/>
                <a:gd name="connsiteX49" fmla="*/ 142113 w 517152"/>
                <a:gd name="connsiteY49" fmla="*/ 412930 h 504641"/>
                <a:gd name="connsiteX50" fmla="*/ 131184 w 517152"/>
                <a:gd name="connsiteY50" fmla="*/ 412930 h 504641"/>
                <a:gd name="connsiteX51" fmla="*/ 129160 w 517152"/>
                <a:gd name="connsiteY51" fmla="*/ 414152 h 504641"/>
                <a:gd name="connsiteX52" fmla="*/ 119851 w 517152"/>
                <a:gd name="connsiteY52" fmla="*/ 430042 h 504641"/>
                <a:gd name="connsiteX53" fmla="*/ 95969 w 517152"/>
                <a:gd name="connsiteY53" fmla="*/ 443895 h 504641"/>
                <a:gd name="connsiteX54" fmla="*/ 71683 w 517152"/>
                <a:gd name="connsiteY54" fmla="*/ 430042 h 504641"/>
                <a:gd name="connsiteX55" fmla="*/ 62373 w 517152"/>
                <a:gd name="connsiteY55" fmla="*/ 414152 h 504641"/>
                <a:gd name="connsiteX56" fmla="*/ 60754 w 517152"/>
                <a:gd name="connsiteY56" fmla="*/ 412930 h 504641"/>
                <a:gd name="connsiteX57" fmla="*/ 49420 w 517152"/>
                <a:gd name="connsiteY57" fmla="*/ 412930 h 504641"/>
                <a:gd name="connsiteX58" fmla="*/ 19062 w 517152"/>
                <a:gd name="connsiteY58" fmla="*/ 442265 h 504641"/>
                <a:gd name="connsiteX59" fmla="*/ 14205 w 517152"/>
                <a:gd name="connsiteY59" fmla="*/ 498084 h 504641"/>
                <a:gd name="connsiteX60" fmla="*/ 6514 w 517152"/>
                <a:gd name="connsiteY60" fmla="*/ 504603 h 504641"/>
                <a:gd name="connsiteX61" fmla="*/ 38 w 517152"/>
                <a:gd name="connsiteY61" fmla="*/ 496862 h 504641"/>
                <a:gd name="connsiteX62" fmla="*/ 4490 w 517152"/>
                <a:gd name="connsiteY62" fmla="*/ 440636 h 504641"/>
                <a:gd name="connsiteX63" fmla="*/ 49015 w 517152"/>
                <a:gd name="connsiteY63" fmla="*/ 398262 h 504641"/>
                <a:gd name="connsiteX64" fmla="*/ 420221 w 517152"/>
                <a:gd name="connsiteY64" fmla="*/ 307133 h 504641"/>
                <a:gd name="connsiteX65" fmla="*/ 382125 w 517152"/>
                <a:gd name="connsiteY65" fmla="*/ 345375 h 504641"/>
                <a:gd name="connsiteX66" fmla="*/ 420221 w 517152"/>
                <a:gd name="connsiteY66" fmla="*/ 383618 h 504641"/>
                <a:gd name="connsiteX67" fmla="*/ 458316 w 517152"/>
                <a:gd name="connsiteY67" fmla="*/ 345375 h 504641"/>
                <a:gd name="connsiteX68" fmla="*/ 420221 w 517152"/>
                <a:gd name="connsiteY68" fmla="*/ 307133 h 504641"/>
                <a:gd name="connsiteX69" fmla="*/ 95181 w 517152"/>
                <a:gd name="connsiteY69" fmla="*/ 307133 h 504641"/>
                <a:gd name="connsiteX70" fmla="*/ 56681 w 517152"/>
                <a:gd name="connsiteY70" fmla="*/ 345375 h 504641"/>
                <a:gd name="connsiteX71" fmla="*/ 95181 w 517152"/>
                <a:gd name="connsiteY71" fmla="*/ 383618 h 504641"/>
                <a:gd name="connsiteX72" fmla="*/ 133277 w 517152"/>
                <a:gd name="connsiteY72" fmla="*/ 345375 h 504641"/>
                <a:gd name="connsiteX73" fmla="*/ 95181 w 517152"/>
                <a:gd name="connsiteY73" fmla="*/ 307133 h 504641"/>
                <a:gd name="connsiteX74" fmla="*/ 420221 w 517152"/>
                <a:gd name="connsiteY74" fmla="*/ 292893 h 504641"/>
                <a:gd name="connsiteX75" fmla="*/ 472501 w 517152"/>
                <a:gd name="connsiteY75" fmla="*/ 345375 h 504641"/>
                <a:gd name="connsiteX76" fmla="*/ 420221 w 517152"/>
                <a:gd name="connsiteY76" fmla="*/ 397857 h 504641"/>
                <a:gd name="connsiteX77" fmla="*/ 367535 w 517152"/>
                <a:gd name="connsiteY77" fmla="*/ 345375 h 504641"/>
                <a:gd name="connsiteX78" fmla="*/ 420221 w 517152"/>
                <a:gd name="connsiteY78" fmla="*/ 292893 h 504641"/>
                <a:gd name="connsiteX79" fmla="*/ 95181 w 517152"/>
                <a:gd name="connsiteY79" fmla="*/ 292893 h 504641"/>
                <a:gd name="connsiteX80" fmla="*/ 147462 w 517152"/>
                <a:gd name="connsiteY80" fmla="*/ 345375 h 504641"/>
                <a:gd name="connsiteX81" fmla="*/ 95181 w 517152"/>
                <a:gd name="connsiteY81" fmla="*/ 397857 h 504641"/>
                <a:gd name="connsiteX82" fmla="*/ 42496 w 517152"/>
                <a:gd name="connsiteY82" fmla="*/ 345375 h 504641"/>
                <a:gd name="connsiteX83" fmla="*/ 95181 w 517152"/>
                <a:gd name="connsiteY83" fmla="*/ 292893 h 504641"/>
                <a:gd name="connsiteX84" fmla="*/ 257898 w 517152"/>
                <a:gd name="connsiteY84" fmla="*/ 89298 h 504641"/>
                <a:gd name="connsiteX85" fmla="*/ 272487 w 517152"/>
                <a:gd name="connsiteY85" fmla="*/ 103887 h 504641"/>
                <a:gd name="connsiteX86" fmla="*/ 257898 w 517152"/>
                <a:gd name="connsiteY86" fmla="*/ 119264 h 504641"/>
                <a:gd name="connsiteX87" fmla="*/ 242521 w 517152"/>
                <a:gd name="connsiteY87" fmla="*/ 103887 h 504641"/>
                <a:gd name="connsiteX88" fmla="*/ 257898 w 517152"/>
                <a:gd name="connsiteY88" fmla="*/ 89298 h 504641"/>
                <a:gd name="connsiteX89" fmla="*/ 196980 w 517152"/>
                <a:gd name="connsiteY89" fmla="*/ 89298 h 504641"/>
                <a:gd name="connsiteX90" fmla="*/ 211761 w 517152"/>
                <a:gd name="connsiteY90" fmla="*/ 103887 h 504641"/>
                <a:gd name="connsiteX91" fmla="*/ 196980 w 517152"/>
                <a:gd name="connsiteY91" fmla="*/ 119264 h 504641"/>
                <a:gd name="connsiteX92" fmla="*/ 181800 w 517152"/>
                <a:gd name="connsiteY92" fmla="*/ 103887 h 504641"/>
                <a:gd name="connsiteX93" fmla="*/ 196980 w 517152"/>
                <a:gd name="connsiteY93" fmla="*/ 89298 h 504641"/>
                <a:gd name="connsiteX94" fmla="*/ 134073 w 517152"/>
                <a:gd name="connsiteY94" fmla="*/ 89298 h 504641"/>
                <a:gd name="connsiteX95" fmla="*/ 149253 w 517152"/>
                <a:gd name="connsiteY95" fmla="*/ 103887 h 504641"/>
                <a:gd name="connsiteX96" fmla="*/ 134073 w 517152"/>
                <a:gd name="connsiteY96" fmla="*/ 119264 h 504641"/>
                <a:gd name="connsiteX97" fmla="*/ 119292 w 517152"/>
                <a:gd name="connsiteY97" fmla="*/ 103887 h 504641"/>
                <a:gd name="connsiteX98" fmla="*/ 134073 w 517152"/>
                <a:gd name="connsiteY98" fmla="*/ 89298 h 504641"/>
                <a:gd name="connsiteX99" fmla="*/ 374112 w 517152"/>
                <a:gd name="connsiteY99" fmla="*/ 45456 h 504641"/>
                <a:gd name="connsiteX100" fmla="*/ 470715 w 517152"/>
                <a:gd name="connsiteY100" fmla="*/ 155971 h 504641"/>
                <a:gd name="connsiteX101" fmla="*/ 470715 w 517152"/>
                <a:gd name="connsiteY101" fmla="*/ 160019 h 504641"/>
                <a:gd name="connsiteX102" fmla="*/ 371271 w 517152"/>
                <a:gd name="connsiteY102" fmla="*/ 270937 h 504641"/>
                <a:gd name="connsiteX103" fmla="*/ 371271 w 517152"/>
                <a:gd name="connsiteY103" fmla="*/ 305751 h 504641"/>
                <a:gd name="connsiteX104" fmla="*/ 365182 w 517152"/>
                <a:gd name="connsiteY104" fmla="*/ 316276 h 504641"/>
                <a:gd name="connsiteX105" fmla="*/ 359906 w 517152"/>
                <a:gd name="connsiteY105" fmla="*/ 317490 h 504641"/>
                <a:gd name="connsiteX106" fmla="*/ 353005 w 517152"/>
                <a:gd name="connsiteY106" fmla="*/ 315062 h 504641"/>
                <a:gd name="connsiteX107" fmla="*/ 300645 w 517152"/>
                <a:gd name="connsiteY107" fmla="*/ 273366 h 504641"/>
                <a:gd name="connsiteX108" fmla="*/ 296180 w 517152"/>
                <a:gd name="connsiteY108" fmla="*/ 271747 h 504641"/>
                <a:gd name="connsiteX109" fmla="*/ 255590 w 517152"/>
                <a:gd name="connsiteY109" fmla="*/ 271747 h 504641"/>
                <a:gd name="connsiteX110" fmla="*/ 199171 w 517152"/>
                <a:gd name="connsiteY110" fmla="*/ 256769 h 504641"/>
                <a:gd name="connsiteX111" fmla="*/ 196329 w 517152"/>
                <a:gd name="connsiteY111" fmla="*/ 247053 h 504641"/>
                <a:gd name="connsiteX112" fmla="*/ 206477 w 517152"/>
                <a:gd name="connsiteY112" fmla="*/ 244219 h 504641"/>
                <a:gd name="connsiteX113" fmla="*/ 255590 w 517152"/>
                <a:gd name="connsiteY113" fmla="*/ 257578 h 504641"/>
                <a:gd name="connsiteX114" fmla="*/ 296180 w 517152"/>
                <a:gd name="connsiteY114" fmla="*/ 257578 h 504641"/>
                <a:gd name="connsiteX115" fmla="*/ 309574 w 517152"/>
                <a:gd name="connsiteY115" fmla="*/ 262031 h 504641"/>
                <a:gd name="connsiteX116" fmla="*/ 357064 w 517152"/>
                <a:gd name="connsiteY116" fmla="*/ 300084 h 504641"/>
                <a:gd name="connsiteX117" fmla="*/ 357064 w 517152"/>
                <a:gd name="connsiteY117" fmla="*/ 269318 h 504641"/>
                <a:gd name="connsiteX118" fmla="*/ 368429 w 517152"/>
                <a:gd name="connsiteY118" fmla="*/ 257173 h 504641"/>
                <a:gd name="connsiteX119" fmla="*/ 456509 w 517152"/>
                <a:gd name="connsiteY119" fmla="*/ 160019 h 504641"/>
                <a:gd name="connsiteX120" fmla="*/ 456509 w 517152"/>
                <a:gd name="connsiteY120" fmla="*/ 155971 h 504641"/>
                <a:gd name="connsiteX121" fmla="*/ 371677 w 517152"/>
                <a:gd name="connsiteY121" fmla="*/ 59625 h 504641"/>
                <a:gd name="connsiteX122" fmla="*/ 365588 w 517152"/>
                <a:gd name="connsiteY122" fmla="*/ 51529 h 504641"/>
                <a:gd name="connsiteX123" fmla="*/ 374112 w 517152"/>
                <a:gd name="connsiteY123" fmla="*/ 45456 h 504641"/>
                <a:gd name="connsiteX124" fmla="*/ 148914 w 517152"/>
                <a:gd name="connsiteY124" fmla="*/ 13763 h 504641"/>
                <a:gd name="connsiteX125" fmla="*/ 51717 w 517152"/>
                <a:gd name="connsiteY125" fmla="*/ 111728 h 504641"/>
                <a:gd name="connsiteX126" fmla="*/ 51717 w 517152"/>
                <a:gd name="connsiteY126" fmla="*/ 115372 h 504641"/>
                <a:gd name="connsiteX127" fmla="*/ 139194 w 517152"/>
                <a:gd name="connsiteY127" fmla="*/ 212122 h 504641"/>
                <a:gd name="connsiteX128" fmla="*/ 150534 w 517152"/>
                <a:gd name="connsiteY128" fmla="*/ 224671 h 504641"/>
                <a:gd name="connsiteX129" fmla="*/ 150534 w 517152"/>
                <a:gd name="connsiteY129" fmla="*/ 255437 h 504641"/>
                <a:gd name="connsiteX130" fmla="*/ 197918 w 517152"/>
                <a:gd name="connsiteY130" fmla="*/ 217384 h 504641"/>
                <a:gd name="connsiteX131" fmla="*/ 211283 w 517152"/>
                <a:gd name="connsiteY131" fmla="*/ 212931 h 504641"/>
                <a:gd name="connsiteX132" fmla="*/ 251782 w 517152"/>
                <a:gd name="connsiteY132" fmla="*/ 212931 h 504641"/>
                <a:gd name="connsiteX133" fmla="*/ 349384 w 517152"/>
                <a:gd name="connsiteY133" fmla="*/ 115372 h 504641"/>
                <a:gd name="connsiteX134" fmla="*/ 349384 w 517152"/>
                <a:gd name="connsiteY134" fmla="*/ 111728 h 504641"/>
                <a:gd name="connsiteX135" fmla="*/ 251782 w 517152"/>
                <a:gd name="connsiteY135" fmla="*/ 13763 h 504641"/>
                <a:gd name="connsiteX136" fmla="*/ 148914 w 517152"/>
                <a:gd name="connsiteY136" fmla="*/ 0 h 504641"/>
                <a:gd name="connsiteX137" fmla="*/ 251782 w 517152"/>
                <a:gd name="connsiteY137" fmla="*/ 0 h 504641"/>
                <a:gd name="connsiteX138" fmla="*/ 363559 w 517152"/>
                <a:gd name="connsiteY138" fmla="*/ 111728 h 504641"/>
                <a:gd name="connsiteX139" fmla="*/ 363559 w 517152"/>
                <a:gd name="connsiteY139" fmla="*/ 115372 h 504641"/>
                <a:gd name="connsiteX140" fmla="*/ 251782 w 517152"/>
                <a:gd name="connsiteY140" fmla="*/ 227100 h 504641"/>
                <a:gd name="connsiteX141" fmla="*/ 211283 w 517152"/>
                <a:gd name="connsiteY141" fmla="*/ 227100 h 504641"/>
                <a:gd name="connsiteX142" fmla="*/ 206828 w 517152"/>
                <a:gd name="connsiteY142" fmla="*/ 228719 h 504641"/>
                <a:gd name="connsiteX143" fmla="*/ 154584 w 517152"/>
                <a:gd name="connsiteY143" fmla="*/ 270415 h 504641"/>
                <a:gd name="connsiteX144" fmla="*/ 147699 w 517152"/>
                <a:gd name="connsiteY144" fmla="*/ 272843 h 504641"/>
                <a:gd name="connsiteX145" fmla="*/ 142839 w 517152"/>
                <a:gd name="connsiteY145" fmla="*/ 271629 h 504641"/>
                <a:gd name="connsiteX146" fmla="*/ 136360 w 517152"/>
                <a:gd name="connsiteY146" fmla="*/ 261509 h 504641"/>
                <a:gd name="connsiteX147" fmla="*/ 136360 w 517152"/>
                <a:gd name="connsiteY147" fmla="*/ 226695 h 504641"/>
                <a:gd name="connsiteX148" fmla="*/ 37137 w 517152"/>
                <a:gd name="connsiteY148" fmla="*/ 115372 h 504641"/>
                <a:gd name="connsiteX149" fmla="*/ 37137 w 517152"/>
                <a:gd name="connsiteY149" fmla="*/ 111728 h 504641"/>
                <a:gd name="connsiteX150" fmla="*/ 148914 w 517152"/>
                <a:gd name="connsiteY150" fmla="*/ 0 h 5046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Lst>
              <a:rect l="l" t="t" r="r" b="b"/>
              <a:pathLst>
                <a:path w="517152" h="504641">
                  <a:moveTo>
                    <a:pt x="375077" y="398262"/>
                  </a:moveTo>
                  <a:lnTo>
                    <a:pt x="386006" y="398262"/>
                  </a:lnTo>
                  <a:cubicBezTo>
                    <a:pt x="391673" y="398262"/>
                    <a:pt x="397339" y="401522"/>
                    <a:pt x="400173" y="406818"/>
                  </a:cubicBezTo>
                  <a:lnTo>
                    <a:pt x="409483" y="422708"/>
                  </a:lnTo>
                  <a:cubicBezTo>
                    <a:pt x="411911" y="427190"/>
                    <a:pt x="416364" y="429635"/>
                    <a:pt x="421221" y="429635"/>
                  </a:cubicBezTo>
                  <a:cubicBezTo>
                    <a:pt x="426078" y="429635"/>
                    <a:pt x="430531" y="427190"/>
                    <a:pt x="432959" y="422708"/>
                  </a:cubicBezTo>
                  <a:lnTo>
                    <a:pt x="442269" y="406818"/>
                  </a:lnTo>
                  <a:cubicBezTo>
                    <a:pt x="445103" y="401522"/>
                    <a:pt x="450769" y="398262"/>
                    <a:pt x="456436" y="398262"/>
                  </a:cubicBezTo>
                  <a:lnTo>
                    <a:pt x="467770" y="398262"/>
                  </a:lnTo>
                  <a:cubicBezTo>
                    <a:pt x="490437" y="398670"/>
                    <a:pt x="510271" y="417412"/>
                    <a:pt x="512295" y="440636"/>
                  </a:cubicBezTo>
                  <a:lnTo>
                    <a:pt x="517152" y="496862"/>
                  </a:lnTo>
                  <a:cubicBezTo>
                    <a:pt x="517152" y="500936"/>
                    <a:pt x="514724" y="504603"/>
                    <a:pt x="510676" y="504603"/>
                  </a:cubicBezTo>
                  <a:cubicBezTo>
                    <a:pt x="506628" y="505011"/>
                    <a:pt x="503390" y="502159"/>
                    <a:pt x="502985" y="498084"/>
                  </a:cubicBezTo>
                  <a:lnTo>
                    <a:pt x="498128" y="442265"/>
                  </a:lnTo>
                  <a:cubicBezTo>
                    <a:pt x="496509" y="425968"/>
                    <a:pt x="483151" y="412930"/>
                    <a:pt x="467770" y="412930"/>
                  </a:cubicBezTo>
                  <a:lnTo>
                    <a:pt x="456436" y="412930"/>
                  </a:lnTo>
                  <a:cubicBezTo>
                    <a:pt x="455222" y="412930"/>
                    <a:pt x="454817" y="413337"/>
                    <a:pt x="454412" y="414152"/>
                  </a:cubicBezTo>
                  <a:lnTo>
                    <a:pt x="445507" y="430042"/>
                  </a:lnTo>
                  <a:cubicBezTo>
                    <a:pt x="440245" y="438599"/>
                    <a:pt x="431340" y="443895"/>
                    <a:pt x="421221" y="443895"/>
                  </a:cubicBezTo>
                  <a:cubicBezTo>
                    <a:pt x="411102" y="443895"/>
                    <a:pt x="402197" y="438599"/>
                    <a:pt x="397339" y="430042"/>
                  </a:cubicBezTo>
                  <a:lnTo>
                    <a:pt x="387625" y="414152"/>
                  </a:lnTo>
                  <a:cubicBezTo>
                    <a:pt x="387625" y="413337"/>
                    <a:pt x="386815" y="412930"/>
                    <a:pt x="386006" y="412930"/>
                  </a:cubicBezTo>
                  <a:lnTo>
                    <a:pt x="375077" y="412930"/>
                  </a:lnTo>
                  <a:cubicBezTo>
                    <a:pt x="362934" y="412930"/>
                    <a:pt x="351600" y="418227"/>
                    <a:pt x="344314" y="427598"/>
                  </a:cubicBezTo>
                  <a:lnTo>
                    <a:pt x="337838" y="435746"/>
                  </a:lnTo>
                  <a:cubicBezTo>
                    <a:pt x="333385" y="441451"/>
                    <a:pt x="311527" y="478120"/>
                    <a:pt x="298170" y="501344"/>
                  </a:cubicBezTo>
                  <a:cubicBezTo>
                    <a:pt x="296956" y="503381"/>
                    <a:pt x="294527" y="504603"/>
                    <a:pt x="292098" y="504603"/>
                  </a:cubicBezTo>
                  <a:cubicBezTo>
                    <a:pt x="290884" y="504603"/>
                    <a:pt x="289265" y="504603"/>
                    <a:pt x="288051" y="503788"/>
                  </a:cubicBezTo>
                  <a:cubicBezTo>
                    <a:pt x="284812" y="501751"/>
                    <a:pt x="283598" y="497270"/>
                    <a:pt x="285622" y="494010"/>
                  </a:cubicBezTo>
                  <a:cubicBezTo>
                    <a:pt x="289265" y="487898"/>
                    <a:pt x="320028" y="434932"/>
                    <a:pt x="326909" y="426783"/>
                  </a:cubicBezTo>
                  <a:lnTo>
                    <a:pt x="332980" y="418634"/>
                  </a:lnTo>
                  <a:cubicBezTo>
                    <a:pt x="343504" y="405596"/>
                    <a:pt x="358481" y="398262"/>
                    <a:pt x="375077" y="398262"/>
                  </a:cubicBezTo>
                  <a:close/>
                  <a:moveTo>
                    <a:pt x="49015" y="398262"/>
                  </a:moveTo>
                  <a:lnTo>
                    <a:pt x="60754" y="398262"/>
                  </a:lnTo>
                  <a:cubicBezTo>
                    <a:pt x="66421" y="398262"/>
                    <a:pt x="72087" y="401522"/>
                    <a:pt x="74516" y="406818"/>
                  </a:cubicBezTo>
                  <a:lnTo>
                    <a:pt x="84231" y="422708"/>
                  </a:lnTo>
                  <a:cubicBezTo>
                    <a:pt x="86659" y="427190"/>
                    <a:pt x="91112" y="429635"/>
                    <a:pt x="95969" y="429635"/>
                  </a:cubicBezTo>
                  <a:cubicBezTo>
                    <a:pt x="100826" y="429635"/>
                    <a:pt x="104874" y="427190"/>
                    <a:pt x="107303" y="422708"/>
                  </a:cubicBezTo>
                  <a:lnTo>
                    <a:pt x="116612" y="406818"/>
                  </a:lnTo>
                  <a:cubicBezTo>
                    <a:pt x="119851" y="401522"/>
                    <a:pt x="125113" y="398262"/>
                    <a:pt x="131184" y="398262"/>
                  </a:cubicBezTo>
                  <a:lnTo>
                    <a:pt x="142113" y="398262"/>
                  </a:lnTo>
                  <a:cubicBezTo>
                    <a:pt x="158304" y="398262"/>
                    <a:pt x="173686" y="405596"/>
                    <a:pt x="183805" y="418634"/>
                  </a:cubicBezTo>
                  <a:lnTo>
                    <a:pt x="190281" y="426783"/>
                  </a:lnTo>
                  <a:cubicBezTo>
                    <a:pt x="196758" y="434932"/>
                    <a:pt x="227925" y="487898"/>
                    <a:pt x="231163" y="494010"/>
                  </a:cubicBezTo>
                  <a:cubicBezTo>
                    <a:pt x="233187" y="497270"/>
                    <a:pt x="231973" y="501751"/>
                    <a:pt x="228735" y="503788"/>
                  </a:cubicBezTo>
                  <a:cubicBezTo>
                    <a:pt x="227520" y="504603"/>
                    <a:pt x="226306" y="504603"/>
                    <a:pt x="225092" y="504603"/>
                  </a:cubicBezTo>
                  <a:cubicBezTo>
                    <a:pt x="222663" y="504603"/>
                    <a:pt x="220234" y="503381"/>
                    <a:pt x="219020" y="501344"/>
                  </a:cubicBezTo>
                  <a:cubicBezTo>
                    <a:pt x="205258" y="478120"/>
                    <a:pt x="183400" y="441451"/>
                    <a:pt x="178948" y="435746"/>
                  </a:cubicBezTo>
                  <a:lnTo>
                    <a:pt x="172471" y="427598"/>
                  </a:lnTo>
                  <a:cubicBezTo>
                    <a:pt x="165185" y="418227"/>
                    <a:pt x="153852" y="412930"/>
                    <a:pt x="142113" y="412930"/>
                  </a:cubicBezTo>
                  <a:lnTo>
                    <a:pt x="131184" y="412930"/>
                  </a:lnTo>
                  <a:cubicBezTo>
                    <a:pt x="130375" y="412930"/>
                    <a:pt x="129565" y="413337"/>
                    <a:pt x="129160" y="414152"/>
                  </a:cubicBezTo>
                  <a:lnTo>
                    <a:pt x="119851" y="430042"/>
                  </a:lnTo>
                  <a:cubicBezTo>
                    <a:pt x="114589" y="438599"/>
                    <a:pt x="106088" y="443895"/>
                    <a:pt x="95969" y="443895"/>
                  </a:cubicBezTo>
                  <a:cubicBezTo>
                    <a:pt x="85850" y="443895"/>
                    <a:pt x="76945" y="438599"/>
                    <a:pt x="71683" y="430042"/>
                  </a:cubicBezTo>
                  <a:lnTo>
                    <a:pt x="62373" y="414152"/>
                  </a:lnTo>
                  <a:cubicBezTo>
                    <a:pt x="61968" y="413337"/>
                    <a:pt x="61159" y="412930"/>
                    <a:pt x="60754" y="412930"/>
                  </a:cubicBezTo>
                  <a:lnTo>
                    <a:pt x="49420" y="412930"/>
                  </a:lnTo>
                  <a:cubicBezTo>
                    <a:pt x="33634" y="412930"/>
                    <a:pt x="20276" y="425968"/>
                    <a:pt x="19062" y="442265"/>
                  </a:cubicBezTo>
                  <a:lnTo>
                    <a:pt x="14205" y="498084"/>
                  </a:lnTo>
                  <a:cubicBezTo>
                    <a:pt x="13800" y="502159"/>
                    <a:pt x="10562" y="505011"/>
                    <a:pt x="6514" y="504603"/>
                  </a:cubicBezTo>
                  <a:cubicBezTo>
                    <a:pt x="2466" y="504603"/>
                    <a:pt x="-367" y="500936"/>
                    <a:pt x="38" y="496862"/>
                  </a:cubicBezTo>
                  <a:lnTo>
                    <a:pt x="4490" y="440636"/>
                  </a:lnTo>
                  <a:cubicBezTo>
                    <a:pt x="6919" y="417412"/>
                    <a:pt x="26348" y="398670"/>
                    <a:pt x="49015" y="398262"/>
                  </a:cubicBezTo>
                  <a:close/>
                  <a:moveTo>
                    <a:pt x="420221" y="307133"/>
                  </a:moveTo>
                  <a:cubicBezTo>
                    <a:pt x="399146" y="307133"/>
                    <a:pt x="382125" y="324627"/>
                    <a:pt x="382125" y="345375"/>
                  </a:cubicBezTo>
                  <a:cubicBezTo>
                    <a:pt x="382125" y="366531"/>
                    <a:pt x="399146" y="383618"/>
                    <a:pt x="420221" y="383618"/>
                  </a:cubicBezTo>
                  <a:cubicBezTo>
                    <a:pt x="441295" y="383618"/>
                    <a:pt x="458316" y="366531"/>
                    <a:pt x="458316" y="345375"/>
                  </a:cubicBezTo>
                  <a:cubicBezTo>
                    <a:pt x="458316" y="324627"/>
                    <a:pt x="441295" y="307133"/>
                    <a:pt x="420221" y="307133"/>
                  </a:cubicBezTo>
                  <a:close/>
                  <a:moveTo>
                    <a:pt x="95181" y="307133"/>
                  </a:moveTo>
                  <a:cubicBezTo>
                    <a:pt x="73702" y="307133"/>
                    <a:pt x="56681" y="324627"/>
                    <a:pt x="56681" y="345375"/>
                  </a:cubicBezTo>
                  <a:cubicBezTo>
                    <a:pt x="56681" y="366531"/>
                    <a:pt x="73702" y="383618"/>
                    <a:pt x="95181" y="383618"/>
                  </a:cubicBezTo>
                  <a:cubicBezTo>
                    <a:pt x="116256" y="383618"/>
                    <a:pt x="133277" y="366531"/>
                    <a:pt x="133277" y="345375"/>
                  </a:cubicBezTo>
                  <a:cubicBezTo>
                    <a:pt x="133277" y="324627"/>
                    <a:pt x="116256" y="307133"/>
                    <a:pt x="95181" y="307133"/>
                  </a:cubicBezTo>
                  <a:close/>
                  <a:moveTo>
                    <a:pt x="420221" y="292893"/>
                  </a:moveTo>
                  <a:cubicBezTo>
                    <a:pt x="448995" y="292893"/>
                    <a:pt x="472501" y="316083"/>
                    <a:pt x="472501" y="345375"/>
                  </a:cubicBezTo>
                  <a:cubicBezTo>
                    <a:pt x="472501" y="374261"/>
                    <a:pt x="448995" y="397857"/>
                    <a:pt x="420221" y="397857"/>
                  </a:cubicBezTo>
                  <a:cubicBezTo>
                    <a:pt x="391446" y="397857"/>
                    <a:pt x="367535" y="374261"/>
                    <a:pt x="367535" y="345375"/>
                  </a:cubicBezTo>
                  <a:cubicBezTo>
                    <a:pt x="367535" y="316083"/>
                    <a:pt x="391446" y="292893"/>
                    <a:pt x="420221" y="292893"/>
                  </a:cubicBezTo>
                  <a:close/>
                  <a:moveTo>
                    <a:pt x="95181" y="292893"/>
                  </a:moveTo>
                  <a:cubicBezTo>
                    <a:pt x="123551" y="292893"/>
                    <a:pt x="147462" y="316083"/>
                    <a:pt x="147462" y="345375"/>
                  </a:cubicBezTo>
                  <a:cubicBezTo>
                    <a:pt x="147462" y="374261"/>
                    <a:pt x="123551" y="397857"/>
                    <a:pt x="95181" y="397857"/>
                  </a:cubicBezTo>
                  <a:cubicBezTo>
                    <a:pt x="66002" y="397857"/>
                    <a:pt x="42496" y="374261"/>
                    <a:pt x="42496" y="345375"/>
                  </a:cubicBezTo>
                  <a:cubicBezTo>
                    <a:pt x="42496" y="316083"/>
                    <a:pt x="66002" y="292893"/>
                    <a:pt x="95181" y="292893"/>
                  </a:cubicBezTo>
                  <a:close/>
                  <a:moveTo>
                    <a:pt x="257898" y="89298"/>
                  </a:moveTo>
                  <a:cubicBezTo>
                    <a:pt x="265784" y="89298"/>
                    <a:pt x="272487" y="95607"/>
                    <a:pt x="272487" y="103887"/>
                  </a:cubicBezTo>
                  <a:cubicBezTo>
                    <a:pt x="272487" y="112167"/>
                    <a:pt x="265784" y="119264"/>
                    <a:pt x="257898" y="119264"/>
                  </a:cubicBezTo>
                  <a:cubicBezTo>
                    <a:pt x="249618" y="119264"/>
                    <a:pt x="242521" y="112167"/>
                    <a:pt x="242521" y="103887"/>
                  </a:cubicBezTo>
                  <a:cubicBezTo>
                    <a:pt x="242521" y="95607"/>
                    <a:pt x="249618" y="89298"/>
                    <a:pt x="257898" y="89298"/>
                  </a:cubicBezTo>
                  <a:close/>
                  <a:moveTo>
                    <a:pt x="196980" y="89298"/>
                  </a:moveTo>
                  <a:cubicBezTo>
                    <a:pt x="205369" y="89298"/>
                    <a:pt x="211761" y="95607"/>
                    <a:pt x="211761" y="103887"/>
                  </a:cubicBezTo>
                  <a:cubicBezTo>
                    <a:pt x="211761" y="112167"/>
                    <a:pt x="205369" y="119264"/>
                    <a:pt x="196980" y="119264"/>
                  </a:cubicBezTo>
                  <a:cubicBezTo>
                    <a:pt x="188591" y="119264"/>
                    <a:pt x="181800" y="112167"/>
                    <a:pt x="181800" y="103887"/>
                  </a:cubicBezTo>
                  <a:cubicBezTo>
                    <a:pt x="181800" y="95607"/>
                    <a:pt x="188591" y="89298"/>
                    <a:pt x="196980" y="89298"/>
                  </a:cubicBezTo>
                  <a:close/>
                  <a:moveTo>
                    <a:pt x="134073" y="89298"/>
                  </a:moveTo>
                  <a:cubicBezTo>
                    <a:pt x="142461" y="89298"/>
                    <a:pt x="149253" y="95607"/>
                    <a:pt x="149253" y="103887"/>
                  </a:cubicBezTo>
                  <a:cubicBezTo>
                    <a:pt x="149253" y="112167"/>
                    <a:pt x="142461" y="119264"/>
                    <a:pt x="134073" y="119264"/>
                  </a:cubicBezTo>
                  <a:cubicBezTo>
                    <a:pt x="125684" y="119264"/>
                    <a:pt x="119292" y="112167"/>
                    <a:pt x="119292" y="103887"/>
                  </a:cubicBezTo>
                  <a:cubicBezTo>
                    <a:pt x="119292" y="95607"/>
                    <a:pt x="125684" y="89298"/>
                    <a:pt x="134073" y="89298"/>
                  </a:cubicBezTo>
                  <a:close/>
                  <a:moveTo>
                    <a:pt x="374112" y="45456"/>
                  </a:moveTo>
                  <a:cubicBezTo>
                    <a:pt x="428908" y="52743"/>
                    <a:pt x="470715" y="100511"/>
                    <a:pt x="470715" y="155971"/>
                  </a:cubicBezTo>
                  <a:lnTo>
                    <a:pt x="470715" y="160019"/>
                  </a:lnTo>
                  <a:cubicBezTo>
                    <a:pt x="470715" y="217097"/>
                    <a:pt x="428096" y="264460"/>
                    <a:pt x="371271" y="270937"/>
                  </a:cubicBezTo>
                  <a:lnTo>
                    <a:pt x="371271" y="305751"/>
                  </a:lnTo>
                  <a:cubicBezTo>
                    <a:pt x="371271" y="310609"/>
                    <a:pt x="368835" y="314252"/>
                    <a:pt x="365182" y="316276"/>
                  </a:cubicBezTo>
                  <a:cubicBezTo>
                    <a:pt x="363153" y="317086"/>
                    <a:pt x="361935" y="317490"/>
                    <a:pt x="359906" y="317490"/>
                  </a:cubicBezTo>
                  <a:cubicBezTo>
                    <a:pt x="357470" y="317490"/>
                    <a:pt x="355035" y="316681"/>
                    <a:pt x="353005" y="315062"/>
                  </a:cubicBezTo>
                  <a:lnTo>
                    <a:pt x="300645" y="273366"/>
                  </a:lnTo>
                  <a:cubicBezTo>
                    <a:pt x="299427" y="272152"/>
                    <a:pt x="297803" y="271747"/>
                    <a:pt x="296180" y="271747"/>
                  </a:cubicBezTo>
                  <a:lnTo>
                    <a:pt x="255590" y="271747"/>
                  </a:lnTo>
                  <a:cubicBezTo>
                    <a:pt x="235701" y="271747"/>
                    <a:pt x="216218" y="266484"/>
                    <a:pt x="199171" y="256769"/>
                  </a:cubicBezTo>
                  <a:cubicBezTo>
                    <a:pt x="195518" y="254745"/>
                    <a:pt x="194300" y="249887"/>
                    <a:pt x="196329" y="247053"/>
                  </a:cubicBezTo>
                  <a:cubicBezTo>
                    <a:pt x="198359" y="243410"/>
                    <a:pt x="202824" y="242195"/>
                    <a:pt x="206477" y="244219"/>
                  </a:cubicBezTo>
                  <a:cubicBezTo>
                    <a:pt x="221089" y="252721"/>
                    <a:pt x="238137" y="257578"/>
                    <a:pt x="255590" y="257578"/>
                  </a:cubicBezTo>
                  <a:lnTo>
                    <a:pt x="296180" y="257578"/>
                  </a:lnTo>
                  <a:cubicBezTo>
                    <a:pt x="301051" y="257578"/>
                    <a:pt x="305921" y="259198"/>
                    <a:pt x="309574" y="262031"/>
                  </a:cubicBezTo>
                  <a:lnTo>
                    <a:pt x="357064" y="300084"/>
                  </a:lnTo>
                  <a:lnTo>
                    <a:pt x="357064" y="269318"/>
                  </a:lnTo>
                  <a:cubicBezTo>
                    <a:pt x="357064" y="263246"/>
                    <a:pt x="361935" y="257578"/>
                    <a:pt x="368429" y="257173"/>
                  </a:cubicBezTo>
                  <a:cubicBezTo>
                    <a:pt x="418760" y="251911"/>
                    <a:pt x="456509" y="210215"/>
                    <a:pt x="456509" y="160019"/>
                  </a:cubicBezTo>
                  <a:lnTo>
                    <a:pt x="456509" y="155971"/>
                  </a:lnTo>
                  <a:cubicBezTo>
                    <a:pt x="456509" y="107393"/>
                    <a:pt x="419978" y="65697"/>
                    <a:pt x="371677" y="59625"/>
                  </a:cubicBezTo>
                  <a:cubicBezTo>
                    <a:pt x="368023" y="58815"/>
                    <a:pt x="365182" y="55172"/>
                    <a:pt x="365588" y="51529"/>
                  </a:cubicBezTo>
                  <a:cubicBezTo>
                    <a:pt x="365994" y="47885"/>
                    <a:pt x="370053" y="44647"/>
                    <a:pt x="374112" y="45456"/>
                  </a:cubicBezTo>
                  <a:close/>
                  <a:moveTo>
                    <a:pt x="148914" y="13763"/>
                  </a:moveTo>
                  <a:cubicBezTo>
                    <a:pt x="95456" y="13763"/>
                    <a:pt x="51717" y="57888"/>
                    <a:pt x="51717" y="111728"/>
                  </a:cubicBezTo>
                  <a:lnTo>
                    <a:pt x="51717" y="115372"/>
                  </a:lnTo>
                  <a:cubicBezTo>
                    <a:pt x="51717" y="165568"/>
                    <a:pt x="89381" y="207669"/>
                    <a:pt x="139194" y="212122"/>
                  </a:cubicBezTo>
                  <a:cubicBezTo>
                    <a:pt x="145674" y="213336"/>
                    <a:pt x="150534" y="218194"/>
                    <a:pt x="150534" y="224671"/>
                  </a:cubicBezTo>
                  <a:lnTo>
                    <a:pt x="150534" y="255437"/>
                  </a:lnTo>
                  <a:lnTo>
                    <a:pt x="197918" y="217384"/>
                  </a:lnTo>
                  <a:cubicBezTo>
                    <a:pt x="201563" y="214551"/>
                    <a:pt x="206423" y="212931"/>
                    <a:pt x="211283" y="212931"/>
                  </a:cubicBezTo>
                  <a:lnTo>
                    <a:pt x="251782" y="212931"/>
                  </a:lnTo>
                  <a:cubicBezTo>
                    <a:pt x="305645" y="212931"/>
                    <a:pt x="349384" y="168807"/>
                    <a:pt x="349384" y="115372"/>
                  </a:cubicBezTo>
                  <a:lnTo>
                    <a:pt x="349384" y="111728"/>
                  </a:lnTo>
                  <a:cubicBezTo>
                    <a:pt x="349384" y="57888"/>
                    <a:pt x="305645" y="13763"/>
                    <a:pt x="251782" y="13763"/>
                  </a:cubicBezTo>
                  <a:close/>
                  <a:moveTo>
                    <a:pt x="148914" y="0"/>
                  </a:moveTo>
                  <a:lnTo>
                    <a:pt x="251782" y="0"/>
                  </a:lnTo>
                  <a:cubicBezTo>
                    <a:pt x="313340" y="0"/>
                    <a:pt x="363559" y="50197"/>
                    <a:pt x="363559" y="111728"/>
                  </a:cubicBezTo>
                  <a:lnTo>
                    <a:pt x="363559" y="115372"/>
                  </a:lnTo>
                  <a:cubicBezTo>
                    <a:pt x="363559" y="177308"/>
                    <a:pt x="313340" y="227100"/>
                    <a:pt x="251782" y="227100"/>
                  </a:cubicBezTo>
                  <a:lnTo>
                    <a:pt x="211283" y="227100"/>
                  </a:lnTo>
                  <a:cubicBezTo>
                    <a:pt x="209258" y="227100"/>
                    <a:pt x="208043" y="227909"/>
                    <a:pt x="206828" y="228719"/>
                  </a:cubicBezTo>
                  <a:lnTo>
                    <a:pt x="154584" y="270415"/>
                  </a:lnTo>
                  <a:cubicBezTo>
                    <a:pt x="152559" y="272034"/>
                    <a:pt x="150129" y="272843"/>
                    <a:pt x="147699" y="272843"/>
                  </a:cubicBezTo>
                  <a:cubicBezTo>
                    <a:pt x="145674" y="272843"/>
                    <a:pt x="144054" y="272439"/>
                    <a:pt x="142839" y="271629"/>
                  </a:cubicBezTo>
                  <a:cubicBezTo>
                    <a:pt x="138789" y="269605"/>
                    <a:pt x="136360" y="265557"/>
                    <a:pt x="136360" y="261509"/>
                  </a:cubicBezTo>
                  <a:lnTo>
                    <a:pt x="136360" y="226695"/>
                  </a:lnTo>
                  <a:cubicBezTo>
                    <a:pt x="79661" y="219813"/>
                    <a:pt x="37137" y="172450"/>
                    <a:pt x="37137" y="115372"/>
                  </a:cubicBezTo>
                  <a:lnTo>
                    <a:pt x="37137" y="111728"/>
                  </a:lnTo>
                  <a:cubicBezTo>
                    <a:pt x="37137" y="50197"/>
                    <a:pt x="87356" y="0"/>
                    <a:pt x="148914" y="0"/>
                  </a:cubicBezTo>
                  <a:close/>
                </a:path>
              </a:pathLst>
            </a:custGeom>
            <a:solidFill>
              <a:srgbClr val="FFFFFF"/>
            </a:solidFill>
            <a:ln>
              <a:noFill/>
            </a:ln>
            <a:effectLst/>
          </p:spPr>
          <p:txBody>
            <a:bodyPr wrap="square" anchor="ctr">
              <a:noAutofit/>
            </a:bodyP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272" b="0" i="0" u="none" strike="noStrike" kern="0" cap="none" spc="0" normalizeH="0" baseline="0" noProof="0">
                <a:ln>
                  <a:noFill/>
                </a:ln>
                <a:solidFill>
                  <a:srgbClr val="272727"/>
                </a:solidFill>
                <a:effectLst/>
                <a:uLnTx/>
                <a:uFillTx/>
                <a:latin typeface="Tw Cen MT" panose="020B0602020104020603" pitchFamily="34" charset="77"/>
              </a:endParaRPr>
            </a:p>
          </p:txBody>
        </p:sp>
      </p:grpSp>
      <p:grpSp>
        <p:nvGrpSpPr>
          <p:cNvPr id="61" name="Group 60">
            <a:extLst>
              <a:ext uri="{FF2B5EF4-FFF2-40B4-BE49-F238E27FC236}">
                <a16:creationId xmlns:a16="http://schemas.microsoft.com/office/drawing/2014/main" id="{3F7A0C77-7479-0247-AE54-DF6E9F20CDCE}"/>
              </a:ext>
            </a:extLst>
          </p:cNvPr>
          <p:cNvGrpSpPr/>
          <p:nvPr/>
        </p:nvGrpSpPr>
        <p:grpSpPr>
          <a:xfrm flipH="1">
            <a:off x="866558" y="2404709"/>
            <a:ext cx="3088250" cy="2569049"/>
            <a:chOff x="2814330" y="4846377"/>
            <a:chExt cx="7693908" cy="6400400"/>
          </a:xfrm>
        </p:grpSpPr>
        <p:sp>
          <p:nvSpPr>
            <p:cNvPr id="62" name="Freeform 70">
              <a:extLst>
                <a:ext uri="{FF2B5EF4-FFF2-40B4-BE49-F238E27FC236}">
                  <a16:creationId xmlns:a16="http://schemas.microsoft.com/office/drawing/2014/main" id="{C15FF70F-4B2F-8241-8116-539F914BA3F4}"/>
                </a:ext>
              </a:extLst>
            </p:cNvPr>
            <p:cNvSpPr>
              <a:spLocks noChangeArrowheads="1"/>
            </p:cNvSpPr>
            <p:nvPr/>
          </p:nvSpPr>
          <p:spPr bwMode="auto">
            <a:xfrm flipV="1">
              <a:off x="2814330" y="4846377"/>
              <a:ext cx="6400404" cy="6400400"/>
            </a:xfrm>
            <a:prstGeom prst="ellipse">
              <a:avLst/>
            </a:prstGeom>
            <a:solidFill>
              <a:srgbClr val="FFFFFF"/>
            </a:solidFill>
            <a:ln w="76200">
              <a:noFill/>
            </a:ln>
            <a:effectLst/>
          </p:spPr>
          <p:txBody>
            <a:bodyPr wrap="none" anchor="ct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272727"/>
                </a:solidFill>
                <a:effectLst/>
                <a:uLnTx/>
                <a:uFillTx/>
                <a:latin typeface="Tw Cen MT" panose="020B0602020104020603" pitchFamily="34" charset="77"/>
              </a:endParaRPr>
            </a:p>
          </p:txBody>
        </p:sp>
        <p:sp>
          <p:nvSpPr>
            <p:cNvPr id="63" name="Freeform 62">
              <a:extLst>
                <a:ext uri="{FF2B5EF4-FFF2-40B4-BE49-F238E27FC236}">
                  <a16:creationId xmlns:a16="http://schemas.microsoft.com/office/drawing/2014/main" id="{2E33361A-7786-3C44-883F-D04A7A2752C4}"/>
                </a:ext>
              </a:extLst>
            </p:cNvPr>
            <p:cNvSpPr>
              <a:spLocks noChangeArrowheads="1"/>
            </p:cNvSpPr>
            <p:nvPr/>
          </p:nvSpPr>
          <p:spPr bwMode="auto">
            <a:xfrm flipV="1">
              <a:off x="2885173" y="4921254"/>
              <a:ext cx="6258717" cy="6250647"/>
            </a:xfrm>
            <a:custGeom>
              <a:avLst/>
              <a:gdLst>
                <a:gd name="connsiteX0" fmla="*/ 2130013 w 4250287"/>
                <a:gd name="connsiteY0" fmla="*/ 1417177 h 4250286"/>
                <a:gd name="connsiteX1" fmla="*/ 2838601 w 4250287"/>
                <a:gd name="connsiteY1" fmla="*/ 2124520 h 4250286"/>
                <a:gd name="connsiteX2" fmla="*/ 2130013 w 4250287"/>
                <a:gd name="connsiteY2" fmla="*/ 2833109 h 4250286"/>
                <a:gd name="connsiteX3" fmla="*/ 1422669 w 4250287"/>
                <a:gd name="connsiteY3" fmla="*/ 2124520 h 4250286"/>
                <a:gd name="connsiteX4" fmla="*/ 2130013 w 4250287"/>
                <a:gd name="connsiteY4" fmla="*/ 1417177 h 4250286"/>
                <a:gd name="connsiteX5" fmla="*/ 2124517 w 4250287"/>
                <a:gd name="connsiteY5" fmla="*/ 1061324 h 4250286"/>
                <a:gd name="connsiteX6" fmla="*/ 1062256 w 4250287"/>
                <a:gd name="connsiteY6" fmla="*/ 2124518 h 4250286"/>
                <a:gd name="connsiteX7" fmla="*/ 2124517 w 4250287"/>
                <a:gd name="connsiteY7" fmla="*/ 3187713 h 4250286"/>
                <a:gd name="connsiteX8" fmla="*/ 3186777 w 4250287"/>
                <a:gd name="connsiteY8" fmla="*/ 2124518 h 4250286"/>
                <a:gd name="connsiteX9" fmla="*/ 2124517 w 4250287"/>
                <a:gd name="connsiteY9" fmla="*/ 1061324 h 4250286"/>
                <a:gd name="connsiteX10" fmla="*/ 2124517 w 4250287"/>
                <a:gd name="connsiteY10" fmla="*/ 708587 h 4250286"/>
                <a:gd name="connsiteX11" fmla="*/ 3541693 w 4250287"/>
                <a:gd name="connsiteY11" fmla="*/ 2124518 h 4250286"/>
                <a:gd name="connsiteX12" fmla="*/ 2124517 w 4250287"/>
                <a:gd name="connsiteY12" fmla="*/ 3541696 h 4250286"/>
                <a:gd name="connsiteX13" fmla="*/ 708584 w 4250287"/>
                <a:gd name="connsiteY13" fmla="*/ 2124518 h 4250286"/>
                <a:gd name="connsiteX14" fmla="*/ 2124517 w 4250287"/>
                <a:gd name="connsiteY14" fmla="*/ 708587 h 4250286"/>
                <a:gd name="connsiteX15" fmla="*/ 2124521 w 4250287"/>
                <a:gd name="connsiteY15" fmla="*/ 355125 h 4250286"/>
                <a:gd name="connsiteX16" fmla="*/ 353672 w 4250287"/>
                <a:gd name="connsiteY16" fmla="*/ 2124520 h 4250286"/>
                <a:gd name="connsiteX17" fmla="*/ 2124521 w 4250287"/>
                <a:gd name="connsiteY17" fmla="*/ 3896407 h 4250286"/>
                <a:gd name="connsiteX18" fmla="*/ 3895371 w 4250287"/>
                <a:gd name="connsiteY18" fmla="*/ 2124520 h 4250286"/>
                <a:gd name="connsiteX19" fmla="*/ 2124521 w 4250287"/>
                <a:gd name="connsiteY19" fmla="*/ 355125 h 4250286"/>
                <a:gd name="connsiteX20" fmla="*/ 2124521 w 4250287"/>
                <a:gd name="connsiteY20" fmla="*/ 0 h 4250286"/>
                <a:gd name="connsiteX21" fmla="*/ 4250287 w 4250287"/>
                <a:gd name="connsiteY21" fmla="*/ 2124520 h 4250286"/>
                <a:gd name="connsiteX22" fmla="*/ 2124521 w 4250287"/>
                <a:gd name="connsiteY22" fmla="*/ 4250286 h 4250286"/>
                <a:gd name="connsiteX23" fmla="*/ 0 w 4250287"/>
                <a:gd name="connsiteY23" fmla="*/ 2124520 h 4250286"/>
                <a:gd name="connsiteX24" fmla="*/ 2124521 w 4250287"/>
                <a:gd name="connsiteY24" fmla="*/ 0 h 42502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Lst>
              <a:rect l="l" t="t" r="r" b="b"/>
              <a:pathLst>
                <a:path w="4250287" h="4250286">
                  <a:moveTo>
                    <a:pt x="2130013" y="1417177"/>
                  </a:moveTo>
                  <a:cubicBezTo>
                    <a:pt x="2521045" y="1417177"/>
                    <a:pt x="2838601" y="1733489"/>
                    <a:pt x="2838601" y="2124520"/>
                  </a:cubicBezTo>
                  <a:cubicBezTo>
                    <a:pt x="2838601" y="2515552"/>
                    <a:pt x="2521045" y="2833109"/>
                    <a:pt x="2130013" y="2833109"/>
                  </a:cubicBezTo>
                  <a:cubicBezTo>
                    <a:pt x="1738981" y="2833109"/>
                    <a:pt x="1422669" y="2515552"/>
                    <a:pt x="1422669" y="2124520"/>
                  </a:cubicBezTo>
                  <a:cubicBezTo>
                    <a:pt x="1422669" y="1733489"/>
                    <a:pt x="1738981" y="1417177"/>
                    <a:pt x="2130013" y="1417177"/>
                  </a:cubicBezTo>
                  <a:close/>
                  <a:moveTo>
                    <a:pt x="2124517" y="1061324"/>
                  </a:moveTo>
                  <a:cubicBezTo>
                    <a:pt x="1537969" y="1061324"/>
                    <a:pt x="1062256" y="1537455"/>
                    <a:pt x="1062256" y="2124518"/>
                  </a:cubicBezTo>
                  <a:cubicBezTo>
                    <a:pt x="1062256" y="2711581"/>
                    <a:pt x="1537969" y="3187713"/>
                    <a:pt x="2124517" y="3187713"/>
                  </a:cubicBezTo>
                  <a:cubicBezTo>
                    <a:pt x="2711063" y="3187713"/>
                    <a:pt x="3186777" y="2711581"/>
                    <a:pt x="3186777" y="2124518"/>
                  </a:cubicBezTo>
                  <a:cubicBezTo>
                    <a:pt x="3186777" y="1537455"/>
                    <a:pt x="2711063" y="1061324"/>
                    <a:pt x="2124517" y="1061324"/>
                  </a:cubicBezTo>
                  <a:close/>
                  <a:moveTo>
                    <a:pt x="2124517" y="708587"/>
                  </a:moveTo>
                  <a:cubicBezTo>
                    <a:pt x="2906579" y="708587"/>
                    <a:pt x="3541693" y="1341768"/>
                    <a:pt x="3541693" y="2124518"/>
                  </a:cubicBezTo>
                  <a:cubicBezTo>
                    <a:pt x="3541693" y="2908515"/>
                    <a:pt x="2906579" y="3541696"/>
                    <a:pt x="2124517" y="3541696"/>
                  </a:cubicBezTo>
                  <a:cubicBezTo>
                    <a:pt x="1342453" y="3541696"/>
                    <a:pt x="708584" y="2908515"/>
                    <a:pt x="708584" y="2124518"/>
                  </a:cubicBezTo>
                  <a:cubicBezTo>
                    <a:pt x="708584" y="1341768"/>
                    <a:pt x="1342453" y="708587"/>
                    <a:pt x="2124517" y="708587"/>
                  </a:cubicBezTo>
                  <a:close/>
                  <a:moveTo>
                    <a:pt x="2124521" y="355125"/>
                  </a:moveTo>
                  <a:cubicBezTo>
                    <a:pt x="1146943" y="355125"/>
                    <a:pt x="353672" y="1146369"/>
                    <a:pt x="353672" y="2124520"/>
                  </a:cubicBezTo>
                  <a:cubicBezTo>
                    <a:pt x="353672" y="3103918"/>
                    <a:pt x="1146943" y="3896407"/>
                    <a:pt x="2124521" y="3896407"/>
                  </a:cubicBezTo>
                  <a:cubicBezTo>
                    <a:pt x="3103345" y="3896407"/>
                    <a:pt x="3895371" y="3103918"/>
                    <a:pt x="3895371" y="2124520"/>
                  </a:cubicBezTo>
                  <a:cubicBezTo>
                    <a:pt x="3895371" y="1146369"/>
                    <a:pt x="3103345" y="355125"/>
                    <a:pt x="2124521" y="355125"/>
                  </a:cubicBezTo>
                  <a:close/>
                  <a:moveTo>
                    <a:pt x="2124521" y="0"/>
                  </a:moveTo>
                  <a:cubicBezTo>
                    <a:pt x="3298861" y="0"/>
                    <a:pt x="4250287" y="950738"/>
                    <a:pt x="4250287" y="2124520"/>
                  </a:cubicBezTo>
                  <a:cubicBezTo>
                    <a:pt x="4250287" y="3298302"/>
                    <a:pt x="3298861" y="4250286"/>
                    <a:pt x="2124521" y="4250286"/>
                  </a:cubicBezTo>
                  <a:cubicBezTo>
                    <a:pt x="951427" y="4250286"/>
                    <a:pt x="0" y="3298302"/>
                    <a:pt x="0" y="2124520"/>
                  </a:cubicBezTo>
                  <a:cubicBezTo>
                    <a:pt x="0" y="950738"/>
                    <a:pt x="951427" y="0"/>
                    <a:pt x="2124521" y="0"/>
                  </a:cubicBezTo>
                  <a:close/>
                </a:path>
              </a:pathLst>
            </a:custGeom>
            <a:solidFill>
              <a:srgbClr val="DB3A3E"/>
            </a:solidFill>
            <a:ln>
              <a:noFill/>
            </a:ln>
            <a:effectLst/>
          </p:spPr>
          <p:txBody>
            <a:bodyPr wrap="square" anchor="ctr">
              <a:noAutofit/>
            </a:bodyP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272727"/>
                </a:solidFill>
                <a:effectLst/>
                <a:uLnTx/>
                <a:uFillTx/>
                <a:latin typeface="Tw Cen MT" panose="020B0602020104020603" pitchFamily="34" charset="77"/>
              </a:endParaRPr>
            </a:p>
          </p:txBody>
        </p:sp>
        <p:sp>
          <p:nvSpPr>
            <p:cNvPr id="64" name="Freeform 89">
              <a:extLst>
                <a:ext uri="{FF2B5EF4-FFF2-40B4-BE49-F238E27FC236}">
                  <a16:creationId xmlns:a16="http://schemas.microsoft.com/office/drawing/2014/main" id="{9FD8CD2F-B0A6-A946-B148-760694BD02F5}"/>
                </a:ext>
              </a:extLst>
            </p:cNvPr>
            <p:cNvSpPr>
              <a:spLocks noChangeArrowheads="1"/>
            </p:cNvSpPr>
            <p:nvPr/>
          </p:nvSpPr>
          <p:spPr bwMode="auto">
            <a:xfrm flipV="1">
              <a:off x="5591099" y="7623145"/>
              <a:ext cx="846865" cy="846865"/>
            </a:xfrm>
            <a:custGeom>
              <a:avLst/>
              <a:gdLst>
                <a:gd name="T0" fmla="*/ 461 w 462"/>
                <a:gd name="T1" fmla="*/ 231 h 463"/>
                <a:gd name="T2" fmla="*/ 461 w 462"/>
                <a:gd name="T3" fmla="*/ 231 h 463"/>
                <a:gd name="T4" fmla="*/ 230 w 462"/>
                <a:gd name="T5" fmla="*/ 462 h 463"/>
                <a:gd name="T6" fmla="*/ 230 w 462"/>
                <a:gd name="T7" fmla="*/ 462 h 463"/>
                <a:gd name="T8" fmla="*/ 0 w 462"/>
                <a:gd name="T9" fmla="*/ 231 h 463"/>
                <a:gd name="T10" fmla="*/ 0 w 462"/>
                <a:gd name="T11" fmla="*/ 231 h 463"/>
                <a:gd name="T12" fmla="*/ 230 w 462"/>
                <a:gd name="T13" fmla="*/ 0 h 463"/>
                <a:gd name="T14" fmla="*/ 230 w 462"/>
                <a:gd name="T15" fmla="*/ 0 h 463"/>
                <a:gd name="T16" fmla="*/ 461 w 462"/>
                <a:gd name="T17" fmla="*/ 231 h 4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Lst>
              <a:rect l="0" t="0" r="r" b="b"/>
              <a:pathLst>
                <a:path w="462" h="463">
                  <a:moveTo>
                    <a:pt x="461" y="231"/>
                  </a:moveTo>
                  <a:lnTo>
                    <a:pt x="461" y="231"/>
                  </a:lnTo>
                  <a:cubicBezTo>
                    <a:pt x="461" y="359"/>
                    <a:pt x="358" y="462"/>
                    <a:pt x="230" y="462"/>
                  </a:cubicBezTo>
                  <a:lnTo>
                    <a:pt x="230" y="462"/>
                  </a:lnTo>
                  <a:cubicBezTo>
                    <a:pt x="103" y="462"/>
                    <a:pt x="0" y="359"/>
                    <a:pt x="0" y="231"/>
                  </a:cubicBezTo>
                  <a:lnTo>
                    <a:pt x="0" y="231"/>
                  </a:lnTo>
                  <a:cubicBezTo>
                    <a:pt x="0" y="104"/>
                    <a:pt x="103" y="0"/>
                    <a:pt x="230" y="0"/>
                  </a:cubicBezTo>
                  <a:lnTo>
                    <a:pt x="230" y="0"/>
                  </a:lnTo>
                  <a:cubicBezTo>
                    <a:pt x="358" y="0"/>
                    <a:pt x="461" y="104"/>
                    <a:pt x="461" y="231"/>
                  </a:cubicBezTo>
                </a:path>
              </a:pathLst>
            </a:custGeom>
            <a:solidFill>
              <a:srgbClr val="111340">
                <a:alpha val="30000"/>
              </a:srgbClr>
            </a:solidFill>
            <a:ln>
              <a:noFill/>
            </a:ln>
            <a:effectLst/>
          </p:spPr>
          <p:txBody>
            <a:bodyPr wrap="none" anchor="ct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272727"/>
                </a:solidFill>
                <a:effectLst/>
                <a:uLnTx/>
                <a:uFillTx/>
                <a:latin typeface="Tw Cen MT" panose="020B0602020104020603" pitchFamily="34" charset="77"/>
              </a:endParaRPr>
            </a:p>
          </p:txBody>
        </p:sp>
        <p:sp>
          <p:nvSpPr>
            <p:cNvPr id="65" name="Freeform 90">
              <a:extLst>
                <a:ext uri="{FF2B5EF4-FFF2-40B4-BE49-F238E27FC236}">
                  <a16:creationId xmlns:a16="http://schemas.microsoft.com/office/drawing/2014/main" id="{2E894C03-254A-5840-BD79-E0CEB64AC326}"/>
                </a:ext>
              </a:extLst>
            </p:cNvPr>
            <p:cNvSpPr>
              <a:spLocks noChangeArrowheads="1"/>
            </p:cNvSpPr>
            <p:nvPr/>
          </p:nvSpPr>
          <p:spPr bwMode="auto">
            <a:xfrm flipV="1">
              <a:off x="5954048" y="5872961"/>
              <a:ext cx="4210117" cy="2234101"/>
            </a:xfrm>
            <a:custGeom>
              <a:avLst/>
              <a:gdLst>
                <a:gd name="T0" fmla="*/ 2240 w 2301"/>
                <a:gd name="T1" fmla="*/ 1209 h 1220"/>
                <a:gd name="T2" fmla="*/ 25 w 2301"/>
                <a:gd name="T3" fmla="*/ 76 h 1220"/>
                <a:gd name="T4" fmla="*/ 25 w 2301"/>
                <a:gd name="T5" fmla="*/ 76 h 1220"/>
                <a:gd name="T6" fmla="*/ 9 w 2301"/>
                <a:gd name="T7" fmla="*/ 26 h 1220"/>
                <a:gd name="T8" fmla="*/ 9 w 2301"/>
                <a:gd name="T9" fmla="*/ 26 h 1220"/>
                <a:gd name="T10" fmla="*/ 59 w 2301"/>
                <a:gd name="T11" fmla="*/ 10 h 1220"/>
                <a:gd name="T12" fmla="*/ 2274 w 2301"/>
                <a:gd name="T13" fmla="*/ 1143 h 1220"/>
                <a:gd name="T14" fmla="*/ 2274 w 2301"/>
                <a:gd name="T15" fmla="*/ 1143 h 1220"/>
                <a:gd name="T16" fmla="*/ 2290 w 2301"/>
                <a:gd name="T17" fmla="*/ 1193 h 1220"/>
                <a:gd name="T18" fmla="*/ 2290 w 2301"/>
                <a:gd name="T19" fmla="*/ 1193 h 1220"/>
                <a:gd name="T20" fmla="*/ 2240 w 2301"/>
                <a:gd name="T21" fmla="*/ 1209 h 122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301" h="1220">
                  <a:moveTo>
                    <a:pt x="2240" y="1209"/>
                  </a:moveTo>
                  <a:lnTo>
                    <a:pt x="25" y="76"/>
                  </a:lnTo>
                  <a:lnTo>
                    <a:pt x="25" y="76"/>
                  </a:lnTo>
                  <a:cubicBezTo>
                    <a:pt x="7" y="66"/>
                    <a:pt x="0" y="44"/>
                    <a:pt x="9" y="26"/>
                  </a:cubicBezTo>
                  <a:lnTo>
                    <a:pt x="9" y="26"/>
                  </a:lnTo>
                  <a:cubicBezTo>
                    <a:pt x="18" y="8"/>
                    <a:pt x="41" y="0"/>
                    <a:pt x="59" y="10"/>
                  </a:cubicBezTo>
                  <a:lnTo>
                    <a:pt x="2274" y="1143"/>
                  </a:lnTo>
                  <a:lnTo>
                    <a:pt x="2274" y="1143"/>
                  </a:lnTo>
                  <a:cubicBezTo>
                    <a:pt x="2292" y="1153"/>
                    <a:pt x="2300" y="1175"/>
                    <a:pt x="2290" y="1193"/>
                  </a:cubicBezTo>
                  <a:lnTo>
                    <a:pt x="2290" y="1193"/>
                  </a:lnTo>
                  <a:cubicBezTo>
                    <a:pt x="2281" y="1212"/>
                    <a:pt x="2259" y="1219"/>
                    <a:pt x="2240" y="1209"/>
                  </a:cubicBezTo>
                </a:path>
              </a:pathLst>
            </a:custGeom>
            <a:solidFill>
              <a:srgbClr val="000000"/>
            </a:solidFill>
            <a:ln>
              <a:noFill/>
            </a:ln>
            <a:effectLst/>
          </p:spPr>
          <p:txBody>
            <a:bodyPr wrap="none" anchor="ct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272727"/>
                </a:solidFill>
                <a:effectLst/>
                <a:uLnTx/>
                <a:uFillTx/>
                <a:latin typeface="Tw Cen MT" panose="020B0602020104020603" pitchFamily="34" charset="77"/>
              </a:endParaRPr>
            </a:p>
          </p:txBody>
        </p:sp>
        <p:sp>
          <p:nvSpPr>
            <p:cNvPr id="66" name="Freeform 65">
              <a:extLst>
                <a:ext uri="{FF2B5EF4-FFF2-40B4-BE49-F238E27FC236}">
                  <a16:creationId xmlns:a16="http://schemas.microsoft.com/office/drawing/2014/main" id="{30DECAB5-61A7-F84D-8D07-90C13A0B47D7}"/>
                </a:ext>
              </a:extLst>
            </p:cNvPr>
            <p:cNvSpPr>
              <a:spLocks noChangeArrowheads="1"/>
            </p:cNvSpPr>
            <p:nvPr/>
          </p:nvSpPr>
          <p:spPr bwMode="auto">
            <a:xfrm flipV="1">
              <a:off x="9147924" y="5446329"/>
              <a:ext cx="1360314" cy="1192838"/>
            </a:xfrm>
            <a:custGeom>
              <a:avLst/>
              <a:gdLst>
                <a:gd name="connsiteX0" fmla="*/ 0 w 926446"/>
                <a:gd name="connsiteY0" fmla="*/ 192251 h 812386"/>
                <a:gd name="connsiteX1" fmla="*/ 576610 w 926446"/>
                <a:gd name="connsiteY1" fmla="*/ 489197 h 812386"/>
                <a:gd name="connsiteX2" fmla="*/ 651172 w 926446"/>
                <a:gd name="connsiteY2" fmla="*/ 812234 h 812386"/>
                <a:gd name="connsiteX3" fmla="*/ 461040 w 926446"/>
                <a:gd name="connsiteY3" fmla="*/ 699171 h 812386"/>
                <a:gd name="connsiteX4" fmla="*/ 197588 w 926446"/>
                <a:gd name="connsiteY4" fmla="*/ 387316 h 812386"/>
                <a:gd name="connsiteX5" fmla="*/ 218714 w 926446"/>
                <a:gd name="connsiteY5" fmla="*/ 560016 h 812386"/>
                <a:gd name="connsiteX6" fmla="*/ 69590 w 926446"/>
                <a:gd name="connsiteY6" fmla="*/ 476772 h 812386"/>
                <a:gd name="connsiteX7" fmla="*/ 311928 w 926446"/>
                <a:gd name="connsiteY7" fmla="*/ 0 h 812386"/>
                <a:gd name="connsiteX8" fmla="*/ 466772 w 926446"/>
                <a:gd name="connsiteY8" fmla="*/ 72097 h 812386"/>
                <a:gd name="connsiteX9" fmla="*/ 313176 w 926446"/>
                <a:gd name="connsiteY9" fmla="*/ 156624 h 812386"/>
                <a:gd name="connsiteX10" fmla="*/ 722764 w 926446"/>
                <a:gd name="connsiteY10" fmla="*/ 186457 h 812386"/>
                <a:gd name="connsiteX11" fmla="*/ 926310 w 926446"/>
                <a:gd name="connsiteY11" fmla="*/ 275957 h 812386"/>
                <a:gd name="connsiteX12" fmla="*/ 619118 w 926446"/>
                <a:gd name="connsiteY12" fmla="*/ 405234 h 812386"/>
                <a:gd name="connsiteX13" fmla="*/ 38452 w 926446"/>
                <a:gd name="connsiteY13" fmla="*/ 109388 h 8123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926446" h="812386">
                  <a:moveTo>
                    <a:pt x="0" y="192251"/>
                  </a:moveTo>
                  <a:lnTo>
                    <a:pt x="576610" y="489197"/>
                  </a:lnTo>
                  <a:cubicBezTo>
                    <a:pt x="581582" y="509076"/>
                    <a:pt x="648688" y="806021"/>
                    <a:pt x="651172" y="812234"/>
                  </a:cubicBezTo>
                  <a:cubicBezTo>
                    <a:pt x="652416" y="817204"/>
                    <a:pt x="461040" y="699171"/>
                    <a:pt x="461040" y="699171"/>
                  </a:cubicBezTo>
                  <a:lnTo>
                    <a:pt x="197588" y="387316"/>
                  </a:lnTo>
                  <a:lnTo>
                    <a:pt x="218714" y="560016"/>
                  </a:lnTo>
                  <a:lnTo>
                    <a:pt x="69590" y="476772"/>
                  </a:lnTo>
                  <a:close/>
                  <a:moveTo>
                    <a:pt x="311928" y="0"/>
                  </a:moveTo>
                  <a:lnTo>
                    <a:pt x="466772" y="72097"/>
                  </a:lnTo>
                  <a:lnTo>
                    <a:pt x="313176" y="156624"/>
                  </a:lnTo>
                  <a:lnTo>
                    <a:pt x="722764" y="186457"/>
                  </a:lnTo>
                  <a:cubicBezTo>
                    <a:pt x="722764" y="186457"/>
                    <a:pt x="932554" y="274714"/>
                    <a:pt x="926310" y="275957"/>
                  </a:cubicBezTo>
                  <a:cubicBezTo>
                    <a:pt x="921314" y="277200"/>
                    <a:pt x="639098" y="396533"/>
                    <a:pt x="619118" y="405234"/>
                  </a:cubicBezTo>
                  <a:lnTo>
                    <a:pt x="38452" y="109388"/>
                  </a:lnTo>
                  <a:close/>
                </a:path>
              </a:pathLst>
            </a:custGeom>
            <a:solidFill>
              <a:srgbClr val="DB3A3E"/>
            </a:solidFill>
            <a:ln>
              <a:noFill/>
            </a:ln>
            <a:effectLst/>
          </p:spPr>
          <p:txBody>
            <a:bodyPr wrap="square" anchor="ctr">
              <a:noAutofit/>
            </a:bodyPr>
            <a:lstStyle/>
            <a:p>
              <a:pPr marL="0" marR="0" lvl="0" indent="0" defTabSz="685846" eaLnBrk="1" fontAlgn="auto" latinLnBrk="0" hangingPunct="1">
                <a:lnSpc>
                  <a:spcPct val="100000"/>
                </a:lnSpc>
                <a:spcBef>
                  <a:spcPts val="0"/>
                </a:spcBef>
                <a:spcAft>
                  <a:spcPts val="0"/>
                </a:spcAft>
                <a:buClrTx/>
                <a:buSzTx/>
                <a:buFontTx/>
                <a:buNone/>
                <a:tabLst/>
                <a:defRPr/>
              </a:pPr>
              <a:endParaRPr kumimoji="0" lang="en-US" sz="1350" b="0" i="0" u="none" strike="noStrike" kern="0" cap="none" spc="0" normalizeH="0" baseline="0" noProof="0">
                <a:ln>
                  <a:noFill/>
                </a:ln>
                <a:solidFill>
                  <a:srgbClr val="272727"/>
                </a:solidFill>
                <a:effectLst/>
                <a:uLnTx/>
                <a:uFillTx/>
                <a:latin typeface="Tw Cen MT" panose="020B0602020104020603" pitchFamily="34" charset="77"/>
              </a:endParaRPr>
            </a:p>
          </p:txBody>
        </p:sp>
      </p:grpSp>
      <p:sp>
        <p:nvSpPr>
          <p:cNvPr id="67" name="TextBox 66">
            <a:extLst>
              <a:ext uri="{FF2B5EF4-FFF2-40B4-BE49-F238E27FC236}">
                <a16:creationId xmlns:a16="http://schemas.microsoft.com/office/drawing/2014/main" id="{0F7CE110-6D83-8E47-A48C-994E1B2B49F2}"/>
              </a:ext>
            </a:extLst>
          </p:cNvPr>
          <p:cNvSpPr txBox="1"/>
          <p:nvPr/>
        </p:nvSpPr>
        <p:spPr>
          <a:xfrm>
            <a:off x="5508940" y="1577456"/>
            <a:ext cx="2726159" cy="1015663"/>
          </a:xfrm>
          <a:prstGeom prst="rect">
            <a:avLst/>
          </a:prstGeom>
          <a:noFill/>
        </p:spPr>
        <p:txBody>
          <a:bodyPr wrap="square" rtlCol="0" anchor="b">
            <a:spAutoFit/>
          </a:bodyPr>
          <a:lstStyle/>
          <a:p>
            <a:pPr defTabSz="685846"/>
            <a:r>
              <a:rPr lang="en-US" sz="1200" b="1" spc="-11" dirty="0">
                <a:solidFill>
                  <a:srgbClr val="000000"/>
                </a:solidFill>
                <a:latin typeface="Tw Cen MT" panose="020B0602020104020603" pitchFamily="34" charset="77"/>
                <a:cs typeface="Poppins" pitchFamily="2" charset="77"/>
              </a:rPr>
              <a:t>WHAT IS THE PURPOSE OF THE LIVED EXPERIENCE WORKING GROUP? </a:t>
            </a:r>
            <a:br>
              <a:rPr lang="en-US" sz="1200" b="1" spc="-11" dirty="0">
                <a:solidFill>
                  <a:srgbClr val="000000"/>
                </a:solidFill>
                <a:latin typeface="Tw Cen MT" panose="020B0602020104020603" pitchFamily="34" charset="77"/>
                <a:cs typeface="Poppins" pitchFamily="2" charset="77"/>
              </a:rPr>
            </a:br>
            <a:r>
              <a:rPr lang="en-US" sz="1200" i="1" spc="-11" dirty="0">
                <a:solidFill>
                  <a:srgbClr val="000000"/>
                </a:solidFill>
                <a:latin typeface="Tw Cen MT" panose="020B0602020104020603" pitchFamily="34" charset="77"/>
                <a:cs typeface="Poppins" pitchFamily="2" charset="77"/>
              </a:rPr>
              <a:t>(e.g. empowering young people, learning new skills, </a:t>
            </a:r>
            <a:r>
              <a:rPr lang="en-US" sz="1200" i="1" spc="-11" dirty="0" err="1">
                <a:solidFill>
                  <a:srgbClr val="000000"/>
                </a:solidFill>
                <a:latin typeface="Tw Cen MT" panose="020B0602020104020603" pitchFamily="34" charset="77"/>
                <a:cs typeface="Poppins" pitchFamily="2" charset="77"/>
              </a:rPr>
              <a:t>etc</a:t>
            </a:r>
            <a:r>
              <a:rPr lang="en-US" sz="1200" i="1" spc="-11" dirty="0">
                <a:solidFill>
                  <a:srgbClr val="000000"/>
                </a:solidFill>
                <a:latin typeface="Tw Cen MT" panose="020B0602020104020603" pitchFamily="34" charset="77"/>
                <a:cs typeface="Poppins" pitchFamily="2" charset="77"/>
              </a:rPr>
              <a:t>)</a:t>
            </a:r>
            <a:br>
              <a:rPr lang="en-US" sz="1200" i="1" spc="-11" dirty="0">
                <a:solidFill>
                  <a:srgbClr val="000000"/>
                </a:solidFill>
                <a:latin typeface="Tw Cen MT" panose="020B0602020104020603" pitchFamily="34" charset="77"/>
                <a:cs typeface="Poppins" pitchFamily="2" charset="77"/>
              </a:rPr>
            </a:br>
            <a:r>
              <a:rPr lang="en-US" sz="1200" i="1" spc="-11" dirty="0">
                <a:solidFill>
                  <a:schemeClr val="tx2"/>
                </a:solidFill>
                <a:latin typeface="Tw Cen MT" panose="020B0602020104020603" pitchFamily="34" charset="77"/>
                <a:cs typeface="Poppins" pitchFamily="2" charset="77"/>
              </a:rPr>
              <a:t>ACTION: TOR, create Slack group</a:t>
            </a:r>
          </a:p>
        </p:txBody>
      </p:sp>
      <p:sp>
        <p:nvSpPr>
          <p:cNvPr id="69" name="TextBox 68">
            <a:extLst>
              <a:ext uri="{FF2B5EF4-FFF2-40B4-BE49-F238E27FC236}">
                <a16:creationId xmlns:a16="http://schemas.microsoft.com/office/drawing/2014/main" id="{22298092-8327-3444-886B-3937414AE4BE}"/>
              </a:ext>
            </a:extLst>
          </p:cNvPr>
          <p:cNvSpPr txBox="1"/>
          <p:nvPr/>
        </p:nvSpPr>
        <p:spPr>
          <a:xfrm>
            <a:off x="5508943" y="3001434"/>
            <a:ext cx="2726157" cy="1015663"/>
          </a:xfrm>
          <a:prstGeom prst="rect">
            <a:avLst/>
          </a:prstGeom>
          <a:noFill/>
        </p:spPr>
        <p:txBody>
          <a:bodyPr wrap="square" lIns="91440" tIns="45720" rIns="91440" bIns="45720" rtlCol="0" anchor="b">
            <a:spAutoFit/>
          </a:bodyPr>
          <a:lstStyle/>
          <a:p>
            <a:pPr defTabSz="685846"/>
            <a:r>
              <a:rPr lang="en-US" sz="1200" b="1" spc="-11" dirty="0">
                <a:solidFill>
                  <a:srgbClr val="000000"/>
                </a:solidFill>
                <a:latin typeface="Tw Cen MT"/>
                <a:cs typeface="Poppins"/>
              </a:rPr>
              <a:t>WHAT ARE OUR GOALS BY THE NEXT LIVED EXPERIENCE WORKING GROUP MEETING?</a:t>
            </a:r>
            <a:br>
              <a:rPr lang="en-US" sz="1200" b="1" spc="-11" dirty="0">
                <a:latin typeface="Tw Cen MT" panose="020B0602020104020603" pitchFamily="34" charset="77"/>
                <a:cs typeface="Poppins" pitchFamily="2" charset="77"/>
              </a:rPr>
            </a:br>
            <a:r>
              <a:rPr lang="en-US" sz="1200" i="1" spc="-11" dirty="0">
                <a:solidFill>
                  <a:schemeClr val="tx2"/>
                </a:solidFill>
                <a:latin typeface="Tw Cen MT"/>
                <a:cs typeface="Poppins"/>
              </a:rPr>
              <a:t>ACTION: Provide ‘crash course’ on research stages </a:t>
            </a:r>
            <a:endParaRPr lang="en-US" sz="1200" spc="-11" dirty="0">
              <a:solidFill>
                <a:schemeClr val="tx2"/>
              </a:solidFill>
              <a:latin typeface="Tw Cen MT"/>
              <a:cs typeface="Poppins"/>
            </a:endParaRPr>
          </a:p>
        </p:txBody>
      </p:sp>
      <p:sp>
        <p:nvSpPr>
          <p:cNvPr id="76" name="TextBox 75">
            <a:extLst>
              <a:ext uri="{FF2B5EF4-FFF2-40B4-BE49-F238E27FC236}">
                <a16:creationId xmlns:a16="http://schemas.microsoft.com/office/drawing/2014/main" id="{F9D7A803-10EA-064F-BF6C-06B6B89F9189}"/>
              </a:ext>
            </a:extLst>
          </p:cNvPr>
          <p:cNvSpPr txBox="1"/>
          <p:nvPr/>
        </p:nvSpPr>
        <p:spPr>
          <a:xfrm>
            <a:off x="5508942" y="4208570"/>
            <a:ext cx="2726157" cy="1015663"/>
          </a:xfrm>
          <a:prstGeom prst="rect">
            <a:avLst/>
          </a:prstGeom>
          <a:noFill/>
        </p:spPr>
        <p:txBody>
          <a:bodyPr wrap="square" rtlCol="0" anchor="b">
            <a:spAutoFit/>
          </a:bodyPr>
          <a:lstStyle/>
          <a:p>
            <a:pPr defTabSz="685846"/>
            <a:r>
              <a:rPr lang="en-US" sz="1200" b="1" spc="-11" dirty="0">
                <a:solidFill>
                  <a:srgbClr val="000000"/>
                </a:solidFill>
                <a:latin typeface="Tw Cen MT" panose="020B0602020104020603" pitchFamily="34" charset="77"/>
                <a:cs typeface="Poppins" pitchFamily="2" charset="77"/>
              </a:rPr>
              <a:t>WHAT ARE OUR GOALS BY THE END OF THE YEAR?</a:t>
            </a:r>
            <a:br>
              <a:rPr lang="en-US" sz="1200" b="1" spc="-11" dirty="0">
                <a:solidFill>
                  <a:srgbClr val="000000"/>
                </a:solidFill>
                <a:latin typeface="Tw Cen MT" panose="020B0602020104020603" pitchFamily="34" charset="77"/>
                <a:cs typeface="Poppins" pitchFamily="2" charset="77"/>
              </a:rPr>
            </a:br>
            <a:r>
              <a:rPr lang="en-US" sz="1200" i="1" spc="-11" dirty="0">
                <a:solidFill>
                  <a:schemeClr val="tx2"/>
                </a:solidFill>
                <a:latin typeface="Tw Cen MT" panose="020B0602020104020603" pitchFamily="34" charset="77"/>
                <a:cs typeface="Poppins" pitchFamily="2" charset="77"/>
              </a:rPr>
              <a:t>ACTION: Plan an opinion piece on guidelines of working with LE (educating researchers, setting research priorities) </a:t>
            </a:r>
            <a:endParaRPr lang="en-US" sz="1200" b="1" spc="-11" dirty="0">
              <a:solidFill>
                <a:schemeClr val="tx2"/>
              </a:solidFill>
              <a:latin typeface="Tw Cen MT" panose="020B0602020104020603" pitchFamily="34" charset="77"/>
              <a:cs typeface="Poppins" pitchFamily="2" charset="77"/>
            </a:endParaRPr>
          </a:p>
        </p:txBody>
      </p:sp>
      <p:sp>
        <p:nvSpPr>
          <p:cNvPr id="79" name="Freeform 757">
            <a:extLst>
              <a:ext uri="{FF2B5EF4-FFF2-40B4-BE49-F238E27FC236}">
                <a16:creationId xmlns:a16="http://schemas.microsoft.com/office/drawing/2014/main" id="{A5C271A3-F497-5F49-AF11-C4AF673F45EA}"/>
              </a:ext>
            </a:extLst>
          </p:cNvPr>
          <p:cNvSpPr>
            <a:spLocks noChangeArrowheads="1"/>
          </p:cNvSpPr>
          <p:nvPr/>
        </p:nvSpPr>
        <p:spPr bwMode="auto">
          <a:xfrm>
            <a:off x="4543470" y="4380324"/>
            <a:ext cx="513473" cy="532051"/>
          </a:xfrm>
          <a:custGeom>
            <a:avLst/>
            <a:gdLst/>
            <a:ahLst/>
            <a:cxnLst/>
            <a:rect l="0" t="0" r="r" b="b"/>
            <a:pathLst>
              <a:path w="309202" h="308874">
                <a:moveTo>
                  <a:pt x="109321" y="223205"/>
                </a:moveTo>
                <a:lnTo>
                  <a:pt x="109321" y="263520"/>
                </a:lnTo>
                <a:lnTo>
                  <a:pt x="199881" y="297356"/>
                </a:lnTo>
                <a:lnTo>
                  <a:pt x="199881" y="257041"/>
                </a:lnTo>
                <a:lnTo>
                  <a:pt x="109321" y="223205"/>
                </a:lnTo>
                <a:close/>
                <a:moveTo>
                  <a:pt x="99940" y="223205"/>
                </a:moveTo>
                <a:lnTo>
                  <a:pt x="9020" y="257041"/>
                </a:lnTo>
                <a:lnTo>
                  <a:pt x="9020" y="297356"/>
                </a:lnTo>
                <a:lnTo>
                  <a:pt x="99940" y="263520"/>
                </a:lnTo>
                <a:lnTo>
                  <a:pt x="99940" y="223205"/>
                </a:lnTo>
                <a:close/>
                <a:moveTo>
                  <a:pt x="299822" y="144015"/>
                </a:moveTo>
                <a:lnTo>
                  <a:pt x="270597" y="154813"/>
                </a:lnTo>
                <a:lnTo>
                  <a:pt x="270597" y="231124"/>
                </a:lnTo>
                <a:cubicBezTo>
                  <a:pt x="270597" y="232924"/>
                  <a:pt x="269515" y="234723"/>
                  <a:pt x="267711" y="235443"/>
                </a:cubicBezTo>
                <a:lnTo>
                  <a:pt x="209262" y="257041"/>
                </a:lnTo>
                <a:lnTo>
                  <a:pt x="209262" y="297356"/>
                </a:lnTo>
                <a:lnTo>
                  <a:pt x="299822" y="263520"/>
                </a:lnTo>
                <a:lnTo>
                  <a:pt x="299822" y="144015"/>
                </a:lnTo>
                <a:close/>
                <a:moveTo>
                  <a:pt x="99940" y="144015"/>
                </a:moveTo>
                <a:lnTo>
                  <a:pt x="9020" y="177490"/>
                </a:lnTo>
                <a:lnTo>
                  <a:pt x="9020" y="247322"/>
                </a:lnTo>
                <a:lnTo>
                  <a:pt x="99940" y="213486"/>
                </a:lnTo>
                <a:lnTo>
                  <a:pt x="99940" y="144015"/>
                </a:lnTo>
                <a:close/>
                <a:moveTo>
                  <a:pt x="99940" y="64464"/>
                </a:moveTo>
                <a:lnTo>
                  <a:pt x="9020" y="98300"/>
                </a:lnTo>
                <a:lnTo>
                  <a:pt x="9020" y="167772"/>
                </a:lnTo>
                <a:lnTo>
                  <a:pt x="99940" y="133576"/>
                </a:lnTo>
                <a:lnTo>
                  <a:pt x="99940" y="64464"/>
                </a:lnTo>
                <a:close/>
                <a:moveTo>
                  <a:pt x="204606" y="42474"/>
                </a:moveTo>
                <a:cubicBezTo>
                  <a:pt x="194050" y="42474"/>
                  <a:pt x="185677" y="50846"/>
                  <a:pt x="185677" y="61402"/>
                </a:cubicBezTo>
                <a:cubicBezTo>
                  <a:pt x="185677" y="71959"/>
                  <a:pt x="194050" y="80331"/>
                  <a:pt x="204606" y="80331"/>
                </a:cubicBezTo>
                <a:cubicBezTo>
                  <a:pt x="215162" y="80331"/>
                  <a:pt x="223535" y="71959"/>
                  <a:pt x="223535" y="61402"/>
                </a:cubicBezTo>
                <a:cubicBezTo>
                  <a:pt x="223535" y="50846"/>
                  <a:pt x="215162" y="42474"/>
                  <a:pt x="204606" y="42474"/>
                </a:cubicBezTo>
                <a:close/>
                <a:moveTo>
                  <a:pt x="204606" y="33009"/>
                </a:moveTo>
                <a:cubicBezTo>
                  <a:pt x="220259" y="33009"/>
                  <a:pt x="232999" y="45750"/>
                  <a:pt x="232999" y="61402"/>
                </a:cubicBezTo>
                <a:cubicBezTo>
                  <a:pt x="232999" y="77055"/>
                  <a:pt x="220259" y="89795"/>
                  <a:pt x="204606" y="89795"/>
                </a:cubicBezTo>
                <a:cubicBezTo>
                  <a:pt x="188954" y="89795"/>
                  <a:pt x="176213" y="77055"/>
                  <a:pt x="176213" y="61402"/>
                </a:cubicBezTo>
                <a:cubicBezTo>
                  <a:pt x="176213" y="45750"/>
                  <a:pt x="188954" y="33009"/>
                  <a:pt x="204606" y="33009"/>
                </a:cubicBezTo>
                <a:close/>
                <a:moveTo>
                  <a:pt x="109321" y="11550"/>
                </a:moveTo>
                <a:lnTo>
                  <a:pt x="109321" y="133576"/>
                </a:lnTo>
                <a:lnTo>
                  <a:pt x="170296" y="156613"/>
                </a:lnTo>
                <a:cubicBezTo>
                  <a:pt x="172460" y="157693"/>
                  <a:pt x="173904" y="160213"/>
                  <a:pt x="172821" y="162732"/>
                </a:cubicBezTo>
                <a:cubicBezTo>
                  <a:pt x="172460" y="164532"/>
                  <a:pt x="170296" y="165612"/>
                  <a:pt x="168492" y="165612"/>
                </a:cubicBezTo>
                <a:cubicBezTo>
                  <a:pt x="168131" y="165612"/>
                  <a:pt x="167409" y="165612"/>
                  <a:pt x="166688" y="165252"/>
                </a:cubicBezTo>
                <a:lnTo>
                  <a:pt x="109321" y="144015"/>
                </a:lnTo>
                <a:lnTo>
                  <a:pt x="109321" y="213486"/>
                </a:lnTo>
                <a:lnTo>
                  <a:pt x="199881" y="247322"/>
                </a:lnTo>
                <a:lnTo>
                  <a:pt x="199881" y="201247"/>
                </a:lnTo>
                <a:cubicBezTo>
                  <a:pt x="199881" y="198728"/>
                  <a:pt x="202046" y="196568"/>
                  <a:pt x="204571" y="196568"/>
                </a:cubicBezTo>
                <a:cubicBezTo>
                  <a:pt x="207097" y="196568"/>
                  <a:pt x="209262" y="198728"/>
                  <a:pt x="209262" y="201247"/>
                </a:cubicBezTo>
                <a:lnTo>
                  <a:pt x="209262" y="247322"/>
                </a:lnTo>
                <a:lnTo>
                  <a:pt x="261216" y="227884"/>
                </a:lnTo>
                <a:lnTo>
                  <a:pt x="261216" y="158413"/>
                </a:lnTo>
                <a:lnTo>
                  <a:pt x="242094" y="165252"/>
                </a:lnTo>
                <a:cubicBezTo>
                  <a:pt x="241733" y="165612"/>
                  <a:pt x="241012" y="165612"/>
                  <a:pt x="240651" y="165612"/>
                </a:cubicBezTo>
                <a:cubicBezTo>
                  <a:pt x="238486" y="165612"/>
                  <a:pt x="236682" y="164532"/>
                  <a:pt x="235961" y="162732"/>
                </a:cubicBezTo>
                <a:cubicBezTo>
                  <a:pt x="235239" y="160213"/>
                  <a:pt x="236322" y="157693"/>
                  <a:pt x="238847" y="156613"/>
                </a:cubicBezTo>
                <a:lnTo>
                  <a:pt x="299822" y="133576"/>
                </a:lnTo>
                <a:lnTo>
                  <a:pt x="299822" y="11550"/>
                </a:lnTo>
                <a:lnTo>
                  <a:pt x="255805" y="28108"/>
                </a:lnTo>
                <a:cubicBezTo>
                  <a:pt x="261938" y="37468"/>
                  <a:pt x="265546" y="48626"/>
                  <a:pt x="265546" y="60865"/>
                </a:cubicBezTo>
                <a:cubicBezTo>
                  <a:pt x="265546" y="106579"/>
                  <a:pt x="210344" y="174611"/>
                  <a:pt x="208179" y="177490"/>
                </a:cubicBezTo>
                <a:cubicBezTo>
                  <a:pt x="207458" y="178570"/>
                  <a:pt x="206015" y="179290"/>
                  <a:pt x="204571" y="179290"/>
                </a:cubicBezTo>
                <a:cubicBezTo>
                  <a:pt x="203128" y="179290"/>
                  <a:pt x="201685" y="178570"/>
                  <a:pt x="200964" y="177490"/>
                </a:cubicBezTo>
                <a:cubicBezTo>
                  <a:pt x="198438" y="174611"/>
                  <a:pt x="143597" y="106579"/>
                  <a:pt x="143597" y="60865"/>
                </a:cubicBezTo>
                <a:cubicBezTo>
                  <a:pt x="143597" y="48626"/>
                  <a:pt x="147205" y="37468"/>
                  <a:pt x="153338" y="28108"/>
                </a:cubicBezTo>
                <a:lnTo>
                  <a:pt x="109321" y="11550"/>
                </a:lnTo>
                <a:close/>
                <a:moveTo>
                  <a:pt x="99940" y="11550"/>
                </a:moveTo>
                <a:lnTo>
                  <a:pt x="9020" y="45387"/>
                </a:lnTo>
                <a:lnTo>
                  <a:pt x="9020" y="88221"/>
                </a:lnTo>
                <a:lnTo>
                  <a:pt x="99940" y="54026"/>
                </a:lnTo>
                <a:lnTo>
                  <a:pt x="99940" y="11550"/>
                </a:lnTo>
                <a:close/>
                <a:moveTo>
                  <a:pt x="204571" y="9391"/>
                </a:moveTo>
                <a:cubicBezTo>
                  <a:pt x="176068" y="9391"/>
                  <a:pt x="152977" y="32428"/>
                  <a:pt x="152977" y="60865"/>
                </a:cubicBezTo>
                <a:cubicBezTo>
                  <a:pt x="152977" y="96860"/>
                  <a:pt x="192304" y="150854"/>
                  <a:pt x="204571" y="166692"/>
                </a:cubicBezTo>
                <a:cubicBezTo>
                  <a:pt x="216839" y="150854"/>
                  <a:pt x="256165" y="96860"/>
                  <a:pt x="256165" y="60865"/>
                </a:cubicBezTo>
                <a:cubicBezTo>
                  <a:pt x="256165" y="32428"/>
                  <a:pt x="233074" y="9391"/>
                  <a:pt x="204571" y="9391"/>
                </a:cubicBezTo>
                <a:close/>
                <a:moveTo>
                  <a:pt x="103909" y="32"/>
                </a:moveTo>
                <a:cubicBezTo>
                  <a:pt x="103909" y="32"/>
                  <a:pt x="104270" y="32"/>
                  <a:pt x="104631" y="32"/>
                </a:cubicBezTo>
                <a:cubicBezTo>
                  <a:pt x="104631" y="32"/>
                  <a:pt x="104992" y="32"/>
                  <a:pt x="105352" y="32"/>
                </a:cubicBezTo>
                <a:cubicBezTo>
                  <a:pt x="105352" y="32"/>
                  <a:pt x="105713" y="32"/>
                  <a:pt x="105713" y="392"/>
                </a:cubicBezTo>
                <a:cubicBezTo>
                  <a:pt x="106074" y="392"/>
                  <a:pt x="106074" y="392"/>
                  <a:pt x="106074" y="392"/>
                </a:cubicBezTo>
                <a:lnTo>
                  <a:pt x="159472" y="20189"/>
                </a:lnTo>
                <a:cubicBezTo>
                  <a:pt x="170296" y="7951"/>
                  <a:pt x="186532" y="32"/>
                  <a:pt x="204571" y="32"/>
                </a:cubicBezTo>
                <a:cubicBezTo>
                  <a:pt x="222611" y="32"/>
                  <a:pt x="238486" y="7951"/>
                  <a:pt x="249671" y="20189"/>
                </a:cubicBezTo>
                <a:lnTo>
                  <a:pt x="303069" y="392"/>
                </a:lnTo>
                <a:cubicBezTo>
                  <a:pt x="304151" y="-328"/>
                  <a:pt x="305955" y="32"/>
                  <a:pt x="307038" y="752"/>
                </a:cubicBezTo>
                <a:cubicBezTo>
                  <a:pt x="308481" y="1831"/>
                  <a:pt x="309202" y="2911"/>
                  <a:pt x="309202" y="4711"/>
                </a:cubicBezTo>
                <a:lnTo>
                  <a:pt x="309202" y="266759"/>
                </a:lnTo>
                <a:cubicBezTo>
                  <a:pt x="309202" y="268559"/>
                  <a:pt x="307759" y="270359"/>
                  <a:pt x="306316" y="271079"/>
                </a:cubicBezTo>
                <a:lnTo>
                  <a:pt x="206375" y="308154"/>
                </a:lnTo>
                <a:cubicBezTo>
                  <a:pt x="206015" y="308154"/>
                  <a:pt x="206015" y="308154"/>
                  <a:pt x="206015" y="308154"/>
                </a:cubicBezTo>
                <a:cubicBezTo>
                  <a:pt x="205654" y="308514"/>
                  <a:pt x="204932" y="308874"/>
                  <a:pt x="204571" y="308874"/>
                </a:cubicBezTo>
                <a:cubicBezTo>
                  <a:pt x="203850" y="308874"/>
                  <a:pt x="203489" y="308514"/>
                  <a:pt x="203128" y="308154"/>
                </a:cubicBezTo>
                <a:cubicBezTo>
                  <a:pt x="202768" y="308154"/>
                  <a:pt x="202768" y="308154"/>
                  <a:pt x="202768" y="308154"/>
                </a:cubicBezTo>
                <a:lnTo>
                  <a:pt x="104631" y="271439"/>
                </a:lnTo>
                <a:lnTo>
                  <a:pt x="6133" y="308154"/>
                </a:lnTo>
                <a:cubicBezTo>
                  <a:pt x="5412" y="308514"/>
                  <a:pt x="5051" y="308874"/>
                  <a:pt x="4329" y="308874"/>
                </a:cubicBezTo>
                <a:cubicBezTo>
                  <a:pt x="3608" y="308874"/>
                  <a:pt x="2525" y="308154"/>
                  <a:pt x="1804" y="307794"/>
                </a:cubicBezTo>
                <a:cubicBezTo>
                  <a:pt x="361" y="307074"/>
                  <a:pt x="0" y="305635"/>
                  <a:pt x="0" y="304195"/>
                </a:cubicBezTo>
                <a:lnTo>
                  <a:pt x="0" y="42147"/>
                </a:lnTo>
                <a:cubicBezTo>
                  <a:pt x="0" y="39987"/>
                  <a:pt x="1082" y="38188"/>
                  <a:pt x="2886" y="37828"/>
                </a:cubicBezTo>
                <a:lnTo>
                  <a:pt x="102827" y="392"/>
                </a:lnTo>
                <a:lnTo>
                  <a:pt x="103188" y="392"/>
                </a:lnTo>
                <a:cubicBezTo>
                  <a:pt x="103548" y="32"/>
                  <a:pt x="103548" y="32"/>
                  <a:pt x="103909" y="32"/>
                </a:cubicBezTo>
                <a:close/>
              </a:path>
            </a:pathLst>
          </a:custGeom>
          <a:solidFill>
            <a:schemeClr val="bg1"/>
          </a:solidFill>
          <a:ln>
            <a:noFill/>
          </a:ln>
          <a:effectLst/>
        </p:spPr>
        <p:txBody>
          <a:bodyPr anchor="ctr"/>
          <a:lstStyle/>
          <a:p>
            <a:endParaRPr lang="en-US">
              <a:latin typeface="Lato Light" panose="020F0502020204030203" pitchFamily="34" charset="0"/>
            </a:endParaRPr>
          </a:p>
        </p:txBody>
      </p:sp>
      <p:sp>
        <p:nvSpPr>
          <p:cNvPr id="19" name="TextBox 18">
            <a:extLst>
              <a:ext uri="{FF2B5EF4-FFF2-40B4-BE49-F238E27FC236}">
                <a16:creationId xmlns:a16="http://schemas.microsoft.com/office/drawing/2014/main" id="{9C6CEFB1-CBA8-4398-B503-3D8E82667A98}"/>
              </a:ext>
            </a:extLst>
          </p:cNvPr>
          <p:cNvSpPr txBox="1"/>
          <p:nvPr/>
        </p:nvSpPr>
        <p:spPr>
          <a:xfrm>
            <a:off x="1732495" y="5733698"/>
            <a:ext cx="6648895" cy="461665"/>
          </a:xfrm>
          <a:prstGeom prst="rect">
            <a:avLst/>
          </a:prstGeom>
          <a:noFill/>
        </p:spPr>
        <p:txBody>
          <a:bodyPr wrap="square" rtlCol="0" anchor="b">
            <a:spAutoFit/>
          </a:bodyPr>
          <a:lstStyle/>
          <a:p>
            <a:pPr algn="ctr" defTabSz="685846"/>
            <a:r>
              <a:rPr lang="en-US" sz="1200" b="1" spc="-11" dirty="0">
                <a:solidFill>
                  <a:srgbClr val="000000"/>
                </a:solidFill>
                <a:latin typeface="Tw Cen MT" panose="020B0602020104020603" pitchFamily="34" charset="77"/>
                <a:cs typeface="Poppins" pitchFamily="2" charset="77"/>
              </a:rPr>
              <a:t>WHAT ARE OUR GOALS FOR NEXT YEAR?</a:t>
            </a:r>
            <a:br>
              <a:rPr lang="en-US" sz="1200" b="1" spc="-11" dirty="0">
                <a:solidFill>
                  <a:srgbClr val="000000"/>
                </a:solidFill>
                <a:latin typeface="Tw Cen MT" panose="020B0602020104020603" pitchFamily="34" charset="77"/>
                <a:cs typeface="Poppins" pitchFamily="2" charset="77"/>
              </a:rPr>
            </a:br>
            <a:r>
              <a:rPr lang="en-US" sz="1200" i="1" spc="-11" dirty="0">
                <a:solidFill>
                  <a:schemeClr val="tx2"/>
                </a:solidFill>
                <a:latin typeface="Tw Cen MT" panose="020B0602020104020603" pitchFamily="34" charset="77"/>
                <a:cs typeface="Poppins" pitchFamily="2" charset="77"/>
              </a:rPr>
              <a:t>ACTION: Submit an opinion piece, </a:t>
            </a:r>
            <a:r>
              <a:rPr lang="en-US" sz="1200" i="1" spc="-11" dirty="0" err="1">
                <a:solidFill>
                  <a:schemeClr val="tx2"/>
                </a:solidFill>
                <a:latin typeface="Tw Cen MT" panose="020B0602020104020603" pitchFamily="34" charset="77"/>
                <a:cs typeface="Poppins" pitchFamily="2" charset="77"/>
              </a:rPr>
              <a:t>organise</a:t>
            </a:r>
            <a:r>
              <a:rPr lang="en-US" sz="1200" i="1" spc="-11" dirty="0">
                <a:solidFill>
                  <a:schemeClr val="tx2"/>
                </a:solidFill>
                <a:latin typeface="Tw Cen MT" panose="020B0602020104020603" pitchFamily="34" charset="77"/>
                <a:cs typeface="Poppins" pitchFamily="2" charset="77"/>
              </a:rPr>
              <a:t> a webinar/podcast </a:t>
            </a:r>
            <a:endParaRPr lang="en-US" sz="1200" b="1" spc="-11" dirty="0">
              <a:solidFill>
                <a:schemeClr val="tx2"/>
              </a:solidFill>
              <a:latin typeface="Tw Cen MT" panose="020B0602020104020603" pitchFamily="34" charset="77"/>
              <a:cs typeface="Poppins" pitchFamily="2" charset="77"/>
            </a:endParaRPr>
          </a:p>
        </p:txBody>
      </p:sp>
    </p:spTree>
    <p:extLst>
      <p:ext uri="{BB962C8B-B14F-4D97-AF65-F5344CB8AC3E}">
        <p14:creationId xmlns:p14="http://schemas.microsoft.com/office/powerpoint/2010/main" val="404390816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4" name="Rectangle 143">
            <a:extLst>
              <a:ext uri="{FF2B5EF4-FFF2-40B4-BE49-F238E27FC236}">
                <a16:creationId xmlns:a16="http://schemas.microsoft.com/office/drawing/2014/main" id="{B745DD95-0352-4F89-A688-F1CCA35611CE}"/>
              </a:ext>
            </a:extLst>
          </p:cNvPr>
          <p:cNvSpPr/>
          <p:nvPr/>
        </p:nvSpPr>
        <p:spPr>
          <a:xfrm>
            <a:off x="5615608" y="892705"/>
            <a:ext cx="1283647" cy="553998"/>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3" name="TextBox 2">
            <a:extLst>
              <a:ext uri="{FF2B5EF4-FFF2-40B4-BE49-F238E27FC236}">
                <a16:creationId xmlns:a16="http://schemas.microsoft.com/office/drawing/2014/main" id="{3F736E9F-099F-6E49-8413-5352C763CACD}"/>
              </a:ext>
            </a:extLst>
          </p:cNvPr>
          <p:cNvSpPr txBox="1"/>
          <p:nvPr/>
        </p:nvSpPr>
        <p:spPr>
          <a:xfrm>
            <a:off x="2047882" y="300278"/>
            <a:ext cx="5293180" cy="553998"/>
          </a:xfrm>
          <a:prstGeom prst="rect">
            <a:avLst/>
          </a:prstGeom>
          <a:noFill/>
        </p:spPr>
        <p:txBody>
          <a:bodyPr wrap="none" rtlCol="0">
            <a:spAutoFit/>
          </a:bodyPr>
          <a:lstStyle/>
          <a:p>
            <a:pPr algn="ctr"/>
            <a:r>
              <a:rPr lang="en-US" sz="3000" b="1" dirty="0">
                <a:solidFill>
                  <a:schemeClr val="accent1"/>
                </a:solidFill>
                <a:latin typeface="+mj-lt"/>
                <a:cs typeface="Poppins" pitchFamily="2" charset="77"/>
              </a:rPr>
              <a:t>SURVEY RESULTS AT A GLANCE</a:t>
            </a:r>
          </a:p>
        </p:txBody>
      </p:sp>
      <p:sp>
        <p:nvSpPr>
          <p:cNvPr id="85" name="Freeform 69">
            <a:extLst>
              <a:ext uri="{FF2B5EF4-FFF2-40B4-BE49-F238E27FC236}">
                <a16:creationId xmlns:a16="http://schemas.microsoft.com/office/drawing/2014/main" id="{C47DF526-2797-4792-8BE1-5AD5ED023296}"/>
              </a:ext>
            </a:extLst>
          </p:cNvPr>
          <p:cNvSpPr>
            <a:spLocks noChangeArrowheads="1"/>
          </p:cNvSpPr>
          <p:nvPr/>
        </p:nvSpPr>
        <p:spPr bwMode="auto">
          <a:xfrm>
            <a:off x="1154901" y="3585584"/>
            <a:ext cx="6809716" cy="916890"/>
          </a:xfrm>
          <a:custGeom>
            <a:avLst/>
            <a:gdLst>
              <a:gd name="T0" fmla="*/ 7288 w 14575"/>
              <a:gd name="T1" fmla="*/ 0 h 1962"/>
              <a:gd name="T2" fmla="*/ 7288 w 14575"/>
              <a:gd name="T3" fmla="*/ 0 h 1962"/>
              <a:gd name="T4" fmla="*/ 0 w 14575"/>
              <a:gd name="T5" fmla="*/ 1961 h 1962"/>
              <a:gd name="T6" fmla="*/ 14574 w 14575"/>
              <a:gd name="T7" fmla="*/ 1961 h 1962"/>
              <a:gd name="T8" fmla="*/ 14574 w 14575"/>
              <a:gd name="T9" fmla="*/ 1961 h 1962"/>
              <a:gd name="T10" fmla="*/ 7288 w 14575"/>
              <a:gd name="T11" fmla="*/ 0 h 1962"/>
            </a:gdLst>
            <a:ahLst/>
            <a:cxnLst>
              <a:cxn ang="0">
                <a:pos x="T0" y="T1"/>
              </a:cxn>
              <a:cxn ang="0">
                <a:pos x="T2" y="T3"/>
              </a:cxn>
              <a:cxn ang="0">
                <a:pos x="T4" y="T5"/>
              </a:cxn>
              <a:cxn ang="0">
                <a:pos x="T6" y="T7"/>
              </a:cxn>
              <a:cxn ang="0">
                <a:pos x="T8" y="T9"/>
              </a:cxn>
              <a:cxn ang="0">
                <a:pos x="T10" y="T11"/>
              </a:cxn>
            </a:cxnLst>
            <a:rect l="0" t="0" r="r" b="b"/>
            <a:pathLst>
              <a:path w="14575" h="1962">
                <a:moveTo>
                  <a:pt x="7288" y="0"/>
                </a:moveTo>
                <a:lnTo>
                  <a:pt x="7288" y="0"/>
                </a:lnTo>
                <a:cubicBezTo>
                  <a:pt x="3272" y="0"/>
                  <a:pt x="15" y="878"/>
                  <a:pt x="0" y="1961"/>
                </a:cubicBezTo>
                <a:lnTo>
                  <a:pt x="14574" y="1961"/>
                </a:lnTo>
                <a:lnTo>
                  <a:pt x="14574" y="1961"/>
                </a:lnTo>
                <a:cubicBezTo>
                  <a:pt x="14559" y="878"/>
                  <a:pt x="11302" y="0"/>
                  <a:pt x="7288" y="0"/>
                </a:cubicBezTo>
              </a:path>
            </a:pathLst>
          </a:custGeom>
          <a:solidFill>
            <a:schemeClr val="bg1">
              <a:lumMod val="65000"/>
              <a:alpha val="15000"/>
            </a:schemeClr>
          </a:solidFill>
          <a:ln>
            <a:noFill/>
          </a:ln>
          <a:effectLst/>
        </p:spPr>
        <p:txBody>
          <a:bodyPr wrap="none" anchor="ctr"/>
          <a:lstStyle/>
          <a:p>
            <a:endParaRPr lang="en-US" sz="1350">
              <a:latin typeface="+mj-lt"/>
            </a:endParaRPr>
          </a:p>
        </p:txBody>
      </p:sp>
      <p:sp>
        <p:nvSpPr>
          <p:cNvPr id="86" name="Freeform 76">
            <a:extLst>
              <a:ext uri="{FF2B5EF4-FFF2-40B4-BE49-F238E27FC236}">
                <a16:creationId xmlns:a16="http://schemas.microsoft.com/office/drawing/2014/main" id="{91FC40A4-A51E-491E-9B8B-06E1E1586D86}"/>
              </a:ext>
            </a:extLst>
          </p:cNvPr>
          <p:cNvSpPr>
            <a:spLocks noChangeArrowheads="1"/>
          </p:cNvSpPr>
          <p:nvPr/>
        </p:nvSpPr>
        <p:spPr bwMode="auto">
          <a:xfrm>
            <a:off x="565497" y="3024485"/>
            <a:ext cx="1283646" cy="890105"/>
          </a:xfrm>
          <a:custGeom>
            <a:avLst/>
            <a:gdLst>
              <a:gd name="T0" fmla="*/ 1195 w 2747"/>
              <a:gd name="T1" fmla="*/ 1840 h 1903"/>
              <a:gd name="T2" fmla="*/ 1195 w 2747"/>
              <a:gd name="T3" fmla="*/ 1840 h 1903"/>
              <a:gd name="T4" fmla="*/ 1550 w 2747"/>
              <a:gd name="T5" fmla="*/ 1840 h 1903"/>
              <a:gd name="T6" fmla="*/ 2746 w 2747"/>
              <a:gd name="T7" fmla="*/ 1162 h 1903"/>
              <a:gd name="T8" fmla="*/ 2746 w 2747"/>
              <a:gd name="T9" fmla="*/ 470 h 1903"/>
              <a:gd name="T10" fmla="*/ 2746 w 2747"/>
              <a:gd name="T11" fmla="*/ 470 h 1903"/>
              <a:gd name="T12" fmla="*/ 1337 w 2747"/>
              <a:gd name="T13" fmla="*/ 0 h 1903"/>
              <a:gd name="T14" fmla="*/ 1337 w 2747"/>
              <a:gd name="T15" fmla="*/ 0 h 1903"/>
              <a:gd name="T16" fmla="*/ 0 w 2747"/>
              <a:gd name="T17" fmla="*/ 418 h 1903"/>
              <a:gd name="T18" fmla="*/ 0 w 2747"/>
              <a:gd name="T19" fmla="*/ 1162 h 1903"/>
              <a:gd name="T20" fmla="*/ 1195 w 2747"/>
              <a:gd name="T21" fmla="*/ 1840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7" h="1903">
                <a:moveTo>
                  <a:pt x="1195" y="1840"/>
                </a:moveTo>
                <a:lnTo>
                  <a:pt x="1195" y="1840"/>
                </a:lnTo>
                <a:cubicBezTo>
                  <a:pt x="1305" y="1902"/>
                  <a:pt x="1440" y="1902"/>
                  <a:pt x="1550" y="1840"/>
                </a:cubicBezTo>
                <a:lnTo>
                  <a:pt x="2746" y="1162"/>
                </a:lnTo>
                <a:lnTo>
                  <a:pt x="2746" y="470"/>
                </a:lnTo>
                <a:lnTo>
                  <a:pt x="2746" y="470"/>
                </a:lnTo>
                <a:cubicBezTo>
                  <a:pt x="2353" y="175"/>
                  <a:pt x="1865" y="0"/>
                  <a:pt x="1337" y="0"/>
                </a:cubicBezTo>
                <a:lnTo>
                  <a:pt x="1337" y="0"/>
                </a:lnTo>
                <a:cubicBezTo>
                  <a:pt x="840" y="0"/>
                  <a:pt x="379" y="154"/>
                  <a:pt x="0" y="418"/>
                </a:cubicBezTo>
                <a:lnTo>
                  <a:pt x="0" y="1162"/>
                </a:lnTo>
                <a:lnTo>
                  <a:pt x="1195" y="1840"/>
                </a:lnTo>
              </a:path>
            </a:pathLst>
          </a:custGeom>
          <a:solidFill>
            <a:schemeClr val="accent1"/>
          </a:solidFill>
          <a:ln>
            <a:noFill/>
          </a:ln>
          <a:effectLst/>
        </p:spPr>
        <p:txBody>
          <a:bodyPr wrap="none" anchor="ctr"/>
          <a:lstStyle/>
          <a:p>
            <a:endParaRPr lang="en-US" sz="1350">
              <a:latin typeface="+mj-lt"/>
            </a:endParaRPr>
          </a:p>
        </p:txBody>
      </p:sp>
      <p:sp>
        <p:nvSpPr>
          <p:cNvPr id="87" name="Freeform 78">
            <a:extLst>
              <a:ext uri="{FF2B5EF4-FFF2-40B4-BE49-F238E27FC236}">
                <a16:creationId xmlns:a16="http://schemas.microsoft.com/office/drawing/2014/main" id="{B0FDE50E-4742-4FD5-985A-FAD1C60C9447}"/>
              </a:ext>
            </a:extLst>
          </p:cNvPr>
          <p:cNvSpPr>
            <a:spLocks noChangeArrowheads="1"/>
          </p:cNvSpPr>
          <p:nvPr/>
        </p:nvSpPr>
        <p:spPr bwMode="auto">
          <a:xfrm>
            <a:off x="2244747" y="2330121"/>
            <a:ext cx="1283647" cy="890105"/>
          </a:xfrm>
          <a:custGeom>
            <a:avLst/>
            <a:gdLst>
              <a:gd name="T0" fmla="*/ 1196 w 2747"/>
              <a:gd name="T1" fmla="*/ 1840 h 1903"/>
              <a:gd name="T2" fmla="*/ 1196 w 2747"/>
              <a:gd name="T3" fmla="*/ 1840 h 1903"/>
              <a:gd name="T4" fmla="*/ 1551 w 2747"/>
              <a:gd name="T5" fmla="*/ 1840 h 1903"/>
              <a:gd name="T6" fmla="*/ 2746 w 2747"/>
              <a:gd name="T7" fmla="*/ 1162 h 1903"/>
              <a:gd name="T8" fmla="*/ 2746 w 2747"/>
              <a:gd name="T9" fmla="*/ 470 h 1903"/>
              <a:gd name="T10" fmla="*/ 2746 w 2747"/>
              <a:gd name="T11" fmla="*/ 470 h 1903"/>
              <a:gd name="T12" fmla="*/ 1337 w 2747"/>
              <a:gd name="T13" fmla="*/ 0 h 1903"/>
              <a:gd name="T14" fmla="*/ 1337 w 2747"/>
              <a:gd name="T15" fmla="*/ 0 h 1903"/>
              <a:gd name="T16" fmla="*/ 0 w 2747"/>
              <a:gd name="T17" fmla="*/ 418 h 1903"/>
              <a:gd name="T18" fmla="*/ 0 w 2747"/>
              <a:gd name="T19" fmla="*/ 1162 h 1903"/>
              <a:gd name="T20" fmla="*/ 1196 w 2747"/>
              <a:gd name="T21" fmla="*/ 1840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7" h="1903">
                <a:moveTo>
                  <a:pt x="1196" y="1840"/>
                </a:moveTo>
                <a:lnTo>
                  <a:pt x="1196" y="1840"/>
                </a:lnTo>
                <a:cubicBezTo>
                  <a:pt x="1306" y="1902"/>
                  <a:pt x="1441" y="1902"/>
                  <a:pt x="1551" y="1840"/>
                </a:cubicBezTo>
                <a:lnTo>
                  <a:pt x="2746" y="1162"/>
                </a:lnTo>
                <a:lnTo>
                  <a:pt x="2746" y="470"/>
                </a:lnTo>
                <a:lnTo>
                  <a:pt x="2746" y="470"/>
                </a:lnTo>
                <a:cubicBezTo>
                  <a:pt x="2354" y="175"/>
                  <a:pt x="1866" y="0"/>
                  <a:pt x="1337" y="0"/>
                </a:cubicBezTo>
                <a:lnTo>
                  <a:pt x="1337" y="0"/>
                </a:lnTo>
                <a:cubicBezTo>
                  <a:pt x="840" y="0"/>
                  <a:pt x="380" y="155"/>
                  <a:pt x="0" y="418"/>
                </a:cubicBezTo>
                <a:lnTo>
                  <a:pt x="0" y="1162"/>
                </a:lnTo>
                <a:lnTo>
                  <a:pt x="1196" y="1840"/>
                </a:lnTo>
              </a:path>
            </a:pathLst>
          </a:custGeom>
          <a:solidFill>
            <a:schemeClr val="accent2"/>
          </a:solidFill>
          <a:ln>
            <a:noFill/>
          </a:ln>
          <a:effectLst/>
        </p:spPr>
        <p:txBody>
          <a:bodyPr wrap="none" anchor="ctr"/>
          <a:lstStyle/>
          <a:p>
            <a:endParaRPr lang="en-US" sz="1350">
              <a:latin typeface="+mj-lt"/>
            </a:endParaRPr>
          </a:p>
        </p:txBody>
      </p:sp>
      <p:sp>
        <p:nvSpPr>
          <p:cNvPr id="88" name="Freeform 80">
            <a:extLst>
              <a:ext uri="{FF2B5EF4-FFF2-40B4-BE49-F238E27FC236}">
                <a16:creationId xmlns:a16="http://schemas.microsoft.com/office/drawing/2014/main" id="{17DD1B6A-4BAB-4C2F-BB59-7374CC25F347}"/>
              </a:ext>
            </a:extLst>
          </p:cNvPr>
          <p:cNvSpPr>
            <a:spLocks noChangeArrowheads="1"/>
          </p:cNvSpPr>
          <p:nvPr/>
        </p:nvSpPr>
        <p:spPr bwMode="auto">
          <a:xfrm>
            <a:off x="5623849" y="2330121"/>
            <a:ext cx="1283647" cy="890105"/>
          </a:xfrm>
          <a:custGeom>
            <a:avLst/>
            <a:gdLst>
              <a:gd name="T0" fmla="*/ 1195 w 2747"/>
              <a:gd name="T1" fmla="*/ 1840 h 1903"/>
              <a:gd name="T2" fmla="*/ 1195 w 2747"/>
              <a:gd name="T3" fmla="*/ 1840 h 1903"/>
              <a:gd name="T4" fmla="*/ 1550 w 2747"/>
              <a:gd name="T5" fmla="*/ 1840 h 1903"/>
              <a:gd name="T6" fmla="*/ 2746 w 2747"/>
              <a:gd name="T7" fmla="*/ 1162 h 1903"/>
              <a:gd name="T8" fmla="*/ 2746 w 2747"/>
              <a:gd name="T9" fmla="*/ 470 h 1903"/>
              <a:gd name="T10" fmla="*/ 2746 w 2747"/>
              <a:gd name="T11" fmla="*/ 470 h 1903"/>
              <a:gd name="T12" fmla="*/ 1336 w 2747"/>
              <a:gd name="T13" fmla="*/ 0 h 1903"/>
              <a:gd name="T14" fmla="*/ 1336 w 2747"/>
              <a:gd name="T15" fmla="*/ 0 h 1903"/>
              <a:gd name="T16" fmla="*/ 0 w 2747"/>
              <a:gd name="T17" fmla="*/ 418 h 1903"/>
              <a:gd name="T18" fmla="*/ 0 w 2747"/>
              <a:gd name="T19" fmla="*/ 1162 h 1903"/>
              <a:gd name="T20" fmla="*/ 1195 w 2747"/>
              <a:gd name="T21" fmla="*/ 1840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7" h="1903">
                <a:moveTo>
                  <a:pt x="1195" y="1840"/>
                </a:moveTo>
                <a:lnTo>
                  <a:pt x="1195" y="1840"/>
                </a:lnTo>
                <a:cubicBezTo>
                  <a:pt x="1305" y="1902"/>
                  <a:pt x="1440" y="1902"/>
                  <a:pt x="1550" y="1840"/>
                </a:cubicBezTo>
                <a:lnTo>
                  <a:pt x="2746" y="1162"/>
                </a:lnTo>
                <a:lnTo>
                  <a:pt x="2746" y="470"/>
                </a:lnTo>
                <a:lnTo>
                  <a:pt x="2746" y="470"/>
                </a:lnTo>
                <a:cubicBezTo>
                  <a:pt x="2353" y="175"/>
                  <a:pt x="1865" y="0"/>
                  <a:pt x="1336" y="0"/>
                </a:cubicBezTo>
                <a:lnTo>
                  <a:pt x="1336" y="0"/>
                </a:lnTo>
                <a:cubicBezTo>
                  <a:pt x="840" y="0"/>
                  <a:pt x="379" y="155"/>
                  <a:pt x="0" y="418"/>
                </a:cubicBezTo>
                <a:lnTo>
                  <a:pt x="0" y="1162"/>
                </a:lnTo>
                <a:lnTo>
                  <a:pt x="1195" y="1840"/>
                </a:lnTo>
              </a:path>
            </a:pathLst>
          </a:custGeom>
          <a:solidFill>
            <a:schemeClr val="accent4"/>
          </a:solidFill>
          <a:ln>
            <a:noFill/>
          </a:ln>
          <a:effectLst/>
        </p:spPr>
        <p:txBody>
          <a:bodyPr wrap="none" anchor="ctr"/>
          <a:lstStyle/>
          <a:p>
            <a:endParaRPr lang="en-US" sz="1350">
              <a:latin typeface="+mj-lt"/>
            </a:endParaRPr>
          </a:p>
        </p:txBody>
      </p:sp>
      <p:sp>
        <p:nvSpPr>
          <p:cNvPr id="89" name="Freeform 82">
            <a:extLst>
              <a:ext uri="{FF2B5EF4-FFF2-40B4-BE49-F238E27FC236}">
                <a16:creationId xmlns:a16="http://schemas.microsoft.com/office/drawing/2014/main" id="{DB9D7741-0521-4EFC-A487-909D4316F516}"/>
              </a:ext>
            </a:extLst>
          </p:cNvPr>
          <p:cNvSpPr>
            <a:spLocks noChangeArrowheads="1"/>
          </p:cNvSpPr>
          <p:nvPr/>
        </p:nvSpPr>
        <p:spPr bwMode="auto">
          <a:xfrm>
            <a:off x="7296917" y="3024485"/>
            <a:ext cx="1283647" cy="890105"/>
          </a:xfrm>
          <a:custGeom>
            <a:avLst/>
            <a:gdLst>
              <a:gd name="T0" fmla="*/ 1196 w 2747"/>
              <a:gd name="T1" fmla="*/ 1840 h 1903"/>
              <a:gd name="T2" fmla="*/ 1196 w 2747"/>
              <a:gd name="T3" fmla="*/ 1840 h 1903"/>
              <a:gd name="T4" fmla="*/ 1551 w 2747"/>
              <a:gd name="T5" fmla="*/ 1840 h 1903"/>
              <a:gd name="T6" fmla="*/ 2746 w 2747"/>
              <a:gd name="T7" fmla="*/ 1162 h 1903"/>
              <a:gd name="T8" fmla="*/ 2746 w 2747"/>
              <a:gd name="T9" fmla="*/ 470 h 1903"/>
              <a:gd name="T10" fmla="*/ 2746 w 2747"/>
              <a:gd name="T11" fmla="*/ 470 h 1903"/>
              <a:gd name="T12" fmla="*/ 1338 w 2747"/>
              <a:gd name="T13" fmla="*/ 0 h 1903"/>
              <a:gd name="T14" fmla="*/ 1338 w 2747"/>
              <a:gd name="T15" fmla="*/ 0 h 1903"/>
              <a:gd name="T16" fmla="*/ 0 w 2747"/>
              <a:gd name="T17" fmla="*/ 418 h 1903"/>
              <a:gd name="T18" fmla="*/ 0 w 2747"/>
              <a:gd name="T19" fmla="*/ 1162 h 1903"/>
              <a:gd name="T20" fmla="*/ 1196 w 2747"/>
              <a:gd name="T21" fmla="*/ 1840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7" h="1903">
                <a:moveTo>
                  <a:pt x="1196" y="1840"/>
                </a:moveTo>
                <a:lnTo>
                  <a:pt x="1196" y="1840"/>
                </a:lnTo>
                <a:cubicBezTo>
                  <a:pt x="1306" y="1902"/>
                  <a:pt x="1441" y="1902"/>
                  <a:pt x="1551" y="1840"/>
                </a:cubicBezTo>
                <a:lnTo>
                  <a:pt x="2746" y="1162"/>
                </a:lnTo>
                <a:lnTo>
                  <a:pt x="2746" y="470"/>
                </a:lnTo>
                <a:lnTo>
                  <a:pt x="2746" y="470"/>
                </a:lnTo>
                <a:cubicBezTo>
                  <a:pt x="2354" y="175"/>
                  <a:pt x="1866" y="0"/>
                  <a:pt x="1338" y="0"/>
                </a:cubicBezTo>
                <a:lnTo>
                  <a:pt x="1338" y="0"/>
                </a:lnTo>
                <a:cubicBezTo>
                  <a:pt x="841" y="0"/>
                  <a:pt x="380" y="154"/>
                  <a:pt x="0" y="418"/>
                </a:cubicBezTo>
                <a:lnTo>
                  <a:pt x="0" y="1162"/>
                </a:lnTo>
                <a:lnTo>
                  <a:pt x="1196" y="1840"/>
                </a:lnTo>
              </a:path>
            </a:pathLst>
          </a:custGeom>
          <a:solidFill>
            <a:schemeClr val="accent5"/>
          </a:solidFill>
          <a:ln>
            <a:noFill/>
          </a:ln>
          <a:effectLst/>
        </p:spPr>
        <p:txBody>
          <a:bodyPr wrap="none" anchor="ctr"/>
          <a:lstStyle/>
          <a:p>
            <a:endParaRPr lang="en-US" sz="1350">
              <a:latin typeface="+mj-lt"/>
            </a:endParaRPr>
          </a:p>
        </p:txBody>
      </p:sp>
      <p:sp>
        <p:nvSpPr>
          <p:cNvPr id="90" name="Freeform 84">
            <a:extLst>
              <a:ext uri="{FF2B5EF4-FFF2-40B4-BE49-F238E27FC236}">
                <a16:creationId xmlns:a16="http://schemas.microsoft.com/office/drawing/2014/main" id="{58C45246-94CA-4DCA-9AB3-E4AEA022B964}"/>
              </a:ext>
            </a:extLst>
          </p:cNvPr>
          <p:cNvSpPr>
            <a:spLocks noChangeArrowheads="1"/>
          </p:cNvSpPr>
          <p:nvPr/>
        </p:nvSpPr>
        <p:spPr bwMode="auto">
          <a:xfrm>
            <a:off x="3926056" y="2041661"/>
            <a:ext cx="1281586" cy="890105"/>
          </a:xfrm>
          <a:custGeom>
            <a:avLst/>
            <a:gdLst>
              <a:gd name="T0" fmla="*/ 1195 w 2745"/>
              <a:gd name="T1" fmla="*/ 1839 h 1903"/>
              <a:gd name="T2" fmla="*/ 1195 w 2745"/>
              <a:gd name="T3" fmla="*/ 1839 h 1903"/>
              <a:gd name="T4" fmla="*/ 1549 w 2745"/>
              <a:gd name="T5" fmla="*/ 1839 h 1903"/>
              <a:gd name="T6" fmla="*/ 2744 w 2745"/>
              <a:gd name="T7" fmla="*/ 1161 h 1903"/>
              <a:gd name="T8" fmla="*/ 2744 w 2745"/>
              <a:gd name="T9" fmla="*/ 469 h 1903"/>
              <a:gd name="T10" fmla="*/ 2744 w 2745"/>
              <a:gd name="T11" fmla="*/ 469 h 1903"/>
              <a:gd name="T12" fmla="*/ 1337 w 2745"/>
              <a:gd name="T13" fmla="*/ 0 h 1903"/>
              <a:gd name="T14" fmla="*/ 1337 w 2745"/>
              <a:gd name="T15" fmla="*/ 0 h 1903"/>
              <a:gd name="T16" fmla="*/ 0 w 2745"/>
              <a:gd name="T17" fmla="*/ 418 h 1903"/>
              <a:gd name="T18" fmla="*/ 0 w 2745"/>
              <a:gd name="T19" fmla="*/ 1161 h 1903"/>
              <a:gd name="T20" fmla="*/ 1195 w 2745"/>
              <a:gd name="T21" fmla="*/ 1839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5" h="1903">
                <a:moveTo>
                  <a:pt x="1195" y="1839"/>
                </a:moveTo>
                <a:lnTo>
                  <a:pt x="1195" y="1839"/>
                </a:lnTo>
                <a:cubicBezTo>
                  <a:pt x="1305" y="1902"/>
                  <a:pt x="1439" y="1902"/>
                  <a:pt x="1549" y="1839"/>
                </a:cubicBezTo>
                <a:lnTo>
                  <a:pt x="2744" y="1161"/>
                </a:lnTo>
                <a:lnTo>
                  <a:pt x="2744" y="469"/>
                </a:lnTo>
                <a:lnTo>
                  <a:pt x="2744" y="469"/>
                </a:lnTo>
                <a:cubicBezTo>
                  <a:pt x="2352" y="174"/>
                  <a:pt x="1864" y="0"/>
                  <a:pt x="1337" y="0"/>
                </a:cubicBezTo>
                <a:lnTo>
                  <a:pt x="1337" y="0"/>
                </a:lnTo>
                <a:cubicBezTo>
                  <a:pt x="840" y="0"/>
                  <a:pt x="379" y="154"/>
                  <a:pt x="0" y="418"/>
                </a:cubicBezTo>
                <a:lnTo>
                  <a:pt x="0" y="1161"/>
                </a:lnTo>
                <a:lnTo>
                  <a:pt x="1195" y="1839"/>
                </a:lnTo>
              </a:path>
            </a:pathLst>
          </a:custGeom>
          <a:solidFill>
            <a:schemeClr val="accent3"/>
          </a:solidFill>
          <a:ln>
            <a:noFill/>
          </a:ln>
          <a:effectLst/>
        </p:spPr>
        <p:txBody>
          <a:bodyPr wrap="none" anchor="ctr"/>
          <a:lstStyle/>
          <a:p>
            <a:endParaRPr lang="en-US" sz="1350">
              <a:latin typeface="+mj-lt"/>
            </a:endParaRPr>
          </a:p>
        </p:txBody>
      </p:sp>
      <p:sp>
        <p:nvSpPr>
          <p:cNvPr id="91" name="Freeform 85">
            <a:extLst>
              <a:ext uri="{FF2B5EF4-FFF2-40B4-BE49-F238E27FC236}">
                <a16:creationId xmlns:a16="http://schemas.microsoft.com/office/drawing/2014/main" id="{CBBECDFD-4FDD-4694-91C5-510B31F8F324}"/>
              </a:ext>
            </a:extLst>
          </p:cNvPr>
          <p:cNvSpPr>
            <a:spLocks noChangeArrowheads="1"/>
          </p:cNvSpPr>
          <p:nvPr/>
        </p:nvSpPr>
        <p:spPr bwMode="auto">
          <a:xfrm>
            <a:off x="565497" y="1648119"/>
            <a:ext cx="1283646" cy="1594772"/>
          </a:xfrm>
          <a:custGeom>
            <a:avLst/>
            <a:gdLst>
              <a:gd name="T0" fmla="*/ 2746 w 2747"/>
              <a:gd name="T1" fmla="*/ 3413 h 3414"/>
              <a:gd name="T2" fmla="*/ 2746 w 2747"/>
              <a:gd name="T3" fmla="*/ 415 h 3414"/>
              <a:gd name="T4" fmla="*/ 2746 w 2747"/>
              <a:gd name="T5" fmla="*/ 415 h 3414"/>
              <a:gd name="T6" fmla="*/ 2330 w 2747"/>
              <a:gd name="T7" fmla="*/ 0 h 3414"/>
              <a:gd name="T8" fmla="*/ 358 w 2747"/>
              <a:gd name="T9" fmla="*/ 0 h 3414"/>
              <a:gd name="T10" fmla="*/ 358 w 2747"/>
              <a:gd name="T11" fmla="*/ 0 h 3414"/>
              <a:gd name="T12" fmla="*/ 0 w 2747"/>
              <a:gd name="T13" fmla="*/ 357 h 3414"/>
              <a:gd name="T14" fmla="*/ 0 w 2747"/>
              <a:gd name="T15" fmla="*/ 3361 h 3414"/>
              <a:gd name="T16" fmla="*/ 0 w 2747"/>
              <a:gd name="T17" fmla="*/ 3361 h 3414"/>
              <a:gd name="T18" fmla="*/ 1337 w 2747"/>
              <a:gd name="T19" fmla="*/ 2943 h 3414"/>
              <a:gd name="T20" fmla="*/ 1337 w 2747"/>
              <a:gd name="T21" fmla="*/ 2943 h 3414"/>
              <a:gd name="T22" fmla="*/ 2746 w 2747"/>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7" h="3414">
                <a:moveTo>
                  <a:pt x="2746" y="3413"/>
                </a:moveTo>
                <a:lnTo>
                  <a:pt x="2746" y="415"/>
                </a:lnTo>
                <a:lnTo>
                  <a:pt x="2746" y="415"/>
                </a:lnTo>
                <a:cubicBezTo>
                  <a:pt x="2746" y="186"/>
                  <a:pt x="2560" y="0"/>
                  <a:pt x="2330" y="0"/>
                </a:cubicBezTo>
                <a:lnTo>
                  <a:pt x="358" y="0"/>
                </a:lnTo>
                <a:lnTo>
                  <a:pt x="358" y="0"/>
                </a:lnTo>
                <a:cubicBezTo>
                  <a:pt x="160" y="0"/>
                  <a:pt x="0" y="160"/>
                  <a:pt x="0" y="357"/>
                </a:cubicBezTo>
                <a:lnTo>
                  <a:pt x="0" y="3361"/>
                </a:lnTo>
                <a:lnTo>
                  <a:pt x="0" y="3361"/>
                </a:lnTo>
                <a:cubicBezTo>
                  <a:pt x="379" y="3097"/>
                  <a:pt x="840" y="2943"/>
                  <a:pt x="1337" y="2943"/>
                </a:cubicBezTo>
                <a:lnTo>
                  <a:pt x="1337" y="2943"/>
                </a:lnTo>
                <a:cubicBezTo>
                  <a:pt x="1865" y="2943"/>
                  <a:pt x="2353" y="3118"/>
                  <a:pt x="2746"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2" name="Freeform 86">
            <a:extLst>
              <a:ext uri="{FF2B5EF4-FFF2-40B4-BE49-F238E27FC236}">
                <a16:creationId xmlns:a16="http://schemas.microsoft.com/office/drawing/2014/main" id="{F803AAF6-CD73-4A4B-B968-C39DBA71447C}"/>
              </a:ext>
            </a:extLst>
          </p:cNvPr>
          <p:cNvSpPr>
            <a:spLocks noChangeArrowheads="1"/>
          </p:cNvSpPr>
          <p:nvPr/>
        </p:nvSpPr>
        <p:spPr bwMode="auto">
          <a:xfrm>
            <a:off x="2244747" y="955816"/>
            <a:ext cx="1283647" cy="1594772"/>
          </a:xfrm>
          <a:custGeom>
            <a:avLst/>
            <a:gdLst>
              <a:gd name="T0" fmla="*/ 2746 w 2747"/>
              <a:gd name="T1" fmla="*/ 3413 h 3414"/>
              <a:gd name="T2" fmla="*/ 2746 w 2747"/>
              <a:gd name="T3" fmla="*/ 416 h 3414"/>
              <a:gd name="T4" fmla="*/ 2746 w 2747"/>
              <a:gd name="T5" fmla="*/ 416 h 3414"/>
              <a:gd name="T6" fmla="*/ 2330 w 2747"/>
              <a:gd name="T7" fmla="*/ 0 h 3414"/>
              <a:gd name="T8" fmla="*/ 358 w 2747"/>
              <a:gd name="T9" fmla="*/ 0 h 3414"/>
              <a:gd name="T10" fmla="*/ 358 w 2747"/>
              <a:gd name="T11" fmla="*/ 0 h 3414"/>
              <a:gd name="T12" fmla="*/ 0 w 2747"/>
              <a:gd name="T13" fmla="*/ 358 h 3414"/>
              <a:gd name="T14" fmla="*/ 0 w 2747"/>
              <a:gd name="T15" fmla="*/ 3361 h 3414"/>
              <a:gd name="T16" fmla="*/ 0 w 2747"/>
              <a:gd name="T17" fmla="*/ 3361 h 3414"/>
              <a:gd name="T18" fmla="*/ 1337 w 2747"/>
              <a:gd name="T19" fmla="*/ 2943 h 3414"/>
              <a:gd name="T20" fmla="*/ 1337 w 2747"/>
              <a:gd name="T21" fmla="*/ 2943 h 3414"/>
              <a:gd name="T22" fmla="*/ 2746 w 2747"/>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7" h="3414">
                <a:moveTo>
                  <a:pt x="2746" y="3413"/>
                </a:moveTo>
                <a:lnTo>
                  <a:pt x="2746" y="416"/>
                </a:lnTo>
                <a:lnTo>
                  <a:pt x="2746" y="416"/>
                </a:lnTo>
                <a:cubicBezTo>
                  <a:pt x="2746" y="186"/>
                  <a:pt x="2560" y="0"/>
                  <a:pt x="2330" y="0"/>
                </a:cubicBezTo>
                <a:lnTo>
                  <a:pt x="358" y="0"/>
                </a:lnTo>
                <a:lnTo>
                  <a:pt x="358" y="0"/>
                </a:lnTo>
                <a:cubicBezTo>
                  <a:pt x="161" y="0"/>
                  <a:pt x="0" y="160"/>
                  <a:pt x="0" y="358"/>
                </a:cubicBezTo>
                <a:lnTo>
                  <a:pt x="0" y="3361"/>
                </a:lnTo>
                <a:lnTo>
                  <a:pt x="0" y="3361"/>
                </a:lnTo>
                <a:cubicBezTo>
                  <a:pt x="380" y="3098"/>
                  <a:pt x="840" y="2943"/>
                  <a:pt x="1337" y="2943"/>
                </a:cubicBezTo>
                <a:lnTo>
                  <a:pt x="1337" y="2943"/>
                </a:lnTo>
                <a:cubicBezTo>
                  <a:pt x="1866" y="2943"/>
                  <a:pt x="2354" y="3118"/>
                  <a:pt x="2746"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4" name="Freeform 87">
            <a:extLst>
              <a:ext uri="{FF2B5EF4-FFF2-40B4-BE49-F238E27FC236}">
                <a16:creationId xmlns:a16="http://schemas.microsoft.com/office/drawing/2014/main" id="{6EF25402-CA98-4E30-8D3C-ADB64DF8C0F0}"/>
              </a:ext>
            </a:extLst>
          </p:cNvPr>
          <p:cNvSpPr>
            <a:spLocks noChangeArrowheads="1"/>
          </p:cNvSpPr>
          <p:nvPr/>
        </p:nvSpPr>
        <p:spPr bwMode="auto">
          <a:xfrm>
            <a:off x="5623849" y="1660482"/>
            <a:ext cx="1283647" cy="890106"/>
          </a:xfrm>
          <a:custGeom>
            <a:avLst/>
            <a:gdLst>
              <a:gd name="T0" fmla="*/ 2746 w 2747"/>
              <a:gd name="T1" fmla="*/ 3413 h 3414"/>
              <a:gd name="T2" fmla="*/ 2746 w 2747"/>
              <a:gd name="T3" fmla="*/ 416 h 3414"/>
              <a:gd name="T4" fmla="*/ 2746 w 2747"/>
              <a:gd name="T5" fmla="*/ 416 h 3414"/>
              <a:gd name="T6" fmla="*/ 2330 w 2747"/>
              <a:gd name="T7" fmla="*/ 0 h 3414"/>
              <a:gd name="T8" fmla="*/ 358 w 2747"/>
              <a:gd name="T9" fmla="*/ 0 h 3414"/>
              <a:gd name="T10" fmla="*/ 358 w 2747"/>
              <a:gd name="T11" fmla="*/ 0 h 3414"/>
              <a:gd name="T12" fmla="*/ 0 w 2747"/>
              <a:gd name="T13" fmla="*/ 358 h 3414"/>
              <a:gd name="T14" fmla="*/ 0 w 2747"/>
              <a:gd name="T15" fmla="*/ 3361 h 3414"/>
              <a:gd name="T16" fmla="*/ 0 w 2747"/>
              <a:gd name="T17" fmla="*/ 3361 h 3414"/>
              <a:gd name="T18" fmla="*/ 1336 w 2747"/>
              <a:gd name="T19" fmla="*/ 2943 h 3414"/>
              <a:gd name="T20" fmla="*/ 1336 w 2747"/>
              <a:gd name="T21" fmla="*/ 2943 h 3414"/>
              <a:gd name="T22" fmla="*/ 2746 w 2747"/>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7" h="3414">
                <a:moveTo>
                  <a:pt x="2746" y="3413"/>
                </a:moveTo>
                <a:lnTo>
                  <a:pt x="2746" y="416"/>
                </a:lnTo>
                <a:lnTo>
                  <a:pt x="2746" y="416"/>
                </a:lnTo>
                <a:cubicBezTo>
                  <a:pt x="2746" y="186"/>
                  <a:pt x="2559" y="0"/>
                  <a:pt x="2330" y="0"/>
                </a:cubicBezTo>
                <a:lnTo>
                  <a:pt x="358" y="0"/>
                </a:lnTo>
                <a:lnTo>
                  <a:pt x="358" y="0"/>
                </a:lnTo>
                <a:cubicBezTo>
                  <a:pt x="160" y="0"/>
                  <a:pt x="0" y="160"/>
                  <a:pt x="0" y="358"/>
                </a:cubicBezTo>
                <a:lnTo>
                  <a:pt x="0" y="3361"/>
                </a:lnTo>
                <a:lnTo>
                  <a:pt x="0" y="3361"/>
                </a:lnTo>
                <a:cubicBezTo>
                  <a:pt x="379" y="3098"/>
                  <a:pt x="840" y="2943"/>
                  <a:pt x="1336" y="2943"/>
                </a:cubicBezTo>
                <a:lnTo>
                  <a:pt x="1336" y="2943"/>
                </a:lnTo>
                <a:cubicBezTo>
                  <a:pt x="1865" y="2943"/>
                  <a:pt x="2353" y="3118"/>
                  <a:pt x="2746"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5" name="Freeform 88">
            <a:extLst>
              <a:ext uri="{FF2B5EF4-FFF2-40B4-BE49-F238E27FC236}">
                <a16:creationId xmlns:a16="http://schemas.microsoft.com/office/drawing/2014/main" id="{5A04142E-B117-4114-8144-C49BC7C5357B}"/>
              </a:ext>
            </a:extLst>
          </p:cNvPr>
          <p:cNvSpPr>
            <a:spLocks noChangeArrowheads="1"/>
          </p:cNvSpPr>
          <p:nvPr/>
        </p:nvSpPr>
        <p:spPr bwMode="auto">
          <a:xfrm>
            <a:off x="7296917" y="1648119"/>
            <a:ext cx="1283647" cy="1594772"/>
          </a:xfrm>
          <a:custGeom>
            <a:avLst/>
            <a:gdLst>
              <a:gd name="T0" fmla="*/ 2746 w 2747"/>
              <a:gd name="T1" fmla="*/ 3413 h 3414"/>
              <a:gd name="T2" fmla="*/ 2746 w 2747"/>
              <a:gd name="T3" fmla="*/ 415 h 3414"/>
              <a:gd name="T4" fmla="*/ 2746 w 2747"/>
              <a:gd name="T5" fmla="*/ 415 h 3414"/>
              <a:gd name="T6" fmla="*/ 2331 w 2747"/>
              <a:gd name="T7" fmla="*/ 0 h 3414"/>
              <a:gd name="T8" fmla="*/ 358 w 2747"/>
              <a:gd name="T9" fmla="*/ 0 h 3414"/>
              <a:gd name="T10" fmla="*/ 358 w 2747"/>
              <a:gd name="T11" fmla="*/ 0 h 3414"/>
              <a:gd name="T12" fmla="*/ 0 w 2747"/>
              <a:gd name="T13" fmla="*/ 357 h 3414"/>
              <a:gd name="T14" fmla="*/ 0 w 2747"/>
              <a:gd name="T15" fmla="*/ 3361 h 3414"/>
              <a:gd name="T16" fmla="*/ 0 w 2747"/>
              <a:gd name="T17" fmla="*/ 3361 h 3414"/>
              <a:gd name="T18" fmla="*/ 1338 w 2747"/>
              <a:gd name="T19" fmla="*/ 2943 h 3414"/>
              <a:gd name="T20" fmla="*/ 1338 w 2747"/>
              <a:gd name="T21" fmla="*/ 2943 h 3414"/>
              <a:gd name="T22" fmla="*/ 2746 w 2747"/>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7" h="3414">
                <a:moveTo>
                  <a:pt x="2746" y="3413"/>
                </a:moveTo>
                <a:lnTo>
                  <a:pt x="2746" y="415"/>
                </a:lnTo>
                <a:lnTo>
                  <a:pt x="2746" y="415"/>
                </a:lnTo>
                <a:cubicBezTo>
                  <a:pt x="2746" y="186"/>
                  <a:pt x="2560" y="0"/>
                  <a:pt x="2331" y="0"/>
                </a:cubicBezTo>
                <a:lnTo>
                  <a:pt x="358" y="0"/>
                </a:lnTo>
                <a:lnTo>
                  <a:pt x="358" y="0"/>
                </a:lnTo>
                <a:cubicBezTo>
                  <a:pt x="160" y="0"/>
                  <a:pt x="0" y="160"/>
                  <a:pt x="0" y="357"/>
                </a:cubicBezTo>
                <a:lnTo>
                  <a:pt x="0" y="3361"/>
                </a:lnTo>
                <a:lnTo>
                  <a:pt x="0" y="3361"/>
                </a:lnTo>
                <a:cubicBezTo>
                  <a:pt x="380" y="3097"/>
                  <a:pt x="841" y="2943"/>
                  <a:pt x="1338" y="2943"/>
                </a:cubicBezTo>
                <a:lnTo>
                  <a:pt x="1338" y="2943"/>
                </a:lnTo>
                <a:cubicBezTo>
                  <a:pt x="1866" y="2943"/>
                  <a:pt x="2354" y="3118"/>
                  <a:pt x="2746"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7" name="Freeform 89">
            <a:extLst>
              <a:ext uri="{FF2B5EF4-FFF2-40B4-BE49-F238E27FC236}">
                <a16:creationId xmlns:a16="http://schemas.microsoft.com/office/drawing/2014/main" id="{92C73712-FAA8-4948-92B4-DA31886C5B49}"/>
              </a:ext>
            </a:extLst>
          </p:cNvPr>
          <p:cNvSpPr>
            <a:spLocks noChangeArrowheads="1"/>
          </p:cNvSpPr>
          <p:nvPr/>
        </p:nvSpPr>
        <p:spPr bwMode="auto">
          <a:xfrm>
            <a:off x="3926056" y="1102857"/>
            <a:ext cx="1281586" cy="1159270"/>
          </a:xfrm>
          <a:custGeom>
            <a:avLst/>
            <a:gdLst>
              <a:gd name="T0" fmla="*/ 2744 w 2745"/>
              <a:gd name="T1" fmla="*/ 3413 h 3414"/>
              <a:gd name="T2" fmla="*/ 2744 w 2745"/>
              <a:gd name="T3" fmla="*/ 416 h 3414"/>
              <a:gd name="T4" fmla="*/ 2744 w 2745"/>
              <a:gd name="T5" fmla="*/ 416 h 3414"/>
              <a:gd name="T6" fmla="*/ 2329 w 2745"/>
              <a:gd name="T7" fmla="*/ 0 h 3414"/>
              <a:gd name="T8" fmla="*/ 357 w 2745"/>
              <a:gd name="T9" fmla="*/ 0 h 3414"/>
              <a:gd name="T10" fmla="*/ 357 w 2745"/>
              <a:gd name="T11" fmla="*/ 0 h 3414"/>
              <a:gd name="T12" fmla="*/ 0 w 2745"/>
              <a:gd name="T13" fmla="*/ 358 h 3414"/>
              <a:gd name="T14" fmla="*/ 0 w 2745"/>
              <a:gd name="T15" fmla="*/ 3362 h 3414"/>
              <a:gd name="T16" fmla="*/ 0 w 2745"/>
              <a:gd name="T17" fmla="*/ 3362 h 3414"/>
              <a:gd name="T18" fmla="*/ 1337 w 2745"/>
              <a:gd name="T19" fmla="*/ 2944 h 3414"/>
              <a:gd name="T20" fmla="*/ 1337 w 2745"/>
              <a:gd name="T21" fmla="*/ 2944 h 3414"/>
              <a:gd name="T22" fmla="*/ 2744 w 2745"/>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5" h="3414">
                <a:moveTo>
                  <a:pt x="2744" y="3413"/>
                </a:moveTo>
                <a:lnTo>
                  <a:pt x="2744" y="416"/>
                </a:lnTo>
                <a:lnTo>
                  <a:pt x="2744" y="416"/>
                </a:lnTo>
                <a:cubicBezTo>
                  <a:pt x="2744" y="186"/>
                  <a:pt x="2558" y="0"/>
                  <a:pt x="2329" y="0"/>
                </a:cubicBezTo>
                <a:lnTo>
                  <a:pt x="357" y="0"/>
                </a:lnTo>
                <a:lnTo>
                  <a:pt x="357" y="0"/>
                </a:lnTo>
                <a:cubicBezTo>
                  <a:pt x="160" y="0"/>
                  <a:pt x="0" y="161"/>
                  <a:pt x="0" y="358"/>
                </a:cubicBezTo>
                <a:lnTo>
                  <a:pt x="0" y="3362"/>
                </a:lnTo>
                <a:lnTo>
                  <a:pt x="0" y="3362"/>
                </a:lnTo>
                <a:cubicBezTo>
                  <a:pt x="379" y="3098"/>
                  <a:pt x="840" y="2944"/>
                  <a:pt x="1337" y="2944"/>
                </a:cubicBezTo>
                <a:lnTo>
                  <a:pt x="1337" y="2944"/>
                </a:lnTo>
                <a:cubicBezTo>
                  <a:pt x="1864" y="2944"/>
                  <a:pt x="2352" y="3118"/>
                  <a:pt x="2744"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8" name="TextBox 97">
            <a:extLst>
              <a:ext uri="{FF2B5EF4-FFF2-40B4-BE49-F238E27FC236}">
                <a16:creationId xmlns:a16="http://schemas.microsoft.com/office/drawing/2014/main" id="{1881009A-AC4B-4615-BD56-7C2271DD3E1A}"/>
              </a:ext>
            </a:extLst>
          </p:cNvPr>
          <p:cNvSpPr txBox="1"/>
          <p:nvPr/>
        </p:nvSpPr>
        <p:spPr>
          <a:xfrm>
            <a:off x="3794031" y="3822917"/>
            <a:ext cx="1608827" cy="484748"/>
          </a:xfrm>
          <a:prstGeom prst="rect">
            <a:avLst/>
          </a:prstGeom>
          <a:noFill/>
        </p:spPr>
        <p:txBody>
          <a:bodyPr wrap="square" rtlCol="0" anchor="ctr">
            <a:spAutoFit/>
          </a:bodyPr>
          <a:lstStyle/>
          <a:p>
            <a:pPr algn="ctr"/>
            <a:r>
              <a:rPr lang="en-US" sz="1275" b="1" spc="-11">
                <a:solidFill>
                  <a:schemeClr val="bg1">
                    <a:lumMod val="50000"/>
                  </a:schemeClr>
                </a:solidFill>
                <a:latin typeface="+mj-lt"/>
                <a:cs typeface="Poppins" panose="00000500000000000000" pitchFamily="2" charset="0"/>
              </a:rPr>
              <a:t>AREAS OF IMPROVEMENT</a:t>
            </a:r>
          </a:p>
        </p:txBody>
      </p:sp>
      <p:sp>
        <p:nvSpPr>
          <p:cNvPr id="99" name="TextBox 98">
            <a:extLst>
              <a:ext uri="{FF2B5EF4-FFF2-40B4-BE49-F238E27FC236}">
                <a16:creationId xmlns:a16="http://schemas.microsoft.com/office/drawing/2014/main" id="{FABCD218-6E14-4AB5-8317-0C49B6433658}"/>
              </a:ext>
            </a:extLst>
          </p:cNvPr>
          <p:cNvSpPr txBox="1"/>
          <p:nvPr/>
        </p:nvSpPr>
        <p:spPr>
          <a:xfrm>
            <a:off x="497586" y="3275738"/>
            <a:ext cx="1401997" cy="276999"/>
          </a:xfrm>
          <a:prstGeom prst="rect">
            <a:avLst/>
          </a:prstGeom>
          <a:noFill/>
        </p:spPr>
        <p:txBody>
          <a:bodyPr wrap="square" rtlCol="0" anchor="ctr">
            <a:spAutoFit/>
          </a:bodyPr>
          <a:lstStyle/>
          <a:p>
            <a:pPr algn="ctr"/>
            <a:r>
              <a:rPr lang="en-US" sz="1200" b="1" spc="-11">
                <a:solidFill>
                  <a:schemeClr val="bg1"/>
                </a:solidFill>
                <a:latin typeface="+mj-lt"/>
                <a:cs typeface="Poppins" panose="00000500000000000000" pitchFamily="2" charset="0"/>
              </a:rPr>
              <a:t>COMMUNICATION</a:t>
            </a:r>
          </a:p>
        </p:txBody>
      </p:sp>
      <p:sp>
        <p:nvSpPr>
          <p:cNvPr id="100" name="TextBox 99">
            <a:extLst>
              <a:ext uri="{FF2B5EF4-FFF2-40B4-BE49-F238E27FC236}">
                <a16:creationId xmlns:a16="http://schemas.microsoft.com/office/drawing/2014/main" id="{A0655893-0BF9-43AE-AB96-68995F31142A}"/>
              </a:ext>
            </a:extLst>
          </p:cNvPr>
          <p:cNvSpPr txBox="1"/>
          <p:nvPr/>
        </p:nvSpPr>
        <p:spPr>
          <a:xfrm>
            <a:off x="639553" y="1865193"/>
            <a:ext cx="1135904" cy="974754"/>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Better communication before research activities, and of final research learnings</a:t>
            </a:r>
          </a:p>
        </p:txBody>
      </p:sp>
      <p:sp>
        <p:nvSpPr>
          <p:cNvPr id="101" name="TextBox 100">
            <a:extLst>
              <a:ext uri="{FF2B5EF4-FFF2-40B4-BE49-F238E27FC236}">
                <a16:creationId xmlns:a16="http://schemas.microsoft.com/office/drawing/2014/main" id="{10498E5E-7735-4C23-952C-915CD73C0385}"/>
              </a:ext>
            </a:extLst>
          </p:cNvPr>
          <p:cNvSpPr txBox="1"/>
          <p:nvPr/>
        </p:nvSpPr>
        <p:spPr>
          <a:xfrm>
            <a:off x="2319526" y="2584164"/>
            <a:ext cx="1135903" cy="288541"/>
          </a:xfrm>
          <a:prstGeom prst="rect">
            <a:avLst/>
          </a:prstGeom>
          <a:noFill/>
        </p:spPr>
        <p:txBody>
          <a:bodyPr wrap="square" rtlCol="0" anchor="ctr">
            <a:spAutoFit/>
          </a:bodyPr>
          <a:lstStyle/>
          <a:p>
            <a:pPr algn="ctr"/>
            <a:r>
              <a:rPr lang="en-US" sz="1275" b="1" spc="-11">
                <a:solidFill>
                  <a:schemeClr val="bg1"/>
                </a:solidFill>
                <a:latin typeface="+mj-lt"/>
                <a:cs typeface="Poppins" panose="00000500000000000000" pitchFamily="2" charset="0"/>
              </a:rPr>
              <a:t>DIVERSITY</a:t>
            </a:r>
          </a:p>
        </p:txBody>
      </p:sp>
      <p:sp>
        <p:nvSpPr>
          <p:cNvPr id="102" name="TextBox 101">
            <a:extLst>
              <a:ext uri="{FF2B5EF4-FFF2-40B4-BE49-F238E27FC236}">
                <a16:creationId xmlns:a16="http://schemas.microsoft.com/office/drawing/2014/main" id="{D18C9A4A-48FC-4E7D-A8DB-100653C6540A}"/>
              </a:ext>
            </a:extLst>
          </p:cNvPr>
          <p:cNvSpPr txBox="1"/>
          <p:nvPr/>
        </p:nvSpPr>
        <p:spPr>
          <a:xfrm>
            <a:off x="2319526" y="971114"/>
            <a:ext cx="1135904" cy="1333827"/>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More diversity of young people from all backgrounds (culture, where people live, income/occupation, </a:t>
            </a:r>
            <a:r>
              <a:rPr lang="en-US" sz="900" spc="-8" err="1">
                <a:latin typeface="+mj-lt"/>
                <a:cs typeface="Poppins" panose="00000500000000000000" pitchFamily="2" charset="0"/>
              </a:rPr>
              <a:t>etc</a:t>
            </a:r>
            <a:r>
              <a:rPr lang="en-US" sz="900" spc="-8">
                <a:latin typeface="+mj-lt"/>
                <a:cs typeface="Poppins" panose="00000500000000000000" pitchFamily="2" charset="0"/>
              </a:rPr>
              <a:t>)</a:t>
            </a:r>
          </a:p>
        </p:txBody>
      </p:sp>
      <p:sp>
        <p:nvSpPr>
          <p:cNvPr id="103" name="TextBox 102">
            <a:extLst>
              <a:ext uri="{FF2B5EF4-FFF2-40B4-BE49-F238E27FC236}">
                <a16:creationId xmlns:a16="http://schemas.microsoft.com/office/drawing/2014/main" id="{8746DBF3-577F-4828-8DA1-843BDFF8B4A9}"/>
              </a:ext>
            </a:extLst>
          </p:cNvPr>
          <p:cNvSpPr txBox="1"/>
          <p:nvPr/>
        </p:nvSpPr>
        <p:spPr>
          <a:xfrm>
            <a:off x="3931208" y="2274575"/>
            <a:ext cx="1281584" cy="288541"/>
          </a:xfrm>
          <a:prstGeom prst="rect">
            <a:avLst/>
          </a:prstGeom>
          <a:noFill/>
        </p:spPr>
        <p:txBody>
          <a:bodyPr wrap="square" rtlCol="0" anchor="ctr">
            <a:spAutoFit/>
          </a:bodyPr>
          <a:lstStyle/>
          <a:p>
            <a:pPr algn="ctr"/>
            <a:r>
              <a:rPr lang="en-US" sz="1275" b="1" spc="-11">
                <a:solidFill>
                  <a:schemeClr val="bg1"/>
                </a:solidFill>
                <a:latin typeface="+mj-lt"/>
                <a:cs typeface="Poppins" panose="00000500000000000000" pitchFamily="2" charset="0"/>
              </a:rPr>
              <a:t>ORGANISATION</a:t>
            </a:r>
          </a:p>
        </p:txBody>
      </p:sp>
      <p:sp>
        <p:nvSpPr>
          <p:cNvPr id="108" name="TextBox 107">
            <a:extLst>
              <a:ext uri="{FF2B5EF4-FFF2-40B4-BE49-F238E27FC236}">
                <a16:creationId xmlns:a16="http://schemas.microsoft.com/office/drawing/2014/main" id="{501EA496-7C42-44F0-B647-2935D4331678}"/>
              </a:ext>
            </a:extLst>
          </p:cNvPr>
          <p:cNvSpPr txBox="1"/>
          <p:nvPr/>
        </p:nvSpPr>
        <p:spPr>
          <a:xfrm>
            <a:off x="3991807" y="1372022"/>
            <a:ext cx="1135904" cy="436145"/>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Better </a:t>
            </a:r>
            <a:r>
              <a:rPr lang="en-US" sz="900" spc="-8" err="1">
                <a:latin typeface="+mj-lt"/>
                <a:cs typeface="Poppins" panose="00000500000000000000" pitchFamily="2" charset="0"/>
              </a:rPr>
              <a:t>organisation</a:t>
            </a:r>
            <a:r>
              <a:rPr lang="en-US" sz="900" spc="-8">
                <a:latin typeface="+mj-lt"/>
                <a:cs typeface="Poppins" panose="00000500000000000000" pitchFamily="2" charset="0"/>
              </a:rPr>
              <a:t> of research activities</a:t>
            </a:r>
          </a:p>
        </p:txBody>
      </p:sp>
      <p:sp>
        <p:nvSpPr>
          <p:cNvPr id="109" name="TextBox 108">
            <a:extLst>
              <a:ext uri="{FF2B5EF4-FFF2-40B4-BE49-F238E27FC236}">
                <a16:creationId xmlns:a16="http://schemas.microsoft.com/office/drawing/2014/main" id="{467FB290-A875-4840-9875-ED489406C9F2}"/>
              </a:ext>
            </a:extLst>
          </p:cNvPr>
          <p:cNvSpPr txBox="1"/>
          <p:nvPr/>
        </p:nvSpPr>
        <p:spPr>
          <a:xfrm>
            <a:off x="5688781" y="2486061"/>
            <a:ext cx="1135903" cy="484748"/>
          </a:xfrm>
          <a:prstGeom prst="rect">
            <a:avLst/>
          </a:prstGeom>
          <a:noFill/>
        </p:spPr>
        <p:txBody>
          <a:bodyPr wrap="square" rtlCol="0" anchor="ctr">
            <a:spAutoFit/>
          </a:bodyPr>
          <a:lstStyle/>
          <a:p>
            <a:pPr algn="ctr"/>
            <a:r>
              <a:rPr lang="en-US" sz="1275" b="1" spc="-11">
                <a:solidFill>
                  <a:schemeClr val="bg1"/>
                </a:solidFill>
                <a:latin typeface="+mj-lt"/>
                <a:cs typeface="Poppins" panose="00000500000000000000" pitchFamily="2" charset="0"/>
              </a:rPr>
              <a:t>ENGAGING ACTIVITIES </a:t>
            </a:r>
          </a:p>
        </p:txBody>
      </p:sp>
      <p:sp>
        <p:nvSpPr>
          <p:cNvPr id="114" name="TextBox 113">
            <a:extLst>
              <a:ext uri="{FF2B5EF4-FFF2-40B4-BE49-F238E27FC236}">
                <a16:creationId xmlns:a16="http://schemas.microsoft.com/office/drawing/2014/main" id="{A0541818-56FD-430F-BAAE-C3F0E547F923}"/>
              </a:ext>
            </a:extLst>
          </p:cNvPr>
          <p:cNvSpPr txBox="1"/>
          <p:nvPr/>
        </p:nvSpPr>
        <p:spPr>
          <a:xfrm>
            <a:off x="5696237" y="1705639"/>
            <a:ext cx="1135904" cy="615681"/>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Having a variety of tasks to keep the group engaged</a:t>
            </a:r>
          </a:p>
        </p:txBody>
      </p:sp>
      <p:sp>
        <p:nvSpPr>
          <p:cNvPr id="115" name="TextBox 114">
            <a:extLst>
              <a:ext uri="{FF2B5EF4-FFF2-40B4-BE49-F238E27FC236}">
                <a16:creationId xmlns:a16="http://schemas.microsoft.com/office/drawing/2014/main" id="{3A30BAD5-FEAF-47A8-BB90-E6BA645F90C7}"/>
              </a:ext>
            </a:extLst>
          </p:cNvPr>
          <p:cNvSpPr txBox="1"/>
          <p:nvPr/>
        </p:nvSpPr>
        <p:spPr>
          <a:xfrm>
            <a:off x="7370605" y="3184625"/>
            <a:ext cx="1135903" cy="484748"/>
          </a:xfrm>
          <a:prstGeom prst="rect">
            <a:avLst/>
          </a:prstGeom>
          <a:noFill/>
        </p:spPr>
        <p:txBody>
          <a:bodyPr wrap="square" rtlCol="0" anchor="ctr">
            <a:spAutoFit/>
          </a:bodyPr>
          <a:lstStyle/>
          <a:p>
            <a:pPr algn="ctr"/>
            <a:r>
              <a:rPr lang="en-US" sz="1275" b="1" spc="-11">
                <a:solidFill>
                  <a:schemeClr val="bg1"/>
                </a:solidFill>
                <a:latin typeface="+mj-lt"/>
                <a:cs typeface="Poppins" panose="00000500000000000000" pitchFamily="2" charset="0"/>
              </a:rPr>
              <a:t>CONSUMER-LED</a:t>
            </a:r>
          </a:p>
        </p:txBody>
      </p:sp>
      <p:sp>
        <p:nvSpPr>
          <p:cNvPr id="116" name="TextBox 115">
            <a:extLst>
              <a:ext uri="{FF2B5EF4-FFF2-40B4-BE49-F238E27FC236}">
                <a16:creationId xmlns:a16="http://schemas.microsoft.com/office/drawing/2014/main" id="{EBF52669-1F24-488D-B67E-3930E18BDFBE}"/>
              </a:ext>
            </a:extLst>
          </p:cNvPr>
          <p:cNvSpPr txBox="1"/>
          <p:nvPr/>
        </p:nvSpPr>
        <p:spPr>
          <a:xfrm>
            <a:off x="7370605" y="2044729"/>
            <a:ext cx="1135904" cy="615681"/>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Having opportunities where young people can lead</a:t>
            </a:r>
          </a:p>
        </p:txBody>
      </p:sp>
      <p:sp>
        <p:nvSpPr>
          <p:cNvPr id="117" name="Freeform 16">
            <a:extLst>
              <a:ext uri="{FF2B5EF4-FFF2-40B4-BE49-F238E27FC236}">
                <a16:creationId xmlns:a16="http://schemas.microsoft.com/office/drawing/2014/main" id="{DA9C14B9-3DDB-4C9E-BFCA-1D1CA1E790AB}"/>
              </a:ext>
            </a:extLst>
          </p:cNvPr>
          <p:cNvSpPr/>
          <p:nvPr/>
        </p:nvSpPr>
        <p:spPr>
          <a:xfrm>
            <a:off x="1193698" y="3822918"/>
            <a:ext cx="233857" cy="459917"/>
          </a:xfrm>
          <a:custGeom>
            <a:avLst/>
            <a:gdLst>
              <a:gd name="connsiteX0" fmla="*/ 0 w 623455"/>
              <a:gd name="connsiteY0" fmla="*/ 0 h 1226127"/>
              <a:gd name="connsiteX1" fmla="*/ 0 w 623455"/>
              <a:gd name="connsiteY1" fmla="*/ 0 h 1226127"/>
              <a:gd name="connsiteX2" fmla="*/ 10391 w 623455"/>
              <a:gd name="connsiteY2" fmla="*/ 1101436 h 1226127"/>
              <a:gd name="connsiteX3" fmla="*/ 623455 w 623455"/>
              <a:gd name="connsiteY3" fmla="*/ 1226127 h 1226127"/>
            </a:gdLst>
            <a:ahLst/>
            <a:cxnLst>
              <a:cxn ang="0">
                <a:pos x="connsiteX0" y="connsiteY0"/>
              </a:cxn>
              <a:cxn ang="0">
                <a:pos x="connsiteX1" y="connsiteY1"/>
              </a:cxn>
              <a:cxn ang="0">
                <a:pos x="connsiteX2" y="connsiteY2"/>
              </a:cxn>
              <a:cxn ang="0">
                <a:pos x="connsiteX3" y="connsiteY3"/>
              </a:cxn>
            </a:cxnLst>
            <a:rect l="l" t="t" r="r" b="b"/>
            <a:pathLst>
              <a:path w="623455" h="1226127">
                <a:moveTo>
                  <a:pt x="0" y="0"/>
                </a:moveTo>
                <a:lnTo>
                  <a:pt x="0" y="0"/>
                </a:lnTo>
                <a:cubicBezTo>
                  <a:pt x="3464" y="367145"/>
                  <a:pt x="6927" y="734291"/>
                  <a:pt x="10391" y="1101436"/>
                </a:cubicBezTo>
                <a:lnTo>
                  <a:pt x="623455" y="1226127"/>
                </a:lnTo>
              </a:path>
            </a:pathLst>
          </a:cu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cxnSp>
        <p:nvCxnSpPr>
          <p:cNvPr id="118" name="Straight Connector 117">
            <a:extLst>
              <a:ext uri="{FF2B5EF4-FFF2-40B4-BE49-F238E27FC236}">
                <a16:creationId xmlns:a16="http://schemas.microsoft.com/office/drawing/2014/main" id="{77306D67-E43A-4F45-856A-480F463CCEF5}"/>
              </a:ext>
            </a:extLst>
          </p:cNvPr>
          <p:cNvCxnSpPr>
            <a:cxnSpLocks/>
          </p:cNvCxnSpPr>
          <p:nvPr/>
        </p:nvCxnSpPr>
        <p:spPr>
          <a:xfrm>
            <a:off x="4564929" y="2864106"/>
            <a:ext cx="0" cy="856123"/>
          </a:xfrm>
          <a:prstGeom prst="line">
            <a:avLst/>
          </a:pr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119" name="Freeform 17">
            <a:extLst>
              <a:ext uri="{FF2B5EF4-FFF2-40B4-BE49-F238E27FC236}">
                <a16:creationId xmlns:a16="http://schemas.microsoft.com/office/drawing/2014/main" id="{368D9133-401D-44BB-BB14-98D2BDC0C2A8}"/>
              </a:ext>
            </a:extLst>
          </p:cNvPr>
          <p:cNvSpPr/>
          <p:nvPr/>
        </p:nvSpPr>
        <p:spPr>
          <a:xfrm>
            <a:off x="2883407" y="3096133"/>
            <a:ext cx="237927" cy="726784"/>
          </a:xfrm>
          <a:custGeom>
            <a:avLst/>
            <a:gdLst>
              <a:gd name="connsiteX0" fmla="*/ 0 w 623455"/>
              <a:gd name="connsiteY0" fmla="*/ 0 h 1226127"/>
              <a:gd name="connsiteX1" fmla="*/ 0 w 623455"/>
              <a:gd name="connsiteY1" fmla="*/ 0 h 1226127"/>
              <a:gd name="connsiteX2" fmla="*/ 10391 w 623455"/>
              <a:gd name="connsiteY2" fmla="*/ 1101436 h 1226127"/>
              <a:gd name="connsiteX3" fmla="*/ 623455 w 623455"/>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Lst>
            <a:ahLst/>
            <a:cxnLst>
              <a:cxn ang="0">
                <a:pos x="connsiteX0" y="connsiteY0"/>
              </a:cxn>
              <a:cxn ang="0">
                <a:pos x="connsiteX1" y="connsiteY1"/>
              </a:cxn>
              <a:cxn ang="0">
                <a:pos x="connsiteX2" y="connsiteY2"/>
              </a:cxn>
              <a:cxn ang="0">
                <a:pos x="connsiteX3" y="connsiteY3"/>
              </a:cxn>
            </a:cxnLst>
            <a:rect l="l" t="t" r="r" b="b"/>
            <a:pathLst>
              <a:path w="634306" h="1226127">
                <a:moveTo>
                  <a:pt x="10851" y="0"/>
                </a:moveTo>
                <a:lnTo>
                  <a:pt x="10851" y="0"/>
                </a:lnTo>
                <a:cubicBezTo>
                  <a:pt x="14315" y="367145"/>
                  <a:pt x="-3004" y="399675"/>
                  <a:pt x="460" y="766820"/>
                </a:cubicBezTo>
                <a:cubicBezTo>
                  <a:pt x="163251" y="880087"/>
                  <a:pt x="492296" y="1106884"/>
                  <a:pt x="634306" y="1226127"/>
                </a:cubicBezTo>
              </a:path>
            </a:pathLst>
          </a:cu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120" name="Freeform 21">
            <a:extLst>
              <a:ext uri="{FF2B5EF4-FFF2-40B4-BE49-F238E27FC236}">
                <a16:creationId xmlns:a16="http://schemas.microsoft.com/office/drawing/2014/main" id="{061E4784-FD6C-49F5-B0D1-98AD70D44DEC}"/>
              </a:ext>
            </a:extLst>
          </p:cNvPr>
          <p:cNvSpPr/>
          <p:nvPr/>
        </p:nvSpPr>
        <p:spPr>
          <a:xfrm flipH="1">
            <a:off x="6018805" y="3096133"/>
            <a:ext cx="237927" cy="726784"/>
          </a:xfrm>
          <a:custGeom>
            <a:avLst/>
            <a:gdLst>
              <a:gd name="connsiteX0" fmla="*/ 0 w 623455"/>
              <a:gd name="connsiteY0" fmla="*/ 0 h 1226127"/>
              <a:gd name="connsiteX1" fmla="*/ 0 w 623455"/>
              <a:gd name="connsiteY1" fmla="*/ 0 h 1226127"/>
              <a:gd name="connsiteX2" fmla="*/ 10391 w 623455"/>
              <a:gd name="connsiteY2" fmla="*/ 1101436 h 1226127"/>
              <a:gd name="connsiteX3" fmla="*/ 623455 w 623455"/>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Lst>
            <a:ahLst/>
            <a:cxnLst>
              <a:cxn ang="0">
                <a:pos x="connsiteX0" y="connsiteY0"/>
              </a:cxn>
              <a:cxn ang="0">
                <a:pos x="connsiteX1" y="connsiteY1"/>
              </a:cxn>
              <a:cxn ang="0">
                <a:pos x="connsiteX2" y="connsiteY2"/>
              </a:cxn>
              <a:cxn ang="0">
                <a:pos x="connsiteX3" y="connsiteY3"/>
              </a:cxn>
            </a:cxnLst>
            <a:rect l="l" t="t" r="r" b="b"/>
            <a:pathLst>
              <a:path w="634306" h="1226127">
                <a:moveTo>
                  <a:pt x="10851" y="0"/>
                </a:moveTo>
                <a:lnTo>
                  <a:pt x="10851" y="0"/>
                </a:lnTo>
                <a:cubicBezTo>
                  <a:pt x="14315" y="367145"/>
                  <a:pt x="-3004" y="399675"/>
                  <a:pt x="460" y="766820"/>
                </a:cubicBezTo>
                <a:cubicBezTo>
                  <a:pt x="163251" y="880087"/>
                  <a:pt x="492296" y="1106884"/>
                  <a:pt x="634306" y="1226127"/>
                </a:cubicBezTo>
              </a:path>
            </a:pathLst>
          </a:cu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121" name="Freeform 22">
            <a:extLst>
              <a:ext uri="{FF2B5EF4-FFF2-40B4-BE49-F238E27FC236}">
                <a16:creationId xmlns:a16="http://schemas.microsoft.com/office/drawing/2014/main" id="{696935E0-1D76-4CF2-91FE-CE17F111B991}"/>
              </a:ext>
            </a:extLst>
          </p:cNvPr>
          <p:cNvSpPr/>
          <p:nvPr/>
        </p:nvSpPr>
        <p:spPr>
          <a:xfrm flipH="1">
            <a:off x="7704700" y="3822918"/>
            <a:ext cx="233857" cy="459917"/>
          </a:xfrm>
          <a:custGeom>
            <a:avLst/>
            <a:gdLst>
              <a:gd name="connsiteX0" fmla="*/ 0 w 623455"/>
              <a:gd name="connsiteY0" fmla="*/ 0 h 1226127"/>
              <a:gd name="connsiteX1" fmla="*/ 0 w 623455"/>
              <a:gd name="connsiteY1" fmla="*/ 0 h 1226127"/>
              <a:gd name="connsiteX2" fmla="*/ 10391 w 623455"/>
              <a:gd name="connsiteY2" fmla="*/ 1101436 h 1226127"/>
              <a:gd name="connsiteX3" fmla="*/ 623455 w 623455"/>
              <a:gd name="connsiteY3" fmla="*/ 1226127 h 1226127"/>
            </a:gdLst>
            <a:ahLst/>
            <a:cxnLst>
              <a:cxn ang="0">
                <a:pos x="connsiteX0" y="connsiteY0"/>
              </a:cxn>
              <a:cxn ang="0">
                <a:pos x="connsiteX1" y="connsiteY1"/>
              </a:cxn>
              <a:cxn ang="0">
                <a:pos x="connsiteX2" y="connsiteY2"/>
              </a:cxn>
              <a:cxn ang="0">
                <a:pos x="connsiteX3" y="connsiteY3"/>
              </a:cxn>
            </a:cxnLst>
            <a:rect l="l" t="t" r="r" b="b"/>
            <a:pathLst>
              <a:path w="623455" h="1226127">
                <a:moveTo>
                  <a:pt x="0" y="0"/>
                </a:moveTo>
                <a:lnTo>
                  <a:pt x="0" y="0"/>
                </a:lnTo>
                <a:cubicBezTo>
                  <a:pt x="3464" y="367145"/>
                  <a:pt x="6927" y="734291"/>
                  <a:pt x="10391" y="1101436"/>
                </a:cubicBezTo>
                <a:lnTo>
                  <a:pt x="623455" y="1226127"/>
                </a:lnTo>
              </a:path>
            </a:pathLst>
          </a:cu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cxnSp>
        <p:nvCxnSpPr>
          <p:cNvPr id="138" name="Straight Connector 137">
            <a:extLst>
              <a:ext uri="{FF2B5EF4-FFF2-40B4-BE49-F238E27FC236}">
                <a16:creationId xmlns:a16="http://schemas.microsoft.com/office/drawing/2014/main" id="{9959127E-055C-4B8D-AE54-60BEBE6FB27F}"/>
              </a:ext>
            </a:extLst>
          </p:cNvPr>
          <p:cNvCxnSpPr>
            <a:cxnSpLocks/>
          </p:cNvCxnSpPr>
          <p:nvPr/>
        </p:nvCxnSpPr>
        <p:spPr>
          <a:xfrm>
            <a:off x="6263614" y="1471606"/>
            <a:ext cx="0" cy="267412"/>
          </a:xfrm>
          <a:prstGeom prst="line">
            <a:avLst/>
          </a:pr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142" name="TextBox 141">
            <a:extLst>
              <a:ext uri="{FF2B5EF4-FFF2-40B4-BE49-F238E27FC236}">
                <a16:creationId xmlns:a16="http://schemas.microsoft.com/office/drawing/2014/main" id="{86B23B6A-5700-4425-B4D0-EAA428DDD848}"/>
              </a:ext>
            </a:extLst>
          </p:cNvPr>
          <p:cNvSpPr txBox="1"/>
          <p:nvPr/>
        </p:nvSpPr>
        <p:spPr>
          <a:xfrm>
            <a:off x="5631065" y="937507"/>
            <a:ext cx="1268190" cy="436145"/>
          </a:xfrm>
          <a:prstGeom prst="rect">
            <a:avLst/>
          </a:prstGeom>
          <a:noFill/>
        </p:spPr>
        <p:txBody>
          <a:bodyPr wrap="square" rtlCol="0" anchor="ctr">
            <a:spAutoFit/>
          </a:bodyPr>
          <a:lstStyle/>
          <a:p>
            <a:pPr algn="ctr">
              <a:lnSpc>
                <a:spcPts val="1350"/>
              </a:lnSpc>
            </a:pPr>
            <a:r>
              <a:rPr lang="en-US" sz="900" i="1" spc="-8">
                <a:latin typeface="+mj-lt"/>
                <a:cs typeface="Poppins" panose="00000500000000000000" pitchFamily="2" charset="0"/>
              </a:rPr>
              <a:t>What activities are engaging to the group?</a:t>
            </a:r>
          </a:p>
        </p:txBody>
      </p:sp>
      <p:sp>
        <p:nvSpPr>
          <p:cNvPr id="2" name="Freeform 1000">
            <a:extLst>
              <a:ext uri="{FF2B5EF4-FFF2-40B4-BE49-F238E27FC236}">
                <a16:creationId xmlns:a16="http://schemas.microsoft.com/office/drawing/2014/main" id="{BC9C602D-B932-5FA5-4872-C3F15DB5A41B}"/>
              </a:ext>
            </a:extLst>
          </p:cNvPr>
          <p:cNvSpPr>
            <a:spLocks noChangeAspect="1" noChangeArrowheads="1"/>
          </p:cNvSpPr>
          <p:nvPr/>
        </p:nvSpPr>
        <p:spPr bwMode="auto">
          <a:xfrm>
            <a:off x="656328" y="4825257"/>
            <a:ext cx="417105" cy="267361"/>
          </a:xfrm>
          <a:custGeom>
            <a:avLst/>
            <a:gdLst>
              <a:gd name="T0" fmla="*/ 73901 w 290132"/>
              <a:gd name="T1" fmla="*/ 708677 h 289197"/>
              <a:gd name="T2" fmla="*/ 868984 w 290132"/>
              <a:gd name="T3" fmla="*/ 673933 h 289197"/>
              <a:gd name="T4" fmla="*/ 680804 w 290132"/>
              <a:gd name="T5" fmla="*/ 761616 h 289197"/>
              <a:gd name="T6" fmla="*/ 860592 w 290132"/>
              <a:gd name="T7" fmla="*/ 712510 h 289197"/>
              <a:gd name="T8" fmla="*/ 152217 w 290132"/>
              <a:gd name="T9" fmla="*/ 644704 h 289197"/>
              <a:gd name="T10" fmla="*/ 934905 w 290132"/>
              <a:gd name="T11" fmla="*/ 737061 h 289197"/>
              <a:gd name="T12" fmla="*/ 632859 w 290132"/>
              <a:gd name="T13" fmla="*/ 814219 h 289197"/>
              <a:gd name="T14" fmla="*/ 400336 w 290132"/>
              <a:gd name="T15" fmla="*/ 817726 h 289197"/>
              <a:gd name="T16" fmla="*/ 624468 w 290132"/>
              <a:gd name="T17" fmla="*/ 787331 h 289197"/>
              <a:gd name="T18" fmla="*/ 641250 w 290132"/>
              <a:gd name="T19" fmla="*/ 721863 h 289197"/>
              <a:gd name="T20" fmla="*/ 152217 w 290132"/>
              <a:gd name="T21" fmla="*/ 644704 h 289197"/>
              <a:gd name="T22" fmla="*/ 122247 w 290132"/>
              <a:gd name="T23" fmla="*/ 872674 h 289197"/>
              <a:gd name="T24" fmla="*/ 14389 w 290132"/>
              <a:gd name="T25" fmla="*/ 616643 h 289197"/>
              <a:gd name="T26" fmla="*/ 612486 w 290132"/>
              <a:gd name="T27" fmla="*/ 682113 h 289197"/>
              <a:gd name="T28" fmla="*/ 787474 w 290132"/>
              <a:gd name="T29" fmla="*/ 670424 h 289197"/>
              <a:gd name="T30" fmla="*/ 904936 w 290132"/>
              <a:gd name="T31" fmla="*/ 696143 h 289197"/>
              <a:gd name="T32" fmla="*/ 927709 w 290132"/>
              <a:gd name="T33" fmla="*/ 790838 h 289197"/>
              <a:gd name="T34" fmla="*/ 14389 w 290132"/>
              <a:gd name="T35" fmla="*/ 900730 h 289197"/>
              <a:gd name="T36" fmla="*/ 14389 w 290132"/>
              <a:gd name="T37" fmla="*/ 616643 h 289197"/>
              <a:gd name="T38" fmla="*/ 415829 w 290132"/>
              <a:gd name="T39" fmla="*/ 605337 h 289197"/>
              <a:gd name="T40" fmla="*/ 385374 w 290132"/>
              <a:gd name="T41" fmla="*/ 531143 h 289197"/>
              <a:gd name="T42" fmla="*/ 553031 w 290132"/>
              <a:gd name="T43" fmla="*/ 418322 h 289197"/>
              <a:gd name="T44" fmla="*/ 522625 w 290132"/>
              <a:gd name="T45" fmla="*/ 647971 h 289197"/>
              <a:gd name="T46" fmla="*/ 675723 w 290132"/>
              <a:gd name="T47" fmla="*/ 326456 h 289197"/>
              <a:gd name="T48" fmla="*/ 675723 w 290132"/>
              <a:gd name="T49" fmla="*/ 677661 h 289197"/>
              <a:gd name="T50" fmla="*/ 675723 w 290132"/>
              <a:gd name="T51" fmla="*/ 326456 h 289197"/>
              <a:gd name="T52" fmla="*/ 827544 w 290132"/>
              <a:gd name="T53" fmla="*/ 626113 h 289197"/>
              <a:gd name="T54" fmla="*/ 797138 w 290132"/>
              <a:gd name="T55" fmla="*/ 268005 h 289197"/>
              <a:gd name="T56" fmla="*/ 964804 w 290132"/>
              <a:gd name="T57" fmla="*/ 133282 h 289197"/>
              <a:gd name="T58" fmla="*/ 934387 w 290132"/>
              <a:gd name="T59" fmla="*/ 667571 h 289197"/>
              <a:gd name="T60" fmla="*/ 934509 w 290132"/>
              <a:gd name="T61" fmla="*/ 31793 h 289197"/>
              <a:gd name="T62" fmla="*/ 711168 w 290132"/>
              <a:gd name="T63" fmla="*/ 290449 h 289197"/>
              <a:gd name="T64" fmla="*/ 408997 w 290132"/>
              <a:gd name="T65" fmla="*/ 473862 h 289197"/>
              <a:gd name="T66" fmla="*/ 195201 w 290132"/>
              <a:gd name="T67" fmla="*/ 579674 h 289197"/>
              <a:gd name="T68" fmla="*/ 174897 w 290132"/>
              <a:gd name="T69" fmla="*/ 559686 h 289197"/>
              <a:gd name="T70" fmla="*/ 399438 w 290132"/>
              <a:gd name="T71" fmla="*/ 443293 h 289197"/>
              <a:gd name="T72" fmla="*/ 701609 w 290132"/>
              <a:gd name="T73" fmla="*/ 261056 h 289197"/>
              <a:gd name="T74" fmla="*/ 172251 w 290132"/>
              <a:gd name="T75" fmla="*/ 192767 h 289197"/>
              <a:gd name="T76" fmla="*/ 470609 w 290132"/>
              <a:gd name="T77" fmla="*/ 240067 h 289197"/>
              <a:gd name="T78" fmla="*/ 156801 w 290132"/>
              <a:gd name="T79" fmla="*/ 0 h 289197"/>
              <a:gd name="T80" fmla="*/ 500323 w 290132"/>
              <a:gd name="T81" fmla="*/ 269630 h 289197"/>
              <a:gd name="T82" fmla="*/ 476551 w 290132"/>
              <a:gd name="T83" fmla="*/ 281455 h 289197"/>
              <a:gd name="T84" fmla="*/ 142533 w 290132"/>
              <a:gd name="T85" fmla="*/ 206955 h 289197"/>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 name="T99" fmla="*/ 0 60000 65536"/>
              <a:gd name="T100" fmla="*/ 0 60000 65536"/>
              <a:gd name="T101" fmla="*/ 0 60000 65536"/>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Lst>
            <a:ahLst/>
            <a:cxnLst>
              <a:cxn ang="T86">
                <a:pos x="T0" y="T1"/>
              </a:cxn>
              <a:cxn ang="T87">
                <a:pos x="T2" y="T3"/>
              </a:cxn>
              <a:cxn ang="T88">
                <a:pos x="T4" y="T5"/>
              </a:cxn>
              <a:cxn ang="T89">
                <a:pos x="T6" y="T7"/>
              </a:cxn>
              <a:cxn ang="T90">
                <a:pos x="T8" y="T9"/>
              </a:cxn>
              <a:cxn ang="T91">
                <a:pos x="T10" y="T11"/>
              </a:cxn>
              <a:cxn ang="T92">
                <a:pos x="T12" y="T13"/>
              </a:cxn>
              <a:cxn ang="T93">
                <a:pos x="T14" y="T15"/>
              </a:cxn>
              <a:cxn ang="T94">
                <a:pos x="T16" y="T17"/>
              </a:cxn>
              <a:cxn ang="T95">
                <a:pos x="T18" y="T19"/>
              </a:cxn>
              <a:cxn ang="T96">
                <a:pos x="T20" y="T21"/>
              </a:cxn>
              <a:cxn ang="T97">
                <a:pos x="T22" y="T23"/>
              </a:cxn>
              <a:cxn ang="T98">
                <a:pos x="T24" y="T25"/>
              </a:cxn>
              <a:cxn ang="T99">
                <a:pos x="T26" y="T27"/>
              </a:cxn>
              <a:cxn ang="T100">
                <a:pos x="T28" y="T29"/>
              </a:cxn>
              <a:cxn ang="T101">
                <a:pos x="T30" y="T31"/>
              </a:cxn>
              <a:cxn ang="T102">
                <a:pos x="T32" y="T33"/>
              </a:cxn>
              <a:cxn ang="T103">
                <a:pos x="T34" y="T35"/>
              </a:cxn>
              <a:cxn ang="T104">
                <a:pos x="T36" y="T37"/>
              </a:cxn>
              <a:cxn ang="T105">
                <a:pos x="T38" y="T39"/>
              </a:cxn>
              <a:cxn ang="T106">
                <a:pos x="T40" y="T41"/>
              </a:cxn>
              <a:cxn ang="T107">
                <a:pos x="T42" y="T43"/>
              </a:cxn>
              <a:cxn ang="T108">
                <a:pos x="T44" y="T45"/>
              </a:cxn>
              <a:cxn ang="T109">
                <a:pos x="T46" y="T47"/>
              </a:cxn>
              <a:cxn ang="T110">
                <a:pos x="T48" y="T49"/>
              </a:cxn>
              <a:cxn ang="T111">
                <a:pos x="T50" y="T51"/>
              </a:cxn>
              <a:cxn ang="T112">
                <a:pos x="T52" y="T53"/>
              </a:cxn>
              <a:cxn ang="T113">
                <a:pos x="T54" y="T55"/>
              </a:cxn>
              <a:cxn ang="T114">
                <a:pos x="T56" y="T57"/>
              </a:cxn>
              <a:cxn ang="T115">
                <a:pos x="T58" y="T59"/>
              </a:cxn>
              <a:cxn ang="T116">
                <a:pos x="T60" y="T61"/>
              </a:cxn>
              <a:cxn ang="T117">
                <a:pos x="T62" y="T63"/>
              </a:cxn>
              <a:cxn ang="T118">
                <a:pos x="T64" y="T65"/>
              </a:cxn>
              <a:cxn ang="T119">
                <a:pos x="T66" y="T67"/>
              </a:cxn>
              <a:cxn ang="T120">
                <a:pos x="T68" y="T69"/>
              </a:cxn>
              <a:cxn ang="T121">
                <a:pos x="T70" y="T71"/>
              </a:cxn>
              <a:cxn ang="T122">
                <a:pos x="T72" y="T73"/>
              </a:cxn>
              <a:cxn ang="T123">
                <a:pos x="T74" y="T75"/>
              </a:cxn>
              <a:cxn ang="T124">
                <a:pos x="T76" y="T77"/>
              </a:cxn>
              <a:cxn ang="T125">
                <a:pos x="T78" y="T79"/>
              </a:cxn>
              <a:cxn ang="T126">
                <a:pos x="T80" y="T81"/>
              </a:cxn>
              <a:cxn ang="T127">
                <a:pos x="T82" y="T83"/>
              </a:cxn>
              <a:cxn ang="T128">
                <a:pos x="T84" y="T85"/>
              </a:cxn>
            </a:cxnLst>
            <a:rect l="0" t="0" r="r" b="b"/>
            <a:pathLst>
              <a:path w="290132" h="289197">
                <a:moveTo>
                  <a:pt x="22225" y="207963"/>
                </a:moveTo>
                <a:cubicBezTo>
                  <a:pt x="24423" y="207963"/>
                  <a:pt x="26621" y="210249"/>
                  <a:pt x="26621" y="212535"/>
                </a:cubicBezTo>
                <a:cubicBezTo>
                  <a:pt x="26621" y="215202"/>
                  <a:pt x="24423" y="217107"/>
                  <a:pt x="22225" y="217107"/>
                </a:cubicBezTo>
                <a:cubicBezTo>
                  <a:pt x="19661" y="217107"/>
                  <a:pt x="17463" y="215202"/>
                  <a:pt x="17463" y="212535"/>
                </a:cubicBezTo>
                <a:cubicBezTo>
                  <a:pt x="17463" y="210249"/>
                  <a:pt x="19661" y="207963"/>
                  <a:pt x="22225" y="207963"/>
                </a:cubicBezTo>
                <a:close/>
                <a:moveTo>
                  <a:pt x="261318" y="206463"/>
                </a:moveTo>
                <a:cubicBezTo>
                  <a:pt x="259155" y="205030"/>
                  <a:pt x="247982" y="209686"/>
                  <a:pt x="240052" y="213268"/>
                </a:cubicBezTo>
                <a:cubicBezTo>
                  <a:pt x="230320" y="217566"/>
                  <a:pt x="218426" y="222580"/>
                  <a:pt x="204369" y="226520"/>
                </a:cubicBezTo>
                <a:cubicBezTo>
                  <a:pt x="204729" y="228669"/>
                  <a:pt x="205089" y="230817"/>
                  <a:pt x="204729" y="233325"/>
                </a:cubicBezTo>
                <a:cubicBezTo>
                  <a:pt x="204369" y="234757"/>
                  <a:pt x="204369" y="235832"/>
                  <a:pt x="204008" y="237264"/>
                </a:cubicBezTo>
                <a:cubicBezTo>
                  <a:pt x="227437" y="231534"/>
                  <a:pt x="244017" y="224371"/>
                  <a:pt x="255911" y="219356"/>
                </a:cubicBezTo>
                <a:cubicBezTo>
                  <a:pt x="256993" y="218998"/>
                  <a:pt x="258074" y="218640"/>
                  <a:pt x="258795" y="218282"/>
                </a:cubicBezTo>
                <a:cubicBezTo>
                  <a:pt x="262039" y="215417"/>
                  <a:pt x="263841" y="212193"/>
                  <a:pt x="263841" y="210403"/>
                </a:cubicBezTo>
                <a:cubicBezTo>
                  <a:pt x="263841" y="209686"/>
                  <a:pt x="263480" y="208254"/>
                  <a:pt x="261318" y="206463"/>
                </a:cubicBezTo>
                <a:close/>
                <a:moveTo>
                  <a:pt x="45776" y="197509"/>
                </a:moveTo>
                <a:lnTo>
                  <a:pt x="45776" y="268424"/>
                </a:lnTo>
                <a:cubicBezTo>
                  <a:pt x="65960" y="274512"/>
                  <a:pt x="184184" y="306030"/>
                  <a:pt x="273933" y="235115"/>
                </a:cubicBezTo>
                <a:cubicBezTo>
                  <a:pt x="276096" y="233683"/>
                  <a:pt x="280781" y="229743"/>
                  <a:pt x="281142" y="225803"/>
                </a:cubicBezTo>
                <a:cubicBezTo>
                  <a:pt x="281142" y="225087"/>
                  <a:pt x="280781" y="223296"/>
                  <a:pt x="278979" y="221864"/>
                </a:cubicBezTo>
                <a:cubicBezTo>
                  <a:pt x="276817" y="220073"/>
                  <a:pt x="268166" y="223654"/>
                  <a:pt x="259155" y="227594"/>
                </a:cubicBezTo>
                <a:cubicBezTo>
                  <a:pt x="244738" y="233683"/>
                  <a:pt x="222751" y="242995"/>
                  <a:pt x="190311" y="249442"/>
                </a:cubicBezTo>
                <a:lnTo>
                  <a:pt x="189951" y="249442"/>
                </a:lnTo>
                <a:cubicBezTo>
                  <a:pt x="183103" y="251949"/>
                  <a:pt x="172650" y="253739"/>
                  <a:pt x="159674" y="253739"/>
                </a:cubicBezTo>
                <a:cubicBezTo>
                  <a:pt x="148501" y="253739"/>
                  <a:pt x="135525" y="252307"/>
                  <a:pt x="120387" y="250516"/>
                </a:cubicBezTo>
                <a:cubicBezTo>
                  <a:pt x="118224" y="250158"/>
                  <a:pt x="116422" y="248009"/>
                  <a:pt x="116782" y="245860"/>
                </a:cubicBezTo>
                <a:cubicBezTo>
                  <a:pt x="117143" y="243353"/>
                  <a:pt x="119305" y="241562"/>
                  <a:pt x="121828" y="241920"/>
                </a:cubicBezTo>
                <a:cubicBezTo>
                  <a:pt x="161476" y="246934"/>
                  <a:pt x="179498" y="244427"/>
                  <a:pt x="187788" y="241204"/>
                </a:cubicBezTo>
                <a:lnTo>
                  <a:pt x="187788" y="240846"/>
                </a:lnTo>
                <a:cubicBezTo>
                  <a:pt x="195718" y="237981"/>
                  <a:pt x="195718" y="234041"/>
                  <a:pt x="195718" y="232608"/>
                </a:cubicBezTo>
                <a:cubicBezTo>
                  <a:pt x="196439" y="227594"/>
                  <a:pt x="195358" y="223296"/>
                  <a:pt x="192835" y="221147"/>
                </a:cubicBezTo>
                <a:cubicBezTo>
                  <a:pt x="189591" y="217924"/>
                  <a:pt x="184544" y="217924"/>
                  <a:pt x="184544" y="217924"/>
                </a:cubicBezTo>
                <a:cubicBezTo>
                  <a:pt x="141292" y="218640"/>
                  <a:pt x="133723" y="213984"/>
                  <a:pt x="124351" y="208612"/>
                </a:cubicBezTo>
                <a:cubicBezTo>
                  <a:pt x="115701" y="203598"/>
                  <a:pt x="105609" y="197867"/>
                  <a:pt x="45776" y="197509"/>
                </a:cubicBezTo>
                <a:close/>
                <a:moveTo>
                  <a:pt x="8650" y="197509"/>
                </a:moveTo>
                <a:lnTo>
                  <a:pt x="8650" y="267349"/>
                </a:lnTo>
                <a:lnTo>
                  <a:pt x="36764" y="267349"/>
                </a:lnTo>
                <a:lnTo>
                  <a:pt x="36764" y="197509"/>
                </a:lnTo>
                <a:lnTo>
                  <a:pt x="8650" y="197509"/>
                </a:lnTo>
                <a:close/>
                <a:moveTo>
                  <a:pt x="4325" y="188913"/>
                </a:moveTo>
                <a:lnTo>
                  <a:pt x="41450" y="188913"/>
                </a:lnTo>
                <a:cubicBezTo>
                  <a:pt x="107771" y="188913"/>
                  <a:pt x="118945" y="195360"/>
                  <a:pt x="129037" y="201449"/>
                </a:cubicBezTo>
                <a:cubicBezTo>
                  <a:pt x="136967" y="205747"/>
                  <a:pt x="143815" y="210044"/>
                  <a:pt x="184184" y="208970"/>
                </a:cubicBezTo>
                <a:cubicBezTo>
                  <a:pt x="184184" y="208970"/>
                  <a:pt x="192835" y="208612"/>
                  <a:pt x="198962" y="215059"/>
                </a:cubicBezTo>
                <a:cubicBezTo>
                  <a:pt x="200043" y="215775"/>
                  <a:pt x="200764" y="216849"/>
                  <a:pt x="201485" y="218282"/>
                </a:cubicBezTo>
                <a:cubicBezTo>
                  <a:pt x="215182" y="214342"/>
                  <a:pt x="227076" y="209328"/>
                  <a:pt x="236808" y="205388"/>
                </a:cubicBezTo>
                <a:cubicBezTo>
                  <a:pt x="251586" y="198942"/>
                  <a:pt x="260597" y="195002"/>
                  <a:pt x="266724" y="199658"/>
                </a:cubicBezTo>
                <a:cubicBezTo>
                  <a:pt x="271410" y="203239"/>
                  <a:pt x="272491" y="207179"/>
                  <a:pt x="272491" y="209686"/>
                </a:cubicBezTo>
                <a:cubicBezTo>
                  <a:pt x="272852" y="211119"/>
                  <a:pt x="272491" y="212193"/>
                  <a:pt x="272131" y="213268"/>
                </a:cubicBezTo>
                <a:cubicBezTo>
                  <a:pt x="277177" y="212193"/>
                  <a:pt x="281142" y="212193"/>
                  <a:pt x="284386" y="215059"/>
                </a:cubicBezTo>
                <a:cubicBezTo>
                  <a:pt x="289071" y="218998"/>
                  <a:pt x="290153" y="223296"/>
                  <a:pt x="289792" y="226161"/>
                </a:cubicBezTo>
                <a:cubicBezTo>
                  <a:pt x="289432" y="234757"/>
                  <a:pt x="280061" y="241562"/>
                  <a:pt x="278979" y="242278"/>
                </a:cubicBezTo>
                <a:cubicBezTo>
                  <a:pt x="232122" y="279527"/>
                  <a:pt x="177336" y="289197"/>
                  <a:pt x="132281" y="289197"/>
                </a:cubicBezTo>
                <a:cubicBezTo>
                  <a:pt x="83622" y="289197"/>
                  <a:pt x="46136" y="278094"/>
                  <a:pt x="40729" y="275945"/>
                </a:cubicBezTo>
                <a:lnTo>
                  <a:pt x="4325" y="275945"/>
                </a:lnTo>
                <a:cubicBezTo>
                  <a:pt x="2163" y="275945"/>
                  <a:pt x="0" y="274154"/>
                  <a:pt x="0" y="272005"/>
                </a:cubicBezTo>
                <a:lnTo>
                  <a:pt x="0" y="193211"/>
                </a:lnTo>
                <a:cubicBezTo>
                  <a:pt x="0" y="190704"/>
                  <a:pt x="2163" y="188913"/>
                  <a:pt x="4325" y="188913"/>
                </a:cubicBezTo>
                <a:close/>
                <a:moveTo>
                  <a:pt x="120284" y="158750"/>
                </a:moveTo>
                <a:cubicBezTo>
                  <a:pt x="122849" y="158750"/>
                  <a:pt x="125047" y="160554"/>
                  <a:pt x="125047" y="162719"/>
                </a:cubicBezTo>
                <a:lnTo>
                  <a:pt x="125047" y="185449"/>
                </a:lnTo>
                <a:cubicBezTo>
                  <a:pt x="125047" y="187975"/>
                  <a:pt x="122849" y="190139"/>
                  <a:pt x="120284" y="190139"/>
                </a:cubicBezTo>
                <a:cubicBezTo>
                  <a:pt x="117720" y="190139"/>
                  <a:pt x="115888" y="187975"/>
                  <a:pt x="115888" y="185449"/>
                </a:cubicBezTo>
                <a:lnTo>
                  <a:pt x="115888" y="162719"/>
                </a:lnTo>
                <a:cubicBezTo>
                  <a:pt x="115888" y="160554"/>
                  <a:pt x="117720" y="158750"/>
                  <a:pt x="120284" y="158750"/>
                </a:cubicBezTo>
                <a:close/>
                <a:moveTo>
                  <a:pt x="161735" y="123825"/>
                </a:moveTo>
                <a:cubicBezTo>
                  <a:pt x="164402" y="123825"/>
                  <a:pt x="166307" y="125629"/>
                  <a:pt x="166307" y="128155"/>
                </a:cubicBezTo>
                <a:lnTo>
                  <a:pt x="166307" y="198510"/>
                </a:lnTo>
                <a:cubicBezTo>
                  <a:pt x="166307" y="201035"/>
                  <a:pt x="164402" y="202839"/>
                  <a:pt x="161735" y="202839"/>
                </a:cubicBezTo>
                <a:cubicBezTo>
                  <a:pt x="159068" y="202839"/>
                  <a:pt x="157163" y="201035"/>
                  <a:pt x="157163" y="198510"/>
                </a:cubicBezTo>
                <a:lnTo>
                  <a:pt x="157163" y="128155"/>
                </a:lnTo>
                <a:cubicBezTo>
                  <a:pt x="157163" y="125629"/>
                  <a:pt x="159068" y="123825"/>
                  <a:pt x="161735" y="123825"/>
                </a:cubicBezTo>
                <a:close/>
                <a:moveTo>
                  <a:pt x="203201" y="100013"/>
                </a:moveTo>
                <a:cubicBezTo>
                  <a:pt x="205765" y="100013"/>
                  <a:pt x="207597" y="101801"/>
                  <a:pt x="207597" y="104303"/>
                </a:cubicBezTo>
                <a:lnTo>
                  <a:pt x="207597" y="202959"/>
                </a:lnTo>
                <a:cubicBezTo>
                  <a:pt x="207597" y="205461"/>
                  <a:pt x="205765" y="207606"/>
                  <a:pt x="203201" y="207606"/>
                </a:cubicBezTo>
                <a:cubicBezTo>
                  <a:pt x="200636" y="207606"/>
                  <a:pt x="198438" y="205461"/>
                  <a:pt x="198438" y="202959"/>
                </a:cubicBezTo>
                <a:lnTo>
                  <a:pt x="198438" y="104303"/>
                </a:lnTo>
                <a:cubicBezTo>
                  <a:pt x="198438" y="101801"/>
                  <a:pt x="200636" y="100013"/>
                  <a:pt x="203201" y="100013"/>
                </a:cubicBezTo>
                <a:close/>
                <a:moveTo>
                  <a:pt x="244285" y="77788"/>
                </a:moveTo>
                <a:cubicBezTo>
                  <a:pt x="246952" y="77788"/>
                  <a:pt x="248857" y="79587"/>
                  <a:pt x="248857" y="82105"/>
                </a:cubicBezTo>
                <a:lnTo>
                  <a:pt x="248857" y="191814"/>
                </a:lnTo>
                <a:cubicBezTo>
                  <a:pt x="248857" y="194332"/>
                  <a:pt x="246952" y="196491"/>
                  <a:pt x="244285" y="196491"/>
                </a:cubicBezTo>
                <a:cubicBezTo>
                  <a:pt x="241618" y="196491"/>
                  <a:pt x="239713" y="194332"/>
                  <a:pt x="239713" y="191814"/>
                </a:cubicBezTo>
                <a:lnTo>
                  <a:pt x="239713" y="82105"/>
                </a:lnTo>
                <a:cubicBezTo>
                  <a:pt x="239713" y="79587"/>
                  <a:pt x="241618" y="77788"/>
                  <a:pt x="244285" y="77788"/>
                </a:cubicBezTo>
                <a:close/>
                <a:moveTo>
                  <a:pt x="285560" y="36513"/>
                </a:moveTo>
                <a:cubicBezTo>
                  <a:pt x="288227" y="36513"/>
                  <a:pt x="290132" y="38672"/>
                  <a:pt x="290132" y="40830"/>
                </a:cubicBezTo>
                <a:lnTo>
                  <a:pt x="290132" y="204514"/>
                </a:lnTo>
                <a:cubicBezTo>
                  <a:pt x="290132" y="207032"/>
                  <a:pt x="288227" y="209190"/>
                  <a:pt x="285560" y="209190"/>
                </a:cubicBezTo>
                <a:cubicBezTo>
                  <a:pt x="283274" y="209190"/>
                  <a:pt x="280988" y="207032"/>
                  <a:pt x="280988" y="204514"/>
                </a:cubicBezTo>
                <a:lnTo>
                  <a:pt x="280988" y="40830"/>
                </a:lnTo>
                <a:cubicBezTo>
                  <a:pt x="280988" y="38672"/>
                  <a:pt x="283274" y="36513"/>
                  <a:pt x="285560" y="36513"/>
                </a:cubicBezTo>
                <a:close/>
                <a:moveTo>
                  <a:pt x="281024" y="9739"/>
                </a:moveTo>
                <a:cubicBezTo>
                  <a:pt x="282460" y="7938"/>
                  <a:pt x="285334" y="7938"/>
                  <a:pt x="287129" y="9739"/>
                </a:cubicBezTo>
                <a:cubicBezTo>
                  <a:pt x="288566" y="11180"/>
                  <a:pt x="288566" y="14061"/>
                  <a:pt x="287129" y="15862"/>
                </a:cubicBezTo>
                <a:lnTo>
                  <a:pt x="213860" y="88981"/>
                </a:lnTo>
                <a:cubicBezTo>
                  <a:pt x="212064" y="91142"/>
                  <a:pt x="209550" y="91142"/>
                  <a:pt x="207754" y="88981"/>
                </a:cubicBezTo>
                <a:lnTo>
                  <a:pt x="193388" y="74933"/>
                </a:lnTo>
                <a:lnTo>
                  <a:pt x="122992" y="145170"/>
                </a:lnTo>
                <a:cubicBezTo>
                  <a:pt x="121555" y="146971"/>
                  <a:pt x="118682" y="146971"/>
                  <a:pt x="116886" y="145170"/>
                </a:cubicBezTo>
                <a:lnTo>
                  <a:pt x="103956" y="132203"/>
                </a:lnTo>
                <a:lnTo>
                  <a:pt x="58702" y="177587"/>
                </a:lnTo>
                <a:cubicBezTo>
                  <a:pt x="57984" y="178308"/>
                  <a:pt x="56906" y="179028"/>
                  <a:pt x="55829" y="179028"/>
                </a:cubicBezTo>
                <a:cubicBezTo>
                  <a:pt x="54392" y="179028"/>
                  <a:pt x="53314" y="178308"/>
                  <a:pt x="52596" y="177587"/>
                </a:cubicBezTo>
                <a:cubicBezTo>
                  <a:pt x="50800" y="175786"/>
                  <a:pt x="50800" y="172905"/>
                  <a:pt x="52596" y="171464"/>
                </a:cubicBezTo>
                <a:lnTo>
                  <a:pt x="101083" y="122839"/>
                </a:lnTo>
                <a:cubicBezTo>
                  <a:pt x="102520" y="121038"/>
                  <a:pt x="105393" y="121038"/>
                  <a:pt x="107189" y="122839"/>
                </a:cubicBezTo>
                <a:lnTo>
                  <a:pt x="120119" y="135805"/>
                </a:lnTo>
                <a:lnTo>
                  <a:pt x="190155" y="65569"/>
                </a:lnTo>
                <a:cubicBezTo>
                  <a:pt x="191951" y="63768"/>
                  <a:pt x="194465" y="63768"/>
                  <a:pt x="196261" y="65569"/>
                </a:cubicBezTo>
                <a:lnTo>
                  <a:pt x="210987" y="79976"/>
                </a:lnTo>
                <a:lnTo>
                  <a:pt x="281024" y="9739"/>
                </a:lnTo>
                <a:close/>
                <a:moveTo>
                  <a:pt x="51800" y="9058"/>
                </a:moveTo>
                <a:lnTo>
                  <a:pt x="51800" y="59054"/>
                </a:lnTo>
                <a:lnTo>
                  <a:pt x="122217" y="59054"/>
                </a:lnTo>
                <a:cubicBezTo>
                  <a:pt x="122932" y="59054"/>
                  <a:pt x="124362" y="59417"/>
                  <a:pt x="124719" y="60141"/>
                </a:cubicBezTo>
                <a:lnTo>
                  <a:pt x="141520" y="73546"/>
                </a:lnTo>
                <a:lnTo>
                  <a:pt x="141520" y="9058"/>
                </a:lnTo>
                <a:lnTo>
                  <a:pt x="51800" y="9058"/>
                </a:lnTo>
                <a:close/>
                <a:moveTo>
                  <a:pt x="47153" y="0"/>
                </a:moveTo>
                <a:lnTo>
                  <a:pt x="146166" y="0"/>
                </a:lnTo>
                <a:cubicBezTo>
                  <a:pt x="148311" y="0"/>
                  <a:pt x="150456" y="2174"/>
                  <a:pt x="150456" y="4710"/>
                </a:cubicBezTo>
                <a:lnTo>
                  <a:pt x="150456" y="82603"/>
                </a:lnTo>
                <a:cubicBezTo>
                  <a:pt x="150456" y="84053"/>
                  <a:pt x="149383" y="85864"/>
                  <a:pt x="147954" y="86589"/>
                </a:cubicBezTo>
                <a:cubicBezTo>
                  <a:pt x="147239" y="86589"/>
                  <a:pt x="146524" y="86951"/>
                  <a:pt x="146166" y="86951"/>
                </a:cubicBezTo>
                <a:cubicBezTo>
                  <a:pt x="145094" y="86951"/>
                  <a:pt x="144022" y="86589"/>
                  <a:pt x="143307" y="86226"/>
                </a:cubicBezTo>
                <a:lnTo>
                  <a:pt x="120787" y="68112"/>
                </a:lnTo>
                <a:lnTo>
                  <a:pt x="47153" y="68112"/>
                </a:lnTo>
                <a:cubicBezTo>
                  <a:pt x="45008" y="68112"/>
                  <a:pt x="42863" y="65938"/>
                  <a:pt x="42863" y="63402"/>
                </a:cubicBezTo>
                <a:lnTo>
                  <a:pt x="42863" y="4710"/>
                </a:lnTo>
                <a:cubicBezTo>
                  <a:pt x="42863" y="2174"/>
                  <a:pt x="45008" y="0"/>
                  <a:pt x="47153" y="0"/>
                </a:cubicBezTo>
                <a:close/>
              </a:path>
            </a:pathLst>
          </a:custGeom>
          <a:solidFill>
            <a:schemeClr val="bg1"/>
          </a:solidFill>
          <a:ln>
            <a:noFill/>
          </a:ln>
          <a:effectLst/>
        </p:spPr>
        <p:txBody>
          <a:bodyPr anchor="ctr"/>
          <a:lstStyle/>
          <a:p>
            <a:endParaRPr lang="en-US" sz="675">
              <a:latin typeface="+mj-lt"/>
            </a:endParaRPr>
          </a:p>
        </p:txBody>
      </p:sp>
      <p:sp>
        <p:nvSpPr>
          <p:cNvPr id="4" name="Freeform 1001">
            <a:extLst>
              <a:ext uri="{FF2B5EF4-FFF2-40B4-BE49-F238E27FC236}">
                <a16:creationId xmlns:a16="http://schemas.microsoft.com/office/drawing/2014/main" id="{50E44D17-1B30-0264-D63D-9C4E60B7EFE5}"/>
              </a:ext>
            </a:extLst>
          </p:cNvPr>
          <p:cNvSpPr>
            <a:spLocks noChangeAspect="1" noChangeArrowheads="1"/>
          </p:cNvSpPr>
          <p:nvPr/>
        </p:nvSpPr>
        <p:spPr bwMode="auto">
          <a:xfrm>
            <a:off x="4729913" y="4835686"/>
            <a:ext cx="417105" cy="268980"/>
          </a:xfrm>
          <a:custGeom>
            <a:avLst/>
            <a:gdLst>
              <a:gd name="T0" fmla="*/ 369470 w 290151"/>
              <a:gd name="T1" fmla="*/ 801981 h 290152"/>
              <a:gd name="T2" fmla="*/ 369470 w 290151"/>
              <a:gd name="T3" fmla="*/ 832423 h 290152"/>
              <a:gd name="T4" fmla="*/ 100253 w 290151"/>
              <a:gd name="T5" fmla="*/ 817811 h 290152"/>
              <a:gd name="T6" fmla="*/ 251621 w 290151"/>
              <a:gd name="T7" fmla="*/ 691180 h 290152"/>
              <a:gd name="T8" fmla="*/ 304838 w 290151"/>
              <a:gd name="T9" fmla="*/ 707009 h 290152"/>
              <a:gd name="T10" fmla="*/ 251621 w 290151"/>
              <a:gd name="T11" fmla="*/ 721617 h 290152"/>
              <a:gd name="T12" fmla="*/ 251621 w 290151"/>
              <a:gd name="T13" fmla="*/ 691180 h 290152"/>
              <a:gd name="T14" fmla="*/ 174185 w 290151"/>
              <a:gd name="T15" fmla="*/ 691180 h 290152"/>
              <a:gd name="T16" fmla="*/ 174185 w 290151"/>
              <a:gd name="T17" fmla="*/ 721617 h 290152"/>
              <a:gd name="T18" fmla="*/ 100253 w 290151"/>
              <a:gd name="T19" fmla="*/ 707009 h 290152"/>
              <a:gd name="T20" fmla="*/ 539753 w 290151"/>
              <a:gd name="T21" fmla="*/ 629702 h 290152"/>
              <a:gd name="T22" fmla="*/ 638105 w 290151"/>
              <a:gd name="T23" fmla="*/ 838402 h 290152"/>
              <a:gd name="T24" fmla="*/ 714871 w 290151"/>
              <a:gd name="T25" fmla="*/ 647692 h 290152"/>
              <a:gd name="T26" fmla="*/ 539753 w 290151"/>
              <a:gd name="T27" fmla="*/ 629702 h 290152"/>
              <a:gd name="T28" fmla="*/ 258865 w 290151"/>
              <a:gd name="T29" fmla="*/ 580381 h 290152"/>
              <a:gd name="T30" fmla="*/ 258865 w 290151"/>
              <a:gd name="T31" fmla="*/ 610771 h 290152"/>
              <a:gd name="T32" fmla="*/ 100253 w 290151"/>
              <a:gd name="T33" fmla="*/ 595576 h 290152"/>
              <a:gd name="T34" fmla="*/ 114557 w 290151"/>
              <a:gd name="T35" fmla="*/ 474856 h 290152"/>
              <a:gd name="T36" fmla="*/ 273171 w 290151"/>
              <a:gd name="T37" fmla="*/ 490050 h 290152"/>
              <a:gd name="T38" fmla="*/ 114557 w 290151"/>
              <a:gd name="T39" fmla="*/ 505245 h 290152"/>
              <a:gd name="T40" fmla="*/ 114557 w 290151"/>
              <a:gd name="T41" fmla="*/ 474856 h 290152"/>
              <a:gd name="T42" fmla="*/ 534955 w 290151"/>
              <a:gd name="T43" fmla="*/ 540946 h 290152"/>
              <a:gd name="T44" fmla="*/ 740058 w 290151"/>
              <a:gd name="T45" fmla="*/ 540946 h 290152"/>
              <a:gd name="T46" fmla="*/ 114605 w 290151"/>
              <a:gd name="T47" fmla="*/ 364057 h 290152"/>
              <a:gd name="T48" fmla="*/ 304825 w 290151"/>
              <a:gd name="T49" fmla="*/ 379255 h 290152"/>
              <a:gd name="T50" fmla="*/ 114605 w 290151"/>
              <a:gd name="T51" fmla="*/ 394450 h 290152"/>
              <a:gd name="T52" fmla="*/ 114605 w 290151"/>
              <a:gd name="T53" fmla="*/ 364057 h 290152"/>
              <a:gd name="T54" fmla="*/ 742456 w 290151"/>
              <a:gd name="T55" fmla="*/ 462982 h 290152"/>
              <a:gd name="T56" fmla="*/ 736460 w 290151"/>
              <a:gd name="T57" fmla="*/ 628501 h 290152"/>
              <a:gd name="T58" fmla="*/ 934368 w 290151"/>
              <a:gd name="T59" fmla="*/ 540946 h 290152"/>
              <a:gd name="T60" fmla="*/ 267593 w 290151"/>
              <a:gd name="T61" fmla="*/ 258533 h 290152"/>
              <a:gd name="T62" fmla="*/ 378697 w 290151"/>
              <a:gd name="T63" fmla="*/ 273732 h 290152"/>
              <a:gd name="T64" fmla="*/ 267593 w 290151"/>
              <a:gd name="T65" fmla="*/ 288925 h 290152"/>
              <a:gd name="T66" fmla="*/ 267593 w 290151"/>
              <a:gd name="T67" fmla="*/ 258533 h 290152"/>
              <a:gd name="T68" fmla="*/ 190531 w 290151"/>
              <a:gd name="T69" fmla="*/ 258533 h 290152"/>
              <a:gd name="T70" fmla="*/ 190531 w 290151"/>
              <a:gd name="T71" fmla="*/ 288925 h 290152"/>
              <a:gd name="T72" fmla="*/ 100253 w 290151"/>
              <a:gd name="T73" fmla="*/ 273732 h 290152"/>
              <a:gd name="T74" fmla="*/ 652495 w 290151"/>
              <a:gd name="T75" fmla="*/ 244685 h 290152"/>
              <a:gd name="T76" fmla="*/ 723267 w 290151"/>
              <a:gd name="T77" fmla="*/ 440192 h 290152"/>
              <a:gd name="T78" fmla="*/ 652495 w 290151"/>
              <a:gd name="T79" fmla="*/ 244685 h 290152"/>
              <a:gd name="T80" fmla="*/ 340648 w 290151"/>
              <a:gd name="T81" fmla="*/ 540946 h 290152"/>
              <a:gd name="T82" fmla="*/ 522957 w 290151"/>
              <a:gd name="T83" fmla="*/ 605714 h 290152"/>
              <a:gd name="T84" fmla="*/ 623710 w 290151"/>
              <a:gd name="T85" fmla="*/ 410208 h 290152"/>
              <a:gd name="T86" fmla="*/ 203908 w 290151"/>
              <a:gd name="T87" fmla="*/ 29981 h 290152"/>
              <a:gd name="T88" fmla="*/ 248286 w 290151"/>
              <a:gd name="T89" fmla="*/ 117541 h 290152"/>
              <a:gd name="T90" fmla="*/ 564936 w 290151"/>
              <a:gd name="T91" fmla="*/ 73162 h 290152"/>
              <a:gd name="T92" fmla="*/ 203908 w 290151"/>
              <a:gd name="T93" fmla="*/ 29981 h 290152"/>
              <a:gd name="T94" fmla="*/ 28789 w 290151"/>
              <a:gd name="T95" fmla="*/ 73162 h 290152"/>
              <a:gd name="T96" fmla="*/ 73164 w 290151"/>
              <a:gd name="T97" fmla="*/ 935558 h 290152"/>
              <a:gd name="T98" fmla="*/ 740058 w 290151"/>
              <a:gd name="T99" fmla="*/ 892375 h 290152"/>
              <a:gd name="T100" fmla="*/ 638105 w 290151"/>
              <a:gd name="T101" fmla="*/ 867192 h 290152"/>
              <a:gd name="T102" fmla="*/ 638105 w 290151"/>
              <a:gd name="T103" fmla="*/ 215896 h 290152"/>
              <a:gd name="T104" fmla="*/ 740058 w 290151"/>
              <a:gd name="T105" fmla="*/ 73162 h 290152"/>
              <a:gd name="T106" fmla="*/ 593725 w 290151"/>
              <a:gd name="T107" fmla="*/ 29981 h 290152"/>
              <a:gd name="T108" fmla="*/ 521760 w 290151"/>
              <a:gd name="T109" fmla="*/ 146332 h 290152"/>
              <a:gd name="T110" fmla="*/ 175122 w 290151"/>
              <a:gd name="T111" fmla="*/ 73162 h 290152"/>
              <a:gd name="T112" fmla="*/ 73164 w 290151"/>
              <a:gd name="T113" fmla="*/ 29981 h 290152"/>
              <a:gd name="T114" fmla="*/ 696879 w 290151"/>
              <a:gd name="T115" fmla="*/ 0 h 290152"/>
              <a:gd name="T116" fmla="*/ 768846 w 290151"/>
              <a:gd name="T117" fmla="*/ 242285 h 290152"/>
              <a:gd name="T118" fmla="*/ 768846 w 290151"/>
              <a:gd name="T119" fmla="*/ 839599 h 290152"/>
              <a:gd name="T120" fmla="*/ 696879 w 290151"/>
              <a:gd name="T121" fmla="*/ 964341 h 290152"/>
              <a:gd name="T122" fmla="*/ 0 w 290151"/>
              <a:gd name="T123" fmla="*/ 892375 h 290152"/>
              <a:gd name="T124" fmla="*/ 73164 w 290151"/>
              <a:gd name="T125" fmla="*/ 0 h 290152"/>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60000 65536"/>
              <a:gd name="T154" fmla="*/ 0 60000 65536"/>
              <a:gd name="T155" fmla="*/ 0 60000 65536"/>
              <a:gd name="T156" fmla="*/ 0 60000 65536"/>
              <a:gd name="T157" fmla="*/ 0 60000 65536"/>
              <a:gd name="T158" fmla="*/ 0 60000 65536"/>
              <a:gd name="T159" fmla="*/ 0 60000 65536"/>
              <a:gd name="T160" fmla="*/ 0 60000 65536"/>
              <a:gd name="T161" fmla="*/ 0 60000 65536"/>
              <a:gd name="T162" fmla="*/ 0 60000 65536"/>
              <a:gd name="T163" fmla="*/ 0 60000 65536"/>
              <a:gd name="T164" fmla="*/ 0 60000 65536"/>
              <a:gd name="T165" fmla="*/ 0 60000 65536"/>
              <a:gd name="T166" fmla="*/ 0 60000 65536"/>
              <a:gd name="T167" fmla="*/ 0 60000 65536"/>
              <a:gd name="T168" fmla="*/ 0 60000 65536"/>
              <a:gd name="T169" fmla="*/ 0 60000 65536"/>
              <a:gd name="T170" fmla="*/ 0 60000 65536"/>
              <a:gd name="T171" fmla="*/ 0 60000 65536"/>
              <a:gd name="T172" fmla="*/ 0 60000 65536"/>
              <a:gd name="T173" fmla="*/ 0 60000 65536"/>
              <a:gd name="T174" fmla="*/ 0 60000 65536"/>
              <a:gd name="T175" fmla="*/ 0 60000 65536"/>
              <a:gd name="T176" fmla="*/ 0 60000 65536"/>
              <a:gd name="T177" fmla="*/ 0 60000 65536"/>
              <a:gd name="T178" fmla="*/ 0 60000 65536"/>
              <a:gd name="T179" fmla="*/ 0 60000 65536"/>
              <a:gd name="T180" fmla="*/ 0 60000 65536"/>
              <a:gd name="T181" fmla="*/ 0 60000 65536"/>
              <a:gd name="T182" fmla="*/ 0 60000 65536"/>
              <a:gd name="T183" fmla="*/ 0 60000 65536"/>
              <a:gd name="T184" fmla="*/ 0 60000 65536"/>
              <a:gd name="T185" fmla="*/ 0 60000 65536"/>
              <a:gd name="T186" fmla="*/ 0 60000 65536"/>
              <a:gd name="T187" fmla="*/ 0 60000 65536"/>
              <a:gd name="T188" fmla="*/ 0 60000 65536"/>
            </a:gdLst>
            <a:ahLst/>
            <a:cxnLst>
              <a:cxn ang="T126">
                <a:pos x="T0" y="T1"/>
              </a:cxn>
              <a:cxn ang="T127">
                <a:pos x="T2" y="T3"/>
              </a:cxn>
              <a:cxn ang="T128">
                <a:pos x="T4" y="T5"/>
              </a:cxn>
              <a:cxn ang="T129">
                <a:pos x="T6" y="T7"/>
              </a:cxn>
              <a:cxn ang="T130">
                <a:pos x="T8" y="T9"/>
              </a:cxn>
              <a:cxn ang="T131">
                <a:pos x="T10" y="T11"/>
              </a:cxn>
              <a:cxn ang="T132">
                <a:pos x="T12" y="T13"/>
              </a:cxn>
              <a:cxn ang="T133">
                <a:pos x="T14" y="T15"/>
              </a:cxn>
              <a:cxn ang="T134">
                <a:pos x="T16" y="T17"/>
              </a:cxn>
              <a:cxn ang="T135">
                <a:pos x="T18" y="T19"/>
              </a:cxn>
              <a:cxn ang="T136">
                <a:pos x="T20" y="T21"/>
              </a:cxn>
              <a:cxn ang="T137">
                <a:pos x="T22" y="T23"/>
              </a:cxn>
              <a:cxn ang="T138">
                <a:pos x="T24" y="T25"/>
              </a:cxn>
              <a:cxn ang="T139">
                <a:pos x="T26" y="T27"/>
              </a:cxn>
              <a:cxn ang="T140">
                <a:pos x="T28" y="T29"/>
              </a:cxn>
              <a:cxn ang="T141">
                <a:pos x="T30" y="T31"/>
              </a:cxn>
              <a:cxn ang="T142">
                <a:pos x="T32" y="T33"/>
              </a:cxn>
              <a:cxn ang="T143">
                <a:pos x="T34" y="T35"/>
              </a:cxn>
              <a:cxn ang="T144">
                <a:pos x="T36" y="T37"/>
              </a:cxn>
              <a:cxn ang="T145">
                <a:pos x="T38" y="T39"/>
              </a:cxn>
              <a:cxn ang="T146">
                <a:pos x="T40" y="T41"/>
              </a:cxn>
              <a:cxn ang="T147">
                <a:pos x="T42" y="T43"/>
              </a:cxn>
              <a:cxn ang="T148">
                <a:pos x="T44" y="T45"/>
              </a:cxn>
              <a:cxn ang="T149">
                <a:pos x="T46" y="T47"/>
              </a:cxn>
              <a:cxn ang="T150">
                <a:pos x="T48" y="T49"/>
              </a:cxn>
              <a:cxn ang="T151">
                <a:pos x="T50" y="T51"/>
              </a:cxn>
              <a:cxn ang="T152">
                <a:pos x="T52" y="T53"/>
              </a:cxn>
              <a:cxn ang="T153">
                <a:pos x="T54" y="T55"/>
              </a:cxn>
              <a:cxn ang="T154">
                <a:pos x="T56" y="T57"/>
              </a:cxn>
              <a:cxn ang="T155">
                <a:pos x="T58" y="T59"/>
              </a:cxn>
              <a:cxn ang="T156">
                <a:pos x="T60" y="T61"/>
              </a:cxn>
              <a:cxn ang="T157">
                <a:pos x="T62" y="T63"/>
              </a:cxn>
              <a:cxn ang="T158">
                <a:pos x="T64" y="T65"/>
              </a:cxn>
              <a:cxn ang="T159">
                <a:pos x="T66" y="T67"/>
              </a:cxn>
              <a:cxn ang="T160">
                <a:pos x="T68" y="T69"/>
              </a:cxn>
              <a:cxn ang="T161">
                <a:pos x="T70" y="T71"/>
              </a:cxn>
              <a:cxn ang="T162">
                <a:pos x="T72" y="T73"/>
              </a:cxn>
              <a:cxn ang="T163">
                <a:pos x="T74" y="T75"/>
              </a:cxn>
              <a:cxn ang="T164">
                <a:pos x="T76" y="T77"/>
              </a:cxn>
              <a:cxn ang="T165">
                <a:pos x="T78" y="T79"/>
              </a:cxn>
              <a:cxn ang="T166">
                <a:pos x="T80" y="T81"/>
              </a:cxn>
              <a:cxn ang="T167">
                <a:pos x="T82" y="T83"/>
              </a:cxn>
              <a:cxn ang="T168">
                <a:pos x="T84" y="T85"/>
              </a:cxn>
              <a:cxn ang="T169">
                <a:pos x="T86" y="T87"/>
              </a:cxn>
              <a:cxn ang="T170">
                <a:pos x="T88" y="T89"/>
              </a:cxn>
              <a:cxn ang="T171">
                <a:pos x="T90" y="T91"/>
              </a:cxn>
              <a:cxn ang="T172">
                <a:pos x="T92" y="T93"/>
              </a:cxn>
              <a:cxn ang="T173">
                <a:pos x="T94" y="T95"/>
              </a:cxn>
              <a:cxn ang="T174">
                <a:pos x="T96" y="T97"/>
              </a:cxn>
              <a:cxn ang="T175">
                <a:pos x="T98" y="T99"/>
              </a:cxn>
              <a:cxn ang="T176">
                <a:pos x="T100" y="T101"/>
              </a:cxn>
              <a:cxn ang="T177">
                <a:pos x="T102" y="T103"/>
              </a:cxn>
              <a:cxn ang="T178">
                <a:pos x="T104" y="T105"/>
              </a:cxn>
              <a:cxn ang="T179">
                <a:pos x="T106" y="T107"/>
              </a:cxn>
              <a:cxn ang="T180">
                <a:pos x="T108" y="T109"/>
              </a:cxn>
              <a:cxn ang="T181">
                <a:pos x="T110" y="T111"/>
              </a:cxn>
              <a:cxn ang="T182">
                <a:pos x="T112" y="T113"/>
              </a:cxn>
              <a:cxn ang="T183">
                <a:pos x="T114" y="T115"/>
              </a:cxn>
              <a:cxn ang="T184">
                <a:pos x="T116" y="T117"/>
              </a:cxn>
              <a:cxn ang="T185">
                <a:pos x="T118" y="T119"/>
              </a:cxn>
              <a:cxn ang="T186">
                <a:pos x="T120" y="T121"/>
              </a:cxn>
              <a:cxn ang="T187">
                <a:pos x="T122" y="T123"/>
              </a:cxn>
              <a:cxn ang="T188">
                <a:pos x="T124" y="T125"/>
              </a:cxn>
            </a:cxnLst>
            <a:rect l="0" t="0" r="r" b="b"/>
            <a:pathLst>
              <a:path w="290151" h="290152">
                <a:moveTo>
                  <a:pt x="34521" y="241300"/>
                </a:moveTo>
                <a:lnTo>
                  <a:pt x="111165" y="241300"/>
                </a:lnTo>
                <a:cubicBezTo>
                  <a:pt x="113708" y="241300"/>
                  <a:pt x="115524" y="243498"/>
                  <a:pt x="115524" y="246063"/>
                </a:cubicBezTo>
                <a:cubicBezTo>
                  <a:pt x="115524" y="248627"/>
                  <a:pt x="113708" y="250459"/>
                  <a:pt x="111165" y="250459"/>
                </a:cubicBezTo>
                <a:lnTo>
                  <a:pt x="34521" y="250459"/>
                </a:lnTo>
                <a:cubicBezTo>
                  <a:pt x="31978" y="250459"/>
                  <a:pt x="30162" y="248627"/>
                  <a:pt x="30162" y="246063"/>
                </a:cubicBezTo>
                <a:cubicBezTo>
                  <a:pt x="30162" y="243498"/>
                  <a:pt x="31978" y="241300"/>
                  <a:pt x="34521" y="241300"/>
                </a:cubicBezTo>
                <a:close/>
                <a:moveTo>
                  <a:pt x="75707" y="207963"/>
                </a:moveTo>
                <a:lnTo>
                  <a:pt x="87449" y="207963"/>
                </a:lnTo>
                <a:cubicBezTo>
                  <a:pt x="89584" y="207963"/>
                  <a:pt x="91719" y="210161"/>
                  <a:pt x="91719" y="212725"/>
                </a:cubicBezTo>
                <a:cubicBezTo>
                  <a:pt x="91719" y="215290"/>
                  <a:pt x="89584" y="217121"/>
                  <a:pt x="87449" y="217121"/>
                </a:cubicBezTo>
                <a:lnTo>
                  <a:pt x="75707" y="217121"/>
                </a:lnTo>
                <a:cubicBezTo>
                  <a:pt x="73216" y="217121"/>
                  <a:pt x="71437" y="215290"/>
                  <a:pt x="71437" y="212725"/>
                </a:cubicBezTo>
                <a:cubicBezTo>
                  <a:pt x="71437" y="210161"/>
                  <a:pt x="73216" y="207963"/>
                  <a:pt x="75707" y="207963"/>
                </a:cubicBezTo>
                <a:close/>
                <a:moveTo>
                  <a:pt x="34539" y="207963"/>
                </a:moveTo>
                <a:lnTo>
                  <a:pt x="52409" y="207963"/>
                </a:lnTo>
                <a:cubicBezTo>
                  <a:pt x="54962" y="207963"/>
                  <a:pt x="56786" y="210161"/>
                  <a:pt x="56786" y="212725"/>
                </a:cubicBezTo>
                <a:cubicBezTo>
                  <a:pt x="56786" y="215290"/>
                  <a:pt x="54962" y="217121"/>
                  <a:pt x="52409" y="217121"/>
                </a:cubicBezTo>
                <a:lnTo>
                  <a:pt x="34539" y="217121"/>
                </a:lnTo>
                <a:cubicBezTo>
                  <a:pt x="31986" y="217121"/>
                  <a:pt x="30162" y="215290"/>
                  <a:pt x="30162" y="212725"/>
                </a:cubicBezTo>
                <a:cubicBezTo>
                  <a:pt x="30162" y="210161"/>
                  <a:pt x="31986" y="207963"/>
                  <a:pt x="34539" y="207963"/>
                </a:cubicBezTo>
                <a:close/>
                <a:moveTo>
                  <a:pt x="162398" y="189465"/>
                </a:moveTo>
                <a:lnTo>
                  <a:pt x="121979" y="218336"/>
                </a:lnTo>
                <a:cubicBezTo>
                  <a:pt x="138219" y="238906"/>
                  <a:pt x="163481" y="252259"/>
                  <a:pt x="191991" y="252259"/>
                </a:cubicBezTo>
                <a:cubicBezTo>
                  <a:pt x="213283" y="252259"/>
                  <a:pt x="233132" y="244681"/>
                  <a:pt x="248289" y="232049"/>
                </a:cubicBezTo>
                <a:lnTo>
                  <a:pt x="215087" y="194878"/>
                </a:lnTo>
                <a:cubicBezTo>
                  <a:pt x="208591" y="199570"/>
                  <a:pt x="200652" y="202457"/>
                  <a:pt x="191991" y="202457"/>
                </a:cubicBezTo>
                <a:cubicBezTo>
                  <a:pt x="180442" y="202457"/>
                  <a:pt x="169616" y="197404"/>
                  <a:pt x="162398" y="189465"/>
                </a:cubicBezTo>
                <a:close/>
                <a:moveTo>
                  <a:pt x="34468" y="174625"/>
                </a:moveTo>
                <a:lnTo>
                  <a:pt x="77886" y="174625"/>
                </a:lnTo>
                <a:cubicBezTo>
                  <a:pt x="80397" y="174625"/>
                  <a:pt x="82191" y="176530"/>
                  <a:pt x="82191" y="179197"/>
                </a:cubicBezTo>
                <a:cubicBezTo>
                  <a:pt x="82191" y="181864"/>
                  <a:pt x="80397" y="183769"/>
                  <a:pt x="77886" y="183769"/>
                </a:cubicBezTo>
                <a:lnTo>
                  <a:pt x="34468" y="183769"/>
                </a:lnTo>
                <a:cubicBezTo>
                  <a:pt x="31956" y="183769"/>
                  <a:pt x="30162" y="181864"/>
                  <a:pt x="30162" y="179197"/>
                </a:cubicBezTo>
                <a:cubicBezTo>
                  <a:pt x="30162" y="176530"/>
                  <a:pt x="31956" y="174625"/>
                  <a:pt x="34468" y="174625"/>
                </a:cubicBezTo>
                <a:close/>
                <a:moveTo>
                  <a:pt x="34468" y="142875"/>
                </a:moveTo>
                <a:lnTo>
                  <a:pt x="77886" y="142875"/>
                </a:lnTo>
                <a:cubicBezTo>
                  <a:pt x="80397" y="142875"/>
                  <a:pt x="82191" y="144780"/>
                  <a:pt x="82191" y="147447"/>
                </a:cubicBezTo>
                <a:cubicBezTo>
                  <a:pt x="82191" y="150114"/>
                  <a:pt x="80397" y="152019"/>
                  <a:pt x="77886" y="152019"/>
                </a:cubicBezTo>
                <a:lnTo>
                  <a:pt x="34468" y="152019"/>
                </a:lnTo>
                <a:cubicBezTo>
                  <a:pt x="31956" y="152019"/>
                  <a:pt x="30162" y="150114"/>
                  <a:pt x="30162" y="147447"/>
                </a:cubicBezTo>
                <a:cubicBezTo>
                  <a:pt x="30162" y="144780"/>
                  <a:pt x="31956" y="142875"/>
                  <a:pt x="34468" y="142875"/>
                </a:cubicBezTo>
                <a:close/>
                <a:moveTo>
                  <a:pt x="191991" y="132084"/>
                </a:moveTo>
                <a:cubicBezTo>
                  <a:pt x="175029" y="132084"/>
                  <a:pt x="160955" y="145798"/>
                  <a:pt x="160955" y="162759"/>
                </a:cubicBezTo>
                <a:cubicBezTo>
                  <a:pt x="160955" y="179721"/>
                  <a:pt x="175029" y="193795"/>
                  <a:pt x="191991" y="193795"/>
                </a:cubicBezTo>
                <a:cubicBezTo>
                  <a:pt x="208952" y="193795"/>
                  <a:pt x="222666" y="179721"/>
                  <a:pt x="222666" y="162759"/>
                </a:cubicBezTo>
                <a:cubicBezTo>
                  <a:pt x="222666" y="145798"/>
                  <a:pt x="208952" y="132084"/>
                  <a:pt x="191991" y="132084"/>
                </a:cubicBezTo>
                <a:close/>
                <a:moveTo>
                  <a:pt x="34482" y="109538"/>
                </a:moveTo>
                <a:lnTo>
                  <a:pt x="87396" y="109538"/>
                </a:lnTo>
                <a:cubicBezTo>
                  <a:pt x="89556" y="109538"/>
                  <a:pt x="91715" y="111443"/>
                  <a:pt x="91715" y="114110"/>
                </a:cubicBezTo>
                <a:cubicBezTo>
                  <a:pt x="91715" y="116777"/>
                  <a:pt x="89556" y="118682"/>
                  <a:pt x="87396" y="118682"/>
                </a:cubicBezTo>
                <a:lnTo>
                  <a:pt x="34482" y="118682"/>
                </a:lnTo>
                <a:cubicBezTo>
                  <a:pt x="31962" y="118682"/>
                  <a:pt x="30162" y="116777"/>
                  <a:pt x="30162" y="114110"/>
                </a:cubicBezTo>
                <a:cubicBezTo>
                  <a:pt x="30162" y="111443"/>
                  <a:pt x="31962" y="109538"/>
                  <a:pt x="34482" y="109538"/>
                </a:cubicBezTo>
                <a:close/>
                <a:moveTo>
                  <a:pt x="259476" y="105017"/>
                </a:moveTo>
                <a:lnTo>
                  <a:pt x="223388" y="139302"/>
                </a:lnTo>
                <a:cubicBezTo>
                  <a:pt x="228440" y="145798"/>
                  <a:pt x="231327" y="154098"/>
                  <a:pt x="231327" y="162759"/>
                </a:cubicBezTo>
                <a:cubicBezTo>
                  <a:pt x="231327" y="172864"/>
                  <a:pt x="227718" y="181886"/>
                  <a:pt x="221583" y="189104"/>
                </a:cubicBezTo>
                <a:lnTo>
                  <a:pt x="255146" y="226275"/>
                </a:lnTo>
                <a:cubicBezTo>
                  <a:pt x="271385" y="210035"/>
                  <a:pt x="281129" y="187299"/>
                  <a:pt x="281129" y="162759"/>
                </a:cubicBezTo>
                <a:cubicBezTo>
                  <a:pt x="281129" y="140745"/>
                  <a:pt x="273190" y="120175"/>
                  <a:pt x="259476" y="105017"/>
                </a:cubicBezTo>
                <a:close/>
                <a:moveTo>
                  <a:pt x="80513" y="77788"/>
                </a:moveTo>
                <a:lnTo>
                  <a:pt x="109628" y="77788"/>
                </a:lnTo>
                <a:cubicBezTo>
                  <a:pt x="112144" y="77788"/>
                  <a:pt x="113941" y="79693"/>
                  <a:pt x="113941" y="82360"/>
                </a:cubicBezTo>
                <a:cubicBezTo>
                  <a:pt x="113941" y="85027"/>
                  <a:pt x="112144" y="86932"/>
                  <a:pt x="109628" y="86932"/>
                </a:cubicBezTo>
                <a:lnTo>
                  <a:pt x="80513" y="86932"/>
                </a:lnTo>
                <a:cubicBezTo>
                  <a:pt x="78357" y="86932"/>
                  <a:pt x="76200" y="85027"/>
                  <a:pt x="76200" y="82360"/>
                </a:cubicBezTo>
                <a:cubicBezTo>
                  <a:pt x="76200" y="79693"/>
                  <a:pt x="78357" y="77788"/>
                  <a:pt x="80513" y="77788"/>
                </a:cubicBezTo>
                <a:close/>
                <a:moveTo>
                  <a:pt x="34396" y="77788"/>
                </a:moveTo>
                <a:lnTo>
                  <a:pt x="57326" y="77788"/>
                </a:lnTo>
                <a:cubicBezTo>
                  <a:pt x="59796" y="77788"/>
                  <a:pt x="61559" y="79693"/>
                  <a:pt x="61559" y="82360"/>
                </a:cubicBezTo>
                <a:cubicBezTo>
                  <a:pt x="61559" y="85027"/>
                  <a:pt x="59796" y="86932"/>
                  <a:pt x="57326" y="86932"/>
                </a:cubicBezTo>
                <a:lnTo>
                  <a:pt x="34396" y="86932"/>
                </a:lnTo>
                <a:cubicBezTo>
                  <a:pt x="31926" y="86932"/>
                  <a:pt x="30162" y="85027"/>
                  <a:pt x="30162" y="82360"/>
                </a:cubicBezTo>
                <a:cubicBezTo>
                  <a:pt x="30162" y="79693"/>
                  <a:pt x="31926" y="77788"/>
                  <a:pt x="34396" y="77788"/>
                </a:cubicBezTo>
                <a:close/>
                <a:moveTo>
                  <a:pt x="196321" y="73620"/>
                </a:moveTo>
                <a:lnTo>
                  <a:pt x="196321" y="123423"/>
                </a:lnTo>
                <a:cubicBezTo>
                  <a:pt x="204261" y="124505"/>
                  <a:pt x="211479" y="127753"/>
                  <a:pt x="217614" y="132445"/>
                </a:cubicBezTo>
                <a:lnTo>
                  <a:pt x="253702" y="98161"/>
                </a:lnTo>
                <a:cubicBezTo>
                  <a:pt x="238545" y="83725"/>
                  <a:pt x="218696" y="74703"/>
                  <a:pt x="196321" y="73620"/>
                </a:cubicBezTo>
                <a:close/>
                <a:moveTo>
                  <a:pt x="187660" y="73620"/>
                </a:moveTo>
                <a:cubicBezTo>
                  <a:pt x="140384" y="76147"/>
                  <a:pt x="102491" y="115122"/>
                  <a:pt x="102491" y="162759"/>
                </a:cubicBezTo>
                <a:cubicBezTo>
                  <a:pt x="102491" y="180804"/>
                  <a:pt x="107905" y="197404"/>
                  <a:pt x="116927" y="211118"/>
                </a:cubicBezTo>
                <a:lnTo>
                  <a:pt x="157346" y="182247"/>
                </a:lnTo>
                <a:cubicBezTo>
                  <a:pt x="154098" y="176473"/>
                  <a:pt x="152293" y="169977"/>
                  <a:pt x="152293" y="162759"/>
                </a:cubicBezTo>
                <a:cubicBezTo>
                  <a:pt x="152293" y="142550"/>
                  <a:pt x="167812" y="125588"/>
                  <a:pt x="187660" y="123423"/>
                </a:cubicBezTo>
                <a:lnTo>
                  <a:pt x="187660" y="73620"/>
                </a:lnTo>
                <a:close/>
                <a:moveTo>
                  <a:pt x="61351" y="9022"/>
                </a:moveTo>
                <a:lnTo>
                  <a:pt x="61351" y="22014"/>
                </a:lnTo>
                <a:cubicBezTo>
                  <a:pt x="61351" y="29231"/>
                  <a:pt x="67486" y="35367"/>
                  <a:pt x="74703" y="35367"/>
                </a:cubicBezTo>
                <a:lnTo>
                  <a:pt x="156985" y="35367"/>
                </a:lnTo>
                <a:cubicBezTo>
                  <a:pt x="164203" y="35367"/>
                  <a:pt x="169977" y="29231"/>
                  <a:pt x="169977" y="22014"/>
                </a:cubicBezTo>
                <a:lnTo>
                  <a:pt x="169977" y="9022"/>
                </a:lnTo>
                <a:lnTo>
                  <a:pt x="61351" y="9022"/>
                </a:lnTo>
                <a:close/>
                <a:moveTo>
                  <a:pt x="22014" y="9022"/>
                </a:moveTo>
                <a:cubicBezTo>
                  <a:pt x="14435" y="9022"/>
                  <a:pt x="8661" y="14796"/>
                  <a:pt x="8661" y="22014"/>
                </a:cubicBezTo>
                <a:lnTo>
                  <a:pt x="8661" y="268499"/>
                </a:lnTo>
                <a:cubicBezTo>
                  <a:pt x="8661" y="275717"/>
                  <a:pt x="14435" y="281491"/>
                  <a:pt x="22014" y="281491"/>
                </a:cubicBezTo>
                <a:lnTo>
                  <a:pt x="209674" y="281491"/>
                </a:lnTo>
                <a:cubicBezTo>
                  <a:pt x="216892" y="281491"/>
                  <a:pt x="222666" y="275717"/>
                  <a:pt x="222666" y="268499"/>
                </a:cubicBezTo>
                <a:lnTo>
                  <a:pt x="222666" y="255868"/>
                </a:lnTo>
                <a:cubicBezTo>
                  <a:pt x="212922" y="259477"/>
                  <a:pt x="202456" y="260921"/>
                  <a:pt x="191991" y="260921"/>
                </a:cubicBezTo>
                <a:cubicBezTo>
                  <a:pt x="137858" y="260921"/>
                  <a:pt x="93830" y="216892"/>
                  <a:pt x="93830" y="162759"/>
                </a:cubicBezTo>
                <a:cubicBezTo>
                  <a:pt x="93830" y="108626"/>
                  <a:pt x="137858" y="64959"/>
                  <a:pt x="191991" y="64959"/>
                </a:cubicBezTo>
                <a:cubicBezTo>
                  <a:pt x="202456" y="64959"/>
                  <a:pt x="212922" y="66403"/>
                  <a:pt x="222666" y="69651"/>
                </a:cubicBezTo>
                <a:lnTo>
                  <a:pt x="222666" y="22014"/>
                </a:lnTo>
                <a:cubicBezTo>
                  <a:pt x="222666" y="14796"/>
                  <a:pt x="216892" y="9022"/>
                  <a:pt x="209674" y="9022"/>
                </a:cubicBezTo>
                <a:lnTo>
                  <a:pt x="178638" y="9022"/>
                </a:lnTo>
                <a:lnTo>
                  <a:pt x="178638" y="22014"/>
                </a:lnTo>
                <a:cubicBezTo>
                  <a:pt x="178638" y="34284"/>
                  <a:pt x="168894" y="44028"/>
                  <a:pt x="156985" y="44028"/>
                </a:cubicBezTo>
                <a:lnTo>
                  <a:pt x="74703" y="44028"/>
                </a:lnTo>
                <a:cubicBezTo>
                  <a:pt x="62433" y="44028"/>
                  <a:pt x="52689" y="34284"/>
                  <a:pt x="52689" y="22014"/>
                </a:cubicBezTo>
                <a:lnTo>
                  <a:pt x="52689" y="9022"/>
                </a:lnTo>
                <a:lnTo>
                  <a:pt x="22014" y="9022"/>
                </a:lnTo>
                <a:close/>
                <a:moveTo>
                  <a:pt x="22014" y="0"/>
                </a:moveTo>
                <a:lnTo>
                  <a:pt x="209674" y="0"/>
                </a:lnTo>
                <a:cubicBezTo>
                  <a:pt x="221583" y="0"/>
                  <a:pt x="231327" y="10105"/>
                  <a:pt x="231327" y="22014"/>
                </a:cubicBezTo>
                <a:lnTo>
                  <a:pt x="231327" y="72899"/>
                </a:lnTo>
                <a:cubicBezTo>
                  <a:pt x="265972" y="88417"/>
                  <a:pt x="290151" y="122701"/>
                  <a:pt x="290151" y="162759"/>
                </a:cubicBezTo>
                <a:cubicBezTo>
                  <a:pt x="290151" y="202818"/>
                  <a:pt x="265972" y="237463"/>
                  <a:pt x="231327" y="252620"/>
                </a:cubicBezTo>
                <a:lnTo>
                  <a:pt x="231327" y="268499"/>
                </a:lnTo>
                <a:cubicBezTo>
                  <a:pt x="231327" y="280408"/>
                  <a:pt x="221583" y="290152"/>
                  <a:pt x="209674" y="290152"/>
                </a:cubicBezTo>
                <a:lnTo>
                  <a:pt x="22014" y="290152"/>
                </a:lnTo>
                <a:cubicBezTo>
                  <a:pt x="9744" y="290152"/>
                  <a:pt x="0" y="280408"/>
                  <a:pt x="0" y="268499"/>
                </a:cubicBezTo>
                <a:lnTo>
                  <a:pt x="0" y="22014"/>
                </a:lnTo>
                <a:cubicBezTo>
                  <a:pt x="0" y="10105"/>
                  <a:pt x="9744" y="0"/>
                  <a:pt x="22014" y="0"/>
                </a:cubicBezTo>
                <a:close/>
              </a:path>
            </a:pathLst>
          </a:custGeom>
          <a:solidFill>
            <a:schemeClr val="bg1"/>
          </a:solidFill>
          <a:ln>
            <a:noFill/>
          </a:ln>
          <a:effectLst/>
        </p:spPr>
        <p:txBody>
          <a:bodyPr anchor="ctr"/>
          <a:lstStyle/>
          <a:p>
            <a:endParaRPr lang="en-US" sz="675">
              <a:latin typeface="+mj-lt"/>
            </a:endParaRPr>
          </a:p>
        </p:txBody>
      </p:sp>
      <p:sp>
        <p:nvSpPr>
          <p:cNvPr id="5" name="Rectangle 4">
            <a:extLst>
              <a:ext uri="{FF2B5EF4-FFF2-40B4-BE49-F238E27FC236}">
                <a16:creationId xmlns:a16="http://schemas.microsoft.com/office/drawing/2014/main" id="{352C5CCE-3A79-5C64-583A-32681681BD8A}"/>
              </a:ext>
            </a:extLst>
          </p:cNvPr>
          <p:cNvSpPr/>
          <p:nvPr/>
        </p:nvSpPr>
        <p:spPr>
          <a:xfrm>
            <a:off x="198120" y="4743423"/>
            <a:ext cx="8820890" cy="1897932"/>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mj-lt"/>
            </a:endParaRPr>
          </a:p>
        </p:txBody>
      </p:sp>
      <p:sp>
        <p:nvSpPr>
          <p:cNvPr id="6" name="TextBox 5">
            <a:extLst>
              <a:ext uri="{FF2B5EF4-FFF2-40B4-BE49-F238E27FC236}">
                <a16:creationId xmlns:a16="http://schemas.microsoft.com/office/drawing/2014/main" id="{8C5ED8F4-CB75-B970-1AD0-0EE35179AAAB}"/>
              </a:ext>
            </a:extLst>
          </p:cNvPr>
          <p:cNvSpPr txBox="1"/>
          <p:nvPr/>
        </p:nvSpPr>
        <p:spPr>
          <a:xfrm>
            <a:off x="401749" y="5267902"/>
            <a:ext cx="5712575" cy="1477328"/>
          </a:xfrm>
          <a:prstGeom prst="rect">
            <a:avLst/>
          </a:prstGeom>
          <a:noFill/>
        </p:spPr>
        <p:txBody>
          <a:bodyPr wrap="square" lIns="0" rtlCol="0" anchor="ctr" anchorCtr="0">
            <a:spAutoFit/>
          </a:bodyPr>
          <a:lstStyle/>
          <a:p>
            <a:pPr defTabSz="685846"/>
            <a:r>
              <a:rPr lang="en-US" sz="1000" b="1" dirty="0">
                <a:solidFill>
                  <a:schemeClr val="bg1">
                    <a:lumMod val="50000"/>
                  </a:schemeClr>
                </a:solidFill>
                <a:latin typeface="+mj-lt"/>
                <a:ea typeface="League Spartan" charset="0"/>
                <a:cs typeface="Poppins" pitchFamily="2" charset="77"/>
              </a:rPr>
              <a:t>WILL CONTINUE PARTICIPATING IN THE LIVED EXPERIENCE RESEARCH PROJECT</a:t>
            </a:r>
          </a:p>
          <a:p>
            <a:pPr defTabSz="685846"/>
            <a:endParaRPr lang="en-US" sz="1000" b="1" dirty="0">
              <a:solidFill>
                <a:schemeClr val="bg1">
                  <a:lumMod val="50000"/>
                </a:schemeClr>
              </a:solidFill>
              <a:latin typeface="+mj-lt"/>
              <a:ea typeface="League Spartan" charset="0"/>
              <a:cs typeface="Poppins" pitchFamily="2" charset="77"/>
            </a:endParaRPr>
          </a:p>
          <a:p>
            <a:pPr defTabSz="685846"/>
            <a:r>
              <a:rPr lang="en-US" sz="1000" b="1" dirty="0">
                <a:solidFill>
                  <a:schemeClr val="bg1">
                    <a:lumMod val="50000"/>
                  </a:schemeClr>
                </a:solidFill>
                <a:latin typeface="+mj-lt"/>
                <a:ea typeface="League Spartan" charset="0"/>
                <a:cs typeface="Poppins" pitchFamily="2" charset="77"/>
              </a:rPr>
              <a:t>WOULD RECOMMEND PARTICIPATING IN THE LIVED EXPERIENCE RESEARCH PROJECT</a:t>
            </a:r>
          </a:p>
          <a:p>
            <a:pPr defTabSz="685846"/>
            <a:endParaRPr lang="en-US" sz="1000" b="1" dirty="0">
              <a:solidFill>
                <a:schemeClr val="bg1">
                  <a:lumMod val="50000"/>
                </a:schemeClr>
              </a:solidFill>
              <a:latin typeface="+mj-lt"/>
              <a:ea typeface="League Spartan" charset="0"/>
              <a:cs typeface="Poppins" pitchFamily="2" charset="77"/>
            </a:endParaRPr>
          </a:p>
          <a:p>
            <a:pPr defTabSz="685846"/>
            <a:r>
              <a:rPr lang="en-US" sz="1000" b="1" dirty="0">
                <a:solidFill>
                  <a:schemeClr val="bg1">
                    <a:lumMod val="50000"/>
                  </a:schemeClr>
                </a:solidFill>
                <a:latin typeface="+mj-lt"/>
                <a:ea typeface="League Spartan" charset="0"/>
                <a:cs typeface="Poppins" pitchFamily="2" charset="77"/>
              </a:rPr>
              <a:t>UNDERSTAND THE BENEFITS INVOLVED IN THE LIVED EXPERIENCE RESEARCH PROJECT</a:t>
            </a:r>
          </a:p>
          <a:p>
            <a:pPr defTabSz="685846"/>
            <a:r>
              <a:rPr lang="en-US" sz="1000" b="1" dirty="0">
                <a:solidFill>
                  <a:schemeClr val="bg1">
                    <a:lumMod val="50000"/>
                  </a:schemeClr>
                </a:solidFill>
                <a:latin typeface="+mj-lt"/>
                <a:ea typeface="League Spartan" charset="0"/>
                <a:cs typeface="Poppins" pitchFamily="2" charset="77"/>
              </a:rPr>
              <a:t> </a:t>
            </a:r>
          </a:p>
          <a:p>
            <a:pPr defTabSz="685846"/>
            <a:r>
              <a:rPr lang="en-US" sz="1000" b="1" dirty="0">
                <a:solidFill>
                  <a:schemeClr val="bg1">
                    <a:lumMod val="50000"/>
                  </a:schemeClr>
                </a:solidFill>
                <a:latin typeface="+mj-lt"/>
                <a:ea typeface="League Spartan" charset="0"/>
                <a:cs typeface="Poppins" pitchFamily="2" charset="77"/>
              </a:rPr>
              <a:t>UNDERSTAND THE RISKS INVOLVED IN THE LIVED EXPERIENCE RESEARCH PROJECT</a:t>
            </a:r>
          </a:p>
          <a:p>
            <a:pPr defTabSz="685846"/>
            <a:endParaRPr lang="en-US" sz="1000" b="1" dirty="0">
              <a:solidFill>
                <a:schemeClr val="bg1">
                  <a:lumMod val="50000"/>
                </a:schemeClr>
              </a:solidFill>
              <a:latin typeface="+mj-lt"/>
              <a:ea typeface="League Spartan" charset="0"/>
              <a:cs typeface="Poppins" pitchFamily="2" charset="77"/>
            </a:endParaRPr>
          </a:p>
          <a:p>
            <a:pPr defTabSz="685846"/>
            <a:endParaRPr lang="en-US" sz="1000" b="1" dirty="0">
              <a:solidFill>
                <a:schemeClr val="bg1">
                  <a:lumMod val="50000"/>
                </a:schemeClr>
              </a:solidFill>
              <a:latin typeface="+mj-lt"/>
              <a:ea typeface="League Spartan" charset="0"/>
              <a:cs typeface="Poppins" pitchFamily="2" charset="77"/>
            </a:endParaRPr>
          </a:p>
        </p:txBody>
      </p:sp>
      <p:sp>
        <p:nvSpPr>
          <p:cNvPr id="7" name="TextBox 6">
            <a:extLst>
              <a:ext uri="{FF2B5EF4-FFF2-40B4-BE49-F238E27FC236}">
                <a16:creationId xmlns:a16="http://schemas.microsoft.com/office/drawing/2014/main" id="{5E92A92A-838B-84A1-CFEF-BCAA6A0BF3DC}"/>
              </a:ext>
            </a:extLst>
          </p:cNvPr>
          <p:cNvSpPr txBox="1"/>
          <p:nvPr/>
        </p:nvSpPr>
        <p:spPr>
          <a:xfrm>
            <a:off x="7985943" y="5267902"/>
            <a:ext cx="955507" cy="1631216"/>
          </a:xfrm>
          <a:prstGeom prst="rect">
            <a:avLst/>
          </a:prstGeom>
          <a:noFill/>
        </p:spPr>
        <p:txBody>
          <a:bodyPr wrap="square" lIns="0" rtlCol="0" anchor="ctr" anchorCtr="0">
            <a:spAutoFit/>
          </a:bodyPr>
          <a:lstStyle/>
          <a:p>
            <a:pPr algn="r" defTabSz="685846"/>
            <a:r>
              <a:rPr lang="en-US" sz="1000" b="1" dirty="0">
                <a:solidFill>
                  <a:schemeClr val="bg1">
                    <a:lumMod val="50000"/>
                  </a:schemeClr>
                </a:solidFill>
                <a:latin typeface="+mj-lt"/>
                <a:ea typeface="League Spartan" charset="0"/>
                <a:cs typeface="Poppins" pitchFamily="2" charset="77"/>
              </a:rPr>
              <a:t>89%</a:t>
            </a:r>
          </a:p>
          <a:p>
            <a:pPr algn="r" defTabSz="685846"/>
            <a:endParaRPr lang="en-US" sz="1000" b="1" dirty="0">
              <a:solidFill>
                <a:schemeClr val="bg1">
                  <a:lumMod val="50000"/>
                </a:schemeClr>
              </a:solidFill>
              <a:latin typeface="+mj-lt"/>
              <a:ea typeface="League Spartan" charset="0"/>
              <a:cs typeface="Poppins" pitchFamily="2" charset="77"/>
            </a:endParaRPr>
          </a:p>
          <a:p>
            <a:pPr algn="r" defTabSz="685846"/>
            <a:r>
              <a:rPr lang="en-US" sz="1000" b="1" dirty="0">
                <a:solidFill>
                  <a:schemeClr val="bg1">
                    <a:lumMod val="50000"/>
                  </a:schemeClr>
                </a:solidFill>
                <a:latin typeface="+mj-lt"/>
                <a:ea typeface="League Spartan" charset="0"/>
                <a:cs typeface="Poppins" pitchFamily="2" charset="77"/>
              </a:rPr>
              <a:t>89%</a:t>
            </a:r>
          </a:p>
          <a:p>
            <a:pPr algn="r" defTabSz="685846"/>
            <a:endParaRPr lang="en-US" sz="1000" b="1" dirty="0">
              <a:solidFill>
                <a:schemeClr val="bg1">
                  <a:lumMod val="50000"/>
                </a:schemeClr>
              </a:solidFill>
              <a:latin typeface="+mj-lt"/>
              <a:ea typeface="League Spartan" charset="0"/>
              <a:cs typeface="Poppins" pitchFamily="2" charset="77"/>
            </a:endParaRPr>
          </a:p>
          <a:p>
            <a:pPr algn="r" defTabSz="685846"/>
            <a:r>
              <a:rPr lang="en-US" sz="1000" b="1" dirty="0">
                <a:solidFill>
                  <a:schemeClr val="bg1">
                    <a:lumMod val="50000"/>
                  </a:schemeClr>
                </a:solidFill>
                <a:latin typeface="+mj-lt"/>
                <a:ea typeface="League Spartan" charset="0"/>
                <a:cs typeface="Poppins" pitchFamily="2" charset="77"/>
              </a:rPr>
              <a:t>67%</a:t>
            </a:r>
          </a:p>
          <a:p>
            <a:pPr algn="r" defTabSz="685846"/>
            <a:endParaRPr lang="en-US" sz="1000" b="1" dirty="0">
              <a:solidFill>
                <a:schemeClr val="bg1">
                  <a:lumMod val="50000"/>
                </a:schemeClr>
              </a:solidFill>
              <a:latin typeface="+mj-lt"/>
              <a:ea typeface="League Spartan" charset="0"/>
              <a:cs typeface="Poppins" pitchFamily="2" charset="77"/>
            </a:endParaRPr>
          </a:p>
          <a:p>
            <a:pPr algn="r" defTabSz="685846"/>
            <a:r>
              <a:rPr lang="en-US" sz="1000" b="1" dirty="0">
                <a:solidFill>
                  <a:schemeClr val="bg1">
                    <a:lumMod val="50000"/>
                  </a:schemeClr>
                </a:solidFill>
                <a:latin typeface="+mj-lt"/>
                <a:ea typeface="League Spartan" charset="0"/>
                <a:cs typeface="Poppins" pitchFamily="2" charset="77"/>
              </a:rPr>
              <a:t>56%</a:t>
            </a:r>
          </a:p>
          <a:p>
            <a:pPr algn="r" defTabSz="685846"/>
            <a:endParaRPr lang="en-US" sz="1000" b="1" dirty="0">
              <a:solidFill>
                <a:schemeClr val="bg1">
                  <a:lumMod val="50000"/>
                </a:schemeClr>
              </a:solidFill>
              <a:latin typeface="+mj-lt"/>
              <a:ea typeface="League Spartan" charset="0"/>
              <a:cs typeface="Poppins" pitchFamily="2" charset="77"/>
            </a:endParaRPr>
          </a:p>
          <a:p>
            <a:pPr algn="r" defTabSz="685846"/>
            <a:endParaRPr lang="en-US" sz="1000" b="1" dirty="0">
              <a:solidFill>
                <a:schemeClr val="bg1">
                  <a:lumMod val="50000"/>
                </a:schemeClr>
              </a:solidFill>
              <a:latin typeface="+mj-lt"/>
              <a:ea typeface="League Spartan" charset="0"/>
              <a:cs typeface="Poppins" pitchFamily="2" charset="77"/>
            </a:endParaRPr>
          </a:p>
          <a:p>
            <a:pPr algn="r" defTabSz="685846"/>
            <a:endParaRPr lang="en-US" sz="1000" b="1" dirty="0">
              <a:solidFill>
                <a:schemeClr val="bg1">
                  <a:lumMod val="50000"/>
                </a:schemeClr>
              </a:solidFill>
              <a:latin typeface="+mj-lt"/>
              <a:ea typeface="League Spartan" charset="0"/>
              <a:cs typeface="Poppins" pitchFamily="2" charset="77"/>
            </a:endParaRPr>
          </a:p>
        </p:txBody>
      </p:sp>
      <p:sp>
        <p:nvSpPr>
          <p:cNvPr id="8" name="Rectangle 7">
            <a:extLst>
              <a:ext uri="{FF2B5EF4-FFF2-40B4-BE49-F238E27FC236}">
                <a16:creationId xmlns:a16="http://schemas.microsoft.com/office/drawing/2014/main" id="{F72004AE-73C5-DF37-F602-E1E34072CFB7}"/>
              </a:ext>
            </a:extLst>
          </p:cNvPr>
          <p:cNvSpPr/>
          <p:nvPr/>
        </p:nvSpPr>
        <p:spPr>
          <a:xfrm>
            <a:off x="5132060" y="5353593"/>
            <a:ext cx="3417734"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9" name="Rectangle 8">
            <a:extLst>
              <a:ext uri="{FF2B5EF4-FFF2-40B4-BE49-F238E27FC236}">
                <a16:creationId xmlns:a16="http://schemas.microsoft.com/office/drawing/2014/main" id="{5C09211A-9370-7FA3-C70C-42F3C6953F4A}"/>
              </a:ext>
            </a:extLst>
          </p:cNvPr>
          <p:cNvSpPr/>
          <p:nvPr/>
        </p:nvSpPr>
        <p:spPr>
          <a:xfrm>
            <a:off x="5132059" y="5353593"/>
            <a:ext cx="2806497" cy="8658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0" name="Rectangle 9">
            <a:extLst>
              <a:ext uri="{FF2B5EF4-FFF2-40B4-BE49-F238E27FC236}">
                <a16:creationId xmlns:a16="http://schemas.microsoft.com/office/drawing/2014/main" id="{B06C883E-B722-BA21-DE1E-FF95BD0A7BFB}"/>
              </a:ext>
            </a:extLst>
          </p:cNvPr>
          <p:cNvSpPr/>
          <p:nvPr/>
        </p:nvSpPr>
        <p:spPr>
          <a:xfrm>
            <a:off x="5130442" y="5965787"/>
            <a:ext cx="3417734"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1" name="Rectangle 10">
            <a:extLst>
              <a:ext uri="{FF2B5EF4-FFF2-40B4-BE49-F238E27FC236}">
                <a16:creationId xmlns:a16="http://schemas.microsoft.com/office/drawing/2014/main" id="{A98C26D0-1453-F917-28C3-CDE7D6F526AD}"/>
              </a:ext>
            </a:extLst>
          </p:cNvPr>
          <p:cNvSpPr/>
          <p:nvPr/>
        </p:nvSpPr>
        <p:spPr>
          <a:xfrm>
            <a:off x="5130442" y="5962167"/>
            <a:ext cx="2068380" cy="90206"/>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2" name="Rectangle 11">
            <a:extLst>
              <a:ext uri="{FF2B5EF4-FFF2-40B4-BE49-F238E27FC236}">
                <a16:creationId xmlns:a16="http://schemas.microsoft.com/office/drawing/2014/main" id="{5E0E96DC-F57B-BB04-97C5-BFF82C762993}"/>
              </a:ext>
            </a:extLst>
          </p:cNvPr>
          <p:cNvSpPr/>
          <p:nvPr/>
        </p:nvSpPr>
        <p:spPr>
          <a:xfrm>
            <a:off x="5128824" y="6290561"/>
            <a:ext cx="3417734"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3" name="Rectangle 12">
            <a:extLst>
              <a:ext uri="{FF2B5EF4-FFF2-40B4-BE49-F238E27FC236}">
                <a16:creationId xmlns:a16="http://schemas.microsoft.com/office/drawing/2014/main" id="{B9A522B5-64E5-6EB6-907E-CBD3F1782D95}"/>
              </a:ext>
            </a:extLst>
          </p:cNvPr>
          <p:cNvSpPr/>
          <p:nvPr/>
        </p:nvSpPr>
        <p:spPr>
          <a:xfrm>
            <a:off x="5128824" y="6293321"/>
            <a:ext cx="1894102" cy="83825"/>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4" name="TextBox 13">
            <a:extLst>
              <a:ext uri="{FF2B5EF4-FFF2-40B4-BE49-F238E27FC236}">
                <a16:creationId xmlns:a16="http://schemas.microsoft.com/office/drawing/2014/main" id="{1F72E1C6-5BF2-8275-DA20-4F38E4970B39}"/>
              </a:ext>
            </a:extLst>
          </p:cNvPr>
          <p:cNvSpPr txBox="1"/>
          <p:nvPr/>
        </p:nvSpPr>
        <p:spPr>
          <a:xfrm>
            <a:off x="198194" y="4857123"/>
            <a:ext cx="5009448" cy="276999"/>
          </a:xfrm>
          <a:prstGeom prst="rect">
            <a:avLst/>
          </a:prstGeom>
          <a:noFill/>
        </p:spPr>
        <p:txBody>
          <a:bodyPr wrap="none" rtlCol="0" anchor="ctr" anchorCtr="0">
            <a:spAutoFit/>
          </a:bodyPr>
          <a:lstStyle/>
          <a:p>
            <a:r>
              <a:rPr lang="en-US" sz="1200" b="1" i="1">
                <a:solidFill>
                  <a:schemeClr val="bg1">
                    <a:lumMod val="50000"/>
                  </a:schemeClr>
                </a:solidFill>
                <a:latin typeface="+mj-lt"/>
                <a:ea typeface="League Spartan" charset="0"/>
                <a:cs typeface="Poppins" pitchFamily="2" charset="77"/>
              </a:rPr>
              <a:t>FROM MY EXPERIENCE JOINING THE LIVED EXPERIENCE WORKING GROUP, I…</a:t>
            </a:r>
          </a:p>
        </p:txBody>
      </p:sp>
      <p:sp>
        <p:nvSpPr>
          <p:cNvPr id="15" name="Rectangle 14">
            <a:extLst>
              <a:ext uri="{FF2B5EF4-FFF2-40B4-BE49-F238E27FC236}">
                <a16:creationId xmlns:a16="http://schemas.microsoft.com/office/drawing/2014/main" id="{36D7B833-2F24-D1C6-757B-E17F612DB4E0}"/>
              </a:ext>
            </a:extLst>
          </p:cNvPr>
          <p:cNvSpPr/>
          <p:nvPr/>
        </p:nvSpPr>
        <p:spPr>
          <a:xfrm>
            <a:off x="5127712" y="5658119"/>
            <a:ext cx="3417734" cy="86585"/>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
        <p:nvSpPr>
          <p:cNvPr id="16" name="Rectangle 15">
            <a:extLst>
              <a:ext uri="{FF2B5EF4-FFF2-40B4-BE49-F238E27FC236}">
                <a16:creationId xmlns:a16="http://schemas.microsoft.com/office/drawing/2014/main" id="{78036935-EF2B-9435-4213-EE4CC56FD284}"/>
              </a:ext>
            </a:extLst>
          </p:cNvPr>
          <p:cNvSpPr/>
          <p:nvPr/>
        </p:nvSpPr>
        <p:spPr>
          <a:xfrm>
            <a:off x="5127711" y="5658119"/>
            <a:ext cx="2806497" cy="8658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Lato Light" panose="020F0502020204030203" pitchFamily="34" charset="0"/>
            </a:endParaRPr>
          </a:p>
        </p:txBody>
      </p:sp>
    </p:spTree>
    <p:extLst>
      <p:ext uri="{BB962C8B-B14F-4D97-AF65-F5344CB8AC3E}">
        <p14:creationId xmlns:p14="http://schemas.microsoft.com/office/powerpoint/2010/main" val="8843968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4" name="Rectangle 143">
            <a:extLst>
              <a:ext uri="{FF2B5EF4-FFF2-40B4-BE49-F238E27FC236}">
                <a16:creationId xmlns:a16="http://schemas.microsoft.com/office/drawing/2014/main" id="{B745DD95-0352-4F89-A688-F1CCA35611CE}"/>
              </a:ext>
            </a:extLst>
          </p:cNvPr>
          <p:cNvSpPr/>
          <p:nvPr/>
        </p:nvSpPr>
        <p:spPr>
          <a:xfrm>
            <a:off x="5621831" y="854276"/>
            <a:ext cx="2963902" cy="1637484"/>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3" name="TextBox 2">
            <a:extLst>
              <a:ext uri="{FF2B5EF4-FFF2-40B4-BE49-F238E27FC236}">
                <a16:creationId xmlns:a16="http://schemas.microsoft.com/office/drawing/2014/main" id="{3F736E9F-099F-6E49-8413-5352C763CACD}"/>
              </a:ext>
            </a:extLst>
          </p:cNvPr>
          <p:cNvSpPr txBox="1"/>
          <p:nvPr/>
        </p:nvSpPr>
        <p:spPr>
          <a:xfrm>
            <a:off x="1170352" y="300278"/>
            <a:ext cx="7048276" cy="553998"/>
          </a:xfrm>
          <a:prstGeom prst="rect">
            <a:avLst/>
          </a:prstGeom>
          <a:noFill/>
        </p:spPr>
        <p:txBody>
          <a:bodyPr wrap="none" rtlCol="0">
            <a:spAutoFit/>
          </a:bodyPr>
          <a:lstStyle/>
          <a:p>
            <a:pPr algn="ctr"/>
            <a:r>
              <a:rPr lang="en-US" sz="3000" b="1" dirty="0">
                <a:solidFill>
                  <a:schemeClr val="accent1"/>
                </a:solidFill>
                <a:latin typeface="+mj-lt"/>
                <a:cs typeface="Poppins" pitchFamily="2" charset="77"/>
              </a:rPr>
              <a:t>INCORPORATING FEEDBACK TO IMPROVE</a:t>
            </a:r>
          </a:p>
        </p:txBody>
      </p:sp>
      <p:sp>
        <p:nvSpPr>
          <p:cNvPr id="85" name="Freeform 69">
            <a:extLst>
              <a:ext uri="{FF2B5EF4-FFF2-40B4-BE49-F238E27FC236}">
                <a16:creationId xmlns:a16="http://schemas.microsoft.com/office/drawing/2014/main" id="{C47DF526-2797-4792-8BE1-5AD5ED023296}"/>
              </a:ext>
            </a:extLst>
          </p:cNvPr>
          <p:cNvSpPr>
            <a:spLocks noChangeArrowheads="1"/>
          </p:cNvSpPr>
          <p:nvPr/>
        </p:nvSpPr>
        <p:spPr bwMode="auto">
          <a:xfrm>
            <a:off x="1161123" y="4630641"/>
            <a:ext cx="6809716" cy="916890"/>
          </a:xfrm>
          <a:custGeom>
            <a:avLst/>
            <a:gdLst>
              <a:gd name="T0" fmla="*/ 7288 w 14575"/>
              <a:gd name="T1" fmla="*/ 0 h 1962"/>
              <a:gd name="T2" fmla="*/ 7288 w 14575"/>
              <a:gd name="T3" fmla="*/ 0 h 1962"/>
              <a:gd name="T4" fmla="*/ 0 w 14575"/>
              <a:gd name="T5" fmla="*/ 1961 h 1962"/>
              <a:gd name="T6" fmla="*/ 14574 w 14575"/>
              <a:gd name="T7" fmla="*/ 1961 h 1962"/>
              <a:gd name="T8" fmla="*/ 14574 w 14575"/>
              <a:gd name="T9" fmla="*/ 1961 h 1962"/>
              <a:gd name="T10" fmla="*/ 7288 w 14575"/>
              <a:gd name="T11" fmla="*/ 0 h 1962"/>
            </a:gdLst>
            <a:ahLst/>
            <a:cxnLst>
              <a:cxn ang="0">
                <a:pos x="T0" y="T1"/>
              </a:cxn>
              <a:cxn ang="0">
                <a:pos x="T2" y="T3"/>
              </a:cxn>
              <a:cxn ang="0">
                <a:pos x="T4" y="T5"/>
              </a:cxn>
              <a:cxn ang="0">
                <a:pos x="T6" y="T7"/>
              </a:cxn>
              <a:cxn ang="0">
                <a:pos x="T8" y="T9"/>
              </a:cxn>
              <a:cxn ang="0">
                <a:pos x="T10" y="T11"/>
              </a:cxn>
            </a:cxnLst>
            <a:rect l="0" t="0" r="r" b="b"/>
            <a:pathLst>
              <a:path w="14575" h="1962">
                <a:moveTo>
                  <a:pt x="7288" y="0"/>
                </a:moveTo>
                <a:lnTo>
                  <a:pt x="7288" y="0"/>
                </a:lnTo>
                <a:cubicBezTo>
                  <a:pt x="3272" y="0"/>
                  <a:pt x="15" y="878"/>
                  <a:pt x="0" y="1961"/>
                </a:cubicBezTo>
                <a:lnTo>
                  <a:pt x="14574" y="1961"/>
                </a:lnTo>
                <a:lnTo>
                  <a:pt x="14574" y="1961"/>
                </a:lnTo>
                <a:cubicBezTo>
                  <a:pt x="14559" y="878"/>
                  <a:pt x="11302" y="0"/>
                  <a:pt x="7288" y="0"/>
                </a:cubicBezTo>
              </a:path>
            </a:pathLst>
          </a:custGeom>
          <a:solidFill>
            <a:schemeClr val="bg1">
              <a:lumMod val="65000"/>
              <a:alpha val="15000"/>
            </a:schemeClr>
          </a:solidFill>
          <a:ln>
            <a:noFill/>
          </a:ln>
          <a:effectLst/>
        </p:spPr>
        <p:txBody>
          <a:bodyPr wrap="none" anchor="ctr"/>
          <a:lstStyle/>
          <a:p>
            <a:endParaRPr lang="en-US" sz="1350">
              <a:latin typeface="+mj-lt"/>
            </a:endParaRPr>
          </a:p>
        </p:txBody>
      </p:sp>
      <p:sp>
        <p:nvSpPr>
          <p:cNvPr id="86" name="Freeform 76">
            <a:extLst>
              <a:ext uri="{FF2B5EF4-FFF2-40B4-BE49-F238E27FC236}">
                <a16:creationId xmlns:a16="http://schemas.microsoft.com/office/drawing/2014/main" id="{91FC40A4-A51E-491E-9B8B-06E1E1586D86}"/>
              </a:ext>
            </a:extLst>
          </p:cNvPr>
          <p:cNvSpPr>
            <a:spLocks noChangeArrowheads="1"/>
          </p:cNvSpPr>
          <p:nvPr/>
        </p:nvSpPr>
        <p:spPr bwMode="auto">
          <a:xfrm>
            <a:off x="571719" y="4069542"/>
            <a:ext cx="1283646" cy="890105"/>
          </a:xfrm>
          <a:custGeom>
            <a:avLst/>
            <a:gdLst>
              <a:gd name="T0" fmla="*/ 1195 w 2747"/>
              <a:gd name="T1" fmla="*/ 1840 h 1903"/>
              <a:gd name="T2" fmla="*/ 1195 w 2747"/>
              <a:gd name="T3" fmla="*/ 1840 h 1903"/>
              <a:gd name="T4" fmla="*/ 1550 w 2747"/>
              <a:gd name="T5" fmla="*/ 1840 h 1903"/>
              <a:gd name="T6" fmla="*/ 2746 w 2747"/>
              <a:gd name="T7" fmla="*/ 1162 h 1903"/>
              <a:gd name="T8" fmla="*/ 2746 w 2747"/>
              <a:gd name="T9" fmla="*/ 470 h 1903"/>
              <a:gd name="T10" fmla="*/ 2746 w 2747"/>
              <a:gd name="T11" fmla="*/ 470 h 1903"/>
              <a:gd name="T12" fmla="*/ 1337 w 2747"/>
              <a:gd name="T13" fmla="*/ 0 h 1903"/>
              <a:gd name="T14" fmla="*/ 1337 w 2747"/>
              <a:gd name="T15" fmla="*/ 0 h 1903"/>
              <a:gd name="T16" fmla="*/ 0 w 2747"/>
              <a:gd name="T17" fmla="*/ 418 h 1903"/>
              <a:gd name="T18" fmla="*/ 0 w 2747"/>
              <a:gd name="T19" fmla="*/ 1162 h 1903"/>
              <a:gd name="T20" fmla="*/ 1195 w 2747"/>
              <a:gd name="T21" fmla="*/ 1840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7" h="1903">
                <a:moveTo>
                  <a:pt x="1195" y="1840"/>
                </a:moveTo>
                <a:lnTo>
                  <a:pt x="1195" y="1840"/>
                </a:lnTo>
                <a:cubicBezTo>
                  <a:pt x="1305" y="1902"/>
                  <a:pt x="1440" y="1902"/>
                  <a:pt x="1550" y="1840"/>
                </a:cubicBezTo>
                <a:lnTo>
                  <a:pt x="2746" y="1162"/>
                </a:lnTo>
                <a:lnTo>
                  <a:pt x="2746" y="470"/>
                </a:lnTo>
                <a:lnTo>
                  <a:pt x="2746" y="470"/>
                </a:lnTo>
                <a:cubicBezTo>
                  <a:pt x="2353" y="175"/>
                  <a:pt x="1865" y="0"/>
                  <a:pt x="1337" y="0"/>
                </a:cubicBezTo>
                <a:lnTo>
                  <a:pt x="1337" y="0"/>
                </a:lnTo>
                <a:cubicBezTo>
                  <a:pt x="840" y="0"/>
                  <a:pt x="379" y="154"/>
                  <a:pt x="0" y="418"/>
                </a:cubicBezTo>
                <a:lnTo>
                  <a:pt x="0" y="1162"/>
                </a:lnTo>
                <a:lnTo>
                  <a:pt x="1195" y="1840"/>
                </a:lnTo>
              </a:path>
            </a:pathLst>
          </a:custGeom>
          <a:solidFill>
            <a:schemeClr val="accent1"/>
          </a:solidFill>
          <a:ln>
            <a:noFill/>
          </a:ln>
          <a:effectLst/>
        </p:spPr>
        <p:txBody>
          <a:bodyPr wrap="none" anchor="ctr"/>
          <a:lstStyle/>
          <a:p>
            <a:endParaRPr lang="en-US" sz="1350">
              <a:latin typeface="+mj-lt"/>
            </a:endParaRPr>
          </a:p>
        </p:txBody>
      </p:sp>
      <p:sp>
        <p:nvSpPr>
          <p:cNvPr id="87" name="Freeform 78">
            <a:extLst>
              <a:ext uri="{FF2B5EF4-FFF2-40B4-BE49-F238E27FC236}">
                <a16:creationId xmlns:a16="http://schemas.microsoft.com/office/drawing/2014/main" id="{B0FDE50E-4742-4FD5-985A-FAD1C60C9447}"/>
              </a:ext>
            </a:extLst>
          </p:cNvPr>
          <p:cNvSpPr>
            <a:spLocks noChangeArrowheads="1"/>
          </p:cNvSpPr>
          <p:nvPr/>
        </p:nvSpPr>
        <p:spPr bwMode="auto">
          <a:xfrm>
            <a:off x="2250969" y="3375178"/>
            <a:ext cx="1283647" cy="890105"/>
          </a:xfrm>
          <a:custGeom>
            <a:avLst/>
            <a:gdLst>
              <a:gd name="T0" fmla="*/ 1196 w 2747"/>
              <a:gd name="T1" fmla="*/ 1840 h 1903"/>
              <a:gd name="T2" fmla="*/ 1196 w 2747"/>
              <a:gd name="T3" fmla="*/ 1840 h 1903"/>
              <a:gd name="T4" fmla="*/ 1551 w 2747"/>
              <a:gd name="T5" fmla="*/ 1840 h 1903"/>
              <a:gd name="T6" fmla="*/ 2746 w 2747"/>
              <a:gd name="T7" fmla="*/ 1162 h 1903"/>
              <a:gd name="T8" fmla="*/ 2746 w 2747"/>
              <a:gd name="T9" fmla="*/ 470 h 1903"/>
              <a:gd name="T10" fmla="*/ 2746 w 2747"/>
              <a:gd name="T11" fmla="*/ 470 h 1903"/>
              <a:gd name="T12" fmla="*/ 1337 w 2747"/>
              <a:gd name="T13" fmla="*/ 0 h 1903"/>
              <a:gd name="T14" fmla="*/ 1337 w 2747"/>
              <a:gd name="T15" fmla="*/ 0 h 1903"/>
              <a:gd name="T16" fmla="*/ 0 w 2747"/>
              <a:gd name="T17" fmla="*/ 418 h 1903"/>
              <a:gd name="T18" fmla="*/ 0 w 2747"/>
              <a:gd name="T19" fmla="*/ 1162 h 1903"/>
              <a:gd name="T20" fmla="*/ 1196 w 2747"/>
              <a:gd name="T21" fmla="*/ 1840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7" h="1903">
                <a:moveTo>
                  <a:pt x="1196" y="1840"/>
                </a:moveTo>
                <a:lnTo>
                  <a:pt x="1196" y="1840"/>
                </a:lnTo>
                <a:cubicBezTo>
                  <a:pt x="1306" y="1902"/>
                  <a:pt x="1441" y="1902"/>
                  <a:pt x="1551" y="1840"/>
                </a:cubicBezTo>
                <a:lnTo>
                  <a:pt x="2746" y="1162"/>
                </a:lnTo>
                <a:lnTo>
                  <a:pt x="2746" y="470"/>
                </a:lnTo>
                <a:lnTo>
                  <a:pt x="2746" y="470"/>
                </a:lnTo>
                <a:cubicBezTo>
                  <a:pt x="2354" y="175"/>
                  <a:pt x="1866" y="0"/>
                  <a:pt x="1337" y="0"/>
                </a:cubicBezTo>
                <a:lnTo>
                  <a:pt x="1337" y="0"/>
                </a:lnTo>
                <a:cubicBezTo>
                  <a:pt x="840" y="0"/>
                  <a:pt x="380" y="155"/>
                  <a:pt x="0" y="418"/>
                </a:cubicBezTo>
                <a:lnTo>
                  <a:pt x="0" y="1162"/>
                </a:lnTo>
                <a:lnTo>
                  <a:pt x="1196" y="1840"/>
                </a:lnTo>
              </a:path>
            </a:pathLst>
          </a:custGeom>
          <a:solidFill>
            <a:schemeClr val="accent2"/>
          </a:solidFill>
          <a:ln>
            <a:noFill/>
          </a:ln>
          <a:effectLst/>
        </p:spPr>
        <p:txBody>
          <a:bodyPr wrap="none" anchor="ctr"/>
          <a:lstStyle/>
          <a:p>
            <a:endParaRPr lang="en-US" sz="1350">
              <a:latin typeface="+mj-lt"/>
            </a:endParaRPr>
          </a:p>
        </p:txBody>
      </p:sp>
      <p:sp>
        <p:nvSpPr>
          <p:cNvPr id="88" name="Freeform 80">
            <a:extLst>
              <a:ext uri="{FF2B5EF4-FFF2-40B4-BE49-F238E27FC236}">
                <a16:creationId xmlns:a16="http://schemas.microsoft.com/office/drawing/2014/main" id="{17DD1B6A-4BAB-4C2F-BB59-7374CC25F347}"/>
              </a:ext>
            </a:extLst>
          </p:cNvPr>
          <p:cNvSpPr>
            <a:spLocks noChangeArrowheads="1"/>
          </p:cNvSpPr>
          <p:nvPr/>
        </p:nvSpPr>
        <p:spPr bwMode="auto">
          <a:xfrm>
            <a:off x="5630071" y="3375178"/>
            <a:ext cx="1283647" cy="890105"/>
          </a:xfrm>
          <a:custGeom>
            <a:avLst/>
            <a:gdLst>
              <a:gd name="T0" fmla="*/ 1195 w 2747"/>
              <a:gd name="T1" fmla="*/ 1840 h 1903"/>
              <a:gd name="T2" fmla="*/ 1195 w 2747"/>
              <a:gd name="T3" fmla="*/ 1840 h 1903"/>
              <a:gd name="T4" fmla="*/ 1550 w 2747"/>
              <a:gd name="T5" fmla="*/ 1840 h 1903"/>
              <a:gd name="T6" fmla="*/ 2746 w 2747"/>
              <a:gd name="T7" fmla="*/ 1162 h 1903"/>
              <a:gd name="T8" fmla="*/ 2746 w 2747"/>
              <a:gd name="T9" fmla="*/ 470 h 1903"/>
              <a:gd name="T10" fmla="*/ 2746 w 2747"/>
              <a:gd name="T11" fmla="*/ 470 h 1903"/>
              <a:gd name="T12" fmla="*/ 1336 w 2747"/>
              <a:gd name="T13" fmla="*/ 0 h 1903"/>
              <a:gd name="T14" fmla="*/ 1336 w 2747"/>
              <a:gd name="T15" fmla="*/ 0 h 1903"/>
              <a:gd name="T16" fmla="*/ 0 w 2747"/>
              <a:gd name="T17" fmla="*/ 418 h 1903"/>
              <a:gd name="T18" fmla="*/ 0 w 2747"/>
              <a:gd name="T19" fmla="*/ 1162 h 1903"/>
              <a:gd name="T20" fmla="*/ 1195 w 2747"/>
              <a:gd name="T21" fmla="*/ 1840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7" h="1903">
                <a:moveTo>
                  <a:pt x="1195" y="1840"/>
                </a:moveTo>
                <a:lnTo>
                  <a:pt x="1195" y="1840"/>
                </a:lnTo>
                <a:cubicBezTo>
                  <a:pt x="1305" y="1902"/>
                  <a:pt x="1440" y="1902"/>
                  <a:pt x="1550" y="1840"/>
                </a:cubicBezTo>
                <a:lnTo>
                  <a:pt x="2746" y="1162"/>
                </a:lnTo>
                <a:lnTo>
                  <a:pt x="2746" y="470"/>
                </a:lnTo>
                <a:lnTo>
                  <a:pt x="2746" y="470"/>
                </a:lnTo>
                <a:cubicBezTo>
                  <a:pt x="2353" y="175"/>
                  <a:pt x="1865" y="0"/>
                  <a:pt x="1336" y="0"/>
                </a:cubicBezTo>
                <a:lnTo>
                  <a:pt x="1336" y="0"/>
                </a:lnTo>
                <a:cubicBezTo>
                  <a:pt x="840" y="0"/>
                  <a:pt x="379" y="155"/>
                  <a:pt x="0" y="418"/>
                </a:cubicBezTo>
                <a:lnTo>
                  <a:pt x="0" y="1162"/>
                </a:lnTo>
                <a:lnTo>
                  <a:pt x="1195" y="1840"/>
                </a:lnTo>
              </a:path>
            </a:pathLst>
          </a:custGeom>
          <a:solidFill>
            <a:schemeClr val="accent4"/>
          </a:solidFill>
          <a:ln>
            <a:noFill/>
          </a:ln>
          <a:effectLst/>
        </p:spPr>
        <p:txBody>
          <a:bodyPr wrap="none" anchor="ctr"/>
          <a:lstStyle/>
          <a:p>
            <a:endParaRPr lang="en-US" sz="1350">
              <a:latin typeface="+mj-lt"/>
            </a:endParaRPr>
          </a:p>
        </p:txBody>
      </p:sp>
      <p:sp>
        <p:nvSpPr>
          <p:cNvPr id="89" name="Freeform 82">
            <a:extLst>
              <a:ext uri="{FF2B5EF4-FFF2-40B4-BE49-F238E27FC236}">
                <a16:creationId xmlns:a16="http://schemas.microsoft.com/office/drawing/2014/main" id="{DB9D7741-0521-4EFC-A487-909D4316F516}"/>
              </a:ext>
            </a:extLst>
          </p:cNvPr>
          <p:cNvSpPr>
            <a:spLocks noChangeArrowheads="1"/>
          </p:cNvSpPr>
          <p:nvPr/>
        </p:nvSpPr>
        <p:spPr bwMode="auto">
          <a:xfrm>
            <a:off x="7303139" y="4069542"/>
            <a:ext cx="1283647" cy="890105"/>
          </a:xfrm>
          <a:custGeom>
            <a:avLst/>
            <a:gdLst>
              <a:gd name="T0" fmla="*/ 1196 w 2747"/>
              <a:gd name="T1" fmla="*/ 1840 h 1903"/>
              <a:gd name="T2" fmla="*/ 1196 w 2747"/>
              <a:gd name="T3" fmla="*/ 1840 h 1903"/>
              <a:gd name="T4" fmla="*/ 1551 w 2747"/>
              <a:gd name="T5" fmla="*/ 1840 h 1903"/>
              <a:gd name="T6" fmla="*/ 2746 w 2747"/>
              <a:gd name="T7" fmla="*/ 1162 h 1903"/>
              <a:gd name="T8" fmla="*/ 2746 w 2747"/>
              <a:gd name="T9" fmla="*/ 470 h 1903"/>
              <a:gd name="T10" fmla="*/ 2746 w 2747"/>
              <a:gd name="T11" fmla="*/ 470 h 1903"/>
              <a:gd name="T12" fmla="*/ 1338 w 2747"/>
              <a:gd name="T13" fmla="*/ 0 h 1903"/>
              <a:gd name="T14" fmla="*/ 1338 w 2747"/>
              <a:gd name="T15" fmla="*/ 0 h 1903"/>
              <a:gd name="T16" fmla="*/ 0 w 2747"/>
              <a:gd name="T17" fmla="*/ 418 h 1903"/>
              <a:gd name="T18" fmla="*/ 0 w 2747"/>
              <a:gd name="T19" fmla="*/ 1162 h 1903"/>
              <a:gd name="T20" fmla="*/ 1196 w 2747"/>
              <a:gd name="T21" fmla="*/ 1840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7" h="1903">
                <a:moveTo>
                  <a:pt x="1196" y="1840"/>
                </a:moveTo>
                <a:lnTo>
                  <a:pt x="1196" y="1840"/>
                </a:lnTo>
                <a:cubicBezTo>
                  <a:pt x="1306" y="1902"/>
                  <a:pt x="1441" y="1902"/>
                  <a:pt x="1551" y="1840"/>
                </a:cubicBezTo>
                <a:lnTo>
                  <a:pt x="2746" y="1162"/>
                </a:lnTo>
                <a:lnTo>
                  <a:pt x="2746" y="470"/>
                </a:lnTo>
                <a:lnTo>
                  <a:pt x="2746" y="470"/>
                </a:lnTo>
                <a:cubicBezTo>
                  <a:pt x="2354" y="175"/>
                  <a:pt x="1866" y="0"/>
                  <a:pt x="1338" y="0"/>
                </a:cubicBezTo>
                <a:lnTo>
                  <a:pt x="1338" y="0"/>
                </a:lnTo>
                <a:cubicBezTo>
                  <a:pt x="841" y="0"/>
                  <a:pt x="380" y="154"/>
                  <a:pt x="0" y="418"/>
                </a:cubicBezTo>
                <a:lnTo>
                  <a:pt x="0" y="1162"/>
                </a:lnTo>
                <a:lnTo>
                  <a:pt x="1196" y="1840"/>
                </a:lnTo>
              </a:path>
            </a:pathLst>
          </a:custGeom>
          <a:solidFill>
            <a:schemeClr val="accent5"/>
          </a:solidFill>
          <a:ln>
            <a:noFill/>
          </a:ln>
          <a:effectLst/>
        </p:spPr>
        <p:txBody>
          <a:bodyPr wrap="none" anchor="ctr"/>
          <a:lstStyle/>
          <a:p>
            <a:endParaRPr lang="en-US" sz="1350">
              <a:latin typeface="+mj-lt"/>
            </a:endParaRPr>
          </a:p>
        </p:txBody>
      </p:sp>
      <p:sp>
        <p:nvSpPr>
          <p:cNvPr id="90" name="Freeform 84">
            <a:extLst>
              <a:ext uri="{FF2B5EF4-FFF2-40B4-BE49-F238E27FC236}">
                <a16:creationId xmlns:a16="http://schemas.microsoft.com/office/drawing/2014/main" id="{58C45246-94CA-4DCA-9AB3-E4AEA022B964}"/>
              </a:ext>
            </a:extLst>
          </p:cNvPr>
          <p:cNvSpPr>
            <a:spLocks noChangeArrowheads="1"/>
          </p:cNvSpPr>
          <p:nvPr/>
        </p:nvSpPr>
        <p:spPr bwMode="auto">
          <a:xfrm>
            <a:off x="3932278" y="3086718"/>
            <a:ext cx="1281586" cy="890105"/>
          </a:xfrm>
          <a:custGeom>
            <a:avLst/>
            <a:gdLst>
              <a:gd name="T0" fmla="*/ 1195 w 2745"/>
              <a:gd name="T1" fmla="*/ 1839 h 1903"/>
              <a:gd name="T2" fmla="*/ 1195 w 2745"/>
              <a:gd name="T3" fmla="*/ 1839 h 1903"/>
              <a:gd name="T4" fmla="*/ 1549 w 2745"/>
              <a:gd name="T5" fmla="*/ 1839 h 1903"/>
              <a:gd name="T6" fmla="*/ 2744 w 2745"/>
              <a:gd name="T7" fmla="*/ 1161 h 1903"/>
              <a:gd name="T8" fmla="*/ 2744 w 2745"/>
              <a:gd name="T9" fmla="*/ 469 h 1903"/>
              <a:gd name="T10" fmla="*/ 2744 w 2745"/>
              <a:gd name="T11" fmla="*/ 469 h 1903"/>
              <a:gd name="T12" fmla="*/ 1337 w 2745"/>
              <a:gd name="T13" fmla="*/ 0 h 1903"/>
              <a:gd name="T14" fmla="*/ 1337 w 2745"/>
              <a:gd name="T15" fmla="*/ 0 h 1903"/>
              <a:gd name="T16" fmla="*/ 0 w 2745"/>
              <a:gd name="T17" fmla="*/ 418 h 1903"/>
              <a:gd name="T18" fmla="*/ 0 w 2745"/>
              <a:gd name="T19" fmla="*/ 1161 h 1903"/>
              <a:gd name="T20" fmla="*/ 1195 w 2745"/>
              <a:gd name="T21" fmla="*/ 1839 h 190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2745" h="1903">
                <a:moveTo>
                  <a:pt x="1195" y="1839"/>
                </a:moveTo>
                <a:lnTo>
                  <a:pt x="1195" y="1839"/>
                </a:lnTo>
                <a:cubicBezTo>
                  <a:pt x="1305" y="1902"/>
                  <a:pt x="1439" y="1902"/>
                  <a:pt x="1549" y="1839"/>
                </a:cubicBezTo>
                <a:lnTo>
                  <a:pt x="2744" y="1161"/>
                </a:lnTo>
                <a:lnTo>
                  <a:pt x="2744" y="469"/>
                </a:lnTo>
                <a:lnTo>
                  <a:pt x="2744" y="469"/>
                </a:lnTo>
                <a:cubicBezTo>
                  <a:pt x="2352" y="174"/>
                  <a:pt x="1864" y="0"/>
                  <a:pt x="1337" y="0"/>
                </a:cubicBezTo>
                <a:lnTo>
                  <a:pt x="1337" y="0"/>
                </a:lnTo>
                <a:cubicBezTo>
                  <a:pt x="840" y="0"/>
                  <a:pt x="379" y="154"/>
                  <a:pt x="0" y="418"/>
                </a:cubicBezTo>
                <a:lnTo>
                  <a:pt x="0" y="1161"/>
                </a:lnTo>
                <a:lnTo>
                  <a:pt x="1195" y="1839"/>
                </a:lnTo>
              </a:path>
            </a:pathLst>
          </a:custGeom>
          <a:solidFill>
            <a:schemeClr val="accent3"/>
          </a:solidFill>
          <a:ln>
            <a:noFill/>
          </a:ln>
          <a:effectLst/>
        </p:spPr>
        <p:txBody>
          <a:bodyPr wrap="none" anchor="ctr"/>
          <a:lstStyle/>
          <a:p>
            <a:endParaRPr lang="en-US" sz="1350">
              <a:latin typeface="+mj-lt"/>
            </a:endParaRPr>
          </a:p>
        </p:txBody>
      </p:sp>
      <p:sp>
        <p:nvSpPr>
          <p:cNvPr id="91" name="Freeform 85">
            <a:extLst>
              <a:ext uri="{FF2B5EF4-FFF2-40B4-BE49-F238E27FC236}">
                <a16:creationId xmlns:a16="http://schemas.microsoft.com/office/drawing/2014/main" id="{CBBECDFD-4FDD-4694-91C5-510B31F8F324}"/>
              </a:ext>
            </a:extLst>
          </p:cNvPr>
          <p:cNvSpPr>
            <a:spLocks noChangeArrowheads="1"/>
          </p:cNvSpPr>
          <p:nvPr/>
        </p:nvSpPr>
        <p:spPr bwMode="auto">
          <a:xfrm>
            <a:off x="571719" y="2693176"/>
            <a:ext cx="1283646" cy="1594772"/>
          </a:xfrm>
          <a:custGeom>
            <a:avLst/>
            <a:gdLst>
              <a:gd name="T0" fmla="*/ 2746 w 2747"/>
              <a:gd name="T1" fmla="*/ 3413 h 3414"/>
              <a:gd name="T2" fmla="*/ 2746 w 2747"/>
              <a:gd name="T3" fmla="*/ 415 h 3414"/>
              <a:gd name="T4" fmla="*/ 2746 w 2747"/>
              <a:gd name="T5" fmla="*/ 415 h 3414"/>
              <a:gd name="T6" fmla="*/ 2330 w 2747"/>
              <a:gd name="T7" fmla="*/ 0 h 3414"/>
              <a:gd name="T8" fmla="*/ 358 w 2747"/>
              <a:gd name="T9" fmla="*/ 0 h 3414"/>
              <a:gd name="T10" fmla="*/ 358 w 2747"/>
              <a:gd name="T11" fmla="*/ 0 h 3414"/>
              <a:gd name="T12" fmla="*/ 0 w 2747"/>
              <a:gd name="T13" fmla="*/ 357 h 3414"/>
              <a:gd name="T14" fmla="*/ 0 w 2747"/>
              <a:gd name="T15" fmla="*/ 3361 h 3414"/>
              <a:gd name="T16" fmla="*/ 0 w 2747"/>
              <a:gd name="T17" fmla="*/ 3361 h 3414"/>
              <a:gd name="T18" fmla="*/ 1337 w 2747"/>
              <a:gd name="T19" fmla="*/ 2943 h 3414"/>
              <a:gd name="T20" fmla="*/ 1337 w 2747"/>
              <a:gd name="T21" fmla="*/ 2943 h 3414"/>
              <a:gd name="T22" fmla="*/ 2746 w 2747"/>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7" h="3414">
                <a:moveTo>
                  <a:pt x="2746" y="3413"/>
                </a:moveTo>
                <a:lnTo>
                  <a:pt x="2746" y="415"/>
                </a:lnTo>
                <a:lnTo>
                  <a:pt x="2746" y="415"/>
                </a:lnTo>
                <a:cubicBezTo>
                  <a:pt x="2746" y="186"/>
                  <a:pt x="2560" y="0"/>
                  <a:pt x="2330" y="0"/>
                </a:cubicBezTo>
                <a:lnTo>
                  <a:pt x="358" y="0"/>
                </a:lnTo>
                <a:lnTo>
                  <a:pt x="358" y="0"/>
                </a:lnTo>
                <a:cubicBezTo>
                  <a:pt x="160" y="0"/>
                  <a:pt x="0" y="160"/>
                  <a:pt x="0" y="357"/>
                </a:cubicBezTo>
                <a:lnTo>
                  <a:pt x="0" y="3361"/>
                </a:lnTo>
                <a:lnTo>
                  <a:pt x="0" y="3361"/>
                </a:lnTo>
                <a:cubicBezTo>
                  <a:pt x="379" y="3097"/>
                  <a:pt x="840" y="2943"/>
                  <a:pt x="1337" y="2943"/>
                </a:cubicBezTo>
                <a:lnTo>
                  <a:pt x="1337" y="2943"/>
                </a:lnTo>
                <a:cubicBezTo>
                  <a:pt x="1865" y="2943"/>
                  <a:pt x="2353" y="3118"/>
                  <a:pt x="2746"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2" name="Freeform 86">
            <a:extLst>
              <a:ext uri="{FF2B5EF4-FFF2-40B4-BE49-F238E27FC236}">
                <a16:creationId xmlns:a16="http://schemas.microsoft.com/office/drawing/2014/main" id="{F803AAF6-CD73-4A4B-B968-C39DBA71447C}"/>
              </a:ext>
            </a:extLst>
          </p:cNvPr>
          <p:cNvSpPr>
            <a:spLocks noChangeArrowheads="1"/>
          </p:cNvSpPr>
          <p:nvPr/>
        </p:nvSpPr>
        <p:spPr bwMode="auto">
          <a:xfrm>
            <a:off x="2250969" y="2000873"/>
            <a:ext cx="1283647" cy="1594772"/>
          </a:xfrm>
          <a:custGeom>
            <a:avLst/>
            <a:gdLst>
              <a:gd name="T0" fmla="*/ 2746 w 2747"/>
              <a:gd name="T1" fmla="*/ 3413 h 3414"/>
              <a:gd name="T2" fmla="*/ 2746 w 2747"/>
              <a:gd name="T3" fmla="*/ 416 h 3414"/>
              <a:gd name="T4" fmla="*/ 2746 w 2747"/>
              <a:gd name="T5" fmla="*/ 416 h 3414"/>
              <a:gd name="T6" fmla="*/ 2330 w 2747"/>
              <a:gd name="T7" fmla="*/ 0 h 3414"/>
              <a:gd name="T8" fmla="*/ 358 w 2747"/>
              <a:gd name="T9" fmla="*/ 0 h 3414"/>
              <a:gd name="T10" fmla="*/ 358 w 2747"/>
              <a:gd name="T11" fmla="*/ 0 h 3414"/>
              <a:gd name="T12" fmla="*/ 0 w 2747"/>
              <a:gd name="T13" fmla="*/ 358 h 3414"/>
              <a:gd name="T14" fmla="*/ 0 w 2747"/>
              <a:gd name="T15" fmla="*/ 3361 h 3414"/>
              <a:gd name="T16" fmla="*/ 0 w 2747"/>
              <a:gd name="T17" fmla="*/ 3361 h 3414"/>
              <a:gd name="T18" fmla="*/ 1337 w 2747"/>
              <a:gd name="T19" fmla="*/ 2943 h 3414"/>
              <a:gd name="T20" fmla="*/ 1337 w 2747"/>
              <a:gd name="T21" fmla="*/ 2943 h 3414"/>
              <a:gd name="T22" fmla="*/ 2746 w 2747"/>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7" h="3414">
                <a:moveTo>
                  <a:pt x="2746" y="3413"/>
                </a:moveTo>
                <a:lnTo>
                  <a:pt x="2746" y="416"/>
                </a:lnTo>
                <a:lnTo>
                  <a:pt x="2746" y="416"/>
                </a:lnTo>
                <a:cubicBezTo>
                  <a:pt x="2746" y="186"/>
                  <a:pt x="2560" y="0"/>
                  <a:pt x="2330" y="0"/>
                </a:cubicBezTo>
                <a:lnTo>
                  <a:pt x="358" y="0"/>
                </a:lnTo>
                <a:lnTo>
                  <a:pt x="358" y="0"/>
                </a:lnTo>
                <a:cubicBezTo>
                  <a:pt x="161" y="0"/>
                  <a:pt x="0" y="160"/>
                  <a:pt x="0" y="358"/>
                </a:cubicBezTo>
                <a:lnTo>
                  <a:pt x="0" y="3361"/>
                </a:lnTo>
                <a:lnTo>
                  <a:pt x="0" y="3361"/>
                </a:lnTo>
                <a:cubicBezTo>
                  <a:pt x="380" y="3098"/>
                  <a:pt x="840" y="2943"/>
                  <a:pt x="1337" y="2943"/>
                </a:cubicBezTo>
                <a:lnTo>
                  <a:pt x="1337" y="2943"/>
                </a:lnTo>
                <a:cubicBezTo>
                  <a:pt x="1866" y="2943"/>
                  <a:pt x="2354" y="3118"/>
                  <a:pt x="2746"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4" name="Freeform 87">
            <a:extLst>
              <a:ext uri="{FF2B5EF4-FFF2-40B4-BE49-F238E27FC236}">
                <a16:creationId xmlns:a16="http://schemas.microsoft.com/office/drawing/2014/main" id="{6EF25402-CA98-4E30-8D3C-ADB64DF8C0F0}"/>
              </a:ext>
            </a:extLst>
          </p:cNvPr>
          <p:cNvSpPr>
            <a:spLocks noChangeArrowheads="1"/>
          </p:cNvSpPr>
          <p:nvPr/>
        </p:nvSpPr>
        <p:spPr bwMode="auto">
          <a:xfrm>
            <a:off x="5630071" y="2705539"/>
            <a:ext cx="1283647" cy="890106"/>
          </a:xfrm>
          <a:custGeom>
            <a:avLst/>
            <a:gdLst>
              <a:gd name="T0" fmla="*/ 2746 w 2747"/>
              <a:gd name="T1" fmla="*/ 3413 h 3414"/>
              <a:gd name="T2" fmla="*/ 2746 w 2747"/>
              <a:gd name="T3" fmla="*/ 416 h 3414"/>
              <a:gd name="T4" fmla="*/ 2746 w 2747"/>
              <a:gd name="T5" fmla="*/ 416 h 3414"/>
              <a:gd name="T6" fmla="*/ 2330 w 2747"/>
              <a:gd name="T7" fmla="*/ 0 h 3414"/>
              <a:gd name="T8" fmla="*/ 358 w 2747"/>
              <a:gd name="T9" fmla="*/ 0 h 3414"/>
              <a:gd name="T10" fmla="*/ 358 w 2747"/>
              <a:gd name="T11" fmla="*/ 0 h 3414"/>
              <a:gd name="T12" fmla="*/ 0 w 2747"/>
              <a:gd name="T13" fmla="*/ 358 h 3414"/>
              <a:gd name="T14" fmla="*/ 0 w 2747"/>
              <a:gd name="T15" fmla="*/ 3361 h 3414"/>
              <a:gd name="T16" fmla="*/ 0 w 2747"/>
              <a:gd name="T17" fmla="*/ 3361 h 3414"/>
              <a:gd name="T18" fmla="*/ 1336 w 2747"/>
              <a:gd name="T19" fmla="*/ 2943 h 3414"/>
              <a:gd name="T20" fmla="*/ 1336 w 2747"/>
              <a:gd name="T21" fmla="*/ 2943 h 3414"/>
              <a:gd name="T22" fmla="*/ 2746 w 2747"/>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7" h="3414">
                <a:moveTo>
                  <a:pt x="2746" y="3413"/>
                </a:moveTo>
                <a:lnTo>
                  <a:pt x="2746" y="416"/>
                </a:lnTo>
                <a:lnTo>
                  <a:pt x="2746" y="416"/>
                </a:lnTo>
                <a:cubicBezTo>
                  <a:pt x="2746" y="186"/>
                  <a:pt x="2559" y="0"/>
                  <a:pt x="2330" y="0"/>
                </a:cubicBezTo>
                <a:lnTo>
                  <a:pt x="358" y="0"/>
                </a:lnTo>
                <a:lnTo>
                  <a:pt x="358" y="0"/>
                </a:lnTo>
                <a:cubicBezTo>
                  <a:pt x="160" y="0"/>
                  <a:pt x="0" y="160"/>
                  <a:pt x="0" y="358"/>
                </a:cubicBezTo>
                <a:lnTo>
                  <a:pt x="0" y="3361"/>
                </a:lnTo>
                <a:lnTo>
                  <a:pt x="0" y="3361"/>
                </a:lnTo>
                <a:cubicBezTo>
                  <a:pt x="379" y="3098"/>
                  <a:pt x="840" y="2943"/>
                  <a:pt x="1336" y="2943"/>
                </a:cubicBezTo>
                <a:lnTo>
                  <a:pt x="1336" y="2943"/>
                </a:lnTo>
                <a:cubicBezTo>
                  <a:pt x="1865" y="2943"/>
                  <a:pt x="2353" y="3118"/>
                  <a:pt x="2746"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5" name="Freeform 88">
            <a:extLst>
              <a:ext uri="{FF2B5EF4-FFF2-40B4-BE49-F238E27FC236}">
                <a16:creationId xmlns:a16="http://schemas.microsoft.com/office/drawing/2014/main" id="{5A04142E-B117-4114-8144-C49BC7C5357B}"/>
              </a:ext>
            </a:extLst>
          </p:cNvPr>
          <p:cNvSpPr>
            <a:spLocks noChangeArrowheads="1"/>
          </p:cNvSpPr>
          <p:nvPr/>
        </p:nvSpPr>
        <p:spPr bwMode="auto">
          <a:xfrm>
            <a:off x="7303139" y="2731052"/>
            <a:ext cx="1283647" cy="1556896"/>
          </a:xfrm>
          <a:custGeom>
            <a:avLst/>
            <a:gdLst>
              <a:gd name="T0" fmla="*/ 2746 w 2747"/>
              <a:gd name="T1" fmla="*/ 3413 h 3414"/>
              <a:gd name="T2" fmla="*/ 2746 w 2747"/>
              <a:gd name="T3" fmla="*/ 415 h 3414"/>
              <a:gd name="T4" fmla="*/ 2746 w 2747"/>
              <a:gd name="T5" fmla="*/ 415 h 3414"/>
              <a:gd name="T6" fmla="*/ 2331 w 2747"/>
              <a:gd name="T7" fmla="*/ 0 h 3414"/>
              <a:gd name="T8" fmla="*/ 358 w 2747"/>
              <a:gd name="T9" fmla="*/ 0 h 3414"/>
              <a:gd name="T10" fmla="*/ 358 w 2747"/>
              <a:gd name="T11" fmla="*/ 0 h 3414"/>
              <a:gd name="T12" fmla="*/ 0 w 2747"/>
              <a:gd name="T13" fmla="*/ 357 h 3414"/>
              <a:gd name="T14" fmla="*/ 0 w 2747"/>
              <a:gd name="T15" fmla="*/ 3361 h 3414"/>
              <a:gd name="T16" fmla="*/ 0 w 2747"/>
              <a:gd name="T17" fmla="*/ 3361 h 3414"/>
              <a:gd name="T18" fmla="*/ 1338 w 2747"/>
              <a:gd name="T19" fmla="*/ 2943 h 3414"/>
              <a:gd name="T20" fmla="*/ 1338 w 2747"/>
              <a:gd name="T21" fmla="*/ 2943 h 3414"/>
              <a:gd name="T22" fmla="*/ 2746 w 2747"/>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7" h="3414">
                <a:moveTo>
                  <a:pt x="2746" y="3413"/>
                </a:moveTo>
                <a:lnTo>
                  <a:pt x="2746" y="415"/>
                </a:lnTo>
                <a:lnTo>
                  <a:pt x="2746" y="415"/>
                </a:lnTo>
                <a:cubicBezTo>
                  <a:pt x="2746" y="186"/>
                  <a:pt x="2560" y="0"/>
                  <a:pt x="2331" y="0"/>
                </a:cubicBezTo>
                <a:lnTo>
                  <a:pt x="358" y="0"/>
                </a:lnTo>
                <a:lnTo>
                  <a:pt x="358" y="0"/>
                </a:lnTo>
                <a:cubicBezTo>
                  <a:pt x="160" y="0"/>
                  <a:pt x="0" y="160"/>
                  <a:pt x="0" y="357"/>
                </a:cubicBezTo>
                <a:lnTo>
                  <a:pt x="0" y="3361"/>
                </a:lnTo>
                <a:lnTo>
                  <a:pt x="0" y="3361"/>
                </a:lnTo>
                <a:cubicBezTo>
                  <a:pt x="380" y="3097"/>
                  <a:pt x="841" y="2943"/>
                  <a:pt x="1338" y="2943"/>
                </a:cubicBezTo>
                <a:lnTo>
                  <a:pt x="1338" y="2943"/>
                </a:lnTo>
                <a:cubicBezTo>
                  <a:pt x="1866" y="2943"/>
                  <a:pt x="2354" y="3118"/>
                  <a:pt x="2746"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7" name="Freeform 89">
            <a:extLst>
              <a:ext uri="{FF2B5EF4-FFF2-40B4-BE49-F238E27FC236}">
                <a16:creationId xmlns:a16="http://schemas.microsoft.com/office/drawing/2014/main" id="{92C73712-FAA8-4948-92B4-DA31886C5B49}"/>
              </a:ext>
            </a:extLst>
          </p:cNvPr>
          <p:cNvSpPr>
            <a:spLocks noChangeArrowheads="1"/>
          </p:cNvSpPr>
          <p:nvPr/>
        </p:nvSpPr>
        <p:spPr bwMode="auto">
          <a:xfrm>
            <a:off x="3932278" y="2147914"/>
            <a:ext cx="1281586" cy="1159270"/>
          </a:xfrm>
          <a:custGeom>
            <a:avLst/>
            <a:gdLst>
              <a:gd name="T0" fmla="*/ 2744 w 2745"/>
              <a:gd name="T1" fmla="*/ 3413 h 3414"/>
              <a:gd name="T2" fmla="*/ 2744 w 2745"/>
              <a:gd name="T3" fmla="*/ 416 h 3414"/>
              <a:gd name="T4" fmla="*/ 2744 w 2745"/>
              <a:gd name="T5" fmla="*/ 416 h 3414"/>
              <a:gd name="T6" fmla="*/ 2329 w 2745"/>
              <a:gd name="T7" fmla="*/ 0 h 3414"/>
              <a:gd name="T8" fmla="*/ 357 w 2745"/>
              <a:gd name="T9" fmla="*/ 0 h 3414"/>
              <a:gd name="T10" fmla="*/ 357 w 2745"/>
              <a:gd name="T11" fmla="*/ 0 h 3414"/>
              <a:gd name="T12" fmla="*/ 0 w 2745"/>
              <a:gd name="T13" fmla="*/ 358 h 3414"/>
              <a:gd name="T14" fmla="*/ 0 w 2745"/>
              <a:gd name="T15" fmla="*/ 3362 h 3414"/>
              <a:gd name="T16" fmla="*/ 0 w 2745"/>
              <a:gd name="T17" fmla="*/ 3362 h 3414"/>
              <a:gd name="T18" fmla="*/ 1337 w 2745"/>
              <a:gd name="T19" fmla="*/ 2944 h 3414"/>
              <a:gd name="T20" fmla="*/ 1337 w 2745"/>
              <a:gd name="T21" fmla="*/ 2944 h 3414"/>
              <a:gd name="T22" fmla="*/ 2744 w 2745"/>
              <a:gd name="T23" fmla="*/ 3413 h 34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745" h="3414">
                <a:moveTo>
                  <a:pt x="2744" y="3413"/>
                </a:moveTo>
                <a:lnTo>
                  <a:pt x="2744" y="416"/>
                </a:lnTo>
                <a:lnTo>
                  <a:pt x="2744" y="416"/>
                </a:lnTo>
                <a:cubicBezTo>
                  <a:pt x="2744" y="186"/>
                  <a:pt x="2558" y="0"/>
                  <a:pt x="2329" y="0"/>
                </a:cubicBezTo>
                <a:lnTo>
                  <a:pt x="357" y="0"/>
                </a:lnTo>
                <a:lnTo>
                  <a:pt x="357" y="0"/>
                </a:lnTo>
                <a:cubicBezTo>
                  <a:pt x="160" y="0"/>
                  <a:pt x="0" y="161"/>
                  <a:pt x="0" y="358"/>
                </a:cubicBezTo>
                <a:lnTo>
                  <a:pt x="0" y="3362"/>
                </a:lnTo>
                <a:lnTo>
                  <a:pt x="0" y="3362"/>
                </a:lnTo>
                <a:cubicBezTo>
                  <a:pt x="379" y="3098"/>
                  <a:pt x="840" y="2944"/>
                  <a:pt x="1337" y="2944"/>
                </a:cubicBezTo>
                <a:lnTo>
                  <a:pt x="1337" y="2944"/>
                </a:lnTo>
                <a:cubicBezTo>
                  <a:pt x="1864" y="2944"/>
                  <a:pt x="2352" y="3118"/>
                  <a:pt x="2744" y="3413"/>
                </a:cubicBezTo>
              </a:path>
            </a:pathLst>
          </a:custGeom>
          <a:solidFill>
            <a:schemeClr val="bg1">
              <a:lumMod val="75000"/>
              <a:alpha val="15000"/>
            </a:schemeClr>
          </a:solidFill>
          <a:ln>
            <a:noFill/>
          </a:ln>
          <a:effectLst/>
        </p:spPr>
        <p:txBody>
          <a:bodyPr wrap="none" anchor="ctr"/>
          <a:lstStyle/>
          <a:p>
            <a:endParaRPr lang="en-US" sz="1350">
              <a:latin typeface="+mj-lt"/>
            </a:endParaRPr>
          </a:p>
        </p:txBody>
      </p:sp>
      <p:sp>
        <p:nvSpPr>
          <p:cNvPr id="98" name="TextBox 97">
            <a:extLst>
              <a:ext uri="{FF2B5EF4-FFF2-40B4-BE49-F238E27FC236}">
                <a16:creationId xmlns:a16="http://schemas.microsoft.com/office/drawing/2014/main" id="{1881009A-AC4B-4615-BD56-7C2271DD3E1A}"/>
              </a:ext>
            </a:extLst>
          </p:cNvPr>
          <p:cNvSpPr txBox="1"/>
          <p:nvPr/>
        </p:nvSpPr>
        <p:spPr>
          <a:xfrm>
            <a:off x="3800253" y="4867974"/>
            <a:ext cx="1608827" cy="484748"/>
          </a:xfrm>
          <a:prstGeom prst="rect">
            <a:avLst/>
          </a:prstGeom>
          <a:noFill/>
        </p:spPr>
        <p:txBody>
          <a:bodyPr wrap="square" rtlCol="0" anchor="ctr">
            <a:spAutoFit/>
          </a:bodyPr>
          <a:lstStyle/>
          <a:p>
            <a:pPr algn="ctr"/>
            <a:r>
              <a:rPr lang="en-US" sz="1275" b="1" spc="-11">
                <a:solidFill>
                  <a:schemeClr val="bg1">
                    <a:lumMod val="50000"/>
                  </a:schemeClr>
                </a:solidFill>
                <a:latin typeface="+mj-lt"/>
                <a:cs typeface="Poppins" panose="00000500000000000000" pitchFamily="2" charset="0"/>
              </a:rPr>
              <a:t>AREAS OF IMPROVEMENT</a:t>
            </a:r>
          </a:p>
        </p:txBody>
      </p:sp>
      <p:sp>
        <p:nvSpPr>
          <p:cNvPr id="99" name="TextBox 98">
            <a:extLst>
              <a:ext uri="{FF2B5EF4-FFF2-40B4-BE49-F238E27FC236}">
                <a16:creationId xmlns:a16="http://schemas.microsoft.com/office/drawing/2014/main" id="{FABCD218-6E14-4AB5-8317-0C49B6433658}"/>
              </a:ext>
            </a:extLst>
          </p:cNvPr>
          <p:cNvSpPr txBox="1"/>
          <p:nvPr/>
        </p:nvSpPr>
        <p:spPr>
          <a:xfrm>
            <a:off x="503808" y="4320795"/>
            <a:ext cx="1401997" cy="276999"/>
          </a:xfrm>
          <a:prstGeom prst="rect">
            <a:avLst/>
          </a:prstGeom>
          <a:noFill/>
        </p:spPr>
        <p:txBody>
          <a:bodyPr wrap="square" rtlCol="0" anchor="ctr">
            <a:spAutoFit/>
          </a:bodyPr>
          <a:lstStyle/>
          <a:p>
            <a:pPr algn="ctr"/>
            <a:r>
              <a:rPr lang="en-US" sz="1200" b="1" spc="-11">
                <a:solidFill>
                  <a:schemeClr val="bg1"/>
                </a:solidFill>
                <a:latin typeface="+mj-lt"/>
                <a:cs typeface="Poppins" panose="00000500000000000000" pitchFamily="2" charset="0"/>
              </a:rPr>
              <a:t>COMMUNICATION</a:t>
            </a:r>
          </a:p>
        </p:txBody>
      </p:sp>
      <p:sp>
        <p:nvSpPr>
          <p:cNvPr id="100" name="TextBox 99">
            <a:extLst>
              <a:ext uri="{FF2B5EF4-FFF2-40B4-BE49-F238E27FC236}">
                <a16:creationId xmlns:a16="http://schemas.microsoft.com/office/drawing/2014/main" id="{A0655893-0BF9-43AE-AB96-68995F31142A}"/>
              </a:ext>
            </a:extLst>
          </p:cNvPr>
          <p:cNvSpPr txBox="1"/>
          <p:nvPr/>
        </p:nvSpPr>
        <p:spPr>
          <a:xfrm>
            <a:off x="645775" y="2910250"/>
            <a:ext cx="1135904" cy="974754"/>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Better communication before research activities, and of final research learnings</a:t>
            </a:r>
          </a:p>
        </p:txBody>
      </p:sp>
      <p:sp>
        <p:nvSpPr>
          <p:cNvPr id="101" name="TextBox 100">
            <a:extLst>
              <a:ext uri="{FF2B5EF4-FFF2-40B4-BE49-F238E27FC236}">
                <a16:creationId xmlns:a16="http://schemas.microsoft.com/office/drawing/2014/main" id="{10498E5E-7735-4C23-952C-915CD73C0385}"/>
              </a:ext>
            </a:extLst>
          </p:cNvPr>
          <p:cNvSpPr txBox="1"/>
          <p:nvPr/>
        </p:nvSpPr>
        <p:spPr>
          <a:xfrm>
            <a:off x="2325748" y="3629221"/>
            <a:ext cx="1135903" cy="288541"/>
          </a:xfrm>
          <a:prstGeom prst="rect">
            <a:avLst/>
          </a:prstGeom>
          <a:noFill/>
        </p:spPr>
        <p:txBody>
          <a:bodyPr wrap="square" rtlCol="0" anchor="ctr">
            <a:spAutoFit/>
          </a:bodyPr>
          <a:lstStyle/>
          <a:p>
            <a:pPr algn="ctr"/>
            <a:r>
              <a:rPr lang="en-US" sz="1275" b="1" spc="-11">
                <a:solidFill>
                  <a:schemeClr val="bg1"/>
                </a:solidFill>
                <a:latin typeface="+mj-lt"/>
                <a:cs typeface="Poppins" panose="00000500000000000000" pitchFamily="2" charset="0"/>
              </a:rPr>
              <a:t>DIVERSITY</a:t>
            </a:r>
          </a:p>
        </p:txBody>
      </p:sp>
      <p:sp>
        <p:nvSpPr>
          <p:cNvPr id="102" name="TextBox 101">
            <a:extLst>
              <a:ext uri="{FF2B5EF4-FFF2-40B4-BE49-F238E27FC236}">
                <a16:creationId xmlns:a16="http://schemas.microsoft.com/office/drawing/2014/main" id="{D18C9A4A-48FC-4E7D-A8DB-100653C6540A}"/>
              </a:ext>
            </a:extLst>
          </p:cNvPr>
          <p:cNvSpPr txBox="1"/>
          <p:nvPr/>
        </p:nvSpPr>
        <p:spPr>
          <a:xfrm>
            <a:off x="2325748" y="2016171"/>
            <a:ext cx="1135904" cy="1333827"/>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More diversity of young people from all backgrounds (culture, where people live, income/occupation, </a:t>
            </a:r>
            <a:r>
              <a:rPr lang="en-US" sz="900" spc="-8" err="1">
                <a:latin typeface="+mj-lt"/>
                <a:cs typeface="Poppins" panose="00000500000000000000" pitchFamily="2" charset="0"/>
              </a:rPr>
              <a:t>etc</a:t>
            </a:r>
            <a:r>
              <a:rPr lang="en-US" sz="900" spc="-8">
                <a:latin typeface="+mj-lt"/>
                <a:cs typeface="Poppins" panose="00000500000000000000" pitchFamily="2" charset="0"/>
              </a:rPr>
              <a:t>)</a:t>
            </a:r>
          </a:p>
        </p:txBody>
      </p:sp>
      <p:sp>
        <p:nvSpPr>
          <p:cNvPr id="103" name="TextBox 102">
            <a:extLst>
              <a:ext uri="{FF2B5EF4-FFF2-40B4-BE49-F238E27FC236}">
                <a16:creationId xmlns:a16="http://schemas.microsoft.com/office/drawing/2014/main" id="{8746DBF3-577F-4828-8DA1-843BDFF8B4A9}"/>
              </a:ext>
            </a:extLst>
          </p:cNvPr>
          <p:cNvSpPr txBox="1"/>
          <p:nvPr/>
        </p:nvSpPr>
        <p:spPr>
          <a:xfrm>
            <a:off x="3937430" y="3319632"/>
            <a:ext cx="1281584" cy="288541"/>
          </a:xfrm>
          <a:prstGeom prst="rect">
            <a:avLst/>
          </a:prstGeom>
          <a:noFill/>
        </p:spPr>
        <p:txBody>
          <a:bodyPr wrap="square" rtlCol="0" anchor="ctr">
            <a:spAutoFit/>
          </a:bodyPr>
          <a:lstStyle/>
          <a:p>
            <a:pPr algn="ctr"/>
            <a:r>
              <a:rPr lang="en-US" sz="1275" b="1" spc="-11">
                <a:solidFill>
                  <a:schemeClr val="bg1"/>
                </a:solidFill>
                <a:latin typeface="+mj-lt"/>
                <a:cs typeface="Poppins" panose="00000500000000000000" pitchFamily="2" charset="0"/>
              </a:rPr>
              <a:t>ORGANISATION</a:t>
            </a:r>
          </a:p>
        </p:txBody>
      </p:sp>
      <p:sp>
        <p:nvSpPr>
          <p:cNvPr id="108" name="TextBox 107">
            <a:extLst>
              <a:ext uri="{FF2B5EF4-FFF2-40B4-BE49-F238E27FC236}">
                <a16:creationId xmlns:a16="http://schemas.microsoft.com/office/drawing/2014/main" id="{501EA496-7C42-44F0-B647-2935D4331678}"/>
              </a:ext>
            </a:extLst>
          </p:cNvPr>
          <p:cNvSpPr txBox="1"/>
          <p:nvPr/>
        </p:nvSpPr>
        <p:spPr>
          <a:xfrm>
            <a:off x="3998029" y="2417079"/>
            <a:ext cx="1135904" cy="436145"/>
          </a:xfrm>
          <a:prstGeom prst="rect">
            <a:avLst/>
          </a:prstGeom>
          <a:noFill/>
        </p:spPr>
        <p:txBody>
          <a:bodyPr wrap="square" rtlCol="0" anchor="ctr">
            <a:spAutoFit/>
          </a:bodyPr>
          <a:lstStyle/>
          <a:p>
            <a:pPr algn="ctr">
              <a:lnSpc>
                <a:spcPts val="1350"/>
              </a:lnSpc>
            </a:pPr>
            <a:r>
              <a:rPr lang="en-US" sz="900" spc="-8">
                <a:latin typeface="+mj-lt"/>
                <a:cs typeface="Poppins" panose="00000500000000000000" pitchFamily="2" charset="0"/>
              </a:rPr>
              <a:t>Better </a:t>
            </a:r>
            <a:r>
              <a:rPr lang="en-US" sz="900" spc="-8" err="1">
                <a:latin typeface="+mj-lt"/>
                <a:cs typeface="Poppins" panose="00000500000000000000" pitchFamily="2" charset="0"/>
              </a:rPr>
              <a:t>organisation</a:t>
            </a:r>
            <a:r>
              <a:rPr lang="en-US" sz="900" spc="-8">
                <a:latin typeface="+mj-lt"/>
                <a:cs typeface="Poppins" panose="00000500000000000000" pitchFamily="2" charset="0"/>
              </a:rPr>
              <a:t> of research activities</a:t>
            </a:r>
          </a:p>
        </p:txBody>
      </p:sp>
      <p:sp>
        <p:nvSpPr>
          <p:cNvPr id="109" name="TextBox 108">
            <a:extLst>
              <a:ext uri="{FF2B5EF4-FFF2-40B4-BE49-F238E27FC236}">
                <a16:creationId xmlns:a16="http://schemas.microsoft.com/office/drawing/2014/main" id="{467FB290-A875-4840-9875-ED489406C9F2}"/>
              </a:ext>
            </a:extLst>
          </p:cNvPr>
          <p:cNvSpPr txBox="1"/>
          <p:nvPr/>
        </p:nvSpPr>
        <p:spPr>
          <a:xfrm>
            <a:off x="5695003" y="3531118"/>
            <a:ext cx="1135903" cy="484748"/>
          </a:xfrm>
          <a:prstGeom prst="rect">
            <a:avLst/>
          </a:prstGeom>
          <a:noFill/>
        </p:spPr>
        <p:txBody>
          <a:bodyPr wrap="square" rtlCol="0" anchor="ctr">
            <a:spAutoFit/>
          </a:bodyPr>
          <a:lstStyle/>
          <a:p>
            <a:pPr algn="ctr"/>
            <a:r>
              <a:rPr lang="en-US" sz="1275" b="1" spc="-11">
                <a:solidFill>
                  <a:schemeClr val="bg1"/>
                </a:solidFill>
                <a:latin typeface="+mj-lt"/>
                <a:cs typeface="Poppins" panose="00000500000000000000" pitchFamily="2" charset="0"/>
              </a:rPr>
              <a:t>ENGAGING ACTIVITIES </a:t>
            </a:r>
          </a:p>
        </p:txBody>
      </p:sp>
      <p:sp>
        <p:nvSpPr>
          <p:cNvPr id="114" name="TextBox 113">
            <a:extLst>
              <a:ext uri="{FF2B5EF4-FFF2-40B4-BE49-F238E27FC236}">
                <a16:creationId xmlns:a16="http://schemas.microsoft.com/office/drawing/2014/main" id="{A0541818-56FD-430F-BAAE-C3F0E547F923}"/>
              </a:ext>
            </a:extLst>
          </p:cNvPr>
          <p:cNvSpPr txBox="1"/>
          <p:nvPr/>
        </p:nvSpPr>
        <p:spPr>
          <a:xfrm>
            <a:off x="5702459" y="2750696"/>
            <a:ext cx="1135904" cy="615681"/>
          </a:xfrm>
          <a:prstGeom prst="rect">
            <a:avLst/>
          </a:prstGeom>
          <a:noFill/>
        </p:spPr>
        <p:txBody>
          <a:bodyPr wrap="square" rtlCol="0" anchor="ctr">
            <a:spAutoFit/>
          </a:bodyPr>
          <a:lstStyle/>
          <a:p>
            <a:pPr algn="ctr">
              <a:lnSpc>
                <a:spcPts val="1350"/>
              </a:lnSpc>
            </a:pPr>
            <a:r>
              <a:rPr lang="en-US" sz="900" spc="-8" dirty="0">
                <a:latin typeface="+mj-lt"/>
                <a:cs typeface="Poppins" panose="00000500000000000000" pitchFamily="2" charset="0"/>
              </a:rPr>
              <a:t>Having a variety of tasks to keep the group engaged</a:t>
            </a:r>
          </a:p>
        </p:txBody>
      </p:sp>
      <p:sp>
        <p:nvSpPr>
          <p:cNvPr id="115" name="TextBox 114">
            <a:extLst>
              <a:ext uri="{FF2B5EF4-FFF2-40B4-BE49-F238E27FC236}">
                <a16:creationId xmlns:a16="http://schemas.microsoft.com/office/drawing/2014/main" id="{3A30BAD5-FEAF-47A8-BB90-E6BA645F90C7}"/>
              </a:ext>
            </a:extLst>
          </p:cNvPr>
          <p:cNvSpPr txBox="1"/>
          <p:nvPr/>
        </p:nvSpPr>
        <p:spPr>
          <a:xfrm>
            <a:off x="7376827" y="4229682"/>
            <a:ext cx="1135903" cy="484748"/>
          </a:xfrm>
          <a:prstGeom prst="rect">
            <a:avLst/>
          </a:prstGeom>
          <a:noFill/>
        </p:spPr>
        <p:txBody>
          <a:bodyPr wrap="square" rtlCol="0" anchor="ctr">
            <a:spAutoFit/>
          </a:bodyPr>
          <a:lstStyle/>
          <a:p>
            <a:pPr algn="ctr"/>
            <a:r>
              <a:rPr lang="en-US" sz="1275" b="1" spc="-11">
                <a:solidFill>
                  <a:schemeClr val="bg1"/>
                </a:solidFill>
                <a:latin typeface="+mj-lt"/>
                <a:cs typeface="Poppins" panose="00000500000000000000" pitchFamily="2" charset="0"/>
              </a:rPr>
              <a:t>CONSUMER-LED</a:t>
            </a:r>
          </a:p>
        </p:txBody>
      </p:sp>
      <p:sp>
        <p:nvSpPr>
          <p:cNvPr id="116" name="TextBox 115">
            <a:extLst>
              <a:ext uri="{FF2B5EF4-FFF2-40B4-BE49-F238E27FC236}">
                <a16:creationId xmlns:a16="http://schemas.microsoft.com/office/drawing/2014/main" id="{EBF52669-1F24-488D-B67E-3930E18BDFBE}"/>
              </a:ext>
            </a:extLst>
          </p:cNvPr>
          <p:cNvSpPr txBox="1"/>
          <p:nvPr/>
        </p:nvSpPr>
        <p:spPr>
          <a:xfrm>
            <a:off x="7376827" y="3089786"/>
            <a:ext cx="1135904" cy="615681"/>
          </a:xfrm>
          <a:prstGeom prst="rect">
            <a:avLst/>
          </a:prstGeom>
          <a:noFill/>
        </p:spPr>
        <p:txBody>
          <a:bodyPr wrap="square" rtlCol="0" anchor="ctr">
            <a:spAutoFit/>
          </a:bodyPr>
          <a:lstStyle/>
          <a:p>
            <a:pPr algn="ctr">
              <a:lnSpc>
                <a:spcPts val="1350"/>
              </a:lnSpc>
            </a:pPr>
            <a:r>
              <a:rPr lang="en-US" sz="900" spc="-8" dirty="0">
                <a:latin typeface="+mj-lt"/>
                <a:cs typeface="Poppins" panose="00000500000000000000" pitchFamily="2" charset="0"/>
              </a:rPr>
              <a:t>Having opportunities where young people can lead</a:t>
            </a:r>
          </a:p>
        </p:txBody>
      </p:sp>
      <p:sp>
        <p:nvSpPr>
          <p:cNvPr id="117" name="Freeform 16">
            <a:extLst>
              <a:ext uri="{FF2B5EF4-FFF2-40B4-BE49-F238E27FC236}">
                <a16:creationId xmlns:a16="http://schemas.microsoft.com/office/drawing/2014/main" id="{DA9C14B9-3DDB-4C9E-BFCA-1D1CA1E790AB}"/>
              </a:ext>
            </a:extLst>
          </p:cNvPr>
          <p:cNvSpPr/>
          <p:nvPr/>
        </p:nvSpPr>
        <p:spPr>
          <a:xfrm>
            <a:off x="1199920" y="4867975"/>
            <a:ext cx="233857" cy="459917"/>
          </a:xfrm>
          <a:custGeom>
            <a:avLst/>
            <a:gdLst>
              <a:gd name="connsiteX0" fmla="*/ 0 w 623455"/>
              <a:gd name="connsiteY0" fmla="*/ 0 h 1226127"/>
              <a:gd name="connsiteX1" fmla="*/ 0 w 623455"/>
              <a:gd name="connsiteY1" fmla="*/ 0 h 1226127"/>
              <a:gd name="connsiteX2" fmla="*/ 10391 w 623455"/>
              <a:gd name="connsiteY2" fmla="*/ 1101436 h 1226127"/>
              <a:gd name="connsiteX3" fmla="*/ 623455 w 623455"/>
              <a:gd name="connsiteY3" fmla="*/ 1226127 h 1226127"/>
            </a:gdLst>
            <a:ahLst/>
            <a:cxnLst>
              <a:cxn ang="0">
                <a:pos x="connsiteX0" y="connsiteY0"/>
              </a:cxn>
              <a:cxn ang="0">
                <a:pos x="connsiteX1" y="connsiteY1"/>
              </a:cxn>
              <a:cxn ang="0">
                <a:pos x="connsiteX2" y="connsiteY2"/>
              </a:cxn>
              <a:cxn ang="0">
                <a:pos x="connsiteX3" y="connsiteY3"/>
              </a:cxn>
            </a:cxnLst>
            <a:rect l="l" t="t" r="r" b="b"/>
            <a:pathLst>
              <a:path w="623455" h="1226127">
                <a:moveTo>
                  <a:pt x="0" y="0"/>
                </a:moveTo>
                <a:lnTo>
                  <a:pt x="0" y="0"/>
                </a:lnTo>
                <a:cubicBezTo>
                  <a:pt x="3464" y="367145"/>
                  <a:pt x="6927" y="734291"/>
                  <a:pt x="10391" y="1101436"/>
                </a:cubicBezTo>
                <a:lnTo>
                  <a:pt x="623455" y="1226127"/>
                </a:lnTo>
              </a:path>
            </a:pathLst>
          </a:cu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cxnSp>
        <p:nvCxnSpPr>
          <p:cNvPr id="118" name="Straight Connector 117">
            <a:extLst>
              <a:ext uri="{FF2B5EF4-FFF2-40B4-BE49-F238E27FC236}">
                <a16:creationId xmlns:a16="http://schemas.microsoft.com/office/drawing/2014/main" id="{77306D67-E43A-4F45-856A-480F463CCEF5}"/>
              </a:ext>
            </a:extLst>
          </p:cNvPr>
          <p:cNvCxnSpPr>
            <a:cxnSpLocks/>
          </p:cNvCxnSpPr>
          <p:nvPr/>
        </p:nvCxnSpPr>
        <p:spPr>
          <a:xfrm>
            <a:off x="4571151" y="3909163"/>
            <a:ext cx="0" cy="856123"/>
          </a:xfrm>
          <a:prstGeom prst="line">
            <a:avLst/>
          </a:pr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119" name="Freeform 17">
            <a:extLst>
              <a:ext uri="{FF2B5EF4-FFF2-40B4-BE49-F238E27FC236}">
                <a16:creationId xmlns:a16="http://schemas.microsoft.com/office/drawing/2014/main" id="{368D9133-401D-44BB-BB14-98D2BDC0C2A8}"/>
              </a:ext>
            </a:extLst>
          </p:cNvPr>
          <p:cNvSpPr/>
          <p:nvPr/>
        </p:nvSpPr>
        <p:spPr>
          <a:xfrm>
            <a:off x="2889629" y="4141190"/>
            <a:ext cx="237927" cy="726784"/>
          </a:xfrm>
          <a:custGeom>
            <a:avLst/>
            <a:gdLst>
              <a:gd name="connsiteX0" fmla="*/ 0 w 623455"/>
              <a:gd name="connsiteY0" fmla="*/ 0 h 1226127"/>
              <a:gd name="connsiteX1" fmla="*/ 0 w 623455"/>
              <a:gd name="connsiteY1" fmla="*/ 0 h 1226127"/>
              <a:gd name="connsiteX2" fmla="*/ 10391 w 623455"/>
              <a:gd name="connsiteY2" fmla="*/ 1101436 h 1226127"/>
              <a:gd name="connsiteX3" fmla="*/ 623455 w 623455"/>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Lst>
            <a:ahLst/>
            <a:cxnLst>
              <a:cxn ang="0">
                <a:pos x="connsiteX0" y="connsiteY0"/>
              </a:cxn>
              <a:cxn ang="0">
                <a:pos x="connsiteX1" y="connsiteY1"/>
              </a:cxn>
              <a:cxn ang="0">
                <a:pos x="connsiteX2" y="connsiteY2"/>
              </a:cxn>
              <a:cxn ang="0">
                <a:pos x="connsiteX3" y="connsiteY3"/>
              </a:cxn>
            </a:cxnLst>
            <a:rect l="l" t="t" r="r" b="b"/>
            <a:pathLst>
              <a:path w="634306" h="1226127">
                <a:moveTo>
                  <a:pt x="10851" y="0"/>
                </a:moveTo>
                <a:lnTo>
                  <a:pt x="10851" y="0"/>
                </a:lnTo>
                <a:cubicBezTo>
                  <a:pt x="14315" y="367145"/>
                  <a:pt x="-3004" y="399675"/>
                  <a:pt x="460" y="766820"/>
                </a:cubicBezTo>
                <a:cubicBezTo>
                  <a:pt x="163251" y="880087"/>
                  <a:pt x="492296" y="1106884"/>
                  <a:pt x="634306" y="1226127"/>
                </a:cubicBezTo>
              </a:path>
            </a:pathLst>
          </a:cu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120" name="Freeform 21">
            <a:extLst>
              <a:ext uri="{FF2B5EF4-FFF2-40B4-BE49-F238E27FC236}">
                <a16:creationId xmlns:a16="http://schemas.microsoft.com/office/drawing/2014/main" id="{061E4784-FD6C-49F5-B0D1-98AD70D44DEC}"/>
              </a:ext>
            </a:extLst>
          </p:cNvPr>
          <p:cNvSpPr/>
          <p:nvPr/>
        </p:nvSpPr>
        <p:spPr>
          <a:xfrm flipH="1">
            <a:off x="6025027" y="4141190"/>
            <a:ext cx="237927" cy="726784"/>
          </a:xfrm>
          <a:custGeom>
            <a:avLst/>
            <a:gdLst>
              <a:gd name="connsiteX0" fmla="*/ 0 w 623455"/>
              <a:gd name="connsiteY0" fmla="*/ 0 h 1226127"/>
              <a:gd name="connsiteX1" fmla="*/ 0 w 623455"/>
              <a:gd name="connsiteY1" fmla="*/ 0 h 1226127"/>
              <a:gd name="connsiteX2" fmla="*/ 10391 w 623455"/>
              <a:gd name="connsiteY2" fmla="*/ 1101436 h 1226127"/>
              <a:gd name="connsiteX3" fmla="*/ 623455 w 623455"/>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 name="connsiteX0" fmla="*/ 10851 w 634306"/>
              <a:gd name="connsiteY0" fmla="*/ 0 h 1226127"/>
              <a:gd name="connsiteX1" fmla="*/ 10851 w 634306"/>
              <a:gd name="connsiteY1" fmla="*/ 0 h 1226127"/>
              <a:gd name="connsiteX2" fmla="*/ 460 w 634306"/>
              <a:gd name="connsiteY2" fmla="*/ 766820 h 1226127"/>
              <a:gd name="connsiteX3" fmla="*/ 634306 w 634306"/>
              <a:gd name="connsiteY3" fmla="*/ 1226127 h 1226127"/>
            </a:gdLst>
            <a:ahLst/>
            <a:cxnLst>
              <a:cxn ang="0">
                <a:pos x="connsiteX0" y="connsiteY0"/>
              </a:cxn>
              <a:cxn ang="0">
                <a:pos x="connsiteX1" y="connsiteY1"/>
              </a:cxn>
              <a:cxn ang="0">
                <a:pos x="connsiteX2" y="connsiteY2"/>
              </a:cxn>
              <a:cxn ang="0">
                <a:pos x="connsiteX3" y="connsiteY3"/>
              </a:cxn>
            </a:cxnLst>
            <a:rect l="l" t="t" r="r" b="b"/>
            <a:pathLst>
              <a:path w="634306" h="1226127">
                <a:moveTo>
                  <a:pt x="10851" y="0"/>
                </a:moveTo>
                <a:lnTo>
                  <a:pt x="10851" y="0"/>
                </a:lnTo>
                <a:cubicBezTo>
                  <a:pt x="14315" y="367145"/>
                  <a:pt x="-3004" y="399675"/>
                  <a:pt x="460" y="766820"/>
                </a:cubicBezTo>
                <a:cubicBezTo>
                  <a:pt x="163251" y="880087"/>
                  <a:pt x="492296" y="1106884"/>
                  <a:pt x="634306" y="1226127"/>
                </a:cubicBezTo>
              </a:path>
            </a:pathLst>
          </a:cu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sp>
        <p:nvSpPr>
          <p:cNvPr id="121" name="Freeform 22">
            <a:extLst>
              <a:ext uri="{FF2B5EF4-FFF2-40B4-BE49-F238E27FC236}">
                <a16:creationId xmlns:a16="http://schemas.microsoft.com/office/drawing/2014/main" id="{696935E0-1D76-4CF2-91FE-CE17F111B991}"/>
              </a:ext>
            </a:extLst>
          </p:cNvPr>
          <p:cNvSpPr/>
          <p:nvPr/>
        </p:nvSpPr>
        <p:spPr>
          <a:xfrm flipH="1">
            <a:off x="7710922" y="4867975"/>
            <a:ext cx="233857" cy="459917"/>
          </a:xfrm>
          <a:custGeom>
            <a:avLst/>
            <a:gdLst>
              <a:gd name="connsiteX0" fmla="*/ 0 w 623455"/>
              <a:gd name="connsiteY0" fmla="*/ 0 h 1226127"/>
              <a:gd name="connsiteX1" fmla="*/ 0 w 623455"/>
              <a:gd name="connsiteY1" fmla="*/ 0 h 1226127"/>
              <a:gd name="connsiteX2" fmla="*/ 10391 w 623455"/>
              <a:gd name="connsiteY2" fmla="*/ 1101436 h 1226127"/>
              <a:gd name="connsiteX3" fmla="*/ 623455 w 623455"/>
              <a:gd name="connsiteY3" fmla="*/ 1226127 h 1226127"/>
            </a:gdLst>
            <a:ahLst/>
            <a:cxnLst>
              <a:cxn ang="0">
                <a:pos x="connsiteX0" y="connsiteY0"/>
              </a:cxn>
              <a:cxn ang="0">
                <a:pos x="connsiteX1" y="connsiteY1"/>
              </a:cxn>
              <a:cxn ang="0">
                <a:pos x="connsiteX2" y="connsiteY2"/>
              </a:cxn>
              <a:cxn ang="0">
                <a:pos x="connsiteX3" y="connsiteY3"/>
              </a:cxn>
            </a:cxnLst>
            <a:rect l="l" t="t" r="r" b="b"/>
            <a:pathLst>
              <a:path w="623455" h="1226127">
                <a:moveTo>
                  <a:pt x="0" y="0"/>
                </a:moveTo>
                <a:lnTo>
                  <a:pt x="0" y="0"/>
                </a:lnTo>
                <a:cubicBezTo>
                  <a:pt x="3464" y="367145"/>
                  <a:pt x="6927" y="734291"/>
                  <a:pt x="10391" y="1101436"/>
                </a:cubicBezTo>
                <a:lnTo>
                  <a:pt x="623455" y="1226127"/>
                </a:lnTo>
              </a:path>
            </a:pathLst>
          </a:cu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cxnSp>
        <p:nvCxnSpPr>
          <p:cNvPr id="138" name="Straight Connector 137">
            <a:extLst>
              <a:ext uri="{FF2B5EF4-FFF2-40B4-BE49-F238E27FC236}">
                <a16:creationId xmlns:a16="http://schemas.microsoft.com/office/drawing/2014/main" id="{9959127E-055C-4B8D-AE54-60BEBE6FB27F}"/>
              </a:ext>
            </a:extLst>
          </p:cNvPr>
          <p:cNvCxnSpPr>
            <a:cxnSpLocks/>
            <a:endCxn id="114" idx="0"/>
          </p:cNvCxnSpPr>
          <p:nvPr/>
        </p:nvCxnSpPr>
        <p:spPr>
          <a:xfrm>
            <a:off x="6269836" y="2516663"/>
            <a:ext cx="575" cy="234033"/>
          </a:xfrm>
          <a:prstGeom prst="line">
            <a:avLst/>
          </a:pr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142" name="TextBox 141">
            <a:extLst>
              <a:ext uri="{FF2B5EF4-FFF2-40B4-BE49-F238E27FC236}">
                <a16:creationId xmlns:a16="http://schemas.microsoft.com/office/drawing/2014/main" id="{86B23B6A-5700-4425-B4D0-EAA428DDD848}"/>
              </a:ext>
            </a:extLst>
          </p:cNvPr>
          <p:cNvSpPr txBox="1"/>
          <p:nvPr/>
        </p:nvSpPr>
        <p:spPr>
          <a:xfrm>
            <a:off x="5702459" y="993445"/>
            <a:ext cx="2835097" cy="1333827"/>
          </a:xfrm>
          <a:prstGeom prst="rect">
            <a:avLst/>
          </a:prstGeom>
          <a:noFill/>
        </p:spPr>
        <p:txBody>
          <a:bodyPr wrap="square" rtlCol="0" anchor="ctr">
            <a:spAutoFit/>
          </a:bodyPr>
          <a:lstStyle/>
          <a:p>
            <a:pPr algn="ctr">
              <a:lnSpc>
                <a:spcPts val="1350"/>
              </a:lnSpc>
            </a:pPr>
            <a:r>
              <a:rPr lang="en-US" sz="900" b="1" i="1" spc="-8" dirty="0">
                <a:latin typeface="+mj-lt"/>
                <a:cs typeface="Poppins" panose="00000500000000000000" pitchFamily="2" charset="0"/>
              </a:rPr>
              <a:t>Commitment to not just have researchers present to the Group, to ensure that there are dedicated activities that are led by the Working Group.</a:t>
            </a:r>
          </a:p>
          <a:p>
            <a:pPr algn="ctr">
              <a:lnSpc>
                <a:spcPts val="1350"/>
              </a:lnSpc>
            </a:pPr>
            <a:r>
              <a:rPr lang="en-US" sz="900" b="1" i="1" spc="-8" dirty="0">
                <a:latin typeface="+mj-lt"/>
                <a:cs typeface="Poppins" panose="00000500000000000000" pitchFamily="2" charset="0"/>
              </a:rPr>
              <a:t>Examples of other activities discussed:</a:t>
            </a:r>
          </a:p>
          <a:p>
            <a:pPr marL="228600" indent="-228600" algn="ctr">
              <a:lnSpc>
                <a:spcPts val="1350"/>
              </a:lnSpc>
              <a:buAutoNum type="arabicPeriod"/>
            </a:pPr>
            <a:r>
              <a:rPr lang="en-US" sz="900" b="1" i="1" spc="-8" dirty="0" err="1">
                <a:latin typeface="+mj-lt"/>
                <a:cs typeface="Poppins" panose="00000500000000000000" pitchFamily="2" charset="0"/>
              </a:rPr>
              <a:t>Organise</a:t>
            </a:r>
            <a:r>
              <a:rPr lang="en-US" sz="900" b="1" i="1" spc="-8" dirty="0">
                <a:latin typeface="+mj-lt"/>
                <a:cs typeface="Poppins" panose="00000500000000000000" pitchFamily="2" charset="0"/>
              </a:rPr>
              <a:t> a webinar</a:t>
            </a:r>
          </a:p>
          <a:p>
            <a:pPr marL="228600" indent="-228600" algn="ctr">
              <a:lnSpc>
                <a:spcPts val="1350"/>
              </a:lnSpc>
              <a:buAutoNum type="arabicPeriod"/>
            </a:pPr>
            <a:r>
              <a:rPr lang="en-US" sz="900" b="1" i="1" spc="-8" dirty="0">
                <a:latin typeface="+mj-lt"/>
                <a:cs typeface="Poppins" panose="00000500000000000000" pitchFamily="2" charset="0"/>
              </a:rPr>
              <a:t>Record a podcast</a:t>
            </a:r>
          </a:p>
          <a:p>
            <a:pPr marL="228600" indent="-228600" algn="ctr">
              <a:lnSpc>
                <a:spcPts val="1350"/>
              </a:lnSpc>
              <a:buAutoNum type="arabicPeriod"/>
            </a:pPr>
            <a:r>
              <a:rPr lang="en-US" sz="900" b="1" i="1" spc="-8" dirty="0">
                <a:latin typeface="+mj-lt"/>
                <a:cs typeface="Poppins" panose="00000500000000000000" pitchFamily="2" charset="0"/>
              </a:rPr>
              <a:t>Write an opinion piece / blog </a:t>
            </a:r>
          </a:p>
        </p:txBody>
      </p:sp>
      <p:sp>
        <p:nvSpPr>
          <p:cNvPr id="47" name="Rectangle 46">
            <a:extLst>
              <a:ext uri="{FF2B5EF4-FFF2-40B4-BE49-F238E27FC236}">
                <a16:creationId xmlns:a16="http://schemas.microsoft.com/office/drawing/2014/main" id="{76897DC9-D586-3A47-8236-111CF0BD7315}"/>
              </a:ext>
            </a:extLst>
          </p:cNvPr>
          <p:cNvSpPr/>
          <p:nvPr/>
        </p:nvSpPr>
        <p:spPr>
          <a:xfrm>
            <a:off x="569660" y="1505733"/>
            <a:ext cx="1283647" cy="933003"/>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cxnSp>
        <p:nvCxnSpPr>
          <p:cNvPr id="48" name="Straight Connector 47">
            <a:extLst>
              <a:ext uri="{FF2B5EF4-FFF2-40B4-BE49-F238E27FC236}">
                <a16:creationId xmlns:a16="http://schemas.microsoft.com/office/drawing/2014/main" id="{0771AD49-5203-C143-8B58-D2D0426724C2}"/>
              </a:ext>
            </a:extLst>
          </p:cNvPr>
          <p:cNvCxnSpPr>
            <a:cxnSpLocks/>
          </p:cNvCxnSpPr>
          <p:nvPr/>
        </p:nvCxnSpPr>
        <p:spPr>
          <a:xfrm>
            <a:off x="1217666" y="2463640"/>
            <a:ext cx="0" cy="267412"/>
          </a:xfrm>
          <a:prstGeom prst="line">
            <a:avLst/>
          </a:pr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49" name="TextBox 48">
            <a:extLst>
              <a:ext uri="{FF2B5EF4-FFF2-40B4-BE49-F238E27FC236}">
                <a16:creationId xmlns:a16="http://schemas.microsoft.com/office/drawing/2014/main" id="{F908E994-F6FA-FF47-B0B6-935CD1E90D60}"/>
              </a:ext>
            </a:extLst>
          </p:cNvPr>
          <p:cNvSpPr txBox="1"/>
          <p:nvPr/>
        </p:nvSpPr>
        <p:spPr>
          <a:xfrm>
            <a:off x="559851" y="1639711"/>
            <a:ext cx="1268190" cy="795218"/>
          </a:xfrm>
          <a:prstGeom prst="rect">
            <a:avLst/>
          </a:prstGeom>
          <a:noFill/>
        </p:spPr>
        <p:txBody>
          <a:bodyPr wrap="square" rtlCol="0" anchor="ctr">
            <a:spAutoFit/>
          </a:bodyPr>
          <a:lstStyle/>
          <a:p>
            <a:pPr algn="ctr">
              <a:lnSpc>
                <a:spcPts val="1350"/>
              </a:lnSpc>
            </a:pPr>
            <a:r>
              <a:rPr lang="en-US" sz="900" b="1" i="1" spc="-8" dirty="0">
                <a:latin typeface="+mj-lt"/>
                <a:cs typeface="Poppins" panose="00000500000000000000" pitchFamily="2" charset="0"/>
              </a:rPr>
              <a:t>Group to vote on appropriate feedback mechanism</a:t>
            </a:r>
            <a:br>
              <a:rPr lang="en-US" sz="900" b="1" i="1" spc="-8" dirty="0">
                <a:latin typeface="+mj-lt"/>
                <a:cs typeface="Poppins" panose="00000500000000000000" pitchFamily="2" charset="0"/>
              </a:rPr>
            </a:br>
            <a:endParaRPr lang="en-US" sz="900" b="1" i="1" spc="-8" dirty="0">
              <a:latin typeface="+mj-lt"/>
              <a:cs typeface="Poppins" panose="00000500000000000000" pitchFamily="2" charset="0"/>
            </a:endParaRPr>
          </a:p>
        </p:txBody>
      </p:sp>
      <p:sp>
        <p:nvSpPr>
          <p:cNvPr id="50" name="Rectangle 49">
            <a:extLst>
              <a:ext uri="{FF2B5EF4-FFF2-40B4-BE49-F238E27FC236}">
                <a16:creationId xmlns:a16="http://schemas.microsoft.com/office/drawing/2014/main" id="{CBCDE5FC-6FA0-8E4D-9364-B3F03AAE1480}"/>
              </a:ext>
            </a:extLst>
          </p:cNvPr>
          <p:cNvSpPr/>
          <p:nvPr/>
        </p:nvSpPr>
        <p:spPr>
          <a:xfrm>
            <a:off x="2249918" y="898884"/>
            <a:ext cx="1283647" cy="840905"/>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cxnSp>
        <p:nvCxnSpPr>
          <p:cNvPr id="51" name="Straight Connector 50">
            <a:extLst>
              <a:ext uri="{FF2B5EF4-FFF2-40B4-BE49-F238E27FC236}">
                <a16:creationId xmlns:a16="http://schemas.microsoft.com/office/drawing/2014/main" id="{09BC59E7-E6DB-744E-A925-F3600C503790}"/>
              </a:ext>
            </a:extLst>
          </p:cNvPr>
          <p:cNvCxnSpPr>
            <a:cxnSpLocks/>
          </p:cNvCxnSpPr>
          <p:nvPr/>
        </p:nvCxnSpPr>
        <p:spPr>
          <a:xfrm>
            <a:off x="2897924" y="1764692"/>
            <a:ext cx="0" cy="267412"/>
          </a:xfrm>
          <a:prstGeom prst="line">
            <a:avLst/>
          </a:pr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52" name="TextBox 51">
            <a:extLst>
              <a:ext uri="{FF2B5EF4-FFF2-40B4-BE49-F238E27FC236}">
                <a16:creationId xmlns:a16="http://schemas.microsoft.com/office/drawing/2014/main" id="{31E02B73-E03A-C04A-8F77-57DE7CCB8A15}"/>
              </a:ext>
            </a:extLst>
          </p:cNvPr>
          <p:cNvSpPr txBox="1"/>
          <p:nvPr/>
        </p:nvSpPr>
        <p:spPr>
          <a:xfrm>
            <a:off x="2272806" y="914486"/>
            <a:ext cx="1268190" cy="795218"/>
          </a:xfrm>
          <a:prstGeom prst="rect">
            <a:avLst/>
          </a:prstGeom>
          <a:noFill/>
        </p:spPr>
        <p:txBody>
          <a:bodyPr wrap="square" rtlCol="0" anchor="ctr">
            <a:spAutoFit/>
          </a:bodyPr>
          <a:lstStyle/>
          <a:p>
            <a:pPr algn="ctr">
              <a:lnSpc>
                <a:spcPts val="1350"/>
              </a:lnSpc>
            </a:pPr>
            <a:r>
              <a:rPr lang="en-US" sz="900" b="1" i="1" spc="-8" dirty="0">
                <a:latin typeface="+mj-lt"/>
                <a:cs typeface="Poppins" panose="00000500000000000000" pitchFamily="2" charset="0"/>
              </a:rPr>
              <a:t>To discuss when reviewing Terms of Reference (recruiting new members)</a:t>
            </a:r>
          </a:p>
        </p:txBody>
      </p:sp>
      <p:sp>
        <p:nvSpPr>
          <p:cNvPr id="53" name="Rectangle 52">
            <a:extLst>
              <a:ext uri="{FF2B5EF4-FFF2-40B4-BE49-F238E27FC236}">
                <a16:creationId xmlns:a16="http://schemas.microsoft.com/office/drawing/2014/main" id="{1DB94EDF-3B56-6041-9C54-B1A492FFE9FF}"/>
              </a:ext>
            </a:extLst>
          </p:cNvPr>
          <p:cNvSpPr/>
          <p:nvPr/>
        </p:nvSpPr>
        <p:spPr>
          <a:xfrm>
            <a:off x="3930176" y="1223832"/>
            <a:ext cx="1283647" cy="699315"/>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75">
              <a:latin typeface="+mj-lt"/>
            </a:endParaRPr>
          </a:p>
        </p:txBody>
      </p:sp>
      <p:cxnSp>
        <p:nvCxnSpPr>
          <p:cNvPr id="54" name="Straight Connector 53">
            <a:extLst>
              <a:ext uri="{FF2B5EF4-FFF2-40B4-BE49-F238E27FC236}">
                <a16:creationId xmlns:a16="http://schemas.microsoft.com/office/drawing/2014/main" id="{A2B0D731-44DD-F740-B8A7-F29FCC1AC949}"/>
              </a:ext>
            </a:extLst>
          </p:cNvPr>
          <p:cNvCxnSpPr>
            <a:cxnSpLocks/>
          </p:cNvCxnSpPr>
          <p:nvPr/>
        </p:nvCxnSpPr>
        <p:spPr>
          <a:xfrm>
            <a:off x="4578182" y="1948050"/>
            <a:ext cx="0" cy="267412"/>
          </a:xfrm>
          <a:prstGeom prst="line">
            <a:avLst/>
          </a:pr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55" name="TextBox 54">
            <a:extLst>
              <a:ext uri="{FF2B5EF4-FFF2-40B4-BE49-F238E27FC236}">
                <a16:creationId xmlns:a16="http://schemas.microsoft.com/office/drawing/2014/main" id="{A543AA6A-443A-934D-A355-4E98E1B2676D}"/>
              </a:ext>
            </a:extLst>
          </p:cNvPr>
          <p:cNvSpPr txBox="1"/>
          <p:nvPr/>
        </p:nvSpPr>
        <p:spPr>
          <a:xfrm>
            <a:off x="3938976" y="1327116"/>
            <a:ext cx="1268190" cy="436145"/>
          </a:xfrm>
          <a:prstGeom prst="rect">
            <a:avLst/>
          </a:prstGeom>
          <a:noFill/>
        </p:spPr>
        <p:txBody>
          <a:bodyPr wrap="square" rtlCol="0" anchor="ctr">
            <a:spAutoFit/>
          </a:bodyPr>
          <a:lstStyle/>
          <a:p>
            <a:pPr algn="ctr">
              <a:lnSpc>
                <a:spcPts val="1350"/>
              </a:lnSpc>
            </a:pPr>
            <a:r>
              <a:rPr lang="en-US" sz="900" b="1" i="1" spc="-8" dirty="0">
                <a:latin typeface="+mj-lt"/>
                <a:cs typeface="Poppins" panose="00000500000000000000" pitchFamily="2" charset="0"/>
              </a:rPr>
              <a:t>Commitment to meeting Pre-briefs and De-briefs</a:t>
            </a:r>
          </a:p>
        </p:txBody>
      </p:sp>
      <p:cxnSp>
        <p:nvCxnSpPr>
          <p:cNvPr id="56" name="Straight Connector 55">
            <a:extLst>
              <a:ext uri="{FF2B5EF4-FFF2-40B4-BE49-F238E27FC236}">
                <a16:creationId xmlns:a16="http://schemas.microsoft.com/office/drawing/2014/main" id="{BE64939A-CFB5-0640-96B9-CDDA4687627E}"/>
              </a:ext>
            </a:extLst>
          </p:cNvPr>
          <p:cNvCxnSpPr>
            <a:cxnSpLocks/>
          </p:cNvCxnSpPr>
          <p:nvPr/>
        </p:nvCxnSpPr>
        <p:spPr>
          <a:xfrm>
            <a:off x="7944779" y="2516663"/>
            <a:ext cx="0" cy="267412"/>
          </a:xfrm>
          <a:prstGeom prst="line">
            <a:avLst/>
          </a:prstGeom>
          <a:noFill/>
          <a:ln w="76200" cap="rnd">
            <a:solidFill>
              <a:schemeClr val="bg1">
                <a:lumMod val="65000"/>
                <a:alpha val="15094"/>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58" name="Freeform 1001">
            <a:extLst>
              <a:ext uri="{FF2B5EF4-FFF2-40B4-BE49-F238E27FC236}">
                <a16:creationId xmlns:a16="http://schemas.microsoft.com/office/drawing/2014/main" id="{E4111F66-2734-E548-B19E-E88B6373E4F7}"/>
              </a:ext>
            </a:extLst>
          </p:cNvPr>
          <p:cNvSpPr>
            <a:spLocks noChangeAspect="1" noChangeArrowheads="1"/>
          </p:cNvSpPr>
          <p:nvPr/>
        </p:nvSpPr>
        <p:spPr bwMode="auto">
          <a:xfrm>
            <a:off x="4729913" y="4835686"/>
            <a:ext cx="417105" cy="268980"/>
          </a:xfrm>
          <a:custGeom>
            <a:avLst/>
            <a:gdLst>
              <a:gd name="T0" fmla="*/ 369470 w 290151"/>
              <a:gd name="T1" fmla="*/ 801981 h 290152"/>
              <a:gd name="T2" fmla="*/ 369470 w 290151"/>
              <a:gd name="T3" fmla="*/ 832423 h 290152"/>
              <a:gd name="T4" fmla="*/ 100253 w 290151"/>
              <a:gd name="T5" fmla="*/ 817811 h 290152"/>
              <a:gd name="T6" fmla="*/ 251621 w 290151"/>
              <a:gd name="T7" fmla="*/ 691180 h 290152"/>
              <a:gd name="T8" fmla="*/ 304838 w 290151"/>
              <a:gd name="T9" fmla="*/ 707009 h 290152"/>
              <a:gd name="T10" fmla="*/ 251621 w 290151"/>
              <a:gd name="T11" fmla="*/ 721617 h 290152"/>
              <a:gd name="T12" fmla="*/ 251621 w 290151"/>
              <a:gd name="T13" fmla="*/ 691180 h 290152"/>
              <a:gd name="T14" fmla="*/ 174185 w 290151"/>
              <a:gd name="T15" fmla="*/ 691180 h 290152"/>
              <a:gd name="T16" fmla="*/ 174185 w 290151"/>
              <a:gd name="T17" fmla="*/ 721617 h 290152"/>
              <a:gd name="T18" fmla="*/ 100253 w 290151"/>
              <a:gd name="T19" fmla="*/ 707009 h 290152"/>
              <a:gd name="T20" fmla="*/ 539753 w 290151"/>
              <a:gd name="T21" fmla="*/ 629702 h 290152"/>
              <a:gd name="T22" fmla="*/ 638105 w 290151"/>
              <a:gd name="T23" fmla="*/ 838402 h 290152"/>
              <a:gd name="T24" fmla="*/ 714871 w 290151"/>
              <a:gd name="T25" fmla="*/ 647692 h 290152"/>
              <a:gd name="T26" fmla="*/ 539753 w 290151"/>
              <a:gd name="T27" fmla="*/ 629702 h 290152"/>
              <a:gd name="T28" fmla="*/ 258865 w 290151"/>
              <a:gd name="T29" fmla="*/ 580381 h 290152"/>
              <a:gd name="T30" fmla="*/ 258865 w 290151"/>
              <a:gd name="T31" fmla="*/ 610771 h 290152"/>
              <a:gd name="T32" fmla="*/ 100253 w 290151"/>
              <a:gd name="T33" fmla="*/ 595576 h 290152"/>
              <a:gd name="T34" fmla="*/ 114557 w 290151"/>
              <a:gd name="T35" fmla="*/ 474856 h 290152"/>
              <a:gd name="T36" fmla="*/ 273171 w 290151"/>
              <a:gd name="T37" fmla="*/ 490050 h 290152"/>
              <a:gd name="T38" fmla="*/ 114557 w 290151"/>
              <a:gd name="T39" fmla="*/ 505245 h 290152"/>
              <a:gd name="T40" fmla="*/ 114557 w 290151"/>
              <a:gd name="T41" fmla="*/ 474856 h 290152"/>
              <a:gd name="T42" fmla="*/ 534955 w 290151"/>
              <a:gd name="T43" fmla="*/ 540946 h 290152"/>
              <a:gd name="T44" fmla="*/ 740058 w 290151"/>
              <a:gd name="T45" fmla="*/ 540946 h 290152"/>
              <a:gd name="T46" fmla="*/ 114605 w 290151"/>
              <a:gd name="T47" fmla="*/ 364057 h 290152"/>
              <a:gd name="T48" fmla="*/ 304825 w 290151"/>
              <a:gd name="T49" fmla="*/ 379255 h 290152"/>
              <a:gd name="T50" fmla="*/ 114605 w 290151"/>
              <a:gd name="T51" fmla="*/ 394450 h 290152"/>
              <a:gd name="T52" fmla="*/ 114605 w 290151"/>
              <a:gd name="T53" fmla="*/ 364057 h 290152"/>
              <a:gd name="T54" fmla="*/ 742456 w 290151"/>
              <a:gd name="T55" fmla="*/ 462982 h 290152"/>
              <a:gd name="T56" fmla="*/ 736460 w 290151"/>
              <a:gd name="T57" fmla="*/ 628501 h 290152"/>
              <a:gd name="T58" fmla="*/ 934368 w 290151"/>
              <a:gd name="T59" fmla="*/ 540946 h 290152"/>
              <a:gd name="T60" fmla="*/ 267593 w 290151"/>
              <a:gd name="T61" fmla="*/ 258533 h 290152"/>
              <a:gd name="T62" fmla="*/ 378697 w 290151"/>
              <a:gd name="T63" fmla="*/ 273732 h 290152"/>
              <a:gd name="T64" fmla="*/ 267593 w 290151"/>
              <a:gd name="T65" fmla="*/ 288925 h 290152"/>
              <a:gd name="T66" fmla="*/ 267593 w 290151"/>
              <a:gd name="T67" fmla="*/ 258533 h 290152"/>
              <a:gd name="T68" fmla="*/ 190531 w 290151"/>
              <a:gd name="T69" fmla="*/ 258533 h 290152"/>
              <a:gd name="T70" fmla="*/ 190531 w 290151"/>
              <a:gd name="T71" fmla="*/ 288925 h 290152"/>
              <a:gd name="T72" fmla="*/ 100253 w 290151"/>
              <a:gd name="T73" fmla="*/ 273732 h 290152"/>
              <a:gd name="T74" fmla="*/ 652495 w 290151"/>
              <a:gd name="T75" fmla="*/ 244685 h 290152"/>
              <a:gd name="T76" fmla="*/ 723267 w 290151"/>
              <a:gd name="T77" fmla="*/ 440192 h 290152"/>
              <a:gd name="T78" fmla="*/ 652495 w 290151"/>
              <a:gd name="T79" fmla="*/ 244685 h 290152"/>
              <a:gd name="T80" fmla="*/ 340648 w 290151"/>
              <a:gd name="T81" fmla="*/ 540946 h 290152"/>
              <a:gd name="T82" fmla="*/ 522957 w 290151"/>
              <a:gd name="T83" fmla="*/ 605714 h 290152"/>
              <a:gd name="T84" fmla="*/ 623710 w 290151"/>
              <a:gd name="T85" fmla="*/ 410208 h 290152"/>
              <a:gd name="T86" fmla="*/ 203908 w 290151"/>
              <a:gd name="T87" fmla="*/ 29981 h 290152"/>
              <a:gd name="T88" fmla="*/ 248286 w 290151"/>
              <a:gd name="T89" fmla="*/ 117541 h 290152"/>
              <a:gd name="T90" fmla="*/ 564936 w 290151"/>
              <a:gd name="T91" fmla="*/ 73162 h 290152"/>
              <a:gd name="T92" fmla="*/ 203908 w 290151"/>
              <a:gd name="T93" fmla="*/ 29981 h 290152"/>
              <a:gd name="T94" fmla="*/ 28789 w 290151"/>
              <a:gd name="T95" fmla="*/ 73162 h 290152"/>
              <a:gd name="T96" fmla="*/ 73164 w 290151"/>
              <a:gd name="T97" fmla="*/ 935558 h 290152"/>
              <a:gd name="T98" fmla="*/ 740058 w 290151"/>
              <a:gd name="T99" fmla="*/ 892375 h 290152"/>
              <a:gd name="T100" fmla="*/ 638105 w 290151"/>
              <a:gd name="T101" fmla="*/ 867192 h 290152"/>
              <a:gd name="T102" fmla="*/ 638105 w 290151"/>
              <a:gd name="T103" fmla="*/ 215896 h 290152"/>
              <a:gd name="T104" fmla="*/ 740058 w 290151"/>
              <a:gd name="T105" fmla="*/ 73162 h 290152"/>
              <a:gd name="T106" fmla="*/ 593725 w 290151"/>
              <a:gd name="T107" fmla="*/ 29981 h 290152"/>
              <a:gd name="T108" fmla="*/ 521760 w 290151"/>
              <a:gd name="T109" fmla="*/ 146332 h 290152"/>
              <a:gd name="T110" fmla="*/ 175122 w 290151"/>
              <a:gd name="T111" fmla="*/ 73162 h 290152"/>
              <a:gd name="T112" fmla="*/ 73164 w 290151"/>
              <a:gd name="T113" fmla="*/ 29981 h 290152"/>
              <a:gd name="T114" fmla="*/ 696879 w 290151"/>
              <a:gd name="T115" fmla="*/ 0 h 290152"/>
              <a:gd name="T116" fmla="*/ 768846 w 290151"/>
              <a:gd name="T117" fmla="*/ 242285 h 290152"/>
              <a:gd name="T118" fmla="*/ 768846 w 290151"/>
              <a:gd name="T119" fmla="*/ 839599 h 290152"/>
              <a:gd name="T120" fmla="*/ 696879 w 290151"/>
              <a:gd name="T121" fmla="*/ 964341 h 290152"/>
              <a:gd name="T122" fmla="*/ 0 w 290151"/>
              <a:gd name="T123" fmla="*/ 892375 h 290152"/>
              <a:gd name="T124" fmla="*/ 73164 w 290151"/>
              <a:gd name="T125" fmla="*/ 0 h 290152"/>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60000 65536"/>
              <a:gd name="T154" fmla="*/ 0 60000 65536"/>
              <a:gd name="T155" fmla="*/ 0 60000 65536"/>
              <a:gd name="T156" fmla="*/ 0 60000 65536"/>
              <a:gd name="T157" fmla="*/ 0 60000 65536"/>
              <a:gd name="T158" fmla="*/ 0 60000 65536"/>
              <a:gd name="T159" fmla="*/ 0 60000 65536"/>
              <a:gd name="T160" fmla="*/ 0 60000 65536"/>
              <a:gd name="T161" fmla="*/ 0 60000 65536"/>
              <a:gd name="T162" fmla="*/ 0 60000 65536"/>
              <a:gd name="T163" fmla="*/ 0 60000 65536"/>
              <a:gd name="T164" fmla="*/ 0 60000 65536"/>
              <a:gd name="T165" fmla="*/ 0 60000 65536"/>
              <a:gd name="T166" fmla="*/ 0 60000 65536"/>
              <a:gd name="T167" fmla="*/ 0 60000 65536"/>
              <a:gd name="T168" fmla="*/ 0 60000 65536"/>
              <a:gd name="T169" fmla="*/ 0 60000 65536"/>
              <a:gd name="T170" fmla="*/ 0 60000 65536"/>
              <a:gd name="T171" fmla="*/ 0 60000 65536"/>
              <a:gd name="T172" fmla="*/ 0 60000 65536"/>
              <a:gd name="T173" fmla="*/ 0 60000 65536"/>
              <a:gd name="T174" fmla="*/ 0 60000 65536"/>
              <a:gd name="T175" fmla="*/ 0 60000 65536"/>
              <a:gd name="T176" fmla="*/ 0 60000 65536"/>
              <a:gd name="T177" fmla="*/ 0 60000 65536"/>
              <a:gd name="T178" fmla="*/ 0 60000 65536"/>
              <a:gd name="T179" fmla="*/ 0 60000 65536"/>
              <a:gd name="T180" fmla="*/ 0 60000 65536"/>
              <a:gd name="T181" fmla="*/ 0 60000 65536"/>
              <a:gd name="T182" fmla="*/ 0 60000 65536"/>
              <a:gd name="T183" fmla="*/ 0 60000 65536"/>
              <a:gd name="T184" fmla="*/ 0 60000 65536"/>
              <a:gd name="T185" fmla="*/ 0 60000 65536"/>
              <a:gd name="T186" fmla="*/ 0 60000 65536"/>
              <a:gd name="T187" fmla="*/ 0 60000 65536"/>
              <a:gd name="T188" fmla="*/ 0 60000 65536"/>
            </a:gdLst>
            <a:ahLst/>
            <a:cxnLst>
              <a:cxn ang="T126">
                <a:pos x="T0" y="T1"/>
              </a:cxn>
              <a:cxn ang="T127">
                <a:pos x="T2" y="T3"/>
              </a:cxn>
              <a:cxn ang="T128">
                <a:pos x="T4" y="T5"/>
              </a:cxn>
              <a:cxn ang="T129">
                <a:pos x="T6" y="T7"/>
              </a:cxn>
              <a:cxn ang="T130">
                <a:pos x="T8" y="T9"/>
              </a:cxn>
              <a:cxn ang="T131">
                <a:pos x="T10" y="T11"/>
              </a:cxn>
              <a:cxn ang="T132">
                <a:pos x="T12" y="T13"/>
              </a:cxn>
              <a:cxn ang="T133">
                <a:pos x="T14" y="T15"/>
              </a:cxn>
              <a:cxn ang="T134">
                <a:pos x="T16" y="T17"/>
              </a:cxn>
              <a:cxn ang="T135">
                <a:pos x="T18" y="T19"/>
              </a:cxn>
              <a:cxn ang="T136">
                <a:pos x="T20" y="T21"/>
              </a:cxn>
              <a:cxn ang="T137">
                <a:pos x="T22" y="T23"/>
              </a:cxn>
              <a:cxn ang="T138">
                <a:pos x="T24" y="T25"/>
              </a:cxn>
              <a:cxn ang="T139">
                <a:pos x="T26" y="T27"/>
              </a:cxn>
              <a:cxn ang="T140">
                <a:pos x="T28" y="T29"/>
              </a:cxn>
              <a:cxn ang="T141">
                <a:pos x="T30" y="T31"/>
              </a:cxn>
              <a:cxn ang="T142">
                <a:pos x="T32" y="T33"/>
              </a:cxn>
              <a:cxn ang="T143">
                <a:pos x="T34" y="T35"/>
              </a:cxn>
              <a:cxn ang="T144">
                <a:pos x="T36" y="T37"/>
              </a:cxn>
              <a:cxn ang="T145">
                <a:pos x="T38" y="T39"/>
              </a:cxn>
              <a:cxn ang="T146">
                <a:pos x="T40" y="T41"/>
              </a:cxn>
              <a:cxn ang="T147">
                <a:pos x="T42" y="T43"/>
              </a:cxn>
              <a:cxn ang="T148">
                <a:pos x="T44" y="T45"/>
              </a:cxn>
              <a:cxn ang="T149">
                <a:pos x="T46" y="T47"/>
              </a:cxn>
              <a:cxn ang="T150">
                <a:pos x="T48" y="T49"/>
              </a:cxn>
              <a:cxn ang="T151">
                <a:pos x="T50" y="T51"/>
              </a:cxn>
              <a:cxn ang="T152">
                <a:pos x="T52" y="T53"/>
              </a:cxn>
              <a:cxn ang="T153">
                <a:pos x="T54" y="T55"/>
              </a:cxn>
              <a:cxn ang="T154">
                <a:pos x="T56" y="T57"/>
              </a:cxn>
              <a:cxn ang="T155">
                <a:pos x="T58" y="T59"/>
              </a:cxn>
              <a:cxn ang="T156">
                <a:pos x="T60" y="T61"/>
              </a:cxn>
              <a:cxn ang="T157">
                <a:pos x="T62" y="T63"/>
              </a:cxn>
              <a:cxn ang="T158">
                <a:pos x="T64" y="T65"/>
              </a:cxn>
              <a:cxn ang="T159">
                <a:pos x="T66" y="T67"/>
              </a:cxn>
              <a:cxn ang="T160">
                <a:pos x="T68" y="T69"/>
              </a:cxn>
              <a:cxn ang="T161">
                <a:pos x="T70" y="T71"/>
              </a:cxn>
              <a:cxn ang="T162">
                <a:pos x="T72" y="T73"/>
              </a:cxn>
              <a:cxn ang="T163">
                <a:pos x="T74" y="T75"/>
              </a:cxn>
              <a:cxn ang="T164">
                <a:pos x="T76" y="T77"/>
              </a:cxn>
              <a:cxn ang="T165">
                <a:pos x="T78" y="T79"/>
              </a:cxn>
              <a:cxn ang="T166">
                <a:pos x="T80" y="T81"/>
              </a:cxn>
              <a:cxn ang="T167">
                <a:pos x="T82" y="T83"/>
              </a:cxn>
              <a:cxn ang="T168">
                <a:pos x="T84" y="T85"/>
              </a:cxn>
              <a:cxn ang="T169">
                <a:pos x="T86" y="T87"/>
              </a:cxn>
              <a:cxn ang="T170">
                <a:pos x="T88" y="T89"/>
              </a:cxn>
              <a:cxn ang="T171">
                <a:pos x="T90" y="T91"/>
              </a:cxn>
              <a:cxn ang="T172">
                <a:pos x="T92" y="T93"/>
              </a:cxn>
              <a:cxn ang="T173">
                <a:pos x="T94" y="T95"/>
              </a:cxn>
              <a:cxn ang="T174">
                <a:pos x="T96" y="T97"/>
              </a:cxn>
              <a:cxn ang="T175">
                <a:pos x="T98" y="T99"/>
              </a:cxn>
              <a:cxn ang="T176">
                <a:pos x="T100" y="T101"/>
              </a:cxn>
              <a:cxn ang="T177">
                <a:pos x="T102" y="T103"/>
              </a:cxn>
              <a:cxn ang="T178">
                <a:pos x="T104" y="T105"/>
              </a:cxn>
              <a:cxn ang="T179">
                <a:pos x="T106" y="T107"/>
              </a:cxn>
              <a:cxn ang="T180">
                <a:pos x="T108" y="T109"/>
              </a:cxn>
              <a:cxn ang="T181">
                <a:pos x="T110" y="T111"/>
              </a:cxn>
              <a:cxn ang="T182">
                <a:pos x="T112" y="T113"/>
              </a:cxn>
              <a:cxn ang="T183">
                <a:pos x="T114" y="T115"/>
              </a:cxn>
              <a:cxn ang="T184">
                <a:pos x="T116" y="T117"/>
              </a:cxn>
              <a:cxn ang="T185">
                <a:pos x="T118" y="T119"/>
              </a:cxn>
              <a:cxn ang="T186">
                <a:pos x="T120" y="T121"/>
              </a:cxn>
              <a:cxn ang="T187">
                <a:pos x="T122" y="T123"/>
              </a:cxn>
              <a:cxn ang="T188">
                <a:pos x="T124" y="T125"/>
              </a:cxn>
            </a:cxnLst>
            <a:rect l="0" t="0" r="r" b="b"/>
            <a:pathLst>
              <a:path w="290151" h="290152">
                <a:moveTo>
                  <a:pt x="34521" y="241300"/>
                </a:moveTo>
                <a:lnTo>
                  <a:pt x="111165" y="241300"/>
                </a:lnTo>
                <a:cubicBezTo>
                  <a:pt x="113708" y="241300"/>
                  <a:pt x="115524" y="243498"/>
                  <a:pt x="115524" y="246063"/>
                </a:cubicBezTo>
                <a:cubicBezTo>
                  <a:pt x="115524" y="248627"/>
                  <a:pt x="113708" y="250459"/>
                  <a:pt x="111165" y="250459"/>
                </a:cubicBezTo>
                <a:lnTo>
                  <a:pt x="34521" y="250459"/>
                </a:lnTo>
                <a:cubicBezTo>
                  <a:pt x="31978" y="250459"/>
                  <a:pt x="30162" y="248627"/>
                  <a:pt x="30162" y="246063"/>
                </a:cubicBezTo>
                <a:cubicBezTo>
                  <a:pt x="30162" y="243498"/>
                  <a:pt x="31978" y="241300"/>
                  <a:pt x="34521" y="241300"/>
                </a:cubicBezTo>
                <a:close/>
                <a:moveTo>
                  <a:pt x="75707" y="207963"/>
                </a:moveTo>
                <a:lnTo>
                  <a:pt x="87449" y="207963"/>
                </a:lnTo>
                <a:cubicBezTo>
                  <a:pt x="89584" y="207963"/>
                  <a:pt x="91719" y="210161"/>
                  <a:pt x="91719" y="212725"/>
                </a:cubicBezTo>
                <a:cubicBezTo>
                  <a:pt x="91719" y="215290"/>
                  <a:pt x="89584" y="217121"/>
                  <a:pt x="87449" y="217121"/>
                </a:cubicBezTo>
                <a:lnTo>
                  <a:pt x="75707" y="217121"/>
                </a:lnTo>
                <a:cubicBezTo>
                  <a:pt x="73216" y="217121"/>
                  <a:pt x="71437" y="215290"/>
                  <a:pt x="71437" y="212725"/>
                </a:cubicBezTo>
                <a:cubicBezTo>
                  <a:pt x="71437" y="210161"/>
                  <a:pt x="73216" y="207963"/>
                  <a:pt x="75707" y="207963"/>
                </a:cubicBezTo>
                <a:close/>
                <a:moveTo>
                  <a:pt x="34539" y="207963"/>
                </a:moveTo>
                <a:lnTo>
                  <a:pt x="52409" y="207963"/>
                </a:lnTo>
                <a:cubicBezTo>
                  <a:pt x="54962" y="207963"/>
                  <a:pt x="56786" y="210161"/>
                  <a:pt x="56786" y="212725"/>
                </a:cubicBezTo>
                <a:cubicBezTo>
                  <a:pt x="56786" y="215290"/>
                  <a:pt x="54962" y="217121"/>
                  <a:pt x="52409" y="217121"/>
                </a:cubicBezTo>
                <a:lnTo>
                  <a:pt x="34539" y="217121"/>
                </a:lnTo>
                <a:cubicBezTo>
                  <a:pt x="31986" y="217121"/>
                  <a:pt x="30162" y="215290"/>
                  <a:pt x="30162" y="212725"/>
                </a:cubicBezTo>
                <a:cubicBezTo>
                  <a:pt x="30162" y="210161"/>
                  <a:pt x="31986" y="207963"/>
                  <a:pt x="34539" y="207963"/>
                </a:cubicBezTo>
                <a:close/>
                <a:moveTo>
                  <a:pt x="162398" y="189465"/>
                </a:moveTo>
                <a:lnTo>
                  <a:pt x="121979" y="218336"/>
                </a:lnTo>
                <a:cubicBezTo>
                  <a:pt x="138219" y="238906"/>
                  <a:pt x="163481" y="252259"/>
                  <a:pt x="191991" y="252259"/>
                </a:cubicBezTo>
                <a:cubicBezTo>
                  <a:pt x="213283" y="252259"/>
                  <a:pt x="233132" y="244681"/>
                  <a:pt x="248289" y="232049"/>
                </a:cubicBezTo>
                <a:lnTo>
                  <a:pt x="215087" y="194878"/>
                </a:lnTo>
                <a:cubicBezTo>
                  <a:pt x="208591" y="199570"/>
                  <a:pt x="200652" y="202457"/>
                  <a:pt x="191991" y="202457"/>
                </a:cubicBezTo>
                <a:cubicBezTo>
                  <a:pt x="180442" y="202457"/>
                  <a:pt x="169616" y="197404"/>
                  <a:pt x="162398" y="189465"/>
                </a:cubicBezTo>
                <a:close/>
                <a:moveTo>
                  <a:pt x="34468" y="174625"/>
                </a:moveTo>
                <a:lnTo>
                  <a:pt x="77886" y="174625"/>
                </a:lnTo>
                <a:cubicBezTo>
                  <a:pt x="80397" y="174625"/>
                  <a:pt x="82191" y="176530"/>
                  <a:pt x="82191" y="179197"/>
                </a:cubicBezTo>
                <a:cubicBezTo>
                  <a:pt x="82191" y="181864"/>
                  <a:pt x="80397" y="183769"/>
                  <a:pt x="77886" y="183769"/>
                </a:cubicBezTo>
                <a:lnTo>
                  <a:pt x="34468" y="183769"/>
                </a:lnTo>
                <a:cubicBezTo>
                  <a:pt x="31956" y="183769"/>
                  <a:pt x="30162" y="181864"/>
                  <a:pt x="30162" y="179197"/>
                </a:cubicBezTo>
                <a:cubicBezTo>
                  <a:pt x="30162" y="176530"/>
                  <a:pt x="31956" y="174625"/>
                  <a:pt x="34468" y="174625"/>
                </a:cubicBezTo>
                <a:close/>
                <a:moveTo>
                  <a:pt x="34468" y="142875"/>
                </a:moveTo>
                <a:lnTo>
                  <a:pt x="77886" y="142875"/>
                </a:lnTo>
                <a:cubicBezTo>
                  <a:pt x="80397" y="142875"/>
                  <a:pt x="82191" y="144780"/>
                  <a:pt x="82191" y="147447"/>
                </a:cubicBezTo>
                <a:cubicBezTo>
                  <a:pt x="82191" y="150114"/>
                  <a:pt x="80397" y="152019"/>
                  <a:pt x="77886" y="152019"/>
                </a:cubicBezTo>
                <a:lnTo>
                  <a:pt x="34468" y="152019"/>
                </a:lnTo>
                <a:cubicBezTo>
                  <a:pt x="31956" y="152019"/>
                  <a:pt x="30162" y="150114"/>
                  <a:pt x="30162" y="147447"/>
                </a:cubicBezTo>
                <a:cubicBezTo>
                  <a:pt x="30162" y="144780"/>
                  <a:pt x="31956" y="142875"/>
                  <a:pt x="34468" y="142875"/>
                </a:cubicBezTo>
                <a:close/>
                <a:moveTo>
                  <a:pt x="191991" y="132084"/>
                </a:moveTo>
                <a:cubicBezTo>
                  <a:pt x="175029" y="132084"/>
                  <a:pt x="160955" y="145798"/>
                  <a:pt x="160955" y="162759"/>
                </a:cubicBezTo>
                <a:cubicBezTo>
                  <a:pt x="160955" y="179721"/>
                  <a:pt x="175029" y="193795"/>
                  <a:pt x="191991" y="193795"/>
                </a:cubicBezTo>
                <a:cubicBezTo>
                  <a:pt x="208952" y="193795"/>
                  <a:pt x="222666" y="179721"/>
                  <a:pt x="222666" y="162759"/>
                </a:cubicBezTo>
                <a:cubicBezTo>
                  <a:pt x="222666" y="145798"/>
                  <a:pt x="208952" y="132084"/>
                  <a:pt x="191991" y="132084"/>
                </a:cubicBezTo>
                <a:close/>
                <a:moveTo>
                  <a:pt x="34482" y="109538"/>
                </a:moveTo>
                <a:lnTo>
                  <a:pt x="87396" y="109538"/>
                </a:lnTo>
                <a:cubicBezTo>
                  <a:pt x="89556" y="109538"/>
                  <a:pt x="91715" y="111443"/>
                  <a:pt x="91715" y="114110"/>
                </a:cubicBezTo>
                <a:cubicBezTo>
                  <a:pt x="91715" y="116777"/>
                  <a:pt x="89556" y="118682"/>
                  <a:pt x="87396" y="118682"/>
                </a:cubicBezTo>
                <a:lnTo>
                  <a:pt x="34482" y="118682"/>
                </a:lnTo>
                <a:cubicBezTo>
                  <a:pt x="31962" y="118682"/>
                  <a:pt x="30162" y="116777"/>
                  <a:pt x="30162" y="114110"/>
                </a:cubicBezTo>
                <a:cubicBezTo>
                  <a:pt x="30162" y="111443"/>
                  <a:pt x="31962" y="109538"/>
                  <a:pt x="34482" y="109538"/>
                </a:cubicBezTo>
                <a:close/>
                <a:moveTo>
                  <a:pt x="259476" y="105017"/>
                </a:moveTo>
                <a:lnTo>
                  <a:pt x="223388" y="139302"/>
                </a:lnTo>
                <a:cubicBezTo>
                  <a:pt x="228440" y="145798"/>
                  <a:pt x="231327" y="154098"/>
                  <a:pt x="231327" y="162759"/>
                </a:cubicBezTo>
                <a:cubicBezTo>
                  <a:pt x="231327" y="172864"/>
                  <a:pt x="227718" y="181886"/>
                  <a:pt x="221583" y="189104"/>
                </a:cubicBezTo>
                <a:lnTo>
                  <a:pt x="255146" y="226275"/>
                </a:lnTo>
                <a:cubicBezTo>
                  <a:pt x="271385" y="210035"/>
                  <a:pt x="281129" y="187299"/>
                  <a:pt x="281129" y="162759"/>
                </a:cubicBezTo>
                <a:cubicBezTo>
                  <a:pt x="281129" y="140745"/>
                  <a:pt x="273190" y="120175"/>
                  <a:pt x="259476" y="105017"/>
                </a:cubicBezTo>
                <a:close/>
                <a:moveTo>
                  <a:pt x="80513" y="77788"/>
                </a:moveTo>
                <a:lnTo>
                  <a:pt x="109628" y="77788"/>
                </a:lnTo>
                <a:cubicBezTo>
                  <a:pt x="112144" y="77788"/>
                  <a:pt x="113941" y="79693"/>
                  <a:pt x="113941" y="82360"/>
                </a:cubicBezTo>
                <a:cubicBezTo>
                  <a:pt x="113941" y="85027"/>
                  <a:pt x="112144" y="86932"/>
                  <a:pt x="109628" y="86932"/>
                </a:cubicBezTo>
                <a:lnTo>
                  <a:pt x="80513" y="86932"/>
                </a:lnTo>
                <a:cubicBezTo>
                  <a:pt x="78357" y="86932"/>
                  <a:pt x="76200" y="85027"/>
                  <a:pt x="76200" y="82360"/>
                </a:cubicBezTo>
                <a:cubicBezTo>
                  <a:pt x="76200" y="79693"/>
                  <a:pt x="78357" y="77788"/>
                  <a:pt x="80513" y="77788"/>
                </a:cubicBezTo>
                <a:close/>
                <a:moveTo>
                  <a:pt x="34396" y="77788"/>
                </a:moveTo>
                <a:lnTo>
                  <a:pt x="57326" y="77788"/>
                </a:lnTo>
                <a:cubicBezTo>
                  <a:pt x="59796" y="77788"/>
                  <a:pt x="61559" y="79693"/>
                  <a:pt x="61559" y="82360"/>
                </a:cubicBezTo>
                <a:cubicBezTo>
                  <a:pt x="61559" y="85027"/>
                  <a:pt x="59796" y="86932"/>
                  <a:pt x="57326" y="86932"/>
                </a:cubicBezTo>
                <a:lnTo>
                  <a:pt x="34396" y="86932"/>
                </a:lnTo>
                <a:cubicBezTo>
                  <a:pt x="31926" y="86932"/>
                  <a:pt x="30162" y="85027"/>
                  <a:pt x="30162" y="82360"/>
                </a:cubicBezTo>
                <a:cubicBezTo>
                  <a:pt x="30162" y="79693"/>
                  <a:pt x="31926" y="77788"/>
                  <a:pt x="34396" y="77788"/>
                </a:cubicBezTo>
                <a:close/>
                <a:moveTo>
                  <a:pt x="196321" y="73620"/>
                </a:moveTo>
                <a:lnTo>
                  <a:pt x="196321" y="123423"/>
                </a:lnTo>
                <a:cubicBezTo>
                  <a:pt x="204261" y="124505"/>
                  <a:pt x="211479" y="127753"/>
                  <a:pt x="217614" y="132445"/>
                </a:cubicBezTo>
                <a:lnTo>
                  <a:pt x="253702" y="98161"/>
                </a:lnTo>
                <a:cubicBezTo>
                  <a:pt x="238545" y="83725"/>
                  <a:pt x="218696" y="74703"/>
                  <a:pt x="196321" y="73620"/>
                </a:cubicBezTo>
                <a:close/>
                <a:moveTo>
                  <a:pt x="187660" y="73620"/>
                </a:moveTo>
                <a:cubicBezTo>
                  <a:pt x="140384" y="76147"/>
                  <a:pt x="102491" y="115122"/>
                  <a:pt x="102491" y="162759"/>
                </a:cubicBezTo>
                <a:cubicBezTo>
                  <a:pt x="102491" y="180804"/>
                  <a:pt x="107905" y="197404"/>
                  <a:pt x="116927" y="211118"/>
                </a:cubicBezTo>
                <a:lnTo>
                  <a:pt x="157346" y="182247"/>
                </a:lnTo>
                <a:cubicBezTo>
                  <a:pt x="154098" y="176473"/>
                  <a:pt x="152293" y="169977"/>
                  <a:pt x="152293" y="162759"/>
                </a:cubicBezTo>
                <a:cubicBezTo>
                  <a:pt x="152293" y="142550"/>
                  <a:pt x="167812" y="125588"/>
                  <a:pt x="187660" y="123423"/>
                </a:cubicBezTo>
                <a:lnTo>
                  <a:pt x="187660" y="73620"/>
                </a:lnTo>
                <a:close/>
                <a:moveTo>
                  <a:pt x="61351" y="9022"/>
                </a:moveTo>
                <a:lnTo>
                  <a:pt x="61351" y="22014"/>
                </a:lnTo>
                <a:cubicBezTo>
                  <a:pt x="61351" y="29231"/>
                  <a:pt x="67486" y="35367"/>
                  <a:pt x="74703" y="35367"/>
                </a:cubicBezTo>
                <a:lnTo>
                  <a:pt x="156985" y="35367"/>
                </a:lnTo>
                <a:cubicBezTo>
                  <a:pt x="164203" y="35367"/>
                  <a:pt x="169977" y="29231"/>
                  <a:pt x="169977" y="22014"/>
                </a:cubicBezTo>
                <a:lnTo>
                  <a:pt x="169977" y="9022"/>
                </a:lnTo>
                <a:lnTo>
                  <a:pt x="61351" y="9022"/>
                </a:lnTo>
                <a:close/>
                <a:moveTo>
                  <a:pt x="22014" y="9022"/>
                </a:moveTo>
                <a:cubicBezTo>
                  <a:pt x="14435" y="9022"/>
                  <a:pt x="8661" y="14796"/>
                  <a:pt x="8661" y="22014"/>
                </a:cubicBezTo>
                <a:lnTo>
                  <a:pt x="8661" y="268499"/>
                </a:lnTo>
                <a:cubicBezTo>
                  <a:pt x="8661" y="275717"/>
                  <a:pt x="14435" y="281491"/>
                  <a:pt x="22014" y="281491"/>
                </a:cubicBezTo>
                <a:lnTo>
                  <a:pt x="209674" y="281491"/>
                </a:lnTo>
                <a:cubicBezTo>
                  <a:pt x="216892" y="281491"/>
                  <a:pt x="222666" y="275717"/>
                  <a:pt x="222666" y="268499"/>
                </a:cubicBezTo>
                <a:lnTo>
                  <a:pt x="222666" y="255868"/>
                </a:lnTo>
                <a:cubicBezTo>
                  <a:pt x="212922" y="259477"/>
                  <a:pt x="202456" y="260921"/>
                  <a:pt x="191991" y="260921"/>
                </a:cubicBezTo>
                <a:cubicBezTo>
                  <a:pt x="137858" y="260921"/>
                  <a:pt x="93830" y="216892"/>
                  <a:pt x="93830" y="162759"/>
                </a:cubicBezTo>
                <a:cubicBezTo>
                  <a:pt x="93830" y="108626"/>
                  <a:pt x="137858" y="64959"/>
                  <a:pt x="191991" y="64959"/>
                </a:cubicBezTo>
                <a:cubicBezTo>
                  <a:pt x="202456" y="64959"/>
                  <a:pt x="212922" y="66403"/>
                  <a:pt x="222666" y="69651"/>
                </a:cubicBezTo>
                <a:lnTo>
                  <a:pt x="222666" y="22014"/>
                </a:lnTo>
                <a:cubicBezTo>
                  <a:pt x="222666" y="14796"/>
                  <a:pt x="216892" y="9022"/>
                  <a:pt x="209674" y="9022"/>
                </a:cubicBezTo>
                <a:lnTo>
                  <a:pt x="178638" y="9022"/>
                </a:lnTo>
                <a:lnTo>
                  <a:pt x="178638" y="22014"/>
                </a:lnTo>
                <a:cubicBezTo>
                  <a:pt x="178638" y="34284"/>
                  <a:pt x="168894" y="44028"/>
                  <a:pt x="156985" y="44028"/>
                </a:cubicBezTo>
                <a:lnTo>
                  <a:pt x="74703" y="44028"/>
                </a:lnTo>
                <a:cubicBezTo>
                  <a:pt x="62433" y="44028"/>
                  <a:pt x="52689" y="34284"/>
                  <a:pt x="52689" y="22014"/>
                </a:cubicBezTo>
                <a:lnTo>
                  <a:pt x="52689" y="9022"/>
                </a:lnTo>
                <a:lnTo>
                  <a:pt x="22014" y="9022"/>
                </a:lnTo>
                <a:close/>
                <a:moveTo>
                  <a:pt x="22014" y="0"/>
                </a:moveTo>
                <a:lnTo>
                  <a:pt x="209674" y="0"/>
                </a:lnTo>
                <a:cubicBezTo>
                  <a:pt x="221583" y="0"/>
                  <a:pt x="231327" y="10105"/>
                  <a:pt x="231327" y="22014"/>
                </a:cubicBezTo>
                <a:lnTo>
                  <a:pt x="231327" y="72899"/>
                </a:lnTo>
                <a:cubicBezTo>
                  <a:pt x="265972" y="88417"/>
                  <a:pt x="290151" y="122701"/>
                  <a:pt x="290151" y="162759"/>
                </a:cubicBezTo>
                <a:cubicBezTo>
                  <a:pt x="290151" y="202818"/>
                  <a:pt x="265972" y="237463"/>
                  <a:pt x="231327" y="252620"/>
                </a:cubicBezTo>
                <a:lnTo>
                  <a:pt x="231327" y="268499"/>
                </a:lnTo>
                <a:cubicBezTo>
                  <a:pt x="231327" y="280408"/>
                  <a:pt x="221583" y="290152"/>
                  <a:pt x="209674" y="290152"/>
                </a:cubicBezTo>
                <a:lnTo>
                  <a:pt x="22014" y="290152"/>
                </a:lnTo>
                <a:cubicBezTo>
                  <a:pt x="9744" y="290152"/>
                  <a:pt x="0" y="280408"/>
                  <a:pt x="0" y="268499"/>
                </a:cubicBezTo>
                <a:lnTo>
                  <a:pt x="0" y="22014"/>
                </a:lnTo>
                <a:cubicBezTo>
                  <a:pt x="0" y="10105"/>
                  <a:pt x="9744" y="0"/>
                  <a:pt x="22014" y="0"/>
                </a:cubicBezTo>
                <a:close/>
              </a:path>
            </a:pathLst>
          </a:custGeom>
          <a:solidFill>
            <a:schemeClr val="bg1"/>
          </a:solidFill>
          <a:ln>
            <a:noFill/>
          </a:ln>
          <a:effectLst/>
        </p:spPr>
        <p:txBody>
          <a:bodyPr anchor="ctr"/>
          <a:lstStyle/>
          <a:p>
            <a:endParaRPr lang="en-US" sz="675">
              <a:latin typeface="+mj-lt"/>
            </a:endParaRPr>
          </a:p>
        </p:txBody>
      </p:sp>
      <p:sp>
        <p:nvSpPr>
          <p:cNvPr id="59" name="Rectangle 58">
            <a:extLst>
              <a:ext uri="{FF2B5EF4-FFF2-40B4-BE49-F238E27FC236}">
                <a16:creationId xmlns:a16="http://schemas.microsoft.com/office/drawing/2014/main" id="{2834B778-6886-E946-89D4-B04A8B26D5D1}"/>
              </a:ext>
            </a:extLst>
          </p:cNvPr>
          <p:cNvSpPr/>
          <p:nvPr/>
        </p:nvSpPr>
        <p:spPr>
          <a:xfrm>
            <a:off x="198194" y="5694648"/>
            <a:ext cx="8820890" cy="1064774"/>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46"/>
            <a:endParaRPr lang="en-US" sz="1350">
              <a:solidFill>
                <a:srgbClr val="FFFFFF"/>
              </a:solidFill>
              <a:latin typeface="+mj-lt"/>
            </a:endParaRPr>
          </a:p>
        </p:txBody>
      </p:sp>
      <p:sp>
        <p:nvSpPr>
          <p:cNvPr id="60" name="TextBox 59">
            <a:extLst>
              <a:ext uri="{FF2B5EF4-FFF2-40B4-BE49-F238E27FC236}">
                <a16:creationId xmlns:a16="http://schemas.microsoft.com/office/drawing/2014/main" id="{CD9701E9-623F-1E4C-BC48-DD8ABC8E6605}"/>
              </a:ext>
            </a:extLst>
          </p:cNvPr>
          <p:cNvSpPr txBox="1"/>
          <p:nvPr/>
        </p:nvSpPr>
        <p:spPr>
          <a:xfrm>
            <a:off x="844658" y="5877808"/>
            <a:ext cx="8285577" cy="1015663"/>
          </a:xfrm>
          <a:prstGeom prst="rect">
            <a:avLst/>
          </a:prstGeom>
          <a:noFill/>
        </p:spPr>
        <p:txBody>
          <a:bodyPr wrap="square" lIns="0" rtlCol="0" anchor="ctr" anchorCtr="0">
            <a:spAutoFit/>
          </a:bodyPr>
          <a:lstStyle/>
          <a:p>
            <a:pPr marL="228600" indent="-228600" defTabSz="685846">
              <a:buAutoNum type="arabicPeriod"/>
            </a:pPr>
            <a:r>
              <a:rPr lang="en-US" sz="1000" b="1" dirty="0">
                <a:solidFill>
                  <a:schemeClr val="bg1">
                    <a:lumMod val="50000"/>
                  </a:schemeClr>
                </a:solidFill>
                <a:latin typeface="+mj-lt"/>
                <a:ea typeface="League Spartan" charset="0"/>
                <a:cs typeface="Poppins" pitchFamily="2" charset="77"/>
              </a:rPr>
              <a:t>CLINICIAN WILL BE PRESENT AT MEETINGS MOVING FORWARD TO PROVIDE MENTAL HEALTH SUPPORT. </a:t>
            </a:r>
          </a:p>
          <a:p>
            <a:pPr marL="228600" indent="-228600" defTabSz="685846">
              <a:buAutoNum type="arabicPeriod"/>
            </a:pPr>
            <a:r>
              <a:rPr lang="en-US" sz="1000" b="1" dirty="0">
                <a:solidFill>
                  <a:schemeClr val="bg1">
                    <a:lumMod val="50000"/>
                  </a:schemeClr>
                </a:solidFill>
                <a:latin typeface="+mj-lt"/>
                <a:ea typeface="League Spartan" charset="0"/>
                <a:cs typeface="Poppins" pitchFamily="2" charset="77"/>
              </a:rPr>
              <a:t>SLACK GROUP CREATED TO PROMOTE INFORMAL COMMUNICATION/ENGAGEMENT. </a:t>
            </a:r>
          </a:p>
          <a:p>
            <a:pPr marL="228600" indent="-228600" defTabSz="685846">
              <a:buAutoNum type="arabicPeriod"/>
            </a:pPr>
            <a:r>
              <a:rPr lang="en-US" sz="1000" b="1" dirty="0">
                <a:solidFill>
                  <a:schemeClr val="bg1">
                    <a:lumMod val="50000"/>
                  </a:schemeClr>
                </a:solidFill>
                <a:latin typeface="+mj-lt"/>
                <a:ea typeface="League Spartan" charset="0"/>
                <a:cs typeface="Poppins" pitchFamily="2" charset="77"/>
              </a:rPr>
              <a:t>AGENDA SENT VIA SLACK, EMAIL, AND IN VIDEO FORM AT LEAST 1-WEEK PRIOR TO THE WORKNIG GROUP MEETING. </a:t>
            </a:r>
          </a:p>
          <a:p>
            <a:pPr marL="228600" indent="-228600" defTabSz="685846">
              <a:buAutoNum type="arabicPeriod"/>
            </a:pPr>
            <a:r>
              <a:rPr lang="en-US" sz="1000" b="1" dirty="0">
                <a:solidFill>
                  <a:schemeClr val="bg1">
                    <a:lumMod val="50000"/>
                  </a:schemeClr>
                </a:solidFill>
                <a:latin typeface="+mj-lt"/>
                <a:ea typeface="League Spartan" charset="0"/>
                <a:cs typeface="Poppins" pitchFamily="2" charset="77"/>
              </a:rPr>
              <a:t>MAKING SURE THAT ALL RESEARCHERS WILL GIVE AN UPDATE ON HOW THE GROUP’S CONTRIBUTIONS LED TO IMPACT.</a:t>
            </a:r>
          </a:p>
          <a:p>
            <a:pPr marL="228600" indent="-228600" defTabSz="685846">
              <a:buAutoNum type="arabicPeriod"/>
            </a:pPr>
            <a:r>
              <a:rPr lang="en-US" sz="1000" b="1" dirty="0">
                <a:solidFill>
                  <a:schemeClr val="bg1">
                    <a:lumMod val="50000"/>
                  </a:schemeClr>
                </a:solidFill>
                <a:latin typeface="+mj-lt"/>
                <a:ea typeface="League Spartan" charset="0"/>
                <a:cs typeface="Poppins" pitchFamily="2" charset="77"/>
              </a:rPr>
              <a:t>ENGAGING WITH THE RESEARCHERS WHO HAVE ENGAGED WITH THE GROUP TO REFLECT, GIVE FEEDBACK, AND COLLECTIVELY IMPROVE.</a:t>
            </a:r>
          </a:p>
          <a:p>
            <a:pPr marL="228600" indent="-228600" defTabSz="685846">
              <a:buAutoNum type="arabicPeriod"/>
            </a:pPr>
            <a:endParaRPr lang="en-US" sz="1000" b="1" dirty="0">
              <a:solidFill>
                <a:schemeClr val="bg1">
                  <a:lumMod val="50000"/>
                </a:schemeClr>
              </a:solidFill>
              <a:latin typeface="+mj-lt"/>
              <a:ea typeface="League Spartan" charset="0"/>
              <a:cs typeface="Poppins" pitchFamily="2" charset="77"/>
            </a:endParaRPr>
          </a:p>
        </p:txBody>
      </p:sp>
      <p:sp>
        <p:nvSpPr>
          <p:cNvPr id="70" name="TextBox 69">
            <a:extLst>
              <a:ext uri="{FF2B5EF4-FFF2-40B4-BE49-F238E27FC236}">
                <a16:creationId xmlns:a16="http://schemas.microsoft.com/office/drawing/2014/main" id="{7DD07CBF-24B8-654F-AB74-30DA05684354}"/>
              </a:ext>
            </a:extLst>
          </p:cNvPr>
          <p:cNvSpPr txBox="1"/>
          <p:nvPr/>
        </p:nvSpPr>
        <p:spPr>
          <a:xfrm>
            <a:off x="309345" y="5713520"/>
            <a:ext cx="1769202" cy="276999"/>
          </a:xfrm>
          <a:prstGeom prst="rect">
            <a:avLst/>
          </a:prstGeom>
          <a:noFill/>
        </p:spPr>
        <p:txBody>
          <a:bodyPr wrap="none" rtlCol="0" anchor="ctr" anchorCtr="0">
            <a:spAutoFit/>
          </a:bodyPr>
          <a:lstStyle/>
          <a:p>
            <a:r>
              <a:rPr lang="en-US" sz="1200" b="1" i="1" dirty="0">
                <a:solidFill>
                  <a:schemeClr val="bg1">
                    <a:lumMod val="50000"/>
                  </a:schemeClr>
                </a:solidFill>
                <a:latin typeface="+mj-lt"/>
                <a:ea typeface="League Spartan" charset="0"/>
                <a:cs typeface="Poppins" pitchFamily="2" charset="77"/>
              </a:rPr>
              <a:t>OTHER IMPROVEMENTS…</a:t>
            </a:r>
          </a:p>
        </p:txBody>
      </p:sp>
    </p:spTree>
    <p:extLst>
      <p:ext uri="{BB962C8B-B14F-4D97-AF65-F5344CB8AC3E}">
        <p14:creationId xmlns:p14="http://schemas.microsoft.com/office/powerpoint/2010/main" val="338876846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8D0356E6-8D19-AE44-8443-077E4CF7B0AF}"/>
              </a:ext>
            </a:extLst>
          </p:cNvPr>
          <p:cNvSpPr>
            <a:spLocks noGrp="1"/>
          </p:cNvSpPr>
          <p:nvPr>
            <p:ph type="title"/>
          </p:nvPr>
        </p:nvSpPr>
        <p:spPr/>
        <p:txBody>
          <a:bodyPr/>
          <a:lstStyle/>
          <a:p>
            <a:r>
              <a:rPr lang="en-US" sz="3000" dirty="0"/>
              <a:t>FEEDBACK MECHANISM OPTIONS:</a:t>
            </a:r>
            <a:br>
              <a:rPr lang="en-US" sz="3000" dirty="0"/>
            </a:br>
            <a:r>
              <a:rPr lang="en-US" sz="3000" i="1" dirty="0"/>
              <a:t>RESEARCHER TO WORKING GROUP</a:t>
            </a:r>
          </a:p>
        </p:txBody>
      </p:sp>
      <p:graphicFrame>
        <p:nvGraphicFramePr>
          <p:cNvPr id="9" name="Diagram 8">
            <a:extLst>
              <a:ext uri="{FF2B5EF4-FFF2-40B4-BE49-F238E27FC236}">
                <a16:creationId xmlns:a16="http://schemas.microsoft.com/office/drawing/2014/main" id="{066C7485-F79E-994F-BE13-3E29EA4F23BC}"/>
              </a:ext>
            </a:extLst>
          </p:cNvPr>
          <p:cNvGraphicFramePr/>
          <p:nvPr>
            <p:extLst>
              <p:ext uri="{D42A27DB-BD31-4B8C-83A1-F6EECF244321}">
                <p14:modId xmlns:p14="http://schemas.microsoft.com/office/powerpoint/2010/main" val="2847813624"/>
              </p:ext>
            </p:extLst>
          </p:nvPr>
        </p:nvGraphicFramePr>
        <p:xfrm>
          <a:off x="512956" y="1817649"/>
          <a:ext cx="8272270" cy="3453780"/>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10" name="TextBox 9">
            <a:extLst>
              <a:ext uri="{FF2B5EF4-FFF2-40B4-BE49-F238E27FC236}">
                <a16:creationId xmlns:a16="http://schemas.microsoft.com/office/drawing/2014/main" id="{FB081E2E-9C33-B54A-A5AF-76549E23558B}"/>
              </a:ext>
            </a:extLst>
          </p:cNvPr>
          <p:cNvSpPr txBox="1"/>
          <p:nvPr/>
        </p:nvSpPr>
        <p:spPr>
          <a:xfrm>
            <a:off x="512956" y="5271429"/>
            <a:ext cx="8285577" cy="1246495"/>
          </a:xfrm>
          <a:prstGeom prst="rect">
            <a:avLst/>
          </a:prstGeom>
          <a:noFill/>
        </p:spPr>
        <p:txBody>
          <a:bodyPr wrap="square" lIns="0" rtlCol="0" anchor="ctr" anchorCtr="0">
            <a:spAutoFit/>
          </a:bodyPr>
          <a:lstStyle/>
          <a:p>
            <a:pPr algn="ctr" defTabSz="685846"/>
            <a:r>
              <a:rPr lang="en-US" sz="1500" b="1" i="1" dirty="0">
                <a:solidFill>
                  <a:schemeClr val="bg1">
                    <a:lumMod val="50000"/>
                  </a:schemeClr>
                </a:solidFill>
                <a:latin typeface="+mj-lt"/>
                <a:ea typeface="League Spartan" charset="0"/>
                <a:cs typeface="Poppins" pitchFamily="2" charset="77"/>
              </a:rPr>
              <a:t>We will ensure that all Working Group contributions are formally acknowledged.</a:t>
            </a:r>
          </a:p>
          <a:p>
            <a:pPr algn="ctr" defTabSz="685846"/>
            <a:br>
              <a:rPr lang="en-US" sz="1500" b="1" i="1" dirty="0">
                <a:solidFill>
                  <a:schemeClr val="bg1">
                    <a:lumMod val="50000"/>
                  </a:schemeClr>
                </a:solidFill>
                <a:latin typeface="+mj-lt"/>
                <a:ea typeface="League Spartan" charset="0"/>
                <a:cs typeface="Poppins" pitchFamily="2" charset="77"/>
              </a:rPr>
            </a:br>
            <a:r>
              <a:rPr lang="en-US" sz="1500" b="1" i="1" dirty="0">
                <a:solidFill>
                  <a:schemeClr val="bg1">
                    <a:lumMod val="50000"/>
                  </a:schemeClr>
                </a:solidFill>
                <a:latin typeface="+mj-lt"/>
                <a:ea typeface="League Spartan" charset="0"/>
                <a:cs typeface="Poppins" pitchFamily="2" charset="77"/>
              </a:rPr>
              <a:t>We are also currently working with the Youth Mental Health team researchers to understand how they might like feedback given to them, with the aim of ensuring that research is constantly improving. </a:t>
            </a:r>
          </a:p>
          <a:p>
            <a:pPr algn="ctr" defTabSz="685846"/>
            <a:endParaRPr lang="en-US" sz="1500" b="1" i="1" dirty="0">
              <a:solidFill>
                <a:schemeClr val="bg1">
                  <a:lumMod val="50000"/>
                </a:schemeClr>
              </a:solidFill>
              <a:latin typeface="+mj-lt"/>
              <a:ea typeface="League Spartan" charset="0"/>
              <a:cs typeface="Poppins" pitchFamily="2" charset="77"/>
            </a:endParaRPr>
          </a:p>
        </p:txBody>
      </p:sp>
    </p:spTree>
    <p:extLst>
      <p:ext uri="{BB962C8B-B14F-4D97-AF65-F5344CB8AC3E}">
        <p14:creationId xmlns:p14="http://schemas.microsoft.com/office/powerpoint/2010/main" val="155616669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A picture containing text&#10;&#10;Description automatically generated">
            <a:extLst>
              <a:ext uri="{FF2B5EF4-FFF2-40B4-BE49-F238E27FC236}">
                <a16:creationId xmlns:a16="http://schemas.microsoft.com/office/drawing/2014/main" id="{F0DC7E57-F0EE-42A2-9C8E-8D8197227A3B}"/>
              </a:ext>
            </a:extLst>
          </p:cNvPr>
          <p:cNvPicPr>
            <a:picLocks noChangeAspect="1"/>
          </p:cNvPicPr>
          <p:nvPr/>
        </p:nvPicPr>
        <p:blipFill>
          <a:blip r:embed="rId3"/>
          <a:stretch>
            <a:fillRect/>
          </a:stretch>
        </p:blipFill>
        <p:spPr>
          <a:xfrm>
            <a:off x="3594" y="657325"/>
            <a:ext cx="9143497" cy="5095173"/>
          </a:xfrm>
          <a:prstGeom prst="rect">
            <a:avLst/>
          </a:prstGeom>
          <a:noFill/>
        </p:spPr>
      </p:pic>
    </p:spTree>
    <p:extLst>
      <p:ext uri="{BB962C8B-B14F-4D97-AF65-F5344CB8AC3E}">
        <p14:creationId xmlns:p14="http://schemas.microsoft.com/office/powerpoint/2010/main" val="1051965027"/>
      </p:ext>
    </p:extLst>
  </p:cSld>
  <p:clrMapOvr>
    <a:masterClrMapping/>
  </p:clrMapOvr>
</p:sld>
</file>

<file path=ppt/theme/theme1.xml><?xml version="1.0" encoding="utf-8"?>
<a:theme xmlns:a="http://schemas.openxmlformats.org/drawingml/2006/main" name="Master 2">
  <a:themeElements>
    <a:clrScheme name="The University of Sydney_Color Theme">
      <a:dk1>
        <a:sysClr val="windowText" lastClr="000000"/>
      </a:dk1>
      <a:lt1>
        <a:sysClr val="window" lastClr="FFFFFF"/>
      </a:lt1>
      <a:dk2>
        <a:srgbClr val="0148A4"/>
      </a:dk2>
      <a:lt2>
        <a:srgbClr val="EEECE1"/>
      </a:lt2>
      <a:accent1>
        <a:srgbClr val="E64626"/>
      </a:accent1>
      <a:accent2>
        <a:srgbClr val="EF8025"/>
      </a:accent2>
      <a:accent3>
        <a:srgbClr val="FFB800"/>
      </a:accent3>
      <a:accent4>
        <a:srgbClr val="5C923E"/>
      </a:accent4>
      <a:accent5>
        <a:srgbClr val="5496DB"/>
      </a:accent5>
      <a:accent6>
        <a:srgbClr val="0148A4"/>
      </a:accent6>
      <a:hlink>
        <a:srgbClr val="E64626"/>
      </a:hlink>
      <a:folHlink>
        <a:srgbClr val="F05133"/>
      </a:folHlink>
    </a:clrScheme>
    <a:fontScheme name="Median">
      <a:maj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1_PPT-template-standard-JGC">
  <a:themeElements>
    <a:clrScheme name="The University of Sydney_Color Theme">
      <a:dk1>
        <a:sysClr val="windowText" lastClr="000000"/>
      </a:dk1>
      <a:lt1>
        <a:sysClr val="window" lastClr="FFFFFF"/>
      </a:lt1>
      <a:dk2>
        <a:srgbClr val="0148A4"/>
      </a:dk2>
      <a:lt2>
        <a:srgbClr val="EEECE1"/>
      </a:lt2>
      <a:accent1>
        <a:srgbClr val="E64626"/>
      </a:accent1>
      <a:accent2>
        <a:srgbClr val="EF8025"/>
      </a:accent2>
      <a:accent3>
        <a:srgbClr val="FFB800"/>
      </a:accent3>
      <a:accent4>
        <a:srgbClr val="5C923E"/>
      </a:accent4>
      <a:accent5>
        <a:srgbClr val="5496DB"/>
      </a:accent5>
      <a:accent6>
        <a:srgbClr val="0148A4"/>
      </a:accent6>
      <a:hlink>
        <a:srgbClr val="E64626"/>
      </a:hlink>
      <a:folHlink>
        <a:srgbClr val="F05133"/>
      </a:folHlink>
    </a:clrScheme>
    <a:fontScheme name="Median">
      <a:maj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889</TotalTime>
  <Words>1260</Words>
  <Application>Microsoft Office PowerPoint</Application>
  <PresentationFormat>On-screen Show (4:3)</PresentationFormat>
  <Paragraphs>222</Paragraphs>
  <Slides>21</Slides>
  <Notes>5</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21</vt:i4>
      </vt:variant>
    </vt:vector>
  </HeadingPairs>
  <TitlesOfParts>
    <vt:vector size="28" baseType="lpstr">
      <vt:lpstr>Lucida Grande</vt:lpstr>
      <vt:lpstr>Arial</vt:lpstr>
      <vt:lpstr>Calibri</vt:lpstr>
      <vt:lpstr>Lato Light</vt:lpstr>
      <vt:lpstr>Tw Cen MT</vt:lpstr>
      <vt:lpstr>Master 2</vt:lpstr>
      <vt:lpstr>1_PPT-template-standard-JGC</vt:lpstr>
      <vt:lpstr>WELCOME.. </vt:lpstr>
      <vt:lpstr>PowerPoint Presentation</vt:lpstr>
      <vt:lpstr>PowerPoint Presentation</vt:lpstr>
      <vt:lpstr>AGENDA</vt:lpstr>
      <vt:lpstr>UPDATE – WHAT ARE OUR GOALS?</vt:lpstr>
      <vt:lpstr>PowerPoint Presentation</vt:lpstr>
      <vt:lpstr>PowerPoint Presentation</vt:lpstr>
      <vt:lpstr>FEEDBACK MECHANISM OPTIONS: RESEARCHER TO WORKING GROUP</vt:lpstr>
      <vt:lpstr>PowerPoint Presentation</vt:lpstr>
      <vt:lpstr>PowerPoint Presentation</vt:lpstr>
      <vt:lpstr>PowerPoint Presentation</vt:lpstr>
      <vt:lpstr>ACTIVITY – TERMS OF REFERENCE</vt:lpstr>
      <vt:lpstr>AGENDA</vt:lpstr>
      <vt:lpstr>COMMON TERMS AND/OR ROLES </vt:lpstr>
      <vt:lpstr>PowerPoint Presentation</vt:lpstr>
      <vt:lpstr>PowerPoint Presentation</vt:lpstr>
      <vt:lpstr>PowerPoint Presentation</vt:lpstr>
      <vt:lpstr>PowerPoint Presentation</vt:lpstr>
      <vt:lpstr>PowerPoint Presentation</vt:lpstr>
      <vt:lpstr>DEBRIEF</vt:lpstr>
      <vt:lpstr>QUESTIONS AND/OR FEEDBACK?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Grace Lee</cp:lastModifiedBy>
  <cp:revision>16</cp:revision>
  <dcterms:created xsi:type="dcterms:W3CDTF">2021-08-31T06:01:01Z</dcterms:created>
  <dcterms:modified xsi:type="dcterms:W3CDTF">2023-04-14T03:41:49Z</dcterms:modified>
</cp:coreProperties>
</file>